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6480175" cy="5040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50" d="100"/>
          <a:sy n="150" d="100"/>
        </p:scale>
        <p:origin x="1710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824885"/>
            <a:ext cx="5508149" cy="1754776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2647331"/>
            <a:ext cx="4860131" cy="1216909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2FAB1-C95B-494E-80DB-FF0CF42C7890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047-9752-4542-8D1E-91CED16B2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980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2FAB1-C95B-494E-80DB-FF0CF42C7890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047-9752-4542-8D1E-91CED16B2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612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268350"/>
            <a:ext cx="1397288" cy="427143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268350"/>
            <a:ext cx="4110861" cy="427143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2FAB1-C95B-494E-80DB-FF0CF42C7890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047-9752-4542-8D1E-91CED16B2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860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2FAB1-C95B-494E-80DB-FF0CF42C7890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047-9752-4542-8D1E-91CED16B2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846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256579"/>
            <a:ext cx="5589151" cy="2096630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3373044"/>
            <a:ext cx="5589151" cy="110256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2FAB1-C95B-494E-80DB-FF0CF42C7890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047-9752-4542-8D1E-91CED16B2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799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1341750"/>
            <a:ext cx="2754074" cy="319803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1341750"/>
            <a:ext cx="2754074" cy="319803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2FAB1-C95B-494E-80DB-FF0CF42C7890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047-9752-4542-8D1E-91CED16B2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8372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268351"/>
            <a:ext cx="5589151" cy="97422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235577"/>
            <a:ext cx="2741417" cy="60553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1841114"/>
            <a:ext cx="2741417" cy="270800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235577"/>
            <a:ext cx="2754918" cy="60553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1841114"/>
            <a:ext cx="2754918" cy="270800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2FAB1-C95B-494E-80DB-FF0CF42C7890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047-9752-4542-8D1E-91CED16B2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8033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2FAB1-C95B-494E-80DB-FF0CF42C7890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047-9752-4542-8D1E-91CED16B2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746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2FAB1-C95B-494E-80DB-FF0CF42C7890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047-9752-4542-8D1E-91CED16B2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453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36021"/>
            <a:ext cx="2090025" cy="1176073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725713"/>
            <a:ext cx="3280589" cy="3581889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512094"/>
            <a:ext cx="2090025" cy="2801341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2FAB1-C95B-494E-80DB-FF0CF42C7890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047-9752-4542-8D1E-91CED16B2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294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36021"/>
            <a:ext cx="2090025" cy="1176073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725713"/>
            <a:ext cx="3280589" cy="3581889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512094"/>
            <a:ext cx="2090025" cy="2801341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2FAB1-C95B-494E-80DB-FF0CF42C7890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047-9752-4542-8D1E-91CED16B2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072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268351"/>
            <a:ext cx="5589151" cy="9742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1341750"/>
            <a:ext cx="5589151" cy="31980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4671625"/>
            <a:ext cx="1458039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32FAB1-C95B-494E-80DB-FF0CF42C7890}" type="datetimeFigureOut">
              <a:rPr lang="en-US" smtClean="0"/>
              <a:t>4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4671625"/>
            <a:ext cx="2187059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4671625"/>
            <a:ext cx="1458039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A79047-9752-4542-8D1E-91CED16B2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428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A61804DB-66F3-3E02-4A8A-F0604119BA15}"/>
              </a:ext>
            </a:extLst>
          </p:cNvPr>
          <p:cNvGrpSpPr/>
          <p:nvPr/>
        </p:nvGrpSpPr>
        <p:grpSpPr>
          <a:xfrm>
            <a:off x="195493" y="0"/>
            <a:ext cx="6039083" cy="5015641"/>
            <a:chOff x="195493" y="0"/>
            <a:chExt cx="6039083" cy="5015641"/>
          </a:xfrm>
        </p:grpSpPr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DCF0182C-D70E-D11F-85B5-4F3F44D166F6}"/>
                </a:ext>
              </a:extLst>
            </p:cNvPr>
            <p:cNvSpPr txBox="1"/>
            <p:nvPr/>
          </p:nvSpPr>
          <p:spPr>
            <a:xfrm>
              <a:off x="198292" y="54949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A5D9CEC7-D9AD-8A66-FA54-81DC75349B34}"/>
                </a:ext>
              </a:extLst>
            </p:cNvPr>
            <p:cNvSpPr txBox="1"/>
            <p:nvPr/>
          </p:nvSpPr>
          <p:spPr>
            <a:xfrm>
              <a:off x="1535517" y="54949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27B86AB1-0D61-27D9-02B4-B690695C631C}"/>
                </a:ext>
              </a:extLst>
            </p:cNvPr>
            <p:cNvSpPr txBox="1"/>
            <p:nvPr/>
          </p:nvSpPr>
          <p:spPr>
            <a:xfrm>
              <a:off x="4942999" y="54949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90" name="Picture 89">
              <a:extLst>
                <a:ext uri="{FF2B5EF4-FFF2-40B4-BE49-F238E27FC236}">
                  <a16:creationId xmlns:a16="http://schemas.microsoft.com/office/drawing/2014/main" id="{B8A2CD3B-0FA8-AB06-C930-12A605486AB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705798" y="217744"/>
              <a:ext cx="3240000" cy="1079999"/>
            </a:xfrm>
            <a:prstGeom prst="rect">
              <a:avLst/>
            </a:prstGeom>
          </p:spPr>
        </p:pic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id="{9B0DFEE1-3D45-CD18-B747-EF00B2CE3781}"/>
                </a:ext>
              </a:extLst>
            </p:cNvPr>
            <p:cNvGrpSpPr/>
            <p:nvPr/>
          </p:nvGrpSpPr>
          <p:grpSpPr>
            <a:xfrm>
              <a:off x="437648" y="0"/>
              <a:ext cx="900000" cy="1550888"/>
              <a:chOff x="1446449" y="1252619"/>
              <a:chExt cx="900000" cy="1550888"/>
            </a:xfrm>
          </p:grpSpPr>
          <p:pic>
            <p:nvPicPr>
              <p:cNvPr id="124" name="Picture 123">
                <a:extLst>
                  <a:ext uri="{FF2B5EF4-FFF2-40B4-BE49-F238E27FC236}">
                    <a16:creationId xmlns:a16="http://schemas.microsoft.com/office/drawing/2014/main" id="{150752B2-DCBD-404A-99AF-34F68615CFA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1446449" y="1252619"/>
                <a:ext cx="900000" cy="900000"/>
              </a:xfrm>
              <a:prstGeom prst="rect">
                <a:avLst/>
              </a:prstGeom>
              <a:scene3d>
                <a:camera prst="isometricOffAxis2Top"/>
                <a:lightRig rig="threePt" dir="t"/>
              </a:scene3d>
            </p:spPr>
          </p:pic>
          <p:pic>
            <p:nvPicPr>
              <p:cNvPr id="125" name="Picture 124">
                <a:extLst>
                  <a:ext uri="{FF2B5EF4-FFF2-40B4-BE49-F238E27FC236}">
                    <a16:creationId xmlns:a16="http://schemas.microsoft.com/office/drawing/2014/main" id="{7AED9E34-A47C-7812-F5FB-97420488764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1446449" y="1903507"/>
                <a:ext cx="900000" cy="900000"/>
              </a:xfrm>
              <a:prstGeom prst="rect">
                <a:avLst/>
              </a:prstGeom>
              <a:scene3d>
                <a:camera prst="isometricOffAxis2Top"/>
                <a:lightRig rig="threePt" dir="t"/>
              </a:scene3d>
            </p:spPr>
          </p:pic>
          <p:sp>
            <p:nvSpPr>
              <p:cNvPr id="126" name="Rectangle 125">
                <a:extLst>
                  <a:ext uri="{FF2B5EF4-FFF2-40B4-BE49-F238E27FC236}">
                    <a16:creationId xmlns:a16="http://schemas.microsoft.com/office/drawing/2014/main" id="{BCD4F84F-AA74-07DE-0744-4E077FAF819B}"/>
                  </a:ext>
                </a:extLst>
              </p:cNvPr>
              <p:cNvSpPr/>
              <p:nvPr/>
            </p:nvSpPr>
            <p:spPr>
              <a:xfrm rot="16200000">
                <a:off x="1758455" y="1969006"/>
                <a:ext cx="275989" cy="18573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…</a:t>
                </a:r>
              </a:p>
            </p:txBody>
          </p:sp>
        </p:grp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E215DD46-2724-5927-8047-E81133774E2B}"/>
                </a:ext>
              </a:extLst>
            </p:cNvPr>
            <p:cNvSpPr txBox="1"/>
            <p:nvPr/>
          </p:nvSpPr>
          <p:spPr>
            <a:xfrm>
              <a:off x="195493" y="1297744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AAD9B074-3D46-E973-C83D-B47DAF9F73BC}"/>
                </a:ext>
              </a:extLst>
            </p:cNvPr>
            <p:cNvSpPr txBox="1"/>
            <p:nvPr/>
          </p:nvSpPr>
          <p:spPr>
            <a:xfrm>
              <a:off x="1532718" y="1297744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DB1E020F-F448-E390-81D8-DE5FB2EE0668}"/>
                </a:ext>
              </a:extLst>
            </p:cNvPr>
            <p:cNvSpPr txBox="1"/>
            <p:nvPr/>
          </p:nvSpPr>
          <p:spPr>
            <a:xfrm>
              <a:off x="4940200" y="1297744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pic>
          <p:nvPicPr>
            <p:cNvPr id="95" name="Picture 94" descr="A close up of the moon&#10;&#10;Description automatically generated with medium confidence">
              <a:extLst>
                <a:ext uri="{FF2B5EF4-FFF2-40B4-BE49-F238E27FC236}">
                  <a16:creationId xmlns:a16="http://schemas.microsoft.com/office/drawing/2014/main" id="{6ED52C0E-AB2A-4CD8-A1A9-99CD004639B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648" y="1460539"/>
              <a:ext cx="1080000" cy="1080000"/>
            </a:xfrm>
            <a:prstGeom prst="rect">
              <a:avLst/>
            </a:prstGeom>
          </p:spPr>
        </p:pic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5473489F-AD7F-2F5C-1751-A79A6B227B4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703000" y="1460539"/>
              <a:ext cx="3239997" cy="1079999"/>
            </a:xfrm>
            <a:prstGeom prst="rect">
              <a:avLst/>
            </a:prstGeom>
          </p:spPr>
        </p:pic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5EF63C7C-B524-8FC0-A86B-35EC3052B662}"/>
                </a:ext>
              </a:extLst>
            </p:cNvPr>
            <p:cNvCxnSpPr>
              <a:cxnSpLocks/>
            </p:cNvCxnSpPr>
            <p:nvPr/>
          </p:nvCxnSpPr>
          <p:spPr>
            <a:xfrm>
              <a:off x="1769298" y="1222005"/>
              <a:ext cx="288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33FFBE22-198D-873C-F40D-586A7B92D154}"/>
                </a:ext>
              </a:extLst>
            </p:cNvPr>
            <p:cNvSpPr/>
            <p:nvPr/>
          </p:nvSpPr>
          <p:spPr>
            <a:xfrm>
              <a:off x="1670447" y="220125"/>
              <a:ext cx="1167355" cy="2543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700" dirty="0" err="1">
                  <a:solidFill>
                    <a:srgbClr val="20B0B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pose</a:t>
              </a:r>
              <a:r>
                <a:rPr lang="en-US" sz="700" dirty="0">
                  <a:solidFill>
                    <a:srgbClr val="20B0B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r>
                <a:rPr lang="en-US" sz="700" dirty="0">
                  <a:solidFill>
                    <a:srgbClr val="20B0B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3D z-stack)</a:t>
              </a:r>
            </a:p>
          </p:txBody>
        </p:sp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id="{39F5E134-21DE-5B98-9A77-70BDF2ADDFAD}"/>
                </a:ext>
              </a:extLst>
            </p:cNvPr>
            <p:cNvSpPr/>
            <p:nvPr/>
          </p:nvSpPr>
          <p:spPr>
            <a:xfrm>
              <a:off x="1667549" y="1461982"/>
              <a:ext cx="1162194" cy="2543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7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Snap</a:t>
              </a:r>
              <a:endParaRPr lang="en-US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7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2D snapshot)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1F5BD793-45D2-1BA1-4F39-2EB775830F92}"/>
                </a:ext>
              </a:extLst>
            </p:cNvPr>
            <p:cNvSpPr txBox="1"/>
            <p:nvPr/>
          </p:nvSpPr>
          <p:spPr>
            <a:xfrm>
              <a:off x="203553" y="2530967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48DBB240-72A0-87CA-ED7B-577F0E6CBF38}"/>
                </a:ext>
              </a:extLst>
            </p:cNvPr>
            <p:cNvSpPr txBox="1"/>
            <p:nvPr/>
          </p:nvSpPr>
          <p:spPr>
            <a:xfrm>
              <a:off x="1540778" y="2530967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06FE2FAE-6109-97F0-6445-11D2400A9796}"/>
                </a:ext>
              </a:extLst>
            </p:cNvPr>
            <p:cNvSpPr txBox="1"/>
            <p:nvPr/>
          </p:nvSpPr>
          <p:spPr>
            <a:xfrm>
              <a:off x="4948260" y="2530967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pic>
          <p:nvPicPr>
            <p:cNvPr id="103" name="Picture 102">
              <a:extLst>
                <a:ext uri="{FF2B5EF4-FFF2-40B4-BE49-F238E27FC236}">
                  <a16:creationId xmlns:a16="http://schemas.microsoft.com/office/drawing/2014/main" id="{AB7F4496-8018-4640-1B76-2F7E66BA683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704916" y="2692846"/>
              <a:ext cx="3239997" cy="1079998"/>
            </a:xfrm>
            <a:prstGeom prst="rect">
              <a:avLst/>
            </a:prstGeom>
          </p:spPr>
        </p:pic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00ECF7E2-1579-EA73-BE1A-49F6E3EEA28A}"/>
                </a:ext>
              </a:extLst>
            </p:cNvPr>
            <p:cNvSpPr/>
            <p:nvPr/>
          </p:nvSpPr>
          <p:spPr>
            <a:xfrm>
              <a:off x="1675609" y="2695205"/>
              <a:ext cx="1162194" cy="33855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ue positive</a:t>
              </a:r>
            </a:p>
            <a:p>
              <a:r>
                <a:rPr lang="en-US" sz="7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alse positive</a:t>
              </a:r>
            </a:p>
            <a:p>
              <a:r>
                <a:rPr lang="en-US" sz="700" dirty="0">
                  <a:solidFill>
                    <a:srgbClr val="00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alse negative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03FAE867-C5BA-1ACE-88B0-777BED677F35}"/>
                </a:ext>
              </a:extLst>
            </p:cNvPr>
            <p:cNvSpPr txBox="1"/>
            <p:nvPr/>
          </p:nvSpPr>
          <p:spPr>
            <a:xfrm>
              <a:off x="195493" y="3764190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4C709427-1DA2-BEB6-80BC-B5933F61D735}"/>
                </a:ext>
              </a:extLst>
            </p:cNvPr>
            <p:cNvSpPr txBox="1"/>
            <p:nvPr/>
          </p:nvSpPr>
          <p:spPr>
            <a:xfrm>
              <a:off x="1532718" y="3764190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84E6428A-5EDE-3E52-3CF1-61A2536B5F92}"/>
                </a:ext>
              </a:extLst>
            </p:cNvPr>
            <p:cNvSpPr txBox="1"/>
            <p:nvPr/>
          </p:nvSpPr>
          <p:spPr>
            <a:xfrm>
              <a:off x="3209866" y="3773761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F0B2DEE9-8F8F-8769-F487-8FDBA5AF171F}"/>
                </a:ext>
              </a:extLst>
            </p:cNvPr>
            <p:cNvSpPr txBox="1"/>
            <p:nvPr/>
          </p:nvSpPr>
          <p:spPr>
            <a:xfrm>
              <a:off x="4497405" y="3773761"/>
              <a:ext cx="209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F0E943A4-0C5D-C1C2-4F3C-CDC3B4EAD9B1}"/>
                </a:ext>
              </a:extLst>
            </p:cNvPr>
            <p:cNvSpPr/>
            <p:nvPr/>
          </p:nvSpPr>
          <p:spPr>
            <a:xfrm>
              <a:off x="2028826" y="1869569"/>
              <a:ext cx="126206" cy="96762"/>
            </a:xfrm>
            <a:prstGeom prst="rect">
              <a:avLst/>
            </a:prstGeom>
            <a:noFill/>
            <a:ln w="635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8" name="Rectangle 127">
              <a:extLst>
                <a:ext uri="{FF2B5EF4-FFF2-40B4-BE49-F238E27FC236}">
                  <a16:creationId xmlns:a16="http://schemas.microsoft.com/office/drawing/2014/main" id="{10FF343C-4C48-8359-3834-7370F6D564A0}"/>
                </a:ext>
              </a:extLst>
            </p:cNvPr>
            <p:cNvSpPr/>
            <p:nvPr/>
          </p:nvSpPr>
          <p:spPr>
            <a:xfrm>
              <a:off x="2028826" y="623930"/>
              <a:ext cx="126206" cy="96762"/>
            </a:xfrm>
            <a:prstGeom prst="rect">
              <a:avLst/>
            </a:prstGeom>
            <a:noFill/>
            <a:ln w="635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9" name="Rectangle 128">
              <a:extLst>
                <a:ext uri="{FF2B5EF4-FFF2-40B4-BE49-F238E27FC236}">
                  <a16:creationId xmlns:a16="http://schemas.microsoft.com/office/drawing/2014/main" id="{A395F9C6-D6B1-8B76-B0A1-881871DDC300}"/>
                </a:ext>
              </a:extLst>
            </p:cNvPr>
            <p:cNvSpPr/>
            <p:nvPr/>
          </p:nvSpPr>
          <p:spPr>
            <a:xfrm>
              <a:off x="2028826" y="3101348"/>
              <a:ext cx="126206" cy="96762"/>
            </a:xfrm>
            <a:prstGeom prst="rect">
              <a:avLst/>
            </a:prstGeom>
            <a:noFill/>
            <a:ln w="635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39" name="Group 138">
              <a:extLst>
                <a:ext uri="{FF2B5EF4-FFF2-40B4-BE49-F238E27FC236}">
                  <a16:creationId xmlns:a16="http://schemas.microsoft.com/office/drawing/2014/main" id="{37565A6B-6A02-02BA-7F23-D89BAC42778A}"/>
                </a:ext>
              </a:extLst>
            </p:cNvPr>
            <p:cNvGrpSpPr/>
            <p:nvPr/>
          </p:nvGrpSpPr>
          <p:grpSpPr>
            <a:xfrm>
              <a:off x="2409338" y="1008838"/>
              <a:ext cx="360000" cy="276020"/>
              <a:chOff x="2421243" y="1019242"/>
              <a:chExt cx="360000" cy="276020"/>
            </a:xfrm>
          </p:grpSpPr>
          <p:pic>
            <p:nvPicPr>
              <p:cNvPr id="132" name="Picture 131" descr="A picture containing outdoor object&#10;&#10;Description automatically generated">
                <a:extLst>
                  <a:ext uri="{FF2B5EF4-FFF2-40B4-BE49-F238E27FC236}">
                    <a16:creationId xmlns:a16="http://schemas.microsoft.com/office/drawing/2014/main" id="{FE503689-6DB0-8F0F-401B-2242F573E26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952" t="38070" r="86153" b="52970"/>
              <a:stretch/>
            </p:blipFill>
            <p:spPr>
              <a:xfrm>
                <a:off x="2421243" y="1019242"/>
                <a:ext cx="360000" cy="276020"/>
              </a:xfrm>
              <a:prstGeom prst="rect">
                <a:avLst/>
              </a:prstGeom>
            </p:spPr>
          </p:pic>
          <p:sp>
            <p:nvSpPr>
              <p:cNvPr id="131" name="Rectangle 130">
                <a:extLst>
                  <a:ext uri="{FF2B5EF4-FFF2-40B4-BE49-F238E27FC236}">
                    <a16:creationId xmlns:a16="http://schemas.microsoft.com/office/drawing/2014/main" id="{81DDB11D-DBA2-E5B7-D413-3B1EB05E0E0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421243" y="1019246"/>
                <a:ext cx="360000" cy="276012"/>
              </a:xfrm>
              <a:prstGeom prst="rect">
                <a:avLst/>
              </a:prstGeom>
              <a:noFill/>
              <a:ln w="63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38" name="Group 137">
              <a:extLst>
                <a:ext uri="{FF2B5EF4-FFF2-40B4-BE49-F238E27FC236}">
                  <a16:creationId xmlns:a16="http://schemas.microsoft.com/office/drawing/2014/main" id="{46294F0F-D643-3E50-E04D-0EB2CF1F6F9A}"/>
                </a:ext>
              </a:extLst>
            </p:cNvPr>
            <p:cNvGrpSpPr/>
            <p:nvPr/>
          </p:nvGrpSpPr>
          <p:grpSpPr>
            <a:xfrm>
              <a:off x="2409338" y="2253709"/>
              <a:ext cx="360000" cy="276020"/>
              <a:chOff x="2421243" y="2267381"/>
              <a:chExt cx="360000" cy="276020"/>
            </a:xfrm>
          </p:grpSpPr>
          <p:pic>
            <p:nvPicPr>
              <p:cNvPr id="130" name="Picture 129">
                <a:extLst>
                  <a:ext uri="{FF2B5EF4-FFF2-40B4-BE49-F238E27FC236}">
                    <a16:creationId xmlns:a16="http://schemas.microsoft.com/office/drawing/2014/main" id="{C441FD02-3EDF-B212-304F-CCC8B87A4E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952" t="38069" r="86153" b="52971"/>
              <a:stretch/>
            </p:blipFill>
            <p:spPr>
              <a:xfrm>
                <a:off x="2421243" y="2267381"/>
                <a:ext cx="360000" cy="276020"/>
              </a:xfrm>
              <a:prstGeom prst="rect">
                <a:avLst/>
              </a:prstGeom>
            </p:spPr>
          </p:pic>
          <p:sp>
            <p:nvSpPr>
              <p:cNvPr id="135" name="Rectangle 134">
                <a:extLst>
                  <a:ext uri="{FF2B5EF4-FFF2-40B4-BE49-F238E27FC236}">
                    <a16:creationId xmlns:a16="http://schemas.microsoft.com/office/drawing/2014/main" id="{02ACBA55-B336-F5FE-70F4-03FB9032DEB4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421243" y="2267385"/>
                <a:ext cx="360000" cy="276012"/>
              </a:xfrm>
              <a:prstGeom prst="rect">
                <a:avLst/>
              </a:prstGeom>
              <a:noFill/>
              <a:ln w="63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37" name="Group 136">
              <a:extLst>
                <a:ext uri="{FF2B5EF4-FFF2-40B4-BE49-F238E27FC236}">
                  <a16:creationId xmlns:a16="http://schemas.microsoft.com/office/drawing/2014/main" id="{F8F5CE67-4DF0-B31C-7C62-4B4A485BEC90}"/>
                </a:ext>
              </a:extLst>
            </p:cNvPr>
            <p:cNvGrpSpPr/>
            <p:nvPr/>
          </p:nvGrpSpPr>
          <p:grpSpPr>
            <a:xfrm>
              <a:off x="2409338" y="3483414"/>
              <a:ext cx="360000" cy="276014"/>
              <a:chOff x="2416447" y="3488176"/>
              <a:chExt cx="360000" cy="276014"/>
            </a:xfrm>
          </p:grpSpPr>
          <p:pic>
            <p:nvPicPr>
              <p:cNvPr id="133" name="Picture 132">
                <a:extLst>
                  <a:ext uri="{FF2B5EF4-FFF2-40B4-BE49-F238E27FC236}">
                    <a16:creationId xmlns:a16="http://schemas.microsoft.com/office/drawing/2014/main" id="{FDA5B81D-16B9-891E-6E49-924C7287DC7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951" t="38070" r="86154" b="52971"/>
              <a:stretch/>
            </p:blipFill>
            <p:spPr>
              <a:xfrm>
                <a:off x="2416447" y="3488176"/>
                <a:ext cx="360000" cy="276014"/>
              </a:xfrm>
              <a:prstGeom prst="rect">
                <a:avLst/>
              </a:prstGeom>
            </p:spPr>
          </p:pic>
          <p:sp>
            <p:nvSpPr>
              <p:cNvPr id="136" name="Rectangle 135">
                <a:extLst>
                  <a:ext uri="{FF2B5EF4-FFF2-40B4-BE49-F238E27FC236}">
                    <a16:creationId xmlns:a16="http://schemas.microsoft.com/office/drawing/2014/main" id="{329B6410-67DC-52D3-1C7E-E1E8717C4EF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416447" y="3488178"/>
                <a:ext cx="360000" cy="276012"/>
              </a:xfrm>
              <a:prstGeom prst="rect">
                <a:avLst/>
              </a:prstGeom>
              <a:noFill/>
              <a:ln w="63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41" name="Isosceles Triangle 140">
              <a:extLst>
                <a:ext uri="{FF2B5EF4-FFF2-40B4-BE49-F238E27FC236}">
                  <a16:creationId xmlns:a16="http://schemas.microsoft.com/office/drawing/2014/main" id="{C8F47F78-5AD4-B2F5-E96F-85B8FFC577C4}"/>
                </a:ext>
              </a:extLst>
            </p:cNvPr>
            <p:cNvSpPr/>
            <p:nvPr/>
          </p:nvSpPr>
          <p:spPr>
            <a:xfrm rot="13580308">
              <a:off x="1332030" y="1920215"/>
              <a:ext cx="45085" cy="64800"/>
            </a:xfrm>
            <a:prstGeom prst="triangl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US"/>
            </a:p>
          </p:txBody>
        </p:sp>
        <p:sp>
          <p:nvSpPr>
            <p:cNvPr id="142" name="Isosceles Triangle 141">
              <a:extLst>
                <a:ext uri="{FF2B5EF4-FFF2-40B4-BE49-F238E27FC236}">
                  <a16:creationId xmlns:a16="http://schemas.microsoft.com/office/drawing/2014/main" id="{875F9CA8-B2A4-05E6-98C8-3E43F5E46599}"/>
                </a:ext>
              </a:extLst>
            </p:cNvPr>
            <p:cNvSpPr/>
            <p:nvPr/>
          </p:nvSpPr>
          <p:spPr>
            <a:xfrm rot="13580308">
              <a:off x="2670451" y="1920215"/>
              <a:ext cx="45085" cy="64800"/>
            </a:xfrm>
            <a:prstGeom prst="triangl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US"/>
            </a:p>
          </p:txBody>
        </p:sp>
        <p:sp>
          <p:nvSpPr>
            <p:cNvPr id="143" name="Isosceles Triangle 142">
              <a:extLst>
                <a:ext uri="{FF2B5EF4-FFF2-40B4-BE49-F238E27FC236}">
                  <a16:creationId xmlns:a16="http://schemas.microsoft.com/office/drawing/2014/main" id="{D422E932-B2A3-C0BA-31DA-A2707E870C19}"/>
                </a:ext>
              </a:extLst>
            </p:cNvPr>
            <p:cNvSpPr/>
            <p:nvPr/>
          </p:nvSpPr>
          <p:spPr>
            <a:xfrm rot="13580308">
              <a:off x="2670451" y="3150366"/>
              <a:ext cx="45085" cy="64800"/>
            </a:xfrm>
            <a:prstGeom prst="triangl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US"/>
            </a:p>
          </p:txBody>
        </p: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56EA0070-C487-F177-5DD8-E43D85C2F7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96" t="9496"/>
            <a:stretch/>
          </p:blipFill>
          <p:spPr>
            <a:xfrm>
              <a:off x="5116079" y="217744"/>
              <a:ext cx="1080000" cy="1080000"/>
            </a:xfrm>
            <a:prstGeom prst="rect">
              <a:avLst/>
            </a:prstGeom>
          </p:spPr>
        </p:pic>
        <p:pic>
          <p:nvPicPr>
            <p:cNvPr id="20" name="Picture 19" descr="A picture containing text, satellite&#10;&#10;Description automatically generated">
              <a:extLst>
                <a:ext uri="{FF2B5EF4-FFF2-40B4-BE49-F238E27FC236}">
                  <a16:creationId xmlns:a16="http://schemas.microsoft.com/office/drawing/2014/main" id="{6529CB4F-732B-D52C-A841-EE1A094E19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96" t="9496"/>
            <a:stretch/>
          </p:blipFill>
          <p:spPr>
            <a:xfrm>
              <a:off x="5113198" y="2692845"/>
              <a:ext cx="1080000" cy="1080000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7D438B8F-2C02-A080-D1A3-986AD6B8337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96" t="9496"/>
            <a:stretch/>
          </p:blipFill>
          <p:spPr>
            <a:xfrm>
              <a:off x="5113280" y="1460538"/>
              <a:ext cx="1080000" cy="1080000"/>
            </a:xfrm>
            <a:prstGeom prst="rect">
              <a:avLst/>
            </a:prstGeom>
          </p:spPr>
        </p:pic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76553E42-ADFD-8AAB-D172-5FF9A50C96AF}"/>
                </a:ext>
              </a:extLst>
            </p:cNvPr>
            <p:cNvGrpSpPr/>
            <p:nvPr/>
          </p:nvGrpSpPr>
          <p:grpSpPr>
            <a:xfrm>
              <a:off x="5617977" y="285392"/>
              <a:ext cx="348803" cy="246185"/>
              <a:chOff x="5656079" y="347306"/>
              <a:chExt cx="348803" cy="246185"/>
            </a:xfrm>
          </p:grpSpPr>
          <p:cxnSp>
            <p:nvCxnSpPr>
              <p:cNvPr id="112" name="Straight Arrow Connector 111">
                <a:extLst>
                  <a:ext uri="{FF2B5EF4-FFF2-40B4-BE49-F238E27FC236}">
                    <a16:creationId xmlns:a16="http://schemas.microsoft.com/office/drawing/2014/main" id="{884DBB4A-7AC3-2E5E-5BDC-72E5C7FFCC76}"/>
                  </a:ext>
                </a:extLst>
              </p:cNvPr>
              <p:cNvCxnSpPr>
                <a:cxnSpLocks/>
              </p:cNvCxnSpPr>
              <p:nvPr/>
            </p:nvCxnSpPr>
            <p:spPr>
              <a:xfrm rot="180000" flipH="1">
                <a:off x="5812706" y="363212"/>
                <a:ext cx="26216" cy="132088"/>
              </a:xfrm>
              <a:prstGeom prst="straightConnector1">
                <a:avLst/>
              </a:prstGeom>
              <a:ln w="6350">
                <a:solidFill>
                  <a:schemeClr val="bg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Straight Arrow Connector 112">
                <a:extLst>
                  <a:ext uri="{FF2B5EF4-FFF2-40B4-BE49-F238E27FC236}">
                    <a16:creationId xmlns:a16="http://schemas.microsoft.com/office/drawing/2014/main" id="{E6AFDAE3-E4C2-3008-EBD2-E456CB46B9EF}"/>
                  </a:ext>
                </a:extLst>
              </p:cNvPr>
              <p:cNvCxnSpPr>
                <a:cxnSpLocks/>
              </p:cNvCxnSpPr>
              <p:nvPr/>
            </p:nvCxnSpPr>
            <p:spPr>
              <a:xfrm rot="21420000">
                <a:off x="5846065" y="360831"/>
                <a:ext cx="60928" cy="96989"/>
              </a:xfrm>
              <a:prstGeom prst="straightConnector1">
                <a:avLst/>
              </a:prstGeom>
              <a:ln w="6350">
                <a:solidFill>
                  <a:schemeClr val="bg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4" name="Rectangle 113">
                <a:extLst>
                  <a:ext uri="{FF2B5EF4-FFF2-40B4-BE49-F238E27FC236}">
                    <a16:creationId xmlns:a16="http://schemas.microsoft.com/office/drawing/2014/main" id="{5E42FA8B-3527-DA71-1F40-E1E1556BE5BC}"/>
                  </a:ext>
                </a:extLst>
              </p:cNvPr>
              <p:cNvSpPr/>
              <p:nvPr/>
            </p:nvSpPr>
            <p:spPr>
              <a:xfrm>
                <a:off x="5778542" y="461858"/>
                <a:ext cx="120759" cy="131633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z</a:t>
                </a:r>
              </a:p>
            </p:txBody>
          </p:sp>
          <p:sp>
            <p:nvSpPr>
              <p:cNvPr id="115" name="Rectangle 114">
                <a:extLst>
                  <a:ext uri="{FF2B5EF4-FFF2-40B4-BE49-F238E27FC236}">
                    <a16:creationId xmlns:a16="http://schemas.microsoft.com/office/drawing/2014/main" id="{4FA125DC-BD63-1EBF-5EF6-0F51B5DBA758}"/>
                  </a:ext>
                </a:extLst>
              </p:cNvPr>
              <p:cNvSpPr/>
              <p:nvPr/>
            </p:nvSpPr>
            <p:spPr>
              <a:xfrm>
                <a:off x="5884123" y="394385"/>
                <a:ext cx="120759" cy="131633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sp>
            <p:nvSpPr>
              <p:cNvPr id="116" name="Rectangle 115">
                <a:extLst>
                  <a:ext uri="{FF2B5EF4-FFF2-40B4-BE49-F238E27FC236}">
                    <a16:creationId xmlns:a16="http://schemas.microsoft.com/office/drawing/2014/main" id="{B4B6E5C5-A194-79E1-2793-49DA721C7DD5}"/>
                  </a:ext>
                </a:extLst>
              </p:cNvPr>
              <p:cNvSpPr/>
              <p:nvPr/>
            </p:nvSpPr>
            <p:spPr>
              <a:xfrm>
                <a:off x="5656079" y="347306"/>
                <a:ext cx="120759" cy="131633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</a:p>
            </p:txBody>
          </p:sp>
          <p:cxnSp>
            <p:nvCxnSpPr>
              <p:cNvPr id="117" name="Straight Arrow Connector 116">
                <a:extLst>
                  <a:ext uri="{FF2B5EF4-FFF2-40B4-BE49-F238E27FC236}">
                    <a16:creationId xmlns:a16="http://schemas.microsoft.com/office/drawing/2014/main" id="{2AFB49B2-F6ED-8FEC-6AB9-DDD3746EA5D6}"/>
                  </a:ext>
                </a:extLst>
              </p:cNvPr>
              <p:cNvCxnSpPr>
                <a:cxnSpLocks/>
              </p:cNvCxnSpPr>
              <p:nvPr/>
            </p:nvCxnSpPr>
            <p:spPr>
              <a:xfrm rot="180000" flipH="1">
                <a:off x="5726896" y="360234"/>
                <a:ext cx="116341" cy="19118"/>
              </a:xfrm>
              <a:prstGeom prst="straightConnector1">
                <a:avLst/>
              </a:prstGeom>
              <a:ln w="6350">
                <a:solidFill>
                  <a:schemeClr val="bg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85D3D313-8A49-EC83-22B6-B0F5E19E404E}"/>
                </a:ext>
              </a:extLst>
            </p:cNvPr>
            <p:cNvSpPr/>
            <p:nvPr/>
          </p:nvSpPr>
          <p:spPr>
            <a:xfrm>
              <a:off x="5072382" y="1486955"/>
              <a:ext cx="1162194" cy="22939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 instances</a:t>
              </a:r>
            </a:p>
            <a:p>
              <a:endParaRPr lang="en-US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6F3E386-47F8-4EA3-55B3-82BFFA5DE6BE}"/>
                </a:ext>
              </a:extLst>
            </p:cNvPr>
            <p:cNvSpPr txBox="1"/>
            <p:nvPr/>
          </p:nvSpPr>
          <p:spPr>
            <a:xfrm>
              <a:off x="1675610" y="3460190"/>
              <a:ext cx="101863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ce=0.7 </a:t>
              </a:r>
            </a:p>
            <a:p>
              <a:r>
                <a: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an AP=0.27</a:t>
              </a:r>
              <a:r>
                <a:rPr lang="en-US" sz="7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E85006A1-87BB-E1FA-D93E-77C688E5E8A3}"/>
                </a:ext>
              </a:extLst>
            </p:cNvPr>
            <p:cNvGrpSpPr/>
            <p:nvPr/>
          </p:nvGrpSpPr>
          <p:grpSpPr>
            <a:xfrm>
              <a:off x="2484038" y="2705386"/>
              <a:ext cx="288000" cy="316798"/>
              <a:chOff x="2488800" y="2700624"/>
              <a:chExt cx="288000" cy="316798"/>
            </a:xfrm>
          </p:grpSpPr>
          <p:pic>
            <p:nvPicPr>
              <p:cNvPr id="69" name="Picture 68">
                <a:extLst>
                  <a:ext uri="{FF2B5EF4-FFF2-40B4-BE49-F238E27FC236}">
                    <a16:creationId xmlns:a16="http://schemas.microsoft.com/office/drawing/2014/main" id="{66F18057-03D1-96EE-273A-2E3F34D6067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152" t="50372" r="79495" b="41911"/>
              <a:stretch/>
            </p:blipFill>
            <p:spPr>
              <a:xfrm>
                <a:off x="2488800" y="2701521"/>
                <a:ext cx="288000" cy="315005"/>
              </a:xfrm>
              <a:prstGeom prst="rect">
                <a:avLst/>
              </a:prstGeom>
            </p:spPr>
          </p:pic>
          <p:sp>
            <p:nvSpPr>
              <p:cNvPr id="72" name="Rectangle 71">
                <a:extLst>
                  <a:ext uri="{FF2B5EF4-FFF2-40B4-BE49-F238E27FC236}">
                    <a16:creationId xmlns:a16="http://schemas.microsoft.com/office/drawing/2014/main" id="{903A0798-03FB-9642-A6D6-F59733D3D3AD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488801" y="2700624"/>
                <a:ext cx="287999" cy="316798"/>
              </a:xfrm>
              <a:prstGeom prst="rect">
                <a:avLst/>
              </a:prstGeom>
              <a:noFill/>
              <a:ln w="63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2EF1CC61-4D08-CED3-0624-3A54A1B0B93B}"/>
                </a:ext>
              </a:extLst>
            </p:cNvPr>
            <p:cNvGrpSpPr/>
            <p:nvPr/>
          </p:nvGrpSpPr>
          <p:grpSpPr>
            <a:xfrm>
              <a:off x="2481338" y="230819"/>
              <a:ext cx="288000" cy="316798"/>
              <a:chOff x="6870241" y="833244"/>
              <a:chExt cx="288000" cy="316798"/>
            </a:xfrm>
          </p:grpSpPr>
          <p:pic>
            <p:nvPicPr>
              <p:cNvPr id="67" name="Picture 66" descr="A picture containing outdoor object&#10;&#10;Description automatically generated">
                <a:extLst>
                  <a:ext uri="{FF2B5EF4-FFF2-40B4-BE49-F238E27FC236}">
                    <a16:creationId xmlns:a16="http://schemas.microsoft.com/office/drawing/2014/main" id="{99A1C4DD-4855-6893-55B1-DE4B8C3332A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152" t="50372" r="79496" b="41911"/>
              <a:stretch/>
            </p:blipFill>
            <p:spPr>
              <a:xfrm>
                <a:off x="6870241" y="834141"/>
                <a:ext cx="288000" cy="315005"/>
              </a:xfrm>
              <a:prstGeom prst="rect">
                <a:avLst/>
              </a:prstGeom>
            </p:spPr>
          </p:pic>
          <p:sp>
            <p:nvSpPr>
              <p:cNvPr id="82" name="Rectangle 81">
                <a:extLst>
                  <a:ext uri="{FF2B5EF4-FFF2-40B4-BE49-F238E27FC236}">
                    <a16:creationId xmlns:a16="http://schemas.microsoft.com/office/drawing/2014/main" id="{968308B1-F192-333C-87A4-59D89E37781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870242" y="833244"/>
                <a:ext cx="287999" cy="316798"/>
              </a:xfrm>
              <a:prstGeom prst="rect">
                <a:avLst/>
              </a:prstGeom>
              <a:noFill/>
              <a:ln w="63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34" name="Group 133">
              <a:extLst>
                <a:ext uri="{FF2B5EF4-FFF2-40B4-BE49-F238E27FC236}">
                  <a16:creationId xmlns:a16="http://schemas.microsoft.com/office/drawing/2014/main" id="{712F9E50-6314-17FD-B15E-1D4D691423A3}"/>
                </a:ext>
              </a:extLst>
            </p:cNvPr>
            <p:cNvGrpSpPr/>
            <p:nvPr/>
          </p:nvGrpSpPr>
          <p:grpSpPr>
            <a:xfrm>
              <a:off x="2481338" y="1473854"/>
              <a:ext cx="288000" cy="316798"/>
              <a:chOff x="6869365" y="1540226"/>
              <a:chExt cx="288000" cy="316798"/>
            </a:xfrm>
          </p:grpSpPr>
          <p:pic>
            <p:nvPicPr>
              <p:cNvPr id="68" name="Picture 67">
                <a:extLst>
                  <a:ext uri="{FF2B5EF4-FFF2-40B4-BE49-F238E27FC236}">
                    <a16:creationId xmlns:a16="http://schemas.microsoft.com/office/drawing/2014/main" id="{BB114157-0B32-F49B-2345-413049C8FC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152" t="50372" r="79496" b="41911"/>
              <a:stretch/>
            </p:blipFill>
            <p:spPr>
              <a:xfrm>
                <a:off x="6869365" y="1541121"/>
                <a:ext cx="288000" cy="315009"/>
              </a:xfrm>
              <a:prstGeom prst="rect">
                <a:avLst/>
              </a:prstGeom>
            </p:spPr>
          </p:pic>
          <p:sp>
            <p:nvSpPr>
              <p:cNvPr id="86" name="Rectangle 85">
                <a:extLst>
                  <a:ext uri="{FF2B5EF4-FFF2-40B4-BE49-F238E27FC236}">
                    <a16:creationId xmlns:a16="http://schemas.microsoft.com/office/drawing/2014/main" id="{85C4A9DA-D7F4-8752-955D-BA7E9C40C5C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869366" y="1540226"/>
                <a:ext cx="287999" cy="316798"/>
              </a:xfrm>
              <a:prstGeom prst="rect">
                <a:avLst/>
              </a:prstGeom>
              <a:noFill/>
              <a:ln w="63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44" name="Group 143">
              <a:extLst>
                <a:ext uri="{FF2B5EF4-FFF2-40B4-BE49-F238E27FC236}">
                  <a16:creationId xmlns:a16="http://schemas.microsoft.com/office/drawing/2014/main" id="{C3621E89-DD40-CE5C-366A-4C7857E3EEEF}"/>
                </a:ext>
              </a:extLst>
            </p:cNvPr>
            <p:cNvGrpSpPr/>
            <p:nvPr/>
          </p:nvGrpSpPr>
          <p:grpSpPr>
            <a:xfrm>
              <a:off x="2289953" y="3180707"/>
              <a:ext cx="312559" cy="200055"/>
              <a:chOff x="2289953" y="3180707"/>
              <a:chExt cx="312559" cy="200055"/>
            </a:xfrm>
          </p:grpSpPr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15F76BED-A623-64DB-D2DF-96353DE32FCD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289953" y="3229390"/>
                <a:ext cx="82722" cy="90994"/>
              </a:xfrm>
              <a:prstGeom prst="rect">
                <a:avLst/>
              </a:prstGeom>
              <a:noFill/>
              <a:ln w="63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6B101662-F4FB-0D75-B8EE-D1090C781D95}"/>
                  </a:ext>
                </a:extLst>
              </p:cNvPr>
              <p:cNvSpPr txBox="1"/>
              <p:nvPr/>
            </p:nvSpPr>
            <p:spPr>
              <a:xfrm>
                <a:off x="2312116" y="3180707"/>
                <a:ext cx="290396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sz="700" dirty="0" err="1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r>
                  <a:rPr lang="en-US" sz="7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5932A73F-D237-3A1A-3D1E-E3F42BE09007}"/>
                </a:ext>
              </a:extLst>
            </p:cNvPr>
            <p:cNvSpPr txBox="1"/>
            <p:nvPr/>
          </p:nvSpPr>
          <p:spPr>
            <a:xfrm>
              <a:off x="1816213" y="2981408"/>
              <a:ext cx="290396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ii)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3CE88A54-9D45-8029-03BA-69D7F92AB4DC}"/>
                </a:ext>
              </a:extLst>
            </p:cNvPr>
            <p:cNvSpPr txBox="1"/>
            <p:nvPr/>
          </p:nvSpPr>
          <p:spPr>
            <a:xfrm>
              <a:off x="1816213" y="1751957"/>
              <a:ext cx="290396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ii)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9F7AD3BC-D695-DFB5-E256-F138A93D53B6}"/>
                </a:ext>
              </a:extLst>
            </p:cNvPr>
            <p:cNvSpPr txBox="1"/>
            <p:nvPr/>
          </p:nvSpPr>
          <p:spPr>
            <a:xfrm>
              <a:off x="1816213" y="510000"/>
              <a:ext cx="290396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ii)</a:t>
              </a:r>
            </a:p>
          </p:txBody>
        </p:sp>
        <p:grpSp>
          <p:nvGrpSpPr>
            <p:cNvPr id="151" name="Group 150">
              <a:extLst>
                <a:ext uri="{FF2B5EF4-FFF2-40B4-BE49-F238E27FC236}">
                  <a16:creationId xmlns:a16="http://schemas.microsoft.com/office/drawing/2014/main" id="{4F4D86DE-15C3-3BCD-F63D-D098FA5345E1}"/>
                </a:ext>
              </a:extLst>
            </p:cNvPr>
            <p:cNvGrpSpPr/>
            <p:nvPr/>
          </p:nvGrpSpPr>
          <p:grpSpPr>
            <a:xfrm>
              <a:off x="2289953" y="1951701"/>
              <a:ext cx="312559" cy="200055"/>
              <a:chOff x="2289953" y="3180707"/>
              <a:chExt cx="312559" cy="200055"/>
            </a:xfrm>
          </p:grpSpPr>
          <p:sp>
            <p:nvSpPr>
              <p:cNvPr id="152" name="Rectangle 151">
                <a:extLst>
                  <a:ext uri="{FF2B5EF4-FFF2-40B4-BE49-F238E27FC236}">
                    <a16:creationId xmlns:a16="http://schemas.microsoft.com/office/drawing/2014/main" id="{9921C3FE-A7A5-79C0-275D-B76B47290358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289953" y="3229390"/>
                <a:ext cx="82722" cy="90994"/>
              </a:xfrm>
              <a:prstGeom prst="rect">
                <a:avLst/>
              </a:prstGeom>
              <a:noFill/>
              <a:ln w="63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587C8B02-4C6C-0AA6-DEDD-761880E4EBB5}"/>
                  </a:ext>
                </a:extLst>
              </p:cNvPr>
              <p:cNvSpPr txBox="1"/>
              <p:nvPr/>
            </p:nvSpPr>
            <p:spPr>
              <a:xfrm>
                <a:off x="2312116" y="3180707"/>
                <a:ext cx="290396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sz="700" dirty="0" err="1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r>
                  <a:rPr lang="en-US" sz="7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grpSp>
          <p:nvGrpSpPr>
            <p:cNvPr id="154" name="Group 153">
              <a:extLst>
                <a:ext uri="{FF2B5EF4-FFF2-40B4-BE49-F238E27FC236}">
                  <a16:creationId xmlns:a16="http://schemas.microsoft.com/office/drawing/2014/main" id="{37F01BB2-3522-FDD7-2513-827B89D1C5DA}"/>
                </a:ext>
              </a:extLst>
            </p:cNvPr>
            <p:cNvGrpSpPr/>
            <p:nvPr/>
          </p:nvGrpSpPr>
          <p:grpSpPr>
            <a:xfrm>
              <a:off x="2289953" y="706395"/>
              <a:ext cx="312559" cy="200055"/>
              <a:chOff x="2289953" y="3180707"/>
              <a:chExt cx="312559" cy="200055"/>
            </a:xfrm>
          </p:grpSpPr>
          <p:sp>
            <p:nvSpPr>
              <p:cNvPr id="155" name="Rectangle 154">
                <a:extLst>
                  <a:ext uri="{FF2B5EF4-FFF2-40B4-BE49-F238E27FC236}">
                    <a16:creationId xmlns:a16="http://schemas.microsoft.com/office/drawing/2014/main" id="{85A213D7-5702-86B8-8243-7B3EE0EA5F8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289953" y="3229390"/>
                <a:ext cx="82722" cy="90994"/>
              </a:xfrm>
              <a:prstGeom prst="rect">
                <a:avLst/>
              </a:prstGeom>
              <a:noFill/>
              <a:ln w="63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6" name="TextBox 155">
                <a:extLst>
                  <a:ext uri="{FF2B5EF4-FFF2-40B4-BE49-F238E27FC236}">
                    <a16:creationId xmlns:a16="http://schemas.microsoft.com/office/drawing/2014/main" id="{B1771E4D-BB9B-D9EE-25A3-38C5634CCBC6}"/>
                  </a:ext>
                </a:extLst>
              </p:cNvPr>
              <p:cNvSpPr txBox="1"/>
              <p:nvPr/>
            </p:nvSpPr>
            <p:spPr>
              <a:xfrm>
                <a:off x="2312116" y="3180707"/>
                <a:ext cx="290396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sz="700" dirty="0" err="1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r>
                  <a:rPr lang="en-US" sz="7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22357C0E-27F6-B16E-FE5C-0158AD48685F}"/>
                </a:ext>
              </a:extLst>
            </p:cNvPr>
            <p:cNvSpPr txBox="1"/>
            <p:nvPr/>
          </p:nvSpPr>
          <p:spPr>
            <a:xfrm>
              <a:off x="2403844" y="2852191"/>
              <a:ext cx="290396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700" dirty="0" err="1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7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DE3E6105-CC06-F5D3-77E8-5EEBA060015C}"/>
                </a:ext>
              </a:extLst>
            </p:cNvPr>
            <p:cNvSpPr txBox="1"/>
            <p:nvPr/>
          </p:nvSpPr>
          <p:spPr>
            <a:xfrm>
              <a:off x="2403844" y="1623128"/>
              <a:ext cx="290396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700" dirty="0" err="1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7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20543B9E-CE70-6A20-539F-46C22CC50882}"/>
                </a:ext>
              </a:extLst>
            </p:cNvPr>
            <p:cNvSpPr txBox="1"/>
            <p:nvPr/>
          </p:nvSpPr>
          <p:spPr>
            <a:xfrm>
              <a:off x="2403844" y="378799"/>
              <a:ext cx="290396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700" dirty="0" err="1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7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ED6DA878-352A-2DEB-D152-51EF9651BF82}"/>
                </a:ext>
              </a:extLst>
            </p:cNvPr>
            <p:cNvSpPr txBox="1"/>
            <p:nvPr/>
          </p:nvSpPr>
          <p:spPr>
            <a:xfrm>
              <a:off x="2336450" y="2213672"/>
              <a:ext cx="290396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ii)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808082F4-429E-3415-ECE3-461CE01CF40F}"/>
                </a:ext>
              </a:extLst>
            </p:cNvPr>
            <p:cNvSpPr txBox="1"/>
            <p:nvPr/>
          </p:nvSpPr>
          <p:spPr>
            <a:xfrm>
              <a:off x="2336450" y="3444238"/>
              <a:ext cx="290396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ii)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95B9F4C3-DD70-7A7B-82AE-13A243DA5A87}"/>
                </a:ext>
              </a:extLst>
            </p:cNvPr>
            <p:cNvSpPr txBox="1"/>
            <p:nvPr/>
          </p:nvSpPr>
          <p:spPr>
            <a:xfrm>
              <a:off x="2336450" y="967545"/>
              <a:ext cx="290396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ii)</a:t>
              </a:r>
            </a:p>
          </p:txBody>
        </p:sp>
        <p:grpSp>
          <p:nvGrpSpPr>
            <p:cNvPr id="1207" name="Group 1206">
              <a:extLst>
                <a:ext uri="{FF2B5EF4-FFF2-40B4-BE49-F238E27FC236}">
                  <a16:creationId xmlns:a16="http://schemas.microsoft.com/office/drawing/2014/main" id="{F9220081-713A-243A-280D-61BDDA94C8ED}"/>
                </a:ext>
              </a:extLst>
            </p:cNvPr>
            <p:cNvGrpSpPr/>
            <p:nvPr/>
          </p:nvGrpSpPr>
          <p:grpSpPr>
            <a:xfrm>
              <a:off x="351019" y="2691190"/>
              <a:ext cx="1074984" cy="1076400"/>
              <a:chOff x="-958033" y="2692845"/>
              <a:chExt cx="1074984" cy="1076400"/>
            </a:xfrm>
          </p:grpSpPr>
          <p:sp>
            <p:nvSpPr>
              <p:cNvPr id="1208" name="Rectangle 8">
                <a:extLst>
                  <a:ext uri="{FF2B5EF4-FFF2-40B4-BE49-F238E27FC236}">
                    <a16:creationId xmlns:a16="http://schemas.microsoft.com/office/drawing/2014/main" id="{EF92EDB7-0C1B-44BB-8DFE-CA6AFB1119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00830" y="2709274"/>
                <a:ext cx="816931" cy="967060"/>
              </a:xfrm>
              <a:prstGeom prst="rect">
                <a:avLst/>
              </a:prstGeom>
              <a:solidFill>
                <a:srgbClr val="EAEA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209" name="Freeform 9">
                <a:extLst>
                  <a:ext uri="{FF2B5EF4-FFF2-40B4-BE49-F238E27FC236}">
                    <a16:creationId xmlns:a16="http://schemas.microsoft.com/office/drawing/2014/main" id="{3566F625-B967-3267-B9B1-88FFA641E06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672504" y="3709193"/>
                <a:ext cx="43056" cy="47022"/>
              </a:xfrm>
              <a:custGeom>
                <a:avLst/>
                <a:gdLst>
                  <a:gd name="T0" fmla="*/ 334 w 668"/>
                  <a:gd name="T1" fmla="*/ 97 h 729"/>
                  <a:gd name="T2" fmla="*/ 200 w 668"/>
                  <a:gd name="T3" fmla="*/ 460 h 729"/>
                  <a:gd name="T4" fmla="*/ 468 w 668"/>
                  <a:gd name="T5" fmla="*/ 460 h 729"/>
                  <a:gd name="T6" fmla="*/ 334 w 668"/>
                  <a:gd name="T7" fmla="*/ 97 h 729"/>
                  <a:gd name="T8" fmla="*/ 278 w 668"/>
                  <a:gd name="T9" fmla="*/ 0 h 729"/>
                  <a:gd name="T10" fmla="*/ 390 w 668"/>
                  <a:gd name="T11" fmla="*/ 0 h 729"/>
                  <a:gd name="T12" fmla="*/ 668 w 668"/>
                  <a:gd name="T13" fmla="*/ 729 h 729"/>
                  <a:gd name="T14" fmla="*/ 565 w 668"/>
                  <a:gd name="T15" fmla="*/ 729 h 729"/>
                  <a:gd name="T16" fmla="*/ 499 w 668"/>
                  <a:gd name="T17" fmla="*/ 542 h 729"/>
                  <a:gd name="T18" fmla="*/ 170 w 668"/>
                  <a:gd name="T19" fmla="*/ 542 h 729"/>
                  <a:gd name="T20" fmla="*/ 104 w 668"/>
                  <a:gd name="T21" fmla="*/ 729 h 729"/>
                  <a:gd name="T22" fmla="*/ 0 w 668"/>
                  <a:gd name="T23" fmla="*/ 729 h 729"/>
                  <a:gd name="T24" fmla="*/ 278 w 668"/>
                  <a:gd name="T25" fmla="*/ 0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</a:cxnLst>
                <a:rect l="0" t="0" r="r" b="b"/>
                <a:pathLst>
                  <a:path w="668" h="729">
                    <a:moveTo>
                      <a:pt x="334" y="97"/>
                    </a:moveTo>
                    <a:lnTo>
                      <a:pt x="200" y="460"/>
                    </a:lnTo>
                    <a:lnTo>
                      <a:pt x="468" y="460"/>
                    </a:lnTo>
                    <a:lnTo>
                      <a:pt x="334" y="97"/>
                    </a:lnTo>
                    <a:close/>
                    <a:moveTo>
                      <a:pt x="278" y="0"/>
                    </a:moveTo>
                    <a:lnTo>
                      <a:pt x="390" y="0"/>
                    </a:lnTo>
                    <a:lnTo>
                      <a:pt x="668" y="729"/>
                    </a:lnTo>
                    <a:lnTo>
                      <a:pt x="565" y="729"/>
                    </a:lnTo>
                    <a:lnTo>
                      <a:pt x="499" y="542"/>
                    </a:lnTo>
                    <a:lnTo>
                      <a:pt x="170" y="542"/>
                    </a:lnTo>
                    <a:lnTo>
                      <a:pt x="104" y="729"/>
                    </a:lnTo>
                    <a:lnTo>
                      <a:pt x="0" y="729"/>
                    </a:lnTo>
                    <a:lnTo>
                      <a:pt x="278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0" name="Freeform 10">
                <a:extLst>
                  <a:ext uri="{FF2B5EF4-FFF2-40B4-BE49-F238E27FC236}">
                    <a16:creationId xmlns:a16="http://schemas.microsoft.com/office/drawing/2014/main" id="{4832BF35-361F-FBD1-6B77-B5E41F5B19C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626615" y="3719957"/>
                <a:ext cx="27760" cy="36824"/>
              </a:xfrm>
              <a:custGeom>
                <a:avLst/>
                <a:gdLst>
                  <a:gd name="T0" fmla="*/ 433 w 433"/>
                  <a:gd name="T1" fmla="*/ 34 h 573"/>
                  <a:gd name="T2" fmla="*/ 433 w 433"/>
                  <a:gd name="T3" fmla="*/ 118 h 573"/>
                  <a:gd name="T4" fmla="*/ 356 w 433"/>
                  <a:gd name="T5" fmla="*/ 87 h 573"/>
                  <a:gd name="T6" fmla="*/ 279 w 433"/>
                  <a:gd name="T7" fmla="*/ 76 h 573"/>
                  <a:gd name="T8" fmla="*/ 143 w 433"/>
                  <a:gd name="T9" fmla="*/ 132 h 573"/>
                  <a:gd name="T10" fmla="*/ 95 w 433"/>
                  <a:gd name="T11" fmla="*/ 287 h 573"/>
                  <a:gd name="T12" fmla="*/ 143 w 433"/>
                  <a:gd name="T13" fmla="*/ 443 h 573"/>
                  <a:gd name="T14" fmla="*/ 279 w 433"/>
                  <a:gd name="T15" fmla="*/ 498 h 573"/>
                  <a:gd name="T16" fmla="*/ 356 w 433"/>
                  <a:gd name="T17" fmla="*/ 488 h 573"/>
                  <a:gd name="T18" fmla="*/ 433 w 433"/>
                  <a:gd name="T19" fmla="*/ 456 h 573"/>
                  <a:gd name="T20" fmla="*/ 433 w 433"/>
                  <a:gd name="T21" fmla="*/ 539 h 573"/>
                  <a:gd name="T22" fmla="*/ 355 w 433"/>
                  <a:gd name="T23" fmla="*/ 565 h 573"/>
                  <a:gd name="T24" fmla="*/ 269 w 433"/>
                  <a:gd name="T25" fmla="*/ 573 h 573"/>
                  <a:gd name="T26" fmla="*/ 73 w 433"/>
                  <a:gd name="T27" fmla="*/ 496 h 573"/>
                  <a:gd name="T28" fmla="*/ 0 w 433"/>
                  <a:gd name="T29" fmla="*/ 287 h 573"/>
                  <a:gd name="T30" fmla="*/ 73 w 433"/>
                  <a:gd name="T31" fmla="*/ 77 h 573"/>
                  <a:gd name="T32" fmla="*/ 275 w 433"/>
                  <a:gd name="T33" fmla="*/ 0 h 573"/>
                  <a:gd name="T34" fmla="*/ 356 w 433"/>
                  <a:gd name="T35" fmla="*/ 9 h 573"/>
                  <a:gd name="T36" fmla="*/ 433 w 433"/>
                  <a:gd name="T37" fmla="*/ 34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433" h="573">
                    <a:moveTo>
                      <a:pt x="433" y="34"/>
                    </a:moveTo>
                    <a:lnTo>
                      <a:pt x="433" y="118"/>
                    </a:lnTo>
                    <a:cubicBezTo>
                      <a:pt x="407" y="104"/>
                      <a:pt x="382" y="94"/>
                      <a:pt x="356" y="87"/>
                    </a:cubicBezTo>
                    <a:cubicBezTo>
                      <a:pt x="330" y="80"/>
                      <a:pt x="305" y="76"/>
                      <a:pt x="279" y="76"/>
                    </a:cubicBezTo>
                    <a:cubicBezTo>
                      <a:pt x="221" y="76"/>
                      <a:pt x="175" y="95"/>
                      <a:pt x="143" y="132"/>
                    </a:cubicBezTo>
                    <a:cubicBezTo>
                      <a:pt x="111" y="169"/>
                      <a:pt x="95" y="221"/>
                      <a:pt x="95" y="287"/>
                    </a:cubicBezTo>
                    <a:cubicBezTo>
                      <a:pt x="95" y="354"/>
                      <a:pt x="111" y="406"/>
                      <a:pt x="143" y="443"/>
                    </a:cubicBezTo>
                    <a:cubicBezTo>
                      <a:pt x="175" y="480"/>
                      <a:pt x="221" y="498"/>
                      <a:pt x="279" y="498"/>
                    </a:cubicBezTo>
                    <a:cubicBezTo>
                      <a:pt x="305" y="498"/>
                      <a:pt x="330" y="495"/>
                      <a:pt x="356" y="488"/>
                    </a:cubicBezTo>
                    <a:cubicBezTo>
                      <a:pt x="382" y="481"/>
                      <a:pt x="407" y="470"/>
                      <a:pt x="433" y="456"/>
                    </a:cubicBezTo>
                    <a:lnTo>
                      <a:pt x="433" y="539"/>
                    </a:lnTo>
                    <a:cubicBezTo>
                      <a:pt x="407" y="551"/>
                      <a:pt x="381" y="560"/>
                      <a:pt x="355" y="565"/>
                    </a:cubicBezTo>
                    <a:cubicBezTo>
                      <a:pt x="328" y="570"/>
                      <a:pt x="299" y="573"/>
                      <a:pt x="269" y="573"/>
                    </a:cubicBezTo>
                    <a:cubicBezTo>
                      <a:pt x="187" y="573"/>
                      <a:pt x="121" y="548"/>
                      <a:pt x="73" y="496"/>
                    </a:cubicBezTo>
                    <a:cubicBezTo>
                      <a:pt x="24" y="445"/>
                      <a:pt x="0" y="375"/>
                      <a:pt x="0" y="287"/>
                    </a:cubicBezTo>
                    <a:cubicBezTo>
                      <a:pt x="0" y="198"/>
                      <a:pt x="24" y="128"/>
                      <a:pt x="73" y="77"/>
                    </a:cubicBezTo>
                    <a:cubicBezTo>
                      <a:pt x="122" y="26"/>
                      <a:pt x="189" y="0"/>
                      <a:pt x="275" y="0"/>
                    </a:cubicBezTo>
                    <a:cubicBezTo>
                      <a:pt x="303" y="0"/>
                      <a:pt x="330" y="3"/>
                      <a:pt x="356" y="9"/>
                    </a:cubicBezTo>
                    <a:cubicBezTo>
                      <a:pt x="382" y="15"/>
                      <a:pt x="408" y="23"/>
                      <a:pt x="433" y="34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1" name="Freeform 11">
                <a:extLst>
                  <a:ext uri="{FF2B5EF4-FFF2-40B4-BE49-F238E27FC236}">
                    <a16:creationId xmlns:a16="http://schemas.microsoft.com/office/drawing/2014/main" id="{D1E85E1A-698D-D58D-4DB0-1F2AA272156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590924" y="3719957"/>
                <a:ext cx="31159" cy="49288"/>
              </a:xfrm>
              <a:custGeom>
                <a:avLst/>
                <a:gdLst>
                  <a:gd name="T0" fmla="*/ 93 w 489"/>
                  <a:gd name="T1" fmla="*/ 287 h 767"/>
                  <a:gd name="T2" fmla="*/ 133 w 489"/>
                  <a:gd name="T3" fmla="*/ 443 h 767"/>
                  <a:gd name="T4" fmla="*/ 245 w 489"/>
                  <a:gd name="T5" fmla="*/ 499 h 767"/>
                  <a:gd name="T6" fmla="*/ 358 w 489"/>
                  <a:gd name="T7" fmla="*/ 443 h 767"/>
                  <a:gd name="T8" fmla="*/ 399 w 489"/>
                  <a:gd name="T9" fmla="*/ 287 h 767"/>
                  <a:gd name="T10" fmla="*/ 358 w 489"/>
                  <a:gd name="T11" fmla="*/ 132 h 767"/>
                  <a:gd name="T12" fmla="*/ 245 w 489"/>
                  <a:gd name="T13" fmla="*/ 75 h 767"/>
                  <a:gd name="T14" fmla="*/ 133 w 489"/>
                  <a:gd name="T15" fmla="*/ 132 h 767"/>
                  <a:gd name="T16" fmla="*/ 93 w 489"/>
                  <a:gd name="T17" fmla="*/ 287 h 767"/>
                  <a:gd name="T18" fmla="*/ 399 w 489"/>
                  <a:gd name="T19" fmla="*/ 478 h 767"/>
                  <a:gd name="T20" fmla="*/ 327 w 489"/>
                  <a:gd name="T21" fmla="*/ 550 h 767"/>
                  <a:gd name="T22" fmla="*/ 224 w 489"/>
                  <a:gd name="T23" fmla="*/ 573 h 767"/>
                  <a:gd name="T24" fmla="*/ 62 w 489"/>
                  <a:gd name="T25" fmla="*/ 495 h 767"/>
                  <a:gd name="T26" fmla="*/ 0 w 489"/>
                  <a:gd name="T27" fmla="*/ 287 h 767"/>
                  <a:gd name="T28" fmla="*/ 62 w 489"/>
                  <a:gd name="T29" fmla="*/ 79 h 767"/>
                  <a:gd name="T30" fmla="*/ 224 w 489"/>
                  <a:gd name="T31" fmla="*/ 0 h 767"/>
                  <a:gd name="T32" fmla="*/ 327 w 489"/>
                  <a:gd name="T33" fmla="*/ 24 h 767"/>
                  <a:gd name="T34" fmla="*/ 399 w 489"/>
                  <a:gd name="T35" fmla="*/ 96 h 767"/>
                  <a:gd name="T36" fmla="*/ 399 w 489"/>
                  <a:gd name="T37" fmla="*/ 13 h 767"/>
                  <a:gd name="T38" fmla="*/ 489 w 489"/>
                  <a:gd name="T39" fmla="*/ 13 h 767"/>
                  <a:gd name="T40" fmla="*/ 489 w 489"/>
                  <a:gd name="T41" fmla="*/ 767 h 767"/>
                  <a:gd name="T42" fmla="*/ 399 w 489"/>
                  <a:gd name="T43" fmla="*/ 767 h 767"/>
                  <a:gd name="T44" fmla="*/ 399 w 489"/>
                  <a:gd name="T45" fmla="*/ 478 h 7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89" h="767">
                    <a:moveTo>
                      <a:pt x="93" y="287"/>
                    </a:moveTo>
                    <a:cubicBezTo>
                      <a:pt x="93" y="353"/>
                      <a:pt x="106" y="405"/>
                      <a:pt x="133" y="443"/>
                    </a:cubicBezTo>
                    <a:cubicBezTo>
                      <a:pt x="160" y="481"/>
                      <a:pt x="197" y="499"/>
                      <a:pt x="245" y="499"/>
                    </a:cubicBezTo>
                    <a:cubicBezTo>
                      <a:pt x="293" y="499"/>
                      <a:pt x="330" y="481"/>
                      <a:pt x="358" y="443"/>
                    </a:cubicBezTo>
                    <a:cubicBezTo>
                      <a:pt x="385" y="405"/>
                      <a:pt x="399" y="353"/>
                      <a:pt x="399" y="287"/>
                    </a:cubicBezTo>
                    <a:cubicBezTo>
                      <a:pt x="399" y="221"/>
                      <a:pt x="385" y="170"/>
                      <a:pt x="358" y="132"/>
                    </a:cubicBezTo>
                    <a:cubicBezTo>
                      <a:pt x="330" y="94"/>
                      <a:pt x="293" y="75"/>
                      <a:pt x="245" y="75"/>
                    </a:cubicBezTo>
                    <a:cubicBezTo>
                      <a:pt x="197" y="75"/>
                      <a:pt x="160" y="94"/>
                      <a:pt x="133" y="132"/>
                    </a:cubicBezTo>
                    <a:cubicBezTo>
                      <a:pt x="106" y="170"/>
                      <a:pt x="93" y="221"/>
                      <a:pt x="93" y="287"/>
                    </a:cubicBezTo>
                    <a:close/>
                    <a:moveTo>
                      <a:pt x="399" y="478"/>
                    </a:moveTo>
                    <a:cubicBezTo>
                      <a:pt x="380" y="511"/>
                      <a:pt x="356" y="535"/>
                      <a:pt x="327" y="550"/>
                    </a:cubicBezTo>
                    <a:cubicBezTo>
                      <a:pt x="298" y="565"/>
                      <a:pt x="264" y="573"/>
                      <a:pt x="224" y="573"/>
                    </a:cubicBezTo>
                    <a:cubicBezTo>
                      <a:pt x="158" y="573"/>
                      <a:pt x="104" y="547"/>
                      <a:pt x="62" y="495"/>
                    </a:cubicBezTo>
                    <a:cubicBezTo>
                      <a:pt x="20" y="443"/>
                      <a:pt x="0" y="373"/>
                      <a:pt x="0" y="287"/>
                    </a:cubicBezTo>
                    <a:cubicBezTo>
                      <a:pt x="0" y="201"/>
                      <a:pt x="20" y="132"/>
                      <a:pt x="62" y="79"/>
                    </a:cubicBezTo>
                    <a:cubicBezTo>
                      <a:pt x="104" y="27"/>
                      <a:pt x="158" y="0"/>
                      <a:pt x="224" y="0"/>
                    </a:cubicBezTo>
                    <a:cubicBezTo>
                      <a:pt x="264" y="0"/>
                      <a:pt x="298" y="8"/>
                      <a:pt x="327" y="24"/>
                    </a:cubicBezTo>
                    <a:cubicBezTo>
                      <a:pt x="356" y="40"/>
                      <a:pt x="380" y="64"/>
                      <a:pt x="399" y="96"/>
                    </a:cubicBezTo>
                    <a:lnTo>
                      <a:pt x="399" y="13"/>
                    </a:lnTo>
                    <a:lnTo>
                      <a:pt x="489" y="13"/>
                    </a:lnTo>
                    <a:lnTo>
                      <a:pt x="489" y="767"/>
                    </a:lnTo>
                    <a:lnTo>
                      <a:pt x="399" y="767"/>
                    </a:lnTo>
                    <a:lnTo>
                      <a:pt x="399" y="478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2" name="Freeform 12">
                <a:extLst>
                  <a:ext uri="{FF2B5EF4-FFF2-40B4-BE49-F238E27FC236}">
                    <a16:creationId xmlns:a16="http://schemas.microsoft.com/office/drawing/2014/main" id="{F81ED2FA-D49E-721A-6A18-5FDD3EB27FD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548434" y="3719957"/>
                <a:ext cx="29459" cy="36824"/>
              </a:xfrm>
              <a:custGeom>
                <a:avLst/>
                <a:gdLst>
                  <a:gd name="T0" fmla="*/ 0 w 458"/>
                  <a:gd name="T1" fmla="*/ 344 h 573"/>
                  <a:gd name="T2" fmla="*/ 0 w 458"/>
                  <a:gd name="T3" fmla="*/ 13 h 573"/>
                  <a:gd name="T4" fmla="*/ 90 w 458"/>
                  <a:gd name="T5" fmla="*/ 13 h 573"/>
                  <a:gd name="T6" fmla="*/ 90 w 458"/>
                  <a:gd name="T7" fmla="*/ 341 h 573"/>
                  <a:gd name="T8" fmla="*/ 120 w 458"/>
                  <a:gd name="T9" fmla="*/ 457 h 573"/>
                  <a:gd name="T10" fmla="*/ 211 w 458"/>
                  <a:gd name="T11" fmla="*/ 496 h 573"/>
                  <a:gd name="T12" fmla="*/ 326 w 458"/>
                  <a:gd name="T13" fmla="*/ 450 h 573"/>
                  <a:gd name="T14" fmla="*/ 368 w 458"/>
                  <a:gd name="T15" fmla="*/ 323 h 573"/>
                  <a:gd name="T16" fmla="*/ 368 w 458"/>
                  <a:gd name="T17" fmla="*/ 13 h 573"/>
                  <a:gd name="T18" fmla="*/ 458 w 458"/>
                  <a:gd name="T19" fmla="*/ 13 h 573"/>
                  <a:gd name="T20" fmla="*/ 458 w 458"/>
                  <a:gd name="T21" fmla="*/ 560 h 573"/>
                  <a:gd name="T22" fmla="*/ 368 w 458"/>
                  <a:gd name="T23" fmla="*/ 560 h 573"/>
                  <a:gd name="T24" fmla="*/ 368 w 458"/>
                  <a:gd name="T25" fmla="*/ 476 h 573"/>
                  <a:gd name="T26" fmla="*/ 292 w 458"/>
                  <a:gd name="T27" fmla="*/ 550 h 573"/>
                  <a:gd name="T28" fmla="*/ 192 w 458"/>
                  <a:gd name="T29" fmla="*/ 573 h 573"/>
                  <a:gd name="T30" fmla="*/ 49 w 458"/>
                  <a:gd name="T31" fmla="*/ 515 h 573"/>
                  <a:gd name="T32" fmla="*/ 0 w 458"/>
                  <a:gd name="T33" fmla="*/ 344 h 573"/>
                  <a:gd name="T34" fmla="*/ 226 w 458"/>
                  <a:gd name="T35" fmla="*/ 0 h 573"/>
                  <a:gd name="T36" fmla="*/ 227 w 458"/>
                  <a:gd name="T37" fmla="*/ 0 h 573"/>
                  <a:gd name="T38" fmla="*/ 226 w 458"/>
                  <a:gd name="T39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458" h="573">
                    <a:moveTo>
                      <a:pt x="0" y="344"/>
                    </a:moveTo>
                    <a:lnTo>
                      <a:pt x="0" y="13"/>
                    </a:lnTo>
                    <a:lnTo>
                      <a:pt x="90" y="13"/>
                    </a:lnTo>
                    <a:lnTo>
                      <a:pt x="90" y="341"/>
                    </a:lnTo>
                    <a:cubicBezTo>
                      <a:pt x="90" y="393"/>
                      <a:pt x="100" y="431"/>
                      <a:pt x="120" y="457"/>
                    </a:cubicBezTo>
                    <a:cubicBezTo>
                      <a:pt x="140" y="483"/>
                      <a:pt x="170" y="496"/>
                      <a:pt x="211" y="496"/>
                    </a:cubicBezTo>
                    <a:cubicBezTo>
                      <a:pt x="259" y="496"/>
                      <a:pt x="298" y="481"/>
                      <a:pt x="326" y="450"/>
                    </a:cubicBezTo>
                    <a:cubicBezTo>
                      <a:pt x="354" y="419"/>
                      <a:pt x="368" y="377"/>
                      <a:pt x="368" y="323"/>
                    </a:cubicBezTo>
                    <a:lnTo>
                      <a:pt x="368" y="13"/>
                    </a:lnTo>
                    <a:lnTo>
                      <a:pt x="458" y="13"/>
                    </a:lnTo>
                    <a:lnTo>
                      <a:pt x="458" y="560"/>
                    </a:lnTo>
                    <a:lnTo>
                      <a:pt x="368" y="560"/>
                    </a:lnTo>
                    <a:lnTo>
                      <a:pt x="368" y="476"/>
                    </a:lnTo>
                    <a:cubicBezTo>
                      <a:pt x="346" y="510"/>
                      <a:pt x="320" y="534"/>
                      <a:pt x="292" y="550"/>
                    </a:cubicBezTo>
                    <a:cubicBezTo>
                      <a:pt x="263" y="565"/>
                      <a:pt x="230" y="573"/>
                      <a:pt x="192" y="573"/>
                    </a:cubicBezTo>
                    <a:cubicBezTo>
                      <a:pt x="129" y="573"/>
                      <a:pt x="81" y="554"/>
                      <a:pt x="49" y="515"/>
                    </a:cubicBezTo>
                    <a:cubicBezTo>
                      <a:pt x="16" y="477"/>
                      <a:pt x="0" y="420"/>
                      <a:pt x="0" y="344"/>
                    </a:cubicBezTo>
                    <a:close/>
                    <a:moveTo>
                      <a:pt x="226" y="0"/>
                    </a:moveTo>
                    <a:lnTo>
                      <a:pt x="227" y="0"/>
                    </a:lnTo>
                    <a:lnTo>
                      <a:pt x="226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3" name="Freeform 13">
                <a:extLst>
                  <a:ext uri="{FF2B5EF4-FFF2-40B4-BE49-F238E27FC236}">
                    <a16:creationId xmlns:a16="http://schemas.microsoft.com/office/drawing/2014/main" id="{711EAA86-205F-A942-F500-0DDB463391D1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507078" y="3706927"/>
                <a:ext cx="5665" cy="49288"/>
              </a:xfrm>
              <a:custGeom>
                <a:avLst/>
                <a:gdLst>
                  <a:gd name="T0" fmla="*/ 0 w 90"/>
                  <a:gd name="T1" fmla="*/ 213 h 760"/>
                  <a:gd name="T2" fmla="*/ 90 w 90"/>
                  <a:gd name="T3" fmla="*/ 213 h 760"/>
                  <a:gd name="T4" fmla="*/ 90 w 90"/>
                  <a:gd name="T5" fmla="*/ 760 h 760"/>
                  <a:gd name="T6" fmla="*/ 0 w 90"/>
                  <a:gd name="T7" fmla="*/ 760 h 760"/>
                  <a:gd name="T8" fmla="*/ 0 w 90"/>
                  <a:gd name="T9" fmla="*/ 213 h 760"/>
                  <a:gd name="T10" fmla="*/ 0 w 90"/>
                  <a:gd name="T11" fmla="*/ 0 h 760"/>
                  <a:gd name="T12" fmla="*/ 90 w 90"/>
                  <a:gd name="T13" fmla="*/ 0 h 760"/>
                  <a:gd name="T14" fmla="*/ 90 w 90"/>
                  <a:gd name="T15" fmla="*/ 114 h 760"/>
                  <a:gd name="T16" fmla="*/ 0 w 90"/>
                  <a:gd name="T17" fmla="*/ 114 h 760"/>
                  <a:gd name="T18" fmla="*/ 0 w 90"/>
                  <a:gd name="T19" fmla="*/ 0 h 7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90" h="760">
                    <a:moveTo>
                      <a:pt x="0" y="213"/>
                    </a:moveTo>
                    <a:lnTo>
                      <a:pt x="90" y="213"/>
                    </a:lnTo>
                    <a:lnTo>
                      <a:pt x="90" y="760"/>
                    </a:lnTo>
                    <a:lnTo>
                      <a:pt x="0" y="760"/>
                    </a:lnTo>
                    <a:lnTo>
                      <a:pt x="0" y="213"/>
                    </a:lnTo>
                    <a:close/>
                    <a:moveTo>
                      <a:pt x="0" y="0"/>
                    </a:moveTo>
                    <a:lnTo>
                      <a:pt x="90" y="0"/>
                    </a:lnTo>
                    <a:lnTo>
                      <a:pt x="90" y="114"/>
                    </a:lnTo>
                    <a:lnTo>
                      <a:pt x="0" y="11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4" name="Freeform 14">
                <a:extLst>
                  <a:ext uri="{FF2B5EF4-FFF2-40B4-BE49-F238E27FC236}">
                    <a16:creationId xmlns:a16="http://schemas.microsoft.com/office/drawing/2014/main" id="{5D707C20-E134-8DEE-6234-0DB05E24C28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491782" y="3719957"/>
                <a:ext cx="27193" cy="36824"/>
              </a:xfrm>
              <a:custGeom>
                <a:avLst/>
                <a:gdLst>
                  <a:gd name="T0" fmla="*/ 389 w 418"/>
                  <a:gd name="T1" fmla="*/ 29 h 573"/>
                  <a:gd name="T2" fmla="*/ 389 w 418"/>
                  <a:gd name="T3" fmla="*/ 114 h 573"/>
                  <a:gd name="T4" fmla="*/ 310 w 418"/>
                  <a:gd name="T5" fmla="*/ 85 h 573"/>
                  <a:gd name="T6" fmla="*/ 225 w 418"/>
                  <a:gd name="T7" fmla="*/ 75 h 573"/>
                  <a:gd name="T8" fmla="*/ 124 w 418"/>
                  <a:gd name="T9" fmla="*/ 96 h 573"/>
                  <a:gd name="T10" fmla="*/ 91 w 418"/>
                  <a:gd name="T11" fmla="*/ 157 h 573"/>
                  <a:gd name="T12" fmla="*/ 115 w 418"/>
                  <a:gd name="T13" fmla="*/ 206 h 573"/>
                  <a:gd name="T14" fmla="*/ 211 w 418"/>
                  <a:gd name="T15" fmla="*/ 240 h 573"/>
                  <a:gd name="T16" fmla="*/ 242 w 418"/>
                  <a:gd name="T17" fmla="*/ 247 h 573"/>
                  <a:gd name="T18" fmla="*/ 378 w 418"/>
                  <a:gd name="T19" fmla="*/ 305 h 573"/>
                  <a:gd name="T20" fmla="*/ 418 w 418"/>
                  <a:gd name="T21" fmla="*/ 409 h 573"/>
                  <a:gd name="T22" fmla="*/ 358 w 418"/>
                  <a:gd name="T23" fmla="*/ 529 h 573"/>
                  <a:gd name="T24" fmla="*/ 192 w 418"/>
                  <a:gd name="T25" fmla="*/ 573 h 573"/>
                  <a:gd name="T26" fmla="*/ 100 w 418"/>
                  <a:gd name="T27" fmla="*/ 565 h 573"/>
                  <a:gd name="T28" fmla="*/ 0 w 418"/>
                  <a:gd name="T29" fmla="*/ 540 h 573"/>
                  <a:gd name="T30" fmla="*/ 0 w 418"/>
                  <a:gd name="T31" fmla="*/ 447 h 573"/>
                  <a:gd name="T32" fmla="*/ 98 w 418"/>
                  <a:gd name="T33" fmla="*/ 486 h 573"/>
                  <a:gd name="T34" fmla="*/ 194 w 418"/>
                  <a:gd name="T35" fmla="*/ 499 h 573"/>
                  <a:gd name="T36" fmla="*/ 292 w 418"/>
                  <a:gd name="T37" fmla="*/ 478 h 573"/>
                  <a:gd name="T38" fmla="*/ 326 w 418"/>
                  <a:gd name="T39" fmla="*/ 416 h 573"/>
                  <a:gd name="T40" fmla="*/ 301 w 418"/>
                  <a:gd name="T41" fmla="*/ 360 h 573"/>
                  <a:gd name="T42" fmla="*/ 193 w 418"/>
                  <a:gd name="T43" fmla="*/ 322 h 573"/>
                  <a:gd name="T44" fmla="*/ 162 w 418"/>
                  <a:gd name="T45" fmla="*/ 315 h 573"/>
                  <a:gd name="T46" fmla="*/ 41 w 418"/>
                  <a:gd name="T47" fmla="*/ 261 h 573"/>
                  <a:gd name="T48" fmla="*/ 4 w 418"/>
                  <a:gd name="T49" fmla="*/ 161 h 573"/>
                  <a:gd name="T50" fmla="*/ 58 w 418"/>
                  <a:gd name="T51" fmla="*/ 42 h 573"/>
                  <a:gd name="T52" fmla="*/ 214 w 418"/>
                  <a:gd name="T53" fmla="*/ 0 h 573"/>
                  <a:gd name="T54" fmla="*/ 308 w 418"/>
                  <a:gd name="T55" fmla="*/ 8 h 573"/>
                  <a:gd name="T56" fmla="*/ 389 w 418"/>
                  <a:gd name="T57" fmla="*/ 29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418" h="573">
                    <a:moveTo>
                      <a:pt x="389" y="29"/>
                    </a:moveTo>
                    <a:lnTo>
                      <a:pt x="389" y="114"/>
                    </a:lnTo>
                    <a:cubicBezTo>
                      <a:pt x="363" y="102"/>
                      <a:pt x="337" y="92"/>
                      <a:pt x="310" y="85"/>
                    </a:cubicBezTo>
                    <a:cubicBezTo>
                      <a:pt x="282" y="79"/>
                      <a:pt x="254" y="75"/>
                      <a:pt x="225" y="75"/>
                    </a:cubicBezTo>
                    <a:cubicBezTo>
                      <a:pt x="180" y="75"/>
                      <a:pt x="146" y="82"/>
                      <a:pt x="124" y="96"/>
                    </a:cubicBezTo>
                    <a:cubicBezTo>
                      <a:pt x="102" y="110"/>
                      <a:pt x="91" y="130"/>
                      <a:pt x="91" y="157"/>
                    </a:cubicBezTo>
                    <a:cubicBezTo>
                      <a:pt x="91" y="178"/>
                      <a:pt x="99" y="194"/>
                      <a:pt x="115" y="206"/>
                    </a:cubicBezTo>
                    <a:cubicBezTo>
                      <a:pt x="131" y="218"/>
                      <a:pt x="163" y="230"/>
                      <a:pt x="211" y="240"/>
                    </a:cubicBezTo>
                    <a:lnTo>
                      <a:pt x="242" y="247"/>
                    </a:lnTo>
                    <a:cubicBezTo>
                      <a:pt x="306" y="261"/>
                      <a:pt x="351" y="281"/>
                      <a:pt x="378" y="305"/>
                    </a:cubicBezTo>
                    <a:cubicBezTo>
                      <a:pt x="404" y="330"/>
                      <a:pt x="418" y="365"/>
                      <a:pt x="418" y="409"/>
                    </a:cubicBezTo>
                    <a:cubicBezTo>
                      <a:pt x="418" y="460"/>
                      <a:pt x="398" y="500"/>
                      <a:pt x="358" y="529"/>
                    </a:cubicBezTo>
                    <a:cubicBezTo>
                      <a:pt x="318" y="559"/>
                      <a:pt x="262" y="573"/>
                      <a:pt x="192" y="573"/>
                    </a:cubicBezTo>
                    <a:cubicBezTo>
                      <a:pt x="162" y="573"/>
                      <a:pt x="132" y="570"/>
                      <a:pt x="100" y="565"/>
                    </a:cubicBezTo>
                    <a:cubicBezTo>
                      <a:pt x="68" y="560"/>
                      <a:pt x="35" y="552"/>
                      <a:pt x="0" y="540"/>
                    </a:cubicBezTo>
                    <a:lnTo>
                      <a:pt x="0" y="447"/>
                    </a:lnTo>
                    <a:cubicBezTo>
                      <a:pt x="33" y="465"/>
                      <a:pt x="66" y="478"/>
                      <a:pt x="98" y="486"/>
                    </a:cubicBezTo>
                    <a:cubicBezTo>
                      <a:pt x="130" y="495"/>
                      <a:pt x="162" y="499"/>
                      <a:pt x="194" y="499"/>
                    </a:cubicBezTo>
                    <a:cubicBezTo>
                      <a:pt x="236" y="499"/>
                      <a:pt x="269" y="492"/>
                      <a:pt x="292" y="478"/>
                    </a:cubicBezTo>
                    <a:cubicBezTo>
                      <a:pt x="314" y="464"/>
                      <a:pt x="326" y="443"/>
                      <a:pt x="326" y="416"/>
                    </a:cubicBezTo>
                    <a:cubicBezTo>
                      <a:pt x="326" y="392"/>
                      <a:pt x="317" y="373"/>
                      <a:pt x="301" y="360"/>
                    </a:cubicBezTo>
                    <a:cubicBezTo>
                      <a:pt x="285" y="347"/>
                      <a:pt x="249" y="334"/>
                      <a:pt x="193" y="322"/>
                    </a:cubicBezTo>
                    <a:lnTo>
                      <a:pt x="162" y="315"/>
                    </a:lnTo>
                    <a:cubicBezTo>
                      <a:pt x="106" y="303"/>
                      <a:pt x="65" y="285"/>
                      <a:pt x="41" y="261"/>
                    </a:cubicBezTo>
                    <a:cubicBezTo>
                      <a:pt x="16" y="237"/>
                      <a:pt x="4" y="204"/>
                      <a:pt x="4" y="161"/>
                    </a:cubicBezTo>
                    <a:cubicBezTo>
                      <a:pt x="4" y="110"/>
                      <a:pt x="22" y="70"/>
                      <a:pt x="58" y="42"/>
                    </a:cubicBezTo>
                    <a:cubicBezTo>
                      <a:pt x="94" y="14"/>
                      <a:pt x="146" y="0"/>
                      <a:pt x="214" y="0"/>
                    </a:cubicBezTo>
                    <a:cubicBezTo>
                      <a:pt x="247" y="0"/>
                      <a:pt x="278" y="3"/>
                      <a:pt x="308" y="8"/>
                    </a:cubicBezTo>
                    <a:cubicBezTo>
                      <a:pt x="337" y="13"/>
                      <a:pt x="364" y="20"/>
                      <a:pt x="389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5" name="Freeform 15">
                <a:extLst>
                  <a:ext uri="{FF2B5EF4-FFF2-40B4-BE49-F238E27FC236}">
                    <a16:creationId xmlns:a16="http://schemas.microsoft.com/office/drawing/2014/main" id="{6DA879FD-8EA9-A719-1282-E28DB7538BC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455524" y="3706927"/>
                <a:ext cx="5665" cy="49288"/>
              </a:xfrm>
              <a:custGeom>
                <a:avLst/>
                <a:gdLst>
                  <a:gd name="T0" fmla="*/ 0 w 90"/>
                  <a:gd name="T1" fmla="*/ 213 h 760"/>
                  <a:gd name="T2" fmla="*/ 90 w 90"/>
                  <a:gd name="T3" fmla="*/ 213 h 760"/>
                  <a:gd name="T4" fmla="*/ 90 w 90"/>
                  <a:gd name="T5" fmla="*/ 760 h 760"/>
                  <a:gd name="T6" fmla="*/ 0 w 90"/>
                  <a:gd name="T7" fmla="*/ 760 h 760"/>
                  <a:gd name="T8" fmla="*/ 0 w 90"/>
                  <a:gd name="T9" fmla="*/ 213 h 760"/>
                  <a:gd name="T10" fmla="*/ 0 w 90"/>
                  <a:gd name="T11" fmla="*/ 0 h 760"/>
                  <a:gd name="T12" fmla="*/ 90 w 90"/>
                  <a:gd name="T13" fmla="*/ 0 h 760"/>
                  <a:gd name="T14" fmla="*/ 90 w 90"/>
                  <a:gd name="T15" fmla="*/ 114 h 760"/>
                  <a:gd name="T16" fmla="*/ 0 w 90"/>
                  <a:gd name="T17" fmla="*/ 114 h 760"/>
                  <a:gd name="T18" fmla="*/ 0 w 90"/>
                  <a:gd name="T19" fmla="*/ 0 h 7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90" h="760">
                    <a:moveTo>
                      <a:pt x="0" y="213"/>
                    </a:moveTo>
                    <a:lnTo>
                      <a:pt x="90" y="213"/>
                    </a:lnTo>
                    <a:lnTo>
                      <a:pt x="90" y="760"/>
                    </a:lnTo>
                    <a:lnTo>
                      <a:pt x="0" y="760"/>
                    </a:lnTo>
                    <a:lnTo>
                      <a:pt x="0" y="213"/>
                    </a:lnTo>
                    <a:close/>
                    <a:moveTo>
                      <a:pt x="0" y="0"/>
                    </a:moveTo>
                    <a:lnTo>
                      <a:pt x="90" y="0"/>
                    </a:lnTo>
                    <a:lnTo>
                      <a:pt x="90" y="114"/>
                    </a:lnTo>
                    <a:lnTo>
                      <a:pt x="0" y="11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6" name="Freeform 16">
                <a:extLst>
                  <a:ext uri="{FF2B5EF4-FFF2-40B4-BE49-F238E27FC236}">
                    <a16:creationId xmlns:a16="http://schemas.microsoft.com/office/drawing/2014/main" id="{CA0C663E-FD75-5CAB-5BE1-35BDBD25055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441927" y="3710893"/>
                <a:ext cx="22095" cy="45322"/>
              </a:xfrm>
              <a:custGeom>
                <a:avLst/>
                <a:gdLst>
                  <a:gd name="T0" fmla="*/ 156 w 341"/>
                  <a:gd name="T1" fmla="*/ 0 h 702"/>
                  <a:gd name="T2" fmla="*/ 156 w 341"/>
                  <a:gd name="T3" fmla="*/ 155 h 702"/>
                  <a:gd name="T4" fmla="*/ 341 w 341"/>
                  <a:gd name="T5" fmla="*/ 155 h 702"/>
                  <a:gd name="T6" fmla="*/ 341 w 341"/>
                  <a:gd name="T7" fmla="*/ 225 h 702"/>
                  <a:gd name="T8" fmla="*/ 156 w 341"/>
                  <a:gd name="T9" fmla="*/ 225 h 702"/>
                  <a:gd name="T10" fmla="*/ 156 w 341"/>
                  <a:gd name="T11" fmla="*/ 522 h 702"/>
                  <a:gd name="T12" fmla="*/ 174 w 341"/>
                  <a:gd name="T13" fmla="*/ 608 h 702"/>
                  <a:gd name="T14" fmla="*/ 249 w 341"/>
                  <a:gd name="T15" fmla="*/ 627 h 702"/>
                  <a:gd name="T16" fmla="*/ 341 w 341"/>
                  <a:gd name="T17" fmla="*/ 627 h 702"/>
                  <a:gd name="T18" fmla="*/ 341 w 341"/>
                  <a:gd name="T19" fmla="*/ 702 h 702"/>
                  <a:gd name="T20" fmla="*/ 249 w 341"/>
                  <a:gd name="T21" fmla="*/ 702 h 702"/>
                  <a:gd name="T22" fmla="*/ 105 w 341"/>
                  <a:gd name="T23" fmla="*/ 663 h 702"/>
                  <a:gd name="T24" fmla="*/ 66 w 341"/>
                  <a:gd name="T25" fmla="*/ 522 h 702"/>
                  <a:gd name="T26" fmla="*/ 66 w 341"/>
                  <a:gd name="T27" fmla="*/ 225 h 702"/>
                  <a:gd name="T28" fmla="*/ 0 w 341"/>
                  <a:gd name="T29" fmla="*/ 225 h 702"/>
                  <a:gd name="T30" fmla="*/ 0 w 341"/>
                  <a:gd name="T31" fmla="*/ 155 h 702"/>
                  <a:gd name="T32" fmla="*/ 66 w 341"/>
                  <a:gd name="T33" fmla="*/ 155 h 702"/>
                  <a:gd name="T34" fmla="*/ 66 w 341"/>
                  <a:gd name="T35" fmla="*/ 0 h 702"/>
                  <a:gd name="T36" fmla="*/ 156 w 341"/>
                  <a:gd name="T37" fmla="*/ 0 h 7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341" h="702">
                    <a:moveTo>
                      <a:pt x="156" y="0"/>
                    </a:moveTo>
                    <a:lnTo>
                      <a:pt x="156" y="155"/>
                    </a:lnTo>
                    <a:lnTo>
                      <a:pt x="341" y="155"/>
                    </a:lnTo>
                    <a:lnTo>
                      <a:pt x="341" y="225"/>
                    </a:lnTo>
                    <a:lnTo>
                      <a:pt x="156" y="225"/>
                    </a:lnTo>
                    <a:lnTo>
                      <a:pt x="156" y="522"/>
                    </a:lnTo>
                    <a:cubicBezTo>
                      <a:pt x="156" y="567"/>
                      <a:pt x="162" y="596"/>
                      <a:pt x="174" y="608"/>
                    </a:cubicBezTo>
                    <a:cubicBezTo>
                      <a:pt x="186" y="621"/>
                      <a:pt x="211" y="627"/>
                      <a:pt x="249" y="627"/>
                    </a:cubicBezTo>
                    <a:lnTo>
                      <a:pt x="341" y="627"/>
                    </a:lnTo>
                    <a:lnTo>
                      <a:pt x="341" y="702"/>
                    </a:lnTo>
                    <a:lnTo>
                      <a:pt x="249" y="702"/>
                    </a:lnTo>
                    <a:cubicBezTo>
                      <a:pt x="179" y="702"/>
                      <a:pt x="131" y="689"/>
                      <a:pt x="105" y="663"/>
                    </a:cubicBezTo>
                    <a:cubicBezTo>
                      <a:pt x="79" y="637"/>
                      <a:pt x="66" y="590"/>
                      <a:pt x="66" y="522"/>
                    </a:cubicBezTo>
                    <a:lnTo>
                      <a:pt x="66" y="225"/>
                    </a:lnTo>
                    <a:lnTo>
                      <a:pt x="0" y="225"/>
                    </a:lnTo>
                    <a:lnTo>
                      <a:pt x="0" y="155"/>
                    </a:lnTo>
                    <a:lnTo>
                      <a:pt x="66" y="155"/>
                    </a:lnTo>
                    <a:lnTo>
                      <a:pt x="66" y="0"/>
                    </a:lnTo>
                    <a:lnTo>
                      <a:pt x="156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7" name="Freeform 17">
                <a:extLst>
                  <a:ext uri="{FF2B5EF4-FFF2-40B4-BE49-F238E27FC236}">
                    <a16:creationId xmlns:a16="http://schemas.microsoft.com/office/drawing/2014/main" id="{3C27EC1B-DE4F-9DD5-054B-2C34F52F43F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412468" y="3706927"/>
                <a:ext cx="5665" cy="49288"/>
              </a:xfrm>
              <a:custGeom>
                <a:avLst/>
                <a:gdLst>
                  <a:gd name="T0" fmla="*/ 0 w 90"/>
                  <a:gd name="T1" fmla="*/ 213 h 760"/>
                  <a:gd name="T2" fmla="*/ 90 w 90"/>
                  <a:gd name="T3" fmla="*/ 213 h 760"/>
                  <a:gd name="T4" fmla="*/ 90 w 90"/>
                  <a:gd name="T5" fmla="*/ 760 h 760"/>
                  <a:gd name="T6" fmla="*/ 0 w 90"/>
                  <a:gd name="T7" fmla="*/ 760 h 760"/>
                  <a:gd name="T8" fmla="*/ 0 w 90"/>
                  <a:gd name="T9" fmla="*/ 213 h 760"/>
                  <a:gd name="T10" fmla="*/ 0 w 90"/>
                  <a:gd name="T11" fmla="*/ 0 h 760"/>
                  <a:gd name="T12" fmla="*/ 90 w 90"/>
                  <a:gd name="T13" fmla="*/ 0 h 760"/>
                  <a:gd name="T14" fmla="*/ 90 w 90"/>
                  <a:gd name="T15" fmla="*/ 114 h 760"/>
                  <a:gd name="T16" fmla="*/ 0 w 90"/>
                  <a:gd name="T17" fmla="*/ 114 h 760"/>
                  <a:gd name="T18" fmla="*/ 0 w 90"/>
                  <a:gd name="T19" fmla="*/ 0 h 7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90" h="760">
                    <a:moveTo>
                      <a:pt x="0" y="213"/>
                    </a:moveTo>
                    <a:lnTo>
                      <a:pt x="90" y="213"/>
                    </a:lnTo>
                    <a:lnTo>
                      <a:pt x="90" y="760"/>
                    </a:lnTo>
                    <a:lnTo>
                      <a:pt x="0" y="760"/>
                    </a:lnTo>
                    <a:lnTo>
                      <a:pt x="0" y="213"/>
                    </a:lnTo>
                    <a:close/>
                    <a:moveTo>
                      <a:pt x="0" y="0"/>
                    </a:moveTo>
                    <a:lnTo>
                      <a:pt x="90" y="0"/>
                    </a:lnTo>
                    <a:lnTo>
                      <a:pt x="90" y="114"/>
                    </a:lnTo>
                    <a:lnTo>
                      <a:pt x="0" y="11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8" name="Freeform 18">
                <a:extLst>
                  <a:ext uri="{FF2B5EF4-FFF2-40B4-BE49-F238E27FC236}">
                    <a16:creationId xmlns:a16="http://schemas.microsoft.com/office/drawing/2014/main" id="{16EC204A-8E65-8276-8547-746CD42B2F6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397172" y="3719957"/>
                <a:ext cx="32292" cy="36824"/>
              </a:xfrm>
              <a:custGeom>
                <a:avLst/>
                <a:gdLst>
                  <a:gd name="T0" fmla="*/ 251 w 502"/>
                  <a:gd name="T1" fmla="*/ 76 h 573"/>
                  <a:gd name="T2" fmla="*/ 137 w 502"/>
                  <a:gd name="T3" fmla="*/ 133 h 573"/>
                  <a:gd name="T4" fmla="*/ 95 w 502"/>
                  <a:gd name="T5" fmla="*/ 287 h 573"/>
                  <a:gd name="T6" fmla="*/ 136 w 502"/>
                  <a:gd name="T7" fmla="*/ 442 h 573"/>
                  <a:gd name="T8" fmla="*/ 251 w 502"/>
                  <a:gd name="T9" fmla="*/ 498 h 573"/>
                  <a:gd name="T10" fmla="*/ 365 w 502"/>
                  <a:gd name="T11" fmla="*/ 442 h 573"/>
                  <a:gd name="T12" fmla="*/ 407 w 502"/>
                  <a:gd name="T13" fmla="*/ 287 h 573"/>
                  <a:gd name="T14" fmla="*/ 365 w 502"/>
                  <a:gd name="T15" fmla="*/ 133 h 573"/>
                  <a:gd name="T16" fmla="*/ 251 w 502"/>
                  <a:gd name="T17" fmla="*/ 76 h 573"/>
                  <a:gd name="T18" fmla="*/ 251 w 502"/>
                  <a:gd name="T19" fmla="*/ 0 h 573"/>
                  <a:gd name="T20" fmla="*/ 435 w 502"/>
                  <a:gd name="T21" fmla="*/ 76 h 573"/>
                  <a:gd name="T22" fmla="*/ 502 w 502"/>
                  <a:gd name="T23" fmla="*/ 287 h 573"/>
                  <a:gd name="T24" fmla="*/ 435 w 502"/>
                  <a:gd name="T25" fmla="*/ 497 h 573"/>
                  <a:gd name="T26" fmla="*/ 251 w 502"/>
                  <a:gd name="T27" fmla="*/ 573 h 573"/>
                  <a:gd name="T28" fmla="*/ 66 w 502"/>
                  <a:gd name="T29" fmla="*/ 497 h 573"/>
                  <a:gd name="T30" fmla="*/ 0 w 502"/>
                  <a:gd name="T31" fmla="*/ 287 h 573"/>
                  <a:gd name="T32" fmla="*/ 66 w 502"/>
                  <a:gd name="T33" fmla="*/ 76 h 573"/>
                  <a:gd name="T34" fmla="*/ 251 w 502"/>
                  <a:gd name="T35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2" h="573">
                    <a:moveTo>
                      <a:pt x="251" y="76"/>
                    </a:moveTo>
                    <a:cubicBezTo>
                      <a:pt x="203" y="76"/>
                      <a:pt x="165" y="95"/>
                      <a:pt x="137" y="133"/>
                    </a:cubicBezTo>
                    <a:cubicBezTo>
                      <a:pt x="109" y="171"/>
                      <a:pt x="95" y="222"/>
                      <a:pt x="95" y="287"/>
                    </a:cubicBezTo>
                    <a:cubicBezTo>
                      <a:pt x="95" y="353"/>
                      <a:pt x="108" y="404"/>
                      <a:pt x="136" y="442"/>
                    </a:cubicBezTo>
                    <a:cubicBezTo>
                      <a:pt x="164" y="480"/>
                      <a:pt x="202" y="498"/>
                      <a:pt x="251" y="498"/>
                    </a:cubicBezTo>
                    <a:cubicBezTo>
                      <a:pt x="299" y="498"/>
                      <a:pt x="337" y="480"/>
                      <a:pt x="365" y="442"/>
                    </a:cubicBezTo>
                    <a:cubicBezTo>
                      <a:pt x="393" y="404"/>
                      <a:pt x="407" y="353"/>
                      <a:pt x="407" y="287"/>
                    </a:cubicBezTo>
                    <a:cubicBezTo>
                      <a:pt x="407" y="223"/>
                      <a:pt x="393" y="171"/>
                      <a:pt x="365" y="133"/>
                    </a:cubicBezTo>
                    <a:cubicBezTo>
                      <a:pt x="337" y="95"/>
                      <a:pt x="299" y="76"/>
                      <a:pt x="251" y="76"/>
                    </a:cubicBezTo>
                    <a:close/>
                    <a:moveTo>
                      <a:pt x="251" y="0"/>
                    </a:moveTo>
                    <a:cubicBezTo>
                      <a:pt x="329" y="0"/>
                      <a:pt x="390" y="26"/>
                      <a:pt x="435" y="76"/>
                    </a:cubicBezTo>
                    <a:cubicBezTo>
                      <a:pt x="479" y="127"/>
                      <a:pt x="502" y="197"/>
                      <a:pt x="502" y="287"/>
                    </a:cubicBezTo>
                    <a:cubicBezTo>
                      <a:pt x="502" y="377"/>
                      <a:pt x="479" y="447"/>
                      <a:pt x="435" y="497"/>
                    </a:cubicBezTo>
                    <a:cubicBezTo>
                      <a:pt x="390" y="548"/>
                      <a:pt x="329" y="573"/>
                      <a:pt x="251" y="573"/>
                    </a:cubicBezTo>
                    <a:cubicBezTo>
                      <a:pt x="172" y="573"/>
                      <a:pt x="110" y="548"/>
                      <a:pt x="66" y="497"/>
                    </a:cubicBezTo>
                    <a:cubicBezTo>
                      <a:pt x="22" y="447"/>
                      <a:pt x="0" y="377"/>
                      <a:pt x="0" y="287"/>
                    </a:cubicBezTo>
                    <a:cubicBezTo>
                      <a:pt x="0" y="197"/>
                      <a:pt x="22" y="127"/>
                      <a:pt x="66" y="76"/>
                    </a:cubicBezTo>
                    <a:cubicBezTo>
                      <a:pt x="110" y="26"/>
                      <a:pt x="172" y="0"/>
                      <a:pt x="251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9" name="Freeform 19">
                <a:extLst>
                  <a:ext uri="{FF2B5EF4-FFF2-40B4-BE49-F238E27FC236}">
                    <a16:creationId xmlns:a16="http://schemas.microsoft.com/office/drawing/2014/main" id="{82D99BEB-7DB7-55FB-AE11-171FA8B8BD1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355249" y="3719957"/>
                <a:ext cx="29459" cy="36258"/>
              </a:xfrm>
              <a:custGeom>
                <a:avLst/>
                <a:gdLst>
                  <a:gd name="T0" fmla="*/ 458 w 458"/>
                  <a:gd name="T1" fmla="*/ 230 h 560"/>
                  <a:gd name="T2" fmla="*/ 458 w 458"/>
                  <a:gd name="T3" fmla="*/ 560 h 560"/>
                  <a:gd name="T4" fmla="*/ 368 w 458"/>
                  <a:gd name="T5" fmla="*/ 560 h 560"/>
                  <a:gd name="T6" fmla="*/ 368 w 458"/>
                  <a:gd name="T7" fmla="*/ 233 h 560"/>
                  <a:gd name="T8" fmla="*/ 337 w 458"/>
                  <a:gd name="T9" fmla="*/ 117 h 560"/>
                  <a:gd name="T10" fmla="*/ 247 w 458"/>
                  <a:gd name="T11" fmla="*/ 78 h 560"/>
                  <a:gd name="T12" fmla="*/ 132 w 458"/>
                  <a:gd name="T13" fmla="*/ 125 h 560"/>
                  <a:gd name="T14" fmla="*/ 90 w 458"/>
                  <a:gd name="T15" fmla="*/ 251 h 560"/>
                  <a:gd name="T16" fmla="*/ 90 w 458"/>
                  <a:gd name="T17" fmla="*/ 560 h 560"/>
                  <a:gd name="T18" fmla="*/ 0 w 458"/>
                  <a:gd name="T19" fmla="*/ 560 h 560"/>
                  <a:gd name="T20" fmla="*/ 0 w 458"/>
                  <a:gd name="T21" fmla="*/ 13 h 560"/>
                  <a:gd name="T22" fmla="*/ 90 w 458"/>
                  <a:gd name="T23" fmla="*/ 13 h 560"/>
                  <a:gd name="T24" fmla="*/ 90 w 458"/>
                  <a:gd name="T25" fmla="*/ 98 h 560"/>
                  <a:gd name="T26" fmla="*/ 166 w 458"/>
                  <a:gd name="T27" fmla="*/ 25 h 560"/>
                  <a:gd name="T28" fmla="*/ 267 w 458"/>
                  <a:gd name="T29" fmla="*/ 0 h 560"/>
                  <a:gd name="T30" fmla="*/ 409 w 458"/>
                  <a:gd name="T31" fmla="*/ 59 h 560"/>
                  <a:gd name="T32" fmla="*/ 458 w 458"/>
                  <a:gd name="T33" fmla="*/ 230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58" h="560">
                    <a:moveTo>
                      <a:pt x="458" y="230"/>
                    </a:moveTo>
                    <a:lnTo>
                      <a:pt x="458" y="560"/>
                    </a:lnTo>
                    <a:lnTo>
                      <a:pt x="368" y="560"/>
                    </a:lnTo>
                    <a:lnTo>
                      <a:pt x="368" y="233"/>
                    </a:lnTo>
                    <a:cubicBezTo>
                      <a:pt x="368" y="181"/>
                      <a:pt x="357" y="143"/>
                      <a:pt x="337" y="117"/>
                    </a:cubicBezTo>
                    <a:cubicBezTo>
                      <a:pt x="317" y="91"/>
                      <a:pt x="287" y="78"/>
                      <a:pt x="247" y="78"/>
                    </a:cubicBezTo>
                    <a:cubicBezTo>
                      <a:pt x="198" y="78"/>
                      <a:pt x="160" y="94"/>
                      <a:pt x="132" y="125"/>
                    </a:cubicBezTo>
                    <a:cubicBezTo>
                      <a:pt x="104" y="156"/>
                      <a:pt x="90" y="198"/>
                      <a:pt x="90" y="251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11" y="66"/>
                      <a:pt x="136" y="41"/>
                      <a:pt x="166" y="25"/>
                    </a:cubicBezTo>
                    <a:cubicBezTo>
                      <a:pt x="195" y="9"/>
                      <a:pt x="229" y="0"/>
                      <a:pt x="267" y="0"/>
                    </a:cubicBezTo>
                    <a:cubicBezTo>
                      <a:pt x="329" y="0"/>
                      <a:pt x="377" y="20"/>
                      <a:pt x="409" y="59"/>
                    </a:cubicBezTo>
                    <a:cubicBezTo>
                      <a:pt x="441" y="98"/>
                      <a:pt x="458" y="155"/>
                      <a:pt x="458" y="23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0" name="Freeform 20">
                <a:extLst>
                  <a:ext uri="{FF2B5EF4-FFF2-40B4-BE49-F238E27FC236}">
                    <a16:creationId xmlns:a16="http://schemas.microsoft.com/office/drawing/2014/main" id="{C9E0665A-473C-0454-FABD-50E566AE6C9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253274" y="3709193"/>
                <a:ext cx="30026" cy="47022"/>
              </a:xfrm>
              <a:custGeom>
                <a:avLst/>
                <a:gdLst>
                  <a:gd name="T0" fmla="*/ 99 w 471"/>
                  <a:gd name="T1" fmla="*/ 81 h 729"/>
                  <a:gd name="T2" fmla="*/ 99 w 471"/>
                  <a:gd name="T3" fmla="*/ 355 h 729"/>
                  <a:gd name="T4" fmla="*/ 223 w 471"/>
                  <a:gd name="T5" fmla="*/ 355 h 729"/>
                  <a:gd name="T6" fmla="*/ 329 w 471"/>
                  <a:gd name="T7" fmla="*/ 320 h 729"/>
                  <a:gd name="T8" fmla="*/ 367 w 471"/>
                  <a:gd name="T9" fmla="*/ 218 h 729"/>
                  <a:gd name="T10" fmla="*/ 329 w 471"/>
                  <a:gd name="T11" fmla="*/ 117 h 729"/>
                  <a:gd name="T12" fmla="*/ 223 w 471"/>
                  <a:gd name="T13" fmla="*/ 81 h 729"/>
                  <a:gd name="T14" fmla="*/ 99 w 471"/>
                  <a:gd name="T15" fmla="*/ 81 h 729"/>
                  <a:gd name="T16" fmla="*/ 0 w 471"/>
                  <a:gd name="T17" fmla="*/ 0 h 729"/>
                  <a:gd name="T18" fmla="*/ 223 w 471"/>
                  <a:gd name="T19" fmla="*/ 0 h 729"/>
                  <a:gd name="T20" fmla="*/ 408 w 471"/>
                  <a:gd name="T21" fmla="*/ 56 h 729"/>
                  <a:gd name="T22" fmla="*/ 471 w 471"/>
                  <a:gd name="T23" fmla="*/ 218 h 729"/>
                  <a:gd name="T24" fmla="*/ 408 w 471"/>
                  <a:gd name="T25" fmla="*/ 381 h 729"/>
                  <a:gd name="T26" fmla="*/ 223 w 471"/>
                  <a:gd name="T27" fmla="*/ 436 h 729"/>
                  <a:gd name="T28" fmla="*/ 99 w 471"/>
                  <a:gd name="T29" fmla="*/ 436 h 729"/>
                  <a:gd name="T30" fmla="*/ 99 w 471"/>
                  <a:gd name="T31" fmla="*/ 729 h 729"/>
                  <a:gd name="T32" fmla="*/ 0 w 471"/>
                  <a:gd name="T33" fmla="*/ 729 h 729"/>
                  <a:gd name="T34" fmla="*/ 0 w 471"/>
                  <a:gd name="T35" fmla="*/ 0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71" h="729">
                    <a:moveTo>
                      <a:pt x="99" y="81"/>
                    </a:moveTo>
                    <a:lnTo>
                      <a:pt x="99" y="355"/>
                    </a:lnTo>
                    <a:lnTo>
                      <a:pt x="223" y="355"/>
                    </a:lnTo>
                    <a:cubicBezTo>
                      <a:pt x="269" y="355"/>
                      <a:pt x="304" y="344"/>
                      <a:pt x="329" y="320"/>
                    </a:cubicBezTo>
                    <a:cubicBezTo>
                      <a:pt x="354" y="296"/>
                      <a:pt x="367" y="262"/>
                      <a:pt x="367" y="218"/>
                    </a:cubicBezTo>
                    <a:cubicBezTo>
                      <a:pt x="367" y="174"/>
                      <a:pt x="354" y="141"/>
                      <a:pt x="329" y="117"/>
                    </a:cubicBezTo>
                    <a:cubicBezTo>
                      <a:pt x="304" y="93"/>
                      <a:pt x="269" y="81"/>
                      <a:pt x="223" y="81"/>
                    </a:cubicBezTo>
                    <a:lnTo>
                      <a:pt x="99" y="81"/>
                    </a:lnTo>
                    <a:close/>
                    <a:moveTo>
                      <a:pt x="0" y="0"/>
                    </a:moveTo>
                    <a:lnTo>
                      <a:pt x="223" y="0"/>
                    </a:lnTo>
                    <a:cubicBezTo>
                      <a:pt x="304" y="0"/>
                      <a:pt x="366" y="19"/>
                      <a:pt x="408" y="56"/>
                    </a:cubicBezTo>
                    <a:cubicBezTo>
                      <a:pt x="450" y="93"/>
                      <a:pt x="471" y="147"/>
                      <a:pt x="471" y="218"/>
                    </a:cubicBezTo>
                    <a:cubicBezTo>
                      <a:pt x="471" y="290"/>
                      <a:pt x="450" y="345"/>
                      <a:pt x="408" y="381"/>
                    </a:cubicBezTo>
                    <a:cubicBezTo>
                      <a:pt x="366" y="418"/>
                      <a:pt x="304" y="436"/>
                      <a:pt x="223" y="436"/>
                    </a:cubicBezTo>
                    <a:lnTo>
                      <a:pt x="99" y="436"/>
                    </a:lnTo>
                    <a:lnTo>
                      <a:pt x="99" y="729"/>
                    </a:lnTo>
                    <a:lnTo>
                      <a:pt x="0" y="729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1" name="Freeform 21">
                <a:extLst>
                  <a:ext uri="{FF2B5EF4-FFF2-40B4-BE49-F238E27FC236}">
                    <a16:creationId xmlns:a16="http://schemas.microsoft.com/office/drawing/2014/main" id="{A6CC4E09-4EE3-D7A1-0EFE-6F7BC4A2F5A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216450" y="3719957"/>
                <a:ext cx="20962" cy="36258"/>
              </a:xfrm>
              <a:custGeom>
                <a:avLst/>
                <a:gdLst>
                  <a:gd name="T0" fmla="*/ 320 w 320"/>
                  <a:gd name="T1" fmla="*/ 97 h 560"/>
                  <a:gd name="T2" fmla="*/ 287 w 320"/>
                  <a:gd name="T3" fmla="*/ 84 h 560"/>
                  <a:gd name="T4" fmla="*/ 248 w 320"/>
                  <a:gd name="T5" fmla="*/ 80 h 560"/>
                  <a:gd name="T6" fmla="*/ 131 w 320"/>
                  <a:gd name="T7" fmla="*/ 130 h 560"/>
                  <a:gd name="T8" fmla="*/ 90 w 320"/>
                  <a:gd name="T9" fmla="*/ 272 h 560"/>
                  <a:gd name="T10" fmla="*/ 90 w 320"/>
                  <a:gd name="T11" fmla="*/ 560 h 560"/>
                  <a:gd name="T12" fmla="*/ 0 w 320"/>
                  <a:gd name="T13" fmla="*/ 560 h 560"/>
                  <a:gd name="T14" fmla="*/ 0 w 320"/>
                  <a:gd name="T15" fmla="*/ 13 h 560"/>
                  <a:gd name="T16" fmla="*/ 90 w 320"/>
                  <a:gd name="T17" fmla="*/ 13 h 560"/>
                  <a:gd name="T18" fmla="*/ 90 w 320"/>
                  <a:gd name="T19" fmla="*/ 98 h 560"/>
                  <a:gd name="T20" fmla="*/ 163 w 320"/>
                  <a:gd name="T21" fmla="*/ 24 h 560"/>
                  <a:gd name="T22" fmla="*/ 274 w 320"/>
                  <a:gd name="T23" fmla="*/ 0 h 560"/>
                  <a:gd name="T24" fmla="*/ 295 w 320"/>
                  <a:gd name="T25" fmla="*/ 1 h 560"/>
                  <a:gd name="T26" fmla="*/ 320 w 320"/>
                  <a:gd name="T27" fmla="*/ 5 h 560"/>
                  <a:gd name="T28" fmla="*/ 320 w 320"/>
                  <a:gd name="T29" fmla="*/ 97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320" h="560">
                    <a:moveTo>
                      <a:pt x="320" y="97"/>
                    </a:moveTo>
                    <a:cubicBezTo>
                      <a:pt x="310" y="91"/>
                      <a:pt x="299" y="87"/>
                      <a:pt x="287" y="84"/>
                    </a:cubicBezTo>
                    <a:cubicBezTo>
                      <a:pt x="275" y="82"/>
                      <a:pt x="262" y="80"/>
                      <a:pt x="248" y="80"/>
                    </a:cubicBezTo>
                    <a:cubicBezTo>
                      <a:pt x="197" y="80"/>
                      <a:pt x="158" y="97"/>
                      <a:pt x="131" y="130"/>
                    </a:cubicBezTo>
                    <a:cubicBezTo>
                      <a:pt x="103" y="163"/>
                      <a:pt x="90" y="210"/>
                      <a:pt x="90" y="272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08" y="65"/>
                      <a:pt x="133" y="40"/>
                      <a:pt x="163" y="24"/>
                    </a:cubicBezTo>
                    <a:cubicBezTo>
                      <a:pt x="193" y="8"/>
                      <a:pt x="230" y="0"/>
                      <a:pt x="274" y="0"/>
                    </a:cubicBezTo>
                    <a:cubicBezTo>
                      <a:pt x="280" y="0"/>
                      <a:pt x="287" y="1"/>
                      <a:pt x="295" y="1"/>
                    </a:cubicBezTo>
                    <a:cubicBezTo>
                      <a:pt x="302" y="2"/>
                      <a:pt x="310" y="3"/>
                      <a:pt x="320" y="5"/>
                    </a:cubicBezTo>
                    <a:lnTo>
                      <a:pt x="320" y="97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2" name="Freeform 22">
                <a:extLst>
                  <a:ext uri="{FF2B5EF4-FFF2-40B4-BE49-F238E27FC236}">
                    <a16:creationId xmlns:a16="http://schemas.microsoft.com/office/drawing/2014/main" id="{69DBCA88-0CB1-8C57-3740-4A42E292733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193789" y="3719957"/>
                <a:ext cx="32292" cy="36824"/>
              </a:xfrm>
              <a:custGeom>
                <a:avLst/>
                <a:gdLst>
                  <a:gd name="T0" fmla="*/ 251 w 502"/>
                  <a:gd name="T1" fmla="*/ 76 h 573"/>
                  <a:gd name="T2" fmla="*/ 137 w 502"/>
                  <a:gd name="T3" fmla="*/ 133 h 573"/>
                  <a:gd name="T4" fmla="*/ 95 w 502"/>
                  <a:gd name="T5" fmla="*/ 287 h 573"/>
                  <a:gd name="T6" fmla="*/ 136 w 502"/>
                  <a:gd name="T7" fmla="*/ 442 h 573"/>
                  <a:gd name="T8" fmla="*/ 251 w 502"/>
                  <a:gd name="T9" fmla="*/ 498 h 573"/>
                  <a:gd name="T10" fmla="*/ 365 w 502"/>
                  <a:gd name="T11" fmla="*/ 442 h 573"/>
                  <a:gd name="T12" fmla="*/ 407 w 502"/>
                  <a:gd name="T13" fmla="*/ 287 h 573"/>
                  <a:gd name="T14" fmla="*/ 365 w 502"/>
                  <a:gd name="T15" fmla="*/ 133 h 573"/>
                  <a:gd name="T16" fmla="*/ 251 w 502"/>
                  <a:gd name="T17" fmla="*/ 76 h 573"/>
                  <a:gd name="T18" fmla="*/ 251 w 502"/>
                  <a:gd name="T19" fmla="*/ 0 h 573"/>
                  <a:gd name="T20" fmla="*/ 435 w 502"/>
                  <a:gd name="T21" fmla="*/ 76 h 573"/>
                  <a:gd name="T22" fmla="*/ 502 w 502"/>
                  <a:gd name="T23" fmla="*/ 287 h 573"/>
                  <a:gd name="T24" fmla="*/ 435 w 502"/>
                  <a:gd name="T25" fmla="*/ 497 h 573"/>
                  <a:gd name="T26" fmla="*/ 251 w 502"/>
                  <a:gd name="T27" fmla="*/ 573 h 573"/>
                  <a:gd name="T28" fmla="*/ 66 w 502"/>
                  <a:gd name="T29" fmla="*/ 497 h 573"/>
                  <a:gd name="T30" fmla="*/ 0 w 502"/>
                  <a:gd name="T31" fmla="*/ 287 h 573"/>
                  <a:gd name="T32" fmla="*/ 66 w 502"/>
                  <a:gd name="T33" fmla="*/ 76 h 573"/>
                  <a:gd name="T34" fmla="*/ 251 w 502"/>
                  <a:gd name="T35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2" h="573">
                    <a:moveTo>
                      <a:pt x="251" y="76"/>
                    </a:moveTo>
                    <a:cubicBezTo>
                      <a:pt x="203" y="76"/>
                      <a:pt x="165" y="95"/>
                      <a:pt x="137" y="133"/>
                    </a:cubicBezTo>
                    <a:cubicBezTo>
                      <a:pt x="109" y="171"/>
                      <a:pt x="95" y="222"/>
                      <a:pt x="95" y="287"/>
                    </a:cubicBezTo>
                    <a:cubicBezTo>
                      <a:pt x="95" y="353"/>
                      <a:pt x="108" y="404"/>
                      <a:pt x="136" y="442"/>
                    </a:cubicBezTo>
                    <a:cubicBezTo>
                      <a:pt x="164" y="480"/>
                      <a:pt x="202" y="498"/>
                      <a:pt x="251" y="498"/>
                    </a:cubicBezTo>
                    <a:cubicBezTo>
                      <a:pt x="299" y="498"/>
                      <a:pt x="337" y="480"/>
                      <a:pt x="365" y="442"/>
                    </a:cubicBezTo>
                    <a:cubicBezTo>
                      <a:pt x="393" y="404"/>
                      <a:pt x="407" y="353"/>
                      <a:pt x="407" y="287"/>
                    </a:cubicBezTo>
                    <a:cubicBezTo>
                      <a:pt x="407" y="223"/>
                      <a:pt x="393" y="171"/>
                      <a:pt x="365" y="133"/>
                    </a:cubicBezTo>
                    <a:cubicBezTo>
                      <a:pt x="337" y="95"/>
                      <a:pt x="299" y="76"/>
                      <a:pt x="251" y="76"/>
                    </a:cubicBezTo>
                    <a:close/>
                    <a:moveTo>
                      <a:pt x="251" y="0"/>
                    </a:moveTo>
                    <a:cubicBezTo>
                      <a:pt x="329" y="0"/>
                      <a:pt x="390" y="26"/>
                      <a:pt x="435" y="76"/>
                    </a:cubicBezTo>
                    <a:cubicBezTo>
                      <a:pt x="479" y="127"/>
                      <a:pt x="502" y="197"/>
                      <a:pt x="502" y="287"/>
                    </a:cubicBezTo>
                    <a:cubicBezTo>
                      <a:pt x="502" y="377"/>
                      <a:pt x="479" y="447"/>
                      <a:pt x="435" y="497"/>
                    </a:cubicBezTo>
                    <a:cubicBezTo>
                      <a:pt x="390" y="548"/>
                      <a:pt x="329" y="573"/>
                      <a:pt x="251" y="573"/>
                    </a:cubicBezTo>
                    <a:cubicBezTo>
                      <a:pt x="172" y="573"/>
                      <a:pt x="110" y="548"/>
                      <a:pt x="66" y="497"/>
                    </a:cubicBezTo>
                    <a:cubicBezTo>
                      <a:pt x="22" y="447"/>
                      <a:pt x="0" y="377"/>
                      <a:pt x="0" y="287"/>
                    </a:cubicBezTo>
                    <a:cubicBezTo>
                      <a:pt x="0" y="197"/>
                      <a:pt x="22" y="127"/>
                      <a:pt x="66" y="76"/>
                    </a:cubicBezTo>
                    <a:cubicBezTo>
                      <a:pt x="110" y="26"/>
                      <a:pt x="172" y="0"/>
                      <a:pt x="251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3" name="Freeform 23">
                <a:extLst>
                  <a:ext uri="{FF2B5EF4-FFF2-40B4-BE49-F238E27FC236}">
                    <a16:creationId xmlns:a16="http://schemas.microsoft.com/office/drawing/2014/main" id="{36B539B6-FC68-E611-91F0-44693B624D4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154132" y="3719957"/>
                <a:ext cx="27760" cy="36824"/>
              </a:xfrm>
              <a:custGeom>
                <a:avLst/>
                <a:gdLst>
                  <a:gd name="T0" fmla="*/ 433 w 433"/>
                  <a:gd name="T1" fmla="*/ 34 h 573"/>
                  <a:gd name="T2" fmla="*/ 433 w 433"/>
                  <a:gd name="T3" fmla="*/ 118 h 573"/>
                  <a:gd name="T4" fmla="*/ 356 w 433"/>
                  <a:gd name="T5" fmla="*/ 87 h 573"/>
                  <a:gd name="T6" fmla="*/ 279 w 433"/>
                  <a:gd name="T7" fmla="*/ 76 h 573"/>
                  <a:gd name="T8" fmla="*/ 143 w 433"/>
                  <a:gd name="T9" fmla="*/ 132 h 573"/>
                  <a:gd name="T10" fmla="*/ 95 w 433"/>
                  <a:gd name="T11" fmla="*/ 287 h 573"/>
                  <a:gd name="T12" fmla="*/ 143 w 433"/>
                  <a:gd name="T13" fmla="*/ 443 h 573"/>
                  <a:gd name="T14" fmla="*/ 279 w 433"/>
                  <a:gd name="T15" fmla="*/ 498 h 573"/>
                  <a:gd name="T16" fmla="*/ 356 w 433"/>
                  <a:gd name="T17" fmla="*/ 488 h 573"/>
                  <a:gd name="T18" fmla="*/ 433 w 433"/>
                  <a:gd name="T19" fmla="*/ 456 h 573"/>
                  <a:gd name="T20" fmla="*/ 433 w 433"/>
                  <a:gd name="T21" fmla="*/ 539 h 573"/>
                  <a:gd name="T22" fmla="*/ 355 w 433"/>
                  <a:gd name="T23" fmla="*/ 565 h 573"/>
                  <a:gd name="T24" fmla="*/ 269 w 433"/>
                  <a:gd name="T25" fmla="*/ 573 h 573"/>
                  <a:gd name="T26" fmla="*/ 73 w 433"/>
                  <a:gd name="T27" fmla="*/ 496 h 573"/>
                  <a:gd name="T28" fmla="*/ 0 w 433"/>
                  <a:gd name="T29" fmla="*/ 287 h 573"/>
                  <a:gd name="T30" fmla="*/ 73 w 433"/>
                  <a:gd name="T31" fmla="*/ 77 h 573"/>
                  <a:gd name="T32" fmla="*/ 275 w 433"/>
                  <a:gd name="T33" fmla="*/ 0 h 573"/>
                  <a:gd name="T34" fmla="*/ 356 w 433"/>
                  <a:gd name="T35" fmla="*/ 9 h 573"/>
                  <a:gd name="T36" fmla="*/ 433 w 433"/>
                  <a:gd name="T37" fmla="*/ 34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433" h="573">
                    <a:moveTo>
                      <a:pt x="433" y="34"/>
                    </a:moveTo>
                    <a:lnTo>
                      <a:pt x="433" y="118"/>
                    </a:lnTo>
                    <a:cubicBezTo>
                      <a:pt x="407" y="104"/>
                      <a:pt x="382" y="94"/>
                      <a:pt x="356" y="87"/>
                    </a:cubicBezTo>
                    <a:cubicBezTo>
                      <a:pt x="330" y="80"/>
                      <a:pt x="305" y="76"/>
                      <a:pt x="279" y="76"/>
                    </a:cubicBezTo>
                    <a:cubicBezTo>
                      <a:pt x="221" y="76"/>
                      <a:pt x="175" y="95"/>
                      <a:pt x="143" y="132"/>
                    </a:cubicBezTo>
                    <a:cubicBezTo>
                      <a:pt x="111" y="169"/>
                      <a:pt x="95" y="221"/>
                      <a:pt x="95" y="287"/>
                    </a:cubicBezTo>
                    <a:cubicBezTo>
                      <a:pt x="95" y="354"/>
                      <a:pt x="111" y="406"/>
                      <a:pt x="143" y="443"/>
                    </a:cubicBezTo>
                    <a:cubicBezTo>
                      <a:pt x="175" y="480"/>
                      <a:pt x="221" y="498"/>
                      <a:pt x="279" y="498"/>
                    </a:cubicBezTo>
                    <a:cubicBezTo>
                      <a:pt x="305" y="498"/>
                      <a:pt x="330" y="495"/>
                      <a:pt x="356" y="488"/>
                    </a:cubicBezTo>
                    <a:cubicBezTo>
                      <a:pt x="382" y="481"/>
                      <a:pt x="407" y="470"/>
                      <a:pt x="433" y="456"/>
                    </a:cubicBezTo>
                    <a:lnTo>
                      <a:pt x="433" y="539"/>
                    </a:lnTo>
                    <a:cubicBezTo>
                      <a:pt x="407" y="551"/>
                      <a:pt x="381" y="560"/>
                      <a:pt x="355" y="565"/>
                    </a:cubicBezTo>
                    <a:cubicBezTo>
                      <a:pt x="328" y="570"/>
                      <a:pt x="299" y="573"/>
                      <a:pt x="269" y="573"/>
                    </a:cubicBezTo>
                    <a:cubicBezTo>
                      <a:pt x="187" y="573"/>
                      <a:pt x="121" y="548"/>
                      <a:pt x="73" y="496"/>
                    </a:cubicBezTo>
                    <a:cubicBezTo>
                      <a:pt x="24" y="445"/>
                      <a:pt x="0" y="375"/>
                      <a:pt x="0" y="287"/>
                    </a:cubicBezTo>
                    <a:cubicBezTo>
                      <a:pt x="0" y="198"/>
                      <a:pt x="24" y="128"/>
                      <a:pt x="73" y="77"/>
                    </a:cubicBezTo>
                    <a:cubicBezTo>
                      <a:pt x="122" y="26"/>
                      <a:pt x="189" y="0"/>
                      <a:pt x="275" y="0"/>
                    </a:cubicBezTo>
                    <a:cubicBezTo>
                      <a:pt x="303" y="0"/>
                      <a:pt x="330" y="3"/>
                      <a:pt x="356" y="9"/>
                    </a:cubicBezTo>
                    <a:cubicBezTo>
                      <a:pt x="382" y="15"/>
                      <a:pt x="408" y="23"/>
                      <a:pt x="433" y="34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4" name="Freeform 24">
                <a:extLst>
                  <a:ext uri="{FF2B5EF4-FFF2-40B4-BE49-F238E27FC236}">
                    <a16:creationId xmlns:a16="http://schemas.microsoft.com/office/drawing/2014/main" id="{E29A333A-C19D-695A-9AD0-775AB12932A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119007" y="3719957"/>
                <a:ext cx="32859" cy="36824"/>
              </a:xfrm>
              <a:custGeom>
                <a:avLst/>
                <a:gdLst>
                  <a:gd name="T0" fmla="*/ 507 w 507"/>
                  <a:gd name="T1" fmla="*/ 264 h 573"/>
                  <a:gd name="T2" fmla="*/ 507 w 507"/>
                  <a:gd name="T3" fmla="*/ 308 h 573"/>
                  <a:gd name="T4" fmla="*/ 94 w 507"/>
                  <a:gd name="T5" fmla="*/ 308 h 573"/>
                  <a:gd name="T6" fmla="*/ 150 w 507"/>
                  <a:gd name="T7" fmla="*/ 450 h 573"/>
                  <a:gd name="T8" fmla="*/ 289 w 507"/>
                  <a:gd name="T9" fmla="*/ 498 h 573"/>
                  <a:gd name="T10" fmla="*/ 389 w 507"/>
                  <a:gd name="T11" fmla="*/ 486 h 573"/>
                  <a:gd name="T12" fmla="*/ 486 w 507"/>
                  <a:gd name="T13" fmla="*/ 447 h 573"/>
                  <a:gd name="T14" fmla="*/ 486 w 507"/>
                  <a:gd name="T15" fmla="*/ 532 h 573"/>
                  <a:gd name="T16" fmla="*/ 387 w 507"/>
                  <a:gd name="T17" fmla="*/ 563 h 573"/>
                  <a:gd name="T18" fmla="*/ 284 w 507"/>
                  <a:gd name="T19" fmla="*/ 573 h 573"/>
                  <a:gd name="T20" fmla="*/ 76 w 507"/>
                  <a:gd name="T21" fmla="*/ 498 h 573"/>
                  <a:gd name="T22" fmla="*/ 0 w 507"/>
                  <a:gd name="T23" fmla="*/ 292 h 573"/>
                  <a:gd name="T24" fmla="*/ 72 w 507"/>
                  <a:gd name="T25" fmla="*/ 79 h 573"/>
                  <a:gd name="T26" fmla="*/ 268 w 507"/>
                  <a:gd name="T27" fmla="*/ 0 h 573"/>
                  <a:gd name="T28" fmla="*/ 443 w 507"/>
                  <a:gd name="T29" fmla="*/ 71 h 573"/>
                  <a:gd name="T30" fmla="*/ 507 w 507"/>
                  <a:gd name="T31" fmla="*/ 264 h 573"/>
                  <a:gd name="T32" fmla="*/ 417 w 507"/>
                  <a:gd name="T33" fmla="*/ 238 h 573"/>
                  <a:gd name="T34" fmla="*/ 376 w 507"/>
                  <a:gd name="T35" fmla="*/ 120 h 573"/>
                  <a:gd name="T36" fmla="*/ 269 w 507"/>
                  <a:gd name="T37" fmla="*/ 76 h 573"/>
                  <a:gd name="T38" fmla="*/ 149 w 507"/>
                  <a:gd name="T39" fmla="*/ 119 h 573"/>
                  <a:gd name="T40" fmla="*/ 97 w 507"/>
                  <a:gd name="T41" fmla="*/ 238 h 573"/>
                  <a:gd name="T42" fmla="*/ 417 w 507"/>
                  <a:gd name="T43" fmla="*/ 23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07" h="573">
                    <a:moveTo>
                      <a:pt x="507" y="264"/>
                    </a:moveTo>
                    <a:lnTo>
                      <a:pt x="507" y="308"/>
                    </a:lnTo>
                    <a:lnTo>
                      <a:pt x="94" y="308"/>
                    </a:lnTo>
                    <a:cubicBezTo>
                      <a:pt x="98" y="370"/>
                      <a:pt x="116" y="418"/>
                      <a:pt x="150" y="450"/>
                    </a:cubicBezTo>
                    <a:cubicBezTo>
                      <a:pt x="183" y="482"/>
                      <a:pt x="229" y="498"/>
                      <a:pt x="289" y="498"/>
                    </a:cubicBezTo>
                    <a:cubicBezTo>
                      <a:pt x="323" y="498"/>
                      <a:pt x="357" y="494"/>
                      <a:pt x="389" y="486"/>
                    </a:cubicBezTo>
                    <a:cubicBezTo>
                      <a:pt x="421" y="478"/>
                      <a:pt x="454" y="465"/>
                      <a:pt x="486" y="447"/>
                    </a:cubicBezTo>
                    <a:lnTo>
                      <a:pt x="486" y="532"/>
                    </a:lnTo>
                    <a:cubicBezTo>
                      <a:pt x="454" y="546"/>
                      <a:pt x="421" y="557"/>
                      <a:pt x="387" y="563"/>
                    </a:cubicBezTo>
                    <a:cubicBezTo>
                      <a:pt x="353" y="569"/>
                      <a:pt x="318" y="573"/>
                      <a:pt x="284" y="573"/>
                    </a:cubicBezTo>
                    <a:cubicBezTo>
                      <a:pt x="196" y="573"/>
                      <a:pt x="127" y="548"/>
                      <a:pt x="76" y="498"/>
                    </a:cubicBezTo>
                    <a:cubicBezTo>
                      <a:pt x="25" y="448"/>
                      <a:pt x="0" y="379"/>
                      <a:pt x="0" y="292"/>
                    </a:cubicBezTo>
                    <a:cubicBezTo>
                      <a:pt x="0" y="203"/>
                      <a:pt x="24" y="132"/>
                      <a:pt x="72" y="79"/>
                    </a:cubicBezTo>
                    <a:cubicBezTo>
                      <a:pt x="120" y="27"/>
                      <a:pt x="186" y="0"/>
                      <a:pt x="268" y="0"/>
                    </a:cubicBezTo>
                    <a:cubicBezTo>
                      <a:pt x="342" y="0"/>
                      <a:pt x="400" y="24"/>
                      <a:pt x="443" y="71"/>
                    </a:cubicBezTo>
                    <a:cubicBezTo>
                      <a:pt x="485" y="119"/>
                      <a:pt x="507" y="183"/>
                      <a:pt x="507" y="264"/>
                    </a:cubicBezTo>
                    <a:close/>
                    <a:moveTo>
                      <a:pt x="417" y="238"/>
                    </a:moveTo>
                    <a:cubicBezTo>
                      <a:pt x="416" y="189"/>
                      <a:pt x="402" y="150"/>
                      <a:pt x="376" y="120"/>
                    </a:cubicBezTo>
                    <a:cubicBezTo>
                      <a:pt x="349" y="91"/>
                      <a:pt x="313" y="76"/>
                      <a:pt x="269" y="76"/>
                    </a:cubicBezTo>
                    <a:cubicBezTo>
                      <a:pt x="219" y="76"/>
                      <a:pt x="179" y="91"/>
                      <a:pt x="149" y="119"/>
                    </a:cubicBezTo>
                    <a:cubicBezTo>
                      <a:pt x="119" y="147"/>
                      <a:pt x="101" y="187"/>
                      <a:pt x="97" y="238"/>
                    </a:cubicBezTo>
                    <a:lnTo>
                      <a:pt x="417" y="238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5" name="Freeform 25">
                <a:extLst>
                  <a:ext uri="{FF2B5EF4-FFF2-40B4-BE49-F238E27FC236}">
                    <a16:creationId xmlns:a16="http://schemas.microsoft.com/office/drawing/2014/main" id="{F3BE44B5-5E98-EFCB-0DC0-EDF19D3874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79350" y="3719957"/>
                <a:ext cx="27193" cy="36824"/>
              </a:xfrm>
              <a:custGeom>
                <a:avLst/>
                <a:gdLst>
                  <a:gd name="T0" fmla="*/ 389 w 418"/>
                  <a:gd name="T1" fmla="*/ 29 h 573"/>
                  <a:gd name="T2" fmla="*/ 389 w 418"/>
                  <a:gd name="T3" fmla="*/ 114 h 573"/>
                  <a:gd name="T4" fmla="*/ 310 w 418"/>
                  <a:gd name="T5" fmla="*/ 85 h 573"/>
                  <a:gd name="T6" fmla="*/ 225 w 418"/>
                  <a:gd name="T7" fmla="*/ 75 h 573"/>
                  <a:gd name="T8" fmla="*/ 124 w 418"/>
                  <a:gd name="T9" fmla="*/ 96 h 573"/>
                  <a:gd name="T10" fmla="*/ 91 w 418"/>
                  <a:gd name="T11" fmla="*/ 157 h 573"/>
                  <a:gd name="T12" fmla="*/ 115 w 418"/>
                  <a:gd name="T13" fmla="*/ 206 h 573"/>
                  <a:gd name="T14" fmla="*/ 211 w 418"/>
                  <a:gd name="T15" fmla="*/ 240 h 573"/>
                  <a:gd name="T16" fmla="*/ 242 w 418"/>
                  <a:gd name="T17" fmla="*/ 247 h 573"/>
                  <a:gd name="T18" fmla="*/ 378 w 418"/>
                  <a:gd name="T19" fmla="*/ 305 h 573"/>
                  <a:gd name="T20" fmla="*/ 418 w 418"/>
                  <a:gd name="T21" fmla="*/ 409 h 573"/>
                  <a:gd name="T22" fmla="*/ 358 w 418"/>
                  <a:gd name="T23" fmla="*/ 529 h 573"/>
                  <a:gd name="T24" fmla="*/ 192 w 418"/>
                  <a:gd name="T25" fmla="*/ 573 h 573"/>
                  <a:gd name="T26" fmla="*/ 100 w 418"/>
                  <a:gd name="T27" fmla="*/ 565 h 573"/>
                  <a:gd name="T28" fmla="*/ 0 w 418"/>
                  <a:gd name="T29" fmla="*/ 540 h 573"/>
                  <a:gd name="T30" fmla="*/ 0 w 418"/>
                  <a:gd name="T31" fmla="*/ 447 h 573"/>
                  <a:gd name="T32" fmla="*/ 98 w 418"/>
                  <a:gd name="T33" fmla="*/ 486 h 573"/>
                  <a:gd name="T34" fmla="*/ 194 w 418"/>
                  <a:gd name="T35" fmla="*/ 499 h 573"/>
                  <a:gd name="T36" fmla="*/ 292 w 418"/>
                  <a:gd name="T37" fmla="*/ 478 h 573"/>
                  <a:gd name="T38" fmla="*/ 326 w 418"/>
                  <a:gd name="T39" fmla="*/ 416 h 573"/>
                  <a:gd name="T40" fmla="*/ 301 w 418"/>
                  <a:gd name="T41" fmla="*/ 360 h 573"/>
                  <a:gd name="T42" fmla="*/ 193 w 418"/>
                  <a:gd name="T43" fmla="*/ 322 h 573"/>
                  <a:gd name="T44" fmla="*/ 162 w 418"/>
                  <a:gd name="T45" fmla="*/ 315 h 573"/>
                  <a:gd name="T46" fmla="*/ 41 w 418"/>
                  <a:gd name="T47" fmla="*/ 261 h 573"/>
                  <a:gd name="T48" fmla="*/ 4 w 418"/>
                  <a:gd name="T49" fmla="*/ 161 h 573"/>
                  <a:gd name="T50" fmla="*/ 58 w 418"/>
                  <a:gd name="T51" fmla="*/ 42 h 573"/>
                  <a:gd name="T52" fmla="*/ 214 w 418"/>
                  <a:gd name="T53" fmla="*/ 0 h 573"/>
                  <a:gd name="T54" fmla="*/ 308 w 418"/>
                  <a:gd name="T55" fmla="*/ 8 h 573"/>
                  <a:gd name="T56" fmla="*/ 389 w 418"/>
                  <a:gd name="T57" fmla="*/ 29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418" h="573">
                    <a:moveTo>
                      <a:pt x="389" y="29"/>
                    </a:moveTo>
                    <a:lnTo>
                      <a:pt x="389" y="114"/>
                    </a:lnTo>
                    <a:cubicBezTo>
                      <a:pt x="363" y="102"/>
                      <a:pt x="337" y="92"/>
                      <a:pt x="310" y="85"/>
                    </a:cubicBezTo>
                    <a:cubicBezTo>
                      <a:pt x="282" y="79"/>
                      <a:pt x="254" y="75"/>
                      <a:pt x="225" y="75"/>
                    </a:cubicBezTo>
                    <a:cubicBezTo>
                      <a:pt x="180" y="75"/>
                      <a:pt x="146" y="82"/>
                      <a:pt x="124" y="96"/>
                    </a:cubicBezTo>
                    <a:cubicBezTo>
                      <a:pt x="102" y="110"/>
                      <a:pt x="91" y="130"/>
                      <a:pt x="91" y="157"/>
                    </a:cubicBezTo>
                    <a:cubicBezTo>
                      <a:pt x="91" y="178"/>
                      <a:pt x="99" y="194"/>
                      <a:pt x="115" y="206"/>
                    </a:cubicBezTo>
                    <a:cubicBezTo>
                      <a:pt x="131" y="218"/>
                      <a:pt x="163" y="230"/>
                      <a:pt x="211" y="240"/>
                    </a:cubicBezTo>
                    <a:lnTo>
                      <a:pt x="242" y="247"/>
                    </a:lnTo>
                    <a:cubicBezTo>
                      <a:pt x="306" y="261"/>
                      <a:pt x="351" y="281"/>
                      <a:pt x="378" y="305"/>
                    </a:cubicBezTo>
                    <a:cubicBezTo>
                      <a:pt x="404" y="330"/>
                      <a:pt x="418" y="365"/>
                      <a:pt x="418" y="409"/>
                    </a:cubicBezTo>
                    <a:cubicBezTo>
                      <a:pt x="418" y="460"/>
                      <a:pt x="398" y="500"/>
                      <a:pt x="358" y="529"/>
                    </a:cubicBezTo>
                    <a:cubicBezTo>
                      <a:pt x="318" y="559"/>
                      <a:pt x="262" y="573"/>
                      <a:pt x="192" y="573"/>
                    </a:cubicBezTo>
                    <a:cubicBezTo>
                      <a:pt x="162" y="573"/>
                      <a:pt x="132" y="570"/>
                      <a:pt x="100" y="565"/>
                    </a:cubicBezTo>
                    <a:cubicBezTo>
                      <a:pt x="68" y="560"/>
                      <a:pt x="35" y="552"/>
                      <a:pt x="0" y="540"/>
                    </a:cubicBezTo>
                    <a:lnTo>
                      <a:pt x="0" y="447"/>
                    </a:lnTo>
                    <a:cubicBezTo>
                      <a:pt x="33" y="465"/>
                      <a:pt x="66" y="478"/>
                      <a:pt x="98" y="486"/>
                    </a:cubicBezTo>
                    <a:cubicBezTo>
                      <a:pt x="130" y="495"/>
                      <a:pt x="162" y="499"/>
                      <a:pt x="194" y="499"/>
                    </a:cubicBezTo>
                    <a:cubicBezTo>
                      <a:pt x="236" y="499"/>
                      <a:pt x="269" y="492"/>
                      <a:pt x="292" y="478"/>
                    </a:cubicBezTo>
                    <a:cubicBezTo>
                      <a:pt x="314" y="464"/>
                      <a:pt x="326" y="443"/>
                      <a:pt x="326" y="416"/>
                    </a:cubicBezTo>
                    <a:cubicBezTo>
                      <a:pt x="326" y="392"/>
                      <a:pt x="317" y="373"/>
                      <a:pt x="301" y="360"/>
                    </a:cubicBezTo>
                    <a:cubicBezTo>
                      <a:pt x="285" y="347"/>
                      <a:pt x="249" y="334"/>
                      <a:pt x="193" y="322"/>
                    </a:cubicBezTo>
                    <a:lnTo>
                      <a:pt x="162" y="315"/>
                    </a:lnTo>
                    <a:cubicBezTo>
                      <a:pt x="106" y="303"/>
                      <a:pt x="65" y="285"/>
                      <a:pt x="41" y="261"/>
                    </a:cubicBezTo>
                    <a:cubicBezTo>
                      <a:pt x="16" y="237"/>
                      <a:pt x="4" y="204"/>
                      <a:pt x="4" y="161"/>
                    </a:cubicBezTo>
                    <a:cubicBezTo>
                      <a:pt x="4" y="110"/>
                      <a:pt x="22" y="70"/>
                      <a:pt x="58" y="42"/>
                    </a:cubicBezTo>
                    <a:cubicBezTo>
                      <a:pt x="94" y="14"/>
                      <a:pt x="146" y="0"/>
                      <a:pt x="214" y="0"/>
                    </a:cubicBezTo>
                    <a:cubicBezTo>
                      <a:pt x="247" y="0"/>
                      <a:pt x="278" y="3"/>
                      <a:pt x="308" y="8"/>
                    </a:cubicBezTo>
                    <a:cubicBezTo>
                      <a:pt x="337" y="13"/>
                      <a:pt x="364" y="20"/>
                      <a:pt x="389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6" name="Freeform 26">
                <a:extLst>
                  <a:ext uri="{FF2B5EF4-FFF2-40B4-BE49-F238E27FC236}">
                    <a16:creationId xmlns:a16="http://schemas.microsoft.com/office/drawing/2014/main" id="{331068F7-21AA-29FD-0A59-858C5C41908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45926" y="3719957"/>
                <a:ext cx="27193" cy="36824"/>
              </a:xfrm>
              <a:custGeom>
                <a:avLst/>
                <a:gdLst>
                  <a:gd name="T0" fmla="*/ 389 w 418"/>
                  <a:gd name="T1" fmla="*/ 29 h 573"/>
                  <a:gd name="T2" fmla="*/ 389 w 418"/>
                  <a:gd name="T3" fmla="*/ 114 h 573"/>
                  <a:gd name="T4" fmla="*/ 310 w 418"/>
                  <a:gd name="T5" fmla="*/ 85 h 573"/>
                  <a:gd name="T6" fmla="*/ 225 w 418"/>
                  <a:gd name="T7" fmla="*/ 75 h 573"/>
                  <a:gd name="T8" fmla="*/ 124 w 418"/>
                  <a:gd name="T9" fmla="*/ 96 h 573"/>
                  <a:gd name="T10" fmla="*/ 91 w 418"/>
                  <a:gd name="T11" fmla="*/ 157 h 573"/>
                  <a:gd name="T12" fmla="*/ 115 w 418"/>
                  <a:gd name="T13" fmla="*/ 206 h 573"/>
                  <a:gd name="T14" fmla="*/ 211 w 418"/>
                  <a:gd name="T15" fmla="*/ 240 h 573"/>
                  <a:gd name="T16" fmla="*/ 242 w 418"/>
                  <a:gd name="T17" fmla="*/ 247 h 573"/>
                  <a:gd name="T18" fmla="*/ 378 w 418"/>
                  <a:gd name="T19" fmla="*/ 305 h 573"/>
                  <a:gd name="T20" fmla="*/ 418 w 418"/>
                  <a:gd name="T21" fmla="*/ 409 h 573"/>
                  <a:gd name="T22" fmla="*/ 358 w 418"/>
                  <a:gd name="T23" fmla="*/ 529 h 573"/>
                  <a:gd name="T24" fmla="*/ 192 w 418"/>
                  <a:gd name="T25" fmla="*/ 573 h 573"/>
                  <a:gd name="T26" fmla="*/ 100 w 418"/>
                  <a:gd name="T27" fmla="*/ 565 h 573"/>
                  <a:gd name="T28" fmla="*/ 0 w 418"/>
                  <a:gd name="T29" fmla="*/ 540 h 573"/>
                  <a:gd name="T30" fmla="*/ 0 w 418"/>
                  <a:gd name="T31" fmla="*/ 447 h 573"/>
                  <a:gd name="T32" fmla="*/ 98 w 418"/>
                  <a:gd name="T33" fmla="*/ 486 h 573"/>
                  <a:gd name="T34" fmla="*/ 194 w 418"/>
                  <a:gd name="T35" fmla="*/ 499 h 573"/>
                  <a:gd name="T36" fmla="*/ 292 w 418"/>
                  <a:gd name="T37" fmla="*/ 478 h 573"/>
                  <a:gd name="T38" fmla="*/ 326 w 418"/>
                  <a:gd name="T39" fmla="*/ 416 h 573"/>
                  <a:gd name="T40" fmla="*/ 301 w 418"/>
                  <a:gd name="T41" fmla="*/ 360 h 573"/>
                  <a:gd name="T42" fmla="*/ 193 w 418"/>
                  <a:gd name="T43" fmla="*/ 322 h 573"/>
                  <a:gd name="T44" fmla="*/ 162 w 418"/>
                  <a:gd name="T45" fmla="*/ 315 h 573"/>
                  <a:gd name="T46" fmla="*/ 41 w 418"/>
                  <a:gd name="T47" fmla="*/ 261 h 573"/>
                  <a:gd name="T48" fmla="*/ 4 w 418"/>
                  <a:gd name="T49" fmla="*/ 161 h 573"/>
                  <a:gd name="T50" fmla="*/ 58 w 418"/>
                  <a:gd name="T51" fmla="*/ 42 h 573"/>
                  <a:gd name="T52" fmla="*/ 214 w 418"/>
                  <a:gd name="T53" fmla="*/ 0 h 573"/>
                  <a:gd name="T54" fmla="*/ 308 w 418"/>
                  <a:gd name="T55" fmla="*/ 8 h 573"/>
                  <a:gd name="T56" fmla="*/ 389 w 418"/>
                  <a:gd name="T57" fmla="*/ 29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418" h="573">
                    <a:moveTo>
                      <a:pt x="389" y="29"/>
                    </a:moveTo>
                    <a:lnTo>
                      <a:pt x="389" y="114"/>
                    </a:lnTo>
                    <a:cubicBezTo>
                      <a:pt x="363" y="102"/>
                      <a:pt x="337" y="92"/>
                      <a:pt x="310" y="85"/>
                    </a:cubicBezTo>
                    <a:cubicBezTo>
                      <a:pt x="282" y="79"/>
                      <a:pt x="254" y="75"/>
                      <a:pt x="225" y="75"/>
                    </a:cubicBezTo>
                    <a:cubicBezTo>
                      <a:pt x="180" y="75"/>
                      <a:pt x="146" y="82"/>
                      <a:pt x="124" y="96"/>
                    </a:cubicBezTo>
                    <a:cubicBezTo>
                      <a:pt x="102" y="110"/>
                      <a:pt x="91" y="130"/>
                      <a:pt x="91" y="157"/>
                    </a:cubicBezTo>
                    <a:cubicBezTo>
                      <a:pt x="91" y="178"/>
                      <a:pt x="99" y="194"/>
                      <a:pt x="115" y="206"/>
                    </a:cubicBezTo>
                    <a:cubicBezTo>
                      <a:pt x="131" y="218"/>
                      <a:pt x="163" y="230"/>
                      <a:pt x="211" y="240"/>
                    </a:cubicBezTo>
                    <a:lnTo>
                      <a:pt x="242" y="247"/>
                    </a:lnTo>
                    <a:cubicBezTo>
                      <a:pt x="306" y="261"/>
                      <a:pt x="351" y="281"/>
                      <a:pt x="378" y="305"/>
                    </a:cubicBezTo>
                    <a:cubicBezTo>
                      <a:pt x="404" y="330"/>
                      <a:pt x="418" y="365"/>
                      <a:pt x="418" y="409"/>
                    </a:cubicBezTo>
                    <a:cubicBezTo>
                      <a:pt x="418" y="460"/>
                      <a:pt x="398" y="500"/>
                      <a:pt x="358" y="529"/>
                    </a:cubicBezTo>
                    <a:cubicBezTo>
                      <a:pt x="318" y="559"/>
                      <a:pt x="262" y="573"/>
                      <a:pt x="192" y="573"/>
                    </a:cubicBezTo>
                    <a:cubicBezTo>
                      <a:pt x="162" y="573"/>
                      <a:pt x="132" y="570"/>
                      <a:pt x="100" y="565"/>
                    </a:cubicBezTo>
                    <a:cubicBezTo>
                      <a:pt x="68" y="560"/>
                      <a:pt x="35" y="552"/>
                      <a:pt x="0" y="540"/>
                    </a:cubicBezTo>
                    <a:lnTo>
                      <a:pt x="0" y="447"/>
                    </a:lnTo>
                    <a:cubicBezTo>
                      <a:pt x="33" y="465"/>
                      <a:pt x="66" y="478"/>
                      <a:pt x="98" y="486"/>
                    </a:cubicBezTo>
                    <a:cubicBezTo>
                      <a:pt x="130" y="495"/>
                      <a:pt x="162" y="499"/>
                      <a:pt x="194" y="499"/>
                    </a:cubicBezTo>
                    <a:cubicBezTo>
                      <a:pt x="236" y="499"/>
                      <a:pt x="269" y="492"/>
                      <a:pt x="292" y="478"/>
                    </a:cubicBezTo>
                    <a:cubicBezTo>
                      <a:pt x="314" y="464"/>
                      <a:pt x="326" y="443"/>
                      <a:pt x="326" y="416"/>
                    </a:cubicBezTo>
                    <a:cubicBezTo>
                      <a:pt x="326" y="392"/>
                      <a:pt x="317" y="373"/>
                      <a:pt x="301" y="360"/>
                    </a:cubicBezTo>
                    <a:cubicBezTo>
                      <a:pt x="285" y="347"/>
                      <a:pt x="249" y="334"/>
                      <a:pt x="193" y="322"/>
                    </a:cubicBezTo>
                    <a:lnTo>
                      <a:pt x="162" y="315"/>
                    </a:lnTo>
                    <a:cubicBezTo>
                      <a:pt x="106" y="303"/>
                      <a:pt x="65" y="285"/>
                      <a:pt x="41" y="261"/>
                    </a:cubicBezTo>
                    <a:cubicBezTo>
                      <a:pt x="16" y="237"/>
                      <a:pt x="4" y="204"/>
                      <a:pt x="4" y="161"/>
                    </a:cubicBezTo>
                    <a:cubicBezTo>
                      <a:pt x="4" y="110"/>
                      <a:pt x="22" y="70"/>
                      <a:pt x="58" y="42"/>
                    </a:cubicBezTo>
                    <a:cubicBezTo>
                      <a:pt x="94" y="14"/>
                      <a:pt x="146" y="0"/>
                      <a:pt x="214" y="0"/>
                    </a:cubicBezTo>
                    <a:cubicBezTo>
                      <a:pt x="247" y="0"/>
                      <a:pt x="278" y="3"/>
                      <a:pt x="308" y="8"/>
                    </a:cubicBezTo>
                    <a:cubicBezTo>
                      <a:pt x="337" y="13"/>
                      <a:pt x="364" y="20"/>
                      <a:pt x="389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7" name="Freeform 27">
                <a:extLst>
                  <a:ext uri="{FF2B5EF4-FFF2-40B4-BE49-F238E27FC236}">
                    <a16:creationId xmlns:a16="http://schemas.microsoft.com/office/drawing/2014/main" id="{46AA086C-D0C8-295E-9DA2-53E17996A3B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9668" y="3706927"/>
                <a:ext cx="5665" cy="49288"/>
              </a:xfrm>
              <a:custGeom>
                <a:avLst/>
                <a:gdLst>
                  <a:gd name="T0" fmla="*/ 0 w 90"/>
                  <a:gd name="T1" fmla="*/ 213 h 760"/>
                  <a:gd name="T2" fmla="*/ 90 w 90"/>
                  <a:gd name="T3" fmla="*/ 213 h 760"/>
                  <a:gd name="T4" fmla="*/ 90 w 90"/>
                  <a:gd name="T5" fmla="*/ 760 h 760"/>
                  <a:gd name="T6" fmla="*/ 0 w 90"/>
                  <a:gd name="T7" fmla="*/ 760 h 760"/>
                  <a:gd name="T8" fmla="*/ 0 w 90"/>
                  <a:gd name="T9" fmla="*/ 213 h 760"/>
                  <a:gd name="T10" fmla="*/ 0 w 90"/>
                  <a:gd name="T11" fmla="*/ 0 h 760"/>
                  <a:gd name="T12" fmla="*/ 90 w 90"/>
                  <a:gd name="T13" fmla="*/ 0 h 760"/>
                  <a:gd name="T14" fmla="*/ 90 w 90"/>
                  <a:gd name="T15" fmla="*/ 114 h 760"/>
                  <a:gd name="T16" fmla="*/ 0 w 90"/>
                  <a:gd name="T17" fmla="*/ 114 h 760"/>
                  <a:gd name="T18" fmla="*/ 0 w 90"/>
                  <a:gd name="T19" fmla="*/ 0 h 7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90" h="760">
                    <a:moveTo>
                      <a:pt x="0" y="213"/>
                    </a:moveTo>
                    <a:lnTo>
                      <a:pt x="90" y="213"/>
                    </a:lnTo>
                    <a:lnTo>
                      <a:pt x="90" y="760"/>
                    </a:lnTo>
                    <a:lnTo>
                      <a:pt x="0" y="760"/>
                    </a:lnTo>
                    <a:lnTo>
                      <a:pt x="0" y="213"/>
                    </a:lnTo>
                    <a:close/>
                    <a:moveTo>
                      <a:pt x="0" y="0"/>
                    </a:moveTo>
                    <a:lnTo>
                      <a:pt x="90" y="0"/>
                    </a:lnTo>
                    <a:lnTo>
                      <a:pt x="90" y="114"/>
                    </a:lnTo>
                    <a:lnTo>
                      <a:pt x="0" y="11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8" name="Freeform 28">
                <a:extLst>
                  <a:ext uri="{FF2B5EF4-FFF2-40B4-BE49-F238E27FC236}">
                    <a16:creationId xmlns:a16="http://schemas.microsoft.com/office/drawing/2014/main" id="{FE22B86A-EF06-E81A-73D8-C1ED99E8044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895" y="3719957"/>
                <a:ext cx="29459" cy="36258"/>
              </a:xfrm>
              <a:custGeom>
                <a:avLst/>
                <a:gdLst>
                  <a:gd name="T0" fmla="*/ 458 w 458"/>
                  <a:gd name="T1" fmla="*/ 230 h 560"/>
                  <a:gd name="T2" fmla="*/ 458 w 458"/>
                  <a:gd name="T3" fmla="*/ 560 h 560"/>
                  <a:gd name="T4" fmla="*/ 368 w 458"/>
                  <a:gd name="T5" fmla="*/ 560 h 560"/>
                  <a:gd name="T6" fmla="*/ 368 w 458"/>
                  <a:gd name="T7" fmla="*/ 233 h 560"/>
                  <a:gd name="T8" fmla="*/ 337 w 458"/>
                  <a:gd name="T9" fmla="*/ 117 h 560"/>
                  <a:gd name="T10" fmla="*/ 247 w 458"/>
                  <a:gd name="T11" fmla="*/ 78 h 560"/>
                  <a:gd name="T12" fmla="*/ 132 w 458"/>
                  <a:gd name="T13" fmla="*/ 125 h 560"/>
                  <a:gd name="T14" fmla="*/ 90 w 458"/>
                  <a:gd name="T15" fmla="*/ 251 h 560"/>
                  <a:gd name="T16" fmla="*/ 90 w 458"/>
                  <a:gd name="T17" fmla="*/ 560 h 560"/>
                  <a:gd name="T18" fmla="*/ 0 w 458"/>
                  <a:gd name="T19" fmla="*/ 560 h 560"/>
                  <a:gd name="T20" fmla="*/ 0 w 458"/>
                  <a:gd name="T21" fmla="*/ 13 h 560"/>
                  <a:gd name="T22" fmla="*/ 90 w 458"/>
                  <a:gd name="T23" fmla="*/ 13 h 560"/>
                  <a:gd name="T24" fmla="*/ 90 w 458"/>
                  <a:gd name="T25" fmla="*/ 98 h 560"/>
                  <a:gd name="T26" fmla="*/ 166 w 458"/>
                  <a:gd name="T27" fmla="*/ 25 h 560"/>
                  <a:gd name="T28" fmla="*/ 267 w 458"/>
                  <a:gd name="T29" fmla="*/ 0 h 560"/>
                  <a:gd name="T30" fmla="*/ 409 w 458"/>
                  <a:gd name="T31" fmla="*/ 59 h 560"/>
                  <a:gd name="T32" fmla="*/ 458 w 458"/>
                  <a:gd name="T33" fmla="*/ 230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58" h="560">
                    <a:moveTo>
                      <a:pt x="458" y="230"/>
                    </a:moveTo>
                    <a:lnTo>
                      <a:pt x="458" y="560"/>
                    </a:lnTo>
                    <a:lnTo>
                      <a:pt x="368" y="560"/>
                    </a:lnTo>
                    <a:lnTo>
                      <a:pt x="368" y="233"/>
                    </a:lnTo>
                    <a:cubicBezTo>
                      <a:pt x="368" y="181"/>
                      <a:pt x="357" y="143"/>
                      <a:pt x="337" y="117"/>
                    </a:cubicBezTo>
                    <a:cubicBezTo>
                      <a:pt x="317" y="91"/>
                      <a:pt x="287" y="78"/>
                      <a:pt x="247" y="78"/>
                    </a:cubicBezTo>
                    <a:cubicBezTo>
                      <a:pt x="198" y="78"/>
                      <a:pt x="160" y="94"/>
                      <a:pt x="132" y="125"/>
                    </a:cubicBezTo>
                    <a:cubicBezTo>
                      <a:pt x="104" y="156"/>
                      <a:pt x="90" y="198"/>
                      <a:pt x="90" y="251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11" y="66"/>
                      <a:pt x="136" y="41"/>
                      <a:pt x="166" y="25"/>
                    </a:cubicBezTo>
                    <a:cubicBezTo>
                      <a:pt x="195" y="9"/>
                      <a:pt x="229" y="0"/>
                      <a:pt x="267" y="0"/>
                    </a:cubicBezTo>
                    <a:cubicBezTo>
                      <a:pt x="329" y="0"/>
                      <a:pt x="377" y="20"/>
                      <a:pt x="409" y="59"/>
                    </a:cubicBezTo>
                    <a:cubicBezTo>
                      <a:pt x="441" y="98"/>
                      <a:pt x="458" y="155"/>
                      <a:pt x="458" y="23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9" name="Freeform 29">
                <a:extLst>
                  <a:ext uri="{FF2B5EF4-FFF2-40B4-BE49-F238E27FC236}">
                    <a16:creationId xmlns:a16="http://schemas.microsoft.com/office/drawing/2014/main" id="{A22302F1-4972-EA56-BDD5-74F16E096BC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6418" y="3719957"/>
                <a:ext cx="31725" cy="49288"/>
              </a:xfrm>
              <a:custGeom>
                <a:avLst/>
                <a:gdLst>
                  <a:gd name="T0" fmla="*/ 399 w 489"/>
                  <a:gd name="T1" fmla="*/ 280 h 767"/>
                  <a:gd name="T2" fmla="*/ 359 w 489"/>
                  <a:gd name="T3" fmla="*/ 129 h 767"/>
                  <a:gd name="T4" fmla="*/ 246 w 489"/>
                  <a:gd name="T5" fmla="*/ 75 h 767"/>
                  <a:gd name="T6" fmla="*/ 133 w 489"/>
                  <a:gd name="T7" fmla="*/ 129 h 767"/>
                  <a:gd name="T8" fmla="*/ 93 w 489"/>
                  <a:gd name="T9" fmla="*/ 280 h 767"/>
                  <a:gd name="T10" fmla="*/ 133 w 489"/>
                  <a:gd name="T11" fmla="*/ 431 h 767"/>
                  <a:gd name="T12" fmla="*/ 246 w 489"/>
                  <a:gd name="T13" fmla="*/ 485 h 767"/>
                  <a:gd name="T14" fmla="*/ 359 w 489"/>
                  <a:gd name="T15" fmla="*/ 431 h 767"/>
                  <a:gd name="T16" fmla="*/ 399 w 489"/>
                  <a:gd name="T17" fmla="*/ 280 h 767"/>
                  <a:gd name="T18" fmla="*/ 489 w 489"/>
                  <a:gd name="T19" fmla="*/ 492 h 767"/>
                  <a:gd name="T20" fmla="*/ 427 w 489"/>
                  <a:gd name="T21" fmla="*/ 699 h 767"/>
                  <a:gd name="T22" fmla="*/ 237 w 489"/>
                  <a:gd name="T23" fmla="*/ 767 h 767"/>
                  <a:gd name="T24" fmla="*/ 148 w 489"/>
                  <a:gd name="T25" fmla="*/ 760 h 767"/>
                  <a:gd name="T26" fmla="*/ 66 w 489"/>
                  <a:gd name="T27" fmla="*/ 738 h 767"/>
                  <a:gd name="T28" fmla="*/ 66 w 489"/>
                  <a:gd name="T29" fmla="*/ 651 h 767"/>
                  <a:gd name="T30" fmla="*/ 144 w 489"/>
                  <a:gd name="T31" fmla="*/ 682 h 767"/>
                  <a:gd name="T32" fmla="*/ 223 w 489"/>
                  <a:gd name="T33" fmla="*/ 693 h 767"/>
                  <a:gd name="T34" fmla="*/ 355 w 489"/>
                  <a:gd name="T35" fmla="*/ 647 h 767"/>
                  <a:gd name="T36" fmla="*/ 399 w 489"/>
                  <a:gd name="T37" fmla="*/ 508 h 767"/>
                  <a:gd name="T38" fmla="*/ 399 w 489"/>
                  <a:gd name="T39" fmla="*/ 464 h 767"/>
                  <a:gd name="T40" fmla="*/ 327 w 489"/>
                  <a:gd name="T41" fmla="*/ 536 h 767"/>
                  <a:gd name="T42" fmla="*/ 224 w 489"/>
                  <a:gd name="T43" fmla="*/ 560 h 767"/>
                  <a:gd name="T44" fmla="*/ 61 w 489"/>
                  <a:gd name="T45" fmla="*/ 484 h 767"/>
                  <a:gd name="T46" fmla="*/ 0 w 489"/>
                  <a:gd name="T47" fmla="*/ 280 h 767"/>
                  <a:gd name="T48" fmla="*/ 61 w 489"/>
                  <a:gd name="T49" fmla="*/ 77 h 767"/>
                  <a:gd name="T50" fmla="*/ 224 w 489"/>
                  <a:gd name="T51" fmla="*/ 0 h 767"/>
                  <a:gd name="T52" fmla="*/ 327 w 489"/>
                  <a:gd name="T53" fmla="*/ 24 h 767"/>
                  <a:gd name="T54" fmla="*/ 399 w 489"/>
                  <a:gd name="T55" fmla="*/ 96 h 767"/>
                  <a:gd name="T56" fmla="*/ 399 w 489"/>
                  <a:gd name="T57" fmla="*/ 13 h 767"/>
                  <a:gd name="T58" fmla="*/ 489 w 489"/>
                  <a:gd name="T59" fmla="*/ 13 h 767"/>
                  <a:gd name="T60" fmla="*/ 489 w 489"/>
                  <a:gd name="T61" fmla="*/ 492 h 7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489" h="767">
                    <a:moveTo>
                      <a:pt x="399" y="280"/>
                    </a:moveTo>
                    <a:cubicBezTo>
                      <a:pt x="399" y="216"/>
                      <a:pt x="385" y="165"/>
                      <a:pt x="359" y="129"/>
                    </a:cubicBezTo>
                    <a:cubicBezTo>
                      <a:pt x="332" y="93"/>
                      <a:pt x="294" y="75"/>
                      <a:pt x="246" y="75"/>
                    </a:cubicBezTo>
                    <a:cubicBezTo>
                      <a:pt x="198" y="75"/>
                      <a:pt x="160" y="93"/>
                      <a:pt x="133" y="129"/>
                    </a:cubicBezTo>
                    <a:cubicBezTo>
                      <a:pt x="106" y="165"/>
                      <a:pt x="93" y="216"/>
                      <a:pt x="93" y="280"/>
                    </a:cubicBezTo>
                    <a:cubicBezTo>
                      <a:pt x="93" y="345"/>
                      <a:pt x="106" y="395"/>
                      <a:pt x="133" y="431"/>
                    </a:cubicBezTo>
                    <a:cubicBezTo>
                      <a:pt x="160" y="467"/>
                      <a:pt x="198" y="485"/>
                      <a:pt x="246" y="485"/>
                    </a:cubicBezTo>
                    <a:cubicBezTo>
                      <a:pt x="294" y="485"/>
                      <a:pt x="332" y="467"/>
                      <a:pt x="359" y="431"/>
                    </a:cubicBezTo>
                    <a:cubicBezTo>
                      <a:pt x="385" y="395"/>
                      <a:pt x="399" y="345"/>
                      <a:pt x="399" y="280"/>
                    </a:cubicBezTo>
                    <a:close/>
                    <a:moveTo>
                      <a:pt x="489" y="492"/>
                    </a:moveTo>
                    <a:cubicBezTo>
                      <a:pt x="489" y="584"/>
                      <a:pt x="468" y="653"/>
                      <a:pt x="427" y="699"/>
                    </a:cubicBezTo>
                    <a:cubicBezTo>
                      <a:pt x="385" y="744"/>
                      <a:pt x="322" y="767"/>
                      <a:pt x="237" y="767"/>
                    </a:cubicBezTo>
                    <a:cubicBezTo>
                      <a:pt x="205" y="767"/>
                      <a:pt x="176" y="764"/>
                      <a:pt x="148" y="760"/>
                    </a:cubicBezTo>
                    <a:cubicBezTo>
                      <a:pt x="120" y="755"/>
                      <a:pt x="92" y="748"/>
                      <a:pt x="66" y="738"/>
                    </a:cubicBezTo>
                    <a:lnTo>
                      <a:pt x="66" y="651"/>
                    </a:lnTo>
                    <a:cubicBezTo>
                      <a:pt x="92" y="665"/>
                      <a:pt x="118" y="675"/>
                      <a:pt x="144" y="682"/>
                    </a:cubicBezTo>
                    <a:cubicBezTo>
                      <a:pt x="170" y="689"/>
                      <a:pt x="196" y="693"/>
                      <a:pt x="223" y="693"/>
                    </a:cubicBezTo>
                    <a:cubicBezTo>
                      <a:pt x="281" y="693"/>
                      <a:pt x="325" y="677"/>
                      <a:pt x="355" y="647"/>
                    </a:cubicBezTo>
                    <a:cubicBezTo>
                      <a:pt x="384" y="616"/>
                      <a:pt x="399" y="570"/>
                      <a:pt x="399" y="508"/>
                    </a:cubicBezTo>
                    <a:lnTo>
                      <a:pt x="399" y="464"/>
                    </a:lnTo>
                    <a:cubicBezTo>
                      <a:pt x="380" y="496"/>
                      <a:pt x="356" y="520"/>
                      <a:pt x="327" y="536"/>
                    </a:cubicBezTo>
                    <a:cubicBezTo>
                      <a:pt x="298" y="552"/>
                      <a:pt x="264" y="560"/>
                      <a:pt x="224" y="560"/>
                    </a:cubicBezTo>
                    <a:cubicBezTo>
                      <a:pt x="156" y="560"/>
                      <a:pt x="102" y="535"/>
                      <a:pt x="61" y="484"/>
                    </a:cubicBezTo>
                    <a:cubicBezTo>
                      <a:pt x="20" y="433"/>
                      <a:pt x="0" y="365"/>
                      <a:pt x="0" y="280"/>
                    </a:cubicBezTo>
                    <a:cubicBezTo>
                      <a:pt x="0" y="196"/>
                      <a:pt x="20" y="128"/>
                      <a:pt x="61" y="77"/>
                    </a:cubicBezTo>
                    <a:cubicBezTo>
                      <a:pt x="102" y="26"/>
                      <a:pt x="156" y="0"/>
                      <a:pt x="224" y="0"/>
                    </a:cubicBezTo>
                    <a:cubicBezTo>
                      <a:pt x="264" y="0"/>
                      <a:pt x="298" y="8"/>
                      <a:pt x="327" y="24"/>
                    </a:cubicBezTo>
                    <a:cubicBezTo>
                      <a:pt x="356" y="40"/>
                      <a:pt x="380" y="64"/>
                      <a:pt x="399" y="96"/>
                    </a:cubicBezTo>
                    <a:lnTo>
                      <a:pt x="399" y="13"/>
                    </a:lnTo>
                    <a:lnTo>
                      <a:pt x="489" y="13"/>
                    </a:lnTo>
                    <a:lnTo>
                      <a:pt x="489" y="492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0" name="Line 30">
                <a:extLst>
                  <a:ext uri="{FF2B5EF4-FFF2-40B4-BE49-F238E27FC236}">
                    <a16:creationId xmlns:a16="http://schemas.microsoft.com/office/drawing/2014/main" id="{536AB243-1DD9-1301-239B-B6116CF1A9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700830" y="3444625"/>
                <a:ext cx="816931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1" name="Freeform 31">
                <a:extLst>
                  <a:ext uri="{FF2B5EF4-FFF2-40B4-BE49-F238E27FC236}">
                    <a16:creationId xmlns:a16="http://schemas.microsoft.com/office/drawing/2014/main" id="{E9C44A33-3FDE-C46B-D607-B33478E3328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875886" y="3421964"/>
                <a:ext cx="27760" cy="47022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2" name="Freeform 32">
                <a:extLst>
                  <a:ext uri="{FF2B5EF4-FFF2-40B4-BE49-F238E27FC236}">
                    <a16:creationId xmlns:a16="http://schemas.microsoft.com/office/drawing/2014/main" id="{04C0F9E9-0D40-B132-6084-521AAE0B3EC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837929" y="3420831"/>
                <a:ext cx="32859" cy="48721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3" name="Freeform 33">
                <a:extLst>
                  <a:ext uri="{FF2B5EF4-FFF2-40B4-BE49-F238E27FC236}">
                    <a16:creationId xmlns:a16="http://schemas.microsoft.com/office/drawing/2014/main" id="{0C61DD64-9509-4D6D-7B90-E8AB9FCB176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757483" y="3411200"/>
                <a:ext cx="19262" cy="32859"/>
              </a:xfrm>
              <a:custGeom>
                <a:avLst/>
                <a:gdLst>
                  <a:gd name="T0" fmla="*/ 9 w 303"/>
                  <a:gd name="T1" fmla="*/ 452 h 510"/>
                  <a:gd name="T2" fmla="*/ 122 w 303"/>
                  <a:gd name="T3" fmla="*/ 452 h 510"/>
                  <a:gd name="T4" fmla="*/ 122 w 303"/>
                  <a:gd name="T5" fmla="*/ 63 h 510"/>
                  <a:gd name="T6" fmla="*/ 0 w 303"/>
                  <a:gd name="T7" fmla="*/ 87 h 510"/>
                  <a:gd name="T8" fmla="*/ 0 w 303"/>
                  <a:gd name="T9" fmla="*/ 24 h 510"/>
                  <a:gd name="T10" fmla="*/ 121 w 303"/>
                  <a:gd name="T11" fmla="*/ 0 h 510"/>
                  <a:gd name="T12" fmla="*/ 191 w 303"/>
                  <a:gd name="T13" fmla="*/ 0 h 510"/>
                  <a:gd name="T14" fmla="*/ 191 w 303"/>
                  <a:gd name="T15" fmla="*/ 452 h 510"/>
                  <a:gd name="T16" fmla="*/ 303 w 303"/>
                  <a:gd name="T17" fmla="*/ 452 h 510"/>
                  <a:gd name="T18" fmla="*/ 303 w 303"/>
                  <a:gd name="T19" fmla="*/ 510 h 510"/>
                  <a:gd name="T20" fmla="*/ 9 w 303"/>
                  <a:gd name="T21" fmla="*/ 510 h 510"/>
                  <a:gd name="T22" fmla="*/ 9 w 303"/>
                  <a:gd name="T23" fmla="*/ 452 h 5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03" h="510">
                    <a:moveTo>
                      <a:pt x="9" y="452"/>
                    </a:moveTo>
                    <a:lnTo>
                      <a:pt x="122" y="452"/>
                    </a:lnTo>
                    <a:lnTo>
                      <a:pt x="122" y="63"/>
                    </a:lnTo>
                    <a:lnTo>
                      <a:pt x="0" y="87"/>
                    </a:lnTo>
                    <a:lnTo>
                      <a:pt x="0" y="24"/>
                    </a:lnTo>
                    <a:lnTo>
                      <a:pt x="121" y="0"/>
                    </a:lnTo>
                    <a:lnTo>
                      <a:pt x="191" y="0"/>
                    </a:lnTo>
                    <a:lnTo>
                      <a:pt x="191" y="452"/>
                    </a:lnTo>
                    <a:lnTo>
                      <a:pt x="303" y="452"/>
                    </a:lnTo>
                    <a:lnTo>
                      <a:pt x="303" y="510"/>
                    </a:lnTo>
                    <a:lnTo>
                      <a:pt x="9" y="510"/>
                    </a:lnTo>
                    <a:lnTo>
                      <a:pt x="9" y="452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4" name="Rectangle 34">
                <a:extLst>
                  <a:ext uri="{FF2B5EF4-FFF2-40B4-BE49-F238E27FC236}">
                    <a16:creationId xmlns:a16="http://schemas.microsoft.com/office/drawing/2014/main" id="{2AAE303F-15F0-F993-FDBB-4BBA18D481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95440" y="3428196"/>
                <a:ext cx="28326" cy="3966"/>
              </a:xfrm>
              <a:prstGeom prst="rect">
                <a:avLst/>
              </a:prstGeom>
              <a:solidFill>
                <a:srgbClr val="26262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5" name="Line 35">
                <a:extLst>
                  <a:ext uri="{FF2B5EF4-FFF2-40B4-BE49-F238E27FC236}">
                    <a16:creationId xmlns:a16="http://schemas.microsoft.com/office/drawing/2014/main" id="{33EAC93C-B8AE-D72D-6CEB-75FBDF6BA2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700830" y="3085448"/>
                <a:ext cx="816931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6" name="Freeform 36">
                <a:extLst>
                  <a:ext uri="{FF2B5EF4-FFF2-40B4-BE49-F238E27FC236}">
                    <a16:creationId xmlns:a16="http://schemas.microsoft.com/office/drawing/2014/main" id="{B129D505-AF5E-FB09-06FF-736F28F8F4E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840196" y="3061087"/>
                <a:ext cx="27760" cy="47022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7" name="Freeform 37">
                <a:extLst>
                  <a:ext uri="{FF2B5EF4-FFF2-40B4-BE49-F238E27FC236}">
                    <a16:creationId xmlns:a16="http://schemas.microsoft.com/office/drawing/2014/main" id="{6855750D-FE94-A02E-35FD-2DC48E059A6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802238" y="3059954"/>
                <a:ext cx="32292" cy="48721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8" name="Freeform 38">
                <a:extLst>
                  <a:ext uri="{FF2B5EF4-FFF2-40B4-BE49-F238E27FC236}">
                    <a16:creationId xmlns:a16="http://schemas.microsoft.com/office/drawing/2014/main" id="{1712AAA3-970B-A9BF-8519-15C52A08979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762015" y="3049756"/>
                <a:ext cx="22661" cy="33992"/>
              </a:xfrm>
              <a:custGeom>
                <a:avLst/>
                <a:gdLst>
                  <a:gd name="T0" fmla="*/ 177 w 353"/>
                  <a:gd name="T1" fmla="*/ 55 h 529"/>
                  <a:gd name="T2" fmla="*/ 96 w 353"/>
                  <a:gd name="T3" fmla="*/ 107 h 529"/>
                  <a:gd name="T4" fmla="*/ 70 w 353"/>
                  <a:gd name="T5" fmla="*/ 265 h 529"/>
                  <a:gd name="T6" fmla="*/ 96 w 353"/>
                  <a:gd name="T7" fmla="*/ 422 h 529"/>
                  <a:gd name="T8" fmla="*/ 177 w 353"/>
                  <a:gd name="T9" fmla="*/ 475 h 529"/>
                  <a:gd name="T10" fmla="*/ 257 w 353"/>
                  <a:gd name="T11" fmla="*/ 422 h 529"/>
                  <a:gd name="T12" fmla="*/ 284 w 353"/>
                  <a:gd name="T13" fmla="*/ 265 h 529"/>
                  <a:gd name="T14" fmla="*/ 257 w 353"/>
                  <a:gd name="T15" fmla="*/ 107 h 529"/>
                  <a:gd name="T16" fmla="*/ 177 w 353"/>
                  <a:gd name="T17" fmla="*/ 55 h 529"/>
                  <a:gd name="T18" fmla="*/ 177 w 353"/>
                  <a:gd name="T19" fmla="*/ 0 h 529"/>
                  <a:gd name="T20" fmla="*/ 308 w 353"/>
                  <a:gd name="T21" fmla="*/ 68 h 529"/>
                  <a:gd name="T22" fmla="*/ 353 w 353"/>
                  <a:gd name="T23" fmla="*/ 265 h 529"/>
                  <a:gd name="T24" fmla="*/ 308 w 353"/>
                  <a:gd name="T25" fmla="*/ 461 h 529"/>
                  <a:gd name="T26" fmla="*/ 176 w 353"/>
                  <a:gd name="T27" fmla="*/ 529 h 529"/>
                  <a:gd name="T28" fmla="*/ 45 w 353"/>
                  <a:gd name="T29" fmla="*/ 461 h 529"/>
                  <a:gd name="T30" fmla="*/ 0 w 353"/>
                  <a:gd name="T31" fmla="*/ 265 h 529"/>
                  <a:gd name="T32" fmla="*/ 45 w 353"/>
                  <a:gd name="T33" fmla="*/ 68 h 529"/>
                  <a:gd name="T34" fmla="*/ 177 w 353"/>
                  <a:gd name="T35" fmla="*/ 0 h 5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353" h="529">
                    <a:moveTo>
                      <a:pt x="177" y="55"/>
                    </a:moveTo>
                    <a:cubicBezTo>
                      <a:pt x="141" y="55"/>
                      <a:pt x="114" y="72"/>
                      <a:pt x="96" y="107"/>
                    </a:cubicBezTo>
                    <a:cubicBezTo>
                      <a:pt x="78" y="142"/>
                      <a:pt x="70" y="195"/>
                      <a:pt x="70" y="265"/>
                    </a:cubicBezTo>
                    <a:cubicBezTo>
                      <a:pt x="70" y="335"/>
                      <a:pt x="78" y="387"/>
                      <a:pt x="96" y="422"/>
                    </a:cubicBezTo>
                    <a:cubicBezTo>
                      <a:pt x="114" y="457"/>
                      <a:pt x="141" y="475"/>
                      <a:pt x="177" y="475"/>
                    </a:cubicBezTo>
                    <a:cubicBezTo>
                      <a:pt x="212" y="475"/>
                      <a:pt x="239" y="457"/>
                      <a:pt x="257" y="422"/>
                    </a:cubicBezTo>
                    <a:cubicBezTo>
                      <a:pt x="275" y="387"/>
                      <a:pt x="284" y="335"/>
                      <a:pt x="284" y="265"/>
                    </a:cubicBezTo>
                    <a:cubicBezTo>
                      <a:pt x="284" y="195"/>
                      <a:pt x="275" y="142"/>
                      <a:pt x="257" y="107"/>
                    </a:cubicBezTo>
                    <a:cubicBezTo>
                      <a:pt x="239" y="72"/>
                      <a:pt x="212" y="55"/>
                      <a:pt x="177" y="55"/>
                    </a:cubicBezTo>
                    <a:close/>
                    <a:moveTo>
                      <a:pt x="177" y="0"/>
                    </a:moveTo>
                    <a:cubicBezTo>
                      <a:pt x="233" y="0"/>
                      <a:pt x="277" y="23"/>
                      <a:pt x="308" y="68"/>
                    </a:cubicBezTo>
                    <a:cubicBezTo>
                      <a:pt x="338" y="114"/>
                      <a:pt x="353" y="179"/>
                      <a:pt x="353" y="265"/>
                    </a:cubicBezTo>
                    <a:cubicBezTo>
                      <a:pt x="353" y="351"/>
                      <a:pt x="338" y="417"/>
                      <a:pt x="308" y="461"/>
                    </a:cubicBezTo>
                    <a:cubicBezTo>
                      <a:pt x="277" y="506"/>
                      <a:pt x="233" y="529"/>
                      <a:pt x="176" y="529"/>
                    </a:cubicBezTo>
                    <a:cubicBezTo>
                      <a:pt x="119" y="529"/>
                      <a:pt x="75" y="506"/>
                      <a:pt x="45" y="461"/>
                    </a:cubicBezTo>
                    <a:cubicBezTo>
                      <a:pt x="15" y="417"/>
                      <a:pt x="0" y="351"/>
                      <a:pt x="0" y="265"/>
                    </a:cubicBezTo>
                    <a:cubicBezTo>
                      <a:pt x="0" y="179"/>
                      <a:pt x="15" y="114"/>
                      <a:pt x="45" y="68"/>
                    </a:cubicBezTo>
                    <a:cubicBezTo>
                      <a:pt x="75" y="23"/>
                      <a:pt x="119" y="0"/>
                      <a:pt x="177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9" name="Line 39">
                <a:extLst>
                  <a:ext uri="{FF2B5EF4-FFF2-40B4-BE49-F238E27FC236}">
                    <a16:creationId xmlns:a16="http://schemas.microsoft.com/office/drawing/2014/main" id="{FED1C47B-19E6-523B-4B93-0CF7664292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700830" y="2707222"/>
                <a:ext cx="816931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0" name="Freeform 40">
                <a:extLst>
                  <a:ext uri="{FF2B5EF4-FFF2-40B4-BE49-F238E27FC236}">
                    <a16:creationId xmlns:a16="http://schemas.microsoft.com/office/drawing/2014/main" id="{1FCC9F58-AD09-945F-3FC8-2A4C8A92526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840196" y="2703609"/>
                <a:ext cx="27760" cy="47022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1" name="Freeform 41">
                <a:extLst>
                  <a:ext uri="{FF2B5EF4-FFF2-40B4-BE49-F238E27FC236}">
                    <a16:creationId xmlns:a16="http://schemas.microsoft.com/office/drawing/2014/main" id="{09B4D1FE-1F38-D5AF-4722-A39556D5D0E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802238" y="2702476"/>
                <a:ext cx="32292" cy="48721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2" name="Freeform 42">
                <a:extLst>
                  <a:ext uri="{FF2B5EF4-FFF2-40B4-BE49-F238E27FC236}">
                    <a16:creationId xmlns:a16="http://schemas.microsoft.com/office/drawing/2014/main" id="{C2A4D837-0F2C-D558-018D-BCA8AC9A46B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759749" y="2692845"/>
                <a:ext cx="19262" cy="32859"/>
              </a:xfrm>
              <a:custGeom>
                <a:avLst/>
                <a:gdLst>
                  <a:gd name="T0" fmla="*/ 10 w 304"/>
                  <a:gd name="T1" fmla="*/ 452 h 510"/>
                  <a:gd name="T2" fmla="*/ 123 w 304"/>
                  <a:gd name="T3" fmla="*/ 452 h 510"/>
                  <a:gd name="T4" fmla="*/ 123 w 304"/>
                  <a:gd name="T5" fmla="*/ 63 h 510"/>
                  <a:gd name="T6" fmla="*/ 0 w 304"/>
                  <a:gd name="T7" fmla="*/ 88 h 510"/>
                  <a:gd name="T8" fmla="*/ 0 w 304"/>
                  <a:gd name="T9" fmla="*/ 25 h 510"/>
                  <a:gd name="T10" fmla="*/ 122 w 304"/>
                  <a:gd name="T11" fmla="*/ 0 h 510"/>
                  <a:gd name="T12" fmla="*/ 191 w 304"/>
                  <a:gd name="T13" fmla="*/ 0 h 510"/>
                  <a:gd name="T14" fmla="*/ 191 w 304"/>
                  <a:gd name="T15" fmla="*/ 452 h 510"/>
                  <a:gd name="T16" fmla="*/ 304 w 304"/>
                  <a:gd name="T17" fmla="*/ 452 h 510"/>
                  <a:gd name="T18" fmla="*/ 304 w 304"/>
                  <a:gd name="T19" fmla="*/ 510 h 510"/>
                  <a:gd name="T20" fmla="*/ 10 w 304"/>
                  <a:gd name="T21" fmla="*/ 510 h 510"/>
                  <a:gd name="T22" fmla="*/ 10 w 304"/>
                  <a:gd name="T23" fmla="*/ 452 h 5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04" h="510">
                    <a:moveTo>
                      <a:pt x="10" y="452"/>
                    </a:moveTo>
                    <a:lnTo>
                      <a:pt x="123" y="452"/>
                    </a:lnTo>
                    <a:lnTo>
                      <a:pt x="123" y="63"/>
                    </a:lnTo>
                    <a:lnTo>
                      <a:pt x="0" y="88"/>
                    </a:lnTo>
                    <a:lnTo>
                      <a:pt x="0" y="25"/>
                    </a:lnTo>
                    <a:lnTo>
                      <a:pt x="122" y="0"/>
                    </a:lnTo>
                    <a:lnTo>
                      <a:pt x="191" y="0"/>
                    </a:lnTo>
                    <a:lnTo>
                      <a:pt x="191" y="452"/>
                    </a:lnTo>
                    <a:lnTo>
                      <a:pt x="304" y="452"/>
                    </a:lnTo>
                    <a:lnTo>
                      <a:pt x="304" y="510"/>
                    </a:lnTo>
                    <a:lnTo>
                      <a:pt x="10" y="510"/>
                    </a:lnTo>
                    <a:lnTo>
                      <a:pt x="10" y="452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3" name="Freeform 43">
                <a:extLst>
                  <a:ext uri="{FF2B5EF4-FFF2-40B4-BE49-F238E27FC236}">
                    <a16:creationId xmlns:a16="http://schemas.microsoft.com/office/drawing/2014/main" id="{DCCB8522-02DD-4C03-E1D3-C6882813B65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955767" y="3321689"/>
                <a:ext cx="46455" cy="39657"/>
              </a:xfrm>
              <a:custGeom>
                <a:avLst/>
                <a:gdLst>
                  <a:gd name="T0" fmla="*/ 0 w 729"/>
                  <a:gd name="T1" fmla="*/ 616 h 616"/>
                  <a:gd name="T2" fmla="*/ 0 w 729"/>
                  <a:gd name="T3" fmla="*/ 0 h 616"/>
                  <a:gd name="T4" fmla="*/ 83 w 729"/>
                  <a:gd name="T5" fmla="*/ 0 h 616"/>
                  <a:gd name="T6" fmla="*/ 83 w 729"/>
                  <a:gd name="T7" fmla="*/ 259 h 616"/>
                  <a:gd name="T8" fmla="*/ 729 w 729"/>
                  <a:gd name="T9" fmla="*/ 259 h 616"/>
                  <a:gd name="T10" fmla="*/ 729 w 729"/>
                  <a:gd name="T11" fmla="*/ 358 h 616"/>
                  <a:gd name="T12" fmla="*/ 83 w 729"/>
                  <a:gd name="T13" fmla="*/ 358 h 616"/>
                  <a:gd name="T14" fmla="*/ 83 w 729"/>
                  <a:gd name="T15" fmla="*/ 616 h 616"/>
                  <a:gd name="T16" fmla="*/ 0 w 729"/>
                  <a:gd name="T17" fmla="*/ 616 h 6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729" h="616">
                    <a:moveTo>
                      <a:pt x="0" y="616"/>
                    </a:moveTo>
                    <a:lnTo>
                      <a:pt x="0" y="0"/>
                    </a:lnTo>
                    <a:lnTo>
                      <a:pt x="83" y="0"/>
                    </a:lnTo>
                    <a:lnTo>
                      <a:pt x="83" y="259"/>
                    </a:lnTo>
                    <a:lnTo>
                      <a:pt x="729" y="259"/>
                    </a:lnTo>
                    <a:lnTo>
                      <a:pt x="729" y="358"/>
                    </a:lnTo>
                    <a:lnTo>
                      <a:pt x="83" y="358"/>
                    </a:lnTo>
                    <a:lnTo>
                      <a:pt x="83" y="616"/>
                    </a:lnTo>
                    <a:lnTo>
                      <a:pt x="0" y="61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4" name="Freeform 44">
                <a:extLst>
                  <a:ext uri="{FF2B5EF4-FFF2-40B4-BE49-F238E27FC236}">
                    <a16:creationId xmlns:a16="http://schemas.microsoft.com/office/drawing/2014/main" id="{57F59AFD-CF3F-E40B-3188-6F33D9C9D9B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958033" y="3312058"/>
                <a:ext cx="48721" cy="5665"/>
              </a:xfrm>
              <a:custGeom>
                <a:avLst/>
                <a:gdLst>
                  <a:gd name="T0" fmla="*/ 213 w 760"/>
                  <a:gd name="T1" fmla="*/ 90 h 90"/>
                  <a:gd name="T2" fmla="*/ 213 w 760"/>
                  <a:gd name="T3" fmla="*/ 0 h 90"/>
                  <a:gd name="T4" fmla="*/ 760 w 760"/>
                  <a:gd name="T5" fmla="*/ 0 h 90"/>
                  <a:gd name="T6" fmla="*/ 760 w 760"/>
                  <a:gd name="T7" fmla="*/ 90 h 90"/>
                  <a:gd name="T8" fmla="*/ 213 w 760"/>
                  <a:gd name="T9" fmla="*/ 90 h 90"/>
                  <a:gd name="T10" fmla="*/ 0 w 760"/>
                  <a:gd name="T11" fmla="*/ 90 h 90"/>
                  <a:gd name="T12" fmla="*/ 0 w 760"/>
                  <a:gd name="T13" fmla="*/ 0 h 90"/>
                  <a:gd name="T14" fmla="*/ 114 w 760"/>
                  <a:gd name="T15" fmla="*/ 0 h 90"/>
                  <a:gd name="T16" fmla="*/ 114 w 760"/>
                  <a:gd name="T17" fmla="*/ 90 h 90"/>
                  <a:gd name="T18" fmla="*/ 0 w 760"/>
                  <a:gd name="T19" fmla="*/ 9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760" h="90">
                    <a:moveTo>
                      <a:pt x="213" y="90"/>
                    </a:moveTo>
                    <a:lnTo>
                      <a:pt x="213" y="0"/>
                    </a:lnTo>
                    <a:lnTo>
                      <a:pt x="760" y="0"/>
                    </a:lnTo>
                    <a:lnTo>
                      <a:pt x="760" y="90"/>
                    </a:lnTo>
                    <a:lnTo>
                      <a:pt x="213" y="90"/>
                    </a:lnTo>
                    <a:close/>
                    <a:moveTo>
                      <a:pt x="0" y="90"/>
                    </a:moveTo>
                    <a:lnTo>
                      <a:pt x="0" y="0"/>
                    </a:lnTo>
                    <a:lnTo>
                      <a:pt x="114" y="0"/>
                    </a:lnTo>
                    <a:lnTo>
                      <a:pt x="114" y="90"/>
                    </a:lnTo>
                    <a:lnTo>
                      <a:pt x="0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5" name="Freeform 45">
                <a:extLst>
                  <a:ext uri="{FF2B5EF4-FFF2-40B4-BE49-F238E27FC236}">
                    <a16:creationId xmlns:a16="http://schemas.microsoft.com/office/drawing/2014/main" id="{70A9C642-9E2C-59A1-16BC-3CF94D55227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945003" y="3248607"/>
                <a:ext cx="35691" cy="51554"/>
              </a:xfrm>
              <a:custGeom>
                <a:avLst/>
                <a:gdLst>
                  <a:gd name="T0" fmla="*/ 118 w 560"/>
                  <a:gd name="T1" fmla="*/ 369 h 798"/>
                  <a:gd name="T2" fmla="*/ 29 w 560"/>
                  <a:gd name="T3" fmla="*/ 289 h 798"/>
                  <a:gd name="T4" fmla="*/ 0 w 560"/>
                  <a:gd name="T5" fmla="*/ 178 h 798"/>
                  <a:gd name="T6" fmla="*/ 60 w 560"/>
                  <a:gd name="T7" fmla="*/ 47 h 798"/>
                  <a:gd name="T8" fmla="*/ 230 w 560"/>
                  <a:gd name="T9" fmla="*/ 0 h 798"/>
                  <a:gd name="T10" fmla="*/ 560 w 560"/>
                  <a:gd name="T11" fmla="*/ 0 h 798"/>
                  <a:gd name="T12" fmla="*/ 560 w 560"/>
                  <a:gd name="T13" fmla="*/ 90 h 798"/>
                  <a:gd name="T14" fmla="*/ 233 w 560"/>
                  <a:gd name="T15" fmla="*/ 90 h 798"/>
                  <a:gd name="T16" fmla="*/ 116 w 560"/>
                  <a:gd name="T17" fmla="*/ 118 h 798"/>
                  <a:gd name="T18" fmla="*/ 78 w 560"/>
                  <a:gd name="T19" fmla="*/ 203 h 798"/>
                  <a:gd name="T20" fmla="*/ 125 w 560"/>
                  <a:gd name="T21" fmla="*/ 314 h 798"/>
                  <a:gd name="T22" fmla="*/ 251 w 560"/>
                  <a:gd name="T23" fmla="*/ 354 h 798"/>
                  <a:gd name="T24" fmla="*/ 560 w 560"/>
                  <a:gd name="T25" fmla="*/ 354 h 798"/>
                  <a:gd name="T26" fmla="*/ 560 w 560"/>
                  <a:gd name="T27" fmla="*/ 444 h 798"/>
                  <a:gd name="T28" fmla="*/ 233 w 560"/>
                  <a:gd name="T29" fmla="*/ 444 h 798"/>
                  <a:gd name="T30" fmla="*/ 116 w 560"/>
                  <a:gd name="T31" fmla="*/ 472 h 798"/>
                  <a:gd name="T32" fmla="*/ 78 w 560"/>
                  <a:gd name="T33" fmla="*/ 558 h 798"/>
                  <a:gd name="T34" fmla="*/ 125 w 560"/>
                  <a:gd name="T35" fmla="*/ 668 h 798"/>
                  <a:gd name="T36" fmla="*/ 251 w 560"/>
                  <a:gd name="T37" fmla="*/ 708 h 798"/>
                  <a:gd name="T38" fmla="*/ 560 w 560"/>
                  <a:gd name="T39" fmla="*/ 708 h 798"/>
                  <a:gd name="T40" fmla="*/ 560 w 560"/>
                  <a:gd name="T41" fmla="*/ 798 h 798"/>
                  <a:gd name="T42" fmla="*/ 13 w 560"/>
                  <a:gd name="T43" fmla="*/ 798 h 798"/>
                  <a:gd name="T44" fmla="*/ 13 w 560"/>
                  <a:gd name="T45" fmla="*/ 708 h 798"/>
                  <a:gd name="T46" fmla="*/ 98 w 560"/>
                  <a:gd name="T47" fmla="*/ 708 h 798"/>
                  <a:gd name="T48" fmla="*/ 24 w 560"/>
                  <a:gd name="T49" fmla="*/ 634 h 798"/>
                  <a:gd name="T50" fmla="*/ 0 w 560"/>
                  <a:gd name="T51" fmla="*/ 532 h 798"/>
                  <a:gd name="T52" fmla="*/ 30 w 560"/>
                  <a:gd name="T53" fmla="*/ 431 h 798"/>
                  <a:gd name="T54" fmla="*/ 118 w 560"/>
                  <a:gd name="T55" fmla="*/ 369 h 7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</a:cxnLst>
                <a:rect l="0" t="0" r="r" b="b"/>
                <a:pathLst>
                  <a:path w="560" h="798">
                    <a:moveTo>
                      <a:pt x="118" y="369"/>
                    </a:moveTo>
                    <a:cubicBezTo>
                      <a:pt x="78" y="347"/>
                      <a:pt x="49" y="320"/>
                      <a:pt x="29" y="289"/>
                    </a:cubicBezTo>
                    <a:cubicBezTo>
                      <a:pt x="10" y="258"/>
                      <a:pt x="0" y="221"/>
                      <a:pt x="0" y="178"/>
                    </a:cubicBezTo>
                    <a:cubicBezTo>
                      <a:pt x="0" y="122"/>
                      <a:pt x="20" y="78"/>
                      <a:pt x="60" y="47"/>
                    </a:cubicBezTo>
                    <a:cubicBezTo>
                      <a:pt x="100" y="16"/>
                      <a:pt x="157" y="0"/>
                      <a:pt x="230" y="0"/>
                    </a:cubicBezTo>
                    <a:lnTo>
                      <a:pt x="560" y="0"/>
                    </a:lnTo>
                    <a:lnTo>
                      <a:pt x="560" y="90"/>
                    </a:lnTo>
                    <a:lnTo>
                      <a:pt x="233" y="90"/>
                    </a:lnTo>
                    <a:cubicBezTo>
                      <a:pt x="181" y="90"/>
                      <a:pt x="142" y="100"/>
                      <a:pt x="116" y="118"/>
                    </a:cubicBezTo>
                    <a:cubicBezTo>
                      <a:pt x="91" y="137"/>
                      <a:pt x="78" y="165"/>
                      <a:pt x="78" y="203"/>
                    </a:cubicBezTo>
                    <a:cubicBezTo>
                      <a:pt x="78" y="250"/>
                      <a:pt x="94" y="287"/>
                      <a:pt x="125" y="314"/>
                    </a:cubicBezTo>
                    <a:cubicBezTo>
                      <a:pt x="156" y="341"/>
                      <a:pt x="198" y="354"/>
                      <a:pt x="251" y="354"/>
                    </a:cubicBezTo>
                    <a:lnTo>
                      <a:pt x="560" y="354"/>
                    </a:lnTo>
                    <a:lnTo>
                      <a:pt x="560" y="444"/>
                    </a:lnTo>
                    <a:lnTo>
                      <a:pt x="233" y="444"/>
                    </a:lnTo>
                    <a:cubicBezTo>
                      <a:pt x="181" y="444"/>
                      <a:pt x="142" y="454"/>
                      <a:pt x="116" y="472"/>
                    </a:cubicBezTo>
                    <a:cubicBezTo>
                      <a:pt x="91" y="491"/>
                      <a:pt x="78" y="520"/>
                      <a:pt x="78" y="558"/>
                    </a:cubicBezTo>
                    <a:cubicBezTo>
                      <a:pt x="78" y="604"/>
                      <a:pt x="94" y="641"/>
                      <a:pt x="125" y="668"/>
                    </a:cubicBezTo>
                    <a:cubicBezTo>
                      <a:pt x="156" y="695"/>
                      <a:pt x="198" y="708"/>
                      <a:pt x="251" y="708"/>
                    </a:cubicBezTo>
                    <a:lnTo>
                      <a:pt x="560" y="708"/>
                    </a:lnTo>
                    <a:lnTo>
                      <a:pt x="560" y="798"/>
                    </a:lnTo>
                    <a:lnTo>
                      <a:pt x="13" y="798"/>
                    </a:lnTo>
                    <a:lnTo>
                      <a:pt x="13" y="708"/>
                    </a:lnTo>
                    <a:lnTo>
                      <a:pt x="98" y="708"/>
                    </a:lnTo>
                    <a:cubicBezTo>
                      <a:pt x="65" y="688"/>
                      <a:pt x="40" y="663"/>
                      <a:pt x="24" y="634"/>
                    </a:cubicBezTo>
                    <a:cubicBezTo>
                      <a:pt x="8" y="606"/>
                      <a:pt x="0" y="572"/>
                      <a:pt x="0" y="532"/>
                    </a:cubicBezTo>
                    <a:cubicBezTo>
                      <a:pt x="0" y="492"/>
                      <a:pt x="10" y="459"/>
                      <a:pt x="30" y="431"/>
                    </a:cubicBezTo>
                    <a:cubicBezTo>
                      <a:pt x="50" y="403"/>
                      <a:pt x="80" y="383"/>
                      <a:pt x="118" y="36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6" name="Freeform 46">
                <a:extLst>
                  <a:ext uri="{FF2B5EF4-FFF2-40B4-BE49-F238E27FC236}">
                    <a16:creationId xmlns:a16="http://schemas.microsoft.com/office/drawing/2014/main" id="{24B8E1A4-8868-7753-0A9C-D37B6DDCF18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945003" y="3207251"/>
                <a:ext cx="36824" cy="32292"/>
              </a:xfrm>
              <a:custGeom>
                <a:avLst/>
                <a:gdLst>
                  <a:gd name="T0" fmla="*/ 264 w 573"/>
                  <a:gd name="T1" fmla="*/ 0 h 507"/>
                  <a:gd name="T2" fmla="*/ 308 w 573"/>
                  <a:gd name="T3" fmla="*/ 0 h 507"/>
                  <a:gd name="T4" fmla="*/ 308 w 573"/>
                  <a:gd name="T5" fmla="*/ 413 h 507"/>
                  <a:gd name="T6" fmla="*/ 450 w 573"/>
                  <a:gd name="T7" fmla="*/ 357 h 507"/>
                  <a:gd name="T8" fmla="*/ 498 w 573"/>
                  <a:gd name="T9" fmla="*/ 218 h 507"/>
                  <a:gd name="T10" fmla="*/ 486 w 573"/>
                  <a:gd name="T11" fmla="*/ 118 h 507"/>
                  <a:gd name="T12" fmla="*/ 447 w 573"/>
                  <a:gd name="T13" fmla="*/ 21 h 507"/>
                  <a:gd name="T14" fmla="*/ 532 w 573"/>
                  <a:gd name="T15" fmla="*/ 21 h 507"/>
                  <a:gd name="T16" fmla="*/ 563 w 573"/>
                  <a:gd name="T17" fmla="*/ 120 h 507"/>
                  <a:gd name="T18" fmla="*/ 573 w 573"/>
                  <a:gd name="T19" fmla="*/ 223 h 507"/>
                  <a:gd name="T20" fmla="*/ 498 w 573"/>
                  <a:gd name="T21" fmla="*/ 431 h 507"/>
                  <a:gd name="T22" fmla="*/ 292 w 573"/>
                  <a:gd name="T23" fmla="*/ 507 h 507"/>
                  <a:gd name="T24" fmla="*/ 79 w 573"/>
                  <a:gd name="T25" fmla="*/ 435 h 507"/>
                  <a:gd name="T26" fmla="*/ 0 w 573"/>
                  <a:gd name="T27" fmla="*/ 239 h 507"/>
                  <a:gd name="T28" fmla="*/ 71 w 573"/>
                  <a:gd name="T29" fmla="*/ 64 h 507"/>
                  <a:gd name="T30" fmla="*/ 264 w 573"/>
                  <a:gd name="T31" fmla="*/ 0 h 507"/>
                  <a:gd name="T32" fmla="*/ 238 w 573"/>
                  <a:gd name="T33" fmla="*/ 90 h 507"/>
                  <a:gd name="T34" fmla="*/ 120 w 573"/>
                  <a:gd name="T35" fmla="*/ 131 h 507"/>
                  <a:gd name="T36" fmla="*/ 76 w 573"/>
                  <a:gd name="T37" fmla="*/ 238 h 507"/>
                  <a:gd name="T38" fmla="*/ 119 w 573"/>
                  <a:gd name="T39" fmla="*/ 358 h 507"/>
                  <a:gd name="T40" fmla="*/ 238 w 573"/>
                  <a:gd name="T41" fmla="*/ 410 h 507"/>
                  <a:gd name="T42" fmla="*/ 238 w 573"/>
                  <a:gd name="T43" fmla="*/ 90 h 5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73" h="507">
                    <a:moveTo>
                      <a:pt x="264" y="0"/>
                    </a:moveTo>
                    <a:lnTo>
                      <a:pt x="308" y="0"/>
                    </a:lnTo>
                    <a:lnTo>
                      <a:pt x="308" y="413"/>
                    </a:lnTo>
                    <a:cubicBezTo>
                      <a:pt x="370" y="409"/>
                      <a:pt x="418" y="391"/>
                      <a:pt x="450" y="357"/>
                    </a:cubicBezTo>
                    <a:cubicBezTo>
                      <a:pt x="482" y="324"/>
                      <a:pt x="498" y="278"/>
                      <a:pt x="498" y="218"/>
                    </a:cubicBezTo>
                    <a:cubicBezTo>
                      <a:pt x="498" y="184"/>
                      <a:pt x="494" y="150"/>
                      <a:pt x="486" y="118"/>
                    </a:cubicBezTo>
                    <a:cubicBezTo>
                      <a:pt x="478" y="86"/>
                      <a:pt x="465" y="53"/>
                      <a:pt x="447" y="21"/>
                    </a:cubicBezTo>
                    <a:lnTo>
                      <a:pt x="532" y="21"/>
                    </a:lnTo>
                    <a:cubicBezTo>
                      <a:pt x="546" y="53"/>
                      <a:pt x="557" y="86"/>
                      <a:pt x="563" y="120"/>
                    </a:cubicBezTo>
                    <a:cubicBezTo>
                      <a:pt x="569" y="154"/>
                      <a:pt x="573" y="189"/>
                      <a:pt x="573" y="223"/>
                    </a:cubicBezTo>
                    <a:cubicBezTo>
                      <a:pt x="573" y="311"/>
                      <a:pt x="548" y="380"/>
                      <a:pt x="498" y="431"/>
                    </a:cubicBezTo>
                    <a:cubicBezTo>
                      <a:pt x="448" y="482"/>
                      <a:pt x="379" y="507"/>
                      <a:pt x="292" y="507"/>
                    </a:cubicBezTo>
                    <a:cubicBezTo>
                      <a:pt x="203" y="507"/>
                      <a:pt x="132" y="483"/>
                      <a:pt x="79" y="435"/>
                    </a:cubicBezTo>
                    <a:cubicBezTo>
                      <a:pt x="27" y="387"/>
                      <a:pt x="0" y="321"/>
                      <a:pt x="0" y="239"/>
                    </a:cubicBezTo>
                    <a:cubicBezTo>
                      <a:pt x="0" y="165"/>
                      <a:pt x="24" y="107"/>
                      <a:pt x="71" y="64"/>
                    </a:cubicBezTo>
                    <a:cubicBezTo>
                      <a:pt x="119" y="22"/>
                      <a:pt x="183" y="0"/>
                      <a:pt x="264" y="0"/>
                    </a:cubicBezTo>
                    <a:close/>
                    <a:moveTo>
                      <a:pt x="238" y="90"/>
                    </a:moveTo>
                    <a:cubicBezTo>
                      <a:pt x="189" y="91"/>
                      <a:pt x="150" y="105"/>
                      <a:pt x="120" y="131"/>
                    </a:cubicBezTo>
                    <a:cubicBezTo>
                      <a:pt x="91" y="158"/>
                      <a:pt x="76" y="194"/>
                      <a:pt x="76" y="238"/>
                    </a:cubicBezTo>
                    <a:cubicBezTo>
                      <a:pt x="76" y="288"/>
                      <a:pt x="91" y="328"/>
                      <a:pt x="119" y="358"/>
                    </a:cubicBezTo>
                    <a:cubicBezTo>
                      <a:pt x="147" y="388"/>
                      <a:pt x="187" y="406"/>
                      <a:pt x="238" y="410"/>
                    </a:cubicBezTo>
                    <a:lnTo>
                      <a:pt x="238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7" name="Freeform 47">
                <a:extLst>
                  <a:ext uri="{FF2B5EF4-FFF2-40B4-BE49-F238E27FC236}">
                    <a16:creationId xmlns:a16="http://schemas.microsoft.com/office/drawing/2014/main" id="{31DBB598-538E-B341-5813-9A27BF76C70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958033" y="3163062"/>
                <a:ext cx="57219" cy="14730"/>
              </a:xfrm>
              <a:custGeom>
                <a:avLst/>
                <a:gdLst>
                  <a:gd name="T0" fmla="*/ 0 w 890"/>
                  <a:gd name="T1" fmla="*/ 0 h 224"/>
                  <a:gd name="T2" fmla="*/ 223 w 890"/>
                  <a:gd name="T3" fmla="*/ 97 h 224"/>
                  <a:gd name="T4" fmla="*/ 445 w 890"/>
                  <a:gd name="T5" fmla="*/ 129 h 224"/>
                  <a:gd name="T6" fmla="*/ 668 w 890"/>
                  <a:gd name="T7" fmla="*/ 97 h 224"/>
                  <a:gd name="T8" fmla="*/ 890 w 890"/>
                  <a:gd name="T9" fmla="*/ 0 h 224"/>
                  <a:gd name="T10" fmla="*/ 890 w 890"/>
                  <a:gd name="T11" fmla="*/ 78 h 224"/>
                  <a:gd name="T12" fmla="*/ 665 w 890"/>
                  <a:gd name="T13" fmla="*/ 188 h 224"/>
                  <a:gd name="T14" fmla="*/ 445 w 890"/>
                  <a:gd name="T15" fmla="*/ 224 h 224"/>
                  <a:gd name="T16" fmla="*/ 226 w 890"/>
                  <a:gd name="T17" fmla="*/ 188 h 224"/>
                  <a:gd name="T18" fmla="*/ 0 w 890"/>
                  <a:gd name="T19" fmla="*/ 78 h 224"/>
                  <a:gd name="T20" fmla="*/ 0 w 890"/>
                  <a:gd name="T21" fmla="*/ 0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890" h="224">
                    <a:moveTo>
                      <a:pt x="0" y="0"/>
                    </a:moveTo>
                    <a:cubicBezTo>
                      <a:pt x="76" y="44"/>
                      <a:pt x="150" y="76"/>
                      <a:pt x="223" y="97"/>
                    </a:cubicBezTo>
                    <a:cubicBezTo>
                      <a:pt x="296" y="119"/>
                      <a:pt x="370" y="129"/>
                      <a:pt x="445" y="129"/>
                    </a:cubicBezTo>
                    <a:cubicBezTo>
                      <a:pt x="521" y="129"/>
                      <a:pt x="595" y="119"/>
                      <a:pt x="668" y="97"/>
                    </a:cubicBezTo>
                    <a:cubicBezTo>
                      <a:pt x="742" y="76"/>
                      <a:pt x="815" y="44"/>
                      <a:pt x="890" y="0"/>
                    </a:cubicBezTo>
                    <a:lnTo>
                      <a:pt x="890" y="78"/>
                    </a:lnTo>
                    <a:cubicBezTo>
                      <a:pt x="813" y="127"/>
                      <a:pt x="739" y="164"/>
                      <a:pt x="665" y="188"/>
                    </a:cubicBezTo>
                    <a:cubicBezTo>
                      <a:pt x="591" y="212"/>
                      <a:pt x="518" y="224"/>
                      <a:pt x="445" y="224"/>
                    </a:cubicBezTo>
                    <a:cubicBezTo>
                      <a:pt x="373" y="224"/>
                      <a:pt x="300" y="212"/>
                      <a:pt x="226" y="188"/>
                    </a:cubicBezTo>
                    <a:cubicBezTo>
                      <a:pt x="152" y="164"/>
                      <a:pt x="77" y="128"/>
                      <a:pt x="0" y="78"/>
                    </a:cubicBez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8" name="Freeform 48">
                <a:extLst>
                  <a:ext uri="{FF2B5EF4-FFF2-40B4-BE49-F238E27FC236}">
                    <a16:creationId xmlns:a16="http://schemas.microsoft.com/office/drawing/2014/main" id="{BEADD534-FCCC-C5D9-63E2-3DB3D30BAA0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945003" y="3127937"/>
                <a:ext cx="36824" cy="26627"/>
              </a:xfrm>
              <a:custGeom>
                <a:avLst/>
                <a:gdLst>
                  <a:gd name="T0" fmla="*/ 29 w 573"/>
                  <a:gd name="T1" fmla="*/ 29 h 418"/>
                  <a:gd name="T2" fmla="*/ 114 w 573"/>
                  <a:gd name="T3" fmla="*/ 29 h 418"/>
                  <a:gd name="T4" fmla="*/ 85 w 573"/>
                  <a:gd name="T5" fmla="*/ 108 h 418"/>
                  <a:gd name="T6" fmla="*/ 75 w 573"/>
                  <a:gd name="T7" fmla="*/ 193 h 418"/>
                  <a:gd name="T8" fmla="*/ 96 w 573"/>
                  <a:gd name="T9" fmla="*/ 294 h 418"/>
                  <a:gd name="T10" fmla="*/ 157 w 573"/>
                  <a:gd name="T11" fmla="*/ 327 h 418"/>
                  <a:gd name="T12" fmla="*/ 206 w 573"/>
                  <a:gd name="T13" fmla="*/ 303 h 418"/>
                  <a:gd name="T14" fmla="*/ 240 w 573"/>
                  <a:gd name="T15" fmla="*/ 207 h 418"/>
                  <a:gd name="T16" fmla="*/ 247 w 573"/>
                  <a:gd name="T17" fmla="*/ 176 h 418"/>
                  <a:gd name="T18" fmla="*/ 305 w 573"/>
                  <a:gd name="T19" fmla="*/ 40 h 418"/>
                  <a:gd name="T20" fmla="*/ 409 w 573"/>
                  <a:gd name="T21" fmla="*/ 0 h 418"/>
                  <a:gd name="T22" fmla="*/ 529 w 573"/>
                  <a:gd name="T23" fmla="*/ 60 h 418"/>
                  <a:gd name="T24" fmla="*/ 573 w 573"/>
                  <a:gd name="T25" fmla="*/ 226 h 418"/>
                  <a:gd name="T26" fmla="*/ 565 w 573"/>
                  <a:gd name="T27" fmla="*/ 318 h 418"/>
                  <a:gd name="T28" fmla="*/ 540 w 573"/>
                  <a:gd name="T29" fmla="*/ 418 h 418"/>
                  <a:gd name="T30" fmla="*/ 447 w 573"/>
                  <a:gd name="T31" fmla="*/ 418 h 418"/>
                  <a:gd name="T32" fmla="*/ 486 w 573"/>
                  <a:gd name="T33" fmla="*/ 320 h 418"/>
                  <a:gd name="T34" fmla="*/ 499 w 573"/>
                  <a:gd name="T35" fmla="*/ 224 h 418"/>
                  <a:gd name="T36" fmla="*/ 478 w 573"/>
                  <a:gd name="T37" fmla="*/ 126 h 418"/>
                  <a:gd name="T38" fmla="*/ 416 w 573"/>
                  <a:gd name="T39" fmla="*/ 92 h 418"/>
                  <a:gd name="T40" fmla="*/ 360 w 573"/>
                  <a:gd name="T41" fmla="*/ 117 h 418"/>
                  <a:gd name="T42" fmla="*/ 322 w 573"/>
                  <a:gd name="T43" fmla="*/ 225 h 418"/>
                  <a:gd name="T44" fmla="*/ 315 w 573"/>
                  <a:gd name="T45" fmla="*/ 256 h 418"/>
                  <a:gd name="T46" fmla="*/ 261 w 573"/>
                  <a:gd name="T47" fmla="*/ 377 h 418"/>
                  <a:gd name="T48" fmla="*/ 161 w 573"/>
                  <a:gd name="T49" fmla="*/ 414 h 418"/>
                  <a:gd name="T50" fmla="*/ 42 w 573"/>
                  <a:gd name="T51" fmla="*/ 360 h 418"/>
                  <a:gd name="T52" fmla="*/ 0 w 573"/>
                  <a:gd name="T53" fmla="*/ 204 h 418"/>
                  <a:gd name="T54" fmla="*/ 8 w 573"/>
                  <a:gd name="T55" fmla="*/ 110 h 418"/>
                  <a:gd name="T56" fmla="*/ 29 w 573"/>
                  <a:gd name="T57" fmla="*/ 29 h 4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573" h="418">
                    <a:moveTo>
                      <a:pt x="29" y="29"/>
                    </a:moveTo>
                    <a:lnTo>
                      <a:pt x="114" y="29"/>
                    </a:lnTo>
                    <a:cubicBezTo>
                      <a:pt x="102" y="55"/>
                      <a:pt x="92" y="81"/>
                      <a:pt x="85" y="108"/>
                    </a:cubicBezTo>
                    <a:cubicBezTo>
                      <a:pt x="79" y="136"/>
                      <a:pt x="75" y="164"/>
                      <a:pt x="75" y="193"/>
                    </a:cubicBezTo>
                    <a:cubicBezTo>
                      <a:pt x="75" y="238"/>
                      <a:pt x="82" y="272"/>
                      <a:pt x="96" y="294"/>
                    </a:cubicBezTo>
                    <a:cubicBezTo>
                      <a:pt x="110" y="316"/>
                      <a:pt x="130" y="327"/>
                      <a:pt x="157" y="327"/>
                    </a:cubicBezTo>
                    <a:cubicBezTo>
                      <a:pt x="178" y="327"/>
                      <a:pt x="194" y="319"/>
                      <a:pt x="206" y="303"/>
                    </a:cubicBezTo>
                    <a:cubicBezTo>
                      <a:pt x="218" y="287"/>
                      <a:pt x="230" y="255"/>
                      <a:pt x="240" y="207"/>
                    </a:cubicBezTo>
                    <a:lnTo>
                      <a:pt x="247" y="176"/>
                    </a:lnTo>
                    <a:cubicBezTo>
                      <a:pt x="261" y="112"/>
                      <a:pt x="281" y="67"/>
                      <a:pt x="305" y="40"/>
                    </a:cubicBezTo>
                    <a:cubicBezTo>
                      <a:pt x="330" y="14"/>
                      <a:pt x="365" y="0"/>
                      <a:pt x="409" y="0"/>
                    </a:cubicBezTo>
                    <a:cubicBezTo>
                      <a:pt x="460" y="0"/>
                      <a:pt x="500" y="20"/>
                      <a:pt x="529" y="60"/>
                    </a:cubicBezTo>
                    <a:cubicBezTo>
                      <a:pt x="559" y="100"/>
                      <a:pt x="573" y="156"/>
                      <a:pt x="573" y="226"/>
                    </a:cubicBezTo>
                    <a:cubicBezTo>
                      <a:pt x="573" y="256"/>
                      <a:pt x="570" y="286"/>
                      <a:pt x="565" y="318"/>
                    </a:cubicBezTo>
                    <a:cubicBezTo>
                      <a:pt x="560" y="350"/>
                      <a:pt x="552" y="383"/>
                      <a:pt x="540" y="418"/>
                    </a:cubicBezTo>
                    <a:lnTo>
                      <a:pt x="447" y="418"/>
                    </a:lnTo>
                    <a:cubicBezTo>
                      <a:pt x="465" y="385"/>
                      <a:pt x="478" y="352"/>
                      <a:pt x="486" y="320"/>
                    </a:cubicBezTo>
                    <a:cubicBezTo>
                      <a:pt x="495" y="288"/>
                      <a:pt x="499" y="256"/>
                      <a:pt x="499" y="224"/>
                    </a:cubicBezTo>
                    <a:cubicBezTo>
                      <a:pt x="499" y="182"/>
                      <a:pt x="492" y="149"/>
                      <a:pt x="478" y="126"/>
                    </a:cubicBezTo>
                    <a:cubicBezTo>
                      <a:pt x="464" y="104"/>
                      <a:pt x="443" y="92"/>
                      <a:pt x="416" y="92"/>
                    </a:cubicBezTo>
                    <a:cubicBezTo>
                      <a:pt x="392" y="92"/>
                      <a:pt x="373" y="101"/>
                      <a:pt x="360" y="117"/>
                    </a:cubicBezTo>
                    <a:cubicBezTo>
                      <a:pt x="347" y="133"/>
                      <a:pt x="334" y="169"/>
                      <a:pt x="322" y="225"/>
                    </a:cubicBezTo>
                    <a:lnTo>
                      <a:pt x="315" y="256"/>
                    </a:lnTo>
                    <a:cubicBezTo>
                      <a:pt x="303" y="312"/>
                      <a:pt x="285" y="353"/>
                      <a:pt x="261" y="377"/>
                    </a:cubicBezTo>
                    <a:cubicBezTo>
                      <a:pt x="237" y="402"/>
                      <a:pt x="204" y="414"/>
                      <a:pt x="161" y="414"/>
                    </a:cubicBezTo>
                    <a:cubicBezTo>
                      <a:pt x="110" y="414"/>
                      <a:pt x="70" y="396"/>
                      <a:pt x="42" y="360"/>
                    </a:cubicBezTo>
                    <a:cubicBezTo>
                      <a:pt x="14" y="324"/>
                      <a:pt x="0" y="272"/>
                      <a:pt x="0" y="204"/>
                    </a:cubicBezTo>
                    <a:cubicBezTo>
                      <a:pt x="0" y="171"/>
                      <a:pt x="3" y="140"/>
                      <a:pt x="8" y="110"/>
                    </a:cubicBezTo>
                    <a:cubicBezTo>
                      <a:pt x="13" y="81"/>
                      <a:pt x="20" y="54"/>
                      <a:pt x="29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9" name="Freeform 49">
                <a:extLst>
                  <a:ext uri="{FF2B5EF4-FFF2-40B4-BE49-F238E27FC236}">
                    <a16:creationId xmlns:a16="http://schemas.microsoft.com/office/drawing/2014/main" id="{B6726306-5F2D-04A4-D2D5-FA7454B31F8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945003" y="3088280"/>
                <a:ext cx="36824" cy="32859"/>
              </a:xfrm>
              <a:custGeom>
                <a:avLst/>
                <a:gdLst>
                  <a:gd name="T0" fmla="*/ 264 w 573"/>
                  <a:gd name="T1" fmla="*/ 0 h 507"/>
                  <a:gd name="T2" fmla="*/ 308 w 573"/>
                  <a:gd name="T3" fmla="*/ 0 h 507"/>
                  <a:gd name="T4" fmla="*/ 308 w 573"/>
                  <a:gd name="T5" fmla="*/ 413 h 507"/>
                  <a:gd name="T6" fmla="*/ 450 w 573"/>
                  <a:gd name="T7" fmla="*/ 357 h 507"/>
                  <a:gd name="T8" fmla="*/ 498 w 573"/>
                  <a:gd name="T9" fmla="*/ 218 h 507"/>
                  <a:gd name="T10" fmla="*/ 486 w 573"/>
                  <a:gd name="T11" fmla="*/ 118 h 507"/>
                  <a:gd name="T12" fmla="*/ 447 w 573"/>
                  <a:gd name="T13" fmla="*/ 21 h 507"/>
                  <a:gd name="T14" fmla="*/ 532 w 573"/>
                  <a:gd name="T15" fmla="*/ 21 h 507"/>
                  <a:gd name="T16" fmla="*/ 563 w 573"/>
                  <a:gd name="T17" fmla="*/ 120 h 507"/>
                  <a:gd name="T18" fmla="*/ 573 w 573"/>
                  <a:gd name="T19" fmla="*/ 223 h 507"/>
                  <a:gd name="T20" fmla="*/ 498 w 573"/>
                  <a:gd name="T21" fmla="*/ 431 h 507"/>
                  <a:gd name="T22" fmla="*/ 292 w 573"/>
                  <a:gd name="T23" fmla="*/ 507 h 507"/>
                  <a:gd name="T24" fmla="*/ 79 w 573"/>
                  <a:gd name="T25" fmla="*/ 435 h 507"/>
                  <a:gd name="T26" fmla="*/ 0 w 573"/>
                  <a:gd name="T27" fmla="*/ 239 h 507"/>
                  <a:gd name="T28" fmla="*/ 71 w 573"/>
                  <a:gd name="T29" fmla="*/ 64 h 507"/>
                  <a:gd name="T30" fmla="*/ 264 w 573"/>
                  <a:gd name="T31" fmla="*/ 0 h 507"/>
                  <a:gd name="T32" fmla="*/ 238 w 573"/>
                  <a:gd name="T33" fmla="*/ 90 h 507"/>
                  <a:gd name="T34" fmla="*/ 120 w 573"/>
                  <a:gd name="T35" fmla="*/ 131 h 507"/>
                  <a:gd name="T36" fmla="*/ 76 w 573"/>
                  <a:gd name="T37" fmla="*/ 238 h 507"/>
                  <a:gd name="T38" fmla="*/ 119 w 573"/>
                  <a:gd name="T39" fmla="*/ 358 h 507"/>
                  <a:gd name="T40" fmla="*/ 238 w 573"/>
                  <a:gd name="T41" fmla="*/ 410 h 507"/>
                  <a:gd name="T42" fmla="*/ 238 w 573"/>
                  <a:gd name="T43" fmla="*/ 90 h 5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73" h="507">
                    <a:moveTo>
                      <a:pt x="264" y="0"/>
                    </a:moveTo>
                    <a:lnTo>
                      <a:pt x="308" y="0"/>
                    </a:lnTo>
                    <a:lnTo>
                      <a:pt x="308" y="413"/>
                    </a:lnTo>
                    <a:cubicBezTo>
                      <a:pt x="370" y="409"/>
                      <a:pt x="418" y="391"/>
                      <a:pt x="450" y="357"/>
                    </a:cubicBezTo>
                    <a:cubicBezTo>
                      <a:pt x="482" y="324"/>
                      <a:pt x="498" y="278"/>
                      <a:pt x="498" y="218"/>
                    </a:cubicBezTo>
                    <a:cubicBezTo>
                      <a:pt x="498" y="184"/>
                      <a:pt x="494" y="150"/>
                      <a:pt x="486" y="118"/>
                    </a:cubicBezTo>
                    <a:cubicBezTo>
                      <a:pt x="478" y="86"/>
                      <a:pt x="465" y="53"/>
                      <a:pt x="447" y="21"/>
                    </a:cubicBezTo>
                    <a:lnTo>
                      <a:pt x="532" y="21"/>
                    </a:lnTo>
                    <a:cubicBezTo>
                      <a:pt x="546" y="53"/>
                      <a:pt x="557" y="86"/>
                      <a:pt x="563" y="120"/>
                    </a:cubicBezTo>
                    <a:cubicBezTo>
                      <a:pt x="569" y="154"/>
                      <a:pt x="573" y="189"/>
                      <a:pt x="573" y="223"/>
                    </a:cubicBezTo>
                    <a:cubicBezTo>
                      <a:pt x="573" y="311"/>
                      <a:pt x="548" y="380"/>
                      <a:pt x="498" y="431"/>
                    </a:cubicBezTo>
                    <a:cubicBezTo>
                      <a:pt x="448" y="482"/>
                      <a:pt x="379" y="507"/>
                      <a:pt x="292" y="507"/>
                    </a:cubicBezTo>
                    <a:cubicBezTo>
                      <a:pt x="203" y="507"/>
                      <a:pt x="132" y="483"/>
                      <a:pt x="79" y="435"/>
                    </a:cubicBezTo>
                    <a:cubicBezTo>
                      <a:pt x="27" y="387"/>
                      <a:pt x="0" y="321"/>
                      <a:pt x="0" y="239"/>
                    </a:cubicBezTo>
                    <a:cubicBezTo>
                      <a:pt x="0" y="165"/>
                      <a:pt x="24" y="107"/>
                      <a:pt x="71" y="64"/>
                    </a:cubicBezTo>
                    <a:cubicBezTo>
                      <a:pt x="119" y="22"/>
                      <a:pt x="183" y="0"/>
                      <a:pt x="264" y="0"/>
                    </a:cubicBezTo>
                    <a:close/>
                    <a:moveTo>
                      <a:pt x="238" y="90"/>
                    </a:moveTo>
                    <a:cubicBezTo>
                      <a:pt x="189" y="91"/>
                      <a:pt x="150" y="105"/>
                      <a:pt x="120" y="131"/>
                    </a:cubicBezTo>
                    <a:cubicBezTo>
                      <a:pt x="91" y="158"/>
                      <a:pt x="76" y="194"/>
                      <a:pt x="76" y="238"/>
                    </a:cubicBezTo>
                    <a:cubicBezTo>
                      <a:pt x="76" y="288"/>
                      <a:pt x="91" y="328"/>
                      <a:pt x="119" y="358"/>
                    </a:cubicBezTo>
                    <a:cubicBezTo>
                      <a:pt x="147" y="388"/>
                      <a:pt x="187" y="406"/>
                      <a:pt x="238" y="410"/>
                    </a:cubicBezTo>
                    <a:lnTo>
                      <a:pt x="238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0" name="Freeform 50">
                <a:extLst>
                  <a:ext uri="{FF2B5EF4-FFF2-40B4-BE49-F238E27FC236}">
                    <a16:creationId xmlns:a16="http://schemas.microsoft.com/office/drawing/2014/main" id="{C9A957F5-BD36-A2DA-5BBD-9500BE5FAE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945003" y="3053722"/>
                <a:ext cx="36824" cy="27760"/>
              </a:xfrm>
              <a:custGeom>
                <a:avLst/>
                <a:gdLst>
                  <a:gd name="T0" fmla="*/ 34 w 573"/>
                  <a:gd name="T1" fmla="*/ 0 h 433"/>
                  <a:gd name="T2" fmla="*/ 118 w 573"/>
                  <a:gd name="T3" fmla="*/ 0 h 433"/>
                  <a:gd name="T4" fmla="*/ 87 w 573"/>
                  <a:gd name="T5" fmla="*/ 77 h 433"/>
                  <a:gd name="T6" fmla="*/ 76 w 573"/>
                  <a:gd name="T7" fmla="*/ 154 h 433"/>
                  <a:gd name="T8" fmla="*/ 132 w 573"/>
                  <a:gd name="T9" fmla="*/ 290 h 433"/>
                  <a:gd name="T10" fmla="*/ 287 w 573"/>
                  <a:gd name="T11" fmla="*/ 338 h 433"/>
                  <a:gd name="T12" fmla="*/ 443 w 573"/>
                  <a:gd name="T13" fmla="*/ 290 h 433"/>
                  <a:gd name="T14" fmla="*/ 498 w 573"/>
                  <a:gd name="T15" fmla="*/ 154 h 433"/>
                  <a:gd name="T16" fmla="*/ 488 w 573"/>
                  <a:gd name="T17" fmla="*/ 77 h 433"/>
                  <a:gd name="T18" fmla="*/ 456 w 573"/>
                  <a:gd name="T19" fmla="*/ 0 h 433"/>
                  <a:gd name="T20" fmla="*/ 539 w 573"/>
                  <a:gd name="T21" fmla="*/ 0 h 433"/>
                  <a:gd name="T22" fmla="*/ 565 w 573"/>
                  <a:gd name="T23" fmla="*/ 78 h 433"/>
                  <a:gd name="T24" fmla="*/ 573 w 573"/>
                  <a:gd name="T25" fmla="*/ 164 h 433"/>
                  <a:gd name="T26" fmla="*/ 496 w 573"/>
                  <a:gd name="T27" fmla="*/ 360 h 433"/>
                  <a:gd name="T28" fmla="*/ 287 w 573"/>
                  <a:gd name="T29" fmla="*/ 433 h 433"/>
                  <a:gd name="T30" fmla="*/ 77 w 573"/>
                  <a:gd name="T31" fmla="*/ 360 h 433"/>
                  <a:gd name="T32" fmla="*/ 0 w 573"/>
                  <a:gd name="T33" fmla="*/ 158 h 433"/>
                  <a:gd name="T34" fmla="*/ 9 w 573"/>
                  <a:gd name="T35" fmla="*/ 77 h 433"/>
                  <a:gd name="T36" fmla="*/ 34 w 573"/>
                  <a:gd name="T37" fmla="*/ 0 h 4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573" h="433">
                    <a:moveTo>
                      <a:pt x="34" y="0"/>
                    </a:moveTo>
                    <a:lnTo>
                      <a:pt x="118" y="0"/>
                    </a:lnTo>
                    <a:cubicBezTo>
                      <a:pt x="104" y="26"/>
                      <a:pt x="94" y="51"/>
                      <a:pt x="87" y="77"/>
                    </a:cubicBezTo>
                    <a:cubicBezTo>
                      <a:pt x="80" y="103"/>
                      <a:pt x="76" y="128"/>
                      <a:pt x="76" y="154"/>
                    </a:cubicBezTo>
                    <a:cubicBezTo>
                      <a:pt x="76" y="212"/>
                      <a:pt x="95" y="258"/>
                      <a:pt x="132" y="290"/>
                    </a:cubicBezTo>
                    <a:cubicBezTo>
                      <a:pt x="169" y="322"/>
                      <a:pt x="221" y="338"/>
                      <a:pt x="287" y="338"/>
                    </a:cubicBezTo>
                    <a:cubicBezTo>
                      <a:pt x="354" y="338"/>
                      <a:pt x="406" y="322"/>
                      <a:pt x="443" y="290"/>
                    </a:cubicBezTo>
                    <a:cubicBezTo>
                      <a:pt x="480" y="258"/>
                      <a:pt x="498" y="212"/>
                      <a:pt x="498" y="154"/>
                    </a:cubicBezTo>
                    <a:cubicBezTo>
                      <a:pt x="498" y="128"/>
                      <a:pt x="495" y="103"/>
                      <a:pt x="488" y="77"/>
                    </a:cubicBezTo>
                    <a:cubicBezTo>
                      <a:pt x="481" y="51"/>
                      <a:pt x="470" y="26"/>
                      <a:pt x="456" y="0"/>
                    </a:cubicBezTo>
                    <a:lnTo>
                      <a:pt x="539" y="0"/>
                    </a:lnTo>
                    <a:cubicBezTo>
                      <a:pt x="551" y="26"/>
                      <a:pt x="560" y="52"/>
                      <a:pt x="565" y="78"/>
                    </a:cubicBezTo>
                    <a:cubicBezTo>
                      <a:pt x="570" y="105"/>
                      <a:pt x="573" y="134"/>
                      <a:pt x="573" y="164"/>
                    </a:cubicBezTo>
                    <a:cubicBezTo>
                      <a:pt x="573" y="246"/>
                      <a:pt x="548" y="312"/>
                      <a:pt x="496" y="360"/>
                    </a:cubicBezTo>
                    <a:cubicBezTo>
                      <a:pt x="445" y="409"/>
                      <a:pt x="375" y="433"/>
                      <a:pt x="287" y="433"/>
                    </a:cubicBezTo>
                    <a:cubicBezTo>
                      <a:pt x="198" y="433"/>
                      <a:pt x="128" y="409"/>
                      <a:pt x="77" y="360"/>
                    </a:cubicBezTo>
                    <a:cubicBezTo>
                      <a:pt x="26" y="311"/>
                      <a:pt x="0" y="244"/>
                      <a:pt x="0" y="158"/>
                    </a:cubicBezTo>
                    <a:cubicBezTo>
                      <a:pt x="0" y="130"/>
                      <a:pt x="3" y="103"/>
                      <a:pt x="9" y="77"/>
                    </a:cubicBezTo>
                    <a:cubicBezTo>
                      <a:pt x="15" y="51"/>
                      <a:pt x="23" y="25"/>
                      <a:pt x="34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1" name="Freeform 51">
                <a:extLst>
                  <a:ext uri="{FF2B5EF4-FFF2-40B4-BE49-F238E27FC236}">
                    <a16:creationId xmlns:a16="http://schemas.microsoft.com/office/drawing/2014/main" id="{175DB331-DA43-2E17-8F7C-6DF09E93316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958033" y="3029928"/>
                <a:ext cx="57219" cy="14730"/>
              </a:xfrm>
              <a:custGeom>
                <a:avLst/>
                <a:gdLst>
                  <a:gd name="T0" fmla="*/ 0 w 890"/>
                  <a:gd name="T1" fmla="*/ 224 h 224"/>
                  <a:gd name="T2" fmla="*/ 0 w 890"/>
                  <a:gd name="T3" fmla="*/ 146 h 224"/>
                  <a:gd name="T4" fmla="*/ 226 w 890"/>
                  <a:gd name="T5" fmla="*/ 37 h 224"/>
                  <a:gd name="T6" fmla="*/ 445 w 890"/>
                  <a:gd name="T7" fmla="*/ 0 h 224"/>
                  <a:gd name="T8" fmla="*/ 665 w 890"/>
                  <a:gd name="T9" fmla="*/ 37 h 224"/>
                  <a:gd name="T10" fmla="*/ 890 w 890"/>
                  <a:gd name="T11" fmla="*/ 146 h 224"/>
                  <a:gd name="T12" fmla="*/ 890 w 890"/>
                  <a:gd name="T13" fmla="*/ 224 h 224"/>
                  <a:gd name="T14" fmla="*/ 668 w 890"/>
                  <a:gd name="T15" fmla="*/ 127 h 224"/>
                  <a:gd name="T16" fmla="*/ 445 w 890"/>
                  <a:gd name="T17" fmla="*/ 95 h 224"/>
                  <a:gd name="T18" fmla="*/ 223 w 890"/>
                  <a:gd name="T19" fmla="*/ 127 h 224"/>
                  <a:gd name="T20" fmla="*/ 0 w 890"/>
                  <a:gd name="T21" fmla="*/ 224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890" h="224">
                    <a:moveTo>
                      <a:pt x="0" y="224"/>
                    </a:moveTo>
                    <a:lnTo>
                      <a:pt x="0" y="146"/>
                    </a:lnTo>
                    <a:cubicBezTo>
                      <a:pt x="77" y="98"/>
                      <a:pt x="152" y="61"/>
                      <a:pt x="226" y="37"/>
                    </a:cubicBezTo>
                    <a:cubicBezTo>
                      <a:pt x="300" y="13"/>
                      <a:pt x="373" y="0"/>
                      <a:pt x="445" y="0"/>
                    </a:cubicBezTo>
                    <a:cubicBezTo>
                      <a:pt x="518" y="0"/>
                      <a:pt x="591" y="13"/>
                      <a:pt x="665" y="37"/>
                    </a:cubicBezTo>
                    <a:cubicBezTo>
                      <a:pt x="739" y="61"/>
                      <a:pt x="813" y="98"/>
                      <a:pt x="890" y="146"/>
                    </a:cubicBezTo>
                    <a:lnTo>
                      <a:pt x="890" y="224"/>
                    </a:lnTo>
                    <a:cubicBezTo>
                      <a:pt x="815" y="181"/>
                      <a:pt x="742" y="149"/>
                      <a:pt x="668" y="127"/>
                    </a:cubicBezTo>
                    <a:cubicBezTo>
                      <a:pt x="595" y="106"/>
                      <a:pt x="521" y="95"/>
                      <a:pt x="445" y="95"/>
                    </a:cubicBezTo>
                    <a:cubicBezTo>
                      <a:pt x="370" y="95"/>
                      <a:pt x="296" y="106"/>
                      <a:pt x="223" y="127"/>
                    </a:cubicBezTo>
                    <a:cubicBezTo>
                      <a:pt x="150" y="149"/>
                      <a:pt x="76" y="181"/>
                      <a:pt x="0" y="224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2" name="Rectangle 52">
                <a:extLst>
                  <a:ext uri="{FF2B5EF4-FFF2-40B4-BE49-F238E27FC236}">
                    <a16:creationId xmlns:a16="http://schemas.microsoft.com/office/drawing/2014/main" id="{6CABCD2F-9C70-82C1-3FAF-30703A1901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60040" y="3273534"/>
                <a:ext cx="163160" cy="402799"/>
              </a:xfrm>
              <a:prstGeom prst="rect">
                <a:avLst/>
              </a:prstGeom>
              <a:solidFill>
                <a:srgbClr val="71AEC0"/>
              </a:solidFill>
              <a:ln w="17463" cap="flat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17463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3" name="Rectangle 53">
                <a:extLst>
                  <a:ext uri="{FF2B5EF4-FFF2-40B4-BE49-F238E27FC236}">
                    <a16:creationId xmlns:a16="http://schemas.microsoft.com/office/drawing/2014/main" id="{97185DD5-4252-8324-7D34-EBDBB57246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60040" y="3274384"/>
                <a:ext cx="163160" cy="403402"/>
              </a:xfrm>
              <a:prstGeom prst="rect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4" name="Rectangle 54">
                <a:extLst>
                  <a:ext uri="{FF2B5EF4-FFF2-40B4-BE49-F238E27FC236}">
                    <a16:creationId xmlns:a16="http://schemas.microsoft.com/office/drawing/2014/main" id="{B8C32599-846B-8973-8706-37314A2557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1574" y="2754597"/>
                <a:ext cx="163726" cy="921135"/>
              </a:xfrm>
              <a:prstGeom prst="rect">
                <a:avLst/>
              </a:prstGeom>
              <a:solidFill>
                <a:srgbClr val="71AEC0"/>
              </a:solidFill>
              <a:ln w="17463" cap="flat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17463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255" name="Rectangle 55">
                <a:extLst>
                  <a:ext uri="{FF2B5EF4-FFF2-40B4-BE49-F238E27FC236}">
                    <a16:creationId xmlns:a16="http://schemas.microsoft.com/office/drawing/2014/main" id="{112D228E-2EB6-2142-3A9B-4F039CBE1A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1574" y="2755446"/>
                <a:ext cx="163726" cy="922340"/>
              </a:xfrm>
              <a:prstGeom prst="rect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6" name="Rectangle 56">
                <a:extLst>
                  <a:ext uri="{FF2B5EF4-FFF2-40B4-BE49-F238E27FC236}">
                    <a16:creationId xmlns:a16="http://schemas.microsoft.com/office/drawing/2014/main" id="{E1017B4E-F779-E196-B77A-7EAFC33174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96881" y="3632712"/>
                <a:ext cx="163726" cy="43621"/>
              </a:xfrm>
              <a:prstGeom prst="rect">
                <a:avLst/>
              </a:prstGeom>
              <a:solidFill>
                <a:srgbClr val="B55D60"/>
              </a:solidFill>
              <a:ln w="17463" cap="flat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17463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7" name="Rectangle 57">
                <a:extLst>
                  <a:ext uri="{FF2B5EF4-FFF2-40B4-BE49-F238E27FC236}">
                    <a16:creationId xmlns:a16="http://schemas.microsoft.com/office/drawing/2014/main" id="{62465244-532E-7F4C-EB02-CE0A73F0B6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96881" y="3632712"/>
                <a:ext cx="163726" cy="45322"/>
              </a:xfrm>
              <a:prstGeom prst="rect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8" name="Rectangle 58">
                <a:extLst>
                  <a:ext uri="{FF2B5EF4-FFF2-40B4-BE49-F238E27FC236}">
                    <a16:creationId xmlns:a16="http://schemas.microsoft.com/office/drawing/2014/main" id="{58A93AD8-7DDF-5D37-3360-A02F5A85E3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7848" y="3286565"/>
                <a:ext cx="163160" cy="389166"/>
              </a:xfrm>
              <a:prstGeom prst="rect">
                <a:avLst/>
              </a:prstGeom>
              <a:solidFill>
                <a:srgbClr val="B55D60"/>
              </a:solidFill>
              <a:ln w="17463" cap="flat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17463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9" name="Rectangle 59">
                <a:extLst>
                  <a:ext uri="{FF2B5EF4-FFF2-40B4-BE49-F238E27FC236}">
                    <a16:creationId xmlns:a16="http://schemas.microsoft.com/office/drawing/2014/main" id="{0B97012D-6B61-83C3-0581-89DF7D33E8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7848" y="3286564"/>
                <a:ext cx="163160" cy="391505"/>
              </a:xfrm>
              <a:prstGeom prst="rect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0" name="Line 60">
                <a:extLst>
                  <a:ext uri="{FF2B5EF4-FFF2-40B4-BE49-F238E27FC236}">
                    <a16:creationId xmlns:a16="http://schemas.microsoft.com/office/drawing/2014/main" id="{CA44FC5A-83AB-97CA-FD5E-6732FAE5B8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578460" y="3273534"/>
                <a:ext cx="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1" name="Line 61">
                <a:extLst>
                  <a:ext uri="{FF2B5EF4-FFF2-40B4-BE49-F238E27FC236}">
                    <a16:creationId xmlns:a16="http://schemas.microsoft.com/office/drawing/2014/main" id="{7C333D9D-51EB-ADDD-0B29-546D4ADE73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169995" y="2753463"/>
                <a:ext cx="0" cy="2266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2" name="Line 62">
                <a:extLst>
                  <a:ext uri="{FF2B5EF4-FFF2-40B4-BE49-F238E27FC236}">
                    <a16:creationId xmlns:a16="http://schemas.microsoft.com/office/drawing/2014/main" id="{5046A8C0-B016-CC8F-0CA1-D6F854110B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415301" y="3632712"/>
                <a:ext cx="567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3" name="Line 63">
                <a:extLst>
                  <a:ext uri="{FF2B5EF4-FFF2-40B4-BE49-F238E27FC236}">
                    <a16:creationId xmlns:a16="http://schemas.microsoft.com/office/drawing/2014/main" id="{C0FCCE8B-82E2-4AD1-FDBC-A5DFE9441C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6269" y="3283165"/>
                <a:ext cx="0" cy="679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4" name="Line 64">
                <a:extLst>
                  <a:ext uri="{FF2B5EF4-FFF2-40B4-BE49-F238E27FC236}">
                    <a16:creationId xmlns:a16="http://schemas.microsoft.com/office/drawing/2014/main" id="{4918F53E-79C2-E209-9438-C69D8A9D59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700830" y="2709274"/>
                <a:ext cx="0" cy="967060"/>
              </a:xfrm>
              <a:prstGeom prst="line">
                <a:avLst/>
              </a:prstGeom>
              <a:noFill/>
              <a:ln w="3175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5" name="Line 65">
                <a:extLst>
                  <a:ext uri="{FF2B5EF4-FFF2-40B4-BE49-F238E27FC236}">
                    <a16:creationId xmlns:a16="http://schemas.microsoft.com/office/drawing/2014/main" id="{68F15E80-DEBC-6891-26F5-6E0867C4D0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16101" y="2709274"/>
                <a:ext cx="0" cy="967060"/>
              </a:xfrm>
              <a:prstGeom prst="line">
                <a:avLst/>
              </a:prstGeom>
              <a:noFill/>
              <a:ln w="3175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6" name="Line 66">
                <a:extLst>
                  <a:ext uri="{FF2B5EF4-FFF2-40B4-BE49-F238E27FC236}">
                    <a16:creationId xmlns:a16="http://schemas.microsoft.com/office/drawing/2014/main" id="{1A0160B5-236D-F94C-6DEE-5AD18320E4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700830" y="3677184"/>
                <a:ext cx="816931" cy="0"/>
              </a:xfrm>
              <a:prstGeom prst="line">
                <a:avLst/>
              </a:prstGeom>
              <a:noFill/>
              <a:ln w="11113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7" name="Line 67">
                <a:extLst>
                  <a:ext uri="{FF2B5EF4-FFF2-40B4-BE49-F238E27FC236}">
                    <a16:creationId xmlns:a16="http://schemas.microsoft.com/office/drawing/2014/main" id="{1A588E32-354B-7859-A45F-47122A54E1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700830" y="2723560"/>
                <a:ext cx="816931" cy="0"/>
              </a:xfrm>
              <a:prstGeom prst="line">
                <a:avLst/>
              </a:prstGeom>
              <a:noFill/>
              <a:ln w="3175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pic>
            <p:nvPicPr>
              <p:cNvPr id="1268" name="Picture 68">
                <a:extLst>
                  <a:ext uri="{FF2B5EF4-FFF2-40B4-BE49-F238E27FC236}">
                    <a16:creationId xmlns:a16="http://schemas.microsoft.com/office/drawing/2014/main" id="{513DA0D0-C3C5-EC3E-37F4-BC13D1A7E51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671937" y="2738167"/>
                <a:ext cx="681531" cy="21471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269" name="Rectangle 1268">
                <a:extLst>
                  <a:ext uri="{FF2B5EF4-FFF2-40B4-BE49-F238E27FC236}">
                    <a16:creationId xmlns:a16="http://schemas.microsoft.com/office/drawing/2014/main" id="{6F60FD97-ED5F-74AA-3061-788B409A40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43044" y="2771026"/>
                <a:ext cx="128602" cy="44756"/>
              </a:xfrm>
              <a:prstGeom prst="rect">
                <a:avLst/>
              </a:prstGeom>
              <a:solidFill>
                <a:srgbClr val="71AEC0"/>
              </a:solidFill>
              <a:ln w="17463" cap="flat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17463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0" name="Rectangle 1269">
                <a:extLst>
                  <a:ext uri="{FF2B5EF4-FFF2-40B4-BE49-F238E27FC236}">
                    <a16:creationId xmlns:a16="http://schemas.microsoft.com/office/drawing/2014/main" id="{57AFAB07-BB57-1329-E7DD-D3125C4E8B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43044" y="2771026"/>
                <a:ext cx="128602" cy="44756"/>
              </a:xfrm>
              <a:prstGeom prst="rect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1" name="Freeform 71">
                <a:extLst>
                  <a:ext uri="{FF2B5EF4-FFF2-40B4-BE49-F238E27FC236}">
                    <a16:creationId xmlns:a16="http://schemas.microsoft.com/office/drawing/2014/main" id="{3116B4FC-52A3-0206-77F1-ECE1895C199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459490" y="2768193"/>
                <a:ext cx="37957" cy="48721"/>
              </a:xfrm>
              <a:custGeom>
                <a:avLst/>
                <a:gdLst>
                  <a:gd name="T0" fmla="*/ 588 w 588"/>
                  <a:gd name="T1" fmla="*/ 69 h 755"/>
                  <a:gd name="T2" fmla="*/ 588 w 588"/>
                  <a:gd name="T3" fmla="*/ 173 h 755"/>
                  <a:gd name="T4" fmla="*/ 481 w 588"/>
                  <a:gd name="T5" fmla="*/ 104 h 755"/>
                  <a:gd name="T6" fmla="*/ 362 w 588"/>
                  <a:gd name="T7" fmla="*/ 81 h 755"/>
                  <a:gd name="T8" fmla="*/ 170 w 588"/>
                  <a:gd name="T9" fmla="*/ 158 h 755"/>
                  <a:gd name="T10" fmla="*/ 104 w 588"/>
                  <a:gd name="T11" fmla="*/ 378 h 755"/>
                  <a:gd name="T12" fmla="*/ 170 w 588"/>
                  <a:gd name="T13" fmla="*/ 599 h 755"/>
                  <a:gd name="T14" fmla="*/ 362 w 588"/>
                  <a:gd name="T15" fmla="*/ 675 h 755"/>
                  <a:gd name="T16" fmla="*/ 481 w 588"/>
                  <a:gd name="T17" fmla="*/ 652 h 755"/>
                  <a:gd name="T18" fmla="*/ 588 w 588"/>
                  <a:gd name="T19" fmla="*/ 583 h 755"/>
                  <a:gd name="T20" fmla="*/ 588 w 588"/>
                  <a:gd name="T21" fmla="*/ 686 h 755"/>
                  <a:gd name="T22" fmla="*/ 478 w 588"/>
                  <a:gd name="T23" fmla="*/ 738 h 755"/>
                  <a:gd name="T24" fmla="*/ 356 w 588"/>
                  <a:gd name="T25" fmla="*/ 755 h 755"/>
                  <a:gd name="T26" fmla="*/ 95 w 588"/>
                  <a:gd name="T27" fmla="*/ 655 h 755"/>
                  <a:gd name="T28" fmla="*/ 0 w 588"/>
                  <a:gd name="T29" fmla="*/ 378 h 755"/>
                  <a:gd name="T30" fmla="*/ 95 w 588"/>
                  <a:gd name="T31" fmla="*/ 101 h 755"/>
                  <a:gd name="T32" fmla="*/ 356 w 588"/>
                  <a:gd name="T33" fmla="*/ 0 h 755"/>
                  <a:gd name="T34" fmla="*/ 479 w 588"/>
                  <a:gd name="T35" fmla="*/ 17 h 755"/>
                  <a:gd name="T36" fmla="*/ 588 w 588"/>
                  <a:gd name="T37" fmla="*/ 69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588" h="755">
                    <a:moveTo>
                      <a:pt x="588" y="69"/>
                    </a:moveTo>
                    <a:lnTo>
                      <a:pt x="588" y="173"/>
                    </a:lnTo>
                    <a:cubicBezTo>
                      <a:pt x="554" y="143"/>
                      <a:pt x="519" y="120"/>
                      <a:pt x="481" y="104"/>
                    </a:cubicBezTo>
                    <a:cubicBezTo>
                      <a:pt x="443" y="89"/>
                      <a:pt x="404" y="81"/>
                      <a:pt x="362" y="81"/>
                    </a:cubicBezTo>
                    <a:cubicBezTo>
                      <a:pt x="278" y="81"/>
                      <a:pt x="214" y="107"/>
                      <a:pt x="170" y="158"/>
                    </a:cubicBezTo>
                    <a:cubicBezTo>
                      <a:pt x="126" y="209"/>
                      <a:pt x="104" y="282"/>
                      <a:pt x="104" y="378"/>
                    </a:cubicBezTo>
                    <a:cubicBezTo>
                      <a:pt x="104" y="474"/>
                      <a:pt x="126" y="548"/>
                      <a:pt x="170" y="599"/>
                    </a:cubicBezTo>
                    <a:cubicBezTo>
                      <a:pt x="214" y="650"/>
                      <a:pt x="278" y="675"/>
                      <a:pt x="362" y="675"/>
                    </a:cubicBezTo>
                    <a:cubicBezTo>
                      <a:pt x="404" y="675"/>
                      <a:pt x="443" y="668"/>
                      <a:pt x="481" y="652"/>
                    </a:cubicBezTo>
                    <a:cubicBezTo>
                      <a:pt x="519" y="637"/>
                      <a:pt x="554" y="614"/>
                      <a:pt x="588" y="583"/>
                    </a:cubicBezTo>
                    <a:lnTo>
                      <a:pt x="588" y="686"/>
                    </a:lnTo>
                    <a:cubicBezTo>
                      <a:pt x="553" y="710"/>
                      <a:pt x="516" y="727"/>
                      <a:pt x="478" y="738"/>
                    </a:cubicBezTo>
                    <a:cubicBezTo>
                      <a:pt x="440" y="749"/>
                      <a:pt x="399" y="755"/>
                      <a:pt x="356" y="755"/>
                    </a:cubicBezTo>
                    <a:cubicBezTo>
                      <a:pt x="246" y="755"/>
                      <a:pt x="159" y="722"/>
                      <a:pt x="95" y="655"/>
                    </a:cubicBezTo>
                    <a:cubicBezTo>
                      <a:pt x="31" y="588"/>
                      <a:pt x="0" y="496"/>
                      <a:pt x="0" y="378"/>
                    </a:cubicBezTo>
                    <a:cubicBezTo>
                      <a:pt x="0" y="261"/>
                      <a:pt x="31" y="169"/>
                      <a:pt x="95" y="101"/>
                    </a:cubicBezTo>
                    <a:cubicBezTo>
                      <a:pt x="159" y="34"/>
                      <a:pt x="246" y="0"/>
                      <a:pt x="356" y="0"/>
                    </a:cubicBezTo>
                    <a:cubicBezTo>
                      <a:pt x="400" y="0"/>
                      <a:pt x="441" y="6"/>
                      <a:pt x="479" y="17"/>
                    </a:cubicBezTo>
                    <a:cubicBezTo>
                      <a:pt x="517" y="29"/>
                      <a:pt x="554" y="46"/>
                      <a:pt x="588" y="6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2" name="Freeform 72">
                <a:extLst>
                  <a:ext uri="{FF2B5EF4-FFF2-40B4-BE49-F238E27FC236}">
                    <a16:creationId xmlns:a16="http://schemas.microsoft.com/office/drawing/2014/main" id="{B43C89E4-82D8-8BA8-EF17-49A9CAD3CB0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414734" y="2780090"/>
                <a:ext cx="32859" cy="36824"/>
              </a:xfrm>
              <a:custGeom>
                <a:avLst/>
                <a:gdLst>
                  <a:gd name="T0" fmla="*/ 507 w 507"/>
                  <a:gd name="T1" fmla="*/ 264 h 573"/>
                  <a:gd name="T2" fmla="*/ 507 w 507"/>
                  <a:gd name="T3" fmla="*/ 308 h 573"/>
                  <a:gd name="T4" fmla="*/ 94 w 507"/>
                  <a:gd name="T5" fmla="*/ 308 h 573"/>
                  <a:gd name="T6" fmla="*/ 150 w 507"/>
                  <a:gd name="T7" fmla="*/ 450 h 573"/>
                  <a:gd name="T8" fmla="*/ 289 w 507"/>
                  <a:gd name="T9" fmla="*/ 498 h 573"/>
                  <a:gd name="T10" fmla="*/ 389 w 507"/>
                  <a:gd name="T11" fmla="*/ 486 h 573"/>
                  <a:gd name="T12" fmla="*/ 486 w 507"/>
                  <a:gd name="T13" fmla="*/ 447 h 573"/>
                  <a:gd name="T14" fmla="*/ 486 w 507"/>
                  <a:gd name="T15" fmla="*/ 532 h 573"/>
                  <a:gd name="T16" fmla="*/ 387 w 507"/>
                  <a:gd name="T17" fmla="*/ 563 h 573"/>
                  <a:gd name="T18" fmla="*/ 284 w 507"/>
                  <a:gd name="T19" fmla="*/ 573 h 573"/>
                  <a:gd name="T20" fmla="*/ 76 w 507"/>
                  <a:gd name="T21" fmla="*/ 498 h 573"/>
                  <a:gd name="T22" fmla="*/ 0 w 507"/>
                  <a:gd name="T23" fmla="*/ 292 h 573"/>
                  <a:gd name="T24" fmla="*/ 72 w 507"/>
                  <a:gd name="T25" fmla="*/ 79 h 573"/>
                  <a:gd name="T26" fmla="*/ 268 w 507"/>
                  <a:gd name="T27" fmla="*/ 0 h 573"/>
                  <a:gd name="T28" fmla="*/ 443 w 507"/>
                  <a:gd name="T29" fmla="*/ 71 h 573"/>
                  <a:gd name="T30" fmla="*/ 507 w 507"/>
                  <a:gd name="T31" fmla="*/ 264 h 573"/>
                  <a:gd name="T32" fmla="*/ 417 w 507"/>
                  <a:gd name="T33" fmla="*/ 238 h 573"/>
                  <a:gd name="T34" fmla="*/ 376 w 507"/>
                  <a:gd name="T35" fmla="*/ 120 h 573"/>
                  <a:gd name="T36" fmla="*/ 269 w 507"/>
                  <a:gd name="T37" fmla="*/ 76 h 573"/>
                  <a:gd name="T38" fmla="*/ 149 w 507"/>
                  <a:gd name="T39" fmla="*/ 119 h 573"/>
                  <a:gd name="T40" fmla="*/ 97 w 507"/>
                  <a:gd name="T41" fmla="*/ 238 h 573"/>
                  <a:gd name="T42" fmla="*/ 417 w 507"/>
                  <a:gd name="T43" fmla="*/ 23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07" h="573">
                    <a:moveTo>
                      <a:pt x="507" y="264"/>
                    </a:moveTo>
                    <a:lnTo>
                      <a:pt x="507" y="308"/>
                    </a:lnTo>
                    <a:lnTo>
                      <a:pt x="94" y="308"/>
                    </a:lnTo>
                    <a:cubicBezTo>
                      <a:pt x="98" y="370"/>
                      <a:pt x="116" y="418"/>
                      <a:pt x="150" y="450"/>
                    </a:cubicBezTo>
                    <a:cubicBezTo>
                      <a:pt x="183" y="482"/>
                      <a:pt x="229" y="498"/>
                      <a:pt x="289" y="498"/>
                    </a:cubicBezTo>
                    <a:cubicBezTo>
                      <a:pt x="323" y="498"/>
                      <a:pt x="357" y="494"/>
                      <a:pt x="389" y="486"/>
                    </a:cubicBezTo>
                    <a:cubicBezTo>
                      <a:pt x="421" y="478"/>
                      <a:pt x="454" y="465"/>
                      <a:pt x="486" y="447"/>
                    </a:cubicBezTo>
                    <a:lnTo>
                      <a:pt x="486" y="532"/>
                    </a:lnTo>
                    <a:cubicBezTo>
                      <a:pt x="454" y="546"/>
                      <a:pt x="421" y="557"/>
                      <a:pt x="387" y="563"/>
                    </a:cubicBezTo>
                    <a:cubicBezTo>
                      <a:pt x="353" y="569"/>
                      <a:pt x="318" y="573"/>
                      <a:pt x="284" y="573"/>
                    </a:cubicBezTo>
                    <a:cubicBezTo>
                      <a:pt x="196" y="573"/>
                      <a:pt x="127" y="548"/>
                      <a:pt x="76" y="498"/>
                    </a:cubicBezTo>
                    <a:cubicBezTo>
                      <a:pt x="25" y="448"/>
                      <a:pt x="0" y="379"/>
                      <a:pt x="0" y="292"/>
                    </a:cubicBezTo>
                    <a:cubicBezTo>
                      <a:pt x="0" y="203"/>
                      <a:pt x="24" y="132"/>
                      <a:pt x="72" y="79"/>
                    </a:cubicBezTo>
                    <a:cubicBezTo>
                      <a:pt x="120" y="27"/>
                      <a:pt x="186" y="0"/>
                      <a:pt x="268" y="0"/>
                    </a:cubicBezTo>
                    <a:cubicBezTo>
                      <a:pt x="342" y="0"/>
                      <a:pt x="400" y="24"/>
                      <a:pt x="443" y="71"/>
                    </a:cubicBezTo>
                    <a:cubicBezTo>
                      <a:pt x="485" y="119"/>
                      <a:pt x="507" y="183"/>
                      <a:pt x="507" y="264"/>
                    </a:cubicBezTo>
                    <a:close/>
                    <a:moveTo>
                      <a:pt x="417" y="238"/>
                    </a:moveTo>
                    <a:cubicBezTo>
                      <a:pt x="416" y="189"/>
                      <a:pt x="402" y="150"/>
                      <a:pt x="376" y="120"/>
                    </a:cubicBezTo>
                    <a:cubicBezTo>
                      <a:pt x="349" y="91"/>
                      <a:pt x="313" y="76"/>
                      <a:pt x="269" y="76"/>
                    </a:cubicBezTo>
                    <a:cubicBezTo>
                      <a:pt x="219" y="76"/>
                      <a:pt x="179" y="91"/>
                      <a:pt x="149" y="119"/>
                    </a:cubicBezTo>
                    <a:cubicBezTo>
                      <a:pt x="119" y="147"/>
                      <a:pt x="101" y="187"/>
                      <a:pt x="97" y="238"/>
                    </a:cubicBezTo>
                    <a:lnTo>
                      <a:pt x="417" y="238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3" name="Rectangle 1272">
                <a:extLst>
                  <a:ext uri="{FF2B5EF4-FFF2-40B4-BE49-F238E27FC236}">
                    <a16:creationId xmlns:a16="http://schemas.microsoft.com/office/drawing/2014/main" id="{602F35CB-A258-E3D1-B63D-55D29CA4EA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72245" y="2767060"/>
                <a:ext cx="5665" cy="48721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4" name="Rectangle 1273">
                <a:extLst>
                  <a:ext uri="{FF2B5EF4-FFF2-40B4-BE49-F238E27FC236}">
                    <a16:creationId xmlns:a16="http://schemas.microsoft.com/office/drawing/2014/main" id="{2F16082A-B96A-5E27-840E-31B77DC377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4682" y="2767060"/>
                <a:ext cx="5665" cy="48721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5" name="Freeform 75">
                <a:extLst>
                  <a:ext uri="{FF2B5EF4-FFF2-40B4-BE49-F238E27FC236}">
                    <a16:creationId xmlns:a16="http://schemas.microsoft.com/office/drawing/2014/main" id="{ECD689E5-A4BA-173F-490D-CF6E8FE8EEF1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337120" y="2780090"/>
                <a:ext cx="31725" cy="49288"/>
              </a:xfrm>
              <a:custGeom>
                <a:avLst/>
                <a:gdLst>
                  <a:gd name="T0" fmla="*/ 90 w 489"/>
                  <a:gd name="T1" fmla="*/ 478 h 767"/>
                  <a:gd name="T2" fmla="*/ 90 w 489"/>
                  <a:gd name="T3" fmla="*/ 767 h 767"/>
                  <a:gd name="T4" fmla="*/ 0 w 489"/>
                  <a:gd name="T5" fmla="*/ 767 h 767"/>
                  <a:gd name="T6" fmla="*/ 0 w 489"/>
                  <a:gd name="T7" fmla="*/ 13 h 767"/>
                  <a:gd name="T8" fmla="*/ 90 w 489"/>
                  <a:gd name="T9" fmla="*/ 13 h 767"/>
                  <a:gd name="T10" fmla="*/ 90 w 489"/>
                  <a:gd name="T11" fmla="*/ 96 h 767"/>
                  <a:gd name="T12" fmla="*/ 161 w 489"/>
                  <a:gd name="T13" fmla="*/ 24 h 767"/>
                  <a:gd name="T14" fmla="*/ 265 w 489"/>
                  <a:gd name="T15" fmla="*/ 0 h 767"/>
                  <a:gd name="T16" fmla="*/ 427 w 489"/>
                  <a:gd name="T17" fmla="*/ 79 h 767"/>
                  <a:gd name="T18" fmla="*/ 489 w 489"/>
                  <a:gd name="T19" fmla="*/ 287 h 767"/>
                  <a:gd name="T20" fmla="*/ 427 w 489"/>
                  <a:gd name="T21" fmla="*/ 495 h 767"/>
                  <a:gd name="T22" fmla="*/ 265 w 489"/>
                  <a:gd name="T23" fmla="*/ 573 h 767"/>
                  <a:gd name="T24" fmla="*/ 161 w 489"/>
                  <a:gd name="T25" fmla="*/ 550 h 767"/>
                  <a:gd name="T26" fmla="*/ 90 w 489"/>
                  <a:gd name="T27" fmla="*/ 478 h 767"/>
                  <a:gd name="T28" fmla="*/ 396 w 489"/>
                  <a:gd name="T29" fmla="*/ 287 h 767"/>
                  <a:gd name="T30" fmla="*/ 355 w 489"/>
                  <a:gd name="T31" fmla="*/ 132 h 767"/>
                  <a:gd name="T32" fmla="*/ 243 w 489"/>
                  <a:gd name="T33" fmla="*/ 75 h 767"/>
                  <a:gd name="T34" fmla="*/ 131 w 489"/>
                  <a:gd name="T35" fmla="*/ 132 h 767"/>
                  <a:gd name="T36" fmla="*/ 90 w 489"/>
                  <a:gd name="T37" fmla="*/ 287 h 767"/>
                  <a:gd name="T38" fmla="*/ 131 w 489"/>
                  <a:gd name="T39" fmla="*/ 443 h 767"/>
                  <a:gd name="T40" fmla="*/ 243 w 489"/>
                  <a:gd name="T41" fmla="*/ 499 h 767"/>
                  <a:gd name="T42" fmla="*/ 355 w 489"/>
                  <a:gd name="T43" fmla="*/ 443 h 767"/>
                  <a:gd name="T44" fmla="*/ 396 w 489"/>
                  <a:gd name="T45" fmla="*/ 287 h 7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89" h="767">
                    <a:moveTo>
                      <a:pt x="90" y="478"/>
                    </a:moveTo>
                    <a:lnTo>
                      <a:pt x="90" y="767"/>
                    </a:lnTo>
                    <a:lnTo>
                      <a:pt x="0" y="767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6"/>
                    </a:lnTo>
                    <a:cubicBezTo>
                      <a:pt x="108" y="64"/>
                      <a:pt x="132" y="40"/>
                      <a:pt x="161" y="24"/>
                    </a:cubicBezTo>
                    <a:cubicBezTo>
                      <a:pt x="190" y="8"/>
                      <a:pt x="225" y="0"/>
                      <a:pt x="265" y="0"/>
                    </a:cubicBezTo>
                    <a:cubicBezTo>
                      <a:pt x="331" y="0"/>
                      <a:pt x="385" y="27"/>
                      <a:pt x="427" y="79"/>
                    </a:cubicBezTo>
                    <a:cubicBezTo>
                      <a:pt x="468" y="132"/>
                      <a:pt x="489" y="201"/>
                      <a:pt x="489" y="287"/>
                    </a:cubicBezTo>
                    <a:cubicBezTo>
                      <a:pt x="489" y="373"/>
                      <a:pt x="468" y="443"/>
                      <a:pt x="427" y="495"/>
                    </a:cubicBezTo>
                    <a:cubicBezTo>
                      <a:pt x="385" y="547"/>
                      <a:pt x="331" y="573"/>
                      <a:pt x="265" y="573"/>
                    </a:cubicBezTo>
                    <a:cubicBezTo>
                      <a:pt x="225" y="573"/>
                      <a:pt x="190" y="565"/>
                      <a:pt x="161" y="550"/>
                    </a:cubicBezTo>
                    <a:cubicBezTo>
                      <a:pt x="132" y="535"/>
                      <a:pt x="108" y="511"/>
                      <a:pt x="90" y="478"/>
                    </a:cubicBezTo>
                    <a:close/>
                    <a:moveTo>
                      <a:pt x="396" y="287"/>
                    </a:moveTo>
                    <a:cubicBezTo>
                      <a:pt x="396" y="221"/>
                      <a:pt x="382" y="170"/>
                      <a:pt x="355" y="132"/>
                    </a:cubicBezTo>
                    <a:cubicBezTo>
                      <a:pt x="327" y="94"/>
                      <a:pt x="290" y="75"/>
                      <a:pt x="243" y="75"/>
                    </a:cubicBezTo>
                    <a:cubicBezTo>
                      <a:pt x="195" y="75"/>
                      <a:pt x="158" y="94"/>
                      <a:pt x="131" y="132"/>
                    </a:cubicBezTo>
                    <a:cubicBezTo>
                      <a:pt x="103" y="170"/>
                      <a:pt x="90" y="221"/>
                      <a:pt x="90" y="287"/>
                    </a:cubicBezTo>
                    <a:cubicBezTo>
                      <a:pt x="90" y="353"/>
                      <a:pt x="103" y="405"/>
                      <a:pt x="131" y="443"/>
                    </a:cubicBezTo>
                    <a:cubicBezTo>
                      <a:pt x="158" y="481"/>
                      <a:pt x="195" y="499"/>
                      <a:pt x="243" y="499"/>
                    </a:cubicBezTo>
                    <a:cubicBezTo>
                      <a:pt x="290" y="499"/>
                      <a:pt x="327" y="481"/>
                      <a:pt x="355" y="443"/>
                    </a:cubicBezTo>
                    <a:cubicBezTo>
                      <a:pt x="382" y="405"/>
                      <a:pt x="396" y="353"/>
                      <a:pt x="396" y="287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6" name="Freeform 76">
                <a:extLst>
                  <a:ext uri="{FF2B5EF4-FFF2-40B4-BE49-F238E27FC236}">
                    <a16:creationId xmlns:a16="http://schemas.microsoft.com/office/drawing/2014/main" id="{45427788-9ABC-E31F-44DA-98A22EED48D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298030" y="2780090"/>
                <a:ext cx="32292" cy="36824"/>
              </a:xfrm>
              <a:custGeom>
                <a:avLst/>
                <a:gdLst>
                  <a:gd name="T0" fmla="*/ 251 w 502"/>
                  <a:gd name="T1" fmla="*/ 76 h 573"/>
                  <a:gd name="T2" fmla="*/ 137 w 502"/>
                  <a:gd name="T3" fmla="*/ 133 h 573"/>
                  <a:gd name="T4" fmla="*/ 95 w 502"/>
                  <a:gd name="T5" fmla="*/ 287 h 573"/>
                  <a:gd name="T6" fmla="*/ 136 w 502"/>
                  <a:gd name="T7" fmla="*/ 442 h 573"/>
                  <a:gd name="T8" fmla="*/ 251 w 502"/>
                  <a:gd name="T9" fmla="*/ 498 h 573"/>
                  <a:gd name="T10" fmla="*/ 365 w 502"/>
                  <a:gd name="T11" fmla="*/ 442 h 573"/>
                  <a:gd name="T12" fmla="*/ 407 w 502"/>
                  <a:gd name="T13" fmla="*/ 287 h 573"/>
                  <a:gd name="T14" fmla="*/ 365 w 502"/>
                  <a:gd name="T15" fmla="*/ 133 h 573"/>
                  <a:gd name="T16" fmla="*/ 251 w 502"/>
                  <a:gd name="T17" fmla="*/ 76 h 573"/>
                  <a:gd name="T18" fmla="*/ 251 w 502"/>
                  <a:gd name="T19" fmla="*/ 0 h 573"/>
                  <a:gd name="T20" fmla="*/ 435 w 502"/>
                  <a:gd name="T21" fmla="*/ 76 h 573"/>
                  <a:gd name="T22" fmla="*/ 502 w 502"/>
                  <a:gd name="T23" fmla="*/ 287 h 573"/>
                  <a:gd name="T24" fmla="*/ 435 w 502"/>
                  <a:gd name="T25" fmla="*/ 497 h 573"/>
                  <a:gd name="T26" fmla="*/ 251 w 502"/>
                  <a:gd name="T27" fmla="*/ 573 h 573"/>
                  <a:gd name="T28" fmla="*/ 66 w 502"/>
                  <a:gd name="T29" fmla="*/ 497 h 573"/>
                  <a:gd name="T30" fmla="*/ 0 w 502"/>
                  <a:gd name="T31" fmla="*/ 287 h 573"/>
                  <a:gd name="T32" fmla="*/ 66 w 502"/>
                  <a:gd name="T33" fmla="*/ 76 h 573"/>
                  <a:gd name="T34" fmla="*/ 251 w 502"/>
                  <a:gd name="T35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2" h="573">
                    <a:moveTo>
                      <a:pt x="251" y="76"/>
                    </a:moveTo>
                    <a:cubicBezTo>
                      <a:pt x="203" y="76"/>
                      <a:pt x="165" y="95"/>
                      <a:pt x="137" y="133"/>
                    </a:cubicBezTo>
                    <a:cubicBezTo>
                      <a:pt x="109" y="171"/>
                      <a:pt x="95" y="222"/>
                      <a:pt x="95" y="287"/>
                    </a:cubicBezTo>
                    <a:cubicBezTo>
                      <a:pt x="95" y="353"/>
                      <a:pt x="108" y="404"/>
                      <a:pt x="136" y="442"/>
                    </a:cubicBezTo>
                    <a:cubicBezTo>
                      <a:pt x="164" y="480"/>
                      <a:pt x="202" y="498"/>
                      <a:pt x="251" y="498"/>
                    </a:cubicBezTo>
                    <a:cubicBezTo>
                      <a:pt x="299" y="498"/>
                      <a:pt x="337" y="480"/>
                      <a:pt x="365" y="442"/>
                    </a:cubicBezTo>
                    <a:cubicBezTo>
                      <a:pt x="393" y="404"/>
                      <a:pt x="407" y="353"/>
                      <a:pt x="407" y="287"/>
                    </a:cubicBezTo>
                    <a:cubicBezTo>
                      <a:pt x="407" y="223"/>
                      <a:pt x="393" y="171"/>
                      <a:pt x="365" y="133"/>
                    </a:cubicBezTo>
                    <a:cubicBezTo>
                      <a:pt x="337" y="95"/>
                      <a:pt x="299" y="76"/>
                      <a:pt x="251" y="76"/>
                    </a:cubicBezTo>
                    <a:close/>
                    <a:moveTo>
                      <a:pt x="251" y="0"/>
                    </a:moveTo>
                    <a:cubicBezTo>
                      <a:pt x="329" y="0"/>
                      <a:pt x="390" y="26"/>
                      <a:pt x="435" y="76"/>
                    </a:cubicBezTo>
                    <a:cubicBezTo>
                      <a:pt x="479" y="127"/>
                      <a:pt x="502" y="197"/>
                      <a:pt x="502" y="287"/>
                    </a:cubicBezTo>
                    <a:cubicBezTo>
                      <a:pt x="502" y="377"/>
                      <a:pt x="479" y="447"/>
                      <a:pt x="435" y="497"/>
                    </a:cubicBezTo>
                    <a:cubicBezTo>
                      <a:pt x="390" y="548"/>
                      <a:pt x="329" y="573"/>
                      <a:pt x="251" y="573"/>
                    </a:cubicBezTo>
                    <a:cubicBezTo>
                      <a:pt x="172" y="573"/>
                      <a:pt x="110" y="548"/>
                      <a:pt x="66" y="497"/>
                    </a:cubicBezTo>
                    <a:cubicBezTo>
                      <a:pt x="22" y="447"/>
                      <a:pt x="0" y="377"/>
                      <a:pt x="0" y="287"/>
                    </a:cubicBezTo>
                    <a:cubicBezTo>
                      <a:pt x="0" y="197"/>
                      <a:pt x="22" y="127"/>
                      <a:pt x="66" y="76"/>
                    </a:cubicBezTo>
                    <a:cubicBezTo>
                      <a:pt x="110" y="26"/>
                      <a:pt x="172" y="0"/>
                      <a:pt x="251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7" name="Freeform 77">
                <a:extLst>
                  <a:ext uri="{FF2B5EF4-FFF2-40B4-BE49-F238E27FC236}">
                    <a16:creationId xmlns:a16="http://schemas.microsoft.com/office/drawing/2014/main" id="{C968FEAA-F242-542E-F110-EA3138DB5B3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258939" y="2780090"/>
                <a:ext cx="26627" cy="36824"/>
              </a:xfrm>
              <a:custGeom>
                <a:avLst/>
                <a:gdLst>
                  <a:gd name="T0" fmla="*/ 389 w 418"/>
                  <a:gd name="T1" fmla="*/ 29 h 573"/>
                  <a:gd name="T2" fmla="*/ 389 w 418"/>
                  <a:gd name="T3" fmla="*/ 114 h 573"/>
                  <a:gd name="T4" fmla="*/ 310 w 418"/>
                  <a:gd name="T5" fmla="*/ 85 h 573"/>
                  <a:gd name="T6" fmla="*/ 225 w 418"/>
                  <a:gd name="T7" fmla="*/ 75 h 573"/>
                  <a:gd name="T8" fmla="*/ 124 w 418"/>
                  <a:gd name="T9" fmla="*/ 96 h 573"/>
                  <a:gd name="T10" fmla="*/ 91 w 418"/>
                  <a:gd name="T11" fmla="*/ 157 h 573"/>
                  <a:gd name="T12" fmla="*/ 115 w 418"/>
                  <a:gd name="T13" fmla="*/ 206 h 573"/>
                  <a:gd name="T14" fmla="*/ 211 w 418"/>
                  <a:gd name="T15" fmla="*/ 240 h 573"/>
                  <a:gd name="T16" fmla="*/ 242 w 418"/>
                  <a:gd name="T17" fmla="*/ 247 h 573"/>
                  <a:gd name="T18" fmla="*/ 378 w 418"/>
                  <a:gd name="T19" fmla="*/ 305 h 573"/>
                  <a:gd name="T20" fmla="*/ 418 w 418"/>
                  <a:gd name="T21" fmla="*/ 409 h 573"/>
                  <a:gd name="T22" fmla="*/ 358 w 418"/>
                  <a:gd name="T23" fmla="*/ 529 h 573"/>
                  <a:gd name="T24" fmla="*/ 192 w 418"/>
                  <a:gd name="T25" fmla="*/ 573 h 573"/>
                  <a:gd name="T26" fmla="*/ 100 w 418"/>
                  <a:gd name="T27" fmla="*/ 565 h 573"/>
                  <a:gd name="T28" fmla="*/ 0 w 418"/>
                  <a:gd name="T29" fmla="*/ 540 h 573"/>
                  <a:gd name="T30" fmla="*/ 0 w 418"/>
                  <a:gd name="T31" fmla="*/ 447 h 573"/>
                  <a:gd name="T32" fmla="*/ 98 w 418"/>
                  <a:gd name="T33" fmla="*/ 486 h 573"/>
                  <a:gd name="T34" fmla="*/ 194 w 418"/>
                  <a:gd name="T35" fmla="*/ 499 h 573"/>
                  <a:gd name="T36" fmla="*/ 292 w 418"/>
                  <a:gd name="T37" fmla="*/ 478 h 573"/>
                  <a:gd name="T38" fmla="*/ 326 w 418"/>
                  <a:gd name="T39" fmla="*/ 416 h 573"/>
                  <a:gd name="T40" fmla="*/ 301 w 418"/>
                  <a:gd name="T41" fmla="*/ 360 h 573"/>
                  <a:gd name="T42" fmla="*/ 193 w 418"/>
                  <a:gd name="T43" fmla="*/ 322 h 573"/>
                  <a:gd name="T44" fmla="*/ 162 w 418"/>
                  <a:gd name="T45" fmla="*/ 315 h 573"/>
                  <a:gd name="T46" fmla="*/ 41 w 418"/>
                  <a:gd name="T47" fmla="*/ 261 h 573"/>
                  <a:gd name="T48" fmla="*/ 4 w 418"/>
                  <a:gd name="T49" fmla="*/ 161 h 573"/>
                  <a:gd name="T50" fmla="*/ 58 w 418"/>
                  <a:gd name="T51" fmla="*/ 42 h 573"/>
                  <a:gd name="T52" fmla="*/ 214 w 418"/>
                  <a:gd name="T53" fmla="*/ 0 h 573"/>
                  <a:gd name="T54" fmla="*/ 308 w 418"/>
                  <a:gd name="T55" fmla="*/ 8 h 573"/>
                  <a:gd name="T56" fmla="*/ 389 w 418"/>
                  <a:gd name="T57" fmla="*/ 29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418" h="573">
                    <a:moveTo>
                      <a:pt x="389" y="29"/>
                    </a:moveTo>
                    <a:lnTo>
                      <a:pt x="389" y="114"/>
                    </a:lnTo>
                    <a:cubicBezTo>
                      <a:pt x="363" y="102"/>
                      <a:pt x="337" y="92"/>
                      <a:pt x="310" y="85"/>
                    </a:cubicBezTo>
                    <a:cubicBezTo>
                      <a:pt x="282" y="79"/>
                      <a:pt x="254" y="75"/>
                      <a:pt x="225" y="75"/>
                    </a:cubicBezTo>
                    <a:cubicBezTo>
                      <a:pt x="180" y="75"/>
                      <a:pt x="146" y="82"/>
                      <a:pt x="124" y="96"/>
                    </a:cubicBezTo>
                    <a:cubicBezTo>
                      <a:pt x="102" y="110"/>
                      <a:pt x="91" y="130"/>
                      <a:pt x="91" y="157"/>
                    </a:cubicBezTo>
                    <a:cubicBezTo>
                      <a:pt x="91" y="178"/>
                      <a:pt x="99" y="194"/>
                      <a:pt x="115" y="206"/>
                    </a:cubicBezTo>
                    <a:cubicBezTo>
                      <a:pt x="131" y="218"/>
                      <a:pt x="163" y="230"/>
                      <a:pt x="211" y="240"/>
                    </a:cubicBezTo>
                    <a:lnTo>
                      <a:pt x="242" y="247"/>
                    </a:lnTo>
                    <a:cubicBezTo>
                      <a:pt x="306" y="261"/>
                      <a:pt x="351" y="281"/>
                      <a:pt x="378" y="305"/>
                    </a:cubicBezTo>
                    <a:cubicBezTo>
                      <a:pt x="404" y="330"/>
                      <a:pt x="418" y="365"/>
                      <a:pt x="418" y="409"/>
                    </a:cubicBezTo>
                    <a:cubicBezTo>
                      <a:pt x="418" y="460"/>
                      <a:pt x="398" y="500"/>
                      <a:pt x="358" y="529"/>
                    </a:cubicBezTo>
                    <a:cubicBezTo>
                      <a:pt x="318" y="559"/>
                      <a:pt x="262" y="573"/>
                      <a:pt x="192" y="573"/>
                    </a:cubicBezTo>
                    <a:cubicBezTo>
                      <a:pt x="162" y="573"/>
                      <a:pt x="132" y="570"/>
                      <a:pt x="100" y="565"/>
                    </a:cubicBezTo>
                    <a:cubicBezTo>
                      <a:pt x="68" y="560"/>
                      <a:pt x="35" y="552"/>
                      <a:pt x="0" y="540"/>
                    </a:cubicBezTo>
                    <a:lnTo>
                      <a:pt x="0" y="447"/>
                    </a:lnTo>
                    <a:cubicBezTo>
                      <a:pt x="33" y="465"/>
                      <a:pt x="66" y="478"/>
                      <a:pt x="98" y="486"/>
                    </a:cubicBezTo>
                    <a:cubicBezTo>
                      <a:pt x="130" y="495"/>
                      <a:pt x="162" y="499"/>
                      <a:pt x="194" y="499"/>
                    </a:cubicBezTo>
                    <a:cubicBezTo>
                      <a:pt x="236" y="499"/>
                      <a:pt x="269" y="492"/>
                      <a:pt x="292" y="478"/>
                    </a:cubicBezTo>
                    <a:cubicBezTo>
                      <a:pt x="314" y="464"/>
                      <a:pt x="326" y="443"/>
                      <a:pt x="326" y="416"/>
                    </a:cubicBezTo>
                    <a:cubicBezTo>
                      <a:pt x="326" y="392"/>
                      <a:pt x="317" y="373"/>
                      <a:pt x="301" y="360"/>
                    </a:cubicBezTo>
                    <a:cubicBezTo>
                      <a:pt x="285" y="347"/>
                      <a:pt x="249" y="334"/>
                      <a:pt x="193" y="322"/>
                    </a:cubicBezTo>
                    <a:lnTo>
                      <a:pt x="162" y="315"/>
                    </a:lnTo>
                    <a:cubicBezTo>
                      <a:pt x="106" y="303"/>
                      <a:pt x="65" y="285"/>
                      <a:pt x="41" y="261"/>
                    </a:cubicBezTo>
                    <a:cubicBezTo>
                      <a:pt x="16" y="237"/>
                      <a:pt x="4" y="204"/>
                      <a:pt x="4" y="161"/>
                    </a:cubicBezTo>
                    <a:cubicBezTo>
                      <a:pt x="4" y="110"/>
                      <a:pt x="22" y="70"/>
                      <a:pt x="58" y="42"/>
                    </a:cubicBezTo>
                    <a:cubicBezTo>
                      <a:pt x="94" y="14"/>
                      <a:pt x="146" y="0"/>
                      <a:pt x="214" y="0"/>
                    </a:cubicBezTo>
                    <a:cubicBezTo>
                      <a:pt x="247" y="0"/>
                      <a:pt x="278" y="3"/>
                      <a:pt x="308" y="8"/>
                    </a:cubicBezTo>
                    <a:cubicBezTo>
                      <a:pt x="337" y="13"/>
                      <a:pt x="364" y="20"/>
                      <a:pt x="389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8" name="Freeform 78">
                <a:extLst>
                  <a:ext uri="{FF2B5EF4-FFF2-40B4-BE49-F238E27FC236}">
                    <a16:creationId xmlns:a16="http://schemas.microsoft.com/office/drawing/2014/main" id="{8AB6849C-FA3E-6EF8-B76C-29BBE6D2771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225514" y="2780090"/>
                <a:ext cx="32859" cy="36824"/>
              </a:xfrm>
              <a:custGeom>
                <a:avLst/>
                <a:gdLst>
                  <a:gd name="T0" fmla="*/ 507 w 507"/>
                  <a:gd name="T1" fmla="*/ 264 h 573"/>
                  <a:gd name="T2" fmla="*/ 507 w 507"/>
                  <a:gd name="T3" fmla="*/ 308 h 573"/>
                  <a:gd name="T4" fmla="*/ 94 w 507"/>
                  <a:gd name="T5" fmla="*/ 308 h 573"/>
                  <a:gd name="T6" fmla="*/ 150 w 507"/>
                  <a:gd name="T7" fmla="*/ 450 h 573"/>
                  <a:gd name="T8" fmla="*/ 289 w 507"/>
                  <a:gd name="T9" fmla="*/ 498 h 573"/>
                  <a:gd name="T10" fmla="*/ 389 w 507"/>
                  <a:gd name="T11" fmla="*/ 486 h 573"/>
                  <a:gd name="T12" fmla="*/ 486 w 507"/>
                  <a:gd name="T13" fmla="*/ 447 h 573"/>
                  <a:gd name="T14" fmla="*/ 486 w 507"/>
                  <a:gd name="T15" fmla="*/ 532 h 573"/>
                  <a:gd name="T16" fmla="*/ 387 w 507"/>
                  <a:gd name="T17" fmla="*/ 563 h 573"/>
                  <a:gd name="T18" fmla="*/ 284 w 507"/>
                  <a:gd name="T19" fmla="*/ 573 h 573"/>
                  <a:gd name="T20" fmla="*/ 76 w 507"/>
                  <a:gd name="T21" fmla="*/ 498 h 573"/>
                  <a:gd name="T22" fmla="*/ 0 w 507"/>
                  <a:gd name="T23" fmla="*/ 292 h 573"/>
                  <a:gd name="T24" fmla="*/ 72 w 507"/>
                  <a:gd name="T25" fmla="*/ 79 h 573"/>
                  <a:gd name="T26" fmla="*/ 268 w 507"/>
                  <a:gd name="T27" fmla="*/ 0 h 573"/>
                  <a:gd name="T28" fmla="*/ 443 w 507"/>
                  <a:gd name="T29" fmla="*/ 71 h 573"/>
                  <a:gd name="T30" fmla="*/ 507 w 507"/>
                  <a:gd name="T31" fmla="*/ 264 h 573"/>
                  <a:gd name="T32" fmla="*/ 417 w 507"/>
                  <a:gd name="T33" fmla="*/ 238 h 573"/>
                  <a:gd name="T34" fmla="*/ 376 w 507"/>
                  <a:gd name="T35" fmla="*/ 120 h 573"/>
                  <a:gd name="T36" fmla="*/ 269 w 507"/>
                  <a:gd name="T37" fmla="*/ 76 h 573"/>
                  <a:gd name="T38" fmla="*/ 149 w 507"/>
                  <a:gd name="T39" fmla="*/ 119 h 573"/>
                  <a:gd name="T40" fmla="*/ 97 w 507"/>
                  <a:gd name="T41" fmla="*/ 238 h 573"/>
                  <a:gd name="T42" fmla="*/ 417 w 507"/>
                  <a:gd name="T43" fmla="*/ 23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07" h="573">
                    <a:moveTo>
                      <a:pt x="507" y="264"/>
                    </a:moveTo>
                    <a:lnTo>
                      <a:pt x="507" y="308"/>
                    </a:lnTo>
                    <a:lnTo>
                      <a:pt x="94" y="308"/>
                    </a:lnTo>
                    <a:cubicBezTo>
                      <a:pt x="98" y="370"/>
                      <a:pt x="116" y="418"/>
                      <a:pt x="150" y="450"/>
                    </a:cubicBezTo>
                    <a:cubicBezTo>
                      <a:pt x="183" y="482"/>
                      <a:pt x="229" y="498"/>
                      <a:pt x="289" y="498"/>
                    </a:cubicBezTo>
                    <a:cubicBezTo>
                      <a:pt x="323" y="498"/>
                      <a:pt x="357" y="494"/>
                      <a:pt x="389" y="486"/>
                    </a:cubicBezTo>
                    <a:cubicBezTo>
                      <a:pt x="421" y="478"/>
                      <a:pt x="454" y="465"/>
                      <a:pt x="486" y="447"/>
                    </a:cubicBezTo>
                    <a:lnTo>
                      <a:pt x="486" y="532"/>
                    </a:lnTo>
                    <a:cubicBezTo>
                      <a:pt x="454" y="546"/>
                      <a:pt x="421" y="557"/>
                      <a:pt x="387" y="563"/>
                    </a:cubicBezTo>
                    <a:cubicBezTo>
                      <a:pt x="353" y="569"/>
                      <a:pt x="318" y="573"/>
                      <a:pt x="284" y="573"/>
                    </a:cubicBezTo>
                    <a:cubicBezTo>
                      <a:pt x="196" y="573"/>
                      <a:pt x="127" y="548"/>
                      <a:pt x="76" y="498"/>
                    </a:cubicBezTo>
                    <a:cubicBezTo>
                      <a:pt x="25" y="448"/>
                      <a:pt x="0" y="379"/>
                      <a:pt x="0" y="292"/>
                    </a:cubicBezTo>
                    <a:cubicBezTo>
                      <a:pt x="0" y="203"/>
                      <a:pt x="24" y="132"/>
                      <a:pt x="72" y="79"/>
                    </a:cubicBezTo>
                    <a:cubicBezTo>
                      <a:pt x="120" y="27"/>
                      <a:pt x="186" y="0"/>
                      <a:pt x="268" y="0"/>
                    </a:cubicBezTo>
                    <a:cubicBezTo>
                      <a:pt x="342" y="0"/>
                      <a:pt x="400" y="24"/>
                      <a:pt x="443" y="71"/>
                    </a:cubicBezTo>
                    <a:cubicBezTo>
                      <a:pt x="485" y="119"/>
                      <a:pt x="507" y="183"/>
                      <a:pt x="507" y="264"/>
                    </a:cubicBezTo>
                    <a:close/>
                    <a:moveTo>
                      <a:pt x="417" y="238"/>
                    </a:moveTo>
                    <a:cubicBezTo>
                      <a:pt x="416" y="189"/>
                      <a:pt x="402" y="150"/>
                      <a:pt x="376" y="120"/>
                    </a:cubicBezTo>
                    <a:cubicBezTo>
                      <a:pt x="349" y="91"/>
                      <a:pt x="313" y="76"/>
                      <a:pt x="269" y="76"/>
                    </a:cubicBezTo>
                    <a:cubicBezTo>
                      <a:pt x="219" y="76"/>
                      <a:pt x="179" y="91"/>
                      <a:pt x="149" y="119"/>
                    </a:cubicBezTo>
                    <a:cubicBezTo>
                      <a:pt x="119" y="147"/>
                      <a:pt x="101" y="187"/>
                      <a:pt x="97" y="238"/>
                    </a:cubicBezTo>
                    <a:lnTo>
                      <a:pt x="417" y="238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9" name="Freeform 79">
                <a:extLst>
                  <a:ext uri="{FF2B5EF4-FFF2-40B4-BE49-F238E27FC236}">
                    <a16:creationId xmlns:a16="http://schemas.microsoft.com/office/drawing/2014/main" id="{7D368C08-5895-093F-E003-D56F01BB9BD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163196" y="2767060"/>
                <a:ext cx="14163" cy="57219"/>
              </a:xfrm>
              <a:custGeom>
                <a:avLst/>
                <a:gdLst>
                  <a:gd name="T0" fmla="*/ 224 w 224"/>
                  <a:gd name="T1" fmla="*/ 0 h 890"/>
                  <a:gd name="T2" fmla="*/ 127 w 224"/>
                  <a:gd name="T3" fmla="*/ 223 h 890"/>
                  <a:gd name="T4" fmla="*/ 95 w 224"/>
                  <a:gd name="T5" fmla="*/ 445 h 890"/>
                  <a:gd name="T6" fmla="*/ 127 w 224"/>
                  <a:gd name="T7" fmla="*/ 668 h 890"/>
                  <a:gd name="T8" fmla="*/ 224 w 224"/>
                  <a:gd name="T9" fmla="*/ 890 h 890"/>
                  <a:gd name="T10" fmla="*/ 146 w 224"/>
                  <a:gd name="T11" fmla="*/ 890 h 890"/>
                  <a:gd name="T12" fmla="*/ 36 w 224"/>
                  <a:gd name="T13" fmla="*/ 665 h 890"/>
                  <a:gd name="T14" fmla="*/ 0 w 224"/>
                  <a:gd name="T15" fmla="*/ 445 h 890"/>
                  <a:gd name="T16" fmla="*/ 36 w 224"/>
                  <a:gd name="T17" fmla="*/ 226 h 890"/>
                  <a:gd name="T18" fmla="*/ 146 w 224"/>
                  <a:gd name="T19" fmla="*/ 0 h 890"/>
                  <a:gd name="T20" fmla="*/ 224 w 224"/>
                  <a:gd name="T21" fmla="*/ 0 h 8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224" h="890">
                    <a:moveTo>
                      <a:pt x="224" y="0"/>
                    </a:moveTo>
                    <a:cubicBezTo>
                      <a:pt x="180" y="76"/>
                      <a:pt x="148" y="150"/>
                      <a:pt x="127" y="223"/>
                    </a:cubicBezTo>
                    <a:cubicBezTo>
                      <a:pt x="105" y="296"/>
                      <a:pt x="95" y="370"/>
                      <a:pt x="95" y="445"/>
                    </a:cubicBezTo>
                    <a:cubicBezTo>
                      <a:pt x="95" y="521"/>
                      <a:pt x="105" y="595"/>
                      <a:pt x="127" y="668"/>
                    </a:cubicBezTo>
                    <a:cubicBezTo>
                      <a:pt x="148" y="742"/>
                      <a:pt x="180" y="815"/>
                      <a:pt x="224" y="890"/>
                    </a:cubicBezTo>
                    <a:lnTo>
                      <a:pt x="146" y="890"/>
                    </a:lnTo>
                    <a:cubicBezTo>
                      <a:pt x="97" y="813"/>
                      <a:pt x="60" y="739"/>
                      <a:pt x="36" y="665"/>
                    </a:cubicBezTo>
                    <a:cubicBezTo>
                      <a:pt x="12" y="591"/>
                      <a:pt x="0" y="518"/>
                      <a:pt x="0" y="445"/>
                    </a:cubicBezTo>
                    <a:cubicBezTo>
                      <a:pt x="0" y="373"/>
                      <a:pt x="12" y="300"/>
                      <a:pt x="36" y="226"/>
                    </a:cubicBezTo>
                    <a:cubicBezTo>
                      <a:pt x="60" y="152"/>
                      <a:pt x="96" y="77"/>
                      <a:pt x="146" y="0"/>
                    </a:cubicBezTo>
                    <a:lnTo>
                      <a:pt x="224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0" name="Freeform 80">
                <a:extLst>
                  <a:ext uri="{FF2B5EF4-FFF2-40B4-BE49-F238E27FC236}">
                    <a16:creationId xmlns:a16="http://schemas.microsoft.com/office/drawing/2014/main" id="{E0FB7C18-CB85-55BF-416C-0574D135FF8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138836" y="2768193"/>
                <a:ext cx="31159" cy="48721"/>
              </a:xfrm>
              <a:custGeom>
                <a:avLst/>
                <a:gdLst>
                  <a:gd name="T0" fmla="*/ 330 w 480"/>
                  <a:gd name="T1" fmla="*/ 349 h 755"/>
                  <a:gd name="T2" fmla="*/ 440 w 480"/>
                  <a:gd name="T3" fmla="*/ 412 h 755"/>
                  <a:gd name="T4" fmla="*/ 480 w 480"/>
                  <a:gd name="T5" fmla="*/ 530 h 755"/>
                  <a:gd name="T6" fmla="*/ 406 w 480"/>
                  <a:gd name="T7" fmla="*/ 697 h 755"/>
                  <a:gd name="T8" fmla="*/ 195 w 480"/>
                  <a:gd name="T9" fmla="*/ 755 h 755"/>
                  <a:gd name="T10" fmla="*/ 100 w 480"/>
                  <a:gd name="T11" fmla="*/ 746 h 755"/>
                  <a:gd name="T12" fmla="*/ 0 w 480"/>
                  <a:gd name="T13" fmla="*/ 720 h 755"/>
                  <a:gd name="T14" fmla="*/ 0 w 480"/>
                  <a:gd name="T15" fmla="*/ 625 h 755"/>
                  <a:gd name="T16" fmla="*/ 90 w 480"/>
                  <a:gd name="T17" fmla="*/ 661 h 755"/>
                  <a:gd name="T18" fmla="*/ 192 w 480"/>
                  <a:gd name="T19" fmla="*/ 673 h 755"/>
                  <a:gd name="T20" fmla="*/ 333 w 480"/>
                  <a:gd name="T21" fmla="*/ 637 h 755"/>
                  <a:gd name="T22" fmla="*/ 382 w 480"/>
                  <a:gd name="T23" fmla="*/ 530 h 755"/>
                  <a:gd name="T24" fmla="*/ 337 w 480"/>
                  <a:gd name="T25" fmla="*/ 430 h 755"/>
                  <a:gd name="T26" fmla="*/ 211 w 480"/>
                  <a:gd name="T27" fmla="*/ 393 h 755"/>
                  <a:gd name="T28" fmla="*/ 126 w 480"/>
                  <a:gd name="T29" fmla="*/ 393 h 755"/>
                  <a:gd name="T30" fmla="*/ 126 w 480"/>
                  <a:gd name="T31" fmla="*/ 312 h 755"/>
                  <a:gd name="T32" fmla="*/ 215 w 480"/>
                  <a:gd name="T33" fmla="*/ 312 h 755"/>
                  <a:gd name="T34" fmla="*/ 326 w 480"/>
                  <a:gd name="T35" fmla="*/ 283 h 755"/>
                  <a:gd name="T36" fmla="*/ 365 w 480"/>
                  <a:gd name="T37" fmla="*/ 199 h 755"/>
                  <a:gd name="T38" fmla="*/ 325 w 480"/>
                  <a:gd name="T39" fmla="*/ 113 h 755"/>
                  <a:gd name="T40" fmla="*/ 211 w 480"/>
                  <a:gd name="T41" fmla="*/ 83 h 755"/>
                  <a:gd name="T42" fmla="*/ 124 w 480"/>
                  <a:gd name="T43" fmla="*/ 92 h 755"/>
                  <a:gd name="T44" fmla="*/ 22 w 480"/>
                  <a:gd name="T45" fmla="*/ 119 h 755"/>
                  <a:gd name="T46" fmla="*/ 22 w 480"/>
                  <a:gd name="T47" fmla="*/ 31 h 755"/>
                  <a:gd name="T48" fmla="*/ 127 w 480"/>
                  <a:gd name="T49" fmla="*/ 8 h 755"/>
                  <a:gd name="T50" fmla="*/ 220 w 480"/>
                  <a:gd name="T51" fmla="*/ 0 h 755"/>
                  <a:gd name="T52" fmla="*/ 397 w 480"/>
                  <a:gd name="T53" fmla="*/ 51 h 755"/>
                  <a:gd name="T54" fmla="*/ 463 w 480"/>
                  <a:gd name="T55" fmla="*/ 189 h 755"/>
                  <a:gd name="T56" fmla="*/ 428 w 480"/>
                  <a:gd name="T57" fmla="*/ 291 h 755"/>
                  <a:gd name="T58" fmla="*/ 330 w 480"/>
                  <a:gd name="T59" fmla="*/ 349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480" h="755">
                    <a:moveTo>
                      <a:pt x="330" y="349"/>
                    </a:moveTo>
                    <a:cubicBezTo>
                      <a:pt x="377" y="359"/>
                      <a:pt x="414" y="380"/>
                      <a:pt x="440" y="412"/>
                    </a:cubicBezTo>
                    <a:cubicBezTo>
                      <a:pt x="466" y="444"/>
                      <a:pt x="480" y="484"/>
                      <a:pt x="480" y="530"/>
                    </a:cubicBezTo>
                    <a:cubicBezTo>
                      <a:pt x="480" y="602"/>
                      <a:pt x="455" y="658"/>
                      <a:pt x="406" y="697"/>
                    </a:cubicBezTo>
                    <a:cubicBezTo>
                      <a:pt x="356" y="736"/>
                      <a:pt x="286" y="755"/>
                      <a:pt x="195" y="755"/>
                    </a:cubicBezTo>
                    <a:cubicBezTo>
                      <a:pt x="164" y="755"/>
                      <a:pt x="132" y="752"/>
                      <a:pt x="100" y="746"/>
                    </a:cubicBezTo>
                    <a:cubicBezTo>
                      <a:pt x="68" y="741"/>
                      <a:pt x="34" y="732"/>
                      <a:pt x="0" y="720"/>
                    </a:cubicBezTo>
                    <a:lnTo>
                      <a:pt x="0" y="625"/>
                    </a:lnTo>
                    <a:cubicBezTo>
                      <a:pt x="27" y="641"/>
                      <a:pt x="57" y="653"/>
                      <a:pt x="90" y="661"/>
                    </a:cubicBezTo>
                    <a:cubicBezTo>
                      <a:pt x="122" y="669"/>
                      <a:pt x="156" y="673"/>
                      <a:pt x="192" y="673"/>
                    </a:cubicBezTo>
                    <a:cubicBezTo>
                      <a:pt x="254" y="673"/>
                      <a:pt x="301" y="661"/>
                      <a:pt x="333" y="637"/>
                    </a:cubicBezTo>
                    <a:cubicBezTo>
                      <a:pt x="365" y="613"/>
                      <a:pt x="382" y="577"/>
                      <a:pt x="382" y="530"/>
                    </a:cubicBezTo>
                    <a:cubicBezTo>
                      <a:pt x="382" y="488"/>
                      <a:pt x="367" y="454"/>
                      <a:pt x="337" y="430"/>
                    </a:cubicBezTo>
                    <a:cubicBezTo>
                      <a:pt x="307" y="406"/>
                      <a:pt x="265" y="393"/>
                      <a:pt x="211" y="393"/>
                    </a:cubicBezTo>
                    <a:lnTo>
                      <a:pt x="126" y="393"/>
                    </a:lnTo>
                    <a:lnTo>
                      <a:pt x="126" y="312"/>
                    </a:lnTo>
                    <a:lnTo>
                      <a:pt x="215" y="312"/>
                    </a:lnTo>
                    <a:cubicBezTo>
                      <a:pt x="263" y="312"/>
                      <a:pt x="300" y="303"/>
                      <a:pt x="326" y="283"/>
                    </a:cubicBezTo>
                    <a:cubicBezTo>
                      <a:pt x="352" y="264"/>
                      <a:pt x="365" y="236"/>
                      <a:pt x="365" y="199"/>
                    </a:cubicBezTo>
                    <a:cubicBezTo>
                      <a:pt x="365" y="162"/>
                      <a:pt x="351" y="133"/>
                      <a:pt x="325" y="113"/>
                    </a:cubicBezTo>
                    <a:cubicBezTo>
                      <a:pt x="298" y="93"/>
                      <a:pt x="260" y="83"/>
                      <a:pt x="211" y="83"/>
                    </a:cubicBezTo>
                    <a:cubicBezTo>
                      <a:pt x="184" y="83"/>
                      <a:pt x="155" y="86"/>
                      <a:pt x="124" y="92"/>
                    </a:cubicBezTo>
                    <a:cubicBezTo>
                      <a:pt x="93" y="98"/>
                      <a:pt x="59" y="107"/>
                      <a:pt x="22" y="119"/>
                    </a:cubicBezTo>
                    <a:lnTo>
                      <a:pt x="22" y="31"/>
                    </a:lnTo>
                    <a:cubicBezTo>
                      <a:pt x="59" y="21"/>
                      <a:pt x="94" y="13"/>
                      <a:pt x="127" y="8"/>
                    </a:cubicBezTo>
                    <a:cubicBezTo>
                      <a:pt x="159" y="3"/>
                      <a:pt x="190" y="0"/>
                      <a:pt x="220" y="0"/>
                    </a:cubicBezTo>
                    <a:cubicBezTo>
                      <a:pt x="294" y="0"/>
                      <a:pt x="353" y="17"/>
                      <a:pt x="397" y="51"/>
                    </a:cubicBezTo>
                    <a:cubicBezTo>
                      <a:pt x="441" y="85"/>
                      <a:pt x="463" y="131"/>
                      <a:pt x="463" y="189"/>
                    </a:cubicBezTo>
                    <a:cubicBezTo>
                      <a:pt x="463" y="229"/>
                      <a:pt x="451" y="263"/>
                      <a:pt x="428" y="291"/>
                    </a:cubicBezTo>
                    <a:cubicBezTo>
                      <a:pt x="405" y="319"/>
                      <a:pt x="372" y="339"/>
                      <a:pt x="330" y="34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1" name="Freeform 81">
                <a:extLst>
                  <a:ext uri="{FF2B5EF4-FFF2-40B4-BE49-F238E27FC236}">
                    <a16:creationId xmlns:a16="http://schemas.microsoft.com/office/drawing/2014/main" id="{2EDBE365-6DE0-E60D-8237-7B0CEA5579E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96346" y="2769326"/>
                <a:ext cx="39090" cy="46455"/>
              </a:xfrm>
              <a:custGeom>
                <a:avLst/>
                <a:gdLst>
                  <a:gd name="T0" fmla="*/ 99 w 613"/>
                  <a:gd name="T1" fmla="*/ 81 h 729"/>
                  <a:gd name="T2" fmla="*/ 99 w 613"/>
                  <a:gd name="T3" fmla="*/ 648 h 729"/>
                  <a:gd name="T4" fmla="*/ 218 w 613"/>
                  <a:gd name="T5" fmla="*/ 648 h 729"/>
                  <a:gd name="T6" fmla="*/ 439 w 613"/>
                  <a:gd name="T7" fmla="*/ 580 h 729"/>
                  <a:gd name="T8" fmla="*/ 509 w 613"/>
                  <a:gd name="T9" fmla="*/ 364 h 729"/>
                  <a:gd name="T10" fmla="*/ 439 w 613"/>
                  <a:gd name="T11" fmla="*/ 149 h 729"/>
                  <a:gd name="T12" fmla="*/ 218 w 613"/>
                  <a:gd name="T13" fmla="*/ 81 h 729"/>
                  <a:gd name="T14" fmla="*/ 99 w 613"/>
                  <a:gd name="T15" fmla="*/ 81 h 729"/>
                  <a:gd name="T16" fmla="*/ 0 w 613"/>
                  <a:gd name="T17" fmla="*/ 0 h 729"/>
                  <a:gd name="T18" fmla="*/ 203 w 613"/>
                  <a:gd name="T19" fmla="*/ 0 h 729"/>
                  <a:gd name="T20" fmla="*/ 514 w 613"/>
                  <a:gd name="T21" fmla="*/ 88 h 729"/>
                  <a:gd name="T22" fmla="*/ 613 w 613"/>
                  <a:gd name="T23" fmla="*/ 364 h 729"/>
                  <a:gd name="T24" fmla="*/ 513 w 613"/>
                  <a:gd name="T25" fmla="*/ 641 h 729"/>
                  <a:gd name="T26" fmla="*/ 203 w 613"/>
                  <a:gd name="T27" fmla="*/ 729 h 729"/>
                  <a:gd name="T28" fmla="*/ 0 w 613"/>
                  <a:gd name="T29" fmla="*/ 729 h 729"/>
                  <a:gd name="T30" fmla="*/ 0 w 613"/>
                  <a:gd name="T31" fmla="*/ 0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613" h="729">
                    <a:moveTo>
                      <a:pt x="99" y="81"/>
                    </a:moveTo>
                    <a:lnTo>
                      <a:pt x="99" y="648"/>
                    </a:lnTo>
                    <a:lnTo>
                      <a:pt x="218" y="648"/>
                    </a:lnTo>
                    <a:cubicBezTo>
                      <a:pt x="318" y="648"/>
                      <a:pt x="392" y="626"/>
                      <a:pt x="439" y="580"/>
                    </a:cubicBezTo>
                    <a:cubicBezTo>
                      <a:pt x="485" y="534"/>
                      <a:pt x="509" y="462"/>
                      <a:pt x="509" y="364"/>
                    </a:cubicBezTo>
                    <a:cubicBezTo>
                      <a:pt x="509" y="266"/>
                      <a:pt x="485" y="195"/>
                      <a:pt x="439" y="149"/>
                    </a:cubicBezTo>
                    <a:cubicBezTo>
                      <a:pt x="392" y="104"/>
                      <a:pt x="318" y="81"/>
                      <a:pt x="218" y="81"/>
                    </a:cubicBezTo>
                    <a:lnTo>
                      <a:pt x="99" y="81"/>
                    </a:lnTo>
                    <a:close/>
                    <a:moveTo>
                      <a:pt x="0" y="0"/>
                    </a:moveTo>
                    <a:lnTo>
                      <a:pt x="203" y="0"/>
                    </a:lnTo>
                    <a:cubicBezTo>
                      <a:pt x="344" y="0"/>
                      <a:pt x="448" y="30"/>
                      <a:pt x="514" y="88"/>
                    </a:cubicBezTo>
                    <a:cubicBezTo>
                      <a:pt x="580" y="147"/>
                      <a:pt x="613" y="239"/>
                      <a:pt x="613" y="364"/>
                    </a:cubicBezTo>
                    <a:cubicBezTo>
                      <a:pt x="613" y="490"/>
                      <a:pt x="579" y="582"/>
                      <a:pt x="513" y="641"/>
                    </a:cubicBezTo>
                    <a:cubicBezTo>
                      <a:pt x="447" y="700"/>
                      <a:pt x="343" y="729"/>
                      <a:pt x="203" y="729"/>
                    </a:cubicBezTo>
                    <a:lnTo>
                      <a:pt x="0" y="729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2" name="Freeform 82">
                <a:extLst>
                  <a:ext uri="{FF2B5EF4-FFF2-40B4-BE49-F238E27FC236}">
                    <a16:creationId xmlns:a16="http://schemas.microsoft.com/office/drawing/2014/main" id="{7CF0D692-F139-023E-2FF2-524560D8541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48192" y="2767060"/>
                <a:ext cx="14730" cy="57219"/>
              </a:xfrm>
              <a:custGeom>
                <a:avLst/>
                <a:gdLst>
                  <a:gd name="T0" fmla="*/ 0 w 224"/>
                  <a:gd name="T1" fmla="*/ 0 h 890"/>
                  <a:gd name="T2" fmla="*/ 78 w 224"/>
                  <a:gd name="T3" fmla="*/ 0 h 890"/>
                  <a:gd name="T4" fmla="*/ 187 w 224"/>
                  <a:gd name="T5" fmla="*/ 226 h 890"/>
                  <a:gd name="T6" fmla="*/ 224 w 224"/>
                  <a:gd name="T7" fmla="*/ 445 h 890"/>
                  <a:gd name="T8" fmla="*/ 187 w 224"/>
                  <a:gd name="T9" fmla="*/ 665 h 890"/>
                  <a:gd name="T10" fmla="*/ 78 w 224"/>
                  <a:gd name="T11" fmla="*/ 890 h 890"/>
                  <a:gd name="T12" fmla="*/ 0 w 224"/>
                  <a:gd name="T13" fmla="*/ 890 h 890"/>
                  <a:gd name="T14" fmla="*/ 97 w 224"/>
                  <a:gd name="T15" fmla="*/ 668 h 890"/>
                  <a:gd name="T16" fmla="*/ 129 w 224"/>
                  <a:gd name="T17" fmla="*/ 445 h 890"/>
                  <a:gd name="T18" fmla="*/ 97 w 224"/>
                  <a:gd name="T19" fmla="*/ 223 h 890"/>
                  <a:gd name="T20" fmla="*/ 0 w 224"/>
                  <a:gd name="T21" fmla="*/ 0 h 8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224" h="890">
                    <a:moveTo>
                      <a:pt x="0" y="0"/>
                    </a:moveTo>
                    <a:lnTo>
                      <a:pt x="78" y="0"/>
                    </a:lnTo>
                    <a:cubicBezTo>
                      <a:pt x="126" y="77"/>
                      <a:pt x="163" y="152"/>
                      <a:pt x="187" y="226"/>
                    </a:cubicBezTo>
                    <a:cubicBezTo>
                      <a:pt x="211" y="300"/>
                      <a:pt x="224" y="373"/>
                      <a:pt x="224" y="445"/>
                    </a:cubicBezTo>
                    <a:cubicBezTo>
                      <a:pt x="224" y="518"/>
                      <a:pt x="211" y="591"/>
                      <a:pt x="187" y="665"/>
                    </a:cubicBezTo>
                    <a:cubicBezTo>
                      <a:pt x="163" y="739"/>
                      <a:pt x="126" y="813"/>
                      <a:pt x="78" y="890"/>
                    </a:cubicBezTo>
                    <a:lnTo>
                      <a:pt x="0" y="890"/>
                    </a:lnTo>
                    <a:cubicBezTo>
                      <a:pt x="43" y="815"/>
                      <a:pt x="75" y="742"/>
                      <a:pt x="97" y="668"/>
                    </a:cubicBezTo>
                    <a:cubicBezTo>
                      <a:pt x="118" y="595"/>
                      <a:pt x="129" y="521"/>
                      <a:pt x="129" y="445"/>
                    </a:cubicBezTo>
                    <a:cubicBezTo>
                      <a:pt x="129" y="370"/>
                      <a:pt x="118" y="296"/>
                      <a:pt x="97" y="223"/>
                    </a:cubicBezTo>
                    <a:cubicBezTo>
                      <a:pt x="75" y="150"/>
                      <a:pt x="43" y="76"/>
                      <a:pt x="0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3" name="Rectangle 1282">
                <a:extLst>
                  <a:ext uri="{FF2B5EF4-FFF2-40B4-BE49-F238E27FC236}">
                    <a16:creationId xmlns:a16="http://schemas.microsoft.com/office/drawing/2014/main" id="{FC975211-DED6-75D6-2F26-AE8BAB8E03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43044" y="2865636"/>
                <a:ext cx="128602" cy="44756"/>
              </a:xfrm>
              <a:prstGeom prst="rect">
                <a:avLst/>
              </a:prstGeom>
              <a:solidFill>
                <a:srgbClr val="B55D60"/>
              </a:solidFill>
              <a:ln w="17463" cap="flat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17463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4" name="Rectangle 1283">
                <a:extLst>
                  <a:ext uri="{FF2B5EF4-FFF2-40B4-BE49-F238E27FC236}">
                    <a16:creationId xmlns:a16="http://schemas.microsoft.com/office/drawing/2014/main" id="{05AC6C22-4E92-4BCF-E5A4-388917E4F1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43044" y="2865636"/>
                <a:ext cx="128602" cy="44756"/>
              </a:xfrm>
              <a:prstGeom prst="rect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5" name="Freeform 85">
                <a:extLst>
                  <a:ext uri="{FF2B5EF4-FFF2-40B4-BE49-F238E27FC236}">
                    <a16:creationId xmlns:a16="http://schemas.microsoft.com/office/drawing/2014/main" id="{32B75C17-F92D-D865-37EC-4B9A7005BFE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459490" y="2862803"/>
                <a:ext cx="37957" cy="48721"/>
              </a:xfrm>
              <a:custGeom>
                <a:avLst/>
                <a:gdLst>
                  <a:gd name="T0" fmla="*/ 588 w 588"/>
                  <a:gd name="T1" fmla="*/ 69 h 755"/>
                  <a:gd name="T2" fmla="*/ 588 w 588"/>
                  <a:gd name="T3" fmla="*/ 173 h 755"/>
                  <a:gd name="T4" fmla="*/ 481 w 588"/>
                  <a:gd name="T5" fmla="*/ 104 h 755"/>
                  <a:gd name="T6" fmla="*/ 362 w 588"/>
                  <a:gd name="T7" fmla="*/ 81 h 755"/>
                  <a:gd name="T8" fmla="*/ 170 w 588"/>
                  <a:gd name="T9" fmla="*/ 158 h 755"/>
                  <a:gd name="T10" fmla="*/ 104 w 588"/>
                  <a:gd name="T11" fmla="*/ 378 h 755"/>
                  <a:gd name="T12" fmla="*/ 170 w 588"/>
                  <a:gd name="T13" fmla="*/ 599 h 755"/>
                  <a:gd name="T14" fmla="*/ 362 w 588"/>
                  <a:gd name="T15" fmla="*/ 675 h 755"/>
                  <a:gd name="T16" fmla="*/ 481 w 588"/>
                  <a:gd name="T17" fmla="*/ 652 h 755"/>
                  <a:gd name="T18" fmla="*/ 588 w 588"/>
                  <a:gd name="T19" fmla="*/ 583 h 755"/>
                  <a:gd name="T20" fmla="*/ 588 w 588"/>
                  <a:gd name="T21" fmla="*/ 686 h 755"/>
                  <a:gd name="T22" fmla="*/ 478 w 588"/>
                  <a:gd name="T23" fmla="*/ 738 h 755"/>
                  <a:gd name="T24" fmla="*/ 356 w 588"/>
                  <a:gd name="T25" fmla="*/ 755 h 755"/>
                  <a:gd name="T26" fmla="*/ 95 w 588"/>
                  <a:gd name="T27" fmla="*/ 655 h 755"/>
                  <a:gd name="T28" fmla="*/ 0 w 588"/>
                  <a:gd name="T29" fmla="*/ 378 h 755"/>
                  <a:gd name="T30" fmla="*/ 95 w 588"/>
                  <a:gd name="T31" fmla="*/ 101 h 755"/>
                  <a:gd name="T32" fmla="*/ 356 w 588"/>
                  <a:gd name="T33" fmla="*/ 0 h 755"/>
                  <a:gd name="T34" fmla="*/ 479 w 588"/>
                  <a:gd name="T35" fmla="*/ 17 h 755"/>
                  <a:gd name="T36" fmla="*/ 588 w 588"/>
                  <a:gd name="T37" fmla="*/ 69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588" h="755">
                    <a:moveTo>
                      <a:pt x="588" y="69"/>
                    </a:moveTo>
                    <a:lnTo>
                      <a:pt x="588" y="173"/>
                    </a:lnTo>
                    <a:cubicBezTo>
                      <a:pt x="554" y="143"/>
                      <a:pt x="519" y="120"/>
                      <a:pt x="481" y="104"/>
                    </a:cubicBezTo>
                    <a:cubicBezTo>
                      <a:pt x="443" y="89"/>
                      <a:pt x="404" y="81"/>
                      <a:pt x="362" y="81"/>
                    </a:cubicBezTo>
                    <a:cubicBezTo>
                      <a:pt x="278" y="81"/>
                      <a:pt x="214" y="107"/>
                      <a:pt x="170" y="158"/>
                    </a:cubicBezTo>
                    <a:cubicBezTo>
                      <a:pt x="126" y="209"/>
                      <a:pt x="104" y="282"/>
                      <a:pt x="104" y="378"/>
                    </a:cubicBezTo>
                    <a:cubicBezTo>
                      <a:pt x="104" y="474"/>
                      <a:pt x="126" y="548"/>
                      <a:pt x="170" y="599"/>
                    </a:cubicBezTo>
                    <a:cubicBezTo>
                      <a:pt x="214" y="650"/>
                      <a:pt x="278" y="675"/>
                      <a:pt x="362" y="675"/>
                    </a:cubicBezTo>
                    <a:cubicBezTo>
                      <a:pt x="404" y="675"/>
                      <a:pt x="443" y="668"/>
                      <a:pt x="481" y="652"/>
                    </a:cubicBezTo>
                    <a:cubicBezTo>
                      <a:pt x="519" y="637"/>
                      <a:pt x="554" y="614"/>
                      <a:pt x="588" y="583"/>
                    </a:cubicBezTo>
                    <a:lnTo>
                      <a:pt x="588" y="686"/>
                    </a:lnTo>
                    <a:cubicBezTo>
                      <a:pt x="553" y="710"/>
                      <a:pt x="516" y="727"/>
                      <a:pt x="478" y="738"/>
                    </a:cubicBezTo>
                    <a:cubicBezTo>
                      <a:pt x="440" y="749"/>
                      <a:pt x="399" y="755"/>
                      <a:pt x="356" y="755"/>
                    </a:cubicBezTo>
                    <a:cubicBezTo>
                      <a:pt x="246" y="755"/>
                      <a:pt x="159" y="722"/>
                      <a:pt x="95" y="655"/>
                    </a:cubicBezTo>
                    <a:cubicBezTo>
                      <a:pt x="31" y="588"/>
                      <a:pt x="0" y="496"/>
                      <a:pt x="0" y="378"/>
                    </a:cubicBezTo>
                    <a:cubicBezTo>
                      <a:pt x="0" y="261"/>
                      <a:pt x="31" y="169"/>
                      <a:pt x="95" y="101"/>
                    </a:cubicBezTo>
                    <a:cubicBezTo>
                      <a:pt x="159" y="34"/>
                      <a:pt x="246" y="0"/>
                      <a:pt x="356" y="0"/>
                    </a:cubicBezTo>
                    <a:cubicBezTo>
                      <a:pt x="400" y="0"/>
                      <a:pt x="441" y="6"/>
                      <a:pt x="479" y="17"/>
                    </a:cubicBezTo>
                    <a:cubicBezTo>
                      <a:pt x="517" y="29"/>
                      <a:pt x="554" y="46"/>
                      <a:pt x="588" y="6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6" name="Freeform 86">
                <a:extLst>
                  <a:ext uri="{FF2B5EF4-FFF2-40B4-BE49-F238E27FC236}">
                    <a16:creationId xmlns:a16="http://schemas.microsoft.com/office/drawing/2014/main" id="{322A163B-D35D-3178-2002-9FA29CF8002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414734" y="2874700"/>
                <a:ext cx="32859" cy="36824"/>
              </a:xfrm>
              <a:custGeom>
                <a:avLst/>
                <a:gdLst>
                  <a:gd name="T0" fmla="*/ 507 w 507"/>
                  <a:gd name="T1" fmla="*/ 264 h 573"/>
                  <a:gd name="T2" fmla="*/ 507 w 507"/>
                  <a:gd name="T3" fmla="*/ 308 h 573"/>
                  <a:gd name="T4" fmla="*/ 94 w 507"/>
                  <a:gd name="T5" fmla="*/ 308 h 573"/>
                  <a:gd name="T6" fmla="*/ 150 w 507"/>
                  <a:gd name="T7" fmla="*/ 450 h 573"/>
                  <a:gd name="T8" fmla="*/ 289 w 507"/>
                  <a:gd name="T9" fmla="*/ 498 h 573"/>
                  <a:gd name="T10" fmla="*/ 389 w 507"/>
                  <a:gd name="T11" fmla="*/ 486 h 573"/>
                  <a:gd name="T12" fmla="*/ 486 w 507"/>
                  <a:gd name="T13" fmla="*/ 447 h 573"/>
                  <a:gd name="T14" fmla="*/ 486 w 507"/>
                  <a:gd name="T15" fmla="*/ 532 h 573"/>
                  <a:gd name="T16" fmla="*/ 387 w 507"/>
                  <a:gd name="T17" fmla="*/ 563 h 573"/>
                  <a:gd name="T18" fmla="*/ 284 w 507"/>
                  <a:gd name="T19" fmla="*/ 573 h 573"/>
                  <a:gd name="T20" fmla="*/ 76 w 507"/>
                  <a:gd name="T21" fmla="*/ 498 h 573"/>
                  <a:gd name="T22" fmla="*/ 0 w 507"/>
                  <a:gd name="T23" fmla="*/ 292 h 573"/>
                  <a:gd name="T24" fmla="*/ 72 w 507"/>
                  <a:gd name="T25" fmla="*/ 79 h 573"/>
                  <a:gd name="T26" fmla="*/ 268 w 507"/>
                  <a:gd name="T27" fmla="*/ 0 h 573"/>
                  <a:gd name="T28" fmla="*/ 443 w 507"/>
                  <a:gd name="T29" fmla="*/ 71 h 573"/>
                  <a:gd name="T30" fmla="*/ 507 w 507"/>
                  <a:gd name="T31" fmla="*/ 264 h 573"/>
                  <a:gd name="T32" fmla="*/ 417 w 507"/>
                  <a:gd name="T33" fmla="*/ 238 h 573"/>
                  <a:gd name="T34" fmla="*/ 376 w 507"/>
                  <a:gd name="T35" fmla="*/ 120 h 573"/>
                  <a:gd name="T36" fmla="*/ 269 w 507"/>
                  <a:gd name="T37" fmla="*/ 76 h 573"/>
                  <a:gd name="T38" fmla="*/ 149 w 507"/>
                  <a:gd name="T39" fmla="*/ 119 h 573"/>
                  <a:gd name="T40" fmla="*/ 97 w 507"/>
                  <a:gd name="T41" fmla="*/ 238 h 573"/>
                  <a:gd name="T42" fmla="*/ 417 w 507"/>
                  <a:gd name="T43" fmla="*/ 23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07" h="573">
                    <a:moveTo>
                      <a:pt x="507" y="264"/>
                    </a:moveTo>
                    <a:lnTo>
                      <a:pt x="507" y="308"/>
                    </a:lnTo>
                    <a:lnTo>
                      <a:pt x="94" y="308"/>
                    </a:lnTo>
                    <a:cubicBezTo>
                      <a:pt x="98" y="370"/>
                      <a:pt x="116" y="418"/>
                      <a:pt x="150" y="450"/>
                    </a:cubicBezTo>
                    <a:cubicBezTo>
                      <a:pt x="183" y="482"/>
                      <a:pt x="229" y="498"/>
                      <a:pt x="289" y="498"/>
                    </a:cubicBezTo>
                    <a:cubicBezTo>
                      <a:pt x="323" y="498"/>
                      <a:pt x="357" y="494"/>
                      <a:pt x="389" y="486"/>
                    </a:cubicBezTo>
                    <a:cubicBezTo>
                      <a:pt x="421" y="478"/>
                      <a:pt x="454" y="465"/>
                      <a:pt x="486" y="447"/>
                    </a:cubicBezTo>
                    <a:lnTo>
                      <a:pt x="486" y="532"/>
                    </a:lnTo>
                    <a:cubicBezTo>
                      <a:pt x="454" y="546"/>
                      <a:pt x="421" y="557"/>
                      <a:pt x="387" y="563"/>
                    </a:cubicBezTo>
                    <a:cubicBezTo>
                      <a:pt x="353" y="569"/>
                      <a:pt x="318" y="573"/>
                      <a:pt x="284" y="573"/>
                    </a:cubicBezTo>
                    <a:cubicBezTo>
                      <a:pt x="196" y="573"/>
                      <a:pt x="127" y="548"/>
                      <a:pt x="76" y="498"/>
                    </a:cubicBezTo>
                    <a:cubicBezTo>
                      <a:pt x="25" y="448"/>
                      <a:pt x="0" y="379"/>
                      <a:pt x="0" y="292"/>
                    </a:cubicBezTo>
                    <a:cubicBezTo>
                      <a:pt x="0" y="203"/>
                      <a:pt x="24" y="132"/>
                      <a:pt x="72" y="79"/>
                    </a:cubicBezTo>
                    <a:cubicBezTo>
                      <a:pt x="120" y="27"/>
                      <a:pt x="186" y="0"/>
                      <a:pt x="268" y="0"/>
                    </a:cubicBezTo>
                    <a:cubicBezTo>
                      <a:pt x="342" y="0"/>
                      <a:pt x="400" y="24"/>
                      <a:pt x="443" y="71"/>
                    </a:cubicBezTo>
                    <a:cubicBezTo>
                      <a:pt x="485" y="119"/>
                      <a:pt x="507" y="183"/>
                      <a:pt x="507" y="264"/>
                    </a:cubicBezTo>
                    <a:close/>
                    <a:moveTo>
                      <a:pt x="417" y="238"/>
                    </a:moveTo>
                    <a:cubicBezTo>
                      <a:pt x="416" y="189"/>
                      <a:pt x="402" y="150"/>
                      <a:pt x="376" y="120"/>
                    </a:cubicBezTo>
                    <a:cubicBezTo>
                      <a:pt x="349" y="91"/>
                      <a:pt x="313" y="76"/>
                      <a:pt x="269" y="76"/>
                    </a:cubicBezTo>
                    <a:cubicBezTo>
                      <a:pt x="219" y="76"/>
                      <a:pt x="179" y="91"/>
                      <a:pt x="149" y="119"/>
                    </a:cubicBezTo>
                    <a:cubicBezTo>
                      <a:pt x="119" y="147"/>
                      <a:pt x="101" y="187"/>
                      <a:pt x="97" y="238"/>
                    </a:cubicBezTo>
                    <a:lnTo>
                      <a:pt x="417" y="238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7" name="Rectangle 1286">
                <a:extLst>
                  <a:ext uri="{FF2B5EF4-FFF2-40B4-BE49-F238E27FC236}">
                    <a16:creationId xmlns:a16="http://schemas.microsoft.com/office/drawing/2014/main" id="{4A7D23B9-80D6-7412-1461-37F29C4B8A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72245" y="2861670"/>
                <a:ext cx="5665" cy="48721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8" name="Rectangle 1287">
                <a:extLst>
                  <a:ext uri="{FF2B5EF4-FFF2-40B4-BE49-F238E27FC236}">
                    <a16:creationId xmlns:a16="http://schemas.microsoft.com/office/drawing/2014/main" id="{DFBB9713-A2CA-BB6C-1710-D2A10F94DA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4682" y="2861670"/>
                <a:ext cx="5665" cy="48721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9" name="Freeform 89">
                <a:extLst>
                  <a:ext uri="{FF2B5EF4-FFF2-40B4-BE49-F238E27FC236}">
                    <a16:creationId xmlns:a16="http://schemas.microsoft.com/office/drawing/2014/main" id="{75C21A0F-C3BB-DD6F-D66C-13A61E1741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338253" y="2862803"/>
                <a:ext cx="32859" cy="48721"/>
              </a:xfrm>
              <a:custGeom>
                <a:avLst/>
                <a:gdLst>
                  <a:gd name="T0" fmla="*/ 469 w 513"/>
                  <a:gd name="T1" fmla="*/ 37 h 755"/>
                  <a:gd name="T2" fmla="*/ 469 w 513"/>
                  <a:gd name="T3" fmla="*/ 133 h 755"/>
                  <a:gd name="T4" fmla="*/ 363 w 513"/>
                  <a:gd name="T5" fmla="*/ 93 h 755"/>
                  <a:gd name="T6" fmla="*/ 267 w 513"/>
                  <a:gd name="T7" fmla="*/ 80 h 755"/>
                  <a:gd name="T8" fmla="*/ 142 w 513"/>
                  <a:gd name="T9" fmla="*/ 111 h 755"/>
                  <a:gd name="T10" fmla="*/ 99 w 513"/>
                  <a:gd name="T11" fmla="*/ 200 h 755"/>
                  <a:gd name="T12" fmla="*/ 128 w 513"/>
                  <a:gd name="T13" fmla="*/ 273 h 755"/>
                  <a:gd name="T14" fmla="*/ 238 w 513"/>
                  <a:gd name="T15" fmla="*/ 313 h 755"/>
                  <a:gd name="T16" fmla="*/ 298 w 513"/>
                  <a:gd name="T17" fmla="*/ 325 h 755"/>
                  <a:gd name="T18" fmla="*/ 460 w 513"/>
                  <a:gd name="T19" fmla="*/ 399 h 755"/>
                  <a:gd name="T20" fmla="*/ 513 w 513"/>
                  <a:gd name="T21" fmla="*/ 541 h 755"/>
                  <a:gd name="T22" fmla="*/ 442 w 513"/>
                  <a:gd name="T23" fmla="*/ 701 h 755"/>
                  <a:gd name="T24" fmla="*/ 234 w 513"/>
                  <a:gd name="T25" fmla="*/ 755 h 755"/>
                  <a:gd name="T26" fmla="*/ 123 w 513"/>
                  <a:gd name="T27" fmla="*/ 744 h 755"/>
                  <a:gd name="T28" fmla="*/ 3 w 513"/>
                  <a:gd name="T29" fmla="*/ 710 h 755"/>
                  <a:gd name="T30" fmla="*/ 3 w 513"/>
                  <a:gd name="T31" fmla="*/ 608 h 755"/>
                  <a:gd name="T32" fmla="*/ 120 w 513"/>
                  <a:gd name="T33" fmla="*/ 659 h 755"/>
                  <a:gd name="T34" fmla="*/ 234 w 513"/>
                  <a:gd name="T35" fmla="*/ 676 h 755"/>
                  <a:gd name="T36" fmla="*/ 364 w 513"/>
                  <a:gd name="T37" fmla="*/ 643 h 755"/>
                  <a:gd name="T38" fmla="*/ 410 w 513"/>
                  <a:gd name="T39" fmla="*/ 548 h 755"/>
                  <a:gd name="T40" fmla="*/ 377 w 513"/>
                  <a:gd name="T41" fmla="*/ 464 h 755"/>
                  <a:gd name="T42" fmla="*/ 269 w 513"/>
                  <a:gd name="T43" fmla="*/ 419 h 755"/>
                  <a:gd name="T44" fmla="*/ 209 w 513"/>
                  <a:gd name="T45" fmla="*/ 407 h 755"/>
                  <a:gd name="T46" fmla="*/ 49 w 513"/>
                  <a:gd name="T47" fmla="*/ 338 h 755"/>
                  <a:gd name="T48" fmla="*/ 0 w 513"/>
                  <a:gd name="T49" fmla="*/ 208 h 755"/>
                  <a:gd name="T50" fmla="*/ 68 w 513"/>
                  <a:gd name="T51" fmla="*/ 56 h 755"/>
                  <a:gd name="T52" fmla="*/ 256 w 513"/>
                  <a:gd name="T53" fmla="*/ 0 h 755"/>
                  <a:gd name="T54" fmla="*/ 360 w 513"/>
                  <a:gd name="T55" fmla="*/ 9 h 755"/>
                  <a:gd name="T56" fmla="*/ 469 w 513"/>
                  <a:gd name="T57" fmla="*/ 37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513" h="755">
                    <a:moveTo>
                      <a:pt x="469" y="37"/>
                    </a:moveTo>
                    <a:lnTo>
                      <a:pt x="469" y="133"/>
                    </a:lnTo>
                    <a:cubicBezTo>
                      <a:pt x="431" y="115"/>
                      <a:pt x="396" y="102"/>
                      <a:pt x="363" y="93"/>
                    </a:cubicBezTo>
                    <a:cubicBezTo>
                      <a:pt x="329" y="85"/>
                      <a:pt x="297" y="80"/>
                      <a:pt x="267" y="80"/>
                    </a:cubicBezTo>
                    <a:cubicBezTo>
                      <a:pt x="213" y="80"/>
                      <a:pt x="171" y="91"/>
                      <a:pt x="142" y="111"/>
                    </a:cubicBezTo>
                    <a:cubicBezTo>
                      <a:pt x="113" y="132"/>
                      <a:pt x="99" y="162"/>
                      <a:pt x="99" y="200"/>
                    </a:cubicBezTo>
                    <a:cubicBezTo>
                      <a:pt x="99" y="232"/>
                      <a:pt x="108" y="257"/>
                      <a:pt x="128" y="273"/>
                    </a:cubicBezTo>
                    <a:cubicBezTo>
                      <a:pt x="147" y="290"/>
                      <a:pt x="184" y="303"/>
                      <a:pt x="238" y="313"/>
                    </a:cubicBezTo>
                    <a:lnTo>
                      <a:pt x="298" y="325"/>
                    </a:lnTo>
                    <a:cubicBezTo>
                      <a:pt x="371" y="339"/>
                      <a:pt x="425" y="364"/>
                      <a:pt x="460" y="399"/>
                    </a:cubicBezTo>
                    <a:cubicBezTo>
                      <a:pt x="495" y="435"/>
                      <a:pt x="513" y="482"/>
                      <a:pt x="513" y="541"/>
                    </a:cubicBezTo>
                    <a:cubicBezTo>
                      <a:pt x="513" y="612"/>
                      <a:pt x="489" y="665"/>
                      <a:pt x="442" y="701"/>
                    </a:cubicBezTo>
                    <a:cubicBezTo>
                      <a:pt x="394" y="737"/>
                      <a:pt x="325" y="755"/>
                      <a:pt x="234" y="755"/>
                    </a:cubicBezTo>
                    <a:cubicBezTo>
                      <a:pt x="199" y="755"/>
                      <a:pt x="162" y="751"/>
                      <a:pt x="123" y="744"/>
                    </a:cubicBezTo>
                    <a:cubicBezTo>
                      <a:pt x="84" y="737"/>
                      <a:pt x="44" y="726"/>
                      <a:pt x="3" y="710"/>
                    </a:cubicBezTo>
                    <a:lnTo>
                      <a:pt x="3" y="608"/>
                    </a:lnTo>
                    <a:cubicBezTo>
                      <a:pt x="43" y="631"/>
                      <a:pt x="82" y="648"/>
                      <a:pt x="120" y="659"/>
                    </a:cubicBezTo>
                    <a:cubicBezTo>
                      <a:pt x="158" y="671"/>
                      <a:pt x="196" y="676"/>
                      <a:pt x="234" y="676"/>
                    </a:cubicBezTo>
                    <a:cubicBezTo>
                      <a:pt x="290" y="676"/>
                      <a:pt x="333" y="665"/>
                      <a:pt x="364" y="643"/>
                    </a:cubicBezTo>
                    <a:cubicBezTo>
                      <a:pt x="394" y="621"/>
                      <a:pt x="410" y="590"/>
                      <a:pt x="410" y="548"/>
                    </a:cubicBezTo>
                    <a:cubicBezTo>
                      <a:pt x="410" y="512"/>
                      <a:pt x="399" y="484"/>
                      <a:pt x="377" y="464"/>
                    </a:cubicBezTo>
                    <a:cubicBezTo>
                      <a:pt x="355" y="444"/>
                      <a:pt x="319" y="429"/>
                      <a:pt x="269" y="419"/>
                    </a:cubicBezTo>
                    <a:lnTo>
                      <a:pt x="209" y="407"/>
                    </a:lnTo>
                    <a:cubicBezTo>
                      <a:pt x="135" y="393"/>
                      <a:pt x="82" y="370"/>
                      <a:pt x="49" y="338"/>
                    </a:cubicBezTo>
                    <a:cubicBezTo>
                      <a:pt x="16" y="307"/>
                      <a:pt x="0" y="264"/>
                      <a:pt x="0" y="208"/>
                    </a:cubicBezTo>
                    <a:cubicBezTo>
                      <a:pt x="0" y="144"/>
                      <a:pt x="22" y="93"/>
                      <a:pt x="68" y="56"/>
                    </a:cubicBezTo>
                    <a:cubicBezTo>
                      <a:pt x="113" y="19"/>
                      <a:pt x="176" y="0"/>
                      <a:pt x="256" y="0"/>
                    </a:cubicBezTo>
                    <a:cubicBezTo>
                      <a:pt x="290" y="0"/>
                      <a:pt x="324" y="3"/>
                      <a:pt x="360" y="9"/>
                    </a:cubicBezTo>
                    <a:cubicBezTo>
                      <a:pt x="395" y="15"/>
                      <a:pt x="431" y="25"/>
                      <a:pt x="469" y="37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0" name="Freeform 90">
                <a:extLst>
                  <a:ext uri="{FF2B5EF4-FFF2-40B4-BE49-F238E27FC236}">
                    <a16:creationId xmlns:a16="http://schemas.microsoft.com/office/drawing/2014/main" id="{2F809454-7A50-F012-401B-427F3E8155C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295763" y="2874700"/>
                <a:ext cx="29459" cy="35691"/>
              </a:xfrm>
              <a:custGeom>
                <a:avLst/>
                <a:gdLst>
                  <a:gd name="T0" fmla="*/ 458 w 458"/>
                  <a:gd name="T1" fmla="*/ 230 h 560"/>
                  <a:gd name="T2" fmla="*/ 458 w 458"/>
                  <a:gd name="T3" fmla="*/ 560 h 560"/>
                  <a:gd name="T4" fmla="*/ 368 w 458"/>
                  <a:gd name="T5" fmla="*/ 560 h 560"/>
                  <a:gd name="T6" fmla="*/ 368 w 458"/>
                  <a:gd name="T7" fmla="*/ 233 h 560"/>
                  <a:gd name="T8" fmla="*/ 337 w 458"/>
                  <a:gd name="T9" fmla="*/ 117 h 560"/>
                  <a:gd name="T10" fmla="*/ 247 w 458"/>
                  <a:gd name="T11" fmla="*/ 78 h 560"/>
                  <a:gd name="T12" fmla="*/ 132 w 458"/>
                  <a:gd name="T13" fmla="*/ 125 h 560"/>
                  <a:gd name="T14" fmla="*/ 90 w 458"/>
                  <a:gd name="T15" fmla="*/ 251 h 560"/>
                  <a:gd name="T16" fmla="*/ 90 w 458"/>
                  <a:gd name="T17" fmla="*/ 560 h 560"/>
                  <a:gd name="T18" fmla="*/ 0 w 458"/>
                  <a:gd name="T19" fmla="*/ 560 h 560"/>
                  <a:gd name="T20" fmla="*/ 0 w 458"/>
                  <a:gd name="T21" fmla="*/ 13 h 560"/>
                  <a:gd name="T22" fmla="*/ 90 w 458"/>
                  <a:gd name="T23" fmla="*/ 13 h 560"/>
                  <a:gd name="T24" fmla="*/ 90 w 458"/>
                  <a:gd name="T25" fmla="*/ 98 h 560"/>
                  <a:gd name="T26" fmla="*/ 166 w 458"/>
                  <a:gd name="T27" fmla="*/ 25 h 560"/>
                  <a:gd name="T28" fmla="*/ 267 w 458"/>
                  <a:gd name="T29" fmla="*/ 0 h 560"/>
                  <a:gd name="T30" fmla="*/ 409 w 458"/>
                  <a:gd name="T31" fmla="*/ 59 h 560"/>
                  <a:gd name="T32" fmla="*/ 458 w 458"/>
                  <a:gd name="T33" fmla="*/ 230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58" h="560">
                    <a:moveTo>
                      <a:pt x="458" y="230"/>
                    </a:moveTo>
                    <a:lnTo>
                      <a:pt x="458" y="560"/>
                    </a:lnTo>
                    <a:lnTo>
                      <a:pt x="368" y="560"/>
                    </a:lnTo>
                    <a:lnTo>
                      <a:pt x="368" y="233"/>
                    </a:lnTo>
                    <a:cubicBezTo>
                      <a:pt x="368" y="181"/>
                      <a:pt x="357" y="143"/>
                      <a:pt x="337" y="117"/>
                    </a:cubicBezTo>
                    <a:cubicBezTo>
                      <a:pt x="317" y="91"/>
                      <a:pt x="287" y="78"/>
                      <a:pt x="247" y="78"/>
                    </a:cubicBezTo>
                    <a:cubicBezTo>
                      <a:pt x="198" y="78"/>
                      <a:pt x="160" y="94"/>
                      <a:pt x="132" y="125"/>
                    </a:cubicBezTo>
                    <a:cubicBezTo>
                      <a:pt x="104" y="156"/>
                      <a:pt x="90" y="198"/>
                      <a:pt x="90" y="251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11" y="66"/>
                      <a:pt x="136" y="41"/>
                      <a:pt x="166" y="25"/>
                    </a:cubicBezTo>
                    <a:cubicBezTo>
                      <a:pt x="195" y="9"/>
                      <a:pt x="229" y="0"/>
                      <a:pt x="267" y="0"/>
                    </a:cubicBezTo>
                    <a:cubicBezTo>
                      <a:pt x="329" y="0"/>
                      <a:pt x="377" y="20"/>
                      <a:pt x="409" y="59"/>
                    </a:cubicBezTo>
                    <a:cubicBezTo>
                      <a:pt x="441" y="98"/>
                      <a:pt x="458" y="155"/>
                      <a:pt x="458" y="23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1" name="Freeform 91">
                <a:extLst>
                  <a:ext uri="{FF2B5EF4-FFF2-40B4-BE49-F238E27FC236}">
                    <a16:creationId xmlns:a16="http://schemas.microsoft.com/office/drawing/2014/main" id="{07B63307-C92E-6BB8-3288-7D2BB516840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257240" y="2874700"/>
                <a:ext cx="30026" cy="36824"/>
              </a:xfrm>
              <a:custGeom>
                <a:avLst/>
                <a:gdLst>
                  <a:gd name="T0" fmla="*/ 283 w 462"/>
                  <a:gd name="T1" fmla="*/ 285 h 573"/>
                  <a:gd name="T2" fmla="*/ 132 w 462"/>
                  <a:gd name="T3" fmla="*/ 310 h 573"/>
                  <a:gd name="T4" fmla="*/ 90 w 462"/>
                  <a:gd name="T5" fmla="*/ 395 h 573"/>
                  <a:gd name="T6" fmla="*/ 121 w 462"/>
                  <a:gd name="T7" fmla="*/ 471 h 573"/>
                  <a:gd name="T8" fmla="*/ 207 w 462"/>
                  <a:gd name="T9" fmla="*/ 499 h 573"/>
                  <a:gd name="T10" fmla="*/ 327 w 462"/>
                  <a:gd name="T11" fmla="*/ 446 h 573"/>
                  <a:gd name="T12" fmla="*/ 372 w 462"/>
                  <a:gd name="T13" fmla="*/ 305 h 573"/>
                  <a:gd name="T14" fmla="*/ 372 w 462"/>
                  <a:gd name="T15" fmla="*/ 285 h 573"/>
                  <a:gd name="T16" fmla="*/ 283 w 462"/>
                  <a:gd name="T17" fmla="*/ 285 h 573"/>
                  <a:gd name="T18" fmla="*/ 462 w 462"/>
                  <a:gd name="T19" fmla="*/ 248 h 573"/>
                  <a:gd name="T20" fmla="*/ 462 w 462"/>
                  <a:gd name="T21" fmla="*/ 560 h 573"/>
                  <a:gd name="T22" fmla="*/ 372 w 462"/>
                  <a:gd name="T23" fmla="*/ 560 h 573"/>
                  <a:gd name="T24" fmla="*/ 372 w 462"/>
                  <a:gd name="T25" fmla="*/ 477 h 573"/>
                  <a:gd name="T26" fmla="*/ 295 w 462"/>
                  <a:gd name="T27" fmla="*/ 550 h 573"/>
                  <a:gd name="T28" fmla="*/ 183 w 462"/>
                  <a:gd name="T29" fmla="*/ 573 h 573"/>
                  <a:gd name="T30" fmla="*/ 49 w 462"/>
                  <a:gd name="T31" fmla="*/ 527 h 573"/>
                  <a:gd name="T32" fmla="*/ 0 w 462"/>
                  <a:gd name="T33" fmla="*/ 401 h 573"/>
                  <a:gd name="T34" fmla="*/ 62 w 462"/>
                  <a:gd name="T35" fmla="*/ 262 h 573"/>
                  <a:gd name="T36" fmla="*/ 246 w 462"/>
                  <a:gd name="T37" fmla="*/ 215 h 573"/>
                  <a:gd name="T38" fmla="*/ 372 w 462"/>
                  <a:gd name="T39" fmla="*/ 215 h 573"/>
                  <a:gd name="T40" fmla="*/ 372 w 462"/>
                  <a:gd name="T41" fmla="*/ 206 h 573"/>
                  <a:gd name="T42" fmla="*/ 331 w 462"/>
                  <a:gd name="T43" fmla="*/ 110 h 573"/>
                  <a:gd name="T44" fmla="*/ 217 w 462"/>
                  <a:gd name="T45" fmla="*/ 76 h 573"/>
                  <a:gd name="T46" fmla="*/ 125 w 462"/>
                  <a:gd name="T47" fmla="*/ 88 h 573"/>
                  <a:gd name="T48" fmla="*/ 40 w 462"/>
                  <a:gd name="T49" fmla="*/ 121 h 573"/>
                  <a:gd name="T50" fmla="*/ 40 w 462"/>
                  <a:gd name="T51" fmla="*/ 38 h 573"/>
                  <a:gd name="T52" fmla="*/ 135 w 462"/>
                  <a:gd name="T53" fmla="*/ 10 h 573"/>
                  <a:gd name="T54" fmla="*/ 226 w 462"/>
                  <a:gd name="T55" fmla="*/ 0 h 573"/>
                  <a:gd name="T56" fmla="*/ 403 w 462"/>
                  <a:gd name="T57" fmla="*/ 62 h 573"/>
                  <a:gd name="T58" fmla="*/ 462 w 462"/>
                  <a:gd name="T59" fmla="*/ 24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462" h="573">
                    <a:moveTo>
                      <a:pt x="283" y="285"/>
                    </a:moveTo>
                    <a:cubicBezTo>
                      <a:pt x="210" y="285"/>
                      <a:pt x="160" y="294"/>
                      <a:pt x="132" y="310"/>
                    </a:cubicBezTo>
                    <a:cubicBezTo>
                      <a:pt x="104" y="327"/>
                      <a:pt x="90" y="355"/>
                      <a:pt x="90" y="395"/>
                    </a:cubicBezTo>
                    <a:cubicBezTo>
                      <a:pt x="90" y="427"/>
                      <a:pt x="100" y="453"/>
                      <a:pt x="121" y="471"/>
                    </a:cubicBezTo>
                    <a:cubicBezTo>
                      <a:pt x="142" y="490"/>
                      <a:pt x="171" y="499"/>
                      <a:pt x="207" y="499"/>
                    </a:cubicBezTo>
                    <a:cubicBezTo>
                      <a:pt x="257" y="499"/>
                      <a:pt x="297" y="482"/>
                      <a:pt x="327" y="446"/>
                    </a:cubicBezTo>
                    <a:cubicBezTo>
                      <a:pt x="357" y="411"/>
                      <a:pt x="372" y="364"/>
                      <a:pt x="372" y="305"/>
                    </a:cubicBezTo>
                    <a:lnTo>
                      <a:pt x="372" y="285"/>
                    </a:lnTo>
                    <a:lnTo>
                      <a:pt x="283" y="285"/>
                    </a:lnTo>
                    <a:close/>
                    <a:moveTo>
                      <a:pt x="462" y="248"/>
                    </a:moveTo>
                    <a:lnTo>
                      <a:pt x="462" y="560"/>
                    </a:lnTo>
                    <a:lnTo>
                      <a:pt x="372" y="560"/>
                    </a:lnTo>
                    <a:lnTo>
                      <a:pt x="372" y="477"/>
                    </a:lnTo>
                    <a:cubicBezTo>
                      <a:pt x="351" y="511"/>
                      <a:pt x="325" y="535"/>
                      <a:pt x="295" y="550"/>
                    </a:cubicBezTo>
                    <a:cubicBezTo>
                      <a:pt x="265" y="565"/>
                      <a:pt x="227" y="573"/>
                      <a:pt x="183" y="573"/>
                    </a:cubicBezTo>
                    <a:cubicBezTo>
                      <a:pt x="127" y="573"/>
                      <a:pt x="82" y="558"/>
                      <a:pt x="49" y="527"/>
                    </a:cubicBezTo>
                    <a:cubicBezTo>
                      <a:pt x="16" y="496"/>
                      <a:pt x="0" y="454"/>
                      <a:pt x="0" y="401"/>
                    </a:cubicBezTo>
                    <a:cubicBezTo>
                      <a:pt x="0" y="340"/>
                      <a:pt x="20" y="294"/>
                      <a:pt x="62" y="262"/>
                    </a:cubicBezTo>
                    <a:cubicBezTo>
                      <a:pt x="103" y="231"/>
                      <a:pt x="164" y="215"/>
                      <a:pt x="246" y="215"/>
                    </a:cubicBezTo>
                    <a:lnTo>
                      <a:pt x="372" y="215"/>
                    </a:lnTo>
                    <a:lnTo>
                      <a:pt x="372" y="206"/>
                    </a:lnTo>
                    <a:cubicBezTo>
                      <a:pt x="372" y="165"/>
                      <a:pt x="358" y="133"/>
                      <a:pt x="331" y="110"/>
                    </a:cubicBezTo>
                    <a:cubicBezTo>
                      <a:pt x="304" y="88"/>
                      <a:pt x="266" y="76"/>
                      <a:pt x="217" y="76"/>
                    </a:cubicBezTo>
                    <a:cubicBezTo>
                      <a:pt x="185" y="76"/>
                      <a:pt x="155" y="80"/>
                      <a:pt x="125" y="88"/>
                    </a:cubicBezTo>
                    <a:cubicBezTo>
                      <a:pt x="95" y="96"/>
                      <a:pt x="67" y="107"/>
                      <a:pt x="40" y="121"/>
                    </a:cubicBezTo>
                    <a:lnTo>
                      <a:pt x="40" y="38"/>
                    </a:lnTo>
                    <a:cubicBezTo>
                      <a:pt x="72" y="26"/>
                      <a:pt x="104" y="16"/>
                      <a:pt x="135" y="10"/>
                    </a:cubicBezTo>
                    <a:cubicBezTo>
                      <a:pt x="166" y="4"/>
                      <a:pt x="196" y="0"/>
                      <a:pt x="226" y="0"/>
                    </a:cubicBezTo>
                    <a:cubicBezTo>
                      <a:pt x="305" y="0"/>
                      <a:pt x="364" y="21"/>
                      <a:pt x="403" y="62"/>
                    </a:cubicBezTo>
                    <a:cubicBezTo>
                      <a:pt x="442" y="103"/>
                      <a:pt x="462" y="165"/>
                      <a:pt x="462" y="24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2" name="Freeform 92">
                <a:extLst>
                  <a:ext uri="{FF2B5EF4-FFF2-40B4-BE49-F238E27FC236}">
                    <a16:creationId xmlns:a16="http://schemas.microsoft.com/office/drawing/2014/main" id="{6962BB04-65B7-05F3-D1B0-C75B11874AC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215883" y="2874700"/>
                <a:ext cx="31725" cy="49288"/>
              </a:xfrm>
              <a:custGeom>
                <a:avLst/>
                <a:gdLst>
                  <a:gd name="T0" fmla="*/ 90 w 490"/>
                  <a:gd name="T1" fmla="*/ 478 h 767"/>
                  <a:gd name="T2" fmla="*/ 90 w 490"/>
                  <a:gd name="T3" fmla="*/ 767 h 767"/>
                  <a:gd name="T4" fmla="*/ 0 w 490"/>
                  <a:gd name="T5" fmla="*/ 767 h 767"/>
                  <a:gd name="T6" fmla="*/ 0 w 490"/>
                  <a:gd name="T7" fmla="*/ 13 h 767"/>
                  <a:gd name="T8" fmla="*/ 90 w 490"/>
                  <a:gd name="T9" fmla="*/ 13 h 767"/>
                  <a:gd name="T10" fmla="*/ 90 w 490"/>
                  <a:gd name="T11" fmla="*/ 96 h 767"/>
                  <a:gd name="T12" fmla="*/ 161 w 490"/>
                  <a:gd name="T13" fmla="*/ 24 h 767"/>
                  <a:gd name="T14" fmla="*/ 265 w 490"/>
                  <a:gd name="T15" fmla="*/ 0 h 767"/>
                  <a:gd name="T16" fmla="*/ 427 w 490"/>
                  <a:gd name="T17" fmla="*/ 79 h 767"/>
                  <a:gd name="T18" fmla="*/ 490 w 490"/>
                  <a:gd name="T19" fmla="*/ 287 h 767"/>
                  <a:gd name="T20" fmla="*/ 427 w 490"/>
                  <a:gd name="T21" fmla="*/ 495 h 767"/>
                  <a:gd name="T22" fmla="*/ 265 w 490"/>
                  <a:gd name="T23" fmla="*/ 573 h 767"/>
                  <a:gd name="T24" fmla="*/ 161 w 490"/>
                  <a:gd name="T25" fmla="*/ 550 h 767"/>
                  <a:gd name="T26" fmla="*/ 90 w 490"/>
                  <a:gd name="T27" fmla="*/ 478 h 767"/>
                  <a:gd name="T28" fmla="*/ 396 w 490"/>
                  <a:gd name="T29" fmla="*/ 287 h 767"/>
                  <a:gd name="T30" fmla="*/ 355 w 490"/>
                  <a:gd name="T31" fmla="*/ 132 h 767"/>
                  <a:gd name="T32" fmla="*/ 243 w 490"/>
                  <a:gd name="T33" fmla="*/ 75 h 767"/>
                  <a:gd name="T34" fmla="*/ 131 w 490"/>
                  <a:gd name="T35" fmla="*/ 132 h 767"/>
                  <a:gd name="T36" fmla="*/ 90 w 490"/>
                  <a:gd name="T37" fmla="*/ 287 h 767"/>
                  <a:gd name="T38" fmla="*/ 131 w 490"/>
                  <a:gd name="T39" fmla="*/ 443 h 767"/>
                  <a:gd name="T40" fmla="*/ 243 w 490"/>
                  <a:gd name="T41" fmla="*/ 499 h 767"/>
                  <a:gd name="T42" fmla="*/ 355 w 490"/>
                  <a:gd name="T43" fmla="*/ 443 h 767"/>
                  <a:gd name="T44" fmla="*/ 396 w 490"/>
                  <a:gd name="T45" fmla="*/ 287 h 7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90" h="767">
                    <a:moveTo>
                      <a:pt x="90" y="478"/>
                    </a:moveTo>
                    <a:lnTo>
                      <a:pt x="90" y="767"/>
                    </a:lnTo>
                    <a:lnTo>
                      <a:pt x="0" y="767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6"/>
                    </a:lnTo>
                    <a:cubicBezTo>
                      <a:pt x="108" y="64"/>
                      <a:pt x="132" y="40"/>
                      <a:pt x="161" y="24"/>
                    </a:cubicBezTo>
                    <a:cubicBezTo>
                      <a:pt x="190" y="8"/>
                      <a:pt x="225" y="0"/>
                      <a:pt x="265" y="0"/>
                    </a:cubicBezTo>
                    <a:cubicBezTo>
                      <a:pt x="331" y="0"/>
                      <a:pt x="385" y="27"/>
                      <a:pt x="427" y="79"/>
                    </a:cubicBezTo>
                    <a:cubicBezTo>
                      <a:pt x="468" y="132"/>
                      <a:pt x="490" y="201"/>
                      <a:pt x="490" y="287"/>
                    </a:cubicBezTo>
                    <a:cubicBezTo>
                      <a:pt x="490" y="373"/>
                      <a:pt x="468" y="443"/>
                      <a:pt x="427" y="495"/>
                    </a:cubicBezTo>
                    <a:cubicBezTo>
                      <a:pt x="385" y="547"/>
                      <a:pt x="331" y="573"/>
                      <a:pt x="265" y="573"/>
                    </a:cubicBezTo>
                    <a:cubicBezTo>
                      <a:pt x="225" y="573"/>
                      <a:pt x="190" y="565"/>
                      <a:pt x="161" y="550"/>
                    </a:cubicBezTo>
                    <a:cubicBezTo>
                      <a:pt x="132" y="535"/>
                      <a:pt x="108" y="511"/>
                      <a:pt x="90" y="478"/>
                    </a:cubicBezTo>
                    <a:close/>
                    <a:moveTo>
                      <a:pt x="396" y="287"/>
                    </a:moveTo>
                    <a:cubicBezTo>
                      <a:pt x="396" y="221"/>
                      <a:pt x="382" y="170"/>
                      <a:pt x="355" y="132"/>
                    </a:cubicBezTo>
                    <a:cubicBezTo>
                      <a:pt x="327" y="94"/>
                      <a:pt x="290" y="75"/>
                      <a:pt x="243" y="75"/>
                    </a:cubicBezTo>
                    <a:cubicBezTo>
                      <a:pt x="195" y="75"/>
                      <a:pt x="158" y="94"/>
                      <a:pt x="131" y="132"/>
                    </a:cubicBezTo>
                    <a:cubicBezTo>
                      <a:pt x="103" y="170"/>
                      <a:pt x="90" y="221"/>
                      <a:pt x="90" y="287"/>
                    </a:cubicBezTo>
                    <a:cubicBezTo>
                      <a:pt x="90" y="353"/>
                      <a:pt x="103" y="405"/>
                      <a:pt x="131" y="443"/>
                    </a:cubicBezTo>
                    <a:cubicBezTo>
                      <a:pt x="158" y="481"/>
                      <a:pt x="195" y="499"/>
                      <a:pt x="243" y="499"/>
                    </a:cubicBezTo>
                    <a:cubicBezTo>
                      <a:pt x="290" y="499"/>
                      <a:pt x="327" y="481"/>
                      <a:pt x="355" y="443"/>
                    </a:cubicBezTo>
                    <a:cubicBezTo>
                      <a:pt x="382" y="405"/>
                      <a:pt x="396" y="353"/>
                      <a:pt x="396" y="287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3" name="Freeform 93">
                <a:extLst>
                  <a:ext uri="{FF2B5EF4-FFF2-40B4-BE49-F238E27FC236}">
                    <a16:creationId xmlns:a16="http://schemas.microsoft.com/office/drawing/2014/main" id="{5E24A436-513B-913A-736E-375D8BD26F8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154699" y="2861670"/>
                <a:ext cx="14730" cy="57219"/>
              </a:xfrm>
              <a:custGeom>
                <a:avLst/>
                <a:gdLst>
                  <a:gd name="T0" fmla="*/ 224 w 224"/>
                  <a:gd name="T1" fmla="*/ 0 h 890"/>
                  <a:gd name="T2" fmla="*/ 127 w 224"/>
                  <a:gd name="T3" fmla="*/ 223 h 890"/>
                  <a:gd name="T4" fmla="*/ 95 w 224"/>
                  <a:gd name="T5" fmla="*/ 445 h 890"/>
                  <a:gd name="T6" fmla="*/ 127 w 224"/>
                  <a:gd name="T7" fmla="*/ 668 h 890"/>
                  <a:gd name="T8" fmla="*/ 224 w 224"/>
                  <a:gd name="T9" fmla="*/ 890 h 890"/>
                  <a:gd name="T10" fmla="*/ 146 w 224"/>
                  <a:gd name="T11" fmla="*/ 890 h 890"/>
                  <a:gd name="T12" fmla="*/ 36 w 224"/>
                  <a:gd name="T13" fmla="*/ 665 h 890"/>
                  <a:gd name="T14" fmla="*/ 0 w 224"/>
                  <a:gd name="T15" fmla="*/ 445 h 890"/>
                  <a:gd name="T16" fmla="*/ 36 w 224"/>
                  <a:gd name="T17" fmla="*/ 226 h 890"/>
                  <a:gd name="T18" fmla="*/ 146 w 224"/>
                  <a:gd name="T19" fmla="*/ 0 h 890"/>
                  <a:gd name="T20" fmla="*/ 224 w 224"/>
                  <a:gd name="T21" fmla="*/ 0 h 8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224" h="890">
                    <a:moveTo>
                      <a:pt x="224" y="0"/>
                    </a:moveTo>
                    <a:cubicBezTo>
                      <a:pt x="180" y="76"/>
                      <a:pt x="148" y="150"/>
                      <a:pt x="127" y="223"/>
                    </a:cubicBezTo>
                    <a:cubicBezTo>
                      <a:pt x="105" y="296"/>
                      <a:pt x="95" y="370"/>
                      <a:pt x="95" y="445"/>
                    </a:cubicBezTo>
                    <a:cubicBezTo>
                      <a:pt x="95" y="521"/>
                      <a:pt x="105" y="595"/>
                      <a:pt x="127" y="668"/>
                    </a:cubicBezTo>
                    <a:cubicBezTo>
                      <a:pt x="148" y="742"/>
                      <a:pt x="180" y="815"/>
                      <a:pt x="224" y="890"/>
                    </a:cubicBezTo>
                    <a:lnTo>
                      <a:pt x="146" y="890"/>
                    </a:lnTo>
                    <a:cubicBezTo>
                      <a:pt x="97" y="813"/>
                      <a:pt x="60" y="739"/>
                      <a:pt x="36" y="665"/>
                    </a:cubicBezTo>
                    <a:cubicBezTo>
                      <a:pt x="12" y="591"/>
                      <a:pt x="0" y="518"/>
                      <a:pt x="0" y="445"/>
                    </a:cubicBezTo>
                    <a:cubicBezTo>
                      <a:pt x="0" y="373"/>
                      <a:pt x="12" y="300"/>
                      <a:pt x="36" y="226"/>
                    </a:cubicBezTo>
                    <a:cubicBezTo>
                      <a:pt x="60" y="152"/>
                      <a:pt x="96" y="77"/>
                      <a:pt x="146" y="0"/>
                    </a:cubicBezTo>
                    <a:lnTo>
                      <a:pt x="224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4" name="Freeform 94">
                <a:extLst>
                  <a:ext uri="{FF2B5EF4-FFF2-40B4-BE49-F238E27FC236}">
                    <a16:creationId xmlns:a16="http://schemas.microsoft.com/office/drawing/2014/main" id="{5B026260-0AA1-041B-ED34-9CCBFBF3AB9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130338" y="2862803"/>
                <a:ext cx="29459" cy="47588"/>
              </a:xfrm>
              <a:custGeom>
                <a:avLst/>
                <a:gdLst>
                  <a:gd name="T0" fmla="*/ 119 w 463"/>
                  <a:gd name="T1" fmla="*/ 659 h 742"/>
                  <a:gd name="T2" fmla="*/ 463 w 463"/>
                  <a:gd name="T3" fmla="*/ 659 h 742"/>
                  <a:gd name="T4" fmla="*/ 463 w 463"/>
                  <a:gd name="T5" fmla="*/ 742 h 742"/>
                  <a:gd name="T6" fmla="*/ 0 w 463"/>
                  <a:gd name="T7" fmla="*/ 742 h 742"/>
                  <a:gd name="T8" fmla="*/ 0 w 463"/>
                  <a:gd name="T9" fmla="*/ 659 h 742"/>
                  <a:gd name="T10" fmla="*/ 153 w 463"/>
                  <a:gd name="T11" fmla="*/ 503 h 742"/>
                  <a:gd name="T12" fmla="*/ 275 w 463"/>
                  <a:gd name="T13" fmla="*/ 377 h 742"/>
                  <a:gd name="T14" fmla="*/ 341 w 463"/>
                  <a:gd name="T15" fmla="*/ 287 h 742"/>
                  <a:gd name="T16" fmla="*/ 360 w 463"/>
                  <a:gd name="T17" fmla="*/ 214 h 742"/>
                  <a:gd name="T18" fmla="*/ 319 w 463"/>
                  <a:gd name="T19" fmla="*/ 120 h 742"/>
                  <a:gd name="T20" fmla="*/ 213 w 463"/>
                  <a:gd name="T21" fmla="*/ 83 h 742"/>
                  <a:gd name="T22" fmla="*/ 115 w 463"/>
                  <a:gd name="T23" fmla="*/ 99 h 742"/>
                  <a:gd name="T24" fmla="*/ 5 w 463"/>
                  <a:gd name="T25" fmla="*/ 148 h 742"/>
                  <a:gd name="T26" fmla="*/ 5 w 463"/>
                  <a:gd name="T27" fmla="*/ 48 h 742"/>
                  <a:gd name="T28" fmla="*/ 116 w 463"/>
                  <a:gd name="T29" fmla="*/ 12 h 742"/>
                  <a:gd name="T30" fmla="*/ 211 w 463"/>
                  <a:gd name="T31" fmla="*/ 0 h 742"/>
                  <a:gd name="T32" fmla="*/ 391 w 463"/>
                  <a:gd name="T33" fmla="*/ 57 h 742"/>
                  <a:gd name="T34" fmla="*/ 459 w 463"/>
                  <a:gd name="T35" fmla="*/ 208 h 742"/>
                  <a:gd name="T36" fmla="*/ 442 w 463"/>
                  <a:gd name="T37" fmla="*/ 293 h 742"/>
                  <a:gd name="T38" fmla="*/ 381 w 463"/>
                  <a:gd name="T39" fmla="*/ 388 h 742"/>
                  <a:gd name="T40" fmla="*/ 303 w 463"/>
                  <a:gd name="T41" fmla="*/ 470 h 742"/>
                  <a:gd name="T42" fmla="*/ 119 w 463"/>
                  <a:gd name="T43" fmla="*/ 659 h 7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463" h="742">
                    <a:moveTo>
                      <a:pt x="119" y="659"/>
                    </a:moveTo>
                    <a:lnTo>
                      <a:pt x="463" y="659"/>
                    </a:lnTo>
                    <a:lnTo>
                      <a:pt x="463" y="742"/>
                    </a:lnTo>
                    <a:lnTo>
                      <a:pt x="0" y="742"/>
                    </a:lnTo>
                    <a:lnTo>
                      <a:pt x="0" y="659"/>
                    </a:lnTo>
                    <a:cubicBezTo>
                      <a:pt x="37" y="621"/>
                      <a:pt x="88" y="569"/>
                      <a:pt x="153" y="503"/>
                    </a:cubicBezTo>
                    <a:cubicBezTo>
                      <a:pt x="217" y="438"/>
                      <a:pt x="258" y="396"/>
                      <a:pt x="275" y="377"/>
                    </a:cubicBezTo>
                    <a:cubicBezTo>
                      <a:pt x="307" y="342"/>
                      <a:pt x="329" y="312"/>
                      <a:pt x="341" y="287"/>
                    </a:cubicBezTo>
                    <a:cubicBezTo>
                      <a:pt x="353" y="263"/>
                      <a:pt x="360" y="238"/>
                      <a:pt x="360" y="214"/>
                    </a:cubicBezTo>
                    <a:cubicBezTo>
                      <a:pt x="360" y="176"/>
                      <a:pt x="346" y="144"/>
                      <a:pt x="319" y="120"/>
                    </a:cubicBezTo>
                    <a:cubicBezTo>
                      <a:pt x="292" y="96"/>
                      <a:pt x="257" y="83"/>
                      <a:pt x="213" y="83"/>
                    </a:cubicBezTo>
                    <a:cubicBezTo>
                      <a:pt x="182" y="83"/>
                      <a:pt x="149" y="89"/>
                      <a:pt x="115" y="99"/>
                    </a:cubicBezTo>
                    <a:cubicBezTo>
                      <a:pt x="81" y="110"/>
                      <a:pt x="44" y="126"/>
                      <a:pt x="5" y="148"/>
                    </a:cubicBezTo>
                    <a:lnTo>
                      <a:pt x="5" y="48"/>
                    </a:lnTo>
                    <a:cubicBezTo>
                      <a:pt x="45" y="32"/>
                      <a:pt x="82" y="20"/>
                      <a:pt x="116" y="12"/>
                    </a:cubicBezTo>
                    <a:cubicBezTo>
                      <a:pt x="150" y="4"/>
                      <a:pt x="182" y="0"/>
                      <a:pt x="211" y="0"/>
                    </a:cubicBezTo>
                    <a:cubicBezTo>
                      <a:pt x="286" y="0"/>
                      <a:pt x="346" y="19"/>
                      <a:pt x="391" y="57"/>
                    </a:cubicBezTo>
                    <a:cubicBezTo>
                      <a:pt x="436" y="95"/>
                      <a:pt x="459" y="145"/>
                      <a:pt x="459" y="208"/>
                    </a:cubicBezTo>
                    <a:cubicBezTo>
                      <a:pt x="459" y="238"/>
                      <a:pt x="453" y="267"/>
                      <a:pt x="442" y="293"/>
                    </a:cubicBezTo>
                    <a:cubicBezTo>
                      <a:pt x="431" y="320"/>
                      <a:pt x="411" y="352"/>
                      <a:pt x="381" y="388"/>
                    </a:cubicBezTo>
                    <a:cubicBezTo>
                      <a:pt x="373" y="398"/>
                      <a:pt x="347" y="425"/>
                      <a:pt x="303" y="470"/>
                    </a:cubicBezTo>
                    <a:cubicBezTo>
                      <a:pt x="259" y="515"/>
                      <a:pt x="198" y="578"/>
                      <a:pt x="119" y="65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5" name="Freeform 95">
                <a:extLst>
                  <a:ext uri="{FF2B5EF4-FFF2-40B4-BE49-F238E27FC236}">
                    <a16:creationId xmlns:a16="http://schemas.microsoft.com/office/drawing/2014/main" id="{2B4E81A9-67EA-0D6F-B0C5-12820ACF23D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-87848" y="2863370"/>
                <a:ext cx="39657" cy="47022"/>
              </a:xfrm>
              <a:custGeom>
                <a:avLst/>
                <a:gdLst>
                  <a:gd name="T0" fmla="*/ 99 w 613"/>
                  <a:gd name="T1" fmla="*/ 81 h 729"/>
                  <a:gd name="T2" fmla="*/ 99 w 613"/>
                  <a:gd name="T3" fmla="*/ 648 h 729"/>
                  <a:gd name="T4" fmla="*/ 218 w 613"/>
                  <a:gd name="T5" fmla="*/ 648 h 729"/>
                  <a:gd name="T6" fmla="*/ 439 w 613"/>
                  <a:gd name="T7" fmla="*/ 580 h 729"/>
                  <a:gd name="T8" fmla="*/ 509 w 613"/>
                  <a:gd name="T9" fmla="*/ 364 h 729"/>
                  <a:gd name="T10" fmla="*/ 439 w 613"/>
                  <a:gd name="T11" fmla="*/ 149 h 729"/>
                  <a:gd name="T12" fmla="*/ 218 w 613"/>
                  <a:gd name="T13" fmla="*/ 81 h 729"/>
                  <a:gd name="T14" fmla="*/ 99 w 613"/>
                  <a:gd name="T15" fmla="*/ 81 h 729"/>
                  <a:gd name="T16" fmla="*/ 0 w 613"/>
                  <a:gd name="T17" fmla="*/ 0 h 729"/>
                  <a:gd name="T18" fmla="*/ 203 w 613"/>
                  <a:gd name="T19" fmla="*/ 0 h 729"/>
                  <a:gd name="T20" fmla="*/ 514 w 613"/>
                  <a:gd name="T21" fmla="*/ 88 h 729"/>
                  <a:gd name="T22" fmla="*/ 613 w 613"/>
                  <a:gd name="T23" fmla="*/ 364 h 729"/>
                  <a:gd name="T24" fmla="*/ 513 w 613"/>
                  <a:gd name="T25" fmla="*/ 641 h 729"/>
                  <a:gd name="T26" fmla="*/ 203 w 613"/>
                  <a:gd name="T27" fmla="*/ 729 h 729"/>
                  <a:gd name="T28" fmla="*/ 0 w 613"/>
                  <a:gd name="T29" fmla="*/ 729 h 729"/>
                  <a:gd name="T30" fmla="*/ 0 w 613"/>
                  <a:gd name="T31" fmla="*/ 0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613" h="729">
                    <a:moveTo>
                      <a:pt x="99" y="81"/>
                    </a:moveTo>
                    <a:lnTo>
                      <a:pt x="99" y="648"/>
                    </a:lnTo>
                    <a:lnTo>
                      <a:pt x="218" y="648"/>
                    </a:lnTo>
                    <a:cubicBezTo>
                      <a:pt x="318" y="648"/>
                      <a:pt x="392" y="626"/>
                      <a:pt x="439" y="580"/>
                    </a:cubicBezTo>
                    <a:cubicBezTo>
                      <a:pt x="485" y="534"/>
                      <a:pt x="509" y="462"/>
                      <a:pt x="509" y="364"/>
                    </a:cubicBezTo>
                    <a:cubicBezTo>
                      <a:pt x="509" y="266"/>
                      <a:pt x="485" y="195"/>
                      <a:pt x="439" y="149"/>
                    </a:cubicBezTo>
                    <a:cubicBezTo>
                      <a:pt x="392" y="104"/>
                      <a:pt x="318" y="81"/>
                      <a:pt x="218" y="81"/>
                    </a:cubicBezTo>
                    <a:lnTo>
                      <a:pt x="99" y="81"/>
                    </a:lnTo>
                    <a:close/>
                    <a:moveTo>
                      <a:pt x="0" y="0"/>
                    </a:moveTo>
                    <a:lnTo>
                      <a:pt x="203" y="0"/>
                    </a:lnTo>
                    <a:cubicBezTo>
                      <a:pt x="344" y="0"/>
                      <a:pt x="448" y="30"/>
                      <a:pt x="514" y="88"/>
                    </a:cubicBezTo>
                    <a:cubicBezTo>
                      <a:pt x="580" y="147"/>
                      <a:pt x="613" y="239"/>
                      <a:pt x="613" y="364"/>
                    </a:cubicBezTo>
                    <a:cubicBezTo>
                      <a:pt x="613" y="490"/>
                      <a:pt x="579" y="582"/>
                      <a:pt x="513" y="641"/>
                    </a:cubicBezTo>
                    <a:cubicBezTo>
                      <a:pt x="447" y="700"/>
                      <a:pt x="343" y="729"/>
                      <a:pt x="203" y="729"/>
                    </a:cubicBezTo>
                    <a:lnTo>
                      <a:pt x="0" y="729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6" name="Freeform 96">
                <a:extLst>
                  <a:ext uri="{FF2B5EF4-FFF2-40B4-BE49-F238E27FC236}">
                    <a16:creationId xmlns:a16="http://schemas.microsoft.com/office/drawing/2014/main" id="{71A149B2-7252-3860-B054-1A6D0CD37B3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39694" y="2861670"/>
                <a:ext cx="14730" cy="57219"/>
              </a:xfrm>
              <a:custGeom>
                <a:avLst/>
                <a:gdLst>
                  <a:gd name="T0" fmla="*/ 0 w 224"/>
                  <a:gd name="T1" fmla="*/ 0 h 890"/>
                  <a:gd name="T2" fmla="*/ 78 w 224"/>
                  <a:gd name="T3" fmla="*/ 0 h 890"/>
                  <a:gd name="T4" fmla="*/ 187 w 224"/>
                  <a:gd name="T5" fmla="*/ 226 h 890"/>
                  <a:gd name="T6" fmla="*/ 224 w 224"/>
                  <a:gd name="T7" fmla="*/ 445 h 890"/>
                  <a:gd name="T8" fmla="*/ 187 w 224"/>
                  <a:gd name="T9" fmla="*/ 665 h 890"/>
                  <a:gd name="T10" fmla="*/ 78 w 224"/>
                  <a:gd name="T11" fmla="*/ 890 h 890"/>
                  <a:gd name="T12" fmla="*/ 0 w 224"/>
                  <a:gd name="T13" fmla="*/ 890 h 890"/>
                  <a:gd name="T14" fmla="*/ 97 w 224"/>
                  <a:gd name="T15" fmla="*/ 668 h 890"/>
                  <a:gd name="T16" fmla="*/ 129 w 224"/>
                  <a:gd name="T17" fmla="*/ 445 h 890"/>
                  <a:gd name="T18" fmla="*/ 97 w 224"/>
                  <a:gd name="T19" fmla="*/ 223 h 890"/>
                  <a:gd name="T20" fmla="*/ 0 w 224"/>
                  <a:gd name="T21" fmla="*/ 0 h 8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224" h="890">
                    <a:moveTo>
                      <a:pt x="0" y="0"/>
                    </a:moveTo>
                    <a:lnTo>
                      <a:pt x="78" y="0"/>
                    </a:lnTo>
                    <a:cubicBezTo>
                      <a:pt x="126" y="77"/>
                      <a:pt x="163" y="152"/>
                      <a:pt x="187" y="226"/>
                    </a:cubicBezTo>
                    <a:cubicBezTo>
                      <a:pt x="211" y="300"/>
                      <a:pt x="224" y="373"/>
                      <a:pt x="224" y="445"/>
                    </a:cubicBezTo>
                    <a:cubicBezTo>
                      <a:pt x="224" y="518"/>
                      <a:pt x="211" y="591"/>
                      <a:pt x="187" y="665"/>
                    </a:cubicBezTo>
                    <a:cubicBezTo>
                      <a:pt x="163" y="739"/>
                      <a:pt x="126" y="813"/>
                      <a:pt x="78" y="890"/>
                    </a:cubicBezTo>
                    <a:lnTo>
                      <a:pt x="0" y="890"/>
                    </a:lnTo>
                    <a:cubicBezTo>
                      <a:pt x="43" y="815"/>
                      <a:pt x="75" y="742"/>
                      <a:pt x="97" y="668"/>
                    </a:cubicBezTo>
                    <a:cubicBezTo>
                      <a:pt x="118" y="595"/>
                      <a:pt x="129" y="521"/>
                      <a:pt x="129" y="445"/>
                    </a:cubicBezTo>
                    <a:cubicBezTo>
                      <a:pt x="129" y="370"/>
                      <a:pt x="118" y="296"/>
                      <a:pt x="97" y="223"/>
                    </a:cubicBezTo>
                    <a:cubicBezTo>
                      <a:pt x="75" y="150"/>
                      <a:pt x="43" y="76"/>
                      <a:pt x="0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7" name="Line 66">
                <a:extLst>
                  <a:ext uri="{FF2B5EF4-FFF2-40B4-BE49-F238E27FC236}">
                    <a16:creationId xmlns:a16="http://schemas.microsoft.com/office/drawing/2014/main" id="{9A99C043-BEAF-06F5-6C74-F584BD96E7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699980" y="3678919"/>
                <a:ext cx="816931" cy="0"/>
              </a:xfrm>
              <a:prstGeom prst="line">
                <a:avLst/>
              </a:prstGeom>
              <a:noFill/>
              <a:ln w="3175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1298" name="Group 1297">
              <a:extLst>
                <a:ext uri="{FF2B5EF4-FFF2-40B4-BE49-F238E27FC236}">
                  <a16:creationId xmlns:a16="http://schemas.microsoft.com/office/drawing/2014/main" id="{C6963EC9-A0B7-D9B7-1E7C-3B16272F3B1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45723" y="3935639"/>
              <a:ext cx="1079430" cy="1080000"/>
              <a:chOff x="2540000" y="2540000"/>
              <a:chExt cx="3006725" cy="3008313"/>
            </a:xfrm>
          </p:grpSpPr>
          <p:sp>
            <p:nvSpPr>
              <p:cNvPr id="1299" name="Rectangle 103">
                <a:extLst>
                  <a:ext uri="{FF2B5EF4-FFF2-40B4-BE49-F238E27FC236}">
                    <a16:creationId xmlns:a16="http://schemas.microsoft.com/office/drawing/2014/main" id="{76BD0B82-C129-ECDD-43BA-17A951C6B6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000" y="2540000"/>
                <a:ext cx="3006725" cy="300831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0" name="Rectangle 104">
                <a:extLst>
                  <a:ext uri="{FF2B5EF4-FFF2-40B4-BE49-F238E27FC236}">
                    <a16:creationId xmlns:a16="http://schemas.microsoft.com/office/drawing/2014/main" id="{BDE2DD4F-CCA4-35AE-87A8-62E38D2115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81350" y="2540000"/>
                <a:ext cx="2365375" cy="2747963"/>
              </a:xfrm>
              <a:prstGeom prst="rect">
                <a:avLst/>
              </a:prstGeom>
              <a:solidFill>
                <a:srgbClr val="EAEA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1" name="Freeform 105">
                <a:extLst>
                  <a:ext uri="{FF2B5EF4-FFF2-40B4-BE49-F238E27FC236}">
                    <a16:creationId xmlns:a16="http://schemas.microsoft.com/office/drawing/2014/main" id="{6D6B0951-554E-8D8D-E8AD-C35DC5821F3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98838" y="5376863"/>
                <a:ext cx="106363" cy="136525"/>
              </a:xfrm>
              <a:custGeom>
                <a:avLst/>
                <a:gdLst>
                  <a:gd name="T0" fmla="*/ 588 w 588"/>
                  <a:gd name="T1" fmla="*/ 69 h 755"/>
                  <a:gd name="T2" fmla="*/ 588 w 588"/>
                  <a:gd name="T3" fmla="*/ 173 h 755"/>
                  <a:gd name="T4" fmla="*/ 481 w 588"/>
                  <a:gd name="T5" fmla="*/ 104 h 755"/>
                  <a:gd name="T6" fmla="*/ 362 w 588"/>
                  <a:gd name="T7" fmla="*/ 81 h 755"/>
                  <a:gd name="T8" fmla="*/ 170 w 588"/>
                  <a:gd name="T9" fmla="*/ 158 h 755"/>
                  <a:gd name="T10" fmla="*/ 104 w 588"/>
                  <a:gd name="T11" fmla="*/ 378 h 755"/>
                  <a:gd name="T12" fmla="*/ 170 w 588"/>
                  <a:gd name="T13" fmla="*/ 599 h 755"/>
                  <a:gd name="T14" fmla="*/ 362 w 588"/>
                  <a:gd name="T15" fmla="*/ 675 h 755"/>
                  <a:gd name="T16" fmla="*/ 481 w 588"/>
                  <a:gd name="T17" fmla="*/ 652 h 755"/>
                  <a:gd name="T18" fmla="*/ 588 w 588"/>
                  <a:gd name="T19" fmla="*/ 583 h 755"/>
                  <a:gd name="T20" fmla="*/ 588 w 588"/>
                  <a:gd name="T21" fmla="*/ 686 h 755"/>
                  <a:gd name="T22" fmla="*/ 478 w 588"/>
                  <a:gd name="T23" fmla="*/ 738 h 755"/>
                  <a:gd name="T24" fmla="*/ 356 w 588"/>
                  <a:gd name="T25" fmla="*/ 755 h 755"/>
                  <a:gd name="T26" fmla="*/ 95 w 588"/>
                  <a:gd name="T27" fmla="*/ 655 h 755"/>
                  <a:gd name="T28" fmla="*/ 0 w 588"/>
                  <a:gd name="T29" fmla="*/ 378 h 755"/>
                  <a:gd name="T30" fmla="*/ 95 w 588"/>
                  <a:gd name="T31" fmla="*/ 101 h 755"/>
                  <a:gd name="T32" fmla="*/ 356 w 588"/>
                  <a:gd name="T33" fmla="*/ 0 h 755"/>
                  <a:gd name="T34" fmla="*/ 479 w 588"/>
                  <a:gd name="T35" fmla="*/ 17 h 755"/>
                  <a:gd name="T36" fmla="*/ 588 w 588"/>
                  <a:gd name="T37" fmla="*/ 69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588" h="755">
                    <a:moveTo>
                      <a:pt x="588" y="69"/>
                    </a:moveTo>
                    <a:lnTo>
                      <a:pt x="588" y="173"/>
                    </a:lnTo>
                    <a:cubicBezTo>
                      <a:pt x="554" y="143"/>
                      <a:pt x="519" y="120"/>
                      <a:pt x="481" y="104"/>
                    </a:cubicBezTo>
                    <a:cubicBezTo>
                      <a:pt x="443" y="89"/>
                      <a:pt x="404" y="81"/>
                      <a:pt x="362" y="81"/>
                    </a:cubicBezTo>
                    <a:cubicBezTo>
                      <a:pt x="278" y="81"/>
                      <a:pt x="214" y="107"/>
                      <a:pt x="170" y="158"/>
                    </a:cubicBezTo>
                    <a:cubicBezTo>
                      <a:pt x="126" y="209"/>
                      <a:pt x="104" y="282"/>
                      <a:pt x="104" y="378"/>
                    </a:cubicBezTo>
                    <a:cubicBezTo>
                      <a:pt x="104" y="474"/>
                      <a:pt x="126" y="548"/>
                      <a:pt x="170" y="599"/>
                    </a:cubicBezTo>
                    <a:cubicBezTo>
                      <a:pt x="214" y="650"/>
                      <a:pt x="278" y="675"/>
                      <a:pt x="362" y="675"/>
                    </a:cubicBezTo>
                    <a:cubicBezTo>
                      <a:pt x="404" y="675"/>
                      <a:pt x="443" y="668"/>
                      <a:pt x="481" y="652"/>
                    </a:cubicBezTo>
                    <a:cubicBezTo>
                      <a:pt x="519" y="637"/>
                      <a:pt x="554" y="614"/>
                      <a:pt x="588" y="583"/>
                    </a:cubicBezTo>
                    <a:lnTo>
                      <a:pt x="588" y="686"/>
                    </a:lnTo>
                    <a:cubicBezTo>
                      <a:pt x="553" y="710"/>
                      <a:pt x="516" y="727"/>
                      <a:pt x="478" y="738"/>
                    </a:cubicBezTo>
                    <a:cubicBezTo>
                      <a:pt x="440" y="749"/>
                      <a:pt x="399" y="755"/>
                      <a:pt x="356" y="755"/>
                    </a:cubicBezTo>
                    <a:cubicBezTo>
                      <a:pt x="246" y="755"/>
                      <a:pt x="159" y="722"/>
                      <a:pt x="95" y="655"/>
                    </a:cubicBezTo>
                    <a:cubicBezTo>
                      <a:pt x="31" y="588"/>
                      <a:pt x="0" y="496"/>
                      <a:pt x="0" y="378"/>
                    </a:cubicBezTo>
                    <a:cubicBezTo>
                      <a:pt x="0" y="261"/>
                      <a:pt x="31" y="169"/>
                      <a:pt x="95" y="101"/>
                    </a:cubicBezTo>
                    <a:cubicBezTo>
                      <a:pt x="159" y="34"/>
                      <a:pt x="246" y="0"/>
                      <a:pt x="356" y="0"/>
                    </a:cubicBezTo>
                    <a:cubicBezTo>
                      <a:pt x="400" y="0"/>
                      <a:pt x="441" y="6"/>
                      <a:pt x="479" y="17"/>
                    </a:cubicBezTo>
                    <a:cubicBezTo>
                      <a:pt x="517" y="29"/>
                      <a:pt x="554" y="46"/>
                      <a:pt x="588" y="6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2" name="Freeform 106">
                <a:extLst>
                  <a:ext uri="{FF2B5EF4-FFF2-40B4-BE49-F238E27FC236}">
                    <a16:creationId xmlns:a16="http://schemas.microsoft.com/office/drawing/2014/main" id="{94608634-047A-F5A0-6788-28C5C9470E1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524250" y="5408613"/>
                <a:ext cx="92075" cy="104775"/>
              </a:xfrm>
              <a:custGeom>
                <a:avLst/>
                <a:gdLst>
                  <a:gd name="T0" fmla="*/ 507 w 507"/>
                  <a:gd name="T1" fmla="*/ 264 h 573"/>
                  <a:gd name="T2" fmla="*/ 507 w 507"/>
                  <a:gd name="T3" fmla="*/ 308 h 573"/>
                  <a:gd name="T4" fmla="*/ 94 w 507"/>
                  <a:gd name="T5" fmla="*/ 308 h 573"/>
                  <a:gd name="T6" fmla="*/ 150 w 507"/>
                  <a:gd name="T7" fmla="*/ 450 h 573"/>
                  <a:gd name="T8" fmla="*/ 289 w 507"/>
                  <a:gd name="T9" fmla="*/ 498 h 573"/>
                  <a:gd name="T10" fmla="*/ 389 w 507"/>
                  <a:gd name="T11" fmla="*/ 486 h 573"/>
                  <a:gd name="T12" fmla="*/ 486 w 507"/>
                  <a:gd name="T13" fmla="*/ 447 h 573"/>
                  <a:gd name="T14" fmla="*/ 486 w 507"/>
                  <a:gd name="T15" fmla="*/ 532 h 573"/>
                  <a:gd name="T16" fmla="*/ 387 w 507"/>
                  <a:gd name="T17" fmla="*/ 563 h 573"/>
                  <a:gd name="T18" fmla="*/ 284 w 507"/>
                  <a:gd name="T19" fmla="*/ 573 h 573"/>
                  <a:gd name="T20" fmla="*/ 76 w 507"/>
                  <a:gd name="T21" fmla="*/ 498 h 573"/>
                  <a:gd name="T22" fmla="*/ 0 w 507"/>
                  <a:gd name="T23" fmla="*/ 292 h 573"/>
                  <a:gd name="T24" fmla="*/ 72 w 507"/>
                  <a:gd name="T25" fmla="*/ 79 h 573"/>
                  <a:gd name="T26" fmla="*/ 268 w 507"/>
                  <a:gd name="T27" fmla="*/ 0 h 573"/>
                  <a:gd name="T28" fmla="*/ 443 w 507"/>
                  <a:gd name="T29" fmla="*/ 71 h 573"/>
                  <a:gd name="T30" fmla="*/ 507 w 507"/>
                  <a:gd name="T31" fmla="*/ 264 h 573"/>
                  <a:gd name="T32" fmla="*/ 417 w 507"/>
                  <a:gd name="T33" fmla="*/ 238 h 573"/>
                  <a:gd name="T34" fmla="*/ 376 w 507"/>
                  <a:gd name="T35" fmla="*/ 120 h 573"/>
                  <a:gd name="T36" fmla="*/ 269 w 507"/>
                  <a:gd name="T37" fmla="*/ 76 h 573"/>
                  <a:gd name="T38" fmla="*/ 149 w 507"/>
                  <a:gd name="T39" fmla="*/ 119 h 573"/>
                  <a:gd name="T40" fmla="*/ 97 w 507"/>
                  <a:gd name="T41" fmla="*/ 238 h 573"/>
                  <a:gd name="T42" fmla="*/ 417 w 507"/>
                  <a:gd name="T43" fmla="*/ 23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07" h="573">
                    <a:moveTo>
                      <a:pt x="507" y="264"/>
                    </a:moveTo>
                    <a:lnTo>
                      <a:pt x="507" y="308"/>
                    </a:lnTo>
                    <a:lnTo>
                      <a:pt x="94" y="308"/>
                    </a:lnTo>
                    <a:cubicBezTo>
                      <a:pt x="98" y="370"/>
                      <a:pt x="116" y="418"/>
                      <a:pt x="150" y="450"/>
                    </a:cubicBezTo>
                    <a:cubicBezTo>
                      <a:pt x="183" y="482"/>
                      <a:pt x="229" y="498"/>
                      <a:pt x="289" y="498"/>
                    </a:cubicBezTo>
                    <a:cubicBezTo>
                      <a:pt x="323" y="498"/>
                      <a:pt x="357" y="494"/>
                      <a:pt x="389" y="486"/>
                    </a:cubicBezTo>
                    <a:cubicBezTo>
                      <a:pt x="421" y="478"/>
                      <a:pt x="454" y="465"/>
                      <a:pt x="486" y="447"/>
                    </a:cubicBezTo>
                    <a:lnTo>
                      <a:pt x="486" y="532"/>
                    </a:lnTo>
                    <a:cubicBezTo>
                      <a:pt x="454" y="546"/>
                      <a:pt x="421" y="557"/>
                      <a:pt x="387" y="563"/>
                    </a:cubicBezTo>
                    <a:cubicBezTo>
                      <a:pt x="353" y="569"/>
                      <a:pt x="318" y="573"/>
                      <a:pt x="284" y="573"/>
                    </a:cubicBezTo>
                    <a:cubicBezTo>
                      <a:pt x="196" y="573"/>
                      <a:pt x="127" y="548"/>
                      <a:pt x="76" y="498"/>
                    </a:cubicBezTo>
                    <a:cubicBezTo>
                      <a:pt x="25" y="448"/>
                      <a:pt x="0" y="379"/>
                      <a:pt x="0" y="292"/>
                    </a:cubicBezTo>
                    <a:cubicBezTo>
                      <a:pt x="0" y="203"/>
                      <a:pt x="24" y="132"/>
                      <a:pt x="72" y="79"/>
                    </a:cubicBezTo>
                    <a:cubicBezTo>
                      <a:pt x="120" y="27"/>
                      <a:pt x="186" y="0"/>
                      <a:pt x="268" y="0"/>
                    </a:cubicBezTo>
                    <a:cubicBezTo>
                      <a:pt x="342" y="0"/>
                      <a:pt x="400" y="24"/>
                      <a:pt x="443" y="71"/>
                    </a:cubicBezTo>
                    <a:cubicBezTo>
                      <a:pt x="485" y="119"/>
                      <a:pt x="507" y="183"/>
                      <a:pt x="507" y="264"/>
                    </a:cubicBezTo>
                    <a:close/>
                    <a:moveTo>
                      <a:pt x="417" y="238"/>
                    </a:moveTo>
                    <a:cubicBezTo>
                      <a:pt x="416" y="189"/>
                      <a:pt x="402" y="150"/>
                      <a:pt x="376" y="120"/>
                    </a:cubicBezTo>
                    <a:cubicBezTo>
                      <a:pt x="349" y="91"/>
                      <a:pt x="313" y="76"/>
                      <a:pt x="269" y="76"/>
                    </a:cubicBezTo>
                    <a:cubicBezTo>
                      <a:pt x="219" y="76"/>
                      <a:pt x="179" y="91"/>
                      <a:pt x="149" y="119"/>
                    </a:cubicBezTo>
                    <a:cubicBezTo>
                      <a:pt x="119" y="147"/>
                      <a:pt x="101" y="187"/>
                      <a:pt x="97" y="238"/>
                    </a:cubicBezTo>
                    <a:lnTo>
                      <a:pt x="417" y="238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3" name="Rectangle 107">
                <a:extLst>
                  <a:ext uri="{FF2B5EF4-FFF2-40B4-BE49-F238E27FC236}">
                    <a16:creationId xmlns:a16="http://schemas.microsoft.com/office/drawing/2014/main" id="{1D5E0E3D-45BC-39E6-72A6-E95719087D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41725" y="5373688"/>
                <a:ext cx="17463" cy="1365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4" name="Rectangle 108">
                <a:extLst>
                  <a:ext uri="{FF2B5EF4-FFF2-40B4-BE49-F238E27FC236}">
                    <a16:creationId xmlns:a16="http://schemas.microsoft.com/office/drawing/2014/main" id="{00411034-1737-972C-9BEF-8EB7118333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92525" y="5373688"/>
                <a:ext cx="15875" cy="1365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5" name="Freeform 109">
                <a:extLst>
                  <a:ext uri="{FF2B5EF4-FFF2-40B4-BE49-F238E27FC236}">
                    <a16:creationId xmlns:a16="http://schemas.microsoft.com/office/drawing/2014/main" id="{0A1C104D-49C0-8B7F-C968-62DEF288273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741738" y="5408613"/>
                <a:ext cx="88900" cy="139700"/>
              </a:xfrm>
              <a:custGeom>
                <a:avLst/>
                <a:gdLst>
                  <a:gd name="T0" fmla="*/ 90 w 489"/>
                  <a:gd name="T1" fmla="*/ 478 h 767"/>
                  <a:gd name="T2" fmla="*/ 90 w 489"/>
                  <a:gd name="T3" fmla="*/ 767 h 767"/>
                  <a:gd name="T4" fmla="*/ 0 w 489"/>
                  <a:gd name="T5" fmla="*/ 767 h 767"/>
                  <a:gd name="T6" fmla="*/ 0 w 489"/>
                  <a:gd name="T7" fmla="*/ 13 h 767"/>
                  <a:gd name="T8" fmla="*/ 90 w 489"/>
                  <a:gd name="T9" fmla="*/ 13 h 767"/>
                  <a:gd name="T10" fmla="*/ 90 w 489"/>
                  <a:gd name="T11" fmla="*/ 96 h 767"/>
                  <a:gd name="T12" fmla="*/ 161 w 489"/>
                  <a:gd name="T13" fmla="*/ 24 h 767"/>
                  <a:gd name="T14" fmla="*/ 265 w 489"/>
                  <a:gd name="T15" fmla="*/ 0 h 767"/>
                  <a:gd name="T16" fmla="*/ 427 w 489"/>
                  <a:gd name="T17" fmla="*/ 79 h 767"/>
                  <a:gd name="T18" fmla="*/ 489 w 489"/>
                  <a:gd name="T19" fmla="*/ 287 h 767"/>
                  <a:gd name="T20" fmla="*/ 427 w 489"/>
                  <a:gd name="T21" fmla="*/ 495 h 767"/>
                  <a:gd name="T22" fmla="*/ 265 w 489"/>
                  <a:gd name="T23" fmla="*/ 573 h 767"/>
                  <a:gd name="T24" fmla="*/ 161 w 489"/>
                  <a:gd name="T25" fmla="*/ 550 h 767"/>
                  <a:gd name="T26" fmla="*/ 90 w 489"/>
                  <a:gd name="T27" fmla="*/ 478 h 767"/>
                  <a:gd name="T28" fmla="*/ 396 w 489"/>
                  <a:gd name="T29" fmla="*/ 287 h 767"/>
                  <a:gd name="T30" fmla="*/ 355 w 489"/>
                  <a:gd name="T31" fmla="*/ 132 h 767"/>
                  <a:gd name="T32" fmla="*/ 243 w 489"/>
                  <a:gd name="T33" fmla="*/ 75 h 767"/>
                  <a:gd name="T34" fmla="*/ 131 w 489"/>
                  <a:gd name="T35" fmla="*/ 132 h 767"/>
                  <a:gd name="T36" fmla="*/ 90 w 489"/>
                  <a:gd name="T37" fmla="*/ 287 h 767"/>
                  <a:gd name="T38" fmla="*/ 131 w 489"/>
                  <a:gd name="T39" fmla="*/ 443 h 767"/>
                  <a:gd name="T40" fmla="*/ 243 w 489"/>
                  <a:gd name="T41" fmla="*/ 499 h 767"/>
                  <a:gd name="T42" fmla="*/ 355 w 489"/>
                  <a:gd name="T43" fmla="*/ 443 h 767"/>
                  <a:gd name="T44" fmla="*/ 396 w 489"/>
                  <a:gd name="T45" fmla="*/ 287 h 7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89" h="767">
                    <a:moveTo>
                      <a:pt x="90" y="478"/>
                    </a:moveTo>
                    <a:lnTo>
                      <a:pt x="90" y="767"/>
                    </a:lnTo>
                    <a:lnTo>
                      <a:pt x="0" y="767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6"/>
                    </a:lnTo>
                    <a:cubicBezTo>
                      <a:pt x="108" y="64"/>
                      <a:pt x="132" y="40"/>
                      <a:pt x="161" y="24"/>
                    </a:cubicBezTo>
                    <a:cubicBezTo>
                      <a:pt x="190" y="8"/>
                      <a:pt x="225" y="0"/>
                      <a:pt x="265" y="0"/>
                    </a:cubicBezTo>
                    <a:cubicBezTo>
                      <a:pt x="331" y="0"/>
                      <a:pt x="385" y="27"/>
                      <a:pt x="427" y="79"/>
                    </a:cubicBezTo>
                    <a:cubicBezTo>
                      <a:pt x="468" y="132"/>
                      <a:pt x="489" y="201"/>
                      <a:pt x="489" y="287"/>
                    </a:cubicBezTo>
                    <a:cubicBezTo>
                      <a:pt x="489" y="373"/>
                      <a:pt x="468" y="443"/>
                      <a:pt x="427" y="495"/>
                    </a:cubicBezTo>
                    <a:cubicBezTo>
                      <a:pt x="385" y="547"/>
                      <a:pt x="331" y="573"/>
                      <a:pt x="265" y="573"/>
                    </a:cubicBezTo>
                    <a:cubicBezTo>
                      <a:pt x="225" y="573"/>
                      <a:pt x="190" y="565"/>
                      <a:pt x="161" y="550"/>
                    </a:cubicBezTo>
                    <a:cubicBezTo>
                      <a:pt x="132" y="535"/>
                      <a:pt x="108" y="511"/>
                      <a:pt x="90" y="478"/>
                    </a:cubicBezTo>
                    <a:close/>
                    <a:moveTo>
                      <a:pt x="396" y="287"/>
                    </a:moveTo>
                    <a:cubicBezTo>
                      <a:pt x="396" y="221"/>
                      <a:pt x="382" y="170"/>
                      <a:pt x="355" y="132"/>
                    </a:cubicBezTo>
                    <a:cubicBezTo>
                      <a:pt x="327" y="94"/>
                      <a:pt x="290" y="75"/>
                      <a:pt x="243" y="75"/>
                    </a:cubicBezTo>
                    <a:cubicBezTo>
                      <a:pt x="195" y="75"/>
                      <a:pt x="158" y="94"/>
                      <a:pt x="131" y="132"/>
                    </a:cubicBezTo>
                    <a:cubicBezTo>
                      <a:pt x="103" y="170"/>
                      <a:pt x="90" y="221"/>
                      <a:pt x="90" y="287"/>
                    </a:cubicBezTo>
                    <a:cubicBezTo>
                      <a:pt x="90" y="353"/>
                      <a:pt x="103" y="405"/>
                      <a:pt x="131" y="443"/>
                    </a:cubicBezTo>
                    <a:cubicBezTo>
                      <a:pt x="158" y="481"/>
                      <a:pt x="195" y="499"/>
                      <a:pt x="243" y="499"/>
                    </a:cubicBezTo>
                    <a:cubicBezTo>
                      <a:pt x="290" y="499"/>
                      <a:pt x="327" y="481"/>
                      <a:pt x="355" y="443"/>
                    </a:cubicBezTo>
                    <a:cubicBezTo>
                      <a:pt x="382" y="405"/>
                      <a:pt x="396" y="353"/>
                      <a:pt x="396" y="287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6" name="Freeform 110">
                <a:extLst>
                  <a:ext uri="{FF2B5EF4-FFF2-40B4-BE49-F238E27FC236}">
                    <a16:creationId xmlns:a16="http://schemas.microsoft.com/office/drawing/2014/main" id="{79C33AEC-6318-3552-2A72-0871D50064A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849688" y="5408613"/>
                <a:ext cx="90488" cy="104775"/>
              </a:xfrm>
              <a:custGeom>
                <a:avLst/>
                <a:gdLst>
                  <a:gd name="T0" fmla="*/ 251 w 502"/>
                  <a:gd name="T1" fmla="*/ 76 h 573"/>
                  <a:gd name="T2" fmla="*/ 137 w 502"/>
                  <a:gd name="T3" fmla="*/ 133 h 573"/>
                  <a:gd name="T4" fmla="*/ 95 w 502"/>
                  <a:gd name="T5" fmla="*/ 287 h 573"/>
                  <a:gd name="T6" fmla="*/ 136 w 502"/>
                  <a:gd name="T7" fmla="*/ 442 h 573"/>
                  <a:gd name="T8" fmla="*/ 251 w 502"/>
                  <a:gd name="T9" fmla="*/ 498 h 573"/>
                  <a:gd name="T10" fmla="*/ 365 w 502"/>
                  <a:gd name="T11" fmla="*/ 442 h 573"/>
                  <a:gd name="T12" fmla="*/ 407 w 502"/>
                  <a:gd name="T13" fmla="*/ 287 h 573"/>
                  <a:gd name="T14" fmla="*/ 365 w 502"/>
                  <a:gd name="T15" fmla="*/ 133 h 573"/>
                  <a:gd name="T16" fmla="*/ 251 w 502"/>
                  <a:gd name="T17" fmla="*/ 76 h 573"/>
                  <a:gd name="T18" fmla="*/ 251 w 502"/>
                  <a:gd name="T19" fmla="*/ 0 h 573"/>
                  <a:gd name="T20" fmla="*/ 435 w 502"/>
                  <a:gd name="T21" fmla="*/ 76 h 573"/>
                  <a:gd name="T22" fmla="*/ 502 w 502"/>
                  <a:gd name="T23" fmla="*/ 287 h 573"/>
                  <a:gd name="T24" fmla="*/ 435 w 502"/>
                  <a:gd name="T25" fmla="*/ 497 h 573"/>
                  <a:gd name="T26" fmla="*/ 251 w 502"/>
                  <a:gd name="T27" fmla="*/ 573 h 573"/>
                  <a:gd name="T28" fmla="*/ 66 w 502"/>
                  <a:gd name="T29" fmla="*/ 497 h 573"/>
                  <a:gd name="T30" fmla="*/ 0 w 502"/>
                  <a:gd name="T31" fmla="*/ 287 h 573"/>
                  <a:gd name="T32" fmla="*/ 66 w 502"/>
                  <a:gd name="T33" fmla="*/ 76 h 573"/>
                  <a:gd name="T34" fmla="*/ 251 w 502"/>
                  <a:gd name="T35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2" h="573">
                    <a:moveTo>
                      <a:pt x="251" y="76"/>
                    </a:moveTo>
                    <a:cubicBezTo>
                      <a:pt x="203" y="76"/>
                      <a:pt x="165" y="95"/>
                      <a:pt x="137" y="133"/>
                    </a:cubicBezTo>
                    <a:cubicBezTo>
                      <a:pt x="109" y="171"/>
                      <a:pt x="95" y="222"/>
                      <a:pt x="95" y="287"/>
                    </a:cubicBezTo>
                    <a:cubicBezTo>
                      <a:pt x="95" y="353"/>
                      <a:pt x="108" y="404"/>
                      <a:pt x="136" y="442"/>
                    </a:cubicBezTo>
                    <a:cubicBezTo>
                      <a:pt x="164" y="480"/>
                      <a:pt x="202" y="498"/>
                      <a:pt x="251" y="498"/>
                    </a:cubicBezTo>
                    <a:cubicBezTo>
                      <a:pt x="299" y="498"/>
                      <a:pt x="337" y="480"/>
                      <a:pt x="365" y="442"/>
                    </a:cubicBezTo>
                    <a:cubicBezTo>
                      <a:pt x="393" y="404"/>
                      <a:pt x="407" y="353"/>
                      <a:pt x="407" y="287"/>
                    </a:cubicBezTo>
                    <a:cubicBezTo>
                      <a:pt x="407" y="223"/>
                      <a:pt x="393" y="171"/>
                      <a:pt x="365" y="133"/>
                    </a:cubicBezTo>
                    <a:cubicBezTo>
                      <a:pt x="337" y="95"/>
                      <a:pt x="299" y="76"/>
                      <a:pt x="251" y="76"/>
                    </a:cubicBezTo>
                    <a:close/>
                    <a:moveTo>
                      <a:pt x="251" y="0"/>
                    </a:moveTo>
                    <a:cubicBezTo>
                      <a:pt x="329" y="0"/>
                      <a:pt x="390" y="26"/>
                      <a:pt x="435" y="76"/>
                    </a:cubicBezTo>
                    <a:cubicBezTo>
                      <a:pt x="479" y="127"/>
                      <a:pt x="502" y="197"/>
                      <a:pt x="502" y="287"/>
                    </a:cubicBezTo>
                    <a:cubicBezTo>
                      <a:pt x="502" y="377"/>
                      <a:pt x="479" y="447"/>
                      <a:pt x="435" y="497"/>
                    </a:cubicBezTo>
                    <a:cubicBezTo>
                      <a:pt x="390" y="548"/>
                      <a:pt x="329" y="573"/>
                      <a:pt x="251" y="573"/>
                    </a:cubicBezTo>
                    <a:cubicBezTo>
                      <a:pt x="172" y="573"/>
                      <a:pt x="110" y="548"/>
                      <a:pt x="66" y="497"/>
                    </a:cubicBezTo>
                    <a:cubicBezTo>
                      <a:pt x="22" y="447"/>
                      <a:pt x="0" y="377"/>
                      <a:pt x="0" y="287"/>
                    </a:cubicBezTo>
                    <a:cubicBezTo>
                      <a:pt x="0" y="197"/>
                      <a:pt x="22" y="127"/>
                      <a:pt x="66" y="76"/>
                    </a:cubicBezTo>
                    <a:cubicBezTo>
                      <a:pt x="110" y="26"/>
                      <a:pt x="172" y="0"/>
                      <a:pt x="251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7" name="Freeform 111">
                <a:extLst>
                  <a:ext uri="{FF2B5EF4-FFF2-40B4-BE49-F238E27FC236}">
                    <a16:creationId xmlns:a16="http://schemas.microsoft.com/office/drawing/2014/main" id="{DC4D45C4-58E2-5384-9E7C-511C31DF91F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960813" y="5408613"/>
                <a:ext cx="74613" cy="104775"/>
              </a:xfrm>
              <a:custGeom>
                <a:avLst/>
                <a:gdLst>
                  <a:gd name="T0" fmla="*/ 389 w 418"/>
                  <a:gd name="T1" fmla="*/ 29 h 573"/>
                  <a:gd name="T2" fmla="*/ 389 w 418"/>
                  <a:gd name="T3" fmla="*/ 114 h 573"/>
                  <a:gd name="T4" fmla="*/ 310 w 418"/>
                  <a:gd name="T5" fmla="*/ 85 h 573"/>
                  <a:gd name="T6" fmla="*/ 225 w 418"/>
                  <a:gd name="T7" fmla="*/ 75 h 573"/>
                  <a:gd name="T8" fmla="*/ 124 w 418"/>
                  <a:gd name="T9" fmla="*/ 96 h 573"/>
                  <a:gd name="T10" fmla="*/ 91 w 418"/>
                  <a:gd name="T11" fmla="*/ 157 h 573"/>
                  <a:gd name="T12" fmla="*/ 115 w 418"/>
                  <a:gd name="T13" fmla="*/ 206 h 573"/>
                  <a:gd name="T14" fmla="*/ 211 w 418"/>
                  <a:gd name="T15" fmla="*/ 240 h 573"/>
                  <a:gd name="T16" fmla="*/ 242 w 418"/>
                  <a:gd name="T17" fmla="*/ 247 h 573"/>
                  <a:gd name="T18" fmla="*/ 378 w 418"/>
                  <a:gd name="T19" fmla="*/ 305 h 573"/>
                  <a:gd name="T20" fmla="*/ 418 w 418"/>
                  <a:gd name="T21" fmla="*/ 409 h 573"/>
                  <a:gd name="T22" fmla="*/ 358 w 418"/>
                  <a:gd name="T23" fmla="*/ 529 h 573"/>
                  <a:gd name="T24" fmla="*/ 192 w 418"/>
                  <a:gd name="T25" fmla="*/ 573 h 573"/>
                  <a:gd name="T26" fmla="*/ 100 w 418"/>
                  <a:gd name="T27" fmla="*/ 565 h 573"/>
                  <a:gd name="T28" fmla="*/ 0 w 418"/>
                  <a:gd name="T29" fmla="*/ 540 h 573"/>
                  <a:gd name="T30" fmla="*/ 0 w 418"/>
                  <a:gd name="T31" fmla="*/ 447 h 573"/>
                  <a:gd name="T32" fmla="*/ 98 w 418"/>
                  <a:gd name="T33" fmla="*/ 486 h 573"/>
                  <a:gd name="T34" fmla="*/ 194 w 418"/>
                  <a:gd name="T35" fmla="*/ 499 h 573"/>
                  <a:gd name="T36" fmla="*/ 292 w 418"/>
                  <a:gd name="T37" fmla="*/ 478 h 573"/>
                  <a:gd name="T38" fmla="*/ 326 w 418"/>
                  <a:gd name="T39" fmla="*/ 416 h 573"/>
                  <a:gd name="T40" fmla="*/ 301 w 418"/>
                  <a:gd name="T41" fmla="*/ 360 h 573"/>
                  <a:gd name="T42" fmla="*/ 193 w 418"/>
                  <a:gd name="T43" fmla="*/ 322 h 573"/>
                  <a:gd name="T44" fmla="*/ 162 w 418"/>
                  <a:gd name="T45" fmla="*/ 315 h 573"/>
                  <a:gd name="T46" fmla="*/ 41 w 418"/>
                  <a:gd name="T47" fmla="*/ 261 h 573"/>
                  <a:gd name="T48" fmla="*/ 4 w 418"/>
                  <a:gd name="T49" fmla="*/ 161 h 573"/>
                  <a:gd name="T50" fmla="*/ 58 w 418"/>
                  <a:gd name="T51" fmla="*/ 42 h 573"/>
                  <a:gd name="T52" fmla="*/ 214 w 418"/>
                  <a:gd name="T53" fmla="*/ 0 h 573"/>
                  <a:gd name="T54" fmla="*/ 308 w 418"/>
                  <a:gd name="T55" fmla="*/ 8 h 573"/>
                  <a:gd name="T56" fmla="*/ 389 w 418"/>
                  <a:gd name="T57" fmla="*/ 29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418" h="573">
                    <a:moveTo>
                      <a:pt x="389" y="29"/>
                    </a:moveTo>
                    <a:lnTo>
                      <a:pt x="389" y="114"/>
                    </a:lnTo>
                    <a:cubicBezTo>
                      <a:pt x="363" y="102"/>
                      <a:pt x="337" y="92"/>
                      <a:pt x="310" y="85"/>
                    </a:cubicBezTo>
                    <a:cubicBezTo>
                      <a:pt x="282" y="79"/>
                      <a:pt x="254" y="75"/>
                      <a:pt x="225" y="75"/>
                    </a:cubicBezTo>
                    <a:cubicBezTo>
                      <a:pt x="180" y="75"/>
                      <a:pt x="146" y="82"/>
                      <a:pt x="124" y="96"/>
                    </a:cubicBezTo>
                    <a:cubicBezTo>
                      <a:pt x="102" y="110"/>
                      <a:pt x="91" y="130"/>
                      <a:pt x="91" y="157"/>
                    </a:cubicBezTo>
                    <a:cubicBezTo>
                      <a:pt x="91" y="178"/>
                      <a:pt x="99" y="194"/>
                      <a:pt x="115" y="206"/>
                    </a:cubicBezTo>
                    <a:cubicBezTo>
                      <a:pt x="131" y="218"/>
                      <a:pt x="163" y="230"/>
                      <a:pt x="211" y="240"/>
                    </a:cubicBezTo>
                    <a:lnTo>
                      <a:pt x="242" y="247"/>
                    </a:lnTo>
                    <a:cubicBezTo>
                      <a:pt x="306" y="261"/>
                      <a:pt x="351" y="281"/>
                      <a:pt x="378" y="305"/>
                    </a:cubicBezTo>
                    <a:cubicBezTo>
                      <a:pt x="404" y="330"/>
                      <a:pt x="418" y="365"/>
                      <a:pt x="418" y="409"/>
                    </a:cubicBezTo>
                    <a:cubicBezTo>
                      <a:pt x="418" y="460"/>
                      <a:pt x="398" y="500"/>
                      <a:pt x="358" y="529"/>
                    </a:cubicBezTo>
                    <a:cubicBezTo>
                      <a:pt x="318" y="559"/>
                      <a:pt x="262" y="573"/>
                      <a:pt x="192" y="573"/>
                    </a:cubicBezTo>
                    <a:cubicBezTo>
                      <a:pt x="162" y="573"/>
                      <a:pt x="132" y="570"/>
                      <a:pt x="100" y="565"/>
                    </a:cubicBezTo>
                    <a:cubicBezTo>
                      <a:pt x="68" y="560"/>
                      <a:pt x="35" y="552"/>
                      <a:pt x="0" y="540"/>
                    </a:cubicBezTo>
                    <a:lnTo>
                      <a:pt x="0" y="447"/>
                    </a:lnTo>
                    <a:cubicBezTo>
                      <a:pt x="33" y="465"/>
                      <a:pt x="66" y="478"/>
                      <a:pt x="98" y="486"/>
                    </a:cubicBezTo>
                    <a:cubicBezTo>
                      <a:pt x="130" y="495"/>
                      <a:pt x="162" y="499"/>
                      <a:pt x="194" y="499"/>
                    </a:cubicBezTo>
                    <a:cubicBezTo>
                      <a:pt x="236" y="499"/>
                      <a:pt x="269" y="492"/>
                      <a:pt x="292" y="478"/>
                    </a:cubicBezTo>
                    <a:cubicBezTo>
                      <a:pt x="314" y="464"/>
                      <a:pt x="326" y="443"/>
                      <a:pt x="326" y="416"/>
                    </a:cubicBezTo>
                    <a:cubicBezTo>
                      <a:pt x="326" y="392"/>
                      <a:pt x="317" y="373"/>
                      <a:pt x="301" y="360"/>
                    </a:cubicBezTo>
                    <a:cubicBezTo>
                      <a:pt x="285" y="347"/>
                      <a:pt x="249" y="334"/>
                      <a:pt x="193" y="322"/>
                    </a:cubicBezTo>
                    <a:lnTo>
                      <a:pt x="162" y="315"/>
                    </a:lnTo>
                    <a:cubicBezTo>
                      <a:pt x="106" y="303"/>
                      <a:pt x="65" y="285"/>
                      <a:pt x="41" y="261"/>
                    </a:cubicBezTo>
                    <a:cubicBezTo>
                      <a:pt x="16" y="237"/>
                      <a:pt x="4" y="204"/>
                      <a:pt x="4" y="161"/>
                    </a:cubicBezTo>
                    <a:cubicBezTo>
                      <a:pt x="4" y="110"/>
                      <a:pt x="22" y="70"/>
                      <a:pt x="58" y="42"/>
                    </a:cubicBezTo>
                    <a:cubicBezTo>
                      <a:pt x="94" y="14"/>
                      <a:pt x="146" y="0"/>
                      <a:pt x="214" y="0"/>
                    </a:cubicBezTo>
                    <a:cubicBezTo>
                      <a:pt x="247" y="0"/>
                      <a:pt x="278" y="3"/>
                      <a:pt x="308" y="8"/>
                    </a:cubicBezTo>
                    <a:cubicBezTo>
                      <a:pt x="337" y="13"/>
                      <a:pt x="364" y="20"/>
                      <a:pt x="389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8" name="Freeform 112">
                <a:extLst>
                  <a:ext uri="{FF2B5EF4-FFF2-40B4-BE49-F238E27FC236}">
                    <a16:creationId xmlns:a16="http://schemas.microsoft.com/office/drawing/2014/main" id="{D6B18121-4F61-DF68-A10E-B36D32EF7C9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054475" y="5408613"/>
                <a:ext cx="92075" cy="104775"/>
              </a:xfrm>
              <a:custGeom>
                <a:avLst/>
                <a:gdLst>
                  <a:gd name="T0" fmla="*/ 507 w 507"/>
                  <a:gd name="T1" fmla="*/ 264 h 573"/>
                  <a:gd name="T2" fmla="*/ 507 w 507"/>
                  <a:gd name="T3" fmla="*/ 308 h 573"/>
                  <a:gd name="T4" fmla="*/ 94 w 507"/>
                  <a:gd name="T5" fmla="*/ 308 h 573"/>
                  <a:gd name="T6" fmla="*/ 150 w 507"/>
                  <a:gd name="T7" fmla="*/ 450 h 573"/>
                  <a:gd name="T8" fmla="*/ 289 w 507"/>
                  <a:gd name="T9" fmla="*/ 498 h 573"/>
                  <a:gd name="T10" fmla="*/ 389 w 507"/>
                  <a:gd name="T11" fmla="*/ 486 h 573"/>
                  <a:gd name="T12" fmla="*/ 486 w 507"/>
                  <a:gd name="T13" fmla="*/ 447 h 573"/>
                  <a:gd name="T14" fmla="*/ 486 w 507"/>
                  <a:gd name="T15" fmla="*/ 532 h 573"/>
                  <a:gd name="T16" fmla="*/ 387 w 507"/>
                  <a:gd name="T17" fmla="*/ 563 h 573"/>
                  <a:gd name="T18" fmla="*/ 284 w 507"/>
                  <a:gd name="T19" fmla="*/ 573 h 573"/>
                  <a:gd name="T20" fmla="*/ 76 w 507"/>
                  <a:gd name="T21" fmla="*/ 498 h 573"/>
                  <a:gd name="T22" fmla="*/ 0 w 507"/>
                  <a:gd name="T23" fmla="*/ 292 h 573"/>
                  <a:gd name="T24" fmla="*/ 72 w 507"/>
                  <a:gd name="T25" fmla="*/ 79 h 573"/>
                  <a:gd name="T26" fmla="*/ 268 w 507"/>
                  <a:gd name="T27" fmla="*/ 0 h 573"/>
                  <a:gd name="T28" fmla="*/ 443 w 507"/>
                  <a:gd name="T29" fmla="*/ 71 h 573"/>
                  <a:gd name="T30" fmla="*/ 507 w 507"/>
                  <a:gd name="T31" fmla="*/ 264 h 573"/>
                  <a:gd name="T32" fmla="*/ 417 w 507"/>
                  <a:gd name="T33" fmla="*/ 238 h 573"/>
                  <a:gd name="T34" fmla="*/ 376 w 507"/>
                  <a:gd name="T35" fmla="*/ 120 h 573"/>
                  <a:gd name="T36" fmla="*/ 269 w 507"/>
                  <a:gd name="T37" fmla="*/ 76 h 573"/>
                  <a:gd name="T38" fmla="*/ 149 w 507"/>
                  <a:gd name="T39" fmla="*/ 119 h 573"/>
                  <a:gd name="T40" fmla="*/ 97 w 507"/>
                  <a:gd name="T41" fmla="*/ 238 h 573"/>
                  <a:gd name="T42" fmla="*/ 417 w 507"/>
                  <a:gd name="T43" fmla="*/ 23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07" h="573">
                    <a:moveTo>
                      <a:pt x="507" y="264"/>
                    </a:moveTo>
                    <a:lnTo>
                      <a:pt x="507" y="308"/>
                    </a:lnTo>
                    <a:lnTo>
                      <a:pt x="94" y="308"/>
                    </a:lnTo>
                    <a:cubicBezTo>
                      <a:pt x="98" y="370"/>
                      <a:pt x="116" y="418"/>
                      <a:pt x="150" y="450"/>
                    </a:cubicBezTo>
                    <a:cubicBezTo>
                      <a:pt x="183" y="482"/>
                      <a:pt x="229" y="498"/>
                      <a:pt x="289" y="498"/>
                    </a:cubicBezTo>
                    <a:cubicBezTo>
                      <a:pt x="323" y="498"/>
                      <a:pt x="357" y="494"/>
                      <a:pt x="389" y="486"/>
                    </a:cubicBezTo>
                    <a:cubicBezTo>
                      <a:pt x="421" y="478"/>
                      <a:pt x="454" y="465"/>
                      <a:pt x="486" y="447"/>
                    </a:cubicBezTo>
                    <a:lnTo>
                      <a:pt x="486" y="532"/>
                    </a:lnTo>
                    <a:cubicBezTo>
                      <a:pt x="454" y="546"/>
                      <a:pt x="421" y="557"/>
                      <a:pt x="387" y="563"/>
                    </a:cubicBezTo>
                    <a:cubicBezTo>
                      <a:pt x="353" y="569"/>
                      <a:pt x="318" y="573"/>
                      <a:pt x="284" y="573"/>
                    </a:cubicBezTo>
                    <a:cubicBezTo>
                      <a:pt x="196" y="573"/>
                      <a:pt x="127" y="548"/>
                      <a:pt x="76" y="498"/>
                    </a:cubicBezTo>
                    <a:cubicBezTo>
                      <a:pt x="25" y="448"/>
                      <a:pt x="0" y="379"/>
                      <a:pt x="0" y="292"/>
                    </a:cubicBezTo>
                    <a:cubicBezTo>
                      <a:pt x="0" y="203"/>
                      <a:pt x="24" y="132"/>
                      <a:pt x="72" y="79"/>
                    </a:cubicBezTo>
                    <a:cubicBezTo>
                      <a:pt x="120" y="27"/>
                      <a:pt x="186" y="0"/>
                      <a:pt x="268" y="0"/>
                    </a:cubicBezTo>
                    <a:cubicBezTo>
                      <a:pt x="342" y="0"/>
                      <a:pt x="400" y="24"/>
                      <a:pt x="443" y="71"/>
                    </a:cubicBezTo>
                    <a:cubicBezTo>
                      <a:pt x="485" y="119"/>
                      <a:pt x="507" y="183"/>
                      <a:pt x="507" y="264"/>
                    </a:cubicBezTo>
                    <a:close/>
                    <a:moveTo>
                      <a:pt x="417" y="238"/>
                    </a:moveTo>
                    <a:cubicBezTo>
                      <a:pt x="416" y="189"/>
                      <a:pt x="402" y="150"/>
                      <a:pt x="376" y="120"/>
                    </a:cubicBezTo>
                    <a:cubicBezTo>
                      <a:pt x="349" y="91"/>
                      <a:pt x="313" y="76"/>
                      <a:pt x="269" y="76"/>
                    </a:cubicBezTo>
                    <a:cubicBezTo>
                      <a:pt x="219" y="76"/>
                      <a:pt x="179" y="91"/>
                      <a:pt x="149" y="119"/>
                    </a:cubicBezTo>
                    <a:cubicBezTo>
                      <a:pt x="119" y="147"/>
                      <a:pt x="101" y="187"/>
                      <a:pt x="97" y="238"/>
                    </a:cubicBezTo>
                    <a:lnTo>
                      <a:pt x="417" y="238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9" name="Freeform 113">
                <a:extLst>
                  <a:ext uri="{FF2B5EF4-FFF2-40B4-BE49-F238E27FC236}">
                    <a16:creationId xmlns:a16="http://schemas.microsoft.com/office/drawing/2014/main" id="{68435A2C-E162-86FE-5A39-AE6F1850B4D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68825" y="5376863"/>
                <a:ext cx="106363" cy="136525"/>
              </a:xfrm>
              <a:custGeom>
                <a:avLst/>
                <a:gdLst>
                  <a:gd name="T0" fmla="*/ 588 w 588"/>
                  <a:gd name="T1" fmla="*/ 69 h 755"/>
                  <a:gd name="T2" fmla="*/ 588 w 588"/>
                  <a:gd name="T3" fmla="*/ 173 h 755"/>
                  <a:gd name="T4" fmla="*/ 481 w 588"/>
                  <a:gd name="T5" fmla="*/ 104 h 755"/>
                  <a:gd name="T6" fmla="*/ 362 w 588"/>
                  <a:gd name="T7" fmla="*/ 81 h 755"/>
                  <a:gd name="T8" fmla="*/ 170 w 588"/>
                  <a:gd name="T9" fmla="*/ 158 h 755"/>
                  <a:gd name="T10" fmla="*/ 104 w 588"/>
                  <a:gd name="T11" fmla="*/ 378 h 755"/>
                  <a:gd name="T12" fmla="*/ 170 w 588"/>
                  <a:gd name="T13" fmla="*/ 599 h 755"/>
                  <a:gd name="T14" fmla="*/ 362 w 588"/>
                  <a:gd name="T15" fmla="*/ 675 h 755"/>
                  <a:gd name="T16" fmla="*/ 481 w 588"/>
                  <a:gd name="T17" fmla="*/ 652 h 755"/>
                  <a:gd name="T18" fmla="*/ 588 w 588"/>
                  <a:gd name="T19" fmla="*/ 583 h 755"/>
                  <a:gd name="T20" fmla="*/ 588 w 588"/>
                  <a:gd name="T21" fmla="*/ 686 h 755"/>
                  <a:gd name="T22" fmla="*/ 478 w 588"/>
                  <a:gd name="T23" fmla="*/ 738 h 755"/>
                  <a:gd name="T24" fmla="*/ 356 w 588"/>
                  <a:gd name="T25" fmla="*/ 755 h 755"/>
                  <a:gd name="T26" fmla="*/ 95 w 588"/>
                  <a:gd name="T27" fmla="*/ 655 h 755"/>
                  <a:gd name="T28" fmla="*/ 0 w 588"/>
                  <a:gd name="T29" fmla="*/ 378 h 755"/>
                  <a:gd name="T30" fmla="*/ 95 w 588"/>
                  <a:gd name="T31" fmla="*/ 101 h 755"/>
                  <a:gd name="T32" fmla="*/ 356 w 588"/>
                  <a:gd name="T33" fmla="*/ 0 h 755"/>
                  <a:gd name="T34" fmla="*/ 479 w 588"/>
                  <a:gd name="T35" fmla="*/ 17 h 755"/>
                  <a:gd name="T36" fmla="*/ 588 w 588"/>
                  <a:gd name="T37" fmla="*/ 69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588" h="755">
                    <a:moveTo>
                      <a:pt x="588" y="69"/>
                    </a:moveTo>
                    <a:lnTo>
                      <a:pt x="588" y="173"/>
                    </a:lnTo>
                    <a:cubicBezTo>
                      <a:pt x="554" y="143"/>
                      <a:pt x="519" y="120"/>
                      <a:pt x="481" y="104"/>
                    </a:cubicBezTo>
                    <a:cubicBezTo>
                      <a:pt x="443" y="89"/>
                      <a:pt x="404" y="81"/>
                      <a:pt x="362" y="81"/>
                    </a:cubicBezTo>
                    <a:cubicBezTo>
                      <a:pt x="278" y="81"/>
                      <a:pt x="214" y="107"/>
                      <a:pt x="170" y="158"/>
                    </a:cubicBezTo>
                    <a:cubicBezTo>
                      <a:pt x="126" y="209"/>
                      <a:pt x="104" y="282"/>
                      <a:pt x="104" y="378"/>
                    </a:cubicBezTo>
                    <a:cubicBezTo>
                      <a:pt x="104" y="474"/>
                      <a:pt x="126" y="548"/>
                      <a:pt x="170" y="599"/>
                    </a:cubicBezTo>
                    <a:cubicBezTo>
                      <a:pt x="214" y="650"/>
                      <a:pt x="278" y="675"/>
                      <a:pt x="362" y="675"/>
                    </a:cubicBezTo>
                    <a:cubicBezTo>
                      <a:pt x="404" y="675"/>
                      <a:pt x="443" y="668"/>
                      <a:pt x="481" y="652"/>
                    </a:cubicBezTo>
                    <a:cubicBezTo>
                      <a:pt x="519" y="637"/>
                      <a:pt x="554" y="614"/>
                      <a:pt x="588" y="583"/>
                    </a:cubicBezTo>
                    <a:lnTo>
                      <a:pt x="588" y="686"/>
                    </a:lnTo>
                    <a:cubicBezTo>
                      <a:pt x="553" y="710"/>
                      <a:pt x="516" y="727"/>
                      <a:pt x="478" y="738"/>
                    </a:cubicBezTo>
                    <a:cubicBezTo>
                      <a:pt x="440" y="749"/>
                      <a:pt x="399" y="755"/>
                      <a:pt x="356" y="755"/>
                    </a:cubicBezTo>
                    <a:cubicBezTo>
                      <a:pt x="246" y="755"/>
                      <a:pt x="159" y="722"/>
                      <a:pt x="95" y="655"/>
                    </a:cubicBezTo>
                    <a:cubicBezTo>
                      <a:pt x="31" y="588"/>
                      <a:pt x="0" y="496"/>
                      <a:pt x="0" y="378"/>
                    </a:cubicBezTo>
                    <a:cubicBezTo>
                      <a:pt x="0" y="261"/>
                      <a:pt x="31" y="169"/>
                      <a:pt x="95" y="101"/>
                    </a:cubicBezTo>
                    <a:cubicBezTo>
                      <a:pt x="159" y="34"/>
                      <a:pt x="246" y="0"/>
                      <a:pt x="356" y="0"/>
                    </a:cubicBezTo>
                    <a:cubicBezTo>
                      <a:pt x="400" y="0"/>
                      <a:pt x="441" y="6"/>
                      <a:pt x="479" y="17"/>
                    </a:cubicBezTo>
                    <a:cubicBezTo>
                      <a:pt x="517" y="29"/>
                      <a:pt x="554" y="46"/>
                      <a:pt x="588" y="6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0" name="Freeform 114">
                <a:extLst>
                  <a:ext uri="{FF2B5EF4-FFF2-40B4-BE49-F238E27FC236}">
                    <a16:creationId xmlns:a16="http://schemas.microsoft.com/office/drawing/2014/main" id="{365BEC07-A580-2E80-B530-EB95DE3A29D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695825" y="5408613"/>
                <a:ext cx="90488" cy="104775"/>
              </a:xfrm>
              <a:custGeom>
                <a:avLst/>
                <a:gdLst>
                  <a:gd name="T0" fmla="*/ 507 w 507"/>
                  <a:gd name="T1" fmla="*/ 264 h 573"/>
                  <a:gd name="T2" fmla="*/ 507 w 507"/>
                  <a:gd name="T3" fmla="*/ 308 h 573"/>
                  <a:gd name="T4" fmla="*/ 94 w 507"/>
                  <a:gd name="T5" fmla="*/ 308 h 573"/>
                  <a:gd name="T6" fmla="*/ 150 w 507"/>
                  <a:gd name="T7" fmla="*/ 450 h 573"/>
                  <a:gd name="T8" fmla="*/ 289 w 507"/>
                  <a:gd name="T9" fmla="*/ 498 h 573"/>
                  <a:gd name="T10" fmla="*/ 389 w 507"/>
                  <a:gd name="T11" fmla="*/ 486 h 573"/>
                  <a:gd name="T12" fmla="*/ 486 w 507"/>
                  <a:gd name="T13" fmla="*/ 447 h 573"/>
                  <a:gd name="T14" fmla="*/ 486 w 507"/>
                  <a:gd name="T15" fmla="*/ 532 h 573"/>
                  <a:gd name="T16" fmla="*/ 387 w 507"/>
                  <a:gd name="T17" fmla="*/ 563 h 573"/>
                  <a:gd name="T18" fmla="*/ 284 w 507"/>
                  <a:gd name="T19" fmla="*/ 573 h 573"/>
                  <a:gd name="T20" fmla="*/ 76 w 507"/>
                  <a:gd name="T21" fmla="*/ 498 h 573"/>
                  <a:gd name="T22" fmla="*/ 0 w 507"/>
                  <a:gd name="T23" fmla="*/ 292 h 573"/>
                  <a:gd name="T24" fmla="*/ 72 w 507"/>
                  <a:gd name="T25" fmla="*/ 79 h 573"/>
                  <a:gd name="T26" fmla="*/ 268 w 507"/>
                  <a:gd name="T27" fmla="*/ 0 h 573"/>
                  <a:gd name="T28" fmla="*/ 443 w 507"/>
                  <a:gd name="T29" fmla="*/ 71 h 573"/>
                  <a:gd name="T30" fmla="*/ 507 w 507"/>
                  <a:gd name="T31" fmla="*/ 264 h 573"/>
                  <a:gd name="T32" fmla="*/ 417 w 507"/>
                  <a:gd name="T33" fmla="*/ 238 h 573"/>
                  <a:gd name="T34" fmla="*/ 376 w 507"/>
                  <a:gd name="T35" fmla="*/ 120 h 573"/>
                  <a:gd name="T36" fmla="*/ 269 w 507"/>
                  <a:gd name="T37" fmla="*/ 76 h 573"/>
                  <a:gd name="T38" fmla="*/ 149 w 507"/>
                  <a:gd name="T39" fmla="*/ 119 h 573"/>
                  <a:gd name="T40" fmla="*/ 97 w 507"/>
                  <a:gd name="T41" fmla="*/ 238 h 573"/>
                  <a:gd name="T42" fmla="*/ 417 w 507"/>
                  <a:gd name="T43" fmla="*/ 23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07" h="573">
                    <a:moveTo>
                      <a:pt x="507" y="264"/>
                    </a:moveTo>
                    <a:lnTo>
                      <a:pt x="507" y="308"/>
                    </a:lnTo>
                    <a:lnTo>
                      <a:pt x="94" y="308"/>
                    </a:lnTo>
                    <a:cubicBezTo>
                      <a:pt x="98" y="370"/>
                      <a:pt x="116" y="418"/>
                      <a:pt x="150" y="450"/>
                    </a:cubicBezTo>
                    <a:cubicBezTo>
                      <a:pt x="183" y="482"/>
                      <a:pt x="229" y="498"/>
                      <a:pt x="289" y="498"/>
                    </a:cubicBezTo>
                    <a:cubicBezTo>
                      <a:pt x="323" y="498"/>
                      <a:pt x="357" y="494"/>
                      <a:pt x="389" y="486"/>
                    </a:cubicBezTo>
                    <a:cubicBezTo>
                      <a:pt x="421" y="478"/>
                      <a:pt x="454" y="465"/>
                      <a:pt x="486" y="447"/>
                    </a:cubicBezTo>
                    <a:lnTo>
                      <a:pt x="486" y="532"/>
                    </a:lnTo>
                    <a:cubicBezTo>
                      <a:pt x="454" y="546"/>
                      <a:pt x="421" y="557"/>
                      <a:pt x="387" y="563"/>
                    </a:cubicBezTo>
                    <a:cubicBezTo>
                      <a:pt x="353" y="569"/>
                      <a:pt x="318" y="573"/>
                      <a:pt x="284" y="573"/>
                    </a:cubicBezTo>
                    <a:cubicBezTo>
                      <a:pt x="196" y="573"/>
                      <a:pt x="127" y="548"/>
                      <a:pt x="76" y="498"/>
                    </a:cubicBezTo>
                    <a:cubicBezTo>
                      <a:pt x="25" y="448"/>
                      <a:pt x="0" y="379"/>
                      <a:pt x="0" y="292"/>
                    </a:cubicBezTo>
                    <a:cubicBezTo>
                      <a:pt x="0" y="203"/>
                      <a:pt x="24" y="132"/>
                      <a:pt x="72" y="79"/>
                    </a:cubicBezTo>
                    <a:cubicBezTo>
                      <a:pt x="120" y="27"/>
                      <a:pt x="186" y="0"/>
                      <a:pt x="268" y="0"/>
                    </a:cubicBezTo>
                    <a:cubicBezTo>
                      <a:pt x="342" y="0"/>
                      <a:pt x="400" y="24"/>
                      <a:pt x="443" y="71"/>
                    </a:cubicBezTo>
                    <a:cubicBezTo>
                      <a:pt x="485" y="119"/>
                      <a:pt x="507" y="183"/>
                      <a:pt x="507" y="264"/>
                    </a:cubicBezTo>
                    <a:close/>
                    <a:moveTo>
                      <a:pt x="417" y="238"/>
                    </a:moveTo>
                    <a:cubicBezTo>
                      <a:pt x="416" y="189"/>
                      <a:pt x="402" y="150"/>
                      <a:pt x="376" y="120"/>
                    </a:cubicBezTo>
                    <a:cubicBezTo>
                      <a:pt x="349" y="91"/>
                      <a:pt x="313" y="76"/>
                      <a:pt x="269" y="76"/>
                    </a:cubicBezTo>
                    <a:cubicBezTo>
                      <a:pt x="219" y="76"/>
                      <a:pt x="179" y="91"/>
                      <a:pt x="149" y="119"/>
                    </a:cubicBezTo>
                    <a:cubicBezTo>
                      <a:pt x="119" y="147"/>
                      <a:pt x="101" y="187"/>
                      <a:pt x="97" y="238"/>
                    </a:cubicBezTo>
                    <a:lnTo>
                      <a:pt x="417" y="238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1" name="Rectangle 115">
                <a:extLst>
                  <a:ext uri="{FF2B5EF4-FFF2-40B4-BE49-F238E27FC236}">
                    <a16:creationId xmlns:a16="http://schemas.microsoft.com/office/drawing/2014/main" id="{82C658E3-5FBE-C894-DAFC-2F75B88E34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13300" y="5373688"/>
                <a:ext cx="15875" cy="1365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2" name="Rectangle 116">
                <a:extLst>
                  <a:ext uri="{FF2B5EF4-FFF2-40B4-BE49-F238E27FC236}">
                    <a16:creationId xmlns:a16="http://schemas.microsoft.com/office/drawing/2014/main" id="{83342E1F-08C6-9692-3C32-ED901407D3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62513" y="5373688"/>
                <a:ext cx="17463" cy="1365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3" name="Freeform 117">
                <a:extLst>
                  <a:ext uri="{FF2B5EF4-FFF2-40B4-BE49-F238E27FC236}">
                    <a16:creationId xmlns:a16="http://schemas.microsoft.com/office/drawing/2014/main" id="{CDC22174-1635-A7F8-3341-D066DB3A860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908550" y="5376863"/>
                <a:ext cx="92075" cy="136525"/>
              </a:xfrm>
              <a:custGeom>
                <a:avLst/>
                <a:gdLst>
                  <a:gd name="T0" fmla="*/ 469 w 513"/>
                  <a:gd name="T1" fmla="*/ 37 h 755"/>
                  <a:gd name="T2" fmla="*/ 469 w 513"/>
                  <a:gd name="T3" fmla="*/ 133 h 755"/>
                  <a:gd name="T4" fmla="*/ 363 w 513"/>
                  <a:gd name="T5" fmla="*/ 93 h 755"/>
                  <a:gd name="T6" fmla="*/ 267 w 513"/>
                  <a:gd name="T7" fmla="*/ 80 h 755"/>
                  <a:gd name="T8" fmla="*/ 142 w 513"/>
                  <a:gd name="T9" fmla="*/ 111 h 755"/>
                  <a:gd name="T10" fmla="*/ 99 w 513"/>
                  <a:gd name="T11" fmla="*/ 200 h 755"/>
                  <a:gd name="T12" fmla="*/ 128 w 513"/>
                  <a:gd name="T13" fmla="*/ 273 h 755"/>
                  <a:gd name="T14" fmla="*/ 238 w 513"/>
                  <a:gd name="T15" fmla="*/ 313 h 755"/>
                  <a:gd name="T16" fmla="*/ 298 w 513"/>
                  <a:gd name="T17" fmla="*/ 325 h 755"/>
                  <a:gd name="T18" fmla="*/ 460 w 513"/>
                  <a:gd name="T19" fmla="*/ 399 h 755"/>
                  <a:gd name="T20" fmla="*/ 513 w 513"/>
                  <a:gd name="T21" fmla="*/ 541 h 755"/>
                  <a:gd name="T22" fmla="*/ 442 w 513"/>
                  <a:gd name="T23" fmla="*/ 701 h 755"/>
                  <a:gd name="T24" fmla="*/ 234 w 513"/>
                  <a:gd name="T25" fmla="*/ 755 h 755"/>
                  <a:gd name="T26" fmla="*/ 123 w 513"/>
                  <a:gd name="T27" fmla="*/ 744 h 755"/>
                  <a:gd name="T28" fmla="*/ 3 w 513"/>
                  <a:gd name="T29" fmla="*/ 710 h 755"/>
                  <a:gd name="T30" fmla="*/ 3 w 513"/>
                  <a:gd name="T31" fmla="*/ 608 h 755"/>
                  <a:gd name="T32" fmla="*/ 120 w 513"/>
                  <a:gd name="T33" fmla="*/ 659 h 755"/>
                  <a:gd name="T34" fmla="*/ 234 w 513"/>
                  <a:gd name="T35" fmla="*/ 676 h 755"/>
                  <a:gd name="T36" fmla="*/ 364 w 513"/>
                  <a:gd name="T37" fmla="*/ 643 h 755"/>
                  <a:gd name="T38" fmla="*/ 410 w 513"/>
                  <a:gd name="T39" fmla="*/ 548 h 755"/>
                  <a:gd name="T40" fmla="*/ 377 w 513"/>
                  <a:gd name="T41" fmla="*/ 464 h 755"/>
                  <a:gd name="T42" fmla="*/ 269 w 513"/>
                  <a:gd name="T43" fmla="*/ 419 h 755"/>
                  <a:gd name="T44" fmla="*/ 209 w 513"/>
                  <a:gd name="T45" fmla="*/ 407 h 755"/>
                  <a:gd name="T46" fmla="*/ 49 w 513"/>
                  <a:gd name="T47" fmla="*/ 338 h 755"/>
                  <a:gd name="T48" fmla="*/ 0 w 513"/>
                  <a:gd name="T49" fmla="*/ 208 h 755"/>
                  <a:gd name="T50" fmla="*/ 68 w 513"/>
                  <a:gd name="T51" fmla="*/ 56 h 755"/>
                  <a:gd name="T52" fmla="*/ 256 w 513"/>
                  <a:gd name="T53" fmla="*/ 0 h 755"/>
                  <a:gd name="T54" fmla="*/ 360 w 513"/>
                  <a:gd name="T55" fmla="*/ 9 h 755"/>
                  <a:gd name="T56" fmla="*/ 469 w 513"/>
                  <a:gd name="T57" fmla="*/ 37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513" h="755">
                    <a:moveTo>
                      <a:pt x="469" y="37"/>
                    </a:moveTo>
                    <a:lnTo>
                      <a:pt x="469" y="133"/>
                    </a:lnTo>
                    <a:cubicBezTo>
                      <a:pt x="431" y="115"/>
                      <a:pt x="396" y="102"/>
                      <a:pt x="363" y="93"/>
                    </a:cubicBezTo>
                    <a:cubicBezTo>
                      <a:pt x="329" y="85"/>
                      <a:pt x="297" y="80"/>
                      <a:pt x="267" y="80"/>
                    </a:cubicBezTo>
                    <a:cubicBezTo>
                      <a:pt x="213" y="80"/>
                      <a:pt x="171" y="91"/>
                      <a:pt x="142" y="111"/>
                    </a:cubicBezTo>
                    <a:cubicBezTo>
                      <a:pt x="113" y="132"/>
                      <a:pt x="99" y="162"/>
                      <a:pt x="99" y="200"/>
                    </a:cubicBezTo>
                    <a:cubicBezTo>
                      <a:pt x="99" y="232"/>
                      <a:pt x="108" y="257"/>
                      <a:pt x="128" y="273"/>
                    </a:cubicBezTo>
                    <a:cubicBezTo>
                      <a:pt x="147" y="290"/>
                      <a:pt x="184" y="303"/>
                      <a:pt x="238" y="313"/>
                    </a:cubicBezTo>
                    <a:lnTo>
                      <a:pt x="298" y="325"/>
                    </a:lnTo>
                    <a:cubicBezTo>
                      <a:pt x="371" y="339"/>
                      <a:pt x="425" y="364"/>
                      <a:pt x="460" y="399"/>
                    </a:cubicBezTo>
                    <a:cubicBezTo>
                      <a:pt x="495" y="435"/>
                      <a:pt x="513" y="482"/>
                      <a:pt x="513" y="541"/>
                    </a:cubicBezTo>
                    <a:cubicBezTo>
                      <a:pt x="513" y="612"/>
                      <a:pt x="489" y="665"/>
                      <a:pt x="442" y="701"/>
                    </a:cubicBezTo>
                    <a:cubicBezTo>
                      <a:pt x="394" y="737"/>
                      <a:pt x="325" y="755"/>
                      <a:pt x="234" y="755"/>
                    </a:cubicBezTo>
                    <a:cubicBezTo>
                      <a:pt x="199" y="755"/>
                      <a:pt x="162" y="751"/>
                      <a:pt x="123" y="744"/>
                    </a:cubicBezTo>
                    <a:cubicBezTo>
                      <a:pt x="84" y="737"/>
                      <a:pt x="44" y="726"/>
                      <a:pt x="3" y="710"/>
                    </a:cubicBezTo>
                    <a:lnTo>
                      <a:pt x="3" y="608"/>
                    </a:lnTo>
                    <a:cubicBezTo>
                      <a:pt x="43" y="631"/>
                      <a:pt x="82" y="648"/>
                      <a:pt x="120" y="659"/>
                    </a:cubicBezTo>
                    <a:cubicBezTo>
                      <a:pt x="158" y="671"/>
                      <a:pt x="196" y="676"/>
                      <a:pt x="234" y="676"/>
                    </a:cubicBezTo>
                    <a:cubicBezTo>
                      <a:pt x="290" y="676"/>
                      <a:pt x="333" y="665"/>
                      <a:pt x="364" y="643"/>
                    </a:cubicBezTo>
                    <a:cubicBezTo>
                      <a:pt x="394" y="621"/>
                      <a:pt x="410" y="590"/>
                      <a:pt x="410" y="548"/>
                    </a:cubicBezTo>
                    <a:cubicBezTo>
                      <a:pt x="410" y="512"/>
                      <a:pt x="399" y="484"/>
                      <a:pt x="377" y="464"/>
                    </a:cubicBezTo>
                    <a:cubicBezTo>
                      <a:pt x="355" y="444"/>
                      <a:pt x="319" y="429"/>
                      <a:pt x="269" y="419"/>
                    </a:cubicBezTo>
                    <a:lnTo>
                      <a:pt x="209" y="407"/>
                    </a:lnTo>
                    <a:cubicBezTo>
                      <a:pt x="135" y="393"/>
                      <a:pt x="82" y="370"/>
                      <a:pt x="49" y="338"/>
                    </a:cubicBezTo>
                    <a:cubicBezTo>
                      <a:pt x="16" y="307"/>
                      <a:pt x="0" y="264"/>
                      <a:pt x="0" y="208"/>
                    </a:cubicBezTo>
                    <a:cubicBezTo>
                      <a:pt x="0" y="144"/>
                      <a:pt x="22" y="93"/>
                      <a:pt x="68" y="56"/>
                    </a:cubicBezTo>
                    <a:cubicBezTo>
                      <a:pt x="113" y="19"/>
                      <a:pt x="176" y="0"/>
                      <a:pt x="256" y="0"/>
                    </a:cubicBezTo>
                    <a:cubicBezTo>
                      <a:pt x="290" y="0"/>
                      <a:pt x="324" y="3"/>
                      <a:pt x="360" y="9"/>
                    </a:cubicBezTo>
                    <a:cubicBezTo>
                      <a:pt x="395" y="15"/>
                      <a:pt x="431" y="25"/>
                      <a:pt x="469" y="37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4" name="Freeform 118">
                <a:extLst>
                  <a:ext uri="{FF2B5EF4-FFF2-40B4-BE49-F238E27FC236}">
                    <a16:creationId xmlns:a16="http://schemas.microsoft.com/office/drawing/2014/main" id="{4919F912-3CCE-B92A-6EDC-1706285D0B0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27613" y="5408613"/>
                <a:ext cx="82550" cy="101600"/>
              </a:xfrm>
              <a:custGeom>
                <a:avLst/>
                <a:gdLst>
                  <a:gd name="T0" fmla="*/ 458 w 458"/>
                  <a:gd name="T1" fmla="*/ 230 h 560"/>
                  <a:gd name="T2" fmla="*/ 458 w 458"/>
                  <a:gd name="T3" fmla="*/ 560 h 560"/>
                  <a:gd name="T4" fmla="*/ 368 w 458"/>
                  <a:gd name="T5" fmla="*/ 560 h 560"/>
                  <a:gd name="T6" fmla="*/ 368 w 458"/>
                  <a:gd name="T7" fmla="*/ 233 h 560"/>
                  <a:gd name="T8" fmla="*/ 337 w 458"/>
                  <a:gd name="T9" fmla="*/ 117 h 560"/>
                  <a:gd name="T10" fmla="*/ 247 w 458"/>
                  <a:gd name="T11" fmla="*/ 78 h 560"/>
                  <a:gd name="T12" fmla="*/ 132 w 458"/>
                  <a:gd name="T13" fmla="*/ 125 h 560"/>
                  <a:gd name="T14" fmla="*/ 90 w 458"/>
                  <a:gd name="T15" fmla="*/ 251 h 560"/>
                  <a:gd name="T16" fmla="*/ 90 w 458"/>
                  <a:gd name="T17" fmla="*/ 560 h 560"/>
                  <a:gd name="T18" fmla="*/ 0 w 458"/>
                  <a:gd name="T19" fmla="*/ 560 h 560"/>
                  <a:gd name="T20" fmla="*/ 0 w 458"/>
                  <a:gd name="T21" fmla="*/ 13 h 560"/>
                  <a:gd name="T22" fmla="*/ 90 w 458"/>
                  <a:gd name="T23" fmla="*/ 13 h 560"/>
                  <a:gd name="T24" fmla="*/ 90 w 458"/>
                  <a:gd name="T25" fmla="*/ 98 h 560"/>
                  <a:gd name="T26" fmla="*/ 166 w 458"/>
                  <a:gd name="T27" fmla="*/ 25 h 560"/>
                  <a:gd name="T28" fmla="*/ 267 w 458"/>
                  <a:gd name="T29" fmla="*/ 0 h 560"/>
                  <a:gd name="T30" fmla="*/ 409 w 458"/>
                  <a:gd name="T31" fmla="*/ 59 h 560"/>
                  <a:gd name="T32" fmla="*/ 458 w 458"/>
                  <a:gd name="T33" fmla="*/ 230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58" h="560">
                    <a:moveTo>
                      <a:pt x="458" y="230"/>
                    </a:moveTo>
                    <a:lnTo>
                      <a:pt x="458" y="560"/>
                    </a:lnTo>
                    <a:lnTo>
                      <a:pt x="368" y="560"/>
                    </a:lnTo>
                    <a:lnTo>
                      <a:pt x="368" y="233"/>
                    </a:lnTo>
                    <a:cubicBezTo>
                      <a:pt x="368" y="181"/>
                      <a:pt x="357" y="143"/>
                      <a:pt x="337" y="117"/>
                    </a:cubicBezTo>
                    <a:cubicBezTo>
                      <a:pt x="317" y="91"/>
                      <a:pt x="287" y="78"/>
                      <a:pt x="247" y="78"/>
                    </a:cubicBezTo>
                    <a:cubicBezTo>
                      <a:pt x="198" y="78"/>
                      <a:pt x="160" y="94"/>
                      <a:pt x="132" y="125"/>
                    </a:cubicBezTo>
                    <a:cubicBezTo>
                      <a:pt x="104" y="156"/>
                      <a:pt x="90" y="198"/>
                      <a:pt x="90" y="251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11" y="66"/>
                      <a:pt x="136" y="41"/>
                      <a:pt x="166" y="25"/>
                    </a:cubicBezTo>
                    <a:cubicBezTo>
                      <a:pt x="195" y="9"/>
                      <a:pt x="229" y="0"/>
                      <a:pt x="267" y="0"/>
                    </a:cubicBezTo>
                    <a:cubicBezTo>
                      <a:pt x="329" y="0"/>
                      <a:pt x="377" y="20"/>
                      <a:pt x="409" y="59"/>
                    </a:cubicBezTo>
                    <a:cubicBezTo>
                      <a:pt x="441" y="98"/>
                      <a:pt x="458" y="155"/>
                      <a:pt x="458" y="23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5" name="Freeform 119">
                <a:extLst>
                  <a:ext uri="{FF2B5EF4-FFF2-40B4-BE49-F238E27FC236}">
                    <a16:creationId xmlns:a16="http://schemas.microsoft.com/office/drawing/2014/main" id="{8A3A7D3B-750F-CE12-CCA9-5DF6BD9A11A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135563" y="5408613"/>
                <a:ext cx="84138" cy="104775"/>
              </a:xfrm>
              <a:custGeom>
                <a:avLst/>
                <a:gdLst>
                  <a:gd name="T0" fmla="*/ 283 w 462"/>
                  <a:gd name="T1" fmla="*/ 285 h 573"/>
                  <a:gd name="T2" fmla="*/ 132 w 462"/>
                  <a:gd name="T3" fmla="*/ 310 h 573"/>
                  <a:gd name="T4" fmla="*/ 90 w 462"/>
                  <a:gd name="T5" fmla="*/ 395 h 573"/>
                  <a:gd name="T6" fmla="*/ 121 w 462"/>
                  <a:gd name="T7" fmla="*/ 471 h 573"/>
                  <a:gd name="T8" fmla="*/ 207 w 462"/>
                  <a:gd name="T9" fmla="*/ 499 h 573"/>
                  <a:gd name="T10" fmla="*/ 327 w 462"/>
                  <a:gd name="T11" fmla="*/ 446 h 573"/>
                  <a:gd name="T12" fmla="*/ 372 w 462"/>
                  <a:gd name="T13" fmla="*/ 305 h 573"/>
                  <a:gd name="T14" fmla="*/ 372 w 462"/>
                  <a:gd name="T15" fmla="*/ 285 h 573"/>
                  <a:gd name="T16" fmla="*/ 283 w 462"/>
                  <a:gd name="T17" fmla="*/ 285 h 573"/>
                  <a:gd name="T18" fmla="*/ 462 w 462"/>
                  <a:gd name="T19" fmla="*/ 248 h 573"/>
                  <a:gd name="T20" fmla="*/ 462 w 462"/>
                  <a:gd name="T21" fmla="*/ 560 h 573"/>
                  <a:gd name="T22" fmla="*/ 372 w 462"/>
                  <a:gd name="T23" fmla="*/ 560 h 573"/>
                  <a:gd name="T24" fmla="*/ 372 w 462"/>
                  <a:gd name="T25" fmla="*/ 477 h 573"/>
                  <a:gd name="T26" fmla="*/ 295 w 462"/>
                  <a:gd name="T27" fmla="*/ 550 h 573"/>
                  <a:gd name="T28" fmla="*/ 183 w 462"/>
                  <a:gd name="T29" fmla="*/ 573 h 573"/>
                  <a:gd name="T30" fmla="*/ 49 w 462"/>
                  <a:gd name="T31" fmla="*/ 527 h 573"/>
                  <a:gd name="T32" fmla="*/ 0 w 462"/>
                  <a:gd name="T33" fmla="*/ 401 h 573"/>
                  <a:gd name="T34" fmla="*/ 62 w 462"/>
                  <a:gd name="T35" fmla="*/ 262 h 573"/>
                  <a:gd name="T36" fmla="*/ 246 w 462"/>
                  <a:gd name="T37" fmla="*/ 215 h 573"/>
                  <a:gd name="T38" fmla="*/ 372 w 462"/>
                  <a:gd name="T39" fmla="*/ 215 h 573"/>
                  <a:gd name="T40" fmla="*/ 372 w 462"/>
                  <a:gd name="T41" fmla="*/ 206 h 573"/>
                  <a:gd name="T42" fmla="*/ 331 w 462"/>
                  <a:gd name="T43" fmla="*/ 110 h 573"/>
                  <a:gd name="T44" fmla="*/ 217 w 462"/>
                  <a:gd name="T45" fmla="*/ 76 h 573"/>
                  <a:gd name="T46" fmla="*/ 125 w 462"/>
                  <a:gd name="T47" fmla="*/ 88 h 573"/>
                  <a:gd name="T48" fmla="*/ 40 w 462"/>
                  <a:gd name="T49" fmla="*/ 121 h 573"/>
                  <a:gd name="T50" fmla="*/ 40 w 462"/>
                  <a:gd name="T51" fmla="*/ 38 h 573"/>
                  <a:gd name="T52" fmla="*/ 135 w 462"/>
                  <a:gd name="T53" fmla="*/ 10 h 573"/>
                  <a:gd name="T54" fmla="*/ 226 w 462"/>
                  <a:gd name="T55" fmla="*/ 0 h 573"/>
                  <a:gd name="T56" fmla="*/ 403 w 462"/>
                  <a:gd name="T57" fmla="*/ 62 h 573"/>
                  <a:gd name="T58" fmla="*/ 462 w 462"/>
                  <a:gd name="T59" fmla="*/ 24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462" h="573">
                    <a:moveTo>
                      <a:pt x="283" y="285"/>
                    </a:moveTo>
                    <a:cubicBezTo>
                      <a:pt x="210" y="285"/>
                      <a:pt x="160" y="294"/>
                      <a:pt x="132" y="310"/>
                    </a:cubicBezTo>
                    <a:cubicBezTo>
                      <a:pt x="104" y="327"/>
                      <a:pt x="90" y="355"/>
                      <a:pt x="90" y="395"/>
                    </a:cubicBezTo>
                    <a:cubicBezTo>
                      <a:pt x="90" y="427"/>
                      <a:pt x="100" y="453"/>
                      <a:pt x="121" y="471"/>
                    </a:cubicBezTo>
                    <a:cubicBezTo>
                      <a:pt x="142" y="490"/>
                      <a:pt x="171" y="499"/>
                      <a:pt x="207" y="499"/>
                    </a:cubicBezTo>
                    <a:cubicBezTo>
                      <a:pt x="257" y="499"/>
                      <a:pt x="297" y="482"/>
                      <a:pt x="327" y="446"/>
                    </a:cubicBezTo>
                    <a:cubicBezTo>
                      <a:pt x="357" y="411"/>
                      <a:pt x="372" y="364"/>
                      <a:pt x="372" y="305"/>
                    </a:cubicBezTo>
                    <a:lnTo>
                      <a:pt x="372" y="285"/>
                    </a:lnTo>
                    <a:lnTo>
                      <a:pt x="283" y="285"/>
                    </a:lnTo>
                    <a:close/>
                    <a:moveTo>
                      <a:pt x="462" y="248"/>
                    </a:moveTo>
                    <a:lnTo>
                      <a:pt x="462" y="560"/>
                    </a:lnTo>
                    <a:lnTo>
                      <a:pt x="372" y="560"/>
                    </a:lnTo>
                    <a:lnTo>
                      <a:pt x="372" y="477"/>
                    </a:lnTo>
                    <a:cubicBezTo>
                      <a:pt x="351" y="511"/>
                      <a:pt x="325" y="535"/>
                      <a:pt x="295" y="550"/>
                    </a:cubicBezTo>
                    <a:cubicBezTo>
                      <a:pt x="265" y="565"/>
                      <a:pt x="227" y="573"/>
                      <a:pt x="183" y="573"/>
                    </a:cubicBezTo>
                    <a:cubicBezTo>
                      <a:pt x="127" y="573"/>
                      <a:pt x="82" y="558"/>
                      <a:pt x="49" y="527"/>
                    </a:cubicBezTo>
                    <a:cubicBezTo>
                      <a:pt x="16" y="496"/>
                      <a:pt x="0" y="454"/>
                      <a:pt x="0" y="401"/>
                    </a:cubicBezTo>
                    <a:cubicBezTo>
                      <a:pt x="0" y="340"/>
                      <a:pt x="20" y="294"/>
                      <a:pt x="62" y="262"/>
                    </a:cubicBezTo>
                    <a:cubicBezTo>
                      <a:pt x="103" y="231"/>
                      <a:pt x="164" y="215"/>
                      <a:pt x="246" y="215"/>
                    </a:cubicBezTo>
                    <a:lnTo>
                      <a:pt x="372" y="215"/>
                    </a:lnTo>
                    <a:lnTo>
                      <a:pt x="372" y="206"/>
                    </a:lnTo>
                    <a:cubicBezTo>
                      <a:pt x="372" y="165"/>
                      <a:pt x="358" y="133"/>
                      <a:pt x="331" y="110"/>
                    </a:cubicBezTo>
                    <a:cubicBezTo>
                      <a:pt x="304" y="88"/>
                      <a:pt x="266" y="76"/>
                      <a:pt x="217" y="76"/>
                    </a:cubicBezTo>
                    <a:cubicBezTo>
                      <a:pt x="185" y="76"/>
                      <a:pt x="155" y="80"/>
                      <a:pt x="125" y="88"/>
                    </a:cubicBezTo>
                    <a:cubicBezTo>
                      <a:pt x="95" y="96"/>
                      <a:pt x="67" y="107"/>
                      <a:pt x="40" y="121"/>
                    </a:cubicBezTo>
                    <a:lnTo>
                      <a:pt x="40" y="38"/>
                    </a:lnTo>
                    <a:cubicBezTo>
                      <a:pt x="72" y="26"/>
                      <a:pt x="104" y="16"/>
                      <a:pt x="135" y="10"/>
                    </a:cubicBezTo>
                    <a:cubicBezTo>
                      <a:pt x="166" y="4"/>
                      <a:pt x="196" y="0"/>
                      <a:pt x="226" y="0"/>
                    </a:cubicBezTo>
                    <a:cubicBezTo>
                      <a:pt x="305" y="0"/>
                      <a:pt x="364" y="21"/>
                      <a:pt x="403" y="62"/>
                    </a:cubicBezTo>
                    <a:cubicBezTo>
                      <a:pt x="442" y="103"/>
                      <a:pt x="462" y="165"/>
                      <a:pt x="462" y="24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6" name="Freeform 120">
                <a:extLst>
                  <a:ext uri="{FF2B5EF4-FFF2-40B4-BE49-F238E27FC236}">
                    <a16:creationId xmlns:a16="http://schemas.microsoft.com/office/drawing/2014/main" id="{F48CAE5E-9B74-9ED9-E4E6-D69B9D722661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253038" y="5408613"/>
                <a:ext cx="87313" cy="139700"/>
              </a:xfrm>
              <a:custGeom>
                <a:avLst/>
                <a:gdLst>
                  <a:gd name="T0" fmla="*/ 90 w 489"/>
                  <a:gd name="T1" fmla="*/ 478 h 767"/>
                  <a:gd name="T2" fmla="*/ 90 w 489"/>
                  <a:gd name="T3" fmla="*/ 767 h 767"/>
                  <a:gd name="T4" fmla="*/ 0 w 489"/>
                  <a:gd name="T5" fmla="*/ 767 h 767"/>
                  <a:gd name="T6" fmla="*/ 0 w 489"/>
                  <a:gd name="T7" fmla="*/ 13 h 767"/>
                  <a:gd name="T8" fmla="*/ 90 w 489"/>
                  <a:gd name="T9" fmla="*/ 13 h 767"/>
                  <a:gd name="T10" fmla="*/ 90 w 489"/>
                  <a:gd name="T11" fmla="*/ 96 h 767"/>
                  <a:gd name="T12" fmla="*/ 161 w 489"/>
                  <a:gd name="T13" fmla="*/ 24 h 767"/>
                  <a:gd name="T14" fmla="*/ 265 w 489"/>
                  <a:gd name="T15" fmla="*/ 0 h 767"/>
                  <a:gd name="T16" fmla="*/ 427 w 489"/>
                  <a:gd name="T17" fmla="*/ 79 h 767"/>
                  <a:gd name="T18" fmla="*/ 489 w 489"/>
                  <a:gd name="T19" fmla="*/ 287 h 767"/>
                  <a:gd name="T20" fmla="*/ 427 w 489"/>
                  <a:gd name="T21" fmla="*/ 495 h 767"/>
                  <a:gd name="T22" fmla="*/ 265 w 489"/>
                  <a:gd name="T23" fmla="*/ 573 h 767"/>
                  <a:gd name="T24" fmla="*/ 161 w 489"/>
                  <a:gd name="T25" fmla="*/ 550 h 767"/>
                  <a:gd name="T26" fmla="*/ 90 w 489"/>
                  <a:gd name="T27" fmla="*/ 478 h 767"/>
                  <a:gd name="T28" fmla="*/ 396 w 489"/>
                  <a:gd name="T29" fmla="*/ 287 h 767"/>
                  <a:gd name="T30" fmla="*/ 355 w 489"/>
                  <a:gd name="T31" fmla="*/ 132 h 767"/>
                  <a:gd name="T32" fmla="*/ 243 w 489"/>
                  <a:gd name="T33" fmla="*/ 75 h 767"/>
                  <a:gd name="T34" fmla="*/ 131 w 489"/>
                  <a:gd name="T35" fmla="*/ 132 h 767"/>
                  <a:gd name="T36" fmla="*/ 90 w 489"/>
                  <a:gd name="T37" fmla="*/ 287 h 767"/>
                  <a:gd name="T38" fmla="*/ 131 w 489"/>
                  <a:gd name="T39" fmla="*/ 443 h 767"/>
                  <a:gd name="T40" fmla="*/ 243 w 489"/>
                  <a:gd name="T41" fmla="*/ 499 h 767"/>
                  <a:gd name="T42" fmla="*/ 355 w 489"/>
                  <a:gd name="T43" fmla="*/ 443 h 767"/>
                  <a:gd name="T44" fmla="*/ 396 w 489"/>
                  <a:gd name="T45" fmla="*/ 287 h 7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89" h="767">
                    <a:moveTo>
                      <a:pt x="90" y="478"/>
                    </a:moveTo>
                    <a:lnTo>
                      <a:pt x="90" y="767"/>
                    </a:lnTo>
                    <a:lnTo>
                      <a:pt x="0" y="767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6"/>
                    </a:lnTo>
                    <a:cubicBezTo>
                      <a:pt x="108" y="64"/>
                      <a:pt x="132" y="40"/>
                      <a:pt x="161" y="24"/>
                    </a:cubicBezTo>
                    <a:cubicBezTo>
                      <a:pt x="190" y="8"/>
                      <a:pt x="225" y="0"/>
                      <a:pt x="265" y="0"/>
                    </a:cubicBezTo>
                    <a:cubicBezTo>
                      <a:pt x="331" y="0"/>
                      <a:pt x="385" y="27"/>
                      <a:pt x="427" y="79"/>
                    </a:cubicBezTo>
                    <a:cubicBezTo>
                      <a:pt x="468" y="132"/>
                      <a:pt x="489" y="201"/>
                      <a:pt x="489" y="287"/>
                    </a:cubicBezTo>
                    <a:cubicBezTo>
                      <a:pt x="489" y="373"/>
                      <a:pt x="468" y="443"/>
                      <a:pt x="427" y="495"/>
                    </a:cubicBezTo>
                    <a:cubicBezTo>
                      <a:pt x="385" y="547"/>
                      <a:pt x="331" y="573"/>
                      <a:pt x="265" y="573"/>
                    </a:cubicBezTo>
                    <a:cubicBezTo>
                      <a:pt x="225" y="573"/>
                      <a:pt x="190" y="565"/>
                      <a:pt x="161" y="550"/>
                    </a:cubicBezTo>
                    <a:cubicBezTo>
                      <a:pt x="132" y="535"/>
                      <a:pt x="108" y="511"/>
                      <a:pt x="90" y="478"/>
                    </a:cubicBezTo>
                    <a:close/>
                    <a:moveTo>
                      <a:pt x="396" y="287"/>
                    </a:moveTo>
                    <a:cubicBezTo>
                      <a:pt x="396" y="221"/>
                      <a:pt x="382" y="170"/>
                      <a:pt x="355" y="132"/>
                    </a:cubicBezTo>
                    <a:cubicBezTo>
                      <a:pt x="327" y="94"/>
                      <a:pt x="290" y="75"/>
                      <a:pt x="243" y="75"/>
                    </a:cubicBezTo>
                    <a:cubicBezTo>
                      <a:pt x="195" y="75"/>
                      <a:pt x="158" y="94"/>
                      <a:pt x="131" y="132"/>
                    </a:cubicBezTo>
                    <a:cubicBezTo>
                      <a:pt x="103" y="170"/>
                      <a:pt x="90" y="221"/>
                      <a:pt x="90" y="287"/>
                    </a:cubicBezTo>
                    <a:cubicBezTo>
                      <a:pt x="90" y="353"/>
                      <a:pt x="103" y="405"/>
                      <a:pt x="131" y="443"/>
                    </a:cubicBezTo>
                    <a:cubicBezTo>
                      <a:pt x="158" y="481"/>
                      <a:pt x="195" y="499"/>
                      <a:pt x="243" y="499"/>
                    </a:cubicBezTo>
                    <a:cubicBezTo>
                      <a:pt x="290" y="499"/>
                      <a:pt x="327" y="481"/>
                      <a:pt x="355" y="443"/>
                    </a:cubicBezTo>
                    <a:cubicBezTo>
                      <a:pt x="382" y="405"/>
                      <a:pt x="396" y="353"/>
                      <a:pt x="396" y="287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7" name="Line 121">
                <a:extLst>
                  <a:ext uri="{FF2B5EF4-FFF2-40B4-BE49-F238E27FC236}">
                    <a16:creationId xmlns:a16="http://schemas.microsoft.com/office/drawing/2014/main" id="{F853958B-8E4E-A149-6DE8-67EAA30BF5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81350" y="5051425"/>
                <a:ext cx="2365375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8" name="Freeform 122">
                <a:extLst>
                  <a:ext uri="{FF2B5EF4-FFF2-40B4-BE49-F238E27FC236}">
                    <a16:creationId xmlns:a16="http://schemas.microsoft.com/office/drawing/2014/main" id="{4B79DDE1-5A11-ECFB-29C1-1A04C769C56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70188" y="4989513"/>
                <a:ext cx="79375" cy="131763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9" name="Freeform 123">
                <a:extLst>
                  <a:ext uri="{FF2B5EF4-FFF2-40B4-BE49-F238E27FC236}">
                    <a16:creationId xmlns:a16="http://schemas.microsoft.com/office/drawing/2014/main" id="{A6E91C8E-2DA9-2E7A-CA65-5052A28FE7E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878138" y="4986338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0" name="Freeform 124">
                <a:extLst>
                  <a:ext uri="{FF2B5EF4-FFF2-40B4-BE49-F238E27FC236}">
                    <a16:creationId xmlns:a16="http://schemas.microsoft.com/office/drawing/2014/main" id="{F8F2AC90-6D12-06E3-C344-FA3FEB1399B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992438" y="4986338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1" name="Line 125">
                <a:extLst>
                  <a:ext uri="{FF2B5EF4-FFF2-40B4-BE49-F238E27FC236}">
                    <a16:creationId xmlns:a16="http://schemas.microsoft.com/office/drawing/2014/main" id="{9AB9E21A-8592-5AFA-9B2D-A3371A5054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81350" y="4576763"/>
                <a:ext cx="2365375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2" name="Freeform 126">
                <a:extLst>
                  <a:ext uri="{FF2B5EF4-FFF2-40B4-BE49-F238E27FC236}">
                    <a16:creationId xmlns:a16="http://schemas.microsoft.com/office/drawing/2014/main" id="{79CAC83F-0C25-F1C2-0DD9-61C49B3268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70188" y="4513263"/>
                <a:ext cx="79375" cy="131763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3" name="Freeform 127">
                <a:extLst>
                  <a:ext uri="{FF2B5EF4-FFF2-40B4-BE49-F238E27FC236}">
                    <a16:creationId xmlns:a16="http://schemas.microsoft.com/office/drawing/2014/main" id="{2A7071DA-2A3F-52D2-992E-774F9AB6E22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78138" y="4510088"/>
                <a:ext cx="84138" cy="134938"/>
              </a:xfrm>
              <a:custGeom>
                <a:avLst/>
                <a:gdLst>
                  <a:gd name="T0" fmla="*/ 119 w 463"/>
                  <a:gd name="T1" fmla="*/ 659 h 742"/>
                  <a:gd name="T2" fmla="*/ 463 w 463"/>
                  <a:gd name="T3" fmla="*/ 659 h 742"/>
                  <a:gd name="T4" fmla="*/ 463 w 463"/>
                  <a:gd name="T5" fmla="*/ 742 h 742"/>
                  <a:gd name="T6" fmla="*/ 0 w 463"/>
                  <a:gd name="T7" fmla="*/ 742 h 742"/>
                  <a:gd name="T8" fmla="*/ 0 w 463"/>
                  <a:gd name="T9" fmla="*/ 659 h 742"/>
                  <a:gd name="T10" fmla="*/ 153 w 463"/>
                  <a:gd name="T11" fmla="*/ 503 h 742"/>
                  <a:gd name="T12" fmla="*/ 275 w 463"/>
                  <a:gd name="T13" fmla="*/ 377 h 742"/>
                  <a:gd name="T14" fmla="*/ 341 w 463"/>
                  <a:gd name="T15" fmla="*/ 287 h 742"/>
                  <a:gd name="T16" fmla="*/ 360 w 463"/>
                  <a:gd name="T17" fmla="*/ 214 h 742"/>
                  <a:gd name="T18" fmla="*/ 319 w 463"/>
                  <a:gd name="T19" fmla="*/ 120 h 742"/>
                  <a:gd name="T20" fmla="*/ 213 w 463"/>
                  <a:gd name="T21" fmla="*/ 83 h 742"/>
                  <a:gd name="T22" fmla="*/ 115 w 463"/>
                  <a:gd name="T23" fmla="*/ 99 h 742"/>
                  <a:gd name="T24" fmla="*/ 5 w 463"/>
                  <a:gd name="T25" fmla="*/ 148 h 742"/>
                  <a:gd name="T26" fmla="*/ 5 w 463"/>
                  <a:gd name="T27" fmla="*/ 48 h 742"/>
                  <a:gd name="T28" fmla="*/ 116 w 463"/>
                  <a:gd name="T29" fmla="*/ 12 h 742"/>
                  <a:gd name="T30" fmla="*/ 211 w 463"/>
                  <a:gd name="T31" fmla="*/ 0 h 742"/>
                  <a:gd name="T32" fmla="*/ 391 w 463"/>
                  <a:gd name="T33" fmla="*/ 57 h 742"/>
                  <a:gd name="T34" fmla="*/ 459 w 463"/>
                  <a:gd name="T35" fmla="*/ 208 h 742"/>
                  <a:gd name="T36" fmla="*/ 442 w 463"/>
                  <a:gd name="T37" fmla="*/ 293 h 742"/>
                  <a:gd name="T38" fmla="*/ 381 w 463"/>
                  <a:gd name="T39" fmla="*/ 388 h 742"/>
                  <a:gd name="T40" fmla="*/ 303 w 463"/>
                  <a:gd name="T41" fmla="*/ 470 h 742"/>
                  <a:gd name="T42" fmla="*/ 119 w 463"/>
                  <a:gd name="T43" fmla="*/ 659 h 7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463" h="742">
                    <a:moveTo>
                      <a:pt x="119" y="659"/>
                    </a:moveTo>
                    <a:lnTo>
                      <a:pt x="463" y="659"/>
                    </a:lnTo>
                    <a:lnTo>
                      <a:pt x="463" y="742"/>
                    </a:lnTo>
                    <a:lnTo>
                      <a:pt x="0" y="742"/>
                    </a:lnTo>
                    <a:lnTo>
                      <a:pt x="0" y="659"/>
                    </a:lnTo>
                    <a:cubicBezTo>
                      <a:pt x="37" y="621"/>
                      <a:pt x="88" y="569"/>
                      <a:pt x="153" y="503"/>
                    </a:cubicBezTo>
                    <a:cubicBezTo>
                      <a:pt x="217" y="438"/>
                      <a:pt x="258" y="396"/>
                      <a:pt x="275" y="377"/>
                    </a:cubicBezTo>
                    <a:cubicBezTo>
                      <a:pt x="307" y="342"/>
                      <a:pt x="329" y="312"/>
                      <a:pt x="341" y="287"/>
                    </a:cubicBezTo>
                    <a:cubicBezTo>
                      <a:pt x="353" y="263"/>
                      <a:pt x="360" y="238"/>
                      <a:pt x="360" y="214"/>
                    </a:cubicBezTo>
                    <a:cubicBezTo>
                      <a:pt x="360" y="176"/>
                      <a:pt x="346" y="144"/>
                      <a:pt x="319" y="120"/>
                    </a:cubicBezTo>
                    <a:cubicBezTo>
                      <a:pt x="292" y="96"/>
                      <a:pt x="257" y="83"/>
                      <a:pt x="213" y="83"/>
                    </a:cubicBezTo>
                    <a:cubicBezTo>
                      <a:pt x="182" y="83"/>
                      <a:pt x="149" y="89"/>
                      <a:pt x="115" y="99"/>
                    </a:cubicBezTo>
                    <a:cubicBezTo>
                      <a:pt x="81" y="110"/>
                      <a:pt x="44" y="126"/>
                      <a:pt x="5" y="148"/>
                    </a:cubicBezTo>
                    <a:lnTo>
                      <a:pt x="5" y="48"/>
                    </a:lnTo>
                    <a:cubicBezTo>
                      <a:pt x="45" y="32"/>
                      <a:pt x="82" y="20"/>
                      <a:pt x="116" y="12"/>
                    </a:cubicBezTo>
                    <a:cubicBezTo>
                      <a:pt x="150" y="4"/>
                      <a:pt x="182" y="0"/>
                      <a:pt x="211" y="0"/>
                    </a:cubicBezTo>
                    <a:cubicBezTo>
                      <a:pt x="286" y="0"/>
                      <a:pt x="346" y="19"/>
                      <a:pt x="391" y="57"/>
                    </a:cubicBezTo>
                    <a:cubicBezTo>
                      <a:pt x="436" y="95"/>
                      <a:pt x="459" y="145"/>
                      <a:pt x="459" y="208"/>
                    </a:cubicBezTo>
                    <a:cubicBezTo>
                      <a:pt x="459" y="238"/>
                      <a:pt x="453" y="267"/>
                      <a:pt x="442" y="293"/>
                    </a:cubicBezTo>
                    <a:cubicBezTo>
                      <a:pt x="431" y="320"/>
                      <a:pt x="411" y="352"/>
                      <a:pt x="381" y="388"/>
                    </a:cubicBezTo>
                    <a:cubicBezTo>
                      <a:pt x="373" y="398"/>
                      <a:pt x="347" y="425"/>
                      <a:pt x="303" y="470"/>
                    </a:cubicBezTo>
                    <a:cubicBezTo>
                      <a:pt x="259" y="515"/>
                      <a:pt x="198" y="578"/>
                      <a:pt x="119" y="65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4" name="Freeform 128">
                <a:extLst>
                  <a:ext uri="{FF2B5EF4-FFF2-40B4-BE49-F238E27FC236}">
                    <a16:creationId xmlns:a16="http://schemas.microsoft.com/office/drawing/2014/main" id="{540A892E-2F41-B14B-EA2C-0D7B4C7DC09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992438" y="4510088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5" name="Line 129">
                <a:extLst>
                  <a:ext uri="{FF2B5EF4-FFF2-40B4-BE49-F238E27FC236}">
                    <a16:creationId xmlns:a16="http://schemas.microsoft.com/office/drawing/2014/main" id="{AFD06D53-CEB9-133A-BC1D-D06F75569D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81350" y="4100513"/>
                <a:ext cx="2365375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6" name="Freeform 130">
                <a:extLst>
                  <a:ext uri="{FF2B5EF4-FFF2-40B4-BE49-F238E27FC236}">
                    <a16:creationId xmlns:a16="http://schemas.microsoft.com/office/drawing/2014/main" id="{0D5FD5C0-6764-F2AF-E6BE-B9DD90BB6DD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70188" y="4037013"/>
                <a:ext cx="79375" cy="131763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7" name="Freeform 131">
                <a:extLst>
                  <a:ext uri="{FF2B5EF4-FFF2-40B4-BE49-F238E27FC236}">
                    <a16:creationId xmlns:a16="http://schemas.microsoft.com/office/drawing/2014/main" id="{DF46AC79-C2B5-AE63-5FB2-9055E98FC74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874963" y="4037013"/>
                <a:ext cx="95250" cy="131763"/>
              </a:xfrm>
              <a:custGeom>
                <a:avLst/>
                <a:gdLst>
                  <a:gd name="T0" fmla="*/ 329 w 531"/>
                  <a:gd name="T1" fmla="*/ 86 h 729"/>
                  <a:gd name="T2" fmla="*/ 80 w 531"/>
                  <a:gd name="T3" fmla="*/ 475 h 729"/>
                  <a:gd name="T4" fmla="*/ 329 w 531"/>
                  <a:gd name="T5" fmla="*/ 475 h 729"/>
                  <a:gd name="T6" fmla="*/ 329 w 531"/>
                  <a:gd name="T7" fmla="*/ 86 h 729"/>
                  <a:gd name="T8" fmla="*/ 303 w 531"/>
                  <a:gd name="T9" fmla="*/ 0 h 729"/>
                  <a:gd name="T10" fmla="*/ 427 w 531"/>
                  <a:gd name="T11" fmla="*/ 0 h 729"/>
                  <a:gd name="T12" fmla="*/ 427 w 531"/>
                  <a:gd name="T13" fmla="*/ 475 h 729"/>
                  <a:gd name="T14" fmla="*/ 531 w 531"/>
                  <a:gd name="T15" fmla="*/ 475 h 729"/>
                  <a:gd name="T16" fmla="*/ 531 w 531"/>
                  <a:gd name="T17" fmla="*/ 557 h 729"/>
                  <a:gd name="T18" fmla="*/ 427 w 531"/>
                  <a:gd name="T19" fmla="*/ 557 h 729"/>
                  <a:gd name="T20" fmla="*/ 427 w 531"/>
                  <a:gd name="T21" fmla="*/ 729 h 729"/>
                  <a:gd name="T22" fmla="*/ 329 w 531"/>
                  <a:gd name="T23" fmla="*/ 729 h 729"/>
                  <a:gd name="T24" fmla="*/ 329 w 531"/>
                  <a:gd name="T25" fmla="*/ 557 h 729"/>
                  <a:gd name="T26" fmla="*/ 0 w 531"/>
                  <a:gd name="T27" fmla="*/ 557 h 729"/>
                  <a:gd name="T28" fmla="*/ 0 w 531"/>
                  <a:gd name="T29" fmla="*/ 462 h 729"/>
                  <a:gd name="T30" fmla="*/ 303 w 531"/>
                  <a:gd name="T31" fmla="*/ 0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531" h="729">
                    <a:moveTo>
                      <a:pt x="329" y="86"/>
                    </a:moveTo>
                    <a:lnTo>
                      <a:pt x="80" y="475"/>
                    </a:lnTo>
                    <a:lnTo>
                      <a:pt x="329" y="475"/>
                    </a:lnTo>
                    <a:lnTo>
                      <a:pt x="329" y="86"/>
                    </a:lnTo>
                    <a:close/>
                    <a:moveTo>
                      <a:pt x="303" y="0"/>
                    </a:moveTo>
                    <a:lnTo>
                      <a:pt x="427" y="0"/>
                    </a:lnTo>
                    <a:lnTo>
                      <a:pt x="427" y="475"/>
                    </a:lnTo>
                    <a:lnTo>
                      <a:pt x="531" y="475"/>
                    </a:lnTo>
                    <a:lnTo>
                      <a:pt x="531" y="557"/>
                    </a:lnTo>
                    <a:lnTo>
                      <a:pt x="427" y="557"/>
                    </a:lnTo>
                    <a:lnTo>
                      <a:pt x="427" y="729"/>
                    </a:lnTo>
                    <a:lnTo>
                      <a:pt x="329" y="729"/>
                    </a:lnTo>
                    <a:lnTo>
                      <a:pt x="329" y="557"/>
                    </a:lnTo>
                    <a:lnTo>
                      <a:pt x="0" y="557"/>
                    </a:lnTo>
                    <a:lnTo>
                      <a:pt x="0" y="462"/>
                    </a:lnTo>
                    <a:lnTo>
                      <a:pt x="303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8" name="Freeform 132">
                <a:extLst>
                  <a:ext uri="{FF2B5EF4-FFF2-40B4-BE49-F238E27FC236}">
                    <a16:creationId xmlns:a16="http://schemas.microsoft.com/office/drawing/2014/main" id="{6832D78D-1EF6-E1C0-5B23-D3957B40A84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992438" y="4035425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9" name="Line 133">
                <a:extLst>
                  <a:ext uri="{FF2B5EF4-FFF2-40B4-BE49-F238E27FC236}">
                    <a16:creationId xmlns:a16="http://schemas.microsoft.com/office/drawing/2014/main" id="{F50083CF-8C91-4089-B109-C304B27615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81350" y="3624263"/>
                <a:ext cx="2365375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0" name="Freeform 134">
                <a:extLst>
                  <a:ext uri="{FF2B5EF4-FFF2-40B4-BE49-F238E27FC236}">
                    <a16:creationId xmlns:a16="http://schemas.microsoft.com/office/drawing/2014/main" id="{D889ACE7-FB0A-7EF2-0279-EC4410F63D0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70188" y="3560763"/>
                <a:ext cx="79375" cy="131763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1" name="Freeform 135">
                <a:extLst>
                  <a:ext uri="{FF2B5EF4-FFF2-40B4-BE49-F238E27FC236}">
                    <a16:creationId xmlns:a16="http://schemas.microsoft.com/office/drawing/2014/main" id="{0DA80E34-5F85-CF49-F331-84D18E0DBC4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878138" y="3559175"/>
                <a:ext cx="90488" cy="136525"/>
              </a:xfrm>
              <a:custGeom>
                <a:avLst/>
                <a:gdLst>
                  <a:gd name="T0" fmla="*/ 260 w 503"/>
                  <a:gd name="T1" fmla="*/ 338 h 755"/>
                  <a:gd name="T2" fmla="*/ 155 w 503"/>
                  <a:gd name="T3" fmla="*/ 384 h 755"/>
                  <a:gd name="T4" fmla="*/ 116 w 503"/>
                  <a:gd name="T5" fmla="*/ 508 h 755"/>
                  <a:gd name="T6" fmla="*/ 155 w 503"/>
                  <a:gd name="T7" fmla="*/ 633 h 755"/>
                  <a:gd name="T8" fmla="*/ 260 w 503"/>
                  <a:gd name="T9" fmla="*/ 678 h 755"/>
                  <a:gd name="T10" fmla="*/ 365 w 503"/>
                  <a:gd name="T11" fmla="*/ 633 h 755"/>
                  <a:gd name="T12" fmla="*/ 404 w 503"/>
                  <a:gd name="T13" fmla="*/ 508 h 755"/>
                  <a:gd name="T14" fmla="*/ 365 w 503"/>
                  <a:gd name="T15" fmla="*/ 384 h 755"/>
                  <a:gd name="T16" fmla="*/ 260 w 503"/>
                  <a:gd name="T17" fmla="*/ 338 h 755"/>
                  <a:gd name="T18" fmla="*/ 456 w 503"/>
                  <a:gd name="T19" fmla="*/ 29 h 755"/>
                  <a:gd name="T20" fmla="*/ 456 w 503"/>
                  <a:gd name="T21" fmla="*/ 119 h 755"/>
                  <a:gd name="T22" fmla="*/ 381 w 503"/>
                  <a:gd name="T23" fmla="*/ 92 h 755"/>
                  <a:gd name="T24" fmla="*/ 306 w 503"/>
                  <a:gd name="T25" fmla="*/ 83 h 755"/>
                  <a:gd name="T26" fmla="*/ 156 w 503"/>
                  <a:gd name="T27" fmla="*/ 149 h 755"/>
                  <a:gd name="T28" fmla="*/ 98 w 503"/>
                  <a:gd name="T29" fmla="*/ 348 h 755"/>
                  <a:gd name="T30" fmla="*/ 170 w 503"/>
                  <a:gd name="T31" fmla="*/ 283 h 755"/>
                  <a:gd name="T32" fmla="*/ 266 w 503"/>
                  <a:gd name="T33" fmla="*/ 260 h 755"/>
                  <a:gd name="T34" fmla="*/ 439 w 503"/>
                  <a:gd name="T35" fmla="*/ 327 h 755"/>
                  <a:gd name="T36" fmla="*/ 503 w 503"/>
                  <a:gd name="T37" fmla="*/ 508 h 755"/>
                  <a:gd name="T38" fmla="*/ 436 w 503"/>
                  <a:gd name="T39" fmla="*/ 688 h 755"/>
                  <a:gd name="T40" fmla="*/ 260 w 503"/>
                  <a:gd name="T41" fmla="*/ 755 h 755"/>
                  <a:gd name="T42" fmla="*/ 67 w 503"/>
                  <a:gd name="T43" fmla="*/ 659 h 755"/>
                  <a:gd name="T44" fmla="*/ 0 w 503"/>
                  <a:gd name="T45" fmla="*/ 378 h 755"/>
                  <a:gd name="T46" fmla="*/ 82 w 503"/>
                  <a:gd name="T47" fmla="*/ 103 h 755"/>
                  <a:gd name="T48" fmla="*/ 302 w 503"/>
                  <a:gd name="T49" fmla="*/ 0 h 755"/>
                  <a:gd name="T50" fmla="*/ 377 w 503"/>
                  <a:gd name="T51" fmla="*/ 7 h 755"/>
                  <a:gd name="T52" fmla="*/ 456 w 503"/>
                  <a:gd name="T53" fmla="*/ 29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503" h="755">
                    <a:moveTo>
                      <a:pt x="260" y="338"/>
                    </a:moveTo>
                    <a:cubicBezTo>
                      <a:pt x="216" y="338"/>
                      <a:pt x="181" y="354"/>
                      <a:pt x="155" y="384"/>
                    </a:cubicBezTo>
                    <a:cubicBezTo>
                      <a:pt x="129" y="414"/>
                      <a:pt x="116" y="456"/>
                      <a:pt x="116" y="508"/>
                    </a:cubicBezTo>
                    <a:cubicBezTo>
                      <a:pt x="116" y="561"/>
                      <a:pt x="129" y="603"/>
                      <a:pt x="155" y="633"/>
                    </a:cubicBezTo>
                    <a:cubicBezTo>
                      <a:pt x="181" y="663"/>
                      <a:pt x="216" y="678"/>
                      <a:pt x="260" y="678"/>
                    </a:cubicBezTo>
                    <a:cubicBezTo>
                      <a:pt x="304" y="678"/>
                      <a:pt x="339" y="663"/>
                      <a:pt x="365" y="633"/>
                    </a:cubicBezTo>
                    <a:cubicBezTo>
                      <a:pt x="391" y="603"/>
                      <a:pt x="404" y="561"/>
                      <a:pt x="404" y="508"/>
                    </a:cubicBezTo>
                    <a:cubicBezTo>
                      <a:pt x="404" y="456"/>
                      <a:pt x="391" y="414"/>
                      <a:pt x="365" y="384"/>
                    </a:cubicBezTo>
                    <a:cubicBezTo>
                      <a:pt x="339" y="354"/>
                      <a:pt x="304" y="338"/>
                      <a:pt x="260" y="338"/>
                    </a:cubicBezTo>
                    <a:close/>
                    <a:moveTo>
                      <a:pt x="456" y="29"/>
                    </a:moveTo>
                    <a:lnTo>
                      <a:pt x="456" y="119"/>
                    </a:lnTo>
                    <a:cubicBezTo>
                      <a:pt x="431" y="107"/>
                      <a:pt x="406" y="98"/>
                      <a:pt x="381" y="92"/>
                    </a:cubicBezTo>
                    <a:cubicBezTo>
                      <a:pt x="355" y="86"/>
                      <a:pt x="330" y="83"/>
                      <a:pt x="306" y="83"/>
                    </a:cubicBezTo>
                    <a:cubicBezTo>
                      <a:pt x="240" y="83"/>
                      <a:pt x="190" y="105"/>
                      <a:pt x="156" y="149"/>
                    </a:cubicBezTo>
                    <a:cubicBezTo>
                      <a:pt x="122" y="193"/>
                      <a:pt x="102" y="260"/>
                      <a:pt x="98" y="348"/>
                    </a:cubicBezTo>
                    <a:cubicBezTo>
                      <a:pt x="117" y="320"/>
                      <a:pt x="141" y="298"/>
                      <a:pt x="170" y="283"/>
                    </a:cubicBezTo>
                    <a:cubicBezTo>
                      <a:pt x="199" y="268"/>
                      <a:pt x="231" y="260"/>
                      <a:pt x="266" y="260"/>
                    </a:cubicBezTo>
                    <a:cubicBezTo>
                      <a:pt x="339" y="260"/>
                      <a:pt x="397" y="283"/>
                      <a:pt x="439" y="327"/>
                    </a:cubicBezTo>
                    <a:cubicBezTo>
                      <a:pt x="481" y="371"/>
                      <a:pt x="503" y="432"/>
                      <a:pt x="503" y="508"/>
                    </a:cubicBezTo>
                    <a:cubicBezTo>
                      <a:pt x="503" y="583"/>
                      <a:pt x="480" y="643"/>
                      <a:pt x="436" y="688"/>
                    </a:cubicBezTo>
                    <a:cubicBezTo>
                      <a:pt x="392" y="733"/>
                      <a:pt x="333" y="755"/>
                      <a:pt x="260" y="755"/>
                    </a:cubicBezTo>
                    <a:cubicBezTo>
                      <a:pt x="176" y="755"/>
                      <a:pt x="111" y="723"/>
                      <a:pt x="67" y="659"/>
                    </a:cubicBezTo>
                    <a:cubicBezTo>
                      <a:pt x="22" y="595"/>
                      <a:pt x="0" y="501"/>
                      <a:pt x="0" y="378"/>
                    </a:cubicBezTo>
                    <a:cubicBezTo>
                      <a:pt x="0" y="263"/>
                      <a:pt x="27" y="171"/>
                      <a:pt x="82" y="103"/>
                    </a:cubicBezTo>
                    <a:cubicBezTo>
                      <a:pt x="136" y="35"/>
                      <a:pt x="210" y="0"/>
                      <a:pt x="302" y="0"/>
                    </a:cubicBezTo>
                    <a:cubicBezTo>
                      <a:pt x="326" y="0"/>
                      <a:pt x="351" y="3"/>
                      <a:pt x="377" y="7"/>
                    </a:cubicBezTo>
                    <a:cubicBezTo>
                      <a:pt x="402" y="12"/>
                      <a:pt x="428" y="19"/>
                      <a:pt x="456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2" name="Freeform 136">
                <a:extLst>
                  <a:ext uri="{FF2B5EF4-FFF2-40B4-BE49-F238E27FC236}">
                    <a16:creationId xmlns:a16="http://schemas.microsoft.com/office/drawing/2014/main" id="{CE82731B-67FD-6B84-22B1-8CDD3BAD22B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992438" y="3559175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3" name="Line 137">
                <a:extLst>
                  <a:ext uri="{FF2B5EF4-FFF2-40B4-BE49-F238E27FC236}">
                    <a16:creationId xmlns:a16="http://schemas.microsoft.com/office/drawing/2014/main" id="{3676851A-466B-7702-A2D2-0883864B77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81350" y="3148013"/>
                <a:ext cx="2365375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4" name="Freeform 138">
                <a:extLst>
                  <a:ext uri="{FF2B5EF4-FFF2-40B4-BE49-F238E27FC236}">
                    <a16:creationId xmlns:a16="http://schemas.microsoft.com/office/drawing/2014/main" id="{067C63CE-FB32-5787-9CCB-16B41ED01D4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70188" y="3086100"/>
                <a:ext cx="79375" cy="130175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5" name="Freeform 139">
                <a:extLst>
                  <a:ext uri="{FF2B5EF4-FFF2-40B4-BE49-F238E27FC236}">
                    <a16:creationId xmlns:a16="http://schemas.microsoft.com/office/drawing/2014/main" id="{C72ADFC2-F5F0-B186-C96B-D6D90F00216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878138" y="3082925"/>
                <a:ext cx="90488" cy="136525"/>
              </a:xfrm>
              <a:custGeom>
                <a:avLst/>
                <a:gdLst>
                  <a:gd name="T0" fmla="*/ 250 w 500"/>
                  <a:gd name="T1" fmla="*/ 396 h 755"/>
                  <a:gd name="T2" fmla="*/ 139 w 500"/>
                  <a:gd name="T3" fmla="*/ 434 h 755"/>
                  <a:gd name="T4" fmla="*/ 99 w 500"/>
                  <a:gd name="T5" fmla="*/ 537 h 755"/>
                  <a:gd name="T6" fmla="*/ 139 w 500"/>
                  <a:gd name="T7" fmla="*/ 641 h 755"/>
                  <a:gd name="T8" fmla="*/ 250 w 500"/>
                  <a:gd name="T9" fmla="*/ 678 h 755"/>
                  <a:gd name="T10" fmla="*/ 360 w 500"/>
                  <a:gd name="T11" fmla="*/ 640 h 755"/>
                  <a:gd name="T12" fmla="*/ 401 w 500"/>
                  <a:gd name="T13" fmla="*/ 537 h 755"/>
                  <a:gd name="T14" fmla="*/ 361 w 500"/>
                  <a:gd name="T15" fmla="*/ 434 h 755"/>
                  <a:gd name="T16" fmla="*/ 250 w 500"/>
                  <a:gd name="T17" fmla="*/ 396 h 755"/>
                  <a:gd name="T18" fmla="*/ 151 w 500"/>
                  <a:gd name="T19" fmla="*/ 354 h 755"/>
                  <a:gd name="T20" fmla="*/ 52 w 500"/>
                  <a:gd name="T21" fmla="*/ 295 h 755"/>
                  <a:gd name="T22" fmla="*/ 17 w 500"/>
                  <a:gd name="T23" fmla="*/ 189 h 755"/>
                  <a:gd name="T24" fmla="*/ 79 w 500"/>
                  <a:gd name="T25" fmla="*/ 51 h 755"/>
                  <a:gd name="T26" fmla="*/ 250 w 500"/>
                  <a:gd name="T27" fmla="*/ 0 h 755"/>
                  <a:gd name="T28" fmla="*/ 421 w 500"/>
                  <a:gd name="T29" fmla="*/ 51 h 755"/>
                  <a:gd name="T30" fmla="*/ 483 w 500"/>
                  <a:gd name="T31" fmla="*/ 189 h 755"/>
                  <a:gd name="T32" fmla="*/ 447 w 500"/>
                  <a:gd name="T33" fmla="*/ 295 h 755"/>
                  <a:gd name="T34" fmla="*/ 349 w 500"/>
                  <a:gd name="T35" fmla="*/ 354 h 755"/>
                  <a:gd name="T36" fmla="*/ 460 w 500"/>
                  <a:gd name="T37" fmla="*/ 419 h 755"/>
                  <a:gd name="T38" fmla="*/ 500 w 500"/>
                  <a:gd name="T39" fmla="*/ 537 h 755"/>
                  <a:gd name="T40" fmla="*/ 435 w 500"/>
                  <a:gd name="T41" fmla="*/ 699 h 755"/>
                  <a:gd name="T42" fmla="*/ 249 w 500"/>
                  <a:gd name="T43" fmla="*/ 755 h 755"/>
                  <a:gd name="T44" fmla="*/ 64 w 500"/>
                  <a:gd name="T45" fmla="*/ 699 h 755"/>
                  <a:gd name="T46" fmla="*/ 0 w 500"/>
                  <a:gd name="T47" fmla="*/ 537 h 755"/>
                  <a:gd name="T48" fmla="*/ 40 w 500"/>
                  <a:gd name="T49" fmla="*/ 419 h 755"/>
                  <a:gd name="T50" fmla="*/ 151 w 500"/>
                  <a:gd name="T51" fmla="*/ 354 h 755"/>
                  <a:gd name="T52" fmla="*/ 115 w 500"/>
                  <a:gd name="T53" fmla="*/ 198 h 755"/>
                  <a:gd name="T54" fmla="*/ 150 w 500"/>
                  <a:gd name="T55" fmla="*/ 287 h 755"/>
                  <a:gd name="T56" fmla="*/ 250 w 500"/>
                  <a:gd name="T57" fmla="*/ 318 h 755"/>
                  <a:gd name="T58" fmla="*/ 349 w 500"/>
                  <a:gd name="T59" fmla="*/ 287 h 755"/>
                  <a:gd name="T60" fmla="*/ 385 w 500"/>
                  <a:gd name="T61" fmla="*/ 198 h 755"/>
                  <a:gd name="T62" fmla="*/ 349 w 500"/>
                  <a:gd name="T63" fmla="*/ 110 h 755"/>
                  <a:gd name="T64" fmla="*/ 250 w 500"/>
                  <a:gd name="T65" fmla="*/ 78 h 755"/>
                  <a:gd name="T66" fmla="*/ 150 w 500"/>
                  <a:gd name="T67" fmla="*/ 110 h 755"/>
                  <a:gd name="T68" fmla="*/ 115 w 500"/>
                  <a:gd name="T69" fmla="*/ 198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500" h="755">
                    <a:moveTo>
                      <a:pt x="250" y="396"/>
                    </a:moveTo>
                    <a:cubicBezTo>
                      <a:pt x="203" y="396"/>
                      <a:pt x="166" y="409"/>
                      <a:pt x="139" y="434"/>
                    </a:cubicBezTo>
                    <a:cubicBezTo>
                      <a:pt x="112" y="459"/>
                      <a:pt x="99" y="493"/>
                      <a:pt x="99" y="537"/>
                    </a:cubicBezTo>
                    <a:cubicBezTo>
                      <a:pt x="99" y="581"/>
                      <a:pt x="112" y="616"/>
                      <a:pt x="139" y="641"/>
                    </a:cubicBezTo>
                    <a:cubicBezTo>
                      <a:pt x="166" y="666"/>
                      <a:pt x="203" y="678"/>
                      <a:pt x="250" y="678"/>
                    </a:cubicBezTo>
                    <a:cubicBezTo>
                      <a:pt x="296" y="678"/>
                      <a:pt x="333" y="666"/>
                      <a:pt x="360" y="640"/>
                    </a:cubicBezTo>
                    <a:cubicBezTo>
                      <a:pt x="387" y="615"/>
                      <a:pt x="401" y="581"/>
                      <a:pt x="401" y="537"/>
                    </a:cubicBezTo>
                    <a:cubicBezTo>
                      <a:pt x="401" y="493"/>
                      <a:pt x="387" y="459"/>
                      <a:pt x="361" y="434"/>
                    </a:cubicBezTo>
                    <a:cubicBezTo>
                      <a:pt x="334" y="409"/>
                      <a:pt x="297" y="396"/>
                      <a:pt x="250" y="396"/>
                    </a:cubicBezTo>
                    <a:close/>
                    <a:moveTo>
                      <a:pt x="151" y="354"/>
                    </a:moveTo>
                    <a:cubicBezTo>
                      <a:pt x="109" y="344"/>
                      <a:pt x="76" y="324"/>
                      <a:pt x="52" y="295"/>
                    </a:cubicBezTo>
                    <a:cubicBezTo>
                      <a:pt x="28" y="266"/>
                      <a:pt x="17" y="231"/>
                      <a:pt x="17" y="189"/>
                    </a:cubicBezTo>
                    <a:cubicBezTo>
                      <a:pt x="17" y="131"/>
                      <a:pt x="37" y="85"/>
                      <a:pt x="79" y="51"/>
                    </a:cubicBezTo>
                    <a:cubicBezTo>
                      <a:pt x="120" y="17"/>
                      <a:pt x="177" y="0"/>
                      <a:pt x="250" y="0"/>
                    </a:cubicBezTo>
                    <a:cubicBezTo>
                      <a:pt x="322" y="0"/>
                      <a:pt x="379" y="17"/>
                      <a:pt x="421" y="51"/>
                    </a:cubicBezTo>
                    <a:cubicBezTo>
                      <a:pt x="462" y="85"/>
                      <a:pt x="483" y="131"/>
                      <a:pt x="483" y="189"/>
                    </a:cubicBezTo>
                    <a:cubicBezTo>
                      <a:pt x="483" y="231"/>
                      <a:pt x="471" y="266"/>
                      <a:pt x="447" y="295"/>
                    </a:cubicBezTo>
                    <a:cubicBezTo>
                      <a:pt x="423" y="324"/>
                      <a:pt x="391" y="344"/>
                      <a:pt x="349" y="354"/>
                    </a:cubicBezTo>
                    <a:cubicBezTo>
                      <a:pt x="396" y="365"/>
                      <a:pt x="433" y="387"/>
                      <a:pt x="460" y="419"/>
                    </a:cubicBezTo>
                    <a:cubicBezTo>
                      <a:pt x="486" y="451"/>
                      <a:pt x="500" y="491"/>
                      <a:pt x="500" y="537"/>
                    </a:cubicBezTo>
                    <a:cubicBezTo>
                      <a:pt x="500" y="608"/>
                      <a:pt x="478" y="662"/>
                      <a:pt x="435" y="699"/>
                    </a:cubicBezTo>
                    <a:cubicBezTo>
                      <a:pt x="391" y="737"/>
                      <a:pt x="329" y="755"/>
                      <a:pt x="249" y="755"/>
                    </a:cubicBezTo>
                    <a:cubicBezTo>
                      <a:pt x="169" y="755"/>
                      <a:pt x="107" y="737"/>
                      <a:pt x="64" y="699"/>
                    </a:cubicBezTo>
                    <a:cubicBezTo>
                      <a:pt x="21" y="662"/>
                      <a:pt x="0" y="608"/>
                      <a:pt x="0" y="537"/>
                    </a:cubicBezTo>
                    <a:cubicBezTo>
                      <a:pt x="0" y="491"/>
                      <a:pt x="13" y="451"/>
                      <a:pt x="40" y="419"/>
                    </a:cubicBezTo>
                    <a:cubicBezTo>
                      <a:pt x="66" y="387"/>
                      <a:pt x="103" y="365"/>
                      <a:pt x="151" y="354"/>
                    </a:cubicBezTo>
                    <a:close/>
                    <a:moveTo>
                      <a:pt x="115" y="198"/>
                    </a:moveTo>
                    <a:cubicBezTo>
                      <a:pt x="115" y="236"/>
                      <a:pt x="126" y="266"/>
                      <a:pt x="150" y="287"/>
                    </a:cubicBezTo>
                    <a:cubicBezTo>
                      <a:pt x="174" y="308"/>
                      <a:pt x="207" y="318"/>
                      <a:pt x="250" y="318"/>
                    </a:cubicBezTo>
                    <a:cubicBezTo>
                      <a:pt x="292" y="318"/>
                      <a:pt x="325" y="308"/>
                      <a:pt x="349" y="287"/>
                    </a:cubicBezTo>
                    <a:cubicBezTo>
                      <a:pt x="373" y="266"/>
                      <a:pt x="385" y="236"/>
                      <a:pt x="385" y="198"/>
                    </a:cubicBezTo>
                    <a:cubicBezTo>
                      <a:pt x="385" y="160"/>
                      <a:pt x="373" y="131"/>
                      <a:pt x="349" y="110"/>
                    </a:cubicBezTo>
                    <a:cubicBezTo>
                      <a:pt x="325" y="89"/>
                      <a:pt x="292" y="78"/>
                      <a:pt x="250" y="78"/>
                    </a:cubicBezTo>
                    <a:cubicBezTo>
                      <a:pt x="207" y="78"/>
                      <a:pt x="174" y="89"/>
                      <a:pt x="150" y="110"/>
                    </a:cubicBezTo>
                    <a:cubicBezTo>
                      <a:pt x="126" y="131"/>
                      <a:pt x="115" y="160"/>
                      <a:pt x="115" y="19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6" name="Freeform 140">
                <a:extLst>
                  <a:ext uri="{FF2B5EF4-FFF2-40B4-BE49-F238E27FC236}">
                    <a16:creationId xmlns:a16="http://schemas.microsoft.com/office/drawing/2014/main" id="{09D7C505-613F-B626-B77D-B2BD7399921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992438" y="3082925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7" name="Line 141">
                <a:extLst>
                  <a:ext uri="{FF2B5EF4-FFF2-40B4-BE49-F238E27FC236}">
                    <a16:creationId xmlns:a16="http://schemas.microsoft.com/office/drawing/2014/main" id="{69C0A8B1-3415-BC3B-78F8-552AF075CA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81350" y="2671763"/>
                <a:ext cx="2365375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8" name="Freeform 142">
                <a:extLst>
                  <a:ext uri="{FF2B5EF4-FFF2-40B4-BE49-F238E27FC236}">
                    <a16:creationId xmlns:a16="http://schemas.microsoft.com/office/drawing/2014/main" id="{A210C15A-869D-45CF-892C-AEAA6B08840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63838" y="2606675"/>
                <a:ext cx="84138" cy="134938"/>
              </a:xfrm>
              <a:custGeom>
                <a:avLst/>
                <a:gdLst>
                  <a:gd name="T0" fmla="*/ 119 w 463"/>
                  <a:gd name="T1" fmla="*/ 659 h 742"/>
                  <a:gd name="T2" fmla="*/ 463 w 463"/>
                  <a:gd name="T3" fmla="*/ 659 h 742"/>
                  <a:gd name="T4" fmla="*/ 463 w 463"/>
                  <a:gd name="T5" fmla="*/ 742 h 742"/>
                  <a:gd name="T6" fmla="*/ 0 w 463"/>
                  <a:gd name="T7" fmla="*/ 742 h 742"/>
                  <a:gd name="T8" fmla="*/ 0 w 463"/>
                  <a:gd name="T9" fmla="*/ 659 h 742"/>
                  <a:gd name="T10" fmla="*/ 153 w 463"/>
                  <a:gd name="T11" fmla="*/ 503 h 742"/>
                  <a:gd name="T12" fmla="*/ 275 w 463"/>
                  <a:gd name="T13" fmla="*/ 377 h 742"/>
                  <a:gd name="T14" fmla="*/ 341 w 463"/>
                  <a:gd name="T15" fmla="*/ 287 h 742"/>
                  <a:gd name="T16" fmla="*/ 360 w 463"/>
                  <a:gd name="T17" fmla="*/ 214 h 742"/>
                  <a:gd name="T18" fmla="*/ 319 w 463"/>
                  <a:gd name="T19" fmla="*/ 120 h 742"/>
                  <a:gd name="T20" fmla="*/ 213 w 463"/>
                  <a:gd name="T21" fmla="*/ 83 h 742"/>
                  <a:gd name="T22" fmla="*/ 115 w 463"/>
                  <a:gd name="T23" fmla="*/ 99 h 742"/>
                  <a:gd name="T24" fmla="*/ 5 w 463"/>
                  <a:gd name="T25" fmla="*/ 148 h 742"/>
                  <a:gd name="T26" fmla="*/ 5 w 463"/>
                  <a:gd name="T27" fmla="*/ 48 h 742"/>
                  <a:gd name="T28" fmla="*/ 116 w 463"/>
                  <a:gd name="T29" fmla="*/ 12 h 742"/>
                  <a:gd name="T30" fmla="*/ 211 w 463"/>
                  <a:gd name="T31" fmla="*/ 0 h 742"/>
                  <a:gd name="T32" fmla="*/ 391 w 463"/>
                  <a:gd name="T33" fmla="*/ 57 h 742"/>
                  <a:gd name="T34" fmla="*/ 459 w 463"/>
                  <a:gd name="T35" fmla="*/ 208 h 742"/>
                  <a:gd name="T36" fmla="*/ 442 w 463"/>
                  <a:gd name="T37" fmla="*/ 293 h 742"/>
                  <a:gd name="T38" fmla="*/ 381 w 463"/>
                  <a:gd name="T39" fmla="*/ 388 h 742"/>
                  <a:gd name="T40" fmla="*/ 303 w 463"/>
                  <a:gd name="T41" fmla="*/ 470 h 742"/>
                  <a:gd name="T42" fmla="*/ 119 w 463"/>
                  <a:gd name="T43" fmla="*/ 659 h 7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463" h="742">
                    <a:moveTo>
                      <a:pt x="119" y="659"/>
                    </a:moveTo>
                    <a:lnTo>
                      <a:pt x="463" y="659"/>
                    </a:lnTo>
                    <a:lnTo>
                      <a:pt x="463" y="742"/>
                    </a:lnTo>
                    <a:lnTo>
                      <a:pt x="0" y="742"/>
                    </a:lnTo>
                    <a:lnTo>
                      <a:pt x="0" y="659"/>
                    </a:lnTo>
                    <a:cubicBezTo>
                      <a:pt x="37" y="621"/>
                      <a:pt x="88" y="569"/>
                      <a:pt x="153" y="503"/>
                    </a:cubicBezTo>
                    <a:cubicBezTo>
                      <a:pt x="217" y="438"/>
                      <a:pt x="258" y="396"/>
                      <a:pt x="275" y="377"/>
                    </a:cubicBezTo>
                    <a:cubicBezTo>
                      <a:pt x="307" y="342"/>
                      <a:pt x="329" y="312"/>
                      <a:pt x="341" y="287"/>
                    </a:cubicBezTo>
                    <a:cubicBezTo>
                      <a:pt x="353" y="263"/>
                      <a:pt x="360" y="238"/>
                      <a:pt x="360" y="214"/>
                    </a:cubicBezTo>
                    <a:cubicBezTo>
                      <a:pt x="360" y="176"/>
                      <a:pt x="346" y="144"/>
                      <a:pt x="319" y="120"/>
                    </a:cubicBezTo>
                    <a:cubicBezTo>
                      <a:pt x="292" y="96"/>
                      <a:pt x="257" y="83"/>
                      <a:pt x="213" y="83"/>
                    </a:cubicBezTo>
                    <a:cubicBezTo>
                      <a:pt x="182" y="83"/>
                      <a:pt x="149" y="89"/>
                      <a:pt x="115" y="99"/>
                    </a:cubicBezTo>
                    <a:cubicBezTo>
                      <a:pt x="81" y="110"/>
                      <a:pt x="44" y="126"/>
                      <a:pt x="5" y="148"/>
                    </a:cubicBezTo>
                    <a:lnTo>
                      <a:pt x="5" y="48"/>
                    </a:lnTo>
                    <a:cubicBezTo>
                      <a:pt x="45" y="32"/>
                      <a:pt x="82" y="20"/>
                      <a:pt x="116" y="12"/>
                    </a:cubicBezTo>
                    <a:cubicBezTo>
                      <a:pt x="150" y="4"/>
                      <a:pt x="182" y="0"/>
                      <a:pt x="211" y="0"/>
                    </a:cubicBezTo>
                    <a:cubicBezTo>
                      <a:pt x="286" y="0"/>
                      <a:pt x="346" y="19"/>
                      <a:pt x="391" y="57"/>
                    </a:cubicBezTo>
                    <a:cubicBezTo>
                      <a:pt x="436" y="95"/>
                      <a:pt x="459" y="145"/>
                      <a:pt x="459" y="208"/>
                    </a:cubicBezTo>
                    <a:cubicBezTo>
                      <a:pt x="459" y="238"/>
                      <a:pt x="453" y="267"/>
                      <a:pt x="442" y="293"/>
                    </a:cubicBezTo>
                    <a:cubicBezTo>
                      <a:pt x="431" y="320"/>
                      <a:pt x="411" y="352"/>
                      <a:pt x="381" y="388"/>
                    </a:cubicBezTo>
                    <a:cubicBezTo>
                      <a:pt x="373" y="398"/>
                      <a:pt x="347" y="425"/>
                      <a:pt x="303" y="470"/>
                    </a:cubicBezTo>
                    <a:cubicBezTo>
                      <a:pt x="259" y="515"/>
                      <a:pt x="198" y="578"/>
                      <a:pt x="119" y="65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9" name="Freeform 143">
                <a:extLst>
                  <a:ext uri="{FF2B5EF4-FFF2-40B4-BE49-F238E27FC236}">
                    <a16:creationId xmlns:a16="http://schemas.microsoft.com/office/drawing/2014/main" id="{AF82890A-E52E-CE3B-EC54-2E96792D1F7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878138" y="2606675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0" name="Freeform 144">
                <a:extLst>
                  <a:ext uri="{FF2B5EF4-FFF2-40B4-BE49-F238E27FC236}">
                    <a16:creationId xmlns:a16="http://schemas.microsoft.com/office/drawing/2014/main" id="{E57C7A11-6FE8-71F5-92B2-3D215B83512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992438" y="2606675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1" name="Freeform 145">
                <a:extLst>
                  <a:ext uri="{FF2B5EF4-FFF2-40B4-BE49-F238E27FC236}">
                    <a16:creationId xmlns:a16="http://schemas.microsoft.com/office/drawing/2014/main" id="{A2F94E32-8FDB-78E2-2AB0-A994DC7CDDC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3175" y="4659313"/>
                <a:ext cx="136525" cy="106363"/>
              </a:xfrm>
              <a:custGeom>
                <a:avLst/>
                <a:gdLst>
                  <a:gd name="T0" fmla="*/ 69 w 755"/>
                  <a:gd name="T1" fmla="*/ 0 h 588"/>
                  <a:gd name="T2" fmla="*/ 173 w 755"/>
                  <a:gd name="T3" fmla="*/ 0 h 588"/>
                  <a:gd name="T4" fmla="*/ 104 w 755"/>
                  <a:gd name="T5" fmla="*/ 107 h 588"/>
                  <a:gd name="T6" fmla="*/ 81 w 755"/>
                  <a:gd name="T7" fmla="*/ 226 h 588"/>
                  <a:gd name="T8" fmla="*/ 158 w 755"/>
                  <a:gd name="T9" fmla="*/ 418 h 588"/>
                  <a:gd name="T10" fmla="*/ 378 w 755"/>
                  <a:gd name="T11" fmla="*/ 484 h 588"/>
                  <a:gd name="T12" fmla="*/ 599 w 755"/>
                  <a:gd name="T13" fmla="*/ 418 h 588"/>
                  <a:gd name="T14" fmla="*/ 675 w 755"/>
                  <a:gd name="T15" fmla="*/ 226 h 588"/>
                  <a:gd name="T16" fmla="*/ 652 w 755"/>
                  <a:gd name="T17" fmla="*/ 107 h 588"/>
                  <a:gd name="T18" fmla="*/ 583 w 755"/>
                  <a:gd name="T19" fmla="*/ 0 h 588"/>
                  <a:gd name="T20" fmla="*/ 686 w 755"/>
                  <a:gd name="T21" fmla="*/ 0 h 588"/>
                  <a:gd name="T22" fmla="*/ 738 w 755"/>
                  <a:gd name="T23" fmla="*/ 110 h 588"/>
                  <a:gd name="T24" fmla="*/ 755 w 755"/>
                  <a:gd name="T25" fmla="*/ 232 h 588"/>
                  <a:gd name="T26" fmla="*/ 655 w 755"/>
                  <a:gd name="T27" fmla="*/ 493 h 588"/>
                  <a:gd name="T28" fmla="*/ 378 w 755"/>
                  <a:gd name="T29" fmla="*/ 588 h 588"/>
                  <a:gd name="T30" fmla="*/ 101 w 755"/>
                  <a:gd name="T31" fmla="*/ 493 h 588"/>
                  <a:gd name="T32" fmla="*/ 0 w 755"/>
                  <a:gd name="T33" fmla="*/ 232 h 588"/>
                  <a:gd name="T34" fmla="*/ 17 w 755"/>
                  <a:gd name="T35" fmla="*/ 109 h 588"/>
                  <a:gd name="T36" fmla="*/ 69 w 755"/>
                  <a:gd name="T37" fmla="*/ 0 h 5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755" h="588">
                    <a:moveTo>
                      <a:pt x="69" y="0"/>
                    </a:moveTo>
                    <a:lnTo>
                      <a:pt x="173" y="0"/>
                    </a:lnTo>
                    <a:cubicBezTo>
                      <a:pt x="143" y="34"/>
                      <a:pt x="120" y="69"/>
                      <a:pt x="104" y="107"/>
                    </a:cubicBezTo>
                    <a:cubicBezTo>
                      <a:pt x="89" y="145"/>
                      <a:pt x="81" y="184"/>
                      <a:pt x="81" y="226"/>
                    </a:cubicBezTo>
                    <a:cubicBezTo>
                      <a:pt x="81" y="310"/>
                      <a:pt x="107" y="374"/>
                      <a:pt x="158" y="418"/>
                    </a:cubicBezTo>
                    <a:cubicBezTo>
                      <a:pt x="209" y="462"/>
                      <a:pt x="282" y="484"/>
                      <a:pt x="378" y="484"/>
                    </a:cubicBezTo>
                    <a:cubicBezTo>
                      <a:pt x="474" y="484"/>
                      <a:pt x="548" y="462"/>
                      <a:pt x="599" y="418"/>
                    </a:cubicBezTo>
                    <a:cubicBezTo>
                      <a:pt x="650" y="374"/>
                      <a:pt x="675" y="310"/>
                      <a:pt x="675" y="226"/>
                    </a:cubicBezTo>
                    <a:cubicBezTo>
                      <a:pt x="675" y="184"/>
                      <a:pt x="668" y="145"/>
                      <a:pt x="652" y="107"/>
                    </a:cubicBezTo>
                    <a:cubicBezTo>
                      <a:pt x="637" y="69"/>
                      <a:pt x="614" y="34"/>
                      <a:pt x="583" y="0"/>
                    </a:cubicBezTo>
                    <a:lnTo>
                      <a:pt x="686" y="0"/>
                    </a:lnTo>
                    <a:cubicBezTo>
                      <a:pt x="710" y="35"/>
                      <a:pt x="727" y="72"/>
                      <a:pt x="738" y="110"/>
                    </a:cubicBezTo>
                    <a:cubicBezTo>
                      <a:pt x="749" y="148"/>
                      <a:pt x="755" y="189"/>
                      <a:pt x="755" y="232"/>
                    </a:cubicBezTo>
                    <a:cubicBezTo>
                      <a:pt x="755" y="342"/>
                      <a:pt x="722" y="429"/>
                      <a:pt x="655" y="493"/>
                    </a:cubicBezTo>
                    <a:cubicBezTo>
                      <a:pt x="588" y="557"/>
                      <a:pt x="496" y="588"/>
                      <a:pt x="378" y="588"/>
                    </a:cubicBezTo>
                    <a:cubicBezTo>
                      <a:pt x="261" y="588"/>
                      <a:pt x="169" y="557"/>
                      <a:pt x="101" y="493"/>
                    </a:cubicBezTo>
                    <a:cubicBezTo>
                      <a:pt x="34" y="429"/>
                      <a:pt x="0" y="342"/>
                      <a:pt x="0" y="232"/>
                    </a:cubicBezTo>
                    <a:cubicBezTo>
                      <a:pt x="0" y="188"/>
                      <a:pt x="6" y="147"/>
                      <a:pt x="17" y="109"/>
                    </a:cubicBezTo>
                    <a:cubicBezTo>
                      <a:pt x="29" y="71"/>
                      <a:pt x="46" y="34"/>
                      <a:pt x="69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2" name="Freeform 146">
                <a:extLst>
                  <a:ext uri="{FF2B5EF4-FFF2-40B4-BE49-F238E27FC236}">
                    <a16:creationId xmlns:a16="http://schemas.microsoft.com/office/drawing/2014/main" id="{418B9087-C708-7D85-A4E7-469111CB062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4548188"/>
                <a:ext cx="103188" cy="90488"/>
              </a:xfrm>
              <a:custGeom>
                <a:avLst/>
                <a:gdLst>
                  <a:gd name="T0" fmla="*/ 264 w 573"/>
                  <a:gd name="T1" fmla="*/ 0 h 507"/>
                  <a:gd name="T2" fmla="*/ 308 w 573"/>
                  <a:gd name="T3" fmla="*/ 0 h 507"/>
                  <a:gd name="T4" fmla="*/ 308 w 573"/>
                  <a:gd name="T5" fmla="*/ 413 h 507"/>
                  <a:gd name="T6" fmla="*/ 450 w 573"/>
                  <a:gd name="T7" fmla="*/ 357 h 507"/>
                  <a:gd name="T8" fmla="*/ 498 w 573"/>
                  <a:gd name="T9" fmla="*/ 218 h 507"/>
                  <a:gd name="T10" fmla="*/ 486 w 573"/>
                  <a:gd name="T11" fmla="*/ 118 h 507"/>
                  <a:gd name="T12" fmla="*/ 447 w 573"/>
                  <a:gd name="T13" fmla="*/ 21 h 507"/>
                  <a:gd name="T14" fmla="*/ 532 w 573"/>
                  <a:gd name="T15" fmla="*/ 21 h 507"/>
                  <a:gd name="T16" fmla="*/ 563 w 573"/>
                  <a:gd name="T17" fmla="*/ 120 h 507"/>
                  <a:gd name="T18" fmla="*/ 573 w 573"/>
                  <a:gd name="T19" fmla="*/ 223 h 507"/>
                  <a:gd name="T20" fmla="*/ 498 w 573"/>
                  <a:gd name="T21" fmla="*/ 431 h 507"/>
                  <a:gd name="T22" fmla="*/ 292 w 573"/>
                  <a:gd name="T23" fmla="*/ 507 h 507"/>
                  <a:gd name="T24" fmla="*/ 79 w 573"/>
                  <a:gd name="T25" fmla="*/ 435 h 507"/>
                  <a:gd name="T26" fmla="*/ 0 w 573"/>
                  <a:gd name="T27" fmla="*/ 239 h 507"/>
                  <a:gd name="T28" fmla="*/ 71 w 573"/>
                  <a:gd name="T29" fmla="*/ 64 h 507"/>
                  <a:gd name="T30" fmla="*/ 264 w 573"/>
                  <a:gd name="T31" fmla="*/ 0 h 507"/>
                  <a:gd name="T32" fmla="*/ 238 w 573"/>
                  <a:gd name="T33" fmla="*/ 90 h 507"/>
                  <a:gd name="T34" fmla="*/ 120 w 573"/>
                  <a:gd name="T35" fmla="*/ 131 h 507"/>
                  <a:gd name="T36" fmla="*/ 76 w 573"/>
                  <a:gd name="T37" fmla="*/ 238 h 507"/>
                  <a:gd name="T38" fmla="*/ 119 w 573"/>
                  <a:gd name="T39" fmla="*/ 358 h 507"/>
                  <a:gd name="T40" fmla="*/ 238 w 573"/>
                  <a:gd name="T41" fmla="*/ 410 h 507"/>
                  <a:gd name="T42" fmla="*/ 238 w 573"/>
                  <a:gd name="T43" fmla="*/ 90 h 5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73" h="507">
                    <a:moveTo>
                      <a:pt x="264" y="0"/>
                    </a:moveTo>
                    <a:lnTo>
                      <a:pt x="308" y="0"/>
                    </a:lnTo>
                    <a:lnTo>
                      <a:pt x="308" y="413"/>
                    </a:lnTo>
                    <a:cubicBezTo>
                      <a:pt x="370" y="409"/>
                      <a:pt x="418" y="391"/>
                      <a:pt x="450" y="357"/>
                    </a:cubicBezTo>
                    <a:cubicBezTo>
                      <a:pt x="482" y="324"/>
                      <a:pt x="498" y="278"/>
                      <a:pt x="498" y="218"/>
                    </a:cubicBezTo>
                    <a:cubicBezTo>
                      <a:pt x="498" y="184"/>
                      <a:pt x="494" y="150"/>
                      <a:pt x="486" y="118"/>
                    </a:cubicBezTo>
                    <a:cubicBezTo>
                      <a:pt x="478" y="86"/>
                      <a:pt x="465" y="53"/>
                      <a:pt x="447" y="21"/>
                    </a:cubicBezTo>
                    <a:lnTo>
                      <a:pt x="532" y="21"/>
                    </a:lnTo>
                    <a:cubicBezTo>
                      <a:pt x="546" y="53"/>
                      <a:pt x="557" y="86"/>
                      <a:pt x="563" y="120"/>
                    </a:cubicBezTo>
                    <a:cubicBezTo>
                      <a:pt x="569" y="154"/>
                      <a:pt x="573" y="189"/>
                      <a:pt x="573" y="223"/>
                    </a:cubicBezTo>
                    <a:cubicBezTo>
                      <a:pt x="573" y="311"/>
                      <a:pt x="548" y="380"/>
                      <a:pt x="498" y="431"/>
                    </a:cubicBezTo>
                    <a:cubicBezTo>
                      <a:pt x="448" y="482"/>
                      <a:pt x="379" y="507"/>
                      <a:pt x="292" y="507"/>
                    </a:cubicBezTo>
                    <a:cubicBezTo>
                      <a:pt x="203" y="507"/>
                      <a:pt x="132" y="483"/>
                      <a:pt x="79" y="435"/>
                    </a:cubicBezTo>
                    <a:cubicBezTo>
                      <a:pt x="27" y="387"/>
                      <a:pt x="0" y="321"/>
                      <a:pt x="0" y="239"/>
                    </a:cubicBezTo>
                    <a:cubicBezTo>
                      <a:pt x="0" y="165"/>
                      <a:pt x="24" y="107"/>
                      <a:pt x="71" y="64"/>
                    </a:cubicBezTo>
                    <a:cubicBezTo>
                      <a:pt x="119" y="22"/>
                      <a:pt x="183" y="0"/>
                      <a:pt x="264" y="0"/>
                    </a:cubicBezTo>
                    <a:close/>
                    <a:moveTo>
                      <a:pt x="238" y="90"/>
                    </a:moveTo>
                    <a:cubicBezTo>
                      <a:pt x="189" y="91"/>
                      <a:pt x="150" y="105"/>
                      <a:pt x="120" y="131"/>
                    </a:cubicBezTo>
                    <a:cubicBezTo>
                      <a:pt x="91" y="158"/>
                      <a:pt x="76" y="194"/>
                      <a:pt x="76" y="238"/>
                    </a:cubicBezTo>
                    <a:cubicBezTo>
                      <a:pt x="76" y="288"/>
                      <a:pt x="91" y="328"/>
                      <a:pt x="119" y="358"/>
                    </a:cubicBezTo>
                    <a:cubicBezTo>
                      <a:pt x="147" y="388"/>
                      <a:pt x="187" y="406"/>
                      <a:pt x="238" y="410"/>
                    </a:cubicBezTo>
                    <a:lnTo>
                      <a:pt x="238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3" name="Rectangle 147">
                <a:extLst>
                  <a:ext uri="{FF2B5EF4-FFF2-40B4-BE49-F238E27FC236}">
                    <a16:creationId xmlns:a16="http://schemas.microsoft.com/office/drawing/2014/main" id="{6DB5AD8A-911D-0FC3-5A56-613DD32F36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000" y="4505325"/>
                <a:ext cx="136525" cy="1587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4" name="Rectangle 148">
                <a:extLst>
                  <a:ext uri="{FF2B5EF4-FFF2-40B4-BE49-F238E27FC236}">
                    <a16:creationId xmlns:a16="http://schemas.microsoft.com/office/drawing/2014/main" id="{49E15C0B-AC0D-62E1-336E-D8A15CCE4D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000" y="4454525"/>
                <a:ext cx="136525" cy="1587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5" name="Freeform 149">
                <a:extLst>
                  <a:ext uri="{FF2B5EF4-FFF2-40B4-BE49-F238E27FC236}">
                    <a16:creationId xmlns:a16="http://schemas.microsoft.com/office/drawing/2014/main" id="{648EF253-71E0-61B9-254D-C01FEB36B07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6350" y="4264025"/>
                <a:ext cx="130175" cy="98425"/>
              </a:xfrm>
              <a:custGeom>
                <a:avLst/>
                <a:gdLst>
                  <a:gd name="T0" fmla="*/ 0 w 729"/>
                  <a:gd name="T1" fmla="*/ 552 h 552"/>
                  <a:gd name="T2" fmla="*/ 0 w 729"/>
                  <a:gd name="T3" fmla="*/ 419 h 552"/>
                  <a:gd name="T4" fmla="*/ 610 w 729"/>
                  <a:gd name="T5" fmla="*/ 96 h 552"/>
                  <a:gd name="T6" fmla="*/ 0 w 729"/>
                  <a:gd name="T7" fmla="*/ 96 h 552"/>
                  <a:gd name="T8" fmla="*/ 0 w 729"/>
                  <a:gd name="T9" fmla="*/ 0 h 552"/>
                  <a:gd name="T10" fmla="*/ 729 w 729"/>
                  <a:gd name="T11" fmla="*/ 0 h 552"/>
                  <a:gd name="T12" fmla="*/ 729 w 729"/>
                  <a:gd name="T13" fmla="*/ 133 h 552"/>
                  <a:gd name="T14" fmla="*/ 119 w 729"/>
                  <a:gd name="T15" fmla="*/ 456 h 552"/>
                  <a:gd name="T16" fmla="*/ 729 w 729"/>
                  <a:gd name="T17" fmla="*/ 456 h 552"/>
                  <a:gd name="T18" fmla="*/ 729 w 729"/>
                  <a:gd name="T19" fmla="*/ 552 h 552"/>
                  <a:gd name="T20" fmla="*/ 0 w 729"/>
                  <a:gd name="T21" fmla="*/ 552 h 5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729" h="552">
                    <a:moveTo>
                      <a:pt x="0" y="552"/>
                    </a:moveTo>
                    <a:lnTo>
                      <a:pt x="0" y="419"/>
                    </a:lnTo>
                    <a:lnTo>
                      <a:pt x="610" y="96"/>
                    </a:lnTo>
                    <a:lnTo>
                      <a:pt x="0" y="96"/>
                    </a:lnTo>
                    <a:lnTo>
                      <a:pt x="0" y="0"/>
                    </a:lnTo>
                    <a:lnTo>
                      <a:pt x="729" y="0"/>
                    </a:lnTo>
                    <a:lnTo>
                      <a:pt x="729" y="133"/>
                    </a:lnTo>
                    <a:lnTo>
                      <a:pt x="119" y="456"/>
                    </a:lnTo>
                    <a:lnTo>
                      <a:pt x="729" y="456"/>
                    </a:lnTo>
                    <a:lnTo>
                      <a:pt x="729" y="552"/>
                    </a:lnTo>
                    <a:lnTo>
                      <a:pt x="0" y="552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6" name="Freeform 150">
                <a:extLst>
                  <a:ext uri="{FF2B5EF4-FFF2-40B4-BE49-F238E27FC236}">
                    <a16:creationId xmlns:a16="http://schemas.microsoft.com/office/drawing/2014/main" id="{96F2B276-3F8D-7EB8-B54E-7ED2C0EF464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4148138"/>
                <a:ext cx="103188" cy="82550"/>
              </a:xfrm>
              <a:custGeom>
                <a:avLst/>
                <a:gdLst>
                  <a:gd name="T0" fmla="*/ 344 w 573"/>
                  <a:gd name="T1" fmla="*/ 458 h 458"/>
                  <a:gd name="T2" fmla="*/ 13 w 573"/>
                  <a:gd name="T3" fmla="*/ 458 h 458"/>
                  <a:gd name="T4" fmla="*/ 13 w 573"/>
                  <a:gd name="T5" fmla="*/ 368 h 458"/>
                  <a:gd name="T6" fmla="*/ 341 w 573"/>
                  <a:gd name="T7" fmla="*/ 368 h 458"/>
                  <a:gd name="T8" fmla="*/ 457 w 573"/>
                  <a:gd name="T9" fmla="*/ 338 h 458"/>
                  <a:gd name="T10" fmla="*/ 496 w 573"/>
                  <a:gd name="T11" fmla="*/ 247 h 458"/>
                  <a:gd name="T12" fmla="*/ 450 w 573"/>
                  <a:gd name="T13" fmla="*/ 132 h 458"/>
                  <a:gd name="T14" fmla="*/ 323 w 573"/>
                  <a:gd name="T15" fmla="*/ 90 h 458"/>
                  <a:gd name="T16" fmla="*/ 13 w 573"/>
                  <a:gd name="T17" fmla="*/ 90 h 458"/>
                  <a:gd name="T18" fmla="*/ 13 w 573"/>
                  <a:gd name="T19" fmla="*/ 0 h 458"/>
                  <a:gd name="T20" fmla="*/ 560 w 573"/>
                  <a:gd name="T21" fmla="*/ 0 h 458"/>
                  <a:gd name="T22" fmla="*/ 560 w 573"/>
                  <a:gd name="T23" fmla="*/ 90 h 458"/>
                  <a:gd name="T24" fmla="*/ 476 w 573"/>
                  <a:gd name="T25" fmla="*/ 90 h 458"/>
                  <a:gd name="T26" fmla="*/ 550 w 573"/>
                  <a:gd name="T27" fmla="*/ 166 h 458"/>
                  <a:gd name="T28" fmla="*/ 573 w 573"/>
                  <a:gd name="T29" fmla="*/ 266 h 458"/>
                  <a:gd name="T30" fmla="*/ 515 w 573"/>
                  <a:gd name="T31" fmla="*/ 409 h 458"/>
                  <a:gd name="T32" fmla="*/ 344 w 573"/>
                  <a:gd name="T33" fmla="*/ 458 h 458"/>
                  <a:gd name="T34" fmla="*/ 0 w 573"/>
                  <a:gd name="T35" fmla="*/ 232 h 458"/>
                  <a:gd name="T36" fmla="*/ 1 w 573"/>
                  <a:gd name="T37" fmla="*/ 232 h 458"/>
                  <a:gd name="T38" fmla="*/ 0 w 573"/>
                  <a:gd name="T39" fmla="*/ 232 h 4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573" h="458">
                    <a:moveTo>
                      <a:pt x="344" y="458"/>
                    </a:moveTo>
                    <a:lnTo>
                      <a:pt x="13" y="458"/>
                    </a:lnTo>
                    <a:lnTo>
                      <a:pt x="13" y="368"/>
                    </a:lnTo>
                    <a:lnTo>
                      <a:pt x="341" y="368"/>
                    </a:lnTo>
                    <a:cubicBezTo>
                      <a:pt x="393" y="368"/>
                      <a:pt x="431" y="358"/>
                      <a:pt x="457" y="338"/>
                    </a:cubicBezTo>
                    <a:cubicBezTo>
                      <a:pt x="483" y="318"/>
                      <a:pt x="496" y="288"/>
                      <a:pt x="496" y="247"/>
                    </a:cubicBezTo>
                    <a:cubicBezTo>
                      <a:pt x="496" y="199"/>
                      <a:pt x="481" y="160"/>
                      <a:pt x="450" y="132"/>
                    </a:cubicBezTo>
                    <a:cubicBezTo>
                      <a:pt x="419" y="104"/>
                      <a:pt x="377" y="90"/>
                      <a:pt x="323" y="90"/>
                    </a:cubicBezTo>
                    <a:lnTo>
                      <a:pt x="13" y="90"/>
                    </a:lnTo>
                    <a:lnTo>
                      <a:pt x="13" y="0"/>
                    </a:lnTo>
                    <a:lnTo>
                      <a:pt x="560" y="0"/>
                    </a:lnTo>
                    <a:lnTo>
                      <a:pt x="560" y="90"/>
                    </a:lnTo>
                    <a:lnTo>
                      <a:pt x="476" y="90"/>
                    </a:lnTo>
                    <a:cubicBezTo>
                      <a:pt x="510" y="112"/>
                      <a:pt x="534" y="138"/>
                      <a:pt x="550" y="166"/>
                    </a:cubicBezTo>
                    <a:cubicBezTo>
                      <a:pt x="565" y="195"/>
                      <a:pt x="573" y="228"/>
                      <a:pt x="573" y="266"/>
                    </a:cubicBezTo>
                    <a:cubicBezTo>
                      <a:pt x="573" y="329"/>
                      <a:pt x="554" y="377"/>
                      <a:pt x="515" y="409"/>
                    </a:cubicBezTo>
                    <a:cubicBezTo>
                      <a:pt x="477" y="442"/>
                      <a:pt x="420" y="458"/>
                      <a:pt x="344" y="458"/>
                    </a:cubicBezTo>
                    <a:close/>
                    <a:moveTo>
                      <a:pt x="0" y="232"/>
                    </a:moveTo>
                    <a:lnTo>
                      <a:pt x="1" y="232"/>
                    </a:lnTo>
                    <a:lnTo>
                      <a:pt x="0" y="232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7" name="Freeform 151">
                <a:extLst>
                  <a:ext uri="{FF2B5EF4-FFF2-40B4-BE49-F238E27FC236}">
                    <a16:creationId xmlns:a16="http://schemas.microsoft.com/office/drawing/2014/main" id="{05B971D5-CE05-A1AA-E211-BA3FDB9E791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6513" y="3970338"/>
                <a:ext cx="100013" cy="144463"/>
              </a:xfrm>
              <a:custGeom>
                <a:avLst/>
                <a:gdLst>
                  <a:gd name="T0" fmla="*/ 118 w 560"/>
                  <a:gd name="T1" fmla="*/ 369 h 798"/>
                  <a:gd name="T2" fmla="*/ 29 w 560"/>
                  <a:gd name="T3" fmla="*/ 289 h 798"/>
                  <a:gd name="T4" fmla="*/ 0 w 560"/>
                  <a:gd name="T5" fmla="*/ 178 h 798"/>
                  <a:gd name="T6" fmla="*/ 60 w 560"/>
                  <a:gd name="T7" fmla="*/ 47 h 798"/>
                  <a:gd name="T8" fmla="*/ 230 w 560"/>
                  <a:gd name="T9" fmla="*/ 0 h 798"/>
                  <a:gd name="T10" fmla="*/ 560 w 560"/>
                  <a:gd name="T11" fmla="*/ 0 h 798"/>
                  <a:gd name="T12" fmla="*/ 560 w 560"/>
                  <a:gd name="T13" fmla="*/ 90 h 798"/>
                  <a:gd name="T14" fmla="*/ 233 w 560"/>
                  <a:gd name="T15" fmla="*/ 90 h 798"/>
                  <a:gd name="T16" fmla="*/ 116 w 560"/>
                  <a:gd name="T17" fmla="*/ 118 h 798"/>
                  <a:gd name="T18" fmla="*/ 78 w 560"/>
                  <a:gd name="T19" fmla="*/ 203 h 798"/>
                  <a:gd name="T20" fmla="*/ 125 w 560"/>
                  <a:gd name="T21" fmla="*/ 314 h 798"/>
                  <a:gd name="T22" fmla="*/ 251 w 560"/>
                  <a:gd name="T23" fmla="*/ 354 h 798"/>
                  <a:gd name="T24" fmla="*/ 560 w 560"/>
                  <a:gd name="T25" fmla="*/ 354 h 798"/>
                  <a:gd name="T26" fmla="*/ 560 w 560"/>
                  <a:gd name="T27" fmla="*/ 444 h 798"/>
                  <a:gd name="T28" fmla="*/ 233 w 560"/>
                  <a:gd name="T29" fmla="*/ 444 h 798"/>
                  <a:gd name="T30" fmla="*/ 116 w 560"/>
                  <a:gd name="T31" fmla="*/ 472 h 798"/>
                  <a:gd name="T32" fmla="*/ 78 w 560"/>
                  <a:gd name="T33" fmla="*/ 558 h 798"/>
                  <a:gd name="T34" fmla="*/ 125 w 560"/>
                  <a:gd name="T35" fmla="*/ 668 h 798"/>
                  <a:gd name="T36" fmla="*/ 251 w 560"/>
                  <a:gd name="T37" fmla="*/ 708 h 798"/>
                  <a:gd name="T38" fmla="*/ 560 w 560"/>
                  <a:gd name="T39" fmla="*/ 708 h 798"/>
                  <a:gd name="T40" fmla="*/ 560 w 560"/>
                  <a:gd name="T41" fmla="*/ 798 h 798"/>
                  <a:gd name="T42" fmla="*/ 13 w 560"/>
                  <a:gd name="T43" fmla="*/ 798 h 798"/>
                  <a:gd name="T44" fmla="*/ 13 w 560"/>
                  <a:gd name="T45" fmla="*/ 708 h 798"/>
                  <a:gd name="T46" fmla="*/ 98 w 560"/>
                  <a:gd name="T47" fmla="*/ 708 h 798"/>
                  <a:gd name="T48" fmla="*/ 24 w 560"/>
                  <a:gd name="T49" fmla="*/ 634 h 798"/>
                  <a:gd name="T50" fmla="*/ 0 w 560"/>
                  <a:gd name="T51" fmla="*/ 532 h 798"/>
                  <a:gd name="T52" fmla="*/ 30 w 560"/>
                  <a:gd name="T53" fmla="*/ 431 h 798"/>
                  <a:gd name="T54" fmla="*/ 118 w 560"/>
                  <a:gd name="T55" fmla="*/ 369 h 7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</a:cxnLst>
                <a:rect l="0" t="0" r="r" b="b"/>
                <a:pathLst>
                  <a:path w="560" h="798">
                    <a:moveTo>
                      <a:pt x="118" y="369"/>
                    </a:moveTo>
                    <a:cubicBezTo>
                      <a:pt x="78" y="347"/>
                      <a:pt x="49" y="320"/>
                      <a:pt x="29" y="289"/>
                    </a:cubicBezTo>
                    <a:cubicBezTo>
                      <a:pt x="10" y="258"/>
                      <a:pt x="0" y="221"/>
                      <a:pt x="0" y="178"/>
                    </a:cubicBezTo>
                    <a:cubicBezTo>
                      <a:pt x="0" y="122"/>
                      <a:pt x="20" y="78"/>
                      <a:pt x="60" y="47"/>
                    </a:cubicBezTo>
                    <a:cubicBezTo>
                      <a:pt x="100" y="16"/>
                      <a:pt x="157" y="0"/>
                      <a:pt x="230" y="0"/>
                    </a:cubicBezTo>
                    <a:lnTo>
                      <a:pt x="560" y="0"/>
                    </a:lnTo>
                    <a:lnTo>
                      <a:pt x="560" y="90"/>
                    </a:lnTo>
                    <a:lnTo>
                      <a:pt x="233" y="90"/>
                    </a:lnTo>
                    <a:cubicBezTo>
                      <a:pt x="181" y="90"/>
                      <a:pt x="142" y="100"/>
                      <a:pt x="116" y="118"/>
                    </a:cubicBezTo>
                    <a:cubicBezTo>
                      <a:pt x="91" y="137"/>
                      <a:pt x="78" y="165"/>
                      <a:pt x="78" y="203"/>
                    </a:cubicBezTo>
                    <a:cubicBezTo>
                      <a:pt x="78" y="250"/>
                      <a:pt x="94" y="287"/>
                      <a:pt x="125" y="314"/>
                    </a:cubicBezTo>
                    <a:cubicBezTo>
                      <a:pt x="156" y="341"/>
                      <a:pt x="198" y="354"/>
                      <a:pt x="251" y="354"/>
                    </a:cubicBezTo>
                    <a:lnTo>
                      <a:pt x="560" y="354"/>
                    </a:lnTo>
                    <a:lnTo>
                      <a:pt x="560" y="444"/>
                    </a:lnTo>
                    <a:lnTo>
                      <a:pt x="233" y="444"/>
                    </a:lnTo>
                    <a:cubicBezTo>
                      <a:pt x="181" y="444"/>
                      <a:pt x="142" y="454"/>
                      <a:pt x="116" y="472"/>
                    </a:cubicBezTo>
                    <a:cubicBezTo>
                      <a:pt x="91" y="491"/>
                      <a:pt x="78" y="520"/>
                      <a:pt x="78" y="558"/>
                    </a:cubicBezTo>
                    <a:cubicBezTo>
                      <a:pt x="78" y="604"/>
                      <a:pt x="94" y="641"/>
                      <a:pt x="125" y="668"/>
                    </a:cubicBezTo>
                    <a:cubicBezTo>
                      <a:pt x="156" y="695"/>
                      <a:pt x="198" y="708"/>
                      <a:pt x="251" y="708"/>
                    </a:cubicBezTo>
                    <a:lnTo>
                      <a:pt x="560" y="708"/>
                    </a:lnTo>
                    <a:lnTo>
                      <a:pt x="560" y="798"/>
                    </a:lnTo>
                    <a:lnTo>
                      <a:pt x="13" y="798"/>
                    </a:lnTo>
                    <a:lnTo>
                      <a:pt x="13" y="708"/>
                    </a:lnTo>
                    <a:lnTo>
                      <a:pt x="98" y="708"/>
                    </a:lnTo>
                    <a:cubicBezTo>
                      <a:pt x="65" y="688"/>
                      <a:pt x="40" y="663"/>
                      <a:pt x="24" y="634"/>
                    </a:cubicBezTo>
                    <a:cubicBezTo>
                      <a:pt x="8" y="606"/>
                      <a:pt x="0" y="572"/>
                      <a:pt x="0" y="532"/>
                    </a:cubicBezTo>
                    <a:cubicBezTo>
                      <a:pt x="0" y="492"/>
                      <a:pt x="10" y="459"/>
                      <a:pt x="30" y="431"/>
                    </a:cubicBezTo>
                    <a:cubicBezTo>
                      <a:pt x="50" y="403"/>
                      <a:pt x="80" y="383"/>
                      <a:pt x="118" y="36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8" name="Freeform 152">
                <a:extLst>
                  <a:ext uri="{FF2B5EF4-FFF2-40B4-BE49-F238E27FC236}">
                    <a16:creationId xmlns:a16="http://schemas.microsoft.com/office/drawing/2014/main" id="{9EE577CE-EC85-115E-7F7F-591F989DC73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40000" y="3851275"/>
                <a:ext cx="139700" cy="87313"/>
              </a:xfrm>
              <a:custGeom>
                <a:avLst/>
                <a:gdLst>
                  <a:gd name="T0" fmla="*/ 487 w 773"/>
                  <a:gd name="T1" fmla="*/ 93 h 489"/>
                  <a:gd name="T2" fmla="*/ 332 w 773"/>
                  <a:gd name="T3" fmla="*/ 134 h 489"/>
                  <a:gd name="T4" fmla="*/ 275 w 773"/>
                  <a:gd name="T5" fmla="*/ 246 h 489"/>
                  <a:gd name="T6" fmla="*/ 332 w 773"/>
                  <a:gd name="T7" fmla="*/ 358 h 489"/>
                  <a:gd name="T8" fmla="*/ 487 w 773"/>
                  <a:gd name="T9" fmla="*/ 399 h 489"/>
                  <a:gd name="T10" fmla="*/ 643 w 773"/>
                  <a:gd name="T11" fmla="*/ 358 h 489"/>
                  <a:gd name="T12" fmla="*/ 699 w 773"/>
                  <a:gd name="T13" fmla="*/ 246 h 489"/>
                  <a:gd name="T14" fmla="*/ 643 w 773"/>
                  <a:gd name="T15" fmla="*/ 134 h 489"/>
                  <a:gd name="T16" fmla="*/ 487 w 773"/>
                  <a:gd name="T17" fmla="*/ 93 h 489"/>
                  <a:gd name="T18" fmla="*/ 296 w 773"/>
                  <a:gd name="T19" fmla="*/ 399 h 489"/>
                  <a:gd name="T20" fmla="*/ 224 w 773"/>
                  <a:gd name="T21" fmla="*/ 328 h 489"/>
                  <a:gd name="T22" fmla="*/ 200 w 773"/>
                  <a:gd name="T23" fmla="*/ 224 h 489"/>
                  <a:gd name="T24" fmla="*/ 279 w 773"/>
                  <a:gd name="T25" fmla="*/ 62 h 489"/>
                  <a:gd name="T26" fmla="*/ 487 w 773"/>
                  <a:gd name="T27" fmla="*/ 0 h 489"/>
                  <a:gd name="T28" fmla="*/ 695 w 773"/>
                  <a:gd name="T29" fmla="*/ 62 h 489"/>
                  <a:gd name="T30" fmla="*/ 773 w 773"/>
                  <a:gd name="T31" fmla="*/ 224 h 489"/>
                  <a:gd name="T32" fmla="*/ 750 w 773"/>
                  <a:gd name="T33" fmla="*/ 328 h 489"/>
                  <a:gd name="T34" fmla="*/ 678 w 773"/>
                  <a:gd name="T35" fmla="*/ 399 h 489"/>
                  <a:gd name="T36" fmla="*/ 760 w 773"/>
                  <a:gd name="T37" fmla="*/ 399 h 489"/>
                  <a:gd name="T38" fmla="*/ 760 w 773"/>
                  <a:gd name="T39" fmla="*/ 489 h 489"/>
                  <a:gd name="T40" fmla="*/ 0 w 773"/>
                  <a:gd name="T41" fmla="*/ 489 h 489"/>
                  <a:gd name="T42" fmla="*/ 0 w 773"/>
                  <a:gd name="T43" fmla="*/ 399 h 489"/>
                  <a:gd name="T44" fmla="*/ 296 w 773"/>
                  <a:gd name="T45" fmla="*/ 399 h 4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773" h="489">
                    <a:moveTo>
                      <a:pt x="487" y="93"/>
                    </a:moveTo>
                    <a:cubicBezTo>
                      <a:pt x="421" y="93"/>
                      <a:pt x="370" y="107"/>
                      <a:pt x="332" y="134"/>
                    </a:cubicBezTo>
                    <a:cubicBezTo>
                      <a:pt x="294" y="162"/>
                      <a:pt x="275" y="199"/>
                      <a:pt x="275" y="246"/>
                    </a:cubicBezTo>
                    <a:cubicBezTo>
                      <a:pt x="275" y="294"/>
                      <a:pt x="294" y="331"/>
                      <a:pt x="332" y="358"/>
                    </a:cubicBezTo>
                    <a:cubicBezTo>
                      <a:pt x="370" y="386"/>
                      <a:pt x="421" y="399"/>
                      <a:pt x="487" y="399"/>
                    </a:cubicBezTo>
                    <a:cubicBezTo>
                      <a:pt x="553" y="399"/>
                      <a:pt x="605" y="386"/>
                      <a:pt x="643" y="358"/>
                    </a:cubicBezTo>
                    <a:cubicBezTo>
                      <a:pt x="681" y="331"/>
                      <a:pt x="699" y="294"/>
                      <a:pt x="699" y="246"/>
                    </a:cubicBezTo>
                    <a:cubicBezTo>
                      <a:pt x="699" y="199"/>
                      <a:pt x="681" y="162"/>
                      <a:pt x="643" y="134"/>
                    </a:cubicBezTo>
                    <a:cubicBezTo>
                      <a:pt x="605" y="107"/>
                      <a:pt x="553" y="93"/>
                      <a:pt x="487" y="93"/>
                    </a:cubicBezTo>
                    <a:close/>
                    <a:moveTo>
                      <a:pt x="296" y="399"/>
                    </a:moveTo>
                    <a:cubicBezTo>
                      <a:pt x="264" y="381"/>
                      <a:pt x="240" y="357"/>
                      <a:pt x="224" y="328"/>
                    </a:cubicBezTo>
                    <a:cubicBezTo>
                      <a:pt x="208" y="299"/>
                      <a:pt x="200" y="264"/>
                      <a:pt x="200" y="224"/>
                    </a:cubicBezTo>
                    <a:cubicBezTo>
                      <a:pt x="200" y="158"/>
                      <a:pt x="227" y="104"/>
                      <a:pt x="279" y="62"/>
                    </a:cubicBezTo>
                    <a:cubicBezTo>
                      <a:pt x="332" y="21"/>
                      <a:pt x="401" y="0"/>
                      <a:pt x="487" y="0"/>
                    </a:cubicBezTo>
                    <a:cubicBezTo>
                      <a:pt x="573" y="0"/>
                      <a:pt x="643" y="21"/>
                      <a:pt x="695" y="62"/>
                    </a:cubicBezTo>
                    <a:cubicBezTo>
                      <a:pt x="747" y="104"/>
                      <a:pt x="773" y="158"/>
                      <a:pt x="773" y="224"/>
                    </a:cubicBezTo>
                    <a:cubicBezTo>
                      <a:pt x="773" y="264"/>
                      <a:pt x="765" y="299"/>
                      <a:pt x="750" y="328"/>
                    </a:cubicBezTo>
                    <a:cubicBezTo>
                      <a:pt x="735" y="357"/>
                      <a:pt x="711" y="381"/>
                      <a:pt x="678" y="399"/>
                    </a:cubicBezTo>
                    <a:lnTo>
                      <a:pt x="760" y="399"/>
                    </a:lnTo>
                    <a:lnTo>
                      <a:pt x="760" y="489"/>
                    </a:lnTo>
                    <a:lnTo>
                      <a:pt x="0" y="489"/>
                    </a:lnTo>
                    <a:lnTo>
                      <a:pt x="0" y="399"/>
                    </a:lnTo>
                    <a:lnTo>
                      <a:pt x="296" y="399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9" name="Freeform 153">
                <a:extLst>
                  <a:ext uri="{FF2B5EF4-FFF2-40B4-BE49-F238E27FC236}">
                    <a16:creationId xmlns:a16="http://schemas.microsoft.com/office/drawing/2014/main" id="{32586210-B917-2970-9B6A-D6C6671C4BB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3738563"/>
                <a:ext cx="103188" cy="92075"/>
              </a:xfrm>
              <a:custGeom>
                <a:avLst/>
                <a:gdLst>
                  <a:gd name="T0" fmla="*/ 264 w 573"/>
                  <a:gd name="T1" fmla="*/ 0 h 507"/>
                  <a:gd name="T2" fmla="*/ 308 w 573"/>
                  <a:gd name="T3" fmla="*/ 0 h 507"/>
                  <a:gd name="T4" fmla="*/ 308 w 573"/>
                  <a:gd name="T5" fmla="*/ 413 h 507"/>
                  <a:gd name="T6" fmla="*/ 450 w 573"/>
                  <a:gd name="T7" fmla="*/ 357 h 507"/>
                  <a:gd name="T8" fmla="*/ 498 w 573"/>
                  <a:gd name="T9" fmla="*/ 218 h 507"/>
                  <a:gd name="T10" fmla="*/ 486 w 573"/>
                  <a:gd name="T11" fmla="*/ 118 h 507"/>
                  <a:gd name="T12" fmla="*/ 447 w 573"/>
                  <a:gd name="T13" fmla="*/ 21 h 507"/>
                  <a:gd name="T14" fmla="*/ 532 w 573"/>
                  <a:gd name="T15" fmla="*/ 21 h 507"/>
                  <a:gd name="T16" fmla="*/ 563 w 573"/>
                  <a:gd name="T17" fmla="*/ 120 h 507"/>
                  <a:gd name="T18" fmla="*/ 573 w 573"/>
                  <a:gd name="T19" fmla="*/ 223 h 507"/>
                  <a:gd name="T20" fmla="*/ 498 w 573"/>
                  <a:gd name="T21" fmla="*/ 431 h 507"/>
                  <a:gd name="T22" fmla="*/ 292 w 573"/>
                  <a:gd name="T23" fmla="*/ 507 h 507"/>
                  <a:gd name="T24" fmla="*/ 79 w 573"/>
                  <a:gd name="T25" fmla="*/ 435 h 507"/>
                  <a:gd name="T26" fmla="*/ 0 w 573"/>
                  <a:gd name="T27" fmla="*/ 239 h 507"/>
                  <a:gd name="T28" fmla="*/ 71 w 573"/>
                  <a:gd name="T29" fmla="*/ 64 h 507"/>
                  <a:gd name="T30" fmla="*/ 264 w 573"/>
                  <a:gd name="T31" fmla="*/ 0 h 507"/>
                  <a:gd name="T32" fmla="*/ 238 w 573"/>
                  <a:gd name="T33" fmla="*/ 90 h 507"/>
                  <a:gd name="T34" fmla="*/ 120 w 573"/>
                  <a:gd name="T35" fmla="*/ 131 h 507"/>
                  <a:gd name="T36" fmla="*/ 76 w 573"/>
                  <a:gd name="T37" fmla="*/ 238 h 507"/>
                  <a:gd name="T38" fmla="*/ 119 w 573"/>
                  <a:gd name="T39" fmla="*/ 358 h 507"/>
                  <a:gd name="T40" fmla="*/ 238 w 573"/>
                  <a:gd name="T41" fmla="*/ 410 h 507"/>
                  <a:gd name="T42" fmla="*/ 238 w 573"/>
                  <a:gd name="T43" fmla="*/ 90 h 5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73" h="507">
                    <a:moveTo>
                      <a:pt x="264" y="0"/>
                    </a:moveTo>
                    <a:lnTo>
                      <a:pt x="308" y="0"/>
                    </a:lnTo>
                    <a:lnTo>
                      <a:pt x="308" y="413"/>
                    </a:lnTo>
                    <a:cubicBezTo>
                      <a:pt x="370" y="409"/>
                      <a:pt x="418" y="391"/>
                      <a:pt x="450" y="357"/>
                    </a:cubicBezTo>
                    <a:cubicBezTo>
                      <a:pt x="482" y="324"/>
                      <a:pt x="498" y="278"/>
                      <a:pt x="498" y="218"/>
                    </a:cubicBezTo>
                    <a:cubicBezTo>
                      <a:pt x="498" y="184"/>
                      <a:pt x="494" y="150"/>
                      <a:pt x="486" y="118"/>
                    </a:cubicBezTo>
                    <a:cubicBezTo>
                      <a:pt x="478" y="86"/>
                      <a:pt x="465" y="53"/>
                      <a:pt x="447" y="21"/>
                    </a:cubicBezTo>
                    <a:lnTo>
                      <a:pt x="532" y="21"/>
                    </a:lnTo>
                    <a:cubicBezTo>
                      <a:pt x="546" y="53"/>
                      <a:pt x="557" y="86"/>
                      <a:pt x="563" y="120"/>
                    </a:cubicBezTo>
                    <a:cubicBezTo>
                      <a:pt x="569" y="154"/>
                      <a:pt x="573" y="189"/>
                      <a:pt x="573" y="223"/>
                    </a:cubicBezTo>
                    <a:cubicBezTo>
                      <a:pt x="573" y="311"/>
                      <a:pt x="548" y="380"/>
                      <a:pt x="498" y="431"/>
                    </a:cubicBezTo>
                    <a:cubicBezTo>
                      <a:pt x="448" y="482"/>
                      <a:pt x="379" y="507"/>
                      <a:pt x="292" y="507"/>
                    </a:cubicBezTo>
                    <a:cubicBezTo>
                      <a:pt x="203" y="507"/>
                      <a:pt x="132" y="483"/>
                      <a:pt x="79" y="435"/>
                    </a:cubicBezTo>
                    <a:cubicBezTo>
                      <a:pt x="27" y="387"/>
                      <a:pt x="0" y="321"/>
                      <a:pt x="0" y="239"/>
                    </a:cubicBezTo>
                    <a:cubicBezTo>
                      <a:pt x="0" y="165"/>
                      <a:pt x="24" y="107"/>
                      <a:pt x="71" y="64"/>
                    </a:cubicBezTo>
                    <a:cubicBezTo>
                      <a:pt x="119" y="22"/>
                      <a:pt x="183" y="0"/>
                      <a:pt x="264" y="0"/>
                    </a:cubicBezTo>
                    <a:close/>
                    <a:moveTo>
                      <a:pt x="238" y="90"/>
                    </a:moveTo>
                    <a:cubicBezTo>
                      <a:pt x="189" y="91"/>
                      <a:pt x="150" y="105"/>
                      <a:pt x="120" y="131"/>
                    </a:cubicBezTo>
                    <a:cubicBezTo>
                      <a:pt x="91" y="158"/>
                      <a:pt x="76" y="194"/>
                      <a:pt x="76" y="238"/>
                    </a:cubicBezTo>
                    <a:cubicBezTo>
                      <a:pt x="76" y="288"/>
                      <a:pt x="91" y="328"/>
                      <a:pt x="119" y="358"/>
                    </a:cubicBezTo>
                    <a:cubicBezTo>
                      <a:pt x="147" y="388"/>
                      <a:pt x="187" y="406"/>
                      <a:pt x="238" y="410"/>
                    </a:cubicBezTo>
                    <a:lnTo>
                      <a:pt x="238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0" name="Freeform 154">
                <a:extLst>
                  <a:ext uri="{FF2B5EF4-FFF2-40B4-BE49-F238E27FC236}">
                    <a16:creationId xmlns:a16="http://schemas.microsoft.com/office/drawing/2014/main" id="{EDEAECE3-27F4-9194-04F1-5BAAC2AD302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6513" y="3656013"/>
                <a:ext cx="100013" cy="57150"/>
              </a:xfrm>
              <a:custGeom>
                <a:avLst/>
                <a:gdLst>
                  <a:gd name="T0" fmla="*/ 97 w 560"/>
                  <a:gd name="T1" fmla="*/ 0 h 320"/>
                  <a:gd name="T2" fmla="*/ 84 w 560"/>
                  <a:gd name="T3" fmla="*/ 33 h 320"/>
                  <a:gd name="T4" fmla="*/ 80 w 560"/>
                  <a:gd name="T5" fmla="*/ 72 h 320"/>
                  <a:gd name="T6" fmla="*/ 130 w 560"/>
                  <a:gd name="T7" fmla="*/ 189 h 320"/>
                  <a:gd name="T8" fmla="*/ 272 w 560"/>
                  <a:gd name="T9" fmla="*/ 230 h 320"/>
                  <a:gd name="T10" fmla="*/ 560 w 560"/>
                  <a:gd name="T11" fmla="*/ 230 h 320"/>
                  <a:gd name="T12" fmla="*/ 560 w 560"/>
                  <a:gd name="T13" fmla="*/ 320 h 320"/>
                  <a:gd name="T14" fmla="*/ 13 w 560"/>
                  <a:gd name="T15" fmla="*/ 320 h 320"/>
                  <a:gd name="T16" fmla="*/ 13 w 560"/>
                  <a:gd name="T17" fmla="*/ 230 h 320"/>
                  <a:gd name="T18" fmla="*/ 98 w 560"/>
                  <a:gd name="T19" fmla="*/ 230 h 320"/>
                  <a:gd name="T20" fmla="*/ 24 w 560"/>
                  <a:gd name="T21" fmla="*/ 157 h 320"/>
                  <a:gd name="T22" fmla="*/ 0 w 560"/>
                  <a:gd name="T23" fmla="*/ 46 h 320"/>
                  <a:gd name="T24" fmla="*/ 1 w 560"/>
                  <a:gd name="T25" fmla="*/ 25 h 320"/>
                  <a:gd name="T26" fmla="*/ 5 w 560"/>
                  <a:gd name="T27" fmla="*/ 0 h 320"/>
                  <a:gd name="T28" fmla="*/ 97 w 560"/>
                  <a:gd name="T29" fmla="*/ 0 h 3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560" h="320">
                    <a:moveTo>
                      <a:pt x="97" y="0"/>
                    </a:moveTo>
                    <a:cubicBezTo>
                      <a:pt x="91" y="10"/>
                      <a:pt x="87" y="21"/>
                      <a:pt x="84" y="33"/>
                    </a:cubicBezTo>
                    <a:cubicBezTo>
                      <a:pt x="82" y="45"/>
                      <a:pt x="80" y="58"/>
                      <a:pt x="80" y="72"/>
                    </a:cubicBezTo>
                    <a:cubicBezTo>
                      <a:pt x="80" y="123"/>
                      <a:pt x="97" y="162"/>
                      <a:pt x="130" y="189"/>
                    </a:cubicBezTo>
                    <a:cubicBezTo>
                      <a:pt x="163" y="217"/>
                      <a:pt x="210" y="230"/>
                      <a:pt x="272" y="230"/>
                    </a:cubicBezTo>
                    <a:lnTo>
                      <a:pt x="560" y="230"/>
                    </a:lnTo>
                    <a:lnTo>
                      <a:pt x="560" y="320"/>
                    </a:lnTo>
                    <a:lnTo>
                      <a:pt x="13" y="320"/>
                    </a:lnTo>
                    <a:lnTo>
                      <a:pt x="13" y="230"/>
                    </a:lnTo>
                    <a:lnTo>
                      <a:pt x="98" y="230"/>
                    </a:lnTo>
                    <a:cubicBezTo>
                      <a:pt x="65" y="212"/>
                      <a:pt x="40" y="187"/>
                      <a:pt x="24" y="157"/>
                    </a:cubicBezTo>
                    <a:cubicBezTo>
                      <a:pt x="8" y="127"/>
                      <a:pt x="0" y="90"/>
                      <a:pt x="0" y="46"/>
                    </a:cubicBezTo>
                    <a:cubicBezTo>
                      <a:pt x="0" y="40"/>
                      <a:pt x="1" y="33"/>
                      <a:pt x="1" y="25"/>
                    </a:cubicBezTo>
                    <a:cubicBezTo>
                      <a:pt x="2" y="18"/>
                      <a:pt x="3" y="10"/>
                      <a:pt x="5" y="0"/>
                    </a:cubicBezTo>
                    <a:lnTo>
                      <a:pt x="97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1" name="Freeform 155">
                <a:extLst>
                  <a:ext uri="{FF2B5EF4-FFF2-40B4-BE49-F238E27FC236}">
                    <a16:creationId xmlns:a16="http://schemas.microsoft.com/office/drawing/2014/main" id="{28BD811C-E0DE-69AA-75A8-79FBF198B95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0000" y="3541713"/>
                <a:ext cx="160338" cy="41275"/>
              </a:xfrm>
              <a:custGeom>
                <a:avLst/>
                <a:gdLst>
                  <a:gd name="T0" fmla="*/ 0 w 890"/>
                  <a:gd name="T1" fmla="*/ 0 h 224"/>
                  <a:gd name="T2" fmla="*/ 223 w 890"/>
                  <a:gd name="T3" fmla="*/ 97 h 224"/>
                  <a:gd name="T4" fmla="*/ 445 w 890"/>
                  <a:gd name="T5" fmla="*/ 129 h 224"/>
                  <a:gd name="T6" fmla="*/ 668 w 890"/>
                  <a:gd name="T7" fmla="*/ 97 h 224"/>
                  <a:gd name="T8" fmla="*/ 890 w 890"/>
                  <a:gd name="T9" fmla="*/ 0 h 224"/>
                  <a:gd name="T10" fmla="*/ 890 w 890"/>
                  <a:gd name="T11" fmla="*/ 78 h 224"/>
                  <a:gd name="T12" fmla="*/ 665 w 890"/>
                  <a:gd name="T13" fmla="*/ 188 h 224"/>
                  <a:gd name="T14" fmla="*/ 445 w 890"/>
                  <a:gd name="T15" fmla="*/ 224 h 224"/>
                  <a:gd name="T16" fmla="*/ 226 w 890"/>
                  <a:gd name="T17" fmla="*/ 188 h 224"/>
                  <a:gd name="T18" fmla="*/ 0 w 890"/>
                  <a:gd name="T19" fmla="*/ 78 h 224"/>
                  <a:gd name="T20" fmla="*/ 0 w 890"/>
                  <a:gd name="T21" fmla="*/ 0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890" h="224">
                    <a:moveTo>
                      <a:pt x="0" y="0"/>
                    </a:moveTo>
                    <a:cubicBezTo>
                      <a:pt x="76" y="44"/>
                      <a:pt x="150" y="76"/>
                      <a:pt x="223" y="97"/>
                    </a:cubicBezTo>
                    <a:cubicBezTo>
                      <a:pt x="296" y="119"/>
                      <a:pt x="370" y="129"/>
                      <a:pt x="445" y="129"/>
                    </a:cubicBezTo>
                    <a:cubicBezTo>
                      <a:pt x="521" y="129"/>
                      <a:pt x="595" y="119"/>
                      <a:pt x="668" y="97"/>
                    </a:cubicBezTo>
                    <a:cubicBezTo>
                      <a:pt x="742" y="76"/>
                      <a:pt x="815" y="44"/>
                      <a:pt x="890" y="0"/>
                    </a:cubicBezTo>
                    <a:lnTo>
                      <a:pt x="890" y="78"/>
                    </a:lnTo>
                    <a:cubicBezTo>
                      <a:pt x="813" y="127"/>
                      <a:pt x="739" y="164"/>
                      <a:pt x="665" y="188"/>
                    </a:cubicBezTo>
                    <a:cubicBezTo>
                      <a:pt x="591" y="212"/>
                      <a:pt x="518" y="224"/>
                      <a:pt x="445" y="224"/>
                    </a:cubicBezTo>
                    <a:cubicBezTo>
                      <a:pt x="373" y="224"/>
                      <a:pt x="300" y="212"/>
                      <a:pt x="226" y="188"/>
                    </a:cubicBezTo>
                    <a:cubicBezTo>
                      <a:pt x="152" y="164"/>
                      <a:pt x="77" y="128"/>
                      <a:pt x="0" y="78"/>
                    </a:cubicBez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2" name="Freeform 156">
                <a:extLst>
                  <a:ext uri="{FF2B5EF4-FFF2-40B4-BE49-F238E27FC236}">
                    <a16:creationId xmlns:a16="http://schemas.microsoft.com/office/drawing/2014/main" id="{0985FFF5-B78C-7387-B6A4-E39DAF733E9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6513" y="3440113"/>
                <a:ext cx="103188" cy="77788"/>
              </a:xfrm>
              <a:custGeom>
                <a:avLst/>
                <a:gdLst>
                  <a:gd name="T0" fmla="*/ 34 w 573"/>
                  <a:gd name="T1" fmla="*/ 0 h 433"/>
                  <a:gd name="T2" fmla="*/ 118 w 573"/>
                  <a:gd name="T3" fmla="*/ 0 h 433"/>
                  <a:gd name="T4" fmla="*/ 87 w 573"/>
                  <a:gd name="T5" fmla="*/ 77 h 433"/>
                  <a:gd name="T6" fmla="*/ 76 w 573"/>
                  <a:gd name="T7" fmla="*/ 154 h 433"/>
                  <a:gd name="T8" fmla="*/ 132 w 573"/>
                  <a:gd name="T9" fmla="*/ 290 h 433"/>
                  <a:gd name="T10" fmla="*/ 287 w 573"/>
                  <a:gd name="T11" fmla="*/ 338 h 433"/>
                  <a:gd name="T12" fmla="*/ 443 w 573"/>
                  <a:gd name="T13" fmla="*/ 290 h 433"/>
                  <a:gd name="T14" fmla="*/ 498 w 573"/>
                  <a:gd name="T15" fmla="*/ 154 h 433"/>
                  <a:gd name="T16" fmla="*/ 488 w 573"/>
                  <a:gd name="T17" fmla="*/ 77 h 433"/>
                  <a:gd name="T18" fmla="*/ 456 w 573"/>
                  <a:gd name="T19" fmla="*/ 0 h 433"/>
                  <a:gd name="T20" fmla="*/ 539 w 573"/>
                  <a:gd name="T21" fmla="*/ 0 h 433"/>
                  <a:gd name="T22" fmla="*/ 565 w 573"/>
                  <a:gd name="T23" fmla="*/ 78 h 433"/>
                  <a:gd name="T24" fmla="*/ 573 w 573"/>
                  <a:gd name="T25" fmla="*/ 164 h 433"/>
                  <a:gd name="T26" fmla="*/ 496 w 573"/>
                  <a:gd name="T27" fmla="*/ 360 h 433"/>
                  <a:gd name="T28" fmla="*/ 287 w 573"/>
                  <a:gd name="T29" fmla="*/ 433 h 433"/>
                  <a:gd name="T30" fmla="*/ 77 w 573"/>
                  <a:gd name="T31" fmla="*/ 360 h 433"/>
                  <a:gd name="T32" fmla="*/ 0 w 573"/>
                  <a:gd name="T33" fmla="*/ 158 h 433"/>
                  <a:gd name="T34" fmla="*/ 9 w 573"/>
                  <a:gd name="T35" fmla="*/ 77 h 433"/>
                  <a:gd name="T36" fmla="*/ 34 w 573"/>
                  <a:gd name="T37" fmla="*/ 0 h 4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573" h="433">
                    <a:moveTo>
                      <a:pt x="34" y="0"/>
                    </a:moveTo>
                    <a:lnTo>
                      <a:pt x="118" y="0"/>
                    </a:lnTo>
                    <a:cubicBezTo>
                      <a:pt x="104" y="26"/>
                      <a:pt x="94" y="51"/>
                      <a:pt x="87" y="77"/>
                    </a:cubicBezTo>
                    <a:cubicBezTo>
                      <a:pt x="80" y="103"/>
                      <a:pt x="76" y="128"/>
                      <a:pt x="76" y="154"/>
                    </a:cubicBezTo>
                    <a:cubicBezTo>
                      <a:pt x="76" y="212"/>
                      <a:pt x="95" y="258"/>
                      <a:pt x="132" y="290"/>
                    </a:cubicBezTo>
                    <a:cubicBezTo>
                      <a:pt x="169" y="322"/>
                      <a:pt x="221" y="338"/>
                      <a:pt x="287" y="338"/>
                    </a:cubicBezTo>
                    <a:cubicBezTo>
                      <a:pt x="354" y="338"/>
                      <a:pt x="406" y="322"/>
                      <a:pt x="443" y="290"/>
                    </a:cubicBezTo>
                    <a:cubicBezTo>
                      <a:pt x="480" y="258"/>
                      <a:pt x="498" y="212"/>
                      <a:pt x="498" y="154"/>
                    </a:cubicBezTo>
                    <a:cubicBezTo>
                      <a:pt x="498" y="128"/>
                      <a:pt x="495" y="103"/>
                      <a:pt x="488" y="77"/>
                    </a:cubicBezTo>
                    <a:cubicBezTo>
                      <a:pt x="481" y="51"/>
                      <a:pt x="470" y="26"/>
                      <a:pt x="456" y="0"/>
                    </a:cubicBezTo>
                    <a:lnTo>
                      <a:pt x="539" y="0"/>
                    </a:lnTo>
                    <a:cubicBezTo>
                      <a:pt x="551" y="26"/>
                      <a:pt x="560" y="52"/>
                      <a:pt x="565" y="78"/>
                    </a:cubicBezTo>
                    <a:cubicBezTo>
                      <a:pt x="570" y="105"/>
                      <a:pt x="573" y="134"/>
                      <a:pt x="573" y="164"/>
                    </a:cubicBezTo>
                    <a:cubicBezTo>
                      <a:pt x="573" y="246"/>
                      <a:pt x="548" y="312"/>
                      <a:pt x="496" y="360"/>
                    </a:cubicBezTo>
                    <a:cubicBezTo>
                      <a:pt x="445" y="409"/>
                      <a:pt x="375" y="433"/>
                      <a:pt x="287" y="433"/>
                    </a:cubicBezTo>
                    <a:cubicBezTo>
                      <a:pt x="198" y="433"/>
                      <a:pt x="128" y="409"/>
                      <a:pt x="77" y="360"/>
                    </a:cubicBezTo>
                    <a:cubicBezTo>
                      <a:pt x="26" y="311"/>
                      <a:pt x="0" y="244"/>
                      <a:pt x="0" y="158"/>
                    </a:cubicBezTo>
                    <a:cubicBezTo>
                      <a:pt x="0" y="130"/>
                      <a:pt x="3" y="103"/>
                      <a:pt x="9" y="77"/>
                    </a:cubicBezTo>
                    <a:cubicBezTo>
                      <a:pt x="15" y="51"/>
                      <a:pt x="23" y="25"/>
                      <a:pt x="34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3" name="Freeform 157">
                <a:extLst>
                  <a:ext uri="{FF2B5EF4-FFF2-40B4-BE49-F238E27FC236}">
                    <a16:creationId xmlns:a16="http://schemas.microsoft.com/office/drawing/2014/main" id="{01CA1A7E-FF9F-FA66-CD8B-5AB89F766FD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3327400"/>
                <a:ext cx="103188" cy="90488"/>
              </a:xfrm>
              <a:custGeom>
                <a:avLst/>
                <a:gdLst>
                  <a:gd name="T0" fmla="*/ 264 w 573"/>
                  <a:gd name="T1" fmla="*/ 0 h 507"/>
                  <a:gd name="T2" fmla="*/ 308 w 573"/>
                  <a:gd name="T3" fmla="*/ 0 h 507"/>
                  <a:gd name="T4" fmla="*/ 308 w 573"/>
                  <a:gd name="T5" fmla="*/ 413 h 507"/>
                  <a:gd name="T6" fmla="*/ 450 w 573"/>
                  <a:gd name="T7" fmla="*/ 357 h 507"/>
                  <a:gd name="T8" fmla="*/ 498 w 573"/>
                  <a:gd name="T9" fmla="*/ 218 h 507"/>
                  <a:gd name="T10" fmla="*/ 486 w 573"/>
                  <a:gd name="T11" fmla="*/ 118 h 507"/>
                  <a:gd name="T12" fmla="*/ 447 w 573"/>
                  <a:gd name="T13" fmla="*/ 21 h 507"/>
                  <a:gd name="T14" fmla="*/ 532 w 573"/>
                  <a:gd name="T15" fmla="*/ 21 h 507"/>
                  <a:gd name="T16" fmla="*/ 563 w 573"/>
                  <a:gd name="T17" fmla="*/ 120 h 507"/>
                  <a:gd name="T18" fmla="*/ 573 w 573"/>
                  <a:gd name="T19" fmla="*/ 223 h 507"/>
                  <a:gd name="T20" fmla="*/ 498 w 573"/>
                  <a:gd name="T21" fmla="*/ 431 h 507"/>
                  <a:gd name="T22" fmla="*/ 292 w 573"/>
                  <a:gd name="T23" fmla="*/ 507 h 507"/>
                  <a:gd name="T24" fmla="*/ 79 w 573"/>
                  <a:gd name="T25" fmla="*/ 435 h 507"/>
                  <a:gd name="T26" fmla="*/ 0 w 573"/>
                  <a:gd name="T27" fmla="*/ 239 h 507"/>
                  <a:gd name="T28" fmla="*/ 71 w 573"/>
                  <a:gd name="T29" fmla="*/ 64 h 507"/>
                  <a:gd name="T30" fmla="*/ 264 w 573"/>
                  <a:gd name="T31" fmla="*/ 0 h 507"/>
                  <a:gd name="T32" fmla="*/ 238 w 573"/>
                  <a:gd name="T33" fmla="*/ 90 h 507"/>
                  <a:gd name="T34" fmla="*/ 120 w 573"/>
                  <a:gd name="T35" fmla="*/ 131 h 507"/>
                  <a:gd name="T36" fmla="*/ 76 w 573"/>
                  <a:gd name="T37" fmla="*/ 238 h 507"/>
                  <a:gd name="T38" fmla="*/ 119 w 573"/>
                  <a:gd name="T39" fmla="*/ 358 h 507"/>
                  <a:gd name="T40" fmla="*/ 238 w 573"/>
                  <a:gd name="T41" fmla="*/ 410 h 507"/>
                  <a:gd name="T42" fmla="*/ 238 w 573"/>
                  <a:gd name="T43" fmla="*/ 90 h 5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73" h="507">
                    <a:moveTo>
                      <a:pt x="264" y="0"/>
                    </a:moveTo>
                    <a:lnTo>
                      <a:pt x="308" y="0"/>
                    </a:lnTo>
                    <a:lnTo>
                      <a:pt x="308" y="413"/>
                    </a:lnTo>
                    <a:cubicBezTo>
                      <a:pt x="370" y="409"/>
                      <a:pt x="418" y="391"/>
                      <a:pt x="450" y="357"/>
                    </a:cubicBezTo>
                    <a:cubicBezTo>
                      <a:pt x="482" y="324"/>
                      <a:pt x="498" y="278"/>
                      <a:pt x="498" y="218"/>
                    </a:cubicBezTo>
                    <a:cubicBezTo>
                      <a:pt x="498" y="184"/>
                      <a:pt x="494" y="150"/>
                      <a:pt x="486" y="118"/>
                    </a:cubicBezTo>
                    <a:cubicBezTo>
                      <a:pt x="478" y="86"/>
                      <a:pt x="465" y="53"/>
                      <a:pt x="447" y="21"/>
                    </a:cubicBezTo>
                    <a:lnTo>
                      <a:pt x="532" y="21"/>
                    </a:lnTo>
                    <a:cubicBezTo>
                      <a:pt x="546" y="53"/>
                      <a:pt x="557" y="86"/>
                      <a:pt x="563" y="120"/>
                    </a:cubicBezTo>
                    <a:cubicBezTo>
                      <a:pt x="569" y="154"/>
                      <a:pt x="573" y="189"/>
                      <a:pt x="573" y="223"/>
                    </a:cubicBezTo>
                    <a:cubicBezTo>
                      <a:pt x="573" y="311"/>
                      <a:pt x="548" y="380"/>
                      <a:pt x="498" y="431"/>
                    </a:cubicBezTo>
                    <a:cubicBezTo>
                      <a:pt x="448" y="482"/>
                      <a:pt x="379" y="507"/>
                      <a:pt x="292" y="507"/>
                    </a:cubicBezTo>
                    <a:cubicBezTo>
                      <a:pt x="203" y="507"/>
                      <a:pt x="132" y="483"/>
                      <a:pt x="79" y="435"/>
                    </a:cubicBezTo>
                    <a:cubicBezTo>
                      <a:pt x="27" y="387"/>
                      <a:pt x="0" y="321"/>
                      <a:pt x="0" y="239"/>
                    </a:cubicBezTo>
                    <a:cubicBezTo>
                      <a:pt x="0" y="165"/>
                      <a:pt x="24" y="107"/>
                      <a:pt x="71" y="64"/>
                    </a:cubicBezTo>
                    <a:cubicBezTo>
                      <a:pt x="119" y="22"/>
                      <a:pt x="183" y="0"/>
                      <a:pt x="264" y="0"/>
                    </a:cubicBezTo>
                    <a:close/>
                    <a:moveTo>
                      <a:pt x="238" y="90"/>
                    </a:moveTo>
                    <a:cubicBezTo>
                      <a:pt x="189" y="91"/>
                      <a:pt x="150" y="105"/>
                      <a:pt x="120" y="131"/>
                    </a:cubicBezTo>
                    <a:cubicBezTo>
                      <a:pt x="91" y="158"/>
                      <a:pt x="76" y="194"/>
                      <a:pt x="76" y="238"/>
                    </a:cubicBezTo>
                    <a:cubicBezTo>
                      <a:pt x="76" y="288"/>
                      <a:pt x="91" y="328"/>
                      <a:pt x="119" y="358"/>
                    </a:cubicBezTo>
                    <a:cubicBezTo>
                      <a:pt x="147" y="388"/>
                      <a:pt x="187" y="406"/>
                      <a:pt x="238" y="410"/>
                    </a:cubicBezTo>
                    <a:lnTo>
                      <a:pt x="238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4" name="Rectangle 158">
                <a:extLst>
                  <a:ext uri="{FF2B5EF4-FFF2-40B4-BE49-F238E27FC236}">
                    <a16:creationId xmlns:a16="http://schemas.microsoft.com/office/drawing/2014/main" id="{DDE90DA3-25F8-6FC6-B370-5A08A8AC06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000" y="3284538"/>
                <a:ext cx="136525" cy="1587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5" name="Rectangle 159">
                <a:extLst>
                  <a:ext uri="{FF2B5EF4-FFF2-40B4-BE49-F238E27FC236}">
                    <a16:creationId xmlns:a16="http://schemas.microsoft.com/office/drawing/2014/main" id="{9F952C6D-C88E-CA2F-BFB4-B473EFBDC1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000" y="3233738"/>
                <a:ext cx="136525" cy="1587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6" name="Freeform 160">
                <a:extLst>
                  <a:ext uri="{FF2B5EF4-FFF2-40B4-BE49-F238E27FC236}">
                    <a16:creationId xmlns:a16="http://schemas.microsoft.com/office/drawing/2014/main" id="{933E341C-9BAC-99A7-B8CD-FF0F56E1540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6513" y="3132138"/>
                <a:ext cx="103188" cy="74613"/>
              </a:xfrm>
              <a:custGeom>
                <a:avLst/>
                <a:gdLst>
                  <a:gd name="T0" fmla="*/ 29 w 573"/>
                  <a:gd name="T1" fmla="*/ 29 h 418"/>
                  <a:gd name="T2" fmla="*/ 114 w 573"/>
                  <a:gd name="T3" fmla="*/ 29 h 418"/>
                  <a:gd name="T4" fmla="*/ 85 w 573"/>
                  <a:gd name="T5" fmla="*/ 108 h 418"/>
                  <a:gd name="T6" fmla="*/ 75 w 573"/>
                  <a:gd name="T7" fmla="*/ 193 h 418"/>
                  <a:gd name="T8" fmla="*/ 96 w 573"/>
                  <a:gd name="T9" fmla="*/ 294 h 418"/>
                  <a:gd name="T10" fmla="*/ 157 w 573"/>
                  <a:gd name="T11" fmla="*/ 327 h 418"/>
                  <a:gd name="T12" fmla="*/ 206 w 573"/>
                  <a:gd name="T13" fmla="*/ 303 h 418"/>
                  <a:gd name="T14" fmla="*/ 240 w 573"/>
                  <a:gd name="T15" fmla="*/ 207 h 418"/>
                  <a:gd name="T16" fmla="*/ 247 w 573"/>
                  <a:gd name="T17" fmla="*/ 176 h 418"/>
                  <a:gd name="T18" fmla="*/ 305 w 573"/>
                  <a:gd name="T19" fmla="*/ 40 h 418"/>
                  <a:gd name="T20" fmla="*/ 409 w 573"/>
                  <a:gd name="T21" fmla="*/ 0 h 418"/>
                  <a:gd name="T22" fmla="*/ 529 w 573"/>
                  <a:gd name="T23" fmla="*/ 60 h 418"/>
                  <a:gd name="T24" fmla="*/ 573 w 573"/>
                  <a:gd name="T25" fmla="*/ 226 h 418"/>
                  <a:gd name="T26" fmla="*/ 565 w 573"/>
                  <a:gd name="T27" fmla="*/ 318 h 418"/>
                  <a:gd name="T28" fmla="*/ 540 w 573"/>
                  <a:gd name="T29" fmla="*/ 418 h 418"/>
                  <a:gd name="T30" fmla="*/ 447 w 573"/>
                  <a:gd name="T31" fmla="*/ 418 h 418"/>
                  <a:gd name="T32" fmla="*/ 486 w 573"/>
                  <a:gd name="T33" fmla="*/ 320 h 418"/>
                  <a:gd name="T34" fmla="*/ 499 w 573"/>
                  <a:gd name="T35" fmla="*/ 224 h 418"/>
                  <a:gd name="T36" fmla="*/ 478 w 573"/>
                  <a:gd name="T37" fmla="*/ 126 h 418"/>
                  <a:gd name="T38" fmla="*/ 416 w 573"/>
                  <a:gd name="T39" fmla="*/ 92 h 418"/>
                  <a:gd name="T40" fmla="*/ 360 w 573"/>
                  <a:gd name="T41" fmla="*/ 117 h 418"/>
                  <a:gd name="T42" fmla="*/ 322 w 573"/>
                  <a:gd name="T43" fmla="*/ 225 h 418"/>
                  <a:gd name="T44" fmla="*/ 315 w 573"/>
                  <a:gd name="T45" fmla="*/ 256 h 418"/>
                  <a:gd name="T46" fmla="*/ 261 w 573"/>
                  <a:gd name="T47" fmla="*/ 377 h 418"/>
                  <a:gd name="T48" fmla="*/ 161 w 573"/>
                  <a:gd name="T49" fmla="*/ 414 h 418"/>
                  <a:gd name="T50" fmla="*/ 42 w 573"/>
                  <a:gd name="T51" fmla="*/ 360 h 418"/>
                  <a:gd name="T52" fmla="*/ 0 w 573"/>
                  <a:gd name="T53" fmla="*/ 204 h 418"/>
                  <a:gd name="T54" fmla="*/ 8 w 573"/>
                  <a:gd name="T55" fmla="*/ 110 h 418"/>
                  <a:gd name="T56" fmla="*/ 29 w 573"/>
                  <a:gd name="T57" fmla="*/ 29 h 4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573" h="418">
                    <a:moveTo>
                      <a:pt x="29" y="29"/>
                    </a:moveTo>
                    <a:lnTo>
                      <a:pt x="114" y="29"/>
                    </a:lnTo>
                    <a:cubicBezTo>
                      <a:pt x="102" y="55"/>
                      <a:pt x="92" y="81"/>
                      <a:pt x="85" y="108"/>
                    </a:cubicBezTo>
                    <a:cubicBezTo>
                      <a:pt x="79" y="136"/>
                      <a:pt x="75" y="164"/>
                      <a:pt x="75" y="193"/>
                    </a:cubicBezTo>
                    <a:cubicBezTo>
                      <a:pt x="75" y="238"/>
                      <a:pt x="82" y="272"/>
                      <a:pt x="96" y="294"/>
                    </a:cubicBezTo>
                    <a:cubicBezTo>
                      <a:pt x="110" y="316"/>
                      <a:pt x="130" y="327"/>
                      <a:pt x="157" y="327"/>
                    </a:cubicBezTo>
                    <a:cubicBezTo>
                      <a:pt x="178" y="327"/>
                      <a:pt x="194" y="319"/>
                      <a:pt x="206" y="303"/>
                    </a:cubicBezTo>
                    <a:cubicBezTo>
                      <a:pt x="218" y="287"/>
                      <a:pt x="230" y="255"/>
                      <a:pt x="240" y="207"/>
                    </a:cubicBezTo>
                    <a:lnTo>
                      <a:pt x="247" y="176"/>
                    </a:lnTo>
                    <a:cubicBezTo>
                      <a:pt x="261" y="112"/>
                      <a:pt x="281" y="67"/>
                      <a:pt x="305" y="40"/>
                    </a:cubicBezTo>
                    <a:cubicBezTo>
                      <a:pt x="330" y="14"/>
                      <a:pt x="365" y="0"/>
                      <a:pt x="409" y="0"/>
                    </a:cubicBezTo>
                    <a:cubicBezTo>
                      <a:pt x="460" y="0"/>
                      <a:pt x="500" y="20"/>
                      <a:pt x="529" y="60"/>
                    </a:cubicBezTo>
                    <a:cubicBezTo>
                      <a:pt x="559" y="100"/>
                      <a:pt x="573" y="156"/>
                      <a:pt x="573" y="226"/>
                    </a:cubicBezTo>
                    <a:cubicBezTo>
                      <a:pt x="573" y="256"/>
                      <a:pt x="570" y="286"/>
                      <a:pt x="565" y="318"/>
                    </a:cubicBezTo>
                    <a:cubicBezTo>
                      <a:pt x="560" y="350"/>
                      <a:pt x="552" y="383"/>
                      <a:pt x="540" y="418"/>
                    </a:cubicBezTo>
                    <a:lnTo>
                      <a:pt x="447" y="418"/>
                    </a:lnTo>
                    <a:cubicBezTo>
                      <a:pt x="465" y="385"/>
                      <a:pt x="478" y="352"/>
                      <a:pt x="486" y="320"/>
                    </a:cubicBezTo>
                    <a:cubicBezTo>
                      <a:pt x="495" y="288"/>
                      <a:pt x="499" y="256"/>
                      <a:pt x="499" y="224"/>
                    </a:cubicBezTo>
                    <a:cubicBezTo>
                      <a:pt x="499" y="182"/>
                      <a:pt x="492" y="149"/>
                      <a:pt x="478" y="126"/>
                    </a:cubicBezTo>
                    <a:cubicBezTo>
                      <a:pt x="464" y="104"/>
                      <a:pt x="443" y="92"/>
                      <a:pt x="416" y="92"/>
                    </a:cubicBezTo>
                    <a:cubicBezTo>
                      <a:pt x="392" y="92"/>
                      <a:pt x="373" y="101"/>
                      <a:pt x="360" y="117"/>
                    </a:cubicBezTo>
                    <a:cubicBezTo>
                      <a:pt x="347" y="133"/>
                      <a:pt x="334" y="169"/>
                      <a:pt x="322" y="225"/>
                    </a:cubicBezTo>
                    <a:lnTo>
                      <a:pt x="315" y="256"/>
                    </a:lnTo>
                    <a:cubicBezTo>
                      <a:pt x="303" y="312"/>
                      <a:pt x="285" y="353"/>
                      <a:pt x="261" y="377"/>
                    </a:cubicBezTo>
                    <a:cubicBezTo>
                      <a:pt x="237" y="402"/>
                      <a:pt x="204" y="414"/>
                      <a:pt x="161" y="414"/>
                    </a:cubicBezTo>
                    <a:cubicBezTo>
                      <a:pt x="110" y="414"/>
                      <a:pt x="70" y="396"/>
                      <a:pt x="42" y="360"/>
                    </a:cubicBezTo>
                    <a:cubicBezTo>
                      <a:pt x="14" y="324"/>
                      <a:pt x="0" y="272"/>
                      <a:pt x="0" y="204"/>
                    </a:cubicBezTo>
                    <a:cubicBezTo>
                      <a:pt x="0" y="171"/>
                      <a:pt x="3" y="140"/>
                      <a:pt x="8" y="110"/>
                    </a:cubicBezTo>
                    <a:cubicBezTo>
                      <a:pt x="13" y="81"/>
                      <a:pt x="20" y="54"/>
                      <a:pt x="29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7" name="Freeform 161">
                <a:extLst>
                  <a:ext uri="{FF2B5EF4-FFF2-40B4-BE49-F238E27FC236}">
                    <a16:creationId xmlns:a16="http://schemas.microsoft.com/office/drawing/2014/main" id="{B470D44B-7B7F-959E-611D-3FF0114D7C3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0000" y="3068638"/>
                <a:ext cx="160338" cy="39688"/>
              </a:xfrm>
              <a:custGeom>
                <a:avLst/>
                <a:gdLst>
                  <a:gd name="T0" fmla="*/ 0 w 890"/>
                  <a:gd name="T1" fmla="*/ 224 h 224"/>
                  <a:gd name="T2" fmla="*/ 0 w 890"/>
                  <a:gd name="T3" fmla="*/ 146 h 224"/>
                  <a:gd name="T4" fmla="*/ 226 w 890"/>
                  <a:gd name="T5" fmla="*/ 37 h 224"/>
                  <a:gd name="T6" fmla="*/ 445 w 890"/>
                  <a:gd name="T7" fmla="*/ 0 h 224"/>
                  <a:gd name="T8" fmla="*/ 665 w 890"/>
                  <a:gd name="T9" fmla="*/ 37 h 224"/>
                  <a:gd name="T10" fmla="*/ 890 w 890"/>
                  <a:gd name="T11" fmla="*/ 146 h 224"/>
                  <a:gd name="T12" fmla="*/ 890 w 890"/>
                  <a:gd name="T13" fmla="*/ 224 h 224"/>
                  <a:gd name="T14" fmla="*/ 668 w 890"/>
                  <a:gd name="T15" fmla="*/ 127 h 224"/>
                  <a:gd name="T16" fmla="*/ 445 w 890"/>
                  <a:gd name="T17" fmla="*/ 95 h 224"/>
                  <a:gd name="T18" fmla="*/ 223 w 890"/>
                  <a:gd name="T19" fmla="*/ 127 h 224"/>
                  <a:gd name="T20" fmla="*/ 0 w 890"/>
                  <a:gd name="T21" fmla="*/ 224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890" h="224">
                    <a:moveTo>
                      <a:pt x="0" y="224"/>
                    </a:moveTo>
                    <a:lnTo>
                      <a:pt x="0" y="146"/>
                    </a:lnTo>
                    <a:cubicBezTo>
                      <a:pt x="77" y="98"/>
                      <a:pt x="152" y="61"/>
                      <a:pt x="226" y="37"/>
                    </a:cubicBezTo>
                    <a:cubicBezTo>
                      <a:pt x="300" y="13"/>
                      <a:pt x="373" y="0"/>
                      <a:pt x="445" y="0"/>
                    </a:cubicBezTo>
                    <a:cubicBezTo>
                      <a:pt x="518" y="0"/>
                      <a:pt x="591" y="13"/>
                      <a:pt x="665" y="37"/>
                    </a:cubicBezTo>
                    <a:cubicBezTo>
                      <a:pt x="739" y="61"/>
                      <a:pt x="813" y="98"/>
                      <a:pt x="890" y="146"/>
                    </a:cubicBezTo>
                    <a:lnTo>
                      <a:pt x="890" y="224"/>
                    </a:lnTo>
                    <a:cubicBezTo>
                      <a:pt x="815" y="181"/>
                      <a:pt x="742" y="149"/>
                      <a:pt x="668" y="127"/>
                    </a:cubicBezTo>
                    <a:cubicBezTo>
                      <a:pt x="595" y="106"/>
                      <a:pt x="521" y="95"/>
                      <a:pt x="445" y="95"/>
                    </a:cubicBezTo>
                    <a:cubicBezTo>
                      <a:pt x="370" y="95"/>
                      <a:pt x="296" y="106"/>
                      <a:pt x="223" y="127"/>
                    </a:cubicBezTo>
                    <a:cubicBezTo>
                      <a:pt x="150" y="149"/>
                      <a:pt x="76" y="181"/>
                      <a:pt x="0" y="224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8" name="Freeform 162">
                <a:extLst>
                  <a:ext uri="{FF2B5EF4-FFF2-40B4-BE49-F238E27FC236}">
                    <a16:creationId xmlns:a16="http://schemas.microsoft.com/office/drawing/2014/main" id="{E72142DB-717F-76BC-AF82-DC202B361DB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38525" y="2665413"/>
                <a:ext cx="666750" cy="2393950"/>
              </a:xfrm>
              <a:custGeom>
                <a:avLst/>
                <a:gdLst>
                  <a:gd name="T0" fmla="*/ 1753 w 3693"/>
                  <a:gd name="T1" fmla="*/ 12999 h 13267"/>
                  <a:gd name="T2" fmla="*/ 1603 w 3693"/>
                  <a:gd name="T3" fmla="*/ 12463 h 13267"/>
                  <a:gd name="T4" fmla="*/ 1481 w 3693"/>
                  <a:gd name="T5" fmla="*/ 11927 h 13267"/>
                  <a:gd name="T6" fmla="*/ 1419 w 3693"/>
                  <a:gd name="T7" fmla="*/ 11391 h 13267"/>
                  <a:gd name="T8" fmla="*/ 1160 w 3693"/>
                  <a:gd name="T9" fmla="*/ 10855 h 13267"/>
                  <a:gd name="T10" fmla="*/ 683 w 3693"/>
                  <a:gd name="T11" fmla="*/ 10319 h 13267"/>
                  <a:gd name="T12" fmla="*/ 371 w 3693"/>
                  <a:gd name="T13" fmla="*/ 9782 h 13267"/>
                  <a:gd name="T14" fmla="*/ 314 w 3693"/>
                  <a:gd name="T15" fmla="*/ 9246 h 13267"/>
                  <a:gd name="T16" fmla="*/ 383 w 3693"/>
                  <a:gd name="T17" fmla="*/ 8710 h 13267"/>
                  <a:gd name="T18" fmla="*/ 414 w 3693"/>
                  <a:gd name="T19" fmla="*/ 8174 h 13267"/>
                  <a:gd name="T20" fmla="*/ 195 w 3693"/>
                  <a:gd name="T21" fmla="*/ 7638 h 13267"/>
                  <a:gd name="T22" fmla="*/ 0 w 3693"/>
                  <a:gd name="T23" fmla="*/ 7102 h 13267"/>
                  <a:gd name="T24" fmla="*/ 146 w 3693"/>
                  <a:gd name="T25" fmla="*/ 6566 h 13267"/>
                  <a:gd name="T26" fmla="*/ 363 w 3693"/>
                  <a:gd name="T27" fmla="*/ 6030 h 13267"/>
                  <a:gd name="T28" fmla="*/ 481 w 3693"/>
                  <a:gd name="T29" fmla="*/ 5494 h 13267"/>
                  <a:gd name="T30" fmla="*/ 691 w 3693"/>
                  <a:gd name="T31" fmla="*/ 4958 h 13267"/>
                  <a:gd name="T32" fmla="*/ 1055 w 3693"/>
                  <a:gd name="T33" fmla="*/ 4422 h 13267"/>
                  <a:gd name="T34" fmla="*/ 1348 w 3693"/>
                  <a:gd name="T35" fmla="*/ 3886 h 13267"/>
                  <a:gd name="T36" fmla="*/ 1437 w 3693"/>
                  <a:gd name="T37" fmla="*/ 3350 h 13267"/>
                  <a:gd name="T38" fmla="*/ 1483 w 3693"/>
                  <a:gd name="T39" fmla="*/ 2814 h 13267"/>
                  <a:gd name="T40" fmla="*/ 1539 w 3693"/>
                  <a:gd name="T41" fmla="*/ 2278 h 13267"/>
                  <a:gd name="T42" fmla="*/ 1509 w 3693"/>
                  <a:gd name="T43" fmla="*/ 1742 h 13267"/>
                  <a:gd name="T44" fmla="*/ 1510 w 3693"/>
                  <a:gd name="T45" fmla="*/ 1206 h 13267"/>
                  <a:gd name="T46" fmla="*/ 1644 w 3693"/>
                  <a:gd name="T47" fmla="*/ 670 h 13267"/>
                  <a:gd name="T48" fmla="*/ 1780 w 3693"/>
                  <a:gd name="T49" fmla="*/ 134 h 13267"/>
                  <a:gd name="T50" fmla="*/ 1913 w 3693"/>
                  <a:gd name="T51" fmla="*/ 134 h 13267"/>
                  <a:gd name="T52" fmla="*/ 2048 w 3693"/>
                  <a:gd name="T53" fmla="*/ 670 h 13267"/>
                  <a:gd name="T54" fmla="*/ 2182 w 3693"/>
                  <a:gd name="T55" fmla="*/ 1206 h 13267"/>
                  <a:gd name="T56" fmla="*/ 2184 w 3693"/>
                  <a:gd name="T57" fmla="*/ 1742 h 13267"/>
                  <a:gd name="T58" fmla="*/ 2153 w 3693"/>
                  <a:gd name="T59" fmla="*/ 2278 h 13267"/>
                  <a:gd name="T60" fmla="*/ 2210 w 3693"/>
                  <a:gd name="T61" fmla="*/ 2814 h 13267"/>
                  <a:gd name="T62" fmla="*/ 2255 w 3693"/>
                  <a:gd name="T63" fmla="*/ 3350 h 13267"/>
                  <a:gd name="T64" fmla="*/ 2344 w 3693"/>
                  <a:gd name="T65" fmla="*/ 3886 h 13267"/>
                  <a:gd name="T66" fmla="*/ 2638 w 3693"/>
                  <a:gd name="T67" fmla="*/ 4422 h 13267"/>
                  <a:gd name="T68" fmla="*/ 3001 w 3693"/>
                  <a:gd name="T69" fmla="*/ 4958 h 13267"/>
                  <a:gd name="T70" fmla="*/ 3211 w 3693"/>
                  <a:gd name="T71" fmla="*/ 5494 h 13267"/>
                  <a:gd name="T72" fmla="*/ 3329 w 3693"/>
                  <a:gd name="T73" fmla="*/ 6030 h 13267"/>
                  <a:gd name="T74" fmla="*/ 3546 w 3693"/>
                  <a:gd name="T75" fmla="*/ 6566 h 13267"/>
                  <a:gd name="T76" fmla="*/ 3693 w 3693"/>
                  <a:gd name="T77" fmla="*/ 7102 h 13267"/>
                  <a:gd name="T78" fmla="*/ 3498 w 3693"/>
                  <a:gd name="T79" fmla="*/ 7638 h 13267"/>
                  <a:gd name="T80" fmla="*/ 3278 w 3693"/>
                  <a:gd name="T81" fmla="*/ 8174 h 13267"/>
                  <a:gd name="T82" fmla="*/ 3309 w 3693"/>
                  <a:gd name="T83" fmla="*/ 8710 h 13267"/>
                  <a:gd name="T84" fmla="*/ 3379 w 3693"/>
                  <a:gd name="T85" fmla="*/ 9246 h 13267"/>
                  <a:gd name="T86" fmla="*/ 3322 w 3693"/>
                  <a:gd name="T87" fmla="*/ 9782 h 13267"/>
                  <a:gd name="T88" fmla="*/ 3010 w 3693"/>
                  <a:gd name="T89" fmla="*/ 10319 h 13267"/>
                  <a:gd name="T90" fmla="*/ 2533 w 3693"/>
                  <a:gd name="T91" fmla="*/ 10855 h 13267"/>
                  <a:gd name="T92" fmla="*/ 2274 w 3693"/>
                  <a:gd name="T93" fmla="*/ 11391 h 13267"/>
                  <a:gd name="T94" fmla="*/ 2212 w 3693"/>
                  <a:gd name="T95" fmla="*/ 11927 h 13267"/>
                  <a:gd name="T96" fmla="*/ 2090 w 3693"/>
                  <a:gd name="T97" fmla="*/ 12463 h 13267"/>
                  <a:gd name="T98" fmla="*/ 1939 w 3693"/>
                  <a:gd name="T99" fmla="*/ 12999 h 132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3693" h="13267">
                    <a:moveTo>
                      <a:pt x="1892" y="13267"/>
                    </a:moveTo>
                    <a:lnTo>
                      <a:pt x="1801" y="13267"/>
                    </a:lnTo>
                    <a:lnTo>
                      <a:pt x="1780" y="13133"/>
                    </a:lnTo>
                    <a:lnTo>
                      <a:pt x="1753" y="12999"/>
                    </a:lnTo>
                    <a:lnTo>
                      <a:pt x="1721" y="12865"/>
                    </a:lnTo>
                    <a:lnTo>
                      <a:pt x="1684" y="12731"/>
                    </a:lnTo>
                    <a:lnTo>
                      <a:pt x="1644" y="12597"/>
                    </a:lnTo>
                    <a:lnTo>
                      <a:pt x="1603" y="12463"/>
                    </a:lnTo>
                    <a:lnTo>
                      <a:pt x="1563" y="12329"/>
                    </a:lnTo>
                    <a:lnTo>
                      <a:pt x="1529" y="12195"/>
                    </a:lnTo>
                    <a:lnTo>
                      <a:pt x="1501" y="12061"/>
                    </a:lnTo>
                    <a:lnTo>
                      <a:pt x="1481" y="11927"/>
                    </a:lnTo>
                    <a:lnTo>
                      <a:pt x="1466" y="11793"/>
                    </a:lnTo>
                    <a:lnTo>
                      <a:pt x="1454" y="11659"/>
                    </a:lnTo>
                    <a:lnTo>
                      <a:pt x="1441" y="11525"/>
                    </a:lnTo>
                    <a:lnTo>
                      <a:pt x="1419" y="11391"/>
                    </a:lnTo>
                    <a:lnTo>
                      <a:pt x="1383" y="11257"/>
                    </a:lnTo>
                    <a:lnTo>
                      <a:pt x="1330" y="11123"/>
                    </a:lnTo>
                    <a:lnTo>
                      <a:pt x="1255" y="10989"/>
                    </a:lnTo>
                    <a:lnTo>
                      <a:pt x="1160" y="10855"/>
                    </a:lnTo>
                    <a:lnTo>
                      <a:pt x="1048" y="10721"/>
                    </a:lnTo>
                    <a:lnTo>
                      <a:pt x="926" y="10587"/>
                    </a:lnTo>
                    <a:lnTo>
                      <a:pt x="802" y="10453"/>
                    </a:lnTo>
                    <a:lnTo>
                      <a:pt x="683" y="10319"/>
                    </a:lnTo>
                    <a:lnTo>
                      <a:pt x="577" y="10185"/>
                    </a:lnTo>
                    <a:lnTo>
                      <a:pt x="489" y="10051"/>
                    </a:lnTo>
                    <a:lnTo>
                      <a:pt x="420" y="9916"/>
                    </a:lnTo>
                    <a:lnTo>
                      <a:pt x="371" y="9782"/>
                    </a:lnTo>
                    <a:lnTo>
                      <a:pt x="338" y="9648"/>
                    </a:lnTo>
                    <a:lnTo>
                      <a:pt x="320" y="9514"/>
                    </a:lnTo>
                    <a:lnTo>
                      <a:pt x="312" y="9380"/>
                    </a:lnTo>
                    <a:lnTo>
                      <a:pt x="314" y="9246"/>
                    </a:lnTo>
                    <a:lnTo>
                      <a:pt x="323" y="9112"/>
                    </a:lnTo>
                    <a:lnTo>
                      <a:pt x="339" y="8978"/>
                    </a:lnTo>
                    <a:lnTo>
                      <a:pt x="359" y="8844"/>
                    </a:lnTo>
                    <a:lnTo>
                      <a:pt x="383" y="8710"/>
                    </a:lnTo>
                    <a:lnTo>
                      <a:pt x="405" y="8576"/>
                    </a:lnTo>
                    <a:lnTo>
                      <a:pt x="421" y="8442"/>
                    </a:lnTo>
                    <a:lnTo>
                      <a:pt x="426" y="8308"/>
                    </a:lnTo>
                    <a:lnTo>
                      <a:pt x="414" y="8174"/>
                    </a:lnTo>
                    <a:lnTo>
                      <a:pt x="383" y="8040"/>
                    </a:lnTo>
                    <a:lnTo>
                      <a:pt x="333" y="7906"/>
                    </a:lnTo>
                    <a:lnTo>
                      <a:pt x="268" y="7772"/>
                    </a:lnTo>
                    <a:lnTo>
                      <a:pt x="195" y="7638"/>
                    </a:lnTo>
                    <a:lnTo>
                      <a:pt x="123" y="7504"/>
                    </a:lnTo>
                    <a:lnTo>
                      <a:pt x="61" y="7370"/>
                    </a:lnTo>
                    <a:lnTo>
                      <a:pt x="18" y="7236"/>
                    </a:lnTo>
                    <a:lnTo>
                      <a:pt x="0" y="7102"/>
                    </a:lnTo>
                    <a:lnTo>
                      <a:pt x="7" y="6968"/>
                    </a:lnTo>
                    <a:lnTo>
                      <a:pt x="38" y="6834"/>
                    </a:lnTo>
                    <a:lnTo>
                      <a:pt x="87" y="6700"/>
                    </a:lnTo>
                    <a:lnTo>
                      <a:pt x="146" y="6566"/>
                    </a:lnTo>
                    <a:lnTo>
                      <a:pt x="209" y="6432"/>
                    </a:lnTo>
                    <a:lnTo>
                      <a:pt x="269" y="6298"/>
                    </a:lnTo>
                    <a:lnTo>
                      <a:pt x="320" y="6164"/>
                    </a:lnTo>
                    <a:lnTo>
                      <a:pt x="363" y="6030"/>
                    </a:lnTo>
                    <a:lnTo>
                      <a:pt x="397" y="5896"/>
                    </a:lnTo>
                    <a:lnTo>
                      <a:pt x="425" y="5762"/>
                    </a:lnTo>
                    <a:lnTo>
                      <a:pt x="452" y="5628"/>
                    </a:lnTo>
                    <a:lnTo>
                      <a:pt x="481" y="5494"/>
                    </a:lnTo>
                    <a:lnTo>
                      <a:pt x="517" y="5360"/>
                    </a:lnTo>
                    <a:lnTo>
                      <a:pt x="563" y="5226"/>
                    </a:lnTo>
                    <a:lnTo>
                      <a:pt x="621" y="5092"/>
                    </a:lnTo>
                    <a:lnTo>
                      <a:pt x="691" y="4958"/>
                    </a:lnTo>
                    <a:lnTo>
                      <a:pt x="773" y="4824"/>
                    </a:lnTo>
                    <a:lnTo>
                      <a:pt x="864" y="4690"/>
                    </a:lnTo>
                    <a:lnTo>
                      <a:pt x="959" y="4556"/>
                    </a:lnTo>
                    <a:lnTo>
                      <a:pt x="1055" y="4422"/>
                    </a:lnTo>
                    <a:lnTo>
                      <a:pt x="1145" y="4288"/>
                    </a:lnTo>
                    <a:lnTo>
                      <a:pt x="1227" y="4154"/>
                    </a:lnTo>
                    <a:lnTo>
                      <a:pt x="1295" y="4020"/>
                    </a:lnTo>
                    <a:lnTo>
                      <a:pt x="1348" y="3886"/>
                    </a:lnTo>
                    <a:lnTo>
                      <a:pt x="1387" y="3752"/>
                    </a:lnTo>
                    <a:lnTo>
                      <a:pt x="1412" y="3618"/>
                    </a:lnTo>
                    <a:lnTo>
                      <a:pt x="1427" y="3484"/>
                    </a:lnTo>
                    <a:lnTo>
                      <a:pt x="1437" y="3350"/>
                    </a:lnTo>
                    <a:lnTo>
                      <a:pt x="1445" y="3216"/>
                    </a:lnTo>
                    <a:lnTo>
                      <a:pt x="1454" y="3082"/>
                    </a:lnTo>
                    <a:lnTo>
                      <a:pt x="1467" y="2948"/>
                    </a:lnTo>
                    <a:lnTo>
                      <a:pt x="1483" y="2814"/>
                    </a:lnTo>
                    <a:lnTo>
                      <a:pt x="1501" y="2680"/>
                    </a:lnTo>
                    <a:lnTo>
                      <a:pt x="1518" y="2546"/>
                    </a:lnTo>
                    <a:lnTo>
                      <a:pt x="1532" y="2412"/>
                    </a:lnTo>
                    <a:lnTo>
                      <a:pt x="1539" y="2278"/>
                    </a:lnTo>
                    <a:lnTo>
                      <a:pt x="1540" y="2144"/>
                    </a:lnTo>
                    <a:lnTo>
                      <a:pt x="1533" y="2010"/>
                    </a:lnTo>
                    <a:lnTo>
                      <a:pt x="1522" y="1876"/>
                    </a:lnTo>
                    <a:lnTo>
                      <a:pt x="1509" y="1742"/>
                    </a:lnTo>
                    <a:lnTo>
                      <a:pt x="1498" y="1608"/>
                    </a:lnTo>
                    <a:lnTo>
                      <a:pt x="1493" y="1474"/>
                    </a:lnTo>
                    <a:lnTo>
                      <a:pt x="1496" y="1340"/>
                    </a:lnTo>
                    <a:lnTo>
                      <a:pt x="1510" y="1206"/>
                    </a:lnTo>
                    <a:lnTo>
                      <a:pt x="1534" y="1072"/>
                    </a:lnTo>
                    <a:lnTo>
                      <a:pt x="1566" y="938"/>
                    </a:lnTo>
                    <a:lnTo>
                      <a:pt x="1604" y="804"/>
                    </a:lnTo>
                    <a:lnTo>
                      <a:pt x="1644" y="670"/>
                    </a:lnTo>
                    <a:lnTo>
                      <a:pt x="1684" y="536"/>
                    </a:lnTo>
                    <a:lnTo>
                      <a:pt x="1721" y="402"/>
                    </a:lnTo>
                    <a:lnTo>
                      <a:pt x="1753" y="268"/>
                    </a:lnTo>
                    <a:lnTo>
                      <a:pt x="1780" y="134"/>
                    </a:lnTo>
                    <a:lnTo>
                      <a:pt x="1801" y="0"/>
                    </a:lnTo>
                    <a:lnTo>
                      <a:pt x="1892" y="0"/>
                    </a:lnTo>
                    <a:lnTo>
                      <a:pt x="1893" y="0"/>
                    </a:lnTo>
                    <a:lnTo>
                      <a:pt x="1913" y="134"/>
                    </a:lnTo>
                    <a:lnTo>
                      <a:pt x="1939" y="268"/>
                    </a:lnTo>
                    <a:lnTo>
                      <a:pt x="1971" y="402"/>
                    </a:lnTo>
                    <a:lnTo>
                      <a:pt x="2008" y="536"/>
                    </a:lnTo>
                    <a:lnTo>
                      <a:pt x="2048" y="670"/>
                    </a:lnTo>
                    <a:lnTo>
                      <a:pt x="2089" y="804"/>
                    </a:lnTo>
                    <a:lnTo>
                      <a:pt x="2126" y="938"/>
                    </a:lnTo>
                    <a:lnTo>
                      <a:pt x="2159" y="1072"/>
                    </a:lnTo>
                    <a:lnTo>
                      <a:pt x="2182" y="1206"/>
                    </a:lnTo>
                    <a:lnTo>
                      <a:pt x="2196" y="1340"/>
                    </a:lnTo>
                    <a:lnTo>
                      <a:pt x="2200" y="1474"/>
                    </a:lnTo>
                    <a:lnTo>
                      <a:pt x="2194" y="1608"/>
                    </a:lnTo>
                    <a:lnTo>
                      <a:pt x="2184" y="1742"/>
                    </a:lnTo>
                    <a:lnTo>
                      <a:pt x="2171" y="1876"/>
                    </a:lnTo>
                    <a:lnTo>
                      <a:pt x="2159" y="2010"/>
                    </a:lnTo>
                    <a:lnTo>
                      <a:pt x="2153" y="2144"/>
                    </a:lnTo>
                    <a:lnTo>
                      <a:pt x="2153" y="2278"/>
                    </a:lnTo>
                    <a:lnTo>
                      <a:pt x="2161" y="2412"/>
                    </a:lnTo>
                    <a:lnTo>
                      <a:pt x="2174" y="2546"/>
                    </a:lnTo>
                    <a:lnTo>
                      <a:pt x="2192" y="2680"/>
                    </a:lnTo>
                    <a:lnTo>
                      <a:pt x="2210" y="2814"/>
                    </a:lnTo>
                    <a:lnTo>
                      <a:pt x="2225" y="2948"/>
                    </a:lnTo>
                    <a:lnTo>
                      <a:pt x="2238" y="3082"/>
                    </a:lnTo>
                    <a:lnTo>
                      <a:pt x="2247" y="3216"/>
                    </a:lnTo>
                    <a:lnTo>
                      <a:pt x="2255" y="3350"/>
                    </a:lnTo>
                    <a:lnTo>
                      <a:pt x="2265" y="3484"/>
                    </a:lnTo>
                    <a:lnTo>
                      <a:pt x="2280" y="3618"/>
                    </a:lnTo>
                    <a:lnTo>
                      <a:pt x="2306" y="3752"/>
                    </a:lnTo>
                    <a:lnTo>
                      <a:pt x="2344" y="3886"/>
                    </a:lnTo>
                    <a:lnTo>
                      <a:pt x="2398" y="4020"/>
                    </a:lnTo>
                    <a:lnTo>
                      <a:pt x="2466" y="4154"/>
                    </a:lnTo>
                    <a:lnTo>
                      <a:pt x="2547" y="4288"/>
                    </a:lnTo>
                    <a:lnTo>
                      <a:pt x="2638" y="4422"/>
                    </a:lnTo>
                    <a:lnTo>
                      <a:pt x="2733" y="4556"/>
                    </a:lnTo>
                    <a:lnTo>
                      <a:pt x="2829" y="4690"/>
                    </a:lnTo>
                    <a:lnTo>
                      <a:pt x="2920" y="4824"/>
                    </a:lnTo>
                    <a:lnTo>
                      <a:pt x="3001" y="4958"/>
                    </a:lnTo>
                    <a:lnTo>
                      <a:pt x="3072" y="5092"/>
                    </a:lnTo>
                    <a:lnTo>
                      <a:pt x="3130" y="5226"/>
                    </a:lnTo>
                    <a:lnTo>
                      <a:pt x="3176" y="5360"/>
                    </a:lnTo>
                    <a:lnTo>
                      <a:pt x="3211" y="5494"/>
                    </a:lnTo>
                    <a:lnTo>
                      <a:pt x="3241" y="5628"/>
                    </a:lnTo>
                    <a:lnTo>
                      <a:pt x="3267" y="5762"/>
                    </a:lnTo>
                    <a:lnTo>
                      <a:pt x="3295" y="5896"/>
                    </a:lnTo>
                    <a:lnTo>
                      <a:pt x="3329" y="6030"/>
                    </a:lnTo>
                    <a:lnTo>
                      <a:pt x="3372" y="6164"/>
                    </a:lnTo>
                    <a:lnTo>
                      <a:pt x="3424" y="6298"/>
                    </a:lnTo>
                    <a:lnTo>
                      <a:pt x="3483" y="6432"/>
                    </a:lnTo>
                    <a:lnTo>
                      <a:pt x="3546" y="6566"/>
                    </a:lnTo>
                    <a:lnTo>
                      <a:pt x="3606" y="6700"/>
                    </a:lnTo>
                    <a:lnTo>
                      <a:pt x="3655" y="6834"/>
                    </a:lnTo>
                    <a:lnTo>
                      <a:pt x="3685" y="6968"/>
                    </a:lnTo>
                    <a:lnTo>
                      <a:pt x="3693" y="7102"/>
                    </a:lnTo>
                    <a:lnTo>
                      <a:pt x="3674" y="7236"/>
                    </a:lnTo>
                    <a:lnTo>
                      <a:pt x="3631" y="7370"/>
                    </a:lnTo>
                    <a:lnTo>
                      <a:pt x="3570" y="7504"/>
                    </a:lnTo>
                    <a:lnTo>
                      <a:pt x="3498" y="7638"/>
                    </a:lnTo>
                    <a:lnTo>
                      <a:pt x="3425" y="7772"/>
                    </a:lnTo>
                    <a:lnTo>
                      <a:pt x="3360" y="7906"/>
                    </a:lnTo>
                    <a:lnTo>
                      <a:pt x="3310" y="8040"/>
                    </a:lnTo>
                    <a:lnTo>
                      <a:pt x="3278" y="8174"/>
                    </a:lnTo>
                    <a:lnTo>
                      <a:pt x="3266" y="8308"/>
                    </a:lnTo>
                    <a:lnTo>
                      <a:pt x="3271" y="8442"/>
                    </a:lnTo>
                    <a:lnTo>
                      <a:pt x="3287" y="8576"/>
                    </a:lnTo>
                    <a:lnTo>
                      <a:pt x="3309" y="8710"/>
                    </a:lnTo>
                    <a:lnTo>
                      <a:pt x="3333" y="8844"/>
                    </a:lnTo>
                    <a:lnTo>
                      <a:pt x="3354" y="8978"/>
                    </a:lnTo>
                    <a:lnTo>
                      <a:pt x="3370" y="9112"/>
                    </a:lnTo>
                    <a:lnTo>
                      <a:pt x="3379" y="9246"/>
                    </a:lnTo>
                    <a:lnTo>
                      <a:pt x="3380" y="9380"/>
                    </a:lnTo>
                    <a:lnTo>
                      <a:pt x="3373" y="9514"/>
                    </a:lnTo>
                    <a:lnTo>
                      <a:pt x="3354" y="9648"/>
                    </a:lnTo>
                    <a:lnTo>
                      <a:pt x="3322" y="9782"/>
                    </a:lnTo>
                    <a:lnTo>
                      <a:pt x="3272" y="9916"/>
                    </a:lnTo>
                    <a:lnTo>
                      <a:pt x="3204" y="10051"/>
                    </a:lnTo>
                    <a:lnTo>
                      <a:pt x="3115" y="10185"/>
                    </a:lnTo>
                    <a:lnTo>
                      <a:pt x="3010" y="10319"/>
                    </a:lnTo>
                    <a:lnTo>
                      <a:pt x="2891" y="10453"/>
                    </a:lnTo>
                    <a:lnTo>
                      <a:pt x="2766" y="10587"/>
                    </a:lnTo>
                    <a:lnTo>
                      <a:pt x="2644" y="10721"/>
                    </a:lnTo>
                    <a:lnTo>
                      <a:pt x="2533" y="10855"/>
                    </a:lnTo>
                    <a:lnTo>
                      <a:pt x="2438" y="10989"/>
                    </a:lnTo>
                    <a:lnTo>
                      <a:pt x="2363" y="11123"/>
                    </a:lnTo>
                    <a:lnTo>
                      <a:pt x="2309" y="11257"/>
                    </a:lnTo>
                    <a:lnTo>
                      <a:pt x="2274" y="11391"/>
                    </a:lnTo>
                    <a:lnTo>
                      <a:pt x="2252" y="11525"/>
                    </a:lnTo>
                    <a:lnTo>
                      <a:pt x="2238" y="11659"/>
                    </a:lnTo>
                    <a:lnTo>
                      <a:pt x="2226" y="11793"/>
                    </a:lnTo>
                    <a:lnTo>
                      <a:pt x="2212" y="11927"/>
                    </a:lnTo>
                    <a:lnTo>
                      <a:pt x="2191" y="12061"/>
                    </a:lnTo>
                    <a:lnTo>
                      <a:pt x="2163" y="12195"/>
                    </a:lnTo>
                    <a:lnTo>
                      <a:pt x="2129" y="12329"/>
                    </a:lnTo>
                    <a:lnTo>
                      <a:pt x="2090" y="12463"/>
                    </a:lnTo>
                    <a:lnTo>
                      <a:pt x="2049" y="12597"/>
                    </a:lnTo>
                    <a:lnTo>
                      <a:pt x="2008" y="12731"/>
                    </a:lnTo>
                    <a:lnTo>
                      <a:pt x="1971" y="12865"/>
                    </a:lnTo>
                    <a:lnTo>
                      <a:pt x="1939" y="12999"/>
                    </a:lnTo>
                    <a:lnTo>
                      <a:pt x="1913" y="13133"/>
                    </a:lnTo>
                    <a:lnTo>
                      <a:pt x="1892" y="13267"/>
                    </a:lnTo>
                    <a:close/>
                  </a:path>
                </a:pathLst>
              </a:custGeom>
              <a:solidFill>
                <a:srgbClr val="71AEC0"/>
              </a:solidFill>
              <a:ln w="14288" cap="flat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14288" cap="flat">
                    <a:solidFill>
                      <a:srgbClr val="525252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9" name="Freeform 163">
                <a:extLst>
                  <a:ext uri="{FF2B5EF4-FFF2-40B4-BE49-F238E27FC236}">
                    <a16:creationId xmlns:a16="http://schemas.microsoft.com/office/drawing/2014/main" id="{900C7D72-C6D4-C4D6-AE9A-8C134016E30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38525" y="2665413"/>
                <a:ext cx="666750" cy="2393950"/>
              </a:xfrm>
              <a:custGeom>
                <a:avLst/>
                <a:gdLst>
                  <a:gd name="T0" fmla="*/ 1753 w 3693"/>
                  <a:gd name="T1" fmla="*/ 12999 h 13267"/>
                  <a:gd name="T2" fmla="*/ 1603 w 3693"/>
                  <a:gd name="T3" fmla="*/ 12463 h 13267"/>
                  <a:gd name="T4" fmla="*/ 1481 w 3693"/>
                  <a:gd name="T5" fmla="*/ 11927 h 13267"/>
                  <a:gd name="T6" fmla="*/ 1419 w 3693"/>
                  <a:gd name="T7" fmla="*/ 11391 h 13267"/>
                  <a:gd name="T8" fmla="*/ 1160 w 3693"/>
                  <a:gd name="T9" fmla="*/ 10855 h 13267"/>
                  <a:gd name="T10" fmla="*/ 683 w 3693"/>
                  <a:gd name="T11" fmla="*/ 10319 h 13267"/>
                  <a:gd name="T12" fmla="*/ 371 w 3693"/>
                  <a:gd name="T13" fmla="*/ 9782 h 13267"/>
                  <a:gd name="T14" fmla="*/ 314 w 3693"/>
                  <a:gd name="T15" fmla="*/ 9246 h 13267"/>
                  <a:gd name="T16" fmla="*/ 383 w 3693"/>
                  <a:gd name="T17" fmla="*/ 8710 h 13267"/>
                  <a:gd name="T18" fmla="*/ 414 w 3693"/>
                  <a:gd name="T19" fmla="*/ 8174 h 13267"/>
                  <a:gd name="T20" fmla="*/ 195 w 3693"/>
                  <a:gd name="T21" fmla="*/ 7638 h 13267"/>
                  <a:gd name="T22" fmla="*/ 0 w 3693"/>
                  <a:gd name="T23" fmla="*/ 7102 h 13267"/>
                  <a:gd name="T24" fmla="*/ 146 w 3693"/>
                  <a:gd name="T25" fmla="*/ 6566 h 13267"/>
                  <a:gd name="T26" fmla="*/ 363 w 3693"/>
                  <a:gd name="T27" fmla="*/ 6030 h 13267"/>
                  <a:gd name="T28" fmla="*/ 481 w 3693"/>
                  <a:gd name="T29" fmla="*/ 5494 h 13267"/>
                  <a:gd name="T30" fmla="*/ 691 w 3693"/>
                  <a:gd name="T31" fmla="*/ 4958 h 13267"/>
                  <a:gd name="T32" fmla="*/ 1055 w 3693"/>
                  <a:gd name="T33" fmla="*/ 4422 h 13267"/>
                  <a:gd name="T34" fmla="*/ 1348 w 3693"/>
                  <a:gd name="T35" fmla="*/ 3886 h 13267"/>
                  <a:gd name="T36" fmla="*/ 1437 w 3693"/>
                  <a:gd name="T37" fmla="*/ 3350 h 13267"/>
                  <a:gd name="T38" fmla="*/ 1483 w 3693"/>
                  <a:gd name="T39" fmla="*/ 2814 h 13267"/>
                  <a:gd name="T40" fmla="*/ 1539 w 3693"/>
                  <a:gd name="T41" fmla="*/ 2278 h 13267"/>
                  <a:gd name="T42" fmla="*/ 1509 w 3693"/>
                  <a:gd name="T43" fmla="*/ 1742 h 13267"/>
                  <a:gd name="T44" fmla="*/ 1510 w 3693"/>
                  <a:gd name="T45" fmla="*/ 1206 h 13267"/>
                  <a:gd name="T46" fmla="*/ 1644 w 3693"/>
                  <a:gd name="T47" fmla="*/ 670 h 13267"/>
                  <a:gd name="T48" fmla="*/ 1780 w 3693"/>
                  <a:gd name="T49" fmla="*/ 134 h 13267"/>
                  <a:gd name="T50" fmla="*/ 1913 w 3693"/>
                  <a:gd name="T51" fmla="*/ 134 h 13267"/>
                  <a:gd name="T52" fmla="*/ 2048 w 3693"/>
                  <a:gd name="T53" fmla="*/ 670 h 13267"/>
                  <a:gd name="T54" fmla="*/ 2182 w 3693"/>
                  <a:gd name="T55" fmla="*/ 1206 h 13267"/>
                  <a:gd name="T56" fmla="*/ 2184 w 3693"/>
                  <a:gd name="T57" fmla="*/ 1742 h 13267"/>
                  <a:gd name="T58" fmla="*/ 2153 w 3693"/>
                  <a:gd name="T59" fmla="*/ 2278 h 13267"/>
                  <a:gd name="T60" fmla="*/ 2210 w 3693"/>
                  <a:gd name="T61" fmla="*/ 2814 h 13267"/>
                  <a:gd name="T62" fmla="*/ 2255 w 3693"/>
                  <a:gd name="T63" fmla="*/ 3350 h 13267"/>
                  <a:gd name="T64" fmla="*/ 2344 w 3693"/>
                  <a:gd name="T65" fmla="*/ 3886 h 13267"/>
                  <a:gd name="T66" fmla="*/ 2638 w 3693"/>
                  <a:gd name="T67" fmla="*/ 4422 h 13267"/>
                  <a:gd name="T68" fmla="*/ 3001 w 3693"/>
                  <a:gd name="T69" fmla="*/ 4958 h 13267"/>
                  <a:gd name="T70" fmla="*/ 3211 w 3693"/>
                  <a:gd name="T71" fmla="*/ 5494 h 13267"/>
                  <a:gd name="T72" fmla="*/ 3329 w 3693"/>
                  <a:gd name="T73" fmla="*/ 6030 h 13267"/>
                  <a:gd name="T74" fmla="*/ 3546 w 3693"/>
                  <a:gd name="T75" fmla="*/ 6566 h 13267"/>
                  <a:gd name="T76" fmla="*/ 3693 w 3693"/>
                  <a:gd name="T77" fmla="*/ 7102 h 13267"/>
                  <a:gd name="T78" fmla="*/ 3498 w 3693"/>
                  <a:gd name="T79" fmla="*/ 7638 h 13267"/>
                  <a:gd name="T80" fmla="*/ 3278 w 3693"/>
                  <a:gd name="T81" fmla="*/ 8174 h 13267"/>
                  <a:gd name="T82" fmla="*/ 3309 w 3693"/>
                  <a:gd name="T83" fmla="*/ 8710 h 13267"/>
                  <a:gd name="T84" fmla="*/ 3379 w 3693"/>
                  <a:gd name="T85" fmla="*/ 9246 h 13267"/>
                  <a:gd name="T86" fmla="*/ 3322 w 3693"/>
                  <a:gd name="T87" fmla="*/ 9782 h 13267"/>
                  <a:gd name="T88" fmla="*/ 3010 w 3693"/>
                  <a:gd name="T89" fmla="*/ 10319 h 13267"/>
                  <a:gd name="T90" fmla="*/ 2533 w 3693"/>
                  <a:gd name="T91" fmla="*/ 10855 h 13267"/>
                  <a:gd name="T92" fmla="*/ 2274 w 3693"/>
                  <a:gd name="T93" fmla="*/ 11391 h 13267"/>
                  <a:gd name="T94" fmla="*/ 2212 w 3693"/>
                  <a:gd name="T95" fmla="*/ 11927 h 13267"/>
                  <a:gd name="T96" fmla="*/ 2090 w 3693"/>
                  <a:gd name="T97" fmla="*/ 12463 h 13267"/>
                  <a:gd name="T98" fmla="*/ 1939 w 3693"/>
                  <a:gd name="T99" fmla="*/ 12999 h 132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3693" h="13267">
                    <a:moveTo>
                      <a:pt x="1892" y="13267"/>
                    </a:moveTo>
                    <a:lnTo>
                      <a:pt x="1801" y="13267"/>
                    </a:lnTo>
                    <a:lnTo>
                      <a:pt x="1780" y="13133"/>
                    </a:lnTo>
                    <a:lnTo>
                      <a:pt x="1753" y="12999"/>
                    </a:lnTo>
                    <a:lnTo>
                      <a:pt x="1721" y="12865"/>
                    </a:lnTo>
                    <a:lnTo>
                      <a:pt x="1684" y="12731"/>
                    </a:lnTo>
                    <a:lnTo>
                      <a:pt x="1644" y="12597"/>
                    </a:lnTo>
                    <a:lnTo>
                      <a:pt x="1603" y="12463"/>
                    </a:lnTo>
                    <a:lnTo>
                      <a:pt x="1563" y="12329"/>
                    </a:lnTo>
                    <a:lnTo>
                      <a:pt x="1529" y="12195"/>
                    </a:lnTo>
                    <a:lnTo>
                      <a:pt x="1501" y="12061"/>
                    </a:lnTo>
                    <a:lnTo>
                      <a:pt x="1481" y="11927"/>
                    </a:lnTo>
                    <a:lnTo>
                      <a:pt x="1466" y="11793"/>
                    </a:lnTo>
                    <a:lnTo>
                      <a:pt x="1454" y="11659"/>
                    </a:lnTo>
                    <a:lnTo>
                      <a:pt x="1441" y="11525"/>
                    </a:lnTo>
                    <a:lnTo>
                      <a:pt x="1419" y="11391"/>
                    </a:lnTo>
                    <a:lnTo>
                      <a:pt x="1383" y="11257"/>
                    </a:lnTo>
                    <a:lnTo>
                      <a:pt x="1330" y="11123"/>
                    </a:lnTo>
                    <a:lnTo>
                      <a:pt x="1255" y="10989"/>
                    </a:lnTo>
                    <a:lnTo>
                      <a:pt x="1160" y="10855"/>
                    </a:lnTo>
                    <a:lnTo>
                      <a:pt x="1048" y="10721"/>
                    </a:lnTo>
                    <a:lnTo>
                      <a:pt x="926" y="10587"/>
                    </a:lnTo>
                    <a:lnTo>
                      <a:pt x="802" y="10453"/>
                    </a:lnTo>
                    <a:lnTo>
                      <a:pt x="683" y="10319"/>
                    </a:lnTo>
                    <a:lnTo>
                      <a:pt x="577" y="10185"/>
                    </a:lnTo>
                    <a:lnTo>
                      <a:pt x="489" y="10051"/>
                    </a:lnTo>
                    <a:lnTo>
                      <a:pt x="420" y="9916"/>
                    </a:lnTo>
                    <a:lnTo>
                      <a:pt x="371" y="9782"/>
                    </a:lnTo>
                    <a:lnTo>
                      <a:pt x="338" y="9648"/>
                    </a:lnTo>
                    <a:lnTo>
                      <a:pt x="320" y="9514"/>
                    </a:lnTo>
                    <a:lnTo>
                      <a:pt x="312" y="9380"/>
                    </a:lnTo>
                    <a:lnTo>
                      <a:pt x="314" y="9246"/>
                    </a:lnTo>
                    <a:lnTo>
                      <a:pt x="323" y="9112"/>
                    </a:lnTo>
                    <a:lnTo>
                      <a:pt x="339" y="8978"/>
                    </a:lnTo>
                    <a:lnTo>
                      <a:pt x="359" y="8844"/>
                    </a:lnTo>
                    <a:lnTo>
                      <a:pt x="383" y="8710"/>
                    </a:lnTo>
                    <a:lnTo>
                      <a:pt x="405" y="8576"/>
                    </a:lnTo>
                    <a:lnTo>
                      <a:pt x="421" y="8442"/>
                    </a:lnTo>
                    <a:lnTo>
                      <a:pt x="426" y="8308"/>
                    </a:lnTo>
                    <a:lnTo>
                      <a:pt x="414" y="8174"/>
                    </a:lnTo>
                    <a:lnTo>
                      <a:pt x="383" y="8040"/>
                    </a:lnTo>
                    <a:lnTo>
                      <a:pt x="333" y="7906"/>
                    </a:lnTo>
                    <a:lnTo>
                      <a:pt x="268" y="7772"/>
                    </a:lnTo>
                    <a:lnTo>
                      <a:pt x="195" y="7638"/>
                    </a:lnTo>
                    <a:lnTo>
                      <a:pt x="123" y="7504"/>
                    </a:lnTo>
                    <a:lnTo>
                      <a:pt x="61" y="7370"/>
                    </a:lnTo>
                    <a:lnTo>
                      <a:pt x="18" y="7236"/>
                    </a:lnTo>
                    <a:lnTo>
                      <a:pt x="0" y="7102"/>
                    </a:lnTo>
                    <a:lnTo>
                      <a:pt x="7" y="6968"/>
                    </a:lnTo>
                    <a:lnTo>
                      <a:pt x="38" y="6834"/>
                    </a:lnTo>
                    <a:lnTo>
                      <a:pt x="87" y="6700"/>
                    </a:lnTo>
                    <a:lnTo>
                      <a:pt x="146" y="6566"/>
                    </a:lnTo>
                    <a:lnTo>
                      <a:pt x="209" y="6432"/>
                    </a:lnTo>
                    <a:lnTo>
                      <a:pt x="269" y="6298"/>
                    </a:lnTo>
                    <a:lnTo>
                      <a:pt x="320" y="6164"/>
                    </a:lnTo>
                    <a:lnTo>
                      <a:pt x="363" y="6030"/>
                    </a:lnTo>
                    <a:lnTo>
                      <a:pt x="397" y="5896"/>
                    </a:lnTo>
                    <a:lnTo>
                      <a:pt x="425" y="5762"/>
                    </a:lnTo>
                    <a:lnTo>
                      <a:pt x="452" y="5628"/>
                    </a:lnTo>
                    <a:lnTo>
                      <a:pt x="481" y="5494"/>
                    </a:lnTo>
                    <a:lnTo>
                      <a:pt x="517" y="5360"/>
                    </a:lnTo>
                    <a:lnTo>
                      <a:pt x="563" y="5226"/>
                    </a:lnTo>
                    <a:lnTo>
                      <a:pt x="621" y="5092"/>
                    </a:lnTo>
                    <a:lnTo>
                      <a:pt x="691" y="4958"/>
                    </a:lnTo>
                    <a:lnTo>
                      <a:pt x="773" y="4824"/>
                    </a:lnTo>
                    <a:lnTo>
                      <a:pt x="864" y="4690"/>
                    </a:lnTo>
                    <a:lnTo>
                      <a:pt x="959" y="4556"/>
                    </a:lnTo>
                    <a:lnTo>
                      <a:pt x="1055" y="4422"/>
                    </a:lnTo>
                    <a:lnTo>
                      <a:pt x="1145" y="4288"/>
                    </a:lnTo>
                    <a:lnTo>
                      <a:pt x="1227" y="4154"/>
                    </a:lnTo>
                    <a:lnTo>
                      <a:pt x="1295" y="4020"/>
                    </a:lnTo>
                    <a:lnTo>
                      <a:pt x="1348" y="3886"/>
                    </a:lnTo>
                    <a:lnTo>
                      <a:pt x="1387" y="3752"/>
                    </a:lnTo>
                    <a:lnTo>
                      <a:pt x="1412" y="3618"/>
                    </a:lnTo>
                    <a:lnTo>
                      <a:pt x="1427" y="3484"/>
                    </a:lnTo>
                    <a:lnTo>
                      <a:pt x="1437" y="3350"/>
                    </a:lnTo>
                    <a:lnTo>
                      <a:pt x="1445" y="3216"/>
                    </a:lnTo>
                    <a:lnTo>
                      <a:pt x="1454" y="3082"/>
                    </a:lnTo>
                    <a:lnTo>
                      <a:pt x="1467" y="2948"/>
                    </a:lnTo>
                    <a:lnTo>
                      <a:pt x="1483" y="2814"/>
                    </a:lnTo>
                    <a:lnTo>
                      <a:pt x="1501" y="2680"/>
                    </a:lnTo>
                    <a:lnTo>
                      <a:pt x="1518" y="2546"/>
                    </a:lnTo>
                    <a:lnTo>
                      <a:pt x="1532" y="2412"/>
                    </a:lnTo>
                    <a:lnTo>
                      <a:pt x="1539" y="2278"/>
                    </a:lnTo>
                    <a:lnTo>
                      <a:pt x="1540" y="2144"/>
                    </a:lnTo>
                    <a:lnTo>
                      <a:pt x="1533" y="2010"/>
                    </a:lnTo>
                    <a:lnTo>
                      <a:pt x="1522" y="1876"/>
                    </a:lnTo>
                    <a:lnTo>
                      <a:pt x="1509" y="1742"/>
                    </a:lnTo>
                    <a:lnTo>
                      <a:pt x="1498" y="1608"/>
                    </a:lnTo>
                    <a:lnTo>
                      <a:pt x="1493" y="1474"/>
                    </a:lnTo>
                    <a:lnTo>
                      <a:pt x="1496" y="1340"/>
                    </a:lnTo>
                    <a:lnTo>
                      <a:pt x="1510" y="1206"/>
                    </a:lnTo>
                    <a:lnTo>
                      <a:pt x="1534" y="1072"/>
                    </a:lnTo>
                    <a:lnTo>
                      <a:pt x="1566" y="938"/>
                    </a:lnTo>
                    <a:lnTo>
                      <a:pt x="1604" y="804"/>
                    </a:lnTo>
                    <a:lnTo>
                      <a:pt x="1644" y="670"/>
                    </a:lnTo>
                    <a:lnTo>
                      <a:pt x="1684" y="536"/>
                    </a:lnTo>
                    <a:lnTo>
                      <a:pt x="1721" y="402"/>
                    </a:lnTo>
                    <a:lnTo>
                      <a:pt x="1753" y="268"/>
                    </a:lnTo>
                    <a:lnTo>
                      <a:pt x="1780" y="134"/>
                    </a:lnTo>
                    <a:lnTo>
                      <a:pt x="1801" y="0"/>
                    </a:lnTo>
                    <a:lnTo>
                      <a:pt x="1892" y="0"/>
                    </a:lnTo>
                    <a:lnTo>
                      <a:pt x="1893" y="0"/>
                    </a:lnTo>
                    <a:lnTo>
                      <a:pt x="1913" y="134"/>
                    </a:lnTo>
                    <a:lnTo>
                      <a:pt x="1939" y="268"/>
                    </a:lnTo>
                    <a:lnTo>
                      <a:pt x="1971" y="402"/>
                    </a:lnTo>
                    <a:lnTo>
                      <a:pt x="2008" y="536"/>
                    </a:lnTo>
                    <a:lnTo>
                      <a:pt x="2048" y="670"/>
                    </a:lnTo>
                    <a:lnTo>
                      <a:pt x="2089" y="804"/>
                    </a:lnTo>
                    <a:lnTo>
                      <a:pt x="2126" y="938"/>
                    </a:lnTo>
                    <a:lnTo>
                      <a:pt x="2159" y="1072"/>
                    </a:lnTo>
                    <a:lnTo>
                      <a:pt x="2182" y="1206"/>
                    </a:lnTo>
                    <a:lnTo>
                      <a:pt x="2196" y="1340"/>
                    </a:lnTo>
                    <a:lnTo>
                      <a:pt x="2200" y="1474"/>
                    </a:lnTo>
                    <a:lnTo>
                      <a:pt x="2194" y="1608"/>
                    </a:lnTo>
                    <a:lnTo>
                      <a:pt x="2184" y="1742"/>
                    </a:lnTo>
                    <a:lnTo>
                      <a:pt x="2171" y="1876"/>
                    </a:lnTo>
                    <a:lnTo>
                      <a:pt x="2159" y="2010"/>
                    </a:lnTo>
                    <a:lnTo>
                      <a:pt x="2153" y="2144"/>
                    </a:lnTo>
                    <a:lnTo>
                      <a:pt x="2153" y="2278"/>
                    </a:lnTo>
                    <a:lnTo>
                      <a:pt x="2161" y="2412"/>
                    </a:lnTo>
                    <a:lnTo>
                      <a:pt x="2174" y="2546"/>
                    </a:lnTo>
                    <a:lnTo>
                      <a:pt x="2192" y="2680"/>
                    </a:lnTo>
                    <a:lnTo>
                      <a:pt x="2210" y="2814"/>
                    </a:lnTo>
                    <a:lnTo>
                      <a:pt x="2225" y="2948"/>
                    </a:lnTo>
                    <a:lnTo>
                      <a:pt x="2238" y="3082"/>
                    </a:lnTo>
                    <a:lnTo>
                      <a:pt x="2247" y="3216"/>
                    </a:lnTo>
                    <a:lnTo>
                      <a:pt x="2255" y="3350"/>
                    </a:lnTo>
                    <a:lnTo>
                      <a:pt x="2265" y="3484"/>
                    </a:lnTo>
                    <a:lnTo>
                      <a:pt x="2280" y="3618"/>
                    </a:lnTo>
                    <a:lnTo>
                      <a:pt x="2306" y="3752"/>
                    </a:lnTo>
                    <a:lnTo>
                      <a:pt x="2344" y="3886"/>
                    </a:lnTo>
                    <a:lnTo>
                      <a:pt x="2398" y="4020"/>
                    </a:lnTo>
                    <a:lnTo>
                      <a:pt x="2466" y="4154"/>
                    </a:lnTo>
                    <a:lnTo>
                      <a:pt x="2547" y="4288"/>
                    </a:lnTo>
                    <a:lnTo>
                      <a:pt x="2638" y="4422"/>
                    </a:lnTo>
                    <a:lnTo>
                      <a:pt x="2733" y="4556"/>
                    </a:lnTo>
                    <a:lnTo>
                      <a:pt x="2829" y="4690"/>
                    </a:lnTo>
                    <a:lnTo>
                      <a:pt x="2920" y="4824"/>
                    </a:lnTo>
                    <a:lnTo>
                      <a:pt x="3001" y="4958"/>
                    </a:lnTo>
                    <a:lnTo>
                      <a:pt x="3072" y="5092"/>
                    </a:lnTo>
                    <a:lnTo>
                      <a:pt x="3130" y="5226"/>
                    </a:lnTo>
                    <a:lnTo>
                      <a:pt x="3176" y="5360"/>
                    </a:lnTo>
                    <a:lnTo>
                      <a:pt x="3211" y="5494"/>
                    </a:lnTo>
                    <a:lnTo>
                      <a:pt x="3241" y="5628"/>
                    </a:lnTo>
                    <a:lnTo>
                      <a:pt x="3267" y="5762"/>
                    </a:lnTo>
                    <a:lnTo>
                      <a:pt x="3295" y="5896"/>
                    </a:lnTo>
                    <a:lnTo>
                      <a:pt x="3329" y="6030"/>
                    </a:lnTo>
                    <a:lnTo>
                      <a:pt x="3372" y="6164"/>
                    </a:lnTo>
                    <a:lnTo>
                      <a:pt x="3424" y="6298"/>
                    </a:lnTo>
                    <a:lnTo>
                      <a:pt x="3483" y="6432"/>
                    </a:lnTo>
                    <a:lnTo>
                      <a:pt x="3546" y="6566"/>
                    </a:lnTo>
                    <a:lnTo>
                      <a:pt x="3606" y="6700"/>
                    </a:lnTo>
                    <a:lnTo>
                      <a:pt x="3655" y="6834"/>
                    </a:lnTo>
                    <a:lnTo>
                      <a:pt x="3685" y="6968"/>
                    </a:lnTo>
                    <a:lnTo>
                      <a:pt x="3693" y="7102"/>
                    </a:lnTo>
                    <a:lnTo>
                      <a:pt x="3674" y="7236"/>
                    </a:lnTo>
                    <a:lnTo>
                      <a:pt x="3631" y="7370"/>
                    </a:lnTo>
                    <a:lnTo>
                      <a:pt x="3570" y="7504"/>
                    </a:lnTo>
                    <a:lnTo>
                      <a:pt x="3498" y="7638"/>
                    </a:lnTo>
                    <a:lnTo>
                      <a:pt x="3425" y="7772"/>
                    </a:lnTo>
                    <a:lnTo>
                      <a:pt x="3360" y="7906"/>
                    </a:lnTo>
                    <a:lnTo>
                      <a:pt x="3310" y="8040"/>
                    </a:lnTo>
                    <a:lnTo>
                      <a:pt x="3278" y="8174"/>
                    </a:lnTo>
                    <a:lnTo>
                      <a:pt x="3266" y="8308"/>
                    </a:lnTo>
                    <a:lnTo>
                      <a:pt x="3271" y="8442"/>
                    </a:lnTo>
                    <a:lnTo>
                      <a:pt x="3287" y="8576"/>
                    </a:lnTo>
                    <a:lnTo>
                      <a:pt x="3309" y="8710"/>
                    </a:lnTo>
                    <a:lnTo>
                      <a:pt x="3333" y="8844"/>
                    </a:lnTo>
                    <a:lnTo>
                      <a:pt x="3354" y="8978"/>
                    </a:lnTo>
                    <a:lnTo>
                      <a:pt x="3370" y="9112"/>
                    </a:lnTo>
                    <a:lnTo>
                      <a:pt x="3379" y="9246"/>
                    </a:lnTo>
                    <a:lnTo>
                      <a:pt x="3380" y="9380"/>
                    </a:lnTo>
                    <a:lnTo>
                      <a:pt x="3373" y="9514"/>
                    </a:lnTo>
                    <a:lnTo>
                      <a:pt x="3354" y="9648"/>
                    </a:lnTo>
                    <a:lnTo>
                      <a:pt x="3322" y="9782"/>
                    </a:lnTo>
                    <a:lnTo>
                      <a:pt x="3272" y="9916"/>
                    </a:lnTo>
                    <a:lnTo>
                      <a:pt x="3204" y="10051"/>
                    </a:lnTo>
                    <a:lnTo>
                      <a:pt x="3115" y="10185"/>
                    </a:lnTo>
                    <a:lnTo>
                      <a:pt x="3010" y="10319"/>
                    </a:lnTo>
                    <a:lnTo>
                      <a:pt x="2891" y="10453"/>
                    </a:lnTo>
                    <a:lnTo>
                      <a:pt x="2766" y="10587"/>
                    </a:lnTo>
                    <a:lnTo>
                      <a:pt x="2644" y="10721"/>
                    </a:lnTo>
                    <a:lnTo>
                      <a:pt x="2533" y="10855"/>
                    </a:lnTo>
                    <a:lnTo>
                      <a:pt x="2438" y="10989"/>
                    </a:lnTo>
                    <a:lnTo>
                      <a:pt x="2363" y="11123"/>
                    </a:lnTo>
                    <a:lnTo>
                      <a:pt x="2309" y="11257"/>
                    </a:lnTo>
                    <a:lnTo>
                      <a:pt x="2274" y="11391"/>
                    </a:lnTo>
                    <a:lnTo>
                      <a:pt x="2252" y="11525"/>
                    </a:lnTo>
                    <a:lnTo>
                      <a:pt x="2238" y="11659"/>
                    </a:lnTo>
                    <a:lnTo>
                      <a:pt x="2226" y="11793"/>
                    </a:lnTo>
                    <a:lnTo>
                      <a:pt x="2212" y="11927"/>
                    </a:lnTo>
                    <a:lnTo>
                      <a:pt x="2191" y="12061"/>
                    </a:lnTo>
                    <a:lnTo>
                      <a:pt x="2163" y="12195"/>
                    </a:lnTo>
                    <a:lnTo>
                      <a:pt x="2129" y="12329"/>
                    </a:lnTo>
                    <a:lnTo>
                      <a:pt x="2090" y="12463"/>
                    </a:lnTo>
                    <a:lnTo>
                      <a:pt x="2049" y="12597"/>
                    </a:lnTo>
                    <a:lnTo>
                      <a:pt x="2008" y="12731"/>
                    </a:lnTo>
                    <a:lnTo>
                      <a:pt x="1971" y="12865"/>
                    </a:lnTo>
                    <a:lnTo>
                      <a:pt x="1939" y="12999"/>
                    </a:lnTo>
                    <a:lnTo>
                      <a:pt x="1913" y="13133"/>
                    </a:lnTo>
                    <a:lnTo>
                      <a:pt x="1892" y="13267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5252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0" name="Freeform 164">
                <a:extLst>
                  <a:ext uri="{FF2B5EF4-FFF2-40B4-BE49-F238E27FC236}">
                    <a16:creationId xmlns:a16="http://schemas.microsoft.com/office/drawing/2014/main" id="{74F0E5B1-9DD7-1D7E-E2C1-89E6B971154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81513" y="3489325"/>
                <a:ext cx="946150" cy="1673225"/>
              </a:xfrm>
              <a:custGeom>
                <a:avLst/>
                <a:gdLst>
                  <a:gd name="T0" fmla="*/ 2607 w 5244"/>
                  <a:gd name="T1" fmla="*/ 9079 h 9266"/>
                  <a:gd name="T2" fmla="*/ 2557 w 5244"/>
                  <a:gd name="T3" fmla="*/ 8705 h 9266"/>
                  <a:gd name="T4" fmla="*/ 2429 w 5244"/>
                  <a:gd name="T5" fmla="*/ 8330 h 9266"/>
                  <a:gd name="T6" fmla="*/ 2150 w 5244"/>
                  <a:gd name="T7" fmla="*/ 7956 h 9266"/>
                  <a:gd name="T8" fmla="*/ 1654 w 5244"/>
                  <a:gd name="T9" fmla="*/ 7581 h 9266"/>
                  <a:gd name="T10" fmla="*/ 1033 w 5244"/>
                  <a:gd name="T11" fmla="*/ 7207 h 9266"/>
                  <a:gd name="T12" fmla="*/ 570 w 5244"/>
                  <a:gd name="T13" fmla="*/ 6833 h 9266"/>
                  <a:gd name="T14" fmla="*/ 411 w 5244"/>
                  <a:gd name="T15" fmla="*/ 6458 h 9266"/>
                  <a:gd name="T16" fmla="*/ 320 w 5244"/>
                  <a:gd name="T17" fmla="*/ 6084 h 9266"/>
                  <a:gd name="T18" fmla="*/ 135 w 5244"/>
                  <a:gd name="T19" fmla="*/ 5709 h 9266"/>
                  <a:gd name="T20" fmla="*/ 4 w 5244"/>
                  <a:gd name="T21" fmla="*/ 5335 h 9266"/>
                  <a:gd name="T22" fmla="*/ 68 w 5244"/>
                  <a:gd name="T23" fmla="*/ 4960 h 9266"/>
                  <a:gd name="T24" fmla="*/ 292 w 5244"/>
                  <a:gd name="T25" fmla="*/ 4586 h 9266"/>
                  <a:gd name="T26" fmla="*/ 548 w 5244"/>
                  <a:gd name="T27" fmla="*/ 4212 h 9266"/>
                  <a:gd name="T28" fmla="*/ 799 w 5244"/>
                  <a:gd name="T29" fmla="*/ 3837 h 9266"/>
                  <a:gd name="T30" fmla="*/ 1068 w 5244"/>
                  <a:gd name="T31" fmla="*/ 3463 h 9266"/>
                  <a:gd name="T32" fmla="*/ 1316 w 5244"/>
                  <a:gd name="T33" fmla="*/ 3088 h 9266"/>
                  <a:gd name="T34" fmla="*/ 1537 w 5244"/>
                  <a:gd name="T35" fmla="*/ 2714 h 9266"/>
                  <a:gd name="T36" fmla="*/ 1727 w 5244"/>
                  <a:gd name="T37" fmla="*/ 2340 h 9266"/>
                  <a:gd name="T38" fmla="*/ 1870 w 5244"/>
                  <a:gd name="T39" fmla="*/ 1965 h 9266"/>
                  <a:gd name="T40" fmla="*/ 2011 w 5244"/>
                  <a:gd name="T41" fmla="*/ 1591 h 9266"/>
                  <a:gd name="T42" fmla="*/ 2198 w 5244"/>
                  <a:gd name="T43" fmla="*/ 1216 h 9266"/>
                  <a:gd name="T44" fmla="*/ 2406 w 5244"/>
                  <a:gd name="T45" fmla="*/ 842 h 9266"/>
                  <a:gd name="T46" fmla="*/ 2552 w 5244"/>
                  <a:gd name="T47" fmla="*/ 468 h 9266"/>
                  <a:gd name="T48" fmla="*/ 2609 w 5244"/>
                  <a:gd name="T49" fmla="*/ 93 h 9266"/>
                  <a:gd name="T50" fmla="*/ 2635 w 5244"/>
                  <a:gd name="T51" fmla="*/ 93 h 9266"/>
                  <a:gd name="T52" fmla="*/ 2692 w 5244"/>
                  <a:gd name="T53" fmla="*/ 468 h 9266"/>
                  <a:gd name="T54" fmla="*/ 2838 w 5244"/>
                  <a:gd name="T55" fmla="*/ 842 h 9266"/>
                  <a:gd name="T56" fmla="*/ 3046 w 5244"/>
                  <a:gd name="T57" fmla="*/ 1216 h 9266"/>
                  <a:gd name="T58" fmla="*/ 3233 w 5244"/>
                  <a:gd name="T59" fmla="*/ 1591 h 9266"/>
                  <a:gd name="T60" fmla="*/ 3374 w 5244"/>
                  <a:gd name="T61" fmla="*/ 1965 h 9266"/>
                  <a:gd name="T62" fmla="*/ 3517 w 5244"/>
                  <a:gd name="T63" fmla="*/ 2340 h 9266"/>
                  <a:gd name="T64" fmla="*/ 3707 w 5244"/>
                  <a:gd name="T65" fmla="*/ 2714 h 9266"/>
                  <a:gd name="T66" fmla="*/ 3928 w 5244"/>
                  <a:gd name="T67" fmla="*/ 3088 h 9266"/>
                  <a:gd name="T68" fmla="*/ 4176 w 5244"/>
                  <a:gd name="T69" fmla="*/ 3463 h 9266"/>
                  <a:gd name="T70" fmla="*/ 4444 w 5244"/>
                  <a:gd name="T71" fmla="*/ 3837 h 9266"/>
                  <a:gd name="T72" fmla="*/ 4695 w 5244"/>
                  <a:gd name="T73" fmla="*/ 4212 h 9266"/>
                  <a:gd name="T74" fmla="*/ 4951 w 5244"/>
                  <a:gd name="T75" fmla="*/ 4586 h 9266"/>
                  <a:gd name="T76" fmla="*/ 5176 w 5244"/>
                  <a:gd name="T77" fmla="*/ 4960 h 9266"/>
                  <a:gd name="T78" fmla="*/ 5239 w 5244"/>
                  <a:gd name="T79" fmla="*/ 5335 h 9266"/>
                  <a:gd name="T80" fmla="*/ 5109 w 5244"/>
                  <a:gd name="T81" fmla="*/ 5709 h 9266"/>
                  <a:gd name="T82" fmla="*/ 4924 w 5244"/>
                  <a:gd name="T83" fmla="*/ 6084 h 9266"/>
                  <a:gd name="T84" fmla="*/ 4832 w 5244"/>
                  <a:gd name="T85" fmla="*/ 6458 h 9266"/>
                  <a:gd name="T86" fmla="*/ 4673 w 5244"/>
                  <a:gd name="T87" fmla="*/ 6833 h 9266"/>
                  <a:gd name="T88" fmla="*/ 4210 w 5244"/>
                  <a:gd name="T89" fmla="*/ 7207 h 9266"/>
                  <a:gd name="T90" fmla="*/ 3589 w 5244"/>
                  <a:gd name="T91" fmla="*/ 7581 h 9266"/>
                  <a:gd name="T92" fmla="*/ 3094 w 5244"/>
                  <a:gd name="T93" fmla="*/ 7956 h 9266"/>
                  <a:gd name="T94" fmla="*/ 2815 w 5244"/>
                  <a:gd name="T95" fmla="*/ 8330 h 9266"/>
                  <a:gd name="T96" fmla="*/ 2686 w 5244"/>
                  <a:gd name="T97" fmla="*/ 8705 h 9266"/>
                  <a:gd name="T98" fmla="*/ 2637 w 5244"/>
                  <a:gd name="T99" fmla="*/ 9079 h 92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5244" h="9266">
                    <a:moveTo>
                      <a:pt x="2628" y="9266"/>
                    </a:moveTo>
                    <a:lnTo>
                      <a:pt x="2616" y="9266"/>
                    </a:lnTo>
                    <a:lnTo>
                      <a:pt x="2612" y="9173"/>
                    </a:lnTo>
                    <a:lnTo>
                      <a:pt x="2607" y="9079"/>
                    </a:lnTo>
                    <a:lnTo>
                      <a:pt x="2599" y="8985"/>
                    </a:lnTo>
                    <a:lnTo>
                      <a:pt x="2589" y="8892"/>
                    </a:lnTo>
                    <a:lnTo>
                      <a:pt x="2575" y="8798"/>
                    </a:lnTo>
                    <a:lnTo>
                      <a:pt x="2557" y="8705"/>
                    </a:lnTo>
                    <a:lnTo>
                      <a:pt x="2534" y="8611"/>
                    </a:lnTo>
                    <a:lnTo>
                      <a:pt x="2506" y="8517"/>
                    </a:lnTo>
                    <a:lnTo>
                      <a:pt x="2471" y="8424"/>
                    </a:lnTo>
                    <a:lnTo>
                      <a:pt x="2429" y="8330"/>
                    </a:lnTo>
                    <a:lnTo>
                      <a:pt x="2377" y="8237"/>
                    </a:lnTo>
                    <a:lnTo>
                      <a:pt x="2314" y="8143"/>
                    </a:lnTo>
                    <a:lnTo>
                      <a:pt x="2238" y="8049"/>
                    </a:lnTo>
                    <a:lnTo>
                      <a:pt x="2150" y="7956"/>
                    </a:lnTo>
                    <a:lnTo>
                      <a:pt x="2046" y="7862"/>
                    </a:lnTo>
                    <a:lnTo>
                      <a:pt x="1929" y="7769"/>
                    </a:lnTo>
                    <a:lnTo>
                      <a:pt x="1797" y="7675"/>
                    </a:lnTo>
                    <a:lnTo>
                      <a:pt x="1654" y="7581"/>
                    </a:lnTo>
                    <a:lnTo>
                      <a:pt x="1502" y="7488"/>
                    </a:lnTo>
                    <a:lnTo>
                      <a:pt x="1344" y="7394"/>
                    </a:lnTo>
                    <a:lnTo>
                      <a:pt x="1186" y="7301"/>
                    </a:lnTo>
                    <a:lnTo>
                      <a:pt x="1033" y="7207"/>
                    </a:lnTo>
                    <a:lnTo>
                      <a:pt x="891" y="7113"/>
                    </a:lnTo>
                    <a:lnTo>
                      <a:pt x="764" y="7020"/>
                    </a:lnTo>
                    <a:lnTo>
                      <a:pt x="656" y="6926"/>
                    </a:lnTo>
                    <a:lnTo>
                      <a:pt x="570" y="6833"/>
                    </a:lnTo>
                    <a:lnTo>
                      <a:pt x="506" y="6739"/>
                    </a:lnTo>
                    <a:lnTo>
                      <a:pt x="461" y="6645"/>
                    </a:lnTo>
                    <a:lnTo>
                      <a:pt x="431" y="6552"/>
                    </a:lnTo>
                    <a:lnTo>
                      <a:pt x="411" y="6458"/>
                    </a:lnTo>
                    <a:lnTo>
                      <a:pt x="394" y="6364"/>
                    </a:lnTo>
                    <a:lnTo>
                      <a:pt x="376" y="6271"/>
                    </a:lnTo>
                    <a:lnTo>
                      <a:pt x="352" y="6177"/>
                    </a:lnTo>
                    <a:lnTo>
                      <a:pt x="320" y="6084"/>
                    </a:lnTo>
                    <a:lnTo>
                      <a:pt x="280" y="5990"/>
                    </a:lnTo>
                    <a:lnTo>
                      <a:pt x="234" y="5896"/>
                    </a:lnTo>
                    <a:lnTo>
                      <a:pt x="184" y="5803"/>
                    </a:lnTo>
                    <a:lnTo>
                      <a:pt x="135" y="5709"/>
                    </a:lnTo>
                    <a:lnTo>
                      <a:pt x="89" y="5616"/>
                    </a:lnTo>
                    <a:lnTo>
                      <a:pt x="50" y="5522"/>
                    </a:lnTo>
                    <a:lnTo>
                      <a:pt x="21" y="5428"/>
                    </a:lnTo>
                    <a:lnTo>
                      <a:pt x="4" y="5335"/>
                    </a:lnTo>
                    <a:lnTo>
                      <a:pt x="0" y="5241"/>
                    </a:lnTo>
                    <a:lnTo>
                      <a:pt x="9" y="5148"/>
                    </a:lnTo>
                    <a:lnTo>
                      <a:pt x="32" y="5054"/>
                    </a:lnTo>
                    <a:lnTo>
                      <a:pt x="68" y="4960"/>
                    </a:lnTo>
                    <a:lnTo>
                      <a:pt x="114" y="4867"/>
                    </a:lnTo>
                    <a:lnTo>
                      <a:pt x="168" y="4773"/>
                    </a:lnTo>
                    <a:lnTo>
                      <a:pt x="229" y="4680"/>
                    </a:lnTo>
                    <a:lnTo>
                      <a:pt x="292" y="4586"/>
                    </a:lnTo>
                    <a:lnTo>
                      <a:pt x="358" y="4492"/>
                    </a:lnTo>
                    <a:lnTo>
                      <a:pt x="422" y="4399"/>
                    </a:lnTo>
                    <a:lnTo>
                      <a:pt x="486" y="4305"/>
                    </a:lnTo>
                    <a:lnTo>
                      <a:pt x="548" y="4212"/>
                    </a:lnTo>
                    <a:lnTo>
                      <a:pt x="610" y="4118"/>
                    </a:lnTo>
                    <a:lnTo>
                      <a:pt x="672" y="4024"/>
                    </a:lnTo>
                    <a:lnTo>
                      <a:pt x="735" y="3931"/>
                    </a:lnTo>
                    <a:lnTo>
                      <a:pt x="799" y="3837"/>
                    </a:lnTo>
                    <a:lnTo>
                      <a:pt x="865" y="3744"/>
                    </a:lnTo>
                    <a:lnTo>
                      <a:pt x="933" y="3650"/>
                    </a:lnTo>
                    <a:lnTo>
                      <a:pt x="1001" y="3556"/>
                    </a:lnTo>
                    <a:lnTo>
                      <a:pt x="1068" y="3463"/>
                    </a:lnTo>
                    <a:lnTo>
                      <a:pt x="1133" y="3369"/>
                    </a:lnTo>
                    <a:lnTo>
                      <a:pt x="1196" y="3276"/>
                    </a:lnTo>
                    <a:lnTo>
                      <a:pt x="1257" y="3182"/>
                    </a:lnTo>
                    <a:lnTo>
                      <a:pt x="1316" y="3088"/>
                    </a:lnTo>
                    <a:lnTo>
                      <a:pt x="1373" y="2995"/>
                    </a:lnTo>
                    <a:lnTo>
                      <a:pt x="1428" y="2901"/>
                    </a:lnTo>
                    <a:lnTo>
                      <a:pt x="1483" y="2808"/>
                    </a:lnTo>
                    <a:lnTo>
                      <a:pt x="1537" y="2714"/>
                    </a:lnTo>
                    <a:lnTo>
                      <a:pt x="1588" y="2620"/>
                    </a:lnTo>
                    <a:lnTo>
                      <a:pt x="1638" y="2527"/>
                    </a:lnTo>
                    <a:lnTo>
                      <a:pt x="1684" y="2433"/>
                    </a:lnTo>
                    <a:lnTo>
                      <a:pt x="1727" y="2340"/>
                    </a:lnTo>
                    <a:lnTo>
                      <a:pt x="1766" y="2246"/>
                    </a:lnTo>
                    <a:lnTo>
                      <a:pt x="1803" y="2152"/>
                    </a:lnTo>
                    <a:lnTo>
                      <a:pt x="1837" y="2059"/>
                    </a:lnTo>
                    <a:lnTo>
                      <a:pt x="1870" y="1965"/>
                    </a:lnTo>
                    <a:lnTo>
                      <a:pt x="1903" y="1872"/>
                    </a:lnTo>
                    <a:lnTo>
                      <a:pt x="1937" y="1778"/>
                    </a:lnTo>
                    <a:lnTo>
                      <a:pt x="1972" y="1684"/>
                    </a:lnTo>
                    <a:lnTo>
                      <a:pt x="2011" y="1591"/>
                    </a:lnTo>
                    <a:lnTo>
                      <a:pt x="2053" y="1497"/>
                    </a:lnTo>
                    <a:lnTo>
                      <a:pt x="2098" y="1404"/>
                    </a:lnTo>
                    <a:lnTo>
                      <a:pt x="2146" y="1310"/>
                    </a:lnTo>
                    <a:lnTo>
                      <a:pt x="2198" y="1216"/>
                    </a:lnTo>
                    <a:lnTo>
                      <a:pt x="2251" y="1123"/>
                    </a:lnTo>
                    <a:lnTo>
                      <a:pt x="2304" y="1029"/>
                    </a:lnTo>
                    <a:lnTo>
                      <a:pt x="2356" y="936"/>
                    </a:lnTo>
                    <a:lnTo>
                      <a:pt x="2406" y="842"/>
                    </a:lnTo>
                    <a:lnTo>
                      <a:pt x="2451" y="748"/>
                    </a:lnTo>
                    <a:lnTo>
                      <a:pt x="2491" y="655"/>
                    </a:lnTo>
                    <a:lnTo>
                      <a:pt x="2525" y="561"/>
                    </a:lnTo>
                    <a:lnTo>
                      <a:pt x="2552" y="468"/>
                    </a:lnTo>
                    <a:lnTo>
                      <a:pt x="2573" y="374"/>
                    </a:lnTo>
                    <a:lnTo>
                      <a:pt x="2589" y="280"/>
                    </a:lnTo>
                    <a:lnTo>
                      <a:pt x="2601" y="187"/>
                    </a:lnTo>
                    <a:lnTo>
                      <a:pt x="2609" y="93"/>
                    </a:lnTo>
                    <a:lnTo>
                      <a:pt x="2614" y="0"/>
                    </a:lnTo>
                    <a:lnTo>
                      <a:pt x="2630" y="0"/>
                    </a:lnTo>
                    <a:lnTo>
                      <a:pt x="2631" y="0"/>
                    </a:lnTo>
                    <a:lnTo>
                      <a:pt x="2635" y="93"/>
                    </a:lnTo>
                    <a:lnTo>
                      <a:pt x="2643" y="187"/>
                    </a:lnTo>
                    <a:lnTo>
                      <a:pt x="2654" y="280"/>
                    </a:lnTo>
                    <a:lnTo>
                      <a:pt x="2670" y="374"/>
                    </a:lnTo>
                    <a:lnTo>
                      <a:pt x="2692" y="468"/>
                    </a:lnTo>
                    <a:lnTo>
                      <a:pt x="2719" y="561"/>
                    </a:lnTo>
                    <a:lnTo>
                      <a:pt x="2753" y="655"/>
                    </a:lnTo>
                    <a:lnTo>
                      <a:pt x="2792" y="748"/>
                    </a:lnTo>
                    <a:lnTo>
                      <a:pt x="2838" y="842"/>
                    </a:lnTo>
                    <a:lnTo>
                      <a:pt x="2887" y="936"/>
                    </a:lnTo>
                    <a:lnTo>
                      <a:pt x="2939" y="1029"/>
                    </a:lnTo>
                    <a:lnTo>
                      <a:pt x="2993" y="1123"/>
                    </a:lnTo>
                    <a:lnTo>
                      <a:pt x="3046" y="1216"/>
                    </a:lnTo>
                    <a:lnTo>
                      <a:pt x="3097" y="1310"/>
                    </a:lnTo>
                    <a:lnTo>
                      <a:pt x="3146" y="1404"/>
                    </a:lnTo>
                    <a:lnTo>
                      <a:pt x="3191" y="1497"/>
                    </a:lnTo>
                    <a:lnTo>
                      <a:pt x="3233" y="1591"/>
                    </a:lnTo>
                    <a:lnTo>
                      <a:pt x="3271" y="1684"/>
                    </a:lnTo>
                    <a:lnTo>
                      <a:pt x="3307" y="1778"/>
                    </a:lnTo>
                    <a:lnTo>
                      <a:pt x="3341" y="1872"/>
                    </a:lnTo>
                    <a:lnTo>
                      <a:pt x="3374" y="1965"/>
                    </a:lnTo>
                    <a:lnTo>
                      <a:pt x="3407" y="2059"/>
                    </a:lnTo>
                    <a:lnTo>
                      <a:pt x="3441" y="2152"/>
                    </a:lnTo>
                    <a:lnTo>
                      <a:pt x="3477" y="2246"/>
                    </a:lnTo>
                    <a:lnTo>
                      <a:pt x="3517" y="2340"/>
                    </a:lnTo>
                    <a:lnTo>
                      <a:pt x="3559" y="2433"/>
                    </a:lnTo>
                    <a:lnTo>
                      <a:pt x="3606" y="2527"/>
                    </a:lnTo>
                    <a:lnTo>
                      <a:pt x="3655" y="2620"/>
                    </a:lnTo>
                    <a:lnTo>
                      <a:pt x="3707" y="2714"/>
                    </a:lnTo>
                    <a:lnTo>
                      <a:pt x="3760" y="2808"/>
                    </a:lnTo>
                    <a:lnTo>
                      <a:pt x="3815" y="2901"/>
                    </a:lnTo>
                    <a:lnTo>
                      <a:pt x="3871" y="2995"/>
                    </a:lnTo>
                    <a:lnTo>
                      <a:pt x="3928" y="3088"/>
                    </a:lnTo>
                    <a:lnTo>
                      <a:pt x="3986" y="3182"/>
                    </a:lnTo>
                    <a:lnTo>
                      <a:pt x="4047" y="3276"/>
                    </a:lnTo>
                    <a:lnTo>
                      <a:pt x="4110" y="3369"/>
                    </a:lnTo>
                    <a:lnTo>
                      <a:pt x="4176" y="3463"/>
                    </a:lnTo>
                    <a:lnTo>
                      <a:pt x="4243" y="3556"/>
                    </a:lnTo>
                    <a:lnTo>
                      <a:pt x="4310" y="3650"/>
                    </a:lnTo>
                    <a:lnTo>
                      <a:pt x="4378" y="3744"/>
                    </a:lnTo>
                    <a:lnTo>
                      <a:pt x="4444" y="3837"/>
                    </a:lnTo>
                    <a:lnTo>
                      <a:pt x="4509" y="3931"/>
                    </a:lnTo>
                    <a:lnTo>
                      <a:pt x="4572" y="4024"/>
                    </a:lnTo>
                    <a:lnTo>
                      <a:pt x="4634" y="4118"/>
                    </a:lnTo>
                    <a:lnTo>
                      <a:pt x="4695" y="4212"/>
                    </a:lnTo>
                    <a:lnTo>
                      <a:pt x="4758" y="4305"/>
                    </a:lnTo>
                    <a:lnTo>
                      <a:pt x="4821" y="4399"/>
                    </a:lnTo>
                    <a:lnTo>
                      <a:pt x="4886" y="4492"/>
                    </a:lnTo>
                    <a:lnTo>
                      <a:pt x="4951" y="4586"/>
                    </a:lnTo>
                    <a:lnTo>
                      <a:pt x="5015" y="4680"/>
                    </a:lnTo>
                    <a:lnTo>
                      <a:pt x="5075" y="4773"/>
                    </a:lnTo>
                    <a:lnTo>
                      <a:pt x="5130" y="4867"/>
                    </a:lnTo>
                    <a:lnTo>
                      <a:pt x="5176" y="4960"/>
                    </a:lnTo>
                    <a:lnTo>
                      <a:pt x="5211" y="5054"/>
                    </a:lnTo>
                    <a:lnTo>
                      <a:pt x="5234" y="5148"/>
                    </a:lnTo>
                    <a:lnTo>
                      <a:pt x="5244" y="5241"/>
                    </a:lnTo>
                    <a:lnTo>
                      <a:pt x="5239" y="5335"/>
                    </a:lnTo>
                    <a:lnTo>
                      <a:pt x="5222" y="5428"/>
                    </a:lnTo>
                    <a:lnTo>
                      <a:pt x="5193" y="5522"/>
                    </a:lnTo>
                    <a:lnTo>
                      <a:pt x="5154" y="5616"/>
                    </a:lnTo>
                    <a:lnTo>
                      <a:pt x="5109" y="5709"/>
                    </a:lnTo>
                    <a:lnTo>
                      <a:pt x="5059" y="5803"/>
                    </a:lnTo>
                    <a:lnTo>
                      <a:pt x="5010" y="5896"/>
                    </a:lnTo>
                    <a:lnTo>
                      <a:pt x="4964" y="5990"/>
                    </a:lnTo>
                    <a:lnTo>
                      <a:pt x="4924" y="6084"/>
                    </a:lnTo>
                    <a:lnTo>
                      <a:pt x="4892" y="6177"/>
                    </a:lnTo>
                    <a:lnTo>
                      <a:pt x="4867" y="6271"/>
                    </a:lnTo>
                    <a:lnTo>
                      <a:pt x="4849" y="6364"/>
                    </a:lnTo>
                    <a:lnTo>
                      <a:pt x="4832" y="6458"/>
                    </a:lnTo>
                    <a:lnTo>
                      <a:pt x="4812" y="6552"/>
                    </a:lnTo>
                    <a:lnTo>
                      <a:pt x="4783" y="6645"/>
                    </a:lnTo>
                    <a:lnTo>
                      <a:pt x="4738" y="6739"/>
                    </a:lnTo>
                    <a:lnTo>
                      <a:pt x="4673" y="6833"/>
                    </a:lnTo>
                    <a:lnTo>
                      <a:pt x="4588" y="6926"/>
                    </a:lnTo>
                    <a:lnTo>
                      <a:pt x="4480" y="7020"/>
                    </a:lnTo>
                    <a:lnTo>
                      <a:pt x="4353" y="7113"/>
                    </a:lnTo>
                    <a:lnTo>
                      <a:pt x="4210" y="7207"/>
                    </a:lnTo>
                    <a:lnTo>
                      <a:pt x="4057" y="7301"/>
                    </a:lnTo>
                    <a:lnTo>
                      <a:pt x="3899" y="7394"/>
                    </a:lnTo>
                    <a:lnTo>
                      <a:pt x="3742" y="7488"/>
                    </a:lnTo>
                    <a:lnTo>
                      <a:pt x="3589" y="7581"/>
                    </a:lnTo>
                    <a:lnTo>
                      <a:pt x="3446" y="7675"/>
                    </a:lnTo>
                    <a:lnTo>
                      <a:pt x="3315" y="7769"/>
                    </a:lnTo>
                    <a:lnTo>
                      <a:pt x="3197" y="7862"/>
                    </a:lnTo>
                    <a:lnTo>
                      <a:pt x="3094" y="7956"/>
                    </a:lnTo>
                    <a:lnTo>
                      <a:pt x="3005" y="8049"/>
                    </a:lnTo>
                    <a:lnTo>
                      <a:pt x="2930" y="8143"/>
                    </a:lnTo>
                    <a:lnTo>
                      <a:pt x="2867" y="8237"/>
                    </a:lnTo>
                    <a:lnTo>
                      <a:pt x="2815" y="8330"/>
                    </a:lnTo>
                    <a:lnTo>
                      <a:pt x="2772" y="8424"/>
                    </a:lnTo>
                    <a:lnTo>
                      <a:pt x="2737" y="8517"/>
                    </a:lnTo>
                    <a:lnTo>
                      <a:pt x="2709" y="8611"/>
                    </a:lnTo>
                    <a:lnTo>
                      <a:pt x="2686" y="8705"/>
                    </a:lnTo>
                    <a:lnTo>
                      <a:pt x="2669" y="8798"/>
                    </a:lnTo>
                    <a:lnTo>
                      <a:pt x="2655" y="8892"/>
                    </a:lnTo>
                    <a:lnTo>
                      <a:pt x="2644" y="8985"/>
                    </a:lnTo>
                    <a:lnTo>
                      <a:pt x="2637" y="9079"/>
                    </a:lnTo>
                    <a:lnTo>
                      <a:pt x="2631" y="9173"/>
                    </a:lnTo>
                    <a:lnTo>
                      <a:pt x="2628" y="9266"/>
                    </a:lnTo>
                    <a:close/>
                  </a:path>
                </a:pathLst>
              </a:custGeom>
              <a:solidFill>
                <a:srgbClr val="B55D60"/>
              </a:solidFill>
              <a:ln w="14288" cap="flat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14288" cap="flat">
                    <a:solidFill>
                      <a:srgbClr val="525252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1" name="Freeform 165">
                <a:extLst>
                  <a:ext uri="{FF2B5EF4-FFF2-40B4-BE49-F238E27FC236}">
                    <a16:creationId xmlns:a16="http://schemas.microsoft.com/office/drawing/2014/main" id="{A22A1397-B2F5-B24B-9178-C15C08FC959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81513" y="3489325"/>
                <a:ext cx="946150" cy="1673225"/>
              </a:xfrm>
              <a:custGeom>
                <a:avLst/>
                <a:gdLst>
                  <a:gd name="T0" fmla="*/ 2607 w 5244"/>
                  <a:gd name="T1" fmla="*/ 9079 h 9266"/>
                  <a:gd name="T2" fmla="*/ 2557 w 5244"/>
                  <a:gd name="T3" fmla="*/ 8705 h 9266"/>
                  <a:gd name="T4" fmla="*/ 2429 w 5244"/>
                  <a:gd name="T5" fmla="*/ 8330 h 9266"/>
                  <a:gd name="T6" fmla="*/ 2150 w 5244"/>
                  <a:gd name="T7" fmla="*/ 7956 h 9266"/>
                  <a:gd name="T8" fmla="*/ 1654 w 5244"/>
                  <a:gd name="T9" fmla="*/ 7581 h 9266"/>
                  <a:gd name="T10" fmla="*/ 1033 w 5244"/>
                  <a:gd name="T11" fmla="*/ 7207 h 9266"/>
                  <a:gd name="T12" fmla="*/ 570 w 5244"/>
                  <a:gd name="T13" fmla="*/ 6833 h 9266"/>
                  <a:gd name="T14" fmla="*/ 411 w 5244"/>
                  <a:gd name="T15" fmla="*/ 6458 h 9266"/>
                  <a:gd name="T16" fmla="*/ 320 w 5244"/>
                  <a:gd name="T17" fmla="*/ 6084 h 9266"/>
                  <a:gd name="T18" fmla="*/ 135 w 5244"/>
                  <a:gd name="T19" fmla="*/ 5709 h 9266"/>
                  <a:gd name="T20" fmla="*/ 4 w 5244"/>
                  <a:gd name="T21" fmla="*/ 5335 h 9266"/>
                  <a:gd name="T22" fmla="*/ 68 w 5244"/>
                  <a:gd name="T23" fmla="*/ 4960 h 9266"/>
                  <a:gd name="T24" fmla="*/ 292 w 5244"/>
                  <a:gd name="T25" fmla="*/ 4586 h 9266"/>
                  <a:gd name="T26" fmla="*/ 548 w 5244"/>
                  <a:gd name="T27" fmla="*/ 4212 h 9266"/>
                  <a:gd name="T28" fmla="*/ 799 w 5244"/>
                  <a:gd name="T29" fmla="*/ 3837 h 9266"/>
                  <a:gd name="T30" fmla="*/ 1068 w 5244"/>
                  <a:gd name="T31" fmla="*/ 3463 h 9266"/>
                  <a:gd name="T32" fmla="*/ 1316 w 5244"/>
                  <a:gd name="T33" fmla="*/ 3088 h 9266"/>
                  <a:gd name="T34" fmla="*/ 1537 w 5244"/>
                  <a:gd name="T35" fmla="*/ 2714 h 9266"/>
                  <a:gd name="T36" fmla="*/ 1727 w 5244"/>
                  <a:gd name="T37" fmla="*/ 2340 h 9266"/>
                  <a:gd name="T38" fmla="*/ 1870 w 5244"/>
                  <a:gd name="T39" fmla="*/ 1965 h 9266"/>
                  <a:gd name="T40" fmla="*/ 2011 w 5244"/>
                  <a:gd name="T41" fmla="*/ 1591 h 9266"/>
                  <a:gd name="T42" fmla="*/ 2198 w 5244"/>
                  <a:gd name="T43" fmla="*/ 1216 h 9266"/>
                  <a:gd name="T44" fmla="*/ 2406 w 5244"/>
                  <a:gd name="T45" fmla="*/ 842 h 9266"/>
                  <a:gd name="T46" fmla="*/ 2552 w 5244"/>
                  <a:gd name="T47" fmla="*/ 468 h 9266"/>
                  <a:gd name="T48" fmla="*/ 2609 w 5244"/>
                  <a:gd name="T49" fmla="*/ 93 h 9266"/>
                  <a:gd name="T50" fmla="*/ 2635 w 5244"/>
                  <a:gd name="T51" fmla="*/ 93 h 9266"/>
                  <a:gd name="T52" fmla="*/ 2692 w 5244"/>
                  <a:gd name="T53" fmla="*/ 468 h 9266"/>
                  <a:gd name="T54" fmla="*/ 2838 w 5244"/>
                  <a:gd name="T55" fmla="*/ 842 h 9266"/>
                  <a:gd name="T56" fmla="*/ 3046 w 5244"/>
                  <a:gd name="T57" fmla="*/ 1216 h 9266"/>
                  <a:gd name="T58" fmla="*/ 3233 w 5244"/>
                  <a:gd name="T59" fmla="*/ 1591 h 9266"/>
                  <a:gd name="T60" fmla="*/ 3374 w 5244"/>
                  <a:gd name="T61" fmla="*/ 1965 h 9266"/>
                  <a:gd name="T62" fmla="*/ 3517 w 5244"/>
                  <a:gd name="T63" fmla="*/ 2340 h 9266"/>
                  <a:gd name="T64" fmla="*/ 3707 w 5244"/>
                  <a:gd name="T65" fmla="*/ 2714 h 9266"/>
                  <a:gd name="T66" fmla="*/ 3928 w 5244"/>
                  <a:gd name="T67" fmla="*/ 3088 h 9266"/>
                  <a:gd name="T68" fmla="*/ 4176 w 5244"/>
                  <a:gd name="T69" fmla="*/ 3463 h 9266"/>
                  <a:gd name="T70" fmla="*/ 4444 w 5244"/>
                  <a:gd name="T71" fmla="*/ 3837 h 9266"/>
                  <a:gd name="T72" fmla="*/ 4695 w 5244"/>
                  <a:gd name="T73" fmla="*/ 4212 h 9266"/>
                  <a:gd name="T74" fmla="*/ 4951 w 5244"/>
                  <a:gd name="T75" fmla="*/ 4586 h 9266"/>
                  <a:gd name="T76" fmla="*/ 5176 w 5244"/>
                  <a:gd name="T77" fmla="*/ 4960 h 9266"/>
                  <a:gd name="T78" fmla="*/ 5239 w 5244"/>
                  <a:gd name="T79" fmla="*/ 5335 h 9266"/>
                  <a:gd name="T80" fmla="*/ 5109 w 5244"/>
                  <a:gd name="T81" fmla="*/ 5709 h 9266"/>
                  <a:gd name="T82" fmla="*/ 4924 w 5244"/>
                  <a:gd name="T83" fmla="*/ 6084 h 9266"/>
                  <a:gd name="T84" fmla="*/ 4832 w 5244"/>
                  <a:gd name="T85" fmla="*/ 6458 h 9266"/>
                  <a:gd name="T86" fmla="*/ 4673 w 5244"/>
                  <a:gd name="T87" fmla="*/ 6833 h 9266"/>
                  <a:gd name="T88" fmla="*/ 4210 w 5244"/>
                  <a:gd name="T89" fmla="*/ 7207 h 9266"/>
                  <a:gd name="T90" fmla="*/ 3589 w 5244"/>
                  <a:gd name="T91" fmla="*/ 7581 h 9266"/>
                  <a:gd name="T92" fmla="*/ 3094 w 5244"/>
                  <a:gd name="T93" fmla="*/ 7956 h 9266"/>
                  <a:gd name="T94" fmla="*/ 2815 w 5244"/>
                  <a:gd name="T95" fmla="*/ 8330 h 9266"/>
                  <a:gd name="T96" fmla="*/ 2686 w 5244"/>
                  <a:gd name="T97" fmla="*/ 8705 h 9266"/>
                  <a:gd name="T98" fmla="*/ 2637 w 5244"/>
                  <a:gd name="T99" fmla="*/ 9079 h 92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5244" h="9266">
                    <a:moveTo>
                      <a:pt x="2628" y="9266"/>
                    </a:moveTo>
                    <a:lnTo>
                      <a:pt x="2616" y="9266"/>
                    </a:lnTo>
                    <a:lnTo>
                      <a:pt x="2612" y="9173"/>
                    </a:lnTo>
                    <a:lnTo>
                      <a:pt x="2607" y="9079"/>
                    </a:lnTo>
                    <a:lnTo>
                      <a:pt x="2599" y="8985"/>
                    </a:lnTo>
                    <a:lnTo>
                      <a:pt x="2589" y="8892"/>
                    </a:lnTo>
                    <a:lnTo>
                      <a:pt x="2575" y="8798"/>
                    </a:lnTo>
                    <a:lnTo>
                      <a:pt x="2557" y="8705"/>
                    </a:lnTo>
                    <a:lnTo>
                      <a:pt x="2534" y="8611"/>
                    </a:lnTo>
                    <a:lnTo>
                      <a:pt x="2506" y="8517"/>
                    </a:lnTo>
                    <a:lnTo>
                      <a:pt x="2471" y="8424"/>
                    </a:lnTo>
                    <a:lnTo>
                      <a:pt x="2429" y="8330"/>
                    </a:lnTo>
                    <a:lnTo>
                      <a:pt x="2377" y="8237"/>
                    </a:lnTo>
                    <a:lnTo>
                      <a:pt x="2314" y="8143"/>
                    </a:lnTo>
                    <a:lnTo>
                      <a:pt x="2238" y="8049"/>
                    </a:lnTo>
                    <a:lnTo>
                      <a:pt x="2150" y="7956"/>
                    </a:lnTo>
                    <a:lnTo>
                      <a:pt x="2046" y="7862"/>
                    </a:lnTo>
                    <a:lnTo>
                      <a:pt x="1929" y="7769"/>
                    </a:lnTo>
                    <a:lnTo>
                      <a:pt x="1797" y="7675"/>
                    </a:lnTo>
                    <a:lnTo>
                      <a:pt x="1654" y="7581"/>
                    </a:lnTo>
                    <a:lnTo>
                      <a:pt x="1502" y="7488"/>
                    </a:lnTo>
                    <a:lnTo>
                      <a:pt x="1344" y="7394"/>
                    </a:lnTo>
                    <a:lnTo>
                      <a:pt x="1186" y="7301"/>
                    </a:lnTo>
                    <a:lnTo>
                      <a:pt x="1033" y="7207"/>
                    </a:lnTo>
                    <a:lnTo>
                      <a:pt x="891" y="7113"/>
                    </a:lnTo>
                    <a:lnTo>
                      <a:pt x="764" y="7020"/>
                    </a:lnTo>
                    <a:lnTo>
                      <a:pt x="656" y="6926"/>
                    </a:lnTo>
                    <a:lnTo>
                      <a:pt x="570" y="6833"/>
                    </a:lnTo>
                    <a:lnTo>
                      <a:pt x="506" y="6739"/>
                    </a:lnTo>
                    <a:lnTo>
                      <a:pt x="461" y="6645"/>
                    </a:lnTo>
                    <a:lnTo>
                      <a:pt x="431" y="6552"/>
                    </a:lnTo>
                    <a:lnTo>
                      <a:pt x="411" y="6458"/>
                    </a:lnTo>
                    <a:lnTo>
                      <a:pt x="394" y="6364"/>
                    </a:lnTo>
                    <a:lnTo>
                      <a:pt x="376" y="6271"/>
                    </a:lnTo>
                    <a:lnTo>
                      <a:pt x="352" y="6177"/>
                    </a:lnTo>
                    <a:lnTo>
                      <a:pt x="320" y="6084"/>
                    </a:lnTo>
                    <a:lnTo>
                      <a:pt x="280" y="5990"/>
                    </a:lnTo>
                    <a:lnTo>
                      <a:pt x="234" y="5896"/>
                    </a:lnTo>
                    <a:lnTo>
                      <a:pt x="184" y="5803"/>
                    </a:lnTo>
                    <a:lnTo>
                      <a:pt x="135" y="5709"/>
                    </a:lnTo>
                    <a:lnTo>
                      <a:pt x="89" y="5616"/>
                    </a:lnTo>
                    <a:lnTo>
                      <a:pt x="50" y="5522"/>
                    </a:lnTo>
                    <a:lnTo>
                      <a:pt x="21" y="5428"/>
                    </a:lnTo>
                    <a:lnTo>
                      <a:pt x="4" y="5335"/>
                    </a:lnTo>
                    <a:lnTo>
                      <a:pt x="0" y="5241"/>
                    </a:lnTo>
                    <a:lnTo>
                      <a:pt x="9" y="5148"/>
                    </a:lnTo>
                    <a:lnTo>
                      <a:pt x="32" y="5054"/>
                    </a:lnTo>
                    <a:lnTo>
                      <a:pt x="68" y="4960"/>
                    </a:lnTo>
                    <a:lnTo>
                      <a:pt x="114" y="4867"/>
                    </a:lnTo>
                    <a:lnTo>
                      <a:pt x="168" y="4773"/>
                    </a:lnTo>
                    <a:lnTo>
                      <a:pt x="229" y="4680"/>
                    </a:lnTo>
                    <a:lnTo>
                      <a:pt x="292" y="4586"/>
                    </a:lnTo>
                    <a:lnTo>
                      <a:pt x="358" y="4492"/>
                    </a:lnTo>
                    <a:lnTo>
                      <a:pt x="422" y="4399"/>
                    </a:lnTo>
                    <a:lnTo>
                      <a:pt x="486" y="4305"/>
                    </a:lnTo>
                    <a:lnTo>
                      <a:pt x="548" y="4212"/>
                    </a:lnTo>
                    <a:lnTo>
                      <a:pt x="610" y="4118"/>
                    </a:lnTo>
                    <a:lnTo>
                      <a:pt x="672" y="4024"/>
                    </a:lnTo>
                    <a:lnTo>
                      <a:pt x="735" y="3931"/>
                    </a:lnTo>
                    <a:lnTo>
                      <a:pt x="799" y="3837"/>
                    </a:lnTo>
                    <a:lnTo>
                      <a:pt x="865" y="3744"/>
                    </a:lnTo>
                    <a:lnTo>
                      <a:pt x="933" y="3650"/>
                    </a:lnTo>
                    <a:lnTo>
                      <a:pt x="1001" y="3556"/>
                    </a:lnTo>
                    <a:lnTo>
                      <a:pt x="1068" y="3463"/>
                    </a:lnTo>
                    <a:lnTo>
                      <a:pt x="1133" y="3369"/>
                    </a:lnTo>
                    <a:lnTo>
                      <a:pt x="1196" y="3276"/>
                    </a:lnTo>
                    <a:lnTo>
                      <a:pt x="1257" y="3182"/>
                    </a:lnTo>
                    <a:lnTo>
                      <a:pt x="1316" y="3088"/>
                    </a:lnTo>
                    <a:lnTo>
                      <a:pt x="1373" y="2995"/>
                    </a:lnTo>
                    <a:lnTo>
                      <a:pt x="1428" y="2901"/>
                    </a:lnTo>
                    <a:lnTo>
                      <a:pt x="1483" y="2808"/>
                    </a:lnTo>
                    <a:lnTo>
                      <a:pt x="1537" y="2714"/>
                    </a:lnTo>
                    <a:lnTo>
                      <a:pt x="1588" y="2620"/>
                    </a:lnTo>
                    <a:lnTo>
                      <a:pt x="1638" y="2527"/>
                    </a:lnTo>
                    <a:lnTo>
                      <a:pt x="1684" y="2433"/>
                    </a:lnTo>
                    <a:lnTo>
                      <a:pt x="1727" y="2340"/>
                    </a:lnTo>
                    <a:lnTo>
                      <a:pt x="1766" y="2246"/>
                    </a:lnTo>
                    <a:lnTo>
                      <a:pt x="1803" y="2152"/>
                    </a:lnTo>
                    <a:lnTo>
                      <a:pt x="1837" y="2059"/>
                    </a:lnTo>
                    <a:lnTo>
                      <a:pt x="1870" y="1965"/>
                    </a:lnTo>
                    <a:lnTo>
                      <a:pt x="1903" y="1872"/>
                    </a:lnTo>
                    <a:lnTo>
                      <a:pt x="1937" y="1778"/>
                    </a:lnTo>
                    <a:lnTo>
                      <a:pt x="1972" y="1684"/>
                    </a:lnTo>
                    <a:lnTo>
                      <a:pt x="2011" y="1591"/>
                    </a:lnTo>
                    <a:lnTo>
                      <a:pt x="2053" y="1497"/>
                    </a:lnTo>
                    <a:lnTo>
                      <a:pt x="2098" y="1404"/>
                    </a:lnTo>
                    <a:lnTo>
                      <a:pt x="2146" y="1310"/>
                    </a:lnTo>
                    <a:lnTo>
                      <a:pt x="2198" y="1216"/>
                    </a:lnTo>
                    <a:lnTo>
                      <a:pt x="2251" y="1123"/>
                    </a:lnTo>
                    <a:lnTo>
                      <a:pt x="2304" y="1029"/>
                    </a:lnTo>
                    <a:lnTo>
                      <a:pt x="2356" y="936"/>
                    </a:lnTo>
                    <a:lnTo>
                      <a:pt x="2406" y="842"/>
                    </a:lnTo>
                    <a:lnTo>
                      <a:pt x="2451" y="748"/>
                    </a:lnTo>
                    <a:lnTo>
                      <a:pt x="2491" y="655"/>
                    </a:lnTo>
                    <a:lnTo>
                      <a:pt x="2525" y="561"/>
                    </a:lnTo>
                    <a:lnTo>
                      <a:pt x="2552" y="468"/>
                    </a:lnTo>
                    <a:lnTo>
                      <a:pt x="2573" y="374"/>
                    </a:lnTo>
                    <a:lnTo>
                      <a:pt x="2589" y="280"/>
                    </a:lnTo>
                    <a:lnTo>
                      <a:pt x="2601" y="187"/>
                    </a:lnTo>
                    <a:lnTo>
                      <a:pt x="2609" y="93"/>
                    </a:lnTo>
                    <a:lnTo>
                      <a:pt x="2614" y="0"/>
                    </a:lnTo>
                    <a:lnTo>
                      <a:pt x="2630" y="0"/>
                    </a:lnTo>
                    <a:lnTo>
                      <a:pt x="2631" y="0"/>
                    </a:lnTo>
                    <a:lnTo>
                      <a:pt x="2635" y="93"/>
                    </a:lnTo>
                    <a:lnTo>
                      <a:pt x="2643" y="187"/>
                    </a:lnTo>
                    <a:lnTo>
                      <a:pt x="2654" y="280"/>
                    </a:lnTo>
                    <a:lnTo>
                      <a:pt x="2670" y="374"/>
                    </a:lnTo>
                    <a:lnTo>
                      <a:pt x="2692" y="468"/>
                    </a:lnTo>
                    <a:lnTo>
                      <a:pt x="2719" y="561"/>
                    </a:lnTo>
                    <a:lnTo>
                      <a:pt x="2753" y="655"/>
                    </a:lnTo>
                    <a:lnTo>
                      <a:pt x="2792" y="748"/>
                    </a:lnTo>
                    <a:lnTo>
                      <a:pt x="2838" y="842"/>
                    </a:lnTo>
                    <a:lnTo>
                      <a:pt x="2887" y="936"/>
                    </a:lnTo>
                    <a:lnTo>
                      <a:pt x="2939" y="1029"/>
                    </a:lnTo>
                    <a:lnTo>
                      <a:pt x="2993" y="1123"/>
                    </a:lnTo>
                    <a:lnTo>
                      <a:pt x="3046" y="1216"/>
                    </a:lnTo>
                    <a:lnTo>
                      <a:pt x="3097" y="1310"/>
                    </a:lnTo>
                    <a:lnTo>
                      <a:pt x="3146" y="1404"/>
                    </a:lnTo>
                    <a:lnTo>
                      <a:pt x="3191" y="1497"/>
                    </a:lnTo>
                    <a:lnTo>
                      <a:pt x="3233" y="1591"/>
                    </a:lnTo>
                    <a:lnTo>
                      <a:pt x="3271" y="1684"/>
                    </a:lnTo>
                    <a:lnTo>
                      <a:pt x="3307" y="1778"/>
                    </a:lnTo>
                    <a:lnTo>
                      <a:pt x="3341" y="1872"/>
                    </a:lnTo>
                    <a:lnTo>
                      <a:pt x="3374" y="1965"/>
                    </a:lnTo>
                    <a:lnTo>
                      <a:pt x="3407" y="2059"/>
                    </a:lnTo>
                    <a:lnTo>
                      <a:pt x="3441" y="2152"/>
                    </a:lnTo>
                    <a:lnTo>
                      <a:pt x="3477" y="2246"/>
                    </a:lnTo>
                    <a:lnTo>
                      <a:pt x="3517" y="2340"/>
                    </a:lnTo>
                    <a:lnTo>
                      <a:pt x="3559" y="2433"/>
                    </a:lnTo>
                    <a:lnTo>
                      <a:pt x="3606" y="2527"/>
                    </a:lnTo>
                    <a:lnTo>
                      <a:pt x="3655" y="2620"/>
                    </a:lnTo>
                    <a:lnTo>
                      <a:pt x="3707" y="2714"/>
                    </a:lnTo>
                    <a:lnTo>
                      <a:pt x="3760" y="2808"/>
                    </a:lnTo>
                    <a:lnTo>
                      <a:pt x="3815" y="2901"/>
                    </a:lnTo>
                    <a:lnTo>
                      <a:pt x="3871" y="2995"/>
                    </a:lnTo>
                    <a:lnTo>
                      <a:pt x="3928" y="3088"/>
                    </a:lnTo>
                    <a:lnTo>
                      <a:pt x="3986" y="3182"/>
                    </a:lnTo>
                    <a:lnTo>
                      <a:pt x="4047" y="3276"/>
                    </a:lnTo>
                    <a:lnTo>
                      <a:pt x="4110" y="3369"/>
                    </a:lnTo>
                    <a:lnTo>
                      <a:pt x="4176" y="3463"/>
                    </a:lnTo>
                    <a:lnTo>
                      <a:pt x="4243" y="3556"/>
                    </a:lnTo>
                    <a:lnTo>
                      <a:pt x="4310" y="3650"/>
                    </a:lnTo>
                    <a:lnTo>
                      <a:pt x="4378" y="3744"/>
                    </a:lnTo>
                    <a:lnTo>
                      <a:pt x="4444" y="3837"/>
                    </a:lnTo>
                    <a:lnTo>
                      <a:pt x="4509" y="3931"/>
                    </a:lnTo>
                    <a:lnTo>
                      <a:pt x="4572" y="4024"/>
                    </a:lnTo>
                    <a:lnTo>
                      <a:pt x="4634" y="4118"/>
                    </a:lnTo>
                    <a:lnTo>
                      <a:pt x="4695" y="4212"/>
                    </a:lnTo>
                    <a:lnTo>
                      <a:pt x="4758" y="4305"/>
                    </a:lnTo>
                    <a:lnTo>
                      <a:pt x="4821" y="4399"/>
                    </a:lnTo>
                    <a:lnTo>
                      <a:pt x="4886" y="4492"/>
                    </a:lnTo>
                    <a:lnTo>
                      <a:pt x="4951" y="4586"/>
                    </a:lnTo>
                    <a:lnTo>
                      <a:pt x="5015" y="4680"/>
                    </a:lnTo>
                    <a:lnTo>
                      <a:pt x="5075" y="4773"/>
                    </a:lnTo>
                    <a:lnTo>
                      <a:pt x="5130" y="4867"/>
                    </a:lnTo>
                    <a:lnTo>
                      <a:pt x="5176" y="4960"/>
                    </a:lnTo>
                    <a:lnTo>
                      <a:pt x="5211" y="5054"/>
                    </a:lnTo>
                    <a:lnTo>
                      <a:pt x="5234" y="5148"/>
                    </a:lnTo>
                    <a:lnTo>
                      <a:pt x="5244" y="5241"/>
                    </a:lnTo>
                    <a:lnTo>
                      <a:pt x="5239" y="5335"/>
                    </a:lnTo>
                    <a:lnTo>
                      <a:pt x="5222" y="5428"/>
                    </a:lnTo>
                    <a:lnTo>
                      <a:pt x="5193" y="5522"/>
                    </a:lnTo>
                    <a:lnTo>
                      <a:pt x="5154" y="5616"/>
                    </a:lnTo>
                    <a:lnTo>
                      <a:pt x="5109" y="5709"/>
                    </a:lnTo>
                    <a:lnTo>
                      <a:pt x="5059" y="5803"/>
                    </a:lnTo>
                    <a:lnTo>
                      <a:pt x="5010" y="5896"/>
                    </a:lnTo>
                    <a:lnTo>
                      <a:pt x="4964" y="5990"/>
                    </a:lnTo>
                    <a:lnTo>
                      <a:pt x="4924" y="6084"/>
                    </a:lnTo>
                    <a:lnTo>
                      <a:pt x="4892" y="6177"/>
                    </a:lnTo>
                    <a:lnTo>
                      <a:pt x="4867" y="6271"/>
                    </a:lnTo>
                    <a:lnTo>
                      <a:pt x="4849" y="6364"/>
                    </a:lnTo>
                    <a:lnTo>
                      <a:pt x="4832" y="6458"/>
                    </a:lnTo>
                    <a:lnTo>
                      <a:pt x="4812" y="6552"/>
                    </a:lnTo>
                    <a:lnTo>
                      <a:pt x="4783" y="6645"/>
                    </a:lnTo>
                    <a:lnTo>
                      <a:pt x="4738" y="6739"/>
                    </a:lnTo>
                    <a:lnTo>
                      <a:pt x="4673" y="6833"/>
                    </a:lnTo>
                    <a:lnTo>
                      <a:pt x="4588" y="6926"/>
                    </a:lnTo>
                    <a:lnTo>
                      <a:pt x="4480" y="7020"/>
                    </a:lnTo>
                    <a:lnTo>
                      <a:pt x="4353" y="7113"/>
                    </a:lnTo>
                    <a:lnTo>
                      <a:pt x="4210" y="7207"/>
                    </a:lnTo>
                    <a:lnTo>
                      <a:pt x="4057" y="7301"/>
                    </a:lnTo>
                    <a:lnTo>
                      <a:pt x="3899" y="7394"/>
                    </a:lnTo>
                    <a:lnTo>
                      <a:pt x="3742" y="7488"/>
                    </a:lnTo>
                    <a:lnTo>
                      <a:pt x="3589" y="7581"/>
                    </a:lnTo>
                    <a:lnTo>
                      <a:pt x="3446" y="7675"/>
                    </a:lnTo>
                    <a:lnTo>
                      <a:pt x="3315" y="7769"/>
                    </a:lnTo>
                    <a:lnTo>
                      <a:pt x="3197" y="7862"/>
                    </a:lnTo>
                    <a:lnTo>
                      <a:pt x="3094" y="7956"/>
                    </a:lnTo>
                    <a:lnTo>
                      <a:pt x="3005" y="8049"/>
                    </a:lnTo>
                    <a:lnTo>
                      <a:pt x="2930" y="8143"/>
                    </a:lnTo>
                    <a:lnTo>
                      <a:pt x="2867" y="8237"/>
                    </a:lnTo>
                    <a:lnTo>
                      <a:pt x="2815" y="8330"/>
                    </a:lnTo>
                    <a:lnTo>
                      <a:pt x="2772" y="8424"/>
                    </a:lnTo>
                    <a:lnTo>
                      <a:pt x="2737" y="8517"/>
                    </a:lnTo>
                    <a:lnTo>
                      <a:pt x="2709" y="8611"/>
                    </a:lnTo>
                    <a:lnTo>
                      <a:pt x="2686" y="8705"/>
                    </a:lnTo>
                    <a:lnTo>
                      <a:pt x="2669" y="8798"/>
                    </a:lnTo>
                    <a:lnTo>
                      <a:pt x="2655" y="8892"/>
                    </a:lnTo>
                    <a:lnTo>
                      <a:pt x="2644" y="8985"/>
                    </a:lnTo>
                    <a:lnTo>
                      <a:pt x="2637" y="9079"/>
                    </a:lnTo>
                    <a:lnTo>
                      <a:pt x="2631" y="9173"/>
                    </a:lnTo>
                    <a:lnTo>
                      <a:pt x="2628" y="9266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5252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2" name="Line 166">
                <a:extLst>
                  <a:ext uri="{FF2B5EF4-FFF2-40B4-BE49-F238E27FC236}">
                    <a16:creationId xmlns:a16="http://schemas.microsoft.com/office/drawing/2014/main" id="{77C4A51C-86E7-D2CA-B3BB-BC68534CA4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71900" y="2909888"/>
                <a:ext cx="0" cy="1903413"/>
              </a:xfrm>
              <a:prstGeom prst="line">
                <a:avLst/>
              </a:prstGeom>
              <a:noFill/>
              <a:ln w="6350" cap="rnd">
                <a:solidFill>
                  <a:srgbClr val="5252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3" name="Line 167">
                <a:extLst>
                  <a:ext uri="{FF2B5EF4-FFF2-40B4-BE49-F238E27FC236}">
                    <a16:creationId xmlns:a16="http://schemas.microsoft.com/office/drawing/2014/main" id="{39D275F7-B060-7AD6-86E9-CB733546A0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71900" y="3706813"/>
                <a:ext cx="0" cy="595313"/>
              </a:xfrm>
              <a:prstGeom prst="line">
                <a:avLst/>
              </a:prstGeom>
              <a:noFill/>
              <a:ln w="19050" cap="rnd">
                <a:solidFill>
                  <a:srgbClr val="5252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4" name="Line 168">
                <a:extLst>
                  <a:ext uri="{FF2B5EF4-FFF2-40B4-BE49-F238E27FC236}">
                    <a16:creationId xmlns:a16="http://schemas.microsoft.com/office/drawing/2014/main" id="{A8AE7AFA-45CF-A7CC-F0C2-2F0E1CE0D4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54588" y="3648075"/>
                <a:ext cx="0" cy="1355725"/>
              </a:xfrm>
              <a:prstGeom prst="line">
                <a:avLst/>
              </a:prstGeom>
              <a:noFill/>
              <a:ln w="6350" cap="rnd">
                <a:solidFill>
                  <a:srgbClr val="5252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5" name="Line 169">
                <a:extLst>
                  <a:ext uri="{FF2B5EF4-FFF2-40B4-BE49-F238E27FC236}">
                    <a16:creationId xmlns:a16="http://schemas.microsoft.com/office/drawing/2014/main" id="{E89899E0-1DF4-F827-0273-02AB4A7CB4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54588" y="4171950"/>
                <a:ext cx="0" cy="452438"/>
              </a:xfrm>
              <a:prstGeom prst="line">
                <a:avLst/>
              </a:prstGeom>
              <a:noFill/>
              <a:ln w="19050" cap="rnd">
                <a:solidFill>
                  <a:srgbClr val="5252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6" name="Line 170">
                <a:extLst>
                  <a:ext uri="{FF2B5EF4-FFF2-40B4-BE49-F238E27FC236}">
                    <a16:creationId xmlns:a16="http://schemas.microsoft.com/office/drawing/2014/main" id="{06E7C4B2-EE2F-F3E5-5FD3-E1B9F264B4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81350" y="2540000"/>
                <a:ext cx="0" cy="2747963"/>
              </a:xfrm>
              <a:prstGeom prst="line">
                <a:avLst/>
              </a:prstGeom>
              <a:noFill/>
              <a:ln w="3175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7" name="Line 171">
                <a:extLst>
                  <a:ext uri="{FF2B5EF4-FFF2-40B4-BE49-F238E27FC236}">
                    <a16:creationId xmlns:a16="http://schemas.microsoft.com/office/drawing/2014/main" id="{662A750B-3E94-3E1C-D7D8-892457307D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46725" y="2540000"/>
                <a:ext cx="0" cy="2747963"/>
              </a:xfrm>
              <a:prstGeom prst="line">
                <a:avLst/>
              </a:prstGeom>
              <a:noFill/>
              <a:ln w="3175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8" name="Line 172">
                <a:extLst>
                  <a:ext uri="{FF2B5EF4-FFF2-40B4-BE49-F238E27FC236}">
                    <a16:creationId xmlns:a16="http://schemas.microsoft.com/office/drawing/2014/main" id="{7BAC2F64-63C0-BA6A-81C4-5F401F1C24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81350" y="5287963"/>
                <a:ext cx="2365375" cy="0"/>
              </a:xfrm>
              <a:prstGeom prst="line">
                <a:avLst/>
              </a:prstGeom>
              <a:noFill/>
              <a:ln w="3175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9" name="Line 173">
                <a:extLst>
                  <a:ext uri="{FF2B5EF4-FFF2-40B4-BE49-F238E27FC236}">
                    <a16:creationId xmlns:a16="http://schemas.microsoft.com/office/drawing/2014/main" id="{04E2A682-3631-7131-E0D4-C275004306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81350" y="2540000"/>
                <a:ext cx="2365375" cy="0"/>
              </a:xfrm>
              <a:prstGeom prst="line">
                <a:avLst/>
              </a:prstGeom>
              <a:noFill/>
              <a:ln w="3175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0" name="Freeform 174">
                <a:extLst>
                  <a:ext uri="{FF2B5EF4-FFF2-40B4-BE49-F238E27FC236}">
                    <a16:creationId xmlns:a16="http://schemas.microsoft.com/office/drawing/2014/main" id="{14221D67-1217-B3DC-6829-B3550084C507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>
                <a:off x="3752565" y="3949414"/>
                <a:ext cx="40111" cy="40111"/>
              </a:xfrm>
              <a:custGeom>
                <a:avLst/>
                <a:gdLst>
                  <a:gd name="T0" fmla="*/ 75 w 150"/>
                  <a:gd name="T1" fmla="*/ 150 h 150"/>
                  <a:gd name="T2" fmla="*/ 128 w 150"/>
                  <a:gd name="T3" fmla="*/ 129 h 150"/>
                  <a:gd name="T4" fmla="*/ 150 w 150"/>
                  <a:gd name="T5" fmla="*/ 75 h 150"/>
                  <a:gd name="T6" fmla="*/ 128 w 150"/>
                  <a:gd name="T7" fmla="*/ 22 h 150"/>
                  <a:gd name="T8" fmla="*/ 75 w 150"/>
                  <a:gd name="T9" fmla="*/ 0 h 150"/>
                  <a:gd name="T10" fmla="*/ 22 w 150"/>
                  <a:gd name="T11" fmla="*/ 22 h 150"/>
                  <a:gd name="T12" fmla="*/ 0 w 150"/>
                  <a:gd name="T13" fmla="*/ 75 h 150"/>
                  <a:gd name="T14" fmla="*/ 22 w 150"/>
                  <a:gd name="T15" fmla="*/ 129 h 150"/>
                  <a:gd name="T16" fmla="*/ 75 w 150"/>
                  <a:gd name="T17" fmla="*/ 150 h 1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150" h="150">
                    <a:moveTo>
                      <a:pt x="75" y="150"/>
                    </a:moveTo>
                    <a:cubicBezTo>
                      <a:pt x="95" y="150"/>
                      <a:pt x="114" y="143"/>
                      <a:pt x="128" y="129"/>
                    </a:cubicBezTo>
                    <a:cubicBezTo>
                      <a:pt x="142" y="114"/>
                      <a:pt x="150" y="95"/>
                      <a:pt x="150" y="75"/>
                    </a:cubicBezTo>
                    <a:cubicBezTo>
                      <a:pt x="150" y="56"/>
                      <a:pt x="142" y="37"/>
                      <a:pt x="128" y="22"/>
                    </a:cubicBezTo>
                    <a:cubicBezTo>
                      <a:pt x="114" y="8"/>
                      <a:pt x="95" y="0"/>
                      <a:pt x="75" y="0"/>
                    </a:cubicBezTo>
                    <a:cubicBezTo>
                      <a:pt x="55" y="0"/>
                      <a:pt x="36" y="8"/>
                      <a:pt x="22" y="22"/>
                    </a:cubicBezTo>
                    <a:cubicBezTo>
                      <a:pt x="8" y="37"/>
                      <a:pt x="0" y="56"/>
                      <a:pt x="0" y="75"/>
                    </a:cubicBezTo>
                    <a:cubicBezTo>
                      <a:pt x="0" y="95"/>
                      <a:pt x="8" y="114"/>
                      <a:pt x="22" y="129"/>
                    </a:cubicBezTo>
                    <a:cubicBezTo>
                      <a:pt x="36" y="143"/>
                      <a:pt x="55" y="150"/>
                      <a:pt x="75" y="1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 cap="flat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9525" cap="flat">
                    <a:solidFill>
                      <a:srgbClr val="525252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1" name="Freeform 176">
                <a:extLst>
                  <a:ext uri="{FF2B5EF4-FFF2-40B4-BE49-F238E27FC236}">
                    <a16:creationId xmlns:a16="http://schemas.microsoft.com/office/drawing/2014/main" id="{881DB446-25DD-B5C9-94FE-7B364DC4DA55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>
                <a:off x="4935252" y="4389154"/>
                <a:ext cx="40111" cy="40111"/>
              </a:xfrm>
              <a:custGeom>
                <a:avLst/>
                <a:gdLst>
                  <a:gd name="T0" fmla="*/ 75 w 150"/>
                  <a:gd name="T1" fmla="*/ 150 h 150"/>
                  <a:gd name="T2" fmla="*/ 128 w 150"/>
                  <a:gd name="T3" fmla="*/ 128 h 150"/>
                  <a:gd name="T4" fmla="*/ 150 w 150"/>
                  <a:gd name="T5" fmla="*/ 75 h 150"/>
                  <a:gd name="T6" fmla="*/ 128 w 150"/>
                  <a:gd name="T7" fmla="*/ 22 h 150"/>
                  <a:gd name="T8" fmla="*/ 75 w 150"/>
                  <a:gd name="T9" fmla="*/ 0 h 150"/>
                  <a:gd name="T10" fmla="*/ 22 w 150"/>
                  <a:gd name="T11" fmla="*/ 22 h 150"/>
                  <a:gd name="T12" fmla="*/ 0 w 150"/>
                  <a:gd name="T13" fmla="*/ 75 h 150"/>
                  <a:gd name="T14" fmla="*/ 22 w 150"/>
                  <a:gd name="T15" fmla="*/ 128 h 150"/>
                  <a:gd name="T16" fmla="*/ 75 w 150"/>
                  <a:gd name="T17" fmla="*/ 150 h 1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150" h="150">
                    <a:moveTo>
                      <a:pt x="75" y="150"/>
                    </a:moveTo>
                    <a:cubicBezTo>
                      <a:pt x="95" y="150"/>
                      <a:pt x="114" y="142"/>
                      <a:pt x="128" y="128"/>
                    </a:cubicBezTo>
                    <a:cubicBezTo>
                      <a:pt x="142" y="114"/>
                      <a:pt x="150" y="95"/>
                      <a:pt x="150" y="75"/>
                    </a:cubicBezTo>
                    <a:cubicBezTo>
                      <a:pt x="150" y="55"/>
                      <a:pt x="142" y="36"/>
                      <a:pt x="128" y="22"/>
                    </a:cubicBezTo>
                    <a:cubicBezTo>
                      <a:pt x="114" y="8"/>
                      <a:pt x="95" y="0"/>
                      <a:pt x="75" y="0"/>
                    </a:cubicBezTo>
                    <a:cubicBezTo>
                      <a:pt x="55" y="0"/>
                      <a:pt x="36" y="8"/>
                      <a:pt x="22" y="22"/>
                    </a:cubicBezTo>
                    <a:cubicBezTo>
                      <a:pt x="8" y="36"/>
                      <a:pt x="0" y="55"/>
                      <a:pt x="0" y="75"/>
                    </a:cubicBezTo>
                    <a:cubicBezTo>
                      <a:pt x="0" y="95"/>
                      <a:pt x="8" y="114"/>
                      <a:pt x="22" y="128"/>
                    </a:cubicBezTo>
                    <a:cubicBezTo>
                      <a:pt x="36" y="142"/>
                      <a:pt x="55" y="150"/>
                      <a:pt x="75" y="1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 cap="flat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9525" cap="flat">
                    <a:solidFill>
                      <a:srgbClr val="525252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1372" name="Group 1371">
              <a:extLst>
                <a:ext uri="{FF2B5EF4-FFF2-40B4-BE49-F238E27FC236}">
                  <a16:creationId xmlns:a16="http://schemas.microsoft.com/office/drawing/2014/main" id="{31B240C2-4BE0-8450-99E9-748A849B595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708920" y="3935639"/>
              <a:ext cx="1471478" cy="1080000"/>
              <a:chOff x="2540000" y="2540000"/>
              <a:chExt cx="3908426" cy="2868613"/>
            </a:xfrm>
          </p:grpSpPr>
          <p:sp>
            <p:nvSpPr>
              <p:cNvPr id="1373" name="Rectangle 185">
                <a:extLst>
                  <a:ext uri="{FF2B5EF4-FFF2-40B4-BE49-F238E27FC236}">
                    <a16:creationId xmlns:a16="http://schemas.microsoft.com/office/drawing/2014/main" id="{49239AC9-3E40-615D-C9E7-EC77D44199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79763" y="2540000"/>
                <a:ext cx="3268663" cy="2398713"/>
              </a:xfrm>
              <a:prstGeom prst="rect">
                <a:avLst/>
              </a:prstGeom>
              <a:solidFill>
                <a:srgbClr val="EAEA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4" name="Line 186">
                <a:extLst>
                  <a:ext uri="{FF2B5EF4-FFF2-40B4-BE49-F238E27FC236}">
                    <a16:creationId xmlns:a16="http://schemas.microsoft.com/office/drawing/2014/main" id="{9C9CEB28-7828-8C63-BBC5-C43A69E5BB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27400" y="2540000"/>
                <a:ext cx="0" cy="2398713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5" name="Freeform 187">
                <a:extLst>
                  <a:ext uri="{FF2B5EF4-FFF2-40B4-BE49-F238E27FC236}">
                    <a16:creationId xmlns:a16="http://schemas.microsoft.com/office/drawing/2014/main" id="{ECEE8082-8E4D-902B-A776-4EC73F0B124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282950" y="5027613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6" name="Line 188">
                <a:extLst>
                  <a:ext uri="{FF2B5EF4-FFF2-40B4-BE49-F238E27FC236}">
                    <a16:creationId xmlns:a16="http://schemas.microsoft.com/office/drawing/2014/main" id="{F5FB9F25-D55D-B064-11C1-21D24706DE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389438" y="2540000"/>
                <a:ext cx="0" cy="2398713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7" name="Freeform 189">
                <a:extLst>
                  <a:ext uri="{FF2B5EF4-FFF2-40B4-BE49-F238E27FC236}">
                    <a16:creationId xmlns:a16="http://schemas.microsoft.com/office/drawing/2014/main" id="{649BA534-7EF0-9841-A63C-615F5B21C99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287838" y="5029200"/>
                <a:ext cx="85725" cy="134938"/>
              </a:xfrm>
              <a:custGeom>
                <a:avLst/>
                <a:gdLst>
                  <a:gd name="T0" fmla="*/ 31 w 472"/>
                  <a:gd name="T1" fmla="*/ 0 h 742"/>
                  <a:gd name="T2" fmla="*/ 418 w 472"/>
                  <a:gd name="T3" fmla="*/ 0 h 742"/>
                  <a:gd name="T4" fmla="*/ 418 w 472"/>
                  <a:gd name="T5" fmla="*/ 83 h 742"/>
                  <a:gd name="T6" fmla="*/ 121 w 472"/>
                  <a:gd name="T7" fmla="*/ 83 h 742"/>
                  <a:gd name="T8" fmla="*/ 121 w 472"/>
                  <a:gd name="T9" fmla="*/ 262 h 742"/>
                  <a:gd name="T10" fmla="*/ 164 w 472"/>
                  <a:gd name="T11" fmla="*/ 251 h 742"/>
                  <a:gd name="T12" fmla="*/ 207 w 472"/>
                  <a:gd name="T13" fmla="*/ 247 h 742"/>
                  <a:gd name="T14" fmla="*/ 400 w 472"/>
                  <a:gd name="T15" fmla="*/ 314 h 742"/>
                  <a:gd name="T16" fmla="*/ 472 w 472"/>
                  <a:gd name="T17" fmla="*/ 495 h 742"/>
                  <a:gd name="T18" fmla="*/ 398 w 472"/>
                  <a:gd name="T19" fmla="*/ 678 h 742"/>
                  <a:gd name="T20" fmla="*/ 192 w 472"/>
                  <a:gd name="T21" fmla="*/ 742 h 742"/>
                  <a:gd name="T22" fmla="*/ 98 w 472"/>
                  <a:gd name="T23" fmla="*/ 735 h 742"/>
                  <a:gd name="T24" fmla="*/ 0 w 472"/>
                  <a:gd name="T25" fmla="*/ 712 h 742"/>
                  <a:gd name="T26" fmla="*/ 0 w 472"/>
                  <a:gd name="T27" fmla="*/ 613 h 742"/>
                  <a:gd name="T28" fmla="*/ 91 w 472"/>
                  <a:gd name="T29" fmla="*/ 649 h 742"/>
                  <a:gd name="T30" fmla="*/ 190 w 472"/>
                  <a:gd name="T31" fmla="*/ 660 h 742"/>
                  <a:gd name="T32" fmla="*/ 324 w 472"/>
                  <a:gd name="T33" fmla="*/ 616 h 742"/>
                  <a:gd name="T34" fmla="*/ 373 w 472"/>
                  <a:gd name="T35" fmla="*/ 495 h 742"/>
                  <a:gd name="T36" fmla="*/ 324 w 472"/>
                  <a:gd name="T37" fmla="*/ 375 h 742"/>
                  <a:gd name="T38" fmla="*/ 190 w 472"/>
                  <a:gd name="T39" fmla="*/ 330 h 742"/>
                  <a:gd name="T40" fmla="*/ 111 w 472"/>
                  <a:gd name="T41" fmla="*/ 339 h 742"/>
                  <a:gd name="T42" fmla="*/ 31 w 472"/>
                  <a:gd name="T43" fmla="*/ 366 h 742"/>
                  <a:gd name="T44" fmla="*/ 31 w 472"/>
                  <a:gd name="T45" fmla="*/ 0 h 7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72" h="742">
                    <a:moveTo>
                      <a:pt x="31" y="0"/>
                    </a:moveTo>
                    <a:lnTo>
                      <a:pt x="418" y="0"/>
                    </a:lnTo>
                    <a:lnTo>
                      <a:pt x="418" y="83"/>
                    </a:lnTo>
                    <a:lnTo>
                      <a:pt x="121" y="83"/>
                    </a:lnTo>
                    <a:lnTo>
                      <a:pt x="121" y="262"/>
                    </a:lnTo>
                    <a:cubicBezTo>
                      <a:pt x="135" y="257"/>
                      <a:pt x="150" y="253"/>
                      <a:pt x="164" y="251"/>
                    </a:cubicBezTo>
                    <a:cubicBezTo>
                      <a:pt x="178" y="249"/>
                      <a:pt x="193" y="247"/>
                      <a:pt x="207" y="247"/>
                    </a:cubicBezTo>
                    <a:cubicBezTo>
                      <a:pt x="288" y="247"/>
                      <a:pt x="352" y="270"/>
                      <a:pt x="400" y="314"/>
                    </a:cubicBezTo>
                    <a:cubicBezTo>
                      <a:pt x="448" y="359"/>
                      <a:pt x="472" y="419"/>
                      <a:pt x="472" y="495"/>
                    </a:cubicBezTo>
                    <a:cubicBezTo>
                      <a:pt x="472" y="574"/>
                      <a:pt x="447" y="635"/>
                      <a:pt x="398" y="678"/>
                    </a:cubicBezTo>
                    <a:cubicBezTo>
                      <a:pt x="349" y="721"/>
                      <a:pt x="280" y="742"/>
                      <a:pt x="192" y="742"/>
                    </a:cubicBezTo>
                    <a:cubicBezTo>
                      <a:pt x="161" y="742"/>
                      <a:pt x="130" y="739"/>
                      <a:pt x="98" y="735"/>
                    </a:cubicBezTo>
                    <a:cubicBezTo>
                      <a:pt x="66" y="730"/>
                      <a:pt x="34" y="723"/>
                      <a:pt x="0" y="712"/>
                    </a:cubicBezTo>
                    <a:lnTo>
                      <a:pt x="0" y="613"/>
                    </a:lnTo>
                    <a:cubicBezTo>
                      <a:pt x="29" y="629"/>
                      <a:pt x="59" y="641"/>
                      <a:pt x="91" y="649"/>
                    </a:cubicBezTo>
                    <a:cubicBezTo>
                      <a:pt x="122" y="657"/>
                      <a:pt x="155" y="660"/>
                      <a:pt x="190" y="660"/>
                    </a:cubicBezTo>
                    <a:cubicBezTo>
                      <a:pt x="246" y="660"/>
                      <a:pt x="291" y="646"/>
                      <a:pt x="324" y="616"/>
                    </a:cubicBezTo>
                    <a:cubicBezTo>
                      <a:pt x="356" y="586"/>
                      <a:pt x="373" y="546"/>
                      <a:pt x="373" y="495"/>
                    </a:cubicBezTo>
                    <a:cubicBezTo>
                      <a:pt x="373" y="445"/>
                      <a:pt x="356" y="405"/>
                      <a:pt x="324" y="375"/>
                    </a:cubicBezTo>
                    <a:cubicBezTo>
                      <a:pt x="291" y="345"/>
                      <a:pt x="246" y="330"/>
                      <a:pt x="190" y="330"/>
                    </a:cubicBezTo>
                    <a:cubicBezTo>
                      <a:pt x="164" y="330"/>
                      <a:pt x="137" y="333"/>
                      <a:pt x="111" y="339"/>
                    </a:cubicBezTo>
                    <a:cubicBezTo>
                      <a:pt x="85" y="345"/>
                      <a:pt x="58" y="354"/>
                      <a:pt x="31" y="366"/>
                    </a:cubicBezTo>
                    <a:lnTo>
                      <a:pt x="31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8" name="Freeform 190">
                <a:extLst>
                  <a:ext uri="{FF2B5EF4-FFF2-40B4-BE49-F238E27FC236}">
                    <a16:creationId xmlns:a16="http://schemas.microsoft.com/office/drawing/2014/main" id="{FA34F8C4-6F95-F0D0-08BF-FE6672CF6D0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400550" y="5027613"/>
                <a:ext cx="92075" cy="136525"/>
              </a:xfrm>
              <a:custGeom>
                <a:avLst/>
                <a:gdLst>
                  <a:gd name="T0" fmla="*/ 252 w 505"/>
                  <a:gd name="T1" fmla="*/ 78 h 755"/>
                  <a:gd name="T2" fmla="*/ 137 w 505"/>
                  <a:gd name="T3" fmla="*/ 153 h 755"/>
                  <a:gd name="T4" fmla="*/ 99 w 505"/>
                  <a:gd name="T5" fmla="*/ 378 h 755"/>
                  <a:gd name="T6" fmla="*/ 137 w 505"/>
                  <a:gd name="T7" fmla="*/ 603 h 755"/>
                  <a:gd name="T8" fmla="*/ 252 w 505"/>
                  <a:gd name="T9" fmla="*/ 678 h 755"/>
                  <a:gd name="T10" fmla="*/ 368 w 505"/>
                  <a:gd name="T11" fmla="*/ 603 h 755"/>
                  <a:gd name="T12" fmla="*/ 406 w 505"/>
                  <a:gd name="T13" fmla="*/ 378 h 755"/>
                  <a:gd name="T14" fmla="*/ 368 w 505"/>
                  <a:gd name="T15" fmla="*/ 153 h 755"/>
                  <a:gd name="T16" fmla="*/ 252 w 505"/>
                  <a:gd name="T17" fmla="*/ 78 h 755"/>
                  <a:gd name="T18" fmla="*/ 252 w 505"/>
                  <a:gd name="T19" fmla="*/ 0 h 755"/>
                  <a:gd name="T20" fmla="*/ 440 w 505"/>
                  <a:gd name="T21" fmla="*/ 97 h 755"/>
                  <a:gd name="T22" fmla="*/ 505 w 505"/>
                  <a:gd name="T23" fmla="*/ 378 h 755"/>
                  <a:gd name="T24" fmla="*/ 440 w 505"/>
                  <a:gd name="T25" fmla="*/ 659 h 755"/>
                  <a:gd name="T26" fmla="*/ 251 w 505"/>
                  <a:gd name="T27" fmla="*/ 755 h 755"/>
                  <a:gd name="T28" fmla="*/ 64 w 505"/>
                  <a:gd name="T29" fmla="*/ 659 h 755"/>
                  <a:gd name="T30" fmla="*/ 0 w 505"/>
                  <a:gd name="T31" fmla="*/ 378 h 755"/>
                  <a:gd name="T32" fmla="*/ 64 w 505"/>
                  <a:gd name="T33" fmla="*/ 97 h 755"/>
                  <a:gd name="T34" fmla="*/ 252 w 505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5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8" y="603"/>
                    </a:cubicBezTo>
                    <a:cubicBezTo>
                      <a:pt x="393" y="553"/>
                      <a:pt x="406" y="478"/>
                      <a:pt x="406" y="378"/>
                    </a:cubicBezTo>
                    <a:cubicBezTo>
                      <a:pt x="406" y="278"/>
                      <a:pt x="393" y="203"/>
                      <a:pt x="368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6" y="33"/>
                      <a:pt x="440" y="97"/>
                    </a:cubicBezTo>
                    <a:cubicBezTo>
                      <a:pt x="483" y="162"/>
                      <a:pt x="505" y="256"/>
                      <a:pt x="505" y="378"/>
                    </a:cubicBezTo>
                    <a:cubicBezTo>
                      <a:pt x="505" y="501"/>
                      <a:pt x="483" y="595"/>
                      <a:pt x="440" y="659"/>
                    </a:cubicBezTo>
                    <a:cubicBezTo>
                      <a:pt x="396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9" name="Line 191">
                <a:extLst>
                  <a:ext uri="{FF2B5EF4-FFF2-40B4-BE49-F238E27FC236}">
                    <a16:creationId xmlns:a16="http://schemas.microsoft.com/office/drawing/2014/main" id="{734B8699-990F-6D6E-3C06-D5DB852919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49888" y="2540000"/>
                <a:ext cx="0" cy="2398713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0" name="Freeform 192">
                <a:extLst>
                  <a:ext uri="{FF2B5EF4-FFF2-40B4-BE49-F238E27FC236}">
                    <a16:creationId xmlns:a16="http://schemas.microsoft.com/office/drawing/2014/main" id="{7E96BACC-5B2B-6799-259F-35299E5F097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299075" y="5029200"/>
                <a:ext cx="77788" cy="131763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1" name="Freeform 193">
                <a:extLst>
                  <a:ext uri="{FF2B5EF4-FFF2-40B4-BE49-F238E27FC236}">
                    <a16:creationId xmlns:a16="http://schemas.microsoft.com/office/drawing/2014/main" id="{7F810C38-B5F4-5991-DD86-13ED423BB95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405438" y="5027613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2" name="Freeform 194">
                <a:extLst>
                  <a:ext uri="{FF2B5EF4-FFF2-40B4-BE49-F238E27FC236}">
                    <a16:creationId xmlns:a16="http://schemas.microsoft.com/office/drawing/2014/main" id="{144C289F-5FC3-84A8-70DD-808D68E08B6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519738" y="5027613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3" name="Freeform 195">
                <a:extLst>
                  <a:ext uri="{FF2B5EF4-FFF2-40B4-BE49-F238E27FC236}">
                    <a16:creationId xmlns:a16="http://schemas.microsoft.com/office/drawing/2014/main" id="{1967D0EF-383B-F61D-CA56-90599A3B1FB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30700" y="5240338"/>
                <a:ext cx="74613" cy="131763"/>
              </a:xfrm>
              <a:custGeom>
                <a:avLst/>
                <a:gdLst>
                  <a:gd name="T0" fmla="*/ 0 w 419"/>
                  <a:gd name="T1" fmla="*/ 0 h 729"/>
                  <a:gd name="T2" fmla="*/ 419 w 419"/>
                  <a:gd name="T3" fmla="*/ 0 h 729"/>
                  <a:gd name="T4" fmla="*/ 419 w 419"/>
                  <a:gd name="T5" fmla="*/ 83 h 729"/>
                  <a:gd name="T6" fmla="*/ 99 w 419"/>
                  <a:gd name="T7" fmla="*/ 83 h 729"/>
                  <a:gd name="T8" fmla="*/ 99 w 419"/>
                  <a:gd name="T9" fmla="*/ 298 h 729"/>
                  <a:gd name="T10" fmla="*/ 388 w 419"/>
                  <a:gd name="T11" fmla="*/ 298 h 729"/>
                  <a:gd name="T12" fmla="*/ 388 w 419"/>
                  <a:gd name="T13" fmla="*/ 381 h 729"/>
                  <a:gd name="T14" fmla="*/ 99 w 419"/>
                  <a:gd name="T15" fmla="*/ 381 h 729"/>
                  <a:gd name="T16" fmla="*/ 99 w 419"/>
                  <a:gd name="T17" fmla="*/ 729 h 729"/>
                  <a:gd name="T18" fmla="*/ 0 w 419"/>
                  <a:gd name="T19" fmla="*/ 729 h 729"/>
                  <a:gd name="T20" fmla="*/ 0 w 419"/>
                  <a:gd name="T21" fmla="*/ 0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419" h="729">
                    <a:moveTo>
                      <a:pt x="0" y="0"/>
                    </a:moveTo>
                    <a:lnTo>
                      <a:pt x="419" y="0"/>
                    </a:lnTo>
                    <a:lnTo>
                      <a:pt x="419" y="83"/>
                    </a:lnTo>
                    <a:lnTo>
                      <a:pt x="99" y="83"/>
                    </a:lnTo>
                    <a:lnTo>
                      <a:pt x="99" y="298"/>
                    </a:lnTo>
                    <a:lnTo>
                      <a:pt x="388" y="298"/>
                    </a:lnTo>
                    <a:lnTo>
                      <a:pt x="388" y="381"/>
                    </a:lnTo>
                    <a:lnTo>
                      <a:pt x="99" y="381"/>
                    </a:lnTo>
                    <a:lnTo>
                      <a:pt x="99" y="729"/>
                    </a:lnTo>
                    <a:lnTo>
                      <a:pt x="0" y="729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4" name="Freeform 196">
                <a:extLst>
                  <a:ext uri="{FF2B5EF4-FFF2-40B4-BE49-F238E27FC236}">
                    <a16:creationId xmlns:a16="http://schemas.microsoft.com/office/drawing/2014/main" id="{1996FF2D-3E2C-A77D-DBE0-E705B7A5031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419600" y="5270500"/>
                <a:ext cx="90488" cy="103188"/>
              </a:xfrm>
              <a:custGeom>
                <a:avLst/>
                <a:gdLst>
                  <a:gd name="T0" fmla="*/ 251 w 502"/>
                  <a:gd name="T1" fmla="*/ 76 h 573"/>
                  <a:gd name="T2" fmla="*/ 137 w 502"/>
                  <a:gd name="T3" fmla="*/ 133 h 573"/>
                  <a:gd name="T4" fmla="*/ 95 w 502"/>
                  <a:gd name="T5" fmla="*/ 287 h 573"/>
                  <a:gd name="T6" fmla="*/ 136 w 502"/>
                  <a:gd name="T7" fmla="*/ 442 h 573"/>
                  <a:gd name="T8" fmla="*/ 251 w 502"/>
                  <a:gd name="T9" fmla="*/ 498 h 573"/>
                  <a:gd name="T10" fmla="*/ 365 w 502"/>
                  <a:gd name="T11" fmla="*/ 442 h 573"/>
                  <a:gd name="T12" fmla="*/ 407 w 502"/>
                  <a:gd name="T13" fmla="*/ 287 h 573"/>
                  <a:gd name="T14" fmla="*/ 365 w 502"/>
                  <a:gd name="T15" fmla="*/ 133 h 573"/>
                  <a:gd name="T16" fmla="*/ 251 w 502"/>
                  <a:gd name="T17" fmla="*/ 76 h 573"/>
                  <a:gd name="T18" fmla="*/ 251 w 502"/>
                  <a:gd name="T19" fmla="*/ 0 h 573"/>
                  <a:gd name="T20" fmla="*/ 435 w 502"/>
                  <a:gd name="T21" fmla="*/ 76 h 573"/>
                  <a:gd name="T22" fmla="*/ 502 w 502"/>
                  <a:gd name="T23" fmla="*/ 287 h 573"/>
                  <a:gd name="T24" fmla="*/ 435 w 502"/>
                  <a:gd name="T25" fmla="*/ 497 h 573"/>
                  <a:gd name="T26" fmla="*/ 251 w 502"/>
                  <a:gd name="T27" fmla="*/ 573 h 573"/>
                  <a:gd name="T28" fmla="*/ 66 w 502"/>
                  <a:gd name="T29" fmla="*/ 497 h 573"/>
                  <a:gd name="T30" fmla="*/ 0 w 502"/>
                  <a:gd name="T31" fmla="*/ 287 h 573"/>
                  <a:gd name="T32" fmla="*/ 66 w 502"/>
                  <a:gd name="T33" fmla="*/ 76 h 573"/>
                  <a:gd name="T34" fmla="*/ 251 w 502"/>
                  <a:gd name="T35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2" h="573">
                    <a:moveTo>
                      <a:pt x="251" y="76"/>
                    </a:moveTo>
                    <a:cubicBezTo>
                      <a:pt x="203" y="76"/>
                      <a:pt x="165" y="95"/>
                      <a:pt x="137" y="133"/>
                    </a:cubicBezTo>
                    <a:cubicBezTo>
                      <a:pt x="109" y="171"/>
                      <a:pt x="95" y="222"/>
                      <a:pt x="95" y="287"/>
                    </a:cubicBezTo>
                    <a:cubicBezTo>
                      <a:pt x="95" y="353"/>
                      <a:pt x="108" y="404"/>
                      <a:pt x="136" y="442"/>
                    </a:cubicBezTo>
                    <a:cubicBezTo>
                      <a:pt x="164" y="480"/>
                      <a:pt x="202" y="498"/>
                      <a:pt x="251" y="498"/>
                    </a:cubicBezTo>
                    <a:cubicBezTo>
                      <a:pt x="299" y="498"/>
                      <a:pt x="337" y="480"/>
                      <a:pt x="365" y="442"/>
                    </a:cubicBezTo>
                    <a:cubicBezTo>
                      <a:pt x="393" y="404"/>
                      <a:pt x="407" y="353"/>
                      <a:pt x="407" y="287"/>
                    </a:cubicBezTo>
                    <a:cubicBezTo>
                      <a:pt x="407" y="223"/>
                      <a:pt x="393" y="171"/>
                      <a:pt x="365" y="133"/>
                    </a:cubicBezTo>
                    <a:cubicBezTo>
                      <a:pt x="337" y="95"/>
                      <a:pt x="299" y="76"/>
                      <a:pt x="251" y="76"/>
                    </a:cubicBezTo>
                    <a:close/>
                    <a:moveTo>
                      <a:pt x="251" y="0"/>
                    </a:moveTo>
                    <a:cubicBezTo>
                      <a:pt x="329" y="0"/>
                      <a:pt x="390" y="26"/>
                      <a:pt x="435" y="76"/>
                    </a:cubicBezTo>
                    <a:cubicBezTo>
                      <a:pt x="479" y="127"/>
                      <a:pt x="502" y="197"/>
                      <a:pt x="502" y="287"/>
                    </a:cubicBezTo>
                    <a:cubicBezTo>
                      <a:pt x="502" y="377"/>
                      <a:pt x="479" y="447"/>
                      <a:pt x="435" y="497"/>
                    </a:cubicBezTo>
                    <a:cubicBezTo>
                      <a:pt x="390" y="548"/>
                      <a:pt x="329" y="573"/>
                      <a:pt x="251" y="573"/>
                    </a:cubicBezTo>
                    <a:cubicBezTo>
                      <a:pt x="172" y="573"/>
                      <a:pt x="110" y="548"/>
                      <a:pt x="66" y="497"/>
                    </a:cubicBezTo>
                    <a:cubicBezTo>
                      <a:pt x="22" y="447"/>
                      <a:pt x="0" y="377"/>
                      <a:pt x="0" y="287"/>
                    </a:cubicBezTo>
                    <a:cubicBezTo>
                      <a:pt x="0" y="197"/>
                      <a:pt x="22" y="127"/>
                      <a:pt x="66" y="76"/>
                    </a:cubicBezTo>
                    <a:cubicBezTo>
                      <a:pt x="110" y="26"/>
                      <a:pt x="172" y="0"/>
                      <a:pt x="251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5" name="Freeform 197">
                <a:extLst>
                  <a:ext uri="{FF2B5EF4-FFF2-40B4-BE49-F238E27FC236}">
                    <a16:creationId xmlns:a16="http://schemas.microsoft.com/office/drawing/2014/main" id="{3F288038-6571-E45A-772D-5B263AFE909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30725" y="5270500"/>
                <a:ext cx="77788" cy="103188"/>
              </a:xfrm>
              <a:custGeom>
                <a:avLst/>
                <a:gdLst>
                  <a:gd name="T0" fmla="*/ 433 w 433"/>
                  <a:gd name="T1" fmla="*/ 34 h 573"/>
                  <a:gd name="T2" fmla="*/ 433 w 433"/>
                  <a:gd name="T3" fmla="*/ 118 h 573"/>
                  <a:gd name="T4" fmla="*/ 356 w 433"/>
                  <a:gd name="T5" fmla="*/ 87 h 573"/>
                  <a:gd name="T6" fmla="*/ 279 w 433"/>
                  <a:gd name="T7" fmla="*/ 76 h 573"/>
                  <a:gd name="T8" fmla="*/ 143 w 433"/>
                  <a:gd name="T9" fmla="*/ 132 h 573"/>
                  <a:gd name="T10" fmla="*/ 95 w 433"/>
                  <a:gd name="T11" fmla="*/ 287 h 573"/>
                  <a:gd name="T12" fmla="*/ 143 w 433"/>
                  <a:gd name="T13" fmla="*/ 443 h 573"/>
                  <a:gd name="T14" fmla="*/ 279 w 433"/>
                  <a:gd name="T15" fmla="*/ 498 h 573"/>
                  <a:gd name="T16" fmla="*/ 356 w 433"/>
                  <a:gd name="T17" fmla="*/ 488 h 573"/>
                  <a:gd name="T18" fmla="*/ 433 w 433"/>
                  <a:gd name="T19" fmla="*/ 456 h 573"/>
                  <a:gd name="T20" fmla="*/ 433 w 433"/>
                  <a:gd name="T21" fmla="*/ 539 h 573"/>
                  <a:gd name="T22" fmla="*/ 355 w 433"/>
                  <a:gd name="T23" fmla="*/ 565 h 573"/>
                  <a:gd name="T24" fmla="*/ 269 w 433"/>
                  <a:gd name="T25" fmla="*/ 573 h 573"/>
                  <a:gd name="T26" fmla="*/ 73 w 433"/>
                  <a:gd name="T27" fmla="*/ 496 h 573"/>
                  <a:gd name="T28" fmla="*/ 0 w 433"/>
                  <a:gd name="T29" fmla="*/ 287 h 573"/>
                  <a:gd name="T30" fmla="*/ 73 w 433"/>
                  <a:gd name="T31" fmla="*/ 77 h 573"/>
                  <a:gd name="T32" fmla="*/ 275 w 433"/>
                  <a:gd name="T33" fmla="*/ 0 h 573"/>
                  <a:gd name="T34" fmla="*/ 356 w 433"/>
                  <a:gd name="T35" fmla="*/ 9 h 573"/>
                  <a:gd name="T36" fmla="*/ 433 w 433"/>
                  <a:gd name="T37" fmla="*/ 34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433" h="573">
                    <a:moveTo>
                      <a:pt x="433" y="34"/>
                    </a:moveTo>
                    <a:lnTo>
                      <a:pt x="433" y="118"/>
                    </a:lnTo>
                    <a:cubicBezTo>
                      <a:pt x="407" y="104"/>
                      <a:pt x="382" y="94"/>
                      <a:pt x="356" y="87"/>
                    </a:cubicBezTo>
                    <a:cubicBezTo>
                      <a:pt x="330" y="80"/>
                      <a:pt x="305" y="76"/>
                      <a:pt x="279" y="76"/>
                    </a:cubicBezTo>
                    <a:cubicBezTo>
                      <a:pt x="221" y="76"/>
                      <a:pt x="175" y="95"/>
                      <a:pt x="143" y="132"/>
                    </a:cubicBezTo>
                    <a:cubicBezTo>
                      <a:pt x="111" y="169"/>
                      <a:pt x="95" y="221"/>
                      <a:pt x="95" y="287"/>
                    </a:cubicBezTo>
                    <a:cubicBezTo>
                      <a:pt x="95" y="354"/>
                      <a:pt x="111" y="406"/>
                      <a:pt x="143" y="443"/>
                    </a:cubicBezTo>
                    <a:cubicBezTo>
                      <a:pt x="175" y="480"/>
                      <a:pt x="221" y="498"/>
                      <a:pt x="279" y="498"/>
                    </a:cubicBezTo>
                    <a:cubicBezTo>
                      <a:pt x="305" y="498"/>
                      <a:pt x="330" y="495"/>
                      <a:pt x="356" y="488"/>
                    </a:cubicBezTo>
                    <a:cubicBezTo>
                      <a:pt x="382" y="481"/>
                      <a:pt x="407" y="470"/>
                      <a:pt x="433" y="456"/>
                    </a:cubicBezTo>
                    <a:lnTo>
                      <a:pt x="433" y="539"/>
                    </a:lnTo>
                    <a:cubicBezTo>
                      <a:pt x="407" y="551"/>
                      <a:pt x="381" y="560"/>
                      <a:pt x="355" y="565"/>
                    </a:cubicBezTo>
                    <a:cubicBezTo>
                      <a:pt x="328" y="570"/>
                      <a:pt x="299" y="573"/>
                      <a:pt x="269" y="573"/>
                    </a:cubicBezTo>
                    <a:cubicBezTo>
                      <a:pt x="187" y="573"/>
                      <a:pt x="121" y="548"/>
                      <a:pt x="73" y="496"/>
                    </a:cubicBezTo>
                    <a:cubicBezTo>
                      <a:pt x="24" y="445"/>
                      <a:pt x="0" y="375"/>
                      <a:pt x="0" y="287"/>
                    </a:cubicBezTo>
                    <a:cubicBezTo>
                      <a:pt x="0" y="198"/>
                      <a:pt x="24" y="128"/>
                      <a:pt x="73" y="77"/>
                    </a:cubicBezTo>
                    <a:cubicBezTo>
                      <a:pt x="122" y="26"/>
                      <a:pt x="189" y="0"/>
                      <a:pt x="275" y="0"/>
                    </a:cubicBezTo>
                    <a:cubicBezTo>
                      <a:pt x="303" y="0"/>
                      <a:pt x="330" y="3"/>
                      <a:pt x="356" y="9"/>
                    </a:cubicBezTo>
                    <a:cubicBezTo>
                      <a:pt x="382" y="15"/>
                      <a:pt x="408" y="23"/>
                      <a:pt x="433" y="34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6" name="Freeform 198">
                <a:extLst>
                  <a:ext uri="{FF2B5EF4-FFF2-40B4-BE49-F238E27FC236}">
                    <a16:creationId xmlns:a16="http://schemas.microsoft.com/office/drawing/2014/main" id="{24752B50-B791-86D1-0119-5E791129DBD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633913" y="5270500"/>
                <a:ext cx="82550" cy="103188"/>
              </a:xfrm>
              <a:custGeom>
                <a:avLst/>
                <a:gdLst>
                  <a:gd name="T0" fmla="*/ 0 w 458"/>
                  <a:gd name="T1" fmla="*/ 344 h 573"/>
                  <a:gd name="T2" fmla="*/ 0 w 458"/>
                  <a:gd name="T3" fmla="*/ 13 h 573"/>
                  <a:gd name="T4" fmla="*/ 90 w 458"/>
                  <a:gd name="T5" fmla="*/ 13 h 573"/>
                  <a:gd name="T6" fmla="*/ 90 w 458"/>
                  <a:gd name="T7" fmla="*/ 341 h 573"/>
                  <a:gd name="T8" fmla="*/ 120 w 458"/>
                  <a:gd name="T9" fmla="*/ 457 h 573"/>
                  <a:gd name="T10" fmla="*/ 211 w 458"/>
                  <a:gd name="T11" fmla="*/ 496 h 573"/>
                  <a:gd name="T12" fmla="*/ 326 w 458"/>
                  <a:gd name="T13" fmla="*/ 450 h 573"/>
                  <a:gd name="T14" fmla="*/ 368 w 458"/>
                  <a:gd name="T15" fmla="*/ 323 h 573"/>
                  <a:gd name="T16" fmla="*/ 368 w 458"/>
                  <a:gd name="T17" fmla="*/ 13 h 573"/>
                  <a:gd name="T18" fmla="*/ 458 w 458"/>
                  <a:gd name="T19" fmla="*/ 13 h 573"/>
                  <a:gd name="T20" fmla="*/ 458 w 458"/>
                  <a:gd name="T21" fmla="*/ 560 h 573"/>
                  <a:gd name="T22" fmla="*/ 368 w 458"/>
                  <a:gd name="T23" fmla="*/ 560 h 573"/>
                  <a:gd name="T24" fmla="*/ 368 w 458"/>
                  <a:gd name="T25" fmla="*/ 476 h 573"/>
                  <a:gd name="T26" fmla="*/ 292 w 458"/>
                  <a:gd name="T27" fmla="*/ 550 h 573"/>
                  <a:gd name="T28" fmla="*/ 192 w 458"/>
                  <a:gd name="T29" fmla="*/ 573 h 573"/>
                  <a:gd name="T30" fmla="*/ 49 w 458"/>
                  <a:gd name="T31" fmla="*/ 515 h 573"/>
                  <a:gd name="T32" fmla="*/ 0 w 458"/>
                  <a:gd name="T33" fmla="*/ 344 h 573"/>
                  <a:gd name="T34" fmla="*/ 226 w 458"/>
                  <a:gd name="T35" fmla="*/ 0 h 573"/>
                  <a:gd name="T36" fmla="*/ 227 w 458"/>
                  <a:gd name="T37" fmla="*/ 0 h 573"/>
                  <a:gd name="T38" fmla="*/ 226 w 458"/>
                  <a:gd name="T39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458" h="573">
                    <a:moveTo>
                      <a:pt x="0" y="344"/>
                    </a:moveTo>
                    <a:lnTo>
                      <a:pt x="0" y="13"/>
                    </a:lnTo>
                    <a:lnTo>
                      <a:pt x="90" y="13"/>
                    </a:lnTo>
                    <a:lnTo>
                      <a:pt x="90" y="341"/>
                    </a:lnTo>
                    <a:cubicBezTo>
                      <a:pt x="90" y="393"/>
                      <a:pt x="100" y="431"/>
                      <a:pt x="120" y="457"/>
                    </a:cubicBezTo>
                    <a:cubicBezTo>
                      <a:pt x="140" y="483"/>
                      <a:pt x="170" y="496"/>
                      <a:pt x="211" y="496"/>
                    </a:cubicBezTo>
                    <a:cubicBezTo>
                      <a:pt x="259" y="496"/>
                      <a:pt x="298" y="481"/>
                      <a:pt x="326" y="450"/>
                    </a:cubicBezTo>
                    <a:cubicBezTo>
                      <a:pt x="354" y="419"/>
                      <a:pt x="368" y="377"/>
                      <a:pt x="368" y="323"/>
                    </a:cubicBezTo>
                    <a:lnTo>
                      <a:pt x="368" y="13"/>
                    </a:lnTo>
                    <a:lnTo>
                      <a:pt x="458" y="13"/>
                    </a:lnTo>
                    <a:lnTo>
                      <a:pt x="458" y="560"/>
                    </a:lnTo>
                    <a:lnTo>
                      <a:pt x="368" y="560"/>
                    </a:lnTo>
                    <a:lnTo>
                      <a:pt x="368" y="476"/>
                    </a:lnTo>
                    <a:cubicBezTo>
                      <a:pt x="346" y="510"/>
                      <a:pt x="320" y="534"/>
                      <a:pt x="292" y="550"/>
                    </a:cubicBezTo>
                    <a:cubicBezTo>
                      <a:pt x="263" y="565"/>
                      <a:pt x="230" y="573"/>
                      <a:pt x="192" y="573"/>
                    </a:cubicBezTo>
                    <a:cubicBezTo>
                      <a:pt x="129" y="573"/>
                      <a:pt x="81" y="554"/>
                      <a:pt x="49" y="515"/>
                    </a:cubicBezTo>
                    <a:cubicBezTo>
                      <a:pt x="16" y="477"/>
                      <a:pt x="0" y="420"/>
                      <a:pt x="0" y="344"/>
                    </a:cubicBezTo>
                    <a:close/>
                    <a:moveTo>
                      <a:pt x="226" y="0"/>
                    </a:moveTo>
                    <a:lnTo>
                      <a:pt x="227" y="0"/>
                    </a:lnTo>
                    <a:lnTo>
                      <a:pt x="226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7" name="Freeform 199">
                <a:extLst>
                  <a:ext uri="{FF2B5EF4-FFF2-40B4-BE49-F238E27FC236}">
                    <a16:creationId xmlns:a16="http://schemas.microsoft.com/office/drawing/2014/main" id="{9DBF46F5-932A-358E-AD40-F3E821A8D37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43450" y="5270500"/>
                <a:ext cx="74613" cy="103188"/>
              </a:xfrm>
              <a:custGeom>
                <a:avLst/>
                <a:gdLst>
                  <a:gd name="T0" fmla="*/ 389 w 418"/>
                  <a:gd name="T1" fmla="*/ 29 h 573"/>
                  <a:gd name="T2" fmla="*/ 389 w 418"/>
                  <a:gd name="T3" fmla="*/ 114 h 573"/>
                  <a:gd name="T4" fmla="*/ 310 w 418"/>
                  <a:gd name="T5" fmla="*/ 85 h 573"/>
                  <a:gd name="T6" fmla="*/ 225 w 418"/>
                  <a:gd name="T7" fmla="*/ 75 h 573"/>
                  <a:gd name="T8" fmla="*/ 124 w 418"/>
                  <a:gd name="T9" fmla="*/ 96 h 573"/>
                  <a:gd name="T10" fmla="*/ 91 w 418"/>
                  <a:gd name="T11" fmla="*/ 157 h 573"/>
                  <a:gd name="T12" fmla="*/ 115 w 418"/>
                  <a:gd name="T13" fmla="*/ 206 h 573"/>
                  <a:gd name="T14" fmla="*/ 211 w 418"/>
                  <a:gd name="T15" fmla="*/ 240 h 573"/>
                  <a:gd name="T16" fmla="*/ 242 w 418"/>
                  <a:gd name="T17" fmla="*/ 247 h 573"/>
                  <a:gd name="T18" fmla="*/ 378 w 418"/>
                  <a:gd name="T19" fmla="*/ 305 h 573"/>
                  <a:gd name="T20" fmla="*/ 418 w 418"/>
                  <a:gd name="T21" fmla="*/ 409 h 573"/>
                  <a:gd name="T22" fmla="*/ 358 w 418"/>
                  <a:gd name="T23" fmla="*/ 529 h 573"/>
                  <a:gd name="T24" fmla="*/ 192 w 418"/>
                  <a:gd name="T25" fmla="*/ 573 h 573"/>
                  <a:gd name="T26" fmla="*/ 100 w 418"/>
                  <a:gd name="T27" fmla="*/ 565 h 573"/>
                  <a:gd name="T28" fmla="*/ 0 w 418"/>
                  <a:gd name="T29" fmla="*/ 540 h 573"/>
                  <a:gd name="T30" fmla="*/ 0 w 418"/>
                  <a:gd name="T31" fmla="*/ 447 h 573"/>
                  <a:gd name="T32" fmla="*/ 98 w 418"/>
                  <a:gd name="T33" fmla="*/ 486 h 573"/>
                  <a:gd name="T34" fmla="*/ 194 w 418"/>
                  <a:gd name="T35" fmla="*/ 499 h 573"/>
                  <a:gd name="T36" fmla="*/ 292 w 418"/>
                  <a:gd name="T37" fmla="*/ 478 h 573"/>
                  <a:gd name="T38" fmla="*/ 326 w 418"/>
                  <a:gd name="T39" fmla="*/ 416 h 573"/>
                  <a:gd name="T40" fmla="*/ 301 w 418"/>
                  <a:gd name="T41" fmla="*/ 360 h 573"/>
                  <a:gd name="T42" fmla="*/ 193 w 418"/>
                  <a:gd name="T43" fmla="*/ 322 h 573"/>
                  <a:gd name="T44" fmla="*/ 162 w 418"/>
                  <a:gd name="T45" fmla="*/ 315 h 573"/>
                  <a:gd name="T46" fmla="*/ 41 w 418"/>
                  <a:gd name="T47" fmla="*/ 261 h 573"/>
                  <a:gd name="T48" fmla="*/ 4 w 418"/>
                  <a:gd name="T49" fmla="*/ 161 h 573"/>
                  <a:gd name="T50" fmla="*/ 58 w 418"/>
                  <a:gd name="T51" fmla="*/ 42 h 573"/>
                  <a:gd name="T52" fmla="*/ 214 w 418"/>
                  <a:gd name="T53" fmla="*/ 0 h 573"/>
                  <a:gd name="T54" fmla="*/ 308 w 418"/>
                  <a:gd name="T55" fmla="*/ 8 h 573"/>
                  <a:gd name="T56" fmla="*/ 389 w 418"/>
                  <a:gd name="T57" fmla="*/ 29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418" h="573">
                    <a:moveTo>
                      <a:pt x="389" y="29"/>
                    </a:moveTo>
                    <a:lnTo>
                      <a:pt x="389" y="114"/>
                    </a:lnTo>
                    <a:cubicBezTo>
                      <a:pt x="363" y="102"/>
                      <a:pt x="337" y="92"/>
                      <a:pt x="310" y="85"/>
                    </a:cubicBezTo>
                    <a:cubicBezTo>
                      <a:pt x="282" y="79"/>
                      <a:pt x="254" y="75"/>
                      <a:pt x="225" y="75"/>
                    </a:cubicBezTo>
                    <a:cubicBezTo>
                      <a:pt x="180" y="75"/>
                      <a:pt x="146" y="82"/>
                      <a:pt x="124" y="96"/>
                    </a:cubicBezTo>
                    <a:cubicBezTo>
                      <a:pt x="102" y="110"/>
                      <a:pt x="91" y="130"/>
                      <a:pt x="91" y="157"/>
                    </a:cubicBezTo>
                    <a:cubicBezTo>
                      <a:pt x="91" y="178"/>
                      <a:pt x="99" y="194"/>
                      <a:pt x="115" y="206"/>
                    </a:cubicBezTo>
                    <a:cubicBezTo>
                      <a:pt x="131" y="218"/>
                      <a:pt x="163" y="230"/>
                      <a:pt x="211" y="240"/>
                    </a:cubicBezTo>
                    <a:lnTo>
                      <a:pt x="242" y="247"/>
                    </a:lnTo>
                    <a:cubicBezTo>
                      <a:pt x="306" y="261"/>
                      <a:pt x="351" y="281"/>
                      <a:pt x="378" y="305"/>
                    </a:cubicBezTo>
                    <a:cubicBezTo>
                      <a:pt x="404" y="330"/>
                      <a:pt x="418" y="365"/>
                      <a:pt x="418" y="409"/>
                    </a:cubicBezTo>
                    <a:cubicBezTo>
                      <a:pt x="418" y="460"/>
                      <a:pt x="398" y="500"/>
                      <a:pt x="358" y="529"/>
                    </a:cubicBezTo>
                    <a:cubicBezTo>
                      <a:pt x="318" y="559"/>
                      <a:pt x="262" y="573"/>
                      <a:pt x="192" y="573"/>
                    </a:cubicBezTo>
                    <a:cubicBezTo>
                      <a:pt x="162" y="573"/>
                      <a:pt x="132" y="570"/>
                      <a:pt x="100" y="565"/>
                    </a:cubicBezTo>
                    <a:cubicBezTo>
                      <a:pt x="68" y="560"/>
                      <a:pt x="35" y="552"/>
                      <a:pt x="0" y="540"/>
                    </a:cubicBezTo>
                    <a:lnTo>
                      <a:pt x="0" y="447"/>
                    </a:lnTo>
                    <a:cubicBezTo>
                      <a:pt x="33" y="465"/>
                      <a:pt x="66" y="478"/>
                      <a:pt x="98" y="486"/>
                    </a:cubicBezTo>
                    <a:cubicBezTo>
                      <a:pt x="130" y="495"/>
                      <a:pt x="162" y="499"/>
                      <a:pt x="194" y="499"/>
                    </a:cubicBezTo>
                    <a:cubicBezTo>
                      <a:pt x="236" y="499"/>
                      <a:pt x="269" y="492"/>
                      <a:pt x="292" y="478"/>
                    </a:cubicBezTo>
                    <a:cubicBezTo>
                      <a:pt x="314" y="464"/>
                      <a:pt x="326" y="443"/>
                      <a:pt x="326" y="416"/>
                    </a:cubicBezTo>
                    <a:cubicBezTo>
                      <a:pt x="326" y="392"/>
                      <a:pt x="317" y="373"/>
                      <a:pt x="301" y="360"/>
                    </a:cubicBezTo>
                    <a:cubicBezTo>
                      <a:pt x="285" y="347"/>
                      <a:pt x="249" y="334"/>
                      <a:pt x="193" y="322"/>
                    </a:cubicBezTo>
                    <a:lnTo>
                      <a:pt x="162" y="315"/>
                    </a:lnTo>
                    <a:cubicBezTo>
                      <a:pt x="106" y="303"/>
                      <a:pt x="65" y="285"/>
                      <a:pt x="41" y="261"/>
                    </a:cubicBezTo>
                    <a:cubicBezTo>
                      <a:pt x="16" y="237"/>
                      <a:pt x="4" y="204"/>
                      <a:pt x="4" y="161"/>
                    </a:cubicBezTo>
                    <a:cubicBezTo>
                      <a:pt x="4" y="110"/>
                      <a:pt x="22" y="70"/>
                      <a:pt x="58" y="42"/>
                    </a:cubicBezTo>
                    <a:cubicBezTo>
                      <a:pt x="94" y="14"/>
                      <a:pt x="146" y="0"/>
                      <a:pt x="214" y="0"/>
                    </a:cubicBezTo>
                    <a:cubicBezTo>
                      <a:pt x="247" y="0"/>
                      <a:pt x="278" y="3"/>
                      <a:pt x="308" y="8"/>
                    </a:cubicBezTo>
                    <a:cubicBezTo>
                      <a:pt x="337" y="13"/>
                      <a:pt x="364" y="20"/>
                      <a:pt x="389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8" name="Freeform 200">
                <a:extLst>
                  <a:ext uri="{FF2B5EF4-FFF2-40B4-BE49-F238E27FC236}">
                    <a16:creationId xmlns:a16="http://schemas.microsoft.com/office/drawing/2014/main" id="{E5F0A7C4-8F7E-B092-F85F-2ABFA7C867A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900613" y="5235575"/>
                <a:ext cx="39688" cy="160338"/>
              </a:xfrm>
              <a:custGeom>
                <a:avLst/>
                <a:gdLst>
                  <a:gd name="T0" fmla="*/ 224 w 224"/>
                  <a:gd name="T1" fmla="*/ 0 h 890"/>
                  <a:gd name="T2" fmla="*/ 127 w 224"/>
                  <a:gd name="T3" fmla="*/ 223 h 890"/>
                  <a:gd name="T4" fmla="*/ 95 w 224"/>
                  <a:gd name="T5" fmla="*/ 445 h 890"/>
                  <a:gd name="T6" fmla="*/ 127 w 224"/>
                  <a:gd name="T7" fmla="*/ 668 h 890"/>
                  <a:gd name="T8" fmla="*/ 224 w 224"/>
                  <a:gd name="T9" fmla="*/ 890 h 890"/>
                  <a:gd name="T10" fmla="*/ 146 w 224"/>
                  <a:gd name="T11" fmla="*/ 890 h 890"/>
                  <a:gd name="T12" fmla="*/ 36 w 224"/>
                  <a:gd name="T13" fmla="*/ 665 h 890"/>
                  <a:gd name="T14" fmla="*/ 0 w 224"/>
                  <a:gd name="T15" fmla="*/ 445 h 890"/>
                  <a:gd name="T16" fmla="*/ 36 w 224"/>
                  <a:gd name="T17" fmla="*/ 226 h 890"/>
                  <a:gd name="T18" fmla="*/ 146 w 224"/>
                  <a:gd name="T19" fmla="*/ 0 h 890"/>
                  <a:gd name="T20" fmla="*/ 224 w 224"/>
                  <a:gd name="T21" fmla="*/ 0 h 8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224" h="890">
                    <a:moveTo>
                      <a:pt x="224" y="0"/>
                    </a:moveTo>
                    <a:cubicBezTo>
                      <a:pt x="180" y="76"/>
                      <a:pt x="148" y="150"/>
                      <a:pt x="127" y="223"/>
                    </a:cubicBezTo>
                    <a:cubicBezTo>
                      <a:pt x="105" y="296"/>
                      <a:pt x="95" y="370"/>
                      <a:pt x="95" y="445"/>
                    </a:cubicBezTo>
                    <a:cubicBezTo>
                      <a:pt x="95" y="521"/>
                      <a:pt x="105" y="595"/>
                      <a:pt x="127" y="668"/>
                    </a:cubicBezTo>
                    <a:cubicBezTo>
                      <a:pt x="148" y="742"/>
                      <a:pt x="180" y="815"/>
                      <a:pt x="224" y="890"/>
                    </a:cubicBezTo>
                    <a:lnTo>
                      <a:pt x="146" y="890"/>
                    </a:lnTo>
                    <a:cubicBezTo>
                      <a:pt x="97" y="813"/>
                      <a:pt x="60" y="739"/>
                      <a:pt x="36" y="665"/>
                    </a:cubicBezTo>
                    <a:cubicBezTo>
                      <a:pt x="12" y="591"/>
                      <a:pt x="0" y="518"/>
                      <a:pt x="0" y="445"/>
                    </a:cubicBezTo>
                    <a:cubicBezTo>
                      <a:pt x="0" y="373"/>
                      <a:pt x="12" y="300"/>
                      <a:pt x="36" y="226"/>
                    </a:cubicBezTo>
                    <a:cubicBezTo>
                      <a:pt x="60" y="152"/>
                      <a:pt x="96" y="77"/>
                      <a:pt x="146" y="0"/>
                    </a:cubicBezTo>
                    <a:lnTo>
                      <a:pt x="224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9" name="Freeform 201">
                <a:extLst>
                  <a:ext uri="{FF2B5EF4-FFF2-40B4-BE49-F238E27FC236}">
                    <a16:creationId xmlns:a16="http://schemas.microsoft.com/office/drawing/2014/main" id="{E9A90AD5-F468-BFA4-BDCC-969804F5961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86350" y="5270500"/>
                <a:ext cx="142875" cy="101600"/>
              </a:xfrm>
              <a:custGeom>
                <a:avLst/>
                <a:gdLst>
                  <a:gd name="T0" fmla="*/ 429 w 798"/>
                  <a:gd name="T1" fmla="*/ 118 h 560"/>
                  <a:gd name="T2" fmla="*/ 509 w 798"/>
                  <a:gd name="T3" fmla="*/ 29 h 560"/>
                  <a:gd name="T4" fmla="*/ 620 w 798"/>
                  <a:gd name="T5" fmla="*/ 0 h 560"/>
                  <a:gd name="T6" fmla="*/ 751 w 798"/>
                  <a:gd name="T7" fmla="*/ 60 h 560"/>
                  <a:gd name="T8" fmla="*/ 798 w 798"/>
                  <a:gd name="T9" fmla="*/ 230 h 560"/>
                  <a:gd name="T10" fmla="*/ 798 w 798"/>
                  <a:gd name="T11" fmla="*/ 560 h 560"/>
                  <a:gd name="T12" fmla="*/ 708 w 798"/>
                  <a:gd name="T13" fmla="*/ 560 h 560"/>
                  <a:gd name="T14" fmla="*/ 708 w 798"/>
                  <a:gd name="T15" fmla="*/ 233 h 560"/>
                  <a:gd name="T16" fmla="*/ 680 w 798"/>
                  <a:gd name="T17" fmla="*/ 116 h 560"/>
                  <a:gd name="T18" fmla="*/ 595 w 798"/>
                  <a:gd name="T19" fmla="*/ 78 h 560"/>
                  <a:gd name="T20" fmla="*/ 484 w 798"/>
                  <a:gd name="T21" fmla="*/ 125 h 560"/>
                  <a:gd name="T22" fmla="*/ 444 w 798"/>
                  <a:gd name="T23" fmla="*/ 251 h 560"/>
                  <a:gd name="T24" fmla="*/ 444 w 798"/>
                  <a:gd name="T25" fmla="*/ 560 h 560"/>
                  <a:gd name="T26" fmla="*/ 354 w 798"/>
                  <a:gd name="T27" fmla="*/ 560 h 560"/>
                  <a:gd name="T28" fmla="*/ 354 w 798"/>
                  <a:gd name="T29" fmla="*/ 233 h 560"/>
                  <a:gd name="T30" fmla="*/ 326 w 798"/>
                  <a:gd name="T31" fmla="*/ 116 h 560"/>
                  <a:gd name="T32" fmla="*/ 240 w 798"/>
                  <a:gd name="T33" fmla="*/ 78 h 560"/>
                  <a:gd name="T34" fmla="*/ 130 w 798"/>
                  <a:gd name="T35" fmla="*/ 125 h 560"/>
                  <a:gd name="T36" fmla="*/ 90 w 798"/>
                  <a:gd name="T37" fmla="*/ 251 h 560"/>
                  <a:gd name="T38" fmla="*/ 90 w 798"/>
                  <a:gd name="T39" fmla="*/ 560 h 560"/>
                  <a:gd name="T40" fmla="*/ 0 w 798"/>
                  <a:gd name="T41" fmla="*/ 560 h 560"/>
                  <a:gd name="T42" fmla="*/ 0 w 798"/>
                  <a:gd name="T43" fmla="*/ 13 h 560"/>
                  <a:gd name="T44" fmla="*/ 90 w 798"/>
                  <a:gd name="T45" fmla="*/ 13 h 560"/>
                  <a:gd name="T46" fmla="*/ 90 w 798"/>
                  <a:gd name="T47" fmla="*/ 98 h 560"/>
                  <a:gd name="T48" fmla="*/ 164 w 798"/>
                  <a:gd name="T49" fmla="*/ 24 h 560"/>
                  <a:gd name="T50" fmla="*/ 266 w 798"/>
                  <a:gd name="T51" fmla="*/ 0 h 560"/>
                  <a:gd name="T52" fmla="*/ 367 w 798"/>
                  <a:gd name="T53" fmla="*/ 30 h 560"/>
                  <a:gd name="T54" fmla="*/ 429 w 798"/>
                  <a:gd name="T55" fmla="*/ 118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</a:cxnLst>
                <a:rect l="0" t="0" r="r" b="b"/>
                <a:pathLst>
                  <a:path w="798" h="560">
                    <a:moveTo>
                      <a:pt x="429" y="118"/>
                    </a:moveTo>
                    <a:cubicBezTo>
                      <a:pt x="451" y="78"/>
                      <a:pt x="478" y="49"/>
                      <a:pt x="509" y="29"/>
                    </a:cubicBezTo>
                    <a:cubicBezTo>
                      <a:pt x="540" y="10"/>
                      <a:pt x="577" y="0"/>
                      <a:pt x="620" y="0"/>
                    </a:cubicBezTo>
                    <a:cubicBezTo>
                      <a:pt x="676" y="0"/>
                      <a:pt x="720" y="20"/>
                      <a:pt x="751" y="60"/>
                    </a:cubicBezTo>
                    <a:cubicBezTo>
                      <a:pt x="782" y="100"/>
                      <a:pt x="798" y="157"/>
                      <a:pt x="798" y="230"/>
                    </a:cubicBezTo>
                    <a:lnTo>
                      <a:pt x="798" y="560"/>
                    </a:lnTo>
                    <a:lnTo>
                      <a:pt x="708" y="560"/>
                    </a:lnTo>
                    <a:lnTo>
                      <a:pt x="708" y="233"/>
                    </a:lnTo>
                    <a:cubicBezTo>
                      <a:pt x="708" y="181"/>
                      <a:pt x="698" y="142"/>
                      <a:pt x="680" y="116"/>
                    </a:cubicBezTo>
                    <a:cubicBezTo>
                      <a:pt x="661" y="91"/>
                      <a:pt x="633" y="78"/>
                      <a:pt x="595" y="78"/>
                    </a:cubicBezTo>
                    <a:cubicBezTo>
                      <a:pt x="548" y="78"/>
                      <a:pt x="511" y="94"/>
                      <a:pt x="484" y="125"/>
                    </a:cubicBezTo>
                    <a:cubicBezTo>
                      <a:pt x="457" y="156"/>
                      <a:pt x="444" y="198"/>
                      <a:pt x="444" y="251"/>
                    </a:cubicBezTo>
                    <a:lnTo>
                      <a:pt x="444" y="560"/>
                    </a:lnTo>
                    <a:lnTo>
                      <a:pt x="354" y="560"/>
                    </a:lnTo>
                    <a:lnTo>
                      <a:pt x="354" y="233"/>
                    </a:lnTo>
                    <a:cubicBezTo>
                      <a:pt x="354" y="181"/>
                      <a:pt x="344" y="142"/>
                      <a:pt x="326" y="116"/>
                    </a:cubicBezTo>
                    <a:cubicBezTo>
                      <a:pt x="307" y="91"/>
                      <a:pt x="278" y="78"/>
                      <a:pt x="240" y="78"/>
                    </a:cubicBezTo>
                    <a:cubicBezTo>
                      <a:pt x="194" y="78"/>
                      <a:pt x="157" y="94"/>
                      <a:pt x="130" y="125"/>
                    </a:cubicBezTo>
                    <a:cubicBezTo>
                      <a:pt x="103" y="156"/>
                      <a:pt x="90" y="198"/>
                      <a:pt x="90" y="251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10" y="65"/>
                      <a:pt x="135" y="40"/>
                      <a:pt x="164" y="24"/>
                    </a:cubicBezTo>
                    <a:cubicBezTo>
                      <a:pt x="192" y="8"/>
                      <a:pt x="226" y="0"/>
                      <a:pt x="266" y="0"/>
                    </a:cubicBezTo>
                    <a:cubicBezTo>
                      <a:pt x="306" y="0"/>
                      <a:pt x="339" y="10"/>
                      <a:pt x="367" y="30"/>
                    </a:cubicBezTo>
                    <a:cubicBezTo>
                      <a:pt x="395" y="50"/>
                      <a:pt x="415" y="80"/>
                      <a:pt x="429" y="11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0" name="Freeform 202">
                <a:extLst>
                  <a:ext uri="{FF2B5EF4-FFF2-40B4-BE49-F238E27FC236}">
                    <a16:creationId xmlns:a16="http://schemas.microsoft.com/office/drawing/2014/main" id="{035AB16A-C35C-8FE8-E7F5-E85915C5B94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259388" y="5235575"/>
                <a:ext cx="39688" cy="160338"/>
              </a:xfrm>
              <a:custGeom>
                <a:avLst/>
                <a:gdLst>
                  <a:gd name="T0" fmla="*/ 0 w 224"/>
                  <a:gd name="T1" fmla="*/ 0 h 890"/>
                  <a:gd name="T2" fmla="*/ 78 w 224"/>
                  <a:gd name="T3" fmla="*/ 0 h 890"/>
                  <a:gd name="T4" fmla="*/ 187 w 224"/>
                  <a:gd name="T5" fmla="*/ 226 h 890"/>
                  <a:gd name="T6" fmla="*/ 224 w 224"/>
                  <a:gd name="T7" fmla="*/ 445 h 890"/>
                  <a:gd name="T8" fmla="*/ 187 w 224"/>
                  <a:gd name="T9" fmla="*/ 665 h 890"/>
                  <a:gd name="T10" fmla="*/ 78 w 224"/>
                  <a:gd name="T11" fmla="*/ 890 h 890"/>
                  <a:gd name="T12" fmla="*/ 0 w 224"/>
                  <a:gd name="T13" fmla="*/ 890 h 890"/>
                  <a:gd name="T14" fmla="*/ 97 w 224"/>
                  <a:gd name="T15" fmla="*/ 668 h 890"/>
                  <a:gd name="T16" fmla="*/ 129 w 224"/>
                  <a:gd name="T17" fmla="*/ 445 h 890"/>
                  <a:gd name="T18" fmla="*/ 97 w 224"/>
                  <a:gd name="T19" fmla="*/ 223 h 890"/>
                  <a:gd name="T20" fmla="*/ 0 w 224"/>
                  <a:gd name="T21" fmla="*/ 0 h 8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224" h="890">
                    <a:moveTo>
                      <a:pt x="0" y="0"/>
                    </a:moveTo>
                    <a:lnTo>
                      <a:pt x="78" y="0"/>
                    </a:lnTo>
                    <a:cubicBezTo>
                      <a:pt x="126" y="77"/>
                      <a:pt x="163" y="152"/>
                      <a:pt x="187" y="226"/>
                    </a:cubicBezTo>
                    <a:cubicBezTo>
                      <a:pt x="211" y="300"/>
                      <a:pt x="224" y="373"/>
                      <a:pt x="224" y="445"/>
                    </a:cubicBezTo>
                    <a:cubicBezTo>
                      <a:pt x="224" y="518"/>
                      <a:pt x="211" y="591"/>
                      <a:pt x="187" y="665"/>
                    </a:cubicBezTo>
                    <a:cubicBezTo>
                      <a:pt x="163" y="739"/>
                      <a:pt x="126" y="813"/>
                      <a:pt x="78" y="890"/>
                    </a:cubicBezTo>
                    <a:lnTo>
                      <a:pt x="0" y="890"/>
                    </a:lnTo>
                    <a:cubicBezTo>
                      <a:pt x="43" y="815"/>
                      <a:pt x="75" y="742"/>
                      <a:pt x="97" y="668"/>
                    </a:cubicBezTo>
                    <a:cubicBezTo>
                      <a:pt x="118" y="595"/>
                      <a:pt x="129" y="521"/>
                      <a:pt x="129" y="445"/>
                    </a:cubicBezTo>
                    <a:cubicBezTo>
                      <a:pt x="129" y="370"/>
                      <a:pt x="118" y="296"/>
                      <a:pt x="97" y="223"/>
                    </a:cubicBezTo>
                    <a:cubicBezTo>
                      <a:pt x="75" y="150"/>
                      <a:pt x="43" y="76"/>
                      <a:pt x="0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1" name="Freeform 203">
                <a:extLst>
                  <a:ext uri="{FF2B5EF4-FFF2-40B4-BE49-F238E27FC236}">
                    <a16:creationId xmlns:a16="http://schemas.microsoft.com/office/drawing/2014/main" id="{F6E2A2EA-F056-2DB4-0E62-688C8BF873A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970463" y="5273675"/>
                <a:ext cx="95250" cy="134938"/>
              </a:xfrm>
              <a:custGeom>
                <a:avLst/>
                <a:gdLst>
                  <a:gd name="T0" fmla="*/ 0 w 527"/>
                  <a:gd name="T1" fmla="*/ 754 h 754"/>
                  <a:gd name="T2" fmla="*/ 0 w 527"/>
                  <a:gd name="T3" fmla="*/ 0 h 754"/>
                  <a:gd name="T4" fmla="*/ 90 w 527"/>
                  <a:gd name="T5" fmla="*/ 0 h 754"/>
                  <a:gd name="T6" fmla="*/ 90 w 527"/>
                  <a:gd name="T7" fmla="*/ 340 h 754"/>
                  <a:gd name="T8" fmla="*/ 123 w 527"/>
                  <a:gd name="T9" fmla="*/ 447 h 754"/>
                  <a:gd name="T10" fmla="*/ 223 w 527"/>
                  <a:gd name="T11" fmla="*/ 483 h 754"/>
                  <a:gd name="T12" fmla="*/ 331 w 527"/>
                  <a:gd name="T13" fmla="*/ 442 h 754"/>
                  <a:gd name="T14" fmla="*/ 368 w 527"/>
                  <a:gd name="T15" fmla="*/ 319 h 754"/>
                  <a:gd name="T16" fmla="*/ 368 w 527"/>
                  <a:gd name="T17" fmla="*/ 0 h 754"/>
                  <a:gd name="T18" fmla="*/ 458 w 527"/>
                  <a:gd name="T19" fmla="*/ 0 h 754"/>
                  <a:gd name="T20" fmla="*/ 458 w 527"/>
                  <a:gd name="T21" fmla="*/ 421 h 754"/>
                  <a:gd name="T22" fmla="*/ 466 w 527"/>
                  <a:gd name="T23" fmla="*/ 464 h 754"/>
                  <a:gd name="T24" fmla="*/ 493 w 527"/>
                  <a:gd name="T25" fmla="*/ 478 h 754"/>
                  <a:gd name="T26" fmla="*/ 505 w 527"/>
                  <a:gd name="T27" fmla="*/ 476 h 754"/>
                  <a:gd name="T28" fmla="*/ 527 w 527"/>
                  <a:gd name="T29" fmla="*/ 467 h 754"/>
                  <a:gd name="T30" fmla="*/ 527 w 527"/>
                  <a:gd name="T31" fmla="*/ 539 h 754"/>
                  <a:gd name="T32" fmla="*/ 489 w 527"/>
                  <a:gd name="T33" fmla="*/ 554 h 754"/>
                  <a:gd name="T34" fmla="*/ 454 w 527"/>
                  <a:gd name="T35" fmla="*/ 560 h 754"/>
                  <a:gd name="T36" fmla="*/ 400 w 527"/>
                  <a:gd name="T37" fmla="*/ 542 h 754"/>
                  <a:gd name="T38" fmla="*/ 373 w 527"/>
                  <a:gd name="T39" fmla="*/ 484 h 754"/>
                  <a:gd name="T40" fmla="*/ 313 w 527"/>
                  <a:gd name="T41" fmla="*/ 542 h 754"/>
                  <a:gd name="T42" fmla="*/ 230 w 527"/>
                  <a:gd name="T43" fmla="*/ 560 h 754"/>
                  <a:gd name="T44" fmla="*/ 145 w 527"/>
                  <a:gd name="T45" fmla="*/ 542 h 754"/>
                  <a:gd name="T46" fmla="*/ 90 w 527"/>
                  <a:gd name="T47" fmla="*/ 485 h 754"/>
                  <a:gd name="T48" fmla="*/ 90 w 527"/>
                  <a:gd name="T49" fmla="*/ 754 h 754"/>
                  <a:gd name="T50" fmla="*/ 0 w 527"/>
                  <a:gd name="T51" fmla="*/ 754 h 7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</a:cxnLst>
                <a:rect l="0" t="0" r="r" b="b"/>
                <a:pathLst>
                  <a:path w="527" h="754">
                    <a:moveTo>
                      <a:pt x="0" y="754"/>
                    </a:moveTo>
                    <a:lnTo>
                      <a:pt x="0" y="0"/>
                    </a:lnTo>
                    <a:lnTo>
                      <a:pt x="90" y="0"/>
                    </a:lnTo>
                    <a:lnTo>
                      <a:pt x="90" y="340"/>
                    </a:lnTo>
                    <a:cubicBezTo>
                      <a:pt x="90" y="388"/>
                      <a:pt x="101" y="423"/>
                      <a:pt x="123" y="447"/>
                    </a:cubicBezTo>
                    <a:cubicBezTo>
                      <a:pt x="145" y="471"/>
                      <a:pt x="179" y="483"/>
                      <a:pt x="223" y="483"/>
                    </a:cubicBezTo>
                    <a:cubicBezTo>
                      <a:pt x="271" y="483"/>
                      <a:pt x="307" y="470"/>
                      <a:pt x="331" y="442"/>
                    </a:cubicBezTo>
                    <a:cubicBezTo>
                      <a:pt x="355" y="415"/>
                      <a:pt x="368" y="374"/>
                      <a:pt x="368" y="319"/>
                    </a:cubicBezTo>
                    <a:lnTo>
                      <a:pt x="368" y="0"/>
                    </a:lnTo>
                    <a:lnTo>
                      <a:pt x="458" y="0"/>
                    </a:lnTo>
                    <a:lnTo>
                      <a:pt x="458" y="421"/>
                    </a:lnTo>
                    <a:cubicBezTo>
                      <a:pt x="458" y="441"/>
                      <a:pt x="460" y="455"/>
                      <a:pt x="466" y="464"/>
                    </a:cubicBezTo>
                    <a:cubicBezTo>
                      <a:pt x="472" y="474"/>
                      <a:pt x="481" y="478"/>
                      <a:pt x="493" y="478"/>
                    </a:cubicBezTo>
                    <a:cubicBezTo>
                      <a:pt x="496" y="478"/>
                      <a:pt x="500" y="478"/>
                      <a:pt x="505" y="476"/>
                    </a:cubicBezTo>
                    <a:cubicBezTo>
                      <a:pt x="510" y="474"/>
                      <a:pt x="517" y="471"/>
                      <a:pt x="527" y="467"/>
                    </a:cubicBezTo>
                    <a:lnTo>
                      <a:pt x="527" y="539"/>
                    </a:lnTo>
                    <a:cubicBezTo>
                      <a:pt x="513" y="546"/>
                      <a:pt x="501" y="550"/>
                      <a:pt x="489" y="554"/>
                    </a:cubicBezTo>
                    <a:cubicBezTo>
                      <a:pt x="477" y="558"/>
                      <a:pt x="465" y="560"/>
                      <a:pt x="454" y="560"/>
                    </a:cubicBezTo>
                    <a:cubicBezTo>
                      <a:pt x="431" y="560"/>
                      <a:pt x="413" y="554"/>
                      <a:pt x="400" y="542"/>
                    </a:cubicBezTo>
                    <a:cubicBezTo>
                      <a:pt x="386" y="530"/>
                      <a:pt x="377" y="510"/>
                      <a:pt x="373" y="484"/>
                    </a:cubicBezTo>
                    <a:cubicBezTo>
                      <a:pt x="357" y="510"/>
                      <a:pt x="337" y="530"/>
                      <a:pt x="313" y="542"/>
                    </a:cubicBezTo>
                    <a:cubicBezTo>
                      <a:pt x="289" y="554"/>
                      <a:pt x="262" y="560"/>
                      <a:pt x="230" y="560"/>
                    </a:cubicBezTo>
                    <a:cubicBezTo>
                      <a:pt x="196" y="560"/>
                      <a:pt x="168" y="554"/>
                      <a:pt x="145" y="542"/>
                    </a:cubicBezTo>
                    <a:cubicBezTo>
                      <a:pt x="121" y="530"/>
                      <a:pt x="103" y="511"/>
                      <a:pt x="90" y="485"/>
                    </a:cubicBezTo>
                    <a:lnTo>
                      <a:pt x="90" y="754"/>
                    </a:lnTo>
                    <a:lnTo>
                      <a:pt x="0" y="754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2" name="Line 204">
                <a:extLst>
                  <a:ext uri="{FF2B5EF4-FFF2-40B4-BE49-F238E27FC236}">
                    <a16:creationId xmlns:a16="http://schemas.microsoft.com/office/drawing/2014/main" id="{3C06CDCE-D28B-3A36-A783-BB2FE409B6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9763" y="4576763"/>
                <a:ext cx="3268663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3" name="Freeform 205">
                <a:extLst>
                  <a:ext uri="{FF2B5EF4-FFF2-40B4-BE49-F238E27FC236}">
                    <a16:creationId xmlns:a16="http://schemas.microsoft.com/office/drawing/2014/main" id="{94332EFB-8F96-C637-B86F-B42AA2C8F69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70188" y="4513263"/>
                <a:ext cx="77788" cy="131763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4" name="Freeform 206">
                <a:extLst>
                  <a:ext uri="{FF2B5EF4-FFF2-40B4-BE49-F238E27FC236}">
                    <a16:creationId xmlns:a16="http://schemas.microsoft.com/office/drawing/2014/main" id="{71914F54-BFC6-C8AB-2C1F-DE2E9D633DA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78138" y="4511675"/>
                <a:ext cx="82550" cy="133350"/>
              </a:xfrm>
              <a:custGeom>
                <a:avLst/>
                <a:gdLst>
                  <a:gd name="T0" fmla="*/ 119 w 463"/>
                  <a:gd name="T1" fmla="*/ 659 h 742"/>
                  <a:gd name="T2" fmla="*/ 463 w 463"/>
                  <a:gd name="T3" fmla="*/ 659 h 742"/>
                  <a:gd name="T4" fmla="*/ 463 w 463"/>
                  <a:gd name="T5" fmla="*/ 742 h 742"/>
                  <a:gd name="T6" fmla="*/ 0 w 463"/>
                  <a:gd name="T7" fmla="*/ 742 h 742"/>
                  <a:gd name="T8" fmla="*/ 0 w 463"/>
                  <a:gd name="T9" fmla="*/ 659 h 742"/>
                  <a:gd name="T10" fmla="*/ 153 w 463"/>
                  <a:gd name="T11" fmla="*/ 503 h 742"/>
                  <a:gd name="T12" fmla="*/ 275 w 463"/>
                  <a:gd name="T13" fmla="*/ 377 h 742"/>
                  <a:gd name="T14" fmla="*/ 341 w 463"/>
                  <a:gd name="T15" fmla="*/ 287 h 742"/>
                  <a:gd name="T16" fmla="*/ 360 w 463"/>
                  <a:gd name="T17" fmla="*/ 214 h 742"/>
                  <a:gd name="T18" fmla="*/ 319 w 463"/>
                  <a:gd name="T19" fmla="*/ 120 h 742"/>
                  <a:gd name="T20" fmla="*/ 213 w 463"/>
                  <a:gd name="T21" fmla="*/ 83 h 742"/>
                  <a:gd name="T22" fmla="*/ 115 w 463"/>
                  <a:gd name="T23" fmla="*/ 99 h 742"/>
                  <a:gd name="T24" fmla="*/ 5 w 463"/>
                  <a:gd name="T25" fmla="*/ 148 h 742"/>
                  <a:gd name="T26" fmla="*/ 5 w 463"/>
                  <a:gd name="T27" fmla="*/ 48 h 742"/>
                  <a:gd name="T28" fmla="*/ 116 w 463"/>
                  <a:gd name="T29" fmla="*/ 12 h 742"/>
                  <a:gd name="T30" fmla="*/ 211 w 463"/>
                  <a:gd name="T31" fmla="*/ 0 h 742"/>
                  <a:gd name="T32" fmla="*/ 391 w 463"/>
                  <a:gd name="T33" fmla="*/ 57 h 742"/>
                  <a:gd name="T34" fmla="*/ 459 w 463"/>
                  <a:gd name="T35" fmla="*/ 208 h 742"/>
                  <a:gd name="T36" fmla="*/ 442 w 463"/>
                  <a:gd name="T37" fmla="*/ 293 h 742"/>
                  <a:gd name="T38" fmla="*/ 381 w 463"/>
                  <a:gd name="T39" fmla="*/ 388 h 742"/>
                  <a:gd name="T40" fmla="*/ 303 w 463"/>
                  <a:gd name="T41" fmla="*/ 470 h 742"/>
                  <a:gd name="T42" fmla="*/ 119 w 463"/>
                  <a:gd name="T43" fmla="*/ 659 h 7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463" h="742">
                    <a:moveTo>
                      <a:pt x="119" y="659"/>
                    </a:moveTo>
                    <a:lnTo>
                      <a:pt x="463" y="659"/>
                    </a:lnTo>
                    <a:lnTo>
                      <a:pt x="463" y="742"/>
                    </a:lnTo>
                    <a:lnTo>
                      <a:pt x="0" y="742"/>
                    </a:lnTo>
                    <a:lnTo>
                      <a:pt x="0" y="659"/>
                    </a:lnTo>
                    <a:cubicBezTo>
                      <a:pt x="37" y="621"/>
                      <a:pt x="88" y="569"/>
                      <a:pt x="153" y="503"/>
                    </a:cubicBezTo>
                    <a:cubicBezTo>
                      <a:pt x="217" y="438"/>
                      <a:pt x="258" y="396"/>
                      <a:pt x="275" y="377"/>
                    </a:cubicBezTo>
                    <a:cubicBezTo>
                      <a:pt x="307" y="342"/>
                      <a:pt x="329" y="312"/>
                      <a:pt x="341" y="287"/>
                    </a:cubicBezTo>
                    <a:cubicBezTo>
                      <a:pt x="353" y="263"/>
                      <a:pt x="360" y="238"/>
                      <a:pt x="360" y="214"/>
                    </a:cubicBezTo>
                    <a:cubicBezTo>
                      <a:pt x="360" y="176"/>
                      <a:pt x="346" y="144"/>
                      <a:pt x="319" y="120"/>
                    </a:cubicBezTo>
                    <a:cubicBezTo>
                      <a:pt x="292" y="96"/>
                      <a:pt x="257" y="83"/>
                      <a:pt x="213" y="83"/>
                    </a:cubicBezTo>
                    <a:cubicBezTo>
                      <a:pt x="182" y="83"/>
                      <a:pt x="149" y="89"/>
                      <a:pt x="115" y="99"/>
                    </a:cubicBezTo>
                    <a:cubicBezTo>
                      <a:pt x="81" y="110"/>
                      <a:pt x="44" y="126"/>
                      <a:pt x="5" y="148"/>
                    </a:cubicBezTo>
                    <a:lnTo>
                      <a:pt x="5" y="48"/>
                    </a:lnTo>
                    <a:cubicBezTo>
                      <a:pt x="45" y="32"/>
                      <a:pt x="82" y="20"/>
                      <a:pt x="116" y="12"/>
                    </a:cubicBezTo>
                    <a:cubicBezTo>
                      <a:pt x="150" y="4"/>
                      <a:pt x="182" y="0"/>
                      <a:pt x="211" y="0"/>
                    </a:cubicBezTo>
                    <a:cubicBezTo>
                      <a:pt x="286" y="0"/>
                      <a:pt x="346" y="19"/>
                      <a:pt x="391" y="57"/>
                    </a:cubicBezTo>
                    <a:cubicBezTo>
                      <a:pt x="436" y="95"/>
                      <a:pt x="459" y="145"/>
                      <a:pt x="459" y="208"/>
                    </a:cubicBezTo>
                    <a:cubicBezTo>
                      <a:pt x="459" y="238"/>
                      <a:pt x="453" y="267"/>
                      <a:pt x="442" y="293"/>
                    </a:cubicBezTo>
                    <a:cubicBezTo>
                      <a:pt x="431" y="320"/>
                      <a:pt x="411" y="352"/>
                      <a:pt x="381" y="388"/>
                    </a:cubicBezTo>
                    <a:cubicBezTo>
                      <a:pt x="373" y="398"/>
                      <a:pt x="347" y="425"/>
                      <a:pt x="303" y="470"/>
                    </a:cubicBezTo>
                    <a:cubicBezTo>
                      <a:pt x="259" y="515"/>
                      <a:pt x="198" y="578"/>
                      <a:pt x="119" y="65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5" name="Freeform 207">
                <a:extLst>
                  <a:ext uri="{FF2B5EF4-FFF2-40B4-BE49-F238E27FC236}">
                    <a16:creationId xmlns:a16="http://schemas.microsoft.com/office/drawing/2014/main" id="{1A9E7FDA-59D8-CFA3-8105-478F4C3BA6B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990850" y="4511675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6" name="Line 208">
                <a:extLst>
                  <a:ext uri="{FF2B5EF4-FFF2-40B4-BE49-F238E27FC236}">
                    <a16:creationId xmlns:a16="http://schemas.microsoft.com/office/drawing/2014/main" id="{727C2D31-A3D7-1C24-A7B1-E378D555EF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9763" y="4003675"/>
                <a:ext cx="3268663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7" name="Freeform 209">
                <a:extLst>
                  <a:ext uri="{FF2B5EF4-FFF2-40B4-BE49-F238E27FC236}">
                    <a16:creationId xmlns:a16="http://schemas.microsoft.com/office/drawing/2014/main" id="{6A71F732-49B0-FB13-588D-73480F70706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70188" y="3940175"/>
                <a:ext cx="77788" cy="131763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8" name="Freeform 210">
                <a:extLst>
                  <a:ext uri="{FF2B5EF4-FFF2-40B4-BE49-F238E27FC236}">
                    <a16:creationId xmlns:a16="http://schemas.microsoft.com/office/drawing/2014/main" id="{A309B232-591A-F2D9-CE7E-8B35E27EFB1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78138" y="3937000"/>
                <a:ext cx="82550" cy="134938"/>
              </a:xfrm>
              <a:custGeom>
                <a:avLst/>
                <a:gdLst>
                  <a:gd name="T0" fmla="*/ 119 w 463"/>
                  <a:gd name="T1" fmla="*/ 659 h 742"/>
                  <a:gd name="T2" fmla="*/ 463 w 463"/>
                  <a:gd name="T3" fmla="*/ 659 h 742"/>
                  <a:gd name="T4" fmla="*/ 463 w 463"/>
                  <a:gd name="T5" fmla="*/ 742 h 742"/>
                  <a:gd name="T6" fmla="*/ 0 w 463"/>
                  <a:gd name="T7" fmla="*/ 742 h 742"/>
                  <a:gd name="T8" fmla="*/ 0 w 463"/>
                  <a:gd name="T9" fmla="*/ 659 h 742"/>
                  <a:gd name="T10" fmla="*/ 153 w 463"/>
                  <a:gd name="T11" fmla="*/ 503 h 742"/>
                  <a:gd name="T12" fmla="*/ 275 w 463"/>
                  <a:gd name="T13" fmla="*/ 377 h 742"/>
                  <a:gd name="T14" fmla="*/ 341 w 463"/>
                  <a:gd name="T15" fmla="*/ 287 h 742"/>
                  <a:gd name="T16" fmla="*/ 360 w 463"/>
                  <a:gd name="T17" fmla="*/ 214 h 742"/>
                  <a:gd name="T18" fmla="*/ 319 w 463"/>
                  <a:gd name="T19" fmla="*/ 120 h 742"/>
                  <a:gd name="T20" fmla="*/ 213 w 463"/>
                  <a:gd name="T21" fmla="*/ 83 h 742"/>
                  <a:gd name="T22" fmla="*/ 115 w 463"/>
                  <a:gd name="T23" fmla="*/ 99 h 742"/>
                  <a:gd name="T24" fmla="*/ 5 w 463"/>
                  <a:gd name="T25" fmla="*/ 148 h 742"/>
                  <a:gd name="T26" fmla="*/ 5 w 463"/>
                  <a:gd name="T27" fmla="*/ 48 h 742"/>
                  <a:gd name="T28" fmla="*/ 116 w 463"/>
                  <a:gd name="T29" fmla="*/ 12 h 742"/>
                  <a:gd name="T30" fmla="*/ 211 w 463"/>
                  <a:gd name="T31" fmla="*/ 0 h 742"/>
                  <a:gd name="T32" fmla="*/ 391 w 463"/>
                  <a:gd name="T33" fmla="*/ 57 h 742"/>
                  <a:gd name="T34" fmla="*/ 459 w 463"/>
                  <a:gd name="T35" fmla="*/ 208 h 742"/>
                  <a:gd name="T36" fmla="*/ 442 w 463"/>
                  <a:gd name="T37" fmla="*/ 293 h 742"/>
                  <a:gd name="T38" fmla="*/ 381 w 463"/>
                  <a:gd name="T39" fmla="*/ 388 h 742"/>
                  <a:gd name="T40" fmla="*/ 303 w 463"/>
                  <a:gd name="T41" fmla="*/ 470 h 742"/>
                  <a:gd name="T42" fmla="*/ 119 w 463"/>
                  <a:gd name="T43" fmla="*/ 659 h 7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463" h="742">
                    <a:moveTo>
                      <a:pt x="119" y="659"/>
                    </a:moveTo>
                    <a:lnTo>
                      <a:pt x="463" y="659"/>
                    </a:lnTo>
                    <a:lnTo>
                      <a:pt x="463" y="742"/>
                    </a:lnTo>
                    <a:lnTo>
                      <a:pt x="0" y="742"/>
                    </a:lnTo>
                    <a:lnTo>
                      <a:pt x="0" y="659"/>
                    </a:lnTo>
                    <a:cubicBezTo>
                      <a:pt x="37" y="621"/>
                      <a:pt x="88" y="569"/>
                      <a:pt x="153" y="503"/>
                    </a:cubicBezTo>
                    <a:cubicBezTo>
                      <a:pt x="217" y="438"/>
                      <a:pt x="258" y="396"/>
                      <a:pt x="275" y="377"/>
                    </a:cubicBezTo>
                    <a:cubicBezTo>
                      <a:pt x="307" y="342"/>
                      <a:pt x="329" y="312"/>
                      <a:pt x="341" y="287"/>
                    </a:cubicBezTo>
                    <a:cubicBezTo>
                      <a:pt x="353" y="263"/>
                      <a:pt x="360" y="238"/>
                      <a:pt x="360" y="214"/>
                    </a:cubicBezTo>
                    <a:cubicBezTo>
                      <a:pt x="360" y="176"/>
                      <a:pt x="346" y="144"/>
                      <a:pt x="319" y="120"/>
                    </a:cubicBezTo>
                    <a:cubicBezTo>
                      <a:pt x="292" y="96"/>
                      <a:pt x="257" y="83"/>
                      <a:pt x="213" y="83"/>
                    </a:cubicBezTo>
                    <a:cubicBezTo>
                      <a:pt x="182" y="83"/>
                      <a:pt x="149" y="89"/>
                      <a:pt x="115" y="99"/>
                    </a:cubicBezTo>
                    <a:cubicBezTo>
                      <a:pt x="81" y="110"/>
                      <a:pt x="44" y="126"/>
                      <a:pt x="5" y="148"/>
                    </a:cubicBezTo>
                    <a:lnTo>
                      <a:pt x="5" y="48"/>
                    </a:lnTo>
                    <a:cubicBezTo>
                      <a:pt x="45" y="32"/>
                      <a:pt x="82" y="20"/>
                      <a:pt x="116" y="12"/>
                    </a:cubicBezTo>
                    <a:cubicBezTo>
                      <a:pt x="150" y="4"/>
                      <a:pt x="182" y="0"/>
                      <a:pt x="211" y="0"/>
                    </a:cubicBezTo>
                    <a:cubicBezTo>
                      <a:pt x="286" y="0"/>
                      <a:pt x="346" y="19"/>
                      <a:pt x="391" y="57"/>
                    </a:cubicBezTo>
                    <a:cubicBezTo>
                      <a:pt x="436" y="95"/>
                      <a:pt x="459" y="145"/>
                      <a:pt x="459" y="208"/>
                    </a:cubicBezTo>
                    <a:cubicBezTo>
                      <a:pt x="459" y="238"/>
                      <a:pt x="453" y="267"/>
                      <a:pt x="442" y="293"/>
                    </a:cubicBezTo>
                    <a:cubicBezTo>
                      <a:pt x="431" y="320"/>
                      <a:pt x="411" y="352"/>
                      <a:pt x="381" y="388"/>
                    </a:cubicBezTo>
                    <a:cubicBezTo>
                      <a:pt x="373" y="398"/>
                      <a:pt x="347" y="425"/>
                      <a:pt x="303" y="470"/>
                    </a:cubicBezTo>
                    <a:cubicBezTo>
                      <a:pt x="259" y="515"/>
                      <a:pt x="198" y="578"/>
                      <a:pt x="119" y="65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9" name="Freeform 211">
                <a:extLst>
                  <a:ext uri="{FF2B5EF4-FFF2-40B4-BE49-F238E27FC236}">
                    <a16:creationId xmlns:a16="http://schemas.microsoft.com/office/drawing/2014/main" id="{1E0582C5-FC08-5A4E-A1AC-B05C956237A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94025" y="3940175"/>
                <a:ext cx="84138" cy="133350"/>
              </a:xfrm>
              <a:custGeom>
                <a:avLst/>
                <a:gdLst>
                  <a:gd name="T0" fmla="*/ 31 w 472"/>
                  <a:gd name="T1" fmla="*/ 0 h 742"/>
                  <a:gd name="T2" fmla="*/ 418 w 472"/>
                  <a:gd name="T3" fmla="*/ 0 h 742"/>
                  <a:gd name="T4" fmla="*/ 418 w 472"/>
                  <a:gd name="T5" fmla="*/ 83 h 742"/>
                  <a:gd name="T6" fmla="*/ 121 w 472"/>
                  <a:gd name="T7" fmla="*/ 83 h 742"/>
                  <a:gd name="T8" fmla="*/ 121 w 472"/>
                  <a:gd name="T9" fmla="*/ 262 h 742"/>
                  <a:gd name="T10" fmla="*/ 164 w 472"/>
                  <a:gd name="T11" fmla="*/ 251 h 742"/>
                  <a:gd name="T12" fmla="*/ 207 w 472"/>
                  <a:gd name="T13" fmla="*/ 247 h 742"/>
                  <a:gd name="T14" fmla="*/ 400 w 472"/>
                  <a:gd name="T15" fmla="*/ 314 h 742"/>
                  <a:gd name="T16" fmla="*/ 472 w 472"/>
                  <a:gd name="T17" fmla="*/ 495 h 742"/>
                  <a:gd name="T18" fmla="*/ 398 w 472"/>
                  <a:gd name="T19" fmla="*/ 678 h 742"/>
                  <a:gd name="T20" fmla="*/ 192 w 472"/>
                  <a:gd name="T21" fmla="*/ 742 h 742"/>
                  <a:gd name="T22" fmla="*/ 98 w 472"/>
                  <a:gd name="T23" fmla="*/ 735 h 742"/>
                  <a:gd name="T24" fmla="*/ 0 w 472"/>
                  <a:gd name="T25" fmla="*/ 712 h 742"/>
                  <a:gd name="T26" fmla="*/ 0 w 472"/>
                  <a:gd name="T27" fmla="*/ 613 h 742"/>
                  <a:gd name="T28" fmla="*/ 91 w 472"/>
                  <a:gd name="T29" fmla="*/ 649 h 742"/>
                  <a:gd name="T30" fmla="*/ 190 w 472"/>
                  <a:gd name="T31" fmla="*/ 660 h 742"/>
                  <a:gd name="T32" fmla="*/ 324 w 472"/>
                  <a:gd name="T33" fmla="*/ 616 h 742"/>
                  <a:gd name="T34" fmla="*/ 373 w 472"/>
                  <a:gd name="T35" fmla="*/ 495 h 742"/>
                  <a:gd name="T36" fmla="*/ 324 w 472"/>
                  <a:gd name="T37" fmla="*/ 375 h 742"/>
                  <a:gd name="T38" fmla="*/ 190 w 472"/>
                  <a:gd name="T39" fmla="*/ 330 h 742"/>
                  <a:gd name="T40" fmla="*/ 111 w 472"/>
                  <a:gd name="T41" fmla="*/ 339 h 742"/>
                  <a:gd name="T42" fmla="*/ 31 w 472"/>
                  <a:gd name="T43" fmla="*/ 366 h 742"/>
                  <a:gd name="T44" fmla="*/ 31 w 472"/>
                  <a:gd name="T45" fmla="*/ 0 h 7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72" h="742">
                    <a:moveTo>
                      <a:pt x="31" y="0"/>
                    </a:moveTo>
                    <a:lnTo>
                      <a:pt x="418" y="0"/>
                    </a:lnTo>
                    <a:lnTo>
                      <a:pt x="418" y="83"/>
                    </a:lnTo>
                    <a:lnTo>
                      <a:pt x="121" y="83"/>
                    </a:lnTo>
                    <a:lnTo>
                      <a:pt x="121" y="262"/>
                    </a:lnTo>
                    <a:cubicBezTo>
                      <a:pt x="135" y="257"/>
                      <a:pt x="150" y="253"/>
                      <a:pt x="164" y="251"/>
                    </a:cubicBezTo>
                    <a:cubicBezTo>
                      <a:pt x="178" y="249"/>
                      <a:pt x="193" y="247"/>
                      <a:pt x="207" y="247"/>
                    </a:cubicBezTo>
                    <a:cubicBezTo>
                      <a:pt x="288" y="247"/>
                      <a:pt x="352" y="270"/>
                      <a:pt x="400" y="314"/>
                    </a:cubicBezTo>
                    <a:cubicBezTo>
                      <a:pt x="448" y="359"/>
                      <a:pt x="472" y="419"/>
                      <a:pt x="472" y="495"/>
                    </a:cubicBezTo>
                    <a:cubicBezTo>
                      <a:pt x="472" y="574"/>
                      <a:pt x="447" y="635"/>
                      <a:pt x="398" y="678"/>
                    </a:cubicBezTo>
                    <a:cubicBezTo>
                      <a:pt x="349" y="721"/>
                      <a:pt x="280" y="742"/>
                      <a:pt x="192" y="742"/>
                    </a:cubicBezTo>
                    <a:cubicBezTo>
                      <a:pt x="161" y="742"/>
                      <a:pt x="130" y="739"/>
                      <a:pt x="98" y="735"/>
                    </a:cubicBezTo>
                    <a:cubicBezTo>
                      <a:pt x="66" y="730"/>
                      <a:pt x="34" y="723"/>
                      <a:pt x="0" y="712"/>
                    </a:cubicBezTo>
                    <a:lnTo>
                      <a:pt x="0" y="613"/>
                    </a:lnTo>
                    <a:cubicBezTo>
                      <a:pt x="29" y="629"/>
                      <a:pt x="59" y="641"/>
                      <a:pt x="91" y="649"/>
                    </a:cubicBezTo>
                    <a:cubicBezTo>
                      <a:pt x="122" y="657"/>
                      <a:pt x="155" y="660"/>
                      <a:pt x="190" y="660"/>
                    </a:cubicBezTo>
                    <a:cubicBezTo>
                      <a:pt x="246" y="660"/>
                      <a:pt x="291" y="646"/>
                      <a:pt x="324" y="616"/>
                    </a:cubicBezTo>
                    <a:cubicBezTo>
                      <a:pt x="356" y="586"/>
                      <a:pt x="373" y="546"/>
                      <a:pt x="373" y="495"/>
                    </a:cubicBezTo>
                    <a:cubicBezTo>
                      <a:pt x="373" y="445"/>
                      <a:pt x="356" y="405"/>
                      <a:pt x="324" y="375"/>
                    </a:cubicBezTo>
                    <a:cubicBezTo>
                      <a:pt x="291" y="345"/>
                      <a:pt x="246" y="330"/>
                      <a:pt x="190" y="330"/>
                    </a:cubicBezTo>
                    <a:cubicBezTo>
                      <a:pt x="164" y="330"/>
                      <a:pt x="137" y="333"/>
                      <a:pt x="111" y="339"/>
                    </a:cubicBezTo>
                    <a:cubicBezTo>
                      <a:pt x="85" y="345"/>
                      <a:pt x="58" y="354"/>
                      <a:pt x="31" y="366"/>
                    </a:cubicBezTo>
                    <a:lnTo>
                      <a:pt x="31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0" name="Line 212">
                <a:extLst>
                  <a:ext uri="{FF2B5EF4-FFF2-40B4-BE49-F238E27FC236}">
                    <a16:creationId xmlns:a16="http://schemas.microsoft.com/office/drawing/2014/main" id="{C1A9135B-C0B3-8037-B406-BBB6EC9C76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9763" y="3429000"/>
                <a:ext cx="3268663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1" name="Freeform 213">
                <a:extLst>
                  <a:ext uri="{FF2B5EF4-FFF2-40B4-BE49-F238E27FC236}">
                    <a16:creationId xmlns:a16="http://schemas.microsoft.com/office/drawing/2014/main" id="{0D343A51-3B97-80B3-15B4-67AEE60EF52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70188" y="3367088"/>
                <a:ext cx="77788" cy="130175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2" name="Freeform 214">
                <a:extLst>
                  <a:ext uri="{FF2B5EF4-FFF2-40B4-BE49-F238E27FC236}">
                    <a16:creationId xmlns:a16="http://schemas.microsoft.com/office/drawing/2014/main" id="{F8582922-DFEC-9997-E74B-6D9B58A2710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78138" y="3363913"/>
                <a:ext cx="87313" cy="136525"/>
              </a:xfrm>
              <a:custGeom>
                <a:avLst/>
                <a:gdLst>
                  <a:gd name="T0" fmla="*/ 330 w 480"/>
                  <a:gd name="T1" fmla="*/ 349 h 755"/>
                  <a:gd name="T2" fmla="*/ 440 w 480"/>
                  <a:gd name="T3" fmla="*/ 412 h 755"/>
                  <a:gd name="T4" fmla="*/ 480 w 480"/>
                  <a:gd name="T5" fmla="*/ 530 h 755"/>
                  <a:gd name="T6" fmla="*/ 406 w 480"/>
                  <a:gd name="T7" fmla="*/ 697 h 755"/>
                  <a:gd name="T8" fmla="*/ 195 w 480"/>
                  <a:gd name="T9" fmla="*/ 755 h 755"/>
                  <a:gd name="T10" fmla="*/ 100 w 480"/>
                  <a:gd name="T11" fmla="*/ 746 h 755"/>
                  <a:gd name="T12" fmla="*/ 0 w 480"/>
                  <a:gd name="T13" fmla="*/ 720 h 755"/>
                  <a:gd name="T14" fmla="*/ 0 w 480"/>
                  <a:gd name="T15" fmla="*/ 625 h 755"/>
                  <a:gd name="T16" fmla="*/ 90 w 480"/>
                  <a:gd name="T17" fmla="*/ 661 h 755"/>
                  <a:gd name="T18" fmla="*/ 192 w 480"/>
                  <a:gd name="T19" fmla="*/ 673 h 755"/>
                  <a:gd name="T20" fmla="*/ 333 w 480"/>
                  <a:gd name="T21" fmla="*/ 637 h 755"/>
                  <a:gd name="T22" fmla="*/ 382 w 480"/>
                  <a:gd name="T23" fmla="*/ 530 h 755"/>
                  <a:gd name="T24" fmla="*/ 337 w 480"/>
                  <a:gd name="T25" fmla="*/ 430 h 755"/>
                  <a:gd name="T26" fmla="*/ 211 w 480"/>
                  <a:gd name="T27" fmla="*/ 393 h 755"/>
                  <a:gd name="T28" fmla="*/ 126 w 480"/>
                  <a:gd name="T29" fmla="*/ 393 h 755"/>
                  <a:gd name="T30" fmla="*/ 126 w 480"/>
                  <a:gd name="T31" fmla="*/ 312 h 755"/>
                  <a:gd name="T32" fmla="*/ 215 w 480"/>
                  <a:gd name="T33" fmla="*/ 312 h 755"/>
                  <a:gd name="T34" fmla="*/ 326 w 480"/>
                  <a:gd name="T35" fmla="*/ 283 h 755"/>
                  <a:gd name="T36" fmla="*/ 365 w 480"/>
                  <a:gd name="T37" fmla="*/ 199 h 755"/>
                  <a:gd name="T38" fmla="*/ 325 w 480"/>
                  <a:gd name="T39" fmla="*/ 113 h 755"/>
                  <a:gd name="T40" fmla="*/ 211 w 480"/>
                  <a:gd name="T41" fmla="*/ 83 h 755"/>
                  <a:gd name="T42" fmla="*/ 124 w 480"/>
                  <a:gd name="T43" fmla="*/ 92 h 755"/>
                  <a:gd name="T44" fmla="*/ 22 w 480"/>
                  <a:gd name="T45" fmla="*/ 119 h 755"/>
                  <a:gd name="T46" fmla="*/ 22 w 480"/>
                  <a:gd name="T47" fmla="*/ 31 h 755"/>
                  <a:gd name="T48" fmla="*/ 127 w 480"/>
                  <a:gd name="T49" fmla="*/ 8 h 755"/>
                  <a:gd name="T50" fmla="*/ 220 w 480"/>
                  <a:gd name="T51" fmla="*/ 0 h 755"/>
                  <a:gd name="T52" fmla="*/ 397 w 480"/>
                  <a:gd name="T53" fmla="*/ 51 h 755"/>
                  <a:gd name="T54" fmla="*/ 463 w 480"/>
                  <a:gd name="T55" fmla="*/ 189 h 755"/>
                  <a:gd name="T56" fmla="*/ 428 w 480"/>
                  <a:gd name="T57" fmla="*/ 291 h 755"/>
                  <a:gd name="T58" fmla="*/ 330 w 480"/>
                  <a:gd name="T59" fmla="*/ 349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480" h="755">
                    <a:moveTo>
                      <a:pt x="330" y="349"/>
                    </a:moveTo>
                    <a:cubicBezTo>
                      <a:pt x="377" y="359"/>
                      <a:pt x="414" y="380"/>
                      <a:pt x="440" y="412"/>
                    </a:cubicBezTo>
                    <a:cubicBezTo>
                      <a:pt x="466" y="444"/>
                      <a:pt x="480" y="484"/>
                      <a:pt x="480" y="530"/>
                    </a:cubicBezTo>
                    <a:cubicBezTo>
                      <a:pt x="480" y="602"/>
                      <a:pt x="455" y="658"/>
                      <a:pt x="406" y="697"/>
                    </a:cubicBezTo>
                    <a:cubicBezTo>
                      <a:pt x="356" y="736"/>
                      <a:pt x="286" y="755"/>
                      <a:pt x="195" y="755"/>
                    </a:cubicBezTo>
                    <a:cubicBezTo>
                      <a:pt x="164" y="755"/>
                      <a:pt x="132" y="752"/>
                      <a:pt x="100" y="746"/>
                    </a:cubicBezTo>
                    <a:cubicBezTo>
                      <a:pt x="68" y="741"/>
                      <a:pt x="34" y="732"/>
                      <a:pt x="0" y="720"/>
                    </a:cubicBezTo>
                    <a:lnTo>
                      <a:pt x="0" y="625"/>
                    </a:lnTo>
                    <a:cubicBezTo>
                      <a:pt x="27" y="641"/>
                      <a:pt x="57" y="653"/>
                      <a:pt x="90" y="661"/>
                    </a:cubicBezTo>
                    <a:cubicBezTo>
                      <a:pt x="122" y="669"/>
                      <a:pt x="156" y="673"/>
                      <a:pt x="192" y="673"/>
                    </a:cubicBezTo>
                    <a:cubicBezTo>
                      <a:pt x="254" y="673"/>
                      <a:pt x="301" y="661"/>
                      <a:pt x="333" y="637"/>
                    </a:cubicBezTo>
                    <a:cubicBezTo>
                      <a:pt x="365" y="613"/>
                      <a:pt x="382" y="577"/>
                      <a:pt x="382" y="530"/>
                    </a:cubicBezTo>
                    <a:cubicBezTo>
                      <a:pt x="382" y="488"/>
                      <a:pt x="367" y="454"/>
                      <a:pt x="337" y="430"/>
                    </a:cubicBezTo>
                    <a:cubicBezTo>
                      <a:pt x="307" y="406"/>
                      <a:pt x="265" y="393"/>
                      <a:pt x="211" y="393"/>
                    </a:cubicBezTo>
                    <a:lnTo>
                      <a:pt x="126" y="393"/>
                    </a:lnTo>
                    <a:lnTo>
                      <a:pt x="126" y="312"/>
                    </a:lnTo>
                    <a:lnTo>
                      <a:pt x="215" y="312"/>
                    </a:lnTo>
                    <a:cubicBezTo>
                      <a:pt x="263" y="312"/>
                      <a:pt x="300" y="303"/>
                      <a:pt x="326" y="283"/>
                    </a:cubicBezTo>
                    <a:cubicBezTo>
                      <a:pt x="352" y="264"/>
                      <a:pt x="365" y="236"/>
                      <a:pt x="365" y="199"/>
                    </a:cubicBezTo>
                    <a:cubicBezTo>
                      <a:pt x="365" y="162"/>
                      <a:pt x="351" y="133"/>
                      <a:pt x="325" y="113"/>
                    </a:cubicBezTo>
                    <a:cubicBezTo>
                      <a:pt x="298" y="93"/>
                      <a:pt x="260" y="83"/>
                      <a:pt x="211" y="83"/>
                    </a:cubicBezTo>
                    <a:cubicBezTo>
                      <a:pt x="184" y="83"/>
                      <a:pt x="155" y="86"/>
                      <a:pt x="124" y="92"/>
                    </a:cubicBezTo>
                    <a:cubicBezTo>
                      <a:pt x="93" y="98"/>
                      <a:pt x="59" y="107"/>
                      <a:pt x="22" y="119"/>
                    </a:cubicBezTo>
                    <a:lnTo>
                      <a:pt x="22" y="31"/>
                    </a:lnTo>
                    <a:cubicBezTo>
                      <a:pt x="59" y="21"/>
                      <a:pt x="94" y="13"/>
                      <a:pt x="127" y="8"/>
                    </a:cubicBezTo>
                    <a:cubicBezTo>
                      <a:pt x="159" y="3"/>
                      <a:pt x="190" y="0"/>
                      <a:pt x="220" y="0"/>
                    </a:cubicBezTo>
                    <a:cubicBezTo>
                      <a:pt x="294" y="0"/>
                      <a:pt x="353" y="17"/>
                      <a:pt x="397" y="51"/>
                    </a:cubicBezTo>
                    <a:cubicBezTo>
                      <a:pt x="441" y="85"/>
                      <a:pt x="463" y="131"/>
                      <a:pt x="463" y="189"/>
                    </a:cubicBezTo>
                    <a:cubicBezTo>
                      <a:pt x="463" y="229"/>
                      <a:pt x="451" y="263"/>
                      <a:pt x="428" y="291"/>
                    </a:cubicBezTo>
                    <a:cubicBezTo>
                      <a:pt x="405" y="319"/>
                      <a:pt x="372" y="339"/>
                      <a:pt x="330" y="34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3" name="Freeform 215">
                <a:extLst>
                  <a:ext uri="{FF2B5EF4-FFF2-40B4-BE49-F238E27FC236}">
                    <a16:creationId xmlns:a16="http://schemas.microsoft.com/office/drawing/2014/main" id="{3B76F0D5-C41F-50CF-4B95-C4B6E91EF17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990850" y="3363913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4" name="Line 216">
                <a:extLst>
                  <a:ext uri="{FF2B5EF4-FFF2-40B4-BE49-F238E27FC236}">
                    <a16:creationId xmlns:a16="http://schemas.microsoft.com/office/drawing/2014/main" id="{206AAB5C-CD6D-A555-8577-C711B68ED1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9763" y="2855913"/>
                <a:ext cx="3268663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5" name="Freeform 217">
                <a:extLst>
                  <a:ext uri="{FF2B5EF4-FFF2-40B4-BE49-F238E27FC236}">
                    <a16:creationId xmlns:a16="http://schemas.microsoft.com/office/drawing/2014/main" id="{83AB7EDB-9B14-3627-7716-253F4929E58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70188" y="2792413"/>
                <a:ext cx="77788" cy="131763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6" name="Freeform 218">
                <a:extLst>
                  <a:ext uri="{FF2B5EF4-FFF2-40B4-BE49-F238E27FC236}">
                    <a16:creationId xmlns:a16="http://schemas.microsoft.com/office/drawing/2014/main" id="{3B398030-300A-F6D7-F720-7B851B5C7DA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78138" y="2790825"/>
                <a:ext cx="87313" cy="136525"/>
              </a:xfrm>
              <a:custGeom>
                <a:avLst/>
                <a:gdLst>
                  <a:gd name="T0" fmla="*/ 330 w 480"/>
                  <a:gd name="T1" fmla="*/ 349 h 755"/>
                  <a:gd name="T2" fmla="*/ 440 w 480"/>
                  <a:gd name="T3" fmla="*/ 412 h 755"/>
                  <a:gd name="T4" fmla="*/ 480 w 480"/>
                  <a:gd name="T5" fmla="*/ 530 h 755"/>
                  <a:gd name="T6" fmla="*/ 406 w 480"/>
                  <a:gd name="T7" fmla="*/ 697 h 755"/>
                  <a:gd name="T8" fmla="*/ 195 w 480"/>
                  <a:gd name="T9" fmla="*/ 755 h 755"/>
                  <a:gd name="T10" fmla="*/ 100 w 480"/>
                  <a:gd name="T11" fmla="*/ 746 h 755"/>
                  <a:gd name="T12" fmla="*/ 0 w 480"/>
                  <a:gd name="T13" fmla="*/ 720 h 755"/>
                  <a:gd name="T14" fmla="*/ 0 w 480"/>
                  <a:gd name="T15" fmla="*/ 625 h 755"/>
                  <a:gd name="T16" fmla="*/ 90 w 480"/>
                  <a:gd name="T17" fmla="*/ 661 h 755"/>
                  <a:gd name="T18" fmla="*/ 192 w 480"/>
                  <a:gd name="T19" fmla="*/ 673 h 755"/>
                  <a:gd name="T20" fmla="*/ 333 w 480"/>
                  <a:gd name="T21" fmla="*/ 637 h 755"/>
                  <a:gd name="T22" fmla="*/ 382 w 480"/>
                  <a:gd name="T23" fmla="*/ 530 h 755"/>
                  <a:gd name="T24" fmla="*/ 337 w 480"/>
                  <a:gd name="T25" fmla="*/ 430 h 755"/>
                  <a:gd name="T26" fmla="*/ 211 w 480"/>
                  <a:gd name="T27" fmla="*/ 393 h 755"/>
                  <a:gd name="T28" fmla="*/ 126 w 480"/>
                  <a:gd name="T29" fmla="*/ 393 h 755"/>
                  <a:gd name="T30" fmla="*/ 126 w 480"/>
                  <a:gd name="T31" fmla="*/ 312 h 755"/>
                  <a:gd name="T32" fmla="*/ 215 w 480"/>
                  <a:gd name="T33" fmla="*/ 312 h 755"/>
                  <a:gd name="T34" fmla="*/ 326 w 480"/>
                  <a:gd name="T35" fmla="*/ 283 h 755"/>
                  <a:gd name="T36" fmla="*/ 365 w 480"/>
                  <a:gd name="T37" fmla="*/ 199 h 755"/>
                  <a:gd name="T38" fmla="*/ 325 w 480"/>
                  <a:gd name="T39" fmla="*/ 113 h 755"/>
                  <a:gd name="T40" fmla="*/ 211 w 480"/>
                  <a:gd name="T41" fmla="*/ 83 h 755"/>
                  <a:gd name="T42" fmla="*/ 124 w 480"/>
                  <a:gd name="T43" fmla="*/ 92 h 755"/>
                  <a:gd name="T44" fmla="*/ 22 w 480"/>
                  <a:gd name="T45" fmla="*/ 119 h 755"/>
                  <a:gd name="T46" fmla="*/ 22 w 480"/>
                  <a:gd name="T47" fmla="*/ 31 h 755"/>
                  <a:gd name="T48" fmla="*/ 127 w 480"/>
                  <a:gd name="T49" fmla="*/ 8 h 755"/>
                  <a:gd name="T50" fmla="*/ 220 w 480"/>
                  <a:gd name="T51" fmla="*/ 0 h 755"/>
                  <a:gd name="T52" fmla="*/ 397 w 480"/>
                  <a:gd name="T53" fmla="*/ 51 h 755"/>
                  <a:gd name="T54" fmla="*/ 463 w 480"/>
                  <a:gd name="T55" fmla="*/ 189 h 755"/>
                  <a:gd name="T56" fmla="*/ 428 w 480"/>
                  <a:gd name="T57" fmla="*/ 291 h 755"/>
                  <a:gd name="T58" fmla="*/ 330 w 480"/>
                  <a:gd name="T59" fmla="*/ 349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480" h="755">
                    <a:moveTo>
                      <a:pt x="330" y="349"/>
                    </a:moveTo>
                    <a:cubicBezTo>
                      <a:pt x="377" y="359"/>
                      <a:pt x="414" y="380"/>
                      <a:pt x="440" y="412"/>
                    </a:cubicBezTo>
                    <a:cubicBezTo>
                      <a:pt x="466" y="444"/>
                      <a:pt x="480" y="484"/>
                      <a:pt x="480" y="530"/>
                    </a:cubicBezTo>
                    <a:cubicBezTo>
                      <a:pt x="480" y="602"/>
                      <a:pt x="455" y="658"/>
                      <a:pt x="406" y="697"/>
                    </a:cubicBezTo>
                    <a:cubicBezTo>
                      <a:pt x="356" y="736"/>
                      <a:pt x="286" y="755"/>
                      <a:pt x="195" y="755"/>
                    </a:cubicBezTo>
                    <a:cubicBezTo>
                      <a:pt x="164" y="755"/>
                      <a:pt x="132" y="752"/>
                      <a:pt x="100" y="746"/>
                    </a:cubicBezTo>
                    <a:cubicBezTo>
                      <a:pt x="68" y="741"/>
                      <a:pt x="34" y="732"/>
                      <a:pt x="0" y="720"/>
                    </a:cubicBezTo>
                    <a:lnTo>
                      <a:pt x="0" y="625"/>
                    </a:lnTo>
                    <a:cubicBezTo>
                      <a:pt x="27" y="641"/>
                      <a:pt x="57" y="653"/>
                      <a:pt x="90" y="661"/>
                    </a:cubicBezTo>
                    <a:cubicBezTo>
                      <a:pt x="122" y="669"/>
                      <a:pt x="156" y="673"/>
                      <a:pt x="192" y="673"/>
                    </a:cubicBezTo>
                    <a:cubicBezTo>
                      <a:pt x="254" y="673"/>
                      <a:pt x="301" y="661"/>
                      <a:pt x="333" y="637"/>
                    </a:cubicBezTo>
                    <a:cubicBezTo>
                      <a:pt x="365" y="613"/>
                      <a:pt x="382" y="577"/>
                      <a:pt x="382" y="530"/>
                    </a:cubicBezTo>
                    <a:cubicBezTo>
                      <a:pt x="382" y="488"/>
                      <a:pt x="367" y="454"/>
                      <a:pt x="337" y="430"/>
                    </a:cubicBezTo>
                    <a:cubicBezTo>
                      <a:pt x="307" y="406"/>
                      <a:pt x="265" y="393"/>
                      <a:pt x="211" y="393"/>
                    </a:cubicBezTo>
                    <a:lnTo>
                      <a:pt x="126" y="393"/>
                    </a:lnTo>
                    <a:lnTo>
                      <a:pt x="126" y="312"/>
                    </a:lnTo>
                    <a:lnTo>
                      <a:pt x="215" y="312"/>
                    </a:lnTo>
                    <a:cubicBezTo>
                      <a:pt x="263" y="312"/>
                      <a:pt x="300" y="303"/>
                      <a:pt x="326" y="283"/>
                    </a:cubicBezTo>
                    <a:cubicBezTo>
                      <a:pt x="352" y="264"/>
                      <a:pt x="365" y="236"/>
                      <a:pt x="365" y="199"/>
                    </a:cubicBezTo>
                    <a:cubicBezTo>
                      <a:pt x="365" y="162"/>
                      <a:pt x="351" y="133"/>
                      <a:pt x="325" y="113"/>
                    </a:cubicBezTo>
                    <a:cubicBezTo>
                      <a:pt x="298" y="93"/>
                      <a:pt x="260" y="83"/>
                      <a:pt x="211" y="83"/>
                    </a:cubicBezTo>
                    <a:cubicBezTo>
                      <a:pt x="184" y="83"/>
                      <a:pt x="155" y="86"/>
                      <a:pt x="124" y="92"/>
                    </a:cubicBezTo>
                    <a:cubicBezTo>
                      <a:pt x="93" y="98"/>
                      <a:pt x="59" y="107"/>
                      <a:pt x="22" y="119"/>
                    </a:cubicBezTo>
                    <a:lnTo>
                      <a:pt x="22" y="31"/>
                    </a:lnTo>
                    <a:cubicBezTo>
                      <a:pt x="59" y="21"/>
                      <a:pt x="94" y="13"/>
                      <a:pt x="127" y="8"/>
                    </a:cubicBezTo>
                    <a:cubicBezTo>
                      <a:pt x="159" y="3"/>
                      <a:pt x="190" y="0"/>
                      <a:pt x="220" y="0"/>
                    </a:cubicBezTo>
                    <a:cubicBezTo>
                      <a:pt x="294" y="0"/>
                      <a:pt x="353" y="17"/>
                      <a:pt x="397" y="51"/>
                    </a:cubicBezTo>
                    <a:cubicBezTo>
                      <a:pt x="441" y="85"/>
                      <a:pt x="463" y="131"/>
                      <a:pt x="463" y="189"/>
                    </a:cubicBezTo>
                    <a:cubicBezTo>
                      <a:pt x="463" y="229"/>
                      <a:pt x="451" y="263"/>
                      <a:pt x="428" y="291"/>
                    </a:cubicBezTo>
                    <a:cubicBezTo>
                      <a:pt x="405" y="319"/>
                      <a:pt x="372" y="339"/>
                      <a:pt x="330" y="34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7" name="Freeform 219">
                <a:extLst>
                  <a:ext uri="{FF2B5EF4-FFF2-40B4-BE49-F238E27FC236}">
                    <a16:creationId xmlns:a16="http://schemas.microsoft.com/office/drawing/2014/main" id="{83765487-AAA3-935B-A78E-47586317F7C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94025" y="2792413"/>
                <a:ext cx="84138" cy="134938"/>
              </a:xfrm>
              <a:custGeom>
                <a:avLst/>
                <a:gdLst>
                  <a:gd name="T0" fmla="*/ 31 w 472"/>
                  <a:gd name="T1" fmla="*/ 0 h 742"/>
                  <a:gd name="T2" fmla="*/ 418 w 472"/>
                  <a:gd name="T3" fmla="*/ 0 h 742"/>
                  <a:gd name="T4" fmla="*/ 418 w 472"/>
                  <a:gd name="T5" fmla="*/ 83 h 742"/>
                  <a:gd name="T6" fmla="*/ 121 w 472"/>
                  <a:gd name="T7" fmla="*/ 83 h 742"/>
                  <a:gd name="T8" fmla="*/ 121 w 472"/>
                  <a:gd name="T9" fmla="*/ 262 h 742"/>
                  <a:gd name="T10" fmla="*/ 164 w 472"/>
                  <a:gd name="T11" fmla="*/ 251 h 742"/>
                  <a:gd name="T12" fmla="*/ 207 w 472"/>
                  <a:gd name="T13" fmla="*/ 247 h 742"/>
                  <a:gd name="T14" fmla="*/ 400 w 472"/>
                  <a:gd name="T15" fmla="*/ 314 h 742"/>
                  <a:gd name="T16" fmla="*/ 472 w 472"/>
                  <a:gd name="T17" fmla="*/ 495 h 742"/>
                  <a:gd name="T18" fmla="*/ 398 w 472"/>
                  <a:gd name="T19" fmla="*/ 678 h 742"/>
                  <a:gd name="T20" fmla="*/ 192 w 472"/>
                  <a:gd name="T21" fmla="*/ 742 h 742"/>
                  <a:gd name="T22" fmla="*/ 98 w 472"/>
                  <a:gd name="T23" fmla="*/ 735 h 742"/>
                  <a:gd name="T24" fmla="*/ 0 w 472"/>
                  <a:gd name="T25" fmla="*/ 712 h 742"/>
                  <a:gd name="T26" fmla="*/ 0 w 472"/>
                  <a:gd name="T27" fmla="*/ 613 h 742"/>
                  <a:gd name="T28" fmla="*/ 91 w 472"/>
                  <a:gd name="T29" fmla="*/ 649 h 742"/>
                  <a:gd name="T30" fmla="*/ 190 w 472"/>
                  <a:gd name="T31" fmla="*/ 660 h 742"/>
                  <a:gd name="T32" fmla="*/ 324 w 472"/>
                  <a:gd name="T33" fmla="*/ 616 h 742"/>
                  <a:gd name="T34" fmla="*/ 373 w 472"/>
                  <a:gd name="T35" fmla="*/ 495 h 742"/>
                  <a:gd name="T36" fmla="*/ 324 w 472"/>
                  <a:gd name="T37" fmla="*/ 375 h 742"/>
                  <a:gd name="T38" fmla="*/ 190 w 472"/>
                  <a:gd name="T39" fmla="*/ 330 h 742"/>
                  <a:gd name="T40" fmla="*/ 111 w 472"/>
                  <a:gd name="T41" fmla="*/ 339 h 742"/>
                  <a:gd name="T42" fmla="*/ 31 w 472"/>
                  <a:gd name="T43" fmla="*/ 366 h 742"/>
                  <a:gd name="T44" fmla="*/ 31 w 472"/>
                  <a:gd name="T45" fmla="*/ 0 h 7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72" h="742">
                    <a:moveTo>
                      <a:pt x="31" y="0"/>
                    </a:moveTo>
                    <a:lnTo>
                      <a:pt x="418" y="0"/>
                    </a:lnTo>
                    <a:lnTo>
                      <a:pt x="418" y="83"/>
                    </a:lnTo>
                    <a:lnTo>
                      <a:pt x="121" y="83"/>
                    </a:lnTo>
                    <a:lnTo>
                      <a:pt x="121" y="262"/>
                    </a:lnTo>
                    <a:cubicBezTo>
                      <a:pt x="135" y="257"/>
                      <a:pt x="150" y="253"/>
                      <a:pt x="164" y="251"/>
                    </a:cubicBezTo>
                    <a:cubicBezTo>
                      <a:pt x="178" y="249"/>
                      <a:pt x="193" y="247"/>
                      <a:pt x="207" y="247"/>
                    </a:cubicBezTo>
                    <a:cubicBezTo>
                      <a:pt x="288" y="247"/>
                      <a:pt x="352" y="270"/>
                      <a:pt x="400" y="314"/>
                    </a:cubicBezTo>
                    <a:cubicBezTo>
                      <a:pt x="448" y="359"/>
                      <a:pt x="472" y="419"/>
                      <a:pt x="472" y="495"/>
                    </a:cubicBezTo>
                    <a:cubicBezTo>
                      <a:pt x="472" y="574"/>
                      <a:pt x="447" y="635"/>
                      <a:pt x="398" y="678"/>
                    </a:cubicBezTo>
                    <a:cubicBezTo>
                      <a:pt x="349" y="721"/>
                      <a:pt x="280" y="742"/>
                      <a:pt x="192" y="742"/>
                    </a:cubicBezTo>
                    <a:cubicBezTo>
                      <a:pt x="161" y="742"/>
                      <a:pt x="130" y="739"/>
                      <a:pt x="98" y="735"/>
                    </a:cubicBezTo>
                    <a:cubicBezTo>
                      <a:pt x="66" y="730"/>
                      <a:pt x="34" y="723"/>
                      <a:pt x="0" y="712"/>
                    </a:cubicBezTo>
                    <a:lnTo>
                      <a:pt x="0" y="613"/>
                    </a:lnTo>
                    <a:cubicBezTo>
                      <a:pt x="29" y="629"/>
                      <a:pt x="59" y="641"/>
                      <a:pt x="91" y="649"/>
                    </a:cubicBezTo>
                    <a:cubicBezTo>
                      <a:pt x="122" y="657"/>
                      <a:pt x="155" y="660"/>
                      <a:pt x="190" y="660"/>
                    </a:cubicBezTo>
                    <a:cubicBezTo>
                      <a:pt x="246" y="660"/>
                      <a:pt x="291" y="646"/>
                      <a:pt x="324" y="616"/>
                    </a:cubicBezTo>
                    <a:cubicBezTo>
                      <a:pt x="356" y="586"/>
                      <a:pt x="373" y="546"/>
                      <a:pt x="373" y="495"/>
                    </a:cubicBezTo>
                    <a:cubicBezTo>
                      <a:pt x="373" y="445"/>
                      <a:pt x="356" y="405"/>
                      <a:pt x="324" y="375"/>
                    </a:cubicBezTo>
                    <a:cubicBezTo>
                      <a:pt x="291" y="345"/>
                      <a:pt x="246" y="330"/>
                      <a:pt x="190" y="330"/>
                    </a:cubicBezTo>
                    <a:cubicBezTo>
                      <a:pt x="164" y="330"/>
                      <a:pt x="137" y="333"/>
                      <a:pt x="111" y="339"/>
                    </a:cubicBezTo>
                    <a:cubicBezTo>
                      <a:pt x="85" y="345"/>
                      <a:pt x="58" y="354"/>
                      <a:pt x="31" y="366"/>
                    </a:cubicBezTo>
                    <a:lnTo>
                      <a:pt x="31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8" name="Freeform 220">
                <a:extLst>
                  <a:ext uri="{FF2B5EF4-FFF2-40B4-BE49-F238E27FC236}">
                    <a16:creationId xmlns:a16="http://schemas.microsoft.com/office/drawing/2014/main" id="{F8C91574-F6D7-1009-B3DE-C012C48584E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3175" y="4484688"/>
                <a:ext cx="136525" cy="106363"/>
              </a:xfrm>
              <a:custGeom>
                <a:avLst/>
                <a:gdLst>
                  <a:gd name="T0" fmla="*/ 69 w 755"/>
                  <a:gd name="T1" fmla="*/ 0 h 588"/>
                  <a:gd name="T2" fmla="*/ 173 w 755"/>
                  <a:gd name="T3" fmla="*/ 0 h 588"/>
                  <a:gd name="T4" fmla="*/ 104 w 755"/>
                  <a:gd name="T5" fmla="*/ 107 h 588"/>
                  <a:gd name="T6" fmla="*/ 81 w 755"/>
                  <a:gd name="T7" fmla="*/ 226 h 588"/>
                  <a:gd name="T8" fmla="*/ 158 w 755"/>
                  <a:gd name="T9" fmla="*/ 418 h 588"/>
                  <a:gd name="T10" fmla="*/ 378 w 755"/>
                  <a:gd name="T11" fmla="*/ 484 h 588"/>
                  <a:gd name="T12" fmla="*/ 599 w 755"/>
                  <a:gd name="T13" fmla="*/ 418 h 588"/>
                  <a:gd name="T14" fmla="*/ 675 w 755"/>
                  <a:gd name="T15" fmla="*/ 226 h 588"/>
                  <a:gd name="T16" fmla="*/ 652 w 755"/>
                  <a:gd name="T17" fmla="*/ 107 h 588"/>
                  <a:gd name="T18" fmla="*/ 583 w 755"/>
                  <a:gd name="T19" fmla="*/ 0 h 588"/>
                  <a:gd name="T20" fmla="*/ 686 w 755"/>
                  <a:gd name="T21" fmla="*/ 0 h 588"/>
                  <a:gd name="T22" fmla="*/ 738 w 755"/>
                  <a:gd name="T23" fmla="*/ 110 h 588"/>
                  <a:gd name="T24" fmla="*/ 755 w 755"/>
                  <a:gd name="T25" fmla="*/ 232 h 588"/>
                  <a:gd name="T26" fmla="*/ 655 w 755"/>
                  <a:gd name="T27" fmla="*/ 493 h 588"/>
                  <a:gd name="T28" fmla="*/ 378 w 755"/>
                  <a:gd name="T29" fmla="*/ 588 h 588"/>
                  <a:gd name="T30" fmla="*/ 101 w 755"/>
                  <a:gd name="T31" fmla="*/ 493 h 588"/>
                  <a:gd name="T32" fmla="*/ 0 w 755"/>
                  <a:gd name="T33" fmla="*/ 232 h 588"/>
                  <a:gd name="T34" fmla="*/ 17 w 755"/>
                  <a:gd name="T35" fmla="*/ 109 h 588"/>
                  <a:gd name="T36" fmla="*/ 69 w 755"/>
                  <a:gd name="T37" fmla="*/ 0 h 5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755" h="588">
                    <a:moveTo>
                      <a:pt x="69" y="0"/>
                    </a:moveTo>
                    <a:lnTo>
                      <a:pt x="173" y="0"/>
                    </a:lnTo>
                    <a:cubicBezTo>
                      <a:pt x="143" y="34"/>
                      <a:pt x="120" y="69"/>
                      <a:pt x="104" y="107"/>
                    </a:cubicBezTo>
                    <a:cubicBezTo>
                      <a:pt x="89" y="145"/>
                      <a:pt x="81" y="184"/>
                      <a:pt x="81" y="226"/>
                    </a:cubicBezTo>
                    <a:cubicBezTo>
                      <a:pt x="81" y="310"/>
                      <a:pt x="107" y="374"/>
                      <a:pt x="158" y="418"/>
                    </a:cubicBezTo>
                    <a:cubicBezTo>
                      <a:pt x="209" y="462"/>
                      <a:pt x="282" y="484"/>
                      <a:pt x="378" y="484"/>
                    </a:cubicBezTo>
                    <a:cubicBezTo>
                      <a:pt x="474" y="484"/>
                      <a:pt x="548" y="462"/>
                      <a:pt x="599" y="418"/>
                    </a:cubicBezTo>
                    <a:cubicBezTo>
                      <a:pt x="650" y="374"/>
                      <a:pt x="675" y="310"/>
                      <a:pt x="675" y="226"/>
                    </a:cubicBezTo>
                    <a:cubicBezTo>
                      <a:pt x="675" y="184"/>
                      <a:pt x="668" y="145"/>
                      <a:pt x="652" y="107"/>
                    </a:cubicBezTo>
                    <a:cubicBezTo>
                      <a:pt x="637" y="69"/>
                      <a:pt x="614" y="34"/>
                      <a:pt x="583" y="0"/>
                    </a:cubicBezTo>
                    <a:lnTo>
                      <a:pt x="686" y="0"/>
                    </a:lnTo>
                    <a:cubicBezTo>
                      <a:pt x="710" y="35"/>
                      <a:pt x="727" y="72"/>
                      <a:pt x="738" y="110"/>
                    </a:cubicBezTo>
                    <a:cubicBezTo>
                      <a:pt x="749" y="148"/>
                      <a:pt x="755" y="189"/>
                      <a:pt x="755" y="232"/>
                    </a:cubicBezTo>
                    <a:cubicBezTo>
                      <a:pt x="755" y="342"/>
                      <a:pt x="722" y="429"/>
                      <a:pt x="655" y="493"/>
                    </a:cubicBezTo>
                    <a:cubicBezTo>
                      <a:pt x="588" y="557"/>
                      <a:pt x="496" y="588"/>
                      <a:pt x="378" y="588"/>
                    </a:cubicBezTo>
                    <a:cubicBezTo>
                      <a:pt x="261" y="588"/>
                      <a:pt x="169" y="557"/>
                      <a:pt x="101" y="493"/>
                    </a:cubicBezTo>
                    <a:cubicBezTo>
                      <a:pt x="34" y="429"/>
                      <a:pt x="0" y="342"/>
                      <a:pt x="0" y="232"/>
                    </a:cubicBezTo>
                    <a:cubicBezTo>
                      <a:pt x="0" y="188"/>
                      <a:pt x="6" y="147"/>
                      <a:pt x="17" y="109"/>
                    </a:cubicBezTo>
                    <a:cubicBezTo>
                      <a:pt x="29" y="71"/>
                      <a:pt x="46" y="34"/>
                      <a:pt x="69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9" name="Freeform 221">
                <a:extLst>
                  <a:ext uri="{FF2B5EF4-FFF2-40B4-BE49-F238E27FC236}">
                    <a16:creationId xmlns:a16="http://schemas.microsoft.com/office/drawing/2014/main" id="{38382272-CDCA-2414-75D6-FA65C9DAFC2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4373563"/>
                <a:ext cx="103188" cy="90488"/>
              </a:xfrm>
              <a:custGeom>
                <a:avLst/>
                <a:gdLst>
                  <a:gd name="T0" fmla="*/ 264 w 573"/>
                  <a:gd name="T1" fmla="*/ 0 h 507"/>
                  <a:gd name="T2" fmla="*/ 308 w 573"/>
                  <a:gd name="T3" fmla="*/ 0 h 507"/>
                  <a:gd name="T4" fmla="*/ 308 w 573"/>
                  <a:gd name="T5" fmla="*/ 413 h 507"/>
                  <a:gd name="T6" fmla="*/ 450 w 573"/>
                  <a:gd name="T7" fmla="*/ 357 h 507"/>
                  <a:gd name="T8" fmla="*/ 498 w 573"/>
                  <a:gd name="T9" fmla="*/ 218 h 507"/>
                  <a:gd name="T10" fmla="*/ 486 w 573"/>
                  <a:gd name="T11" fmla="*/ 118 h 507"/>
                  <a:gd name="T12" fmla="*/ 447 w 573"/>
                  <a:gd name="T13" fmla="*/ 21 h 507"/>
                  <a:gd name="T14" fmla="*/ 532 w 573"/>
                  <a:gd name="T15" fmla="*/ 21 h 507"/>
                  <a:gd name="T16" fmla="*/ 563 w 573"/>
                  <a:gd name="T17" fmla="*/ 120 h 507"/>
                  <a:gd name="T18" fmla="*/ 573 w 573"/>
                  <a:gd name="T19" fmla="*/ 223 h 507"/>
                  <a:gd name="T20" fmla="*/ 498 w 573"/>
                  <a:gd name="T21" fmla="*/ 431 h 507"/>
                  <a:gd name="T22" fmla="*/ 292 w 573"/>
                  <a:gd name="T23" fmla="*/ 507 h 507"/>
                  <a:gd name="T24" fmla="*/ 79 w 573"/>
                  <a:gd name="T25" fmla="*/ 435 h 507"/>
                  <a:gd name="T26" fmla="*/ 0 w 573"/>
                  <a:gd name="T27" fmla="*/ 239 h 507"/>
                  <a:gd name="T28" fmla="*/ 71 w 573"/>
                  <a:gd name="T29" fmla="*/ 64 h 507"/>
                  <a:gd name="T30" fmla="*/ 264 w 573"/>
                  <a:gd name="T31" fmla="*/ 0 h 507"/>
                  <a:gd name="T32" fmla="*/ 238 w 573"/>
                  <a:gd name="T33" fmla="*/ 90 h 507"/>
                  <a:gd name="T34" fmla="*/ 120 w 573"/>
                  <a:gd name="T35" fmla="*/ 131 h 507"/>
                  <a:gd name="T36" fmla="*/ 76 w 573"/>
                  <a:gd name="T37" fmla="*/ 238 h 507"/>
                  <a:gd name="T38" fmla="*/ 119 w 573"/>
                  <a:gd name="T39" fmla="*/ 358 h 507"/>
                  <a:gd name="T40" fmla="*/ 238 w 573"/>
                  <a:gd name="T41" fmla="*/ 410 h 507"/>
                  <a:gd name="T42" fmla="*/ 238 w 573"/>
                  <a:gd name="T43" fmla="*/ 90 h 5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73" h="507">
                    <a:moveTo>
                      <a:pt x="264" y="0"/>
                    </a:moveTo>
                    <a:lnTo>
                      <a:pt x="308" y="0"/>
                    </a:lnTo>
                    <a:lnTo>
                      <a:pt x="308" y="413"/>
                    </a:lnTo>
                    <a:cubicBezTo>
                      <a:pt x="370" y="409"/>
                      <a:pt x="418" y="391"/>
                      <a:pt x="450" y="357"/>
                    </a:cubicBezTo>
                    <a:cubicBezTo>
                      <a:pt x="482" y="324"/>
                      <a:pt x="498" y="278"/>
                      <a:pt x="498" y="218"/>
                    </a:cubicBezTo>
                    <a:cubicBezTo>
                      <a:pt x="498" y="184"/>
                      <a:pt x="494" y="150"/>
                      <a:pt x="486" y="118"/>
                    </a:cubicBezTo>
                    <a:cubicBezTo>
                      <a:pt x="478" y="86"/>
                      <a:pt x="465" y="53"/>
                      <a:pt x="447" y="21"/>
                    </a:cubicBezTo>
                    <a:lnTo>
                      <a:pt x="532" y="21"/>
                    </a:lnTo>
                    <a:cubicBezTo>
                      <a:pt x="546" y="53"/>
                      <a:pt x="557" y="86"/>
                      <a:pt x="563" y="120"/>
                    </a:cubicBezTo>
                    <a:cubicBezTo>
                      <a:pt x="569" y="154"/>
                      <a:pt x="573" y="189"/>
                      <a:pt x="573" y="223"/>
                    </a:cubicBezTo>
                    <a:cubicBezTo>
                      <a:pt x="573" y="311"/>
                      <a:pt x="548" y="380"/>
                      <a:pt x="498" y="431"/>
                    </a:cubicBezTo>
                    <a:cubicBezTo>
                      <a:pt x="448" y="482"/>
                      <a:pt x="379" y="507"/>
                      <a:pt x="292" y="507"/>
                    </a:cubicBezTo>
                    <a:cubicBezTo>
                      <a:pt x="203" y="507"/>
                      <a:pt x="132" y="483"/>
                      <a:pt x="79" y="435"/>
                    </a:cubicBezTo>
                    <a:cubicBezTo>
                      <a:pt x="27" y="387"/>
                      <a:pt x="0" y="321"/>
                      <a:pt x="0" y="239"/>
                    </a:cubicBezTo>
                    <a:cubicBezTo>
                      <a:pt x="0" y="165"/>
                      <a:pt x="24" y="107"/>
                      <a:pt x="71" y="64"/>
                    </a:cubicBezTo>
                    <a:cubicBezTo>
                      <a:pt x="119" y="22"/>
                      <a:pt x="183" y="0"/>
                      <a:pt x="264" y="0"/>
                    </a:cubicBezTo>
                    <a:close/>
                    <a:moveTo>
                      <a:pt x="238" y="90"/>
                    </a:moveTo>
                    <a:cubicBezTo>
                      <a:pt x="189" y="91"/>
                      <a:pt x="150" y="105"/>
                      <a:pt x="120" y="131"/>
                    </a:cubicBezTo>
                    <a:cubicBezTo>
                      <a:pt x="91" y="158"/>
                      <a:pt x="76" y="194"/>
                      <a:pt x="76" y="238"/>
                    </a:cubicBezTo>
                    <a:cubicBezTo>
                      <a:pt x="76" y="288"/>
                      <a:pt x="91" y="328"/>
                      <a:pt x="119" y="358"/>
                    </a:cubicBezTo>
                    <a:cubicBezTo>
                      <a:pt x="147" y="388"/>
                      <a:pt x="187" y="406"/>
                      <a:pt x="238" y="410"/>
                    </a:cubicBezTo>
                    <a:lnTo>
                      <a:pt x="238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0" name="Rectangle 222">
                <a:extLst>
                  <a:ext uri="{FF2B5EF4-FFF2-40B4-BE49-F238E27FC236}">
                    <a16:creationId xmlns:a16="http://schemas.microsoft.com/office/drawing/2014/main" id="{2B21945A-2244-FE2F-661B-7313B1BEE7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000" y="4330700"/>
                <a:ext cx="136525" cy="1587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1" name="Rectangle 223">
                <a:extLst>
                  <a:ext uri="{FF2B5EF4-FFF2-40B4-BE49-F238E27FC236}">
                    <a16:creationId xmlns:a16="http://schemas.microsoft.com/office/drawing/2014/main" id="{5D643707-81FC-3CFA-6606-9C9AFB1743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000" y="4279900"/>
                <a:ext cx="136525" cy="1587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2" name="Freeform 224">
                <a:extLst>
                  <a:ext uri="{FF2B5EF4-FFF2-40B4-BE49-F238E27FC236}">
                    <a16:creationId xmlns:a16="http://schemas.microsoft.com/office/drawing/2014/main" id="{37DD0768-A348-BB39-F667-DA3A78BECF6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6350" y="4087813"/>
                <a:ext cx="130175" cy="100013"/>
              </a:xfrm>
              <a:custGeom>
                <a:avLst/>
                <a:gdLst>
                  <a:gd name="T0" fmla="*/ 0 w 729"/>
                  <a:gd name="T1" fmla="*/ 552 h 552"/>
                  <a:gd name="T2" fmla="*/ 0 w 729"/>
                  <a:gd name="T3" fmla="*/ 419 h 552"/>
                  <a:gd name="T4" fmla="*/ 610 w 729"/>
                  <a:gd name="T5" fmla="*/ 96 h 552"/>
                  <a:gd name="T6" fmla="*/ 0 w 729"/>
                  <a:gd name="T7" fmla="*/ 96 h 552"/>
                  <a:gd name="T8" fmla="*/ 0 w 729"/>
                  <a:gd name="T9" fmla="*/ 0 h 552"/>
                  <a:gd name="T10" fmla="*/ 729 w 729"/>
                  <a:gd name="T11" fmla="*/ 0 h 552"/>
                  <a:gd name="T12" fmla="*/ 729 w 729"/>
                  <a:gd name="T13" fmla="*/ 133 h 552"/>
                  <a:gd name="T14" fmla="*/ 119 w 729"/>
                  <a:gd name="T15" fmla="*/ 456 h 552"/>
                  <a:gd name="T16" fmla="*/ 729 w 729"/>
                  <a:gd name="T17" fmla="*/ 456 h 552"/>
                  <a:gd name="T18" fmla="*/ 729 w 729"/>
                  <a:gd name="T19" fmla="*/ 552 h 552"/>
                  <a:gd name="T20" fmla="*/ 0 w 729"/>
                  <a:gd name="T21" fmla="*/ 552 h 5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729" h="552">
                    <a:moveTo>
                      <a:pt x="0" y="552"/>
                    </a:moveTo>
                    <a:lnTo>
                      <a:pt x="0" y="419"/>
                    </a:lnTo>
                    <a:lnTo>
                      <a:pt x="610" y="96"/>
                    </a:lnTo>
                    <a:lnTo>
                      <a:pt x="0" y="96"/>
                    </a:lnTo>
                    <a:lnTo>
                      <a:pt x="0" y="0"/>
                    </a:lnTo>
                    <a:lnTo>
                      <a:pt x="729" y="0"/>
                    </a:lnTo>
                    <a:lnTo>
                      <a:pt x="729" y="133"/>
                    </a:lnTo>
                    <a:lnTo>
                      <a:pt x="119" y="456"/>
                    </a:lnTo>
                    <a:lnTo>
                      <a:pt x="729" y="456"/>
                    </a:lnTo>
                    <a:lnTo>
                      <a:pt x="729" y="552"/>
                    </a:lnTo>
                    <a:lnTo>
                      <a:pt x="0" y="552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3" name="Freeform 225">
                <a:extLst>
                  <a:ext uri="{FF2B5EF4-FFF2-40B4-BE49-F238E27FC236}">
                    <a16:creationId xmlns:a16="http://schemas.microsoft.com/office/drawing/2014/main" id="{AC6FE240-2471-B644-7D8F-78B69761D8F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3973513"/>
                <a:ext cx="103188" cy="82550"/>
              </a:xfrm>
              <a:custGeom>
                <a:avLst/>
                <a:gdLst>
                  <a:gd name="T0" fmla="*/ 344 w 573"/>
                  <a:gd name="T1" fmla="*/ 458 h 458"/>
                  <a:gd name="T2" fmla="*/ 13 w 573"/>
                  <a:gd name="T3" fmla="*/ 458 h 458"/>
                  <a:gd name="T4" fmla="*/ 13 w 573"/>
                  <a:gd name="T5" fmla="*/ 368 h 458"/>
                  <a:gd name="T6" fmla="*/ 341 w 573"/>
                  <a:gd name="T7" fmla="*/ 368 h 458"/>
                  <a:gd name="T8" fmla="*/ 457 w 573"/>
                  <a:gd name="T9" fmla="*/ 338 h 458"/>
                  <a:gd name="T10" fmla="*/ 496 w 573"/>
                  <a:gd name="T11" fmla="*/ 247 h 458"/>
                  <a:gd name="T12" fmla="*/ 450 w 573"/>
                  <a:gd name="T13" fmla="*/ 132 h 458"/>
                  <a:gd name="T14" fmla="*/ 323 w 573"/>
                  <a:gd name="T15" fmla="*/ 90 h 458"/>
                  <a:gd name="T16" fmla="*/ 13 w 573"/>
                  <a:gd name="T17" fmla="*/ 90 h 458"/>
                  <a:gd name="T18" fmla="*/ 13 w 573"/>
                  <a:gd name="T19" fmla="*/ 0 h 458"/>
                  <a:gd name="T20" fmla="*/ 560 w 573"/>
                  <a:gd name="T21" fmla="*/ 0 h 458"/>
                  <a:gd name="T22" fmla="*/ 560 w 573"/>
                  <a:gd name="T23" fmla="*/ 90 h 458"/>
                  <a:gd name="T24" fmla="*/ 476 w 573"/>
                  <a:gd name="T25" fmla="*/ 90 h 458"/>
                  <a:gd name="T26" fmla="*/ 550 w 573"/>
                  <a:gd name="T27" fmla="*/ 166 h 458"/>
                  <a:gd name="T28" fmla="*/ 573 w 573"/>
                  <a:gd name="T29" fmla="*/ 266 h 458"/>
                  <a:gd name="T30" fmla="*/ 515 w 573"/>
                  <a:gd name="T31" fmla="*/ 409 h 458"/>
                  <a:gd name="T32" fmla="*/ 344 w 573"/>
                  <a:gd name="T33" fmla="*/ 458 h 458"/>
                  <a:gd name="T34" fmla="*/ 0 w 573"/>
                  <a:gd name="T35" fmla="*/ 232 h 458"/>
                  <a:gd name="T36" fmla="*/ 1 w 573"/>
                  <a:gd name="T37" fmla="*/ 232 h 458"/>
                  <a:gd name="T38" fmla="*/ 0 w 573"/>
                  <a:gd name="T39" fmla="*/ 232 h 4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573" h="458">
                    <a:moveTo>
                      <a:pt x="344" y="458"/>
                    </a:moveTo>
                    <a:lnTo>
                      <a:pt x="13" y="458"/>
                    </a:lnTo>
                    <a:lnTo>
                      <a:pt x="13" y="368"/>
                    </a:lnTo>
                    <a:lnTo>
                      <a:pt x="341" y="368"/>
                    </a:lnTo>
                    <a:cubicBezTo>
                      <a:pt x="393" y="368"/>
                      <a:pt x="431" y="358"/>
                      <a:pt x="457" y="338"/>
                    </a:cubicBezTo>
                    <a:cubicBezTo>
                      <a:pt x="483" y="318"/>
                      <a:pt x="496" y="288"/>
                      <a:pt x="496" y="247"/>
                    </a:cubicBezTo>
                    <a:cubicBezTo>
                      <a:pt x="496" y="199"/>
                      <a:pt x="481" y="160"/>
                      <a:pt x="450" y="132"/>
                    </a:cubicBezTo>
                    <a:cubicBezTo>
                      <a:pt x="419" y="104"/>
                      <a:pt x="377" y="90"/>
                      <a:pt x="323" y="90"/>
                    </a:cubicBezTo>
                    <a:lnTo>
                      <a:pt x="13" y="90"/>
                    </a:lnTo>
                    <a:lnTo>
                      <a:pt x="13" y="0"/>
                    </a:lnTo>
                    <a:lnTo>
                      <a:pt x="560" y="0"/>
                    </a:lnTo>
                    <a:lnTo>
                      <a:pt x="560" y="90"/>
                    </a:lnTo>
                    <a:lnTo>
                      <a:pt x="476" y="90"/>
                    </a:lnTo>
                    <a:cubicBezTo>
                      <a:pt x="510" y="112"/>
                      <a:pt x="534" y="138"/>
                      <a:pt x="550" y="166"/>
                    </a:cubicBezTo>
                    <a:cubicBezTo>
                      <a:pt x="565" y="195"/>
                      <a:pt x="573" y="228"/>
                      <a:pt x="573" y="266"/>
                    </a:cubicBezTo>
                    <a:cubicBezTo>
                      <a:pt x="573" y="329"/>
                      <a:pt x="554" y="377"/>
                      <a:pt x="515" y="409"/>
                    </a:cubicBezTo>
                    <a:cubicBezTo>
                      <a:pt x="477" y="442"/>
                      <a:pt x="420" y="458"/>
                      <a:pt x="344" y="458"/>
                    </a:cubicBezTo>
                    <a:close/>
                    <a:moveTo>
                      <a:pt x="0" y="232"/>
                    </a:moveTo>
                    <a:lnTo>
                      <a:pt x="1" y="232"/>
                    </a:lnTo>
                    <a:lnTo>
                      <a:pt x="0" y="232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4" name="Freeform 226">
                <a:extLst>
                  <a:ext uri="{FF2B5EF4-FFF2-40B4-BE49-F238E27FC236}">
                    <a16:creationId xmlns:a16="http://schemas.microsoft.com/office/drawing/2014/main" id="{A269741F-C123-41F3-1BFC-A31AA4AAC91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6513" y="3795713"/>
                <a:ext cx="100013" cy="144463"/>
              </a:xfrm>
              <a:custGeom>
                <a:avLst/>
                <a:gdLst>
                  <a:gd name="T0" fmla="*/ 118 w 560"/>
                  <a:gd name="T1" fmla="*/ 369 h 798"/>
                  <a:gd name="T2" fmla="*/ 29 w 560"/>
                  <a:gd name="T3" fmla="*/ 289 h 798"/>
                  <a:gd name="T4" fmla="*/ 0 w 560"/>
                  <a:gd name="T5" fmla="*/ 178 h 798"/>
                  <a:gd name="T6" fmla="*/ 60 w 560"/>
                  <a:gd name="T7" fmla="*/ 47 h 798"/>
                  <a:gd name="T8" fmla="*/ 230 w 560"/>
                  <a:gd name="T9" fmla="*/ 0 h 798"/>
                  <a:gd name="T10" fmla="*/ 560 w 560"/>
                  <a:gd name="T11" fmla="*/ 0 h 798"/>
                  <a:gd name="T12" fmla="*/ 560 w 560"/>
                  <a:gd name="T13" fmla="*/ 90 h 798"/>
                  <a:gd name="T14" fmla="*/ 233 w 560"/>
                  <a:gd name="T15" fmla="*/ 90 h 798"/>
                  <a:gd name="T16" fmla="*/ 116 w 560"/>
                  <a:gd name="T17" fmla="*/ 118 h 798"/>
                  <a:gd name="T18" fmla="*/ 78 w 560"/>
                  <a:gd name="T19" fmla="*/ 203 h 798"/>
                  <a:gd name="T20" fmla="*/ 125 w 560"/>
                  <a:gd name="T21" fmla="*/ 314 h 798"/>
                  <a:gd name="T22" fmla="*/ 251 w 560"/>
                  <a:gd name="T23" fmla="*/ 354 h 798"/>
                  <a:gd name="T24" fmla="*/ 560 w 560"/>
                  <a:gd name="T25" fmla="*/ 354 h 798"/>
                  <a:gd name="T26" fmla="*/ 560 w 560"/>
                  <a:gd name="T27" fmla="*/ 444 h 798"/>
                  <a:gd name="T28" fmla="*/ 233 w 560"/>
                  <a:gd name="T29" fmla="*/ 444 h 798"/>
                  <a:gd name="T30" fmla="*/ 116 w 560"/>
                  <a:gd name="T31" fmla="*/ 472 h 798"/>
                  <a:gd name="T32" fmla="*/ 78 w 560"/>
                  <a:gd name="T33" fmla="*/ 558 h 798"/>
                  <a:gd name="T34" fmla="*/ 125 w 560"/>
                  <a:gd name="T35" fmla="*/ 668 h 798"/>
                  <a:gd name="T36" fmla="*/ 251 w 560"/>
                  <a:gd name="T37" fmla="*/ 708 h 798"/>
                  <a:gd name="T38" fmla="*/ 560 w 560"/>
                  <a:gd name="T39" fmla="*/ 708 h 798"/>
                  <a:gd name="T40" fmla="*/ 560 w 560"/>
                  <a:gd name="T41" fmla="*/ 798 h 798"/>
                  <a:gd name="T42" fmla="*/ 13 w 560"/>
                  <a:gd name="T43" fmla="*/ 798 h 798"/>
                  <a:gd name="T44" fmla="*/ 13 w 560"/>
                  <a:gd name="T45" fmla="*/ 708 h 798"/>
                  <a:gd name="T46" fmla="*/ 98 w 560"/>
                  <a:gd name="T47" fmla="*/ 708 h 798"/>
                  <a:gd name="T48" fmla="*/ 24 w 560"/>
                  <a:gd name="T49" fmla="*/ 634 h 798"/>
                  <a:gd name="T50" fmla="*/ 0 w 560"/>
                  <a:gd name="T51" fmla="*/ 532 h 798"/>
                  <a:gd name="T52" fmla="*/ 30 w 560"/>
                  <a:gd name="T53" fmla="*/ 431 h 798"/>
                  <a:gd name="T54" fmla="*/ 118 w 560"/>
                  <a:gd name="T55" fmla="*/ 369 h 7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</a:cxnLst>
                <a:rect l="0" t="0" r="r" b="b"/>
                <a:pathLst>
                  <a:path w="560" h="798">
                    <a:moveTo>
                      <a:pt x="118" y="369"/>
                    </a:moveTo>
                    <a:cubicBezTo>
                      <a:pt x="78" y="347"/>
                      <a:pt x="49" y="320"/>
                      <a:pt x="29" y="289"/>
                    </a:cubicBezTo>
                    <a:cubicBezTo>
                      <a:pt x="10" y="258"/>
                      <a:pt x="0" y="221"/>
                      <a:pt x="0" y="178"/>
                    </a:cubicBezTo>
                    <a:cubicBezTo>
                      <a:pt x="0" y="122"/>
                      <a:pt x="20" y="78"/>
                      <a:pt x="60" y="47"/>
                    </a:cubicBezTo>
                    <a:cubicBezTo>
                      <a:pt x="100" y="16"/>
                      <a:pt x="157" y="0"/>
                      <a:pt x="230" y="0"/>
                    </a:cubicBezTo>
                    <a:lnTo>
                      <a:pt x="560" y="0"/>
                    </a:lnTo>
                    <a:lnTo>
                      <a:pt x="560" y="90"/>
                    </a:lnTo>
                    <a:lnTo>
                      <a:pt x="233" y="90"/>
                    </a:lnTo>
                    <a:cubicBezTo>
                      <a:pt x="181" y="90"/>
                      <a:pt x="142" y="100"/>
                      <a:pt x="116" y="118"/>
                    </a:cubicBezTo>
                    <a:cubicBezTo>
                      <a:pt x="91" y="137"/>
                      <a:pt x="78" y="165"/>
                      <a:pt x="78" y="203"/>
                    </a:cubicBezTo>
                    <a:cubicBezTo>
                      <a:pt x="78" y="250"/>
                      <a:pt x="94" y="287"/>
                      <a:pt x="125" y="314"/>
                    </a:cubicBezTo>
                    <a:cubicBezTo>
                      <a:pt x="156" y="341"/>
                      <a:pt x="198" y="354"/>
                      <a:pt x="251" y="354"/>
                    </a:cubicBezTo>
                    <a:lnTo>
                      <a:pt x="560" y="354"/>
                    </a:lnTo>
                    <a:lnTo>
                      <a:pt x="560" y="444"/>
                    </a:lnTo>
                    <a:lnTo>
                      <a:pt x="233" y="444"/>
                    </a:lnTo>
                    <a:cubicBezTo>
                      <a:pt x="181" y="444"/>
                      <a:pt x="142" y="454"/>
                      <a:pt x="116" y="472"/>
                    </a:cubicBezTo>
                    <a:cubicBezTo>
                      <a:pt x="91" y="491"/>
                      <a:pt x="78" y="520"/>
                      <a:pt x="78" y="558"/>
                    </a:cubicBezTo>
                    <a:cubicBezTo>
                      <a:pt x="78" y="604"/>
                      <a:pt x="94" y="641"/>
                      <a:pt x="125" y="668"/>
                    </a:cubicBezTo>
                    <a:cubicBezTo>
                      <a:pt x="156" y="695"/>
                      <a:pt x="198" y="708"/>
                      <a:pt x="251" y="708"/>
                    </a:cubicBezTo>
                    <a:lnTo>
                      <a:pt x="560" y="708"/>
                    </a:lnTo>
                    <a:lnTo>
                      <a:pt x="560" y="798"/>
                    </a:lnTo>
                    <a:lnTo>
                      <a:pt x="13" y="798"/>
                    </a:lnTo>
                    <a:lnTo>
                      <a:pt x="13" y="708"/>
                    </a:lnTo>
                    <a:lnTo>
                      <a:pt x="98" y="708"/>
                    </a:lnTo>
                    <a:cubicBezTo>
                      <a:pt x="65" y="688"/>
                      <a:pt x="40" y="663"/>
                      <a:pt x="24" y="634"/>
                    </a:cubicBezTo>
                    <a:cubicBezTo>
                      <a:pt x="8" y="606"/>
                      <a:pt x="0" y="572"/>
                      <a:pt x="0" y="532"/>
                    </a:cubicBezTo>
                    <a:cubicBezTo>
                      <a:pt x="0" y="492"/>
                      <a:pt x="10" y="459"/>
                      <a:pt x="30" y="431"/>
                    </a:cubicBezTo>
                    <a:cubicBezTo>
                      <a:pt x="50" y="403"/>
                      <a:pt x="80" y="383"/>
                      <a:pt x="118" y="36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5" name="Freeform 227">
                <a:extLst>
                  <a:ext uri="{FF2B5EF4-FFF2-40B4-BE49-F238E27FC236}">
                    <a16:creationId xmlns:a16="http://schemas.microsoft.com/office/drawing/2014/main" id="{1642FB22-6D38-E4BC-6916-CCF1D1E988B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40000" y="3676650"/>
                <a:ext cx="139700" cy="87313"/>
              </a:xfrm>
              <a:custGeom>
                <a:avLst/>
                <a:gdLst>
                  <a:gd name="T0" fmla="*/ 487 w 773"/>
                  <a:gd name="T1" fmla="*/ 93 h 489"/>
                  <a:gd name="T2" fmla="*/ 332 w 773"/>
                  <a:gd name="T3" fmla="*/ 134 h 489"/>
                  <a:gd name="T4" fmla="*/ 275 w 773"/>
                  <a:gd name="T5" fmla="*/ 246 h 489"/>
                  <a:gd name="T6" fmla="*/ 332 w 773"/>
                  <a:gd name="T7" fmla="*/ 358 h 489"/>
                  <a:gd name="T8" fmla="*/ 487 w 773"/>
                  <a:gd name="T9" fmla="*/ 399 h 489"/>
                  <a:gd name="T10" fmla="*/ 643 w 773"/>
                  <a:gd name="T11" fmla="*/ 358 h 489"/>
                  <a:gd name="T12" fmla="*/ 699 w 773"/>
                  <a:gd name="T13" fmla="*/ 246 h 489"/>
                  <a:gd name="T14" fmla="*/ 643 w 773"/>
                  <a:gd name="T15" fmla="*/ 134 h 489"/>
                  <a:gd name="T16" fmla="*/ 487 w 773"/>
                  <a:gd name="T17" fmla="*/ 93 h 489"/>
                  <a:gd name="T18" fmla="*/ 296 w 773"/>
                  <a:gd name="T19" fmla="*/ 399 h 489"/>
                  <a:gd name="T20" fmla="*/ 224 w 773"/>
                  <a:gd name="T21" fmla="*/ 328 h 489"/>
                  <a:gd name="T22" fmla="*/ 200 w 773"/>
                  <a:gd name="T23" fmla="*/ 224 h 489"/>
                  <a:gd name="T24" fmla="*/ 279 w 773"/>
                  <a:gd name="T25" fmla="*/ 62 h 489"/>
                  <a:gd name="T26" fmla="*/ 487 w 773"/>
                  <a:gd name="T27" fmla="*/ 0 h 489"/>
                  <a:gd name="T28" fmla="*/ 695 w 773"/>
                  <a:gd name="T29" fmla="*/ 62 h 489"/>
                  <a:gd name="T30" fmla="*/ 773 w 773"/>
                  <a:gd name="T31" fmla="*/ 224 h 489"/>
                  <a:gd name="T32" fmla="*/ 750 w 773"/>
                  <a:gd name="T33" fmla="*/ 328 h 489"/>
                  <a:gd name="T34" fmla="*/ 678 w 773"/>
                  <a:gd name="T35" fmla="*/ 399 h 489"/>
                  <a:gd name="T36" fmla="*/ 760 w 773"/>
                  <a:gd name="T37" fmla="*/ 399 h 489"/>
                  <a:gd name="T38" fmla="*/ 760 w 773"/>
                  <a:gd name="T39" fmla="*/ 489 h 489"/>
                  <a:gd name="T40" fmla="*/ 0 w 773"/>
                  <a:gd name="T41" fmla="*/ 489 h 489"/>
                  <a:gd name="T42" fmla="*/ 0 w 773"/>
                  <a:gd name="T43" fmla="*/ 399 h 489"/>
                  <a:gd name="T44" fmla="*/ 296 w 773"/>
                  <a:gd name="T45" fmla="*/ 399 h 4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773" h="489">
                    <a:moveTo>
                      <a:pt x="487" y="93"/>
                    </a:moveTo>
                    <a:cubicBezTo>
                      <a:pt x="421" y="93"/>
                      <a:pt x="370" y="107"/>
                      <a:pt x="332" y="134"/>
                    </a:cubicBezTo>
                    <a:cubicBezTo>
                      <a:pt x="294" y="162"/>
                      <a:pt x="275" y="199"/>
                      <a:pt x="275" y="246"/>
                    </a:cubicBezTo>
                    <a:cubicBezTo>
                      <a:pt x="275" y="294"/>
                      <a:pt x="294" y="331"/>
                      <a:pt x="332" y="358"/>
                    </a:cubicBezTo>
                    <a:cubicBezTo>
                      <a:pt x="370" y="386"/>
                      <a:pt x="421" y="399"/>
                      <a:pt x="487" y="399"/>
                    </a:cubicBezTo>
                    <a:cubicBezTo>
                      <a:pt x="553" y="399"/>
                      <a:pt x="605" y="386"/>
                      <a:pt x="643" y="358"/>
                    </a:cubicBezTo>
                    <a:cubicBezTo>
                      <a:pt x="681" y="331"/>
                      <a:pt x="699" y="294"/>
                      <a:pt x="699" y="246"/>
                    </a:cubicBezTo>
                    <a:cubicBezTo>
                      <a:pt x="699" y="199"/>
                      <a:pt x="681" y="162"/>
                      <a:pt x="643" y="134"/>
                    </a:cubicBezTo>
                    <a:cubicBezTo>
                      <a:pt x="605" y="107"/>
                      <a:pt x="553" y="93"/>
                      <a:pt x="487" y="93"/>
                    </a:cubicBezTo>
                    <a:close/>
                    <a:moveTo>
                      <a:pt x="296" y="399"/>
                    </a:moveTo>
                    <a:cubicBezTo>
                      <a:pt x="264" y="381"/>
                      <a:pt x="240" y="357"/>
                      <a:pt x="224" y="328"/>
                    </a:cubicBezTo>
                    <a:cubicBezTo>
                      <a:pt x="208" y="299"/>
                      <a:pt x="200" y="264"/>
                      <a:pt x="200" y="224"/>
                    </a:cubicBezTo>
                    <a:cubicBezTo>
                      <a:pt x="200" y="158"/>
                      <a:pt x="227" y="104"/>
                      <a:pt x="279" y="62"/>
                    </a:cubicBezTo>
                    <a:cubicBezTo>
                      <a:pt x="332" y="21"/>
                      <a:pt x="401" y="0"/>
                      <a:pt x="487" y="0"/>
                    </a:cubicBezTo>
                    <a:cubicBezTo>
                      <a:pt x="573" y="0"/>
                      <a:pt x="643" y="21"/>
                      <a:pt x="695" y="62"/>
                    </a:cubicBezTo>
                    <a:cubicBezTo>
                      <a:pt x="747" y="104"/>
                      <a:pt x="773" y="158"/>
                      <a:pt x="773" y="224"/>
                    </a:cubicBezTo>
                    <a:cubicBezTo>
                      <a:pt x="773" y="264"/>
                      <a:pt x="765" y="299"/>
                      <a:pt x="750" y="328"/>
                    </a:cubicBezTo>
                    <a:cubicBezTo>
                      <a:pt x="735" y="357"/>
                      <a:pt x="711" y="381"/>
                      <a:pt x="678" y="399"/>
                    </a:cubicBezTo>
                    <a:lnTo>
                      <a:pt x="760" y="399"/>
                    </a:lnTo>
                    <a:lnTo>
                      <a:pt x="760" y="489"/>
                    </a:lnTo>
                    <a:lnTo>
                      <a:pt x="0" y="489"/>
                    </a:lnTo>
                    <a:lnTo>
                      <a:pt x="0" y="399"/>
                    </a:lnTo>
                    <a:lnTo>
                      <a:pt x="296" y="399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6" name="Freeform 228">
                <a:extLst>
                  <a:ext uri="{FF2B5EF4-FFF2-40B4-BE49-F238E27FC236}">
                    <a16:creationId xmlns:a16="http://schemas.microsoft.com/office/drawing/2014/main" id="{5D07864F-58C3-BE39-84EB-F6D60564939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3565525"/>
                <a:ext cx="103188" cy="90488"/>
              </a:xfrm>
              <a:custGeom>
                <a:avLst/>
                <a:gdLst>
                  <a:gd name="T0" fmla="*/ 264 w 573"/>
                  <a:gd name="T1" fmla="*/ 0 h 507"/>
                  <a:gd name="T2" fmla="*/ 308 w 573"/>
                  <a:gd name="T3" fmla="*/ 0 h 507"/>
                  <a:gd name="T4" fmla="*/ 308 w 573"/>
                  <a:gd name="T5" fmla="*/ 413 h 507"/>
                  <a:gd name="T6" fmla="*/ 450 w 573"/>
                  <a:gd name="T7" fmla="*/ 357 h 507"/>
                  <a:gd name="T8" fmla="*/ 498 w 573"/>
                  <a:gd name="T9" fmla="*/ 218 h 507"/>
                  <a:gd name="T10" fmla="*/ 486 w 573"/>
                  <a:gd name="T11" fmla="*/ 118 h 507"/>
                  <a:gd name="T12" fmla="*/ 447 w 573"/>
                  <a:gd name="T13" fmla="*/ 21 h 507"/>
                  <a:gd name="T14" fmla="*/ 532 w 573"/>
                  <a:gd name="T15" fmla="*/ 21 h 507"/>
                  <a:gd name="T16" fmla="*/ 563 w 573"/>
                  <a:gd name="T17" fmla="*/ 120 h 507"/>
                  <a:gd name="T18" fmla="*/ 573 w 573"/>
                  <a:gd name="T19" fmla="*/ 223 h 507"/>
                  <a:gd name="T20" fmla="*/ 498 w 573"/>
                  <a:gd name="T21" fmla="*/ 431 h 507"/>
                  <a:gd name="T22" fmla="*/ 292 w 573"/>
                  <a:gd name="T23" fmla="*/ 507 h 507"/>
                  <a:gd name="T24" fmla="*/ 79 w 573"/>
                  <a:gd name="T25" fmla="*/ 435 h 507"/>
                  <a:gd name="T26" fmla="*/ 0 w 573"/>
                  <a:gd name="T27" fmla="*/ 239 h 507"/>
                  <a:gd name="T28" fmla="*/ 71 w 573"/>
                  <a:gd name="T29" fmla="*/ 64 h 507"/>
                  <a:gd name="T30" fmla="*/ 264 w 573"/>
                  <a:gd name="T31" fmla="*/ 0 h 507"/>
                  <a:gd name="T32" fmla="*/ 238 w 573"/>
                  <a:gd name="T33" fmla="*/ 90 h 507"/>
                  <a:gd name="T34" fmla="*/ 120 w 573"/>
                  <a:gd name="T35" fmla="*/ 131 h 507"/>
                  <a:gd name="T36" fmla="*/ 76 w 573"/>
                  <a:gd name="T37" fmla="*/ 238 h 507"/>
                  <a:gd name="T38" fmla="*/ 119 w 573"/>
                  <a:gd name="T39" fmla="*/ 358 h 507"/>
                  <a:gd name="T40" fmla="*/ 238 w 573"/>
                  <a:gd name="T41" fmla="*/ 410 h 507"/>
                  <a:gd name="T42" fmla="*/ 238 w 573"/>
                  <a:gd name="T43" fmla="*/ 90 h 5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73" h="507">
                    <a:moveTo>
                      <a:pt x="264" y="0"/>
                    </a:moveTo>
                    <a:lnTo>
                      <a:pt x="308" y="0"/>
                    </a:lnTo>
                    <a:lnTo>
                      <a:pt x="308" y="413"/>
                    </a:lnTo>
                    <a:cubicBezTo>
                      <a:pt x="370" y="409"/>
                      <a:pt x="418" y="391"/>
                      <a:pt x="450" y="357"/>
                    </a:cubicBezTo>
                    <a:cubicBezTo>
                      <a:pt x="482" y="324"/>
                      <a:pt x="498" y="278"/>
                      <a:pt x="498" y="218"/>
                    </a:cubicBezTo>
                    <a:cubicBezTo>
                      <a:pt x="498" y="184"/>
                      <a:pt x="494" y="150"/>
                      <a:pt x="486" y="118"/>
                    </a:cubicBezTo>
                    <a:cubicBezTo>
                      <a:pt x="478" y="86"/>
                      <a:pt x="465" y="53"/>
                      <a:pt x="447" y="21"/>
                    </a:cubicBezTo>
                    <a:lnTo>
                      <a:pt x="532" y="21"/>
                    </a:lnTo>
                    <a:cubicBezTo>
                      <a:pt x="546" y="53"/>
                      <a:pt x="557" y="86"/>
                      <a:pt x="563" y="120"/>
                    </a:cubicBezTo>
                    <a:cubicBezTo>
                      <a:pt x="569" y="154"/>
                      <a:pt x="573" y="189"/>
                      <a:pt x="573" y="223"/>
                    </a:cubicBezTo>
                    <a:cubicBezTo>
                      <a:pt x="573" y="311"/>
                      <a:pt x="548" y="380"/>
                      <a:pt x="498" y="431"/>
                    </a:cubicBezTo>
                    <a:cubicBezTo>
                      <a:pt x="448" y="482"/>
                      <a:pt x="379" y="507"/>
                      <a:pt x="292" y="507"/>
                    </a:cubicBezTo>
                    <a:cubicBezTo>
                      <a:pt x="203" y="507"/>
                      <a:pt x="132" y="483"/>
                      <a:pt x="79" y="435"/>
                    </a:cubicBezTo>
                    <a:cubicBezTo>
                      <a:pt x="27" y="387"/>
                      <a:pt x="0" y="321"/>
                      <a:pt x="0" y="239"/>
                    </a:cubicBezTo>
                    <a:cubicBezTo>
                      <a:pt x="0" y="165"/>
                      <a:pt x="24" y="107"/>
                      <a:pt x="71" y="64"/>
                    </a:cubicBezTo>
                    <a:cubicBezTo>
                      <a:pt x="119" y="22"/>
                      <a:pt x="183" y="0"/>
                      <a:pt x="264" y="0"/>
                    </a:cubicBezTo>
                    <a:close/>
                    <a:moveTo>
                      <a:pt x="238" y="90"/>
                    </a:moveTo>
                    <a:cubicBezTo>
                      <a:pt x="189" y="91"/>
                      <a:pt x="150" y="105"/>
                      <a:pt x="120" y="131"/>
                    </a:cubicBezTo>
                    <a:cubicBezTo>
                      <a:pt x="91" y="158"/>
                      <a:pt x="76" y="194"/>
                      <a:pt x="76" y="238"/>
                    </a:cubicBezTo>
                    <a:cubicBezTo>
                      <a:pt x="76" y="288"/>
                      <a:pt x="91" y="328"/>
                      <a:pt x="119" y="358"/>
                    </a:cubicBezTo>
                    <a:cubicBezTo>
                      <a:pt x="147" y="388"/>
                      <a:pt x="187" y="406"/>
                      <a:pt x="238" y="410"/>
                    </a:cubicBezTo>
                    <a:lnTo>
                      <a:pt x="238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7" name="Freeform 229">
                <a:extLst>
                  <a:ext uri="{FF2B5EF4-FFF2-40B4-BE49-F238E27FC236}">
                    <a16:creationId xmlns:a16="http://schemas.microsoft.com/office/drawing/2014/main" id="{C711A197-6451-4970-BDA3-03E1500FE3E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6513" y="3481388"/>
                <a:ext cx="100013" cy="57150"/>
              </a:xfrm>
              <a:custGeom>
                <a:avLst/>
                <a:gdLst>
                  <a:gd name="T0" fmla="*/ 97 w 560"/>
                  <a:gd name="T1" fmla="*/ 0 h 320"/>
                  <a:gd name="T2" fmla="*/ 84 w 560"/>
                  <a:gd name="T3" fmla="*/ 33 h 320"/>
                  <a:gd name="T4" fmla="*/ 80 w 560"/>
                  <a:gd name="T5" fmla="*/ 72 h 320"/>
                  <a:gd name="T6" fmla="*/ 130 w 560"/>
                  <a:gd name="T7" fmla="*/ 189 h 320"/>
                  <a:gd name="T8" fmla="*/ 272 w 560"/>
                  <a:gd name="T9" fmla="*/ 230 h 320"/>
                  <a:gd name="T10" fmla="*/ 560 w 560"/>
                  <a:gd name="T11" fmla="*/ 230 h 320"/>
                  <a:gd name="T12" fmla="*/ 560 w 560"/>
                  <a:gd name="T13" fmla="*/ 320 h 320"/>
                  <a:gd name="T14" fmla="*/ 13 w 560"/>
                  <a:gd name="T15" fmla="*/ 320 h 320"/>
                  <a:gd name="T16" fmla="*/ 13 w 560"/>
                  <a:gd name="T17" fmla="*/ 230 h 320"/>
                  <a:gd name="T18" fmla="*/ 98 w 560"/>
                  <a:gd name="T19" fmla="*/ 230 h 320"/>
                  <a:gd name="T20" fmla="*/ 24 w 560"/>
                  <a:gd name="T21" fmla="*/ 157 h 320"/>
                  <a:gd name="T22" fmla="*/ 0 w 560"/>
                  <a:gd name="T23" fmla="*/ 46 h 320"/>
                  <a:gd name="T24" fmla="*/ 1 w 560"/>
                  <a:gd name="T25" fmla="*/ 25 h 320"/>
                  <a:gd name="T26" fmla="*/ 5 w 560"/>
                  <a:gd name="T27" fmla="*/ 0 h 320"/>
                  <a:gd name="T28" fmla="*/ 97 w 560"/>
                  <a:gd name="T29" fmla="*/ 0 h 3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560" h="320">
                    <a:moveTo>
                      <a:pt x="97" y="0"/>
                    </a:moveTo>
                    <a:cubicBezTo>
                      <a:pt x="91" y="10"/>
                      <a:pt x="87" y="21"/>
                      <a:pt x="84" y="33"/>
                    </a:cubicBezTo>
                    <a:cubicBezTo>
                      <a:pt x="82" y="45"/>
                      <a:pt x="80" y="58"/>
                      <a:pt x="80" y="72"/>
                    </a:cubicBezTo>
                    <a:cubicBezTo>
                      <a:pt x="80" y="123"/>
                      <a:pt x="97" y="162"/>
                      <a:pt x="130" y="189"/>
                    </a:cubicBezTo>
                    <a:cubicBezTo>
                      <a:pt x="163" y="217"/>
                      <a:pt x="210" y="230"/>
                      <a:pt x="272" y="230"/>
                    </a:cubicBezTo>
                    <a:lnTo>
                      <a:pt x="560" y="230"/>
                    </a:lnTo>
                    <a:lnTo>
                      <a:pt x="560" y="320"/>
                    </a:lnTo>
                    <a:lnTo>
                      <a:pt x="13" y="320"/>
                    </a:lnTo>
                    <a:lnTo>
                      <a:pt x="13" y="230"/>
                    </a:lnTo>
                    <a:lnTo>
                      <a:pt x="98" y="230"/>
                    </a:lnTo>
                    <a:cubicBezTo>
                      <a:pt x="65" y="212"/>
                      <a:pt x="40" y="187"/>
                      <a:pt x="24" y="157"/>
                    </a:cubicBezTo>
                    <a:cubicBezTo>
                      <a:pt x="8" y="127"/>
                      <a:pt x="0" y="90"/>
                      <a:pt x="0" y="46"/>
                    </a:cubicBezTo>
                    <a:cubicBezTo>
                      <a:pt x="0" y="40"/>
                      <a:pt x="1" y="33"/>
                      <a:pt x="1" y="25"/>
                    </a:cubicBezTo>
                    <a:cubicBezTo>
                      <a:pt x="2" y="18"/>
                      <a:pt x="3" y="10"/>
                      <a:pt x="5" y="0"/>
                    </a:cubicBezTo>
                    <a:lnTo>
                      <a:pt x="97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8" name="Freeform 230">
                <a:extLst>
                  <a:ext uri="{FF2B5EF4-FFF2-40B4-BE49-F238E27FC236}">
                    <a16:creationId xmlns:a16="http://schemas.microsoft.com/office/drawing/2014/main" id="{53B8DAD4-1678-75EA-58FE-7EFBB2FE6E1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0000" y="3367088"/>
                <a:ext cx="160338" cy="41275"/>
              </a:xfrm>
              <a:custGeom>
                <a:avLst/>
                <a:gdLst>
                  <a:gd name="T0" fmla="*/ 0 w 890"/>
                  <a:gd name="T1" fmla="*/ 0 h 224"/>
                  <a:gd name="T2" fmla="*/ 223 w 890"/>
                  <a:gd name="T3" fmla="*/ 97 h 224"/>
                  <a:gd name="T4" fmla="*/ 445 w 890"/>
                  <a:gd name="T5" fmla="*/ 129 h 224"/>
                  <a:gd name="T6" fmla="*/ 668 w 890"/>
                  <a:gd name="T7" fmla="*/ 97 h 224"/>
                  <a:gd name="T8" fmla="*/ 890 w 890"/>
                  <a:gd name="T9" fmla="*/ 0 h 224"/>
                  <a:gd name="T10" fmla="*/ 890 w 890"/>
                  <a:gd name="T11" fmla="*/ 78 h 224"/>
                  <a:gd name="T12" fmla="*/ 665 w 890"/>
                  <a:gd name="T13" fmla="*/ 188 h 224"/>
                  <a:gd name="T14" fmla="*/ 445 w 890"/>
                  <a:gd name="T15" fmla="*/ 224 h 224"/>
                  <a:gd name="T16" fmla="*/ 226 w 890"/>
                  <a:gd name="T17" fmla="*/ 188 h 224"/>
                  <a:gd name="T18" fmla="*/ 0 w 890"/>
                  <a:gd name="T19" fmla="*/ 78 h 224"/>
                  <a:gd name="T20" fmla="*/ 0 w 890"/>
                  <a:gd name="T21" fmla="*/ 0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890" h="224">
                    <a:moveTo>
                      <a:pt x="0" y="0"/>
                    </a:moveTo>
                    <a:cubicBezTo>
                      <a:pt x="76" y="44"/>
                      <a:pt x="150" y="76"/>
                      <a:pt x="223" y="97"/>
                    </a:cubicBezTo>
                    <a:cubicBezTo>
                      <a:pt x="296" y="119"/>
                      <a:pt x="370" y="129"/>
                      <a:pt x="445" y="129"/>
                    </a:cubicBezTo>
                    <a:cubicBezTo>
                      <a:pt x="521" y="129"/>
                      <a:pt x="595" y="119"/>
                      <a:pt x="668" y="97"/>
                    </a:cubicBezTo>
                    <a:cubicBezTo>
                      <a:pt x="742" y="76"/>
                      <a:pt x="815" y="44"/>
                      <a:pt x="890" y="0"/>
                    </a:cubicBezTo>
                    <a:lnTo>
                      <a:pt x="890" y="78"/>
                    </a:lnTo>
                    <a:cubicBezTo>
                      <a:pt x="813" y="127"/>
                      <a:pt x="739" y="164"/>
                      <a:pt x="665" y="188"/>
                    </a:cubicBezTo>
                    <a:cubicBezTo>
                      <a:pt x="591" y="212"/>
                      <a:pt x="518" y="224"/>
                      <a:pt x="445" y="224"/>
                    </a:cubicBezTo>
                    <a:cubicBezTo>
                      <a:pt x="373" y="224"/>
                      <a:pt x="300" y="212"/>
                      <a:pt x="226" y="188"/>
                    </a:cubicBezTo>
                    <a:cubicBezTo>
                      <a:pt x="152" y="164"/>
                      <a:pt x="77" y="128"/>
                      <a:pt x="0" y="78"/>
                    </a:cubicBez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9" name="Freeform 231">
                <a:extLst>
                  <a:ext uri="{FF2B5EF4-FFF2-40B4-BE49-F238E27FC236}">
                    <a16:creationId xmlns:a16="http://schemas.microsoft.com/office/drawing/2014/main" id="{659D6773-499A-E5E8-FF0E-3F42D483ADE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6513" y="3265488"/>
                <a:ext cx="103188" cy="77788"/>
              </a:xfrm>
              <a:custGeom>
                <a:avLst/>
                <a:gdLst>
                  <a:gd name="T0" fmla="*/ 34 w 573"/>
                  <a:gd name="T1" fmla="*/ 0 h 433"/>
                  <a:gd name="T2" fmla="*/ 118 w 573"/>
                  <a:gd name="T3" fmla="*/ 0 h 433"/>
                  <a:gd name="T4" fmla="*/ 87 w 573"/>
                  <a:gd name="T5" fmla="*/ 77 h 433"/>
                  <a:gd name="T6" fmla="*/ 76 w 573"/>
                  <a:gd name="T7" fmla="*/ 154 h 433"/>
                  <a:gd name="T8" fmla="*/ 132 w 573"/>
                  <a:gd name="T9" fmla="*/ 290 h 433"/>
                  <a:gd name="T10" fmla="*/ 287 w 573"/>
                  <a:gd name="T11" fmla="*/ 338 h 433"/>
                  <a:gd name="T12" fmla="*/ 443 w 573"/>
                  <a:gd name="T13" fmla="*/ 290 h 433"/>
                  <a:gd name="T14" fmla="*/ 498 w 573"/>
                  <a:gd name="T15" fmla="*/ 154 h 433"/>
                  <a:gd name="T16" fmla="*/ 488 w 573"/>
                  <a:gd name="T17" fmla="*/ 77 h 433"/>
                  <a:gd name="T18" fmla="*/ 456 w 573"/>
                  <a:gd name="T19" fmla="*/ 0 h 433"/>
                  <a:gd name="T20" fmla="*/ 539 w 573"/>
                  <a:gd name="T21" fmla="*/ 0 h 433"/>
                  <a:gd name="T22" fmla="*/ 565 w 573"/>
                  <a:gd name="T23" fmla="*/ 78 h 433"/>
                  <a:gd name="T24" fmla="*/ 573 w 573"/>
                  <a:gd name="T25" fmla="*/ 164 h 433"/>
                  <a:gd name="T26" fmla="*/ 496 w 573"/>
                  <a:gd name="T27" fmla="*/ 360 h 433"/>
                  <a:gd name="T28" fmla="*/ 287 w 573"/>
                  <a:gd name="T29" fmla="*/ 433 h 433"/>
                  <a:gd name="T30" fmla="*/ 77 w 573"/>
                  <a:gd name="T31" fmla="*/ 360 h 433"/>
                  <a:gd name="T32" fmla="*/ 0 w 573"/>
                  <a:gd name="T33" fmla="*/ 158 h 433"/>
                  <a:gd name="T34" fmla="*/ 9 w 573"/>
                  <a:gd name="T35" fmla="*/ 77 h 433"/>
                  <a:gd name="T36" fmla="*/ 34 w 573"/>
                  <a:gd name="T37" fmla="*/ 0 h 4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573" h="433">
                    <a:moveTo>
                      <a:pt x="34" y="0"/>
                    </a:moveTo>
                    <a:lnTo>
                      <a:pt x="118" y="0"/>
                    </a:lnTo>
                    <a:cubicBezTo>
                      <a:pt x="104" y="26"/>
                      <a:pt x="94" y="51"/>
                      <a:pt x="87" y="77"/>
                    </a:cubicBezTo>
                    <a:cubicBezTo>
                      <a:pt x="80" y="103"/>
                      <a:pt x="76" y="128"/>
                      <a:pt x="76" y="154"/>
                    </a:cubicBezTo>
                    <a:cubicBezTo>
                      <a:pt x="76" y="212"/>
                      <a:pt x="95" y="258"/>
                      <a:pt x="132" y="290"/>
                    </a:cubicBezTo>
                    <a:cubicBezTo>
                      <a:pt x="169" y="322"/>
                      <a:pt x="221" y="338"/>
                      <a:pt x="287" y="338"/>
                    </a:cubicBezTo>
                    <a:cubicBezTo>
                      <a:pt x="354" y="338"/>
                      <a:pt x="406" y="322"/>
                      <a:pt x="443" y="290"/>
                    </a:cubicBezTo>
                    <a:cubicBezTo>
                      <a:pt x="480" y="258"/>
                      <a:pt x="498" y="212"/>
                      <a:pt x="498" y="154"/>
                    </a:cubicBezTo>
                    <a:cubicBezTo>
                      <a:pt x="498" y="128"/>
                      <a:pt x="495" y="103"/>
                      <a:pt x="488" y="77"/>
                    </a:cubicBezTo>
                    <a:cubicBezTo>
                      <a:pt x="481" y="51"/>
                      <a:pt x="470" y="26"/>
                      <a:pt x="456" y="0"/>
                    </a:cubicBezTo>
                    <a:lnTo>
                      <a:pt x="539" y="0"/>
                    </a:lnTo>
                    <a:cubicBezTo>
                      <a:pt x="551" y="26"/>
                      <a:pt x="560" y="52"/>
                      <a:pt x="565" y="78"/>
                    </a:cubicBezTo>
                    <a:cubicBezTo>
                      <a:pt x="570" y="105"/>
                      <a:pt x="573" y="134"/>
                      <a:pt x="573" y="164"/>
                    </a:cubicBezTo>
                    <a:cubicBezTo>
                      <a:pt x="573" y="246"/>
                      <a:pt x="548" y="312"/>
                      <a:pt x="496" y="360"/>
                    </a:cubicBezTo>
                    <a:cubicBezTo>
                      <a:pt x="445" y="409"/>
                      <a:pt x="375" y="433"/>
                      <a:pt x="287" y="433"/>
                    </a:cubicBezTo>
                    <a:cubicBezTo>
                      <a:pt x="198" y="433"/>
                      <a:pt x="128" y="409"/>
                      <a:pt x="77" y="360"/>
                    </a:cubicBezTo>
                    <a:cubicBezTo>
                      <a:pt x="26" y="311"/>
                      <a:pt x="0" y="244"/>
                      <a:pt x="0" y="158"/>
                    </a:cubicBezTo>
                    <a:cubicBezTo>
                      <a:pt x="0" y="130"/>
                      <a:pt x="3" y="103"/>
                      <a:pt x="9" y="77"/>
                    </a:cubicBezTo>
                    <a:cubicBezTo>
                      <a:pt x="15" y="51"/>
                      <a:pt x="23" y="25"/>
                      <a:pt x="34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0" name="Freeform 232">
                <a:extLst>
                  <a:ext uri="{FF2B5EF4-FFF2-40B4-BE49-F238E27FC236}">
                    <a16:creationId xmlns:a16="http://schemas.microsoft.com/office/drawing/2014/main" id="{3541A237-57C1-4305-F137-983E09AE697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3152775"/>
                <a:ext cx="103188" cy="92075"/>
              </a:xfrm>
              <a:custGeom>
                <a:avLst/>
                <a:gdLst>
                  <a:gd name="T0" fmla="*/ 264 w 573"/>
                  <a:gd name="T1" fmla="*/ 0 h 507"/>
                  <a:gd name="T2" fmla="*/ 308 w 573"/>
                  <a:gd name="T3" fmla="*/ 0 h 507"/>
                  <a:gd name="T4" fmla="*/ 308 w 573"/>
                  <a:gd name="T5" fmla="*/ 413 h 507"/>
                  <a:gd name="T6" fmla="*/ 450 w 573"/>
                  <a:gd name="T7" fmla="*/ 357 h 507"/>
                  <a:gd name="T8" fmla="*/ 498 w 573"/>
                  <a:gd name="T9" fmla="*/ 218 h 507"/>
                  <a:gd name="T10" fmla="*/ 486 w 573"/>
                  <a:gd name="T11" fmla="*/ 118 h 507"/>
                  <a:gd name="T12" fmla="*/ 447 w 573"/>
                  <a:gd name="T13" fmla="*/ 21 h 507"/>
                  <a:gd name="T14" fmla="*/ 532 w 573"/>
                  <a:gd name="T15" fmla="*/ 21 h 507"/>
                  <a:gd name="T16" fmla="*/ 563 w 573"/>
                  <a:gd name="T17" fmla="*/ 120 h 507"/>
                  <a:gd name="T18" fmla="*/ 573 w 573"/>
                  <a:gd name="T19" fmla="*/ 223 h 507"/>
                  <a:gd name="T20" fmla="*/ 498 w 573"/>
                  <a:gd name="T21" fmla="*/ 431 h 507"/>
                  <a:gd name="T22" fmla="*/ 292 w 573"/>
                  <a:gd name="T23" fmla="*/ 507 h 507"/>
                  <a:gd name="T24" fmla="*/ 79 w 573"/>
                  <a:gd name="T25" fmla="*/ 435 h 507"/>
                  <a:gd name="T26" fmla="*/ 0 w 573"/>
                  <a:gd name="T27" fmla="*/ 239 h 507"/>
                  <a:gd name="T28" fmla="*/ 71 w 573"/>
                  <a:gd name="T29" fmla="*/ 64 h 507"/>
                  <a:gd name="T30" fmla="*/ 264 w 573"/>
                  <a:gd name="T31" fmla="*/ 0 h 507"/>
                  <a:gd name="T32" fmla="*/ 238 w 573"/>
                  <a:gd name="T33" fmla="*/ 90 h 507"/>
                  <a:gd name="T34" fmla="*/ 120 w 573"/>
                  <a:gd name="T35" fmla="*/ 131 h 507"/>
                  <a:gd name="T36" fmla="*/ 76 w 573"/>
                  <a:gd name="T37" fmla="*/ 238 h 507"/>
                  <a:gd name="T38" fmla="*/ 119 w 573"/>
                  <a:gd name="T39" fmla="*/ 358 h 507"/>
                  <a:gd name="T40" fmla="*/ 238 w 573"/>
                  <a:gd name="T41" fmla="*/ 410 h 507"/>
                  <a:gd name="T42" fmla="*/ 238 w 573"/>
                  <a:gd name="T43" fmla="*/ 90 h 5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73" h="507">
                    <a:moveTo>
                      <a:pt x="264" y="0"/>
                    </a:moveTo>
                    <a:lnTo>
                      <a:pt x="308" y="0"/>
                    </a:lnTo>
                    <a:lnTo>
                      <a:pt x="308" y="413"/>
                    </a:lnTo>
                    <a:cubicBezTo>
                      <a:pt x="370" y="409"/>
                      <a:pt x="418" y="391"/>
                      <a:pt x="450" y="357"/>
                    </a:cubicBezTo>
                    <a:cubicBezTo>
                      <a:pt x="482" y="324"/>
                      <a:pt x="498" y="278"/>
                      <a:pt x="498" y="218"/>
                    </a:cubicBezTo>
                    <a:cubicBezTo>
                      <a:pt x="498" y="184"/>
                      <a:pt x="494" y="150"/>
                      <a:pt x="486" y="118"/>
                    </a:cubicBezTo>
                    <a:cubicBezTo>
                      <a:pt x="478" y="86"/>
                      <a:pt x="465" y="53"/>
                      <a:pt x="447" y="21"/>
                    </a:cubicBezTo>
                    <a:lnTo>
                      <a:pt x="532" y="21"/>
                    </a:lnTo>
                    <a:cubicBezTo>
                      <a:pt x="546" y="53"/>
                      <a:pt x="557" y="86"/>
                      <a:pt x="563" y="120"/>
                    </a:cubicBezTo>
                    <a:cubicBezTo>
                      <a:pt x="569" y="154"/>
                      <a:pt x="573" y="189"/>
                      <a:pt x="573" y="223"/>
                    </a:cubicBezTo>
                    <a:cubicBezTo>
                      <a:pt x="573" y="311"/>
                      <a:pt x="548" y="380"/>
                      <a:pt x="498" y="431"/>
                    </a:cubicBezTo>
                    <a:cubicBezTo>
                      <a:pt x="448" y="482"/>
                      <a:pt x="379" y="507"/>
                      <a:pt x="292" y="507"/>
                    </a:cubicBezTo>
                    <a:cubicBezTo>
                      <a:pt x="203" y="507"/>
                      <a:pt x="132" y="483"/>
                      <a:pt x="79" y="435"/>
                    </a:cubicBezTo>
                    <a:cubicBezTo>
                      <a:pt x="27" y="387"/>
                      <a:pt x="0" y="321"/>
                      <a:pt x="0" y="239"/>
                    </a:cubicBezTo>
                    <a:cubicBezTo>
                      <a:pt x="0" y="165"/>
                      <a:pt x="24" y="107"/>
                      <a:pt x="71" y="64"/>
                    </a:cubicBezTo>
                    <a:cubicBezTo>
                      <a:pt x="119" y="22"/>
                      <a:pt x="183" y="0"/>
                      <a:pt x="264" y="0"/>
                    </a:cubicBezTo>
                    <a:close/>
                    <a:moveTo>
                      <a:pt x="238" y="90"/>
                    </a:moveTo>
                    <a:cubicBezTo>
                      <a:pt x="189" y="91"/>
                      <a:pt x="150" y="105"/>
                      <a:pt x="120" y="131"/>
                    </a:cubicBezTo>
                    <a:cubicBezTo>
                      <a:pt x="91" y="158"/>
                      <a:pt x="76" y="194"/>
                      <a:pt x="76" y="238"/>
                    </a:cubicBezTo>
                    <a:cubicBezTo>
                      <a:pt x="76" y="288"/>
                      <a:pt x="91" y="328"/>
                      <a:pt x="119" y="358"/>
                    </a:cubicBezTo>
                    <a:cubicBezTo>
                      <a:pt x="147" y="388"/>
                      <a:pt x="187" y="406"/>
                      <a:pt x="238" y="410"/>
                    </a:cubicBezTo>
                    <a:lnTo>
                      <a:pt x="238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1" name="Rectangle 233">
                <a:extLst>
                  <a:ext uri="{FF2B5EF4-FFF2-40B4-BE49-F238E27FC236}">
                    <a16:creationId xmlns:a16="http://schemas.microsoft.com/office/drawing/2014/main" id="{D8737C27-FE95-0AEA-BCA8-E46525B2C1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000" y="3109913"/>
                <a:ext cx="136525" cy="1587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2" name="Rectangle 234">
                <a:extLst>
                  <a:ext uri="{FF2B5EF4-FFF2-40B4-BE49-F238E27FC236}">
                    <a16:creationId xmlns:a16="http://schemas.microsoft.com/office/drawing/2014/main" id="{C6BD1E86-F3D6-E1DF-A4CB-10EB90698A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000" y="3059113"/>
                <a:ext cx="136525" cy="17463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3" name="Freeform 235">
                <a:extLst>
                  <a:ext uri="{FF2B5EF4-FFF2-40B4-BE49-F238E27FC236}">
                    <a16:creationId xmlns:a16="http://schemas.microsoft.com/office/drawing/2014/main" id="{C42C670B-E4B2-AB88-4037-2E188F98053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6513" y="2957513"/>
                <a:ext cx="103188" cy="76200"/>
              </a:xfrm>
              <a:custGeom>
                <a:avLst/>
                <a:gdLst>
                  <a:gd name="T0" fmla="*/ 29 w 573"/>
                  <a:gd name="T1" fmla="*/ 29 h 418"/>
                  <a:gd name="T2" fmla="*/ 114 w 573"/>
                  <a:gd name="T3" fmla="*/ 29 h 418"/>
                  <a:gd name="T4" fmla="*/ 85 w 573"/>
                  <a:gd name="T5" fmla="*/ 108 h 418"/>
                  <a:gd name="T6" fmla="*/ 75 w 573"/>
                  <a:gd name="T7" fmla="*/ 193 h 418"/>
                  <a:gd name="T8" fmla="*/ 96 w 573"/>
                  <a:gd name="T9" fmla="*/ 294 h 418"/>
                  <a:gd name="T10" fmla="*/ 157 w 573"/>
                  <a:gd name="T11" fmla="*/ 327 h 418"/>
                  <a:gd name="T12" fmla="*/ 206 w 573"/>
                  <a:gd name="T13" fmla="*/ 303 h 418"/>
                  <a:gd name="T14" fmla="*/ 240 w 573"/>
                  <a:gd name="T15" fmla="*/ 207 h 418"/>
                  <a:gd name="T16" fmla="*/ 247 w 573"/>
                  <a:gd name="T17" fmla="*/ 176 h 418"/>
                  <a:gd name="T18" fmla="*/ 305 w 573"/>
                  <a:gd name="T19" fmla="*/ 40 h 418"/>
                  <a:gd name="T20" fmla="*/ 409 w 573"/>
                  <a:gd name="T21" fmla="*/ 0 h 418"/>
                  <a:gd name="T22" fmla="*/ 529 w 573"/>
                  <a:gd name="T23" fmla="*/ 60 h 418"/>
                  <a:gd name="T24" fmla="*/ 573 w 573"/>
                  <a:gd name="T25" fmla="*/ 226 h 418"/>
                  <a:gd name="T26" fmla="*/ 565 w 573"/>
                  <a:gd name="T27" fmla="*/ 318 h 418"/>
                  <a:gd name="T28" fmla="*/ 540 w 573"/>
                  <a:gd name="T29" fmla="*/ 418 h 418"/>
                  <a:gd name="T30" fmla="*/ 447 w 573"/>
                  <a:gd name="T31" fmla="*/ 418 h 418"/>
                  <a:gd name="T32" fmla="*/ 486 w 573"/>
                  <a:gd name="T33" fmla="*/ 320 h 418"/>
                  <a:gd name="T34" fmla="*/ 499 w 573"/>
                  <a:gd name="T35" fmla="*/ 224 h 418"/>
                  <a:gd name="T36" fmla="*/ 478 w 573"/>
                  <a:gd name="T37" fmla="*/ 126 h 418"/>
                  <a:gd name="T38" fmla="*/ 416 w 573"/>
                  <a:gd name="T39" fmla="*/ 92 h 418"/>
                  <a:gd name="T40" fmla="*/ 360 w 573"/>
                  <a:gd name="T41" fmla="*/ 117 h 418"/>
                  <a:gd name="T42" fmla="*/ 322 w 573"/>
                  <a:gd name="T43" fmla="*/ 225 h 418"/>
                  <a:gd name="T44" fmla="*/ 315 w 573"/>
                  <a:gd name="T45" fmla="*/ 256 h 418"/>
                  <a:gd name="T46" fmla="*/ 261 w 573"/>
                  <a:gd name="T47" fmla="*/ 377 h 418"/>
                  <a:gd name="T48" fmla="*/ 161 w 573"/>
                  <a:gd name="T49" fmla="*/ 414 h 418"/>
                  <a:gd name="T50" fmla="*/ 42 w 573"/>
                  <a:gd name="T51" fmla="*/ 360 h 418"/>
                  <a:gd name="T52" fmla="*/ 0 w 573"/>
                  <a:gd name="T53" fmla="*/ 204 h 418"/>
                  <a:gd name="T54" fmla="*/ 8 w 573"/>
                  <a:gd name="T55" fmla="*/ 110 h 418"/>
                  <a:gd name="T56" fmla="*/ 29 w 573"/>
                  <a:gd name="T57" fmla="*/ 29 h 4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573" h="418">
                    <a:moveTo>
                      <a:pt x="29" y="29"/>
                    </a:moveTo>
                    <a:lnTo>
                      <a:pt x="114" y="29"/>
                    </a:lnTo>
                    <a:cubicBezTo>
                      <a:pt x="102" y="55"/>
                      <a:pt x="92" y="81"/>
                      <a:pt x="85" y="108"/>
                    </a:cubicBezTo>
                    <a:cubicBezTo>
                      <a:pt x="79" y="136"/>
                      <a:pt x="75" y="164"/>
                      <a:pt x="75" y="193"/>
                    </a:cubicBezTo>
                    <a:cubicBezTo>
                      <a:pt x="75" y="238"/>
                      <a:pt x="82" y="272"/>
                      <a:pt x="96" y="294"/>
                    </a:cubicBezTo>
                    <a:cubicBezTo>
                      <a:pt x="110" y="316"/>
                      <a:pt x="130" y="327"/>
                      <a:pt x="157" y="327"/>
                    </a:cubicBezTo>
                    <a:cubicBezTo>
                      <a:pt x="178" y="327"/>
                      <a:pt x="194" y="319"/>
                      <a:pt x="206" y="303"/>
                    </a:cubicBezTo>
                    <a:cubicBezTo>
                      <a:pt x="218" y="287"/>
                      <a:pt x="230" y="255"/>
                      <a:pt x="240" y="207"/>
                    </a:cubicBezTo>
                    <a:lnTo>
                      <a:pt x="247" y="176"/>
                    </a:lnTo>
                    <a:cubicBezTo>
                      <a:pt x="261" y="112"/>
                      <a:pt x="281" y="67"/>
                      <a:pt x="305" y="40"/>
                    </a:cubicBezTo>
                    <a:cubicBezTo>
                      <a:pt x="330" y="14"/>
                      <a:pt x="365" y="0"/>
                      <a:pt x="409" y="0"/>
                    </a:cubicBezTo>
                    <a:cubicBezTo>
                      <a:pt x="460" y="0"/>
                      <a:pt x="500" y="20"/>
                      <a:pt x="529" y="60"/>
                    </a:cubicBezTo>
                    <a:cubicBezTo>
                      <a:pt x="559" y="100"/>
                      <a:pt x="573" y="156"/>
                      <a:pt x="573" y="226"/>
                    </a:cubicBezTo>
                    <a:cubicBezTo>
                      <a:pt x="573" y="256"/>
                      <a:pt x="570" y="286"/>
                      <a:pt x="565" y="318"/>
                    </a:cubicBezTo>
                    <a:cubicBezTo>
                      <a:pt x="560" y="350"/>
                      <a:pt x="552" y="383"/>
                      <a:pt x="540" y="418"/>
                    </a:cubicBezTo>
                    <a:lnTo>
                      <a:pt x="447" y="418"/>
                    </a:lnTo>
                    <a:cubicBezTo>
                      <a:pt x="465" y="385"/>
                      <a:pt x="478" y="352"/>
                      <a:pt x="486" y="320"/>
                    </a:cubicBezTo>
                    <a:cubicBezTo>
                      <a:pt x="495" y="288"/>
                      <a:pt x="499" y="256"/>
                      <a:pt x="499" y="224"/>
                    </a:cubicBezTo>
                    <a:cubicBezTo>
                      <a:pt x="499" y="182"/>
                      <a:pt x="492" y="149"/>
                      <a:pt x="478" y="126"/>
                    </a:cubicBezTo>
                    <a:cubicBezTo>
                      <a:pt x="464" y="104"/>
                      <a:pt x="443" y="92"/>
                      <a:pt x="416" y="92"/>
                    </a:cubicBezTo>
                    <a:cubicBezTo>
                      <a:pt x="392" y="92"/>
                      <a:pt x="373" y="101"/>
                      <a:pt x="360" y="117"/>
                    </a:cubicBezTo>
                    <a:cubicBezTo>
                      <a:pt x="347" y="133"/>
                      <a:pt x="334" y="169"/>
                      <a:pt x="322" y="225"/>
                    </a:cubicBezTo>
                    <a:lnTo>
                      <a:pt x="315" y="256"/>
                    </a:lnTo>
                    <a:cubicBezTo>
                      <a:pt x="303" y="312"/>
                      <a:pt x="285" y="353"/>
                      <a:pt x="261" y="377"/>
                    </a:cubicBezTo>
                    <a:cubicBezTo>
                      <a:pt x="237" y="402"/>
                      <a:pt x="204" y="414"/>
                      <a:pt x="161" y="414"/>
                    </a:cubicBezTo>
                    <a:cubicBezTo>
                      <a:pt x="110" y="414"/>
                      <a:pt x="70" y="396"/>
                      <a:pt x="42" y="360"/>
                    </a:cubicBezTo>
                    <a:cubicBezTo>
                      <a:pt x="14" y="324"/>
                      <a:pt x="0" y="272"/>
                      <a:pt x="0" y="204"/>
                    </a:cubicBezTo>
                    <a:cubicBezTo>
                      <a:pt x="0" y="171"/>
                      <a:pt x="3" y="140"/>
                      <a:pt x="8" y="110"/>
                    </a:cubicBezTo>
                    <a:cubicBezTo>
                      <a:pt x="13" y="81"/>
                      <a:pt x="20" y="54"/>
                      <a:pt x="29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4" name="Freeform 236">
                <a:extLst>
                  <a:ext uri="{FF2B5EF4-FFF2-40B4-BE49-F238E27FC236}">
                    <a16:creationId xmlns:a16="http://schemas.microsoft.com/office/drawing/2014/main" id="{702A7186-52E6-F4E7-DECB-3AA28F13315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0000" y="2894013"/>
                <a:ext cx="160338" cy="39688"/>
              </a:xfrm>
              <a:custGeom>
                <a:avLst/>
                <a:gdLst>
                  <a:gd name="T0" fmla="*/ 0 w 890"/>
                  <a:gd name="T1" fmla="*/ 224 h 224"/>
                  <a:gd name="T2" fmla="*/ 0 w 890"/>
                  <a:gd name="T3" fmla="*/ 146 h 224"/>
                  <a:gd name="T4" fmla="*/ 226 w 890"/>
                  <a:gd name="T5" fmla="*/ 37 h 224"/>
                  <a:gd name="T6" fmla="*/ 445 w 890"/>
                  <a:gd name="T7" fmla="*/ 0 h 224"/>
                  <a:gd name="T8" fmla="*/ 665 w 890"/>
                  <a:gd name="T9" fmla="*/ 37 h 224"/>
                  <a:gd name="T10" fmla="*/ 890 w 890"/>
                  <a:gd name="T11" fmla="*/ 146 h 224"/>
                  <a:gd name="T12" fmla="*/ 890 w 890"/>
                  <a:gd name="T13" fmla="*/ 224 h 224"/>
                  <a:gd name="T14" fmla="*/ 668 w 890"/>
                  <a:gd name="T15" fmla="*/ 127 h 224"/>
                  <a:gd name="T16" fmla="*/ 445 w 890"/>
                  <a:gd name="T17" fmla="*/ 95 h 224"/>
                  <a:gd name="T18" fmla="*/ 223 w 890"/>
                  <a:gd name="T19" fmla="*/ 127 h 224"/>
                  <a:gd name="T20" fmla="*/ 0 w 890"/>
                  <a:gd name="T21" fmla="*/ 224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890" h="224">
                    <a:moveTo>
                      <a:pt x="0" y="224"/>
                    </a:moveTo>
                    <a:lnTo>
                      <a:pt x="0" y="146"/>
                    </a:lnTo>
                    <a:cubicBezTo>
                      <a:pt x="77" y="98"/>
                      <a:pt x="152" y="61"/>
                      <a:pt x="226" y="37"/>
                    </a:cubicBezTo>
                    <a:cubicBezTo>
                      <a:pt x="300" y="13"/>
                      <a:pt x="373" y="0"/>
                      <a:pt x="445" y="0"/>
                    </a:cubicBezTo>
                    <a:cubicBezTo>
                      <a:pt x="518" y="0"/>
                      <a:pt x="591" y="13"/>
                      <a:pt x="665" y="37"/>
                    </a:cubicBezTo>
                    <a:cubicBezTo>
                      <a:pt x="739" y="61"/>
                      <a:pt x="813" y="98"/>
                      <a:pt x="890" y="146"/>
                    </a:cubicBezTo>
                    <a:lnTo>
                      <a:pt x="890" y="224"/>
                    </a:lnTo>
                    <a:cubicBezTo>
                      <a:pt x="815" y="181"/>
                      <a:pt x="742" y="149"/>
                      <a:pt x="668" y="127"/>
                    </a:cubicBezTo>
                    <a:cubicBezTo>
                      <a:pt x="595" y="106"/>
                      <a:pt x="521" y="95"/>
                      <a:pt x="445" y="95"/>
                    </a:cubicBezTo>
                    <a:cubicBezTo>
                      <a:pt x="370" y="95"/>
                      <a:pt x="296" y="106"/>
                      <a:pt x="223" y="127"/>
                    </a:cubicBezTo>
                    <a:cubicBezTo>
                      <a:pt x="150" y="149"/>
                      <a:pt x="76" y="181"/>
                      <a:pt x="0" y="224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pic>
            <p:nvPicPr>
              <p:cNvPr id="1425" name="Picture 237">
                <a:extLst>
                  <a:ext uri="{FF2B5EF4-FFF2-40B4-BE49-F238E27FC236}">
                    <a16:creationId xmlns:a16="http://schemas.microsoft.com/office/drawing/2014/main" id="{D1512B35-3F60-130B-CC5A-0F105004FC9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316288" y="2628900"/>
                <a:ext cx="2992438" cy="22558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426" name="Freeform 238">
                <a:extLst>
                  <a:ext uri="{FF2B5EF4-FFF2-40B4-BE49-F238E27FC236}">
                    <a16:creationId xmlns:a16="http://schemas.microsoft.com/office/drawing/2014/main" id="{0E8ADDD5-5E28-983C-3FA1-AE61BE82E5A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27400" y="3251200"/>
                <a:ext cx="2971800" cy="946150"/>
              </a:xfrm>
              <a:custGeom>
                <a:avLst/>
                <a:gdLst>
                  <a:gd name="T0" fmla="*/ 0 w 16499"/>
                  <a:gd name="T1" fmla="*/ 5245 h 5245"/>
                  <a:gd name="T2" fmla="*/ 471 w 16499"/>
                  <a:gd name="T3" fmla="*/ 4133 h 5245"/>
                  <a:gd name="T4" fmla="*/ 943 w 16499"/>
                  <a:gd name="T5" fmla="*/ 3433 h 5245"/>
                  <a:gd name="T6" fmla="*/ 1414 w 16499"/>
                  <a:gd name="T7" fmla="*/ 2766 h 5245"/>
                  <a:gd name="T8" fmla="*/ 1885 w 16499"/>
                  <a:gd name="T9" fmla="*/ 1876 h 5245"/>
                  <a:gd name="T10" fmla="*/ 2357 w 16499"/>
                  <a:gd name="T11" fmla="*/ 2480 h 5245"/>
                  <a:gd name="T12" fmla="*/ 2828 w 16499"/>
                  <a:gd name="T13" fmla="*/ 2416 h 5245"/>
                  <a:gd name="T14" fmla="*/ 3300 w 16499"/>
                  <a:gd name="T15" fmla="*/ 2480 h 5245"/>
                  <a:gd name="T16" fmla="*/ 3771 w 16499"/>
                  <a:gd name="T17" fmla="*/ 2480 h 5245"/>
                  <a:gd name="T18" fmla="*/ 4243 w 16499"/>
                  <a:gd name="T19" fmla="*/ 1176 h 5245"/>
                  <a:gd name="T20" fmla="*/ 4714 w 16499"/>
                  <a:gd name="T21" fmla="*/ 413 h 5245"/>
                  <a:gd name="T22" fmla="*/ 5185 w 16499"/>
                  <a:gd name="T23" fmla="*/ 954 h 5245"/>
                  <a:gd name="T24" fmla="*/ 5657 w 16499"/>
                  <a:gd name="T25" fmla="*/ 1526 h 5245"/>
                  <a:gd name="T26" fmla="*/ 6128 w 16499"/>
                  <a:gd name="T27" fmla="*/ 2766 h 5245"/>
                  <a:gd name="T28" fmla="*/ 6600 w 16499"/>
                  <a:gd name="T29" fmla="*/ 2893 h 5245"/>
                  <a:gd name="T30" fmla="*/ 7071 w 16499"/>
                  <a:gd name="T31" fmla="*/ 3306 h 5245"/>
                  <a:gd name="T32" fmla="*/ 7542 w 16499"/>
                  <a:gd name="T33" fmla="*/ 2734 h 5245"/>
                  <a:gd name="T34" fmla="*/ 8014 w 16499"/>
                  <a:gd name="T35" fmla="*/ 2639 h 5245"/>
                  <a:gd name="T36" fmla="*/ 8485 w 16499"/>
                  <a:gd name="T37" fmla="*/ 1971 h 5245"/>
                  <a:gd name="T38" fmla="*/ 8957 w 16499"/>
                  <a:gd name="T39" fmla="*/ 2416 h 5245"/>
                  <a:gd name="T40" fmla="*/ 9428 w 16499"/>
                  <a:gd name="T41" fmla="*/ 2289 h 5245"/>
                  <a:gd name="T42" fmla="*/ 9899 w 16499"/>
                  <a:gd name="T43" fmla="*/ 2543 h 5245"/>
                  <a:gd name="T44" fmla="*/ 10371 w 16499"/>
                  <a:gd name="T45" fmla="*/ 2480 h 5245"/>
                  <a:gd name="T46" fmla="*/ 10842 w 16499"/>
                  <a:gd name="T47" fmla="*/ 2734 h 5245"/>
                  <a:gd name="T48" fmla="*/ 11314 w 16499"/>
                  <a:gd name="T49" fmla="*/ 2257 h 5245"/>
                  <a:gd name="T50" fmla="*/ 11785 w 16499"/>
                  <a:gd name="T51" fmla="*/ 2289 h 5245"/>
                  <a:gd name="T52" fmla="*/ 12256 w 16499"/>
                  <a:gd name="T53" fmla="*/ 2893 h 5245"/>
                  <a:gd name="T54" fmla="*/ 12728 w 16499"/>
                  <a:gd name="T55" fmla="*/ 2670 h 5245"/>
                  <a:gd name="T56" fmla="*/ 13199 w 16499"/>
                  <a:gd name="T57" fmla="*/ 2956 h 5245"/>
                  <a:gd name="T58" fmla="*/ 13671 w 16499"/>
                  <a:gd name="T59" fmla="*/ 2448 h 5245"/>
                  <a:gd name="T60" fmla="*/ 14142 w 16499"/>
                  <a:gd name="T61" fmla="*/ 2289 h 5245"/>
                  <a:gd name="T62" fmla="*/ 14613 w 16499"/>
                  <a:gd name="T63" fmla="*/ 1462 h 5245"/>
                  <a:gd name="T64" fmla="*/ 15085 w 16499"/>
                  <a:gd name="T65" fmla="*/ 0 h 5245"/>
                  <a:gd name="T66" fmla="*/ 15556 w 16499"/>
                  <a:gd name="T67" fmla="*/ 381 h 5245"/>
                  <a:gd name="T68" fmla="*/ 16028 w 16499"/>
                  <a:gd name="T69" fmla="*/ 254 h 5245"/>
                  <a:gd name="T70" fmla="*/ 16499 w 16499"/>
                  <a:gd name="T71" fmla="*/ 95 h 52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</a:cxnLst>
                <a:rect l="0" t="0" r="r" b="b"/>
                <a:pathLst>
                  <a:path w="16499" h="5245">
                    <a:moveTo>
                      <a:pt x="0" y="5245"/>
                    </a:moveTo>
                    <a:lnTo>
                      <a:pt x="471" y="4133"/>
                    </a:lnTo>
                    <a:lnTo>
                      <a:pt x="943" y="3433"/>
                    </a:lnTo>
                    <a:lnTo>
                      <a:pt x="1414" y="2766"/>
                    </a:lnTo>
                    <a:lnTo>
                      <a:pt x="1885" y="1876"/>
                    </a:lnTo>
                    <a:lnTo>
                      <a:pt x="2357" y="2480"/>
                    </a:lnTo>
                    <a:lnTo>
                      <a:pt x="2828" y="2416"/>
                    </a:lnTo>
                    <a:lnTo>
                      <a:pt x="3300" y="2480"/>
                    </a:lnTo>
                    <a:lnTo>
                      <a:pt x="3771" y="2480"/>
                    </a:lnTo>
                    <a:lnTo>
                      <a:pt x="4243" y="1176"/>
                    </a:lnTo>
                    <a:lnTo>
                      <a:pt x="4714" y="413"/>
                    </a:lnTo>
                    <a:lnTo>
                      <a:pt x="5185" y="954"/>
                    </a:lnTo>
                    <a:lnTo>
                      <a:pt x="5657" y="1526"/>
                    </a:lnTo>
                    <a:lnTo>
                      <a:pt x="6128" y="2766"/>
                    </a:lnTo>
                    <a:lnTo>
                      <a:pt x="6600" y="2893"/>
                    </a:lnTo>
                    <a:lnTo>
                      <a:pt x="7071" y="3306"/>
                    </a:lnTo>
                    <a:lnTo>
                      <a:pt x="7542" y="2734"/>
                    </a:lnTo>
                    <a:lnTo>
                      <a:pt x="8014" y="2639"/>
                    </a:lnTo>
                    <a:lnTo>
                      <a:pt x="8485" y="1971"/>
                    </a:lnTo>
                    <a:lnTo>
                      <a:pt x="8957" y="2416"/>
                    </a:lnTo>
                    <a:lnTo>
                      <a:pt x="9428" y="2289"/>
                    </a:lnTo>
                    <a:lnTo>
                      <a:pt x="9899" y="2543"/>
                    </a:lnTo>
                    <a:lnTo>
                      <a:pt x="10371" y="2480"/>
                    </a:lnTo>
                    <a:lnTo>
                      <a:pt x="10842" y="2734"/>
                    </a:lnTo>
                    <a:lnTo>
                      <a:pt x="11314" y="2257"/>
                    </a:lnTo>
                    <a:lnTo>
                      <a:pt x="11785" y="2289"/>
                    </a:lnTo>
                    <a:lnTo>
                      <a:pt x="12256" y="2893"/>
                    </a:lnTo>
                    <a:lnTo>
                      <a:pt x="12728" y="2670"/>
                    </a:lnTo>
                    <a:lnTo>
                      <a:pt x="13199" y="2956"/>
                    </a:lnTo>
                    <a:lnTo>
                      <a:pt x="13671" y="2448"/>
                    </a:lnTo>
                    <a:lnTo>
                      <a:pt x="14142" y="2289"/>
                    </a:lnTo>
                    <a:lnTo>
                      <a:pt x="14613" y="1462"/>
                    </a:lnTo>
                    <a:lnTo>
                      <a:pt x="15085" y="0"/>
                    </a:lnTo>
                    <a:lnTo>
                      <a:pt x="15556" y="381"/>
                    </a:lnTo>
                    <a:lnTo>
                      <a:pt x="16028" y="254"/>
                    </a:lnTo>
                    <a:lnTo>
                      <a:pt x="16499" y="95"/>
                    </a:lnTo>
                  </a:path>
                </a:pathLst>
              </a:custGeom>
              <a:noFill/>
              <a:ln w="6350" cap="rnd">
                <a:solidFill>
                  <a:srgbClr val="C44E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7" name="Line 239">
                <a:extLst>
                  <a:ext uri="{FF2B5EF4-FFF2-40B4-BE49-F238E27FC236}">
                    <a16:creationId xmlns:a16="http://schemas.microsoft.com/office/drawing/2014/main" id="{C4D9A55A-15EA-9165-7916-D1C7F85F4F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79763" y="2540000"/>
                <a:ext cx="0" cy="2398713"/>
              </a:xfrm>
              <a:prstGeom prst="line">
                <a:avLst/>
              </a:prstGeom>
              <a:noFill/>
              <a:ln w="11113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8" name="Line 240">
                <a:extLst>
                  <a:ext uri="{FF2B5EF4-FFF2-40B4-BE49-F238E27FC236}">
                    <a16:creationId xmlns:a16="http://schemas.microsoft.com/office/drawing/2014/main" id="{0EE4D387-504A-CE44-383A-A9C4E99E23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448425" y="2540000"/>
                <a:ext cx="0" cy="2398713"/>
              </a:xfrm>
              <a:prstGeom prst="line">
                <a:avLst/>
              </a:prstGeom>
              <a:noFill/>
              <a:ln w="11113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9" name="Line 241">
                <a:extLst>
                  <a:ext uri="{FF2B5EF4-FFF2-40B4-BE49-F238E27FC236}">
                    <a16:creationId xmlns:a16="http://schemas.microsoft.com/office/drawing/2014/main" id="{8AB3D8DD-3DDA-BF3D-933A-5769E75F44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9763" y="4938713"/>
                <a:ext cx="3268663" cy="0"/>
              </a:xfrm>
              <a:prstGeom prst="line">
                <a:avLst/>
              </a:prstGeom>
              <a:noFill/>
              <a:ln w="11113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0" name="Line 242">
                <a:extLst>
                  <a:ext uri="{FF2B5EF4-FFF2-40B4-BE49-F238E27FC236}">
                    <a16:creationId xmlns:a16="http://schemas.microsoft.com/office/drawing/2014/main" id="{1625E8BC-55CA-1782-AE4A-5C8A3C2E19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9763" y="2540000"/>
                <a:ext cx="3268663" cy="0"/>
              </a:xfrm>
              <a:prstGeom prst="line">
                <a:avLst/>
              </a:prstGeom>
              <a:noFill/>
              <a:ln w="11113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1431" name="Group 1430">
              <a:extLst>
                <a:ext uri="{FF2B5EF4-FFF2-40B4-BE49-F238E27FC236}">
                  <a16:creationId xmlns:a16="http://schemas.microsoft.com/office/drawing/2014/main" id="{37815FD7-7A9A-20F3-C939-3C31879D5D96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391640" y="3935641"/>
              <a:ext cx="1079430" cy="1080000"/>
              <a:chOff x="2540000" y="2540000"/>
              <a:chExt cx="3006726" cy="3008313"/>
            </a:xfrm>
          </p:grpSpPr>
          <p:sp>
            <p:nvSpPr>
              <p:cNvPr id="1432" name="Rectangle 249">
                <a:extLst>
                  <a:ext uri="{FF2B5EF4-FFF2-40B4-BE49-F238E27FC236}">
                    <a16:creationId xmlns:a16="http://schemas.microsoft.com/office/drawing/2014/main" id="{108C7CAD-701D-6DA4-CD3E-22E33278E7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000" y="2540000"/>
                <a:ext cx="3006725" cy="300831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3" name="Rectangle 250">
                <a:extLst>
                  <a:ext uri="{FF2B5EF4-FFF2-40B4-BE49-F238E27FC236}">
                    <a16:creationId xmlns:a16="http://schemas.microsoft.com/office/drawing/2014/main" id="{C2769113-4DD6-DA40-BC5A-022BD6D8D8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2613" y="2540000"/>
                <a:ext cx="2424113" cy="2747963"/>
              </a:xfrm>
              <a:prstGeom prst="rect">
                <a:avLst/>
              </a:prstGeom>
              <a:solidFill>
                <a:srgbClr val="EAEA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4" name="Freeform 251">
                <a:extLst>
                  <a:ext uri="{FF2B5EF4-FFF2-40B4-BE49-F238E27FC236}">
                    <a16:creationId xmlns:a16="http://schemas.microsoft.com/office/drawing/2014/main" id="{07668076-9C44-B96A-0AAC-C8E5C5EB6ED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373438" y="5378450"/>
                <a:ext cx="103188" cy="131763"/>
              </a:xfrm>
              <a:custGeom>
                <a:avLst/>
                <a:gdLst>
                  <a:gd name="T0" fmla="*/ 346 w 568"/>
                  <a:gd name="T1" fmla="*/ 387 h 729"/>
                  <a:gd name="T2" fmla="*/ 408 w 568"/>
                  <a:gd name="T3" fmla="*/ 433 h 729"/>
                  <a:gd name="T4" fmla="*/ 468 w 568"/>
                  <a:gd name="T5" fmla="*/ 530 h 729"/>
                  <a:gd name="T6" fmla="*/ 568 w 568"/>
                  <a:gd name="T7" fmla="*/ 729 h 729"/>
                  <a:gd name="T8" fmla="*/ 462 w 568"/>
                  <a:gd name="T9" fmla="*/ 729 h 729"/>
                  <a:gd name="T10" fmla="*/ 369 w 568"/>
                  <a:gd name="T11" fmla="*/ 542 h 729"/>
                  <a:gd name="T12" fmla="*/ 299 w 568"/>
                  <a:gd name="T13" fmla="*/ 445 h 729"/>
                  <a:gd name="T14" fmla="*/ 206 w 568"/>
                  <a:gd name="T15" fmla="*/ 421 h 729"/>
                  <a:gd name="T16" fmla="*/ 99 w 568"/>
                  <a:gd name="T17" fmla="*/ 421 h 729"/>
                  <a:gd name="T18" fmla="*/ 99 w 568"/>
                  <a:gd name="T19" fmla="*/ 729 h 729"/>
                  <a:gd name="T20" fmla="*/ 0 w 568"/>
                  <a:gd name="T21" fmla="*/ 729 h 729"/>
                  <a:gd name="T22" fmla="*/ 0 w 568"/>
                  <a:gd name="T23" fmla="*/ 0 h 729"/>
                  <a:gd name="T24" fmla="*/ 223 w 568"/>
                  <a:gd name="T25" fmla="*/ 0 h 729"/>
                  <a:gd name="T26" fmla="*/ 409 w 568"/>
                  <a:gd name="T27" fmla="*/ 52 h 729"/>
                  <a:gd name="T28" fmla="*/ 471 w 568"/>
                  <a:gd name="T29" fmla="*/ 210 h 729"/>
                  <a:gd name="T30" fmla="*/ 439 w 568"/>
                  <a:gd name="T31" fmla="*/ 325 h 729"/>
                  <a:gd name="T32" fmla="*/ 346 w 568"/>
                  <a:gd name="T33" fmla="*/ 387 h 729"/>
                  <a:gd name="T34" fmla="*/ 99 w 568"/>
                  <a:gd name="T35" fmla="*/ 81 h 729"/>
                  <a:gd name="T36" fmla="*/ 99 w 568"/>
                  <a:gd name="T37" fmla="*/ 340 h 729"/>
                  <a:gd name="T38" fmla="*/ 223 w 568"/>
                  <a:gd name="T39" fmla="*/ 340 h 729"/>
                  <a:gd name="T40" fmla="*/ 330 w 568"/>
                  <a:gd name="T41" fmla="*/ 307 h 729"/>
                  <a:gd name="T42" fmla="*/ 367 w 568"/>
                  <a:gd name="T43" fmla="*/ 210 h 729"/>
                  <a:gd name="T44" fmla="*/ 330 w 568"/>
                  <a:gd name="T45" fmla="*/ 114 h 729"/>
                  <a:gd name="T46" fmla="*/ 223 w 568"/>
                  <a:gd name="T47" fmla="*/ 81 h 729"/>
                  <a:gd name="T48" fmla="*/ 99 w 568"/>
                  <a:gd name="T49" fmla="*/ 81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</a:cxnLst>
                <a:rect l="0" t="0" r="r" b="b"/>
                <a:pathLst>
                  <a:path w="568" h="729">
                    <a:moveTo>
                      <a:pt x="346" y="387"/>
                    </a:moveTo>
                    <a:cubicBezTo>
                      <a:pt x="367" y="395"/>
                      <a:pt x="388" y="410"/>
                      <a:pt x="408" y="433"/>
                    </a:cubicBezTo>
                    <a:cubicBezTo>
                      <a:pt x="428" y="457"/>
                      <a:pt x="448" y="489"/>
                      <a:pt x="468" y="530"/>
                    </a:cubicBezTo>
                    <a:lnTo>
                      <a:pt x="568" y="729"/>
                    </a:lnTo>
                    <a:lnTo>
                      <a:pt x="462" y="729"/>
                    </a:lnTo>
                    <a:lnTo>
                      <a:pt x="369" y="542"/>
                    </a:lnTo>
                    <a:cubicBezTo>
                      <a:pt x="345" y="494"/>
                      <a:pt x="321" y="461"/>
                      <a:pt x="299" y="445"/>
                    </a:cubicBezTo>
                    <a:cubicBezTo>
                      <a:pt x="276" y="429"/>
                      <a:pt x="245" y="421"/>
                      <a:pt x="206" y="421"/>
                    </a:cubicBezTo>
                    <a:lnTo>
                      <a:pt x="99" y="421"/>
                    </a:lnTo>
                    <a:lnTo>
                      <a:pt x="99" y="729"/>
                    </a:lnTo>
                    <a:lnTo>
                      <a:pt x="0" y="729"/>
                    </a:lnTo>
                    <a:lnTo>
                      <a:pt x="0" y="0"/>
                    </a:lnTo>
                    <a:lnTo>
                      <a:pt x="223" y="0"/>
                    </a:lnTo>
                    <a:cubicBezTo>
                      <a:pt x="306" y="0"/>
                      <a:pt x="368" y="18"/>
                      <a:pt x="409" y="52"/>
                    </a:cubicBezTo>
                    <a:cubicBezTo>
                      <a:pt x="450" y="87"/>
                      <a:pt x="471" y="140"/>
                      <a:pt x="471" y="210"/>
                    </a:cubicBezTo>
                    <a:cubicBezTo>
                      <a:pt x="471" y="256"/>
                      <a:pt x="460" y="295"/>
                      <a:pt x="439" y="325"/>
                    </a:cubicBezTo>
                    <a:cubicBezTo>
                      <a:pt x="417" y="355"/>
                      <a:pt x="386" y="376"/>
                      <a:pt x="346" y="387"/>
                    </a:cubicBezTo>
                    <a:close/>
                    <a:moveTo>
                      <a:pt x="99" y="81"/>
                    </a:moveTo>
                    <a:lnTo>
                      <a:pt x="99" y="340"/>
                    </a:lnTo>
                    <a:lnTo>
                      <a:pt x="223" y="340"/>
                    </a:lnTo>
                    <a:cubicBezTo>
                      <a:pt x="270" y="340"/>
                      <a:pt x="306" y="329"/>
                      <a:pt x="330" y="307"/>
                    </a:cubicBezTo>
                    <a:cubicBezTo>
                      <a:pt x="354" y="285"/>
                      <a:pt x="367" y="253"/>
                      <a:pt x="367" y="210"/>
                    </a:cubicBezTo>
                    <a:cubicBezTo>
                      <a:pt x="367" y="168"/>
                      <a:pt x="354" y="136"/>
                      <a:pt x="330" y="114"/>
                    </a:cubicBezTo>
                    <a:cubicBezTo>
                      <a:pt x="306" y="92"/>
                      <a:pt x="270" y="81"/>
                      <a:pt x="223" y="81"/>
                    </a:cubicBezTo>
                    <a:lnTo>
                      <a:pt x="99" y="81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5" name="Freeform 252">
                <a:extLst>
                  <a:ext uri="{FF2B5EF4-FFF2-40B4-BE49-F238E27FC236}">
                    <a16:creationId xmlns:a16="http://schemas.microsoft.com/office/drawing/2014/main" id="{D9B7F975-BF84-7C8E-FDC2-660FF796F36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487738" y="5408613"/>
                <a:ext cx="84138" cy="104775"/>
              </a:xfrm>
              <a:custGeom>
                <a:avLst/>
                <a:gdLst>
                  <a:gd name="T0" fmla="*/ 283 w 462"/>
                  <a:gd name="T1" fmla="*/ 285 h 573"/>
                  <a:gd name="T2" fmla="*/ 132 w 462"/>
                  <a:gd name="T3" fmla="*/ 310 h 573"/>
                  <a:gd name="T4" fmla="*/ 90 w 462"/>
                  <a:gd name="T5" fmla="*/ 395 h 573"/>
                  <a:gd name="T6" fmla="*/ 121 w 462"/>
                  <a:gd name="T7" fmla="*/ 471 h 573"/>
                  <a:gd name="T8" fmla="*/ 207 w 462"/>
                  <a:gd name="T9" fmla="*/ 499 h 573"/>
                  <a:gd name="T10" fmla="*/ 327 w 462"/>
                  <a:gd name="T11" fmla="*/ 446 h 573"/>
                  <a:gd name="T12" fmla="*/ 372 w 462"/>
                  <a:gd name="T13" fmla="*/ 305 h 573"/>
                  <a:gd name="T14" fmla="*/ 372 w 462"/>
                  <a:gd name="T15" fmla="*/ 285 h 573"/>
                  <a:gd name="T16" fmla="*/ 283 w 462"/>
                  <a:gd name="T17" fmla="*/ 285 h 573"/>
                  <a:gd name="T18" fmla="*/ 462 w 462"/>
                  <a:gd name="T19" fmla="*/ 248 h 573"/>
                  <a:gd name="T20" fmla="*/ 462 w 462"/>
                  <a:gd name="T21" fmla="*/ 560 h 573"/>
                  <a:gd name="T22" fmla="*/ 372 w 462"/>
                  <a:gd name="T23" fmla="*/ 560 h 573"/>
                  <a:gd name="T24" fmla="*/ 372 w 462"/>
                  <a:gd name="T25" fmla="*/ 477 h 573"/>
                  <a:gd name="T26" fmla="*/ 295 w 462"/>
                  <a:gd name="T27" fmla="*/ 550 h 573"/>
                  <a:gd name="T28" fmla="*/ 183 w 462"/>
                  <a:gd name="T29" fmla="*/ 573 h 573"/>
                  <a:gd name="T30" fmla="*/ 49 w 462"/>
                  <a:gd name="T31" fmla="*/ 527 h 573"/>
                  <a:gd name="T32" fmla="*/ 0 w 462"/>
                  <a:gd name="T33" fmla="*/ 401 h 573"/>
                  <a:gd name="T34" fmla="*/ 62 w 462"/>
                  <a:gd name="T35" fmla="*/ 262 h 573"/>
                  <a:gd name="T36" fmla="*/ 246 w 462"/>
                  <a:gd name="T37" fmla="*/ 215 h 573"/>
                  <a:gd name="T38" fmla="*/ 372 w 462"/>
                  <a:gd name="T39" fmla="*/ 215 h 573"/>
                  <a:gd name="T40" fmla="*/ 372 w 462"/>
                  <a:gd name="T41" fmla="*/ 206 h 573"/>
                  <a:gd name="T42" fmla="*/ 331 w 462"/>
                  <a:gd name="T43" fmla="*/ 110 h 573"/>
                  <a:gd name="T44" fmla="*/ 217 w 462"/>
                  <a:gd name="T45" fmla="*/ 76 h 573"/>
                  <a:gd name="T46" fmla="*/ 125 w 462"/>
                  <a:gd name="T47" fmla="*/ 88 h 573"/>
                  <a:gd name="T48" fmla="*/ 40 w 462"/>
                  <a:gd name="T49" fmla="*/ 121 h 573"/>
                  <a:gd name="T50" fmla="*/ 40 w 462"/>
                  <a:gd name="T51" fmla="*/ 38 h 573"/>
                  <a:gd name="T52" fmla="*/ 135 w 462"/>
                  <a:gd name="T53" fmla="*/ 10 h 573"/>
                  <a:gd name="T54" fmla="*/ 226 w 462"/>
                  <a:gd name="T55" fmla="*/ 0 h 573"/>
                  <a:gd name="T56" fmla="*/ 403 w 462"/>
                  <a:gd name="T57" fmla="*/ 62 h 573"/>
                  <a:gd name="T58" fmla="*/ 462 w 462"/>
                  <a:gd name="T59" fmla="*/ 24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462" h="573">
                    <a:moveTo>
                      <a:pt x="283" y="285"/>
                    </a:moveTo>
                    <a:cubicBezTo>
                      <a:pt x="210" y="285"/>
                      <a:pt x="160" y="294"/>
                      <a:pt x="132" y="310"/>
                    </a:cubicBezTo>
                    <a:cubicBezTo>
                      <a:pt x="104" y="327"/>
                      <a:pt x="90" y="355"/>
                      <a:pt x="90" y="395"/>
                    </a:cubicBezTo>
                    <a:cubicBezTo>
                      <a:pt x="90" y="427"/>
                      <a:pt x="100" y="453"/>
                      <a:pt x="121" y="471"/>
                    </a:cubicBezTo>
                    <a:cubicBezTo>
                      <a:pt x="142" y="490"/>
                      <a:pt x="171" y="499"/>
                      <a:pt x="207" y="499"/>
                    </a:cubicBezTo>
                    <a:cubicBezTo>
                      <a:pt x="257" y="499"/>
                      <a:pt x="297" y="482"/>
                      <a:pt x="327" y="446"/>
                    </a:cubicBezTo>
                    <a:cubicBezTo>
                      <a:pt x="357" y="411"/>
                      <a:pt x="372" y="364"/>
                      <a:pt x="372" y="305"/>
                    </a:cubicBezTo>
                    <a:lnTo>
                      <a:pt x="372" y="285"/>
                    </a:lnTo>
                    <a:lnTo>
                      <a:pt x="283" y="285"/>
                    </a:lnTo>
                    <a:close/>
                    <a:moveTo>
                      <a:pt x="462" y="248"/>
                    </a:moveTo>
                    <a:lnTo>
                      <a:pt x="462" y="560"/>
                    </a:lnTo>
                    <a:lnTo>
                      <a:pt x="372" y="560"/>
                    </a:lnTo>
                    <a:lnTo>
                      <a:pt x="372" y="477"/>
                    </a:lnTo>
                    <a:cubicBezTo>
                      <a:pt x="351" y="511"/>
                      <a:pt x="325" y="535"/>
                      <a:pt x="295" y="550"/>
                    </a:cubicBezTo>
                    <a:cubicBezTo>
                      <a:pt x="265" y="565"/>
                      <a:pt x="227" y="573"/>
                      <a:pt x="183" y="573"/>
                    </a:cubicBezTo>
                    <a:cubicBezTo>
                      <a:pt x="127" y="573"/>
                      <a:pt x="82" y="558"/>
                      <a:pt x="49" y="527"/>
                    </a:cubicBezTo>
                    <a:cubicBezTo>
                      <a:pt x="16" y="496"/>
                      <a:pt x="0" y="454"/>
                      <a:pt x="0" y="401"/>
                    </a:cubicBezTo>
                    <a:cubicBezTo>
                      <a:pt x="0" y="340"/>
                      <a:pt x="20" y="294"/>
                      <a:pt x="62" y="262"/>
                    </a:cubicBezTo>
                    <a:cubicBezTo>
                      <a:pt x="103" y="231"/>
                      <a:pt x="164" y="215"/>
                      <a:pt x="246" y="215"/>
                    </a:cubicBezTo>
                    <a:lnTo>
                      <a:pt x="372" y="215"/>
                    </a:lnTo>
                    <a:lnTo>
                      <a:pt x="372" y="206"/>
                    </a:lnTo>
                    <a:cubicBezTo>
                      <a:pt x="372" y="165"/>
                      <a:pt x="358" y="133"/>
                      <a:pt x="331" y="110"/>
                    </a:cubicBezTo>
                    <a:cubicBezTo>
                      <a:pt x="304" y="88"/>
                      <a:pt x="266" y="76"/>
                      <a:pt x="217" y="76"/>
                    </a:cubicBezTo>
                    <a:cubicBezTo>
                      <a:pt x="185" y="76"/>
                      <a:pt x="155" y="80"/>
                      <a:pt x="125" y="88"/>
                    </a:cubicBezTo>
                    <a:cubicBezTo>
                      <a:pt x="95" y="96"/>
                      <a:pt x="67" y="107"/>
                      <a:pt x="40" y="121"/>
                    </a:cubicBezTo>
                    <a:lnTo>
                      <a:pt x="40" y="38"/>
                    </a:lnTo>
                    <a:cubicBezTo>
                      <a:pt x="72" y="26"/>
                      <a:pt x="104" y="16"/>
                      <a:pt x="135" y="10"/>
                    </a:cubicBezTo>
                    <a:cubicBezTo>
                      <a:pt x="166" y="4"/>
                      <a:pt x="196" y="0"/>
                      <a:pt x="226" y="0"/>
                    </a:cubicBezTo>
                    <a:cubicBezTo>
                      <a:pt x="305" y="0"/>
                      <a:pt x="364" y="21"/>
                      <a:pt x="403" y="62"/>
                    </a:cubicBezTo>
                    <a:cubicBezTo>
                      <a:pt x="442" y="103"/>
                      <a:pt x="462" y="165"/>
                      <a:pt x="462" y="24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6" name="Freeform 253">
                <a:extLst>
                  <a:ext uri="{FF2B5EF4-FFF2-40B4-BE49-F238E27FC236}">
                    <a16:creationId xmlns:a16="http://schemas.microsoft.com/office/drawing/2014/main" id="{6A839F2E-656D-B262-CF48-C8242A9F2E4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05213" y="5408613"/>
                <a:ext cx="82550" cy="101600"/>
              </a:xfrm>
              <a:custGeom>
                <a:avLst/>
                <a:gdLst>
                  <a:gd name="T0" fmla="*/ 458 w 458"/>
                  <a:gd name="T1" fmla="*/ 230 h 560"/>
                  <a:gd name="T2" fmla="*/ 458 w 458"/>
                  <a:gd name="T3" fmla="*/ 560 h 560"/>
                  <a:gd name="T4" fmla="*/ 368 w 458"/>
                  <a:gd name="T5" fmla="*/ 560 h 560"/>
                  <a:gd name="T6" fmla="*/ 368 w 458"/>
                  <a:gd name="T7" fmla="*/ 233 h 560"/>
                  <a:gd name="T8" fmla="*/ 337 w 458"/>
                  <a:gd name="T9" fmla="*/ 117 h 560"/>
                  <a:gd name="T10" fmla="*/ 247 w 458"/>
                  <a:gd name="T11" fmla="*/ 78 h 560"/>
                  <a:gd name="T12" fmla="*/ 132 w 458"/>
                  <a:gd name="T13" fmla="*/ 125 h 560"/>
                  <a:gd name="T14" fmla="*/ 90 w 458"/>
                  <a:gd name="T15" fmla="*/ 251 h 560"/>
                  <a:gd name="T16" fmla="*/ 90 w 458"/>
                  <a:gd name="T17" fmla="*/ 560 h 560"/>
                  <a:gd name="T18" fmla="*/ 0 w 458"/>
                  <a:gd name="T19" fmla="*/ 560 h 560"/>
                  <a:gd name="T20" fmla="*/ 0 w 458"/>
                  <a:gd name="T21" fmla="*/ 13 h 560"/>
                  <a:gd name="T22" fmla="*/ 90 w 458"/>
                  <a:gd name="T23" fmla="*/ 13 h 560"/>
                  <a:gd name="T24" fmla="*/ 90 w 458"/>
                  <a:gd name="T25" fmla="*/ 98 h 560"/>
                  <a:gd name="T26" fmla="*/ 166 w 458"/>
                  <a:gd name="T27" fmla="*/ 25 h 560"/>
                  <a:gd name="T28" fmla="*/ 267 w 458"/>
                  <a:gd name="T29" fmla="*/ 0 h 560"/>
                  <a:gd name="T30" fmla="*/ 409 w 458"/>
                  <a:gd name="T31" fmla="*/ 59 h 560"/>
                  <a:gd name="T32" fmla="*/ 458 w 458"/>
                  <a:gd name="T33" fmla="*/ 230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58" h="560">
                    <a:moveTo>
                      <a:pt x="458" y="230"/>
                    </a:moveTo>
                    <a:lnTo>
                      <a:pt x="458" y="560"/>
                    </a:lnTo>
                    <a:lnTo>
                      <a:pt x="368" y="560"/>
                    </a:lnTo>
                    <a:lnTo>
                      <a:pt x="368" y="233"/>
                    </a:lnTo>
                    <a:cubicBezTo>
                      <a:pt x="368" y="181"/>
                      <a:pt x="357" y="143"/>
                      <a:pt x="337" y="117"/>
                    </a:cubicBezTo>
                    <a:cubicBezTo>
                      <a:pt x="317" y="91"/>
                      <a:pt x="287" y="78"/>
                      <a:pt x="247" y="78"/>
                    </a:cubicBezTo>
                    <a:cubicBezTo>
                      <a:pt x="198" y="78"/>
                      <a:pt x="160" y="94"/>
                      <a:pt x="132" y="125"/>
                    </a:cubicBezTo>
                    <a:cubicBezTo>
                      <a:pt x="104" y="156"/>
                      <a:pt x="90" y="198"/>
                      <a:pt x="90" y="251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11" y="66"/>
                      <a:pt x="136" y="41"/>
                      <a:pt x="166" y="25"/>
                    </a:cubicBezTo>
                    <a:cubicBezTo>
                      <a:pt x="195" y="9"/>
                      <a:pt x="229" y="0"/>
                      <a:pt x="267" y="0"/>
                    </a:cubicBezTo>
                    <a:cubicBezTo>
                      <a:pt x="329" y="0"/>
                      <a:pt x="377" y="20"/>
                      <a:pt x="409" y="59"/>
                    </a:cubicBezTo>
                    <a:cubicBezTo>
                      <a:pt x="441" y="98"/>
                      <a:pt x="458" y="155"/>
                      <a:pt x="458" y="23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7" name="Freeform 254">
                <a:extLst>
                  <a:ext uri="{FF2B5EF4-FFF2-40B4-BE49-F238E27FC236}">
                    <a16:creationId xmlns:a16="http://schemas.microsoft.com/office/drawing/2014/main" id="{3690D717-45CE-ECAA-21E9-DDB09BE09E1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713163" y="5373688"/>
                <a:ext cx="87313" cy="139700"/>
              </a:xfrm>
              <a:custGeom>
                <a:avLst/>
                <a:gdLst>
                  <a:gd name="T0" fmla="*/ 399 w 489"/>
                  <a:gd name="T1" fmla="*/ 296 h 773"/>
                  <a:gd name="T2" fmla="*/ 399 w 489"/>
                  <a:gd name="T3" fmla="*/ 0 h 773"/>
                  <a:gd name="T4" fmla="*/ 489 w 489"/>
                  <a:gd name="T5" fmla="*/ 0 h 773"/>
                  <a:gd name="T6" fmla="*/ 489 w 489"/>
                  <a:gd name="T7" fmla="*/ 760 h 773"/>
                  <a:gd name="T8" fmla="*/ 399 w 489"/>
                  <a:gd name="T9" fmla="*/ 760 h 773"/>
                  <a:gd name="T10" fmla="*/ 399 w 489"/>
                  <a:gd name="T11" fmla="*/ 678 h 773"/>
                  <a:gd name="T12" fmla="*/ 327 w 489"/>
                  <a:gd name="T13" fmla="*/ 750 h 773"/>
                  <a:gd name="T14" fmla="*/ 224 w 489"/>
                  <a:gd name="T15" fmla="*/ 773 h 773"/>
                  <a:gd name="T16" fmla="*/ 62 w 489"/>
                  <a:gd name="T17" fmla="*/ 695 h 773"/>
                  <a:gd name="T18" fmla="*/ 0 w 489"/>
                  <a:gd name="T19" fmla="*/ 487 h 773"/>
                  <a:gd name="T20" fmla="*/ 62 w 489"/>
                  <a:gd name="T21" fmla="*/ 279 h 773"/>
                  <a:gd name="T22" fmla="*/ 224 w 489"/>
                  <a:gd name="T23" fmla="*/ 200 h 773"/>
                  <a:gd name="T24" fmla="*/ 327 w 489"/>
                  <a:gd name="T25" fmla="*/ 224 h 773"/>
                  <a:gd name="T26" fmla="*/ 399 w 489"/>
                  <a:gd name="T27" fmla="*/ 296 h 773"/>
                  <a:gd name="T28" fmla="*/ 93 w 489"/>
                  <a:gd name="T29" fmla="*/ 487 h 773"/>
                  <a:gd name="T30" fmla="*/ 133 w 489"/>
                  <a:gd name="T31" fmla="*/ 643 h 773"/>
                  <a:gd name="T32" fmla="*/ 245 w 489"/>
                  <a:gd name="T33" fmla="*/ 699 h 773"/>
                  <a:gd name="T34" fmla="*/ 358 w 489"/>
                  <a:gd name="T35" fmla="*/ 643 h 773"/>
                  <a:gd name="T36" fmla="*/ 399 w 489"/>
                  <a:gd name="T37" fmla="*/ 487 h 773"/>
                  <a:gd name="T38" fmla="*/ 358 w 489"/>
                  <a:gd name="T39" fmla="*/ 332 h 773"/>
                  <a:gd name="T40" fmla="*/ 245 w 489"/>
                  <a:gd name="T41" fmla="*/ 275 h 773"/>
                  <a:gd name="T42" fmla="*/ 133 w 489"/>
                  <a:gd name="T43" fmla="*/ 332 h 773"/>
                  <a:gd name="T44" fmla="*/ 93 w 489"/>
                  <a:gd name="T45" fmla="*/ 487 h 7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89" h="773">
                    <a:moveTo>
                      <a:pt x="399" y="296"/>
                    </a:moveTo>
                    <a:lnTo>
                      <a:pt x="399" y="0"/>
                    </a:lnTo>
                    <a:lnTo>
                      <a:pt x="489" y="0"/>
                    </a:lnTo>
                    <a:lnTo>
                      <a:pt x="489" y="760"/>
                    </a:lnTo>
                    <a:lnTo>
                      <a:pt x="399" y="760"/>
                    </a:lnTo>
                    <a:lnTo>
                      <a:pt x="399" y="678"/>
                    </a:lnTo>
                    <a:cubicBezTo>
                      <a:pt x="380" y="711"/>
                      <a:pt x="356" y="735"/>
                      <a:pt x="327" y="750"/>
                    </a:cubicBezTo>
                    <a:cubicBezTo>
                      <a:pt x="298" y="765"/>
                      <a:pt x="264" y="773"/>
                      <a:pt x="224" y="773"/>
                    </a:cubicBezTo>
                    <a:cubicBezTo>
                      <a:pt x="158" y="773"/>
                      <a:pt x="104" y="747"/>
                      <a:pt x="62" y="695"/>
                    </a:cubicBezTo>
                    <a:cubicBezTo>
                      <a:pt x="20" y="643"/>
                      <a:pt x="0" y="573"/>
                      <a:pt x="0" y="487"/>
                    </a:cubicBezTo>
                    <a:cubicBezTo>
                      <a:pt x="0" y="401"/>
                      <a:pt x="20" y="332"/>
                      <a:pt x="62" y="279"/>
                    </a:cubicBezTo>
                    <a:cubicBezTo>
                      <a:pt x="104" y="227"/>
                      <a:pt x="158" y="200"/>
                      <a:pt x="224" y="200"/>
                    </a:cubicBezTo>
                    <a:cubicBezTo>
                      <a:pt x="264" y="200"/>
                      <a:pt x="298" y="208"/>
                      <a:pt x="327" y="224"/>
                    </a:cubicBezTo>
                    <a:cubicBezTo>
                      <a:pt x="356" y="240"/>
                      <a:pt x="380" y="264"/>
                      <a:pt x="399" y="296"/>
                    </a:cubicBezTo>
                    <a:close/>
                    <a:moveTo>
                      <a:pt x="93" y="487"/>
                    </a:moveTo>
                    <a:cubicBezTo>
                      <a:pt x="93" y="553"/>
                      <a:pt x="106" y="605"/>
                      <a:pt x="133" y="643"/>
                    </a:cubicBezTo>
                    <a:cubicBezTo>
                      <a:pt x="160" y="681"/>
                      <a:pt x="197" y="699"/>
                      <a:pt x="245" y="699"/>
                    </a:cubicBezTo>
                    <a:cubicBezTo>
                      <a:pt x="293" y="699"/>
                      <a:pt x="330" y="681"/>
                      <a:pt x="358" y="643"/>
                    </a:cubicBezTo>
                    <a:cubicBezTo>
                      <a:pt x="385" y="605"/>
                      <a:pt x="399" y="553"/>
                      <a:pt x="399" y="487"/>
                    </a:cubicBezTo>
                    <a:cubicBezTo>
                      <a:pt x="399" y="421"/>
                      <a:pt x="385" y="370"/>
                      <a:pt x="358" y="332"/>
                    </a:cubicBezTo>
                    <a:cubicBezTo>
                      <a:pt x="330" y="294"/>
                      <a:pt x="293" y="275"/>
                      <a:pt x="245" y="275"/>
                    </a:cubicBezTo>
                    <a:cubicBezTo>
                      <a:pt x="197" y="275"/>
                      <a:pt x="160" y="294"/>
                      <a:pt x="133" y="332"/>
                    </a:cubicBezTo>
                    <a:cubicBezTo>
                      <a:pt x="106" y="370"/>
                      <a:pt x="93" y="421"/>
                      <a:pt x="93" y="487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8" name="Freeform 255">
                <a:extLst>
                  <a:ext uri="{FF2B5EF4-FFF2-40B4-BE49-F238E27FC236}">
                    <a16:creationId xmlns:a16="http://schemas.microsoft.com/office/drawing/2014/main" id="{D630BE22-93B1-CE8E-EA8B-4AECAA09D67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827463" y="5408613"/>
                <a:ext cx="90488" cy="104775"/>
              </a:xfrm>
              <a:custGeom>
                <a:avLst/>
                <a:gdLst>
                  <a:gd name="T0" fmla="*/ 251 w 502"/>
                  <a:gd name="T1" fmla="*/ 76 h 573"/>
                  <a:gd name="T2" fmla="*/ 137 w 502"/>
                  <a:gd name="T3" fmla="*/ 133 h 573"/>
                  <a:gd name="T4" fmla="*/ 95 w 502"/>
                  <a:gd name="T5" fmla="*/ 287 h 573"/>
                  <a:gd name="T6" fmla="*/ 136 w 502"/>
                  <a:gd name="T7" fmla="*/ 442 h 573"/>
                  <a:gd name="T8" fmla="*/ 251 w 502"/>
                  <a:gd name="T9" fmla="*/ 498 h 573"/>
                  <a:gd name="T10" fmla="*/ 365 w 502"/>
                  <a:gd name="T11" fmla="*/ 442 h 573"/>
                  <a:gd name="T12" fmla="*/ 407 w 502"/>
                  <a:gd name="T13" fmla="*/ 287 h 573"/>
                  <a:gd name="T14" fmla="*/ 365 w 502"/>
                  <a:gd name="T15" fmla="*/ 133 h 573"/>
                  <a:gd name="T16" fmla="*/ 251 w 502"/>
                  <a:gd name="T17" fmla="*/ 76 h 573"/>
                  <a:gd name="T18" fmla="*/ 251 w 502"/>
                  <a:gd name="T19" fmla="*/ 0 h 573"/>
                  <a:gd name="T20" fmla="*/ 435 w 502"/>
                  <a:gd name="T21" fmla="*/ 76 h 573"/>
                  <a:gd name="T22" fmla="*/ 502 w 502"/>
                  <a:gd name="T23" fmla="*/ 287 h 573"/>
                  <a:gd name="T24" fmla="*/ 435 w 502"/>
                  <a:gd name="T25" fmla="*/ 497 h 573"/>
                  <a:gd name="T26" fmla="*/ 251 w 502"/>
                  <a:gd name="T27" fmla="*/ 573 h 573"/>
                  <a:gd name="T28" fmla="*/ 66 w 502"/>
                  <a:gd name="T29" fmla="*/ 497 h 573"/>
                  <a:gd name="T30" fmla="*/ 0 w 502"/>
                  <a:gd name="T31" fmla="*/ 287 h 573"/>
                  <a:gd name="T32" fmla="*/ 66 w 502"/>
                  <a:gd name="T33" fmla="*/ 76 h 573"/>
                  <a:gd name="T34" fmla="*/ 251 w 502"/>
                  <a:gd name="T35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2" h="573">
                    <a:moveTo>
                      <a:pt x="251" y="76"/>
                    </a:moveTo>
                    <a:cubicBezTo>
                      <a:pt x="203" y="76"/>
                      <a:pt x="165" y="95"/>
                      <a:pt x="137" y="133"/>
                    </a:cubicBezTo>
                    <a:cubicBezTo>
                      <a:pt x="109" y="171"/>
                      <a:pt x="95" y="222"/>
                      <a:pt x="95" y="287"/>
                    </a:cubicBezTo>
                    <a:cubicBezTo>
                      <a:pt x="95" y="353"/>
                      <a:pt x="108" y="404"/>
                      <a:pt x="136" y="442"/>
                    </a:cubicBezTo>
                    <a:cubicBezTo>
                      <a:pt x="164" y="480"/>
                      <a:pt x="202" y="498"/>
                      <a:pt x="251" y="498"/>
                    </a:cubicBezTo>
                    <a:cubicBezTo>
                      <a:pt x="299" y="498"/>
                      <a:pt x="337" y="480"/>
                      <a:pt x="365" y="442"/>
                    </a:cubicBezTo>
                    <a:cubicBezTo>
                      <a:pt x="393" y="404"/>
                      <a:pt x="407" y="353"/>
                      <a:pt x="407" y="287"/>
                    </a:cubicBezTo>
                    <a:cubicBezTo>
                      <a:pt x="407" y="223"/>
                      <a:pt x="393" y="171"/>
                      <a:pt x="365" y="133"/>
                    </a:cubicBezTo>
                    <a:cubicBezTo>
                      <a:pt x="337" y="95"/>
                      <a:pt x="299" y="76"/>
                      <a:pt x="251" y="76"/>
                    </a:cubicBezTo>
                    <a:close/>
                    <a:moveTo>
                      <a:pt x="251" y="0"/>
                    </a:moveTo>
                    <a:cubicBezTo>
                      <a:pt x="329" y="0"/>
                      <a:pt x="390" y="26"/>
                      <a:pt x="435" y="76"/>
                    </a:cubicBezTo>
                    <a:cubicBezTo>
                      <a:pt x="479" y="127"/>
                      <a:pt x="502" y="197"/>
                      <a:pt x="502" y="287"/>
                    </a:cubicBezTo>
                    <a:cubicBezTo>
                      <a:pt x="502" y="377"/>
                      <a:pt x="479" y="447"/>
                      <a:pt x="435" y="497"/>
                    </a:cubicBezTo>
                    <a:cubicBezTo>
                      <a:pt x="390" y="548"/>
                      <a:pt x="329" y="573"/>
                      <a:pt x="251" y="573"/>
                    </a:cubicBezTo>
                    <a:cubicBezTo>
                      <a:pt x="172" y="573"/>
                      <a:pt x="110" y="548"/>
                      <a:pt x="66" y="497"/>
                    </a:cubicBezTo>
                    <a:cubicBezTo>
                      <a:pt x="22" y="447"/>
                      <a:pt x="0" y="377"/>
                      <a:pt x="0" y="287"/>
                    </a:cubicBezTo>
                    <a:cubicBezTo>
                      <a:pt x="0" y="197"/>
                      <a:pt x="22" y="127"/>
                      <a:pt x="66" y="76"/>
                    </a:cubicBezTo>
                    <a:cubicBezTo>
                      <a:pt x="110" y="26"/>
                      <a:pt x="172" y="0"/>
                      <a:pt x="251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9" name="Freeform 256">
                <a:extLst>
                  <a:ext uri="{FF2B5EF4-FFF2-40B4-BE49-F238E27FC236}">
                    <a16:creationId xmlns:a16="http://schemas.microsoft.com/office/drawing/2014/main" id="{38C56D1E-6780-0C53-1225-511BAE13CF5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943350" y="5408613"/>
                <a:ext cx="144463" cy="101600"/>
              </a:xfrm>
              <a:custGeom>
                <a:avLst/>
                <a:gdLst>
                  <a:gd name="T0" fmla="*/ 429 w 798"/>
                  <a:gd name="T1" fmla="*/ 118 h 560"/>
                  <a:gd name="T2" fmla="*/ 509 w 798"/>
                  <a:gd name="T3" fmla="*/ 29 h 560"/>
                  <a:gd name="T4" fmla="*/ 620 w 798"/>
                  <a:gd name="T5" fmla="*/ 0 h 560"/>
                  <a:gd name="T6" fmla="*/ 751 w 798"/>
                  <a:gd name="T7" fmla="*/ 60 h 560"/>
                  <a:gd name="T8" fmla="*/ 798 w 798"/>
                  <a:gd name="T9" fmla="*/ 230 h 560"/>
                  <a:gd name="T10" fmla="*/ 798 w 798"/>
                  <a:gd name="T11" fmla="*/ 560 h 560"/>
                  <a:gd name="T12" fmla="*/ 708 w 798"/>
                  <a:gd name="T13" fmla="*/ 560 h 560"/>
                  <a:gd name="T14" fmla="*/ 708 w 798"/>
                  <a:gd name="T15" fmla="*/ 233 h 560"/>
                  <a:gd name="T16" fmla="*/ 680 w 798"/>
                  <a:gd name="T17" fmla="*/ 116 h 560"/>
                  <a:gd name="T18" fmla="*/ 595 w 798"/>
                  <a:gd name="T19" fmla="*/ 78 h 560"/>
                  <a:gd name="T20" fmla="*/ 484 w 798"/>
                  <a:gd name="T21" fmla="*/ 125 h 560"/>
                  <a:gd name="T22" fmla="*/ 444 w 798"/>
                  <a:gd name="T23" fmla="*/ 251 h 560"/>
                  <a:gd name="T24" fmla="*/ 444 w 798"/>
                  <a:gd name="T25" fmla="*/ 560 h 560"/>
                  <a:gd name="T26" fmla="*/ 354 w 798"/>
                  <a:gd name="T27" fmla="*/ 560 h 560"/>
                  <a:gd name="T28" fmla="*/ 354 w 798"/>
                  <a:gd name="T29" fmla="*/ 233 h 560"/>
                  <a:gd name="T30" fmla="*/ 326 w 798"/>
                  <a:gd name="T31" fmla="*/ 116 h 560"/>
                  <a:gd name="T32" fmla="*/ 240 w 798"/>
                  <a:gd name="T33" fmla="*/ 78 h 560"/>
                  <a:gd name="T34" fmla="*/ 130 w 798"/>
                  <a:gd name="T35" fmla="*/ 125 h 560"/>
                  <a:gd name="T36" fmla="*/ 90 w 798"/>
                  <a:gd name="T37" fmla="*/ 251 h 560"/>
                  <a:gd name="T38" fmla="*/ 90 w 798"/>
                  <a:gd name="T39" fmla="*/ 560 h 560"/>
                  <a:gd name="T40" fmla="*/ 0 w 798"/>
                  <a:gd name="T41" fmla="*/ 560 h 560"/>
                  <a:gd name="T42" fmla="*/ 0 w 798"/>
                  <a:gd name="T43" fmla="*/ 13 h 560"/>
                  <a:gd name="T44" fmla="*/ 90 w 798"/>
                  <a:gd name="T45" fmla="*/ 13 h 560"/>
                  <a:gd name="T46" fmla="*/ 90 w 798"/>
                  <a:gd name="T47" fmla="*/ 98 h 560"/>
                  <a:gd name="T48" fmla="*/ 164 w 798"/>
                  <a:gd name="T49" fmla="*/ 24 h 560"/>
                  <a:gd name="T50" fmla="*/ 266 w 798"/>
                  <a:gd name="T51" fmla="*/ 0 h 560"/>
                  <a:gd name="T52" fmla="*/ 367 w 798"/>
                  <a:gd name="T53" fmla="*/ 30 h 560"/>
                  <a:gd name="T54" fmla="*/ 429 w 798"/>
                  <a:gd name="T55" fmla="*/ 118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</a:cxnLst>
                <a:rect l="0" t="0" r="r" b="b"/>
                <a:pathLst>
                  <a:path w="798" h="560">
                    <a:moveTo>
                      <a:pt x="429" y="118"/>
                    </a:moveTo>
                    <a:cubicBezTo>
                      <a:pt x="451" y="78"/>
                      <a:pt x="478" y="49"/>
                      <a:pt x="509" y="29"/>
                    </a:cubicBezTo>
                    <a:cubicBezTo>
                      <a:pt x="540" y="10"/>
                      <a:pt x="577" y="0"/>
                      <a:pt x="620" y="0"/>
                    </a:cubicBezTo>
                    <a:cubicBezTo>
                      <a:pt x="676" y="0"/>
                      <a:pt x="720" y="20"/>
                      <a:pt x="751" y="60"/>
                    </a:cubicBezTo>
                    <a:cubicBezTo>
                      <a:pt x="782" y="100"/>
                      <a:pt x="798" y="157"/>
                      <a:pt x="798" y="230"/>
                    </a:cubicBezTo>
                    <a:lnTo>
                      <a:pt x="798" y="560"/>
                    </a:lnTo>
                    <a:lnTo>
                      <a:pt x="708" y="560"/>
                    </a:lnTo>
                    <a:lnTo>
                      <a:pt x="708" y="233"/>
                    </a:lnTo>
                    <a:cubicBezTo>
                      <a:pt x="708" y="181"/>
                      <a:pt x="698" y="142"/>
                      <a:pt x="680" y="116"/>
                    </a:cubicBezTo>
                    <a:cubicBezTo>
                      <a:pt x="661" y="91"/>
                      <a:pt x="633" y="78"/>
                      <a:pt x="595" y="78"/>
                    </a:cubicBezTo>
                    <a:cubicBezTo>
                      <a:pt x="548" y="78"/>
                      <a:pt x="511" y="94"/>
                      <a:pt x="484" y="125"/>
                    </a:cubicBezTo>
                    <a:cubicBezTo>
                      <a:pt x="457" y="156"/>
                      <a:pt x="444" y="198"/>
                      <a:pt x="444" y="251"/>
                    </a:cubicBezTo>
                    <a:lnTo>
                      <a:pt x="444" y="560"/>
                    </a:lnTo>
                    <a:lnTo>
                      <a:pt x="354" y="560"/>
                    </a:lnTo>
                    <a:lnTo>
                      <a:pt x="354" y="233"/>
                    </a:lnTo>
                    <a:cubicBezTo>
                      <a:pt x="354" y="181"/>
                      <a:pt x="344" y="142"/>
                      <a:pt x="326" y="116"/>
                    </a:cubicBezTo>
                    <a:cubicBezTo>
                      <a:pt x="307" y="91"/>
                      <a:pt x="278" y="78"/>
                      <a:pt x="240" y="78"/>
                    </a:cubicBezTo>
                    <a:cubicBezTo>
                      <a:pt x="194" y="78"/>
                      <a:pt x="157" y="94"/>
                      <a:pt x="130" y="125"/>
                    </a:cubicBezTo>
                    <a:cubicBezTo>
                      <a:pt x="103" y="156"/>
                      <a:pt x="90" y="198"/>
                      <a:pt x="90" y="251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10" y="65"/>
                      <a:pt x="135" y="40"/>
                      <a:pt x="164" y="24"/>
                    </a:cubicBezTo>
                    <a:cubicBezTo>
                      <a:pt x="192" y="8"/>
                      <a:pt x="226" y="0"/>
                      <a:pt x="266" y="0"/>
                    </a:cubicBezTo>
                    <a:cubicBezTo>
                      <a:pt x="306" y="0"/>
                      <a:pt x="339" y="10"/>
                      <a:pt x="367" y="30"/>
                    </a:cubicBezTo>
                    <a:cubicBezTo>
                      <a:pt x="395" y="50"/>
                      <a:pt x="415" y="80"/>
                      <a:pt x="429" y="11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0" name="Freeform 257">
                <a:extLst>
                  <a:ext uri="{FF2B5EF4-FFF2-40B4-BE49-F238E27FC236}">
                    <a16:creationId xmlns:a16="http://schemas.microsoft.com/office/drawing/2014/main" id="{91D8DA6F-030E-1CAC-CEE4-304E311E9FD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56125" y="5376863"/>
                <a:ext cx="104775" cy="136525"/>
              </a:xfrm>
              <a:custGeom>
                <a:avLst/>
                <a:gdLst>
                  <a:gd name="T0" fmla="*/ 588 w 588"/>
                  <a:gd name="T1" fmla="*/ 69 h 755"/>
                  <a:gd name="T2" fmla="*/ 588 w 588"/>
                  <a:gd name="T3" fmla="*/ 173 h 755"/>
                  <a:gd name="T4" fmla="*/ 481 w 588"/>
                  <a:gd name="T5" fmla="*/ 104 h 755"/>
                  <a:gd name="T6" fmla="*/ 362 w 588"/>
                  <a:gd name="T7" fmla="*/ 81 h 755"/>
                  <a:gd name="T8" fmla="*/ 170 w 588"/>
                  <a:gd name="T9" fmla="*/ 158 h 755"/>
                  <a:gd name="T10" fmla="*/ 104 w 588"/>
                  <a:gd name="T11" fmla="*/ 378 h 755"/>
                  <a:gd name="T12" fmla="*/ 170 w 588"/>
                  <a:gd name="T13" fmla="*/ 599 h 755"/>
                  <a:gd name="T14" fmla="*/ 362 w 588"/>
                  <a:gd name="T15" fmla="*/ 675 h 755"/>
                  <a:gd name="T16" fmla="*/ 481 w 588"/>
                  <a:gd name="T17" fmla="*/ 652 h 755"/>
                  <a:gd name="T18" fmla="*/ 588 w 588"/>
                  <a:gd name="T19" fmla="*/ 583 h 755"/>
                  <a:gd name="T20" fmla="*/ 588 w 588"/>
                  <a:gd name="T21" fmla="*/ 686 h 755"/>
                  <a:gd name="T22" fmla="*/ 478 w 588"/>
                  <a:gd name="T23" fmla="*/ 738 h 755"/>
                  <a:gd name="T24" fmla="*/ 356 w 588"/>
                  <a:gd name="T25" fmla="*/ 755 h 755"/>
                  <a:gd name="T26" fmla="*/ 95 w 588"/>
                  <a:gd name="T27" fmla="*/ 655 h 755"/>
                  <a:gd name="T28" fmla="*/ 0 w 588"/>
                  <a:gd name="T29" fmla="*/ 378 h 755"/>
                  <a:gd name="T30" fmla="*/ 95 w 588"/>
                  <a:gd name="T31" fmla="*/ 101 h 755"/>
                  <a:gd name="T32" fmla="*/ 356 w 588"/>
                  <a:gd name="T33" fmla="*/ 0 h 755"/>
                  <a:gd name="T34" fmla="*/ 479 w 588"/>
                  <a:gd name="T35" fmla="*/ 17 h 755"/>
                  <a:gd name="T36" fmla="*/ 588 w 588"/>
                  <a:gd name="T37" fmla="*/ 69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588" h="755">
                    <a:moveTo>
                      <a:pt x="588" y="69"/>
                    </a:moveTo>
                    <a:lnTo>
                      <a:pt x="588" y="173"/>
                    </a:lnTo>
                    <a:cubicBezTo>
                      <a:pt x="554" y="143"/>
                      <a:pt x="519" y="120"/>
                      <a:pt x="481" y="104"/>
                    </a:cubicBezTo>
                    <a:cubicBezTo>
                      <a:pt x="443" y="89"/>
                      <a:pt x="404" y="81"/>
                      <a:pt x="362" y="81"/>
                    </a:cubicBezTo>
                    <a:cubicBezTo>
                      <a:pt x="278" y="81"/>
                      <a:pt x="214" y="107"/>
                      <a:pt x="170" y="158"/>
                    </a:cubicBezTo>
                    <a:cubicBezTo>
                      <a:pt x="126" y="209"/>
                      <a:pt x="104" y="282"/>
                      <a:pt x="104" y="378"/>
                    </a:cubicBezTo>
                    <a:cubicBezTo>
                      <a:pt x="104" y="474"/>
                      <a:pt x="126" y="548"/>
                      <a:pt x="170" y="599"/>
                    </a:cubicBezTo>
                    <a:cubicBezTo>
                      <a:pt x="214" y="650"/>
                      <a:pt x="278" y="675"/>
                      <a:pt x="362" y="675"/>
                    </a:cubicBezTo>
                    <a:cubicBezTo>
                      <a:pt x="404" y="675"/>
                      <a:pt x="443" y="668"/>
                      <a:pt x="481" y="652"/>
                    </a:cubicBezTo>
                    <a:cubicBezTo>
                      <a:pt x="519" y="637"/>
                      <a:pt x="554" y="614"/>
                      <a:pt x="588" y="583"/>
                    </a:cubicBezTo>
                    <a:lnTo>
                      <a:pt x="588" y="686"/>
                    </a:lnTo>
                    <a:cubicBezTo>
                      <a:pt x="553" y="710"/>
                      <a:pt x="516" y="727"/>
                      <a:pt x="478" y="738"/>
                    </a:cubicBezTo>
                    <a:cubicBezTo>
                      <a:pt x="440" y="749"/>
                      <a:pt x="399" y="755"/>
                      <a:pt x="356" y="755"/>
                    </a:cubicBezTo>
                    <a:cubicBezTo>
                      <a:pt x="246" y="755"/>
                      <a:pt x="159" y="722"/>
                      <a:pt x="95" y="655"/>
                    </a:cubicBezTo>
                    <a:cubicBezTo>
                      <a:pt x="31" y="588"/>
                      <a:pt x="0" y="496"/>
                      <a:pt x="0" y="378"/>
                    </a:cubicBezTo>
                    <a:cubicBezTo>
                      <a:pt x="0" y="261"/>
                      <a:pt x="31" y="169"/>
                      <a:pt x="95" y="101"/>
                    </a:cubicBezTo>
                    <a:cubicBezTo>
                      <a:pt x="159" y="34"/>
                      <a:pt x="246" y="0"/>
                      <a:pt x="356" y="0"/>
                    </a:cubicBezTo>
                    <a:cubicBezTo>
                      <a:pt x="400" y="0"/>
                      <a:pt x="441" y="6"/>
                      <a:pt x="479" y="17"/>
                    </a:cubicBezTo>
                    <a:cubicBezTo>
                      <a:pt x="517" y="29"/>
                      <a:pt x="554" y="46"/>
                      <a:pt x="588" y="6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1" name="Freeform 258">
                <a:extLst>
                  <a:ext uri="{FF2B5EF4-FFF2-40B4-BE49-F238E27FC236}">
                    <a16:creationId xmlns:a16="http://schemas.microsoft.com/office/drawing/2014/main" id="{54B588C0-1D17-B9BA-9BEC-BE4500B09ED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681538" y="5408613"/>
                <a:ext cx="90488" cy="104775"/>
              </a:xfrm>
              <a:custGeom>
                <a:avLst/>
                <a:gdLst>
                  <a:gd name="T0" fmla="*/ 507 w 507"/>
                  <a:gd name="T1" fmla="*/ 264 h 573"/>
                  <a:gd name="T2" fmla="*/ 507 w 507"/>
                  <a:gd name="T3" fmla="*/ 308 h 573"/>
                  <a:gd name="T4" fmla="*/ 94 w 507"/>
                  <a:gd name="T5" fmla="*/ 308 h 573"/>
                  <a:gd name="T6" fmla="*/ 150 w 507"/>
                  <a:gd name="T7" fmla="*/ 450 h 573"/>
                  <a:gd name="T8" fmla="*/ 289 w 507"/>
                  <a:gd name="T9" fmla="*/ 498 h 573"/>
                  <a:gd name="T10" fmla="*/ 389 w 507"/>
                  <a:gd name="T11" fmla="*/ 486 h 573"/>
                  <a:gd name="T12" fmla="*/ 486 w 507"/>
                  <a:gd name="T13" fmla="*/ 447 h 573"/>
                  <a:gd name="T14" fmla="*/ 486 w 507"/>
                  <a:gd name="T15" fmla="*/ 532 h 573"/>
                  <a:gd name="T16" fmla="*/ 387 w 507"/>
                  <a:gd name="T17" fmla="*/ 563 h 573"/>
                  <a:gd name="T18" fmla="*/ 284 w 507"/>
                  <a:gd name="T19" fmla="*/ 573 h 573"/>
                  <a:gd name="T20" fmla="*/ 76 w 507"/>
                  <a:gd name="T21" fmla="*/ 498 h 573"/>
                  <a:gd name="T22" fmla="*/ 0 w 507"/>
                  <a:gd name="T23" fmla="*/ 292 h 573"/>
                  <a:gd name="T24" fmla="*/ 72 w 507"/>
                  <a:gd name="T25" fmla="*/ 79 h 573"/>
                  <a:gd name="T26" fmla="*/ 268 w 507"/>
                  <a:gd name="T27" fmla="*/ 0 h 573"/>
                  <a:gd name="T28" fmla="*/ 443 w 507"/>
                  <a:gd name="T29" fmla="*/ 71 h 573"/>
                  <a:gd name="T30" fmla="*/ 507 w 507"/>
                  <a:gd name="T31" fmla="*/ 264 h 573"/>
                  <a:gd name="T32" fmla="*/ 417 w 507"/>
                  <a:gd name="T33" fmla="*/ 238 h 573"/>
                  <a:gd name="T34" fmla="*/ 376 w 507"/>
                  <a:gd name="T35" fmla="*/ 120 h 573"/>
                  <a:gd name="T36" fmla="*/ 269 w 507"/>
                  <a:gd name="T37" fmla="*/ 76 h 573"/>
                  <a:gd name="T38" fmla="*/ 149 w 507"/>
                  <a:gd name="T39" fmla="*/ 119 h 573"/>
                  <a:gd name="T40" fmla="*/ 97 w 507"/>
                  <a:gd name="T41" fmla="*/ 238 h 573"/>
                  <a:gd name="T42" fmla="*/ 417 w 507"/>
                  <a:gd name="T43" fmla="*/ 23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07" h="573">
                    <a:moveTo>
                      <a:pt x="507" y="264"/>
                    </a:moveTo>
                    <a:lnTo>
                      <a:pt x="507" y="308"/>
                    </a:lnTo>
                    <a:lnTo>
                      <a:pt x="94" y="308"/>
                    </a:lnTo>
                    <a:cubicBezTo>
                      <a:pt x="98" y="370"/>
                      <a:pt x="116" y="418"/>
                      <a:pt x="150" y="450"/>
                    </a:cubicBezTo>
                    <a:cubicBezTo>
                      <a:pt x="183" y="482"/>
                      <a:pt x="229" y="498"/>
                      <a:pt x="289" y="498"/>
                    </a:cubicBezTo>
                    <a:cubicBezTo>
                      <a:pt x="323" y="498"/>
                      <a:pt x="357" y="494"/>
                      <a:pt x="389" y="486"/>
                    </a:cubicBezTo>
                    <a:cubicBezTo>
                      <a:pt x="421" y="478"/>
                      <a:pt x="454" y="465"/>
                      <a:pt x="486" y="447"/>
                    </a:cubicBezTo>
                    <a:lnTo>
                      <a:pt x="486" y="532"/>
                    </a:lnTo>
                    <a:cubicBezTo>
                      <a:pt x="454" y="546"/>
                      <a:pt x="421" y="557"/>
                      <a:pt x="387" y="563"/>
                    </a:cubicBezTo>
                    <a:cubicBezTo>
                      <a:pt x="353" y="569"/>
                      <a:pt x="318" y="573"/>
                      <a:pt x="284" y="573"/>
                    </a:cubicBezTo>
                    <a:cubicBezTo>
                      <a:pt x="196" y="573"/>
                      <a:pt x="127" y="548"/>
                      <a:pt x="76" y="498"/>
                    </a:cubicBezTo>
                    <a:cubicBezTo>
                      <a:pt x="25" y="448"/>
                      <a:pt x="0" y="379"/>
                      <a:pt x="0" y="292"/>
                    </a:cubicBezTo>
                    <a:cubicBezTo>
                      <a:pt x="0" y="203"/>
                      <a:pt x="24" y="132"/>
                      <a:pt x="72" y="79"/>
                    </a:cubicBezTo>
                    <a:cubicBezTo>
                      <a:pt x="120" y="27"/>
                      <a:pt x="186" y="0"/>
                      <a:pt x="268" y="0"/>
                    </a:cubicBezTo>
                    <a:cubicBezTo>
                      <a:pt x="342" y="0"/>
                      <a:pt x="400" y="24"/>
                      <a:pt x="443" y="71"/>
                    </a:cubicBezTo>
                    <a:cubicBezTo>
                      <a:pt x="485" y="119"/>
                      <a:pt x="507" y="183"/>
                      <a:pt x="507" y="264"/>
                    </a:cubicBezTo>
                    <a:close/>
                    <a:moveTo>
                      <a:pt x="417" y="238"/>
                    </a:moveTo>
                    <a:cubicBezTo>
                      <a:pt x="416" y="189"/>
                      <a:pt x="402" y="150"/>
                      <a:pt x="376" y="120"/>
                    </a:cubicBezTo>
                    <a:cubicBezTo>
                      <a:pt x="349" y="91"/>
                      <a:pt x="313" y="76"/>
                      <a:pt x="269" y="76"/>
                    </a:cubicBezTo>
                    <a:cubicBezTo>
                      <a:pt x="219" y="76"/>
                      <a:pt x="179" y="91"/>
                      <a:pt x="149" y="119"/>
                    </a:cubicBezTo>
                    <a:cubicBezTo>
                      <a:pt x="119" y="147"/>
                      <a:pt x="101" y="187"/>
                      <a:pt x="97" y="238"/>
                    </a:cubicBezTo>
                    <a:lnTo>
                      <a:pt x="417" y="238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2" name="Rectangle 259">
                <a:extLst>
                  <a:ext uri="{FF2B5EF4-FFF2-40B4-BE49-F238E27FC236}">
                    <a16:creationId xmlns:a16="http://schemas.microsoft.com/office/drawing/2014/main" id="{56AB3526-D72D-A20B-6EAC-D181152593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99013" y="5373688"/>
                <a:ext cx="15875" cy="1365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3" name="Rectangle 260">
                <a:extLst>
                  <a:ext uri="{FF2B5EF4-FFF2-40B4-BE49-F238E27FC236}">
                    <a16:creationId xmlns:a16="http://schemas.microsoft.com/office/drawing/2014/main" id="{ACAF95FD-6130-0C71-BDFC-3CC3A6A89A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9813" y="5373688"/>
                <a:ext cx="15875" cy="1365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4" name="Freeform 261">
                <a:extLst>
                  <a:ext uri="{FF2B5EF4-FFF2-40B4-BE49-F238E27FC236}">
                    <a16:creationId xmlns:a16="http://schemas.microsoft.com/office/drawing/2014/main" id="{BB275D0B-4097-274F-BB89-9DF33219823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894263" y="5376863"/>
                <a:ext cx="92075" cy="136525"/>
              </a:xfrm>
              <a:custGeom>
                <a:avLst/>
                <a:gdLst>
                  <a:gd name="T0" fmla="*/ 469 w 513"/>
                  <a:gd name="T1" fmla="*/ 37 h 755"/>
                  <a:gd name="T2" fmla="*/ 469 w 513"/>
                  <a:gd name="T3" fmla="*/ 133 h 755"/>
                  <a:gd name="T4" fmla="*/ 363 w 513"/>
                  <a:gd name="T5" fmla="*/ 93 h 755"/>
                  <a:gd name="T6" fmla="*/ 267 w 513"/>
                  <a:gd name="T7" fmla="*/ 80 h 755"/>
                  <a:gd name="T8" fmla="*/ 142 w 513"/>
                  <a:gd name="T9" fmla="*/ 111 h 755"/>
                  <a:gd name="T10" fmla="*/ 99 w 513"/>
                  <a:gd name="T11" fmla="*/ 200 h 755"/>
                  <a:gd name="T12" fmla="*/ 128 w 513"/>
                  <a:gd name="T13" fmla="*/ 273 h 755"/>
                  <a:gd name="T14" fmla="*/ 238 w 513"/>
                  <a:gd name="T15" fmla="*/ 313 h 755"/>
                  <a:gd name="T16" fmla="*/ 298 w 513"/>
                  <a:gd name="T17" fmla="*/ 325 h 755"/>
                  <a:gd name="T18" fmla="*/ 460 w 513"/>
                  <a:gd name="T19" fmla="*/ 399 h 755"/>
                  <a:gd name="T20" fmla="*/ 513 w 513"/>
                  <a:gd name="T21" fmla="*/ 541 h 755"/>
                  <a:gd name="T22" fmla="*/ 442 w 513"/>
                  <a:gd name="T23" fmla="*/ 701 h 755"/>
                  <a:gd name="T24" fmla="*/ 234 w 513"/>
                  <a:gd name="T25" fmla="*/ 755 h 755"/>
                  <a:gd name="T26" fmla="*/ 123 w 513"/>
                  <a:gd name="T27" fmla="*/ 744 h 755"/>
                  <a:gd name="T28" fmla="*/ 3 w 513"/>
                  <a:gd name="T29" fmla="*/ 710 h 755"/>
                  <a:gd name="T30" fmla="*/ 3 w 513"/>
                  <a:gd name="T31" fmla="*/ 608 h 755"/>
                  <a:gd name="T32" fmla="*/ 120 w 513"/>
                  <a:gd name="T33" fmla="*/ 659 h 755"/>
                  <a:gd name="T34" fmla="*/ 234 w 513"/>
                  <a:gd name="T35" fmla="*/ 676 h 755"/>
                  <a:gd name="T36" fmla="*/ 364 w 513"/>
                  <a:gd name="T37" fmla="*/ 643 h 755"/>
                  <a:gd name="T38" fmla="*/ 410 w 513"/>
                  <a:gd name="T39" fmla="*/ 548 h 755"/>
                  <a:gd name="T40" fmla="*/ 377 w 513"/>
                  <a:gd name="T41" fmla="*/ 464 h 755"/>
                  <a:gd name="T42" fmla="*/ 269 w 513"/>
                  <a:gd name="T43" fmla="*/ 419 h 755"/>
                  <a:gd name="T44" fmla="*/ 209 w 513"/>
                  <a:gd name="T45" fmla="*/ 407 h 755"/>
                  <a:gd name="T46" fmla="*/ 49 w 513"/>
                  <a:gd name="T47" fmla="*/ 338 h 755"/>
                  <a:gd name="T48" fmla="*/ 0 w 513"/>
                  <a:gd name="T49" fmla="*/ 208 h 755"/>
                  <a:gd name="T50" fmla="*/ 68 w 513"/>
                  <a:gd name="T51" fmla="*/ 56 h 755"/>
                  <a:gd name="T52" fmla="*/ 256 w 513"/>
                  <a:gd name="T53" fmla="*/ 0 h 755"/>
                  <a:gd name="T54" fmla="*/ 360 w 513"/>
                  <a:gd name="T55" fmla="*/ 9 h 755"/>
                  <a:gd name="T56" fmla="*/ 469 w 513"/>
                  <a:gd name="T57" fmla="*/ 37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513" h="755">
                    <a:moveTo>
                      <a:pt x="469" y="37"/>
                    </a:moveTo>
                    <a:lnTo>
                      <a:pt x="469" y="133"/>
                    </a:lnTo>
                    <a:cubicBezTo>
                      <a:pt x="431" y="115"/>
                      <a:pt x="396" y="102"/>
                      <a:pt x="363" y="93"/>
                    </a:cubicBezTo>
                    <a:cubicBezTo>
                      <a:pt x="329" y="85"/>
                      <a:pt x="297" y="80"/>
                      <a:pt x="267" y="80"/>
                    </a:cubicBezTo>
                    <a:cubicBezTo>
                      <a:pt x="213" y="80"/>
                      <a:pt x="171" y="91"/>
                      <a:pt x="142" y="111"/>
                    </a:cubicBezTo>
                    <a:cubicBezTo>
                      <a:pt x="113" y="132"/>
                      <a:pt x="99" y="162"/>
                      <a:pt x="99" y="200"/>
                    </a:cubicBezTo>
                    <a:cubicBezTo>
                      <a:pt x="99" y="232"/>
                      <a:pt x="108" y="257"/>
                      <a:pt x="128" y="273"/>
                    </a:cubicBezTo>
                    <a:cubicBezTo>
                      <a:pt x="147" y="290"/>
                      <a:pt x="184" y="303"/>
                      <a:pt x="238" y="313"/>
                    </a:cubicBezTo>
                    <a:lnTo>
                      <a:pt x="298" y="325"/>
                    </a:lnTo>
                    <a:cubicBezTo>
                      <a:pt x="371" y="339"/>
                      <a:pt x="425" y="364"/>
                      <a:pt x="460" y="399"/>
                    </a:cubicBezTo>
                    <a:cubicBezTo>
                      <a:pt x="495" y="435"/>
                      <a:pt x="513" y="482"/>
                      <a:pt x="513" y="541"/>
                    </a:cubicBezTo>
                    <a:cubicBezTo>
                      <a:pt x="513" y="612"/>
                      <a:pt x="489" y="665"/>
                      <a:pt x="442" y="701"/>
                    </a:cubicBezTo>
                    <a:cubicBezTo>
                      <a:pt x="394" y="737"/>
                      <a:pt x="325" y="755"/>
                      <a:pt x="234" y="755"/>
                    </a:cubicBezTo>
                    <a:cubicBezTo>
                      <a:pt x="199" y="755"/>
                      <a:pt x="162" y="751"/>
                      <a:pt x="123" y="744"/>
                    </a:cubicBezTo>
                    <a:cubicBezTo>
                      <a:pt x="84" y="737"/>
                      <a:pt x="44" y="726"/>
                      <a:pt x="3" y="710"/>
                    </a:cubicBezTo>
                    <a:lnTo>
                      <a:pt x="3" y="608"/>
                    </a:lnTo>
                    <a:cubicBezTo>
                      <a:pt x="43" y="631"/>
                      <a:pt x="82" y="648"/>
                      <a:pt x="120" y="659"/>
                    </a:cubicBezTo>
                    <a:cubicBezTo>
                      <a:pt x="158" y="671"/>
                      <a:pt x="196" y="676"/>
                      <a:pt x="234" y="676"/>
                    </a:cubicBezTo>
                    <a:cubicBezTo>
                      <a:pt x="290" y="676"/>
                      <a:pt x="333" y="665"/>
                      <a:pt x="364" y="643"/>
                    </a:cubicBezTo>
                    <a:cubicBezTo>
                      <a:pt x="394" y="621"/>
                      <a:pt x="410" y="590"/>
                      <a:pt x="410" y="548"/>
                    </a:cubicBezTo>
                    <a:cubicBezTo>
                      <a:pt x="410" y="512"/>
                      <a:pt x="399" y="484"/>
                      <a:pt x="377" y="464"/>
                    </a:cubicBezTo>
                    <a:cubicBezTo>
                      <a:pt x="355" y="444"/>
                      <a:pt x="319" y="429"/>
                      <a:pt x="269" y="419"/>
                    </a:cubicBezTo>
                    <a:lnTo>
                      <a:pt x="209" y="407"/>
                    </a:lnTo>
                    <a:cubicBezTo>
                      <a:pt x="135" y="393"/>
                      <a:pt x="82" y="370"/>
                      <a:pt x="49" y="338"/>
                    </a:cubicBezTo>
                    <a:cubicBezTo>
                      <a:pt x="16" y="307"/>
                      <a:pt x="0" y="264"/>
                      <a:pt x="0" y="208"/>
                    </a:cubicBezTo>
                    <a:cubicBezTo>
                      <a:pt x="0" y="144"/>
                      <a:pt x="22" y="93"/>
                      <a:pt x="68" y="56"/>
                    </a:cubicBezTo>
                    <a:cubicBezTo>
                      <a:pt x="113" y="19"/>
                      <a:pt x="176" y="0"/>
                      <a:pt x="256" y="0"/>
                    </a:cubicBezTo>
                    <a:cubicBezTo>
                      <a:pt x="290" y="0"/>
                      <a:pt x="324" y="3"/>
                      <a:pt x="360" y="9"/>
                    </a:cubicBezTo>
                    <a:cubicBezTo>
                      <a:pt x="395" y="15"/>
                      <a:pt x="431" y="25"/>
                      <a:pt x="469" y="37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5" name="Freeform 262">
                <a:extLst>
                  <a:ext uri="{FF2B5EF4-FFF2-40B4-BE49-F238E27FC236}">
                    <a16:creationId xmlns:a16="http://schemas.microsoft.com/office/drawing/2014/main" id="{5A496ADD-6D81-C058-C3A1-80FC931BFAB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13325" y="5408613"/>
                <a:ext cx="82550" cy="101600"/>
              </a:xfrm>
              <a:custGeom>
                <a:avLst/>
                <a:gdLst>
                  <a:gd name="T0" fmla="*/ 458 w 458"/>
                  <a:gd name="T1" fmla="*/ 230 h 560"/>
                  <a:gd name="T2" fmla="*/ 458 w 458"/>
                  <a:gd name="T3" fmla="*/ 560 h 560"/>
                  <a:gd name="T4" fmla="*/ 368 w 458"/>
                  <a:gd name="T5" fmla="*/ 560 h 560"/>
                  <a:gd name="T6" fmla="*/ 368 w 458"/>
                  <a:gd name="T7" fmla="*/ 233 h 560"/>
                  <a:gd name="T8" fmla="*/ 337 w 458"/>
                  <a:gd name="T9" fmla="*/ 117 h 560"/>
                  <a:gd name="T10" fmla="*/ 247 w 458"/>
                  <a:gd name="T11" fmla="*/ 78 h 560"/>
                  <a:gd name="T12" fmla="*/ 132 w 458"/>
                  <a:gd name="T13" fmla="*/ 125 h 560"/>
                  <a:gd name="T14" fmla="*/ 90 w 458"/>
                  <a:gd name="T15" fmla="*/ 251 h 560"/>
                  <a:gd name="T16" fmla="*/ 90 w 458"/>
                  <a:gd name="T17" fmla="*/ 560 h 560"/>
                  <a:gd name="T18" fmla="*/ 0 w 458"/>
                  <a:gd name="T19" fmla="*/ 560 h 560"/>
                  <a:gd name="T20" fmla="*/ 0 w 458"/>
                  <a:gd name="T21" fmla="*/ 13 h 560"/>
                  <a:gd name="T22" fmla="*/ 90 w 458"/>
                  <a:gd name="T23" fmla="*/ 13 h 560"/>
                  <a:gd name="T24" fmla="*/ 90 w 458"/>
                  <a:gd name="T25" fmla="*/ 98 h 560"/>
                  <a:gd name="T26" fmla="*/ 166 w 458"/>
                  <a:gd name="T27" fmla="*/ 25 h 560"/>
                  <a:gd name="T28" fmla="*/ 267 w 458"/>
                  <a:gd name="T29" fmla="*/ 0 h 560"/>
                  <a:gd name="T30" fmla="*/ 409 w 458"/>
                  <a:gd name="T31" fmla="*/ 59 h 560"/>
                  <a:gd name="T32" fmla="*/ 458 w 458"/>
                  <a:gd name="T33" fmla="*/ 230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58" h="560">
                    <a:moveTo>
                      <a:pt x="458" y="230"/>
                    </a:moveTo>
                    <a:lnTo>
                      <a:pt x="458" y="560"/>
                    </a:lnTo>
                    <a:lnTo>
                      <a:pt x="368" y="560"/>
                    </a:lnTo>
                    <a:lnTo>
                      <a:pt x="368" y="233"/>
                    </a:lnTo>
                    <a:cubicBezTo>
                      <a:pt x="368" y="181"/>
                      <a:pt x="357" y="143"/>
                      <a:pt x="337" y="117"/>
                    </a:cubicBezTo>
                    <a:cubicBezTo>
                      <a:pt x="317" y="91"/>
                      <a:pt x="287" y="78"/>
                      <a:pt x="247" y="78"/>
                    </a:cubicBezTo>
                    <a:cubicBezTo>
                      <a:pt x="198" y="78"/>
                      <a:pt x="160" y="94"/>
                      <a:pt x="132" y="125"/>
                    </a:cubicBezTo>
                    <a:cubicBezTo>
                      <a:pt x="104" y="156"/>
                      <a:pt x="90" y="198"/>
                      <a:pt x="90" y="251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11" y="66"/>
                      <a:pt x="136" y="41"/>
                      <a:pt x="166" y="25"/>
                    </a:cubicBezTo>
                    <a:cubicBezTo>
                      <a:pt x="195" y="9"/>
                      <a:pt x="229" y="0"/>
                      <a:pt x="267" y="0"/>
                    </a:cubicBezTo>
                    <a:cubicBezTo>
                      <a:pt x="329" y="0"/>
                      <a:pt x="377" y="20"/>
                      <a:pt x="409" y="59"/>
                    </a:cubicBezTo>
                    <a:cubicBezTo>
                      <a:pt x="441" y="98"/>
                      <a:pt x="458" y="155"/>
                      <a:pt x="458" y="23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6" name="Freeform 263">
                <a:extLst>
                  <a:ext uri="{FF2B5EF4-FFF2-40B4-BE49-F238E27FC236}">
                    <a16:creationId xmlns:a16="http://schemas.microsoft.com/office/drawing/2014/main" id="{DD4094C6-538F-CA68-8FA1-AD1166E0521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122863" y="5408613"/>
                <a:ext cx="82550" cy="104775"/>
              </a:xfrm>
              <a:custGeom>
                <a:avLst/>
                <a:gdLst>
                  <a:gd name="T0" fmla="*/ 283 w 462"/>
                  <a:gd name="T1" fmla="*/ 285 h 573"/>
                  <a:gd name="T2" fmla="*/ 132 w 462"/>
                  <a:gd name="T3" fmla="*/ 310 h 573"/>
                  <a:gd name="T4" fmla="*/ 90 w 462"/>
                  <a:gd name="T5" fmla="*/ 395 h 573"/>
                  <a:gd name="T6" fmla="*/ 121 w 462"/>
                  <a:gd name="T7" fmla="*/ 471 h 573"/>
                  <a:gd name="T8" fmla="*/ 207 w 462"/>
                  <a:gd name="T9" fmla="*/ 499 h 573"/>
                  <a:gd name="T10" fmla="*/ 327 w 462"/>
                  <a:gd name="T11" fmla="*/ 446 h 573"/>
                  <a:gd name="T12" fmla="*/ 372 w 462"/>
                  <a:gd name="T13" fmla="*/ 305 h 573"/>
                  <a:gd name="T14" fmla="*/ 372 w 462"/>
                  <a:gd name="T15" fmla="*/ 285 h 573"/>
                  <a:gd name="T16" fmla="*/ 283 w 462"/>
                  <a:gd name="T17" fmla="*/ 285 h 573"/>
                  <a:gd name="T18" fmla="*/ 462 w 462"/>
                  <a:gd name="T19" fmla="*/ 248 h 573"/>
                  <a:gd name="T20" fmla="*/ 462 w 462"/>
                  <a:gd name="T21" fmla="*/ 560 h 573"/>
                  <a:gd name="T22" fmla="*/ 372 w 462"/>
                  <a:gd name="T23" fmla="*/ 560 h 573"/>
                  <a:gd name="T24" fmla="*/ 372 w 462"/>
                  <a:gd name="T25" fmla="*/ 477 h 573"/>
                  <a:gd name="T26" fmla="*/ 295 w 462"/>
                  <a:gd name="T27" fmla="*/ 550 h 573"/>
                  <a:gd name="T28" fmla="*/ 183 w 462"/>
                  <a:gd name="T29" fmla="*/ 573 h 573"/>
                  <a:gd name="T30" fmla="*/ 49 w 462"/>
                  <a:gd name="T31" fmla="*/ 527 h 573"/>
                  <a:gd name="T32" fmla="*/ 0 w 462"/>
                  <a:gd name="T33" fmla="*/ 401 h 573"/>
                  <a:gd name="T34" fmla="*/ 62 w 462"/>
                  <a:gd name="T35" fmla="*/ 262 h 573"/>
                  <a:gd name="T36" fmla="*/ 246 w 462"/>
                  <a:gd name="T37" fmla="*/ 215 h 573"/>
                  <a:gd name="T38" fmla="*/ 372 w 462"/>
                  <a:gd name="T39" fmla="*/ 215 h 573"/>
                  <a:gd name="T40" fmla="*/ 372 w 462"/>
                  <a:gd name="T41" fmla="*/ 206 h 573"/>
                  <a:gd name="T42" fmla="*/ 331 w 462"/>
                  <a:gd name="T43" fmla="*/ 110 h 573"/>
                  <a:gd name="T44" fmla="*/ 217 w 462"/>
                  <a:gd name="T45" fmla="*/ 76 h 573"/>
                  <a:gd name="T46" fmla="*/ 125 w 462"/>
                  <a:gd name="T47" fmla="*/ 88 h 573"/>
                  <a:gd name="T48" fmla="*/ 40 w 462"/>
                  <a:gd name="T49" fmla="*/ 121 h 573"/>
                  <a:gd name="T50" fmla="*/ 40 w 462"/>
                  <a:gd name="T51" fmla="*/ 38 h 573"/>
                  <a:gd name="T52" fmla="*/ 135 w 462"/>
                  <a:gd name="T53" fmla="*/ 10 h 573"/>
                  <a:gd name="T54" fmla="*/ 226 w 462"/>
                  <a:gd name="T55" fmla="*/ 0 h 573"/>
                  <a:gd name="T56" fmla="*/ 403 w 462"/>
                  <a:gd name="T57" fmla="*/ 62 h 573"/>
                  <a:gd name="T58" fmla="*/ 462 w 462"/>
                  <a:gd name="T59" fmla="*/ 24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462" h="573">
                    <a:moveTo>
                      <a:pt x="283" y="285"/>
                    </a:moveTo>
                    <a:cubicBezTo>
                      <a:pt x="210" y="285"/>
                      <a:pt x="160" y="294"/>
                      <a:pt x="132" y="310"/>
                    </a:cubicBezTo>
                    <a:cubicBezTo>
                      <a:pt x="104" y="327"/>
                      <a:pt x="90" y="355"/>
                      <a:pt x="90" y="395"/>
                    </a:cubicBezTo>
                    <a:cubicBezTo>
                      <a:pt x="90" y="427"/>
                      <a:pt x="100" y="453"/>
                      <a:pt x="121" y="471"/>
                    </a:cubicBezTo>
                    <a:cubicBezTo>
                      <a:pt x="142" y="490"/>
                      <a:pt x="171" y="499"/>
                      <a:pt x="207" y="499"/>
                    </a:cubicBezTo>
                    <a:cubicBezTo>
                      <a:pt x="257" y="499"/>
                      <a:pt x="297" y="482"/>
                      <a:pt x="327" y="446"/>
                    </a:cubicBezTo>
                    <a:cubicBezTo>
                      <a:pt x="357" y="411"/>
                      <a:pt x="372" y="364"/>
                      <a:pt x="372" y="305"/>
                    </a:cubicBezTo>
                    <a:lnTo>
                      <a:pt x="372" y="285"/>
                    </a:lnTo>
                    <a:lnTo>
                      <a:pt x="283" y="285"/>
                    </a:lnTo>
                    <a:close/>
                    <a:moveTo>
                      <a:pt x="462" y="248"/>
                    </a:moveTo>
                    <a:lnTo>
                      <a:pt x="462" y="560"/>
                    </a:lnTo>
                    <a:lnTo>
                      <a:pt x="372" y="560"/>
                    </a:lnTo>
                    <a:lnTo>
                      <a:pt x="372" y="477"/>
                    </a:lnTo>
                    <a:cubicBezTo>
                      <a:pt x="351" y="511"/>
                      <a:pt x="325" y="535"/>
                      <a:pt x="295" y="550"/>
                    </a:cubicBezTo>
                    <a:cubicBezTo>
                      <a:pt x="265" y="565"/>
                      <a:pt x="227" y="573"/>
                      <a:pt x="183" y="573"/>
                    </a:cubicBezTo>
                    <a:cubicBezTo>
                      <a:pt x="127" y="573"/>
                      <a:pt x="82" y="558"/>
                      <a:pt x="49" y="527"/>
                    </a:cubicBezTo>
                    <a:cubicBezTo>
                      <a:pt x="16" y="496"/>
                      <a:pt x="0" y="454"/>
                      <a:pt x="0" y="401"/>
                    </a:cubicBezTo>
                    <a:cubicBezTo>
                      <a:pt x="0" y="340"/>
                      <a:pt x="20" y="294"/>
                      <a:pt x="62" y="262"/>
                    </a:cubicBezTo>
                    <a:cubicBezTo>
                      <a:pt x="103" y="231"/>
                      <a:pt x="164" y="215"/>
                      <a:pt x="246" y="215"/>
                    </a:cubicBezTo>
                    <a:lnTo>
                      <a:pt x="372" y="215"/>
                    </a:lnTo>
                    <a:lnTo>
                      <a:pt x="372" y="206"/>
                    </a:lnTo>
                    <a:cubicBezTo>
                      <a:pt x="372" y="165"/>
                      <a:pt x="358" y="133"/>
                      <a:pt x="331" y="110"/>
                    </a:cubicBezTo>
                    <a:cubicBezTo>
                      <a:pt x="304" y="88"/>
                      <a:pt x="266" y="76"/>
                      <a:pt x="217" y="76"/>
                    </a:cubicBezTo>
                    <a:cubicBezTo>
                      <a:pt x="185" y="76"/>
                      <a:pt x="155" y="80"/>
                      <a:pt x="125" y="88"/>
                    </a:cubicBezTo>
                    <a:cubicBezTo>
                      <a:pt x="95" y="96"/>
                      <a:pt x="67" y="107"/>
                      <a:pt x="40" y="121"/>
                    </a:cubicBezTo>
                    <a:lnTo>
                      <a:pt x="40" y="38"/>
                    </a:lnTo>
                    <a:cubicBezTo>
                      <a:pt x="72" y="26"/>
                      <a:pt x="104" y="16"/>
                      <a:pt x="135" y="10"/>
                    </a:cubicBezTo>
                    <a:cubicBezTo>
                      <a:pt x="166" y="4"/>
                      <a:pt x="196" y="0"/>
                      <a:pt x="226" y="0"/>
                    </a:cubicBezTo>
                    <a:cubicBezTo>
                      <a:pt x="305" y="0"/>
                      <a:pt x="364" y="21"/>
                      <a:pt x="403" y="62"/>
                    </a:cubicBezTo>
                    <a:cubicBezTo>
                      <a:pt x="442" y="103"/>
                      <a:pt x="462" y="165"/>
                      <a:pt x="462" y="24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7" name="Freeform 264">
                <a:extLst>
                  <a:ext uri="{FF2B5EF4-FFF2-40B4-BE49-F238E27FC236}">
                    <a16:creationId xmlns:a16="http://schemas.microsoft.com/office/drawing/2014/main" id="{97595590-B65D-8370-1435-4AA3693FFDD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238750" y="5408613"/>
                <a:ext cx="88900" cy="139700"/>
              </a:xfrm>
              <a:custGeom>
                <a:avLst/>
                <a:gdLst>
                  <a:gd name="T0" fmla="*/ 90 w 489"/>
                  <a:gd name="T1" fmla="*/ 478 h 767"/>
                  <a:gd name="T2" fmla="*/ 90 w 489"/>
                  <a:gd name="T3" fmla="*/ 767 h 767"/>
                  <a:gd name="T4" fmla="*/ 0 w 489"/>
                  <a:gd name="T5" fmla="*/ 767 h 767"/>
                  <a:gd name="T6" fmla="*/ 0 w 489"/>
                  <a:gd name="T7" fmla="*/ 13 h 767"/>
                  <a:gd name="T8" fmla="*/ 90 w 489"/>
                  <a:gd name="T9" fmla="*/ 13 h 767"/>
                  <a:gd name="T10" fmla="*/ 90 w 489"/>
                  <a:gd name="T11" fmla="*/ 96 h 767"/>
                  <a:gd name="T12" fmla="*/ 161 w 489"/>
                  <a:gd name="T13" fmla="*/ 24 h 767"/>
                  <a:gd name="T14" fmla="*/ 265 w 489"/>
                  <a:gd name="T15" fmla="*/ 0 h 767"/>
                  <a:gd name="T16" fmla="*/ 427 w 489"/>
                  <a:gd name="T17" fmla="*/ 79 h 767"/>
                  <a:gd name="T18" fmla="*/ 489 w 489"/>
                  <a:gd name="T19" fmla="*/ 287 h 767"/>
                  <a:gd name="T20" fmla="*/ 427 w 489"/>
                  <a:gd name="T21" fmla="*/ 495 h 767"/>
                  <a:gd name="T22" fmla="*/ 265 w 489"/>
                  <a:gd name="T23" fmla="*/ 573 h 767"/>
                  <a:gd name="T24" fmla="*/ 161 w 489"/>
                  <a:gd name="T25" fmla="*/ 550 h 767"/>
                  <a:gd name="T26" fmla="*/ 90 w 489"/>
                  <a:gd name="T27" fmla="*/ 478 h 767"/>
                  <a:gd name="T28" fmla="*/ 396 w 489"/>
                  <a:gd name="T29" fmla="*/ 287 h 767"/>
                  <a:gd name="T30" fmla="*/ 355 w 489"/>
                  <a:gd name="T31" fmla="*/ 132 h 767"/>
                  <a:gd name="T32" fmla="*/ 243 w 489"/>
                  <a:gd name="T33" fmla="*/ 75 h 767"/>
                  <a:gd name="T34" fmla="*/ 131 w 489"/>
                  <a:gd name="T35" fmla="*/ 132 h 767"/>
                  <a:gd name="T36" fmla="*/ 90 w 489"/>
                  <a:gd name="T37" fmla="*/ 287 h 767"/>
                  <a:gd name="T38" fmla="*/ 131 w 489"/>
                  <a:gd name="T39" fmla="*/ 443 h 767"/>
                  <a:gd name="T40" fmla="*/ 243 w 489"/>
                  <a:gd name="T41" fmla="*/ 499 h 767"/>
                  <a:gd name="T42" fmla="*/ 355 w 489"/>
                  <a:gd name="T43" fmla="*/ 443 h 767"/>
                  <a:gd name="T44" fmla="*/ 396 w 489"/>
                  <a:gd name="T45" fmla="*/ 287 h 7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89" h="767">
                    <a:moveTo>
                      <a:pt x="90" y="478"/>
                    </a:moveTo>
                    <a:lnTo>
                      <a:pt x="90" y="767"/>
                    </a:lnTo>
                    <a:lnTo>
                      <a:pt x="0" y="767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6"/>
                    </a:lnTo>
                    <a:cubicBezTo>
                      <a:pt x="108" y="64"/>
                      <a:pt x="132" y="40"/>
                      <a:pt x="161" y="24"/>
                    </a:cubicBezTo>
                    <a:cubicBezTo>
                      <a:pt x="190" y="8"/>
                      <a:pt x="225" y="0"/>
                      <a:pt x="265" y="0"/>
                    </a:cubicBezTo>
                    <a:cubicBezTo>
                      <a:pt x="331" y="0"/>
                      <a:pt x="385" y="27"/>
                      <a:pt x="427" y="79"/>
                    </a:cubicBezTo>
                    <a:cubicBezTo>
                      <a:pt x="468" y="132"/>
                      <a:pt x="489" y="201"/>
                      <a:pt x="489" y="287"/>
                    </a:cubicBezTo>
                    <a:cubicBezTo>
                      <a:pt x="489" y="373"/>
                      <a:pt x="468" y="443"/>
                      <a:pt x="427" y="495"/>
                    </a:cubicBezTo>
                    <a:cubicBezTo>
                      <a:pt x="385" y="547"/>
                      <a:pt x="331" y="573"/>
                      <a:pt x="265" y="573"/>
                    </a:cubicBezTo>
                    <a:cubicBezTo>
                      <a:pt x="225" y="573"/>
                      <a:pt x="190" y="565"/>
                      <a:pt x="161" y="550"/>
                    </a:cubicBezTo>
                    <a:cubicBezTo>
                      <a:pt x="132" y="535"/>
                      <a:pt x="108" y="511"/>
                      <a:pt x="90" y="478"/>
                    </a:cubicBezTo>
                    <a:close/>
                    <a:moveTo>
                      <a:pt x="396" y="287"/>
                    </a:moveTo>
                    <a:cubicBezTo>
                      <a:pt x="396" y="221"/>
                      <a:pt x="382" y="170"/>
                      <a:pt x="355" y="132"/>
                    </a:cubicBezTo>
                    <a:cubicBezTo>
                      <a:pt x="327" y="94"/>
                      <a:pt x="290" y="75"/>
                      <a:pt x="243" y="75"/>
                    </a:cubicBezTo>
                    <a:cubicBezTo>
                      <a:pt x="195" y="75"/>
                      <a:pt x="158" y="94"/>
                      <a:pt x="131" y="132"/>
                    </a:cubicBezTo>
                    <a:cubicBezTo>
                      <a:pt x="103" y="170"/>
                      <a:pt x="90" y="221"/>
                      <a:pt x="90" y="287"/>
                    </a:cubicBezTo>
                    <a:cubicBezTo>
                      <a:pt x="90" y="353"/>
                      <a:pt x="103" y="405"/>
                      <a:pt x="131" y="443"/>
                    </a:cubicBezTo>
                    <a:cubicBezTo>
                      <a:pt x="158" y="481"/>
                      <a:pt x="195" y="499"/>
                      <a:pt x="243" y="499"/>
                    </a:cubicBezTo>
                    <a:cubicBezTo>
                      <a:pt x="290" y="499"/>
                      <a:pt x="327" y="481"/>
                      <a:pt x="355" y="443"/>
                    </a:cubicBezTo>
                    <a:cubicBezTo>
                      <a:pt x="382" y="405"/>
                      <a:pt x="396" y="353"/>
                      <a:pt x="396" y="287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8" name="Line 265">
                <a:extLst>
                  <a:ext uri="{FF2B5EF4-FFF2-40B4-BE49-F238E27FC236}">
                    <a16:creationId xmlns:a16="http://schemas.microsoft.com/office/drawing/2014/main" id="{A210C071-0A15-DF58-BEF6-D305A579C0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4200" y="4781550"/>
                <a:ext cx="2422525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9" name="Freeform 266">
                <a:extLst>
                  <a:ext uri="{FF2B5EF4-FFF2-40B4-BE49-F238E27FC236}">
                    <a16:creationId xmlns:a16="http://schemas.microsoft.com/office/drawing/2014/main" id="{3DA19131-707C-E000-F515-79A822CF9A4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762250" y="4716463"/>
                <a:ext cx="92075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0" name="Rectangle 267">
                <a:extLst>
                  <a:ext uri="{FF2B5EF4-FFF2-40B4-BE49-F238E27FC236}">
                    <a16:creationId xmlns:a16="http://schemas.microsoft.com/office/drawing/2014/main" id="{0A6C853F-BBD7-AC53-043F-701E57F84C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4488" y="4827588"/>
                <a:ext cx="19050" cy="222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1" name="Freeform 268">
                <a:extLst>
                  <a:ext uri="{FF2B5EF4-FFF2-40B4-BE49-F238E27FC236}">
                    <a16:creationId xmlns:a16="http://schemas.microsoft.com/office/drawing/2014/main" id="{66922EDB-0381-3C90-7356-B24963E756A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36875" y="4716463"/>
                <a:ext cx="82550" cy="133350"/>
              </a:xfrm>
              <a:custGeom>
                <a:avLst/>
                <a:gdLst>
                  <a:gd name="T0" fmla="*/ 119 w 463"/>
                  <a:gd name="T1" fmla="*/ 659 h 742"/>
                  <a:gd name="T2" fmla="*/ 463 w 463"/>
                  <a:gd name="T3" fmla="*/ 659 h 742"/>
                  <a:gd name="T4" fmla="*/ 463 w 463"/>
                  <a:gd name="T5" fmla="*/ 742 h 742"/>
                  <a:gd name="T6" fmla="*/ 0 w 463"/>
                  <a:gd name="T7" fmla="*/ 742 h 742"/>
                  <a:gd name="T8" fmla="*/ 0 w 463"/>
                  <a:gd name="T9" fmla="*/ 659 h 742"/>
                  <a:gd name="T10" fmla="*/ 153 w 463"/>
                  <a:gd name="T11" fmla="*/ 503 h 742"/>
                  <a:gd name="T12" fmla="*/ 275 w 463"/>
                  <a:gd name="T13" fmla="*/ 377 h 742"/>
                  <a:gd name="T14" fmla="*/ 341 w 463"/>
                  <a:gd name="T15" fmla="*/ 287 h 742"/>
                  <a:gd name="T16" fmla="*/ 360 w 463"/>
                  <a:gd name="T17" fmla="*/ 214 h 742"/>
                  <a:gd name="T18" fmla="*/ 319 w 463"/>
                  <a:gd name="T19" fmla="*/ 120 h 742"/>
                  <a:gd name="T20" fmla="*/ 213 w 463"/>
                  <a:gd name="T21" fmla="*/ 83 h 742"/>
                  <a:gd name="T22" fmla="*/ 115 w 463"/>
                  <a:gd name="T23" fmla="*/ 99 h 742"/>
                  <a:gd name="T24" fmla="*/ 5 w 463"/>
                  <a:gd name="T25" fmla="*/ 148 h 742"/>
                  <a:gd name="T26" fmla="*/ 5 w 463"/>
                  <a:gd name="T27" fmla="*/ 48 h 742"/>
                  <a:gd name="T28" fmla="*/ 116 w 463"/>
                  <a:gd name="T29" fmla="*/ 12 h 742"/>
                  <a:gd name="T30" fmla="*/ 211 w 463"/>
                  <a:gd name="T31" fmla="*/ 0 h 742"/>
                  <a:gd name="T32" fmla="*/ 391 w 463"/>
                  <a:gd name="T33" fmla="*/ 57 h 742"/>
                  <a:gd name="T34" fmla="*/ 459 w 463"/>
                  <a:gd name="T35" fmla="*/ 208 h 742"/>
                  <a:gd name="T36" fmla="*/ 442 w 463"/>
                  <a:gd name="T37" fmla="*/ 293 h 742"/>
                  <a:gd name="T38" fmla="*/ 381 w 463"/>
                  <a:gd name="T39" fmla="*/ 388 h 742"/>
                  <a:gd name="T40" fmla="*/ 303 w 463"/>
                  <a:gd name="T41" fmla="*/ 470 h 742"/>
                  <a:gd name="T42" fmla="*/ 119 w 463"/>
                  <a:gd name="T43" fmla="*/ 659 h 7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463" h="742">
                    <a:moveTo>
                      <a:pt x="119" y="659"/>
                    </a:moveTo>
                    <a:lnTo>
                      <a:pt x="463" y="659"/>
                    </a:lnTo>
                    <a:lnTo>
                      <a:pt x="463" y="742"/>
                    </a:lnTo>
                    <a:lnTo>
                      <a:pt x="0" y="742"/>
                    </a:lnTo>
                    <a:lnTo>
                      <a:pt x="0" y="659"/>
                    </a:lnTo>
                    <a:cubicBezTo>
                      <a:pt x="37" y="621"/>
                      <a:pt x="88" y="569"/>
                      <a:pt x="153" y="503"/>
                    </a:cubicBezTo>
                    <a:cubicBezTo>
                      <a:pt x="217" y="438"/>
                      <a:pt x="258" y="396"/>
                      <a:pt x="275" y="377"/>
                    </a:cubicBezTo>
                    <a:cubicBezTo>
                      <a:pt x="307" y="342"/>
                      <a:pt x="329" y="312"/>
                      <a:pt x="341" y="287"/>
                    </a:cubicBezTo>
                    <a:cubicBezTo>
                      <a:pt x="353" y="263"/>
                      <a:pt x="360" y="238"/>
                      <a:pt x="360" y="214"/>
                    </a:cubicBezTo>
                    <a:cubicBezTo>
                      <a:pt x="360" y="176"/>
                      <a:pt x="346" y="144"/>
                      <a:pt x="319" y="120"/>
                    </a:cubicBezTo>
                    <a:cubicBezTo>
                      <a:pt x="292" y="96"/>
                      <a:pt x="257" y="83"/>
                      <a:pt x="213" y="83"/>
                    </a:cubicBezTo>
                    <a:cubicBezTo>
                      <a:pt x="182" y="83"/>
                      <a:pt x="149" y="89"/>
                      <a:pt x="115" y="99"/>
                    </a:cubicBezTo>
                    <a:cubicBezTo>
                      <a:pt x="81" y="110"/>
                      <a:pt x="44" y="126"/>
                      <a:pt x="5" y="148"/>
                    </a:cubicBezTo>
                    <a:lnTo>
                      <a:pt x="5" y="48"/>
                    </a:lnTo>
                    <a:cubicBezTo>
                      <a:pt x="45" y="32"/>
                      <a:pt x="82" y="20"/>
                      <a:pt x="116" y="12"/>
                    </a:cubicBezTo>
                    <a:cubicBezTo>
                      <a:pt x="150" y="4"/>
                      <a:pt x="182" y="0"/>
                      <a:pt x="211" y="0"/>
                    </a:cubicBezTo>
                    <a:cubicBezTo>
                      <a:pt x="286" y="0"/>
                      <a:pt x="346" y="19"/>
                      <a:pt x="391" y="57"/>
                    </a:cubicBezTo>
                    <a:cubicBezTo>
                      <a:pt x="436" y="95"/>
                      <a:pt x="459" y="145"/>
                      <a:pt x="459" y="208"/>
                    </a:cubicBezTo>
                    <a:cubicBezTo>
                      <a:pt x="459" y="238"/>
                      <a:pt x="453" y="267"/>
                      <a:pt x="442" y="293"/>
                    </a:cubicBezTo>
                    <a:cubicBezTo>
                      <a:pt x="431" y="320"/>
                      <a:pt x="411" y="352"/>
                      <a:pt x="381" y="388"/>
                    </a:cubicBezTo>
                    <a:cubicBezTo>
                      <a:pt x="373" y="398"/>
                      <a:pt x="347" y="425"/>
                      <a:pt x="303" y="470"/>
                    </a:cubicBezTo>
                    <a:cubicBezTo>
                      <a:pt x="259" y="515"/>
                      <a:pt x="198" y="578"/>
                      <a:pt x="119" y="65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2" name="Line 269">
                <a:extLst>
                  <a:ext uri="{FF2B5EF4-FFF2-40B4-BE49-F238E27FC236}">
                    <a16:creationId xmlns:a16="http://schemas.microsoft.com/office/drawing/2014/main" id="{674FBFE0-CEC3-FE22-3F74-EED30B1C44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4200" y="4065588"/>
                <a:ext cx="2422525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3" name="Freeform 270">
                <a:extLst>
                  <a:ext uri="{FF2B5EF4-FFF2-40B4-BE49-F238E27FC236}">
                    <a16:creationId xmlns:a16="http://schemas.microsoft.com/office/drawing/2014/main" id="{58C23DB5-4A3F-C59C-5A9E-25758FED402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762250" y="4000500"/>
                <a:ext cx="92075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4" name="Rectangle 271">
                <a:extLst>
                  <a:ext uri="{FF2B5EF4-FFF2-40B4-BE49-F238E27FC236}">
                    <a16:creationId xmlns:a16="http://schemas.microsoft.com/office/drawing/2014/main" id="{018F043A-F5CB-FAEB-995A-F995454014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4488" y="4111625"/>
                <a:ext cx="19050" cy="222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5" name="Freeform 272">
                <a:extLst>
                  <a:ext uri="{FF2B5EF4-FFF2-40B4-BE49-F238E27FC236}">
                    <a16:creationId xmlns:a16="http://schemas.microsoft.com/office/drawing/2014/main" id="{F8C80331-06D2-6BFE-769F-6CF184FF51B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932113" y="4002088"/>
                <a:ext cx="95250" cy="131763"/>
              </a:xfrm>
              <a:custGeom>
                <a:avLst/>
                <a:gdLst>
                  <a:gd name="T0" fmla="*/ 329 w 531"/>
                  <a:gd name="T1" fmla="*/ 86 h 729"/>
                  <a:gd name="T2" fmla="*/ 80 w 531"/>
                  <a:gd name="T3" fmla="*/ 475 h 729"/>
                  <a:gd name="T4" fmla="*/ 329 w 531"/>
                  <a:gd name="T5" fmla="*/ 475 h 729"/>
                  <a:gd name="T6" fmla="*/ 329 w 531"/>
                  <a:gd name="T7" fmla="*/ 86 h 729"/>
                  <a:gd name="T8" fmla="*/ 303 w 531"/>
                  <a:gd name="T9" fmla="*/ 0 h 729"/>
                  <a:gd name="T10" fmla="*/ 427 w 531"/>
                  <a:gd name="T11" fmla="*/ 0 h 729"/>
                  <a:gd name="T12" fmla="*/ 427 w 531"/>
                  <a:gd name="T13" fmla="*/ 475 h 729"/>
                  <a:gd name="T14" fmla="*/ 531 w 531"/>
                  <a:gd name="T15" fmla="*/ 475 h 729"/>
                  <a:gd name="T16" fmla="*/ 531 w 531"/>
                  <a:gd name="T17" fmla="*/ 557 h 729"/>
                  <a:gd name="T18" fmla="*/ 427 w 531"/>
                  <a:gd name="T19" fmla="*/ 557 h 729"/>
                  <a:gd name="T20" fmla="*/ 427 w 531"/>
                  <a:gd name="T21" fmla="*/ 729 h 729"/>
                  <a:gd name="T22" fmla="*/ 329 w 531"/>
                  <a:gd name="T23" fmla="*/ 729 h 729"/>
                  <a:gd name="T24" fmla="*/ 329 w 531"/>
                  <a:gd name="T25" fmla="*/ 557 h 729"/>
                  <a:gd name="T26" fmla="*/ 0 w 531"/>
                  <a:gd name="T27" fmla="*/ 557 h 729"/>
                  <a:gd name="T28" fmla="*/ 0 w 531"/>
                  <a:gd name="T29" fmla="*/ 462 h 729"/>
                  <a:gd name="T30" fmla="*/ 303 w 531"/>
                  <a:gd name="T31" fmla="*/ 0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531" h="729">
                    <a:moveTo>
                      <a:pt x="329" y="86"/>
                    </a:moveTo>
                    <a:lnTo>
                      <a:pt x="80" y="475"/>
                    </a:lnTo>
                    <a:lnTo>
                      <a:pt x="329" y="475"/>
                    </a:lnTo>
                    <a:lnTo>
                      <a:pt x="329" y="86"/>
                    </a:lnTo>
                    <a:close/>
                    <a:moveTo>
                      <a:pt x="303" y="0"/>
                    </a:moveTo>
                    <a:lnTo>
                      <a:pt x="427" y="0"/>
                    </a:lnTo>
                    <a:lnTo>
                      <a:pt x="427" y="475"/>
                    </a:lnTo>
                    <a:lnTo>
                      <a:pt x="531" y="475"/>
                    </a:lnTo>
                    <a:lnTo>
                      <a:pt x="531" y="557"/>
                    </a:lnTo>
                    <a:lnTo>
                      <a:pt x="427" y="557"/>
                    </a:lnTo>
                    <a:lnTo>
                      <a:pt x="427" y="729"/>
                    </a:lnTo>
                    <a:lnTo>
                      <a:pt x="329" y="729"/>
                    </a:lnTo>
                    <a:lnTo>
                      <a:pt x="329" y="557"/>
                    </a:lnTo>
                    <a:lnTo>
                      <a:pt x="0" y="557"/>
                    </a:lnTo>
                    <a:lnTo>
                      <a:pt x="0" y="462"/>
                    </a:lnTo>
                    <a:lnTo>
                      <a:pt x="303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6" name="Line 273">
                <a:extLst>
                  <a:ext uri="{FF2B5EF4-FFF2-40B4-BE49-F238E27FC236}">
                    <a16:creationId xmlns:a16="http://schemas.microsoft.com/office/drawing/2014/main" id="{FA47B26B-28FC-1FFE-9F98-144994046C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4200" y="3349625"/>
                <a:ext cx="2422525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7" name="Freeform 274">
                <a:extLst>
                  <a:ext uri="{FF2B5EF4-FFF2-40B4-BE49-F238E27FC236}">
                    <a16:creationId xmlns:a16="http://schemas.microsoft.com/office/drawing/2014/main" id="{C1453DA0-D041-117B-1C33-D548DE0588A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762250" y="3284538"/>
                <a:ext cx="92075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8" name="Rectangle 275">
                <a:extLst>
                  <a:ext uri="{FF2B5EF4-FFF2-40B4-BE49-F238E27FC236}">
                    <a16:creationId xmlns:a16="http://schemas.microsoft.com/office/drawing/2014/main" id="{34549D75-AB19-5FC7-8843-0DC2EF4879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4488" y="3395663"/>
                <a:ext cx="19050" cy="222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9" name="Freeform 276">
                <a:extLst>
                  <a:ext uri="{FF2B5EF4-FFF2-40B4-BE49-F238E27FC236}">
                    <a16:creationId xmlns:a16="http://schemas.microsoft.com/office/drawing/2014/main" id="{1F1512EB-CCDF-2749-FCFA-08DF4AE6728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935288" y="3284538"/>
                <a:ext cx="90488" cy="136525"/>
              </a:xfrm>
              <a:custGeom>
                <a:avLst/>
                <a:gdLst>
                  <a:gd name="T0" fmla="*/ 260 w 503"/>
                  <a:gd name="T1" fmla="*/ 338 h 755"/>
                  <a:gd name="T2" fmla="*/ 155 w 503"/>
                  <a:gd name="T3" fmla="*/ 384 h 755"/>
                  <a:gd name="T4" fmla="*/ 116 w 503"/>
                  <a:gd name="T5" fmla="*/ 508 h 755"/>
                  <a:gd name="T6" fmla="*/ 155 w 503"/>
                  <a:gd name="T7" fmla="*/ 633 h 755"/>
                  <a:gd name="T8" fmla="*/ 260 w 503"/>
                  <a:gd name="T9" fmla="*/ 678 h 755"/>
                  <a:gd name="T10" fmla="*/ 365 w 503"/>
                  <a:gd name="T11" fmla="*/ 633 h 755"/>
                  <a:gd name="T12" fmla="*/ 404 w 503"/>
                  <a:gd name="T13" fmla="*/ 508 h 755"/>
                  <a:gd name="T14" fmla="*/ 365 w 503"/>
                  <a:gd name="T15" fmla="*/ 384 h 755"/>
                  <a:gd name="T16" fmla="*/ 260 w 503"/>
                  <a:gd name="T17" fmla="*/ 338 h 755"/>
                  <a:gd name="T18" fmla="*/ 456 w 503"/>
                  <a:gd name="T19" fmla="*/ 29 h 755"/>
                  <a:gd name="T20" fmla="*/ 456 w 503"/>
                  <a:gd name="T21" fmla="*/ 119 h 755"/>
                  <a:gd name="T22" fmla="*/ 381 w 503"/>
                  <a:gd name="T23" fmla="*/ 92 h 755"/>
                  <a:gd name="T24" fmla="*/ 306 w 503"/>
                  <a:gd name="T25" fmla="*/ 83 h 755"/>
                  <a:gd name="T26" fmla="*/ 156 w 503"/>
                  <a:gd name="T27" fmla="*/ 149 h 755"/>
                  <a:gd name="T28" fmla="*/ 98 w 503"/>
                  <a:gd name="T29" fmla="*/ 348 h 755"/>
                  <a:gd name="T30" fmla="*/ 170 w 503"/>
                  <a:gd name="T31" fmla="*/ 283 h 755"/>
                  <a:gd name="T32" fmla="*/ 266 w 503"/>
                  <a:gd name="T33" fmla="*/ 260 h 755"/>
                  <a:gd name="T34" fmla="*/ 439 w 503"/>
                  <a:gd name="T35" fmla="*/ 327 h 755"/>
                  <a:gd name="T36" fmla="*/ 503 w 503"/>
                  <a:gd name="T37" fmla="*/ 508 h 755"/>
                  <a:gd name="T38" fmla="*/ 436 w 503"/>
                  <a:gd name="T39" fmla="*/ 688 h 755"/>
                  <a:gd name="T40" fmla="*/ 260 w 503"/>
                  <a:gd name="T41" fmla="*/ 755 h 755"/>
                  <a:gd name="T42" fmla="*/ 67 w 503"/>
                  <a:gd name="T43" fmla="*/ 659 h 755"/>
                  <a:gd name="T44" fmla="*/ 0 w 503"/>
                  <a:gd name="T45" fmla="*/ 378 h 755"/>
                  <a:gd name="T46" fmla="*/ 82 w 503"/>
                  <a:gd name="T47" fmla="*/ 103 h 755"/>
                  <a:gd name="T48" fmla="*/ 302 w 503"/>
                  <a:gd name="T49" fmla="*/ 0 h 755"/>
                  <a:gd name="T50" fmla="*/ 377 w 503"/>
                  <a:gd name="T51" fmla="*/ 7 h 755"/>
                  <a:gd name="T52" fmla="*/ 456 w 503"/>
                  <a:gd name="T53" fmla="*/ 29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503" h="755">
                    <a:moveTo>
                      <a:pt x="260" y="338"/>
                    </a:moveTo>
                    <a:cubicBezTo>
                      <a:pt x="216" y="338"/>
                      <a:pt x="181" y="354"/>
                      <a:pt x="155" y="384"/>
                    </a:cubicBezTo>
                    <a:cubicBezTo>
                      <a:pt x="129" y="414"/>
                      <a:pt x="116" y="456"/>
                      <a:pt x="116" y="508"/>
                    </a:cubicBezTo>
                    <a:cubicBezTo>
                      <a:pt x="116" y="561"/>
                      <a:pt x="129" y="603"/>
                      <a:pt x="155" y="633"/>
                    </a:cubicBezTo>
                    <a:cubicBezTo>
                      <a:pt x="181" y="663"/>
                      <a:pt x="216" y="678"/>
                      <a:pt x="260" y="678"/>
                    </a:cubicBezTo>
                    <a:cubicBezTo>
                      <a:pt x="304" y="678"/>
                      <a:pt x="339" y="663"/>
                      <a:pt x="365" y="633"/>
                    </a:cubicBezTo>
                    <a:cubicBezTo>
                      <a:pt x="391" y="603"/>
                      <a:pt x="404" y="561"/>
                      <a:pt x="404" y="508"/>
                    </a:cubicBezTo>
                    <a:cubicBezTo>
                      <a:pt x="404" y="456"/>
                      <a:pt x="391" y="414"/>
                      <a:pt x="365" y="384"/>
                    </a:cubicBezTo>
                    <a:cubicBezTo>
                      <a:pt x="339" y="354"/>
                      <a:pt x="304" y="338"/>
                      <a:pt x="260" y="338"/>
                    </a:cubicBezTo>
                    <a:close/>
                    <a:moveTo>
                      <a:pt x="456" y="29"/>
                    </a:moveTo>
                    <a:lnTo>
                      <a:pt x="456" y="119"/>
                    </a:lnTo>
                    <a:cubicBezTo>
                      <a:pt x="431" y="107"/>
                      <a:pt x="406" y="98"/>
                      <a:pt x="381" y="92"/>
                    </a:cubicBezTo>
                    <a:cubicBezTo>
                      <a:pt x="355" y="86"/>
                      <a:pt x="330" y="83"/>
                      <a:pt x="306" y="83"/>
                    </a:cubicBezTo>
                    <a:cubicBezTo>
                      <a:pt x="240" y="83"/>
                      <a:pt x="190" y="105"/>
                      <a:pt x="156" y="149"/>
                    </a:cubicBezTo>
                    <a:cubicBezTo>
                      <a:pt x="122" y="193"/>
                      <a:pt x="102" y="260"/>
                      <a:pt x="98" y="348"/>
                    </a:cubicBezTo>
                    <a:cubicBezTo>
                      <a:pt x="117" y="320"/>
                      <a:pt x="141" y="298"/>
                      <a:pt x="170" y="283"/>
                    </a:cubicBezTo>
                    <a:cubicBezTo>
                      <a:pt x="199" y="268"/>
                      <a:pt x="231" y="260"/>
                      <a:pt x="266" y="260"/>
                    </a:cubicBezTo>
                    <a:cubicBezTo>
                      <a:pt x="339" y="260"/>
                      <a:pt x="397" y="283"/>
                      <a:pt x="439" y="327"/>
                    </a:cubicBezTo>
                    <a:cubicBezTo>
                      <a:pt x="481" y="371"/>
                      <a:pt x="503" y="432"/>
                      <a:pt x="503" y="508"/>
                    </a:cubicBezTo>
                    <a:cubicBezTo>
                      <a:pt x="503" y="583"/>
                      <a:pt x="480" y="643"/>
                      <a:pt x="436" y="688"/>
                    </a:cubicBezTo>
                    <a:cubicBezTo>
                      <a:pt x="392" y="733"/>
                      <a:pt x="333" y="755"/>
                      <a:pt x="260" y="755"/>
                    </a:cubicBezTo>
                    <a:cubicBezTo>
                      <a:pt x="176" y="755"/>
                      <a:pt x="111" y="723"/>
                      <a:pt x="67" y="659"/>
                    </a:cubicBezTo>
                    <a:cubicBezTo>
                      <a:pt x="22" y="595"/>
                      <a:pt x="0" y="501"/>
                      <a:pt x="0" y="378"/>
                    </a:cubicBezTo>
                    <a:cubicBezTo>
                      <a:pt x="0" y="263"/>
                      <a:pt x="27" y="171"/>
                      <a:pt x="82" y="103"/>
                    </a:cubicBezTo>
                    <a:cubicBezTo>
                      <a:pt x="136" y="35"/>
                      <a:pt x="210" y="0"/>
                      <a:pt x="302" y="0"/>
                    </a:cubicBezTo>
                    <a:cubicBezTo>
                      <a:pt x="326" y="0"/>
                      <a:pt x="351" y="3"/>
                      <a:pt x="377" y="7"/>
                    </a:cubicBezTo>
                    <a:cubicBezTo>
                      <a:pt x="402" y="12"/>
                      <a:pt x="428" y="19"/>
                      <a:pt x="456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0" name="Line 277">
                <a:extLst>
                  <a:ext uri="{FF2B5EF4-FFF2-40B4-BE49-F238E27FC236}">
                    <a16:creationId xmlns:a16="http://schemas.microsoft.com/office/drawing/2014/main" id="{38B2BCA2-AA31-C228-CF66-8D11CA50B3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4200" y="2633663"/>
                <a:ext cx="2422525" cy="0"/>
              </a:xfrm>
              <a:prstGeom prst="line">
                <a:avLst/>
              </a:prstGeom>
              <a:noFill/>
              <a:ln w="317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1" name="Freeform 278">
                <a:extLst>
                  <a:ext uri="{FF2B5EF4-FFF2-40B4-BE49-F238E27FC236}">
                    <a16:creationId xmlns:a16="http://schemas.microsoft.com/office/drawing/2014/main" id="{0894F6C8-EB52-D202-FAB3-B39A358D53B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762250" y="2568575"/>
                <a:ext cx="92075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2" name="Rectangle 279">
                <a:extLst>
                  <a:ext uri="{FF2B5EF4-FFF2-40B4-BE49-F238E27FC236}">
                    <a16:creationId xmlns:a16="http://schemas.microsoft.com/office/drawing/2014/main" id="{B36AC31E-6A81-0A64-04CA-F4EBD22D6E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4488" y="2679700"/>
                <a:ext cx="19050" cy="222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3" name="Freeform 280">
                <a:extLst>
                  <a:ext uri="{FF2B5EF4-FFF2-40B4-BE49-F238E27FC236}">
                    <a16:creationId xmlns:a16="http://schemas.microsoft.com/office/drawing/2014/main" id="{BBC90C14-3B56-A14F-5B34-F8A294FCDD9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935288" y="2568575"/>
                <a:ext cx="90488" cy="136525"/>
              </a:xfrm>
              <a:custGeom>
                <a:avLst/>
                <a:gdLst>
                  <a:gd name="T0" fmla="*/ 250 w 500"/>
                  <a:gd name="T1" fmla="*/ 396 h 755"/>
                  <a:gd name="T2" fmla="*/ 139 w 500"/>
                  <a:gd name="T3" fmla="*/ 434 h 755"/>
                  <a:gd name="T4" fmla="*/ 99 w 500"/>
                  <a:gd name="T5" fmla="*/ 537 h 755"/>
                  <a:gd name="T6" fmla="*/ 139 w 500"/>
                  <a:gd name="T7" fmla="*/ 641 h 755"/>
                  <a:gd name="T8" fmla="*/ 250 w 500"/>
                  <a:gd name="T9" fmla="*/ 678 h 755"/>
                  <a:gd name="T10" fmla="*/ 360 w 500"/>
                  <a:gd name="T11" fmla="*/ 640 h 755"/>
                  <a:gd name="T12" fmla="*/ 401 w 500"/>
                  <a:gd name="T13" fmla="*/ 537 h 755"/>
                  <a:gd name="T14" fmla="*/ 361 w 500"/>
                  <a:gd name="T15" fmla="*/ 434 h 755"/>
                  <a:gd name="T16" fmla="*/ 250 w 500"/>
                  <a:gd name="T17" fmla="*/ 396 h 755"/>
                  <a:gd name="T18" fmla="*/ 151 w 500"/>
                  <a:gd name="T19" fmla="*/ 354 h 755"/>
                  <a:gd name="T20" fmla="*/ 52 w 500"/>
                  <a:gd name="T21" fmla="*/ 295 h 755"/>
                  <a:gd name="T22" fmla="*/ 17 w 500"/>
                  <a:gd name="T23" fmla="*/ 189 h 755"/>
                  <a:gd name="T24" fmla="*/ 79 w 500"/>
                  <a:gd name="T25" fmla="*/ 51 h 755"/>
                  <a:gd name="T26" fmla="*/ 250 w 500"/>
                  <a:gd name="T27" fmla="*/ 0 h 755"/>
                  <a:gd name="T28" fmla="*/ 421 w 500"/>
                  <a:gd name="T29" fmla="*/ 51 h 755"/>
                  <a:gd name="T30" fmla="*/ 483 w 500"/>
                  <a:gd name="T31" fmla="*/ 189 h 755"/>
                  <a:gd name="T32" fmla="*/ 447 w 500"/>
                  <a:gd name="T33" fmla="*/ 295 h 755"/>
                  <a:gd name="T34" fmla="*/ 349 w 500"/>
                  <a:gd name="T35" fmla="*/ 354 h 755"/>
                  <a:gd name="T36" fmla="*/ 460 w 500"/>
                  <a:gd name="T37" fmla="*/ 419 h 755"/>
                  <a:gd name="T38" fmla="*/ 500 w 500"/>
                  <a:gd name="T39" fmla="*/ 537 h 755"/>
                  <a:gd name="T40" fmla="*/ 435 w 500"/>
                  <a:gd name="T41" fmla="*/ 699 h 755"/>
                  <a:gd name="T42" fmla="*/ 249 w 500"/>
                  <a:gd name="T43" fmla="*/ 755 h 755"/>
                  <a:gd name="T44" fmla="*/ 64 w 500"/>
                  <a:gd name="T45" fmla="*/ 699 h 755"/>
                  <a:gd name="T46" fmla="*/ 0 w 500"/>
                  <a:gd name="T47" fmla="*/ 537 h 755"/>
                  <a:gd name="T48" fmla="*/ 40 w 500"/>
                  <a:gd name="T49" fmla="*/ 419 h 755"/>
                  <a:gd name="T50" fmla="*/ 151 w 500"/>
                  <a:gd name="T51" fmla="*/ 354 h 755"/>
                  <a:gd name="T52" fmla="*/ 115 w 500"/>
                  <a:gd name="T53" fmla="*/ 198 h 755"/>
                  <a:gd name="T54" fmla="*/ 150 w 500"/>
                  <a:gd name="T55" fmla="*/ 287 h 755"/>
                  <a:gd name="T56" fmla="*/ 250 w 500"/>
                  <a:gd name="T57" fmla="*/ 318 h 755"/>
                  <a:gd name="T58" fmla="*/ 349 w 500"/>
                  <a:gd name="T59" fmla="*/ 287 h 755"/>
                  <a:gd name="T60" fmla="*/ 385 w 500"/>
                  <a:gd name="T61" fmla="*/ 198 h 755"/>
                  <a:gd name="T62" fmla="*/ 349 w 500"/>
                  <a:gd name="T63" fmla="*/ 110 h 755"/>
                  <a:gd name="T64" fmla="*/ 250 w 500"/>
                  <a:gd name="T65" fmla="*/ 78 h 755"/>
                  <a:gd name="T66" fmla="*/ 150 w 500"/>
                  <a:gd name="T67" fmla="*/ 110 h 755"/>
                  <a:gd name="T68" fmla="*/ 115 w 500"/>
                  <a:gd name="T69" fmla="*/ 198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500" h="755">
                    <a:moveTo>
                      <a:pt x="250" y="396"/>
                    </a:moveTo>
                    <a:cubicBezTo>
                      <a:pt x="203" y="396"/>
                      <a:pt x="166" y="409"/>
                      <a:pt x="139" y="434"/>
                    </a:cubicBezTo>
                    <a:cubicBezTo>
                      <a:pt x="112" y="459"/>
                      <a:pt x="99" y="493"/>
                      <a:pt x="99" y="537"/>
                    </a:cubicBezTo>
                    <a:cubicBezTo>
                      <a:pt x="99" y="581"/>
                      <a:pt x="112" y="616"/>
                      <a:pt x="139" y="641"/>
                    </a:cubicBezTo>
                    <a:cubicBezTo>
                      <a:pt x="166" y="666"/>
                      <a:pt x="203" y="678"/>
                      <a:pt x="250" y="678"/>
                    </a:cubicBezTo>
                    <a:cubicBezTo>
                      <a:pt x="296" y="678"/>
                      <a:pt x="333" y="666"/>
                      <a:pt x="360" y="640"/>
                    </a:cubicBezTo>
                    <a:cubicBezTo>
                      <a:pt x="387" y="615"/>
                      <a:pt x="401" y="581"/>
                      <a:pt x="401" y="537"/>
                    </a:cubicBezTo>
                    <a:cubicBezTo>
                      <a:pt x="401" y="493"/>
                      <a:pt x="387" y="459"/>
                      <a:pt x="361" y="434"/>
                    </a:cubicBezTo>
                    <a:cubicBezTo>
                      <a:pt x="334" y="409"/>
                      <a:pt x="297" y="396"/>
                      <a:pt x="250" y="396"/>
                    </a:cubicBezTo>
                    <a:close/>
                    <a:moveTo>
                      <a:pt x="151" y="354"/>
                    </a:moveTo>
                    <a:cubicBezTo>
                      <a:pt x="109" y="344"/>
                      <a:pt x="76" y="324"/>
                      <a:pt x="52" y="295"/>
                    </a:cubicBezTo>
                    <a:cubicBezTo>
                      <a:pt x="28" y="266"/>
                      <a:pt x="17" y="231"/>
                      <a:pt x="17" y="189"/>
                    </a:cubicBezTo>
                    <a:cubicBezTo>
                      <a:pt x="17" y="131"/>
                      <a:pt x="37" y="85"/>
                      <a:pt x="79" y="51"/>
                    </a:cubicBezTo>
                    <a:cubicBezTo>
                      <a:pt x="120" y="17"/>
                      <a:pt x="177" y="0"/>
                      <a:pt x="250" y="0"/>
                    </a:cubicBezTo>
                    <a:cubicBezTo>
                      <a:pt x="322" y="0"/>
                      <a:pt x="379" y="17"/>
                      <a:pt x="421" y="51"/>
                    </a:cubicBezTo>
                    <a:cubicBezTo>
                      <a:pt x="462" y="85"/>
                      <a:pt x="483" y="131"/>
                      <a:pt x="483" y="189"/>
                    </a:cubicBezTo>
                    <a:cubicBezTo>
                      <a:pt x="483" y="231"/>
                      <a:pt x="471" y="266"/>
                      <a:pt x="447" y="295"/>
                    </a:cubicBezTo>
                    <a:cubicBezTo>
                      <a:pt x="423" y="324"/>
                      <a:pt x="391" y="344"/>
                      <a:pt x="349" y="354"/>
                    </a:cubicBezTo>
                    <a:cubicBezTo>
                      <a:pt x="396" y="365"/>
                      <a:pt x="433" y="387"/>
                      <a:pt x="460" y="419"/>
                    </a:cubicBezTo>
                    <a:cubicBezTo>
                      <a:pt x="486" y="451"/>
                      <a:pt x="500" y="491"/>
                      <a:pt x="500" y="537"/>
                    </a:cubicBezTo>
                    <a:cubicBezTo>
                      <a:pt x="500" y="608"/>
                      <a:pt x="478" y="662"/>
                      <a:pt x="435" y="699"/>
                    </a:cubicBezTo>
                    <a:cubicBezTo>
                      <a:pt x="391" y="737"/>
                      <a:pt x="329" y="755"/>
                      <a:pt x="249" y="755"/>
                    </a:cubicBezTo>
                    <a:cubicBezTo>
                      <a:pt x="169" y="755"/>
                      <a:pt x="107" y="737"/>
                      <a:pt x="64" y="699"/>
                    </a:cubicBezTo>
                    <a:cubicBezTo>
                      <a:pt x="21" y="662"/>
                      <a:pt x="0" y="608"/>
                      <a:pt x="0" y="537"/>
                    </a:cubicBezTo>
                    <a:cubicBezTo>
                      <a:pt x="0" y="491"/>
                      <a:pt x="13" y="451"/>
                      <a:pt x="40" y="419"/>
                    </a:cubicBezTo>
                    <a:cubicBezTo>
                      <a:pt x="66" y="387"/>
                      <a:pt x="103" y="365"/>
                      <a:pt x="151" y="354"/>
                    </a:cubicBezTo>
                    <a:close/>
                    <a:moveTo>
                      <a:pt x="115" y="198"/>
                    </a:moveTo>
                    <a:cubicBezTo>
                      <a:pt x="115" y="236"/>
                      <a:pt x="126" y="266"/>
                      <a:pt x="150" y="287"/>
                    </a:cubicBezTo>
                    <a:cubicBezTo>
                      <a:pt x="174" y="308"/>
                      <a:pt x="207" y="318"/>
                      <a:pt x="250" y="318"/>
                    </a:cubicBezTo>
                    <a:cubicBezTo>
                      <a:pt x="292" y="318"/>
                      <a:pt x="325" y="308"/>
                      <a:pt x="349" y="287"/>
                    </a:cubicBezTo>
                    <a:cubicBezTo>
                      <a:pt x="373" y="266"/>
                      <a:pt x="385" y="236"/>
                      <a:pt x="385" y="198"/>
                    </a:cubicBezTo>
                    <a:cubicBezTo>
                      <a:pt x="385" y="160"/>
                      <a:pt x="373" y="131"/>
                      <a:pt x="349" y="110"/>
                    </a:cubicBezTo>
                    <a:cubicBezTo>
                      <a:pt x="325" y="89"/>
                      <a:pt x="292" y="78"/>
                      <a:pt x="250" y="78"/>
                    </a:cubicBezTo>
                    <a:cubicBezTo>
                      <a:pt x="207" y="78"/>
                      <a:pt x="174" y="89"/>
                      <a:pt x="150" y="110"/>
                    </a:cubicBezTo>
                    <a:cubicBezTo>
                      <a:pt x="126" y="131"/>
                      <a:pt x="115" y="160"/>
                      <a:pt x="115" y="19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4" name="Freeform 281">
                <a:extLst>
                  <a:ext uri="{FF2B5EF4-FFF2-40B4-BE49-F238E27FC236}">
                    <a16:creationId xmlns:a16="http://schemas.microsoft.com/office/drawing/2014/main" id="{EF4A3B4F-A65C-6B71-AAEC-06FD152844A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46350" y="4254500"/>
                <a:ext cx="130175" cy="109538"/>
              </a:xfrm>
              <a:custGeom>
                <a:avLst/>
                <a:gdLst>
                  <a:gd name="T0" fmla="*/ 81 w 729"/>
                  <a:gd name="T1" fmla="*/ 514 h 613"/>
                  <a:gd name="T2" fmla="*/ 648 w 729"/>
                  <a:gd name="T3" fmla="*/ 514 h 613"/>
                  <a:gd name="T4" fmla="*/ 648 w 729"/>
                  <a:gd name="T5" fmla="*/ 395 h 613"/>
                  <a:gd name="T6" fmla="*/ 580 w 729"/>
                  <a:gd name="T7" fmla="*/ 174 h 613"/>
                  <a:gd name="T8" fmla="*/ 364 w 729"/>
                  <a:gd name="T9" fmla="*/ 104 h 613"/>
                  <a:gd name="T10" fmla="*/ 149 w 729"/>
                  <a:gd name="T11" fmla="*/ 174 h 613"/>
                  <a:gd name="T12" fmla="*/ 81 w 729"/>
                  <a:gd name="T13" fmla="*/ 395 h 613"/>
                  <a:gd name="T14" fmla="*/ 81 w 729"/>
                  <a:gd name="T15" fmla="*/ 514 h 613"/>
                  <a:gd name="T16" fmla="*/ 0 w 729"/>
                  <a:gd name="T17" fmla="*/ 613 h 613"/>
                  <a:gd name="T18" fmla="*/ 0 w 729"/>
                  <a:gd name="T19" fmla="*/ 410 h 613"/>
                  <a:gd name="T20" fmla="*/ 88 w 729"/>
                  <a:gd name="T21" fmla="*/ 99 h 613"/>
                  <a:gd name="T22" fmla="*/ 364 w 729"/>
                  <a:gd name="T23" fmla="*/ 0 h 613"/>
                  <a:gd name="T24" fmla="*/ 641 w 729"/>
                  <a:gd name="T25" fmla="*/ 100 h 613"/>
                  <a:gd name="T26" fmla="*/ 729 w 729"/>
                  <a:gd name="T27" fmla="*/ 410 h 613"/>
                  <a:gd name="T28" fmla="*/ 729 w 729"/>
                  <a:gd name="T29" fmla="*/ 613 h 613"/>
                  <a:gd name="T30" fmla="*/ 0 w 729"/>
                  <a:gd name="T31" fmla="*/ 613 h 6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729" h="613">
                    <a:moveTo>
                      <a:pt x="81" y="514"/>
                    </a:moveTo>
                    <a:lnTo>
                      <a:pt x="648" y="514"/>
                    </a:lnTo>
                    <a:lnTo>
                      <a:pt x="648" y="395"/>
                    </a:lnTo>
                    <a:cubicBezTo>
                      <a:pt x="648" y="295"/>
                      <a:pt x="626" y="221"/>
                      <a:pt x="580" y="174"/>
                    </a:cubicBezTo>
                    <a:cubicBezTo>
                      <a:pt x="534" y="128"/>
                      <a:pt x="462" y="104"/>
                      <a:pt x="364" y="104"/>
                    </a:cubicBezTo>
                    <a:cubicBezTo>
                      <a:pt x="266" y="104"/>
                      <a:pt x="195" y="128"/>
                      <a:pt x="149" y="174"/>
                    </a:cubicBezTo>
                    <a:cubicBezTo>
                      <a:pt x="104" y="221"/>
                      <a:pt x="81" y="295"/>
                      <a:pt x="81" y="395"/>
                    </a:cubicBezTo>
                    <a:lnTo>
                      <a:pt x="81" y="514"/>
                    </a:lnTo>
                    <a:close/>
                    <a:moveTo>
                      <a:pt x="0" y="613"/>
                    </a:moveTo>
                    <a:lnTo>
                      <a:pt x="0" y="410"/>
                    </a:lnTo>
                    <a:cubicBezTo>
                      <a:pt x="0" y="269"/>
                      <a:pt x="30" y="165"/>
                      <a:pt x="88" y="99"/>
                    </a:cubicBezTo>
                    <a:cubicBezTo>
                      <a:pt x="147" y="33"/>
                      <a:pt x="239" y="0"/>
                      <a:pt x="364" y="0"/>
                    </a:cubicBezTo>
                    <a:cubicBezTo>
                      <a:pt x="490" y="0"/>
                      <a:pt x="582" y="34"/>
                      <a:pt x="641" y="100"/>
                    </a:cubicBezTo>
                    <a:cubicBezTo>
                      <a:pt x="700" y="166"/>
                      <a:pt x="729" y="270"/>
                      <a:pt x="729" y="410"/>
                    </a:cubicBezTo>
                    <a:lnTo>
                      <a:pt x="729" y="613"/>
                    </a:lnTo>
                    <a:lnTo>
                      <a:pt x="0" y="613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5" name="Freeform 282">
                <a:extLst>
                  <a:ext uri="{FF2B5EF4-FFF2-40B4-BE49-F238E27FC236}">
                    <a16:creationId xmlns:a16="http://schemas.microsoft.com/office/drawing/2014/main" id="{8D4BE513-48AA-0D7D-D322-6DE749F2045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40000" y="4210050"/>
                <a:ext cx="136525" cy="15875"/>
              </a:xfrm>
              <a:custGeom>
                <a:avLst/>
                <a:gdLst>
                  <a:gd name="T0" fmla="*/ 213 w 760"/>
                  <a:gd name="T1" fmla="*/ 90 h 90"/>
                  <a:gd name="T2" fmla="*/ 213 w 760"/>
                  <a:gd name="T3" fmla="*/ 0 h 90"/>
                  <a:gd name="T4" fmla="*/ 760 w 760"/>
                  <a:gd name="T5" fmla="*/ 0 h 90"/>
                  <a:gd name="T6" fmla="*/ 760 w 760"/>
                  <a:gd name="T7" fmla="*/ 90 h 90"/>
                  <a:gd name="T8" fmla="*/ 213 w 760"/>
                  <a:gd name="T9" fmla="*/ 90 h 90"/>
                  <a:gd name="T10" fmla="*/ 0 w 760"/>
                  <a:gd name="T11" fmla="*/ 90 h 90"/>
                  <a:gd name="T12" fmla="*/ 0 w 760"/>
                  <a:gd name="T13" fmla="*/ 0 h 90"/>
                  <a:gd name="T14" fmla="*/ 114 w 760"/>
                  <a:gd name="T15" fmla="*/ 0 h 90"/>
                  <a:gd name="T16" fmla="*/ 114 w 760"/>
                  <a:gd name="T17" fmla="*/ 90 h 90"/>
                  <a:gd name="T18" fmla="*/ 0 w 760"/>
                  <a:gd name="T19" fmla="*/ 9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760" h="90">
                    <a:moveTo>
                      <a:pt x="213" y="90"/>
                    </a:moveTo>
                    <a:lnTo>
                      <a:pt x="213" y="0"/>
                    </a:lnTo>
                    <a:lnTo>
                      <a:pt x="760" y="0"/>
                    </a:lnTo>
                    <a:lnTo>
                      <a:pt x="760" y="90"/>
                    </a:lnTo>
                    <a:lnTo>
                      <a:pt x="213" y="90"/>
                    </a:lnTo>
                    <a:close/>
                    <a:moveTo>
                      <a:pt x="0" y="90"/>
                    </a:moveTo>
                    <a:lnTo>
                      <a:pt x="0" y="0"/>
                    </a:lnTo>
                    <a:lnTo>
                      <a:pt x="114" y="0"/>
                    </a:lnTo>
                    <a:lnTo>
                      <a:pt x="114" y="90"/>
                    </a:lnTo>
                    <a:lnTo>
                      <a:pt x="0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6" name="Freeform 283">
                <a:extLst>
                  <a:ext uri="{FF2B5EF4-FFF2-40B4-BE49-F238E27FC236}">
                    <a16:creationId xmlns:a16="http://schemas.microsoft.com/office/drawing/2014/main" id="{B8756631-B735-6FD5-E6E3-0381E48DACE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6513" y="4105275"/>
                <a:ext cx="103188" cy="77788"/>
              </a:xfrm>
              <a:custGeom>
                <a:avLst/>
                <a:gdLst>
                  <a:gd name="T0" fmla="*/ 34 w 573"/>
                  <a:gd name="T1" fmla="*/ 0 h 433"/>
                  <a:gd name="T2" fmla="*/ 118 w 573"/>
                  <a:gd name="T3" fmla="*/ 0 h 433"/>
                  <a:gd name="T4" fmla="*/ 87 w 573"/>
                  <a:gd name="T5" fmla="*/ 77 h 433"/>
                  <a:gd name="T6" fmla="*/ 76 w 573"/>
                  <a:gd name="T7" fmla="*/ 154 h 433"/>
                  <a:gd name="T8" fmla="*/ 132 w 573"/>
                  <a:gd name="T9" fmla="*/ 290 h 433"/>
                  <a:gd name="T10" fmla="*/ 287 w 573"/>
                  <a:gd name="T11" fmla="*/ 338 h 433"/>
                  <a:gd name="T12" fmla="*/ 443 w 573"/>
                  <a:gd name="T13" fmla="*/ 290 h 433"/>
                  <a:gd name="T14" fmla="*/ 498 w 573"/>
                  <a:gd name="T15" fmla="*/ 154 h 433"/>
                  <a:gd name="T16" fmla="*/ 488 w 573"/>
                  <a:gd name="T17" fmla="*/ 77 h 433"/>
                  <a:gd name="T18" fmla="*/ 456 w 573"/>
                  <a:gd name="T19" fmla="*/ 0 h 433"/>
                  <a:gd name="T20" fmla="*/ 539 w 573"/>
                  <a:gd name="T21" fmla="*/ 0 h 433"/>
                  <a:gd name="T22" fmla="*/ 565 w 573"/>
                  <a:gd name="T23" fmla="*/ 78 h 433"/>
                  <a:gd name="T24" fmla="*/ 573 w 573"/>
                  <a:gd name="T25" fmla="*/ 164 h 433"/>
                  <a:gd name="T26" fmla="*/ 496 w 573"/>
                  <a:gd name="T27" fmla="*/ 360 h 433"/>
                  <a:gd name="T28" fmla="*/ 287 w 573"/>
                  <a:gd name="T29" fmla="*/ 433 h 433"/>
                  <a:gd name="T30" fmla="*/ 77 w 573"/>
                  <a:gd name="T31" fmla="*/ 360 h 433"/>
                  <a:gd name="T32" fmla="*/ 0 w 573"/>
                  <a:gd name="T33" fmla="*/ 158 h 433"/>
                  <a:gd name="T34" fmla="*/ 9 w 573"/>
                  <a:gd name="T35" fmla="*/ 77 h 433"/>
                  <a:gd name="T36" fmla="*/ 34 w 573"/>
                  <a:gd name="T37" fmla="*/ 0 h 4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573" h="433">
                    <a:moveTo>
                      <a:pt x="34" y="0"/>
                    </a:moveTo>
                    <a:lnTo>
                      <a:pt x="118" y="0"/>
                    </a:lnTo>
                    <a:cubicBezTo>
                      <a:pt x="104" y="26"/>
                      <a:pt x="94" y="51"/>
                      <a:pt x="87" y="77"/>
                    </a:cubicBezTo>
                    <a:cubicBezTo>
                      <a:pt x="80" y="103"/>
                      <a:pt x="76" y="128"/>
                      <a:pt x="76" y="154"/>
                    </a:cubicBezTo>
                    <a:cubicBezTo>
                      <a:pt x="76" y="212"/>
                      <a:pt x="95" y="258"/>
                      <a:pt x="132" y="290"/>
                    </a:cubicBezTo>
                    <a:cubicBezTo>
                      <a:pt x="169" y="322"/>
                      <a:pt x="221" y="338"/>
                      <a:pt x="287" y="338"/>
                    </a:cubicBezTo>
                    <a:cubicBezTo>
                      <a:pt x="354" y="338"/>
                      <a:pt x="406" y="322"/>
                      <a:pt x="443" y="290"/>
                    </a:cubicBezTo>
                    <a:cubicBezTo>
                      <a:pt x="480" y="258"/>
                      <a:pt x="498" y="212"/>
                      <a:pt x="498" y="154"/>
                    </a:cubicBezTo>
                    <a:cubicBezTo>
                      <a:pt x="498" y="128"/>
                      <a:pt x="495" y="103"/>
                      <a:pt x="488" y="77"/>
                    </a:cubicBezTo>
                    <a:cubicBezTo>
                      <a:pt x="481" y="51"/>
                      <a:pt x="470" y="26"/>
                      <a:pt x="456" y="0"/>
                    </a:cubicBezTo>
                    <a:lnTo>
                      <a:pt x="539" y="0"/>
                    </a:lnTo>
                    <a:cubicBezTo>
                      <a:pt x="551" y="26"/>
                      <a:pt x="560" y="52"/>
                      <a:pt x="565" y="78"/>
                    </a:cubicBezTo>
                    <a:cubicBezTo>
                      <a:pt x="570" y="105"/>
                      <a:pt x="573" y="134"/>
                      <a:pt x="573" y="164"/>
                    </a:cubicBezTo>
                    <a:cubicBezTo>
                      <a:pt x="573" y="246"/>
                      <a:pt x="548" y="312"/>
                      <a:pt x="496" y="360"/>
                    </a:cubicBezTo>
                    <a:cubicBezTo>
                      <a:pt x="445" y="409"/>
                      <a:pt x="375" y="433"/>
                      <a:pt x="287" y="433"/>
                    </a:cubicBezTo>
                    <a:cubicBezTo>
                      <a:pt x="198" y="433"/>
                      <a:pt x="128" y="409"/>
                      <a:pt x="77" y="360"/>
                    </a:cubicBezTo>
                    <a:cubicBezTo>
                      <a:pt x="26" y="311"/>
                      <a:pt x="0" y="244"/>
                      <a:pt x="0" y="158"/>
                    </a:cubicBezTo>
                    <a:cubicBezTo>
                      <a:pt x="0" y="130"/>
                      <a:pt x="3" y="103"/>
                      <a:pt x="9" y="77"/>
                    </a:cubicBezTo>
                    <a:cubicBezTo>
                      <a:pt x="15" y="51"/>
                      <a:pt x="23" y="25"/>
                      <a:pt x="34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7" name="Freeform 284">
                <a:extLst>
                  <a:ext uri="{FF2B5EF4-FFF2-40B4-BE49-F238E27FC236}">
                    <a16:creationId xmlns:a16="http://schemas.microsoft.com/office/drawing/2014/main" id="{DCEE1E57-9E46-C507-347D-D6E42D7FC4D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3992563"/>
                <a:ext cx="103188" cy="92075"/>
              </a:xfrm>
              <a:custGeom>
                <a:avLst/>
                <a:gdLst>
                  <a:gd name="T0" fmla="*/ 264 w 573"/>
                  <a:gd name="T1" fmla="*/ 0 h 507"/>
                  <a:gd name="T2" fmla="*/ 308 w 573"/>
                  <a:gd name="T3" fmla="*/ 0 h 507"/>
                  <a:gd name="T4" fmla="*/ 308 w 573"/>
                  <a:gd name="T5" fmla="*/ 413 h 507"/>
                  <a:gd name="T6" fmla="*/ 450 w 573"/>
                  <a:gd name="T7" fmla="*/ 357 h 507"/>
                  <a:gd name="T8" fmla="*/ 498 w 573"/>
                  <a:gd name="T9" fmla="*/ 218 h 507"/>
                  <a:gd name="T10" fmla="*/ 486 w 573"/>
                  <a:gd name="T11" fmla="*/ 118 h 507"/>
                  <a:gd name="T12" fmla="*/ 447 w 573"/>
                  <a:gd name="T13" fmla="*/ 21 h 507"/>
                  <a:gd name="T14" fmla="*/ 532 w 573"/>
                  <a:gd name="T15" fmla="*/ 21 h 507"/>
                  <a:gd name="T16" fmla="*/ 563 w 573"/>
                  <a:gd name="T17" fmla="*/ 120 h 507"/>
                  <a:gd name="T18" fmla="*/ 573 w 573"/>
                  <a:gd name="T19" fmla="*/ 223 h 507"/>
                  <a:gd name="T20" fmla="*/ 498 w 573"/>
                  <a:gd name="T21" fmla="*/ 431 h 507"/>
                  <a:gd name="T22" fmla="*/ 292 w 573"/>
                  <a:gd name="T23" fmla="*/ 507 h 507"/>
                  <a:gd name="T24" fmla="*/ 79 w 573"/>
                  <a:gd name="T25" fmla="*/ 435 h 507"/>
                  <a:gd name="T26" fmla="*/ 0 w 573"/>
                  <a:gd name="T27" fmla="*/ 239 h 507"/>
                  <a:gd name="T28" fmla="*/ 71 w 573"/>
                  <a:gd name="T29" fmla="*/ 64 h 507"/>
                  <a:gd name="T30" fmla="*/ 264 w 573"/>
                  <a:gd name="T31" fmla="*/ 0 h 507"/>
                  <a:gd name="T32" fmla="*/ 238 w 573"/>
                  <a:gd name="T33" fmla="*/ 90 h 507"/>
                  <a:gd name="T34" fmla="*/ 120 w 573"/>
                  <a:gd name="T35" fmla="*/ 131 h 507"/>
                  <a:gd name="T36" fmla="*/ 76 w 573"/>
                  <a:gd name="T37" fmla="*/ 238 h 507"/>
                  <a:gd name="T38" fmla="*/ 119 w 573"/>
                  <a:gd name="T39" fmla="*/ 358 h 507"/>
                  <a:gd name="T40" fmla="*/ 238 w 573"/>
                  <a:gd name="T41" fmla="*/ 410 h 507"/>
                  <a:gd name="T42" fmla="*/ 238 w 573"/>
                  <a:gd name="T43" fmla="*/ 90 h 5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73" h="507">
                    <a:moveTo>
                      <a:pt x="264" y="0"/>
                    </a:moveTo>
                    <a:lnTo>
                      <a:pt x="308" y="0"/>
                    </a:lnTo>
                    <a:lnTo>
                      <a:pt x="308" y="413"/>
                    </a:lnTo>
                    <a:cubicBezTo>
                      <a:pt x="370" y="409"/>
                      <a:pt x="418" y="391"/>
                      <a:pt x="450" y="357"/>
                    </a:cubicBezTo>
                    <a:cubicBezTo>
                      <a:pt x="482" y="324"/>
                      <a:pt x="498" y="278"/>
                      <a:pt x="498" y="218"/>
                    </a:cubicBezTo>
                    <a:cubicBezTo>
                      <a:pt x="498" y="184"/>
                      <a:pt x="494" y="150"/>
                      <a:pt x="486" y="118"/>
                    </a:cubicBezTo>
                    <a:cubicBezTo>
                      <a:pt x="478" y="86"/>
                      <a:pt x="465" y="53"/>
                      <a:pt x="447" y="21"/>
                    </a:cubicBezTo>
                    <a:lnTo>
                      <a:pt x="532" y="21"/>
                    </a:lnTo>
                    <a:cubicBezTo>
                      <a:pt x="546" y="53"/>
                      <a:pt x="557" y="86"/>
                      <a:pt x="563" y="120"/>
                    </a:cubicBezTo>
                    <a:cubicBezTo>
                      <a:pt x="569" y="154"/>
                      <a:pt x="573" y="189"/>
                      <a:pt x="573" y="223"/>
                    </a:cubicBezTo>
                    <a:cubicBezTo>
                      <a:pt x="573" y="311"/>
                      <a:pt x="548" y="380"/>
                      <a:pt x="498" y="431"/>
                    </a:cubicBezTo>
                    <a:cubicBezTo>
                      <a:pt x="448" y="482"/>
                      <a:pt x="379" y="507"/>
                      <a:pt x="292" y="507"/>
                    </a:cubicBezTo>
                    <a:cubicBezTo>
                      <a:pt x="203" y="507"/>
                      <a:pt x="132" y="483"/>
                      <a:pt x="79" y="435"/>
                    </a:cubicBezTo>
                    <a:cubicBezTo>
                      <a:pt x="27" y="387"/>
                      <a:pt x="0" y="321"/>
                      <a:pt x="0" y="239"/>
                    </a:cubicBezTo>
                    <a:cubicBezTo>
                      <a:pt x="0" y="165"/>
                      <a:pt x="24" y="107"/>
                      <a:pt x="71" y="64"/>
                    </a:cubicBezTo>
                    <a:cubicBezTo>
                      <a:pt x="119" y="22"/>
                      <a:pt x="183" y="0"/>
                      <a:pt x="264" y="0"/>
                    </a:cubicBezTo>
                    <a:close/>
                    <a:moveTo>
                      <a:pt x="238" y="90"/>
                    </a:moveTo>
                    <a:cubicBezTo>
                      <a:pt x="189" y="91"/>
                      <a:pt x="150" y="105"/>
                      <a:pt x="120" y="131"/>
                    </a:cubicBezTo>
                    <a:cubicBezTo>
                      <a:pt x="91" y="158"/>
                      <a:pt x="76" y="194"/>
                      <a:pt x="76" y="238"/>
                    </a:cubicBezTo>
                    <a:cubicBezTo>
                      <a:pt x="76" y="288"/>
                      <a:pt x="91" y="328"/>
                      <a:pt x="119" y="358"/>
                    </a:cubicBezTo>
                    <a:cubicBezTo>
                      <a:pt x="147" y="388"/>
                      <a:pt x="187" y="406"/>
                      <a:pt x="238" y="410"/>
                    </a:cubicBezTo>
                    <a:lnTo>
                      <a:pt x="238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8" name="Freeform 285">
                <a:extLst>
                  <a:ext uri="{FF2B5EF4-FFF2-40B4-BE49-F238E27FC236}">
                    <a16:creationId xmlns:a16="http://schemas.microsoft.com/office/drawing/2014/main" id="{F44B9FA0-1F89-DF8E-AF11-A2CCA750A3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0000" y="3870325"/>
                <a:ext cx="160338" cy="39688"/>
              </a:xfrm>
              <a:custGeom>
                <a:avLst/>
                <a:gdLst>
                  <a:gd name="T0" fmla="*/ 0 w 890"/>
                  <a:gd name="T1" fmla="*/ 0 h 224"/>
                  <a:gd name="T2" fmla="*/ 223 w 890"/>
                  <a:gd name="T3" fmla="*/ 97 h 224"/>
                  <a:gd name="T4" fmla="*/ 445 w 890"/>
                  <a:gd name="T5" fmla="*/ 129 h 224"/>
                  <a:gd name="T6" fmla="*/ 668 w 890"/>
                  <a:gd name="T7" fmla="*/ 97 h 224"/>
                  <a:gd name="T8" fmla="*/ 890 w 890"/>
                  <a:gd name="T9" fmla="*/ 0 h 224"/>
                  <a:gd name="T10" fmla="*/ 890 w 890"/>
                  <a:gd name="T11" fmla="*/ 78 h 224"/>
                  <a:gd name="T12" fmla="*/ 665 w 890"/>
                  <a:gd name="T13" fmla="*/ 188 h 224"/>
                  <a:gd name="T14" fmla="*/ 445 w 890"/>
                  <a:gd name="T15" fmla="*/ 224 h 224"/>
                  <a:gd name="T16" fmla="*/ 226 w 890"/>
                  <a:gd name="T17" fmla="*/ 188 h 224"/>
                  <a:gd name="T18" fmla="*/ 0 w 890"/>
                  <a:gd name="T19" fmla="*/ 78 h 224"/>
                  <a:gd name="T20" fmla="*/ 0 w 890"/>
                  <a:gd name="T21" fmla="*/ 0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890" h="224">
                    <a:moveTo>
                      <a:pt x="0" y="0"/>
                    </a:moveTo>
                    <a:cubicBezTo>
                      <a:pt x="76" y="44"/>
                      <a:pt x="150" y="76"/>
                      <a:pt x="223" y="97"/>
                    </a:cubicBezTo>
                    <a:cubicBezTo>
                      <a:pt x="296" y="119"/>
                      <a:pt x="370" y="129"/>
                      <a:pt x="445" y="129"/>
                    </a:cubicBezTo>
                    <a:cubicBezTo>
                      <a:pt x="521" y="129"/>
                      <a:pt x="595" y="119"/>
                      <a:pt x="668" y="97"/>
                    </a:cubicBezTo>
                    <a:cubicBezTo>
                      <a:pt x="742" y="76"/>
                      <a:pt x="815" y="44"/>
                      <a:pt x="890" y="0"/>
                    </a:cubicBezTo>
                    <a:lnTo>
                      <a:pt x="890" y="78"/>
                    </a:lnTo>
                    <a:cubicBezTo>
                      <a:pt x="813" y="127"/>
                      <a:pt x="739" y="164"/>
                      <a:pt x="665" y="188"/>
                    </a:cubicBezTo>
                    <a:cubicBezTo>
                      <a:pt x="591" y="212"/>
                      <a:pt x="518" y="224"/>
                      <a:pt x="445" y="224"/>
                    </a:cubicBezTo>
                    <a:cubicBezTo>
                      <a:pt x="373" y="224"/>
                      <a:pt x="300" y="212"/>
                      <a:pt x="226" y="188"/>
                    </a:cubicBezTo>
                    <a:cubicBezTo>
                      <a:pt x="152" y="164"/>
                      <a:pt x="77" y="128"/>
                      <a:pt x="0" y="78"/>
                    </a:cubicBez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9" name="Freeform 286">
                <a:extLst>
                  <a:ext uri="{FF2B5EF4-FFF2-40B4-BE49-F238E27FC236}">
                    <a16:creationId xmlns:a16="http://schemas.microsoft.com/office/drawing/2014/main" id="{9E2E9242-1014-E3D7-8AC3-EAC4BF4E923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3760788"/>
                <a:ext cx="103188" cy="84138"/>
              </a:xfrm>
              <a:custGeom>
                <a:avLst/>
                <a:gdLst>
                  <a:gd name="T0" fmla="*/ 285 w 573"/>
                  <a:gd name="T1" fmla="*/ 179 h 462"/>
                  <a:gd name="T2" fmla="*/ 310 w 573"/>
                  <a:gd name="T3" fmla="*/ 330 h 462"/>
                  <a:gd name="T4" fmla="*/ 395 w 573"/>
                  <a:gd name="T5" fmla="*/ 372 h 462"/>
                  <a:gd name="T6" fmla="*/ 471 w 573"/>
                  <a:gd name="T7" fmla="*/ 341 h 462"/>
                  <a:gd name="T8" fmla="*/ 499 w 573"/>
                  <a:gd name="T9" fmla="*/ 255 h 462"/>
                  <a:gd name="T10" fmla="*/ 446 w 573"/>
                  <a:gd name="T11" fmla="*/ 135 h 462"/>
                  <a:gd name="T12" fmla="*/ 305 w 573"/>
                  <a:gd name="T13" fmla="*/ 90 h 462"/>
                  <a:gd name="T14" fmla="*/ 285 w 573"/>
                  <a:gd name="T15" fmla="*/ 90 h 462"/>
                  <a:gd name="T16" fmla="*/ 285 w 573"/>
                  <a:gd name="T17" fmla="*/ 179 h 462"/>
                  <a:gd name="T18" fmla="*/ 248 w 573"/>
                  <a:gd name="T19" fmla="*/ 0 h 462"/>
                  <a:gd name="T20" fmla="*/ 560 w 573"/>
                  <a:gd name="T21" fmla="*/ 0 h 462"/>
                  <a:gd name="T22" fmla="*/ 560 w 573"/>
                  <a:gd name="T23" fmla="*/ 90 h 462"/>
                  <a:gd name="T24" fmla="*/ 477 w 573"/>
                  <a:gd name="T25" fmla="*/ 90 h 462"/>
                  <a:gd name="T26" fmla="*/ 550 w 573"/>
                  <a:gd name="T27" fmla="*/ 167 h 462"/>
                  <a:gd name="T28" fmla="*/ 573 w 573"/>
                  <a:gd name="T29" fmla="*/ 279 h 462"/>
                  <a:gd name="T30" fmla="*/ 527 w 573"/>
                  <a:gd name="T31" fmla="*/ 413 h 462"/>
                  <a:gd name="T32" fmla="*/ 401 w 573"/>
                  <a:gd name="T33" fmla="*/ 462 h 462"/>
                  <a:gd name="T34" fmla="*/ 262 w 573"/>
                  <a:gd name="T35" fmla="*/ 400 h 462"/>
                  <a:gd name="T36" fmla="*/ 215 w 573"/>
                  <a:gd name="T37" fmla="*/ 216 h 462"/>
                  <a:gd name="T38" fmla="*/ 215 w 573"/>
                  <a:gd name="T39" fmla="*/ 90 h 462"/>
                  <a:gd name="T40" fmla="*/ 206 w 573"/>
                  <a:gd name="T41" fmla="*/ 90 h 462"/>
                  <a:gd name="T42" fmla="*/ 110 w 573"/>
                  <a:gd name="T43" fmla="*/ 131 h 462"/>
                  <a:gd name="T44" fmla="*/ 76 w 573"/>
                  <a:gd name="T45" fmla="*/ 245 h 462"/>
                  <a:gd name="T46" fmla="*/ 88 w 573"/>
                  <a:gd name="T47" fmla="*/ 337 h 462"/>
                  <a:gd name="T48" fmla="*/ 121 w 573"/>
                  <a:gd name="T49" fmla="*/ 422 h 462"/>
                  <a:gd name="T50" fmla="*/ 38 w 573"/>
                  <a:gd name="T51" fmla="*/ 422 h 462"/>
                  <a:gd name="T52" fmla="*/ 10 w 573"/>
                  <a:gd name="T53" fmla="*/ 327 h 462"/>
                  <a:gd name="T54" fmla="*/ 0 w 573"/>
                  <a:gd name="T55" fmla="*/ 236 h 462"/>
                  <a:gd name="T56" fmla="*/ 62 w 573"/>
                  <a:gd name="T57" fmla="*/ 59 h 462"/>
                  <a:gd name="T58" fmla="*/ 248 w 573"/>
                  <a:gd name="T59" fmla="*/ 0 h 4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573" h="462">
                    <a:moveTo>
                      <a:pt x="285" y="179"/>
                    </a:moveTo>
                    <a:cubicBezTo>
                      <a:pt x="285" y="252"/>
                      <a:pt x="294" y="302"/>
                      <a:pt x="310" y="330"/>
                    </a:cubicBezTo>
                    <a:cubicBezTo>
                      <a:pt x="327" y="358"/>
                      <a:pt x="355" y="372"/>
                      <a:pt x="395" y="372"/>
                    </a:cubicBezTo>
                    <a:cubicBezTo>
                      <a:pt x="427" y="372"/>
                      <a:pt x="453" y="362"/>
                      <a:pt x="471" y="341"/>
                    </a:cubicBezTo>
                    <a:cubicBezTo>
                      <a:pt x="490" y="320"/>
                      <a:pt x="499" y="291"/>
                      <a:pt x="499" y="255"/>
                    </a:cubicBezTo>
                    <a:cubicBezTo>
                      <a:pt x="499" y="205"/>
                      <a:pt x="482" y="165"/>
                      <a:pt x="446" y="135"/>
                    </a:cubicBezTo>
                    <a:cubicBezTo>
                      <a:pt x="411" y="105"/>
                      <a:pt x="364" y="90"/>
                      <a:pt x="305" y="90"/>
                    </a:cubicBezTo>
                    <a:lnTo>
                      <a:pt x="285" y="90"/>
                    </a:lnTo>
                    <a:lnTo>
                      <a:pt x="285" y="179"/>
                    </a:lnTo>
                    <a:close/>
                    <a:moveTo>
                      <a:pt x="248" y="0"/>
                    </a:moveTo>
                    <a:lnTo>
                      <a:pt x="560" y="0"/>
                    </a:lnTo>
                    <a:lnTo>
                      <a:pt x="560" y="90"/>
                    </a:lnTo>
                    <a:lnTo>
                      <a:pt x="477" y="90"/>
                    </a:lnTo>
                    <a:cubicBezTo>
                      <a:pt x="511" y="111"/>
                      <a:pt x="535" y="137"/>
                      <a:pt x="550" y="167"/>
                    </a:cubicBezTo>
                    <a:cubicBezTo>
                      <a:pt x="565" y="197"/>
                      <a:pt x="573" y="235"/>
                      <a:pt x="573" y="279"/>
                    </a:cubicBezTo>
                    <a:cubicBezTo>
                      <a:pt x="573" y="335"/>
                      <a:pt x="558" y="380"/>
                      <a:pt x="527" y="413"/>
                    </a:cubicBezTo>
                    <a:cubicBezTo>
                      <a:pt x="496" y="446"/>
                      <a:pt x="454" y="462"/>
                      <a:pt x="401" y="462"/>
                    </a:cubicBezTo>
                    <a:cubicBezTo>
                      <a:pt x="340" y="462"/>
                      <a:pt x="294" y="442"/>
                      <a:pt x="262" y="400"/>
                    </a:cubicBezTo>
                    <a:cubicBezTo>
                      <a:pt x="231" y="359"/>
                      <a:pt x="215" y="298"/>
                      <a:pt x="215" y="216"/>
                    </a:cubicBezTo>
                    <a:lnTo>
                      <a:pt x="215" y="90"/>
                    </a:lnTo>
                    <a:lnTo>
                      <a:pt x="206" y="90"/>
                    </a:lnTo>
                    <a:cubicBezTo>
                      <a:pt x="165" y="90"/>
                      <a:pt x="133" y="104"/>
                      <a:pt x="110" y="131"/>
                    </a:cubicBezTo>
                    <a:cubicBezTo>
                      <a:pt x="88" y="158"/>
                      <a:pt x="76" y="196"/>
                      <a:pt x="76" y="245"/>
                    </a:cubicBezTo>
                    <a:cubicBezTo>
                      <a:pt x="76" y="277"/>
                      <a:pt x="80" y="307"/>
                      <a:pt x="88" y="337"/>
                    </a:cubicBezTo>
                    <a:cubicBezTo>
                      <a:pt x="96" y="367"/>
                      <a:pt x="107" y="395"/>
                      <a:pt x="121" y="422"/>
                    </a:cubicBezTo>
                    <a:lnTo>
                      <a:pt x="38" y="422"/>
                    </a:lnTo>
                    <a:cubicBezTo>
                      <a:pt x="26" y="390"/>
                      <a:pt x="16" y="358"/>
                      <a:pt x="10" y="327"/>
                    </a:cubicBezTo>
                    <a:cubicBezTo>
                      <a:pt x="4" y="296"/>
                      <a:pt x="0" y="266"/>
                      <a:pt x="0" y="236"/>
                    </a:cubicBezTo>
                    <a:cubicBezTo>
                      <a:pt x="0" y="157"/>
                      <a:pt x="21" y="98"/>
                      <a:pt x="62" y="59"/>
                    </a:cubicBezTo>
                    <a:cubicBezTo>
                      <a:pt x="103" y="20"/>
                      <a:pt x="165" y="0"/>
                      <a:pt x="248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0" name="Rectangle 287">
                <a:extLst>
                  <a:ext uri="{FF2B5EF4-FFF2-40B4-BE49-F238E27FC236}">
                    <a16:creationId xmlns:a16="http://schemas.microsoft.com/office/drawing/2014/main" id="{05DCEE4F-BE9E-C75E-17E9-DA1EE34E0F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54300" y="3706813"/>
                <a:ext cx="22225" cy="19050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1" name="Freeform 288">
                <a:extLst>
                  <a:ext uri="{FF2B5EF4-FFF2-40B4-BE49-F238E27FC236}">
                    <a16:creationId xmlns:a16="http://schemas.microsoft.com/office/drawing/2014/main" id="{26A2AF7B-FBC4-F435-7119-DF814262154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3589338"/>
                <a:ext cx="103188" cy="82550"/>
              </a:xfrm>
              <a:custGeom>
                <a:avLst/>
                <a:gdLst>
                  <a:gd name="T0" fmla="*/ 344 w 573"/>
                  <a:gd name="T1" fmla="*/ 458 h 458"/>
                  <a:gd name="T2" fmla="*/ 13 w 573"/>
                  <a:gd name="T3" fmla="*/ 458 h 458"/>
                  <a:gd name="T4" fmla="*/ 13 w 573"/>
                  <a:gd name="T5" fmla="*/ 368 h 458"/>
                  <a:gd name="T6" fmla="*/ 341 w 573"/>
                  <a:gd name="T7" fmla="*/ 368 h 458"/>
                  <a:gd name="T8" fmla="*/ 457 w 573"/>
                  <a:gd name="T9" fmla="*/ 338 h 458"/>
                  <a:gd name="T10" fmla="*/ 496 w 573"/>
                  <a:gd name="T11" fmla="*/ 247 h 458"/>
                  <a:gd name="T12" fmla="*/ 450 w 573"/>
                  <a:gd name="T13" fmla="*/ 132 h 458"/>
                  <a:gd name="T14" fmla="*/ 323 w 573"/>
                  <a:gd name="T15" fmla="*/ 90 h 458"/>
                  <a:gd name="T16" fmla="*/ 13 w 573"/>
                  <a:gd name="T17" fmla="*/ 90 h 458"/>
                  <a:gd name="T18" fmla="*/ 13 w 573"/>
                  <a:gd name="T19" fmla="*/ 0 h 458"/>
                  <a:gd name="T20" fmla="*/ 560 w 573"/>
                  <a:gd name="T21" fmla="*/ 0 h 458"/>
                  <a:gd name="T22" fmla="*/ 560 w 573"/>
                  <a:gd name="T23" fmla="*/ 90 h 458"/>
                  <a:gd name="T24" fmla="*/ 476 w 573"/>
                  <a:gd name="T25" fmla="*/ 90 h 458"/>
                  <a:gd name="T26" fmla="*/ 550 w 573"/>
                  <a:gd name="T27" fmla="*/ 166 h 458"/>
                  <a:gd name="T28" fmla="*/ 573 w 573"/>
                  <a:gd name="T29" fmla="*/ 266 h 458"/>
                  <a:gd name="T30" fmla="*/ 515 w 573"/>
                  <a:gd name="T31" fmla="*/ 409 h 458"/>
                  <a:gd name="T32" fmla="*/ 344 w 573"/>
                  <a:gd name="T33" fmla="*/ 458 h 458"/>
                  <a:gd name="T34" fmla="*/ 0 w 573"/>
                  <a:gd name="T35" fmla="*/ 232 h 458"/>
                  <a:gd name="T36" fmla="*/ 1 w 573"/>
                  <a:gd name="T37" fmla="*/ 232 h 458"/>
                  <a:gd name="T38" fmla="*/ 0 w 573"/>
                  <a:gd name="T39" fmla="*/ 232 h 4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573" h="458">
                    <a:moveTo>
                      <a:pt x="344" y="458"/>
                    </a:moveTo>
                    <a:lnTo>
                      <a:pt x="13" y="458"/>
                    </a:lnTo>
                    <a:lnTo>
                      <a:pt x="13" y="368"/>
                    </a:lnTo>
                    <a:lnTo>
                      <a:pt x="341" y="368"/>
                    </a:lnTo>
                    <a:cubicBezTo>
                      <a:pt x="393" y="368"/>
                      <a:pt x="431" y="358"/>
                      <a:pt x="457" y="338"/>
                    </a:cubicBezTo>
                    <a:cubicBezTo>
                      <a:pt x="483" y="318"/>
                      <a:pt x="496" y="288"/>
                      <a:pt x="496" y="247"/>
                    </a:cubicBezTo>
                    <a:cubicBezTo>
                      <a:pt x="496" y="199"/>
                      <a:pt x="481" y="160"/>
                      <a:pt x="450" y="132"/>
                    </a:cubicBezTo>
                    <a:cubicBezTo>
                      <a:pt x="419" y="104"/>
                      <a:pt x="377" y="90"/>
                      <a:pt x="323" y="90"/>
                    </a:cubicBezTo>
                    <a:lnTo>
                      <a:pt x="13" y="90"/>
                    </a:lnTo>
                    <a:lnTo>
                      <a:pt x="13" y="0"/>
                    </a:lnTo>
                    <a:lnTo>
                      <a:pt x="560" y="0"/>
                    </a:lnTo>
                    <a:lnTo>
                      <a:pt x="560" y="90"/>
                    </a:lnTo>
                    <a:lnTo>
                      <a:pt x="476" y="90"/>
                    </a:lnTo>
                    <a:cubicBezTo>
                      <a:pt x="510" y="112"/>
                      <a:pt x="534" y="138"/>
                      <a:pt x="550" y="166"/>
                    </a:cubicBezTo>
                    <a:cubicBezTo>
                      <a:pt x="565" y="195"/>
                      <a:pt x="573" y="228"/>
                      <a:pt x="573" y="266"/>
                    </a:cubicBezTo>
                    <a:cubicBezTo>
                      <a:pt x="573" y="329"/>
                      <a:pt x="554" y="377"/>
                      <a:pt x="515" y="409"/>
                    </a:cubicBezTo>
                    <a:cubicBezTo>
                      <a:pt x="477" y="442"/>
                      <a:pt x="420" y="458"/>
                      <a:pt x="344" y="458"/>
                    </a:cubicBezTo>
                    <a:close/>
                    <a:moveTo>
                      <a:pt x="0" y="232"/>
                    </a:moveTo>
                    <a:lnTo>
                      <a:pt x="1" y="232"/>
                    </a:lnTo>
                    <a:lnTo>
                      <a:pt x="0" y="232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2" name="Rectangle 289">
                <a:extLst>
                  <a:ext uri="{FF2B5EF4-FFF2-40B4-BE49-F238E27FC236}">
                    <a16:creationId xmlns:a16="http://schemas.microsoft.com/office/drawing/2014/main" id="{1B71D69B-C152-1469-FB88-73A7C87F6B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54300" y="3535363"/>
                <a:ext cx="22225" cy="17463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3" name="Freeform 290">
                <a:extLst>
                  <a:ext uri="{FF2B5EF4-FFF2-40B4-BE49-F238E27FC236}">
                    <a16:creationId xmlns:a16="http://schemas.microsoft.com/office/drawing/2014/main" id="{DEF3E802-A69A-E931-356F-5C85DD4B767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0000" y="3460750"/>
                <a:ext cx="160338" cy="39688"/>
              </a:xfrm>
              <a:custGeom>
                <a:avLst/>
                <a:gdLst>
                  <a:gd name="T0" fmla="*/ 0 w 890"/>
                  <a:gd name="T1" fmla="*/ 224 h 224"/>
                  <a:gd name="T2" fmla="*/ 0 w 890"/>
                  <a:gd name="T3" fmla="*/ 146 h 224"/>
                  <a:gd name="T4" fmla="*/ 226 w 890"/>
                  <a:gd name="T5" fmla="*/ 37 h 224"/>
                  <a:gd name="T6" fmla="*/ 445 w 890"/>
                  <a:gd name="T7" fmla="*/ 0 h 224"/>
                  <a:gd name="T8" fmla="*/ 665 w 890"/>
                  <a:gd name="T9" fmla="*/ 37 h 224"/>
                  <a:gd name="T10" fmla="*/ 890 w 890"/>
                  <a:gd name="T11" fmla="*/ 146 h 224"/>
                  <a:gd name="T12" fmla="*/ 890 w 890"/>
                  <a:gd name="T13" fmla="*/ 224 h 224"/>
                  <a:gd name="T14" fmla="*/ 668 w 890"/>
                  <a:gd name="T15" fmla="*/ 127 h 224"/>
                  <a:gd name="T16" fmla="*/ 445 w 890"/>
                  <a:gd name="T17" fmla="*/ 95 h 224"/>
                  <a:gd name="T18" fmla="*/ 223 w 890"/>
                  <a:gd name="T19" fmla="*/ 127 h 224"/>
                  <a:gd name="T20" fmla="*/ 0 w 890"/>
                  <a:gd name="T21" fmla="*/ 224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890" h="224">
                    <a:moveTo>
                      <a:pt x="0" y="224"/>
                    </a:moveTo>
                    <a:lnTo>
                      <a:pt x="0" y="146"/>
                    </a:lnTo>
                    <a:cubicBezTo>
                      <a:pt x="77" y="98"/>
                      <a:pt x="152" y="61"/>
                      <a:pt x="226" y="37"/>
                    </a:cubicBezTo>
                    <a:cubicBezTo>
                      <a:pt x="300" y="13"/>
                      <a:pt x="373" y="0"/>
                      <a:pt x="445" y="0"/>
                    </a:cubicBezTo>
                    <a:cubicBezTo>
                      <a:pt x="518" y="0"/>
                      <a:pt x="591" y="13"/>
                      <a:pt x="665" y="37"/>
                    </a:cubicBezTo>
                    <a:cubicBezTo>
                      <a:pt x="739" y="61"/>
                      <a:pt x="813" y="98"/>
                      <a:pt x="890" y="146"/>
                    </a:cubicBezTo>
                    <a:lnTo>
                      <a:pt x="890" y="224"/>
                    </a:lnTo>
                    <a:cubicBezTo>
                      <a:pt x="815" y="181"/>
                      <a:pt x="742" y="149"/>
                      <a:pt x="668" y="127"/>
                    </a:cubicBezTo>
                    <a:cubicBezTo>
                      <a:pt x="595" y="106"/>
                      <a:pt x="521" y="95"/>
                      <a:pt x="445" y="95"/>
                    </a:cubicBezTo>
                    <a:cubicBezTo>
                      <a:pt x="370" y="95"/>
                      <a:pt x="296" y="106"/>
                      <a:pt x="223" y="127"/>
                    </a:cubicBezTo>
                    <a:cubicBezTo>
                      <a:pt x="150" y="149"/>
                      <a:pt x="76" y="181"/>
                      <a:pt x="0" y="224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4" name="Freeform 291">
                <a:extLst>
                  <a:ext uri="{FF2B5EF4-FFF2-40B4-BE49-F238E27FC236}">
                    <a16:creationId xmlns:a16="http://schemas.microsoft.com/office/drawing/2014/main" id="{DBB04EE9-099B-86E2-97A7-717E1B6249E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44850" y="4476750"/>
                <a:ext cx="969963" cy="685800"/>
              </a:xfrm>
              <a:custGeom>
                <a:avLst/>
                <a:gdLst>
                  <a:gd name="T0" fmla="*/ 2659 w 5372"/>
                  <a:gd name="T1" fmla="*/ 3719 h 3795"/>
                  <a:gd name="T2" fmla="*/ 2567 w 5372"/>
                  <a:gd name="T3" fmla="*/ 3565 h 3795"/>
                  <a:gd name="T4" fmla="*/ 2436 w 5372"/>
                  <a:gd name="T5" fmla="*/ 3412 h 3795"/>
                  <a:gd name="T6" fmla="*/ 2413 w 5372"/>
                  <a:gd name="T7" fmla="*/ 3259 h 3795"/>
                  <a:gd name="T8" fmla="*/ 2492 w 5372"/>
                  <a:gd name="T9" fmla="*/ 3105 h 3795"/>
                  <a:gd name="T10" fmla="*/ 2485 w 5372"/>
                  <a:gd name="T11" fmla="*/ 2952 h 3795"/>
                  <a:gd name="T12" fmla="*/ 2293 w 5372"/>
                  <a:gd name="T13" fmla="*/ 2799 h 3795"/>
                  <a:gd name="T14" fmla="*/ 2072 w 5372"/>
                  <a:gd name="T15" fmla="*/ 2645 h 3795"/>
                  <a:gd name="T16" fmla="*/ 1898 w 5372"/>
                  <a:gd name="T17" fmla="*/ 2492 h 3795"/>
                  <a:gd name="T18" fmla="*/ 1542 w 5372"/>
                  <a:gd name="T19" fmla="*/ 2339 h 3795"/>
                  <a:gd name="T20" fmla="*/ 901 w 5372"/>
                  <a:gd name="T21" fmla="*/ 2185 h 3795"/>
                  <a:gd name="T22" fmla="*/ 249 w 5372"/>
                  <a:gd name="T23" fmla="*/ 2032 h 3795"/>
                  <a:gd name="T24" fmla="*/ 0 w 5372"/>
                  <a:gd name="T25" fmla="*/ 1879 h 3795"/>
                  <a:gd name="T26" fmla="*/ 127 w 5372"/>
                  <a:gd name="T27" fmla="*/ 1725 h 3795"/>
                  <a:gd name="T28" fmla="*/ 410 w 5372"/>
                  <a:gd name="T29" fmla="*/ 1572 h 3795"/>
                  <a:gd name="T30" fmla="*/ 816 w 5372"/>
                  <a:gd name="T31" fmla="*/ 1419 h 3795"/>
                  <a:gd name="T32" fmla="*/ 1291 w 5372"/>
                  <a:gd name="T33" fmla="*/ 1265 h 3795"/>
                  <a:gd name="T34" fmla="*/ 1672 w 5372"/>
                  <a:gd name="T35" fmla="*/ 1112 h 3795"/>
                  <a:gd name="T36" fmla="*/ 1867 w 5372"/>
                  <a:gd name="T37" fmla="*/ 959 h 3795"/>
                  <a:gd name="T38" fmla="*/ 2058 w 5372"/>
                  <a:gd name="T39" fmla="*/ 805 h 3795"/>
                  <a:gd name="T40" fmla="*/ 2282 w 5372"/>
                  <a:gd name="T41" fmla="*/ 652 h 3795"/>
                  <a:gd name="T42" fmla="*/ 2439 w 5372"/>
                  <a:gd name="T43" fmla="*/ 499 h 3795"/>
                  <a:gd name="T44" fmla="*/ 2554 w 5372"/>
                  <a:gd name="T45" fmla="*/ 345 h 3795"/>
                  <a:gd name="T46" fmla="*/ 2642 w 5372"/>
                  <a:gd name="T47" fmla="*/ 192 h 3795"/>
                  <a:gd name="T48" fmla="*/ 2679 w 5372"/>
                  <a:gd name="T49" fmla="*/ 39 h 3795"/>
                  <a:gd name="T50" fmla="*/ 2693 w 5372"/>
                  <a:gd name="T51" fmla="*/ 39 h 3795"/>
                  <a:gd name="T52" fmla="*/ 2730 w 5372"/>
                  <a:gd name="T53" fmla="*/ 192 h 3795"/>
                  <a:gd name="T54" fmla="*/ 2818 w 5372"/>
                  <a:gd name="T55" fmla="*/ 345 h 3795"/>
                  <a:gd name="T56" fmla="*/ 2933 w 5372"/>
                  <a:gd name="T57" fmla="*/ 499 h 3795"/>
                  <a:gd name="T58" fmla="*/ 3090 w 5372"/>
                  <a:gd name="T59" fmla="*/ 652 h 3795"/>
                  <a:gd name="T60" fmla="*/ 3314 w 5372"/>
                  <a:gd name="T61" fmla="*/ 805 h 3795"/>
                  <a:gd name="T62" fmla="*/ 3505 w 5372"/>
                  <a:gd name="T63" fmla="*/ 959 h 3795"/>
                  <a:gd name="T64" fmla="*/ 3700 w 5372"/>
                  <a:gd name="T65" fmla="*/ 1112 h 3795"/>
                  <a:gd name="T66" fmla="*/ 4081 w 5372"/>
                  <a:gd name="T67" fmla="*/ 1265 h 3795"/>
                  <a:gd name="T68" fmla="*/ 4556 w 5372"/>
                  <a:gd name="T69" fmla="*/ 1419 h 3795"/>
                  <a:gd name="T70" fmla="*/ 4962 w 5372"/>
                  <a:gd name="T71" fmla="*/ 1572 h 3795"/>
                  <a:gd name="T72" fmla="*/ 5245 w 5372"/>
                  <a:gd name="T73" fmla="*/ 1725 h 3795"/>
                  <a:gd name="T74" fmla="*/ 5372 w 5372"/>
                  <a:gd name="T75" fmla="*/ 1879 h 3795"/>
                  <a:gd name="T76" fmla="*/ 5123 w 5372"/>
                  <a:gd name="T77" fmla="*/ 2032 h 3795"/>
                  <a:gd name="T78" fmla="*/ 4471 w 5372"/>
                  <a:gd name="T79" fmla="*/ 2185 h 3795"/>
                  <a:gd name="T80" fmla="*/ 3830 w 5372"/>
                  <a:gd name="T81" fmla="*/ 2339 h 3795"/>
                  <a:gd name="T82" fmla="*/ 3474 w 5372"/>
                  <a:gd name="T83" fmla="*/ 2492 h 3795"/>
                  <a:gd name="T84" fmla="*/ 3300 w 5372"/>
                  <a:gd name="T85" fmla="*/ 2645 h 3795"/>
                  <a:gd name="T86" fmla="*/ 3079 w 5372"/>
                  <a:gd name="T87" fmla="*/ 2799 h 3795"/>
                  <a:gd name="T88" fmla="*/ 2886 w 5372"/>
                  <a:gd name="T89" fmla="*/ 2952 h 3795"/>
                  <a:gd name="T90" fmla="*/ 2880 w 5372"/>
                  <a:gd name="T91" fmla="*/ 3105 h 3795"/>
                  <a:gd name="T92" fmla="*/ 2959 w 5372"/>
                  <a:gd name="T93" fmla="*/ 3259 h 3795"/>
                  <a:gd name="T94" fmla="*/ 2936 w 5372"/>
                  <a:gd name="T95" fmla="*/ 3412 h 3795"/>
                  <a:gd name="T96" fmla="*/ 2805 w 5372"/>
                  <a:gd name="T97" fmla="*/ 3565 h 3795"/>
                  <a:gd name="T98" fmla="*/ 2713 w 5372"/>
                  <a:gd name="T99" fmla="*/ 3719 h 37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5372" h="3795">
                    <a:moveTo>
                      <a:pt x="2695" y="3795"/>
                    </a:moveTo>
                    <a:lnTo>
                      <a:pt x="2677" y="3795"/>
                    </a:lnTo>
                    <a:lnTo>
                      <a:pt x="2670" y="3757"/>
                    </a:lnTo>
                    <a:lnTo>
                      <a:pt x="2659" y="3719"/>
                    </a:lnTo>
                    <a:lnTo>
                      <a:pt x="2644" y="3680"/>
                    </a:lnTo>
                    <a:lnTo>
                      <a:pt x="2623" y="3642"/>
                    </a:lnTo>
                    <a:lnTo>
                      <a:pt x="2598" y="3604"/>
                    </a:lnTo>
                    <a:lnTo>
                      <a:pt x="2567" y="3565"/>
                    </a:lnTo>
                    <a:lnTo>
                      <a:pt x="2533" y="3527"/>
                    </a:lnTo>
                    <a:lnTo>
                      <a:pt x="2497" y="3489"/>
                    </a:lnTo>
                    <a:lnTo>
                      <a:pt x="2464" y="3450"/>
                    </a:lnTo>
                    <a:lnTo>
                      <a:pt x="2436" y="3412"/>
                    </a:lnTo>
                    <a:lnTo>
                      <a:pt x="2416" y="3374"/>
                    </a:lnTo>
                    <a:lnTo>
                      <a:pt x="2405" y="3335"/>
                    </a:lnTo>
                    <a:lnTo>
                      <a:pt x="2404" y="3297"/>
                    </a:lnTo>
                    <a:lnTo>
                      <a:pt x="2413" y="3259"/>
                    </a:lnTo>
                    <a:lnTo>
                      <a:pt x="2429" y="3220"/>
                    </a:lnTo>
                    <a:lnTo>
                      <a:pt x="2450" y="3182"/>
                    </a:lnTo>
                    <a:lnTo>
                      <a:pt x="2472" y="3144"/>
                    </a:lnTo>
                    <a:lnTo>
                      <a:pt x="2492" y="3105"/>
                    </a:lnTo>
                    <a:lnTo>
                      <a:pt x="2506" y="3067"/>
                    </a:lnTo>
                    <a:lnTo>
                      <a:pt x="2511" y="3029"/>
                    </a:lnTo>
                    <a:lnTo>
                      <a:pt x="2505" y="2990"/>
                    </a:lnTo>
                    <a:lnTo>
                      <a:pt x="2485" y="2952"/>
                    </a:lnTo>
                    <a:lnTo>
                      <a:pt x="2453" y="2914"/>
                    </a:lnTo>
                    <a:lnTo>
                      <a:pt x="2408" y="2875"/>
                    </a:lnTo>
                    <a:lnTo>
                      <a:pt x="2353" y="2837"/>
                    </a:lnTo>
                    <a:lnTo>
                      <a:pt x="2293" y="2799"/>
                    </a:lnTo>
                    <a:lnTo>
                      <a:pt x="2232" y="2760"/>
                    </a:lnTo>
                    <a:lnTo>
                      <a:pt x="2173" y="2722"/>
                    </a:lnTo>
                    <a:lnTo>
                      <a:pt x="2119" y="2684"/>
                    </a:lnTo>
                    <a:lnTo>
                      <a:pt x="2072" y="2645"/>
                    </a:lnTo>
                    <a:lnTo>
                      <a:pt x="2030" y="2607"/>
                    </a:lnTo>
                    <a:lnTo>
                      <a:pt x="1990" y="2569"/>
                    </a:lnTo>
                    <a:lnTo>
                      <a:pt x="1948" y="2530"/>
                    </a:lnTo>
                    <a:lnTo>
                      <a:pt x="1898" y="2492"/>
                    </a:lnTo>
                    <a:lnTo>
                      <a:pt x="1836" y="2454"/>
                    </a:lnTo>
                    <a:lnTo>
                      <a:pt x="1758" y="2415"/>
                    </a:lnTo>
                    <a:lnTo>
                      <a:pt x="1660" y="2377"/>
                    </a:lnTo>
                    <a:lnTo>
                      <a:pt x="1542" y="2339"/>
                    </a:lnTo>
                    <a:lnTo>
                      <a:pt x="1404" y="2300"/>
                    </a:lnTo>
                    <a:lnTo>
                      <a:pt x="1249" y="2262"/>
                    </a:lnTo>
                    <a:lnTo>
                      <a:pt x="1079" y="2224"/>
                    </a:lnTo>
                    <a:lnTo>
                      <a:pt x="901" y="2185"/>
                    </a:lnTo>
                    <a:lnTo>
                      <a:pt x="721" y="2147"/>
                    </a:lnTo>
                    <a:lnTo>
                      <a:pt x="547" y="2109"/>
                    </a:lnTo>
                    <a:lnTo>
                      <a:pt x="387" y="2070"/>
                    </a:lnTo>
                    <a:lnTo>
                      <a:pt x="249" y="2032"/>
                    </a:lnTo>
                    <a:lnTo>
                      <a:pt x="139" y="1994"/>
                    </a:lnTo>
                    <a:lnTo>
                      <a:pt x="62" y="1955"/>
                    </a:lnTo>
                    <a:lnTo>
                      <a:pt x="16" y="1917"/>
                    </a:lnTo>
                    <a:lnTo>
                      <a:pt x="0" y="1879"/>
                    </a:lnTo>
                    <a:lnTo>
                      <a:pt x="9" y="1840"/>
                    </a:lnTo>
                    <a:lnTo>
                      <a:pt x="36" y="1802"/>
                    </a:lnTo>
                    <a:lnTo>
                      <a:pt x="76" y="1764"/>
                    </a:lnTo>
                    <a:lnTo>
                      <a:pt x="127" y="1725"/>
                    </a:lnTo>
                    <a:lnTo>
                      <a:pt x="186" y="1687"/>
                    </a:lnTo>
                    <a:lnTo>
                      <a:pt x="253" y="1649"/>
                    </a:lnTo>
                    <a:lnTo>
                      <a:pt x="327" y="1610"/>
                    </a:lnTo>
                    <a:lnTo>
                      <a:pt x="410" y="1572"/>
                    </a:lnTo>
                    <a:lnTo>
                      <a:pt x="501" y="1534"/>
                    </a:lnTo>
                    <a:lnTo>
                      <a:pt x="599" y="1495"/>
                    </a:lnTo>
                    <a:lnTo>
                      <a:pt x="705" y="1457"/>
                    </a:lnTo>
                    <a:lnTo>
                      <a:pt x="816" y="1419"/>
                    </a:lnTo>
                    <a:lnTo>
                      <a:pt x="932" y="1380"/>
                    </a:lnTo>
                    <a:lnTo>
                      <a:pt x="1052" y="1342"/>
                    </a:lnTo>
                    <a:lnTo>
                      <a:pt x="1173" y="1304"/>
                    </a:lnTo>
                    <a:lnTo>
                      <a:pt x="1291" y="1265"/>
                    </a:lnTo>
                    <a:lnTo>
                      <a:pt x="1404" y="1227"/>
                    </a:lnTo>
                    <a:lnTo>
                      <a:pt x="1506" y="1189"/>
                    </a:lnTo>
                    <a:lnTo>
                      <a:pt x="1596" y="1150"/>
                    </a:lnTo>
                    <a:lnTo>
                      <a:pt x="1672" y="1112"/>
                    </a:lnTo>
                    <a:lnTo>
                      <a:pt x="1734" y="1074"/>
                    </a:lnTo>
                    <a:lnTo>
                      <a:pt x="1784" y="1035"/>
                    </a:lnTo>
                    <a:lnTo>
                      <a:pt x="1827" y="997"/>
                    </a:lnTo>
                    <a:lnTo>
                      <a:pt x="1867" y="959"/>
                    </a:lnTo>
                    <a:lnTo>
                      <a:pt x="1908" y="920"/>
                    </a:lnTo>
                    <a:lnTo>
                      <a:pt x="1953" y="882"/>
                    </a:lnTo>
                    <a:lnTo>
                      <a:pt x="2003" y="844"/>
                    </a:lnTo>
                    <a:lnTo>
                      <a:pt x="2058" y="805"/>
                    </a:lnTo>
                    <a:lnTo>
                      <a:pt x="2115" y="767"/>
                    </a:lnTo>
                    <a:lnTo>
                      <a:pt x="2174" y="729"/>
                    </a:lnTo>
                    <a:lnTo>
                      <a:pt x="2230" y="690"/>
                    </a:lnTo>
                    <a:lnTo>
                      <a:pt x="2282" y="652"/>
                    </a:lnTo>
                    <a:lnTo>
                      <a:pt x="2328" y="614"/>
                    </a:lnTo>
                    <a:lnTo>
                      <a:pt x="2370" y="575"/>
                    </a:lnTo>
                    <a:lnTo>
                      <a:pt x="2406" y="537"/>
                    </a:lnTo>
                    <a:lnTo>
                      <a:pt x="2439" y="499"/>
                    </a:lnTo>
                    <a:lnTo>
                      <a:pt x="2469" y="460"/>
                    </a:lnTo>
                    <a:lnTo>
                      <a:pt x="2498" y="422"/>
                    </a:lnTo>
                    <a:lnTo>
                      <a:pt x="2527" y="384"/>
                    </a:lnTo>
                    <a:lnTo>
                      <a:pt x="2554" y="345"/>
                    </a:lnTo>
                    <a:lnTo>
                      <a:pt x="2580" y="307"/>
                    </a:lnTo>
                    <a:lnTo>
                      <a:pt x="2604" y="269"/>
                    </a:lnTo>
                    <a:lnTo>
                      <a:pt x="2625" y="230"/>
                    </a:lnTo>
                    <a:lnTo>
                      <a:pt x="2642" y="192"/>
                    </a:lnTo>
                    <a:lnTo>
                      <a:pt x="2656" y="154"/>
                    </a:lnTo>
                    <a:lnTo>
                      <a:pt x="2666" y="115"/>
                    </a:lnTo>
                    <a:lnTo>
                      <a:pt x="2674" y="77"/>
                    </a:lnTo>
                    <a:lnTo>
                      <a:pt x="2679" y="39"/>
                    </a:lnTo>
                    <a:lnTo>
                      <a:pt x="2682" y="0"/>
                    </a:lnTo>
                    <a:lnTo>
                      <a:pt x="2690" y="0"/>
                    </a:lnTo>
                    <a:lnTo>
                      <a:pt x="2691" y="0"/>
                    </a:lnTo>
                    <a:lnTo>
                      <a:pt x="2693" y="39"/>
                    </a:lnTo>
                    <a:lnTo>
                      <a:pt x="2698" y="77"/>
                    </a:lnTo>
                    <a:lnTo>
                      <a:pt x="2705" y="115"/>
                    </a:lnTo>
                    <a:lnTo>
                      <a:pt x="2716" y="154"/>
                    </a:lnTo>
                    <a:lnTo>
                      <a:pt x="2730" y="192"/>
                    </a:lnTo>
                    <a:lnTo>
                      <a:pt x="2747" y="230"/>
                    </a:lnTo>
                    <a:lnTo>
                      <a:pt x="2768" y="269"/>
                    </a:lnTo>
                    <a:lnTo>
                      <a:pt x="2792" y="307"/>
                    </a:lnTo>
                    <a:lnTo>
                      <a:pt x="2818" y="345"/>
                    </a:lnTo>
                    <a:lnTo>
                      <a:pt x="2845" y="384"/>
                    </a:lnTo>
                    <a:lnTo>
                      <a:pt x="2873" y="422"/>
                    </a:lnTo>
                    <a:lnTo>
                      <a:pt x="2902" y="460"/>
                    </a:lnTo>
                    <a:lnTo>
                      <a:pt x="2933" y="499"/>
                    </a:lnTo>
                    <a:lnTo>
                      <a:pt x="2966" y="537"/>
                    </a:lnTo>
                    <a:lnTo>
                      <a:pt x="3002" y="575"/>
                    </a:lnTo>
                    <a:lnTo>
                      <a:pt x="3043" y="614"/>
                    </a:lnTo>
                    <a:lnTo>
                      <a:pt x="3090" y="652"/>
                    </a:lnTo>
                    <a:lnTo>
                      <a:pt x="3142" y="690"/>
                    </a:lnTo>
                    <a:lnTo>
                      <a:pt x="3198" y="729"/>
                    </a:lnTo>
                    <a:lnTo>
                      <a:pt x="3256" y="767"/>
                    </a:lnTo>
                    <a:lnTo>
                      <a:pt x="3314" y="805"/>
                    </a:lnTo>
                    <a:lnTo>
                      <a:pt x="3369" y="844"/>
                    </a:lnTo>
                    <a:lnTo>
                      <a:pt x="3419" y="882"/>
                    </a:lnTo>
                    <a:lnTo>
                      <a:pt x="3464" y="920"/>
                    </a:lnTo>
                    <a:lnTo>
                      <a:pt x="3505" y="959"/>
                    </a:lnTo>
                    <a:lnTo>
                      <a:pt x="3545" y="997"/>
                    </a:lnTo>
                    <a:lnTo>
                      <a:pt x="3587" y="1035"/>
                    </a:lnTo>
                    <a:lnTo>
                      <a:pt x="3638" y="1074"/>
                    </a:lnTo>
                    <a:lnTo>
                      <a:pt x="3700" y="1112"/>
                    </a:lnTo>
                    <a:lnTo>
                      <a:pt x="3775" y="1150"/>
                    </a:lnTo>
                    <a:lnTo>
                      <a:pt x="3865" y="1189"/>
                    </a:lnTo>
                    <a:lnTo>
                      <a:pt x="3968" y="1227"/>
                    </a:lnTo>
                    <a:lnTo>
                      <a:pt x="4081" y="1265"/>
                    </a:lnTo>
                    <a:lnTo>
                      <a:pt x="4199" y="1304"/>
                    </a:lnTo>
                    <a:lnTo>
                      <a:pt x="4320" y="1342"/>
                    </a:lnTo>
                    <a:lnTo>
                      <a:pt x="4440" y="1380"/>
                    </a:lnTo>
                    <a:lnTo>
                      <a:pt x="4556" y="1419"/>
                    </a:lnTo>
                    <a:lnTo>
                      <a:pt x="4667" y="1457"/>
                    </a:lnTo>
                    <a:lnTo>
                      <a:pt x="4772" y="1495"/>
                    </a:lnTo>
                    <a:lnTo>
                      <a:pt x="4871" y="1534"/>
                    </a:lnTo>
                    <a:lnTo>
                      <a:pt x="4962" y="1572"/>
                    </a:lnTo>
                    <a:lnTo>
                      <a:pt x="5044" y="1610"/>
                    </a:lnTo>
                    <a:lnTo>
                      <a:pt x="5119" y="1649"/>
                    </a:lnTo>
                    <a:lnTo>
                      <a:pt x="5186" y="1687"/>
                    </a:lnTo>
                    <a:lnTo>
                      <a:pt x="5245" y="1725"/>
                    </a:lnTo>
                    <a:lnTo>
                      <a:pt x="5295" y="1764"/>
                    </a:lnTo>
                    <a:lnTo>
                      <a:pt x="5336" y="1802"/>
                    </a:lnTo>
                    <a:lnTo>
                      <a:pt x="5363" y="1840"/>
                    </a:lnTo>
                    <a:lnTo>
                      <a:pt x="5372" y="1879"/>
                    </a:lnTo>
                    <a:lnTo>
                      <a:pt x="5355" y="1917"/>
                    </a:lnTo>
                    <a:lnTo>
                      <a:pt x="5310" y="1955"/>
                    </a:lnTo>
                    <a:lnTo>
                      <a:pt x="5232" y="1994"/>
                    </a:lnTo>
                    <a:lnTo>
                      <a:pt x="5123" y="2032"/>
                    </a:lnTo>
                    <a:lnTo>
                      <a:pt x="4985" y="2070"/>
                    </a:lnTo>
                    <a:lnTo>
                      <a:pt x="4825" y="2109"/>
                    </a:lnTo>
                    <a:lnTo>
                      <a:pt x="4651" y="2147"/>
                    </a:lnTo>
                    <a:lnTo>
                      <a:pt x="4471" y="2185"/>
                    </a:lnTo>
                    <a:lnTo>
                      <a:pt x="4292" y="2224"/>
                    </a:lnTo>
                    <a:lnTo>
                      <a:pt x="4123" y="2262"/>
                    </a:lnTo>
                    <a:lnTo>
                      <a:pt x="3967" y="2300"/>
                    </a:lnTo>
                    <a:lnTo>
                      <a:pt x="3830" y="2339"/>
                    </a:lnTo>
                    <a:lnTo>
                      <a:pt x="3712" y="2377"/>
                    </a:lnTo>
                    <a:lnTo>
                      <a:pt x="3614" y="2415"/>
                    </a:lnTo>
                    <a:lnTo>
                      <a:pt x="3536" y="2454"/>
                    </a:lnTo>
                    <a:lnTo>
                      <a:pt x="3474" y="2492"/>
                    </a:lnTo>
                    <a:lnTo>
                      <a:pt x="3424" y="2530"/>
                    </a:lnTo>
                    <a:lnTo>
                      <a:pt x="3382" y="2569"/>
                    </a:lnTo>
                    <a:lnTo>
                      <a:pt x="3342" y="2607"/>
                    </a:lnTo>
                    <a:lnTo>
                      <a:pt x="3300" y="2645"/>
                    </a:lnTo>
                    <a:lnTo>
                      <a:pt x="3253" y="2684"/>
                    </a:lnTo>
                    <a:lnTo>
                      <a:pt x="3199" y="2722"/>
                    </a:lnTo>
                    <a:lnTo>
                      <a:pt x="3140" y="2760"/>
                    </a:lnTo>
                    <a:lnTo>
                      <a:pt x="3079" y="2799"/>
                    </a:lnTo>
                    <a:lnTo>
                      <a:pt x="3019" y="2837"/>
                    </a:lnTo>
                    <a:lnTo>
                      <a:pt x="2964" y="2875"/>
                    </a:lnTo>
                    <a:lnTo>
                      <a:pt x="2919" y="2914"/>
                    </a:lnTo>
                    <a:lnTo>
                      <a:pt x="2886" y="2952"/>
                    </a:lnTo>
                    <a:lnTo>
                      <a:pt x="2867" y="2990"/>
                    </a:lnTo>
                    <a:lnTo>
                      <a:pt x="2860" y="3029"/>
                    </a:lnTo>
                    <a:lnTo>
                      <a:pt x="2866" y="3067"/>
                    </a:lnTo>
                    <a:lnTo>
                      <a:pt x="2880" y="3105"/>
                    </a:lnTo>
                    <a:lnTo>
                      <a:pt x="2900" y="3144"/>
                    </a:lnTo>
                    <a:lnTo>
                      <a:pt x="2922" y="3182"/>
                    </a:lnTo>
                    <a:lnTo>
                      <a:pt x="2943" y="3220"/>
                    </a:lnTo>
                    <a:lnTo>
                      <a:pt x="2959" y="3259"/>
                    </a:lnTo>
                    <a:lnTo>
                      <a:pt x="2967" y="3297"/>
                    </a:lnTo>
                    <a:lnTo>
                      <a:pt x="2967" y="3335"/>
                    </a:lnTo>
                    <a:lnTo>
                      <a:pt x="2956" y="3374"/>
                    </a:lnTo>
                    <a:lnTo>
                      <a:pt x="2936" y="3412"/>
                    </a:lnTo>
                    <a:lnTo>
                      <a:pt x="2907" y="3450"/>
                    </a:lnTo>
                    <a:lnTo>
                      <a:pt x="2874" y="3489"/>
                    </a:lnTo>
                    <a:lnTo>
                      <a:pt x="2839" y="3527"/>
                    </a:lnTo>
                    <a:lnTo>
                      <a:pt x="2805" y="3565"/>
                    </a:lnTo>
                    <a:lnTo>
                      <a:pt x="2774" y="3604"/>
                    </a:lnTo>
                    <a:lnTo>
                      <a:pt x="2748" y="3642"/>
                    </a:lnTo>
                    <a:lnTo>
                      <a:pt x="2728" y="3680"/>
                    </a:lnTo>
                    <a:lnTo>
                      <a:pt x="2713" y="3719"/>
                    </a:lnTo>
                    <a:lnTo>
                      <a:pt x="2702" y="3757"/>
                    </a:lnTo>
                    <a:lnTo>
                      <a:pt x="2695" y="3795"/>
                    </a:lnTo>
                    <a:close/>
                  </a:path>
                </a:pathLst>
              </a:custGeom>
              <a:solidFill>
                <a:srgbClr val="CC8963"/>
              </a:solidFill>
              <a:ln w="14288" cap="flat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14288" cap="flat">
                    <a:solidFill>
                      <a:srgbClr val="525252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5" name="Freeform 292">
                <a:extLst>
                  <a:ext uri="{FF2B5EF4-FFF2-40B4-BE49-F238E27FC236}">
                    <a16:creationId xmlns:a16="http://schemas.microsoft.com/office/drawing/2014/main" id="{CA18E917-039D-1E23-111F-7EE6CFB9F03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44850" y="4476750"/>
                <a:ext cx="969963" cy="685800"/>
              </a:xfrm>
              <a:custGeom>
                <a:avLst/>
                <a:gdLst>
                  <a:gd name="T0" fmla="*/ 2659 w 5372"/>
                  <a:gd name="T1" fmla="*/ 3719 h 3795"/>
                  <a:gd name="T2" fmla="*/ 2567 w 5372"/>
                  <a:gd name="T3" fmla="*/ 3565 h 3795"/>
                  <a:gd name="T4" fmla="*/ 2436 w 5372"/>
                  <a:gd name="T5" fmla="*/ 3412 h 3795"/>
                  <a:gd name="T6" fmla="*/ 2413 w 5372"/>
                  <a:gd name="T7" fmla="*/ 3259 h 3795"/>
                  <a:gd name="T8" fmla="*/ 2492 w 5372"/>
                  <a:gd name="T9" fmla="*/ 3105 h 3795"/>
                  <a:gd name="T10" fmla="*/ 2485 w 5372"/>
                  <a:gd name="T11" fmla="*/ 2952 h 3795"/>
                  <a:gd name="T12" fmla="*/ 2293 w 5372"/>
                  <a:gd name="T13" fmla="*/ 2799 h 3795"/>
                  <a:gd name="T14" fmla="*/ 2072 w 5372"/>
                  <a:gd name="T15" fmla="*/ 2645 h 3795"/>
                  <a:gd name="T16" fmla="*/ 1898 w 5372"/>
                  <a:gd name="T17" fmla="*/ 2492 h 3795"/>
                  <a:gd name="T18" fmla="*/ 1542 w 5372"/>
                  <a:gd name="T19" fmla="*/ 2339 h 3795"/>
                  <a:gd name="T20" fmla="*/ 901 w 5372"/>
                  <a:gd name="T21" fmla="*/ 2185 h 3795"/>
                  <a:gd name="T22" fmla="*/ 249 w 5372"/>
                  <a:gd name="T23" fmla="*/ 2032 h 3795"/>
                  <a:gd name="T24" fmla="*/ 0 w 5372"/>
                  <a:gd name="T25" fmla="*/ 1879 h 3795"/>
                  <a:gd name="T26" fmla="*/ 127 w 5372"/>
                  <a:gd name="T27" fmla="*/ 1725 h 3795"/>
                  <a:gd name="T28" fmla="*/ 410 w 5372"/>
                  <a:gd name="T29" fmla="*/ 1572 h 3795"/>
                  <a:gd name="T30" fmla="*/ 816 w 5372"/>
                  <a:gd name="T31" fmla="*/ 1419 h 3795"/>
                  <a:gd name="T32" fmla="*/ 1291 w 5372"/>
                  <a:gd name="T33" fmla="*/ 1265 h 3795"/>
                  <a:gd name="T34" fmla="*/ 1672 w 5372"/>
                  <a:gd name="T35" fmla="*/ 1112 h 3795"/>
                  <a:gd name="T36" fmla="*/ 1867 w 5372"/>
                  <a:gd name="T37" fmla="*/ 959 h 3795"/>
                  <a:gd name="T38" fmla="*/ 2058 w 5372"/>
                  <a:gd name="T39" fmla="*/ 805 h 3795"/>
                  <a:gd name="T40" fmla="*/ 2282 w 5372"/>
                  <a:gd name="T41" fmla="*/ 652 h 3795"/>
                  <a:gd name="T42" fmla="*/ 2439 w 5372"/>
                  <a:gd name="T43" fmla="*/ 499 h 3795"/>
                  <a:gd name="T44" fmla="*/ 2554 w 5372"/>
                  <a:gd name="T45" fmla="*/ 345 h 3795"/>
                  <a:gd name="T46" fmla="*/ 2642 w 5372"/>
                  <a:gd name="T47" fmla="*/ 192 h 3795"/>
                  <a:gd name="T48" fmla="*/ 2679 w 5372"/>
                  <a:gd name="T49" fmla="*/ 39 h 3795"/>
                  <a:gd name="T50" fmla="*/ 2693 w 5372"/>
                  <a:gd name="T51" fmla="*/ 39 h 3795"/>
                  <a:gd name="T52" fmla="*/ 2730 w 5372"/>
                  <a:gd name="T53" fmla="*/ 192 h 3795"/>
                  <a:gd name="T54" fmla="*/ 2818 w 5372"/>
                  <a:gd name="T55" fmla="*/ 345 h 3795"/>
                  <a:gd name="T56" fmla="*/ 2933 w 5372"/>
                  <a:gd name="T57" fmla="*/ 499 h 3795"/>
                  <a:gd name="T58" fmla="*/ 3090 w 5372"/>
                  <a:gd name="T59" fmla="*/ 652 h 3795"/>
                  <a:gd name="T60" fmla="*/ 3314 w 5372"/>
                  <a:gd name="T61" fmla="*/ 805 h 3795"/>
                  <a:gd name="T62" fmla="*/ 3505 w 5372"/>
                  <a:gd name="T63" fmla="*/ 959 h 3795"/>
                  <a:gd name="T64" fmla="*/ 3700 w 5372"/>
                  <a:gd name="T65" fmla="*/ 1112 h 3795"/>
                  <a:gd name="T66" fmla="*/ 4081 w 5372"/>
                  <a:gd name="T67" fmla="*/ 1265 h 3795"/>
                  <a:gd name="T68" fmla="*/ 4556 w 5372"/>
                  <a:gd name="T69" fmla="*/ 1419 h 3795"/>
                  <a:gd name="T70" fmla="*/ 4962 w 5372"/>
                  <a:gd name="T71" fmla="*/ 1572 h 3795"/>
                  <a:gd name="T72" fmla="*/ 5245 w 5372"/>
                  <a:gd name="T73" fmla="*/ 1725 h 3795"/>
                  <a:gd name="T74" fmla="*/ 5372 w 5372"/>
                  <a:gd name="T75" fmla="*/ 1879 h 3795"/>
                  <a:gd name="T76" fmla="*/ 5123 w 5372"/>
                  <a:gd name="T77" fmla="*/ 2032 h 3795"/>
                  <a:gd name="T78" fmla="*/ 4471 w 5372"/>
                  <a:gd name="T79" fmla="*/ 2185 h 3795"/>
                  <a:gd name="T80" fmla="*/ 3830 w 5372"/>
                  <a:gd name="T81" fmla="*/ 2339 h 3795"/>
                  <a:gd name="T82" fmla="*/ 3474 w 5372"/>
                  <a:gd name="T83" fmla="*/ 2492 h 3795"/>
                  <a:gd name="T84" fmla="*/ 3300 w 5372"/>
                  <a:gd name="T85" fmla="*/ 2645 h 3795"/>
                  <a:gd name="T86" fmla="*/ 3079 w 5372"/>
                  <a:gd name="T87" fmla="*/ 2799 h 3795"/>
                  <a:gd name="T88" fmla="*/ 2886 w 5372"/>
                  <a:gd name="T89" fmla="*/ 2952 h 3795"/>
                  <a:gd name="T90" fmla="*/ 2880 w 5372"/>
                  <a:gd name="T91" fmla="*/ 3105 h 3795"/>
                  <a:gd name="T92" fmla="*/ 2959 w 5372"/>
                  <a:gd name="T93" fmla="*/ 3259 h 3795"/>
                  <a:gd name="T94" fmla="*/ 2936 w 5372"/>
                  <a:gd name="T95" fmla="*/ 3412 h 3795"/>
                  <a:gd name="T96" fmla="*/ 2805 w 5372"/>
                  <a:gd name="T97" fmla="*/ 3565 h 3795"/>
                  <a:gd name="T98" fmla="*/ 2713 w 5372"/>
                  <a:gd name="T99" fmla="*/ 3719 h 37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5372" h="3795">
                    <a:moveTo>
                      <a:pt x="2695" y="3795"/>
                    </a:moveTo>
                    <a:lnTo>
                      <a:pt x="2677" y="3795"/>
                    </a:lnTo>
                    <a:lnTo>
                      <a:pt x="2670" y="3757"/>
                    </a:lnTo>
                    <a:lnTo>
                      <a:pt x="2659" y="3719"/>
                    </a:lnTo>
                    <a:lnTo>
                      <a:pt x="2644" y="3680"/>
                    </a:lnTo>
                    <a:lnTo>
                      <a:pt x="2623" y="3642"/>
                    </a:lnTo>
                    <a:lnTo>
                      <a:pt x="2598" y="3604"/>
                    </a:lnTo>
                    <a:lnTo>
                      <a:pt x="2567" y="3565"/>
                    </a:lnTo>
                    <a:lnTo>
                      <a:pt x="2533" y="3527"/>
                    </a:lnTo>
                    <a:lnTo>
                      <a:pt x="2497" y="3489"/>
                    </a:lnTo>
                    <a:lnTo>
                      <a:pt x="2464" y="3450"/>
                    </a:lnTo>
                    <a:lnTo>
                      <a:pt x="2436" y="3412"/>
                    </a:lnTo>
                    <a:lnTo>
                      <a:pt x="2416" y="3374"/>
                    </a:lnTo>
                    <a:lnTo>
                      <a:pt x="2405" y="3335"/>
                    </a:lnTo>
                    <a:lnTo>
                      <a:pt x="2404" y="3297"/>
                    </a:lnTo>
                    <a:lnTo>
                      <a:pt x="2413" y="3259"/>
                    </a:lnTo>
                    <a:lnTo>
                      <a:pt x="2429" y="3220"/>
                    </a:lnTo>
                    <a:lnTo>
                      <a:pt x="2450" y="3182"/>
                    </a:lnTo>
                    <a:lnTo>
                      <a:pt x="2472" y="3144"/>
                    </a:lnTo>
                    <a:lnTo>
                      <a:pt x="2492" y="3105"/>
                    </a:lnTo>
                    <a:lnTo>
                      <a:pt x="2506" y="3067"/>
                    </a:lnTo>
                    <a:lnTo>
                      <a:pt x="2511" y="3029"/>
                    </a:lnTo>
                    <a:lnTo>
                      <a:pt x="2505" y="2990"/>
                    </a:lnTo>
                    <a:lnTo>
                      <a:pt x="2485" y="2952"/>
                    </a:lnTo>
                    <a:lnTo>
                      <a:pt x="2453" y="2914"/>
                    </a:lnTo>
                    <a:lnTo>
                      <a:pt x="2408" y="2875"/>
                    </a:lnTo>
                    <a:lnTo>
                      <a:pt x="2353" y="2837"/>
                    </a:lnTo>
                    <a:lnTo>
                      <a:pt x="2293" y="2799"/>
                    </a:lnTo>
                    <a:lnTo>
                      <a:pt x="2232" y="2760"/>
                    </a:lnTo>
                    <a:lnTo>
                      <a:pt x="2173" y="2722"/>
                    </a:lnTo>
                    <a:lnTo>
                      <a:pt x="2119" y="2684"/>
                    </a:lnTo>
                    <a:lnTo>
                      <a:pt x="2072" y="2645"/>
                    </a:lnTo>
                    <a:lnTo>
                      <a:pt x="2030" y="2607"/>
                    </a:lnTo>
                    <a:lnTo>
                      <a:pt x="1990" y="2569"/>
                    </a:lnTo>
                    <a:lnTo>
                      <a:pt x="1948" y="2530"/>
                    </a:lnTo>
                    <a:lnTo>
                      <a:pt x="1898" y="2492"/>
                    </a:lnTo>
                    <a:lnTo>
                      <a:pt x="1836" y="2454"/>
                    </a:lnTo>
                    <a:lnTo>
                      <a:pt x="1758" y="2415"/>
                    </a:lnTo>
                    <a:lnTo>
                      <a:pt x="1660" y="2377"/>
                    </a:lnTo>
                    <a:lnTo>
                      <a:pt x="1542" y="2339"/>
                    </a:lnTo>
                    <a:lnTo>
                      <a:pt x="1404" y="2300"/>
                    </a:lnTo>
                    <a:lnTo>
                      <a:pt x="1249" y="2262"/>
                    </a:lnTo>
                    <a:lnTo>
                      <a:pt x="1079" y="2224"/>
                    </a:lnTo>
                    <a:lnTo>
                      <a:pt x="901" y="2185"/>
                    </a:lnTo>
                    <a:lnTo>
                      <a:pt x="721" y="2147"/>
                    </a:lnTo>
                    <a:lnTo>
                      <a:pt x="547" y="2109"/>
                    </a:lnTo>
                    <a:lnTo>
                      <a:pt x="387" y="2070"/>
                    </a:lnTo>
                    <a:lnTo>
                      <a:pt x="249" y="2032"/>
                    </a:lnTo>
                    <a:lnTo>
                      <a:pt x="139" y="1994"/>
                    </a:lnTo>
                    <a:lnTo>
                      <a:pt x="62" y="1955"/>
                    </a:lnTo>
                    <a:lnTo>
                      <a:pt x="16" y="1917"/>
                    </a:lnTo>
                    <a:lnTo>
                      <a:pt x="0" y="1879"/>
                    </a:lnTo>
                    <a:lnTo>
                      <a:pt x="9" y="1840"/>
                    </a:lnTo>
                    <a:lnTo>
                      <a:pt x="36" y="1802"/>
                    </a:lnTo>
                    <a:lnTo>
                      <a:pt x="76" y="1764"/>
                    </a:lnTo>
                    <a:lnTo>
                      <a:pt x="127" y="1725"/>
                    </a:lnTo>
                    <a:lnTo>
                      <a:pt x="186" y="1687"/>
                    </a:lnTo>
                    <a:lnTo>
                      <a:pt x="253" y="1649"/>
                    </a:lnTo>
                    <a:lnTo>
                      <a:pt x="327" y="1610"/>
                    </a:lnTo>
                    <a:lnTo>
                      <a:pt x="410" y="1572"/>
                    </a:lnTo>
                    <a:lnTo>
                      <a:pt x="501" y="1534"/>
                    </a:lnTo>
                    <a:lnTo>
                      <a:pt x="599" y="1495"/>
                    </a:lnTo>
                    <a:lnTo>
                      <a:pt x="705" y="1457"/>
                    </a:lnTo>
                    <a:lnTo>
                      <a:pt x="816" y="1419"/>
                    </a:lnTo>
                    <a:lnTo>
                      <a:pt x="932" y="1380"/>
                    </a:lnTo>
                    <a:lnTo>
                      <a:pt x="1052" y="1342"/>
                    </a:lnTo>
                    <a:lnTo>
                      <a:pt x="1173" y="1304"/>
                    </a:lnTo>
                    <a:lnTo>
                      <a:pt x="1291" y="1265"/>
                    </a:lnTo>
                    <a:lnTo>
                      <a:pt x="1404" y="1227"/>
                    </a:lnTo>
                    <a:lnTo>
                      <a:pt x="1506" y="1189"/>
                    </a:lnTo>
                    <a:lnTo>
                      <a:pt x="1596" y="1150"/>
                    </a:lnTo>
                    <a:lnTo>
                      <a:pt x="1672" y="1112"/>
                    </a:lnTo>
                    <a:lnTo>
                      <a:pt x="1734" y="1074"/>
                    </a:lnTo>
                    <a:lnTo>
                      <a:pt x="1784" y="1035"/>
                    </a:lnTo>
                    <a:lnTo>
                      <a:pt x="1827" y="997"/>
                    </a:lnTo>
                    <a:lnTo>
                      <a:pt x="1867" y="959"/>
                    </a:lnTo>
                    <a:lnTo>
                      <a:pt x="1908" y="920"/>
                    </a:lnTo>
                    <a:lnTo>
                      <a:pt x="1953" y="882"/>
                    </a:lnTo>
                    <a:lnTo>
                      <a:pt x="2003" y="844"/>
                    </a:lnTo>
                    <a:lnTo>
                      <a:pt x="2058" y="805"/>
                    </a:lnTo>
                    <a:lnTo>
                      <a:pt x="2115" y="767"/>
                    </a:lnTo>
                    <a:lnTo>
                      <a:pt x="2174" y="729"/>
                    </a:lnTo>
                    <a:lnTo>
                      <a:pt x="2230" y="690"/>
                    </a:lnTo>
                    <a:lnTo>
                      <a:pt x="2282" y="652"/>
                    </a:lnTo>
                    <a:lnTo>
                      <a:pt x="2328" y="614"/>
                    </a:lnTo>
                    <a:lnTo>
                      <a:pt x="2370" y="575"/>
                    </a:lnTo>
                    <a:lnTo>
                      <a:pt x="2406" y="537"/>
                    </a:lnTo>
                    <a:lnTo>
                      <a:pt x="2439" y="499"/>
                    </a:lnTo>
                    <a:lnTo>
                      <a:pt x="2469" y="460"/>
                    </a:lnTo>
                    <a:lnTo>
                      <a:pt x="2498" y="422"/>
                    </a:lnTo>
                    <a:lnTo>
                      <a:pt x="2527" y="384"/>
                    </a:lnTo>
                    <a:lnTo>
                      <a:pt x="2554" y="345"/>
                    </a:lnTo>
                    <a:lnTo>
                      <a:pt x="2580" y="307"/>
                    </a:lnTo>
                    <a:lnTo>
                      <a:pt x="2604" y="269"/>
                    </a:lnTo>
                    <a:lnTo>
                      <a:pt x="2625" y="230"/>
                    </a:lnTo>
                    <a:lnTo>
                      <a:pt x="2642" y="192"/>
                    </a:lnTo>
                    <a:lnTo>
                      <a:pt x="2656" y="154"/>
                    </a:lnTo>
                    <a:lnTo>
                      <a:pt x="2666" y="115"/>
                    </a:lnTo>
                    <a:lnTo>
                      <a:pt x="2674" y="77"/>
                    </a:lnTo>
                    <a:lnTo>
                      <a:pt x="2679" y="39"/>
                    </a:lnTo>
                    <a:lnTo>
                      <a:pt x="2682" y="0"/>
                    </a:lnTo>
                    <a:lnTo>
                      <a:pt x="2690" y="0"/>
                    </a:lnTo>
                    <a:lnTo>
                      <a:pt x="2691" y="0"/>
                    </a:lnTo>
                    <a:lnTo>
                      <a:pt x="2693" y="39"/>
                    </a:lnTo>
                    <a:lnTo>
                      <a:pt x="2698" y="77"/>
                    </a:lnTo>
                    <a:lnTo>
                      <a:pt x="2705" y="115"/>
                    </a:lnTo>
                    <a:lnTo>
                      <a:pt x="2716" y="154"/>
                    </a:lnTo>
                    <a:lnTo>
                      <a:pt x="2730" y="192"/>
                    </a:lnTo>
                    <a:lnTo>
                      <a:pt x="2747" y="230"/>
                    </a:lnTo>
                    <a:lnTo>
                      <a:pt x="2768" y="269"/>
                    </a:lnTo>
                    <a:lnTo>
                      <a:pt x="2792" y="307"/>
                    </a:lnTo>
                    <a:lnTo>
                      <a:pt x="2818" y="345"/>
                    </a:lnTo>
                    <a:lnTo>
                      <a:pt x="2845" y="384"/>
                    </a:lnTo>
                    <a:lnTo>
                      <a:pt x="2873" y="422"/>
                    </a:lnTo>
                    <a:lnTo>
                      <a:pt x="2902" y="460"/>
                    </a:lnTo>
                    <a:lnTo>
                      <a:pt x="2933" y="499"/>
                    </a:lnTo>
                    <a:lnTo>
                      <a:pt x="2966" y="537"/>
                    </a:lnTo>
                    <a:lnTo>
                      <a:pt x="3002" y="575"/>
                    </a:lnTo>
                    <a:lnTo>
                      <a:pt x="3043" y="614"/>
                    </a:lnTo>
                    <a:lnTo>
                      <a:pt x="3090" y="652"/>
                    </a:lnTo>
                    <a:lnTo>
                      <a:pt x="3142" y="690"/>
                    </a:lnTo>
                    <a:lnTo>
                      <a:pt x="3198" y="729"/>
                    </a:lnTo>
                    <a:lnTo>
                      <a:pt x="3256" y="767"/>
                    </a:lnTo>
                    <a:lnTo>
                      <a:pt x="3314" y="805"/>
                    </a:lnTo>
                    <a:lnTo>
                      <a:pt x="3369" y="844"/>
                    </a:lnTo>
                    <a:lnTo>
                      <a:pt x="3419" y="882"/>
                    </a:lnTo>
                    <a:lnTo>
                      <a:pt x="3464" y="920"/>
                    </a:lnTo>
                    <a:lnTo>
                      <a:pt x="3505" y="959"/>
                    </a:lnTo>
                    <a:lnTo>
                      <a:pt x="3545" y="997"/>
                    </a:lnTo>
                    <a:lnTo>
                      <a:pt x="3587" y="1035"/>
                    </a:lnTo>
                    <a:lnTo>
                      <a:pt x="3638" y="1074"/>
                    </a:lnTo>
                    <a:lnTo>
                      <a:pt x="3700" y="1112"/>
                    </a:lnTo>
                    <a:lnTo>
                      <a:pt x="3775" y="1150"/>
                    </a:lnTo>
                    <a:lnTo>
                      <a:pt x="3865" y="1189"/>
                    </a:lnTo>
                    <a:lnTo>
                      <a:pt x="3968" y="1227"/>
                    </a:lnTo>
                    <a:lnTo>
                      <a:pt x="4081" y="1265"/>
                    </a:lnTo>
                    <a:lnTo>
                      <a:pt x="4199" y="1304"/>
                    </a:lnTo>
                    <a:lnTo>
                      <a:pt x="4320" y="1342"/>
                    </a:lnTo>
                    <a:lnTo>
                      <a:pt x="4440" y="1380"/>
                    </a:lnTo>
                    <a:lnTo>
                      <a:pt x="4556" y="1419"/>
                    </a:lnTo>
                    <a:lnTo>
                      <a:pt x="4667" y="1457"/>
                    </a:lnTo>
                    <a:lnTo>
                      <a:pt x="4772" y="1495"/>
                    </a:lnTo>
                    <a:lnTo>
                      <a:pt x="4871" y="1534"/>
                    </a:lnTo>
                    <a:lnTo>
                      <a:pt x="4962" y="1572"/>
                    </a:lnTo>
                    <a:lnTo>
                      <a:pt x="5044" y="1610"/>
                    </a:lnTo>
                    <a:lnTo>
                      <a:pt x="5119" y="1649"/>
                    </a:lnTo>
                    <a:lnTo>
                      <a:pt x="5186" y="1687"/>
                    </a:lnTo>
                    <a:lnTo>
                      <a:pt x="5245" y="1725"/>
                    </a:lnTo>
                    <a:lnTo>
                      <a:pt x="5295" y="1764"/>
                    </a:lnTo>
                    <a:lnTo>
                      <a:pt x="5336" y="1802"/>
                    </a:lnTo>
                    <a:lnTo>
                      <a:pt x="5363" y="1840"/>
                    </a:lnTo>
                    <a:lnTo>
                      <a:pt x="5372" y="1879"/>
                    </a:lnTo>
                    <a:lnTo>
                      <a:pt x="5355" y="1917"/>
                    </a:lnTo>
                    <a:lnTo>
                      <a:pt x="5310" y="1955"/>
                    </a:lnTo>
                    <a:lnTo>
                      <a:pt x="5232" y="1994"/>
                    </a:lnTo>
                    <a:lnTo>
                      <a:pt x="5123" y="2032"/>
                    </a:lnTo>
                    <a:lnTo>
                      <a:pt x="4985" y="2070"/>
                    </a:lnTo>
                    <a:lnTo>
                      <a:pt x="4825" y="2109"/>
                    </a:lnTo>
                    <a:lnTo>
                      <a:pt x="4651" y="2147"/>
                    </a:lnTo>
                    <a:lnTo>
                      <a:pt x="4471" y="2185"/>
                    </a:lnTo>
                    <a:lnTo>
                      <a:pt x="4292" y="2224"/>
                    </a:lnTo>
                    <a:lnTo>
                      <a:pt x="4123" y="2262"/>
                    </a:lnTo>
                    <a:lnTo>
                      <a:pt x="3967" y="2300"/>
                    </a:lnTo>
                    <a:lnTo>
                      <a:pt x="3830" y="2339"/>
                    </a:lnTo>
                    <a:lnTo>
                      <a:pt x="3712" y="2377"/>
                    </a:lnTo>
                    <a:lnTo>
                      <a:pt x="3614" y="2415"/>
                    </a:lnTo>
                    <a:lnTo>
                      <a:pt x="3536" y="2454"/>
                    </a:lnTo>
                    <a:lnTo>
                      <a:pt x="3474" y="2492"/>
                    </a:lnTo>
                    <a:lnTo>
                      <a:pt x="3424" y="2530"/>
                    </a:lnTo>
                    <a:lnTo>
                      <a:pt x="3382" y="2569"/>
                    </a:lnTo>
                    <a:lnTo>
                      <a:pt x="3342" y="2607"/>
                    </a:lnTo>
                    <a:lnTo>
                      <a:pt x="3300" y="2645"/>
                    </a:lnTo>
                    <a:lnTo>
                      <a:pt x="3253" y="2684"/>
                    </a:lnTo>
                    <a:lnTo>
                      <a:pt x="3199" y="2722"/>
                    </a:lnTo>
                    <a:lnTo>
                      <a:pt x="3140" y="2760"/>
                    </a:lnTo>
                    <a:lnTo>
                      <a:pt x="3079" y="2799"/>
                    </a:lnTo>
                    <a:lnTo>
                      <a:pt x="3019" y="2837"/>
                    </a:lnTo>
                    <a:lnTo>
                      <a:pt x="2964" y="2875"/>
                    </a:lnTo>
                    <a:lnTo>
                      <a:pt x="2919" y="2914"/>
                    </a:lnTo>
                    <a:lnTo>
                      <a:pt x="2886" y="2952"/>
                    </a:lnTo>
                    <a:lnTo>
                      <a:pt x="2867" y="2990"/>
                    </a:lnTo>
                    <a:lnTo>
                      <a:pt x="2860" y="3029"/>
                    </a:lnTo>
                    <a:lnTo>
                      <a:pt x="2866" y="3067"/>
                    </a:lnTo>
                    <a:lnTo>
                      <a:pt x="2880" y="3105"/>
                    </a:lnTo>
                    <a:lnTo>
                      <a:pt x="2900" y="3144"/>
                    </a:lnTo>
                    <a:lnTo>
                      <a:pt x="2922" y="3182"/>
                    </a:lnTo>
                    <a:lnTo>
                      <a:pt x="2943" y="3220"/>
                    </a:lnTo>
                    <a:lnTo>
                      <a:pt x="2959" y="3259"/>
                    </a:lnTo>
                    <a:lnTo>
                      <a:pt x="2967" y="3297"/>
                    </a:lnTo>
                    <a:lnTo>
                      <a:pt x="2967" y="3335"/>
                    </a:lnTo>
                    <a:lnTo>
                      <a:pt x="2956" y="3374"/>
                    </a:lnTo>
                    <a:lnTo>
                      <a:pt x="2936" y="3412"/>
                    </a:lnTo>
                    <a:lnTo>
                      <a:pt x="2907" y="3450"/>
                    </a:lnTo>
                    <a:lnTo>
                      <a:pt x="2874" y="3489"/>
                    </a:lnTo>
                    <a:lnTo>
                      <a:pt x="2839" y="3527"/>
                    </a:lnTo>
                    <a:lnTo>
                      <a:pt x="2805" y="3565"/>
                    </a:lnTo>
                    <a:lnTo>
                      <a:pt x="2774" y="3604"/>
                    </a:lnTo>
                    <a:lnTo>
                      <a:pt x="2748" y="3642"/>
                    </a:lnTo>
                    <a:lnTo>
                      <a:pt x="2728" y="3680"/>
                    </a:lnTo>
                    <a:lnTo>
                      <a:pt x="2713" y="3719"/>
                    </a:lnTo>
                    <a:lnTo>
                      <a:pt x="2702" y="3757"/>
                    </a:lnTo>
                    <a:lnTo>
                      <a:pt x="2695" y="3795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5252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6" name="Freeform 293">
                <a:extLst>
                  <a:ext uri="{FF2B5EF4-FFF2-40B4-BE49-F238E27FC236}">
                    <a16:creationId xmlns:a16="http://schemas.microsoft.com/office/drawing/2014/main" id="{6B2C7EE8-4ED1-C222-E6E3-B27C779A277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03763" y="2665413"/>
                <a:ext cx="474663" cy="1397000"/>
              </a:xfrm>
              <a:custGeom>
                <a:avLst/>
                <a:gdLst>
                  <a:gd name="T0" fmla="*/ 1308 w 2622"/>
                  <a:gd name="T1" fmla="*/ 7588 h 7745"/>
                  <a:gd name="T2" fmla="*/ 1298 w 2622"/>
                  <a:gd name="T3" fmla="*/ 7275 h 7745"/>
                  <a:gd name="T4" fmla="*/ 1278 w 2622"/>
                  <a:gd name="T5" fmla="*/ 6962 h 7745"/>
                  <a:gd name="T6" fmla="*/ 1254 w 2622"/>
                  <a:gd name="T7" fmla="*/ 6650 h 7745"/>
                  <a:gd name="T8" fmla="*/ 1239 w 2622"/>
                  <a:gd name="T9" fmla="*/ 6337 h 7745"/>
                  <a:gd name="T10" fmla="*/ 1234 w 2622"/>
                  <a:gd name="T11" fmla="*/ 6024 h 7745"/>
                  <a:gd name="T12" fmla="*/ 1232 w 2622"/>
                  <a:gd name="T13" fmla="*/ 5711 h 7745"/>
                  <a:gd name="T14" fmla="*/ 1216 w 2622"/>
                  <a:gd name="T15" fmla="*/ 5398 h 7745"/>
                  <a:gd name="T16" fmla="*/ 1163 w 2622"/>
                  <a:gd name="T17" fmla="*/ 5085 h 7745"/>
                  <a:gd name="T18" fmla="*/ 1043 w 2622"/>
                  <a:gd name="T19" fmla="*/ 4772 h 7745"/>
                  <a:gd name="T20" fmla="*/ 888 w 2622"/>
                  <a:gd name="T21" fmla="*/ 4459 h 7745"/>
                  <a:gd name="T22" fmla="*/ 773 w 2622"/>
                  <a:gd name="T23" fmla="*/ 4146 h 7745"/>
                  <a:gd name="T24" fmla="*/ 653 w 2622"/>
                  <a:gd name="T25" fmla="*/ 3833 h 7745"/>
                  <a:gd name="T26" fmla="*/ 472 w 2622"/>
                  <a:gd name="T27" fmla="*/ 3520 h 7745"/>
                  <a:gd name="T28" fmla="*/ 263 w 2622"/>
                  <a:gd name="T29" fmla="*/ 3207 h 7745"/>
                  <a:gd name="T30" fmla="*/ 86 w 2622"/>
                  <a:gd name="T31" fmla="*/ 2894 h 7745"/>
                  <a:gd name="T32" fmla="*/ 0 w 2622"/>
                  <a:gd name="T33" fmla="*/ 2582 h 7745"/>
                  <a:gd name="T34" fmla="*/ 106 w 2622"/>
                  <a:gd name="T35" fmla="*/ 2269 h 7745"/>
                  <a:gd name="T36" fmla="*/ 318 w 2622"/>
                  <a:gd name="T37" fmla="*/ 1956 h 7745"/>
                  <a:gd name="T38" fmla="*/ 480 w 2622"/>
                  <a:gd name="T39" fmla="*/ 1643 h 7745"/>
                  <a:gd name="T40" fmla="*/ 725 w 2622"/>
                  <a:gd name="T41" fmla="*/ 1330 h 7745"/>
                  <a:gd name="T42" fmla="*/ 1019 w 2622"/>
                  <a:gd name="T43" fmla="*/ 1017 h 7745"/>
                  <a:gd name="T44" fmla="*/ 1205 w 2622"/>
                  <a:gd name="T45" fmla="*/ 704 h 7745"/>
                  <a:gd name="T46" fmla="*/ 1284 w 2622"/>
                  <a:gd name="T47" fmla="*/ 391 h 7745"/>
                  <a:gd name="T48" fmla="*/ 1307 w 2622"/>
                  <a:gd name="T49" fmla="*/ 78 h 7745"/>
                  <a:gd name="T50" fmla="*/ 1315 w 2622"/>
                  <a:gd name="T51" fmla="*/ 78 h 7745"/>
                  <a:gd name="T52" fmla="*/ 1338 w 2622"/>
                  <a:gd name="T53" fmla="*/ 391 h 7745"/>
                  <a:gd name="T54" fmla="*/ 1417 w 2622"/>
                  <a:gd name="T55" fmla="*/ 704 h 7745"/>
                  <a:gd name="T56" fmla="*/ 1603 w 2622"/>
                  <a:gd name="T57" fmla="*/ 1017 h 7745"/>
                  <a:gd name="T58" fmla="*/ 1897 w 2622"/>
                  <a:gd name="T59" fmla="*/ 1330 h 7745"/>
                  <a:gd name="T60" fmla="*/ 2142 w 2622"/>
                  <a:gd name="T61" fmla="*/ 1643 h 7745"/>
                  <a:gd name="T62" fmla="*/ 2304 w 2622"/>
                  <a:gd name="T63" fmla="*/ 1956 h 7745"/>
                  <a:gd name="T64" fmla="*/ 2516 w 2622"/>
                  <a:gd name="T65" fmla="*/ 2269 h 7745"/>
                  <a:gd name="T66" fmla="*/ 2622 w 2622"/>
                  <a:gd name="T67" fmla="*/ 2582 h 7745"/>
                  <a:gd name="T68" fmla="*/ 2536 w 2622"/>
                  <a:gd name="T69" fmla="*/ 2894 h 7745"/>
                  <a:gd name="T70" fmla="*/ 2359 w 2622"/>
                  <a:gd name="T71" fmla="*/ 3207 h 7745"/>
                  <a:gd name="T72" fmla="*/ 2150 w 2622"/>
                  <a:gd name="T73" fmla="*/ 3520 h 7745"/>
                  <a:gd name="T74" fmla="*/ 1969 w 2622"/>
                  <a:gd name="T75" fmla="*/ 3833 h 7745"/>
                  <a:gd name="T76" fmla="*/ 1849 w 2622"/>
                  <a:gd name="T77" fmla="*/ 4146 h 7745"/>
                  <a:gd name="T78" fmla="*/ 1734 w 2622"/>
                  <a:gd name="T79" fmla="*/ 4459 h 7745"/>
                  <a:gd name="T80" fmla="*/ 1578 w 2622"/>
                  <a:gd name="T81" fmla="*/ 4772 h 7745"/>
                  <a:gd name="T82" fmla="*/ 1459 w 2622"/>
                  <a:gd name="T83" fmla="*/ 5085 h 7745"/>
                  <a:gd name="T84" fmla="*/ 1406 w 2622"/>
                  <a:gd name="T85" fmla="*/ 5398 h 7745"/>
                  <a:gd name="T86" fmla="*/ 1390 w 2622"/>
                  <a:gd name="T87" fmla="*/ 5711 h 7745"/>
                  <a:gd name="T88" fmla="*/ 1388 w 2622"/>
                  <a:gd name="T89" fmla="*/ 6024 h 7745"/>
                  <a:gd name="T90" fmla="*/ 1383 w 2622"/>
                  <a:gd name="T91" fmla="*/ 6337 h 7745"/>
                  <a:gd name="T92" fmla="*/ 1367 w 2622"/>
                  <a:gd name="T93" fmla="*/ 6650 h 7745"/>
                  <a:gd name="T94" fmla="*/ 1344 w 2622"/>
                  <a:gd name="T95" fmla="*/ 6962 h 7745"/>
                  <a:gd name="T96" fmla="*/ 1323 w 2622"/>
                  <a:gd name="T97" fmla="*/ 7275 h 7745"/>
                  <a:gd name="T98" fmla="*/ 1314 w 2622"/>
                  <a:gd name="T99" fmla="*/ 7588 h 77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2622" h="7745">
                    <a:moveTo>
                      <a:pt x="1312" y="7745"/>
                    </a:moveTo>
                    <a:lnTo>
                      <a:pt x="1310" y="7745"/>
                    </a:lnTo>
                    <a:lnTo>
                      <a:pt x="1309" y="7667"/>
                    </a:lnTo>
                    <a:lnTo>
                      <a:pt x="1308" y="7588"/>
                    </a:lnTo>
                    <a:lnTo>
                      <a:pt x="1307" y="7510"/>
                    </a:lnTo>
                    <a:lnTo>
                      <a:pt x="1305" y="7432"/>
                    </a:lnTo>
                    <a:lnTo>
                      <a:pt x="1302" y="7354"/>
                    </a:lnTo>
                    <a:lnTo>
                      <a:pt x="1298" y="7275"/>
                    </a:lnTo>
                    <a:lnTo>
                      <a:pt x="1294" y="7197"/>
                    </a:lnTo>
                    <a:lnTo>
                      <a:pt x="1290" y="7119"/>
                    </a:lnTo>
                    <a:lnTo>
                      <a:pt x="1284" y="7041"/>
                    </a:lnTo>
                    <a:lnTo>
                      <a:pt x="1278" y="6962"/>
                    </a:lnTo>
                    <a:lnTo>
                      <a:pt x="1272" y="6884"/>
                    </a:lnTo>
                    <a:lnTo>
                      <a:pt x="1266" y="6806"/>
                    </a:lnTo>
                    <a:lnTo>
                      <a:pt x="1260" y="6728"/>
                    </a:lnTo>
                    <a:lnTo>
                      <a:pt x="1254" y="6650"/>
                    </a:lnTo>
                    <a:lnTo>
                      <a:pt x="1250" y="6571"/>
                    </a:lnTo>
                    <a:lnTo>
                      <a:pt x="1245" y="6493"/>
                    </a:lnTo>
                    <a:lnTo>
                      <a:pt x="1242" y="6415"/>
                    </a:lnTo>
                    <a:lnTo>
                      <a:pt x="1239" y="6337"/>
                    </a:lnTo>
                    <a:lnTo>
                      <a:pt x="1237" y="6258"/>
                    </a:lnTo>
                    <a:lnTo>
                      <a:pt x="1235" y="6180"/>
                    </a:lnTo>
                    <a:lnTo>
                      <a:pt x="1234" y="6102"/>
                    </a:lnTo>
                    <a:lnTo>
                      <a:pt x="1234" y="6024"/>
                    </a:lnTo>
                    <a:lnTo>
                      <a:pt x="1234" y="5945"/>
                    </a:lnTo>
                    <a:lnTo>
                      <a:pt x="1233" y="5867"/>
                    </a:lnTo>
                    <a:lnTo>
                      <a:pt x="1233" y="5789"/>
                    </a:lnTo>
                    <a:lnTo>
                      <a:pt x="1232" y="5711"/>
                    </a:lnTo>
                    <a:lnTo>
                      <a:pt x="1230" y="5633"/>
                    </a:lnTo>
                    <a:lnTo>
                      <a:pt x="1227" y="5554"/>
                    </a:lnTo>
                    <a:lnTo>
                      <a:pt x="1222" y="5476"/>
                    </a:lnTo>
                    <a:lnTo>
                      <a:pt x="1216" y="5398"/>
                    </a:lnTo>
                    <a:lnTo>
                      <a:pt x="1207" y="5320"/>
                    </a:lnTo>
                    <a:lnTo>
                      <a:pt x="1196" y="5241"/>
                    </a:lnTo>
                    <a:lnTo>
                      <a:pt x="1182" y="5163"/>
                    </a:lnTo>
                    <a:lnTo>
                      <a:pt x="1163" y="5085"/>
                    </a:lnTo>
                    <a:lnTo>
                      <a:pt x="1140" y="5007"/>
                    </a:lnTo>
                    <a:lnTo>
                      <a:pt x="1112" y="4928"/>
                    </a:lnTo>
                    <a:lnTo>
                      <a:pt x="1080" y="4850"/>
                    </a:lnTo>
                    <a:lnTo>
                      <a:pt x="1043" y="4772"/>
                    </a:lnTo>
                    <a:lnTo>
                      <a:pt x="1004" y="4694"/>
                    </a:lnTo>
                    <a:lnTo>
                      <a:pt x="964" y="4616"/>
                    </a:lnTo>
                    <a:lnTo>
                      <a:pt x="925" y="4537"/>
                    </a:lnTo>
                    <a:lnTo>
                      <a:pt x="888" y="4459"/>
                    </a:lnTo>
                    <a:lnTo>
                      <a:pt x="855" y="4381"/>
                    </a:lnTo>
                    <a:lnTo>
                      <a:pt x="826" y="4303"/>
                    </a:lnTo>
                    <a:lnTo>
                      <a:pt x="799" y="4224"/>
                    </a:lnTo>
                    <a:lnTo>
                      <a:pt x="773" y="4146"/>
                    </a:lnTo>
                    <a:lnTo>
                      <a:pt x="747" y="4068"/>
                    </a:lnTo>
                    <a:lnTo>
                      <a:pt x="719" y="3990"/>
                    </a:lnTo>
                    <a:lnTo>
                      <a:pt x="688" y="3911"/>
                    </a:lnTo>
                    <a:lnTo>
                      <a:pt x="653" y="3833"/>
                    </a:lnTo>
                    <a:lnTo>
                      <a:pt x="613" y="3755"/>
                    </a:lnTo>
                    <a:lnTo>
                      <a:pt x="570" y="3677"/>
                    </a:lnTo>
                    <a:lnTo>
                      <a:pt x="522" y="3599"/>
                    </a:lnTo>
                    <a:lnTo>
                      <a:pt x="472" y="3520"/>
                    </a:lnTo>
                    <a:lnTo>
                      <a:pt x="420" y="3442"/>
                    </a:lnTo>
                    <a:lnTo>
                      <a:pt x="367" y="3364"/>
                    </a:lnTo>
                    <a:lnTo>
                      <a:pt x="314" y="3286"/>
                    </a:lnTo>
                    <a:lnTo>
                      <a:pt x="263" y="3207"/>
                    </a:lnTo>
                    <a:lnTo>
                      <a:pt x="214" y="3129"/>
                    </a:lnTo>
                    <a:lnTo>
                      <a:pt x="168" y="3051"/>
                    </a:lnTo>
                    <a:lnTo>
                      <a:pt x="125" y="2973"/>
                    </a:lnTo>
                    <a:lnTo>
                      <a:pt x="86" y="2894"/>
                    </a:lnTo>
                    <a:lnTo>
                      <a:pt x="52" y="2816"/>
                    </a:lnTo>
                    <a:lnTo>
                      <a:pt x="25" y="2738"/>
                    </a:lnTo>
                    <a:lnTo>
                      <a:pt x="7" y="2660"/>
                    </a:lnTo>
                    <a:lnTo>
                      <a:pt x="0" y="2582"/>
                    </a:lnTo>
                    <a:lnTo>
                      <a:pt x="6" y="2503"/>
                    </a:lnTo>
                    <a:lnTo>
                      <a:pt x="26" y="2425"/>
                    </a:lnTo>
                    <a:lnTo>
                      <a:pt x="60" y="2347"/>
                    </a:lnTo>
                    <a:lnTo>
                      <a:pt x="106" y="2269"/>
                    </a:lnTo>
                    <a:lnTo>
                      <a:pt x="159" y="2190"/>
                    </a:lnTo>
                    <a:lnTo>
                      <a:pt x="215" y="2112"/>
                    </a:lnTo>
                    <a:lnTo>
                      <a:pt x="269" y="2034"/>
                    </a:lnTo>
                    <a:lnTo>
                      <a:pt x="318" y="1956"/>
                    </a:lnTo>
                    <a:lnTo>
                      <a:pt x="361" y="1877"/>
                    </a:lnTo>
                    <a:lnTo>
                      <a:pt x="400" y="1799"/>
                    </a:lnTo>
                    <a:lnTo>
                      <a:pt x="438" y="1721"/>
                    </a:lnTo>
                    <a:lnTo>
                      <a:pt x="480" y="1643"/>
                    </a:lnTo>
                    <a:lnTo>
                      <a:pt x="528" y="1564"/>
                    </a:lnTo>
                    <a:lnTo>
                      <a:pt x="585" y="1486"/>
                    </a:lnTo>
                    <a:lnTo>
                      <a:pt x="652" y="1408"/>
                    </a:lnTo>
                    <a:lnTo>
                      <a:pt x="725" y="1330"/>
                    </a:lnTo>
                    <a:lnTo>
                      <a:pt x="802" y="1252"/>
                    </a:lnTo>
                    <a:lnTo>
                      <a:pt x="879" y="1173"/>
                    </a:lnTo>
                    <a:lnTo>
                      <a:pt x="952" y="1095"/>
                    </a:lnTo>
                    <a:lnTo>
                      <a:pt x="1019" y="1017"/>
                    </a:lnTo>
                    <a:lnTo>
                      <a:pt x="1078" y="939"/>
                    </a:lnTo>
                    <a:lnTo>
                      <a:pt x="1129" y="860"/>
                    </a:lnTo>
                    <a:lnTo>
                      <a:pt x="1171" y="782"/>
                    </a:lnTo>
                    <a:lnTo>
                      <a:pt x="1205" y="704"/>
                    </a:lnTo>
                    <a:lnTo>
                      <a:pt x="1232" y="626"/>
                    </a:lnTo>
                    <a:lnTo>
                      <a:pt x="1254" y="547"/>
                    </a:lnTo>
                    <a:lnTo>
                      <a:pt x="1271" y="469"/>
                    </a:lnTo>
                    <a:lnTo>
                      <a:pt x="1284" y="391"/>
                    </a:lnTo>
                    <a:lnTo>
                      <a:pt x="1293" y="313"/>
                    </a:lnTo>
                    <a:lnTo>
                      <a:pt x="1300" y="235"/>
                    </a:lnTo>
                    <a:lnTo>
                      <a:pt x="1304" y="156"/>
                    </a:lnTo>
                    <a:lnTo>
                      <a:pt x="1307" y="78"/>
                    </a:lnTo>
                    <a:lnTo>
                      <a:pt x="1309" y="0"/>
                    </a:lnTo>
                    <a:lnTo>
                      <a:pt x="1313" y="0"/>
                    </a:lnTo>
                    <a:lnTo>
                      <a:pt x="1314" y="0"/>
                    </a:lnTo>
                    <a:lnTo>
                      <a:pt x="1315" y="78"/>
                    </a:lnTo>
                    <a:lnTo>
                      <a:pt x="1318" y="156"/>
                    </a:lnTo>
                    <a:lnTo>
                      <a:pt x="1322" y="235"/>
                    </a:lnTo>
                    <a:lnTo>
                      <a:pt x="1329" y="313"/>
                    </a:lnTo>
                    <a:lnTo>
                      <a:pt x="1338" y="391"/>
                    </a:lnTo>
                    <a:lnTo>
                      <a:pt x="1351" y="469"/>
                    </a:lnTo>
                    <a:lnTo>
                      <a:pt x="1368" y="547"/>
                    </a:lnTo>
                    <a:lnTo>
                      <a:pt x="1390" y="626"/>
                    </a:lnTo>
                    <a:lnTo>
                      <a:pt x="1417" y="704"/>
                    </a:lnTo>
                    <a:lnTo>
                      <a:pt x="1451" y="782"/>
                    </a:lnTo>
                    <a:lnTo>
                      <a:pt x="1493" y="860"/>
                    </a:lnTo>
                    <a:lnTo>
                      <a:pt x="1544" y="939"/>
                    </a:lnTo>
                    <a:lnTo>
                      <a:pt x="1603" y="1017"/>
                    </a:lnTo>
                    <a:lnTo>
                      <a:pt x="1670" y="1095"/>
                    </a:lnTo>
                    <a:lnTo>
                      <a:pt x="1743" y="1173"/>
                    </a:lnTo>
                    <a:lnTo>
                      <a:pt x="1820" y="1252"/>
                    </a:lnTo>
                    <a:lnTo>
                      <a:pt x="1897" y="1330"/>
                    </a:lnTo>
                    <a:lnTo>
                      <a:pt x="1970" y="1408"/>
                    </a:lnTo>
                    <a:lnTo>
                      <a:pt x="2037" y="1486"/>
                    </a:lnTo>
                    <a:lnTo>
                      <a:pt x="2094" y="1564"/>
                    </a:lnTo>
                    <a:lnTo>
                      <a:pt x="2142" y="1643"/>
                    </a:lnTo>
                    <a:lnTo>
                      <a:pt x="2184" y="1721"/>
                    </a:lnTo>
                    <a:lnTo>
                      <a:pt x="2222" y="1799"/>
                    </a:lnTo>
                    <a:lnTo>
                      <a:pt x="2260" y="1877"/>
                    </a:lnTo>
                    <a:lnTo>
                      <a:pt x="2304" y="1956"/>
                    </a:lnTo>
                    <a:lnTo>
                      <a:pt x="2353" y="2034"/>
                    </a:lnTo>
                    <a:lnTo>
                      <a:pt x="2407" y="2112"/>
                    </a:lnTo>
                    <a:lnTo>
                      <a:pt x="2463" y="2190"/>
                    </a:lnTo>
                    <a:lnTo>
                      <a:pt x="2516" y="2269"/>
                    </a:lnTo>
                    <a:lnTo>
                      <a:pt x="2562" y="2347"/>
                    </a:lnTo>
                    <a:lnTo>
                      <a:pt x="2596" y="2425"/>
                    </a:lnTo>
                    <a:lnTo>
                      <a:pt x="2616" y="2503"/>
                    </a:lnTo>
                    <a:lnTo>
                      <a:pt x="2622" y="2582"/>
                    </a:lnTo>
                    <a:lnTo>
                      <a:pt x="2615" y="2660"/>
                    </a:lnTo>
                    <a:lnTo>
                      <a:pt x="2597" y="2738"/>
                    </a:lnTo>
                    <a:lnTo>
                      <a:pt x="2570" y="2816"/>
                    </a:lnTo>
                    <a:lnTo>
                      <a:pt x="2536" y="2894"/>
                    </a:lnTo>
                    <a:lnTo>
                      <a:pt x="2497" y="2973"/>
                    </a:lnTo>
                    <a:lnTo>
                      <a:pt x="2454" y="3051"/>
                    </a:lnTo>
                    <a:lnTo>
                      <a:pt x="2408" y="3129"/>
                    </a:lnTo>
                    <a:lnTo>
                      <a:pt x="2359" y="3207"/>
                    </a:lnTo>
                    <a:lnTo>
                      <a:pt x="2308" y="3286"/>
                    </a:lnTo>
                    <a:lnTo>
                      <a:pt x="2255" y="3364"/>
                    </a:lnTo>
                    <a:lnTo>
                      <a:pt x="2202" y="3442"/>
                    </a:lnTo>
                    <a:lnTo>
                      <a:pt x="2150" y="3520"/>
                    </a:lnTo>
                    <a:lnTo>
                      <a:pt x="2100" y="3599"/>
                    </a:lnTo>
                    <a:lnTo>
                      <a:pt x="2052" y="3677"/>
                    </a:lnTo>
                    <a:lnTo>
                      <a:pt x="2009" y="3755"/>
                    </a:lnTo>
                    <a:lnTo>
                      <a:pt x="1969" y="3833"/>
                    </a:lnTo>
                    <a:lnTo>
                      <a:pt x="1934" y="3911"/>
                    </a:lnTo>
                    <a:lnTo>
                      <a:pt x="1903" y="3990"/>
                    </a:lnTo>
                    <a:lnTo>
                      <a:pt x="1875" y="4068"/>
                    </a:lnTo>
                    <a:lnTo>
                      <a:pt x="1849" y="4146"/>
                    </a:lnTo>
                    <a:lnTo>
                      <a:pt x="1823" y="4224"/>
                    </a:lnTo>
                    <a:lnTo>
                      <a:pt x="1796" y="4303"/>
                    </a:lnTo>
                    <a:lnTo>
                      <a:pt x="1767" y="4381"/>
                    </a:lnTo>
                    <a:lnTo>
                      <a:pt x="1734" y="4459"/>
                    </a:lnTo>
                    <a:lnTo>
                      <a:pt x="1697" y="4537"/>
                    </a:lnTo>
                    <a:lnTo>
                      <a:pt x="1658" y="4616"/>
                    </a:lnTo>
                    <a:lnTo>
                      <a:pt x="1618" y="4694"/>
                    </a:lnTo>
                    <a:lnTo>
                      <a:pt x="1578" y="4772"/>
                    </a:lnTo>
                    <a:lnTo>
                      <a:pt x="1542" y="4850"/>
                    </a:lnTo>
                    <a:lnTo>
                      <a:pt x="1510" y="4928"/>
                    </a:lnTo>
                    <a:lnTo>
                      <a:pt x="1482" y="5007"/>
                    </a:lnTo>
                    <a:lnTo>
                      <a:pt x="1459" y="5085"/>
                    </a:lnTo>
                    <a:lnTo>
                      <a:pt x="1440" y="5163"/>
                    </a:lnTo>
                    <a:lnTo>
                      <a:pt x="1426" y="5241"/>
                    </a:lnTo>
                    <a:lnTo>
                      <a:pt x="1414" y="5320"/>
                    </a:lnTo>
                    <a:lnTo>
                      <a:pt x="1406" y="5398"/>
                    </a:lnTo>
                    <a:lnTo>
                      <a:pt x="1400" y="5476"/>
                    </a:lnTo>
                    <a:lnTo>
                      <a:pt x="1395" y="5554"/>
                    </a:lnTo>
                    <a:lnTo>
                      <a:pt x="1392" y="5633"/>
                    </a:lnTo>
                    <a:lnTo>
                      <a:pt x="1390" y="5711"/>
                    </a:lnTo>
                    <a:lnTo>
                      <a:pt x="1389" y="5789"/>
                    </a:lnTo>
                    <a:lnTo>
                      <a:pt x="1388" y="5867"/>
                    </a:lnTo>
                    <a:lnTo>
                      <a:pt x="1388" y="5945"/>
                    </a:lnTo>
                    <a:lnTo>
                      <a:pt x="1388" y="6024"/>
                    </a:lnTo>
                    <a:lnTo>
                      <a:pt x="1388" y="6102"/>
                    </a:lnTo>
                    <a:lnTo>
                      <a:pt x="1387" y="6180"/>
                    </a:lnTo>
                    <a:lnTo>
                      <a:pt x="1385" y="6258"/>
                    </a:lnTo>
                    <a:lnTo>
                      <a:pt x="1383" y="6337"/>
                    </a:lnTo>
                    <a:lnTo>
                      <a:pt x="1380" y="6415"/>
                    </a:lnTo>
                    <a:lnTo>
                      <a:pt x="1377" y="6493"/>
                    </a:lnTo>
                    <a:lnTo>
                      <a:pt x="1372" y="6571"/>
                    </a:lnTo>
                    <a:lnTo>
                      <a:pt x="1367" y="6650"/>
                    </a:lnTo>
                    <a:lnTo>
                      <a:pt x="1362" y="6728"/>
                    </a:lnTo>
                    <a:lnTo>
                      <a:pt x="1356" y="6806"/>
                    </a:lnTo>
                    <a:lnTo>
                      <a:pt x="1350" y="6884"/>
                    </a:lnTo>
                    <a:lnTo>
                      <a:pt x="1344" y="6962"/>
                    </a:lnTo>
                    <a:lnTo>
                      <a:pt x="1338" y="7041"/>
                    </a:lnTo>
                    <a:lnTo>
                      <a:pt x="1332" y="7119"/>
                    </a:lnTo>
                    <a:lnTo>
                      <a:pt x="1328" y="7197"/>
                    </a:lnTo>
                    <a:lnTo>
                      <a:pt x="1323" y="7275"/>
                    </a:lnTo>
                    <a:lnTo>
                      <a:pt x="1320" y="7354"/>
                    </a:lnTo>
                    <a:lnTo>
                      <a:pt x="1317" y="7432"/>
                    </a:lnTo>
                    <a:lnTo>
                      <a:pt x="1315" y="7510"/>
                    </a:lnTo>
                    <a:lnTo>
                      <a:pt x="1314" y="7588"/>
                    </a:lnTo>
                    <a:lnTo>
                      <a:pt x="1313" y="7667"/>
                    </a:lnTo>
                    <a:lnTo>
                      <a:pt x="1312" y="7745"/>
                    </a:lnTo>
                    <a:close/>
                  </a:path>
                </a:pathLst>
              </a:custGeom>
              <a:solidFill>
                <a:srgbClr val="B55D60"/>
              </a:solidFill>
              <a:ln w="14288" cap="flat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14288" cap="flat">
                    <a:solidFill>
                      <a:srgbClr val="525252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7" name="Freeform 294">
                <a:extLst>
                  <a:ext uri="{FF2B5EF4-FFF2-40B4-BE49-F238E27FC236}">
                    <a16:creationId xmlns:a16="http://schemas.microsoft.com/office/drawing/2014/main" id="{55FBB6BB-D80F-2CF2-5C20-984D10CE2AC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03763" y="2665413"/>
                <a:ext cx="474663" cy="1397000"/>
              </a:xfrm>
              <a:custGeom>
                <a:avLst/>
                <a:gdLst>
                  <a:gd name="T0" fmla="*/ 1308 w 2622"/>
                  <a:gd name="T1" fmla="*/ 7588 h 7745"/>
                  <a:gd name="T2" fmla="*/ 1298 w 2622"/>
                  <a:gd name="T3" fmla="*/ 7275 h 7745"/>
                  <a:gd name="T4" fmla="*/ 1278 w 2622"/>
                  <a:gd name="T5" fmla="*/ 6962 h 7745"/>
                  <a:gd name="T6" fmla="*/ 1254 w 2622"/>
                  <a:gd name="T7" fmla="*/ 6650 h 7745"/>
                  <a:gd name="T8" fmla="*/ 1239 w 2622"/>
                  <a:gd name="T9" fmla="*/ 6337 h 7745"/>
                  <a:gd name="T10" fmla="*/ 1234 w 2622"/>
                  <a:gd name="T11" fmla="*/ 6024 h 7745"/>
                  <a:gd name="T12" fmla="*/ 1232 w 2622"/>
                  <a:gd name="T13" fmla="*/ 5711 h 7745"/>
                  <a:gd name="T14" fmla="*/ 1216 w 2622"/>
                  <a:gd name="T15" fmla="*/ 5398 h 7745"/>
                  <a:gd name="T16" fmla="*/ 1163 w 2622"/>
                  <a:gd name="T17" fmla="*/ 5085 h 7745"/>
                  <a:gd name="T18" fmla="*/ 1043 w 2622"/>
                  <a:gd name="T19" fmla="*/ 4772 h 7745"/>
                  <a:gd name="T20" fmla="*/ 888 w 2622"/>
                  <a:gd name="T21" fmla="*/ 4459 h 7745"/>
                  <a:gd name="T22" fmla="*/ 773 w 2622"/>
                  <a:gd name="T23" fmla="*/ 4146 h 7745"/>
                  <a:gd name="T24" fmla="*/ 653 w 2622"/>
                  <a:gd name="T25" fmla="*/ 3833 h 7745"/>
                  <a:gd name="T26" fmla="*/ 472 w 2622"/>
                  <a:gd name="T27" fmla="*/ 3520 h 7745"/>
                  <a:gd name="T28" fmla="*/ 263 w 2622"/>
                  <a:gd name="T29" fmla="*/ 3207 h 7745"/>
                  <a:gd name="T30" fmla="*/ 86 w 2622"/>
                  <a:gd name="T31" fmla="*/ 2894 h 7745"/>
                  <a:gd name="T32" fmla="*/ 0 w 2622"/>
                  <a:gd name="T33" fmla="*/ 2582 h 7745"/>
                  <a:gd name="T34" fmla="*/ 106 w 2622"/>
                  <a:gd name="T35" fmla="*/ 2269 h 7745"/>
                  <a:gd name="T36" fmla="*/ 318 w 2622"/>
                  <a:gd name="T37" fmla="*/ 1956 h 7745"/>
                  <a:gd name="T38" fmla="*/ 480 w 2622"/>
                  <a:gd name="T39" fmla="*/ 1643 h 7745"/>
                  <a:gd name="T40" fmla="*/ 725 w 2622"/>
                  <a:gd name="T41" fmla="*/ 1330 h 7745"/>
                  <a:gd name="T42" fmla="*/ 1019 w 2622"/>
                  <a:gd name="T43" fmla="*/ 1017 h 7745"/>
                  <a:gd name="T44" fmla="*/ 1205 w 2622"/>
                  <a:gd name="T45" fmla="*/ 704 h 7745"/>
                  <a:gd name="T46" fmla="*/ 1284 w 2622"/>
                  <a:gd name="T47" fmla="*/ 391 h 7745"/>
                  <a:gd name="T48" fmla="*/ 1307 w 2622"/>
                  <a:gd name="T49" fmla="*/ 78 h 7745"/>
                  <a:gd name="T50" fmla="*/ 1315 w 2622"/>
                  <a:gd name="T51" fmla="*/ 78 h 7745"/>
                  <a:gd name="T52" fmla="*/ 1338 w 2622"/>
                  <a:gd name="T53" fmla="*/ 391 h 7745"/>
                  <a:gd name="T54" fmla="*/ 1417 w 2622"/>
                  <a:gd name="T55" fmla="*/ 704 h 7745"/>
                  <a:gd name="T56" fmla="*/ 1603 w 2622"/>
                  <a:gd name="T57" fmla="*/ 1017 h 7745"/>
                  <a:gd name="T58" fmla="*/ 1897 w 2622"/>
                  <a:gd name="T59" fmla="*/ 1330 h 7745"/>
                  <a:gd name="T60" fmla="*/ 2142 w 2622"/>
                  <a:gd name="T61" fmla="*/ 1643 h 7745"/>
                  <a:gd name="T62" fmla="*/ 2304 w 2622"/>
                  <a:gd name="T63" fmla="*/ 1956 h 7745"/>
                  <a:gd name="T64" fmla="*/ 2516 w 2622"/>
                  <a:gd name="T65" fmla="*/ 2269 h 7745"/>
                  <a:gd name="T66" fmla="*/ 2622 w 2622"/>
                  <a:gd name="T67" fmla="*/ 2582 h 7745"/>
                  <a:gd name="T68" fmla="*/ 2536 w 2622"/>
                  <a:gd name="T69" fmla="*/ 2894 h 7745"/>
                  <a:gd name="T70" fmla="*/ 2359 w 2622"/>
                  <a:gd name="T71" fmla="*/ 3207 h 7745"/>
                  <a:gd name="T72" fmla="*/ 2150 w 2622"/>
                  <a:gd name="T73" fmla="*/ 3520 h 7745"/>
                  <a:gd name="T74" fmla="*/ 1969 w 2622"/>
                  <a:gd name="T75" fmla="*/ 3833 h 7745"/>
                  <a:gd name="T76" fmla="*/ 1849 w 2622"/>
                  <a:gd name="T77" fmla="*/ 4146 h 7745"/>
                  <a:gd name="T78" fmla="*/ 1734 w 2622"/>
                  <a:gd name="T79" fmla="*/ 4459 h 7745"/>
                  <a:gd name="T80" fmla="*/ 1578 w 2622"/>
                  <a:gd name="T81" fmla="*/ 4772 h 7745"/>
                  <a:gd name="T82" fmla="*/ 1459 w 2622"/>
                  <a:gd name="T83" fmla="*/ 5085 h 7745"/>
                  <a:gd name="T84" fmla="*/ 1406 w 2622"/>
                  <a:gd name="T85" fmla="*/ 5398 h 7745"/>
                  <a:gd name="T86" fmla="*/ 1390 w 2622"/>
                  <a:gd name="T87" fmla="*/ 5711 h 7745"/>
                  <a:gd name="T88" fmla="*/ 1388 w 2622"/>
                  <a:gd name="T89" fmla="*/ 6024 h 7745"/>
                  <a:gd name="T90" fmla="*/ 1383 w 2622"/>
                  <a:gd name="T91" fmla="*/ 6337 h 7745"/>
                  <a:gd name="T92" fmla="*/ 1367 w 2622"/>
                  <a:gd name="T93" fmla="*/ 6650 h 7745"/>
                  <a:gd name="T94" fmla="*/ 1344 w 2622"/>
                  <a:gd name="T95" fmla="*/ 6962 h 7745"/>
                  <a:gd name="T96" fmla="*/ 1323 w 2622"/>
                  <a:gd name="T97" fmla="*/ 7275 h 7745"/>
                  <a:gd name="T98" fmla="*/ 1314 w 2622"/>
                  <a:gd name="T99" fmla="*/ 7588 h 77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2622" h="7745">
                    <a:moveTo>
                      <a:pt x="1312" y="7745"/>
                    </a:moveTo>
                    <a:lnTo>
                      <a:pt x="1310" y="7745"/>
                    </a:lnTo>
                    <a:lnTo>
                      <a:pt x="1309" y="7667"/>
                    </a:lnTo>
                    <a:lnTo>
                      <a:pt x="1308" y="7588"/>
                    </a:lnTo>
                    <a:lnTo>
                      <a:pt x="1307" y="7510"/>
                    </a:lnTo>
                    <a:lnTo>
                      <a:pt x="1305" y="7432"/>
                    </a:lnTo>
                    <a:lnTo>
                      <a:pt x="1302" y="7354"/>
                    </a:lnTo>
                    <a:lnTo>
                      <a:pt x="1298" y="7275"/>
                    </a:lnTo>
                    <a:lnTo>
                      <a:pt x="1294" y="7197"/>
                    </a:lnTo>
                    <a:lnTo>
                      <a:pt x="1290" y="7119"/>
                    </a:lnTo>
                    <a:lnTo>
                      <a:pt x="1284" y="7041"/>
                    </a:lnTo>
                    <a:lnTo>
                      <a:pt x="1278" y="6962"/>
                    </a:lnTo>
                    <a:lnTo>
                      <a:pt x="1272" y="6884"/>
                    </a:lnTo>
                    <a:lnTo>
                      <a:pt x="1266" y="6806"/>
                    </a:lnTo>
                    <a:lnTo>
                      <a:pt x="1260" y="6728"/>
                    </a:lnTo>
                    <a:lnTo>
                      <a:pt x="1254" y="6650"/>
                    </a:lnTo>
                    <a:lnTo>
                      <a:pt x="1250" y="6571"/>
                    </a:lnTo>
                    <a:lnTo>
                      <a:pt x="1245" y="6493"/>
                    </a:lnTo>
                    <a:lnTo>
                      <a:pt x="1242" y="6415"/>
                    </a:lnTo>
                    <a:lnTo>
                      <a:pt x="1239" y="6337"/>
                    </a:lnTo>
                    <a:lnTo>
                      <a:pt x="1237" y="6258"/>
                    </a:lnTo>
                    <a:lnTo>
                      <a:pt x="1235" y="6180"/>
                    </a:lnTo>
                    <a:lnTo>
                      <a:pt x="1234" y="6102"/>
                    </a:lnTo>
                    <a:lnTo>
                      <a:pt x="1234" y="6024"/>
                    </a:lnTo>
                    <a:lnTo>
                      <a:pt x="1234" y="5945"/>
                    </a:lnTo>
                    <a:lnTo>
                      <a:pt x="1233" y="5867"/>
                    </a:lnTo>
                    <a:lnTo>
                      <a:pt x="1233" y="5789"/>
                    </a:lnTo>
                    <a:lnTo>
                      <a:pt x="1232" y="5711"/>
                    </a:lnTo>
                    <a:lnTo>
                      <a:pt x="1230" y="5633"/>
                    </a:lnTo>
                    <a:lnTo>
                      <a:pt x="1227" y="5554"/>
                    </a:lnTo>
                    <a:lnTo>
                      <a:pt x="1222" y="5476"/>
                    </a:lnTo>
                    <a:lnTo>
                      <a:pt x="1216" y="5398"/>
                    </a:lnTo>
                    <a:lnTo>
                      <a:pt x="1207" y="5320"/>
                    </a:lnTo>
                    <a:lnTo>
                      <a:pt x="1196" y="5241"/>
                    </a:lnTo>
                    <a:lnTo>
                      <a:pt x="1182" y="5163"/>
                    </a:lnTo>
                    <a:lnTo>
                      <a:pt x="1163" y="5085"/>
                    </a:lnTo>
                    <a:lnTo>
                      <a:pt x="1140" y="5007"/>
                    </a:lnTo>
                    <a:lnTo>
                      <a:pt x="1112" y="4928"/>
                    </a:lnTo>
                    <a:lnTo>
                      <a:pt x="1080" y="4850"/>
                    </a:lnTo>
                    <a:lnTo>
                      <a:pt x="1043" y="4772"/>
                    </a:lnTo>
                    <a:lnTo>
                      <a:pt x="1004" y="4694"/>
                    </a:lnTo>
                    <a:lnTo>
                      <a:pt x="964" y="4616"/>
                    </a:lnTo>
                    <a:lnTo>
                      <a:pt x="925" y="4537"/>
                    </a:lnTo>
                    <a:lnTo>
                      <a:pt x="888" y="4459"/>
                    </a:lnTo>
                    <a:lnTo>
                      <a:pt x="855" y="4381"/>
                    </a:lnTo>
                    <a:lnTo>
                      <a:pt x="826" y="4303"/>
                    </a:lnTo>
                    <a:lnTo>
                      <a:pt x="799" y="4224"/>
                    </a:lnTo>
                    <a:lnTo>
                      <a:pt x="773" y="4146"/>
                    </a:lnTo>
                    <a:lnTo>
                      <a:pt x="747" y="4068"/>
                    </a:lnTo>
                    <a:lnTo>
                      <a:pt x="719" y="3990"/>
                    </a:lnTo>
                    <a:lnTo>
                      <a:pt x="688" y="3911"/>
                    </a:lnTo>
                    <a:lnTo>
                      <a:pt x="653" y="3833"/>
                    </a:lnTo>
                    <a:lnTo>
                      <a:pt x="613" y="3755"/>
                    </a:lnTo>
                    <a:lnTo>
                      <a:pt x="570" y="3677"/>
                    </a:lnTo>
                    <a:lnTo>
                      <a:pt x="522" y="3599"/>
                    </a:lnTo>
                    <a:lnTo>
                      <a:pt x="472" y="3520"/>
                    </a:lnTo>
                    <a:lnTo>
                      <a:pt x="420" y="3442"/>
                    </a:lnTo>
                    <a:lnTo>
                      <a:pt x="367" y="3364"/>
                    </a:lnTo>
                    <a:lnTo>
                      <a:pt x="314" y="3286"/>
                    </a:lnTo>
                    <a:lnTo>
                      <a:pt x="263" y="3207"/>
                    </a:lnTo>
                    <a:lnTo>
                      <a:pt x="214" y="3129"/>
                    </a:lnTo>
                    <a:lnTo>
                      <a:pt x="168" y="3051"/>
                    </a:lnTo>
                    <a:lnTo>
                      <a:pt x="125" y="2973"/>
                    </a:lnTo>
                    <a:lnTo>
                      <a:pt x="86" y="2894"/>
                    </a:lnTo>
                    <a:lnTo>
                      <a:pt x="52" y="2816"/>
                    </a:lnTo>
                    <a:lnTo>
                      <a:pt x="25" y="2738"/>
                    </a:lnTo>
                    <a:lnTo>
                      <a:pt x="7" y="2660"/>
                    </a:lnTo>
                    <a:lnTo>
                      <a:pt x="0" y="2582"/>
                    </a:lnTo>
                    <a:lnTo>
                      <a:pt x="6" y="2503"/>
                    </a:lnTo>
                    <a:lnTo>
                      <a:pt x="26" y="2425"/>
                    </a:lnTo>
                    <a:lnTo>
                      <a:pt x="60" y="2347"/>
                    </a:lnTo>
                    <a:lnTo>
                      <a:pt x="106" y="2269"/>
                    </a:lnTo>
                    <a:lnTo>
                      <a:pt x="159" y="2190"/>
                    </a:lnTo>
                    <a:lnTo>
                      <a:pt x="215" y="2112"/>
                    </a:lnTo>
                    <a:lnTo>
                      <a:pt x="269" y="2034"/>
                    </a:lnTo>
                    <a:lnTo>
                      <a:pt x="318" y="1956"/>
                    </a:lnTo>
                    <a:lnTo>
                      <a:pt x="361" y="1877"/>
                    </a:lnTo>
                    <a:lnTo>
                      <a:pt x="400" y="1799"/>
                    </a:lnTo>
                    <a:lnTo>
                      <a:pt x="438" y="1721"/>
                    </a:lnTo>
                    <a:lnTo>
                      <a:pt x="480" y="1643"/>
                    </a:lnTo>
                    <a:lnTo>
                      <a:pt x="528" y="1564"/>
                    </a:lnTo>
                    <a:lnTo>
                      <a:pt x="585" y="1486"/>
                    </a:lnTo>
                    <a:lnTo>
                      <a:pt x="652" y="1408"/>
                    </a:lnTo>
                    <a:lnTo>
                      <a:pt x="725" y="1330"/>
                    </a:lnTo>
                    <a:lnTo>
                      <a:pt x="802" y="1252"/>
                    </a:lnTo>
                    <a:lnTo>
                      <a:pt x="879" y="1173"/>
                    </a:lnTo>
                    <a:lnTo>
                      <a:pt x="952" y="1095"/>
                    </a:lnTo>
                    <a:lnTo>
                      <a:pt x="1019" y="1017"/>
                    </a:lnTo>
                    <a:lnTo>
                      <a:pt x="1078" y="939"/>
                    </a:lnTo>
                    <a:lnTo>
                      <a:pt x="1129" y="860"/>
                    </a:lnTo>
                    <a:lnTo>
                      <a:pt x="1171" y="782"/>
                    </a:lnTo>
                    <a:lnTo>
                      <a:pt x="1205" y="704"/>
                    </a:lnTo>
                    <a:lnTo>
                      <a:pt x="1232" y="626"/>
                    </a:lnTo>
                    <a:lnTo>
                      <a:pt x="1254" y="547"/>
                    </a:lnTo>
                    <a:lnTo>
                      <a:pt x="1271" y="469"/>
                    </a:lnTo>
                    <a:lnTo>
                      <a:pt x="1284" y="391"/>
                    </a:lnTo>
                    <a:lnTo>
                      <a:pt x="1293" y="313"/>
                    </a:lnTo>
                    <a:lnTo>
                      <a:pt x="1300" y="235"/>
                    </a:lnTo>
                    <a:lnTo>
                      <a:pt x="1304" y="156"/>
                    </a:lnTo>
                    <a:lnTo>
                      <a:pt x="1307" y="78"/>
                    </a:lnTo>
                    <a:lnTo>
                      <a:pt x="1309" y="0"/>
                    </a:lnTo>
                    <a:lnTo>
                      <a:pt x="1313" y="0"/>
                    </a:lnTo>
                    <a:lnTo>
                      <a:pt x="1314" y="0"/>
                    </a:lnTo>
                    <a:lnTo>
                      <a:pt x="1315" y="78"/>
                    </a:lnTo>
                    <a:lnTo>
                      <a:pt x="1318" y="156"/>
                    </a:lnTo>
                    <a:lnTo>
                      <a:pt x="1322" y="235"/>
                    </a:lnTo>
                    <a:lnTo>
                      <a:pt x="1329" y="313"/>
                    </a:lnTo>
                    <a:lnTo>
                      <a:pt x="1338" y="391"/>
                    </a:lnTo>
                    <a:lnTo>
                      <a:pt x="1351" y="469"/>
                    </a:lnTo>
                    <a:lnTo>
                      <a:pt x="1368" y="547"/>
                    </a:lnTo>
                    <a:lnTo>
                      <a:pt x="1390" y="626"/>
                    </a:lnTo>
                    <a:lnTo>
                      <a:pt x="1417" y="704"/>
                    </a:lnTo>
                    <a:lnTo>
                      <a:pt x="1451" y="782"/>
                    </a:lnTo>
                    <a:lnTo>
                      <a:pt x="1493" y="860"/>
                    </a:lnTo>
                    <a:lnTo>
                      <a:pt x="1544" y="939"/>
                    </a:lnTo>
                    <a:lnTo>
                      <a:pt x="1603" y="1017"/>
                    </a:lnTo>
                    <a:lnTo>
                      <a:pt x="1670" y="1095"/>
                    </a:lnTo>
                    <a:lnTo>
                      <a:pt x="1743" y="1173"/>
                    </a:lnTo>
                    <a:lnTo>
                      <a:pt x="1820" y="1252"/>
                    </a:lnTo>
                    <a:lnTo>
                      <a:pt x="1897" y="1330"/>
                    </a:lnTo>
                    <a:lnTo>
                      <a:pt x="1970" y="1408"/>
                    </a:lnTo>
                    <a:lnTo>
                      <a:pt x="2037" y="1486"/>
                    </a:lnTo>
                    <a:lnTo>
                      <a:pt x="2094" y="1564"/>
                    </a:lnTo>
                    <a:lnTo>
                      <a:pt x="2142" y="1643"/>
                    </a:lnTo>
                    <a:lnTo>
                      <a:pt x="2184" y="1721"/>
                    </a:lnTo>
                    <a:lnTo>
                      <a:pt x="2222" y="1799"/>
                    </a:lnTo>
                    <a:lnTo>
                      <a:pt x="2260" y="1877"/>
                    </a:lnTo>
                    <a:lnTo>
                      <a:pt x="2304" y="1956"/>
                    </a:lnTo>
                    <a:lnTo>
                      <a:pt x="2353" y="2034"/>
                    </a:lnTo>
                    <a:lnTo>
                      <a:pt x="2407" y="2112"/>
                    </a:lnTo>
                    <a:lnTo>
                      <a:pt x="2463" y="2190"/>
                    </a:lnTo>
                    <a:lnTo>
                      <a:pt x="2516" y="2269"/>
                    </a:lnTo>
                    <a:lnTo>
                      <a:pt x="2562" y="2347"/>
                    </a:lnTo>
                    <a:lnTo>
                      <a:pt x="2596" y="2425"/>
                    </a:lnTo>
                    <a:lnTo>
                      <a:pt x="2616" y="2503"/>
                    </a:lnTo>
                    <a:lnTo>
                      <a:pt x="2622" y="2582"/>
                    </a:lnTo>
                    <a:lnTo>
                      <a:pt x="2615" y="2660"/>
                    </a:lnTo>
                    <a:lnTo>
                      <a:pt x="2597" y="2738"/>
                    </a:lnTo>
                    <a:lnTo>
                      <a:pt x="2570" y="2816"/>
                    </a:lnTo>
                    <a:lnTo>
                      <a:pt x="2536" y="2894"/>
                    </a:lnTo>
                    <a:lnTo>
                      <a:pt x="2497" y="2973"/>
                    </a:lnTo>
                    <a:lnTo>
                      <a:pt x="2454" y="3051"/>
                    </a:lnTo>
                    <a:lnTo>
                      <a:pt x="2408" y="3129"/>
                    </a:lnTo>
                    <a:lnTo>
                      <a:pt x="2359" y="3207"/>
                    </a:lnTo>
                    <a:lnTo>
                      <a:pt x="2308" y="3286"/>
                    </a:lnTo>
                    <a:lnTo>
                      <a:pt x="2255" y="3364"/>
                    </a:lnTo>
                    <a:lnTo>
                      <a:pt x="2202" y="3442"/>
                    </a:lnTo>
                    <a:lnTo>
                      <a:pt x="2150" y="3520"/>
                    </a:lnTo>
                    <a:lnTo>
                      <a:pt x="2100" y="3599"/>
                    </a:lnTo>
                    <a:lnTo>
                      <a:pt x="2052" y="3677"/>
                    </a:lnTo>
                    <a:lnTo>
                      <a:pt x="2009" y="3755"/>
                    </a:lnTo>
                    <a:lnTo>
                      <a:pt x="1969" y="3833"/>
                    </a:lnTo>
                    <a:lnTo>
                      <a:pt x="1934" y="3911"/>
                    </a:lnTo>
                    <a:lnTo>
                      <a:pt x="1903" y="3990"/>
                    </a:lnTo>
                    <a:lnTo>
                      <a:pt x="1875" y="4068"/>
                    </a:lnTo>
                    <a:lnTo>
                      <a:pt x="1849" y="4146"/>
                    </a:lnTo>
                    <a:lnTo>
                      <a:pt x="1823" y="4224"/>
                    </a:lnTo>
                    <a:lnTo>
                      <a:pt x="1796" y="4303"/>
                    </a:lnTo>
                    <a:lnTo>
                      <a:pt x="1767" y="4381"/>
                    </a:lnTo>
                    <a:lnTo>
                      <a:pt x="1734" y="4459"/>
                    </a:lnTo>
                    <a:lnTo>
                      <a:pt x="1697" y="4537"/>
                    </a:lnTo>
                    <a:lnTo>
                      <a:pt x="1658" y="4616"/>
                    </a:lnTo>
                    <a:lnTo>
                      <a:pt x="1618" y="4694"/>
                    </a:lnTo>
                    <a:lnTo>
                      <a:pt x="1578" y="4772"/>
                    </a:lnTo>
                    <a:lnTo>
                      <a:pt x="1542" y="4850"/>
                    </a:lnTo>
                    <a:lnTo>
                      <a:pt x="1510" y="4928"/>
                    </a:lnTo>
                    <a:lnTo>
                      <a:pt x="1482" y="5007"/>
                    </a:lnTo>
                    <a:lnTo>
                      <a:pt x="1459" y="5085"/>
                    </a:lnTo>
                    <a:lnTo>
                      <a:pt x="1440" y="5163"/>
                    </a:lnTo>
                    <a:lnTo>
                      <a:pt x="1426" y="5241"/>
                    </a:lnTo>
                    <a:lnTo>
                      <a:pt x="1414" y="5320"/>
                    </a:lnTo>
                    <a:lnTo>
                      <a:pt x="1406" y="5398"/>
                    </a:lnTo>
                    <a:lnTo>
                      <a:pt x="1400" y="5476"/>
                    </a:lnTo>
                    <a:lnTo>
                      <a:pt x="1395" y="5554"/>
                    </a:lnTo>
                    <a:lnTo>
                      <a:pt x="1392" y="5633"/>
                    </a:lnTo>
                    <a:lnTo>
                      <a:pt x="1390" y="5711"/>
                    </a:lnTo>
                    <a:lnTo>
                      <a:pt x="1389" y="5789"/>
                    </a:lnTo>
                    <a:lnTo>
                      <a:pt x="1388" y="5867"/>
                    </a:lnTo>
                    <a:lnTo>
                      <a:pt x="1388" y="5945"/>
                    </a:lnTo>
                    <a:lnTo>
                      <a:pt x="1388" y="6024"/>
                    </a:lnTo>
                    <a:lnTo>
                      <a:pt x="1388" y="6102"/>
                    </a:lnTo>
                    <a:lnTo>
                      <a:pt x="1387" y="6180"/>
                    </a:lnTo>
                    <a:lnTo>
                      <a:pt x="1385" y="6258"/>
                    </a:lnTo>
                    <a:lnTo>
                      <a:pt x="1383" y="6337"/>
                    </a:lnTo>
                    <a:lnTo>
                      <a:pt x="1380" y="6415"/>
                    </a:lnTo>
                    <a:lnTo>
                      <a:pt x="1377" y="6493"/>
                    </a:lnTo>
                    <a:lnTo>
                      <a:pt x="1372" y="6571"/>
                    </a:lnTo>
                    <a:lnTo>
                      <a:pt x="1367" y="6650"/>
                    </a:lnTo>
                    <a:lnTo>
                      <a:pt x="1362" y="6728"/>
                    </a:lnTo>
                    <a:lnTo>
                      <a:pt x="1356" y="6806"/>
                    </a:lnTo>
                    <a:lnTo>
                      <a:pt x="1350" y="6884"/>
                    </a:lnTo>
                    <a:lnTo>
                      <a:pt x="1344" y="6962"/>
                    </a:lnTo>
                    <a:lnTo>
                      <a:pt x="1338" y="7041"/>
                    </a:lnTo>
                    <a:lnTo>
                      <a:pt x="1332" y="7119"/>
                    </a:lnTo>
                    <a:lnTo>
                      <a:pt x="1328" y="7197"/>
                    </a:lnTo>
                    <a:lnTo>
                      <a:pt x="1323" y="7275"/>
                    </a:lnTo>
                    <a:lnTo>
                      <a:pt x="1320" y="7354"/>
                    </a:lnTo>
                    <a:lnTo>
                      <a:pt x="1317" y="7432"/>
                    </a:lnTo>
                    <a:lnTo>
                      <a:pt x="1315" y="7510"/>
                    </a:lnTo>
                    <a:lnTo>
                      <a:pt x="1314" y="7588"/>
                    </a:lnTo>
                    <a:lnTo>
                      <a:pt x="1313" y="7667"/>
                    </a:lnTo>
                    <a:lnTo>
                      <a:pt x="1312" y="7745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5252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8" name="Line 295">
                <a:extLst>
                  <a:ext uri="{FF2B5EF4-FFF2-40B4-BE49-F238E27FC236}">
                    <a16:creationId xmlns:a16="http://schemas.microsoft.com/office/drawing/2014/main" id="{209F0988-4C8B-9CF0-4A57-E6D42813E3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9038" y="4559300"/>
                <a:ext cx="0" cy="466725"/>
              </a:xfrm>
              <a:prstGeom prst="line">
                <a:avLst/>
              </a:prstGeom>
              <a:noFill/>
              <a:ln w="6350" cap="rnd">
                <a:solidFill>
                  <a:srgbClr val="5252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9" name="Line 296">
                <a:extLst>
                  <a:ext uri="{FF2B5EF4-FFF2-40B4-BE49-F238E27FC236}">
                    <a16:creationId xmlns:a16="http://schemas.microsoft.com/office/drawing/2014/main" id="{4269244A-6045-B605-C6B9-51AFC41958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9038" y="4737100"/>
                <a:ext cx="0" cy="117475"/>
              </a:xfrm>
              <a:prstGeom prst="line">
                <a:avLst/>
              </a:prstGeom>
              <a:noFill/>
              <a:ln w="19050" cap="rnd">
                <a:solidFill>
                  <a:srgbClr val="5252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80" name="Line 297">
                <a:extLst>
                  <a:ext uri="{FF2B5EF4-FFF2-40B4-BE49-F238E27FC236}">
                    <a16:creationId xmlns:a16="http://schemas.microsoft.com/office/drawing/2014/main" id="{AE626223-0E39-18E5-A090-5509CD8BE0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40300" y="2774950"/>
                <a:ext cx="0" cy="896938"/>
              </a:xfrm>
              <a:prstGeom prst="line">
                <a:avLst/>
              </a:prstGeom>
              <a:noFill/>
              <a:ln w="6350" cap="rnd">
                <a:solidFill>
                  <a:srgbClr val="5252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81" name="Line 298">
                <a:extLst>
                  <a:ext uri="{FF2B5EF4-FFF2-40B4-BE49-F238E27FC236}">
                    <a16:creationId xmlns:a16="http://schemas.microsoft.com/office/drawing/2014/main" id="{C93A84DB-D463-3230-8D88-F8D652B7D1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40300" y="3049588"/>
                <a:ext cx="0" cy="252413"/>
              </a:xfrm>
              <a:prstGeom prst="line">
                <a:avLst/>
              </a:prstGeom>
              <a:noFill/>
              <a:ln w="19050" cap="rnd">
                <a:solidFill>
                  <a:srgbClr val="5252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82" name="Line 299">
                <a:extLst>
                  <a:ext uri="{FF2B5EF4-FFF2-40B4-BE49-F238E27FC236}">
                    <a16:creationId xmlns:a16="http://schemas.microsoft.com/office/drawing/2014/main" id="{A8ABF5B2-1D84-25F0-ACE3-C0E57BC721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24200" y="2540000"/>
                <a:ext cx="0" cy="2747963"/>
              </a:xfrm>
              <a:prstGeom prst="line">
                <a:avLst/>
              </a:prstGeom>
              <a:noFill/>
              <a:ln w="11113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83" name="Line 300">
                <a:extLst>
                  <a:ext uri="{FF2B5EF4-FFF2-40B4-BE49-F238E27FC236}">
                    <a16:creationId xmlns:a16="http://schemas.microsoft.com/office/drawing/2014/main" id="{67033ED3-6A4E-D588-0B90-96AD08C492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46725" y="2540000"/>
                <a:ext cx="0" cy="2747963"/>
              </a:xfrm>
              <a:prstGeom prst="line">
                <a:avLst/>
              </a:prstGeom>
              <a:noFill/>
              <a:ln w="11113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84" name="Line 301">
                <a:extLst>
                  <a:ext uri="{FF2B5EF4-FFF2-40B4-BE49-F238E27FC236}">
                    <a16:creationId xmlns:a16="http://schemas.microsoft.com/office/drawing/2014/main" id="{4A3BD5A7-1A11-3DB2-A642-9094CC9A8F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4200" y="5287963"/>
                <a:ext cx="2422525" cy="0"/>
              </a:xfrm>
              <a:prstGeom prst="line">
                <a:avLst/>
              </a:prstGeom>
              <a:noFill/>
              <a:ln w="3175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85" name="Line 302">
                <a:extLst>
                  <a:ext uri="{FF2B5EF4-FFF2-40B4-BE49-F238E27FC236}">
                    <a16:creationId xmlns:a16="http://schemas.microsoft.com/office/drawing/2014/main" id="{AD0395E4-A35B-518F-FA64-986B63D88C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4200" y="2540000"/>
                <a:ext cx="2422525" cy="0"/>
              </a:xfrm>
              <a:prstGeom prst="line">
                <a:avLst/>
              </a:prstGeom>
              <a:noFill/>
              <a:ln w="3175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86" name="Freeform 303">
                <a:extLst>
                  <a:ext uri="{FF2B5EF4-FFF2-40B4-BE49-F238E27FC236}">
                    <a16:creationId xmlns:a16="http://schemas.microsoft.com/office/drawing/2014/main" id="{B328551B-7067-9E30-7F05-38D0AA24E482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>
                <a:off x="3709702" y="4781266"/>
                <a:ext cx="40111" cy="40111"/>
              </a:xfrm>
              <a:custGeom>
                <a:avLst/>
                <a:gdLst>
                  <a:gd name="T0" fmla="*/ 75 w 150"/>
                  <a:gd name="T1" fmla="*/ 150 h 150"/>
                  <a:gd name="T2" fmla="*/ 128 w 150"/>
                  <a:gd name="T3" fmla="*/ 128 h 150"/>
                  <a:gd name="T4" fmla="*/ 150 w 150"/>
                  <a:gd name="T5" fmla="*/ 75 h 150"/>
                  <a:gd name="T6" fmla="*/ 128 w 150"/>
                  <a:gd name="T7" fmla="*/ 22 h 150"/>
                  <a:gd name="T8" fmla="*/ 75 w 150"/>
                  <a:gd name="T9" fmla="*/ 0 h 150"/>
                  <a:gd name="T10" fmla="*/ 22 w 150"/>
                  <a:gd name="T11" fmla="*/ 22 h 150"/>
                  <a:gd name="T12" fmla="*/ 0 w 150"/>
                  <a:gd name="T13" fmla="*/ 75 h 150"/>
                  <a:gd name="T14" fmla="*/ 22 w 150"/>
                  <a:gd name="T15" fmla="*/ 128 h 150"/>
                  <a:gd name="T16" fmla="*/ 75 w 150"/>
                  <a:gd name="T17" fmla="*/ 150 h 1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150" h="150">
                    <a:moveTo>
                      <a:pt x="75" y="150"/>
                    </a:moveTo>
                    <a:cubicBezTo>
                      <a:pt x="95" y="150"/>
                      <a:pt x="114" y="142"/>
                      <a:pt x="128" y="128"/>
                    </a:cubicBezTo>
                    <a:cubicBezTo>
                      <a:pt x="142" y="114"/>
                      <a:pt x="150" y="95"/>
                      <a:pt x="150" y="75"/>
                    </a:cubicBezTo>
                    <a:cubicBezTo>
                      <a:pt x="150" y="55"/>
                      <a:pt x="142" y="36"/>
                      <a:pt x="128" y="22"/>
                    </a:cubicBezTo>
                    <a:cubicBezTo>
                      <a:pt x="114" y="8"/>
                      <a:pt x="95" y="0"/>
                      <a:pt x="75" y="0"/>
                    </a:cubicBezTo>
                    <a:cubicBezTo>
                      <a:pt x="55" y="0"/>
                      <a:pt x="36" y="8"/>
                      <a:pt x="22" y="22"/>
                    </a:cubicBezTo>
                    <a:cubicBezTo>
                      <a:pt x="8" y="36"/>
                      <a:pt x="0" y="55"/>
                      <a:pt x="0" y="75"/>
                    </a:cubicBezTo>
                    <a:cubicBezTo>
                      <a:pt x="0" y="95"/>
                      <a:pt x="8" y="114"/>
                      <a:pt x="22" y="128"/>
                    </a:cubicBezTo>
                    <a:cubicBezTo>
                      <a:pt x="36" y="142"/>
                      <a:pt x="55" y="150"/>
                      <a:pt x="75" y="1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 cap="flat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9525" cap="flat">
                    <a:solidFill>
                      <a:srgbClr val="525252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87" name="Freeform 305">
                <a:extLst>
                  <a:ext uri="{FF2B5EF4-FFF2-40B4-BE49-F238E27FC236}">
                    <a16:creationId xmlns:a16="http://schemas.microsoft.com/office/drawing/2014/main" id="{FCF1D5FA-31CA-3980-8BCE-EB9F429A8239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>
                <a:off x="4920966" y="3141378"/>
                <a:ext cx="40111" cy="40111"/>
              </a:xfrm>
              <a:custGeom>
                <a:avLst/>
                <a:gdLst>
                  <a:gd name="T0" fmla="*/ 75 w 150"/>
                  <a:gd name="T1" fmla="*/ 150 h 150"/>
                  <a:gd name="T2" fmla="*/ 128 w 150"/>
                  <a:gd name="T3" fmla="*/ 128 h 150"/>
                  <a:gd name="T4" fmla="*/ 150 w 150"/>
                  <a:gd name="T5" fmla="*/ 75 h 150"/>
                  <a:gd name="T6" fmla="*/ 128 w 150"/>
                  <a:gd name="T7" fmla="*/ 22 h 150"/>
                  <a:gd name="T8" fmla="*/ 75 w 150"/>
                  <a:gd name="T9" fmla="*/ 0 h 150"/>
                  <a:gd name="T10" fmla="*/ 22 w 150"/>
                  <a:gd name="T11" fmla="*/ 22 h 150"/>
                  <a:gd name="T12" fmla="*/ 0 w 150"/>
                  <a:gd name="T13" fmla="*/ 75 h 150"/>
                  <a:gd name="T14" fmla="*/ 22 w 150"/>
                  <a:gd name="T15" fmla="*/ 128 h 150"/>
                  <a:gd name="T16" fmla="*/ 75 w 150"/>
                  <a:gd name="T17" fmla="*/ 150 h 1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150" h="150">
                    <a:moveTo>
                      <a:pt x="75" y="150"/>
                    </a:moveTo>
                    <a:cubicBezTo>
                      <a:pt x="95" y="150"/>
                      <a:pt x="114" y="142"/>
                      <a:pt x="128" y="128"/>
                    </a:cubicBezTo>
                    <a:cubicBezTo>
                      <a:pt x="142" y="114"/>
                      <a:pt x="150" y="95"/>
                      <a:pt x="150" y="75"/>
                    </a:cubicBezTo>
                    <a:cubicBezTo>
                      <a:pt x="150" y="55"/>
                      <a:pt x="142" y="36"/>
                      <a:pt x="128" y="22"/>
                    </a:cubicBezTo>
                    <a:cubicBezTo>
                      <a:pt x="114" y="8"/>
                      <a:pt x="95" y="0"/>
                      <a:pt x="75" y="0"/>
                    </a:cubicBezTo>
                    <a:cubicBezTo>
                      <a:pt x="55" y="0"/>
                      <a:pt x="36" y="8"/>
                      <a:pt x="22" y="22"/>
                    </a:cubicBezTo>
                    <a:cubicBezTo>
                      <a:pt x="8" y="36"/>
                      <a:pt x="0" y="55"/>
                      <a:pt x="0" y="75"/>
                    </a:cubicBezTo>
                    <a:cubicBezTo>
                      <a:pt x="0" y="95"/>
                      <a:pt x="8" y="114"/>
                      <a:pt x="22" y="128"/>
                    </a:cubicBezTo>
                    <a:cubicBezTo>
                      <a:pt x="36" y="142"/>
                      <a:pt x="55" y="150"/>
                      <a:pt x="75" y="1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 cap="flat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9525" cap="flat">
                    <a:solidFill>
                      <a:srgbClr val="525252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1585" name="Group 1584">
              <a:extLst>
                <a:ext uri="{FF2B5EF4-FFF2-40B4-BE49-F238E27FC236}">
                  <a16:creationId xmlns:a16="http://schemas.microsoft.com/office/drawing/2014/main" id="{207FD947-A18C-8AB0-B912-492D5223142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730145" y="3935641"/>
              <a:ext cx="1470067" cy="1080000"/>
              <a:chOff x="2540000" y="2540000"/>
              <a:chExt cx="3906838" cy="2870200"/>
            </a:xfrm>
          </p:grpSpPr>
          <p:sp>
            <p:nvSpPr>
              <p:cNvPr id="1586" name="Rectangle 313">
                <a:extLst>
                  <a:ext uri="{FF2B5EF4-FFF2-40B4-BE49-F238E27FC236}">
                    <a16:creationId xmlns:a16="http://schemas.microsoft.com/office/drawing/2014/main" id="{D23D77BE-0257-D79E-2037-8626D44AC7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000" y="2540000"/>
                <a:ext cx="3906838" cy="287020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87" name="Rectangle 314">
                <a:extLst>
                  <a:ext uri="{FF2B5EF4-FFF2-40B4-BE49-F238E27FC236}">
                    <a16:creationId xmlns:a16="http://schemas.microsoft.com/office/drawing/2014/main" id="{2A0984B7-9A37-159B-CCA0-D10A8BCC29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2613" y="2540000"/>
                <a:ext cx="3324225" cy="2398713"/>
              </a:xfrm>
              <a:prstGeom prst="rect">
                <a:avLst/>
              </a:prstGeom>
              <a:solidFill>
                <a:srgbClr val="EAEA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88" name="Line 315">
                <a:extLst>
                  <a:ext uri="{FF2B5EF4-FFF2-40B4-BE49-F238E27FC236}">
                    <a16:creationId xmlns:a16="http://schemas.microsoft.com/office/drawing/2014/main" id="{8AD6F63D-A787-F0B7-FAFB-E9019D8026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78263" y="2540000"/>
                <a:ext cx="0" cy="2398713"/>
              </a:xfrm>
              <a:prstGeom prst="line">
                <a:avLst/>
              </a:prstGeom>
              <a:noFill/>
              <a:ln w="6350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89" name="Freeform 316">
                <a:extLst>
                  <a:ext uri="{FF2B5EF4-FFF2-40B4-BE49-F238E27FC236}">
                    <a16:creationId xmlns:a16="http://schemas.microsoft.com/office/drawing/2014/main" id="{FD80B2C2-B26A-16BE-9F3F-F2007D67032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746500" y="5027613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0" name="Rectangle 317">
                <a:extLst>
                  <a:ext uri="{FF2B5EF4-FFF2-40B4-BE49-F238E27FC236}">
                    <a16:creationId xmlns:a16="http://schemas.microsoft.com/office/drawing/2014/main" id="{F3598FD1-B809-765F-5AAF-05A2273EF9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68738" y="5138738"/>
                <a:ext cx="17463" cy="222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1" name="Freeform 318">
                <a:extLst>
                  <a:ext uri="{FF2B5EF4-FFF2-40B4-BE49-F238E27FC236}">
                    <a16:creationId xmlns:a16="http://schemas.microsoft.com/office/drawing/2014/main" id="{9D243E20-CBB8-19F4-91BF-91EAF416173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914775" y="5029200"/>
                <a:ext cx="95250" cy="131763"/>
              </a:xfrm>
              <a:custGeom>
                <a:avLst/>
                <a:gdLst>
                  <a:gd name="T0" fmla="*/ 329 w 531"/>
                  <a:gd name="T1" fmla="*/ 86 h 729"/>
                  <a:gd name="T2" fmla="*/ 80 w 531"/>
                  <a:gd name="T3" fmla="*/ 475 h 729"/>
                  <a:gd name="T4" fmla="*/ 329 w 531"/>
                  <a:gd name="T5" fmla="*/ 475 h 729"/>
                  <a:gd name="T6" fmla="*/ 329 w 531"/>
                  <a:gd name="T7" fmla="*/ 86 h 729"/>
                  <a:gd name="T8" fmla="*/ 303 w 531"/>
                  <a:gd name="T9" fmla="*/ 0 h 729"/>
                  <a:gd name="T10" fmla="*/ 427 w 531"/>
                  <a:gd name="T11" fmla="*/ 0 h 729"/>
                  <a:gd name="T12" fmla="*/ 427 w 531"/>
                  <a:gd name="T13" fmla="*/ 475 h 729"/>
                  <a:gd name="T14" fmla="*/ 531 w 531"/>
                  <a:gd name="T15" fmla="*/ 475 h 729"/>
                  <a:gd name="T16" fmla="*/ 531 w 531"/>
                  <a:gd name="T17" fmla="*/ 557 h 729"/>
                  <a:gd name="T18" fmla="*/ 427 w 531"/>
                  <a:gd name="T19" fmla="*/ 557 h 729"/>
                  <a:gd name="T20" fmla="*/ 427 w 531"/>
                  <a:gd name="T21" fmla="*/ 729 h 729"/>
                  <a:gd name="T22" fmla="*/ 329 w 531"/>
                  <a:gd name="T23" fmla="*/ 729 h 729"/>
                  <a:gd name="T24" fmla="*/ 329 w 531"/>
                  <a:gd name="T25" fmla="*/ 557 h 729"/>
                  <a:gd name="T26" fmla="*/ 0 w 531"/>
                  <a:gd name="T27" fmla="*/ 557 h 729"/>
                  <a:gd name="T28" fmla="*/ 0 w 531"/>
                  <a:gd name="T29" fmla="*/ 462 h 729"/>
                  <a:gd name="T30" fmla="*/ 303 w 531"/>
                  <a:gd name="T31" fmla="*/ 0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531" h="729">
                    <a:moveTo>
                      <a:pt x="329" y="86"/>
                    </a:moveTo>
                    <a:lnTo>
                      <a:pt x="80" y="475"/>
                    </a:lnTo>
                    <a:lnTo>
                      <a:pt x="329" y="475"/>
                    </a:lnTo>
                    <a:lnTo>
                      <a:pt x="329" y="86"/>
                    </a:lnTo>
                    <a:close/>
                    <a:moveTo>
                      <a:pt x="303" y="0"/>
                    </a:moveTo>
                    <a:lnTo>
                      <a:pt x="427" y="0"/>
                    </a:lnTo>
                    <a:lnTo>
                      <a:pt x="427" y="475"/>
                    </a:lnTo>
                    <a:lnTo>
                      <a:pt x="531" y="475"/>
                    </a:lnTo>
                    <a:lnTo>
                      <a:pt x="531" y="557"/>
                    </a:lnTo>
                    <a:lnTo>
                      <a:pt x="427" y="557"/>
                    </a:lnTo>
                    <a:lnTo>
                      <a:pt x="427" y="729"/>
                    </a:lnTo>
                    <a:lnTo>
                      <a:pt x="329" y="729"/>
                    </a:lnTo>
                    <a:lnTo>
                      <a:pt x="329" y="557"/>
                    </a:lnTo>
                    <a:lnTo>
                      <a:pt x="0" y="557"/>
                    </a:lnTo>
                    <a:lnTo>
                      <a:pt x="0" y="462"/>
                    </a:lnTo>
                    <a:lnTo>
                      <a:pt x="303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2" name="Line 319">
                <a:extLst>
                  <a:ext uri="{FF2B5EF4-FFF2-40B4-BE49-F238E27FC236}">
                    <a16:creationId xmlns:a16="http://schemas.microsoft.com/office/drawing/2014/main" id="{09EFA55D-34B9-8676-921C-187C325DED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683125" y="2540000"/>
                <a:ext cx="0" cy="2398713"/>
              </a:xfrm>
              <a:prstGeom prst="line">
                <a:avLst/>
              </a:prstGeom>
              <a:noFill/>
              <a:ln w="6350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3" name="Freeform 320">
                <a:extLst>
                  <a:ext uri="{FF2B5EF4-FFF2-40B4-BE49-F238E27FC236}">
                    <a16:creationId xmlns:a16="http://schemas.microsoft.com/office/drawing/2014/main" id="{32EFB079-2B83-E2D4-30DE-F5C885BE36B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552950" y="5027613"/>
                <a:ext cx="90488" cy="136525"/>
              </a:xfrm>
              <a:custGeom>
                <a:avLst/>
                <a:gdLst>
                  <a:gd name="T0" fmla="*/ 253 w 505"/>
                  <a:gd name="T1" fmla="*/ 78 h 755"/>
                  <a:gd name="T2" fmla="*/ 137 w 505"/>
                  <a:gd name="T3" fmla="*/ 153 h 755"/>
                  <a:gd name="T4" fmla="*/ 99 w 505"/>
                  <a:gd name="T5" fmla="*/ 378 h 755"/>
                  <a:gd name="T6" fmla="*/ 137 w 505"/>
                  <a:gd name="T7" fmla="*/ 603 h 755"/>
                  <a:gd name="T8" fmla="*/ 253 w 505"/>
                  <a:gd name="T9" fmla="*/ 678 h 755"/>
                  <a:gd name="T10" fmla="*/ 368 w 505"/>
                  <a:gd name="T11" fmla="*/ 603 h 755"/>
                  <a:gd name="T12" fmla="*/ 406 w 505"/>
                  <a:gd name="T13" fmla="*/ 378 h 755"/>
                  <a:gd name="T14" fmla="*/ 368 w 505"/>
                  <a:gd name="T15" fmla="*/ 153 h 755"/>
                  <a:gd name="T16" fmla="*/ 253 w 505"/>
                  <a:gd name="T17" fmla="*/ 78 h 755"/>
                  <a:gd name="T18" fmla="*/ 253 w 505"/>
                  <a:gd name="T19" fmla="*/ 0 h 755"/>
                  <a:gd name="T20" fmla="*/ 440 w 505"/>
                  <a:gd name="T21" fmla="*/ 97 h 755"/>
                  <a:gd name="T22" fmla="*/ 505 w 505"/>
                  <a:gd name="T23" fmla="*/ 378 h 755"/>
                  <a:gd name="T24" fmla="*/ 440 w 505"/>
                  <a:gd name="T25" fmla="*/ 659 h 755"/>
                  <a:gd name="T26" fmla="*/ 252 w 505"/>
                  <a:gd name="T27" fmla="*/ 755 h 755"/>
                  <a:gd name="T28" fmla="*/ 64 w 505"/>
                  <a:gd name="T29" fmla="*/ 659 h 755"/>
                  <a:gd name="T30" fmla="*/ 0 w 505"/>
                  <a:gd name="T31" fmla="*/ 378 h 755"/>
                  <a:gd name="T32" fmla="*/ 64 w 505"/>
                  <a:gd name="T33" fmla="*/ 97 h 755"/>
                  <a:gd name="T34" fmla="*/ 253 w 505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5" h="755">
                    <a:moveTo>
                      <a:pt x="253" y="78"/>
                    </a:moveTo>
                    <a:cubicBezTo>
                      <a:pt x="202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2" y="678"/>
                      <a:pt x="253" y="678"/>
                    </a:cubicBezTo>
                    <a:cubicBezTo>
                      <a:pt x="304" y="678"/>
                      <a:pt x="342" y="653"/>
                      <a:pt x="368" y="603"/>
                    </a:cubicBezTo>
                    <a:cubicBezTo>
                      <a:pt x="393" y="553"/>
                      <a:pt x="406" y="478"/>
                      <a:pt x="406" y="378"/>
                    </a:cubicBezTo>
                    <a:cubicBezTo>
                      <a:pt x="406" y="278"/>
                      <a:pt x="393" y="203"/>
                      <a:pt x="368" y="153"/>
                    </a:cubicBezTo>
                    <a:cubicBezTo>
                      <a:pt x="342" y="103"/>
                      <a:pt x="304" y="78"/>
                      <a:pt x="253" y="78"/>
                    </a:cubicBezTo>
                    <a:close/>
                    <a:moveTo>
                      <a:pt x="253" y="0"/>
                    </a:moveTo>
                    <a:cubicBezTo>
                      <a:pt x="334" y="0"/>
                      <a:pt x="396" y="33"/>
                      <a:pt x="440" y="97"/>
                    </a:cubicBezTo>
                    <a:cubicBezTo>
                      <a:pt x="483" y="162"/>
                      <a:pt x="505" y="256"/>
                      <a:pt x="505" y="378"/>
                    </a:cubicBezTo>
                    <a:cubicBezTo>
                      <a:pt x="505" y="501"/>
                      <a:pt x="483" y="595"/>
                      <a:pt x="440" y="659"/>
                    </a:cubicBezTo>
                    <a:cubicBezTo>
                      <a:pt x="396" y="723"/>
                      <a:pt x="334" y="755"/>
                      <a:pt x="252" y="755"/>
                    </a:cubicBezTo>
                    <a:cubicBezTo>
                      <a:pt x="170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1" y="0"/>
                      <a:pt x="253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4" name="Rectangle 321">
                <a:extLst>
                  <a:ext uri="{FF2B5EF4-FFF2-40B4-BE49-F238E27FC236}">
                    <a16:creationId xmlns:a16="http://schemas.microsoft.com/office/drawing/2014/main" id="{85CDF8AE-E4A3-D499-1FE9-0A404B9821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75188" y="5138738"/>
                <a:ext cx="17463" cy="222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5" name="Freeform 322">
                <a:extLst>
                  <a:ext uri="{FF2B5EF4-FFF2-40B4-BE49-F238E27FC236}">
                    <a16:creationId xmlns:a16="http://schemas.microsoft.com/office/drawing/2014/main" id="{F64752A0-B053-D7BC-6618-B8EDC7D3FA9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724400" y="5027613"/>
                <a:ext cx="90488" cy="136525"/>
              </a:xfrm>
              <a:custGeom>
                <a:avLst/>
                <a:gdLst>
                  <a:gd name="T0" fmla="*/ 260 w 503"/>
                  <a:gd name="T1" fmla="*/ 338 h 755"/>
                  <a:gd name="T2" fmla="*/ 155 w 503"/>
                  <a:gd name="T3" fmla="*/ 384 h 755"/>
                  <a:gd name="T4" fmla="*/ 116 w 503"/>
                  <a:gd name="T5" fmla="*/ 508 h 755"/>
                  <a:gd name="T6" fmla="*/ 155 w 503"/>
                  <a:gd name="T7" fmla="*/ 633 h 755"/>
                  <a:gd name="T8" fmla="*/ 260 w 503"/>
                  <a:gd name="T9" fmla="*/ 678 h 755"/>
                  <a:gd name="T10" fmla="*/ 365 w 503"/>
                  <a:gd name="T11" fmla="*/ 633 h 755"/>
                  <a:gd name="T12" fmla="*/ 404 w 503"/>
                  <a:gd name="T13" fmla="*/ 508 h 755"/>
                  <a:gd name="T14" fmla="*/ 365 w 503"/>
                  <a:gd name="T15" fmla="*/ 384 h 755"/>
                  <a:gd name="T16" fmla="*/ 260 w 503"/>
                  <a:gd name="T17" fmla="*/ 338 h 755"/>
                  <a:gd name="T18" fmla="*/ 456 w 503"/>
                  <a:gd name="T19" fmla="*/ 29 h 755"/>
                  <a:gd name="T20" fmla="*/ 456 w 503"/>
                  <a:gd name="T21" fmla="*/ 119 h 755"/>
                  <a:gd name="T22" fmla="*/ 381 w 503"/>
                  <a:gd name="T23" fmla="*/ 92 h 755"/>
                  <a:gd name="T24" fmla="*/ 306 w 503"/>
                  <a:gd name="T25" fmla="*/ 83 h 755"/>
                  <a:gd name="T26" fmla="*/ 156 w 503"/>
                  <a:gd name="T27" fmla="*/ 149 h 755"/>
                  <a:gd name="T28" fmla="*/ 98 w 503"/>
                  <a:gd name="T29" fmla="*/ 348 h 755"/>
                  <a:gd name="T30" fmla="*/ 170 w 503"/>
                  <a:gd name="T31" fmla="*/ 283 h 755"/>
                  <a:gd name="T32" fmla="*/ 266 w 503"/>
                  <a:gd name="T33" fmla="*/ 260 h 755"/>
                  <a:gd name="T34" fmla="*/ 439 w 503"/>
                  <a:gd name="T35" fmla="*/ 327 h 755"/>
                  <a:gd name="T36" fmla="*/ 503 w 503"/>
                  <a:gd name="T37" fmla="*/ 508 h 755"/>
                  <a:gd name="T38" fmla="*/ 436 w 503"/>
                  <a:gd name="T39" fmla="*/ 688 h 755"/>
                  <a:gd name="T40" fmla="*/ 260 w 503"/>
                  <a:gd name="T41" fmla="*/ 755 h 755"/>
                  <a:gd name="T42" fmla="*/ 67 w 503"/>
                  <a:gd name="T43" fmla="*/ 659 h 755"/>
                  <a:gd name="T44" fmla="*/ 0 w 503"/>
                  <a:gd name="T45" fmla="*/ 378 h 755"/>
                  <a:gd name="T46" fmla="*/ 82 w 503"/>
                  <a:gd name="T47" fmla="*/ 103 h 755"/>
                  <a:gd name="T48" fmla="*/ 302 w 503"/>
                  <a:gd name="T49" fmla="*/ 0 h 755"/>
                  <a:gd name="T50" fmla="*/ 377 w 503"/>
                  <a:gd name="T51" fmla="*/ 7 h 755"/>
                  <a:gd name="T52" fmla="*/ 456 w 503"/>
                  <a:gd name="T53" fmla="*/ 29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503" h="755">
                    <a:moveTo>
                      <a:pt x="260" y="338"/>
                    </a:moveTo>
                    <a:cubicBezTo>
                      <a:pt x="216" y="338"/>
                      <a:pt x="181" y="354"/>
                      <a:pt x="155" y="384"/>
                    </a:cubicBezTo>
                    <a:cubicBezTo>
                      <a:pt x="129" y="414"/>
                      <a:pt x="116" y="456"/>
                      <a:pt x="116" y="508"/>
                    </a:cubicBezTo>
                    <a:cubicBezTo>
                      <a:pt x="116" y="561"/>
                      <a:pt x="129" y="603"/>
                      <a:pt x="155" y="633"/>
                    </a:cubicBezTo>
                    <a:cubicBezTo>
                      <a:pt x="181" y="663"/>
                      <a:pt x="216" y="678"/>
                      <a:pt x="260" y="678"/>
                    </a:cubicBezTo>
                    <a:cubicBezTo>
                      <a:pt x="304" y="678"/>
                      <a:pt x="339" y="663"/>
                      <a:pt x="365" y="633"/>
                    </a:cubicBezTo>
                    <a:cubicBezTo>
                      <a:pt x="391" y="603"/>
                      <a:pt x="404" y="561"/>
                      <a:pt x="404" y="508"/>
                    </a:cubicBezTo>
                    <a:cubicBezTo>
                      <a:pt x="404" y="456"/>
                      <a:pt x="391" y="414"/>
                      <a:pt x="365" y="384"/>
                    </a:cubicBezTo>
                    <a:cubicBezTo>
                      <a:pt x="339" y="354"/>
                      <a:pt x="304" y="338"/>
                      <a:pt x="260" y="338"/>
                    </a:cubicBezTo>
                    <a:close/>
                    <a:moveTo>
                      <a:pt x="456" y="29"/>
                    </a:moveTo>
                    <a:lnTo>
                      <a:pt x="456" y="119"/>
                    </a:lnTo>
                    <a:cubicBezTo>
                      <a:pt x="431" y="107"/>
                      <a:pt x="406" y="98"/>
                      <a:pt x="381" y="92"/>
                    </a:cubicBezTo>
                    <a:cubicBezTo>
                      <a:pt x="355" y="86"/>
                      <a:pt x="330" y="83"/>
                      <a:pt x="306" y="83"/>
                    </a:cubicBezTo>
                    <a:cubicBezTo>
                      <a:pt x="240" y="83"/>
                      <a:pt x="190" y="105"/>
                      <a:pt x="156" y="149"/>
                    </a:cubicBezTo>
                    <a:cubicBezTo>
                      <a:pt x="122" y="193"/>
                      <a:pt x="102" y="260"/>
                      <a:pt x="98" y="348"/>
                    </a:cubicBezTo>
                    <a:cubicBezTo>
                      <a:pt x="117" y="320"/>
                      <a:pt x="141" y="298"/>
                      <a:pt x="170" y="283"/>
                    </a:cubicBezTo>
                    <a:cubicBezTo>
                      <a:pt x="199" y="268"/>
                      <a:pt x="231" y="260"/>
                      <a:pt x="266" y="260"/>
                    </a:cubicBezTo>
                    <a:cubicBezTo>
                      <a:pt x="339" y="260"/>
                      <a:pt x="397" y="283"/>
                      <a:pt x="439" y="327"/>
                    </a:cubicBezTo>
                    <a:cubicBezTo>
                      <a:pt x="481" y="371"/>
                      <a:pt x="503" y="432"/>
                      <a:pt x="503" y="508"/>
                    </a:cubicBezTo>
                    <a:cubicBezTo>
                      <a:pt x="503" y="583"/>
                      <a:pt x="480" y="643"/>
                      <a:pt x="436" y="688"/>
                    </a:cubicBezTo>
                    <a:cubicBezTo>
                      <a:pt x="392" y="733"/>
                      <a:pt x="333" y="755"/>
                      <a:pt x="260" y="755"/>
                    </a:cubicBezTo>
                    <a:cubicBezTo>
                      <a:pt x="176" y="755"/>
                      <a:pt x="111" y="723"/>
                      <a:pt x="67" y="659"/>
                    </a:cubicBezTo>
                    <a:cubicBezTo>
                      <a:pt x="22" y="595"/>
                      <a:pt x="0" y="501"/>
                      <a:pt x="0" y="378"/>
                    </a:cubicBezTo>
                    <a:cubicBezTo>
                      <a:pt x="0" y="263"/>
                      <a:pt x="27" y="171"/>
                      <a:pt x="82" y="103"/>
                    </a:cubicBezTo>
                    <a:cubicBezTo>
                      <a:pt x="136" y="35"/>
                      <a:pt x="210" y="0"/>
                      <a:pt x="302" y="0"/>
                    </a:cubicBezTo>
                    <a:cubicBezTo>
                      <a:pt x="326" y="0"/>
                      <a:pt x="351" y="3"/>
                      <a:pt x="377" y="7"/>
                    </a:cubicBezTo>
                    <a:cubicBezTo>
                      <a:pt x="402" y="12"/>
                      <a:pt x="428" y="19"/>
                      <a:pt x="456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6" name="Line 323">
                <a:extLst>
                  <a:ext uri="{FF2B5EF4-FFF2-40B4-BE49-F238E27FC236}">
                    <a16:creationId xmlns:a16="http://schemas.microsoft.com/office/drawing/2014/main" id="{A44C9A92-168F-4AFE-22AB-EC26DA7890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89575" y="2540000"/>
                <a:ext cx="0" cy="2398713"/>
              </a:xfrm>
              <a:prstGeom prst="line">
                <a:avLst/>
              </a:prstGeom>
              <a:noFill/>
              <a:ln w="6350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7" name="Freeform 324">
                <a:extLst>
                  <a:ext uri="{FF2B5EF4-FFF2-40B4-BE49-F238E27FC236}">
                    <a16:creationId xmlns:a16="http://schemas.microsoft.com/office/drawing/2014/main" id="{FF186971-1414-12AE-C213-C73610BE977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357813" y="5027613"/>
                <a:ext cx="92075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8" name="Rectangle 325">
                <a:extLst>
                  <a:ext uri="{FF2B5EF4-FFF2-40B4-BE49-F238E27FC236}">
                    <a16:creationId xmlns:a16="http://schemas.microsoft.com/office/drawing/2014/main" id="{250785F1-7801-3639-129D-7EE423A895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80050" y="5138738"/>
                <a:ext cx="19050" cy="222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9" name="Freeform 326">
                <a:extLst>
                  <a:ext uri="{FF2B5EF4-FFF2-40B4-BE49-F238E27FC236}">
                    <a16:creationId xmlns:a16="http://schemas.microsoft.com/office/drawing/2014/main" id="{B22E840C-81F8-7F1E-3B9D-7BC515BF427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530850" y="5027613"/>
                <a:ext cx="90488" cy="136525"/>
              </a:xfrm>
              <a:custGeom>
                <a:avLst/>
                <a:gdLst>
                  <a:gd name="T0" fmla="*/ 250 w 500"/>
                  <a:gd name="T1" fmla="*/ 396 h 755"/>
                  <a:gd name="T2" fmla="*/ 139 w 500"/>
                  <a:gd name="T3" fmla="*/ 434 h 755"/>
                  <a:gd name="T4" fmla="*/ 99 w 500"/>
                  <a:gd name="T5" fmla="*/ 537 h 755"/>
                  <a:gd name="T6" fmla="*/ 139 w 500"/>
                  <a:gd name="T7" fmla="*/ 641 h 755"/>
                  <a:gd name="T8" fmla="*/ 250 w 500"/>
                  <a:gd name="T9" fmla="*/ 678 h 755"/>
                  <a:gd name="T10" fmla="*/ 360 w 500"/>
                  <a:gd name="T11" fmla="*/ 640 h 755"/>
                  <a:gd name="T12" fmla="*/ 401 w 500"/>
                  <a:gd name="T13" fmla="*/ 537 h 755"/>
                  <a:gd name="T14" fmla="*/ 361 w 500"/>
                  <a:gd name="T15" fmla="*/ 434 h 755"/>
                  <a:gd name="T16" fmla="*/ 250 w 500"/>
                  <a:gd name="T17" fmla="*/ 396 h 755"/>
                  <a:gd name="T18" fmla="*/ 151 w 500"/>
                  <a:gd name="T19" fmla="*/ 354 h 755"/>
                  <a:gd name="T20" fmla="*/ 52 w 500"/>
                  <a:gd name="T21" fmla="*/ 295 h 755"/>
                  <a:gd name="T22" fmla="*/ 17 w 500"/>
                  <a:gd name="T23" fmla="*/ 189 h 755"/>
                  <a:gd name="T24" fmla="*/ 79 w 500"/>
                  <a:gd name="T25" fmla="*/ 51 h 755"/>
                  <a:gd name="T26" fmla="*/ 250 w 500"/>
                  <a:gd name="T27" fmla="*/ 0 h 755"/>
                  <a:gd name="T28" fmla="*/ 421 w 500"/>
                  <a:gd name="T29" fmla="*/ 51 h 755"/>
                  <a:gd name="T30" fmla="*/ 483 w 500"/>
                  <a:gd name="T31" fmla="*/ 189 h 755"/>
                  <a:gd name="T32" fmla="*/ 447 w 500"/>
                  <a:gd name="T33" fmla="*/ 295 h 755"/>
                  <a:gd name="T34" fmla="*/ 349 w 500"/>
                  <a:gd name="T35" fmla="*/ 354 h 755"/>
                  <a:gd name="T36" fmla="*/ 460 w 500"/>
                  <a:gd name="T37" fmla="*/ 419 h 755"/>
                  <a:gd name="T38" fmla="*/ 500 w 500"/>
                  <a:gd name="T39" fmla="*/ 537 h 755"/>
                  <a:gd name="T40" fmla="*/ 435 w 500"/>
                  <a:gd name="T41" fmla="*/ 699 h 755"/>
                  <a:gd name="T42" fmla="*/ 249 w 500"/>
                  <a:gd name="T43" fmla="*/ 755 h 755"/>
                  <a:gd name="T44" fmla="*/ 64 w 500"/>
                  <a:gd name="T45" fmla="*/ 699 h 755"/>
                  <a:gd name="T46" fmla="*/ 0 w 500"/>
                  <a:gd name="T47" fmla="*/ 537 h 755"/>
                  <a:gd name="T48" fmla="*/ 40 w 500"/>
                  <a:gd name="T49" fmla="*/ 419 h 755"/>
                  <a:gd name="T50" fmla="*/ 151 w 500"/>
                  <a:gd name="T51" fmla="*/ 354 h 755"/>
                  <a:gd name="T52" fmla="*/ 115 w 500"/>
                  <a:gd name="T53" fmla="*/ 198 h 755"/>
                  <a:gd name="T54" fmla="*/ 150 w 500"/>
                  <a:gd name="T55" fmla="*/ 287 h 755"/>
                  <a:gd name="T56" fmla="*/ 250 w 500"/>
                  <a:gd name="T57" fmla="*/ 318 h 755"/>
                  <a:gd name="T58" fmla="*/ 349 w 500"/>
                  <a:gd name="T59" fmla="*/ 287 h 755"/>
                  <a:gd name="T60" fmla="*/ 385 w 500"/>
                  <a:gd name="T61" fmla="*/ 198 h 755"/>
                  <a:gd name="T62" fmla="*/ 349 w 500"/>
                  <a:gd name="T63" fmla="*/ 110 h 755"/>
                  <a:gd name="T64" fmla="*/ 250 w 500"/>
                  <a:gd name="T65" fmla="*/ 78 h 755"/>
                  <a:gd name="T66" fmla="*/ 150 w 500"/>
                  <a:gd name="T67" fmla="*/ 110 h 755"/>
                  <a:gd name="T68" fmla="*/ 115 w 500"/>
                  <a:gd name="T69" fmla="*/ 198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500" h="755">
                    <a:moveTo>
                      <a:pt x="250" y="396"/>
                    </a:moveTo>
                    <a:cubicBezTo>
                      <a:pt x="203" y="396"/>
                      <a:pt x="166" y="409"/>
                      <a:pt x="139" y="434"/>
                    </a:cubicBezTo>
                    <a:cubicBezTo>
                      <a:pt x="112" y="459"/>
                      <a:pt x="99" y="493"/>
                      <a:pt x="99" y="537"/>
                    </a:cubicBezTo>
                    <a:cubicBezTo>
                      <a:pt x="99" y="581"/>
                      <a:pt x="112" y="616"/>
                      <a:pt x="139" y="641"/>
                    </a:cubicBezTo>
                    <a:cubicBezTo>
                      <a:pt x="166" y="666"/>
                      <a:pt x="203" y="678"/>
                      <a:pt x="250" y="678"/>
                    </a:cubicBezTo>
                    <a:cubicBezTo>
                      <a:pt x="296" y="678"/>
                      <a:pt x="333" y="666"/>
                      <a:pt x="360" y="640"/>
                    </a:cubicBezTo>
                    <a:cubicBezTo>
                      <a:pt x="387" y="615"/>
                      <a:pt x="401" y="581"/>
                      <a:pt x="401" y="537"/>
                    </a:cubicBezTo>
                    <a:cubicBezTo>
                      <a:pt x="401" y="493"/>
                      <a:pt x="387" y="459"/>
                      <a:pt x="361" y="434"/>
                    </a:cubicBezTo>
                    <a:cubicBezTo>
                      <a:pt x="334" y="409"/>
                      <a:pt x="297" y="396"/>
                      <a:pt x="250" y="396"/>
                    </a:cubicBezTo>
                    <a:close/>
                    <a:moveTo>
                      <a:pt x="151" y="354"/>
                    </a:moveTo>
                    <a:cubicBezTo>
                      <a:pt x="109" y="344"/>
                      <a:pt x="76" y="324"/>
                      <a:pt x="52" y="295"/>
                    </a:cubicBezTo>
                    <a:cubicBezTo>
                      <a:pt x="28" y="266"/>
                      <a:pt x="17" y="231"/>
                      <a:pt x="17" y="189"/>
                    </a:cubicBezTo>
                    <a:cubicBezTo>
                      <a:pt x="17" y="131"/>
                      <a:pt x="37" y="85"/>
                      <a:pt x="79" y="51"/>
                    </a:cubicBezTo>
                    <a:cubicBezTo>
                      <a:pt x="120" y="17"/>
                      <a:pt x="177" y="0"/>
                      <a:pt x="250" y="0"/>
                    </a:cubicBezTo>
                    <a:cubicBezTo>
                      <a:pt x="322" y="0"/>
                      <a:pt x="379" y="17"/>
                      <a:pt x="421" y="51"/>
                    </a:cubicBezTo>
                    <a:cubicBezTo>
                      <a:pt x="462" y="85"/>
                      <a:pt x="483" y="131"/>
                      <a:pt x="483" y="189"/>
                    </a:cubicBezTo>
                    <a:cubicBezTo>
                      <a:pt x="483" y="231"/>
                      <a:pt x="471" y="266"/>
                      <a:pt x="447" y="295"/>
                    </a:cubicBezTo>
                    <a:cubicBezTo>
                      <a:pt x="423" y="324"/>
                      <a:pt x="391" y="344"/>
                      <a:pt x="349" y="354"/>
                    </a:cubicBezTo>
                    <a:cubicBezTo>
                      <a:pt x="396" y="365"/>
                      <a:pt x="433" y="387"/>
                      <a:pt x="460" y="419"/>
                    </a:cubicBezTo>
                    <a:cubicBezTo>
                      <a:pt x="486" y="451"/>
                      <a:pt x="500" y="491"/>
                      <a:pt x="500" y="537"/>
                    </a:cubicBezTo>
                    <a:cubicBezTo>
                      <a:pt x="500" y="608"/>
                      <a:pt x="478" y="662"/>
                      <a:pt x="435" y="699"/>
                    </a:cubicBezTo>
                    <a:cubicBezTo>
                      <a:pt x="391" y="737"/>
                      <a:pt x="329" y="755"/>
                      <a:pt x="249" y="755"/>
                    </a:cubicBezTo>
                    <a:cubicBezTo>
                      <a:pt x="169" y="755"/>
                      <a:pt x="107" y="737"/>
                      <a:pt x="64" y="699"/>
                    </a:cubicBezTo>
                    <a:cubicBezTo>
                      <a:pt x="21" y="662"/>
                      <a:pt x="0" y="608"/>
                      <a:pt x="0" y="537"/>
                    </a:cubicBezTo>
                    <a:cubicBezTo>
                      <a:pt x="0" y="491"/>
                      <a:pt x="13" y="451"/>
                      <a:pt x="40" y="419"/>
                    </a:cubicBezTo>
                    <a:cubicBezTo>
                      <a:pt x="66" y="387"/>
                      <a:pt x="103" y="365"/>
                      <a:pt x="151" y="354"/>
                    </a:cubicBezTo>
                    <a:close/>
                    <a:moveTo>
                      <a:pt x="115" y="198"/>
                    </a:moveTo>
                    <a:cubicBezTo>
                      <a:pt x="115" y="236"/>
                      <a:pt x="126" y="266"/>
                      <a:pt x="150" y="287"/>
                    </a:cubicBezTo>
                    <a:cubicBezTo>
                      <a:pt x="174" y="308"/>
                      <a:pt x="207" y="318"/>
                      <a:pt x="250" y="318"/>
                    </a:cubicBezTo>
                    <a:cubicBezTo>
                      <a:pt x="292" y="318"/>
                      <a:pt x="325" y="308"/>
                      <a:pt x="349" y="287"/>
                    </a:cubicBezTo>
                    <a:cubicBezTo>
                      <a:pt x="373" y="266"/>
                      <a:pt x="385" y="236"/>
                      <a:pt x="385" y="198"/>
                    </a:cubicBezTo>
                    <a:cubicBezTo>
                      <a:pt x="385" y="160"/>
                      <a:pt x="373" y="131"/>
                      <a:pt x="349" y="110"/>
                    </a:cubicBezTo>
                    <a:cubicBezTo>
                      <a:pt x="325" y="89"/>
                      <a:pt x="292" y="78"/>
                      <a:pt x="250" y="78"/>
                    </a:cubicBezTo>
                    <a:cubicBezTo>
                      <a:pt x="207" y="78"/>
                      <a:pt x="174" y="89"/>
                      <a:pt x="150" y="110"/>
                    </a:cubicBezTo>
                    <a:cubicBezTo>
                      <a:pt x="126" y="131"/>
                      <a:pt x="115" y="160"/>
                      <a:pt x="115" y="19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0" name="Line 327">
                <a:extLst>
                  <a:ext uri="{FF2B5EF4-FFF2-40B4-BE49-F238E27FC236}">
                    <a16:creationId xmlns:a16="http://schemas.microsoft.com/office/drawing/2014/main" id="{D36C0493-A35C-9595-846A-59F73E6D83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296025" y="2540000"/>
                <a:ext cx="0" cy="2398713"/>
              </a:xfrm>
              <a:prstGeom prst="line">
                <a:avLst/>
              </a:prstGeom>
              <a:noFill/>
              <a:ln w="6350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1" name="Freeform 328">
                <a:extLst>
                  <a:ext uri="{FF2B5EF4-FFF2-40B4-BE49-F238E27FC236}">
                    <a16:creationId xmlns:a16="http://schemas.microsoft.com/office/drawing/2014/main" id="{7A40680C-15B1-5319-9272-F23A441A91D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172200" y="5029200"/>
                <a:ext cx="77788" cy="131763"/>
              </a:xfrm>
              <a:custGeom>
                <a:avLst/>
                <a:gdLst>
                  <a:gd name="T0" fmla="*/ 14 w 434"/>
                  <a:gd name="T1" fmla="*/ 646 h 729"/>
                  <a:gd name="T2" fmla="*/ 175 w 434"/>
                  <a:gd name="T3" fmla="*/ 646 h 729"/>
                  <a:gd name="T4" fmla="*/ 175 w 434"/>
                  <a:gd name="T5" fmla="*/ 90 h 729"/>
                  <a:gd name="T6" fmla="*/ 0 w 434"/>
                  <a:gd name="T7" fmla="*/ 125 h 729"/>
                  <a:gd name="T8" fmla="*/ 0 w 434"/>
                  <a:gd name="T9" fmla="*/ 35 h 729"/>
                  <a:gd name="T10" fmla="*/ 174 w 434"/>
                  <a:gd name="T11" fmla="*/ 0 h 729"/>
                  <a:gd name="T12" fmla="*/ 273 w 434"/>
                  <a:gd name="T13" fmla="*/ 0 h 729"/>
                  <a:gd name="T14" fmla="*/ 273 w 434"/>
                  <a:gd name="T15" fmla="*/ 646 h 729"/>
                  <a:gd name="T16" fmla="*/ 434 w 434"/>
                  <a:gd name="T17" fmla="*/ 646 h 729"/>
                  <a:gd name="T18" fmla="*/ 434 w 434"/>
                  <a:gd name="T19" fmla="*/ 729 h 729"/>
                  <a:gd name="T20" fmla="*/ 14 w 434"/>
                  <a:gd name="T21" fmla="*/ 729 h 729"/>
                  <a:gd name="T22" fmla="*/ 14 w 434"/>
                  <a:gd name="T23" fmla="*/ 646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34" h="729">
                    <a:moveTo>
                      <a:pt x="14" y="646"/>
                    </a:moveTo>
                    <a:lnTo>
                      <a:pt x="175" y="646"/>
                    </a:lnTo>
                    <a:lnTo>
                      <a:pt x="175" y="90"/>
                    </a:lnTo>
                    <a:lnTo>
                      <a:pt x="0" y="125"/>
                    </a:lnTo>
                    <a:lnTo>
                      <a:pt x="0" y="35"/>
                    </a:lnTo>
                    <a:lnTo>
                      <a:pt x="174" y="0"/>
                    </a:lnTo>
                    <a:lnTo>
                      <a:pt x="273" y="0"/>
                    </a:lnTo>
                    <a:lnTo>
                      <a:pt x="273" y="646"/>
                    </a:lnTo>
                    <a:lnTo>
                      <a:pt x="434" y="646"/>
                    </a:lnTo>
                    <a:lnTo>
                      <a:pt x="434" y="729"/>
                    </a:lnTo>
                    <a:lnTo>
                      <a:pt x="14" y="729"/>
                    </a:lnTo>
                    <a:lnTo>
                      <a:pt x="14" y="646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2" name="Rectangle 329">
                <a:extLst>
                  <a:ext uri="{FF2B5EF4-FFF2-40B4-BE49-F238E27FC236}">
                    <a16:creationId xmlns:a16="http://schemas.microsoft.com/office/drawing/2014/main" id="{A8E40168-D66A-0B0F-70F6-DE96F99CC0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86500" y="5138738"/>
                <a:ext cx="19050" cy="222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3" name="Freeform 330">
                <a:extLst>
                  <a:ext uri="{FF2B5EF4-FFF2-40B4-BE49-F238E27FC236}">
                    <a16:creationId xmlns:a16="http://schemas.microsoft.com/office/drawing/2014/main" id="{4AFF95C4-8291-93EF-8442-6FDE9165A60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335713" y="5027613"/>
                <a:ext cx="92075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4" name="Rectangle 331">
                <a:extLst>
                  <a:ext uri="{FF2B5EF4-FFF2-40B4-BE49-F238E27FC236}">
                    <a16:creationId xmlns:a16="http://schemas.microsoft.com/office/drawing/2014/main" id="{50C9A9FA-4D30-6F02-4463-19DB5CB8DD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14775" y="5240338"/>
                <a:ext cx="17463" cy="131763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5" name="Freeform 332">
                <a:extLst>
                  <a:ext uri="{FF2B5EF4-FFF2-40B4-BE49-F238E27FC236}">
                    <a16:creationId xmlns:a16="http://schemas.microsoft.com/office/drawing/2014/main" id="{3CCC1A32-41AD-AC73-B4D1-F670FB7F996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959225" y="5270500"/>
                <a:ext cx="90488" cy="103188"/>
              </a:xfrm>
              <a:custGeom>
                <a:avLst/>
                <a:gdLst>
                  <a:gd name="T0" fmla="*/ 251 w 502"/>
                  <a:gd name="T1" fmla="*/ 76 h 573"/>
                  <a:gd name="T2" fmla="*/ 137 w 502"/>
                  <a:gd name="T3" fmla="*/ 133 h 573"/>
                  <a:gd name="T4" fmla="*/ 95 w 502"/>
                  <a:gd name="T5" fmla="*/ 287 h 573"/>
                  <a:gd name="T6" fmla="*/ 136 w 502"/>
                  <a:gd name="T7" fmla="*/ 442 h 573"/>
                  <a:gd name="T8" fmla="*/ 251 w 502"/>
                  <a:gd name="T9" fmla="*/ 498 h 573"/>
                  <a:gd name="T10" fmla="*/ 365 w 502"/>
                  <a:gd name="T11" fmla="*/ 442 h 573"/>
                  <a:gd name="T12" fmla="*/ 407 w 502"/>
                  <a:gd name="T13" fmla="*/ 287 h 573"/>
                  <a:gd name="T14" fmla="*/ 365 w 502"/>
                  <a:gd name="T15" fmla="*/ 133 h 573"/>
                  <a:gd name="T16" fmla="*/ 251 w 502"/>
                  <a:gd name="T17" fmla="*/ 76 h 573"/>
                  <a:gd name="T18" fmla="*/ 251 w 502"/>
                  <a:gd name="T19" fmla="*/ 0 h 573"/>
                  <a:gd name="T20" fmla="*/ 435 w 502"/>
                  <a:gd name="T21" fmla="*/ 76 h 573"/>
                  <a:gd name="T22" fmla="*/ 502 w 502"/>
                  <a:gd name="T23" fmla="*/ 287 h 573"/>
                  <a:gd name="T24" fmla="*/ 435 w 502"/>
                  <a:gd name="T25" fmla="*/ 497 h 573"/>
                  <a:gd name="T26" fmla="*/ 251 w 502"/>
                  <a:gd name="T27" fmla="*/ 573 h 573"/>
                  <a:gd name="T28" fmla="*/ 66 w 502"/>
                  <a:gd name="T29" fmla="*/ 497 h 573"/>
                  <a:gd name="T30" fmla="*/ 0 w 502"/>
                  <a:gd name="T31" fmla="*/ 287 h 573"/>
                  <a:gd name="T32" fmla="*/ 66 w 502"/>
                  <a:gd name="T33" fmla="*/ 76 h 573"/>
                  <a:gd name="T34" fmla="*/ 251 w 502"/>
                  <a:gd name="T35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2" h="573">
                    <a:moveTo>
                      <a:pt x="251" y="76"/>
                    </a:moveTo>
                    <a:cubicBezTo>
                      <a:pt x="203" y="76"/>
                      <a:pt x="165" y="95"/>
                      <a:pt x="137" y="133"/>
                    </a:cubicBezTo>
                    <a:cubicBezTo>
                      <a:pt x="109" y="171"/>
                      <a:pt x="95" y="222"/>
                      <a:pt x="95" y="287"/>
                    </a:cubicBezTo>
                    <a:cubicBezTo>
                      <a:pt x="95" y="353"/>
                      <a:pt x="108" y="404"/>
                      <a:pt x="136" y="442"/>
                    </a:cubicBezTo>
                    <a:cubicBezTo>
                      <a:pt x="164" y="480"/>
                      <a:pt x="202" y="498"/>
                      <a:pt x="251" y="498"/>
                    </a:cubicBezTo>
                    <a:cubicBezTo>
                      <a:pt x="299" y="498"/>
                      <a:pt x="337" y="480"/>
                      <a:pt x="365" y="442"/>
                    </a:cubicBezTo>
                    <a:cubicBezTo>
                      <a:pt x="393" y="404"/>
                      <a:pt x="407" y="353"/>
                      <a:pt x="407" y="287"/>
                    </a:cubicBezTo>
                    <a:cubicBezTo>
                      <a:pt x="407" y="223"/>
                      <a:pt x="393" y="171"/>
                      <a:pt x="365" y="133"/>
                    </a:cubicBezTo>
                    <a:cubicBezTo>
                      <a:pt x="337" y="95"/>
                      <a:pt x="299" y="76"/>
                      <a:pt x="251" y="76"/>
                    </a:cubicBezTo>
                    <a:close/>
                    <a:moveTo>
                      <a:pt x="251" y="0"/>
                    </a:moveTo>
                    <a:cubicBezTo>
                      <a:pt x="329" y="0"/>
                      <a:pt x="390" y="26"/>
                      <a:pt x="435" y="76"/>
                    </a:cubicBezTo>
                    <a:cubicBezTo>
                      <a:pt x="479" y="127"/>
                      <a:pt x="502" y="197"/>
                      <a:pt x="502" y="287"/>
                    </a:cubicBezTo>
                    <a:cubicBezTo>
                      <a:pt x="502" y="377"/>
                      <a:pt x="479" y="447"/>
                      <a:pt x="435" y="497"/>
                    </a:cubicBezTo>
                    <a:cubicBezTo>
                      <a:pt x="390" y="548"/>
                      <a:pt x="329" y="573"/>
                      <a:pt x="251" y="573"/>
                    </a:cubicBezTo>
                    <a:cubicBezTo>
                      <a:pt x="172" y="573"/>
                      <a:pt x="110" y="548"/>
                      <a:pt x="66" y="497"/>
                    </a:cubicBezTo>
                    <a:cubicBezTo>
                      <a:pt x="22" y="447"/>
                      <a:pt x="0" y="377"/>
                      <a:pt x="0" y="287"/>
                    </a:cubicBezTo>
                    <a:cubicBezTo>
                      <a:pt x="0" y="197"/>
                      <a:pt x="22" y="127"/>
                      <a:pt x="66" y="76"/>
                    </a:cubicBezTo>
                    <a:cubicBezTo>
                      <a:pt x="110" y="26"/>
                      <a:pt x="172" y="0"/>
                      <a:pt x="251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6" name="Freeform 333">
                <a:extLst>
                  <a:ext uri="{FF2B5EF4-FFF2-40B4-BE49-F238E27FC236}">
                    <a16:creationId xmlns:a16="http://schemas.microsoft.com/office/drawing/2014/main" id="{0632F367-DF6E-72EF-9005-98CE73AEA63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75113" y="5240338"/>
                <a:ext cx="101600" cy="133350"/>
              </a:xfrm>
              <a:custGeom>
                <a:avLst/>
                <a:gdLst>
                  <a:gd name="T0" fmla="*/ 0 w 558"/>
                  <a:gd name="T1" fmla="*/ 0 h 742"/>
                  <a:gd name="T2" fmla="*/ 99 w 558"/>
                  <a:gd name="T3" fmla="*/ 0 h 742"/>
                  <a:gd name="T4" fmla="*/ 99 w 558"/>
                  <a:gd name="T5" fmla="*/ 443 h 742"/>
                  <a:gd name="T6" fmla="*/ 141 w 558"/>
                  <a:gd name="T7" fmla="*/ 612 h 742"/>
                  <a:gd name="T8" fmla="*/ 279 w 558"/>
                  <a:gd name="T9" fmla="*/ 663 h 742"/>
                  <a:gd name="T10" fmla="*/ 416 w 558"/>
                  <a:gd name="T11" fmla="*/ 612 h 742"/>
                  <a:gd name="T12" fmla="*/ 459 w 558"/>
                  <a:gd name="T13" fmla="*/ 443 h 742"/>
                  <a:gd name="T14" fmla="*/ 459 w 558"/>
                  <a:gd name="T15" fmla="*/ 0 h 742"/>
                  <a:gd name="T16" fmla="*/ 558 w 558"/>
                  <a:gd name="T17" fmla="*/ 0 h 742"/>
                  <a:gd name="T18" fmla="*/ 558 w 558"/>
                  <a:gd name="T19" fmla="*/ 455 h 742"/>
                  <a:gd name="T20" fmla="*/ 487 w 558"/>
                  <a:gd name="T21" fmla="*/ 670 h 742"/>
                  <a:gd name="T22" fmla="*/ 279 w 558"/>
                  <a:gd name="T23" fmla="*/ 742 h 742"/>
                  <a:gd name="T24" fmla="*/ 70 w 558"/>
                  <a:gd name="T25" fmla="*/ 670 h 742"/>
                  <a:gd name="T26" fmla="*/ 0 w 558"/>
                  <a:gd name="T27" fmla="*/ 455 h 742"/>
                  <a:gd name="T28" fmla="*/ 0 w 558"/>
                  <a:gd name="T29" fmla="*/ 0 h 7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558" h="742">
                    <a:moveTo>
                      <a:pt x="0" y="0"/>
                    </a:moveTo>
                    <a:lnTo>
                      <a:pt x="99" y="0"/>
                    </a:lnTo>
                    <a:lnTo>
                      <a:pt x="99" y="443"/>
                    </a:lnTo>
                    <a:cubicBezTo>
                      <a:pt x="99" y="521"/>
                      <a:pt x="113" y="578"/>
                      <a:pt x="141" y="612"/>
                    </a:cubicBezTo>
                    <a:cubicBezTo>
                      <a:pt x="169" y="646"/>
                      <a:pt x="215" y="663"/>
                      <a:pt x="279" y="663"/>
                    </a:cubicBezTo>
                    <a:cubicBezTo>
                      <a:pt x="342" y="663"/>
                      <a:pt x="388" y="646"/>
                      <a:pt x="416" y="612"/>
                    </a:cubicBezTo>
                    <a:cubicBezTo>
                      <a:pt x="444" y="578"/>
                      <a:pt x="459" y="521"/>
                      <a:pt x="459" y="443"/>
                    </a:cubicBezTo>
                    <a:lnTo>
                      <a:pt x="459" y="0"/>
                    </a:lnTo>
                    <a:lnTo>
                      <a:pt x="558" y="0"/>
                    </a:lnTo>
                    <a:lnTo>
                      <a:pt x="558" y="455"/>
                    </a:lnTo>
                    <a:cubicBezTo>
                      <a:pt x="558" y="551"/>
                      <a:pt x="534" y="622"/>
                      <a:pt x="487" y="670"/>
                    </a:cubicBezTo>
                    <a:cubicBezTo>
                      <a:pt x="440" y="718"/>
                      <a:pt x="371" y="742"/>
                      <a:pt x="279" y="742"/>
                    </a:cubicBezTo>
                    <a:cubicBezTo>
                      <a:pt x="187" y="742"/>
                      <a:pt x="117" y="718"/>
                      <a:pt x="70" y="670"/>
                    </a:cubicBezTo>
                    <a:cubicBezTo>
                      <a:pt x="23" y="622"/>
                      <a:pt x="0" y="551"/>
                      <a:pt x="0" y="455"/>
                    </a:cubicBez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7" name="Freeform 334">
                <a:extLst>
                  <a:ext uri="{FF2B5EF4-FFF2-40B4-BE49-F238E27FC236}">
                    <a16:creationId xmlns:a16="http://schemas.microsoft.com/office/drawing/2014/main" id="{2F52E157-3E87-7482-0D69-BB918E314BC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248150" y="5240338"/>
                <a:ext cx="111125" cy="131763"/>
              </a:xfrm>
              <a:custGeom>
                <a:avLst/>
                <a:gdLst>
                  <a:gd name="T0" fmla="*/ 0 w 616"/>
                  <a:gd name="T1" fmla="*/ 0 h 729"/>
                  <a:gd name="T2" fmla="*/ 616 w 616"/>
                  <a:gd name="T3" fmla="*/ 0 h 729"/>
                  <a:gd name="T4" fmla="*/ 616 w 616"/>
                  <a:gd name="T5" fmla="*/ 83 h 729"/>
                  <a:gd name="T6" fmla="*/ 357 w 616"/>
                  <a:gd name="T7" fmla="*/ 83 h 729"/>
                  <a:gd name="T8" fmla="*/ 357 w 616"/>
                  <a:gd name="T9" fmla="*/ 729 h 729"/>
                  <a:gd name="T10" fmla="*/ 258 w 616"/>
                  <a:gd name="T11" fmla="*/ 729 h 729"/>
                  <a:gd name="T12" fmla="*/ 258 w 616"/>
                  <a:gd name="T13" fmla="*/ 83 h 729"/>
                  <a:gd name="T14" fmla="*/ 0 w 616"/>
                  <a:gd name="T15" fmla="*/ 83 h 729"/>
                  <a:gd name="T16" fmla="*/ 0 w 616"/>
                  <a:gd name="T17" fmla="*/ 0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616" h="729">
                    <a:moveTo>
                      <a:pt x="0" y="0"/>
                    </a:moveTo>
                    <a:lnTo>
                      <a:pt x="616" y="0"/>
                    </a:lnTo>
                    <a:lnTo>
                      <a:pt x="616" y="83"/>
                    </a:lnTo>
                    <a:lnTo>
                      <a:pt x="357" y="83"/>
                    </a:lnTo>
                    <a:lnTo>
                      <a:pt x="357" y="729"/>
                    </a:lnTo>
                    <a:lnTo>
                      <a:pt x="258" y="729"/>
                    </a:lnTo>
                    <a:lnTo>
                      <a:pt x="258" y="83"/>
                    </a:lnTo>
                    <a:lnTo>
                      <a:pt x="0" y="8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8" name="Freeform 335">
                <a:extLst>
                  <a:ext uri="{FF2B5EF4-FFF2-40B4-BE49-F238E27FC236}">
                    <a16:creationId xmlns:a16="http://schemas.microsoft.com/office/drawing/2014/main" id="{E85B2800-A0C6-A526-EEFD-4890D32C43B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75150" y="5235575"/>
                <a:ext cx="82550" cy="136525"/>
              </a:xfrm>
              <a:custGeom>
                <a:avLst/>
                <a:gdLst>
                  <a:gd name="T0" fmla="*/ 458 w 458"/>
                  <a:gd name="T1" fmla="*/ 430 h 760"/>
                  <a:gd name="T2" fmla="*/ 458 w 458"/>
                  <a:gd name="T3" fmla="*/ 760 h 760"/>
                  <a:gd name="T4" fmla="*/ 368 w 458"/>
                  <a:gd name="T5" fmla="*/ 760 h 760"/>
                  <a:gd name="T6" fmla="*/ 368 w 458"/>
                  <a:gd name="T7" fmla="*/ 433 h 760"/>
                  <a:gd name="T8" fmla="*/ 337 w 458"/>
                  <a:gd name="T9" fmla="*/ 317 h 760"/>
                  <a:gd name="T10" fmla="*/ 247 w 458"/>
                  <a:gd name="T11" fmla="*/ 278 h 760"/>
                  <a:gd name="T12" fmla="*/ 132 w 458"/>
                  <a:gd name="T13" fmla="*/ 325 h 760"/>
                  <a:gd name="T14" fmla="*/ 90 w 458"/>
                  <a:gd name="T15" fmla="*/ 451 h 760"/>
                  <a:gd name="T16" fmla="*/ 90 w 458"/>
                  <a:gd name="T17" fmla="*/ 760 h 760"/>
                  <a:gd name="T18" fmla="*/ 0 w 458"/>
                  <a:gd name="T19" fmla="*/ 760 h 760"/>
                  <a:gd name="T20" fmla="*/ 0 w 458"/>
                  <a:gd name="T21" fmla="*/ 0 h 760"/>
                  <a:gd name="T22" fmla="*/ 90 w 458"/>
                  <a:gd name="T23" fmla="*/ 0 h 760"/>
                  <a:gd name="T24" fmla="*/ 90 w 458"/>
                  <a:gd name="T25" fmla="*/ 298 h 760"/>
                  <a:gd name="T26" fmla="*/ 166 w 458"/>
                  <a:gd name="T27" fmla="*/ 225 h 760"/>
                  <a:gd name="T28" fmla="*/ 267 w 458"/>
                  <a:gd name="T29" fmla="*/ 200 h 760"/>
                  <a:gd name="T30" fmla="*/ 409 w 458"/>
                  <a:gd name="T31" fmla="*/ 259 h 760"/>
                  <a:gd name="T32" fmla="*/ 458 w 458"/>
                  <a:gd name="T33" fmla="*/ 430 h 7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58" h="760">
                    <a:moveTo>
                      <a:pt x="458" y="430"/>
                    </a:moveTo>
                    <a:lnTo>
                      <a:pt x="458" y="760"/>
                    </a:lnTo>
                    <a:lnTo>
                      <a:pt x="368" y="760"/>
                    </a:lnTo>
                    <a:lnTo>
                      <a:pt x="368" y="433"/>
                    </a:lnTo>
                    <a:cubicBezTo>
                      <a:pt x="368" y="381"/>
                      <a:pt x="357" y="343"/>
                      <a:pt x="337" y="317"/>
                    </a:cubicBezTo>
                    <a:cubicBezTo>
                      <a:pt x="317" y="291"/>
                      <a:pt x="287" y="278"/>
                      <a:pt x="247" y="278"/>
                    </a:cubicBezTo>
                    <a:cubicBezTo>
                      <a:pt x="198" y="278"/>
                      <a:pt x="160" y="294"/>
                      <a:pt x="132" y="325"/>
                    </a:cubicBezTo>
                    <a:cubicBezTo>
                      <a:pt x="104" y="356"/>
                      <a:pt x="90" y="398"/>
                      <a:pt x="90" y="451"/>
                    </a:cubicBezTo>
                    <a:lnTo>
                      <a:pt x="90" y="760"/>
                    </a:lnTo>
                    <a:lnTo>
                      <a:pt x="0" y="76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90" y="298"/>
                    </a:lnTo>
                    <a:cubicBezTo>
                      <a:pt x="111" y="266"/>
                      <a:pt x="136" y="241"/>
                      <a:pt x="166" y="225"/>
                    </a:cubicBezTo>
                    <a:cubicBezTo>
                      <a:pt x="195" y="209"/>
                      <a:pt x="229" y="200"/>
                      <a:pt x="267" y="200"/>
                    </a:cubicBezTo>
                    <a:cubicBezTo>
                      <a:pt x="329" y="200"/>
                      <a:pt x="377" y="220"/>
                      <a:pt x="409" y="259"/>
                    </a:cubicBezTo>
                    <a:cubicBezTo>
                      <a:pt x="441" y="298"/>
                      <a:pt x="458" y="355"/>
                      <a:pt x="458" y="43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9" name="Freeform 336">
                <a:extLst>
                  <a:ext uri="{FF2B5EF4-FFF2-40B4-BE49-F238E27FC236}">
                    <a16:creationId xmlns:a16="http://schemas.microsoft.com/office/drawing/2014/main" id="{E9B03372-D88F-98E4-ABDD-4ECD190ACAA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89450" y="5270500"/>
                <a:ext cx="57150" cy="101600"/>
              </a:xfrm>
              <a:custGeom>
                <a:avLst/>
                <a:gdLst>
                  <a:gd name="T0" fmla="*/ 320 w 320"/>
                  <a:gd name="T1" fmla="*/ 97 h 560"/>
                  <a:gd name="T2" fmla="*/ 287 w 320"/>
                  <a:gd name="T3" fmla="*/ 84 h 560"/>
                  <a:gd name="T4" fmla="*/ 248 w 320"/>
                  <a:gd name="T5" fmla="*/ 80 h 560"/>
                  <a:gd name="T6" fmla="*/ 131 w 320"/>
                  <a:gd name="T7" fmla="*/ 130 h 560"/>
                  <a:gd name="T8" fmla="*/ 90 w 320"/>
                  <a:gd name="T9" fmla="*/ 272 h 560"/>
                  <a:gd name="T10" fmla="*/ 90 w 320"/>
                  <a:gd name="T11" fmla="*/ 560 h 560"/>
                  <a:gd name="T12" fmla="*/ 0 w 320"/>
                  <a:gd name="T13" fmla="*/ 560 h 560"/>
                  <a:gd name="T14" fmla="*/ 0 w 320"/>
                  <a:gd name="T15" fmla="*/ 13 h 560"/>
                  <a:gd name="T16" fmla="*/ 90 w 320"/>
                  <a:gd name="T17" fmla="*/ 13 h 560"/>
                  <a:gd name="T18" fmla="*/ 90 w 320"/>
                  <a:gd name="T19" fmla="*/ 98 h 560"/>
                  <a:gd name="T20" fmla="*/ 163 w 320"/>
                  <a:gd name="T21" fmla="*/ 24 h 560"/>
                  <a:gd name="T22" fmla="*/ 274 w 320"/>
                  <a:gd name="T23" fmla="*/ 0 h 560"/>
                  <a:gd name="T24" fmla="*/ 295 w 320"/>
                  <a:gd name="T25" fmla="*/ 1 h 560"/>
                  <a:gd name="T26" fmla="*/ 320 w 320"/>
                  <a:gd name="T27" fmla="*/ 5 h 560"/>
                  <a:gd name="T28" fmla="*/ 320 w 320"/>
                  <a:gd name="T29" fmla="*/ 97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320" h="560">
                    <a:moveTo>
                      <a:pt x="320" y="97"/>
                    </a:moveTo>
                    <a:cubicBezTo>
                      <a:pt x="310" y="91"/>
                      <a:pt x="299" y="87"/>
                      <a:pt x="287" y="84"/>
                    </a:cubicBezTo>
                    <a:cubicBezTo>
                      <a:pt x="275" y="82"/>
                      <a:pt x="262" y="80"/>
                      <a:pt x="248" y="80"/>
                    </a:cubicBezTo>
                    <a:cubicBezTo>
                      <a:pt x="197" y="80"/>
                      <a:pt x="158" y="97"/>
                      <a:pt x="131" y="130"/>
                    </a:cubicBezTo>
                    <a:cubicBezTo>
                      <a:pt x="103" y="163"/>
                      <a:pt x="90" y="210"/>
                      <a:pt x="90" y="272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08" y="65"/>
                      <a:pt x="133" y="40"/>
                      <a:pt x="163" y="24"/>
                    </a:cubicBezTo>
                    <a:cubicBezTo>
                      <a:pt x="193" y="8"/>
                      <a:pt x="230" y="0"/>
                      <a:pt x="274" y="0"/>
                    </a:cubicBezTo>
                    <a:cubicBezTo>
                      <a:pt x="280" y="0"/>
                      <a:pt x="287" y="1"/>
                      <a:pt x="295" y="1"/>
                    </a:cubicBezTo>
                    <a:cubicBezTo>
                      <a:pt x="302" y="2"/>
                      <a:pt x="310" y="3"/>
                      <a:pt x="320" y="5"/>
                    </a:cubicBezTo>
                    <a:lnTo>
                      <a:pt x="320" y="97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10" name="Freeform 337">
                <a:extLst>
                  <a:ext uri="{FF2B5EF4-FFF2-40B4-BE49-F238E27FC236}">
                    <a16:creationId xmlns:a16="http://schemas.microsoft.com/office/drawing/2014/main" id="{27160E37-F5A2-5616-EDAE-66B3063F67A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552950" y="5270500"/>
                <a:ext cx="92075" cy="103188"/>
              </a:xfrm>
              <a:custGeom>
                <a:avLst/>
                <a:gdLst>
                  <a:gd name="T0" fmla="*/ 507 w 507"/>
                  <a:gd name="T1" fmla="*/ 264 h 573"/>
                  <a:gd name="T2" fmla="*/ 507 w 507"/>
                  <a:gd name="T3" fmla="*/ 308 h 573"/>
                  <a:gd name="T4" fmla="*/ 94 w 507"/>
                  <a:gd name="T5" fmla="*/ 308 h 573"/>
                  <a:gd name="T6" fmla="*/ 150 w 507"/>
                  <a:gd name="T7" fmla="*/ 450 h 573"/>
                  <a:gd name="T8" fmla="*/ 289 w 507"/>
                  <a:gd name="T9" fmla="*/ 498 h 573"/>
                  <a:gd name="T10" fmla="*/ 389 w 507"/>
                  <a:gd name="T11" fmla="*/ 486 h 573"/>
                  <a:gd name="T12" fmla="*/ 486 w 507"/>
                  <a:gd name="T13" fmla="*/ 447 h 573"/>
                  <a:gd name="T14" fmla="*/ 486 w 507"/>
                  <a:gd name="T15" fmla="*/ 532 h 573"/>
                  <a:gd name="T16" fmla="*/ 387 w 507"/>
                  <a:gd name="T17" fmla="*/ 563 h 573"/>
                  <a:gd name="T18" fmla="*/ 284 w 507"/>
                  <a:gd name="T19" fmla="*/ 573 h 573"/>
                  <a:gd name="T20" fmla="*/ 76 w 507"/>
                  <a:gd name="T21" fmla="*/ 498 h 573"/>
                  <a:gd name="T22" fmla="*/ 0 w 507"/>
                  <a:gd name="T23" fmla="*/ 292 h 573"/>
                  <a:gd name="T24" fmla="*/ 72 w 507"/>
                  <a:gd name="T25" fmla="*/ 79 h 573"/>
                  <a:gd name="T26" fmla="*/ 268 w 507"/>
                  <a:gd name="T27" fmla="*/ 0 h 573"/>
                  <a:gd name="T28" fmla="*/ 443 w 507"/>
                  <a:gd name="T29" fmla="*/ 71 h 573"/>
                  <a:gd name="T30" fmla="*/ 507 w 507"/>
                  <a:gd name="T31" fmla="*/ 264 h 573"/>
                  <a:gd name="T32" fmla="*/ 417 w 507"/>
                  <a:gd name="T33" fmla="*/ 238 h 573"/>
                  <a:gd name="T34" fmla="*/ 376 w 507"/>
                  <a:gd name="T35" fmla="*/ 120 h 573"/>
                  <a:gd name="T36" fmla="*/ 269 w 507"/>
                  <a:gd name="T37" fmla="*/ 76 h 573"/>
                  <a:gd name="T38" fmla="*/ 149 w 507"/>
                  <a:gd name="T39" fmla="*/ 119 h 573"/>
                  <a:gd name="T40" fmla="*/ 97 w 507"/>
                  <a:gd name="T41" fmla="*/ 238 h 573"/>
                  <a:gd name="T42" fmla="*/ 417 w 507"/>
                  <a:gd name="T43" fmla="*/ 23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07" h="573">
                    <a:moveTo>
                      <a:pt x="507" y="264"/>
                    </a:moveTo>
                    <a:lnTo>
                      <a:pt x="507" y="308"/>
                    </a:lnTo>
                    <a:lnTo>
                      <a:pt x="94" y="308"/>
                    </a:lnTo>
                    <a:cubicBezTo>
                      <a:pt x="98" y="370"/>
                      <a:pt x="116" y="418"/>
                      <a:pt x="150" y="450"/>
                    </a:cubicBezTo>
                    <a:cubicBezTo>
                      <a:pt x="183" y="482"/>
                      <a:pt x="229" y="498"/>
                      <a:pt x="289" y="498"/>
                    </a:cubicBezTo>
                    <a:cubicBezTo>
                      <a:pt x="323" y="498"/>
                      <a:pt x="357" y="494"/>
                      <a:pt x="389" y="486"/>
                    </a:cubicBezTo>
                    <a:cubicBezTo>
                      <a:pt x="421" y="478"/>
                      <a:pt x="454" y="465"/>
                      <a:pt x="486" y="447"/>
                    </a:cubicBezTo>
                    <a:lnTo>
                      <a:pt x="486" y="532"/>
                    </a:lnTo>
                    <a:cubicBezTo>
                      <a:pt x="454" y="546"/>
                      <a:pt x="421" y="557"/>
                      <a:pt x="387" y="563"/>
                    </a:cubicBezTo>
                    <a:cubicBezTo>
                      <a:pt x="353" y="569"/>
                      <a:pt x="318" y="573"/>
                      <a:pt x="284" y="573"/>
                    </a:cubicBezTo>
                    <a:cubicBezTo>
                      <a:pt x="196" y="573"/>
                      <a:pt x="127" y="548"/>
                      <a:pt x="76" y="498"/>
                    </a:cubicBezTo>
                    <a:cubicBezTo>
                      <a:pt x="25" y="448"/>
                      <a:pt x="0" y="379"/>
                      <a:pt x="0" y="292"/>
                    </a:cubicBezTo>
                    <a:cubicBezTo>
                      <a:pt x="0" y="203"/>
                      <a:pt x="24" y="132"/>
                      <a:pt x="72" y="79"/>
                    </a:cubicBezTo>
                    <a:cubicBezTo>
                      <a:pt x="120" y="27"/>
                      <a:pt x="186" y="0"/>
                      <a:pt x="268" y="0"/>
                    </a:cubicBezTo>
                    <a:cubicBezTo>
                      <a:pt x="342" y="0"/>
                      <a:pt x="400" y="24"/>
                      <a:pt x="443" y="71"/>
                    </a:cubicBezTo>
                    <a:cubicBezTo>
                      <a:pt x="485" y="119"/>
                      <a:pt x="507" y="183"/>
                      <a:pt x="507" y="264"/>
                    </a:cubicBezTo>
                    <a:close/>
                    <a:moveTo>
                      <a:pt x="417" y="238"/>
                    </a:moveTo>
                    <a:cubicBezTo>
                      <a:pt x="416" y="189"/>
                      <a:pt x="402" y="150"/>
                      <a:pt x="376" y="120"/>
                    </a:cubicBezTo>
                    <a:cubicBezTo>
                      <a:pt x="349" y="91"/>
                      <a:pt x="313" y="76"/>
                      <a:pt x="269" y="76"/>
                    </a:cubicBezTo>
                    <a:cubicBezTo>
                      <a:pt x="219" y="76"/>
                      <a:pt x="179" y="91"/>
                      <a:pt x="149" y="119"/>
                    </a:cubicBezTo>
                    <a:cubicBezTo>
                      <a:pt x="119" y="147"/>
                      <a:pt x="101" y="187"/>
                      <a:pt x="97" y="238"/>
                    </a:cubicBezTo>
                    <a:lnTo>
                      <a:pt x="417" y="238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11" name="Freeform 338">
                <a:extLst>
                  <a:ext uri="{FF2B5EF4-FFF2-40B4-BE49-F238E27FC236}">
                    <a16:creationId xmlns:a16="http://schemas.microsoft.com/office/drawing/2014/main" id="{5F31A885-1916-AF7D-8EF5-D35DABA82AA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64075" y="5270500"/>
                <a:ext cx="74613" cy="103188"/>
              </a:xfrm>
              <a:custGeom>
                <a:avLst/>
                <a:gdLst>
                  <a:gd name="T0" fmla="*/ 389 w 418"/>
                  <a:gd name="T1" fmla="*/ 29 h 573"/>
                  <a:gd name="T2" fmla="*/ 389 w 418"/>
                  <a:gd name="T3" fmla="*/ 114 h 573"/>
                  <a:gd name="T4" fmla="*/ 310 w 418"/>
                  <a:gd name="T5" fmla="*/ 85 h 573"/>
                  <a:gd name="T6" fmla="*/ 225 w 418"/>
                  <a:gd name="T7" fmla="*/ 75 h 573"/>
                  <a:gd name="T8" fmla="*/ 124 w 418"/>
                  <a:gd name="T9" fmla="*/ 96 h 573"/>
                  <a:gd name="T10" fmla="*/ 91 w 418"/>
                  <a:gd name="T11" fmla="*/ 157 h 573"/>
                  <a:gd name="T12" fmla="*/ 115 w 418"/>
                  <a:gd name="T13" fmla="*/ 206 h 573"/>
                  <a:gd name="T14" fmla="*/ 211 w 418"/>
                  <a:gd name="T15" fmla="*/ 240 h 573"/>
                  <a:gd name="T16" fmla="*/ 242 w 418"/>
                  <a:gd name="T17" fmla="*/ 247 h 573"/>
                  <a:gd name="T18" fmla="*/ 378 w 418"/>
                  <a:gd name="T19" fmla="*/ 305 h 573"/>
                  <a:gd name="T20" fmla="*/ 418 w 418"/>
                  <a:gd name="T21" fmla="*/ 409 h 573"/>
                  <a:gd name="T22" fmla="*/ 358 w 418"/>
                  <a:gd name="T23" fmla="*/ 529 h 573"/>
                  <a:gd name="T24" fmla="*/ 192 w 418"/>
                  <a:gd name="T25" fmla="*/ 573 h 573"/>
                  <a:gd name="T26" fmla="*/ 100 w 418"/>
                  <a:gd name="T27" fmla="*/ 565 h 573"/>
                  <a:gd name="T28" fmla="*/ 0 w 418"/>
                  <a:gd name="T29" fmla="*/ 540 h 573"/>
                  <a:gd name="T30" fmla="*/ 0 w 418"/>
                  <a:gd name="T31" fmla="*/ 447 h 573"/>
                  <a:gd name="T32" fmla="*/ 98 w 418"/>
                  <a:gd name="T33" fmla="*/ 486 h 573"/>
                  <a:gd name="T34" fmla="*/ 194 w 418"/>
                  <a:gd name="T35" fmla="*/ 499 h 573"/>
                  <a:gd name="T36" fmla="*/ 292 w 418"/>
                  <a:gd name="T37" fmla="*/ 478 h 573"/>
                  <a:gd name="T38" fmla="*/ 326 w 418"/>
                  <a:gd name="T39" fmla="*/ 416 h 573"/>
                  <a:gd name="T40" fmla="*/ 301 w 418"/>
                  <a:gd name="T41" fmla="*/ 360 h 573"/>
                  <a:gd name="T42" fmla="*/ 193 w 418"/>
                  <a:gd name="T43" fmla="*/ 322 h 573"/>
                  <a:gd name="T44" fmla="*/ 162 w 418"/>
                  <a:gd name="T45" fmla="*/ 315 h 573"/>
                  <a:gd name="T46" fmla="*/ 41 w 418"/>
                  <a:gd name="T47" fmla="*/ 261 h 573"/>
                  <a:gd name="T48" fmla="*/ 4 w 418"/>
                  <a:gd name="T49" fmla="*/ 161 h 573"/>
                  <a:gd name="T50" fmla="*/ 58 w 418"/>
                  <a:gd name="T51" fmla="*/ 42 h 573"/>
                  <a:gd name="T52" fmla="*/ 214 w 418"/>
                  <a:gd name="T53" fmla="*/ 0 h 573"/>
                  <a:gd name="T54" fmla="*/ 308 w 418"/>
                  <a:gd name="T55" fmla="*/ 8 h 573"/>
                  <a:gd name="T56" fmla="*/ 389 w 418"/>
                  <a:gd name="T57" fmla="*/ 29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418" h="573">
                    <a:moveTo>
                      <a:pt x="389" y="29"/>
                    </a:moveTo>
                    <a:lnTo>
                      <a:pt x="389" y="114"/>
                    </a:lnTo>
                    <a:cubicBezTo>
                      <a:pt x="363" y="102"/>
                      <a:pt x="337" y="92"/>
                      <a:pt x="310" y="85"/>
                    </a:cubicBezTo>
                    <a:cubicBezTo>
                      <a:pt x="282" y="79"/>
                      <a:pt x="254" y="75"/>
                      <a:pt x="225" y="75"/>
                    </a:cubicBezTo>
                    <a:cubicBezTo>
                      <a:pt x="180" y="75"/>
                      <a:pt x="146" y="82"/>
                      <a:pt x="124" y="96"/>
                    </a:cubicBezTo>
                    <a:cubicBezTo>
                      <a:pt x="102" y="110"/>
                      <a:pt x="91" y="130"/>
                      <a:pt x="91" y="157"/>
                    </a:cubicBezTo>
                    <a:cubicBezTo>
                      <a:pt x="91" y="178"/>
                      <a:pt x="99" y="194"/>
                      <a:pt x="115" y="206"/>
                    </a:cubicBezTo>
                    <a:cubicBezTo>
                      <a:pt x="131" y="218"/>
                      <a:pt x="163" y="230"/>
                      <a:pt x="211" y="240"/>
                    </a:cubicBezTo>
                    <a:lnTo>
                      <a:pt x="242" y="247"/>
                    </a:lnTo>
                    <a:cubicBezTo>
                      <a:pt x="306" y="261"/>
                      <a:pt x="351" y="281"/>
                      <a:pt x="378" y="305"/>
                    </a:cubicBezTo>
                    <a:cubicBezTo>
                      <a:pt x="404" y="330"/>
                      <a:pt x="418" y="365"/>
                      <a:pt x="418" y="409"/>
                    </a:cubicBezTo>
                    <a:cubicBezTo>
                      <a:pt x="418" y="460"/>
                      <a:pt x="398" y="500"/>
                      <a:pt x="358" y="529"/>
                    </a:cubicBezTo>
                    <a:cubicBezTo>
                      <a:pt x="318" y="559"/>
                      <a:pt x="262" y="573"/>
                      <a:pt x="192" y="573"/>
                    </a:cubicBezTo>
                    <a:cubicBezTo>
                      <a:pt x="162" y="573"/>
                      <a:pt x="132" y="570"/>
                      <a:pt x="100" y="565"/>
                    </a:cubicBezTo>
                    <a:cubicBezTo>
                      <a:pt x="68" y="560"/>
                      <a:pt x="35" y="552"/>
                      <a:pt x="0" y="540"/>
                    </a:cubicBezTo>
                    <a:lnTo>
                      <a:pt x="0" y="447"/>
                    </a:lnTo>
                    <a:cubicBezTo>
                      <a:pt x="33" y="465"/>
                      <a:pt x="66" y="478"/>
                      <a:pt x="98" y="486"/>
                    </a:cubicBezTo>
                    <a:cubicBezTo>
                      <a:pt x="130" y="495"/>
                      <a:pt x="162" y="499"/>
                      <a:pt x="194" y="499"/>
                    </a:cubicBezTo>
                    <a:cubicBezTo>
                      <a:pt x="236" y="499"/>
                      <a:pt x="269" y="492"/>
                      <a:pt x="292" y="478"/>
                    </a:cubicBezTo>
                    <a:cubicBezTo>
                      <a:pt x="314" y="464"/>
                      <a:pt x="326" y="443"/>
                      <a:pt x="326" y="416"/>
                    </a:cubicBezTo>
                    <a:cubicBezTo>
                      <a:pt x="326" y="392"/>
                      <a:pt x="317" y="373"/>
                      <a:pt x="301" y="360"/>
                    </a:cubicBezTo>
                    <a:cubicBezTo>
                      <a:pt x="285" y="347"/>
                      <a:pt x="249" y="334"/>
                      <a:pt x="193" y="322"/>
                    </a:cubicBezTo>
                    <a:lnTo>
                      <a:pt x="162" y="315"/>
                    </a:lnTo>
                    <a:cubicBezTo>
                      <a:pt x="106" y="303"/>
                      <a:pt x="65" y="285"/>
                      <a:pt x="41" y="261"/>
                    </a:cubicBezTo>
                    <a:cubicBezTo>
                      <a:pt x="16" y="237"/>
                      <a:pt x="4" y="204"/>
                      <a:pt x="4" y="161"/>
                    </a:cubicBezTo>
                    <a:cubicBezTo>
                      <a:pt x="4" y="110"/>
                      <a:pt x="22" y="70"/>
                      <a:pt x="58" y="42"/>
                    </a:cubicBezTo>
                    <a:cubicBezTo>
                      <a:pt x="94" y="14"/>
                      <a:pt x="146" y="0"/>
                      <a:pt x="214" y="0"/>
                    </a:cubicBezTo>
                    <a:cubicBezTo>
                      <a:pt x="247" y="0"/>
                      <a:pt x="278" y="3"/>
                      <a:pt x="308" y="8"/>
                    </a:cubicBezTo>
                    <a:cubicBezTo>
                      <a:pt x="337" y="13"/>
                      <a:pt x="364" y="20"/>
                      <a:pt x="389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12" name="Freeform 339">
                <a:extLst>
                  <a:ext uri="{FF2B5EF4-FFF2-40B4-BE49-F238E27FC236}">
                    <a16:creationId xmlns:a16="http://schemas.microsoft.com/office/drawing/2014/main" id="{637D6380-F4F4-DC97-4022-0F82CD1C377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64088" y="5235575"/>
                <a:ext cx="82550" cy="136525"/>
              </a:xfrm>
              <a:custGeom>
                <a:avLst/>
                <a:gdLst>
                  <a:gd name="T0" fmla="*/ 458 w 458"/>
                  <a:gd name="T1" fmla="*/ 430 h 760"/>
                  <a:gd name="T2" fmla="*/ 458 w 458"/>
                  <a:gd name="T3" fmla="*/ 760 h 760"/>
                  <a:gd name="T4" fmla="*/ 368 w 458"/>
                  <a:gd name="T5" fmla="*/ 760 h 760"/>
                  <a:gd name="T6" fmla="*/ 368 w 458"/>
                  <a:gd name="T7" fmla="*/ 433 h 760"/>
                  <a:gd name="T8" fmla="*/ 337 w 458"/>
                  <a:gd name="T9" fmla="*/ 317 h 760"/>
                  <a:gd name="T10" fmla="*/ 247 w 458"/>
                  <a:gd name="T11" fmla="*/ 278 h 760"/>
                  <a:gd name="T12" fmla="*/ 132 w 458"/>
                  <a:gd name="T13" fmla="*/ 325 h 760"/>
                  <a:gd name="T14" fmla="*/ 90 w 458"/>
                  <a:gd name="T15" fmla="*/ 451 h 760"/>
                  <a:gd name="T16" fmla="*/ 90 w 458"/>
                  <a:gd name="T17" fmla="*/ 760 h 760"/>
                  <a:gd name="T18" fmla="*/ 0 w 458"/>
                  <a:gd name="T19" fmla="*/ 760 h 760"/>
                  <a:gd name="T20" fmla="*/ 0 w 458"/>
                  <a:gd name="T21" fmla="*/ 0 h 760"/>
                  <a:gd name="T22" fmla="*/ 90 w 458"/>
                  <a:gd name="T23" fmla="*/ 0 h 760"/>
                  <a:gd name="T24" fmla="*/ 90 w 458"/>
                  <a:gd name="T25" fmla="*/ 298 h 760"/>
                  <a:gd name="T26" fmla="*/ 166 w 458"/>
                  <a:gd name="T27" fmla="*/ 225 h 760"/>
                  <a:gd name="T28" fmla="*/ 267 w 458"/>
                  <a:gd name="T29" fmla="*/ 200 h 760"/>
                  <a:gd name="T30" fmla="*/ 409 w 458"/>
                  <a:gd name="T31" fmla="*/ 259 h 760"/>
                  <a:gd name="T32" fmla="*/ 458 w 458"/>
                  <a:gd name="T33" fmla="*/ 430 h 7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58" h="760">
                    <a:moveTo>
                      <a:pt x="458" y="430"/>
                    </a:moveTo>
                    <a:lnTo>
                      <a:pt x="458" y="760"/>
                    </a:lnTo>
                    <a:lnTo>
                      <a:pt x="368" y="760"/>
                    </a:lnTo>
                    <a:lnTo>
                      <a:pt x="368" y="433"/>
                    </a:lnTo>
                    <a:cubicBezTo>
                      <a:pt x="368" y="381"/>
                      <a:pt x="357" y="343"/>
                      <a:pt x="337" y="317"/>
                    </a:cubicBezTo>
                    <a:cubicBezTo>
                      <a:pt x="317" y="291"/>
                      <a:pt x="287" y="278"/>
                      <a:pt x="247" y="278"/>
                    </a:cubicBezTo>
                    <a:cubicBezTo>
                      <a:pt x="198" y="278"/>
                      <a:pt x="160" y="294"/>
                      <a:pt x="132" y="325"/>
                    </a:cubicBezTo>
                    <a:cubicBezTo>
                      <a:pt x="104" y="356"/>
                      <a:pt x="90" y="398"/>
                      <a:pt x="90" y="451"/>
                    </a:cubicBezTo>
                    <a:lnTo>
                      <a:pt x="90" y="760"/>
                    </a:lnTo>
                    <a:lnTo>
                      <a:pt x="0" y="76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90" y="298"/>
                    </a:lnTo>
                    <a:cubicBezTo>
                      <a:pt x="111" y="266"/>
                      <a:pt x="136" y="241"/>
                      <a:pt x="166" y="225"/>
                    </a:cubicBezTo>
                    <a:cubicBezTo>
                      <a:pt x="195" y="209"/>
                      <a:pt x="229" y="200"/>
                      <a:pt x="267" y="200"/>
                    </a:cubicBezTo>
                    <a:cubicBezTo>
                      <a:pt x="329" y="200"/>
                      <a:pt x="377" y="220"/>
                      <a:pt x="409" y="259"/>
                    </a:cubicBezTo>
                    <a:cubicBezTo>
                      <a:pt x="441" y="298"/>
                      <a:pt x="458" y="355"/>
                      <a:pt x="458" y="43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13" name="Freeform 340">
                <a:extLst>
                  <a:ext uri="{FF2B5EF4-FFF2-40B4-BE49-F238E27FC236}">
                    <a16:creationId xmlns:a16="http://schemas.microsoft.com/office/drawing/2014/main" id="{FA2CC3A7-945A-25FF-5F1D-C36B8A33CB4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872038" y="5270500"/>
                <a:ext cx="90488" cy="103188"/>
              </a:xfrm>
              <a:custGeom>
                <a:avLst/>
                <a:gdLst>
                  <a:gd name="T0" fmla="*/ 251 w 502"/>
                  <a:gd name="T1" fmla="*/ 76 h 573"/>
                  <a:gd name="T2" fmla="*/ 137 w 502"/>
                  <a:gd name="T3" fmla="*/ 133 h 573"/>
                  <a:gd name="T4" fmla="*/ 95 w 502"/>
                  <a:gd name="T5" fmla="*/ 287 h 573"/>
                  <a:gd name="T6" fmla="*/ 136 w 502"/>
                  <a:gd name="T7" fmla="*/ 442 h 573"/>
                  <a:gd name="T8" fmla="*/ 251 w 502"/>
                  <a:gd name="T9" fmla="*/ 498 h 573"/>
                  <a:gd name="T10" fmla="*/ 365 w 502"/>
                  <a:gd name="T11" fmla="*/ 442 h 573"/>
                  <a:gd name="T12" fmla="*/ 407 w 502"/>
                  <a:gd name="T13" fmla="*/ 287 h 573"/>
                  <a:gd name="T14" fmla="*/ 365 w 502"/>
                  <a:gd name="T15" fmla="*/ 133 h 573"/>
                  <a:gd name="T16" fmla="*/ 251 w 502"/>
                  <a:gd name="T17" fmla="*/ 76 h 573"/>
                  <a:gd name="T18" fmla="*/ 251 w 502"/>
                  <a:gd name="T19" fmla="*/ 0 h 573"/>
                  <a:gd name="T20" fmla="*/ 435 w 502"/>
                  <a:gd name="T21" fmla="*/ 76 h 573"/>
                  <a:gd name="T22" fmla="*/ 502 w 502"/>
                  <a:gd name="T23" fmla="*/ 287 h 573"/>
                  <a:gd name="T24" fmla="*/ 435 w 502"/>
                  <a:gd name="T25" fmla="*/ 497 h 573"/>
                  <a:gd name="T26" fmla="*/ 251 w 502"/>
                  <a:gd name="T27" fmla="*/ 573 h 573"/>
                  <a:gd name="T28" fmla="*/ 66 w 502"/>
                  <a:gd name="T29" fmla="*/ 497 h 573"/>
                  <a:gd name="T30" fmla="*/ 0 w 502"/>
                  <a:gd name="T31" fmla="*/ 287 h 573"/>
                  <a:gd name="T32" fmla="*/ 66 w 502"/>
                  <a:gd name="T33" fmla="*/ 76 h 573"/>
                  <a:gd name="T34" fmla="*/ 251 w 502"/>
                  <a:gd name="T35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2" h="573">
                    <a:moveTo>
                      <a:pt x="251" y="76"/>
                    </a:moveTo>
                    <a:cubicBezTo>
                      <a:pt x="203" y="76"/>
                      <a:pt x="165" y="95"/>
                      <a:pt x="137" y="133"/>
                    </a:cubicBezTo>
                    <a:cubicBezTo>
                      <a:pt x="109" y="171"/>
                      <a:pt x="95" y="222"/>
                      <a:pt x="95" y="287"/>
                    </a:cubicBezTo>
                    <a:cubicBezTo>
                      <a:pt x="95" y="353"/>
                      <a:pt x="108" y="404"/>
                      <a:pt x="136" y="442"/>
                    </a:cubicBezTo>
                    <a:cubicBezTo>
                      <a:pt x="164" y="480"/>
                      <a:pt x="202" y="498"/>
                      <a:pt x="251" y="498"/>
                    </a:cubicBezTo>
                    <a:cubicBezTo>
                      <a:pt x="299" y="498"/>
                      <a:pt x="337" y="480"/>
                      <a:pt x="365" y="442"/>
                    </a:cubicBezTo>
                    <a:cubicBezTo>
                      <a:pt x="393" y="404"/>
                      <a:pt x="407" y="353"/>
                      <a:pt x="407" y="287"/>
                    </a:cubicBezTo>
                    <a:cubicBezTo>
                      <a:pt x="407" y="223"/>
                      <a:pt x="393" y="171"/>
                      <a:pt x="365" y="133"/>
                    </a:cubicBezTo>
                    <a:cubicBezTo>
                      <a:pt x="337" y="95"/>
                      <a:pt x="299" y="76"/>
                      <a:pt x="251" y="76"/>
                    </a:cubicBezTo>
                    <a:close/>
                    <a:moveTo>
                      <a:pt x="251" y="0"/>
                    </a:moveTo>
                    <a:cubicBezTo>
                      <a:pt x="329" y="0"/>
                      <a:pt x="390" y="26"/>
                      <a:pt x="435" y="76"/>
                    </a:cubicBezTo>
                    <a:cubicBezTo>
                      <a:pt x="479" y="127"/>
                      <a:pt x="502" y="197"/>
                      <a:pt x="502" y="287"/>
                    </a:cubicBezTo>
                    <a:cubicBezTo>
                      <a:pt x="502" y="377"/>
                      <a:pt x="479" y="447"/>
                      <a:pt x="435" y="497"/>
                    </a:cubicBezTo>
                    <a:cubicBezTo>
                      <a:pt x="390" y="548"/>
                      <a:pt x="329" y="573"/>
                      <a:pt x="251" y="573"/>
                    </a:cubicBezTo>
                    <a:cubicBezTo>
                      <a:pt x="172" y="573"/>
                      <a:pt x="110" y="548"/>
                      <a:pt x="66" y="497"/>
                    </a:cubicBezTo>
                    <a:cubicBezTo>
                      <a:pt x="22" y="447"/>
                      <a:pt x="0" y="377"/>
                      <a:pt x="0" y="287"/>
                    </a:cubicBezTo>
                    <a:cubicBezTo>
                      <a:pt x="0" y="197"/>
                      <a:pt x="22" y="127"/>
                      <a:pt x="66" y="76"/>
                    </a:cubicBezTo>
                    <a:cubicBezTo>
                      <a:pt x="110" y="26"/>
                      <a:pt x="172" y="0"/>
                      <a:pt x="251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14" name="Rectangle 341">
                <a:extLst>
                  <a:ext uri="{FF2B5EF4-FFF2-40B4-BE49-F238E27FC236}">
                    <a16:creationId xmlns:a16="http://schemas.microsoft.com/office/drawing/2014/main" id="{E740C4EB-DCB3-B00A-4C1E-6C65F606BF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89513" y="5235575"/>
                <a:ext cx="15875" cy="1365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15" name="Freeform 342">
                <a:extLst>
                  <a:ext uri="{FF2B5EF4-FFF2-40B4-BE49-F238E27FC236}">
                    <a16:creationId xmlns:a16="http://schemas.microsoft.com/office/drawing/2014/main" id="{B831D77E-338E-8996-3126-7D6039EE152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032375" y="5235575"/>
                <a:ext cx="87313" cy="138113"/>
              </a:xfrm>
              <a:custGeom>
                <a:avLst/>
                <a:gdLst>
                  <a:gd name="T0" fmla="*/ 399 w 489"/>
                  <a:gd name="T1" fmla="*/ 296 h 773"/>
                  <a:gd name="T2" fmla="*/ 399 w 489"/>
                  <a:gd name="T3" fmla="*/ 0 h 773"/>
                  <a:gd name="T4" fmla="*/ 489 w 489"/>
                  <a:gd name="T5" fmla="*/ 0 h 773"/>
                  <a:gd name="T6" fmla="*/ 489 w 489"/>
                  <a:gd name="T7" fmla="*/ 760 h 773"/>
                  <a:gd name="T8" fmla="*/ 399 w 489"/>
                  <a:gd name="T9" fmla="*/ 760 h 773"/>
                  <a:gd name="T10" fmla="*/ 399 w 489"/>
                  <a:gd name="T11" fmla="*/ 678 h 773"/>
                  <a:gd name="T12" fmla="*/ 327 w 489"/>
                  <a:gd name="T13" fmla="*/ 750 h 773"/>
                  <a:gd name="T14" fmla="*/ 224 w 489"/>
                  <a:gd name="T15" fmla="*/ 773 h 773"/>
                  <a:gd name="T16" fmla="*/ 62 w 489"/>
                  <a:gd name="T17" fmla="*/ 695 h 773"/>
                  <a:gd name="T18" fmla="*/ 0 w 489"/>
                  <a:gd name="T19" fmla="*/ 487 h 773"/>
                  <a:gd name="T20" fmla="*/ 62 w 489"/>
                  <a:gd name="T21" fmla="*/ 279 h 773"/>
                  <a:gd name="T22" fmla="*/ 224 w 489"/>
                  <a:gd name="T23" fmla="*/ 200 h 773"/>
                  <a:gd name="T24" fmla="*/ 327 w 489"/>
                  <a:gd name="T25" fmla="*/ 224 h 773"/>
                  <a:gd name="T26" fmla="*/ 399 w 489"/>
                  <a:gd name="T27" fmla="*/ 296 h 773"/>
                  <a:gd name="T28" fmla="*/ 93 w 489"/>
                  <a:gd name="T29" fmla="*/ 487 h 773"/>
                  <a:gd name="T30" fmla="*/ 133 w 489"/>
                  <a:gd name="T31" fmla="*/ 643 h 773"/>
                  <a:gd name="T32" fmla="*/ 245 w 489"/>
                  <a:gd name="T33" fmla="*/ 699 h 773"/>
                  <a:gd name="T34" fmla="*/ 358 w 489"/>
                  <a:gd name="T35" fmla="*/ 643 h 773"/>
                  <a:gd name="T36" fmla="*/ 399 w 489"/>
                  <a:gd name="T37" fmla="*/ 487 h 773"/>
                  <a:gd name="T38" fmla="*/ 358 w 489"/>
                  <a:gd name="T39" fmla="*/ 332 h 773"/>
                  <a:gd name="T40" fmla="*/ 245 w 489"/>
                  <a:gd name="T41" fmla="*/ 275 h 773"/>
                  <a:gd name="T42" fmla="*/ 133 w 489"/>
                  <a:gd name="T43" fmla="*/ 332 h 773"/>
                  <a:gd name="T44" fmla="*/ 93 w 489"/>
                  <a:gd name="T45" fmla="*/ 487 h 7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89" h="773">
                    <a:moveTo>
                      <a:pt x="399" y="296"/>
                    </a:moveTo>
                    <a:lnTo>
                      <a:pt x="399" y="0"/>
                    </a:lnTo>
                    <a:lnTo>
                      <a:pt x="489" y="0"/>
                    </a:lnTo>
                    <a:lnTo>
                      <a:pt x="489" y="760"/>
                    </a:lnTo>
                    <a:lnTo>
                      <a:pt x="399" y="760"/>
                    </a:lnTo>
                    <a:lnTo>
                      <a:pt x="399" y="678"/>
                    </a:lnTo>
                    <a:cubicBezTo>
                      <a:pt x="380" y="711"/>
                      <a:pt x="356" y="735"/>
                      <a:pt x="327" y="750"/>
                    </a:cubicBezTo>
                    <a:cubicBezTo>
                      <a:pt x="298" y="765"/>
                      <a:pt x="264" y="773"/>
                      <a:pt x="224" y="773"/>
                    </a:cubicBezTo>
                    <a:cubicBezTo>
                      <a:pt x="158" y="773"/>
                      <a:pt x="104" y="747"/>
                      <a:pt x="62" y="695"/>
                    </a:cubicBezTo>
                    <a:cubicBezTo>
                      <a:pt x="20" y="643"/>
                      <a:pt x="0" y="573"/>
                      <a:pt x="0" y="487"/>
                    </a:cubicBezTo>
                    <a:cubicBezTo>
                      <a:pt x="0" y="401"/>
                      <a:pt x="20" y="332"/>
                      <a:pt x="62" y="279"/>
                    </a:cubicBezTo>
                    <a:cubicBezTo>
                      <a:pt x="104" y="227"/>
                      <a:pt x="158" y="200"/>
                      <a:pt x="224" y="200"/>
                    </a:cubicBezTo>
                    <a:cubicBezTo>
                      <a:pt x="264" y="200"/>
                      <a:pt x="298" y="208"/>
                      <a:pt x="327" y="224"/>
                    </a:cubicBezTo>
                    <a:cubicBezTo>
                      <a:pt x="356" y="240"/>
                      <a:pt x="380" y="264"/>
                      <a:pt x="399" y="296"/>
                    </a:cubicBezTo>
                    <a:close/>
                    <a:moveTo>
                      <a:pt x="93" y="487"/>
                    </a:moveTo>
                    <a:cubicBezTo>
                      <a:pt x="93" y="553"/>
                      <a:pt x="106" y="605"/>
                      <a:pt x="133" y="643"/>
                    </a:cubicBezTo>
                    <a:cubicBezTo>
                      <a:pt x="160" y="681"/>
                      <a:pt x="197" y="699"/>
                      <a:pt x="245" y="699"/>
                    </a:cubicBezTo>
                    <a:cubicBezTo>
                      <a:pt x="293" y="699"/>
                      <a:pt x="330" y="681"/>
                      <a:pt x="358" y="643"/>
                    </a:cubicBezTo>
                    <a:cubicBezTo>
                      <a:pt x="385" y="605"/>
                      <a:pt x="399" y="553"/>
                      <a:pt x="399" y="487"/>
                    </a:cubicBezTo>
                    <a:cubicBezTo>
                      <a:pt x="399" y="421"/>
                      <a:pt x="385" y="370"/>
                      <a:pt x="358" y="332"/>
                    </a:cubicBezTo>
                    <a:cubicBezTo>
                      <a:pt x="330" y="294"/>
                      <a:pt x="293" y="275"/>
                      <a:pt x="245" y="275"/>
                    </a:cubicBezTo>
                    <a:cubicBezTo>
                      <a:pt x="197" y="275"/>
                      <a:pt x="160" y="294"/>
                      <a:pt x="133" y="332"/>
                    </a:cubicBezTo>
                    <a:cubicBezTo>
                      <a:pt x="106" y="370"/>
                      <a:pt x="93" y="421"/>
                      <a:pt x="93" y="487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16" name="Freeform 343">
                <a:extLst>
                  <a:ext uri="{FF2B5EF4-FFF2-40B4-BE49-F238E27FC236}">
                    <a16:creationId xmlns:a16="http://schemas.microsoft.com/office/drawing/2014/main" id="{ABA4C41F-F5D7-298A-FDBB-FDE6A2F5C6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208588" y="5235575"/>
                <a:ext cx="41275" cy="160338"/>
              </a:xfrm>
              <a:custGeom>
                <a:avLst/>
                <a:gdLst>
                  <a:gd name="T0" fmla="*/ 224 w 224"/>
                  <a:gd name="T1" fmla="*/ 0 h 890"/>
                  <a:gd name="T2" fmla="*/ 127 w 224"/>
                  <a:gd name="T3" fmla="*/ 223 h 890"/>
                  <a:gd name="T4" fmla="*/ 95 w 224"/>
                  <a:gd name="T5" fmla="*/ 445 h 890"/>
                  <a:gd name="T6" fmla="*/ 127 w 224"/>
                  <a:gd name="T7" fmla="*/ 668 h 890"/>
                  <a:gd name="T8" fmla="*/ 224 w 224"/>
                  <a:gd name="T9" fmla="*/ 890 h 890"/>
                  <a:gd name="T10" fmla="*/ 146 w 224"/>
                  <a:gd name="T11" fmla="*/ 890 h 890"/>
                  <a:gd name="T12" fmla="*/ 36 w 224"/>
                  <a:gd name="T13" fmla="*/ 665 h 890"/>
                  <a:gd name="T14" fmla="*/ 0 w 224"/>
                  <a:gd name="T15" fmla="*/ 445 h 890"/>
                  <a:gd name="T16" fmla="*/ 36 w 224"/>
                  <a:gd name="T17" fmla="*/ 226 h 890"/>
                  <a:gd name="T18" fmla="*/ 146 w 224"/>
                  <a:gd name="T19" fmla="*/ 0 h 890"/>
                  <a:gd name="T20" fmla="*/ 224 w 224"/>
                  <a:gd name="T21" fmla="*/ 0 h 8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224" h="890">
                    <a:moveTo>
                      <a:pt x="224" y="0"/>
                    </a:moveTo>
                    <a:cubicBezTo>
                      <a:pt x="180" y="76"/>
                      <a:pt x="148" y="150"/>
                      <a:pt x="127" y="223"/>
                    </a:cubicBezTo>
                    <a:cubicBezTo>
                      <a:pt x="105" y="296"/>
                      <a:pt x="95" y="370"/>
                      <a:pt x="95" y="445"/>
                    </a:cubicBezTo>
                    <a:cubicBezTo>
                      <a:pt x="95" y="521"/>
                      <a:pt x="105" y="595"/>
                      <a:pt x="127" y="668"/>
                    </a:cubicBezTo>
                    <a:cubicBezTo>
                      <a:pt x="148" y="742"/>
                      <a:pt x="180" y="815"/>
                      <a:pt x="224" y="890"/>
                    </a:cubicBezTo>
                    <a:lnTo>
                      <a:pt x="146" y="890"/>
                    </a:lnTo>
                    <a:cubicBezTo>
                      <a:pt x="97" y="813"/>
                      <a:pt x="60" y="739"/>
                      <a:pt x="36" y="665"/>
                    </a:cubicBezTo>
                    <a:cubicBezTo>
                      <a:pt x="12" y="591"/>
                      <a:pt x="0" y="518"/>
                      <a:pt x="0" y="445"/>
                    </a:cubicBezTo>
                    <a:cubicBezTo>
                      <a:pt x="0" y="373"/>
                      <a:pt x="12" y="300"/>
                      <a:pt x="36" y="226"/>
                    </a:cubicBezTo>
                    <a:cubicBezTo>
                      <a:pt x="60" y="152"/>
                      <a:pt x="96" y="77"/>
                      <a:pt x="146" y="0"/>
                    </a:cubicBezTo>
                    <a:lnTo>
                      <a:pt x="224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17" name="Freeform 344">
                <a:extLst>
                  <a:ext uri="{FF2B5EF4-FFF2-40B4-BE49-F238E27FC236}">
                    <a16:creationId xmlns:a16="http://schemas.microsoft.com/office/drawing/2014/main" id="{77A01906-067A-C554-6975-2EED120DE53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275263" y="5270500"/>
                <a:ext cx="82550" cy="103188"/>
              </a:xfrm>
              <a:custGeom>
                <a:avLst/>
                <a:gdLst>
                  <a:gd name="T0" fmla="*/ 283 w 462"/>
                  <a:gd name="T1" fmla="*/ 285 h 573"/>
                  <a:gd name="T2" fmla="*/ 132 w 462"/>
                  <a:gd name="T3" fmla="*/ 310 h 573"/>
                  <a:gd name="T4" fmla="*/ 90 w 462"/>
                  <a:gd name="T5" fmla="*/ 395 h 573"/>
                  <a:gd name="T6" fmla="*/ 121 w 462"/>
                  <a:gd name="T7" fmla="*/ 471 h 573"/>
                  <a:gd name="T8" fmla="*/ 207 w 462"/>
                  <a:gd name="T9" fmla="*/ 499 h 573"/>
                  <a:gd name="T10" fmla="*/ 327 w 462"/>
                  <a:gd name="T11" fmla="*/ 446 h 573"/>
                  <a:gd name="T12" fmla="*/ 372 w 462"/>
                  <a:gd name="T13" fmla="*/ 305 h 573"/>
                  <a:gd name="T14" fmla="*/ 372 w 462"/>
                  <a:gd name="T15" fmla="*/ 285 h 573"/>
                  <a:gd name="T16" fmla="*/ 283 w 462"/>
                  <a:gd name="T17" fmla="*/ 285 h 573"/>
                  <a:gd name="T18" fmla="*/ 462 w 462"/>
                  <a:gd name="T19" fmla="*/ 248 h 573"/>
                  <a:gd name="T20" fmla="*/ 462 w 462"/>
                  <a:gd name="T21" fmla="*/ 560 h 573"/>
                  <a:gd name="T22" fmla="*/ 372 w 462"/>
                  <a:gd name="T23" fmla="*/ 560 h 573"/>
                  <a:gd name="T24" fmla="*/ 372 w 462"/>
                  <a:gd name="T25" fmla="*/ 477 h 573"/>
                  <a:gd name="T26" fmla="*/ 295 w 462"/>
                  <a:gd name="T27" fmla="*/ 550 h 573"/>
                  <a:gd name="T28" fmla="*/ 183 w 462"/>
                  <a:gd name="T29" fmla="*/ 573 h 573"/>
                  <a:gd name="T30" fmla="*/ 49 w 462"/>
                  <a:gd name="T31" fmla="*/ 527 h 573"/>
                  <a:gd name="T32" fmla="*/ 0 w 462"/>
                  <a:gd name="T33" fmla="*/ 401 h 573"/>
                  <a:gd name="T34" fmla="*/ 62 w 462"/>
                  <a:gd name="T35" fmla="*/ 262 h 573"/>
                  <a:gd name="T36" fmla="*/ 246 w 462"/>
                  <a:gd name="T37" fmla="*/ 215 h 573"/>
                  <a:gd name="T38" fmla="*/ 372 w 462"/>
                  <a:gd name="T39" fmla="*/ 215 h 573"/>
                  <a:gd name="T40" fmla="*/ 372 w 462"/>
                  <a:gd name="T41" fmla="*/ 206 h 573"/>
                  <a:gd name="T42" fmla="*/ 331 w 462"/>
                  <a:gd name="T43" fmla="*/ 110 h 573"/>
                  <a:gd name="T44" fmla="*/ 217 w 462"/>
                  <a:gd name="T45" fmla="*/ 76 h 573"/>
                  <a:gd name="T46" fmla="*/ 125 w 462"/>
                  <a:gd name="T47" fmla="*/ 88 h 573"/>
                  <a:gd name="T48" fmla="*/ 40 w 462"/>
                  <a:gd name="T49" fmla="*/ 121 h 573"/>
                  <a:gd name="T50" fmla="*/ 40 w 462"/>
                  <a:gd name="T51" fmla="*/ 38 h 573"/>
                  <a:gd name="T52" fmla="*/ 135 w 462"/>
                  <a:gd name="T53" fmla="*/ 10 h 573"/>
                  <a:gd name="T54" fmla="*/ 226 w 462"/>
                  <a:gd name="T55" fmla="*/ 0 h 573"/>
                  <a:gd name="T56" fmla="*/ 403 w 462"/>
                  <a:gd name="T57" fmla="*/ 62 h 573"/>
                  <a:gd name="T58" fmla="*/ 462 w 462"/>
                  <a:gd name="T59" fmla="*/ 24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462" h="573">
                    <a:moveTo>
                      <a:pt x="283" y="285"/>
                    </a:moveTo>
                    <a:cubicBezTo>
                      <a:pt x="210" y="285"/>
                      <a:pt x="160" y="294"/>
                      <a:pt x="132" y="310"/>
                    </a:cubicBezTo>
                    <a:cubicBezTo>
                      <a:pt x="104" y="327"/>
                      <a:pt x="90" y="355"/>
                      <a:pt x="90" y="395"/>
                    </a:cubicBezTo>
                    <a:cubicBezTo>
                      <a:pt x="90" y="427"/>
                      <a:pt x="100" y="453"/>
                      <a:pt x="121" y="471"/>
                    </a:cubicBezTo>
                    <a:cubicBezTo>
                      <a:pt x="142" y="490"/>
                      <a:pt x="171" y="499"/>
                      <a:pt x="207" y="499"/>
                    </a:cubicBezTo>
                    <a:cubicBezTo>
                      <a:pt x="257" y="499"/>
                      <a:pt x="297" y="482"/>
                      <a:pt x="327" y="446"/>
                    </a:cubicBezTo>
                    <a:cubicBezTo>
                      <a:pt x="357" y="411"/>
                      <a:pt x="372" y="364"/>
                      <a:pt x="372" y="305"/>
                    </a:cubicBezTo>
                    <a:lnTo>
                      <a:pt x="372" y="285"/>
                    </a:lnTo>
                    <a:lnTo>
                      <a:pt x="283" y="285"/>
                    </a:lnTo>
                    <a:close/>
                    <a:moveTo>
                      <a:pt x="462" y="248"/>
                    </a:moveTo>
                    <a:lnTo>
                      <a:pt x="462" y="560"/>
                    </a:lnTo>
                    <a:lnTo>
                      <a:pt x="372" y="560"/>
                    </a:lnTo>
                    <a:lnTo>
                      <a:pt x="372" y="477"/>
                    </a:lnTo>
                    <a:cubicBezTo>
                      <a:pt x="351" y="511"/>
                      <a:pt x="325" y="535"/>
                      <a:pt x="295" y="550"/>
                    </a:cubicBezTo>
                    <a:cubicBezTo>
                      <a:pt x="265" y="565"/>
                      <a:pt x="227" y="573"/>
                      <a:pt x="183" y="573"/>
                    </a:cubicBezTo>
                    <a:cubicBezTo>
                      <a:pt x="127" y="573"/>
                      <a:pt x="82" y="558"/>
                      <a:pt x="49" y="527"/>
                    </a:cubicBezTo>
                    <a:cubicBezTo>
                      <a:pt x="16" y="496"/>
                      <a:pt x="0" y="454"/>
                      <a:pt x="0" y="401"/>
                    </a:cubicBezTo>
                    <a:cubicBezTo>
                      <a:pt x="0" y="340"/>
                      <a:pt x="20" y="294"/>
                      <a:pt x="62" y="262"/>
                    </a:cubicBezTo>
                    <a:cubicBezTo>
                      <a:pt x="103" y="231"/>
                      <a:pt x="164" y="215"/>
                      <a:pt x="246" y="215"/>
                    </a:cubicBezTo>
                    <a:lnTo>
                      <a:pt x="372" y="215"/>
                    </a:lnTo>
                    <a:lnTo>
                      <a:pt x="372" y="206"/>
                    </a:lnTo>
                    <a:cubicBezTo>
                      <a:pt x="372" y="165"/>
                      <a:pt x="358" y="133"/>
                      <a:pt x="331" y="110"/>
                    </a:cubicBezTo>
                    <a:cubicBezTo>
                      <a:pt x="304" y="88"/>
                      <a:pt x="266" y="76"/>
                      <a:pt x="217" y="76"/>
                    </a:cubicBezTo>
                    <a:cubicBezTo>
                      <a:pt x="185" y="76"/>
                      <a:pt x="155" y="80"/>
                      <a:pt x="125" y="88"/>
                    </a:cubicBezTo>
                    <a:cubicBezTo>
                      <a:pt x="95" y="96"/>
                      <a:pt x="67" y="107"/>
                      <a:pt x="40" y="121"/>
                    </a:cubicBezTo>
                    <a:lnTo>
                      <a:pt x="40" y="38"/>
                    </a:lnTo>
                    <a:cubicBezTo>
                      <a:pt x="72" y="26"/>
                      <a:pt x="104" y="16"/>
                      <a:pt x="135" y="10"/>
                    </a:cubicBezTo>
                    <a:cubicBezTo>
                      <a:pt x="166" y="4"/>
                      <a:pt x="196" y="0"/>
                      <a:pt x="226" y="0"/>
                    </a:cubicBezTo>
                    <a:cubicBezTo>
                      <a:pt x="305" y="0"/>
                      <a:pt x="364" y="21"/>
                      <a:pt x="403" y="62"/>
                    </a:cubicBezTo>
                    <a:cubicBezTo>
                      <a:pt x="442" y="103"/>
                      <a:pt x="462" y="165"/>
                      <a:pt x="462" y="24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18" name="Rectangle 345">
                <a:extLst>
                  <a:ext uri="{FF2B5EF4-FFF2-40B4-BE49-F238E27FC236}">
                    <a16:creationId xmlns:a16="http://schemas.microsoft.com/office/drawing/2014/main" id="{D59C857E-424D-C6C9-F318-779384CA0A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94325" y="5349875"/>
                <a:ext cx="17463" cy="222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19" name="Freeform 346">
                <a:extLst>
                  <a:ext uri="{FF2B5EF4-FFF2-40B4-BE49-F238E27FC236}">
                    <a16:creationId xmlns:a16="http://schemas.microsoft.com/office/drawing/2014/main" id="{8871B8CF-10B6-61B9-7A5D-F46928995B8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446713" y="5270500"/>
                <a:ext cx="82550" cy="103188"/>
              </a:xfrm>
              <a:custGeom>
                <a:avLst/>
                <a:gdLst>
                  <a:gd name="T0" fmla="*/ 0 w 458"/>
                  <a:gd name="T1" fmla="*/ 344 h 573"/>
                  <a:gd name="T2" fmla="*/ 0 w 458"/>
                  <a:gd name="T3" fmla="*/ 13 h 573"/>
                  <a:gd name="T4" fmla="*/ 90 w 458"/>
                  <a:gd name="T5" fmla="*/ 13 h 573"/>
                  <a:gd name="T6" fmla="*/ 90 w 458"/>
                  <a:gd name="T7" fmla="*/ 341 h 573"/>
                  <a:gd name="T8" fmla="*/ 120 w 458"/>
                  <a:gd name="T9" fmla="*/ 457 h 573"/>
                  <a:gd name="T10" fmla="*/ 211 w 458"/>
                  <a:gd name="T11" fmla="*/ 496 h 573"/>
                  <a:gd name="T12" fmla="*/ 326 w 458"/>
                  <a:gd name="T13" fmla="*/ 450 h 573"/>
                  <a:gd name="T14" fmla="*/ 368 w 458"/>
                  <a:gd name="T15" fmla="*/ 323 h 573"/>
                  <a:gd name="T16" fmla="*/ 368 w 458"/>
                  <a:gd name="T17" fmla="*/ 13 h 573"/>
                  <a:gd name="T18" fmla="*/ 458 w 458"/>
                  <a:gd name="T19" fmla="*/ 13 h 573"/>
                  <a:gd name="T20" fmla="*/ 458 w 458"/>
                  <a:gd name="T21" fmla="*/ 560 h 573"/>
                  <a:gd name="T22" fmla="*/ 368 w 458"/>
                  <a:gd name="T23" fmla="*/ 560 h 573"/>
                  <a:gd name="T24" fmla="*/ 368 w 458"/>
                  <a:gd name="T25" fmla="*/ 476 h 573"/>
                  <a:gd name="T26" fmla="*/ 292 w 458"/>
                  <a:gd name="T27" fmla="*/ 550 h 573"/>
                  <a:gd name="T28" fmla="*/ 192 w 458"/>
                  <a:gd name="T29" fmla="*/ 573 h 573"/>
                  <a:gd name="T30" fmla="*/ 49 w 458"/>
                  <a:gd name="T31" fmla="*/ 515 h 573"/>
                  <a:gd name="T32" fmla="*/ 0 w 458"/>
                  <a:gd name="T33" fmla="*/ 344 h 573"/>
                  <a:gd name="T34" fmla="*/ 226 w 458"/>
                  <a:gd name="T35" fmla="*/ 0 h 573"/>
                  <a:gd name="T36" fmla="*/ 227 w 458"/>
                  <a:gd name="T37" fmla="*/ 0 h 573"/>
                  <a:gd name="T38" fmla="*/ 226 w 458"/>
                  <a:gd name="T39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458" h="573">
                    <a:moveTo>
                      <a:pt x="0" y="344"/>
                    </a:moveTo>
                    <a:lnTo>
                      <a:pt x="0" y="13"/>
                    </a:lnTo>
                    <a:lnTo>
                      <a:pt x="90" y="13"/>
                    </a:lnTo>
                    <a:lnTo>
                      <a:pt x="90" y="341"/>
                    </a:lnTo>
                    <a:cubicBezTo>
                      <a:pt x="90" y="393"/>
                      <a:pt x="100" y="431"/>
                      <a:pt x="120" y="457"/>
                    </a:cubicBezTo>
                    <a:cubicBezTo>
                      <a:pt x="140" y="483"/>
                      <a:pt x="170" y="496"/>
                      <a:pt x="211" y="496"/>
                    </a:cubicBezTo>
                    <a:cubicBezTo>
                      <a:pt x="259" y="496"/>
                      <a:pt x="298" y="481"/>
                      <a:pt x="326" y="450"/>
                    </a:cubicBezTo>
                    <a:cubicBezTo>
                      <a:pt x="354" y="419"/>
                      <a:pt x="368" y="377"/>
                      <a:pt x="368" y="323"/>
                    </a:cubicBezTo>
                    <a:lnTo>
                      <a:pt x="368" y="13"/>
                    </a:lnTo>
                    <a:lnTo>
                      <a:pt x="458" y="13"/>
                    </a:lnTo>
                    <a:lnTo>
                      <a:pt x="458" y="560"/>
                    </a:lnTo>
                    <a:lnTo>
                      <a:pt x="368" y="560"/>
                    </a:lnTo>
                    <a:lnTo>
                      <a:pt x="368" y="476"/>
                    </a:lnTo>
                    <a:cubicBezTo>
                      <a:pt x="346" y="510"/>
                      <a:pt x="320" y="534"/>
                      <a:pt x="292" y="550"/>
                    </a:cubicBezTo>
                    <a:cubicBezTo>
                      <a:pt x="263" y="565"/>
                      <a:pt x="230" y="573"/>
                      <a:pt x="192" y="573"/>
                    </a:cubicBezTo>
                    <a:cubicBezTo>
                      <a:pt x="129" y="573"/>
                      <a:pt x="81" y="554"/>
                      <a:pt x="49" y="515"/>
                    </a:cubicBezTo>
                    <a:cubicBezTo>
                      <a:pt x="16" y="477"/>
                      <a:pt x="0" y="420"/>
                      <a:pt x="0" y="344"/>
                    </a:cubicBezTo>
                    <a:close/>
                    <a:moveTo>
                      <a:pt x="226" y="0"/>
                    </a:moveTo>
                    <a:lnTo>
                      <a:pt x="227" y="0"/>
                    </a:lnTo>
                    <a:lnTo>
                      <a:pt x="226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20" name="Rectangle 347">
                <a:extLst>
                  <a:ext uri="{FF2B5EF4-FFF2-40B4-BE49-F238E27FC236}">
                    <a16:creationId xmlns:a16="http://schemas.microsoft.com/office/drawing/2014/main" id="{6CE9B3C9-6A93-0995-545F-8E7EB66477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65775" y="5349875"/>
                <a:ext cx="17463" cy="222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21" name="Freeform 348">
                <a:extLst>
                  <a:ext uri="{FF2B5EF4-FFF2-40B4-BE49-F238E27FC236}">
                    <a16:creationId xmlns:a16="http://schemas.microsoft.com/office/drawing/2014/main" id="{4FC8BCCA-C4FE-6FDE-B0B2-2E588D3C954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618163" y="5235575"/>
                <a:ext cx="39688" cy="160338"/>
              </a:xfrm>
              <a:custGeom>
                <a:avLst/>
                <a:gdLst>
                  <a:gd name="T0" fmla="*/ 0 w 224"/>
                  <a:gd name="T1" fmla="*/ 0 h 890"/>
                  <a:gd name="T2" fmla="*/ 78 w 224"/>
                  <a:gd name="T3" fmla="*/ 0 h 890"/>
                  <a:gd name="T4" fmla="*/ 187 w 224"/>
                  <a:gd name="T5" fmla="*/ 226 h 890"/>
                  <a:gd name="T6" fmla="*/ 224 w 224"/>
                  <a:gd name="T7" fmla="*/ 445 h 890"/>
                  <a:gd name="T8" fmla="*/ 187 w 224"/>
                  <a:gd name="T9" fmla="*/ 665 h 890"/>
                  <a:gd name="T10" fmla="*/ 78 w 224"/>
                  <a:gd name="T11" fmla="*/ 890 h 890"/>
                  <a:gd name="T12" fmla="*/ 0 w 224"/>
                  <a:gd name="T13" fmla="*/ 890 h 890"/>
                  <a:gd name="T14" fmla="*/ 97 w 224"/>
                  <a:gd name="T15" fmla="*/ 668 h 890"/>
                  <a:gd name="T16" fmla="*/ 129 w 224"/>
                  <a:gd name="T17" fmla="*/ 445 h 890"/>
                  <a:gd name="T18" fmla="*/ 97 w 224"/>
                  <a:gd name="T19" fmla="*/ 223 h 890"/>
                  <a:gd name="T20" fmla="*/ 0 w 224"/>
                  <a:gd name="T21" fmla="*/ 0 h 8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224" h="890">
                    <a:moveTo>
                      <a:pt x="0" y="0"/>
                    </a:moveTo>
                    <a:lnTo>
                      <a:pt x="78" y="0"/>
                    </a:lnTo>
                    <a:cubicBezTo>
                      <a:pt x="126" y="77"/>
                      <a:pt x="163" y="152"/>
                      <a:pt x="187" y="226"/>
                    </a:cubicBezTo>
                    <a:cubicBezTo>
                      <a:pt x="211" y="300"/>
                      <a:pt x="224" y="373"/>
                      <a:pt x="224" y="445"/>
                    </a:cubicBezTo>
                    <a:cubicBezTo>
                      <a:pt x="224" y="518"/>
                      <a:pt x="211" y="591"/>
                      <a:pt x="187" y="665"/>
                    </a:cubicBezTo>
                    <a:cubicBezTo>
                      <a:pt x="163" y="739"/>
                      <a:pt x="126" y="813"/>
                      <a:pt x="78" y="890"/>
                    </a:cubicBezTo>
                    <a:lnTo>
                      <a:pt x="0" y="890"/>
                    </a:lnTo>
                    <a:cubicBezTo>
                      <a:pt x="43" y="815"/>
                      <a:pt x="75" y="742"/>
                      <a:pt x="97" y="668"/>
                    </a:cubicBezTo>
                    <a:cubicBezTo>
                      <a:pt x="118" y="595"/>
                      <a:pt x="129" y="521"/>
                      <a:pt x="129" y="445"/>
                    </a:cubicBezTo>
                    <a:cubicBezTo>
                      <a:pt x="129" y="370"/>
                      <a:pt x="118" y="296"/>
                      <a:pt x="97" y="223"/>
                    </a:cubicBezTo>
                    <a:cubicBezTo>
                      <a:pt x="75" y="150"/>
                      <a:pt x="43" y="76"/>
                      <a:pt x="0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22" name="Line 349">
                <a:extLst>
                  <a:ext uri="{FF2B5EF4-FFF2-40B4-BE49-F238E27FC236}">
                    <a16:creationId xmlns:a16="http://schemas.microsoft.com/office/drawing/2014/main" id="{2DFD7D42-CA32-FC40-B89E-7F480C227B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2613" y="4829175"/>
                <a:ext cx="3324225" cy="0"/>
              </a:xfrm>
              <a:prstGeom prst="line">
                <a:avLst/>
              </a:prstGeom>
              <a:noFill/>
              <a:ln w="6350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23" name="Freeform 350">
                <a:extLst>
                  <a:ext uri="{FF2B5EF4-FFF2-40B4-BE49-F238E27FC236}">
                    <a16:creationId xmlns:a16="http://schemas.microsoft.com/office/drawing/2014/main" id="{B8E080EA-178C-3BF8-C3D7-6BEEFA19452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762250" y="4764088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24" name="Rectangle 351">
                <a:extLst>
                  <a:ext uri="{FF2B5EF4-FFF2-40B4-BE49-F238E27FC236}">
                    <a16:creationId xmlns:a16="http://schemas.microsoft.com/office/drawing/2014/main" id="{778DFF10-0B62-8A13-26E3-1BF884C861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4488" y="4875213"/>
                <a:ext cx="17463" cy="222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25" name="Freeform 352">
                <a:extLst>
                  <a:ext uri="{FF2B5EF4-FFF2-40B4-BE49-F238E27FC236}">
                    <a16:creationId xmlns:a16="http://schemas.microsoft.com/office/drawing/2014/main" id="{0B691059-46E9-5A48-E413-787093FE5B9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933700" y="4764088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26" name="Line 353">
                <a:extLst>
                  <a:ext uri="{FF2B5EF4-FFF2-40B4-BE49-F238E27FC236}">
                    <a16:creationId xmlns:a16="http://schemas.microsoft.com/office/drawing/2014/main" id="{834AD314-6F7B-D771-070C-EC83946F3A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2613" y="4060825"/>
                <a:ext cx="3324225" cy="0"/>
              </a:xfrm>
              <a:prstGeom prst="line">
                <a:avLst/>
              </a:prstGeom>
              <a:noFill/>
              <a:ln w="6350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27" name="Freeform 354">
                <a:extLst>
                  <a:ext uri="{FF2B5EF4-FFF2-40B4-BE49-F238E27FC236}">
                    <a16:creationId xmlns:a16="http://schemas.microsoft.com/office/drawing/2014/main" id="{947EC8DD-42BA-BDBC-3CA4-64D6994C2DD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762250" y="3995738"/>
                <a:ext cx="90488" cy="134938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28" name="Rectangle 355">
                <a:extLst>
                  <a:ext uri="{FF2B5EF4-FFF2-40B4-BE49-F238E27FC236}">
                    <a16:creationId xmlns:a16="http://schemas.microsoft.com/office/drawing/2014/main" id="{7B06E9EC-18D6-750C-B0D1-1B29660ACA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4488" y="4106863"/>
                <a:ext cx="17463" cy="22225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29" name="Freeform 356">
                <a:extLst>
                  <a:ext uri="{FF2B5EF4-FFF2-40B4-BE49-F238E27FC236}">
                    <a16:creationId xmlns:a16="http://schemas.microsoft.com/office/drawing/2014/main" id="{8E20B82F-1F6C-A781-5E9F-F7B48609761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35288" y="3995738"/>
                <a:ext cx="82550" cy="133350"/>
              </a:xfrm>
              <a:custGeom>
                <a:avLst/>
                <a:gdLst>
                  <a:gd name="T0" fmla="*/ 119 w 463"/>
                  <a:gd name="T1" fmla="*/ 659 h 742"/>
                  <a:gd name="T2" fmla="*/ 463 w 463"/>
                  <a:gd name="T3" fmla="*/ 659 h 742"/>
                  <a:gd name="T4" fmla="*/ 463 w 463"/>
                  <a:gd name="T5" fmla="*/ 742 h 742"/>
                  <a:gd name="T6" fmla="*/ 0 w 463"/>
                  <a:gd name="T7" fmla="*/ 742 h 742"/>
                  <a:gd name="T8" fmla="*/ 0 w 463"/>
                  <a:gd name="T9" fmla="*/ 659 h 742"/>
                  <a:gd name="T10" fmla="*/ 153 w 463"/>
                  <a:gd name="T11" fmla="*/ 503 h 742"/>
                  <a:gd name="T12" fmla="*/ 275 w 463"/>
                  <a:gd name="T13" fmla="*/ 377 h 742"/>
                  <a:gd name="T14" fmla="*/ 341 w 463"/>
                  <a:gd name="T15" fmla="*/ 287 h 742"/>
                  <a:gd name="T16" fmla="*/ 360 w 463"/>
                  <a:gd name="T17" fmla="*/ 214 h 742"/>
                  <a:gd name="T18" fmla="*/ 319 w 463"/>
                  <a:gd name="T19" fmla="*/ 120 h 742"/>
                  <a:gd name="T20" fmla="*/ 213 w 463"/>
                  <a:gd name="T21" fmla="*/ 83 h 742"/>
                  <a:gd name="T22" fmla="*/ 115 w 463"/>
                  <a:gd name="T23" fmla="*/ 99 h 742"/>
                  <a:gd name="T24" fmla="*/ 5 w 463"/>
                  <a:gd name="T25" fmla="*/ 148 h 742"/>
                  <a:gd name="T26" fmla="*/ 5 w 463"/>
                  <a:gd name="T27" fmla="*/ 48 h 742"/>
                  <a:gd name="T28" fmla="*/ 116 w 463"/>
                  <a:gd name="T29" fmla="*/ 12 h 742"/>
                  <a:gd name="T30" fmla="*/ 211 w 463"/>
                  <a:gd name="T31" fmla="*/ 0 h 742"/>
                  <a:gd name="T32" fmla="*/ 391 w 463"/>
                  <a:gd name="T33" fmla="*/ 57 h 742"/>
                  <a:gd name="T34" fmla="*/ 459 w 463"/>
                  <a:gd name="T35" fmla="*/ 208 h 742"/>
                  <a:gd name="T36" fmla="*/ 442 w 463"/>
                  <a:gd name="T37" fmla="*/ 293 h 742"/>
                  <a:gd name="T38" fmla="*/ 381 w 463"/>
                  <a:gd name="T39" fmla="*/ 388 h 742"/>
                  <a:gd name="T40" fmla="*/ 303 w 463"/>
                  <a:gd name="T41" fmla="*/ 470 h 742"/>
                  <a:gd name="T42" fmla="*/ 119 w 463"/>
                  <a:gd name="T43" fmla="*/ 659 h 7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463" h="742">
                    <a:moveTo>
                      <a:pt x="119" y="659"/>
                    </a:moveTo>
                    <a:lnTo>
                      <a:pt x="463" y="659"/>
                    </a:lnTo>
                    <a:lnTo>
                      <a:pt x="463" y="742"/>
                    </a:lnTo>
                    <a:lnTo>
                      <a:pt x="0" y="742"/>
                    </a:lnTo>
                    <a:lnTo>
                      <a:pt x="0" y="659"/>
                    </a:lnTo>
                    <a:cubicBezTo>
                      <a:pt x="37" y="621"/>
                      <a:pt x="88" y="569"/>
                      <a:pt x="153" y="503"/>
                    </a:cubicBezTo>
                    <a:cubicBezTo>
                      <a:pt x="217" y="438"/>
                      <a:pt x="258" y="396"/>
                      <a:pt x="275" y="377"/>
                    </a:cubicBezTo>
                    <a:cubicBezTo>
                      <a:pt x="307" y="342"/>
                      <a:pt x="329" y="312"/>
                      <a:pt x="341" y="287"/>
                    </a:cubicBezTo>
                    <a:cubicBezTo>
                      <a:pt x="353" y="263"/>
                      <a:pt x="360" y="238"/>
                      <a:pt x="360" y="214"/>
                    </a:cubicBezTo>
                    <a:cubicBezTo>
                      <a:pt x="360" y="176"/>
                      <a:pt x="346" y="144"/>
                      <a:pt x="319" y="120"/>
                    </a:cubicBezTo>
                    <a:cubicBezTo>
                      <a:pt x="292" y="96"/>
                      <a:pt x="257" y="83"/>
                      <a:pt x="213" y="83"/>
                    </a:cubicBezTo>
                    <a:cubicBezTo>
                      <a:pt x="182" y="83"/>
                      <a:pt x="149" y="89"/>
                      <a:pt x="115" y="99"/>
                    </a:cubicBezTo>
                    <a:cubicBezTo>
                      <a:pt x="81" y="110"/>
                      <a:pt x="44" y="126"/>
                      <a:pt x="5" y="148"/>
                    </a:cubicBezTo>
                    <a:lnTo>
                      <a:pt x="5" y="48"/>
                    </a:lnTo>
                    <a:cubicBezTo>
                      <a:pt x="45" y="32"/>
                      <a:pt x="82" y="20"/>
                      <a:pt x="116" y="12"/>
                    </a:cubicBezTo>
                    <a:cubicBezTo>
                      <a:pt x="150" y="4"/>
                      <a:pt x="182" y="0"/>
                      <a:pt x="211" y="0"/>
                    </a:cubicBezTo>
                    <a:cubicBezTo>
                      <a:pt x="286" y="0"/>
                      <a:pt x="346" y="19"/>
                      <a:pt x="391" y="57"/>
                    </a:cubicBezTo>
                    <a:cubicBezTo>
                      <a:pt x="436" y="95"/>
                      <a:pt x="459" y="145"/>
                      <a:pt x="459" y="208"/>
                    </a:cubicBezTo>
                    <a:cubicBezTo>
                      <a:pt x="459" y="238"/>
                      <a:pt x="453" y="267"/>
                      <a:pt x="442" y="293"/>
                    </a:cubicBezTo>
                    <a:cubicBezTo>
                      <a:pt x="431" y="320"/>
                      <a:pt x="411" y="352"/>
                      <a:pt x="381" y="388"/>
                    </a:cubicBezTo>
                    <a:cubicBezTo>
                      <a:pt x="373" y="398"/>
                      <a:pt x="347" y="425"/>
                      <a:pt x="303" y="470"/>
                    </a:cubicBezTo>
                    <a:cubicBezTo>
                      <a:pt x="259" y="515"/>
                      <a:pt x="198" y="578"/>
                      <a:pt x="119" y="65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30" name="Line 357">
                <a:extLst>
                  <a:ext uri="{FF2B5EF4-FFF2-40B4-BE49-F238E27FC236}">
                    <a16:creationId xmlns:a16="http://schemas.microsoft.com/office/drawing/2014/main" id="{FFE0C97C-FE63-E80E-80AA-D837AC1BF1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2613" y="3290887"/>
                <a:ext cx="3324225" cy="0"/>
              </a:xfrm>
              <a:prstGeom prst="line">
                <a:avLst/>
              </a:prstGeom>
              <a:noFill/>
              <a:ln w="6350" cap="rnd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31" name="Freeform 358">
                <a:extLst>
                  <a:ext uri="{FF2B5EF4-FFF2-40B4-BE49-F238E27FC236}">
                    <a16:creationId xmlns:a16="http://schemas.microsoft.com/office/drawing/2014/main" id="{B0186C9F-50F8-0108-0CF8-6E487F568D2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762250" y="3225800"/>
                <a:ext cx="90488" cy="136525"/>
              </a:xfrm>
              <a:custGeom>
                <a:avLst/>
                <a:gdLst>
                  <a:gd name="T0" fmla="*/ 252 w 504"/>
                  <a:gd name="T1" fmla="*/ 78 h 755"/>
                  <a:gd name="T2" fmla="*/ 137 w 504"/>
                  <a:gd name="T3" fmla="*/ 153 h 755"/>
                  <a:gd name="T4" fmla="*/ 99 w 504"/>
                  <a:gd name="T5" fmla="*/ 378 h 755"/>
                  <a:gd name="T6" fmla="*/ 137 w 504"/>
                  <a:gd name="T7" fmla="*/ 603 h 755"/>
                  <a:gd name="T8" fmla="*/ 252 w 504"/>
                  <a:gd name="T9" fmla="*/ 678 h 755"/>
                  <a:gd name="T10" fmla="*/ 367 w 504"/>
                  <a:gd name="T11" fmla="*/ 603 h 755"/>
                  <a:gd name="T12" fmla="*/ 405 w 504"/>
                  <a:gd name="T13" fmla="*/ 378 h 755"/>
                  <a:gd name="T14" fmla="*/ 367 w 504"/>
                  <a:gd name="T15" fmla="*/ 153 h 755"/>
                  <a:gd name="T16" fmla="*/ 252 w 504"/>
                  <a:gd name="T17" fmla="*/ 78 h 755"/>
                  <a:gd name="T18" fmla="*/ 252 w 504"/>
                  <a:gd name="T19" fmla="*/ 0 h 755"/>
                  <a:gd name="T20" fmla="*/ 439 w 504"/>
                  <a:gd name="T21" fmla="*/ 97 h 755"/>
                  <a:gd name="T22" fmla="*/ 504 w 504"/>
                  <a:gd name="T23" fmla="*/ 378 h 755"/>
                  <a:gd name="T24" fmla="*/ 439 w 504"/>
                  <a:gd name="T25" fmla="*/ 659 h 755"/>
                  <a:gd name="T26" fmla="*/ 251 w 504"/>
                  <a:gd name="T27" fmla="*/ 755 h 755"/>
                  <a:gd name="T28" fmla="*/ 64 w 504"/>
                  <a:gd name="T29" fmla="*/ 659 h 755"/>
                  <a:gd name="T30" fmla="*/ 0 w 504"/>
                  <a:gd name="T31" fmla="*/ 378 h 755"/>
                  <a:gd name="T32" fmla="*/ 64 w 504"/>
                  <a:gd name="T33" fmla="*/ 97 h 755"/>
                  <a:gd name="T34" fmla="*/ 252 w 504"/>
                  <a:gd name="T35" fmla="*/ 0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55">
                    <a:moveTo>
                      <a:pt x="252" y="78"/>
                    </a:moveTo>
                    <a:cubicBezTo>
                      <a:pt x="201" y="78"/>
                      <a:pt x="163" y="103"/>
                      <a:pt x="137" y="153"/>
                    </a:cubicBezTo>
                    <a:cubicBezTo>
                      <a:pt x="111" y="203"/>
                      <a:pt x="99" y="278"/>
                      <a:pt x="99" y="378"/>
                    </a:cubicBezTo>
                    <a:cubicBezTo>
                      <a:pt x="99" y="478"/>
                      <a:pt x="111" y="553"/>
                      <a:pt x="137" y="603"/>
                    </a:cubicBezTo>
                    <a:cubicBezTo>
                      <a:pt x="163" y="653"/>
                      <a:pt x="201" y="678"/>
                      <a:pt x="252" y="678"/>
                    </a:cubicBezTo>
                    <a:cubicBezTo>
                      <a:pt x="303" y="678"/>
                      <a:pt x="341" y="653"/>
                      <a:pt x="367" y="603"/>
                    </a:cubicBezTo>
                    <a:cubicBezTo>
                      <a:pt x="392" y="553"/>
                      <a:pt x="405" y="478"/>
                      <a:pt x="405" y="378"/>
                    </a:cubicBezTo>
                    <a:cubicBezTo>
                      <a:pt x="405" y="278"/>
                      <a:pt x="392" y="203"/>
                      <a:pt x="367" y="153"/>
                    </a:cubicBezTo>
                    <a:cubicBezTo>
                      <a:pt x="341" y="103"/>
                      <a:pt x="303" y="78"/>
                      <a:pt x="252" y="78"/>
                    </a:cubicBezTo>
                    <a:close/>
                    <a:moveTo>
                      <a:pt x="252" y="0"/>
                    </a:moveTo>
                    <a:cubicBezTo>
                      <a:pt x="333" y="0"/>
                      <a:pt x="395" y="33"/>
                      <a:pt x="439" y="97"/>
                    </a:cubicBezTo>
                    <a:cubicBezTo>
                      <a:pt x="482" y="162"/>
                      <a:pt x="504" y="256"/>
                      <a:pt x="504" y="378"/>
                    </a:cubicBezTo>
                    <a:cubicBezTo>
                      <a:pt x="504" y="501"/>
                      <a:pt x="482" y="595"/>
                      <a:pt x="439" y="659"/>
                    </a:cubicBezTo>
                    <a:cubicBezTo>
                      <a:pt x="395" y="723"/>
                      <a:pt x="333" y="755"/>
                      <a:pt x="251" y="755"/>
                    </a:cubicBezTo>
                    <a:cubicBezTo>
                      <a:pt x="169" y="755"/>
                      <a:pt x="107" y="723"/>
                      <a:pt x="64" y="659"/>
                    </a:cubicBezTo>
                    <a:cubicBezTo>
                      <a:pt x="21" y="595"/>
                      <a:pt x="0" y="501"/>
                      <a:pt x="0" y="378"/>
                    </a:cubicBezTo>
                    <a:cubicBezTo>
                      <a:pt x="0" y="256"/>
                      <a:pt x="21" y="162"/>
                      <a:pt x="64" y="97"/>
                    </a:cubicBezTo>
                    <a:cubicBezTo>
                      <a:pt x="107" y="33"/>
                      <a:pt x="170" y="0"/>
                      <a:pt x="252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32" name="Rectangle 359">
                <a:extLst>
                  <a:ext uri="{FF2B5EF4-FFF2-40B4-BE49-F238E27FC236}">
                    <a16:creationId xmlns:a16="http://schemas.microsoft.com/office/drawing/2014/main" id="{7FA0C5D8-90A1-B8CE-EC5A-02FBFC669F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4488" y="3336925"/>
                <a:ext cx="17463" cy="23813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33" name="Freeform 360">
                <a:extLst>
                  <a:ext uri="{FF2B5EF4-FFF2-40B4-BE49-F238E27FC236}">
                    <a16:creationId xmlns:a16="http://schemas.microsoft.com/office/drawing/2014/main" id="{F87DCF85-F816-6C33-6FDB-E72B4E70369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930525" y="3228975"/>
                <a:ext cx="95250" cy="131763"/>
              </a:xfrm>
              <a:custGeom>
                <a:avLst/>
                <a:gdLst>
                  <a:gd name="T0" fmla="*/ 329 w 531"/>
                  <a:gd name="T1" fmla="*/ 86 h 729"/>
                  <a:gd name="T2" fmla="*/ 80 w 531"/>
                  <a:gd name="T3" fmla="*/ 475 h 729"/>
                  <a:gd name="T4" fmla="*/ 329 w 531"/>
                  <a:gd name="T5" fmla="*/ 475 h 729"/>
                  <a:gd name="T6" fmla="*/ 329 w 531"/>
                  <a:gd name="T7" fmla="*/ 86 h 729"/>
                  <a:gd name="T8" fmla="*/ 303 w 531"/>
                  <a:gd name="T9" fmla="*/ 0 h 729"/>
                  <a:gd name="T10" fmla="*/ 427 w 531"/>
                  <a:gd name="T11" fmla="*/ 0 h 729"/>
                  <a:gd name="T12" fmla="*/ 427 w 531"/>
                  <a:gd name="T13" fmla="*/ 475 h 729"/>
                  <a:gd name="T14" fmla="*/ 531 w 531"/>
                  <a:gd name="T15" fmla="*/ 475 h 729"/>
                  <a:gd name="T16" fmla="*/ 531 w 531"/>
                  <a:gd name="T17" fmla="*/ 557 h 729"/>
                  <a:gd name="T18" fmla="*/ 427 w 531"/>
                  <a:gd name="T19" fmla="*/ 557 h 729"/>
                  <a:gd name="T20" fmla="*/ 427 w 531"/>
                  <a:gd name="T21" fmla="*/ 729 h 729"/>
                  <a:gd name="T22" fmla="*/ 329 w 531"/>
                  <a:gd name="T23" fmla="*/ 729 h 729"/>
                  <a:gd name="T24" fmla="*/ 329 w 531"/>
                  <a:gd name="T25" fmla="*/ 557 h 729"/>
                  <a:gd name="T26" fmla="*/ 0 w 531"/>
                  <a:gd name="T27" fmla="*/ 557 h 729"/>
                  <a:gd name="T28" fmla="*/ 0 w 531"/>
                  <a:gd name="T29" fmla="*/ 462 h 729"/>
                  <a:gd name="T30" fmla="*/ 303 w 531"/>
                  <a:gd name="T31" fmla="*/ 0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531" h="729">
                    <a:moveTo>
                      <a:pt x="329" y="86"/>
                    </a:moveTo>
                    <a:lnTo>
                      <a:pt x="80" y="475"/>
                    </a:lnTo>
                    <a:lnTo>
                      <a:pt x="329" y="475"/>
                    </a:lnTo>
                    <a:lnTo>
                      <a:pt x="329" y="86"/>
                    </a:lnTo>
                    <a:close/>
                    <a:moveTo>
                      <a:pt x="303" y="0"/>
                    </a:moveTo>
                    <a:lnTo>
                      <a:pt x="427" y="0"/>
                    </a:lnTo>
                    <a:lnTo>
                      <a:pt x="427" y="475"/>
                    </a:lnTo>
                    <a:lnTo>
                      <a:pt x="531" y="475"/>
                    </a:lnTo>
                    <a:lnTo>
                      <a:pt x="531" y="557"/>
                    </a:lnTo>
                    <a:lnTo>
                      <a:pt x="427" y="557"/>
                    </a:lnTo>
                    <a:lnTo>
                      <a:pt x="427" y="729"/>
                    </a:lnTo>
                    <a:lnTo>
                      <a:pt x="329" y="729"/>
                    </a:lnTo>
                    <a:lnTo>
                      <a:pt x="329" y="557"/>
                    </a:lnTo>
                    <a:lnTo>
                      <a:pt x="0" y="557"/>
                    </a:lnTo>
                    <a:lnTo>
                      <a:pt x="0" y="462"/>
                    </a:lnTo>
                    <a:lnTo>
                      <a:pt x="303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34" name="Freeform 361">
                <a:extLst>
                  <a:ext uri="{FF2B5EF4-FFF2-40B4-BE49-F238E27FC236}">
                    <a16:creationId xmlns:a16="http://schemas.microsoft.com/office/drawing/2014/main" id="{1F388591-DBFE-FA77-56C0-63A663F437B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46350" y="4687888"/>
                <a:ext cx="130175" cy="120650"/>
              </a:xfrm>
              <a:custGeom>
                <a:avLst/>
                <a:gdLst>
                  <a:gd name="T0" fmla="*/ 97 w 729"/>
                  <a:gd name="T1" fmla="*/ 334 h 668"/>
                  <a:gd name="T2" fmla="*/ 460 w 729"/>
                  <a:gd name="T3" fmla="*/ 468 h 668"/>
                  <a:gd name="T4" fmla="*/ 460 w 729"/>
                  <a:gd name="T5" fmla="*/ 200 h 668"/>
                  <a:gd name="T6" fmla="*/ 97 w 729"/>
                  <a:gd name="T7" fmla="*/ 334 h 668"/>
                  <a:gd name="T8" fmla="*/ 0 w 729"/>
                  <a:gd name="T9" fmla="*/ 390 h 668"/>
                  <a:gd name="T10" fmla="*/ 0 w 729"/>
                  <a:gd name="T11" fmla="*/ 278 h 668"/>
                  <a:gd name="T12" fmla="*/ 729 w 729"/>
                  <a:gd name="T13" fmla="*/ 0 h 668"/>
                  <a:gd name="T14" fmla="*/ 729 w 729"/>
                  <a:gd name="T15" fmla="*/ 103 h 668"/>
                  <a:gd name="T16" fmla="*/ 542 w 729"/>
                  <a:gd name="T17" fmla="*/ 169 h 668"/>
                  <a:gd name="T18" fmla="*/ 542 w 729"/>
                  <a:gd name="T19" fmla="*/ 498 h 668"/>
                  <a:gd name="T20" fmla="*/ 729 w 729"/>
                  <a:gd name="T21" fmla="*/ 564 h 668"/>
                  <a:gd name="T22" fmla="*/ 729 w 729"/>
                  <a:gd name="T23" fmla="*/ 668 h 668"/>
                  <a:gd name="T24" fmla="*/ 0 w 729"/>
                  <a:gd name="T25" fmla="*/ 390 h 6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</a:cxnLst>
                <a:rect l="0" t="0" r="r" b="b"/>
                <a:pathLst>
                  <a:path w="729" h="668">
                    <a:moveTo>
                      <a:pt x="97" y="334"/>
                    </a:moveTo>
                    <a:lnTo>
                      <a:pt x="460" y="468"/>
                    </a:lnTo>
                    <a:lnTo>
                      <a:pt x="460" y="200"/>
                    </a:lnTo>
                    <a:lnTo>
                      <a:pt x="97" y="334"/>
                    </a:lnTo>
                    <a:close/>
                    <a:moveTo>
                      <a:pt x="0" y="390"/>
                    </a:moveTo>
                    <a:lnTo>
                      <a:pt x="0" y="278"/>
                    </a:lnTo>
                    <a:lnTo>
                      <a:pt x="729" y="0"/>
                    </a:lnTo>
                    <a:lnTo>
                      <a:pt x="729" y="103"/>
                    </a:lnTo>
                    <a:lnTo>
                      <a:pt x="542" y="169"/>
                    </a:lnTo>
                    <a:lnTo>
                      <a:pt x="542" y="498"/>
                    </a:lnTo>
                    <a:lnTo>
                      <a:pt x="729" y="564"/>
                    </a:lnTo>
                    <a:lnTo>
                      <a:pt x="729" y="668"/>
                    </a:lnTo>
                    <a:lnTo>
                      <a:pt x="0" y="3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35" name="Freeform 362">
                <a:extLst>
                  <a:ext uri="{FF2B5EF4-FFF2-40B4-BE49-F238E27FC236}">
                    <a16:creationId xmlns:a16="http://schemas.microsoft.com/office/drawing/2014/main" id="{1DBCEFAC-AC35-47D4-A6C4-4942E560533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8100" y="4595813"/>
                <a:ext cx="98425" cy="95250"/>
              </a:xfrm>
              <a:custGeom>
                <a:avLst/>
                <a:gdLst>
                  <a:gd name="T0" fmla="*/ 0 w 547"/>
                  <a:gd name="T1" fmla="*/ 532 h 532"/>
                  <a:gd name="T2" fmla="*/ 0 w 547"/>
                  <a:gd name="T3" fmla="*/ 437 h 532"/>
                  <a:gd name="T4" fmla="*/ 459 w 547"/>
                  <a:gd name="T5" fmla="*/ 266 h 532"/>
                  <a:gd name="T6" fmla="*/ 0 w 547"/>
                  <a:gd name="T7" fmla="*/ 95 h 532"/>
                  <a:gd name="T8" fmla="*/ 0 w 547"/>
                  <a:gd name="T9" fmla="*/ 0 h 532"/>
                  <a:gd name="T10" fmla="*/ 547 w 547"/>
                  <a:gd name="T11" fmla="*/ 205 h 532"/>
                  <a:gd name="T12" fmla="*/ 547 w 547"/>
                  <a:gd name="T13" fmla="*/ 327 h 532"/>
                  <a:gd name="T14" fmla="*/ 0 w 547"/>
                  <a:gd name="T15" fmla="*/ 532 h 5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547" h="532">
                    <a:moveTo>
                      <a:pt x="0" y="532"/>
                    </a:moveTo>
                    <a:lnTo>
                      <a:pt x="0" y="437"/>
                    </a:lnTo>
                    <a:lnTo>
                      <a:pt x="459" y="266"/>
                    </a:lnTo>
                    <a:lnTo>
                      <a:pt x="0" y="95"/>
                    </a:lnTo>
                    <a:lnTo>
                      <a:pt x="0" y="0"/>
                    </a:lnTo>
                    <a:lnTo>
                      <a:pt x="547" y="205"/>
                    </a:lnTo>
                    <a:lnTo>
                      <a:pt x="547" y="327"/>
                    </a:lnTo>
                    <a:lnTo>
                      <a:pt x="0" y="532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36" name="Freeform 363">
                <a:extLst>
                  <a:ext uri="{FF2B5EF4-FFF2-40B4-BE49-F238E27FC236}">
                    <a16:creationId xmlns:a16="http://schemas.microsoft.com/office/drawing/2014/main" id="{A43E9315-040B-3E3D-EFDB-BFBD5F5704A1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4487863"/>
                <a:ext cx="103188" cy="92075"/>
              </a:xfrm>
              <a:custGeom>
                <a:avLst/>
                <a:gdLst>
                  <a:gd name="T0" fmla="*/ 264 w 573"/>
                  <a:gd name="T1" fmla="*/ 0 h 507"/>
                  <a:gd name="T2" fmla="*/ 308 w 573"/>
                  <a:gd name="T3" fmla="*/ 0 h 507"/>
                  <a:gd name="T4" fmla="*/ 308 w 573"/>
                  <a:gd name="T5" fmla="*/ 413 h 507"/>
                  <a:gd name="T6" fmla="*/ 450 w 573"/>
                  <a:gd name="T7" fmla="*/ 357 h 507"/>
                  <a:gd name="T8" fmla="*/ 498 w 573"/>
                  <a:gd name="T9" fmla="*/ 218 h 507"/>
                  <a:gd name="T10" fmla="*/ 486 w 573"/>
                  <a:gd name="T11" fmla="*/ 118 h 507"/>
                  <a:gd name="T12" fmla="*/ 447 w 573"/>
                  <a:gd name="T13" fmla="*/ 21 h 507"/>
                  <a:gd name="T14" fmla="*/ 532 w 573"/>
                  <a:gd name="T15" fmla="*/ 21 h 507"/>
                  <a:gd name="T16" fmla="*/ 563 w 573"/>
                  <a:gd name="T17" fmla="*/ 120 h 507"/>
                  <a:gd name="T18" fmla="*/ 573 w 573"/>
                  <a:gd name="T19" fmla="*/ 223 h 507"/>
                  <a:gd name="T20" fmla="*/ 498 w 573"/>
                  <a:gd name="T21" fmla="*/ 431 h 507"/>
                  <a:gd name="T22" fmla="*/ 292 w 573"/>
                  <a:gd name="T23" fmla="*/ 507 h 507"/>
                  <a:gd name="T24" fmla="*/ 79 w 573"/>
                  <a:gd name="T25" fmla="*/ 435 h 507"/>
                  <a:gd name="T26" fmla="*/ 0 w 573"/>
                  <a:gd name="T27" fmla="*/ 239 h 507"/>
                  <a:gd name="T28" fmla="*/ 71 w 573"/>
                  <a:gd name="T29" fmla="*/ 64 h 507"/>
                  <a:gd name="T30" fmla="*/ 264 w 573"/>
                  <a:gd name="T31" fmla="*/ 0 h 507"/>
                  <a:gd name="T32" fmla="*/ 238 w 573"/>
                  <a:gd name="T33" fmla="*/ 90 h 507"/>
                  <a:gd name="T34" fmla="*/ 120 w 573"/>
                  <a:gd name="T35" fmla="*/ 131 h 507"/>
                  <a:gd name="T36" fmla="*/ 76 w 573"/>
                  <a:gd name="T37" fmla="*/ 238 h 507"/>
                  <a:gd name="T38" fmla="*/ 119 w 573"/>
                  <a:gd name="T39" fmla="*/ 358 h 507"/>
                  <a:gd name="T40" fmla="*/ 238 w 573"/>
                  <a:gd name="T41" fmla="*/ 410 h 507"/>
                  <a:gd name="T42" fmla="*/ 238 w 573"/>
                  <a:gd name="T43" fmla="*/ 90 h 5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73" h="507">
                    <a:moveTo>
                      <a:pt x="264" y="0"/>
                    </a:moveTo>
                    <a:lnTo>
                      <a:pt x="308" y="0"/>
                    </a:lnTo>
                    <a:lnTo>
                      <a:pt x="308" y="413"/>
                    </a:lnTo>
                    <a:cubicBezTo>
                      <a:pt x="370" y="409"/>
                      <a:pt x="418" y="391"/>
                      <a:pt x="450" y="357"/>
                    </a:cubicBezTo>
                    <a:cubicBezTo>
                      <a:pt x="482" y="324"/>
                      <a:pt x="498" y="278"/>
                      <a:pt x="498" y="218"/>
                    </a:cubicBezTo>
                    <a:cubicBezTo>
                      <a:pt x="498" y="184"/>
                      <a:pt x="494" y="150"/>
                      <a:pt x="486" y="118"/>
                    </a:cubicBezTo>
                    <a:cubicBezTo>
                      <a:pt x="478" y="86"/>
                      <a:pt x="465" y="53"/>
                      <a:pt x="447" y="21"/>
                    </a:cubicBezTo>
                    <a:lnTo>
                      <a:pt x="532" y="21"/>
                    </a:lnTo>
                    <a:cubicBezTo>
                      <a:pt x="546" y="53"/>
                      <a:pt x="557" y="86"/>
                      <a:pt x="563" y="120"/>
                    </a:cubicBezTo>
                    <a:cubicBezTo>
                      <a:pt x="569" y="154"/>
                      <a:pt x="573" y="189"/>
                      <a:pt x="573" y="223"/>
                    </a:cubicBezTo>
                    <a:cubicBezTo>
                      <a:pt x="573" y="311"/>
                      <a:pt x="548" y="380"/>
                      <a:pt x="498" y="431"/>
                    </a:cubicBezTo>
                    <a:cubicBezTo>
                      <a:pt x="448" y="482"/>
                      <a:pt x="379" y="507"/>
                      <a:pt x="292" y="507"/>
                    </a:cubicBezTo>
                    <a:cubicBezTo>
                      <a:pt x="203" y="507"/>
                      <a:pt x="132" y="483"/>
                      <a:pt x="79" y="435"/>
                    </a:cubicBezTo>
                    <a:cubicBezTo>
                      <a:pt x="27" y="387"/>
                      <a:pt x="0" y="321"/>
                      <a:pt x="0" y="239"/>
                    </a:cubicBezTo>
                    <a:cubicBezTo>
                      <a:pt x="0" y="165"/>
                      <a:pt x="24" y="107"/>
                      <a:pt x="71" y="64"/>
                    </a:cubicBezTo>
                    <a:cubicBezTo>
                      <a:pt x="119" y="22"/>
                      <a:pt x="183" y="0"/>
                      <a:pt x="264" y="0"/>
                    </a:cubicBezTo>
                    <a:close/>
                    <a:moveTo>
                      <a:pt x="238" y="90"/>
                    </a:moveTo>
                    <a:cubicBezTo>
                      <a:pt x="189" y="91"/>
                      <a:pt x="150" y="105"/>
                      <a:pt x="120" y="131"/>
                    </a:cubicBezTo>
                    <a:cubicBezTo>
                      <a:pt x="91" y="158"/>
                      <a:pt x="76" y="194"/>
                      <a:pt x="76" y="238"/>
                    </a:cubicBezTo>
                    <a:cubicBezTo>
                      <a:pt x="76" y="288"/>
                      <a:pt x="91" y="328"/>
                      <a:pt x="119" y="358"/>
                    </a:cubicBezTo>
                    <a:cubicBezTo>
                      <a:pt x="147" y="388"/>
                      <a:pt x="187" y="406"/>
                      <a:pt x="238" y="410"/>
                    </a:cubicBezTo>
                    <a:lnTo>
                      <a:pt x="238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37" name="Freeform 364">
                <a:extLst>
                  <a:ext uri="{FF2B5EF4-FFF2-40B4-BE49-F238E27FC236}">
                    <a16:creationId xmlns:a16="http://schemas.microsoft.com/office/drawing/2014/main" id="{4FD9FD57-A411-916B-5118-2B5587FB00D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6513" y="4405313"/>
                <a:ext cx="100013" cy="57150"/>
              </a:xfrm>
              <a:custGeom>
                <a:avLst/>
                <a:gdLst>
                  <a:gd name="T0" fmla="*/ 97 w 560"/>
                  <a:gd name="T1" fmla="*/ 0 h 320"/>
                  <a:gd name="T2" fmla="*/ 84 w 560"/>
                  <a:gd name="T3" fmla="*/ 33 h 320"/>
                  <a:gd name="T4" fmla="*/ 80 w 560"/>
                  <a:gd name="T5" fmla="*/ 72 h 320"/>
                  <a:gd name="T6" fmla="*/ 130 w 560"/>
                  <a:gd name="T7" fmla="*/ 189 h 320"/>
                  <a:gd name="T8" fmla="*/ 272 w 560"/>
                  <a:gd name="T9" fmla="*/ 230 h 320"/>
                  <a:gd name="T10" fmla="*/ 560 w 560"/>
                  <a:gd name="T11" fmla="*/ 230 h 320"/>
                  <a:gd name="T12" fmla="*/ 560 w 560"/>
                  <a:gd name="T13" fmla="*/ 320 h 320"/>
                  <a:gd name="T14" fmla="*/ 13 w 560"/>
                  <a:gd name="T15" fmla="*/ 320 h 320"/>
                  <a:gd name="T16" fmla="*/ 13 w 560"/>
                  <a:gd name="T17" fmla="*/ 230 h 320"/>
                  <a:gd name="T18" fmla="*/ 98 w 560"/>
                  <a:gd name="T19" fmla="*/ 230 h 320"/>
                  <a:gd name="T20" fmla="*/ 24 w 560"/>
                  <a:gd name="T21" fmla="*/ 157 h 320"/>
                  <a:gd name="T22" fmla="*/ 0 w 560"/>
                  <a:gd name="T23" fmla="*/ 46 h 320"/>
                  <a:gd name="T24" fmla="*/ 1 w 560"/>
                  <a:gd name="T25" fmla="*/ 25 h 320"/>
                  <a:gd name="T26" fmla="*/ 5 w 560"/>
                  <a:gd name="T27" fmla="*/ 0 h 320"/>
                  <a:gd name="T28" fmla="*/ 97 w 560"/>
                  <a:gd name="T29" fmla="*/ 0 h 3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560" h="320">
                    <a:moveTo>
                      <a:pt x="97" y="0"/>
                    </a:moveTo>
                    <a:cubicBezTo>
                      <a:pt x="91" y="10"/>
                      <a:pt x="87" y="21"/>
                      <a:pt x="84" y="33"/>
                    </a:cubicBezTo>
                    <a:cubicBezTo>
                      <a:pt x="82" y="45"/>
                      <a:pt x="80" y="58"/>
                      <a:pt x="80" y="72"/>
                    </a:cubicBezTo>
                    <a:cubicBezTo>
                      <a:pt x="80" y="123"/>
                      <a:pt x="97" y="162"/>
                      <a:pt x="130" y="189"/>
                    </a:cubicBezTo>
                    <a:cubicBezTo>
                      <a:pt x="163" y="217"/>
                      <a:pt x="210" y="230"/>
                      <a:pt x="272" y="230"/>
                    </a:cubicBezTo>
                    <a:lnTo>
                      <a:pt x="560" y="230"/>
                    </a:lnTo>
                    <a:lnTo>
                      <a:pt x="560" y="320"/>
                    </a:lnTo>
                    <a:lnTo>
                      <a:pt x="13" y="320"/>
                    </a:lnTo>
                    <a:lnTo>
                      <a:pt x="13" y="230"/>
                    </a:lnTo>
                    <a:lnTo>
                      <a:pt x="98" y="230"/>
                    </a:lnTo>
                    <a:cubicBezTo>
                      <a:pt x="65" y="212"/>
                      <a:pt x="40" y="187"/>
                      <a:pt x="24" y="157"/>
                    </a:cubicBezTo>
                    <a:cubicBezTo>
                      <a:pt x="8" y="127"/>
                      <a:pt x="0" y="90"/>
                      <a:pt x="0" y="46"/>
                    </a:cubicBezTo>
                    <a:cubicBezTo>
                      <a:pt x="0" y="40"/>
                      <a:pt x="1" y="33"/>
                      <a:pt x="1" y="25"/>
                    </a:cubicBezTo>
                    <a:cubicBezTo>
                      <a:pt x="2" y="18"/>
                      <a:pt x="3" y="10"/>
                      <a:pt x="5" y="0"/>
                    </a:cubicBezTo>
                    <a:lnTo>
                      <a:pt x="97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38" name="Freeform 365">
                <a:extLst>
                  <a:ext uri="{FF2B5EF4-FFF2-40B4-BE49-F238E27FC236}">
                    <a16:creationId xmlns:a16="http://schemas.microsoft.com/office/drawing/2014/main" id="{BDEEA732-6D01-FA08-4EB9-8429EE07AB7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4310063"/>
                <a:ext cx="103188" cy="84138"/>
              </a:xfrm>
              <a:custGeom>
                <a:avLst/>
                <a:gdLst>
                  <a:gd name="T0" fmla="*/ 285 w 573"/>
                  <a:gd name="T1" fmla="*/ 179 h 462"/>
                  <a:gd name="T2" fmla="*/ 310 w 573"/>
                  <a:gd name="T3" fmla="*/ 330 h 462"/>
                  <a:gd name="T4" fmla="*/ 395 w 573"/>
                  <a:gd name="T5" fmla="*/ 372 h 462"/>
                  <a:gd name="T6" fmla="*/ 471 w 573"/>
                  <a:gd name="T7" fmla="*/ 341 h 462"/>
                  <a:gd name="T8" fmla="*/ 499 w 573"/>
                  <a:gd name="T9" fmla="*/ 255 h 462"/>
                  <a:gd name="T10" fmla="*/ 446 w 573"/>
                  <a:gd name="T11" fmla="*/ 135 h 462"/>
                  <a:gd name="T12" fmla="*/ 305 w 573"/>
                  <a:gd name="T13" fmla="*/ 90 h 462"/>
                  <a:gd name="T14" fmla="*/ 285 w 573"/>
                  <a:gd name="T15" fmla="*/ 90 h 462"/>
                  <a:gd name="T16" fmla="*/ 285 w 573"/>
                  <a:gd name="T17" fmla="*/ 179 h 462"/>
                  <a:gd name="T18" fmla="*/ 248 w 573"/>
                  <a:gd name="T19" fmla="*/ 0 h 462"/>
                  <a:gd name="T20" fmla="*/ 560 w 573"/>
                  <a:gd name="T21" fmla="*/ 0 h 462"/>
                  <a:gd name="T22" fmla="*/ 560 w 573"/>
                  <a:gd name="T23" fmla="*/ 90 h 462"/>
                  <a:gd name="T24" fmla="*/ 477 w 573"/>
                  <a:gd name="T25" fmla="*/ 90 h 462"/>
                  <a:gd name="T26" fmla="*/ 550 w 573"/>
                  <a:gd name="T27" fmla="*/ 167 h 462"/>
                  <a:gd name="T28" fmla="*/ 573 w 573"/>
                  <a:gd name="T29" fmla="*/ 279 h 462"/>
                  <a:gd name="T30" fmla="*/ 527 w 573"/>
                  <a:gd name="T31" fmla="*/ 413 h 462"/>
                  <a:gd name="T32" fmla="*/ 401 w 573"/>
                  <a:gd name="T33" fmla="*/ 462 h 462"/>
                  <a:gd name="T34" fmla="*/ 262 w 573"/>
                  <a:gd name="T35" fmla="*/ 400 h 462"/>
                  <a:gd name="T36" fmla="*/ 215 w 573"/>
                  <a:gd name="T37" fmla="*/ 216 h 462"/>
                  <a:gd name="T38" fmla="*/ 215 w 573"/>
                  <a:gd name="T39" fmla="*/ 90 h 462"/>
                  <a:gd name="T40" fmla="*/ 206 w 573"/>
                  <a:gd name="T41" fmla="*/ 90 h 462"/>
                  <a:gd name="T42" fmla="*/ 110 w 573"/>
                  <a:gd name="T43" fmla="*/ 131 h 462"/>
                  <a:gd name="T44" fmla="*/ 76 w 573"/>
                  <a:gd name="T45" fmla="*/ 245 h 462"/>
                  <a:gd name="T46" fmla="*/ 88 w 573"/>
                  <a:gd name="T47" fmla="*/ 337 h 462"/>
                  <a:gd name="T48" fmla="*/ 121 w 573"/>
                  <a:gd name="T49" fmla="*/ 422 h 462"/>
                  <a:gd name="T50" fmla="*/ 38 w 573"/>
                  <a:gd name="T51" fmla="*/ 422 h 462"/>
                  <a:gd name="T52" fmla="*/ 10 w 573"/>
                  <a:gd name="T53" fmla="*/ 327 h 462"/>
                  <a:gd name="T54" fmla="*/ 0 w 573"/>
                  <a:gd name="T55" fmla="*/ 236 h 462"/>
                  <a:gd name="T56" fmla="*/ 62 w 573"/>
                  <a:gd name="T57" fmla="*/ 59 h 462"/>
                  <a:gd name="T58" fmla="*/ 248 w 573"/>
                  <a:gd name="T59" fmla="*/ 0 h 4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573" h="462">
                    <a:moveTo>
                      <a:pt x="285" y="179"/>
                    </a:moveTo>
                    <a:cubicBezTo>
                      <a:pt x="285" y="252"/>
                      <a:pt x="294" y="302"/>
                      <a:pt x="310" y="330"/>
                    </a:cubicBezTo>
                    <a:cubicBezTo>
                      <a:pt x="327" y="358"/>
                      <a:pt x="355" y="372"/>
                      <a:pt x="395" y="372"/>
                    </a:cubicBezTo>
                    <a:cubicBezTo>
                      <a:pt x="427" y="372"/>
                      <a:pt x="453" y="362"/>
                      <a:pt x="471" y="341"/>
                    </a:cubicBezTo>
                    <a:cubicBezTo>
                      <a:pt x="490" y="320"/>
                      <a:pt x="499" y="291"/>
                      <a:pt x="499" y="255"/>
                    </a:cubicBezTo>
                    <a:cubicBezTo>
                      <a:pt x="499" y="205"/>
                      <a:pt x="482" y="165"/>
                      <a:pt x="446" y="135"/>
                    </a:cubicBezTo>
                    <a:cubicBezTo>
                      <a:pt x="411" y="105"/>
                      <a:pt x="364" y="90"/>
                      <a:pt x="305" y="90"/>
                    </a:cubicBezTo>
                    <a:lnTo>
                      <a:pt x="285" y="90"/>
                    </a:lnTo>
                    <a:lnTo>
                      <a:pt x="285" y="179"/>
                    </a:lnTo>
                    <a:close/>
                    <a:moveTo>
                      <a:pt x="248" y="0"/>
                    </a:moveTo>
                    <a:lnTo>
                      <a:pt x="560" y="0"/>
                    </a:lnTo>
                    <a:lnTo>
                      <a:pt x="560" y="90"/>
                    </a:lnTo>
                    <a:lnTo>
                      <a:pt x="477" y="90"/>
                    </a:lnTo>
                    <a:cubicBezTo>
                      <a:pt x="511" y="111"/>
                      <a:pt x="535" y="137"/>
                      <a:pt x="550" y="167"/>
                    </a:cubicBezTo>
                    <a:cubicBezTo>
                      <a:pt x="565" y="197"/>
                      <a:pt x="573" y="235"/>
                      <a:pt x="573" y="279"/>
                    </a:cubicBezTo>
                    <a:cubicBezTo>
                      <a:pt x="573" y="335"/>
                      <a:pt x="558" y="380"/>
                      <a:pt x="527" y="413"/>
                    </a:cubicBezTo>
                    <a:cubicBezTo>
                      <a:pt x="496" y="446"/>
                      <a:pt x="454" y="462"/>
                      <a:pt x="401" y="462"/>
                    </a:cubicBezTo>
                    <a:cubicBezTo>
                      <a:pt x="340" y="462"/>
                      <a:pt x="294" y="442"/>
                      <a:pt x="262" y="400"/>
                    </a:cubicBezTo>
                    <a:cubicBezTo>
                      <a:pt x="231" y="359"/>
                      <a:pt x="215" y="298"/>
                      <a:pt x="215" y="216"/>
                    </a:cubicBezTo>
                    <a:lnTo>
                      <a:pt x="215" y="90"/>
                    </a:lnTo>
                    <a:lnTo>
                      <a:pt x="206" y="90"/>
                    </a:lnTo>
                    <a:cubicBezTo>
                      <a:pt x="165" y="90"/>
                      <a:pt x="133" y="104"/>
                      <a:pt x="110" y="131"/>
                    </a:cubicBezTo>
                    <a:cubicBezTo>
                      <a:pt x="88" y="158"/>
                      <a:pt x="76" y="196"/>
                      <a:pt x="76" y="245"/>
                    </a:cubicBezTo>
                    <a:cubicBezTo>
                      <a:pt x="76" y="277"/>
                      <a:pt x="80" y="307"/>
                      <a:pt x="88" y="337"/>
                    </a:cubicBezTo>
                    <a:cubicBezTo>
                      <a:pt x="96" y="367"/>
                      <a:pt x="107" y="395"/>
                      <a:pt x="121" y="422"/>
                    </a:cubicBezTo>
                    <a:lnTo>
                      <a:pt x="38" y="422"/>
                    </a:lnTo>
                    <a:cubicBezTo>
                      <a:pt x="26" y="390"/>
                      <a:pt x="16" y="358"/>
                      <a:pt x="10" y="327"/>
                    </a:cubicBezTo>
                    <a:cubicBezTo>
                      <a:pt x="4" y="296"/>
                      <a:pt x="0" y="266"/>
                      <a:pt x="0" y="236"/>
                    </a:cubicBezTo>
                    <a:cubicBezTo>
                      <a:pt x="0" y="157"/>
                      <a:pt x="21" y="98"/>
                      <a:pt x="62" y="59"/>
                    </a:cubicBezTo>
                    <a:cubicBezTo>
                      <a:pt x="103" y="20"/>
                      <a:pt x="165" y="0"/>
                      <a:pt x="248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39" name="Freeform 366">
                <a:extLst>
                  <a:ext uri="{FF2B5EF4-FFF2-40B4-BE49-F238E27FC236}">
                    <a16:creationId xmlns:a16="http://schemas.microsoft.com/office/drawing/2014/main" id="{3DDF6F27-F459-E465-BE73-9C41C22345D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4195763"/>
                <a:ext cx="138113" cy="88900"/>
              </a:xfrm>
              <a:custGeom>
                <a:avLst/>
                <a:gdLst>
                  <a:gd name="T0" fmla="*/ 280 w 767"/>
                  <a:gd name="T1" fmla="*/ 90 h 489"/>
                  <a:gd name="T2" fmla="*/ 129 w 767"/>
                  <a:gd name="T3" fmla="*/ 130 h 489"/>
                  <a:gd name="T4" fmla="*/ 75 w 767"/>
                  <a:gd name="T5" fmla="*/ 243 h 489"/>
                  <a:gd name="T6" fmla="*/ 129 w 767"/>
                  <a:gd name="T7" fmla="*/ 356 h 489"/>
                  <a:gd name="T8" fmla="*/ 280 w 767"/>
                  <a:gd name="T9" fmla="*/ 396 h 489"/>
                  <a:gd name="T10" fmla="*/ 431 w 767"/>
                  <a:gd name="T11" fmla="*/ 356 h 489"/>
                  <a:gd name="T12" fmla="*/ 485 w 767"/>
                  <a:gd name="T13" fmla="*/ 243 h 489"/>
                  <a:gd name="T14" fmla="*/ 431 w 767"/>
                  <a:gd name="T15" fmla="*/ 130 h 489"/>
                  <a:gd name="T16" fmla="*/ 280 w 767"/>
                  <a:gd name="T17" fmla="*/ 90 h 489"/>
                  <a:gd name="T18" fmla="*/ 492 w 767"/>
                  <a:gd name="T19" fmla="*/ 0 h 489"/>
                  <a:gd name="T20" fmla="*/ 699 w 767"/>
                  <a:gd name="T21" fmla="*/ 62 h 489"/>
                  <a:gd name="T22" fmla="*/ 767 w 767"/>
                  <a:gd name="T23" fmla="*/ 252 h 489"/>
                  <a:gd name="T24" fmla="*/ 760 w 767"/>
                  <a:gd name="T25" fmla="*/ 341 h 489"/>
                  <a:gd name="T26" fmla="*/ 738 w 767"/>
                  <a:gd name="T27" fmla="*/ 423 h 489"/>
                  <a:gd name="T28" fmla="*/ 651 w 767"/>
                  <a:gd name="T29" fmla="*/ 423 h 489"/>
                  <a:gd name="T30" fmla="*/ 682 w 767"/>
                  <a:gd name="T31" fmla="*/ 345 h 489"/>
                  <a:gd name="T32" fmla="*/ 693 w 767"/>
                  <a:gd name="T33" fmla="*/ 266 h 489"/>
                  <a:gd name="T34" fmla="*/ 647 w 767"/>
                  <a:gd name="T35" fmla="*/ 134 h 489"/>
                  <a:gd name="T36" fmla="*/ 508 w 767"/>
                  <a:gd name="T37" fmla="*/ 90 h 489"/>
                  <a:gd name="T38" fmla="*/ 464 w 767"/>
                  <a:gd name="T39" fmla="*/ 90 h 489"/>
                  <a:gd name="T40" fmla="*/ 536 w 767"/>
                  <a:gd name="T41" fmla="*/ 162 h 489"/>
                  <a:gd name="T42" fmla="*/ 560 w 767"/>
                  <a:gd name="T43" fmla="*/ 265 h 489"/>
                  <a:gd name="T44" fmla="*/ 484 w 767"/>
                  <a:gd name="T45" fmla="*/ 428 h 489"/>
                  <a:gd name="T46" fmla="*/ 280 w 767"/>
                  <a:gd name="T47" fmla="*/ 489 h 489"/>
                  <a:gd name="T48" fmla="*/ 77 w 767"/>
                  <a:gd name="T49" fmla="*/ 428 h 489"/>
                  <a:gd name="T50" fmla="*/ 0 w 767"/>
                  <a:gd name="T51" fmla="*/ 265 h 489"/>
                  <a:gd name="T52" fmla="*/ 24 w 767"/>
                  <a:gd name="T53" fmla="*/ 162 h 489"/>
                  <a:gd name="T54" fmla="*/ 96 w 767"/>
                  <a:gd name="T55" fmla="*/ 90 h 489"/>
                  <a:gd name="T56" fmla="*/ 13 w 767"/>
                  <a:gd name="T57" fmla="*/ 90 h 489"/>
                  <a:gd name="T58" fmla="*/ 13 w 767"/>
                  <a:gd name="T59" fmla="*/ 0 h 489"/>
                  <a:gd name="T60" fmla="*/ 492 w 767"/>
                  <a:gd name="T61" fmla="*/ 0 h 4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767" h="489">
                    <a:moveTo>
                      <a:pt x="280" y="90"/>
                    </a:moveTo>
                    <a:cubicBezTo>
                      <a:pt x="216" y="90"/>
                      <a:pt x="165" y="104"/>
                      <a:pt x="129" y="130"/>
                    </a:cubicBezTo>
                    <a:cubicBezTo>
                      <a:pt x="93" y="157"/>
                      <a:pt x="75" y="195"/>
                      <a:pt x="75" y="243"/>
                    </a:cubicBezTo>
                    <a:cubicBezTo>
                      <a:pt x="75" y="291"/>
                      <a:pt x="93" y="329"/>
                      <a:pt x="129" y="356"/>
                    </a:cubicBezTo>
                    <a:cubicBezTo>
                      <a:pt x="165" y="383"/>
                      <a:pt x="216" y="396"/>
                      <a:pt x="280" y="396"/>
                    </a:cubicBezTo>
                    <a:cubicBezTo>
                      <a:pt x="345" y="396"/>
                      <a:pt x="395" y="383"/>
                      <a:pt x="431" y="356"/>
                    </a:cubicBezTo>
                    <a:cubicBezTo>
                      <a:pt x="467" y="329"/>
                      <a:pt x="485" y="291"/>
                      <a:pt x="485" y="243"/>
                    </a:cubicBezTo>
                    <a:cubicBezTo>
                      <a:pt x="485" y="195"/>
                      <a:pt x="467" y="157"/>
                      <a:pt x="431" y="130"/>
                    </a:cubicBezTo>
                    <a:cubicBezTo>
                      <a:pt x="395" y="104"/>
                      <a:pt x="345" y="90"/>
                      <a:pt x="280" y="90"/>
                    </a:cubicBezTo>
                    <a:close/>
                    <a:moveTo>
                      <a:pt x="492" y="0"/>
                    </a:moveTo>
                    <a:cubicBezTo>
                      <a:pt x="584" y="0"/>
                      <a:pt x="653" y="21"/>
                      <a:pt x="699" y="62"/>
                    </a:cubicBezTo>
                    <a:cubicBezTo>
                      <a:pt x="744" y="104"/>
                      <a:pt x="767" y="167"/>
                      <a:pt x="767" y="252"/>
                    </a:cubicBezTo>
                    <a:cubicBezTo>
                      <a:pt x="767" y="284"/>
                      <a:pt x="764" y="313"/>
                      <a:pt x="760" y="341"/>
                    </a:cubicBezTo>
                    <a:cubicBezTo>
                      <a:pt x="755" y="369"/>
                      <a:pt x="748" y="397"/>
                      <a:pt x="738" y="423"/>
                    </a:cubicBezTo>
                    <a:lnTo>
                      <a:pt x="651" y="423"/>
                    </a:lnTo>
                    <a:cubicBezTo>
                      <a:pt x="665" y="397"/>
                      <a:pt x="675" y="371"/>
                      <a:pt x="682" y="345"/>
                    </a:cubicBezTo>
                    <a:cubicBezTo>
                      <a:pt x="689" y="319"/>
                      <a:pt x="693" y="293"/>
                      <a:pt x="693" y="266"/>
                    </a:cubicBezTo>
                    <a:cubicBezTo>
                      <a:pt x="693" y="208"/>
                      <a:pt x="677" y="164"/>
                      <a:pt x="647" y="134"/>
                    </a:cubicBezTo>
                    <a:cubicBezTo>
                      <a:pt x="616" y="105"/>
                      <a:pt x="570" y="90"/>
                      <a:pt x="508" y="90"/>
                    </a:cubicBezTo>
                    <a:lnTo>
                      <a:pt x="464" y="90"/>
                    </a:lnTo>
                    <a:cubicBezTo>
                      <a:pt x="496" y="109"/>
                      <a:pt x="520" y="133"/>
                      <a:pt x="536" y="162"/>
                    </a:cubicBezTo>
                    <a:cubicBezTo>
                      <a:pt x="552" y="191"/>
                      <a:pt x="560" y="225"/>
                      <a:pt x="560" y="265"/>
                    </a:cubicBezTo>
                    <a:cubicBezTo>
                      <a:pt x="560" y="333"/>
                      <a:pt x="535" y="387"/>
                      <a:pt x="484" y="428"/>
                    </a:cubicBezTo>
                    <a:cubicBezTo>
                      <a:pt x="433" y="469"/>
                      <a:pt x="365" y="489"/>
                      <a:pt x="280" y="489"/>
                    </a:cubicBezTo>
                    <a:cubicBezTo>
                      <a:pt x="196" y="489"/>
                      <a:pt x="128" y="469"/>
                      <a:pt x="77" y="428"/>
                    </a:cubicBezTo>
                    <a:cubicBezTo>
                      <a:pt x="26" y="387"/>
                      <a:pt x="0" y="333"/>
                      <a:pt x="0" y="265"/>
                    </a:cubicBezTo>
                    <a:cubicBezTo>
                      <a:pt x="0" y="225"/>
                      <a:pt x="8" y="191"/>
                      <a:pt x="24" y="162"/>
                    </a:cubicBezTo>
                    <a:cubicBezTo>
                      <a:pt x="40" y="133"/>
                      <a:pt x="64" y="109"/>
                      <a:pt x="96" y="90"/>
                    </a:cubicBezTo>
                    <a:lnTo>
                      <a:pt x="13" y="90"/>
                    </a:lnTo>
                    <a:lnTo>
                      <a:pt x="13" y="0"/>
                    </a:lnTo>
                    <a:lnTo>
                      <a:pt x="492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40" name="Freeform 367">
                <a:extLst>
                  <a:ext uri="{FF2B5EF4-FFF2-40B4-BE49-F238E27FC236}">
                    <a16:creationId xmlns:a16="http://schemas.microsoft.com/office/drawing/2014/main" id="{83C260A1-CBA4-8680-7991-4606992C6B3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4078288"/>
                <a:ext cx="103188" cy="92075"/>
              </a:xfrm>
              <a:custGeom>
                <a:avLst/>
                <a:gdLst>
                  <a:gd name="T0" fmla="*/ 264 w 573"/>
                  <a:gd name="T1" fmla="*/ 0 h 507"/>
                  <a:gd name="T2" fmla="*/ 308 w 573"/>
                  <a:gd name="T3" fmla="*/ 0 h 507"/>
                  <a:gd name="T4" fmla="*/ 308 w 573"/>
                  <a:gd name="T5" fmla="*/ 413 h 507"/>
                  <a:gd name="T6" fmla="*/ 450 w 573"/>
                  <a:gd name="T7" fmla="*/ 357 h 507"/>
                  <a:gd name="T8" fmla="*/ 498 w 573"/>
                  <a:gd name="T9" fmla="*/ 218 h 507"/>
                  <a:gd name="T10" fmla="*/ 486 w 573"/>
                  <a:gd name="T11" fmla="*/ 118 h 507"/>
                  <a:gd name="T12" fmla="*/ 447 w 573"/>
                  <a:gd name="T13" fmla="*/ 21 h 507"/>
                  <a:gd name="T14" fmla="*/ 532 w 573"/>
                  <a:gd name="T15" fmla="*/ 21 h 507"/>
                  <a:gd name="T16" fmla="*/ 563 w 573"/>
                  <a:gd name="T17" fmla="*/ 120 h 507"/>
                  <a:gd name="T18" fmla="*/ 573 w 573"/>
                  <a:gd name="T19" fmla="*/ 223 h 507"/>
                  <a:gd name="T20" fmla="*/ 498 w 573"/>
                  <a:gd name="T21" fmla="*/ 431 h 507"/>
                  <a:gd name="T22" fmla="*/ 292 w 573"/>
                  <a:gd name="T23" fmla="*/ 507 h 507"/>
                  <a:gd name="T24" fmla="*/ 79 w 573"/>
                  <a:gd name="T25" fmla="*/ 435 h 507"/>
                  <a:gd name="T26" fmla="*/ 0 w 573"/>
                  <a:gd name="T27" fmla="*/ 239 h 507"/>
                  <a:gd name="T28" fmla="*/ 71 w 573"/>
                  <a:gd name="T29" fmla="*/ 64 h 507"/>
                  <a:gd name="T30" fmla="*/ 264 w 573"/>
                  <a:gd name="T31" fmla="*/ 0 h 507"/>
                  <a:gd name="T32" fmla="*/ 238 w 573"/>
                  <a:gd name="T33" fmla="*/ 90 h 507"/>
                  <a:gd name="T34" fmla="*/ 120 w 573"/>
                  <a:gd name="T35" fmla="*/ 131 h 507"/>
                  <a:gd name="T36" fmla="*/ 76 w 573"/>
                  <a:gd name="T37" fmla="*/ 238 h 507"/>
                  <a:gd name="T38" fmla="*/ 119 w 573"/>
                  <a:gd name="T39" fmla="*/ 358 h 507"/>
                  <a:gd name="T40" fmla="*/ 238 w 573"/>
                  <a:gd name="T41" fmla="*/ 410 h 507"/>
                  <a:gd name="T42" fmla="*/ 238 w 573"/>
                  <a:gd name="T43" fmla="*/ 90 h 5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73" h="507">
                    <a:moveTo>
                      <a:pt x="264" y="0"/>
                    </a:moveTo>
                    <a:lnTo>
                      <a:pt x="308" y="0"/>
                    </a:lnTo>
                    <a:lnTo>
                      <a:pt x="308" y="413"/>
                    </a:lnTo>
                    <a:cubicBezTo>
                      <a:pt x="370" y="409"/>
                      <a:pt x="418" y="391"/>
                      <a:pt x="450" y="357"/>
                    </a:cubicBezTo>
                    <a:cubicBezTo>
                      <a:pt x="482" y="324"/>
                      <a:pt x="498" y="278"/>
                      <a:pt x="498" y="218"/>
                    </a:cubicBezTo>
                    <a:cubicBezTo>
                      <a:pt x="498" y="184"/>
                      <a:pt x="494" y="150"/>
                      <a:pt x="486" y="118"/>
                    </a:cubicBezTo>
                    <a:cubicBezTo>
                      <a:pt x="478" y="86"/>
                      <a:pt x="465" y="53"/>
                      <a:pt x="447" y="21"/>
                    </a:cubicBezTo>
                    <a:lnTo>
                      <a:pt x="532" y="21"/>
                    </a:lnTo>
                    <a:cubicBezTo>
                      <a:pt x="546" y="53"/>
                      <a:pt x="557" y="86"/>
                      <a:pt x="563" y="120"/>
                    </a:cubicBezTo>
                    <a:cubicBezTo>
                      <a:pt x="569" y="154"/>
                      <a:pt x="573" y="189"/>
                      <a:pt x="573" y="223"/>
                    </a:cubicBezTo>
                    <a:cubicBezTo>
                      <a:pt x="573" y="311"/>
                      <a:pt x="548" y="380"/>
                      <a:pt x="498" y="431"/>
                    </a:cubicBezTo>
                    <a:cubicBezTo>
                      <a:pt x="448" y="482"/>
                      <a:pt x="379" y="507"/>
                      <a:pt x="292" y="507"/>
                    </a:cubicBezTo>
                    <a:cubicBezTo>
                      <a:pt x="203" y="507"/>
                      <a:pt x="132" y="483"/>
                      <a:pt x="79" y="435"/>
                    </a:cubicBezTo>
                    <a:cubicBezTo>
                      <a:pt x="27" y="387"/>
                      <a:pt x="0" y="321"/>
                      <a:pt x="0" y="239"/>
                    </a:cubicBezTo>
                    <a:cubicBezTo>
                      <a:pt x="0" y="165"/>
                      <a:pt x="24" y="107"/>
                      <a:pt x="71" y="64"/>
                    </a:cubicBezTo>
                    <a:cubicBezTo>
                      <a:pt x="119" y="22"/>
                      <a:pt x="183" y="0"/>
                      <a:pt x="264" y="0"/>
                    </a:cubicBezTo>
                    <a:close/>
                    <a:moveTo>
                      <a:pt x="238" y="90"/>
                    </a:moveTo>
                    <a:cubicBezTo>
                      <a:pt x="189" y="91"/>
                      <a:pt x="150" y="105"/>
                      <a:pt x="120" y="131"/>
                    </a:cubicBezTo>
                    <a:cubicBezTo>
                      <a:pt x="91" y="158"/>
                      <a:pt x="76" y="194"/>
                      <a:pt x="76" y="238"/>
                    </a:cubicBezTo>
                    <a:cubicBezTo>
                      <a:pt x="76" y="288"/>
                      <a:pt x="91" y="328"/>
                      <a:pt x="119" y="358"/>
                    </a:cubicBezTo>
                    <a:cubicBezTo>
                      <a:pt x="147" y="388"/>
                      <a:pt x="187" y="406"/>
                      <a:pt x="238" y="410"/>
                    </a:cubicBezTo>
                    <a:lnTo>
                      <a:pt x="238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41" name="Freeform 368">
                <a:extLst>
                  <a:ext uri="{FF2B5EF4-FFF2-40B4-BE49-F238E27FC236}">
                    <a16:creationId xmlns:a16="http://schemas.microsoft.com/office/drawing/2014/main" id="{A7035112-293E-0989-0603-EF1479ED71B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46350" y="3908425"/>
                <a:ext cx="130175" cy="85725"/>
              </a:xfrm>
              <a:custGeom>
                <a:avLst/>
                <a:gdLst>
                  <a:gd name="T0" fmla="*/ 81 w 729"/>
                  <a:gd name="T1" fmla="*/ 372 h 471"/>
                  <a:gd name="T2" fmla="*/ 355 w 729"/>
                  <a:gd name="T3" fmla="*/ 372 h 471"/>
                  <a:gd name="T4" fmla="*/ 355 w 729"/>
                  <a:gd name="T5" fmla="*/ 248 h 471"/>
                  <a:gd name="T6" fmla="*/ 320 w 729"/>
                  <a:gd name="T7" fmla="*/ 142 h 471"/>
                  <a:gd name="T8" fmla="*/ 218 w 729"/>
                  <a:gd name="T9" fmla="*/ 104 h 471"/>
                  <a:gd name="T10" fmla="*/ 117 w 729"/>
                  <a:gd name="T11" fmla="*/ 142 h 471"/>
                  <a:gd name="T12" fmla="*/ 81 w 729"/>
                  <a:gd name="T13" fmla="*/ 248 h 471"/>
                  <a:gd name="T14" fmla="*/ 81 w 729"/>
                  <a:gd name="T15" fmla="*/ 372 h 471"/>
                  <a:gd name="T16" fmla="*/ 0 w 729"/>
                  <a:gd name="T17" fmla="*/ 471 h 471"/>
                  <a:gd name="T18" fmla="*/ 0 w 729"/>
                  <a:gd name="T19" fmla="*/ 248 h 471"/>
                  <a:gd name="T20" fmla="*/ 56 w 729"/>
                  <a:gd name="T21" fmla="*/ 63 h 471"/>
                  <a:gd name="T22" fmla="*/ 218 w 729"/>
                  <a:gd name="T23" fmla="*/ 0 h 471"/>
                  <a:gd name="T24" fmla="*/ 381 w 729"/>
                  <a:gd name="T25" fmla="*/ 63 h 471"/>
                  <a:gd name="T26" fmla="*/ 436 w 729"/>
                  <a:gd name="T27" fmla="*/ 248 h 471"/>
                  <a:gd name="T28" fmla="*/ 436 w 729"/>
                  <a:gd name="T29" fmla="*/ 372 h 471"/>
                  <a:gd name="T30" fmla="*/ 729 w 729"/>
                  <a:gd name="T31" fmla="*/ 372 h 471"/>
                  <a:gd name="T32" fmla="*/ 729 w 729"/>
                  <a:gd name="T33" fmla="*/ 471 h 471"/>
                  <a:gd name="T34" fmla="*/ 0 w 729"/>
                  <a:gd name="T35" fmla="*/ 471 h 4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729" h="471">
                    <a:moveTo>
                      <a:pt x="81" y="372"/>
                    </a:moveTo>
                    <a:lnTo>
                      <a:pt x="355" y="372"/>
                    </a:lnTo>
                    <a:lnTo>
                      <a:pt x="355" y="248"/>
                    </a:lnTo>
                    <a:cubicBezTo>
                      <a:pt x="355" y="202"/>
                      <a:pt x="344" y="167"/>
                      <a:pt x="320" y="142"/>
                    </a:cubicBezTo>
                    <a:cubicBezTo>
                      <a:pt x="296" y="117"/>
                      <a:pt x="262" y="104"/>
                      <a:pt x="218" y="104"/>
                    </a:cubicBezTo>
                    <a:cubicBezTo>
                      <a:pt x="174" y="104"/>
                      <a:pt x="141" y="117"/>
                      <a:pt x="117" y="142"/>
                    </a:cubicBezTo>
                    <a:cubicBezTo>
                      <a:pt x="93" y="167"/>
                      <a:pt x="81" y="202"/>
                      <a:pt x="81" y="248"/>
                    </a:cubicBezTo>
                    <a:lnTo>
                      <a:pt x="81" y="372"/>
                    </a:lnTo>
                    <a:close/>
                    <a:moveTo>
                      <a:pt x="0" y="471"/>
                    </a:moveTo>
                    <a:lnTo>
                      <a:pt x="0" y="248"/>
                    </a:lnTo>
                    <a:cubicBezTo>
                      <a:pt x="0" y="167"/>
                      <a:pt x="19" y="105"/>
                      <a:pt x="56" y="63"/>
                    </a:cubicBezTo>
                    <a:cubicBezTo>
                      <a:pt x="93" y="21"/>
                      <a:pt x="147" y="0"/>
                      <a:pt x="218" y="0"/>
                    </a:cubicBezTo>
                    <a:cubicBezTo>
                      <a:pt x="290" y="0"/>
                      <a:pt x="345" y="21"/>
                      <a:pt x="381" y="63"/>
                    </a:cubicBezTo>
                    <a:cubicBezTo>
                      <a:pt x="418" y="105"/>
                      <a:pt x="436" y="167"/>
                      <a:pt x="436" y="248"/>
                    </a:cubicBezTo>
                    <a:lnTo>
                      <a:pt x="436" y="372"/>
                    </a:lnTo>
                    <a:lnTo>
                      <a:pt x="729" y="372"/>
                    </a:lnTo>
                    <a:lnTo>
                      <a:pt x="729" y="471"/>
                    </a:lnTo>
                    <a:lnTo>
                      <a:pt x="0" y="471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42" name="Freeform 369">
                <a:extLst>
                  <a:ext uri="{FF2B5EF4-FFF2-40B4-BE49-F238E27FC236}">
                    <a16:creationId xmlns:a16="http://schemas.microsoft.com/office/drawing/2014/main" id="{53D70CAF-53FE-DD8A-4C71-DB56BA6971B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6513" y="3832225"/>
                <a:ext cx="100013" cy="57150"/>
              </a:xfrm>
              <a:custGeom>
                <a:avLst/>
                <a:gdLst>
                  <a:gd name="T0" fmla="*/ 97 w 560"/>
                  <a:gd name="T1" fmla="*/ 0 h 320"/>
                  <a:gd name="T2" fmla="*/ 84 w 560"/>
                  <a:gd name="T3" fmla="*/ 33 h 320"/>
                  <a:gd name="T4" fmla="*/ 80 w 560"/>
                  <a:gd name="T5" fmla="*/ 72 h 320"/>
                  <a:gd name="T6" fmla="*/ 130 w 560"/>
                  <a:gd name="T7" fmla="*/ 189 h 320"/>
                  <a:gd name="T8" fmla="*/ 272 w 560"/>
                  <a:gd name="T9" fmla="*/ 230 h 320"/>
                  <a:gd name="T10" fmla="*/ 560 w 560"/>
                  <a:gd name="T11" fmla="*/ 230 h 320"/>
                  <a:gd name="T12" fmla="*/ 560 w 560"/>
                  <a:gd name="T13" fmla="*/ 320 h 320"/>
                  <a:gd name="T14" fmla="*/ 13 w 560"/>
                  <a:gd name="T15" fmla="*/ 320 h 320"/>
                  <a:gd name="T16" fmla="*/ 13 w 560"/>
                  <a:gd name="T17" fmla="*/ 230 h 320"/>
                  <a:gd name="T18" fmla="*/ 98 w 560"/>
                  <a:gd name="T19" fmla="*/ 230 h 320"/>
                  <a:gd name="T20" fmla="*/ 24 w 560"/>
                  <a:gd name="T21" fmla="*/ 157 h 320"/>
                  <a:gd name="T22" fmla="*/ 0 w 560"/>
                  <a:gd name="T23" fmla="*/ 46 h 320"/>
                  <a:gd name="T24" fmla="*/ 1 w 560"/>
                  <a:gd name="T25" fmla="*/ 25 h 320"/>
                  <a:gd name="T26" fmla="*/ 5 w 560"/>
                  <a:gd name="T27" fmla="*/ 0 h 320"/>
                  <a:gd name="T28" fmla="*/ 97 w 560"/>
                  <a:gd name="T29" fmla="*/ 0 h 3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560" h="320">
                    <a:moveTo>
                      <a:pt x="97" y="0"/>
                    </a:moveTo>
                    <a:cubicBezTo>
                      <a:pt x="91" y="10"/>
                      <a:pt x="87" y="21"/>
                      <a:pt x="84" y="33"/>
                    </a:cubicBezTo>
                    <a:cubicBezTo>
                      <a:pt x="82" y="45"/>
                      <a:pt x="80" y="58"/>
                      <a:pt x="80" y="72"/>
                    </a:cubicBezTo>
                    <a:cubicBezTo>
                      <a:pt x="80" y="123"/>
                      <a:pt x="97" y="162"/>
                      <a:pt x="130" y="189"/>
                    </a:cubicBezTo>
                    <a:cubicBezTo>
                      <a:pt x="163" y="217"/>
                      <a:pt x="210" y="230"/>
                      <a:pt x="272" y="230"/>
                    </a:cubicBezTo>
                    <a:lnTo>
                      <a:pt x="560" y="230"/>
                    </a:lnTo>
                    <a:lnTo>
                      <a:pt x="560" y="320"/>
                    </a:lnTo>
                    <a:lnTo>
                      <a:pt x="13" y="320"/>
                    </a:lnTo>
                    <a:lnTo>
                      <a:pt x="13" y="230"/>
                    </a:lnTo>
                    <a:lnTo>
                      <a:pt x="98" y="230"/>
                    </a:lnTo>
                    <a:cubicBezTo>
                      <a:pt x="65" y="212"/>
                      <a:pt x="40" y="187"/>
                      <a:pt x="24" y="157"/>
                    </a:cubicBezTo>
                    <a:cubicBezTo>
                      <a:pt x="8" y="127"/>
                      <a:pt x="0" y="90"/>
                      <a:pt x="0" y="46"/>
                    </a:cubicBezTo>
                    <a:cubicBezTo>
                      <a:pt x="0" y="40"/>
                      <a:pt x="1" y="33"/>
                      <a:pt x="1" y="25"/>
                    </a:cubicBezTo>
                    <a:cubicBezTo>
                      <a:pt x="2" y="18"/>
                      <a:pt x="3" y="10"/>
                      <a:pt x="5" y="0"/>
                    </a:cubicBezTo>
                    <a:lnTo>
                      <a:pt x="97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43" name="Freeform 370">
                <a:extLst>
                  <a:ext uri="{FF2B5EF4-FFF2-40B4-BE49-F238E27FC236}">
                    <a16:creationId xmlns:a16="http://schemas.microsoft.com/office/drawing/2014/main" id="{621E125D-AB06-37F0-5F02-19570BC2A05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3733800"/>
                <a:ext cx="103188" cy="92075"/>
              </a:xfrm>
              <a:custGeom>
                <a:avLst/>
                <a:gdLst>
                  <a:gd name="T0" fmla="*/ 264 w 573"/>
                  <a:gd name="T1" fmla="*/ 0 h 507"/>
                  <a:gd name="T2" fmla="*/ 308 w 573"/>
                  <a:gd name="T3" fmla="*/ 0 h 507"/>
                  <a:gd name="T4" fmla="*/ 308 w 573"/>
                  <a:gd name="T5" fmla="*/ 413 h 507"/>
                  <a:gd name="T6" fmla="*/ 450 w 573"/>
                  <a:gd name="T7" fmla="*/ 357 h 507"/>
                  <a:gd name="T8" fmla="*/ 498 w 573"/>
                  <a:gd name="T9" fmla="*/ 218 h 507"/>
                  <a:gd name="T10" fmla="*/ 486 w 573"/>
                  <a:gd name="T11" fmla="*/ 118 h 507"/>
                  <a:gd name="T12" fmla="*/ 447 w 573"/>
                  <a:gd name="T13" fmla="*/ 21 h 507"/>
                  <a:gd name="T14" fmla="*/ 532 w 573"/>
                  <a:gd name="T15" fmla="*/ 21 h 507"/>
                  <a:gd name="T16" fmla="*/ 563 w 573"/>
                  <a:gd name="T17" fmla="*/ 120 h 507"/>
                  <a:gd name="T18" fmla="*/ 573 w 573"/>
                  <a:gd name="T19" fmla="*/ 223 h 507"/>
                  <a:gd name="T20" fmla="*/ 498 w 573"/>
                  <a:gd name="T21" fmla="*/ 431 h 507"/>
                  <a:gd name="T22" fmla="*/ 292 w 573"/>
                  <a:gd name="T23" fmla="*/ 507 h 507"/>
                  <a:gd name="T24" fmla="*/ 79 w 573"/>
                  <a:gd name="T25" fmla="*/ 435 h 507"/>
                  <a:gd name="T26" fmla="*/ 0 w 573"/>
                  <a:gd name="T27" fmla="*/ 239 h 507"/>
                  <a:gd name="T28" fmla="*/ 71 w 573"/>
                  <a:gd name="T29" fmla="*/ 64 h 507"/>
                  <a:gd name="T30" fmla="*/ 264 w 573"/>
                  <a:gd name="T31" fmla="*/ 0 h 507"/>
                  <a:gd name="T32" fmla="*/ 238 w 573"/>
                  <a:gd name="T33" fmla="*/ 90 h 507"/>
                  <a:gd name="T34" fmla="*/ 120 w 573"/>
                  <a:gd name="T35" fmla="*/ 131 h 507"/>
                  <a:gd name="T36" fmla="*/ 76 w 573"/>
                  <a:gd name="T37" fmla="*/ 238 h 507"/>
                  <a:gd name="T38" fmla="*/ 119 w 573"/>
                  <a:gd name="T39" fmla="*/ 358 h 507"/>
                  <a:gd name="T40" fmla="*/ 238 w 573"/>
                  <a:gd name="T41" fmla="*/ 410 h 507"/>
                  <a:gd name="T42" fmla="*/ 238 w 573"/>
                  <a:gd name="T43" fmla="*/ 90 h 5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73" h="507">
                    <a:moveTo>
                      <a:pt x="264" y="0"/>
                    </a:moveTo>
                    <a:lnTo>
                      <a:pt x="308" y="0"/>
                    </a:lnTo>
                    <a:lnTo>
                      <a:pt x="308" y="413"/>
                    </a:lnTo>
                    <a:cubicBezTo>
                      <a:pt x="370" y="409"/>
                      <a:pt x="418" y="391"/>
                      <a:pt x="450" y="357"/>
                    </a:cubicBezTo>
                    <a:cubicBezTo>
                      <a:pt x="482" y="324"/>
                      <a:pt x="498" y="278"/>
                      <a:pt x="498" y="218"/>
                    </a:cubicBezTo>
                    <a:cubicBezTo>
                      <a:pt x="498" y="184"/>
                      <a:pt x="494" y="150"/>
                      <a:pt x="486" y="118"/>
                    </a:cubicBezTo>
                    <a:cubicBezTo>
                      <a:pt x="478" y="86"/>
                      <a:pt x="465" y="53"/>
                      <a:pt x="447" y="21"/>
                    </a:cubicBezTo>
                    <a:lnTo>
                      <a:pt x="532" y="21"/>
                    </a:lnTo>
                    <a:cubicBezTo>
                      <a:pt x="546" y="53"/>
                      <a:pt x="557" y="86"/>
                      <a:pt x="563" y="120"/>
                    </a:cubicBezTo>
                    <a:cubicBezTo>
                      <a:pt x="569" y="154"/>
                      <a:pt x="573" y="189"/>
                      <a:pt x="573" y="223"/>
                    </a:cubicBezTo>
                    <a:cubicBezTo>
                      <a:pt x="573" y="311"/>
                      <a:pt x="548" y="380"/>
                      <a:pt x="498" y="431"/>
                    </a:cubicBezTo>
                    <a:cubicBezTo>
                      <a:pt x="448" y="482"/>
                      <a:pt x="379" y="507"/>
                      <a:pt x="292" y="507"/>
                    </a:cubicBezTo>
                    <a:cubicBezTo>
                      <a:pt x="203" y="507"/>
                      <a:pt x="132" y="483"/>
                      <a:pt x="79" y="435"/>
                    </a:cubicBezTo>
                    <a:cubicBezTo>
                      <a:pt x="27" y="387"/>
                      <a:pt x="0" y="321"/>
                      <a:pt x="0" y="239"/>
                    </a:cubicBezTo>
                    <a:cubicBezTo>
                      <a:pt x="0" y="165"/>
                      <a:pt x="24" y="107"/>
                      <a:pt x="71" y="64"/>
                    </a:cubicBezTo>
                    <a:cubicBezTo>
                      <a:pt x="119" y="22"/>
                      <a:pt x="183" y="0"/>
                      <a:pt x="264" y="0"/>
                    </a:cubicBezTo>
                    <a:close/>
                    <a:moveTo>
                      <a:pt x="238" y="90"/>
                    </a:moveTo>
                    <a:cubicBezTo>
                      <a:pt x="189" y="91"/>
                      <a:pt x="150" y="105"/>
                      <a:pt x="120" y="131"/>
                    </a:cubicBezTo>
                    <a:cubicBezTo>
                      <a:pt x="91" y="158"/>
                      <a:pt x="76" y="194"/>
                      <a:pt x="76" y="238"/>
                    </a:cubicBezTo>
                    <a:cubicBezTo>
                      <a:pt x="76" y="288"/>
                      <a:pt x="91" y="328"/>
                      <a:pt x="119" y="358"/>
                    </a:cubicBezTo>
                    <a:cubicBezTo>
                      <a:pt x="147" y="388"/>
                      <a:pt x="187" y="406"/>
                      <a:pt x="238" y="410"/>
                    </a:cubicBezTo>
                    <a:lnTo>
                      <a:pt x="238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44" name="Freeform 371">
                <a:extLst>
                  <a:ext uri="{FF2B5EF4-FFF2-40B4-BE49-F238E27FC236}">
                    <a16:creationId xmlns:a16="http://schemas.microsoft.com/office/drawing/2014/main" id="{6966A717-F988-A9AB-E2B6-3A55C4A8A08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6513" y="3636963"/>
                <a:ext cx="103188" cy="77788"/>
              </a:xfrm>
              <a:custGeom>
                <a:avLst/>
                <a:gdLst>
                  <a:gd name="T0" fmla="*/ 34 w 573"/>
                  <a:gd name="T1" fmla="*/ 0 h 433"/>
                  <a:gd name="T2" fmla="*/ 118 w 573"/>
                  <a:gd name="T3" fmla="*/ 0 h 433"/>
                  <a:gd name="T4" fmla="*/ 87 w 573"/>
                  <a:gd name="T5" fmla="*/ 77 h 433"/>
                  <a:gd name="T6" fmla="*/ 76 w 573"/>
                  <a:gd name="T7" fmla="*/ 154 h 433"/>
                  <a:gd name="T8" fmla="*/ 132 w 573"/>
                  <a:gd name="T9" fmla="*/ 290 h 433"/>
                  <a:gd name="T10" fmla="*/ 287 w 573"/>
                  <a:gd name="T11" fmla="*/ 338 h 433"/>
                  <a:gd name="T12" fmla="*/ 443 w 573"/>
                  <a:gd name="T13" fmla="*/ 290 h 433"/>
                  <a:gd name="T14" fmla="*/ 498 w 573"/>
                  <a:gd name="T15" fmla="*/ 154 h 433"/>
                  <a:gd name="T16" fmla="*/ 488 w 573"/>
                  <a:gd name="T17" fmla="*/ 77 h 433"/>
                  <a:gd name="T18" fmla="*/ 456 w 573"/>
                  <a:gd name="T19" fmla="*/ 0 h 433"/>
                  <a:gd name="T20" fmla="*/ 539 w 573"/>
                  <a:gd name="T21" fmla="*/ 0 h 433"/>
                  <a:gd name="T22" fmla="*/ 565 w 573"/>
                  <a:gd name="T23" fmla="*/ 78 h 433"/>
                  <a:gd name="T24" fmla="*/ 573 w 573"/>
                  <a:gd name="T25" fmla="*/ 164 h 433"/>
                  <a:gd name="T26" fmla="*/ 496 w 573"/>
                  <a:gd name="T27" fmla="*/ 360 h 433"/>
                  <a:gd name="T28" fmla="*/ 287 w 573"/>
                  <a:gd name="T29" fmla="*/ 433 h 433"/>
                  <a:gd name="T30" fmla="*/ 77 w 573"/>
                  <a:gd name="T31" fmla="*/ 360 h 433"/>
                  <a:gd name="T32" fmla="*/ 0 w 573"/>
                  <a:gd name="T33" fmla="*/ 158 h 433"/>
                  <a:gd name="T34" fmla="*/ 9 w 573"/>
                  <a:gd name="T35" fmla="*/ 77 h 433"/>
                  <a:gd name="T36" fmla="*/ 34 w 573"/>
                  <a:gd name="T37" fmla="*/ 0 h 4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573" h="433">
                    <a:moveTo>
                      <a:pt x="34" y="0"/>
                    </a:moveTo>
                    <a:lnTo>
                      <a:pt x="118" y="0"/>
                    </a:lnTo>
                    <a:cubicBezTo>
                      <a:pt x="104" y="26"/>
                      <a:pt x="94" y="51"/>
                      <a:pt x="87" y="77"/>
                    </a:cubicBezTo>
                    <a:cubicBezTo>
                      <a:pt x="80" y="103"/>
                      <a:pt x="76" y="128"/>
                      <a:pt x="76" y="154"/>
                    </a:cubicBezTo>
                    <a:cubicBezTo>
                      <a:pt x="76" y="212"/>
                      <a:pt x="95" y="258"/>
                      <a:pt x="132" y="290"/>
                    </a:cubicBezTo>
                    <a:cubicBezTo>
                      <a:pt x="169" y="322"/>
                      <a:pt x="221" y="338"/>
                      <a:pt x="287" y="338"/>
                    </a:cubicBezTo>
                    <a:cubicBezTo>
                      <a:pt x="354" y="338"/>
                      <a:pt x="406" y="322"/>
                      <a:pt x="443" y="290"/>
                    </a:cubicBezTo>
                    <a:cubicBezTo>
                      <a:pt x="480" y="258"/>
                      <a:pt x="498" y="212"/>
                      <a:pt x="498" y="154"/>
                    </a:cubicBezTo>
                    <a:cubicBezTo>
                      <a:pt x="498" y="128"/>
                      <a:pt x="495" y="103"/>
                      <a:pt x="488" y="77"/>
                    </a:cubicBezTo>
                    <a:cubicBezTo>
                      <a:pt x="481" y="51"/>
                      <a:pt x="470" y="26"/>
                      <a:pt x="456" y="0"/>
                    </a:cubicBezTo>
                    <a:lnTo>
                      <a:pt x="539" y="0"/>
                    </a:lnTo>
                    <a:cubicBezTo>
                      <a:pt x="551" y="26"/>
                      <a:pt x="560" y="52"/>
                      <a:pt x="565" y="78"/>
                    </a:cubicBezTo>
                    <a:cubicBezTo>
                      <a:pt x="570" y="105"/>
                      <a:pt x="573" y="134"/>
                      <a:pt x="573" y="164"/>
                    </a:cubicBezTo>
                    <a:cubicBezTo>
                      <a:pt x="573" y="246"/>
                      <a:pt x="548" y="312"/>
                      <a:pt x="496" y="360"/>
                    </a:cubicBezTo>
                    <a:cubicBezTo>
                      <a:pt x="445" y="409"/>
                      <a:pt x="375" y="433"/>
                      <a:pt x="287" y="433"/>
                    </a:cubicBezTo>
                    <a:cubicBezTo>
                      <a:pt x="198" y="433"/>
                      <a:pt x="128" y="409"/>
                      <a:pt x="77" y="360"/>
                    </a:cubicBezTo>
                    <a:cubicBezTo>
                      <a:pt x="26" y="311"/>
                      <a:pt x="0" y="244"/>
                      <a:pt x="0" y="158"/>
                    </a:cubicBezTo>
                    <a:cubicBezTo>
                      <a:pt x="0" y="130"/>
                      <a:pt x="3" y="103"/>
                      <a:pt x="9" y="77"/>
                    </a:cubicBezTo>
                    <a:cubicBezTo>
                      <a:pt x="15" y="51"/>
                      <a:pt x="23" y="25"/>
                      <a:pt x="34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45" name="Freeform 372">
                <a:extLst>
                  <a:ext uri="{FF2B5EF4-FFF2-40B4-BE49-F238E27FC236}">
                    <a16:creationId xmlns:a16="http://schemas.microsoft.com/office/drawing/2014/main" id="{F963CE4A-7B3A-DD6C-603A-8F5F5F1E0D7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40000" y="3592513"/>
                <a:ext cx="136525" cy="15875"/>
              </a:xfrm>
              <a:custGeom>
                <a:avLst/>
                <a:gdLst>
                  <a:gd name="T0" fmla="*/ 213 w 760"/>
                  <a:gd name="T1" fmla="*/ 90 h 90"/>
                  <a:gd name="T2" fmla="*/ 213 w 760"/>
                  <a:gd name="T3" fmla="*/ 0 h 90"/>
                  <a:gd name="T4" fmla="*/ 760 w 760"/>
                  <a:gd name="T5" fmla="*/ 0 h 90"/>
                  <a:gd name="T6" fmla="*/ 760 w 760"/>
                  <a:gd name="T7" fmla="*/ 90 h 90"/>
                  <a:gd name="T8" fmla="*/ 213 w 760"/>
                  <a:gd name="T9" fmla="*/ 90 h 90"/>
                  <a:gd name="T10" fmla="*/ 0 w 760"/>
                  <a:gd name="T11" fmla="*/ 90 h 90"/>
                  <a:gd name="T12" fmla="*/ 0 w 760"/>
                  <a:gd name="T13" fmla="*/ 0 h 90"/>
                  <a:gd name="T14" fmla="*/ 114 w 760"/>
                  <a:gd name="T15" fmla="*/ 0 h 90"/>
                  <a:gd name="T16" fmla="*/ 114 w 760"/>
                  <a:gd name="T17" fmla="*/ 90 h 90"/>
                  <a:gd name="T18" fmla="*/ 0 w 760"/>
                  <a:gd name="T19" fmla="*/ 9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760" h="90">
                    <a:moveTo>
                      <a:pt x="213" y="90"/>
                    </a:moveTo>
                    <a:lnTo>
                      <a:pt x="213" y="0"/>
                    </a:lnTo>
                    <a:lnTo>
                      <a:pt x="760" y="0"/>
                    </a:lnTo>
                    <a:lnTo>
                      <a:pt x="760" y="90"/>
                    </a:lnTo>
                    <a:lnTo>
                      <a:pt x="213" y="90"/>
                    </a:lnTo>
                    <a:close/>
                    <a:moveTo>
                      <a:pt x="0" y="90"/>
                    </a:moveTo>
                    <a:lnTo>
                      <a:pt x="0" y="0"/>
                    </a:lnTo>
                    <a:lnTo>
                      <a:pt x="114" y="0"/>
                    </a:lnTo>
                    <a:lnTo>
                      <a:pt x="114" y="90"/>
                    </a:lnTo>
                    <a:lnTo>
                      <a:pt x="0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46" name="Freeform 373">
                <a:extLst>
                  <a:ext uri="{FF2B5EF4-FFF2-40B4-BE49-F238E27FC236}">
                    <a16:creationId xmlns:a16="http://schemas.microsoft.com/office/drawing/2014/main" id="{CAFDFF88-FED6-9F10-8B0B-DF9EF73473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6513" y="3489325"/>
                <a:ext cx="103188" cy="76200"/>
              </a:xfrm>
              <a:custGeom>
                <a:avLst/>
                <a:gdLst>
                  <a:gd name="T0" fmla="*/ 29 w 573"/>
                  <a:gd name="T1" fmla="*/ 29 h 418"/>
                  <a:gd name="T2" fmla="*/ 114 w 573"/>
                  <a:gd name="T3" fmla="*/ 29 h 418"/>
                  <a:gd name="T4" fmla="*/ 85 w 573"/>
                  <a:gd name="T5" fmla="*/ 108 h 418"/>
                  <a:gd name="T6" fmla="*/ 75 w 573"/>
                  <a:gd name="T7" fmla="*/ 193 h 418"/>
                  <a:gd name="T8" fmla="*/ 96 w 573"/>
                  <a:gd name="T9" fmla="*/ 294 h 418"/>
                  <a:gd name="T10" fmla="*/ 157 w 573"/>
                  <a:gd name="T11" fmla="*/ 327 h 418"/>
                  <a:gd name="T12" fmla="*/ 206 w 573"/>
                  <a:gd name="T13" fmla="*/ 303 h 418"/>
                  <a:gd name="T14" fmla="*/ 240 w 573"/>
                  <a:gd name="T15" fmla="*/ 207 h 418"/>
                  <a:gd name="T16" fmla="*/ 247 w 573"/>
                  <a:gd name="T17" fmla="*/ 176 h 418"/>
                  <a:gd name="T18" fmla="*/ 305 w 573"/>
                  <a:gd name="T19" fmla="*/ 40 h 418"/>
                  <a:gd name="T20" fmla="*/ 409 w 573"/>
                  <a:gd name="T21" fmla="*/ 0 h 418"/>
                  <a:gd name="T22" fmla="*/ 529 w 573"/>
                  <a:gd name="T23" fmla="*/ 60 h 418"/>
                  <a:gd name="T24" fmla="*/ 573 w 573"/>
                  <a:gd name="T25" fmla="*/ 226 h 418"/>
                  <a:gd name="T26" fmla="*/ 565 w 573"/>
                  <a:gd name="T27" fmla="*/ 318 h 418"/>
                  <a:gd name="T28" fmla="*/ 540 w 573"/>
                  <a:gd name="T29" fmla="*/ 418 h 418"/>
                  <a:gd name="T30" fmla="*/ 447 w 573"/>
                  <a:gd name="T31" fmla="*/ 418 h 418"/>
                  <a:gd name="T32" fmla="*/ 486 w 573"/>
                  <a:gd name="T33" fmla="*/ 320 h 418"/>
                  <a:gd name="T34" fmla="*/ 499 w 573"/>
                  <a:gd name="T35" fmla="*/ 224 h 418"/>
                  <a:gd name="T36" fmla="*/ 478 w 573"/>
                  <a:gd name="T37" fmla="*/ 126 h 418"/>
                  <a:gd name="T38" fmla="*/ 416 w 573"/>
                  <a:gd name="T39" fmla="*/ 92 h 418"/>
                  <a:gd name="T40" fmla="*/ 360 w 573"/>
                  <a:gd name="T41" fmla="*/ 117 h 418"/>
                  <a:gd name="T42" fmla="*/ 322 w 573"/>
                  <a:gd name="T43" fmla="*/ 225 h 418"/>
                  <a:gd name="T44" fmla="*/ 315 w 573"/>
                  <a:gd name="T45" fmla="*/ 256 h 418"/>
                  <a:gd name="T46" fmla="*/ 261 w 573"/>
                  <a:gd name="T47" fmla="*/ 377 h 418"/>
                  <a:gd name="T48" fmla="*/ 161 w 573"/>
                  <a:gd name="T49" fmla="*/ 414 h 418"/>
                  <a:gd name="T50" fmla="*/ 42 w 573"/>
                  <a:gd name="T51" fmla="*/ 360 h 418"/>
                  <a:gd name="T52" fmla="*/ 0 w 573"/>
                  <a:gd name="T53" fmla="*/ 204 h 418"/>
                  <a:gd name="T54" fmla="*/ 8 w 573"/>
                  <a:gd name="T55" fmla="*/ 110 h 418"/>
                  <a:gd name="T56" fmla="*/ 29 w 573"/>
                  <a:gd name="T57" fmla="*/ 29 h 4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573" h="418">
                    <a:moveTo>
                      <a:pt x="29" y="29"/>
                    </a:moveTo>
                    <a:lnTo>
                      <a:pt x="114" y="29"/>
                    </a:lnTo>
                    <a:cubicBezTo>
                      <a:pt x="102" y="55"/>
                      <a:pt x="92" y="81"/>
                      <a:pt x="85" y="108"/>
                    </a:cubicBezTo>
                    <a:cubicBezTo>
                      <a:pt x="79" y="136"/>
                      <a:pt x="75" y="164"/>
                      <a:pt x="75" y="193"/>
                    </a:cubicBezTo>
                    <a:cubicBezTo>
                      <a:pt x="75" y="238"/>
                      <a:pt x="82" y="272"/>
                      <a:pt x="96" y="294"/>
                    </a:cubicBezTo>
                    <a:cubicBezTo>
                      <a:pt x="110" y="316"/>
                      <a:pt x="130" y="327"/>
                      <a:pt x="157" y="327"/>
                    </a:cubicBezTo>
                    <a:cubicBezTo>
                      <a:pt x="178" y="327"/>
                      <a:pt x="194" y="319"/>
                      <a:pt x="206" y="303"/>
                    </a:cubicBezTo>
                    <a:cubicBezTo>
                      <a:pt x="218" y="287"/>
                      <a:pt x="230" y="255"/>
                      <a:pt x="240" y="207"/>
                    </a:cubicBezTo>
                    <a:lnTo>
                      <a:pt x="247" y="176"/>
                    </a:lnTo>
                    <a:cubicBezTo>
                      <a:pt x="261" y="112"/>
                      <a:pt x="281" y="67"/>
                      <a:pt x="305" y="40"/>
                    </a:cubicBezTo>
                    <a:cubicBezTo>
                      <a:pt x="330" y="14"/>
                      <a:pt x="365" y="0"/>
                      <a:pt x="409" y="0"/>
                    </a:cubicBezTo>
                    <a:cubicBezTo>
                      <a:pt x="460" y="0"/>
                      <a:pt x="500" y="20"/>
                      <a:pt x="529" y="60"/>
                    </a:cubicBezTo>
                    <a:cubicBezTo>
                      <a:pt x="559" y="100"/>
                      <a:pt x="573" y="156"/>
                      <a:pt x="573" y="226"/>
                    </a:cubicBezTo>
                    <a:cubicBezTo>
                      <a:pt x="573" y="256"/>
                      <a:pt x="570" y="286"/>
                      <a:pt x="565" y="318"/>
                    </a:cubicBezTo>
                    <a:cubicBezTo>
                      <a:pt x="560" y="350"/>
                      <a:pt x="552" y="383"/>
                      <a:pt x="540" y="418"/>
                    </a:cubicBezTo>
                    <a:lnTo>
                      <a:pt x="447" y="418"/>
                    </a:lnTo>
                    <a:cubicBezTo>
                      <a:pt x="465" y="385"/>
                      <a:pt x="478" y="352"/>
                      <a:pt x="486" y="320"/>
                    </a:cubicBezTo>
                    <a:cubicBezTo>
                      <a:pt x="495" y="288"/>
                      <a:pt x="499" y="256"/>
                      <a:pt x="499" y="224"/>
                    </a:cubicBezTo>
                    <a:cubicBezTo>
                      <a:pt x="499" y="182"/>
                      <a:pt x="492" y="149"/>
                      <a:pt x="478" y="126"/>
                    </a:cubicBezTo>
                    <a:cubicBezTo>
                      <a:pt x="464" y="104"/>
                      <a:pt x="443" y="92"/>
                      <a:pt x="416" y="92"/>
                    </a:cubicBezTo>
                    <a:cubicBezTo>
                      <a:pt x="392" y="92"/>
                      <a:pt x="373" y="101"/>
                      <a:pt x="360" y="117"/>
                    </a:cubicBezTo>
                    <a:cubicBezTo>
                      <a:pt x="347" y="133"/>
                      <a:pt x="334" y="169"/>
                      <a:pt x="322" y="225"/>
                    </a:cubicBezTo>
                    <a:lnTo>
                      <a:pt x="315" y="256"/>
                    </a:lnTo>
                    <a:cubicBezTo>
                      <a:pt x="303" y="312"/>
                      <a:pt x="285" y="353"/>
                      <a:pt x="261" y="377"/>
                    </a:cubicBezTo>
                    <a:cubicBezTo>
                      <a:pt x="237" y="402"/>
                      <a:pt x="204" y="414"/>
                      <a:pt x="161" y="414"/>
                    </a:cubicBezTo>
                    <a:cubicBezTo>
                      <a:pt x="110" y="414"/>
                      <a:pt x="70" y="396"/>
                      <a:pt x="42" y="360"/>
                    </a:cubicBezTo>
                    <a:cubicBezTo>
                      <a:pt x="14" y="324"/>
                      <a:pt x="0" y="272"/>
                      <a:pt x="0" y="204"/>
                    </a:cubicBezTo>
                    <a:cubicBezTo>
                      <a:pt x="0" y="171"/>
                      <a:pt x="3" y="140"/>
                      <a:pt x="8" y="110"/>
                    </a:cubicBezTo>
                    <a:cubicBezTo>
                      <a:pt x="13" y="81"/>
                      <a:pt x="20" y="54"/>
                      <a:pt x="29" y="2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47" name="Freeform 374">
                <a:extLst>
                  <a:ext uri="{FF2B5EF4-FFF2-40B4-BE49-F238E27FC236}">
                    <a16:creationId xmlns:a16="http://schemas.microsoft.com/office/drawing/2014/main" id="{DB029130-E072-C002-F695-28BE2CDEA13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40000" y="3448050"/>
                <a:ext cx="136525" cy="15875"/>
              </a:xfrm>
              <a:custGeom>
                <a:avLst/>
                <a:gdLst>
                  <a:gd name="T0" fmla="*/ 213 w 760"/>
                  <a:gd name="T1" fmla="*/ 90 h 90"/>
                  <a:gd name="T2" fmla="*/ 213 w 760"/>
                  <a:gd name="T3" fmla="*/ 0 h 90"/>
                  <a:gd name="T4" fmla="*/ 760 w 760"/>
                  <a:gd name="T5" fmla="*/ 0 h 90"/>
                  <a:gd name="T6" fmla="*/ 760 w 760"/>
                  <a:gd name="T7" fmla="*/ 90 h 90"/>
                  <a:gd name="T8" fmla="*/ 213 w 760"/>
                  <a:gd name="T9" fmla="*/ 90 h 90"/>
                  <a:gd name="T10" fmla="*/ 0 w 760"/>
                  <a:gd name="T11" fmla="*/ 90 h 90"/>
                  <a:gd name="T12" fmla="*/ 0 w 760"/>
                  <a:gd name="T13" fmla="*/ 0 h 90"/>
                  <a:gd name="T14" fmla="*/ 114 w 760"/>
                  <a:gd name="T15" fmla="*/ 0 h 90"/>
                  <a:gd name="T16" fmla="*/ 114 w 760"/>
                  <a:gd name="T17" fmla="*/ 90 h 90"/>
                  <a:gd name="T18" fmla="*/ 0 w 760"/>
                  <a:gd name="T19" fmla="*/ 9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760" h="90">
                    <a:moveTo>
                      <a:pt x="213" y="90"/>
                    </a:moveTo>
                    <a:lnTo>
                      <a:pt x="213" y="0"/>
                    </a:lnTo>
                    <a:lnTo>
                      <a:pt x="760" y="0"/>
                    </a:lnTo>
                    <a:lnTo>
                      <a:pt x="760" y="90"/>
                    </a:lnTo>
                    <a:lnTo>
                      <a:pt x="213" y="90"/>
                    </a:lnTo>
                    <a:close/>
                    <a:moveTo>
                      <a:pt x="0" y="90"/>
                    </a:moveTo>
                    <a:lnTo>
                      <a:pt x="0" y="0"/>
                    </a:lnTo>
                    <a:lnTo>
                      <a:pt x="114" y="0"/>
                    </a:lnTo>
                    <a:lnTo>
                      <a:pt x="114" y="90"/>
                    </a:lnTo>
                    <a:lnTo>
                      <a:pt x="0" y="9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48" name="Freeform 375">
                <a:extLst>
                  <a:ext uri="{FF2B5EF4-FFF2-40B4-BE49-F238E27FC236}">
                    <a16:creationId xmlns:a16="http://schemas.microsoft.com/office/drawing/2014/main" id="{723E0939-7246-E574-D76D-23C905A7A92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3330575"/>
                <a:ext cx="103188" cy="90488"/>
              </a:xfrm>
              <a:custGeom>
                <a:avLst/>
                <a:gdLst>
                  <a:gd name="T0" fmla="*/ 76 w 573"/>
                  <a:gd name="T1" fmla="*/ 251 h 502"/>
                  <a:gd name="T2" fmla="*/ 133 w 573"/>
                  <a:gd name="T3" fmla="*/ 365 h 502"/>
                  <a:gd name="T4" fmla="*/ 287 w 573"/>
                  <a:gd name="T5" fmla="*/ 407 h 502"/>
                  <a:gd name="T6" fmla="*/ 442 w 573"/>
                  <a:gd name="T7" fmla="*/ 366 h 502"/>
                  <a:gd name="T8" fmla="*/ 498 w 573"/>
                  <a:gd name="T9" fmla="*/ 251 h 502"/>
                  <a:gd name="T10" fmla="*/ 442 w 573"/>
                  <a:gd name="T11" fmla="*/ 137 h 502"/>
                  <a:gd name="T12" fmla="*/ 287 w 573"/>
                  <a:gd name="T13" fmla="*/ 95 h 502"/>
                  <a:gd name="T14" fmla="*/ 133 w 573"/>
                  <a:gd name="T15" fmla="*/ 137 h 502"/>
                  <a:gd name="T16" fmla="*/ 76 w 573"/>
                  <a:gd name="T17" fmla="*/ 251 h 502"/>
                  <a:gd name="T18" fmla="*/ 0 w 573"/>
                  <a:gd name="T19" fmla="*/ 251 h 502"/>
                  <a:gd name="T20" fmla="*/ 76 w 573"/>
                  <a:gd name="T21" fmla="*/ 67 h 502"/>
                  <a:gd name="T22" fmla="*/ 287 w 573"/>
                  <a:gd name="T23" fmla="*/ 0 h 502"/>
                  <a:gd name="T24" fmla="*/ 497 w 573"/>
                  <a:gd name="T25" fmla="*/ 67 h 502"/>
                  <a:gd name="T26" fmla="*/ 573 w 573"/>
                  <a:gd name="T27" fmla="*/ 251 h 502"/>
                  <a:gd name="T28" fmla="*/ 497 w 573"/>
                  <a:gd name="T29" fmla="*/ 436 h 502"/>
                  <a:gd name="T30" fmla="*/ 287 w 573"/>
                  <a:gd name="T31" fmla="*/ 502 h 502"/>
                  <a:gd name="T32" fmla="*/ 76 w 573"/>
                  <a:gd name="T33" fmla="*/ 436 h 502"/>
                  <a:gd name="T34" fmla="*/ 0 w 573"/>
                  <a:gd name="T35" fmla="*/ 251 h 5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73" h="502">
                    <a:moveTo>
                      <a:pt x="76" y="251"/>
                    </a:moveTo>
                    <a:cubicBezTo>
                      <a:pt x="76" y="299"/>
                      <a:pt x="95" y="337"/>
                      <a:pt x="133" y="365"/>
                    </a:cubicBezTo>
                    <a:cubicBezTo>
                      <a:pt x="171" y="393"/>
                      <a:pt x="222" y="407"/>
                      <a:pt x="287" y="407"/>
                    </a:cubicBezTo>
                    <a:cubicBezTo>
                      <a:pt x="353" y="407"/>
                      <a:pt x="404" y="394"/>
                      <a:pt x="442" y="366"/>
                    </a:cubicBezTo>
                    <a:cubicBezTo>
                      <a:pt x="480" y="338"/>
                      <a:pt x="498" y="300"/>
                      <a:pt x="498" y="251"/>
                    </a:cubicBezTo>
                    <a:cubicBezTo>
                      <a:pt x="498" y="203"/>
                      <a:pt x="480" y="165"/>
                      <a:pt x="442" y="137"/>
                    </a:cubicBezTo>
                    <a:cubicBezTo>
                      <a:pt x="404" y="109"/>
                      <a:pt x="353" y="95"/>
                      <a:pt x="287" y="95"/>
                    </a:cubicBezTo>
                    <a:cubicBezTo>
                      <a:pt x="223" y="95"/>
                      <a:pt x="171" y="109"/>
                      <a:pt x="133" y="137"/>
                    </a:cubicBezTo>
                    <a:cubicBezTo>
                      <a:pt x="95" y="165"/>
                      <a:pt x="76" y="203"/>
                      <a:pt x="76" y="251"/>
                    </a:cubicBezTo>
                    <a:close/>
                    <a:moveTo>
                      <a:pt x="0" y="251"/>
                    </a:moveTo>
                    <a:cubicBezTo>
                      <a:pt x="0" y="173"/>
                      <a:pt x="26" y="112"/>
                      <a:pt x="76" y="67"/>
                    </a:cubicBezTo>
                    <a:cubicBezTo>
                      <a:pt x="127" y="23"/>
                      <a:pt x="197" y="0"/>
                      <a:pt x="287" y="0"/>
                    </a:cubicBezTo>
                    <a:cubicBezTo>
                      <a:pt x="377" y="0"/>
                      <a:pt x="447" y="23"/>
                      <a:pt x="497" y="67"/>
                    </a:cubicBezTo>
                    <a:cubicBezTo>
                      <a:pt x="548" y="112"/>
                      <a:pt x="573" y="173"/>
                      <a:pt x="573" y="251"/>
                    </a:cubicBezTo>
                    <a:cubicBezTo>
                      <a:pt x="573" y="330"/>
                      <a:pt x="548" y="392"/>
                      <a:pt x="497" y="436"/>
                    </a:cubicBezTo>
                    <a:cubicBezTo>
                      <a:pt x="447" y="480"/>
                      <a:pt x="377" y="502"/>
                      <a:pt x="287" y="502"/>
                    </a:cubicBezTo>
                    <a:cubicBezTo>
                      <a:pt x="197" y="502"/>
                      <a:pt x="127" y="480"/>
                      <a:pt x="76" y="436"/>
                    </a:cubicBezTo>
                    <a:cubicBezTo>
                      <a:pt x="26" y="392"/>
                      <a:pt x="0" y="330"/>
                      <a:pt x="0" y="251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49" name="Freeform 376">
                <a:extLst>
                  <a:ext uri="{FF2B5EF4-FFF2-40B4-BE49-F238E27FC236}">
                    <a16:creationId xmlns:a16="http://schemas.microsoft.com/office/drawing/2014/main" id="{2089FC4D-29A9-5B3C-9DA6-A5B8C08684F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76513" y="3221038"/>
                <a:ext cx="100013" cy="82550"/>
              </a:xfrm>
              <a:custGeom>
                <a:avLst/>
                <a:gdLst>
                  <a:gd name="T0" fmla="*/ 230 w 560"/>
                  <a:gd name="T1" fmla="*/ 0 h 458"/>
                  <a:gd name="T2" fmla="*/ 560 w 560"/>
                  <a:gd name="T3" fmla="*/ 0 h 458"/>
                  <a:gd name="T4" fmla="*/ 560 w 560"/>
                  <a:gd name="T5" fmla="*/ 90 h 458"/>
                  <a:gd name="T6" fmla="*/ 233 w 560"/>
                  <a:gd name="T7" fmla="*/ 90 h 458"/>
                  <a:gd name="T8" fmla="*/ 117 w 560"/>
                  <a:gd name="T9" fmla="*/ 121 h 458"/>
                  <a:gd name="T10" fmla="*/ 78 w 560"/>
                  <a:gd name="T11" fmla="*/ 211 h 458"/>
                  <a:gd name="T12" fmla="*/ 125 w 560"/>
                  <a:gd name="T13" fmla="*/ 326 h 458"/>
                  <a:gd name="T14" fmla="*/ 251 w 560"/>
                  <a:gd name="T15" fmla="*/ 368 h 458"/>
                  <a:gd name="T16" fmla="*/ 560 w 560"/>
                  <a:gd name="T17" fmla="*/ 368 h 458"/>
                  <a:gd name="T18" fmla="*/ 560 w 560"/>
                  <a:gd name="T19" fmla="*/ 458 h 458"/>
                  <a:gd name="T20" fmla="*/ 13 w 560"/>
                  <a:gd name="T21" fmla="*/ 458 h 458"/>
                  <a:gd name="T22" fmla="*/ 13 w 560"/>
                  <a:gd name="T23" fmla="*/ 368 h 458"/>
                  <a:gd name="T24" fmla="*/ 98 w 560"/>
                  <a:gd name="T25" fmla="*/ 368 h 458"/>
                  <a:gd name="T26" fmla="*/ 25 w 560"/>
                  <a:gd name="T27" fmla="*/ 292 h 458"/>
                  <a:gd name="T28" fmla="*/ 0 w 560"/>
                  <a:gd name="T29" fmla="*/ 191 h 458"/>
                  <a:gd name="T30" fmla="*/ 59 w 560"/>
                  <a:gd name="T31" fmla="*/ 49 h 458"/>
                  <a:gd name="T32" fmla="*/ 230 w 560"/>
                  <a:gd name="T33" fmla="*/ 0 h 4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560" h="458">
                    <a:moveTo>
                      <a:pt x="230" y="0"/>
                    </a:moveTo>
                    <a:lnTo>
                      <a:pt x="560" y="0"/>
                    </a:lnTo>
                    <a:lnTo>
                      <a:pt x="560" y="90"/>
                    </a:lnTo>
                    <a:lnTo>
                      <a:pt x="233" y="90"/>
                    </a:lnTo>
                    <a:cubicBezTo>
                      <a:pt x="181" y="90"/>
                      <a:pt x="143" y="101"/>
                      <a:pt x="117" y="121"/>
                    </a:cubicBezTo>
                    <a:cubicBezTo>
                      <a:pt x="91" y="141"/>
                      <a:pt x="78" y="171"/>
                      <a:pt x="78" y="211"/>
                    </a:cubicBezTo>
                    <a:cubicBezTo>
                      <a:pt x="78" y="260"/>
                      <a:pt x="94" y="298"/>
                      <a:pt x="125" y="326"/>
                    </a:cubicBezTo>
                    <a:cubicBezTo>
                      <a:pt x="156" y="354"/>
                      <a:pt x="198" y="368"/>
                      <a:pt x="251" y="368"/>
                    </a:cubicBezTo>
                    <a:lnTo>
                      <a:pt x="560" y="368"/>
                    </a:lnTo>
                    <a:lnTo>
                      <a:pt x="560" y="458"/>
                    </a:lnTo>
                    <a:lnTo>
                      <a:pt x="13" y="458"/>
                    </a:lnTo>
                    <a:lnTo>
                      <a:pt x="13" y="368"/>
                    </a:lnTo>
                    <a:lnTo>
                      <a:pt x="98" y="368"/>
                    </a:lnTo>
                    <a:cubicBezTo>
                      <a:pt x="66" y="347"/>
                      <a:pt x="41" y="322"/>
                      <a:pt x="25" y="292"/>
                    </a:cubicBezTo>
                    <a:cubicBezTo>
                      <a:pt x="9" y="263"/>
                      <a:pt x="0" y="229"/>
                      <a:pt x="0" y="191"/>
                    </a:cubicBezTo>
                    <a:cubicBezTo>
                      <a:pt x="0" y="129"/>
                      <a:pt x="20" y="81"/>
                      <a:pt x="59" y="49"/>
                    </a:cubicBezTo>
                    <a:cubicBezTo>
                      <a:pt x="98" y="17"/>
                      <a:pt x="155" y="0"/>
                      <a:pt x="230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50" name="Freeform 377">
                <a:extLst>
                  <a:ext uri="{FF2B5EF4-FFF2-40B4-BE49-F238E27FC236}">
                    <a16:creationId xmlns:a16="http://schemas.microsoft.com/office/drawing/2014/main" id="{F5B5E885-ED8D-3AB7-05AE-063E5BFA9C7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0000" y="3092450"/>
                <a:ext cx="160338" cy="41275"/>
              </a:xfrm>
              <a:custGeom>
                <a:avLst/>
                <a:gdLst>
                  <a:gd name="T0" fmla="*/ 0 w 890"/>
                  <a:gd name="T1" fmla="*/ 0 h 224"/>
                  <a:gd name="T2" fmla="*/ 223 w 890"/>
                  <a:gd name="T3" fmla="*/ 97 h 224"/>
                  <a:gd name="T4" fmla="*/ 445 w 890"/>
                  <a:gd name="T5" fmla="*/ 129 h 224"/>
                  <a:gd name="T6" fmla="*/ 668 w 890"/>
                  <a:gd name="T7" fmla="*/ 97 h 224"/>
                  <a:gd name="T8" fmla="*/ 890 w 890"/>
                  <a:gd name="T9" fmla="*/ 0 h 224"/>
                  <a:gd name="T10" fmla="*/ 890 w 890"/>
                  <a:gd name="T11" fmla="*/ 78 h 224"/>
                  <a:gd name="T12" fmla="*/ 665 w 890"/>
                  <a:gd name="T13" fmla="*/ 188 h 224"/>
                  <a:gd name="T14" fmla="*/ 445 w 890"/>
                  <a:gd name="T15" fmla="*/ 224 h 224"/>
                  <a:gd name="T16" fmla="*/ 226 w 890"/>
                  <a:gd name="T17" fmla="*/ 188 h 224"/>
                  <a:gd name="T18" fmla="*/ 0 w 890"/>
                  <a:gd name="T19" fmla="*/ 78 h 224"/>
                  <a:gd name="T20" fmla="*/ 0 w 890"/>
                  <a:gd name="T21" fmla="*/ 0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890" h="224">
                    <a:moveTo>
                      <a:pt x="0" y="0"/>
                    </a:moveTo>
                    <a:cubicBezTo>
                      <a:pt x="76" y="44"/>
                      <a:pt x="150" y="76"/>
                      <a:pt x="223" y="97"/>
                    </a:cubicBezTo>
                    <a:cubicBezTo>
                      <a:pt x="296" y="119"/>
                      <a:pt x="370" y="129"/>
                      <a:pt x="445" y="129"/>
                    </a:cubicBezTo>
                    <a:cubicBezTo>
                      <a:pt x="521" y="129"/>
                      <a:pt x="595" y="119"/>
                      <a:pt x="668" y="97"/>
                    </a:cubicBezTo>
                    <a:cubicBezTo>
                      <a:pt x="742" y="76"/>
                      <a:pt x="815" y="44"/>
                      <a:pt x="890" y="0"/>
                    </a:cubicBezTo>
                    <a:lnTo>
                      <a:pt x="890" y="78"/>
                    </a:lnTo>
                    <a:cubicBezTo>
                      <a:pt x="813" y="127"/>
                      <a:pt x="739" y="164"/>
                      <a:pt x="665" y="188"/>
                    </a:cubicBezTo>
                    <a:cubicBezTo>
                      <a:pt x="591" y="212"/>
                      <a:pt x="518" y="224"/>
                      <a:pt x="445" y="224"/>
                    </a:cubicBezTo>
                    <a:cubicBezTo>
                      <a:pt x="373" y="224"/>
                      <a:pt x="300" y="212"/>
                      <a:pt x="226" y="188"/>
                    </a:cubicBezTo>
                    <a:cubicBezTo>
                      <a:pt x="152" y="164"/>
                      <a:pt x="77" y="128"/>
                      <a:pt x="0" y="78"/>
                    </a:cubicBez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51" name="Freeform 378">
                <a:extLst>
                  <a:ext uri="{FF2B5EF4-FFF2-40B4-BE49-F238E27FC236}">
                    <a16:creationId xmlns:a16="http://schemas.microsoft.com/office/drawing/2014/main" id="{C3951AE4-320D-7DE0-16DC-6ACDB54361C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2984500"/>
                <a:ext cx="103188" cy="82550"/>
              </a:xfrm>
              <a:custGeom>
                <a:avLst/>
                <a:gdLst>
                  <a:gd name="T0" fmla="*/ 285 w 573"/>
                  <a:gd name="T1" fmla="*/ 179 h 462"/>
                  <a:gd name="T2" fmla="*/ 310 w 573"/>
                  <a:gd name="T3" fmla="*/ 330 h 462"/>
                  <a:gd name="T4" fmla="*/ 395 w 573"/>
                  <a:gd name="T5" fmla="*/ 372 h 462"/>
                  <a:gd name="T6" fmla="*/ 471 w 573"/>
                  <a:gd name="T7" fmla="*/ 341 h 462"/>
                  <a:gd name="T8" fmla="*/ 499 w 573"/>
                  <a:gd name="T9" fmla="*/ 255 h 462"/>
                  <a:gd name="T10" fmla="*/ 446 w 573"/>
                  <a:gd name="T11" fmla="*/ 135 h 462"/>
                  <a:gd name="T12" fmla="*/ 305 w 573"/>
                  <a:gd name="T13" fmla="*/ 90 h 462"/>
                  <a:gd name="T14" fmla="*/ 285 w 573"/>
                  <a:gd name="T15" fmla="*/ 90 h 462"/>
                  <a:gd name="T16" fmla="*/ 285 w 573"/>
                  <a:gd name="T17" fmla="*/ 179 h 462"/>
                  <a:gd name="T18" fmla="*/ 248 w 573"/>
                  <a:gd name="T19" fmla="*/ 0 h 462"/>
                  <a:gd name="T20" fmla="*/ 560 w 573"/>
                  <a:gd name="T21" fmla="*/ 0 h 462"/>
                  <a:gd name="T22" fmla="*/ 560 w 573"/>
                  <a:gd name="T23" fmla="*/ 90 h 462"/>
                  <a:gd name="T24" fmla="*/ 477 w 573"/>
                  <a:gd name="T25" fmla="*/ 90 h 462"/>
                  <a:gd name="T26" fmla="*/ 550 w 573"/>
                  <a:gd name="T27" fmla="*/ 167 h 462"/>
                  <a:gd name="T28" fmla="*/ 573 w 573"/>
                  <a:gd name="T29" fmla="*/ 279 h 462"/>
                  <a:gd name="T30" fmla="*/ 527 w 573"/>
                  <a:gd name="T31" fmla="*/ 413 h 462"/>
                  <a:gd name="T32" fmla="*/ 401 w 573"/>
                  <a:gd name="T33" fmla="*/ 462 h 462"/>
                  <a:gd name="T34" fmla="*/ 262 w 573"/>
                  <a:gd name="T35" fmla="*/ 400 h 462"/>
                  <a:gd name="T36" fmla="*/ 215 w 573"/>
                  <a:gd name="T37" fmla="*/ 216 h 462"/>
                  <a:gd name="T38" fmla="*/ 215 w 573"/>
                  <a:gd name="T39" fmla="*/ 90 h 462"/>
                  <a:gd name="T40" fmla="*/ 206 w 573"/>
                  <a:gd name="T41" fmla="*/ 90 h 462"/>
                  <a:gd name="T42" fmla="*/ 110 w 573"/>
                  <a:gd name="T43" fmla="*/ 131 h 462"/>
                  <a:gd name="T44" fmla="*/ 76 w 573"/>
                  <a:gd name="T45" fmla="*/ 245 h 462"/>
                  <a:gd name="T46" fmla="*/ 88 w 573"/>
                  <a:gd name="T47" fmla="*/ 337 h 462"/>
                  <a:gd name="T48" fmla="*/ 121 w 573"/>
                  <a:gd name="T49" fmla="*/ 422 h 462"/>
                  <a:gd name="T50" fmla="*/ 38 w 573"/>
                  <a:gd name="T51" fmla="*/ 422 h 462"/>
                  <a:gd name="T52" fmla="*/ 10 w 573"/>
                  <a:gd name="T53" fmla="*/ 327 h 462"/>
                  <a:gd name="T54" fmla="*/ 0 w 573"/>
                  <a:gd name="T55" fmla="*/ 236 h 462"/>
                  <a:gd name="T56" fmla="*/ 62 w 573"/>
                  <a:gd name="T57" fmla="*/ 59 h 462"/>
                  <a:gd name="T58" fmla="*/ 248 w 573"/>
                  <a:gd name="T59" fmla="*/ 0 h 4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573" h="462">
                    <a:moveTo>
                      <a:pt x="285" y="179"/>
                    </a:moveTo>
                    <a:cubicBezTo>
                      <a:pt x="285" y="252"/>
                      <a:pt x="294" y="302"/>
                      <a:pt x="310" y="330"/>
                    </a:cubicBezTo>
                    <a:cubicBezTo>
                      <a:pt x="327" y="358"/>
                      <a:pt x="355" y="372"/>
                      <a:pt x="395" y="372"/>
                    </a:cubicBezTo>
                    <a:cubicBezTo>
                      <a:pt x="427" y="372"/>
                      <a:pt x="453" y="362"/>
                      <a:pt x="471" y="341"/>
                    </a:cubicBezTo>
                    <a:cubicBezTo>
                      <a:pt x="490" y="320"/>
                      <a:pt x="499" y="291"/>
                      <a:pt x="499" y="255"/>
                    </a:cubicBezTo>
                    <a:cubicBezTo>
                      <a:pt x="499" y="205"/>
                      <a:pt x="482" y="165"/>
                      <a:pt x="446" y="135"/>
                    </a:cubicBezTo>
                    <a:cubicBezTo>
                      <a:pt x="411" y="105"/>
                      <a:pt x="364" y="90"/>
                      <a:pt x="305" y="90"/>
                    </a:cubicBezTo>
                    <a:lnTo>
                      <a:pt x="285" y="90"/>
                    </a:lnTo>
                    <a:lnTo>
                      <a:pt x="285" y="179"/>
                    </a:lnTo>
                    <a:close/>
                    <a:moveTo>
                      <a:pt x="248" y="0"/>
                    </a:moveTo>
                    <a:lnTo>
                      <a:pt x="560" y="0"/>
                    </a:lnTo>
                    <a:lnTo>
                      <a:pt x="560" y="90"/>
                    </a:lnTo>
                    <a:lnTo>
                      <a:pt x="477" y="90"/>
                    </a:lnTo>
                    <a:cubicBezTo>
                      <a:pt x="511" y="111"/>
                      <a:pt x="535" y="137"/>
                      <a:pt x="550" y="167"/>
                    </a:cubicBezTo>
                    <a:cubicBezTo>
                      <a:pt x="565" y="197"/>
                      <a:pt x="573" y="235"/>
                      <a:pt x="573" y="279"/>
                    </a:cubicBezTo>
                    <a:cubicBezTo>
                      <a:pt x="573" y="335"/>
                      <a:pt x="558" y="380"/>
                      <a:pt x="527" y="413"/>
                    </a:cubicBezTo>
                    <a:cubicBezTo>
                      <a:pt x="496" y="446"/>
                      <a:pt x="454" y="462"/>
                      <a:pt x="401" y="462"/>
                    </a:cubicBezTo>
                    <a:cubicBezTo>
                      <a:pt x="340" y="462"/>
                      <a:pt x="294" y="442"/>
                      <a:pt x="262" y="400"/>
                    </a:cubicBezTo>
                    <a:cubicBezTo>
                      <a:pt x="231" y="359"/>
                      <a:pt x="215" y="298"/>
                      <a:pt x="215" y="216"/>
                    </a:cubicBezTo>
                    <a:lnTo>
                      <a:pt x="215" y="90"/>
                    </a:lnTo>
                    <a:lnTo>
                      <a:pt x="206" y="90"/>
                    </a:lnTo>
                    <a:cubicBezTo>
                      <a:pt x="165" y="90"/>
                      <a:pt x="133" y="104"/>
                      <a:pt x="110" y="131"/>
                    </a:cubicBezTo>
                    <a:cubicBezTo>
                      <a:pt x="88" y="158"/>
                      <a:pt x="76" y="196"/>
                      <a:pt x="76" y="245"/>
                    </a:cubicBezTo>
                    <a:cubicBezTo>
                      <a:pt x="76" y="277"/>
                      <a:pt x="80" y="307"/>
                      <a:pt x="88" y="337"/>
                    </a:cubicBezTo>
                    <a:cubicBezTo>
                      <a:pt x="96" y="367"/>
                      <a:pt x="107" y="395"/>
                      <a:pt x="121" y="422"/>
                    </a:cubicBezTo>
                    <a:lnTo>
                      <a:pt x="38" y="422"/>
                    </a:lnTo>
                    <a:cubicBezTo>
                      <a:pt x="26" y="390"/>
                      <a:pt x="16" y="358"/>
                      <a:pt x="10" y="327"/>
                    </a:cubicBezTo>
                    <a:cubicBezTo>
                      <a:pt x="4" y="296"/>
                      <a:pt x="0" y="266"/>
                      <a:pt x="0" y="236"/>
                    </a:cubicBezTo>
                    <a:cubicBezTo>
                      <a:pt x="0" y="157"/>
                      <a:pt x="21" y="98"/>
                      <a:pt x="62" y="59"/>
                    </a:cubicBezTo>
                    <a:cubicBezTo>
                      <a:pt x="103" y="20"/>
                      <a:pt x="165" y="0"/>
                      <a:pt x="248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52" name="Rectangle 379">
                <a:extLst>
                  <a:ext uri="{FF2B5EF4-FFF2-40B4-BE49-F238E27FC236}">
                    <a16:creationId xmlns:a16="http://schemas.microsoft.com/office/drawing/2014/main" id="{930BC517-B075-FD66-E209-6A817A434C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54300" y="2930525"/>
                <a:ext cx="22225" cy="17463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53" name="Freeform 380">
                <a:extLst>
                  <a:ext uri="{FF2B5EF4-FFF2-40B4-BE49-F238E27FC236}">
                    <a16:creationId xmlns:a16="http://schemas.microsoft.com/office/drawing/2014/main" id="{4D6562BC-805B-FC81-2123-7FE37604C85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76513" y="2813050"/>
                <a:ext cx="103188" cy="82550"/>
              </a:xfrm>
              <a:custGeom>
                <a:avLst/>
                <a:gdLst>
                  <a:gd name="T0" fmla="*/ 344 w 573"/>
                  <a:gd name="T1" fmla="*/ 458 h 458"/>
                  <a:gd name="T2" fmla="*/ 13 w 573"/>
                  <a:gd name="T3" fmla="*/ 458 h 458"/>
                  <a:gd name="T4" fmla="*/ 13 w 573"/>
                  <a:gd name="T5" fmla="*/ 368 h 458"/>
                  <a:gd name="T6" fmla="*/ 341 w 573"/>
                  <a:gd name="T7" fmla="*/ 368 h 458"/>
                  <a:gd name="T8" fmla="*/ 457 w 573"/>
                  <a:gd name="T9" fmla="*/ 338 h 458"/>
                  <a:gd name="T10" fmla="*/ 496 w 573"/>
                  <a:gd name="T11" fmla="*/ 247 h 458"/>
                  <a:gd name="T12" fmla="*/ 450 w 573"/>
                  <a:gd name="T13" fmla="*/ 132 h 458"/>
                  <a:gd name="T14" fmla="*/ 323 w 573"/>
                  <a:gd name="T15" fmla="*/ 90 h 458"/>
                  <a:gd name="T16" fmla="*/ 13 w 573"/>
                  <a:gd name="T17" fmla="*/ 90 h 458"/>
                  <a:gd name="T18" fmla="*/ 13 w 573"/>
                  <a:gd name="T19" fmla="*/ 0 h 458"/>
                  <a:gd name="T20" fmla="*/ 560 w 573"/>
                  <a:gd name="T21" fmla="*/ 0 h 458"/>
                  <a:gd name="T22" fmla="*/ 560 w 573"/>
                  <a:gd name="T23" fmla="*/ 90 h 458"/>
                  <a:gd name="T24" fmla="*/ 476 w 573"/>
                  <a:gd name="T25" fmla="*/ 90 h 458"/>
                  <a:gd name="T26" fmla="*/ 550 w 573"/>
                  <a:gd name="T27" fmla="*/ 166 h 458"/>
                  <a:gd name="T28" fmla="*/ 573 w 573"/>
                  <a:gd name="T29" fmla="*/ 266 h 458"/>
                  <a:gd name="T30" fmla="*/ 515 w 573"/>
                  <a:gd name="T31" fmla="*/ 409 h 458"/>
                  <a:gd name="T32" fmla="*/ 344 w 573"/>
                  <a:gd name="T33" fmla="*/ 458 h 458"/>
                  <a:gd name="T34" fmla="*/ 0 w 573"/>
                  <a:gd name="T35" fmla="*/ 232 h 458"/>
                  <a:gd name="T36" fmla="*/ 1 w 573"/>
                  <a:gd name="T37" fmla="*/ 232 h 458"/>
                  <a:gd name="T38" fmla="*/ 0 w 573"/>
                  <a:gd name="T39" fmla="*/ 232 h 4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573" h="458">
                    <a:moveTo>
                      <a:pt x="344" y="458"/>
                    </a:moveTo>
                    <a:lnTo>
                      <a:pt x="13" y="458"/>
                    </a:lnTo>
                    <a:lnTo>
                      <a:pt x="13" y="368"/>
                    </a:lnTo>
                    <a:lnTo>
                      <a:pt x="341" y="368"/>
                    </a:lnTo>
                    <a:cubicBezTo>
                      <a:pt x="393" y="368"/>
                      <a:pt x="431" y="358"/>
                      <a:pt x="457" y="338"/>
                    </a:cubicBezTo>
                    <a:cubicBezTo>
                      <a:pt x="483" y="318"/>
                      <a:pt x="496" y="288"/>
                      <a:pt x="496" y="247"/>
                    </a:cubicBezTo>
                    <a:cubicBezTo>
                      <a:pt x="496" y="199"/>
                      <a:pt x="481" y="160"/>
                      <a:pt x="450" y="132"/>
                    </a:cubicBezTo>
                    <a:cubicBezTo>
                      <a:pt x="419" y="104"/>
                      <a:pt x="377" y="90"/>
                      <a:pt x="323" y="90"/>
                    </a:cubicBezTo>
                    <a:lnTo>
                      <a:pt x="13" y="90"/>
                    </a:lnTo>
                    <a:lnTo>
                      <a:pt x="13" y="0"/>
                    </a:lnTo>
                    <a:lnTo>
                      <a:pt x="560" y="0"/>
                    </a:lnTo>
                    <a:lnTo>
                      <a:pt x="560" y="90"/>
                    </a:lnTo>
                    <a:lnTo>
                      <a:pt x="476" y="90"/>
                    </a:lnTo>
                    <a:cubicBezTo>
                      <a:pt x="510" y="112"/>
                      <a:pt x="534" y="138"/>
                      <a:pt x="550" y="166"/>
                    </a:cubicBezTo>
                    <a:cubicBezTo>
                      <a:pt x="565" y="195"/>
                      <a:pt x="573" y="228"/>
                      <a:pt x="573" y="266"/>
                    </a:cubicBezTo>
                    <a:cubicBezTo>
                      <a:pt x="573" y="329"/>
                      <a:pt x="554" y="377"/>
                      <a:pt x="515" y="409"/>
                    </a:cubicBezTo>
                    <a:cubicBezTo>
                      <a:pt x="477" y="442"/>
                      <a:pt x="420" y="458"/>
                      <a:pt x="344" y="458"/>
                    </a:cubicBezTo>
                    <a:close/>
                    <a:moveTo>
                      <a:pt x="0" y="232"/>
                    </a:moveTo>
                    <a:lnTo>
                      <a:pt x="1" y="232"/>
                    </a:lnTo>
                    <a:lnTo>
                      <a:pt x="0" y="232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54" name="Rectangle 381">
                <a:extLst>
                  <a:ext uri="{FF2B5EF4-FFF2-40B4-BE49-F238E27FC236}">
                    <a16:creationId xmlns:a16="http://schemas.microsoft.com/office/drawing/2014/main" id="{7459A4FF-B7EC-E05E-05B2-583C0D3C93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54300" y="2757488"/>
                <a:ext cx="22225" cy="19050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55" name="Freeform 382">
                <a:extLst>
                  <a:ext uri="{FF2B5EF4-FFF2-40B4-BE49-F238E27FC236}">
                    <a16:creationId xmlns:a16="http://schemas.microsoft.com/office/drawing/2014/main" id="{635455D5-12F5-42CE-8422-0E4079894BE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0000" y="2684463"/>
                <a:ext cx="160338" cy="39688"/>
              </a:xfrm>
              <a:custGeom>
                <a:avLst/>
                <a:gdLst>
                  <a:gd name="T0" fmla="*/ 0 w 890"/>
                  <a:gd name="T1" fmla="*/ 224 h 224"/>
                  <a:gd name="T2" fmla="*/ 0 w 890"/>
                  <a:gd name="T3" fmla="*/ 146 h 224"/>
                  <a:gd name="T4" fmla="*/ 226 w 890"/>
                  <a:gd name="T5" fmla="*/ 37 h 224"/>
                  <a:gd name="T6" fmla="*/ 445 w 890"/>
                  <a:gd name="T7" fmla="*/ 0 h 224"/>
                  <a:gd name="T8" fmla="*/ 665 w 890"/>
                  <a:gd name="T9" fmla="*/ 37 h 224"/>
                  <a:gd name="T10" fmla="*/ 890 w 890"/>
                  <a:gd name="T11" fmla="*/ 146 h 224"/>
                  <a:gd name="T12" fmla="*/ 890 w 890"/>
                  <a:gd name="T13" fmla="*/ 224 h 224"/>
                  <a:gd name="T14" fmla="*/ 668 w 890"/>
                  <a:gd name="T15" fmla="*/ 127 h 224"/>
                  <a:gd name="T16" fmla="*/ 445 w 890"/>
                  <a:gd name="T17" fmla="*/ 95 h 224"/>
                  <a:gd name="T18" fmla="*/ 223 w 890"/>
                  <a:gd name="T19" fmla="*/ 127 h 224"/>
                  <a:gd name="T20" fmla="*/ 0 w 890"/>
                  <a:gd name="T21" fmla="*/ 224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890" h="224">
                    <a:moveTo>
                      <a:pt x="0" y="224"/>
                    </a:moveTo>
                    <a:lnTo>
                      <a:pt x="0" y="146"/>
                    </a:lnTo>
                    <a:cubicBezTo>
                      <a:pt x="77" y="98"/>
                      <a:pt x="152" y="61"/>
                      <a:pt x="226" y="37"/>
                    </a:cubicBezTo>
                    <a:cubicBezTo>
                      <a:pt x="300" y="13"/>
                      <a:pt x="373" y="0"/>
                      <a:pt x="445" y="0"/>
                    </a:cubicBezTo>
                    <a:cubicBezTo>
                      <a:pt x="518" y="0"/>
                      <a:pt x="591" y="13"/>
                      <a:pt x="665" y="37"/>
                    </a:cubicBezTo>
                    <a:cubicBezTo>
                      <a:pt x="739" y="61"/>
                      <a:pt x="813" y="98"/>
                      <a:pt x="890" y="146"/>
                    </a:cubicBezTo>
                    <a:lnTo>
                      <a:pt x="890" y="224"/>
                    </a:lnTo>
                    <a:cubicBezTo>
                      <a:pt x="815" y="181"/>
                      <a:pt x="742" y="149"/>
                      <a:pt x="668" y="127"/>
                    </a:cubicBezTo>
                    <a:cubicBezTo>
                      <a:pt x="595" y="106"/>
                      <a:pt x="521" y="95"/>
                      <a:pt x="445" y="95"/>
                    </a:cubicBezTo>
                    <a:cubicBezTo>
                      <a:pt x="370" y="95"/>
                      <a:pt x="296" y="106"/>
                      <a:pt x="223" y="127"/>
                    </a:cubicBezTo>
                    <a:cubicBezTo>
                      <a:pt x="150" y="149"/>
                      <a:pt x="76" y="181"/>
                      <a:pt x="0" y="224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pic>
            <p:nvPicPr>
              <p:cNvPr id="1656" name="Picture 383">
                <a:extLst>
                  <a:ext uri="{FF2B5EF4-FFF2-40B4-BE49-F238E27FC236}">
                    <a16:creationId xmlns:a16="http://schemas.microsoft.com/office/drawing/2014/main" id="{D3753479-01AA-0937-638B-AF44715D708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62313" y="4627563"/>
                <a:ext cx="3043238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657" name="Picture 384">
                <a:extLst>
                  <a:ext uri="{FF2B5EF4-FFF2-40B4-BE49-F238E27FC236}">
                    <a16:creationId xmlns:a16="http://schemas.microsoft.com/office/drawing/2014/main" id="{B810481E-BAC6-6B49-CDC4-FC8A5929438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60725" y="2636838"/>
                <a:ext cx="3044825" cy="22018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658" name="Freeform 385">
                <a:extLst>
                  <a:ext uri="{FF2B5EF4-FFF2-40B4-BE49-F238E27FC236}">
                    <a16:creationId xmlns:a16="http://schemas.microsoft.com/office/drawing/2014/main" id="{99E0DAD3-B651-A9EA-4150-6DDE315C38C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73425" y="4643438"/>
                <a:ext cx="3022600" cy="185738"/>
              </a:xfrm>
              <a:custGeom>
                <a:avLst/>
                <a:gdLst>
                  <a:gd name="T0" fmla="*/ 0 w 16786"/>
                  <a:gd name="T1" fmla="*/ 0 h 1031"/>
                  <a:gd name="T2" fmla="*/ 5595 w 16786"/>
                  <a:gd name="T3" fmla="*/ 940 h 1031"/>
                  <a:gd name="T4" fmla="*/ 11191 w 16786"/>
                  <a:gd name="T5" fmla="*/ 1031 h 1031"/>
                  <a:gd name="T6" fmla="*/ 16786 w 16786"/>
                  <a:gd name="T7" fmla="*/ 1031 h 10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6786" h="1031">
                    <a:moveTo>
                      <a:pt x="0" y="0"/>
                    </a:moveTo>
                    <a:lnTo>
                      <a:pt x="5595" y="940"/>
                    </a:lnTo>
                    <a:lnTo>
                      <a:pt x="11191" y="1031"/>
                    </a:lnTo>
                    <a:lnTo>
                      <a:pt x="16786" y="1031"/>
                    </a:lnTo>
                  </a:path>
                </a:pathLst>
              </a:custGeom>
              <a:noFill/>
              <a:ln w="6350" cap="rnd">
                <a:solidFill>
                  <a:srgbClr val="DD84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59" name="Freeform 386">
                <a:extLst>
                  <a:ext uri="{FF2B5EF4-FFF2-40B4-BE49-F238E27FC236}">
                    <a16:creationId xmlns:a16="http://schemas.microsoft.com/office/drawing/2014/main" id="{141A54D4-B3AD-E174-42FF-63659D01ABF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73425" y="2681288"/>
                <a:ext cx="3022600" cy="2147888"/>
              </a:xfrm>
              <a:custGeom>
                <a:avLst/>
                <a:gdLst>
                  <a:gd name="T0" fmla="*/ 0 w 16786"/>
                  <a:gd name="T1" fmla="*/ 0 h 11905"/>
                  <a:gd name="T2" fmla="*/ 5595 w 16786"/>
                  <a:gd name="T3" fmla="*/ 6093 h 11905"/>
                  <a:gd name="T4" fmla="*/ 11191 w 16786"/>
                  <a:gd name="T5" fmla="*/ 11633 h 11905"/>
                  <a:gd name="T6" fmla="*/ 16786 w 16786"/>
                  <a:gd name="T7" fmla="*/ 11905 h 119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6786" h="11905">
                    <a:moveTo>
                      <a:pt x="0" y="0"/>
                    </a:moveTo>
                    <a:lnTo>
                      <a:pt x="5595" y="6093"/>
                    </a:lnTo>
                    <a:lnTo>
                      <a:pt x="11191" y="11633"/>
                    </a:lnTo>
                    <a:lnTo>
                      <a:pt x="16786" y="11905"/>
                    </a:lnTo>
                  </a:path>
                </a:pathLst>
              </a:custGeom>
              <a:noFill/>
              <a:ln w="6350" cap="rnd">
                <a:solidFill>
                  <a:srgbClr val="C44E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60" name="Line 387">
                <a:extLst>
                  <a:ext uri="{FF2B5EF4-FFF2-40B4-BE49-F238E27FC236}">
                    <a16:creationId xmlns:a16="http://schemas.microsoft.com/office/drawing/2014/main" id="{8F61A13C-6841-74E1-FDE4-D7C28E9314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22613" y="2540000"/>
                <a:ext cx="0" cy="2398713"/>
              </a:xfrm>
              <a:prstGeom prst="line">
                <a:avLst/>
              </a:prstGeom>
              <a:noFill/>
              <a:ln w="6350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61" name="Line 388">
                <a:extLst>
                  <a:ext uri="{FF2B5EF4-FFF2-40B4-BE49-F238E27FC236}">
                    <a16:creationId xmlns:a16="http://schemas.microsoft.com/office/drawing/2014/main" id="{814D24AA-D176-15C7-4A6D-58F215B11A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446838" y="2540000"/>
                <a:ext cx="0" cy="2398713"/>
              </a:xfrm>
              <a:prstGeom prst="line">
                <a:avLst/>
              </a:prstGeom>
              <a:noFill/>
              <a:ln w="6350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62" name="Line 389">
                <a:extLst>
                  <a:ext uri="{FF2B5EF4-FFF2-40B4-BE49-F238E27FC236}">
                    <a16:creationId xmlns:a16="http://schemas.microsoft.com/office/drawing/2014/main" id="{300825EC-F15E-E472-824F-B5C2F2C327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2613" y="4938713"/>
                <a:ext cx="3324225" cy="0"/>
              </a:xfrm>
              <a:prstGeom prst="line">
                <a:avLst/>
              </a:prstGeom>
              <a:noFill/>
              <a:ln w="11113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63" name="Line 390">
                <a:extLst>
                  <a:ext uri="{FF2B5EF4-FFF2-40B4-BE49-F238E27FC236}">
                    <a16:creationId xmlns:a16="http://schemas.microsoft.com/office/drawing/2014/main" id="{461E0F38-4FAE-B3FF-2DF7-18E194F0F6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2613" y="2540000"/>
                <a:ext cx="3324225" cy="0"/>
              </a:xfrm>
              <a:prstGeom prst="line">
                <a:avLst/>
              </a:prstGeom>
              <a:noFill/>
              <a:ln w="6350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pic>
            <p:nvPicPr>
              <p:cNvPr id="1664" name="Picture 391">
                <a:extLst>
                  <a:ext uri="{FF2B5EF4-FFF2-40B4-BE49-F238E27FC236}">
                    <a16:creationId xmlns:a16="http://schemas.microsoft.com/office/drawing/2014/main" id="{5676A2A0-2317-E82C-68A8-A9D26A8E78C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10138" y="2620963"/>
                <a:ext cx="1455738" cy="6016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665" name="Freeform 392">
                <a:extLst>
                  <a:ext uri="{FF2B5EF4-FFF2-40B4-BE49-F238E27FC236}">
                    <a16:creationId xmlns:a16="http://schemas.microsoft.com/office/drawing/2014/main" id="{316A3CD4-9B52-2826-A741-A7C7AD08274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991100" y="2776538"/>
                <a:ext cx="360363" cy="0"/>
              </a:xfrm>
              <a:custGeom>
                <a:avLst/>
                <a:gdLst>
                  <a:gd name="T0" fmla="*/ 0 w 2000"/>
                  <a:gd name="T1" fmla="*/ 1000 w 2000"/>
                  <a:gd name="T2" fmla="*/ 2000 w 200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2000">
                    <a:moveTo>
                      <a:pt x="0" y="0"/>
                    </a:moveTo>
                    <a:lnTo>
                      <a:pt x="1000" y="0"/>
                    </a:lnTo>
                    <a:lnTo>
                      <a:pt x="2000" y="0"/>
                    </a:lnTo>
                  </a:path>
                </a:pathLst>
              </a:custGeom>
              <a:noFill/>
              <a:ln w="6350" cap="rnd">
                <a:solidFill>
                  <a:srgbClr val="DD84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66" name="Freeform 393">
                <a:extLst>
                  <a:ext uri="{FF2B5EF4-FFF2-40B4-BE49-F238E27FC236}">
                    <a16:creationId xmlns:a16="http://schemas.microsoft.com/office/drawing/2014/main" id="{347A6437-C610-4294-990B-DB72EC16FEB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511800" y="2708275"/>
                <a:ext cx="103188" cy="131763"/>
              </a:xfrm>
              <a:custGeom>
                <a:avLst/>
                <a:gdLst>
                  <a:gd name="T0" fmla="*/ 346 w 568"/>
                  <a:gd name="T1" fmla="*/ 387 h 729"/>
                  <a:gd name="T2" fmla="*/ 408 w 568"/>
                  <a:gd name="T3" fmla="*/ 433 h 729"/>
                  <a:gd name="T4" fmla="*/ 468 w 568"/>
                  <a:gd name="T5" fmla="*/ 530 h 729"/>
                  <a:gd name="T6" fmla="*/ 568 w 568"/>
                  <a:gd name="T7" fmla="*/ 729 h 729"/>
                  <a:gd name="T8" fmla="*/ 462 w 568"/>
                  <a:gd name="T9" fmla="*/ 729 h 729"/>
                  <a:gd name="T10" fmla="*/ 369 w 568"/>
                  <a:gd name="T11" fmla="*/ 542 h 729"/>
                  <a:gd name="T12" fmla="*/ 299 w 568"/>
                  <a:gd name="T13" fmla="*/ 445 h 729"/>
                  <a:gd name="T14" fmla="*/ 206 w 568"/>
                  <a:gd name="T15" fmla="*/ 421 h 729"/>
                  <a:gd name="T16" fmla="*/ 99 w 568"/>
                  <a:gd name="T17" fmla="*/ 421 h 729"/>
                  <a:gd name="T18" fmla="*/ 99 w 568"/>
                  <a:gd name="T19" fmla="*/ 729 h 729"/>
                  <a:gd name="T20" fmla="*/ 0 w 568"/>
                  <a:gd name="T21" fmla="*/ 729 h 729"/>
                  <a:gd name="T22" fmla="*/ 0 w 568"/>
                  <a:gd name="T23" fmla="*/ 0 h 729"/>
                  <a:gd name="T24" fmla="*/ 223 w 568"/>
                  <a:gd name="T25" fmla="*/ 0 h 729"/>
                  <a:gd name="T26" fmla="*/ 409 w 568"/>
                  <a:gd name="T27" fmla="*/ 52 h 729"/>
                  <a:gd name="T28" fmla="*/ 471 w 568"/>
                  <a:gd name="T29" fmla="*/ 210 h 729"/>
                  <a:gd name="T30" fmla="*/ 439 w 568"/>
                  <a:gd name="T31" fmla="*/ 325 h 729"/>
                  <a:gd name="T32" fmla="*/ 346 w 568"/>
                  <a:gd name="T33" fmla="*/ 387 h 729"/>
                  <a:gd name="T34" fmla="*/ 99 w 568"/>
                  <a:gd name="T35" fmla="*/ 81 h 729"/>
                  <a:gd name="T36" fmla="*/ 99 w 568"/>
                  <a:gd name="T37" fmla="*/ 340 h 729"/>
                  <a:gd name="T38" fmla="*/ 223 w 568"/>
                  <a:gd name="T39" fmla="*/ 340 h 729"/>
                  <a:gd name="T40" fmla="*/ 330 w 568"/>
                  <a:gd name="T41" fmla="*/ 307 h 729"/>
                  <a:gd name="T42" fmla="*/ 367 w 568"/>
                  <a:gd name="T43" fmla="*/ 210 h 729"/>
                  <a:gd name="T44" fmla="*/ 330 w 568"/>
                  <a:gd name="T45" fmla="*/ 114 h 729"/>
                  <a:gd name="T46" fmla="*/ 223 w 568"/>
                  <a:gd name="T47" fmla="*/ 81 h 729"/>
                  <a:gd name="T48" fmla="*/ 99 w 568"/>
                  <a:gd name="T49" fmla="*/ 81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</a:cxnLst>
                <a:rect l="0" t="0" r="r" b="b"/>
                <a:pathLst>
                  <a:path w="568" h="729">
                    <a:moveTo>
                      <a:pt x="346" y="387"/>
                    </a:moveTo>
                    <a:cubicBezTo>
                      <a:pt x="367" y="395"/>
                      <a:pt x="388" y="410"/>
                      <a:pt x="408" y="433"/>
                    </a:cubicBezTo>
                    <a:cubicBezTo>
                      <a:pt x="428" y="457"/>
                      <a:pt x="448" y="489"/>
                      <a:pt x="468" y="530"/>
                    </a:cubicBezTo>
                    <a:lnTo>
                      <a:pt x="568" y="729"/>
                    </a:lnTo>
                    <a:lnTo>
                      <a:pt x="462" y="729"/>
                    </a:lnTo>
                    <a:lnTo>
                      <a:pt x="369" y="542"/>
                    </a:lnTo>
                    <a:cubicBezTo>
                      <a:pt x="345" y="494"/>
                      <a:pt x="321" y="461"/>
                      <a:pt x="299" y="445"/>
                    </a:cubicBezTo>
                    <a:cubicBezTo>
                      <a:pt x="276" y="429"/>
                      <a:pt x="245" y="421"/>
                      <a:pt x="206" y="421"/>
                    </a:cubicBezTo>
                    <a:lnTo>
                      <a:pt x="99" y="421"/>
                    </a:lnTo>
                    <a:lnTo>
                      <a:pt x="99" y="729"/>
                    </a:lnTo>
                    <a:lnTo>
                      <a:pt x="0" y="729"/>
                    </a:lnTo>
                    <a:lnTo>
                      <a:pt x="0" y="0"/>
                    </a:lnTo>
                    <a:lnTo>
                      <a:pt x="223" y="0"/>
                    </a:lnTo>
                    <a:cubicBezTo>
                      <a:pt x="306" y="0"/>
                      <a:pt x="368" y="18"/>
                      <a:pt x="409" y="52"/>
                    </a:cubicBezTo>
                    <a:cubicBezTo>
                      <a:pt x="450" y="87"/>
                      <a:pt x="471" y="140"/>
                      <a:pt x="471" y="210"/>
                    </a:cubicBezTo>
                    <a:cubicBezTo>
                      <a:pt x="471" y="256"/>
                      <a:pt x="460" y="295"/>
                      <a:pt x="439" y="325"/>
                    </a:cubicBezTo>
                    <a:cubicBezTo>
                      <a:pt x="417" y="355"/>
                      <a:pt x="386" y="376"/>
                      <a:pt x="346" y="387"/>
                    </a:cubicBezTo>
                    <a:close/>
                    <a:moveTo>
                      <a:pt x="99" y="81"/>
                    </a:moveTo>
                    <a:lnTo>
                      <a:pt x="99" y="340"/>
                    </a:lnTo>
                    <a:lnTo>
                      <a:pt x="223" y="340"/>
                    </a:lnTo>
                    <a:cubicBezTo>
                      <a:pt x="270" y="340"/>
                      <a:pt x="306" y="329"/>
                      <a:pt x="330" y="307"/>
                    </a:cubicBezTo>
                    <a:cubicBezTo>
                      <a:pt x="354" y="285"/>
                      <a:pt x="367" y="253"/>
                      <a:pt x="367" y="210"/>
                    </a:cubicBezTo>
                    <a:cubicBezTo>
                      <a:pt x="367" y="168"/>
                      <a:pt x="354" y="136"/>
                      <a:pt x="330" y="114"/>
                    </a:cubicBezTo>
                    <a:cubicBezTo>
                      <a:pt x="306" y="92"/>
                      <a:pt x="270" y="81"/>
                      <a:pt x="223" y="81"/>
                    </a:cubicBezTo>
                    <a:lnTo>
                      <a:pt x="99" y="81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67" name="Freeform 394">
                <a:extLst>
                  <a:ext uri="{FF2B5EF4-FFF2-40B4-BE49-F238E27FC236}">
                    <a16:creationId xmlns:a16="http://schemas.microsoft.com/office/drawing/2014/main" id="{2019AC96-A237-D4EE-307F-6B1C203B2EB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626100" y="2738438"/>
                <a:ext cx="84138" cy="103188"/>
              </a:xfrm>
              <a:custGeom>
                <a:avLst/>
                <a:gdLst>
                  <a:gd name="T0" fmla="*/ 283 w 462"/>
                  <a:gd name="T1" fmla="*/ 285 h 573"/>
                  <a:gd name="T2" fmla="*/ 132 w 462"/>
                  <a:gd name="T3" fmla="*/ 310 h 573"/>
                  <a:gd name="T4" fmla="*/ 90 w 462"/>
                  <a:gd name="T5" fmla="*/ 395 h 573"/>
                  <a:gd name="T6" fmla="*/ 121 w 462"/>
                  <a:gd name="T7" fmla="*/ 471 h 573"/>
                  <a:gd name="T8" fmla="*/ 207 w 462"/>
                  <a:gd name="T9" fmla="*/ 499 h 573"/>
                  <a:gd name="T10" fmla="*/ 327 w 462"/>
                  <a:gd name="T11" fmla="*/ 446 h 573"/>
                  <a:gd name="T12" fmla="*/ 372 w 462"/>
                  <a:gd name="T13" fmla="*/ 305 h 573"/>
                  <a:gd name="T14" fmla="*/ 372 w 462"/>
                  <a:gd name="T15" fmla="*/ 285 h 573"/>
                  <a:gd name="T16" fmla="*/ 283 w 462"/>
                  <a:gd name="T17" fmla="*/ 285 h 573"/>
                  <a:gd name="T18" fmla="*/ 462 w 462"/>
                  <a:gd name="T19" fmla="*/ 248 h 573"/>
                  <a:gd name="T20" fmla="*/ 462 w 462"/>
                  <a:gd name="T21" fmla="*/ 560 h 573"/>
                  <a:gd name="T22" fmla="*/ 372 w 462"/>
                  <a:gd name="T23" fmla="*/ 560 h 573"/>
                  <a:gd name="T24" fmla="*/ 372 w 462"/>
                  <a:gd name="T25" fmla="*/ 477 h 573"/>
                  <a:gd name="T26" fmla="*/ 295 w 462"/>
                  <a:gd name="T27" fmla="*/ 550 h 573"/>
                  <a:gd name="T28" fmla="*/ 183 w 462"/>
                  <a:gd name="T29" fmla="*/ 573 h 573"/>
                  <a:gd name="T30" fmla="*/ 49 w 462"/>
                  <a:gd name="T31" fmla="*/ 527 h 573"/>
                  <a:gd name="T32" fmla="*/ 0 w 462"/>
                  <a:gd name="T33" fmla="*/ 401 h 573"/>
                  <a:gd name="T34" fmla="*/ 62 w 462"/>
                  <a:gd name="T35" fmla="*/ 262 h 573"/>
                  <a:gd name="T36" fmla="*/ 246 w 462"/>
                  <a:gd name="T37" fmla="*/ 215 h 573"/>
                  <a:gd name="T38" fmla="*/ 372 w 462"/>
                  <a:gd name="T39" fmla="*/ 215 h 573"/>
                  <a:gd name="T40" fmla="*/ 372 w 462"/>
                  <a:gd name="T41" fmla="*/ 206 h 573"/>
                  <a:gd name="T42" fmla="*/ 331 w 462"/>
                  <a:gd name="T43" fmla="*/ 110 h 573"/>
                  <a:gd name="T44" fmla="*/ 217 w 462"/>
                  <a:gd name="T45" fmla="*/ 76 h 573"/>
                  <a:gd name="T46" fmla="*/ 125 w 462"/>
                  <a:gd name="T47" fmla="*/ 88 h 573"/>
                  <a:gd name="T48" fmla="*/ 40 w 462"/>
                  <a:gd name="T49" fmla="*/ 121 h 573"/>
                  <a:gd name="T50" fmla="*/ 40 w 462"/>
                  <a:gd name="T51" fmla="*/ 38 h 573"/>
                  <a:gd name="T52" fmla="*/ 135 w 462"/>
                  <a:gd name="T53" fmla="*/ 10 h 573"/>
                  <a:gd name="T54" fmla="*/ 226 w 462"/>
                  <a:gd name="T55" fmla="*/ 0 h 573"/>
                  <a:gd name="T56" fmla="*/ 403 w 462"/>
                  <a:gd name="T57" fmla="*/ 62 h 573"/>
                  <a:gd name="T58" fmla="*/ 462 w 462"/>
                  <a:gd name="T59" fmla="*/ 24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462" h="573">
                    <a:moveTo>
                      <a:pt x="283" y="285"/>
                    </a:moveTo>
                    <a:cubicBezTo>
                      <a:pt x="210" y="285"/>
                      <a:pt x="160" y="294"/>
                      <a:pt x="132" y="310"/>
                    </a:cubicBezTo>
                    <a:cubicBezTo>
                      <a:pt x="104" y="327"/>
                      <a:pt x="90" y="355"/>
                      <a:pt x="90" y="395"/>
                    </a:cubicBezTo>
                    <a:cubicBezTo>
                      <a:pt x="90" y="427"/>
                      <a:pt x="100" y="453"/>
                      <a:pt x="121" y="471"/>
                    </a:cubicBezTo>
                    <a:cubicBezTo>
                      <a:pt x="142" y="490"/>
                      <a:pt x="171" y="499"/>
                      <a:pt x="207" y="499"/>
                    </a:cubicBezTo>
                    <a:cubicBezTo>
                      <a:pt x="257" y="499"/>
                      <a:pt x="297" y="482"/>
                      <a:pt x="327" y="446"/>
                    </a:cubicBezTo>
                    <a:cubicBezTo>
                      <a:pt x="357" y="411"/>
                      <a:pt x="372" y="364"/>
                      <a:pt x="372" y="305"/>
                    </a:cubicBezTo>
                    <a:lnTo>
                      <a:pt x="372" y="285"/>
                    </a:lnTo>
                    <a:lnTo>
                      <a:pt x="283" y="285"/>
                    </a:lnTo>
                    <a:close/>
                    <a:moveTo>
                      <a:pt x="462" y="248"/>
                    </a:moveTo>
                    <a:lnTo>
                      <a:pt x="462" y="560"/>
                    </a:lnTo>
                    <a:lnTo>
                      <a:pt x="372" y="560"/>
                    </a:lnTo>
                    <a:lnTo>
                      <a:pt x="372" y="477"/>
                    </a:lnTo>
                    <a:cubicBezTo>
                      <a:pt x="351" y="511"/>
                      <a:pt x="325" y="535"/>
                      <a:pt x="295" y="550"/>
                    </a:cubicBezTo>
                    <a:cubicBezTo>
                      <a:pt x="265" y="565"/>
                      <a:pt x="227" y="573"/>
                      <a:pt x="183" y="573"/>
                    </a:cubicBezTo>
                    <a:cubicBezTo>
                      <a:pt x="127" y="573"/>
                      <a:pt x="82" y="558"/>
                      <a:pt x="49" y="527"/>
                    </a:cubicBezTo>
                    <a:cubicBezTo>
                      <a:pt x="16" y="496"/>
                      <a:pt x="0" y="454"/>
                      <a:pt x="0" y="401"/>
                    </a:cubicBezTo>
                    <a:cubicBezTo>
                      <a:pt x="0" y="340"/>
                      <a:pt x="20" y="294"/>
                      <a:pt x="62" y="262"/>
                    </a:cubicBezTo>
                    <a:cubicBezTo>
                      <a:pt x="103" y="231"/>
                      <a:pt x="164" y="215"/>
                      <a:pt x="246" y="215"/>
                    </a:cubicBezTo>
                    <a:lnTo>
                      <a:pt x="372" y="215"/>
                    </a:lnTo>
                    <a:lnTo>
                      <a:pt x="372" y="206"/>
                    </a:lnTo>
                    <a:cubicBezTo>
                      <a:pt x="372" y="165"/>
                      <a:pt x="358" y="133"/>
                      <a:pt x="331" y="110"/>
                    </a:cubicBezTo>
                    <a:cubicBezTo>
                      <a:pt x="304" y="88"/>
                      <a:pt x="266" y="76"/>
                      <a:pt x="217" y="76"/>
                    </a:cubicBezTo>
                    <a:cubicBezTo>
                      <a:pt x="185" y="76"/>
                      <a:pt x="155" y="80"/>
                      <a:pt x="125" y="88"/>
                    </a:cubicBezTo>
                    <a:cubicBezTo>
                      <a:pt x="95" y="96"/>
                      <a:pt x="67" y="107"/>
                      <a:pt x="40" y="121"/>
                    </a:cubicBezTo>
                    <a:lnTo>
                      <a:pt x="40" y="38"/>
                    </a:lnTo>
                    <a:cubicBezTo>
                      <a:pt x="72" y="26"/>
                      <a:pt x="104" y="16"/>
                      <a:pt x="135" y="10"/>
                    </a:cubicBezTo>
                    <a:cubicBezTo>
                      <a:pt x="166" y="4"/>
                      <a:pt x="196" y="0"/>
                      <a:pt x="226" y="0"/>
                    </a:cubicBezTo>
                    <a:cubicBezTo>
                      <a:pt x="305" y="0"/>
                      <a:pt x="364" y="21"/>
                      <a:pt x="403" y="62"/>
                    </a:cubicBezTo>
                    <a:cubicBezTo>
                      <a:pt x="442" y="103"/>
                      <a:pt x="462" y="165"/>
                      <a:pt x="462" y="24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68" name="Freeform 395">
                <a:extLst>
                  <a:ext uri="{FF2B5EF4-FFF2-40B4-BE49-F238E27FC236}">
                    <a16:creationId xmlns:a16="http://schemas.microsoft.com/office/drawing/2014/main" id="{A9A1540A-EE07-E9A0-A3C0-2B3412AAF5E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743575" y="2738438"/>
                <a:ext cx="80963" cy="101600"/>
              </a:xfrm>
              <a:custGeom>
                <a:avLst/>
                <a:gdLst>
                  <a:gd name="T0" fmla="*/ 458 w 458"/>
                  <a:gd name="T1" fmla="*/ 230 h 560"/>
                  <a:gd name="T2" fmla="*/ 458 w 458"/>
                  <a:gd name="T3" fmla="*/ 560 h 560"/>
                  <a:gd name="T4" fmla="*/ 368 w 458"/>
                  <a:gd name="T5" fmla="*/ 560 h 560"/>
                  <a:gd name="T6" fmla="*/ 368 w 458"/>
                  <a:gd name="T7" fmla="*/ 233 h 560"/>
                  <a:gd name="T8" fmla="*/ 337 w 458"/>
                  <a:gd name="T9" fmla="*/ 117 h 560"/>
                  <a:gd name="T10" fmla="*/ 247 w 458"/>
                  <a:gd name="T11" fmla="*/ 78 h 560"/>
                  <a:gd name="T12" fmla="*/ 132 w 458"/>
                  <a:gd name="T13" fmla="*/ 125 h 560"/>
                  <a:gd name="T14" fmla="*/ 90 w 458"/>
                  <a:gd name="T15" fmla="*/ 251 h 560"/>
                  <a:gd name="T16" fmla="*/ 90 w 458"/>
                  <a:gd name="T17" fmla="*/ 560 h 560"/>
                  <a:gd name="T18" fmla="*/ 0 w 458"/>
                  <a:gd name="T19" fmla="*/ 560 h 560"/>
                  <a:gd name="T20" fmla="*/ 0 w 458"/>
                  <a:gd name="T21" fmla="*/ 13 h 560"/>
                  <a:gd name="T22" fmla="*/ 90 w 458"/>
                  <a:gd name="T23" fmla="*/ 13 h 560"/>
                  <a:gd name="T24" fmla="*/ 90 w 458"/>
                  <a:gd name="T25" fmla="*/ 98 h 560"/>
                  <a:gd name="T26" fmla="*/ 166 w 458"/>
                  <a:gd name="T27" fmla="*/ 25 h 560"/>
                  <a:gd name="T28" fmla="*/ 267 w 458"/>
                  <a:gd name="T29" fmla="*/ 0 h 560"/>
                  <a:gd name="T30" fmla="*/ 409 w 458"/>
                  <a:gd name="T31" fmla="*/ 59 h 560"/>
                  <a:gd name="T32" fmla="*/ 458 w 458"/>
                  <a:gd name="T33" fmla="*/ 230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58" h="560">
                    <a:moveTo>
                      <a:pt x="458" y="230"/>
                    </a:moveTo>
                    <a:lnTo>
                      <a:pt x="458" y="560"/>
                    </a:lnTo>
                    <a:lnTo>
                      <a:pt x="368" y="560"/>
                    </a:lnTo>
                    <a:lnTo>
                      <a:pt x="368" y="233"/>
                    </a:lnTo>
                    <a:cubicBezTo>
                      <a:pt x="368" y="181"/>
                      <a:pt x="357" y="143"/>
                      <a:pt x="337" y="117"/>
                    </a:cubicBezTo>
                    <a:cubicBezTo>
                      <a:pt x="317" y="91"/>
                      <a:pt x="287" y="78"/>
                      <a:pt x="247" y="78"/>
                    </a:cubicBezTo>
                    <a:cubicBezTo>
                      <a:pt x="198" y="78"/>
                      <a:pt x="160" y="94"/>
                      <a:pt x="132" y="125"/>
                    </a:cubicBezTo>
                    <a:cubicBezTo>
                      <a:pt x="104" y="156"/>
                      <a:pt x="90" y="198"/>
                      <a:pt x="90" y="251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11" y="66"/>
                      <a:pt x="136" y="41"/>
                      <a:pt x="166" y="25"/>
                    </a:cubicBezTo>
                    <a:cubicBezTo>
                      <a:pt x="195" y="9"/>
                      <a:pt x="229" y="0"/>
                      <a:pt x="267" y="0"/>
                    </a:cubicBezTo>
                    <a:cubicBezTo>
                      <a:pt x="329" y="0"/>
                      <a:pt x="377" y="20"/>
                      <a:pt x="409" y="59"/>
                    </a:cubicBezTo>
                    <a:cubicBezTo>
                      <a:pt x="441" y="98"/>
                      <a:pt x="458" y="155"/>
                      <a:pt x="458" y="23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69" name="Freeform 396">
                <a:extLst>
                  <a:ext uri="{FF2B5EF4-FFF2-40B4-BE49-F238E27FC236}">
                    <a16:creationId xmlns:a16="http://schemas.microsoft.com/office/drawing/2014/main" id="{8DB2038C-0C9C-7A26-40F9-852EE1861CD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849938" y="2701925"/>
                <a:ext cx="88900" cy="139700"/>
              </a:xfrm>
              <a:custGeom>
                <a:avLst/>
                <a:gdLst>
                  <a:gd name="T0" fmla="*/ 399 w 489"/>
                  <a:gd name="T1" fmla="*/ 296 h 773"/>
                  <a:gd name="T2" fmla="*/ 399 w 489"/>
                  <a:gd name="T3" fmla="*/ 0 h 773"/>
                  <a:gd name="T4" fmla="*/ 489 w 489"/>
                  <a:gd name="T5" fmla="*/ 0 h 773"/>
                  <a:gd name="T6" fmla="*/ 489 w 489"/>
                  <a:gd name="T7" fmla="*/ 760 h 773"/>
                  <a:gd name="T8" fmla="*/ 399 w 489"/>
                  <a:gd name="T9" fmla="*/ 760 h 773"/>
                  <a:gd name="T10" fmla="*/ 399 w 489"/>
                  <a:gd name="T11" fmla="*/ 678 h 773"/>
                  <a:gd name="T12" fmla="*/ 327 w 489"/>
                  <a:gd name="T13" fmla="*/ 750 h 773"/>
                  <a:gd name="T14" fmla="*/ 224 w 489"/>
                  <a:gd name="T15" fmla="*/ 773 h 773"/>
                  <a:gd name="T16" fmla="*/ 62 w 489"/>
                  <a:gd name="T17" fmla="*/ 695 h 773"/>
                  <a:gd name="T18" fmla="*/ 0 w 489"/>
                  <a:gd name="T19" fmla="*/ 487 h 773"/>
                  <a:gd name="T20" fmla="*/ 62 w 489"/>
                  <a:gd name="T21" fmla="*/ 279 h 773"/>
                  <a:gd name="T22" fmla="*/ 224 w 489"/>
                  <a:gd name="T23" fmla="*/ 200 h 773"/>
                  <a:gd name="T24" fmla="*/ 327 w 489"/>
                  <a:gd name="T25" fmla="*/ 224 h 773"/>
                  <a:gd name="T26" fmla="*/ 399 w 489"/>
                  <a:gd name="T27" fmla="*/ 296 h 773"/>
                  <a:gd name="T28" fmla="*/ 93 w 489"/>
                  <a:gd name="T29" fmla="*/ 487 h 773"/>
                  <a:gd name="T30" fmla="*/ 133 w 489"/>
                  <a:gd name="T31" fmla="*/ 643 h 773"/>
                  <a:gd name="T32" fmla="*/ 245 w 489"/>
                  <a:gd name="T33" fmla="*/ 699 h 773"/>
                  <a:gd name="T34" fmla="*/ 358 w 489"/>
                  <a:gd name="T35" fmla="*/ 643 h 773"/>
                  <a:gd name="T36" fmla="*/ 399 w 489"/>
                  <a:gd name="T37" fmla="*/ 487 h 773"/>
                  <a:gd name="T38" fmla="*/ 358 w 489"/>
                  <a:gd name="T39" fmla="*/ 332 h 773"/>
                  <a:gd name="T40" fmla="*/ 245 w 489"/>
                  <a:gd name="T41" fmla="*/ 275 h 773"/>
                  <a:gd name="T42" fmla="*/ 133 w 489"/>
                  <a:gd name="T43" fmla="*/ 332 h 773"/>
                  <a:gd name="T44" fmla="*/ 93 w 489"/>
                  <a:gd name="T45" fmla="*/ 487 h 7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89" h="773">
                    <a:moveTo>
                      <a:pt x="399" y="296"/>
                    </a:moveTo>
                    <a:lnTo>
                      <a:pt x="399" y="0"/>
                    </a:lnTo>
                    <a:lnTo>
                      <a:pt x="489" y="0"/>
                    </a:lnTo>
                    <a:lnTo>
                      <a:pt x="489" y="760"/>
                    </a:lnTo>
                    <a:lnTo>
                      <a:pt x="399" y="760"/>
                    </a:lnTo>
                    <a:lnTo>
                      <a:pt x="399" y="678"/>
                    </a:lnTo>
                    <a:cubicBezTo>
                      <a:pt x="380" y="711"/>
                      <a:pt x="356" y="735"/>
                      <a:pt x="327" y="750"/>
                    </a:cubicBezTo>
                    <a:cubicBezTo>
                      <a:pt x="298" y="765"/>
                      <a:pt x="264" y="773"/>
                      <a:pt x="224" y="773"/>
                    </a:cubicBezTo>
                    <a:cubicBezTo>
                      <a:pt x="158" y="773"/>
                      <a:pt x="104" y="747"/>
                      <a:pt x="62" y="695"/>
                    </a:cubicBezTo>
                    <a:cubicBezTo>
                      <a:pt x="20" y="643"/>
                      <a:pt x="0" y="573"/>
                      <a:pt x="0" y="487"/>
                    </a:cubicBezTo>
                    <a:cubicBezTo>
                      <a:pt x="0" y="401"/>
                      <a:pt x="20" y="332"/>
                      <a:pt x="62" y="279"/>
                    </a:cubicBezTo>
                    <a:cubicBezTo>
                      <a:pt x="104" y="227"/>
                      <a:pt x="158" y="200"/>
                      <a:pt x="224" y="200"/>
                    </a:cubicBezTo>
                    <a:cubicBezTo>
                      <a:pt x="264" y="200"/>
                      <a:pt x="298" y="208"/>
                      <a:pt x="327" y="224"/>
                    </a:cubicBezTo>
                    <a:cubicBezTo>
                      <a:pt x="356" y="240"/>
                      <a:pt x="380" y="264"/>
                      <a:pt x="399" y="296"/>
                    </a:cubicBezTo>
                    <a:close/>
                    <a:moveTo>
                      <a:pt x="93" y="487"/>
                    </a:moveTo>
                    <a:cubicBezTo>
                      <a:pt x="93" y="553"/>
                      <a:pt x="106" y="605"/>
                      <a:pt x="133" y="643"/>
                    </a:cubicBezTo>
                    <a:cubicBezTo>
                      <a:pt x="160" y="681"/>
                      <a:pt x="197" y="699"/>
                      <a:pt x="245" y="699"/>
                    </a:cubicBezTo>
                    <a:cubicBezTo>
                      <a:pt x="293" y="699"/>
                      <a:pt x="330" y="681"/>
                      <a:pt x="358" y="643"/>
                    </a:cubicBezTo>
                    <a:cubicBezTo>
                      <a:pt x="385" y="605"/>
                      <a:pt x="399" y="553"/>
                      <a:pt x="399" y="487"/>
                    </a:cubicBezTo>
                    <a:cubicBezTo>
                      <a:pt x="399" y="421"/>
                      <a:pt x="385" y="370"/>
                      <a:pt x="358" y="332"/>
                    </a:cubicBezTo>
                    <a:cubicBezTo>
                      <a:pt x="330" y="294"/>
                      <a:pt x="293" y="275"/>
                      <a:pt x="245" y="275"/>
                    </a:cubicBezTo>
                    <a:cubicBezTo>
                      <a:pt x="197" y="275"/>
                      <a:pt x="160" y="294"/>
                      <a:pt x="133" y="332"/>
                    </a:cubicBezTo>
                    <a:cubicBezTo>
                      <a:pt x="106" y="370"/>
                      <a:pt x="93" y="421"/>
                      <a:pt x="93" y="487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70" name="Freeform 397">
                <a:extLst>
                  <a:ext uri="{FF2B5EF4-FFF2-40B4-BE49-F238E27FC236}">
                    <a16:creationId xmlns:a16="http://schemas.microsoft.com/office/drawing/2014/main" id="{944D993C-69AA-E233-AB7A-C29F55357C9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964238" y="2738438"/>
                <a:ext cx="90488" cy="103188"/>
              </a:xfrm>
              <a:custGeom>
                <a:avLst/>
                <a:gdLst>
                  <a:gd name="T0" fmla="*/ 251 w 502"/>
                  <a:gd name="T1" fmla="*/ 76 h 573"/>
                  <a:gd name="T2" fmla="*/ 137 w 502"/>
                  <a:gd name="T3" fmla="*/ 133 h 573"/>
                  <a:gd name="T4" fmla="*/ 95 w 502"/>
                  <a:gd name="T5" fmla="*/ 287 h 573"/>
                  <a:gd name="T6" fmla="*/ 136 w 502"/>
                  <a:gd name="T7" fmla="*/ 442 h 573"/>
                  <a:gd name="T8" fmla="*/ 251 w 502"/>
                  <a:gd name="T9" fmla="*/ 498 h 573"/>
                  <a:gd name="T10" fmla="*/ 365 w 502"/>
                  <a:gd name="T11" fmla="*/ 442 h 573"/>
                  <a:gd name="T12" fmla="*/ 407 w 502"/>
                  <a:gd name="T13" fmla="*/ 287 h 573"/>
                  <a:gd name="T14" fmla="*/ 365 w 502"/>
                  <a:gd name="T15" fmla="*/ 133 h 573"/>
                  <a:gd name="T16" fmla="*/ 251 w 502"/>
                  <a:gd name="T17" fmla="*/ 76 h 573"/>
                  <a:gd name="T18" fmla="*/ 251 w 502"/>
                  <a:gd name="T19" fmla="*/ 0 h 573"/>
                  <a:gd name="T20" fmla="*/ 435 w 502"/>
                  <a:gd name="T21" fmla="*/ 76 h 573"/>
                  <a:gd name="T22" fmla="*/ 502 w 502"/>
                  <a:gd name="T23" fmla="*/ 287 h 573"/>
                  <a:gd name="T24" fmla="*/ 435 w 502"/>
                  <a:gd name="T25" fmla="*/ 497 h 573"/>
                  <a:gd name="T26" fmla="*/ 251 w 502"/>
                  <a:gd name="T27" fmla="*/ 573 h 573"/>
                  <a:gd name="T28" fmla="*/ 66 w 502"/>
                  <a:gd name="T29" fmla="*/ 497 h 573"/>
                  <a:gd name="T30" fmla="*/ 0 w 502"/>
                  <a:gd name="T31" fmla="*/ 287 h 573"/>
                  <a:gd name="T32" fmla="*/ 66 w 502"/>
                  <a:gd name="T33" fmla="*/ 76 h 573"/>
                  <a:gd name="T34" fmla="*/ 251 w 502"/>
                  <a:gd name="T35" fmla="*/ 0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2" h="573">
                    <a:moveTo>
                      <a:pt x="251" y="76"/>
                    </a:moveTo>
                    <a:cubicBezTo>
                      <a:pt x="203" y="76"/>
                      <a:pt x="165" y="95"/>
                      <a:pt x="137" y="133"/>
                    </a:cubicBezTo>
                    <a:cubicBezTo>
                      <a:pt x="109" y="171"/>
                      <a:pt x="95" y="222"/>
                      <a:pt x="95" y="287"/>
                    </a:cubicBezTo>
                    <a:cubicBezTo>
                      <a:pt x="95" y="353"/>
                      <a:pt x="108" y="404"/>
                      <a:pt x="136" y="442"/>
                    </a:cubicBezTo>
                    <a:cubicBezTo>
                      <a:pt x="164" y="480"/>
                      <a:pt x="202" y="498"/>
                      <a:pt x="251" y="498"/>
                    </a:cubicBezTo>
                    <a:cubicBezTo>
                      <a:pt x="299" y="498"/>
                      <a:pt x="337" y="480"/>
                      <a:pt x="365" y="442"/>
                    </a:cubicBezTo>
                    <a:cubicBezTo>
                      <a:pt x="393" y="404"/>
                      <a:pt x="407" y="353"/>
                      <a:pt x="407" y="287"/>
                    </a:cubicBezTo>
                    <a:cubicBezTo>
                      <a:pt x="407" y="223"/>
                      <a:pt x="393" y="171"/>
                      <a:pt x="365" y="133"/>
                    </a:cubicBezTo>
                    <a:cubicBezTo>
                      <a:pt x="337" y="95"/>
                      <a:pt x="299" y="76"/>
                      <a:pt x="251" y="76"/>
                    </a:cubicBezTo>
                    <a:close/>
                    <a:moveTo>
                      <a:pt x="251" y="0"/>
                    </a:moveTo>
                    <a:cubicBezTo>
                      <a:pt x="329" y="0"/>
                      <a:pt x="390" y="26"/>
                      <a:pt x="435" y="76"/>
                    </a:cubicBezTo>
                    <a:cubicBezTo>
                      <a:pt x="479" y="127"/>
                      <a:pt x="502" y="197"/>
                      <a:pt x="502" y="287"/>
                    </a:cubicBezTo>
                    <a:cubicBezTo>
                      <a:pt x="502" y="377"/>
                      <a:pt x="479" y="447"/>
                      <a:pt x="435" y="497"/>
                    </a:cubicBezTo>
                    <a:cubicBezTo>
                      <a:pt x="390" y="548"/>
                      <a:pt x="329" y="573"/>
                      <a:pt x="251" y="573"/>
                    </a:cubicBezTo>
                    <a:cubicBezTo>
                      <a:pt x="172" y="573"/>
                      <a:pt x="110" y="548"/>
                      <a:pt x="66" y="497"/>
                    </a:cubicBezTo>
                    <a:cubicBezTo>
                      <a:pt x="22" y="447"/>
                      <a:pt x="0" y="377"/>
                      <a:pt x="0" y="287"/>
                    </a:cubicBezTo>
                    <a:cubicBezTo>
                      <a:pt x="0" y="197"/>
                      <a:pt x="22" y="127"/>
                      <a:pt x="66" y="76"/>
                    </a:cubicBezTo>
                    <a:cubicBezTo>
                      <a:pt x="110" y="26"/>
                      <a:pt x="172" y="0"/>
                      <a:pt x="251" y="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71" name="Freeform 398">
                <a:extLst>
                  <a:ext uri="{FF2B5EF4-FFF2-40B4-BE49-F238E27FC236}">
                    <a16:creationId xmlns:a16="http://schemas.microsoft.com/office/drawing/2014/main" id="{1C4E1577-4928-3247-F334-550F6BF2714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081713" y="2738438"/>
                <a:ext cx="142875" cy="101600"/>
              </a:xfrm>
              <a:custGeom>
                <a:avLst/>
                <a:gdLst>
                  <a:gd name="T0" fmla="*/ 429 w 798"/>
                  <a:gd name="T1" fmla="*/ 118 h 560"/>
                  <a:gd name="T2" fmla="*/ 509 w 798"/>
                  <a:gd name="T3" fmla="*/ 29 h 560"/>
                  <a:gd name="T4" fmla="*/ 620 w 798"/>
                  <a:gd name="T5" fmla="*/ 0 h 560"/>
                  <a:gd name="T6" fmla="*/ 751 w 798"/>
                  <a:gd name="T7" fmla="*/ 60 h 560"/>
                  <a:gd name="T8" fmla="*/ 798 w 798"/>
                  <a:gd name="T9" fmla="*/ 230 h 560"/>
                  <a:gd name="T10" fmla="*/ 798 w 798"/>
                  <a:gd name="T11" fmla="*/ 560 h 560"/>
                  <a:gd name="T12" fmla="*/ 708 w 798"/>
                  <a:gd name="T13" fmla="*/ 560 h 560"/>
                  <a:gd name="T14" fmla="*/ 708 w 798"/>
                  <a:gd name="T15" fmla="*/ 233 h 560"/>
                  <a:gd name="T16" fmla="*/ 680 w 798"/>
                  <a:gd name="T17" fmla="*/ 116 h 560"/>
                  <a:gd name="T18" fmla="*/ 595 w 798"/>
                  <a:gd name="T19" fmla="*/ 78 h 560"/>
                  <a:gd name="T20" fmla="*/ 484 w 798"/>
                  <a:gd name="T21" fmla="*/ 125 h 560"/>
                  <a:gd name="T22" fmla="*/ 444 w 798"/>
                  <a:gd name="T23" fmla="*/ 251 h 560"/>
                  <a:gd name="T24" fmla="*/ 444 w 798"/>
                  <a:gd name="T25" fmla="*/ 560 h 560"/>
                  <a:gd name="T26" fmla="*/ 354 w 798"/>
                  <a:gd name="T27" fmla="*/ 560 h 560"/>
                  <a:gd name="T28" fmla="*/ 354 w 798"/>
                  <a:gd name="T29" fmla="*/ 233 h 560"/>
                  <a:gd name="T30" fmla="*/ 326 w 798"/>
                  <a:gd name="T31" fmla="*/ 116 h 560"/>
                  <a:gd name="T32" fmla="*/ 240 w 798"/>
                  <a:gd name="T33" fmla="*/ 78 h 560"/>
                  <a:gd name="T34" fmla="*/ 130 w 798"/>
                  <a:gd name="T35" fmla="*/ 125 h 560"/>
                  <a:gd name="T36" fmla="*/ 90 w 798"/>
                  <a:gd name="T37" fmla="*/ 251 h 560"/>
                  <a:gd name="T38" fmla="*/ 90 w 798"/>
                  <a:gd name="T39" fmla="*/ 560 h 560"/>
                  <a:gd name="T40" fmla="*/ 0 w 798"/>
                  <a:gd name="T41" fmla="*/ 560 h 560"/>
                  <a:gd name="T42" fmla="*/ 0 w 798"/>
                  <a:gd name="T43" fmla="*/ 13 h 560"/>
                  <a:gd name="T44" fmla="*/ 90 w 798"/>
                  <a:gd name="T45" fmla="*/ 13 h 560"/>
                  <a:gd name="T46" fmla="*/ 90 w 798"/>
                  <a:gd name="T47" fmla="*/ 98 h 560"/>
                  <a:gd name="T48" fmla="*/ 164 w 798"/>
                  <a:gd name="T49" fmla="*/ 24 h 560"/>
                  <a:gd name="T50" fmla="*/ 266 w 798"/>
                  <a:gd name="T51" fmla="*/ 0 h 560"/>
                  <a:gd name="T52" fmla="*/ 367 w 798"/>
                  <a:gd name="T53" fmla="*/ 30 h 560"/>
                  <a:gd name="T54" fmla="*/ 429 w 798"/>
                  <a:gd name="T55" fmla="*/ 118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</a:cxnLst>
                <a:rect l="0" t="0" r="r" b="b"/>
                <a:pathLst>
                  <a:path w="798" h="560">
                    <a:moveTo>
                      <a:pt x="429" y="118"/>
                    </a:moveTo>
                    <a:cubicBezTo>
                      <a:pt x="451" y="78"/>
                      <a:pt x="478" y="49"/>
                      <a:pt x="509" y="29"/>
                    </a:cubicBezTo>
                    <a:cubicBezTo>
                      <a:pt x="540" y="10"/>
                      <a:pt x="577" y="0"/>
                      <a:pt x="620" y="0"/>
                    </a:cubicBezTo>
                    <a:cubicBezTo>
                      <a:pt x="676" y="0"/>
                      <a:pt x="720" y="20"/>
                      <a:pt x="751" y="60"/>
                    </a:cubicBezTo>
                    <a:cubicBezTo>
                      <a:pt x="782" y="100"/>
                      <a:pt x="798" y="157"/>
                      <a:pt x="798" y="230"/>
                    </a:cubicBezTo>
                    <a:lnTo>
                      <a:pt x="798" y="560"/>
                    </a:lnTo>
                    <a:lnTo>
                      <a:pt x="708" y="560"/>
                    </a:lnTo>
                    <a:lnTo>
                      <a:pt x="708" y="233"/>
                    </a:lnTo>
                    <a:cubicBezTo>
                      <a:pt x="708" y="181"/>
                      <a:pt x="698" y="142"/>
                      <a:pt x="680" y="116"/>
                    </a:cubicBezTo>
                    <a:cubicBezTo>
                      <a:pt x="661" y="91"/>
                      <a:pt x="633" y="78"/>
                      <a:pt x="595" y="78"/>
                    </a:cubicBezTo>
                    <a:cubicBezTo>
                      <a:pt x="548" y="78"/>
                      <a:pt x="511" y="94"/>
                      <a:pt x="484" y="125"/>
                    </a:cubicBezTo>
                    <a:cubicBezTo>
                      <a:pt x="457" y="156"/>
                      <a:pt x="444" y="198"/>
                      <a:pt x="444" y="251"/>
                    </a:cubicBezTo>
                    <a:lnTo>
                      <a:pt x="444" y="560"/>
                    </a:lnTo>
                    <a:lnTo>
                      <a:pt x="354" y="560"/>
                    </a:lnTo>
                    <a:lnTo>
                      <a:pt x="354" y="233"/>
                    </a:lnTo>
                    <a:cubicBezTo>
                      <a:pt x="354" y="181"/>
                      <a:pt x="344" y="142"/>
                      <a:pt x="326" y="116"/>
                    </a:cubicBezTo>
                    <a:cubicBezTo>
                      <a:pt x="307" y="91"/>
                      <a:pt x="278" y="78"/>
                      <a:pt x="240" y="78"/>
                    </a:cubicBezTo>
                    <a:cubicBezTo>
                      <a:pt x="194" y="78"/>
                      <a:pt x="157" y="94"/>
                      <a:pt x="130" y="125"/>
                    </a:cubicBezTo>
                    <a:cubicBezTo>
                      <a:pt x="103" y="156"/>
                      <a:pt x="90" y="198"/>
                      <a:pt x="90" y="251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10" y="65"/>
                      <a:pt x="135" y="40"/>
                      <a:pt x="164" y="24"/>
                    </a:cubicBezTo>
                    <a:cubicBezTo>
                      <a:pt x="192" y="8"/>
                      <a:pt x="226" y="0"/>
                      <a:pt x="266" y="0"/>
                    </a:cubicBezTo>
                    <a:cubicBezTo>
                      <a:pt x="306" y="0"/>
                      <a:pt x="339" y="10"/>
                      <a:pt x="367" y="30"/>
                    </a:cubicBezTo>
                    <a:cubicBezTo>
                      <a:pt x="395" y="50"/>
                      <a:pt x="415" y="80"/>
                      <a:pt x="429" y="11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72" name="Freeform 399">
                <a:extLst>
                  <a:ext uri="{FF2B5EF4-FFF2-40B4-BE49-F238E27FC236}">
                    <a16:creationId xmlns:a16="http://schemas.microsoft.com/office/drawing/2014/main" id="{BE1A6AA9-6FB0-67E8-2F9F-7051BAEA0DF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991100" y="3041650"/>
                <a:ext cx="360363" cy="0"/>
              </a:xfrm>
              <a:custGeom>
                <a:avLst/>
                <a:gdLst>
                  <a:gd name="T0" fmla="*/ 0 w 2000"/>
                  <a:gd name="T1" fmla="*/ 1000 w 2000"/>
                  <a:gd name="T2" fmla="*/ 2000 w 200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2000">
                    <a:moveTo>
                      <a:pt x="0" y="0"/>
                    </a:moveTo>
                    <a:lnTo>
                      <a:pt x="1000" y="0"/>
                    </a:lnTo>
                    <a:lnTo>
                      <a:pt x="2000" y="0"/>
                    </a:lnTo>
                  </a:path>
                </a:pathLst>
              </a:custGeom>
              <a:noFill/>
              <a:ln w="6350" cap="rnd">
                <a:solidFill>
                  <a:srgbClr val="C44E5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73" name="Freeform 400">
                <a:extLst>
                  <a:ext uri="{FF2B5EF4-FFF2-40B4-BE49-F238E27FC236}">
                    <a16:creationId xmlns:a16="http://schemas.microsoft.com/office/drawing/2014/main" id="{2758635B-3449-B0BE-56B0-0D43ADC434A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505450" y="2970213"/>
                <a:ext cx="104775" cy="136525"/>
              </a:xfrm>
              <a:custGeom>
                <a:avLst/>
                <a:gdLst>
                  <a:gd name="T0" fmla="*/ 588 w 588"/>
                  <a:gd name="T1" fmla="*/ 69 h 755"/>
                  <a:gd name="T2" fmla="*/ 588 w 588"/>
                  <a:gd name="T3" fmla="*/ 173 h 755"/>
                  <a:gd name="T4" fmla="*/ 481 w 588"/>
                  <a:gd name="T5" fmla="*/ 104 h 755"/>
                  <a:gd name="T6" fmla="*/ 362 w 588"/>
                  <a:gd name="T7" fmla="*/ 81 h 755"/>
                  <a:gd name="T8" fmla="*/ 170 w 588"/>
                  <a:gd name="T9" fmla="*/ 158 h 755"/>
                  <a:gd name="T10" fmla="*/ 104 w 588"/>
                  <a:gd name="T11" fmla="*/ 378 h 755"/>
                  <a:gd name="T12" fmla="*/ 170 w 588"/>
                  <a:gd name="T13" fmla="*/ 599 h 755"/>
                  <a:gd name="T14" fmla="*/ 362 w 588"/>
                  <a:gd name="T15" fmla="*/ 675 h 755"/>
                  <a:gd name="T16" fmla="*/ 481 w 588"/>
                  <a:gd name="T17" fmla="*/ 652 h 755"/>
                  <a:gd name="T18" fmla="*/ 588 w 588"/>
                  <a:gd name="T19" fmla="*/ 583 h 755"/>
                  <a:gd name="T20" fmla="*/ 588 w 588"/>
                  <a:gd name="T21" fmla="*/ 686 h 755"/>
                  <a:gd name="T22" fmla="*/ 478 w 588"/>
                  <a:gd name="T23" fmla="*/ 738 h 755"/>
                  <a:gd name="T24" fmla="*/ 356 w 588"/>
                  <a:gd name="T25" fmla="*/ 755 h 755"/>
                  <a:gd name="T26" fmla="*/ 95 w 588"/>
                  <a:gd name="T27" fmla="*/ 655 h 755"/>
                  <a:gd name="T28" fmla="*/ 0 w 588"/>
                  <a:gd name="T29" fmla="*/ 378 h 755"/>
                  <a:gd name="T30" fmla="*/ 95 w 588"/>
                  <a:gd name="T31" fmla="*/ 101 h 755"/>
                  <a:gd name="T32" fmla="*/ 356 w 588"/>
                  <a:gd name="T33" fmla="*/ 0 h 755"/>
                  <a:gd name="T34" fmla="*/ 479 w 588"/>
                  <a:gd name="T35" fmla="*/ 17 h 755"/>
                  <a:gd name="T36" fmla="*/ 588 w 588"/>
                  <a:gd name="T37" fmla="*/ 69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588" h="755">
                    <a:moveTo>
                      <a:pt x="588" y="69"/>
                    </a:moveTo>
                    <a:lnTo>
                      <a:pt x="588" y="173"/>
                    </a:lnTo>
                    <a:cubicBezTo>
                      <a:pt x="554" y="143"/>
                      <a:pt x="519" y="120"/>
                      <a:pt x="481" y="104"/>
                    </a:cubicBezTo>
                    <a:cubicBezTo>
                      <a:pt x="443" y="89"/>
                      <a:pt x="404" y="81"/>
                      <a:pt x="362" y="81"/>
                    </a:cubicBezTo>
                    <a:cubicBezTo>
                      <a:pt x="278" y="81"/>
                      <a:pt x="214" y="107"/>
                      <a:pt x="170" y="158"/>
                    </a:cubicBezTo>
                    <a:cubicBezTo>
                      <a:pt x="126" y="209"/>
                      <a:pt x="104" y="282"/>
                      <a:pt x="104" y="378"/>
                    </a:cubicBezTo>
                    <a:cubicBezTo>
                      <a:pt x="104" y="474"/>
                      <a:pt x="126" y="548"/>
                      <a:pt x="170" y="599"/>
                    </a:cubicBezTo>
                    <a:cubicBezTo>
                      <a:pt x="214" y="650"/>
                      <a:pt x="278" y="675"/>
                      <a:pt x="362" y="675"/>
                    </a:cubicBezTo>
                    <a:cubicBezTo>
                      <a:pt x="404" y="675"/>
                      <a:pt x="443" y="668"/>
                      <a:pt x="481" y="652"/>
                    </a:cubicBezTo>
                    <a:cubicBezTo>
                      <a:pt x="519" y="637"/>
                      <a:pt x="554" y="614"/>
                      <a:pt x="588" y="583"/>
                    </a:cubicBezTo>
                    <a:lnTo>
                      <a:pt x="588" y="686"/>
                    </a:lnTo>
                    <a:cubicBezTo>
                      <a:pt x="553" y="710"/>
                      <a:pt x="516" y="727"/>
                      <a:pt x="478" y="738"/>
                    </a:cubicBezTo>
                    <a:cubicBezTo>
                      <a:pt x="440" y="749"/>
                      <a:pt x="399" y="755"/>
                      <a:pt x="356" y="755"/>
                    </a:cubicBezTo>
                    <a:cubicBezTo>
                      <a:pt x="246" y="755"/>
                      <a:pt x="159" y="722"/>
                      <a:pt x="95" y="655"/>
                    </a:cubicBezTo>
                    <a:cubicBezTo>
                      <a:pt x="31" y="588"/>
                      <a:pt x="0" y="496"/>
                      <a:pt x="0" y="378"/>
                    </a:cubicBezTo>
                    <a:cubicBezTo>
                      <a:pt x="0" y="261"/>
                      <a:pt x="31" y="169"/>
                      <a:pt x="95" y="101"/>
                    </a:cubicBezTo>
                    <a:cubicBezTo>
                      <a:pt x="159" y="34"/>
                      <a:pt x="246" y="0"/>
                      <a:pt x="356" y="0"/>
                    </a:cubicBezTo>
                    <a:cubicBezTo>
                      <a:pt x="400" y="0"/>
                      <a:pt x="441" y="6"/>
                      <a:pt x="479" y="17"/>
                    </a:cubicBezTo>
                    <a:cubicBezTo>
                      <a:pt x="517" y="29"/>
                      <a:pt x="554" y="46"/>
                      <a:pt x="588" y="69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74" name="Freeform 401">
                <a:extLst>
                  <a:ext uri="{FF2B5EF4-FFF2-40B4-BE49-F238E27FC236}">
                    <a16:creationId xmlns:a16="http://schemas.microsoft.com/office/drawing/2014/main" id="{5B9F6ABA-9325-9703-58D5-4436520F8DC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630863" y="3003550"/>
                <a:ext cx="90488" cy="103188"/>
              </a:xfrm>
              <a:custGeom>
                <a:avLst/>
                <a:gdLst>
                  <a:gd name="T0" fmla="*/ 507 w 507"/>
                  <a:gd name="T1" fmla="*/ 264 h 573"/>
                  <a:gd name="T2" fmla="*/ 507 w 507"/>
                  <a:gd name="T3" fmla="*/ 308 h 573"/>
                  <a:gd name="T4" fmla="*/ 94 w 507"/>
                  <a:gd name="T5" fmla="*/ 308 h 573"/>
                  <a:gd name="T6" fmla="*/ 150 w 507"/>
                  <a:gd name="T7" fmla="*/ 450 h 573"/>
                  <a:gd name="T8" fmla="*/ 289 w 507"/>
                  <a:gd name="T9" fmla="*/ 498 h 573"/>
                  <a:gd name="T10" fmla="*/ 389 w 507"/>
                  <a:gd name="T11" fmla="*/ 486 h 573"/>
                  <a:gd name="T12" fmla="*/ 486 w 507"/>
                  <a:gd name="T13" fmla="*/ 447 h 573"/>
                  <a:gd name="T14" fmla="*/ 486 w 507"/>
                  <a:gd name="T15" fmla="*/ 532 h 573"/>
                  <a:gd name="T16" fmla="*/ 387 w 507"/>
                  <a:gd name="T17" fmla="*/ 563 h 573"/>
                  <a:gd name="T18" fmla="*/ 284 w 507"/>
                  <a:gd name="T19" fmla="*/ 573 h 573"/>
                  <a:gd name="T20" fmla="*/ 76 w 507"/>
                  <a:gd name="T21" fmla="*/ 498 h 573"/>
                  <a:gd name="T22" fmla="*/ 0 w 507"/>
                  <a:gd name="T23" fmla="*/ 292 h 573"/>
                  <a:gd name="T24" fmla="*/ 72 w 507"/>
                  <a:gd name="T25" fmla="*/ 79 h 573"/>
                  <a:gd name="T26" fmla="*/ 268 w 507"/>
                  <a:gd name="T27" fmla="*/ 0 h 573"/>
                  <a:gd name="T28" fmla="*/ 443 w 507"/>
                  <a:gd name="T29" fmla="*/ 71 h 573"/>
                  <a:gd name="T30" fmla="*/ 507 w 507"/>
                  <a:gd name="T31" fmla="*/ 264 h 573"/>
                  <a:gd name="T32" fmla="*/ 417 w 507"/>
                  <a:gd name="T33" fmla="*/ 238 h 573"/>
                  <a:gd name="T34" fmla="*/ 376 w 507"/>
                  <a:gd name="T35" fmla="*/ 120 h 573"/>
                  <a:gd name="T36" fmla="*/ 269 w 507"/>
                  <a:gd name="T37" fmla="*/ 76 h 573"/>
                  <a:gd name="T38" fmla="*/ 149 w 507"/>
                  <a:gd name="T39" fmla="*/ 119 h 573"/>
                  <a:gd name="T40" fmla="*/ 97 w 507"/>
                  <a:gd name="T41" fmla="*/ 238 h 573"/>
                  <a:gd name="T42" fmla="*/ 417 w 507"/>
                  <a:gd name="T43" fmla="*/ 23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507" h="573">
                    <a:moveTo>
                      <a:pt x="507" y="264"/>
                    </a:moveTo>
                    <a:lnTo>
                      <a:pt x="507" y="308"/>
                    </a:lnTo>
                    <a:lnTo>
                      <a:pt x="94" y="308"/>
                    </a:lnTo>
                    <a:cubicBezTo>
                      <a:pt x="98" y="370"/>
                      <a:pt x="116" y="418"/>
                      <a:pt x="150" y="450"/>
                    </a:cubicBezTo>
                    <a:cubicBezTo>
                      <a:pt x="183" y="482"/>
                      <a:pt x="229" y="498"/>
                      <a:pt x="289" y="498"/>
                    </a:cubicBezTo>
                    <a:cubicBezTo>
                      <a:pt x="323" y="498"/>
                      <a:pt x="357" y="494"/>
                      <a:pt x="389" y="486"/>
                    </a:cubicBezTo>
                    <a:cubicBezTo>
                      <a:pt x="421" y="478"/>
                      <a:pt x="454" y="465"/>
                      <a:pt x="486" y="447"/>
                    </a:cubicBezTo>
                    <a:lnTo>
                      <a:pt x="486" y="532"/>
                    </a:lnTo>
                    <a:cubicBezTo>
                      <a:pt x="454" y="546"/>
                      <a:pt x="421" y="557"/>
                      <a:pt x="387" y="563"/>
                    </a:cubicBezTo>
                    <a:cubicBezTo>
                      <a:pt x="353" y="569"/>
                      <a:pt x="318" y="573"/>
                      <a:pt x="284" y="573"/>
                    </a:cubicBezTo>
                    <a:cubicBezTo>
                      <a:pt x="196" y="573"/>
                      <a:pt x="127" y="548"/>
                      <a:pt x="76" y="498"/>
                    </a:cubicBezTo>
                    <a:cubicBezTo>
                      <a:pt x="25" y="448"/>
                      <a:pt x="0" y="379"/>
                      <a:pt x="0" y="292"/>
                    </a:cubicBezTo>
                    <a:cubicBezTo>
                      <a:pt x="0" y="203"/>
                      <a:pt x="24" y="132"/>
                      <a:pt x="72" y="79"/>
                    </a:cubicBezTo>
                    <a:cubicBezTo>
                      <a:pt x="120" y="27"/>
                      <a:pt x="186" y="0"/>
                      <a:pt x="268" y="0"/>
                    </a:cubicBezTo>
                    <a:cubicBezTo>
                      <a:pt x="342" y="0"/>
                      <a:pt x="400" y="24"/>
                      <a:pt x="443" y="71"/>
                    </a:cubicBezTo>
                    <a:cubicBezTo>
                      <a:pt x="485" y="119"/>
                      <a:pt x="507" y="183"/>
                      <a:pt x="507" y="264"/>
                    </a:cubicBezTo>
                    <a:close/>
                    <a:moveTo>
                      <a:pt x="417" y="238"/>
                    </a:moveTo>
                    <a:cubicBezTo>
                      <a:pt x="416" y="189"/>
                      <a:pt x="402" y="150"/>
                      <a:pt x="376" y="120"/>
                    </a:cubicBezTo>
                    <a:cubicBezTo>
                      <a:pt x="349" y="91"/>
                      <a:pt x="313" y="76"/>
                      <a:pt x="269" y="76"/>
                    </a:cubicBezTo>
                    <a:cubicBezTo>
                      <a:pt x="219" y="76"/>
                      <a:pt x="179" y="91"/>
                      <a:pt x="149" y="119"/>
                    </a:cubicBezTo>
                    <a:cubicBezTo>
                      <a:pt x="119" y="147"/>
                      <a:pt x="101" y="187"/>
                      <a:pt x="97" y="238"/>
                    </a:cubicBezTo>
                    <a:lnTo>
                      <a:pt x="417" y="238"/>
                    </a:ln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75" name="Rectangle 402">
                <a:extLst>
                  <a:ext uri="{FF2B5EF4-FFF2-40B4-BE49-F238E27FC236}">
                    <a16:creationId xmlns:a16="http://schemas.microsoft.com/office/drawing/2014/main" id="{0ADB4D3F-6142-97BA-FDE8-1ABD4B26CF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48338" y="2967038"/>
                <a:ext cx="15875" cy="138113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76" name="Rectangle 403">
                <a:extLst>
                  <a:ext uri="{FF2B5EF4-FFF2-40B4-BE49-F238E27FC236}">
                    <a16:creationId xmlns:a16="http://schemas.microsoft.com/office/drawing/2014/main" id="{BDEF4E5F-90D0-F88C-34E9-F755B40027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97550" y="2967038"/>
                <a:ext cx="17463" cy="138113"/>
              </a:xfrm>
              <a:prstGeom prst="rect">
                <a:avLst/>
              </a:prstGeom>
              <a:solidFill>
                <a:srgbClr val="262626"/>
              </a:solidFill>
              <a:ln w="0">
                <a:noFill/>
                <a:prstDash val="solid"/>
                <a:miter lim="800000"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77" name="Freeform 404">
                <a:extLst>
                  <a:ext uri="{FF2B5EF4-FFF2-40B4-BE49-F238E27FC236}">
                    <a16:creationId xmlns:a16="http://schemas.microsoft.com/office/drawing/2014/main" id="{3EF44F5C-9C20-E78D-6EB2-E95E93F4D5C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843588" y="2970213"/>
                <a:ext cx="92075" cy="136525"/>
              </a:xfrm>
              <a:custGeom>
                <a:avLst/>
                <a:gdLst>
                  <a:gd name="T0" fmla="*/ 469 w 513"/>
                  <a:gd name="T1" fmla="*/ 37 h 755"/>
                  <a:gd name="T2" fmla="*/ 469 w 513"/>
                  <a:gd name="T3" fmla="*/ 133 h 755"/>
                  <a:gd name="T4" fmla="*/ 363 w 513"/>
                  <a:gd name="T5" fmla="*/ 93 h 755"/>
                  <a:gd name="T6" fmla="*/ 267 w 513"/>
                  <a:gd name="T7" fmla="*/ 80 h 755"/>
                  <a:gd name="T8" fmla="*/ 142 w 513"/>
                  <a:gd name="T9" fmla="*/ 111 h 755"/>
                  <a:gd name="T10" fmla="*/ 99 w 513"/>
                  <a:gd name="T11" fmla="*/ 200 h 755"/>
                  <a:gd name="T12" fmla="*/ 128 w 513"/>
                  <a:gd name="T13" fmla="*/ 273 h 755"/>
                  <a:gd name="T14" fmla="*/ 238 w 513"/>
                  <a:gd name="T15" fmla="*/ 313 h 755"/>
                  <a:gd name="T16" fmla="*/ 298 w 513"/>
                  <a:gd name="T17" fmla="*/ 325 h 755"/>
                  <a:gd name="T18" fmla="*/ 460 w 513"/>
                  <a:gd name="T19" fmla="*/ 399 h 755"/>
                  <a:gd name="T20" fmla="*/ 513 w 513"/>
                  <a:gd name="T21" fmla="*/ 541 h 755"/>
                  <a:gd name="T22" fmla="*/ 442 w 513"/>
                  <a:gd name="T23" fmla="*/ 701 h 755"/>
                  <a:gd name="T24" fmla="*/ 234 w 513"/>
                  <a:gd name="T25" fmla="*/ 755 h 755"/>
                  <a:gd name="T26" fmla="*/ 123 w 513"/>
                  <a:gd name="T27" fmla="*/ 744 h 755"/>
                  <a:gd name="T28" fmla="*/ 3 w 513"/>
                  <a:gd name="T29" fmla="*/ 710 h 755"/>
                  <a:gd name="T30" fmla="*/ 3 w 513"/>
                  <a:gd name="T31" fmla="*/ 608 h 755"/>
                  <a:gd name="T32" fmla="*/ 120 w 513"/>
                  <a:gd name="T33" fmla="*/ 659 h 755"/>
                  <a:gd name="T34" fmla="*/ 234 w 513"/>
                  <a:gd name="T35" fmla="*/ 676 h 755"/>
                  <a:gd name="T36" fmla="*/ 364 w 513"/>
                  <a:gd name="T37" fmla="*/ 643 h 755"/>
                  <a:gd name="T38" fmla="*/ 410 w 513"/>
                  <a:gd name="T39" fmla="*/ 548 h 755"/>
                  <a:gd name="T40" fmla="*/ 377 w 513"/>
                  <a:gd name="T41" fmla="*/ 464 h 755"/>
                  <a:gd name="T42" fmla="*/ 269 w 513"/>
                  <a:gd name="T43" fmla="*/ 419 h 755"/>
                  <a:gd name="T44" fmla="*/ 209 w 513"/>
                  <a:gd name="T45" fmla="*/ 407 h 755"/>
                  <a:gd name="T46" fmla="*/ 49 w 513"/>
                  <a:gd name="T47" fmla="*/ 338 h 755"/>
                  <a:gd name="T48" fmla="*/ 0 w 513"/>
                  <a:gd name="T49" fmla="*/ 208 h 755"/>
                  <a:gd name="T50" fmla="*/ 68 w 513"/>
                  <a:gd name="T51" fmla="*/ 56 h 755"/>
                  <a:gd name="T52" fmla="*/ 256 w 513"/>
                  <a:gd name="T53" fmla="*/ 0 h 755"/>
                  <a:gd name="T54" fmla="*/ 360 w 513"/>
                  <a:gd name="T55" fmla="*/ 9 h 755"/>
                  <a:gd name="T56" fmla="*/ 469 w 513"/>
                  <a:gd name="T57" fmla="*/ 37 h 7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513" h="755">
                    <a:moveTo>
                      <a:pt x="469" y="37"/>
                    </a:moveTo>
                    <a:lnTo>
                      <a:pt x="469" y="133"/>
                    </a:lnTo>
                    <a:cubicBezTo>
                      <a:pt x="431" y="115"/>
                      <a:pt x="396" y="102"/>
                      <a:pt x="363" y="93"/>
                    </a:cubicBezTo>
                    <a:cubicBezTo>
                      <a:pt x="329" y="85"/>
                      <a:pt x="297" y="80"/>
                      <a:pt x="267" y="80"/>
                    </a:cubicBezTo>
                    <a:cubicBezTo>
                      <a:pt x="213" y="80"/>
                      <a:pt x="171" y="91"/>
                      <a:pt x="142" y="111"/>
                    </a:cubicBezTo>
                    <a:cubicBezTo>
                      <a:pt x="113" y="132"/>
                      <a:pt x="99" y="162"/>
                      <a:pt x="99" y="200"/>
                    </a:cubicBezTo>
                    <a:cubicBezTo>
                      <a:pt x="99" y="232"/>
                      <a:pt x="108" y="257"/>
                      <a:pt x="128" y="273"/>
                    </a:cubicBezTo>
                    <a:cubicBezTo>
                      <a:pt x="147" y="290"/>
                      <a:pt x="184" y="303"/>
                      <a:pt x="238" y="313"/>
                    </a:cubicBezTo>
                    <a:lnTo>
                      <a:pt x="298" y="325"/>
                    </a:lnTo>
                    <a:cubicBezTo>
                      <a:pt x="371" y="339"/>
                      <a:pt x="425" y="364"/>
                      <a:pt x="460" y="399"/>
                    </a:cubicBezTo>
                    <a:cubicBezTo>
                      <a:pt x="495" y="435"/>
                      <a:pt x="513" y="482"/>
                      <a:pt x="513" y="541"/>
                    </a:cubicBezTo>
                    <a:cubicBezTo>
                      <a:pt x="513" y="612"/>
                      <a:pt x="489" y="665"/>
                      <a:pt x="442" y="701"/>
                    </a:cubicBezTo>
                    <a:cubicBezTo>
                      <a:pt x="394" y="737"/>
                      <a:pt x="325" y="755"/>
                      <a:pt x="234" y="755"/>
                    </a:cubicBezTo>
                    <a:cubicBezTo>
                      <a:pt x="199" y="755"/>
                      <a:pt x="162" y="751"/>
                      <a:pt x="123" y="744"/>
                    </a:cubicBezTo>
                    <a:cubicBezTo>
                      <a:pt x="84" y="737"/>
                      <a:pt x="44" y="726"/>
                      <a:pt x="3" y="710"/>
                    </a:cubicBezTo>
                    <a:lnTo>
                      <a:pt x="3" y="608"/>
                    </a:lnTo>
                    <a:cubicBezTo>
                      <a:pt x="43" y="631"/>
                      <a:pt x="82" y="648"/>
                      <a:pt x="120" y="659"/>
                    </a:cubicBezTo>
                    <a:cubicBezTo>
                      <a:pt x="158" y="671"/>
                      <a:pt x="196" y="676"/>
                      <a:pt x="234" y="676"/>
                    </a:cubicBezTo>
                    <a:cubicBezTo>
                      <a:pt x="290" y="676"/>
                      <a:pt x="333" y="665"/>
                      <a:pt x="364" y="643"/>
                    </a:cubicBezTo>
                    <a:cubicBezTo>
                      <a:pt x="394" y="621"/>
                      <a:pt x="410" y="590"/>
                      <a:pt x="410" y="548"/>
                    </a:cubicBezTo>
                    <a:cubicBezTo>
                      <a:pt x="410" y="512"/>
                      <a:pt x="399" y="484"/>
                      <a:pt x="377" y="464"/>
                    </a:cubicBezTo>
                    <a:cubicBezTo>
                      <a:pt x="355" y="444"/>
                      <a:pt x="319" y="429"/>
                      <a:pt x="269" y="419"/>
                    </a:cubicBezTo>
                    <a:lnTo>
                      <a:pt x="209" y="407"/>
                    </a:lnTo>
                    <a:cubicBezTo>
                      <a:pt x="135" y="393"/>
                      <a:pt x="82" y="370"/>
                      <a:pt x="49" y="338"/>
                    </a:cubicBezTo>
                    <a:cubicBezTo>
                      <a:pt x="16" y="307"/>
                      <a:pt x="0" y="264"/>
                      <a:pt x="0" y="208"/>
                    </a:cubicBezTo>
                    <a:cubicBezTo>
                      <a:pt x="0" y="144"/>
                      <a:pt x="22" y="93"/>
                      <a:pt x="68" y="56"/>
                    </a:cubicBezTo>
                    <a:cubicBezTo>
                      <a:pt x="113" y="19"/>
                      <a:pt x="176" y="0"/>
                      <a:pt x="256" y="0"/>
                    </a:cubicBezTo>
                    <a:cubicBezTo>
                      <a:pt x="290" y="0"/>
                      <a:pt x="324" y="3"/>
                      <a:pt x="360" y="9"/>
                    </a:cubicBezTo>
                    <a:cubicBezTo>
                      <a:pt x="395" y="15"/>
                      <a:pt x="431" y="25"/>
                      <a:pt x="469" y="37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78" name="Freeform 405">
                <a:extLst>
                  <a:ext uri="{FF2B5EF4-FFF2-40B4-BE49-F238E27FC236}">
                    <a16:creationId xmlns:a16="http://schemas.microsoft.com/office/drawing/2014/main" id="{CBADF2A6-87FE-4F09-E098-3E34A75CD1B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962650" y="3003550"/>
                <a:ext cx="82550" cy="101600"/>
              </a:xfrm>
              <a:custGeom>
                <a:avLst/>
                <a:gdLst>
                  <a:gd name="T0" fmla="*/ 458 w 458"/>
                  <a:gd name="T1" fmla="*/ 230 h 560"/>
                  <a:gd name="T2" fmla="*/ 458 w 458"/>
                  <a:gd name="T3" fmla="*/ 560 h 560"/>
                  <a:gd name="T4" fmla="*/ 368 w 458"/>
                  <a:gd name="T5" fmla="*/ 560 h 560"/>
                  <a:gd name="T6" fmla="*/ 368 w 458"/>
                  <a:gd name="T7" fmla="*/ 233 h 560"/>
                  <a:gd name="T8" fmla="*/ 337 w 458"/>
                  <a:gd name="T9" fmla="*/ 117 h 560"/>
                  <a:gd name="T10" fmla="*/ 247 w 458"/>
                  <a:gd name="T11" fmla="*/ 78 h 560"/>
                  <a:gd name="T12" fmla="*/ 132 w 458"/>
                  <a:gd name="T13" fmla="*/ 125 h 560"/>
                  <a:gd name="T14" fmla="*/ 90 w 458"/>
                  <a:gd name="T15" fmla="*/ 251 h 560"/>
                  <a:gd name="T16" fmla="*/ 90 w 458"/>
                  <a:gd name="T17" fmla="*/ 560 h 560"/>
                  <a:gd name="T18" fmla="*/ 0 w 458"/>
                  <a:gd name="T19" fmla="*/ 560 h 560"/>
                  <a:gd name="T20" fmla="*/ 0 w 458"/>
                  <a:gd name="T21" fmla="*/ 13 h 560"/>
                  <a:gd name="T22" fmla="*/ 90 w 458"/>
                  <a:gd name="T23" fmla="*/ 13 h 560"/>
                  <a:gd name="T24" fmla="*/ 90 w 458"/>
                  <a:gd name="T25" fmla="*/ 98 h 560"/>
                  <a:gd name="T26" fmla="*/ 166 w 458"/>
                  <a:gd name="T27" fmla="*/ 25 h 560"/>
                  <a:gd name="T28" fmla="*/ 267 w 458"/>
                  <a:gd name="T29" fmla="*/ 0 h 560"/>
                  <a:gd name="T30" fmla="*/ 409 w 458"/>
                  <a:gd name="T31" fmla="*/ 59 h 560"/>
                  <a:gd name="T32" fmla="*/ 458 w 458"/>
                  <a:gd name="T33" fmla="*/ 230 h 5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58" h="560">
                    <a:moveTo>
                      <a:pt x="458" y="230"/>
                    </a:moveTo>
                    <a:lnTo>
                      <a:pt x="458" y="560"/>
                    </a:lnTo>
                    <a:lnTo>
                      <a:pt x="368" y="560"/>
                    </a:lnTo>
                    <a:lnTo>
                      <a:pt x="368" y="233"/>
                    </a:lnTo>
                    <a:cubicBezTo>
                      <a:pt x="368" y="181"/>
                      <a:pt x="357" y="143"/>
                      <a:pt x="337" y="117"/>
                    </a:cubicBezTo>
                    <a:cubicBezTo>
                      <a:pt x="317" y="91"/>
                      <a:pt x="287" y="78"/>
                      <a:pt x="247" y="78"/>
                    </a:cubicBezTo>
                    <a:cubicBezTo>
                      <a:pt x="198" y="78"/>
                      <a:pt x="160" y="94"/>
                      <a:pt x="132" y="125"/>
                    </a:cubicBezTo>
                    <a:cubicBezTo>
                      <a:pt x="104" y="156"/>
                      <a:pt x="90" y="198"/>
                      <a:pt x="90" y="251"/>
                    </a:cubicBezTo>
                    <a:lnTo>
                      <a:pt x="90" y="560"/>
                    </a:lnTo>
                    <a:lnTo>
                      <a:pt x="0" y="560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8"/>
                    </a:lnTo>
                    <a:cubicBezTo>
                      <a:pt x="111" y="66"/>
                      <a:pt x="136" y="41"/>
                      <a:pt x="166" y="25"/>
                    </a:cubicBezTo>
                    <a:cubicBezTo>
                      <a:pt x="195" y="9"/>
                      <a:pt x="229" y="0"/>
                      <a:pt x="267" y="0"/>
                    </a:cubicBezTo>
                    <a:cubicBezTo>
                      <a:pt x="329" y="0"/>
                      <a:pt x="377" y="20"/>
                      <a:pt x="409" y="59"/>
                    </a:cubicBezTo>
                    <a:cubicBezTo>
                      <a:pt x="441" y="98"/>
                      <a:pt x="458" y="155"/>
                      <a:pt x="458" y="230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79" name="Freeform 406">
                <a:extLst>
                  <a:ext uri="{FF2B5EF4-FFF2-40B4-BE49-F238E27FC236}">
                    <a16:creationId xmlns:a16="http://schemas.microsoft.com/office/drawing/2014/main" id="{7FADE5ED-6A90-1278-F893-5DE3095ACA5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070600" y="3003550"/>
                <a:ext cx="82550" cy="103188"/>
              </a:xfrm>
              <a:custGeom>
                <a:avLst/>
                <a:gdLst>
                  <a:gd name="T0" fmla="*/ 283 w 462"/>
                  <a:gd name="T1" fmla="*/ 285 h 573"/>
                  <a:gd name="T2" fmla="*/ 132 w 462"/>
                  <a:gd name="T3" fmla="*/ 310 h 573"/>
                  <a:gd name="T4" fmla="*/ 90 w 462"/>
                  <a:gd name="T5" fmla="*/ 395 h 573"/>
                  <a:gd name="T6" fmla="*/ 121 w 462"/>
                  <a:gd name="T7" fmla="*/ 471 h 573"/>
                  <a:gd name="T8" fmla="*/ 207 w 462"/>
                  <a:gd name="T9" fmla="*/ 499 h 573"/>
                  <a:gd name="T10" fmla="*/ 327 w 462"/>
                  <a:gd name="T11" fmla="*/ 446 h 573"/>
                  <a:gd name="T12" fmla="*/ 372 w 462"/>
                  <a:gd name="T13" fmla="*/ 305 h 573"/>
                  <a:gd name="T14" fmla="*/ 372 w 462"/>
                  <a:gd name="T15" fmla="*/ 285 h 573"/>
                  <a:gd name="T16" fmla="*/ 283 w 462"/>
                  <a:gd name="T17" fmla="*/ 285 h 573"/>
                  <a:gd name="T18" fmla="*/ 462 w 462"/>
                  <a:gd name="T19" fmla="*/ 248 h 573"/>
                  <a:gd name="T20" fmla="*/ 462 w 462"/>
                  <a:gd name="T21" fmla="*/ 560 h 573"/>
                  <a:gd name="T22" fmla="*/ 372 w 462"/>
                  <a:gd name="T23" fmla="*/ 560 h 573"/>
                  <a:gd name="T24" fmla="*/ 372 w 462"/>
                  <a:gd name="T25" fmla="*/ 477 h 573"/>
                  <a:gd name="T26" fmla="*/ 295 w 462"/>
                  <a:gd name="T27" fmla="*/ 550 h 573"/>
                  <a:gd name="T28" fmla="*/ 183 w 462"/>
                  <a:gd name="T29" fmla="*/ 573 h 573"/>
                  <a:gd name="T30" fmla="*/ 49 w 462"/>
                  <a:gd name="T31" fmla="*/ 527 h 573"/>
                  <a:gd name="T32" fmla="*/ 0 w 462"/>
                  <a:gd name="T33" fmla="*/ 401 h 573"/>
                  <a:gd name="T34" fmla="*/ 62 w 462"/>
                  <a:gd name="T35" fmla="*/ 262 h 573"/>
                  <a:gd name="T36" fmla="*/ 246 w 462"/>
                  <a:gd name="T37" fmla="*/ 215 h 573"/>
                  <a:gd name="T38" fmla="*/ 372 w 462"/>
                  <a:gd name="T39" fmla="*/ 215 h 573"/>
                  <a:gd name="T40" fmla="*/ 372 w 462"/>
                  <a:gd name="T41" fmla="*/ 206 h 573"/>
                  <a:gd name="T42" fmla="*/ 331 w 462"/>
                  <a:gd name="T43" fmla="*/ 110 h 573"/>
                  <a:gd name="T44" fmla="*/ 217 w 462"/>
                  <a:gd name="T45" fmla="*/ 76 h 573"/>
                  <a:gd name="T46" fmla="*/ 125 w 462"/>
                  <a:gd name="T47" fmla="*/ 88 h 573"/>
                  <a:gd name="T48" fmla="*/ 40 w 462"/>
                  <a:gd name="T49" fmla="*/ 121 h 573"/>
                  <a:gd name="T50" fmla="*/ 40 w 462"/>
                  <a:gd name="T51" fmla="*/ 38 h 573"/>
                  <a:gd name="T52" fmla="*/ 135 w 462"/>
                  <a:gd name="T53" fmla="*/ 10 h 573"/>
                  <a:gd name="T54" fmla="*/ 226 w 462"/>
                  <a:gd name="T55" fmla="*/ 0 h 573"/>
                  <a:gd name="T56" fmla="*/ 403 w 462"/>
                  <a:gd name="T57" fmla="*/ 62 h 573"/>
                  <a:gd name="T58" fmla="*/ 462 w 462"/>
                  <a:gd name="T59" fmla="*/ 248 h 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462" h="573">
                    <a:moveTo>
                      <a:pt x="283" y="285"/>
                    </a:moveTo>
                    <a:cubicBezTo>
                      <a:pt x="210" y="285"/>
                      <a:pt x="160" y="294"/>
                      <a:pt x="132" y="310"/>
                    </a:cubicBezTo>
                    <a:cubicBezTo>
                      <a:pt x="104" y="327"/>
                      <a:pt x="90" y="355"/>
                      <a:pt x="90" y="395"/>
                    </a:cubicBezTo>
                    <a:cubicBezTo>
                      <a:pt x="90" y="427"/>
                      <a:pt x="100" y="453"/>
                      <a:pt x="121" y="471"/>
                    </a:cubicBezTo>
                    <a:cubicBezTo>
                      <a:pt x="142" y="490"/>
                      <a:pt x="171" y="499"/>
                      <a:pt x="207" y="499"/>
                    </a:cubicBezTo>
                    <a:cubicBezTo>
                      <a:pt x="257" y="499"/>
                      <a:pt x="297" y="482"/>
                      <a:pt x="327" y="446"/>
                    </a:cubicBezTo>
                    <a:cubicBezTo>
                      <a:pt x="357" y="411"/>
                      <a:pt x="372" y="364"/>
                      <a:pt x="372" y="305"/>
                    </a:cubicBezTo>
                    <a:lnTo>
                      <a:pt x="372" y="285"/>
                    </a:lnTo>
                    <a:lnTo>
                      <a:pt x="283" y="285"/>
                    </a:lnTo>
                    <a:close/>
                    <a:moveTo>
                      <a:pt x="462" y="248"/>
                    </a:moveTo>
                    <a:lnTo>
                      <a:pt x="462" y="560"/>
                    </a:lnTo>
                    <a:lnTo>
                      <a:pt x="372" y="560"/>
                    </a:lnTo>
                    <a:lnTo>
                      <a:pt x="372" y="477"/>
                    </a:lnTo>
                    <a:cubicBezTo>
                      <a:pt x="351" y="511"/>
                      <a:pt x="325" y="535"/>
                      <a:pt x="295" y="550"/>
                    </a:cubicBezTo>
                    <a:cubicBezTo>
                      <a:pt x="265" y="565"/>
                      <a:pt x="227" y="573"/>
                      <a:pt x="183" y="573"/>
                    </a:cubicBezTo>
                    <a:cubicBezTo>
                      <a:pt x="127" y="573"/>
                      <a:pt x="82" y="558"/>
                      <a:pt x="49" y="527"/>
                    </a:cubicBezTo>
                    <a:cubicBezTo>
                      <a:pt x="16" y="496"/>
                      <a:pt x="0" y="454"/>
                      <a:pt x="0" y="401"/>
                    </a:cubicBezTo>
                    <a:cubicBezTo>
                      <a:pt x="0" y="340"/>
                      <a:pt x="20" y="294"/>
                      <a:pt x="62" y="262"/>
                    </a:cubicBezTo>
                    <a:cubicBezTo>
                      <a:pt x="103" y="231"/>
                      <a:pt x="164" y="215"/>
                      <a:pt x="246" y="215"/>
                    </a:cubicBezTo>
                    <a:lnTo>
                      <a:pt x="372" y="215"/>
                    </a:lnTo>
                    <a:lnTo>
                      <a:pt x="372" y="206"/>
                    </a:lnTo>
                    <a:cubicBezTo>
                      <a:pt x="372" y="165"/>
                      <a:pt x="358" y="133"/>
                      <a:pt x="331" y="110"/>
                    </a:cubicBezTo>
                    <a:cubicBezTo>
                      <a:pt x="304" y="88"/>
                      <a:pt x="266" y="76"/>
                      <a:pt x="217" y="76"/>
                    </a:cubicBezTo>
                    <a:cubicBezTo>
                      <a:pt x="185" y="76"/>
                      <a:pt x="155" y="80"/>
                      <a:pt x="125" y="88"/>
                    </a:cubicBezTo>
                    <a:cubicBezTo>
                      <a:pt x="95" y="96"/>
                      <a:pt x="67" y="107"/>
                      <a:pt x="40" y="121"/>
                    </a:cubicBezTo>
                    <a:lnTo>
                      <a:pt x="40" y="38"/>
                    </a:lnTo>
                    <a:cubicBezTo>
                      <a:pt x="72" y="26"/>
                      <a:pt x="104" y="16"/>
                      <a:pt x="135" y="10"/>
                    </a:cubicBezTo>
                    <a:cubicBezTo>
                      <a:pt x="166" y="4"/>
                      <a:pt x="196" y="0"/>
                      <a:pt x="226" y="0"/>
                    </a:cubicBezTo>
                    <a:cubicBezTo>
                      <a:pt x="305" y="0"/>
                      <a:pt x="364" y="21"/>
                      <a:pt x="403" y="62"/>
                    </a:cubicBezTo>
                    <a:cubicBezTo>
                      <a:pt x="442" y="103"/>
                      <a:pt x="462" y="165"/>
                      <a:pt x="462" y="248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80" name="Freeform 407">
                <a:extLst>
                  <a:ext uri="{FF2B5EF4-FFF2-40B4-BE49-F238E27FC236}">
                    <a16:creationId xmlns:a16="http://schemas.microsoft.com/office/drawing/2014/main" id="{56ADC2D4-8D49-4E7D-1D93-E3DE06A29D2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186488" y="3003550"/>
                <a:ext cx="88900" cy="138113"/>
              </a:xfrm>
              <a:custGeom>
                <a:avLst/>
                <a:gdLst>
                  <a:gd name="T0" fmla="*/ 90 w 489"/>
                  <a:gd name="T1" fmla="*/ 478 h 767"/>
                  <a:gd name="T2" fmla="*/ 90 w 489"/>
                  <a:gd name="T3" fmla="*/ 767 h 767"/>
                  <a:gd name="T4" fmla="*/ 0 w 489"/>
                  <a:gd name="T5" fmla="*/ 767 h 767"/>
                  <a:gd name="T6" fmla="*/ 0 w 489"/>
                  <a:gd name="T7" fmla="*/ 13 h 767"/>
                  <a:gd name="T8" fmla="*/ 90 w 489"/>
                  <a:gd name="T9" fmla="*/ 13 h 767"/>
                  <a:gd name="T10" fmla="*/ 90 w 489"/>
                  <a:gd name="T11" fmla="*/ 96 h 767"/>
                  <a:gd name="T12" fmla="*/ 161 w 489"/>
                  <a:gd name="T13" fmla="*/ 24 h 767"/>
                  <a:gd name="T14" fmla="*/ 265 w 489"/>
                  <a:gd name="T15" fmla="*/ 0 h 767"/>
                  <a:gd name="T16" fmla="*/ 427 w 489"/>
                  <a:gd name="T17" fmla="*/ 79 h 767"/>
                  <a:gd name="T18" fmla="*/ 489 w 489"/>
                  <a:gd name="T19" fmla="*/ 287 h 767"/>
                  <a:gd name="T20" fmla="*/ 427 w 489"/>
                  <a:gd name="T21" fmla="*/ 495 h 767"/>
                  <a:gd name="T22" fmla="*/ 265 w 489"/>
                  <a:gd name="T23" fmla="*/ 573 h 767"/>
                  <a:gd name="T24" fmla="*/ 161 w 489"/>
                  <a:gd name="T25" fmla="*/ 550 h 767"/>
                  <a:gd name="T26" fmla="*/ 90 w 489"/>
                  <a:gd name="T27" fmla="*/ 478 h 767"/>
                  <a:gd name="T28" fmla="*/ 396 w 489"/>
                  <a:gd name="T29" fmla="*/ 287 h 767"/>
                  <a:gd name="T30" fmla="*/ 355 w 489"/>
                  <a:gd name="T31" fmla="*/ 132 h 767"/>
                  <a:gd name="T32" fmla="*/ 243 w 489"/>
                  <a:gd name="T33" fmla="*/ 75 h 767"/>
                  <a:gd name="T34" fmla="*/ 131 w 489"/>
                  <a:gd name="T35" fmla="*/ 132 h 767"/>
                  <a:gd name="T36" fmla="*/ 90 w 489"/>
                  <a:gd name="T37" fmla="*/ 287 h 767"/>
                  <a:gd name="T38" fmla="*/ 131 w 489"/>
                  <a:gd name="T39" fmla="*/ 443 h 767"/>
                  <a:gd name="T40" fmla="*/ 243 w 489"/>
                  <a:gd name="T41" fmla="*/ 499 h 767"/>
                  <a:gd name="T42" fmla="*/ 355 w 489"/>
                  <a:gd name="T43" fmla="*/ 443 h 767"/>
                  <a:gd name="T44" fmla="*/ 396 w 489"/>
                  <a:gd name="T45" fmla="*/ 287 h 7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489" h="767">
                    <a:moveTo>
                      <a:pt x="90" y="478"/>
                    </a:moveTo>
                    <a:lnTo>
                      <a:pt x="90" y="767"/>
                    </a:lnTo>
                    <a:lnTo>
                      <a:pt x="0" y="767"/>
                    </a:lnTo>
                    <a:lnTo>
                      <a:pt x="0" y="13"/>
                    </a:lnTo>
                    <a:lnTo>
                      <a:pt x="90" y="13"/>
                    </a:lnTo>
                    <a:lnTo>
                      <a:pt x="90" y="96"/>
                    </a:lnTo>
                    <a:cubicBezTo>
                      <a:pt x="108" y="64"/>
                      <a:pt x="132" y="40"/>
                      <a:pt x="161" y="24"/>
                    </a:cubicBezTo>
                    <a:cubicBezTo>
                      <a:pt x="190" y="8"/>
                      <a:pt x="225" y="0"/>
                      <a:pt x="265" y="0"/>
                    </a:cubicBezTo>
                    <a:cubicBezTo>
                      <a:pt x="331" y="0"/>
                      <a:pt x="385" y="27"/>
                      <a:pt x="427" y="79"/>
                    </a:cubicBezTo>
                    <a:cubicBezTo>
                      <a:pt x="468" y="132"/>
                      <a:pt x="489" y="201"/>
                      <a:pt x="489" y="287"/>
                    </a:cubicBezTo>
                    <a:cubicBezTo>
                      <a:pt x="489" y="373"/>
                      <a:pt x="468" y="443"/>
                      <a:pt x="427" y="495"/>
                    </a:cubicBezTo>
                    <a:cubicBezTo>
                      <a:pt x="385" y="547"/>
                      <a:pt x="331" y="573"/>
                      <a:pt x="265" y="573"/>
                    </a:cubicBezTo>
                    <a:cubicBezTo>
                      <a:pt x="225" y="573"/>
                      <a:pt x="190" y="565"/>
                      <a:pt x="161" y="550"/>
                    </a:cubicBezTo>
                    <a:cubicBezTo>
                      <a:pt x="132" y="535"/>
                      <a:pt x="108" y="511"/>
                      <a:pt x="90" y="478"/>
                    </a:cubicBezTo>
                    <a:close/>
                    <a:moveTo>
                      <a:pt x="396" y="287"/>
                    </a:moveTo>
                    <a:cubicBezTo>
                      <a:pt x="396" y="221"/>
                      <a:pt x="382" y="170"/>
                      <a:pt x="355" y="132"/>
                    </a:cubicBezTo>
                    <a:cubicBezTo>
                      <a:pt x="327" y="94"/>
                      <a:pt x="290" y="75"/>
                      <a:pt x="243" y="75"/>
                    </a:cubicBezTo>
                    <a:cubicBezTo>
                      <a:pt x="195" y="75"/>
                      <a:pt x="158" y="94"/>
                      <a:pt x="131" y="132"/>
                    </a:cubicBezTo>
                    <a:cubicBezTo>
                      <a:pt x="103" y="170"/>
                      <a:pt x="90" y="221"/>
                      <a:pt x="90" y="287"/>
                    </a:cubicBezTo>
                    <a:cubicBezTo>
                      <a:pt x="90" y="353"/>
                      <a:pt x="103" y="405"/>
                      <a:pt x="131" y="443"/>
                    </a:cubicBezTo>
                    <a:cubicBezTo>
                      <a:pt x="158" y="481"/>
                      <a:pt x="195" y="499"/>
                      <a:pt x="243" y="499"/>
                    </a:cubicBezTo>
                    <a:cubicBezTo>
                      <a:pt x="290" y="499"/>
                      <a:pt x="327" y="481"/>
                      <a:pt x="355" y="443"/>
                    </a:cubicBezTo>
                    <a:cubicBezTo>
                      <a:pt x="382" y="405"/>
                      <a:pt x="396" y="353"/>
                      <a:pt x="396" y="287"/>
                    </a:cubicBezTo>
                    <a:close/>
                  </a:path>
                </a:pathLst>
              </a:custGeom>
              <a:solidFill>
                <a:srgbClr val="262626"/>
              </a:solidFill>
              <a:ln w="0">
                <a:noFill/>
                <a:prstDash val="solid"/>
                <a:round/>
                <a:headEnd/>
                <a:tailEnd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747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162</TotalTime>
  <Words>78</Words>
  <Application>Microsoft Office PowerPoint</Application>
  <PresentationFormat>Custom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as Nehme</dc:creator>
  <cp:lastModifiedBy>Elias Nehme</cp:lastModifiedBy>
  <cp:revision>23</cp:revision>
  <dcterms:created xsi:type="dcterms:W3CDTF">2023-04-04T13:02:26Z</dcterms:created>
  <dcterms:modified xsi:type="dcterms:W3CDTF">2024-04-02T14:44:38Z</dcterms:modified>
</cp:coreProperties>
</file>